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charts/chart19.xml" ContentType="application/vnd.openxmlformats-officedocument.drawingml.chart+xml"/>
  <Override PartName="/ppt/charts/chart28.xml" ContentType="application/vnd.openxmlformats-officedocument.drawingml.chart+xml"/>
  <Override PartName="/customXml/itemProps1.xml" ContentType="application/vnd.openxmlformats-officedocument.customXmlPropertie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charts/chart17.xml" ContentType="application/vnd.openxmlformats-officedocument.drawingml.chart+xml"/>
  <Override PartName="/ppt/charts/chart26.xml" ContentType="application/vnd.openxmlformats-officedocument.drawingml.chart+xml"/>
  <Default Extension="rels" ContentType="application/vnd.openxmlformats-package.relationships+xml"/>
  <Default Extension="xml" ContentType="application/xml"/>
  <Override PartName="/ppt/notesMasters/notesMaster1.xml" ContentType="application/vnd.openxmlformats-officedocument.presentationml.notesMaster+xml"/>
  <Override PartName="/ppt/charts/chart13.xml" ContentType="application/vnd.openxmlformats-officedocument.drawingml.chart+xml"/>
  <Override PartName="/ppt/charts/chart15.xml" ContentType="application/vnd.openxmlformats-officedocument.drawingml.chart+xml"/>
  <Override PartName="/ppt/charts/chart24.xml" ContentType="application/vnd.openxmlformats-officedocument.drawingml.chart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9.xml" ContentType="application/vnd.openxmlformats-officedocument.drawingml.chart+xml"/>
  <Override PartName="/ppt/charts/chart11.xml" ContentType="application/vnd.openxmlformats-officedocument.drawingml.chart+xml"/>
  <Override PartName="/ppt/charts/chart22.xml" ContentType="application/vnd.openxmlformats-officedocument.drawingml.chart+xml"/>
  <Override PartName="/docProps/custom.xml" ContentType="application/vnd.openxmlformats-officedocument.custom-properties+xml"/>
  <Override PartName="/ppt/charts/chart7.xml" ContentType="application/vnd.openxmlformats-officedocument.drawingml.chart+xml"/>
  <Override PartName="/ppt/charts/chart20.xml" ContentType="application/vnd.openxmlformats-officedocument.drawingml.chart+xml"/>
  <Override PartName="/ppt/charts/chart3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charts/chart29.xml" ContentType="application/vnd.openxmlformats-officedocument.drawingml.chart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charts/chart18.xml" ContentType="application/vnd.openxmlformats-officedocument.drawingml.chart+xml"/>
  <Override PartName="/ppt/charts/chart27.xml" ContentType="application/vnd.openxmlformats-officedocument.drawingml.chart+xml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  <Override PartName="/ppt/charts/chart16.xml" ContentType="application/vnd.openxmlformats-officedocument.drawingml.chart+xml"/>
  <Override PartName="/ppt/charts/chart25.xml" ContentType="application/vnd.openxmlformats-officedocument.drawingml.chart+xml"/>
  <Default Extension="jpeg" ContentType="image/jpeg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charts/chart14.xml" ContentType="application/vnd.openxmlformats-officedocument.drawingml.chart+xml"/>
  <Override PartName="/ppt/charts/chart23.xml" ContentType="application/vnd.openxmlformats-officedocument.drawingml.chart+xml"/>
  <Override PartName="/docProps/app.xml" ContentType="application/vnd.openxmlformats-officedocument.extended-properties+xml"/>
  <Override PartName="/ppt/charts/chart8.xml" ContentType="application/vnd.openxmlformats-officedocument.drawingml.chart+xml"/>
  <Override PartName="/ppt/charts/chart12.xml" ContentType="application/vnd.openxmlformats-officedocument.drawingml.chart+xml"/>
  <Override PartName="/ppt/charts/chart21.xml" ContentType="application/vnd.openxmlformats-officedocument.drawingml.chart+xml"/>
  <Override PartName="/ppt/charts/chart30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10.xml" ContentType="application/vnd.openxmlformats-officedocument.drawingml.chart+xml"/>
  <Override PartName="/ppt/charts/chart4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7" r:id="rId3"/>
    <p:sldId id="258" r:id="rId4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4878" y="1164"/>
      </p:cViewPr>
      <p:guideLst>
        <p:guide orient="horz" pos="1487"/>
        <p:guide pos="14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openxmlformats.org/officeDocument/2006/relationships/customXml" Target="../customXml/item2.xml"/><Relationship Id="rId5" Type="http://schemas.openxmlformats.org/officeDocument/2006/relationships/notesMaster" Target="notesMasters/notesMaster1.xml"/><Relationship Id="rId10" Type="http://schemas.openxmlformats.org/officeDocument/2006/relationships/customXml" Target="../customXml/item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unc-25%20A2_0.02_50%25_&#34411;&#27598;&#12498;&#12473;&#12488;&#12464;&#12521;&#12512;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unc-25%20A5_0.02_50%25_&#34411;&#27598;&#12498;&#12473;&#12488;&#12464;&#12521;&#12512;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nmr-1(ak4)_A5_0.02_50%25_&#34411;&#27598;&#12498;&#12473;&#12488;&#12464;&#12521;&#12512;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nmr-1(ak4)_A3_0.02_50%25_&#34411;&#27598;&#12498;&#12473;&#12488;&#12464;&#12521;&#12512;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nmr-1(ak4)_A1_0.02_50%25_&#34411;&#27598;&#12498;&#12473;&#12488;&#12464;&#12521;&#12512;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glr-1(n2461)_A5_0.02_50%25_&#34411;&#27598;&#12498;&#12473;&#12488;&#12464;&#12521;&#12512;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glr-1(n2461)_A3_0.02_50%25_&#34411;&#27598;&#12498;&#12473;&#12488;&#12464;&#12521;&#12512;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glr-1(n2461)_A1_0.02_50%25_&#34411;&#27598;&#12498;&#12473;&#12488;&#12464;&#12521;&#12512;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unc-49%20A3_0.02_50%25_&#34411;&#27598;&#12498;&#12473;&#12488;&#12464;&#12521;&#12512;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unc-49%20L4_0.02_50%25_&#34411;&#27598;&#12498;&#12473;&#12488;&#12464;&#12521;&#12512;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unc-49%20A2_0.02_50%25_&#34411;&#27598;&#12498;&#12473;&#12488;&#12464;&#12521;&#12512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unc-25%20A3_0.02_50%25_&#34411;&#27598;&#12498;&#12473;&#12488;&#12464;&#12521;&#12512;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unc-49%20A1_0.02_50%25_&#34411;&#27598;&#12498;&#12473;&#12488;&#12464;&#12521;&#12512;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unc-49%20A5_0.02_50%25_&#34411;&#27598;&#12498;&#12473;&#12488;&#12464;&#12521;&#12512;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cat-2(CB1112)_A5_0.02_50%25_&#34411;&#27598;&#12498;&#12473;&#12488;&#12464;&#12521;&#12512;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cat-2(CB1112)_A3_0.02_50%25_&#34411;&#27598;&#12498;&#12473;&#12488;&#12464;&#12521;&#12512;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cat-2(CB1112)_A1_0.02_50%25_&#34411;&#27598;&#12498;&#12473;&#12488;&#12464;&#12521;&#12512;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cat-1(CB1111)_A5_0.02_50%25_&#34411;&#27598;&#12498;&#12473;&#12488;&#12464;&#12521;&#12512;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cat-1(CB1111)_A3_0.02_50%25_&#34411;&#27598;&#12498;&#12473;&#12488;&#12464;&#12521;&#12512;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cat-1(CB1111)_A1_0.02_50%25_&#34411;&#27598;&#12498;&#12473;&#12488;&#12464;&#12521;&#12512;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tph-1(mg280)_A3_0.02_50%25_&#34411;&#27598;&#12498;&#12473;&#12488;&#12464;&#12521;&#12512;.xlsx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tph-1(mg280)_A5_0.02_50%25_&#34411;&#27598;&#12498;&#12473;&#12488;&#12464;&#12521;&#12512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unc-25%20A1_0.02_50%25_&#34411;&#27598;&#12498;&#12473;&#12488;&#12464;&#12521;&#12512;.xlsx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tph-1(mg280)_A1_0.02_50%25_&#34411;&#27598;&#12498;&#12473;&#12488;&#12464;&#12521;&#12512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unc-25%20L4_0.02_50%25_&#34411;&#27598;&#12498;&#12473;&#12488;&#12464;&#12521;&#12512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N2%20A3_0.02_50%25_&#34411;&#27598;&#12498;&#12473;&#12488;&#12464;&#12521;&#12512;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N2%20A2_0.02_50%25_&#34411;&#27598;&#12498;&#12473;&#12488;&#12464;&#12521;&#12512;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N2%20L4_0.02_50%25_&#34411;&#27598;&#12498;&#12473;&#12488;&#12464;&#12521;&#12512;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N2%20A1_0.02_50%25_&#34411;&#27598;&#12498;&#12473;&#12488;&#12464;&#12521;&#12512;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G:\2012_10_26_&#20132;&#28857;&#38291;&#36317;&#38626;&#35336;&#31639;2\0.02_50%25\&#34411;&#27598;&#12498;&#12473;&#12488;&#12464;&#12521;&#12512;50%25\N2%20A5_0.02_50%25_&#34411;&#27598;&#12498;&#12473;&#12488;&#12464;&#12521;&#1251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25</a:t>
            </a:r>
            <a:r>
              <a:rPr lang="en-US" altLang="ja-JP" sz="1400" b="0" baseline="0" dirty="0">
                <a:latin typeface="Arial" pitchFamily="34" charset="0"/>
                <a:cs typeface="Arial" pitchFamily="34" charset="0"/>
              </a:rPr>
              <a:t> A2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25 A2_0.02_50%'!$B$104</c:f>
              <c:strCache>
                <c:ptCount val="1"/>
                <c:pt idx="0">
                  <c:v>unc-25_A2_40_30_01</c:v>
                </c:pt>
              </c:strCache>
            </c:strRef>
          </c:tx>
          <c:marker>
            <c:symbol val="none"/>
          </c:marker>
          <c:cat>
            <c:numRef>
              <c:f>'unc-25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2_0.02_50%'!$B$105:$B$135</c:f>
              <c:numCache>
                <c:formatCode>General</c:formatCode>
                <c:ptCount val="31"/>
                <c:pt idx="1">
                  <c:v>5.13100436681223E-2</c:v>
                </c:pt>
                <c:pt idx="2">
                  <c:v>5.13100436681223E-2</c:v>
                </c:pt>
                <c:pt idx="3">
                  <c:v>5.5676855895196498E-2</c:v>
                </c:pt>
                <c:pt idx="4">
                  <c:v>4.9126637554585136E-2</c:v>
                </c:pt>
                <c:pt idx="5">
                  <c:v>4.2576419213973815E-2</c:v>
                </c:pt>
                <c:pt idx="6">
                  <c:v>2.5109170305676911E-2</c:v>
                </c:pt>
                <c:pt idx="7">
                  <c:v>2.6200873362445407E-2</c:v>
                </c:pt>
                <c:pt idx="8">
                  <c:v>1.7467248908296894E-2</c:v>
                </c:pt>
                <c:pt idx="9">
                  <c:v>1.4192139737991299E-2</c:v>
                </c:pt>
                <c:pt idx="10">
                  <c:v>1.85589519650655E-2</c:v>
                </c:pt>
                <c:pt idx="11">
                  <c:v>1.6375545851528402E-2</c:v>
                </c:pt>
                <c:pt idx="12">
                  <c:v>2.6200873362445407E-2</c:v>
                </c:pt>
                <c:pt idx="13">
                  <c:v>5.0218340611353697E-2</c:v>
                </c:pt>
                <c:pt idx="14">
                  <c:v>6.1135371179039298E-2</c:v>
                </c:pt>
                <c:pt idx="15">
                  <c:v>4.4759825327510903E-2</c:v>
                </c:pt>
                <c:pt idx="16">
                  <c:v>6.0043668122270702E-2</c:v>
                </c:pt>
                <c:pt idx="17">
                  <c:v>5.13100436681223E-2</c:v>
                </c:pt>
                <c:pt idx="18">
                  <c:v>6.5502183406113509E-2</c:v>
                </c:pt>
                <c:pt idx="19">
                  <c:v>2.8384279475982498E-2</c:v>
                </c:pt>
                <c:pt idx="20">
                  <c:v>3.9301310043668117E-2</c:v>
                </c:pt>
                <c:pt idx="21">
                  <c:v>1.85589519650655E-2</c:v>
                </c:pt>
                <c:pt idx="22">
                  <c:v>1.4192139737991299E-2</c:v>
                </c:pt>
                <c:pt idx="23">
                  <c:v>1.0917030567685601E-2</c:v>
                </c:pt>
                <c:pt idx="24">
                  <c:v>1.0917030567685601E-2</c:v>
                </c:pt>
                <c:pt idx="25">
                  <c:v>6.5502183406113516E-3</c:v>
                </c:pt>
                <c:pt idx="26">
                  <c:v>4.3668122270742399E-3</c:v>
                </c:pt>
                <c:pt idx="27">
                  <c:v>5.4585152838427901E-3</c:v>
                </c:pt>
                <c:pt idx="28">
                  <c:v>3.275109170305681E-3</c:v>
                </c:pt>
                <c:pt idx="29">
                  <c:v>2.1834061135371208E-3</c:v>
                </c:pt>
                <c:pt idx="30">
                  <c:v>0</c:v>
                </c:pt>
              </c:numCache>
            </c:numRef>
          </c:val>
        </c:ser>
        <c:ser>
          <c:idx val="1"/>
          <c:order val="1"/>
          <c:tx>
            <c:strRef>
              <c:f>'unc-25 A2_0.02_50%'!$C$104</c:f>
              <c:strCache>
                <c:ptCount val="1"/>
                <c:pt idx="0">
                  <c:v>unc-25_A2_40_30_02</c:v>
                </c:pt>
              </c:strCache>
            </c:strRef>
          </c:tx>
          <c:marker>
            <c:symbol val="none"/>
          </c:marker>
          <c:cat>
            <c:numRef>
              <c:f>'unc-25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2_0.02_50%'!$C$105:$C$135</c:f>
              <c:numCache>
                <c:formatCode>General</c:formatCode>
                <c:ptCount val="31"/>
                <c:pt idx="1">
                  <c:v>5.3254437869822514E-2</c:v>
                </c:pt>
                <c:pt idx="2">
                  <c:v>3.2544378698224921E-2</c:v>
                </c:pt>
                <c:pt idx="3">
                  <c:v>4.3392504930966538E-2</c:v>
                </c:pt>
                <c:pt idx="4">
                  <c:v>3.35305719921105E-2</c:v>
                </c:pt>
                <c:pt idx="5">
                  <c:v>2.6627218934911209E-2</c:v>
                </c:pt>
                <c:pt idx="6">
                  <c:v>1.1834319526627201E-2</c:v>
                </c:pt>
                <c:pt idx="7">
                  <c:v>1.5779092702169598E-2</c:v>
                </c:pt>
                <c:pt idx="8">
                  <c:v>1.08481262327416E-2</c:v>
                </c:pt>
                <c:pt idx="9">
                  <c:v>1.08481262327416E-2</c:v>
                </c:pt>
                <c:pt idx="10">
                  <c:v>8.8757396449704162E-3</c:v>
                </c:pt>
                <c:pt idx="11">
                  <c:v>2.3668639053254392E-2</c:v>
                </c:pt>
                <c:pt idx="12">
                  <c:v>3.35305719921105E-2</c:v>
                </c:pt>
                <c:pt idx="13">
                  <c:v>5.2268244575936901E-2</c:v>
                </c:pt>
                <c:pt idx="14">
                  <c:v>6.7061143984220903E-2</c:v>
                </c:pt>
                <c:pt idx="15">
                  <c:v>9.7633136094674597E-2</c:v>
                </c:pt>
                <c:pt idx="16">
                  <c:v>9.9605522682445852E-2</c:v>
                </c:pt>
                <c:pt idx="17">
                  <c:v>7.5936883629191335E-2</c:v>
                </c:pt>
                <c:pt idx="18">
                  <c:v>8.8757396449704151E-2</c:v>
                </c:pt>
                <c:pt idx="19">
                  <c:v>5.4240631163708114E-2</c:v>
                </c:pt>
                <c:pt idx="20">
                  <c:v>3.35305719921105E-2</c:v>
                </c:pt>
                <c:pt idx="21">
                  <c:v>3.1558185404339315E-2</c:v>
                </c:pt>
                <c:pt idx="22">
                  <c:v>1.3806706114398401E-2</c:v>
                </c:pt>
                <c:pt idx="23">
                  <c:v>1.1834319526627201E-2</c:v>
                </c:pt>
                <c:pt idx="24">
                  <c:v>5.9171597633136119E-3</c:v>
                </c:pt>
                <c:pt idx="25">
                  <c:v>5.9171597633136119E-3</c:v>
                </c:pt>
                <c:pt idx="26">
                  <c:v>2.9585798816568008E-3</c:v>
                </c:pt>
                <c:pt idx="27">
                  <c:v>1.9723865877712015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unc-25 A2_0.02_50%'!$D$104</c:f>
              <c:strCache>
                <c:ptCount val="1"/>
                <c:pt idx="0">
                  <c:v>unc-25_A2_40_30_03</c:v>
                </c:pt>
              </c:strCache>
            </c:strRef>
          </c:tx>
          <c:marker>
            <c:symbol val="none"/>
          </c:marker>
          <c:cat>
            <c:numRef>
              <c:f>'unc-25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2_0.02_50%'!$D$105:$D$135</c:f>
              <c:numCache>
                <c:formatCode>General</c:formatCode>
                <c:ptCount val="31"/>
                <c:pt idx="1">
                  <c:v>7.272727272727271E-2</c:v>
                </c:pt>
                <c:pt idx="2">
                  <c:v>4.6753246753246817E-2</c:v>
                </c:pt>
                <c:pt idx="3">
                  <c:v>3.1168831168831197E-2</c:v>
                </c:pt>
                <c:pt idx="4">
                  <c:v>4.4155844155844198E-2</c:v>
                </c:pt>
                <c:pt idx="5">
                  <c:v>3.6363636363636397E-2</c:v>
                </c:pt>
                <c:pt idx="6">
                  <c:v>1.5584415584415605E-2</c:v>
                </c:pt>
                <c:pt idx="7">
                  <c:v>1.5584415584415605E-2</c:v>
                </c:pt>
                <c:pt idx="8">
                  <c:v>2.0779220779220814E-2</c:v>
                </c:pt>
                <c:pt idx="9">
                  <c:v>1.5584415584415605E-2</c:v>
                </c:pt>
                <c:pt idx="10">
                  <c:v>1.8181818181818205E-2</c:v>
                </c:pt>
                <c:pt idx="11">
                  <c:v>2.0779220779220814E-2</c:v>
                </c:pt>
                <c:pt idx="12">
                  <c:v>4.1558441558441621E-2</c:v>
                </c:pt>
                <c:pt idx="13">
                  <c:v>5.4545454545454487E-2</c:v>
                </c:pt>
                <c:pt idx="14">
                  <c:v>9.8701298701298734E-2</c:v>
                </c:pt>
                <c:pt idx="15">
                  <c:v>6.4935064935064901E-2</c:v>
                </c:pt>
                <c:pt idx="16">
                  <c:v>5.9740259740259698E-2</c:v>
                </c:pt>
                <c:pt idx="17">
                  <c:v>7.272727272727271E-2</c:v>
                </c:pt>
                <c:pt idx="18">
                  <c:v>4.1558441558441621E-2</c:v>
                </c:pt>
                <c:pt idx="19">
                  <c:v>3.8961038961039002E-2</c:v>
                </c:pt>
                <c:pt idx="20">
                  <c:v>3.6363636363636397E-2</c:v>
                </c:pt>
                <c:pt idx="21">
                  <c:v>7.7922077922077922E-3</c:v>
                </c:pt>
                <c:pt idx="22">
                  <c:v>2.0779220779220814E-2</c:v>
                </c:pt>
                <c:pt idx="23">
                  <c:v>7.7922077922077922E-3</c:v>
                </c:pt>
                <c:pt idx="24">
                  <c:v>5.1948051948051913E-3</c:v>
                </c:pt>
                <c:pt idx="25">
                  <c:v>7.7922077922077922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unc-25 A2_0.02_50%'!$E$104</c:f>
              <c:strCache>
                <c:ptCount val="1"/>
                <c:pt idx="0">
                  <c:v>unc-25_REX_A2_03</c:v>
                </c:pt>
              </c:strCache>
            </c:strRef>
          </c:tx>
          <c:marker>
            <c:symbol val="none"/>
          </c:marker>
          <c:cat>
            <c:numRef>
              <c:f>'unc-25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2_0.02_50%'!$E$105:$E$135</c:f>
              <c:numCache>
                <c:formatCode>General</c:formatCode>
                <c:ptCount val="31"/>
                <c:pt idx="1">
                  <c:v>4.5007032348804502E-2</c:v>
                </c:pt>
                <c:pt idx="2">
                  <c:v>4.781997187060482E-2</c:v>
                </c:pt>
                <c:pt idx="3">
                  <c:v>4.4303797468354403E-2</c:v>
                </c:pt>
                <c:pt idx="4">
                  <c:v>3.3052039381153302E-2</c:v>
                </c:pt>
                <c:pt idx="5">
                  <c:v>3.1645569620253215E-2</c:v>
                </c:pt>
                <c:pt idx="6">
                  <c:v>2.5316455696202493E-2</c:v>
                </c:pt>
                <c:pt idx="7">
                  <c:v>2.0393811533052E-2</c:v>
                </c:pt>
                <c:pt idx="8">
                  <c:v>9.8452883263009973E-3</c:v>
                </c:pt>
                <c:pt idx="9">
                  <c:v>7.0323488045007038E-3</c:v>
                </c:pt>
                <c:pt idx="10">
                  <c:v>1.2658227848101299E-2</c:v>
                </c:pt>
                <c:pt idx="11">
                  <c:v>2.3206751054852294E-2</c:v>
                </c:pt>
                <c:pt idx="12">
                  <c:v>4.1490857946554098E-2</c:v>
                </c:pt>
                <c:pt idx="13">
                  <c:v>6.9620253164557E-2</c:v>
                </c:pt>
                <c:pt idx="14">
                  <c:v>8.1575246132208207E-2</c:v>
                </c:pt>
                <c:pt idx="15">
                  <c:v>9.63431786216596E-2</c:v>
                </c:pt>
                <c:pt idx="16">
                  <c:v>8.9310829817158904E-2</c:v>
                </c:pt>
                <c:pt idx="17">
                  <c:v>7.1729957805907199E-2</c:v>
                </c:pt>
                <c:pt idx="18">
                  <c:v>6.1884669479606198E-2</c:v>
                </c:pt>
                <c:pt idx="19">
                  <c:v>3.8677918424753925E-2</c:v>
                </c:pt>
                <c:pt idx="20">
                  <c:v>2.6722925457102701E-2</c:v>
                </c:pt>
                <c:pt idx="21">
                  <c:v>1.8987341772151899E-2</c:v>
                </c:pt>
                <c:pt idx="22">
                  <c:v>1.0548523206751105E-2</c:v>
                </c:pt>
                <c:pt idx="23">
                  <c:v>7.7355836849507739E-3</c:v>
                </c:pt>
                <c:pt idx="24">
                  <c:v>8.438818565400838E-3</c:v>
                </c:pt>
                <c:pt idx="25">
                  <c:v>2.81293952180028E-3</c:v>
                </c:pt>
                <c:pt idx="26">
                  <c:v>7.0323488045007034E-4</c:v>
                </c:pt>
                <c:pt idx="27">
                  <c:v>7.0323488045007034E-4</c:v>
                </c:pt>
                <c:pt idx="28">
                  <c:v>2.81293952180028E-3</c:v>
                </c:pt>
                <c:pt idx="29">
                  <c:v>2.1097046413502112E-3</c:v>
                </c:pt>
                <c:pt idx="30">
                  <c:v>7.0323488045007034E-4</c:v>
                </c:pt>
              </c:numCache>
            </c:numRef>
          </c:val>
        </c:ser>
        <c:ser>
          <c:idx val="4"/>
          <c:order val="4"/>
          <c:tx>
            <c:strRef>
              <c:f>'unc-25 A2_0.02_50%'!$F$104</c:f>
              <c:strCache>
                <c:ptCount val="1"/>
                <c:pt idx="0">
                  <c:v>unc-25_REX_A2_04</c:v>
                </c:pt>
              </c:strCache>
            </c:strRef>
          </c:tx>
          <c:marker>
            <c:symbol val="none"/>
          </c:marker>
          <c:cat>
            <c:numRef>
              <c:f>'unc-25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2_0.02_50%'!$F$105:$F$135</c:f>
              <c:numCache>
                <c:formatCode>General</c:formatCode>
                <c:ptCount val="31"/>
                <c:pt idx="1">
                  <c:v>4.8500881834215227E-2</c:v>
                </c:pt>
                <c:pt idx="2">
                  <c:v>3.7918871252204604E-2</c:v>
                </c:pt>
                <c:pt idx="3">
                  <c:v>3.1746031746031703E-2</c:v>
                </c:pt>
                <c:pt idx="4">
                  <c:v>3.7918871252204604E-2</c:v>
                </c:pt>
                <c:pt idx="5">
                  <c:v>2.2927689594356301E-2</c:v>
                </c:pt>
                <c:pt idx="6">
                  <c:v>1.3227513227513204E-2</c:v>
                </c:pt>
                <c:pt idx="7">
                  <c:v>9.7001763668430295E-3</c:v>
                </c:pt>
                <c:pt idx="8">
                  <c:v>1.4991181657848305E-2</c:v>
                </c:pt>
                <c:pt idx="9">
                  <c:v>1.1463844797178107E-2</c:v>
                </c:pt>
                <c:pt idx="10">
                  <c:v>1.3227513227513204E-2</c:v>
                </c:pt>
                <c:pt idx="11">
                  <c:v>1.6754850088183407E-2</c:v>
                </c:pt>
                <c:pt idx="12">
                  <c:v>2.4691358024691409E-2</c:v>
                </c:pt>
                <c:pt idx="13">
                  <c:v>3.262786596119932E-2</c:v>
                </c:pt>
                <c:pt idx="14">
                  <c:v>5.6437389770723101E-2</c:v>
                </c:pt>
                <c:pt idx="15">
                  <c:v>7.3192239858906549E-2</c:v>
                </c:pt>
                <c:pt idx="16">
                  <c:v>6.8783068783068793E-2</c:v>
                </c:pt>
                <c:pt idx="17">
                  <c:v>6.1728395061728399E-2</c:v>
                </c:pt>
                <c:pt idx="18">
                  <c:v>5.29100529100529E-2</c:v>
                </c:pt>
                <c:pt idx="19">
                  <c:v>6.3492063492063502E-2</c:v>
                </c:pt>
                <c:pt idx="20">
                  <c:v>4.7619047619047616E-2</c:v>
                </c:pt>
                <c:pt idx="21">
                  <c:v>3.35097001763668E-2</c:v>
                </c:pt>
                <c:pt idx="22">
                  <c:v>1.8518518518518507E-2</c:v>
                </c:pt>
                <c:pt idx="23">
                  <c:v>2.2045855379188708E-2</c:v>
                </c:pt>
                <c:pt idx="24">
                  <c:v>1.6754850088183407E-2</c:v>
                </c:pt>
                <c:pt idx="25">
                  <c:v>1.41093474426808E-2</c:v>
                </c:pt>
                <c:pt idx="26">
                  <c:v>7.9365079365079413E-3</c:v>
                </c:pt>
                <c:pt idx="27">
                  <c:v>7.9365079365079413E-3</c:v>
                </c:pt>
                <c:pt idx="28">
                  <c:v>5.2910052910052898E-3</c:v>
                </c:pt>
                <c:pt idx="29">
                  <c:v>4.4091710758377423E-3</c:v>
                </c:pt>
                <c:pt idx="30">
                  <c:v>2.6455026455026519E-3</c:v>
                </c:pt>
              </c:numCache>
            </c:numRef>
          </c:val>
        </c:ser>
        <c:ser>
          <c:idx val="5"/>
          <c:order val="5"/>
          <c:tx>
            <c:strRef>
              <c:f>'unc-25 A2_0.02_50%'!$G$104</c:f>
              <c:strCache>
                <c:ptCount val="1"/>
                <c:pt idx="0">
                  <c:v>unc-25_REX_A2_05</c:v>
                </c:pt>
              </c:strCache>
            </c:strRef>
          </c:tx>
          <c:marker>
            <c:symbol val="none"/>
          </c:marker>
          <c:cat>
            <c:numRef>
              <c:f>'unc-25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2_0.02_50%'!$G$105:$G$135</c:f>
              <c:numCache>
                <c:formatCode>General</c:formatCode>
                <c:ptCount val="31"/>
                <c:pt idx="1">
                  <c:v>6.1912225705329199E-2</c:v>
                </c:pt>
                <c:pt idx="2">
                  <c:v>4.2319749216300911E-2</c:v>
                </c:pt>
                <c:pt idx="3">
                  <c:v>4.2319749216300911E-2</c:v>
                </c:pt>
                <c:pt idx="4">
                  <c:v>2.9780564263322894E-2</c:v>
                </c:pt>
                <c:pt idx="5">
                  <c:v>2.3510971786833899E-2</c:v>
                </c:pt>
                <c:pt idx="6">
                  <c:v>1.3322884012539208E-2</c:v>
                </c:pt>
                <c:pt idx="7">
                  <c:v>1.0188087774294698E-2</c:v>
                </c:pt>
                <c:pt idx="8">
                  <c:v>5.4858934169279023E-3</c:v>
                </c:pt>
                <c:pt idx="9">
                  <c:v>8.6206896551724154E-3</c:v>
                </c:pt>
                <c:pt idx="10">
                  <c:v>9.4043887147335394E-3</c:v>
                </c:pt>
                <c:pt idx="11">
                  <c:v>4.7021943573667697E-3</c:v>
                </c:pt>
                <c:pt idx="12">
                  <c:v>7.0532915360501623E-3</c:v>
                </c:pt>
                <c:pt idx="13">
                  <c:v>1.0971786833855799E-2</c:v>
                </c:pt>
                <c:pt idx="14">
                  <c:v>1.7241379310344803E-2</c:v>
                </c:pt>
                <c:pt idx="15">
                  <c:v>3.4482758620689717E-2</c:v>
                </c:pt>
                <c:pt idx="16">
                  <c:v>4.3103448275862079E-2</c:v>
                </c:pt>
                <c:pt idx="17">
                  <c:v>5.8777429467084585E-2</c:v>
                </c:pt>
                <c:pt idx="18">
                  <c:v>5.8777429467084585E-2</c:v>
                </c:pt>
                <c:pt idx="19">
                  <c:v>5.4075235109717901E-2</c:v>
                </c:pt>
                <c:pt idx="20">
                  <c:v>6.73981191222571E-2</c:v>
                </c:pt>
                <c:pt idx="21">
                  <c:v>4.9373040752351112E-2</c:v>
                </c:pt>
                <c:pt idx="22">
                  <c:v>4.4670846394984282E-2</c:v>
                </c:pt>
                <c:pt idx="23">
                  <c:v>2.3510971786833899E-2</c:v>
                </c:pt>
                <c:pt idx="24">
                  <c:v>2.4294670846395E-2</c:v>
                </c:pt>
                <c:pt idx="25">
                  <c:v>1.3322884012539208E-2</c:v>
                </c:pt>
                <c:pt idx="26">
                  <c:v>1.8025078369906009E-2</c:v>
                </c:pt>
                <c:pt idx="27">
                  <c:v>1.0971786833855799E-2</c:v>
                </c:pt>
                <c:pt idx="28">
                  <c:v>7.8369905956112828E-3</c:v>
                </c:pt>
                <c:pt idx="29">
                  <c:v>4.7021943573667697E-3</c:v>
                </c:pt>
                <c:pt idx="30">
                  <c:v>1.5673981191222605E-3</c:v>
                </c:pt>
              </c:numCache>
            </c:numRef>
          </c:val>
        </c:ser>
        <c:ser>
          <c:idx val="6"/>
          <c:order val="6"/>
          <c:tx>
            <c:strRef>
              <c:f>'unc-25 A2_0.02_50%'!$H$104</c:f>
              <c:strCache>
                <c:ptCount val="1"/>
                <c:pt idx="0">
                  <c:v>unc-25_REX_A2_06</c:v>
                </c:pt>
              </c:strCache>
            </c:strRef>
          </c:tx>
          <c:marker>
            <c:symbol val="none"/>
          </c:marker>
          <c:cat>
            <c:numRef>
              <c:f>'unc-25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2_0.02_50%'!$H$105:$H$135</c:f>
              <c:numCache>
                <c:formatCode>General</c:formatCode>
                <c:ptCount val="31"/>
                <c:pt idx="1">
                  <c:v>3.8009049773755715E-2</c:v>
                </c:pt>
                <c:pt idx="2">
                  <c:v>3.4389140271493215E-2</c:v>
                </c:pt>
                <c:pt idx="3">
                  <c:v>2.3529411764705889E-2</c:v>
                </c:pt>
                <c:pt idx="4">
                  <c:v>2.2624434389140292E-2</c:v>
                </c:pt>
                <c:pt idx="5">
                  <c:v>2.2624434389140292E-2</c:v>
                </c:pt>
                <c:pt idx="6">
                  <c:v>2.0814479638009E-2</c:v>
                </c:pt>
                <c:pt idx="7">
                  <c:v>1.0859728506787304E-2</c:v>
                </c:pt>
                <c:pt idx="8">
                  <c:v>6.3348416289592804E-3</c:v>
                </c:pt>
                <c:pt idx="9">
                  <c:v>1.0859728506787304E-2</c:v>
                </c:pt>
                <c:pt idx="10">
                  <c:v>7.2398190045248941E-3</c:v>
                </c:pt>
                <c:pt idx="11">
                  <c:v>7.2398190045248941E-3</c:v>
                </c:pt>
                <c:pt idx="12">
                  <c:v>9.0497737556561059E-3</c:v>
                </c:pt>
                <c:pt idx="13">
                  <c:v>2.2624434389140292E-2</c:v>
                </c:pt>
                <c:pt idx="14">
                  <c:v>4.0723981900452517E-2</c:v>
                </c:pt>
                <c:pt idx="15">
                  <c:v>6.0633484162895913E-2</c:v>
                </c:pt>
                <c:pt idx="16">
                  <c:v>6.1538461538461514E-2</c:v>
                </c:pt>
                <c:pt idx="17">
                  <c:v>6.8778280542986431E-2</c:v>
                </c:pt>
                <c:pt idx="18">
                  <c:v>9.2307692307692341E-2</c:v>
                </c:pt>
                <c:pt idx="19">
                  <c:v>8.2352941176470656E-2</c:v>
                </c:pt>
                <c:pt idx="20">
                  <c:v>7.7828054298642493E-2</c:v>
                </c:pt>
                <c:pt idx="21">
                  <c:v>5.6108597285067896E-2</c:v>
                </c:pt>
                <c:pt idx="22">
                  <c:v>3.8009049773755715E-2</c:v>
                </c:pt>
                <c:pt idx="23">
                  <c:v>3.1674208144796406E-2</c:v>
                </c:pt>
                <c:pt idx="24">
                  <c:v>1.6289592760181E-2</c:v>
                </c:pt>
                <c:pt idx="25">
                  <c:v>1.3574660633484201E-2</c:v>
                </c:pt>
                <c:pt idx="26">
                  <c:v>8.1447963800904983E-3</c:v>
                </c:pt>
                <c:pt idx="27">
                  <c:v>7.2398190045248941E-3</c:v>
                </c:pt>
                <c:pt idx="28">
                  <c:v>1.8099547511312205E-3</c:v>
                </c:pt>
                <c:pt idx="29">
                  <c:v>3.6199095022624419E-3</c:v>
                </c:pt>
                <c:pt idx="30">
                  <c:v>3.6199095022624419E-3</c:v>
                </c:pt>
              </c:numCache>
            </c:numRef>
          </c:val>
        </c:ser>
        <c:ser>
          <c:idx val="7"/>
          <c:order val="7"/>
          <c:tx>
            <c:strRef>
              <c:f>'unc-25 A2_0.02_50%'!$I$104</c:f>
              <c:strCache>
                <c:ptCount val="1"/>
                <c:pt idx="0">
                  <c:v>unc-25_REX_A2_08</c:v>
                </c:pt>
              </c:strCache>
            </c:strRef>
          </c:tx>
          <c:marker>
            <c:symbol val="none"/>
          </c:marker>
          <c:cat>
            <c:numRef>
              <c:f>'unc-25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2_0.02_50%'!$I$105:$I$135</c:f>
              <c:numCache>
                <c:formatCode>General</c:formatCode>
                <c:ptCount val="31"/>
                <c:pt idx="1">
                  <c:v>6.3618290258449325E-2</c:v>
                </c:pt>
                <c:pt idx="2">
                  <c:v>4.4731610337972225E-2</c:v>
                </c:pt>
                <c:pt idx="3">
                  <c:v>3.9761431411530795E-2</c:v>
                </c:pt>
                <c:pt idx="4">
                  <c:v>4.0755467196819099E-2</c:v>
                </c:pt>
                <c:pt idx="5">
                  <c:v>2.1868787276341999E-2</c:v>
                </c:pt>
                <c:pt idx="6">
                  <c:v>1.7892644135188901E-2</c:v>
                </c:pt>
                <c:pt idx="7">
                  <c:v>1.4910536779324099E-2</c:v>
                </c:pt>
                <c:pt idx="8">
                  <c:v>1.4910536779324099E-2</c:v>
                </c:pt>
                <c:pt idx="9">
                  <c:v>9.9403578528827041E-3</c:v>
                </c:pt>
                <c:pt idx="10">
                  <c:v>9.9403578528827041E-3</c:v>
                </c:pt>
                <c:pt idx="11">
                  <c:v>1.0934393638170999E-2</c:v>
                </c:pt>
                <c:pt idx="12">
                  <c:v>2.5844930417495013E-2</c:v>
                </c:pt>
                <c:pt idx="13">
                  <c:v>3.2803180914512911E-2</c:v>
                </c:pt>
                <c:pt idx="14">
                  <c:v>5.0695825049701812E-2</c:v>
                </c:pt>
                <c:pt idx="15">
                  <c:v>6.759443339960243E-2</c:v>
                </c:pt>
                <c:pt idx="16">
                  <c:v>7.1570576540755507E-2</c:v>
                </c:pt>
                <c:pt idx="17">
                  <c:v>6.9582504970178927E-2</c:v>
                </c:pt>
                <c:pt idx="18">
                  <c:v>6.163021868787278E-2</c:v>
                </c:pt>
                <c:pt idx="19">
                  <c:v>5.4671968190854868E-2</c:v>
                </c:pt>
                <c:pt idx="20">
                  <c:v>4.2743538767395603E-2</c:v>
                </c:pt>
                <c:pt idx="21">
                  <c:v>2.5844930417495013E-2</c:v>
                </c:pt>
                <c:pt idx="22">
                  <c:v>2.5844930417495013E-2</c:v>
                </c:pt>
                <c:pt idx="23">
                  <c:v>1.9880715705765412E-2</c:v>
                </c:pt>
                <c:pt idx="24">
                  <c:v>1.0934393638170999E-2</c:v>
                </c:pt>
                <c:pt idx="25">
                  <c:v>6.9582504970178921E-3</c:v>
                </c:pt>
                <c:pt idx="26">
                  <c:v>6.9582504970178921E-3</c:v>
                </c:pt>
                <c:pt idx="27">
                  <c:v>1.0934393638170999E-2</c:v>
                </c:pt>
                <c:pt idx="28">
                  <c:v>3.9761431411530802E-3</c:v>
                </c:pt>
                <c:pt idx="29">
                  <c:v>2.982107355864811E-3</c:v>
                </c:pt>
                <c:pt idx="30">
                  <c:v>9.9403578528827049E-4</c:v>
                </c:pt>
              </c:numCache>
            </c:numRef>
          </c:val>
        </c:ser>
        <c:ser>
          <c:idx val="8"/>
          <c:order val="8"/>
          <c:tx>
            <c:strRef>
              <c:f>'unc-25 A2_0.02_50%'!$J$104</c:f>
              <c:strCache>
                <c:ptCount val="1"/>
                <c:pt idx="0">
                  <c:v>unc-25_REX_A2_09</c:v>
                </c:pt>
              </c:strCache>
            </c:strRef>
          </c:tx>
          <c:marker>
            <c:symbol val="none"/>
          </c:marker>
          <c:cat>
            <c:numRef>
              <c:f>'unc-25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2_0.02_50%'!$J$105:$J$135</c:f>
              <c:numCache>
                <c:formatCode>General</c:formatCode>
                <c:ptCount val="31"/>
                <c:pt idx="1">
                  <c:v>8.1583683263347265E-2</c:v>
                </c:pt>
                <c:pt idx="2">
                  <c:v>6.5386922615476933E-2</c:v>
                </c:pt>
                <c:pt idx="3">
                  <c:v>7.0785842831433729E-2</c:v>
                </c:pt>
                <c:pt idx="4">
                  <c:v>3.1793641271745714E-2</c:v>
                </c:pt>
                <c:pt idx="5">
                  <c:v>3.6592681463707297E-2</c:v>
                </c:pt>
                <c:pt idx="6">
                  <c:v>2.5794841031793598E-2</c:v>
                </c:pt>
                <c:pt idx="7">
                  <c:v>2.15956808638272E-2</c:v>
                </c:pt>
                <c:pt idx="8">
                  <c:v>1.4997000599880001E-2</c:v>
                </c:pt>
                <c:pt idx="9">
                  <c:v>1.3197360527894395E-2</c:v>
                </c:pt>
                <c:pt idx="10">
                  <c:v>1.8596280743851203E-2</c:v>
                </c:pt>
                <c:pt idx="11">
                  <c:v>1.4397120575884798E-2</c:v>
                </c:pt>
                <c:pt idx="12">
                  <c:v>2.6994601079783999E-2</c:v>
                </c:pt>
                <c:pt idx="13">
                  <c:v>2.8194361127774407E-2</c:v>
                </c:pt>
                <c:pt idx="14">
                  <c:v>4.3191361727654483E-2</c:v>
                </c:pt>
                <c:pt idx="15">
                  <c:v>3.5392921415716899E-2</c:v>
                </c:pt>
                <c:pt idx="16">
                  <c:v>5.2789442111577704E-2</c:v>
                </c:pt>
                <c:pt idx="17">
                  <c:v>5.8188362327534486E-2</c:v>
                </c:pt>
                <c:pt idx="18">
                  <c:v>5.098980203959208E-2</c:v>
                </c:pt>
                <c:pt idx="19">
                  <c:v>4.9790041991601752E-2</c:v>
                </c:pt>
                <c:pt idx="20">
                  <c:v>2.6994601079783999E-2</c:v>
                </c:pt>
                <c:pt idx="21">
                  <c:v>2.5194961007798392E-2</c:v>
                </c:pt>
                <c:pt idx="22">
                  <c:v>1.97960407918416E-2</c:v>
                </c:pt>
                <c:pt idx="23">
                  <c:v>1.07978404319136E-2</c:v>
                </c:pt>
                <c:pt idx="24">
                  <c:v>7.7984403119376123E-3</c:v>
                </c:pt>
                <c:pt idx="25">
                  <c:v>1.7996400719856006E-3</c:v>
                </c:pt>
                <c:pt idx="26">
                  <c:v>4.1991601679664085E-3</c:v>
                </c:pt>
                <c:pt idx="27">
                  <c:v>4.1991601679664085E-3</c:v>
                </c:pt>
                <c:pt idx="28">
                  <c:v>1.7996400719856006E-3</c:v>
                </c:pt>
                <c:pt idx="29">
                  <c:v>1.7996400719856006E-3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unc-25 A2_0.02_50%'!$K$104</c:f>
              <c:strCache>
                <c:ptCount val="1"/>
                <c:pt idx="0">
                  <c:v>unc-25_REX_A2_10</c:v>
                </c:pt>
              </c:strCache>
            </c:strRef>
          </c:tx>
          <c:marker>
            <c:symbol val="none"/>
          </c:marker>
          <c:cat>
            <c:numRef>
              <c:f>'unc-25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2_0.02_50%'!$K$105:$K$135</c:f>
              <c:numCache>
                <c:formatCode>General</c:formatCode>
                <c:ptCount val="31"/>
                <c:pt idx="1">
                  <c:v>7.7448747152619596E-2</c:v>
                </c:pt>
                <c:pt idx="2">
                  <c:v>5.5239179954441914E-2</c:v>
                </c:pt>
                <c:pt idx="3">
                  <c:v>5.637813211845099E-2</c:v>
                </c:pt>
                <c:pt idx="4">
                  <c:v>3.5307517084282515E-2</c:v>
                </c:pt>
                <c:pt idx="5">
                  <c:v>3.4738041002277897E-2</c:v>
                </c:pt>
                <c:pt idx="6">
                  <c:v>2.4487471526195913E-2</c:v>
                </c:pt>
                <c:pt idx="7">
                  <c:v>1.9931662870159499E-2</c:v>
                </c:pt>
                <c:pt idx="8">
                  <c:v>1.2528473804100201E-2</c:v>
                </c:pt>
                <c:pt idx="9">
                  <c:v>1.1958997722095698E-2</c:v>
                </c:pt>
                <c:pt idx="10">
                  <c:v>1.5375854214123007E-2</c:v>
                </c:pt>
                <c:pt idx="11">
                  <c:v>2.3348519362186789E-2</c:v>
                </c:pt>
                <c:pt idx="12">
                  <c:v>3.1321184510250601E-2</c:v>
                </c:pt>
                <c:pt idx="13">
                  <c:v>4.3849658314350781E-2</c:v>
                </c:pt>
                <c:pt idx="14">
                  <c:v>5.2961275626423721E-2</c:v>
                </c:pt>
                <c:pt idx="15">
                  <c:v>5.8656036446469197E-2</c:v>
                </c:pt>
                <c:pt idx="16">
                  <c:v>4.7835990888382723E-2</c:v>
                </c:pt>
                <c:pt idx="17">
                  <c:v>5.1822323462414603E-2</c:v>
                </c:pt>
                <c:pt idx="18">
                  <c:v>4.7835990888382723E-2</c:v>
                </c:pt>
                <c:pt idx="19">
                  <c:v>3.7015945330296111E-2</c:v>
                </c:pt>
                <c:pt idx="20">
                  <c:v>2.7904328018223217E-2</c:v>
                </c:pt>
                <c:pt idx="21">
                  <c:v>2.1070615034168606E-2</c:v>
                </c:pt>
                <c:pt idx="22">
                  <c:v>2.6765375854214117E-2</c:v>
                </c:pt>
                <c:pt idx="23">
                  <c:v>1.1958997722095698E-2</c:v>
                </c:pt>
                <c:pt idx="24">
                  <c:v>1.08200455580866E-2</c:v>
                </c:pt>
                <c:pt idx="25">
                  <c:v>7.4031890660592303E-3</c:v>
                </c:pt>
                <c:pt idx="26">
                  <c:v>6.8337129840546759E-3</c:v>
                </c:pt>
                <c:pt idx="27">
                  <c:v>2.847380410022781E-3</c:v>
                </c:pt>
                <c:pt idx="28">
                  <c:v>3.9863325740318919E-3</c:v>
                </c:pt>
                <c:pt idx="29">
                  <c:v>5.69476082004556E-4</c:v>
                </c:pt>
                <c:pt idx="30">
                  <c:v>1.1389521640091109E-3</c:v>
                </c:pt>
              </c:numCache>
            </c:numRef>
          </c:val>
        </c:ser>
        <c:marker val="1"/>
        <c:axId val="161947008"/>
        <c:axId val="161952896"/>
      </c:lineChart>
      <c:catAx>
        <c:axId val="161947008"/>
        <c:scaling>
          <c:orientation val="minMax"/>
        </c:scaling>
        <c:axPos val="b"/>
        <c:numFmt formatCode="0.0_ " sourceLinked="1"/>
        <c:tickLblPos val="nextTo"/>
        <c:crossAx val="161952896"/>
        <c:crosses val="autoZero"/>
        <c:auto val="1"/>
        <c:lblAlgn val="ctr"/>
        <c:lblOffset val="100"/>
        <c:tickLblSkip val="5"/>
        <c:tickMarkSkip val="5"/>
      </c:catAx>
      <c:valAx>
        <c:axId val="161952896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1947008"/>
        <c:crosses val="autoZero"/>
        <c:crossBetween val="between"/>
      </c:valAx>
    </c:plotArea>
    <c:plotVisOnly val="1"/>
  </c:chart>
  <c:externalData r:id="rId1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25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5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25 A5_0.02_50%'!$B$104</c:f>
              <c:strCache>
                <c:ptCount val="1"/>
                <c:pt idx="0">
                  <c:v>unc-25_A5_001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B$105:$B$135</c:f>
              <c:numCache>
                <c:formatCode>General</c:formatCode>
                <c:ptCount val="31"/>
                <c:pt idx="1">
                  <c:v>8.964451313755803E-2</c:v>
                </c:pt>
                <c:pt idx="2">
                  <c:v>5.1004636785162302E-2</c:v>
                </c:pt>
                <c:pt idx="3">
                  <c:v>5.4095826893353904E-2</c:v>
                </c:pt>
                <c:pt idx="4">
                  <c:v>4.0185471406491514E-2</c:v>
                </c:pt>
                <c:pt idx="5">
                  <c:v>3.7094281298299801E-2</c:v>
                </c:pt>
                <c:pt idx="6">
                  <c:v>2.3183925811437398E-2</c:v>
                </c:pt>
                <c:pt idx="7">
                  <c:v>2.0092735703245802E-2</c:v>
                </c:pt>
                <c:pt idx="8">
                  <c:v>1.8547140649149901E-2</c:v>
                </c:pt>
                <c:pt idx="9">
                  <c:v>2.3183925811437398E-2</c:v>
                </c:pt>
                <c:pt idx="10">
                  <c:v>2.4729520865533199E-2</c:v>
                </c:pt>
                <c:pt idx="11">
                  <c:v>4.4822256568779001E-2</c:v>
                </c:pt>
                <c:pt idx="12">
                  <c:v>4.9459041731066501E-2</c:v>
                </c:pt>
                <c:pt idx="13">
                  <c:v>6.0278207109737199E-2</c:v>
                </c:pt>
                <c:pt idx="14">
                  <c:v>5.1004636785162302E-2</c:v>
                </c:pt>
                <c:pt idx="15">
                  <c:v>4.7913446676970603E-2</c:v>
                </c:pt>
                <c:pt idx="16">
                  <c:v>3.2457496136012398E-2</c:v>
                </c:pt>
                <c:pt idx="17">
                  <c:v>2.6275115919629128E-2</c:v>
                </c:pt>
                <c:pt idx="18">
                  <c:v>2.6275115919629128E-2</c:v>
                </c:pt>
                <c:pt idx="19">
                  <c:v>2.6275115919629128E-2</c:v>
                </c:pt>
                <c:pt idx="20">
                  <c:v>1.8547140649149901E-2</c:v>
                </c:pt>
                <c:pt idx="21">
                  <c:v>1.8547140649149901E-2</c:v>
                </c:pt>
                <c:pt idx="22">
                  <c:v>4.6367851622874804E-3</c:v>
                </c:pt>
                <c:pt idx="23">
                  <c:v>6.18238021638331E-3</c:v>
                </c:pt>
                <c:pt idx="24">
                  <c:v>1.54559505409583E-2</c:v>
                </c:pt>
                <c:pt idx="25">
                  <c:v>4.6367851622874804E-3</c:v>
                </c:pt>
                <c:pt idx="26">
                  <c:v>6.18238021638331E-3</c:v>
                </c:pt>
                <c:pt idx="27">
                  <c:v>6.18238021638331E-3</c:v>
                </c:pt>
                <c:pt idx="28">
                  <c:v>0</c:v>
                </c:pt>
                <c:pt idx="29">
                  <c:v>1.5455950540958301E-3</c:v>
                </c:pt>
                <c:pt idx="30">
                  <c:v>3.091190108191652E-3</c:v>
                </c:pt>
              </c:numCache>
            </c:numRef>
          </c:val>
        </c:ser>
        <c:ser>
          <c:idx val="1"/>
          <c:order val="1"/>
          <c:tx>
            <c:strRef>
              <c:f>'unc-25 A5_0.02_50%'!$C$104</c:f>
              <c:strCache>
                <c:ptCount val="1"/>
                <c:pt idx="0">
                  <c:v>unc-25_A5_002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C$105:$C$135</c:f>
              <c:numCache>
                <c:formatCode>General</c:formatCode>
                <c:ptCount val="31"/>
                <c:pt idx="1">
                  <c:v>6.4011379800853502E-2</c:v>
                </c:pt>
                <c:pt idx="2">
                  <c:v>6.1166429587482217E-2</c:v>
                </c:pt>
                <c:pt idx="3">
                  <c:v>4.6941678520625883E-2</c:v>
                </c:pt>
                <c:pt idx="4">
                  <c:v>4.1251778093883383E-2</c:v>
                </c:pt>
                <c:pt idx="5">
                  <c:v>2.5604551920341397E-2</c:v>
                </c:pt>
                <c:pt idx="6">
                  <c:v>2.2759601706970108E-2</c:v>
                </c:pt>
                <c:pt idx="7">
                  <c:v>1.7069701280227601E-2</c:v>
                </c:pt>
                <c:pt idx="8">
                  <c:v>2.9871977240398313E-2</c:v>
                </c:pt>
                <c:pt idx="9">
                  <c:v>2.5604551920341397E-2</c:v>
                </c:pt>
                <c:pt idx="10">
                  <c:v>1.8492176386913209E-2</c:v>
                </c:pt>
                <c:pt idx="11">
                  <c:v>2.7027027027027015E-2</c:v>
                </c:pt>
                <c:pt idx="12">
                  <c:v>2.8449502133712699E-2</c:v>
                </c:pt>
                <c:pt idx="13">
                  <c:v>2.7027027027027015E-2</c:v>
                </c:pt>
                <c:pt idx="14">
                  <c:v>3.4139402560455202E-2</c:v>
                </c:pt>
                <c:pt idx="15">
                  <c:v>4.8364153627311501E-2</c:v>
                </c:pt>
                <c:pt idx="16">
                  <c:v>4.8364153627311501E-2</c:v>
                </c:pt>
                <c:pt idx="17">
                  <c:v>3.1294452347083897E-2</c:v>
                </c:pt>
                <c:pt idx="18">
                  <c:v>2.9871977240398313E-2</c:v>
                </c:pt>
                <c:pt idx="19">
                  <c:v>3.2716927453769612E-2</c:v>
                </c:pt>
                <c:pt idx="20">
                  <c:v>2.8449502133712699E-2</c:v>
                </c:pt>
                <c:pt idx="21">
                  <c:v>2.7027027027027015E-2</c:v>
                </c:pt>
                <c:pt idx="22">
                  <c:v>1.5647226173542E-2</c:v>
                </c:pt>
                <c:pt idx="23">
                  <c:v>1.7069701280227601E-2</c:v>
                </c:pt>
                <c:pt idx="24">
                  <c:v>1.4224751066856304E-2</c:v>
                </c:pt>
                <c:pt idx="25">
                  <c:v>1.5647226173542E-2</c:v>
                </c:pt>
                <c:pt idx="26">
                  <c:v>5.6899004267425314E-3</c:v>
                </c:pt>
                <c:pt idx="27">
                  <c:v>2.8449502133712709E-3</c:v>
                </c:pt>
                <c:pt idx="28">
                  <c:v>4.2674253200568986E-3</c:v>
                </c:pt>
                <c:pt idx="29">
                  <c:v>1.4224751066856305E-3</c:v>
                </c:pt>
                <c:pt idx="30">
                  <c:v>1.4224751066856305E-3</c:v>
                </c:pt>
              </c:numCache>
            </c:numRef>
          </c:val>
        </c:ser>
        <c:ser>
          <c:idx val="2"/>
          <c:order val="2"/>
          <c:tx>
            <c:strRef>
              <c:f>'unc-25 A5_0.02_50%'!$D$104</c:f>
              <c:strCache>
                <c:ptCount val="1"/>
                <c:pt idx="0">
                  <c:v>unc-25_A5_003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D$105:$D$135</c:f>
              <c:numCache>
                <c:formatCode>General</c:formatCode>
                <c:ptCount val="31"/>
                <c:pt idx="1">
                  <c:v>5.4698457223001436E-2</c:v>
                </c:pt>
                <c:pt idx="2">
                  <c:v>4.7685834502103799E-2</c:v>
                </c:pt>
                <c:pt idx="3">
                  <c:v>4.6283309957924304E-2</c:v>
                </c:pt>
                <c:pt idx="4">
                  <c:v>4.0673211781206198E-2</c:v>
                </c:pt>
                <c:pt idx="5">
                  <c:v>4.6283309957924304E-2</c:v>
                </c:pt>
                <c:pt idx="6">
                  <c:v>2.2440392706872418E-2</c:v>
                </c:pt>
                <c:pt idx="7">
                  <c:v>3.2258064516129011E-2</c:v>
                </c:pt>
                <c:pt idx="8">
                  <c:v>1.6830294530154302E-2</c:v>
                </c:pt>
                <c:pt idx="9">
                  <c:v>1.5427769985974799E-2</c:v>
                </c:pt>
                <c:pt idx="10">
                  <c:v>3.9270687237026605E-2</c:v>
                </c:pt>
                <c:pt idx="11">
                  <c:v>2.9453015427770027E-2</c:v>
                </c:pt>
                <c:pt idx="12">
                  <c:v>5.1893408134642417E-2</c:v>
                </c:pt>
                <c:pt idx="13">
                  <c:v>5.6100981767180896E-2</c:v>
                </c:pt>
                <c:pt idx="14">
                  <c:v>6.3113604488078512E-2</c:v>
                </c:pt>
                <c:pt idx="15">
                  <c:v>6.3113604488078512E-2</c:v>
                </c:pt>
                <c:pt idx="16">
                  <c:v>6.0308555399719486E-2</c:v>
                </c:pt>
                <c:pt idx="17">
                  <c:v>4.3478260869565202E-2</c:v>
                </c:pt>
                <c:pt idx="18">
                  <c:v>4.3478260869565202E-2</c:v>
                </c:pt>
                <c:pt idx="19">
                  <c:v>2.5245441795231399E-2</c:v>
                </c:pt>
                <c:pt idx="20">
                  <c:v>2.1037868162692808E-2</c:v>
                </c:pt>
                <c:pt idx="21">
                  <c:v>1.2622720897615708E-2</c:v>
                </c:pt>
                <c:pt idx="22">
                  <c:v>1.2622720897615708E-2</c:v>
                </c:pt>
                <c:pt idx="23">
                  <c:v>5.6100981767180898E-3</c:v>
                </c:pt>
                <c:pt idx="24">
                  <c:v>9.8176718092566635E-3</c:v>
                </c:pt>
                <c:pt idx="25">
                  <c:v>8.4151472650771473E-3</c:v>
                </c:pt>
                <c:pt idx="26">
                  <c:v>1.4025245441795201E-3</c:v>
                </c:pt>
                <c:pt idx="27">
                  <c:v>8.4151472650771473E-3</c:v>
                </c:pt>
                <c:pt idx="28">
                  <c:v>4.2075736325385719E-3</c:v>
                </c:pt>
                <c:pt idx="29">
                  <c:v>4.2075736325385719E-3</c:v>
                </c:pt>
                <c:pt idx="30">
                  <c:v>1.4025245441795201E-3</c:v>
                </c:pt>
              </c:numCache>
            </c:numRef>
          </c:val>
        </c:ser>
        <c:ser>
          <c:idx val="3"/>
          <c:order val="3"/>
          <c:tx>
            <c:strRef>
              <c:f>'unc-25 A5_0.02_50%'!$E$104</c:f>
              <c:strCache>
                <c:ptCount val="1"/>
                <c:pt idx="0">
                  <c:v>unc-25_A5_004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E$105:$E$135</c:f>
              <c:numCache>
                <c:formatCode>General</c:formatCode>
                <c:ptCount val="31"/>
                <c:pt idx="1">
                  <c:v>6.1041292639138198E-2</c:v>
                </c:pt>
                <c:pt idx="2">
                  <c:v>8.4380610412926341E-2</c:v>
                </c:pt>
                <c:pt idx="3">
                  <c:v>5.5655296229802496E-2</c:v>
                </c:pt>
                <c:pt idx="4">
                  <c:v>4.4883303411131122E-2</c:v>
                </c:pt>
                <c:pt idx="5">
                  <c:v>3.9497307001795316E-2</c:v>
                </c:pt>
                <c:pt idx="6">
                  <c:v>1.7953321364452407E-2</c:v>
                </c:pt>
                <c:pt idx="7">
                  <c:v>2.69299820466786E-2</c:v>
                </c:pt>
                <c:pt idx="8">
                  <c:v>1.7953321364452407E-2</c:v>
                </c:pt>
                <c:pt idx="9">
                  <c:v>1.0771992818671498E-2</c:v>
                </c:pt>
                <c:pt idx="10">
                  <c:v>1.4362657091561901E-2</c:v>
                </c:pt>
                <c:pt idx="11">
                  <c:v>1.6157989228007208E-2</c:v>
                </c:pt>
                <c:pt idx="12">
                  <c:v>2.5134649910233401E-2</c:v>
                </c:pt>
                <c:pt idx="13">
                  <c:v>2.5134649910233401E-2</c:v>
                </c:pt>
                <c:pt idx="14">
                  <c:v>2.3339317773788209E-2</c:v>
                </c:pt>
                <c:pt idx="15">
                  <c:v>2.1543985637342899E-2</c:v>
                </c:pt>
                <c:pt idx="16">
                  <c:v>3.7701974865350124E-2</c:v>
                </c:pt>
                <c:pt idx="17">
                  <c:v>2.5134649910233401E-2</c:v>
                </c:pt>
                <c:pt idx="18">
                  <c:v>1.4362657091561901E-2</c:v>
                </c:pt>
                <c:pt idx="19">
                  <c:v>3.2315978456014423E-2</c:v>
                </c:pt>
                <c:pt idx="20">
                  <c:v>2.1543985637342899E-2</c:v>
                </c:pt>
                <c:pt idx="21">
                  <c:v>8.9766606822262191E-3</c:v>
                </c:pt>
                <c:pt idx="22">
                  <c:v>7.1813285457809732E-3</c:v>
                </c:pt>
                <c:pt idx="23">
                  <c:v>1.7953321364452409E-3</c:v>
                </c:pt>
                <c:pt idx="24">
                  <c:v>1.2567324955116701E-2</c:v>
                </c:pt>
                <c:pt idx="25">
                  <c:v>3.5906642728904818E-3</c:v>
                </c:pt>
                <c:pt idx="26">
                  <c:v>3.5906642728904818E-3</c:v>
                </c:pt>
                <c:pt idx="27">
                  <c:v>1.7953321364452409E-3</c:v>
                </c:pt>
                <c:pt idx="28">
                  <c:v>3.5906642728904818E-3</c:v>
                </c:pt>
                <c:pt idx="29">
                  <c:v>3.5906642728904818E-3</c:v>
                </c:pt>
                <c:pt idx="30">
                  <c:v>1.7953321364452409E-3</c:v>
                </c:pt>
              </c:numCache>
            </c:numRef>
          </c:val>
        </c:ser>
        <c:ser>
          <c:idx val="4"/>
          <c:order val="4"/>
          <c:tx>
            <c:strRef>
              <c:f>'unc-25 A5_0.02_50%'!$F$104</c:f>
              <c:strCache>
                <c:ptCount val="1"/>
                <c:pt idx="0">
                  <c:v>unc-25_A5_006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F$105:$F$135</c:f>
              <c:numCache>
                <c:formatCode>General</c:formatCode>
                <c:ptCount val="31"/>
                <c:pt idx="1">
                  <c:v>9.5516569200779736E-2</c:v>
                </c:pt>
                <c:pt idx="2">
                  <c:v>5.6530214424951319E-2</c:v>
                </c:pt>
                <c:pt idx="3">
                  <c:v>6.6276803118908406E-2</c:v>
                </c:pt>
                <c:pt idx="4">
                  <c:v>4.483430799220272E-2</c:v>
                </c:pt>
                <c:pt idx="5">
                  <c:v>2.7290448343079914E-2</c:v>
                </c:pt>
                <c:pt idx="6">
                  <c:v>2.5341130604288501E-2</c:v>
                </c:pt>
                <c:pt idx="7">
                  <c:v>1.55945419103314E-2</c:v>
                </c:pt>
                <c:pt idx="8">
                  <c:v>1.7543859649122813E-2</c:v>
                </c:pt>
                <c:pt idx="9">
                  <c:v>1.55945419103314E-2</c:v>
                </c:pt>
                <c:pt idx="10">
                  <c:v>3.7037037037037014E-2</c:v>
                </c:pt>
                <c:pt idx="11">
                  <c:v>2.9239766081871312E-2</c:v>
                </c:pt>
                <c:pt idx="12">
                  <c:v>1.7543859649122813E-2</c:v>
                </c:pt>
                <c:pt idx="13">
                  <c:v>2.3391812865497099E-2</c:v>
                </c:pt>
                <c:pt idx="14">
                  <c:v>4.2884990253411338E-2</c:v>
                </c:pt>
                <c:pt idx="15">
                  <c:v>3.3138401559454203E-2</c:v>
                </c:pt>
                <c:pt idx="16">
                  <c:v>2.1442495126705711E-2</c:v>
                </c:pt>
                <c:pt idx="17">
                  <c:v>1.9493177387914208E-2</c:v>
                </c:pt>
                <c:pt idx="18">
                  <c:v>2.5341130604288501E-2</c:v>
                </c:pt>
                <c:pt idx="19">
                  <c:v>2.3391812865497099E-2</c:v>
                </c:pt>
                <c:pt idx="20">
                  <c:v>2.7290448343079914E-2</c:v>
                </c:pt>
                <c:pt idx="21">
                  <c:v>1.55945419103314E-2</c:v>
                </c:pt>
                <c:pt idx="22">
                  <c:v>1.7543859649122813E-2</c:v>
                </c:pt>
                <c:pt idx="23">
                  <c:v>1.364522417154E-2</c:v>
                </c:pt>
                <c:pt idx="24">
                  <c:v>1.1695906432748499E-2</c:v>
                </c:pt>
                <c:pt idx="25">
                  <c:v>7.7972709551656916E-3</c:v>
                </c:pt>
                <c:pt idx="26">
                  <c:v>1.55945419103314E-2</c:v>
                </c:pt>
                <c:pt idx="27">
                  <c:v>7.7972709551656916E-3</c:v>
                </c:pt>
                <c:pt idx="28">
                  <c:v>7.7972709551656916E-3</c:v>
                </c:pt>
                <c:pt idx="29">
                  <c:v>5.8479532163742704E-3</c:v>
                </c:pt>
                <c:pt idx="30">
                  <c:v>1.9493177387914209E-3</c:v>
                </c:pt>
              </c:numCache>
            </c:numRef>
          </c:val>
        </c:ser>
        <c:ser>
          <c:idx val="5"/>
          <c:order val="5"/>
          <c:tx>
            <c:strRef>
              <c:f>'unc-25 A5_0.02_50%'!$G$104</c:f>
              <c:strCache>
                <c:ptCount val="1"/>
                <c:pt idx="0">
                  <c:v>unc-25_A5_40_30_01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G$105:$G$135</c:f>
              <c:numCache>
                <c:formatCode>General</c:formatCode>
                <c:ptCount val="31"/>
                <c:pt idx="1">
                  <c:v>9.9767981438515105E-2</c:v>
                </c:pt>
                <c:pt idx="2">
                  <c:v>9.0487238979118242E-2</c:v>
                </c:pt>
                <c:pt idx="3">
                  <c:v>6.4965197215777329E-2</c:v>
                </c:pt>
                <c:pt idx="4">
                  <c:v>3.2482598607888602E-2</c:v>
                </c:pt>
                <c:pt idx="5">
                  <c:v>3.2482598607888602E-2</c:v>
                </c:pt>
                <c:pt idx="6">
                  <c:v>2.7842227378190313E-2</c:v>
                </c:pt>
                <c:pt idx="7">
                  <c:v>2.3201856148491892E-2</c:v>
                </c:pt>
                <c:pt idx="8">
                  <c:v>4.64037122969838E-3</c:v>
                </c:pt>
                <c:pt idx="9">
                  <c:v>1.6241299303944301E-2</c:v>
                </c:pt>
                <c:pt idx="10">
                  <c:v>1.3921113689095104E-2</c:v>
                </c:pt>
                <c:pt idx="11">
                  <c:v>2.0881670533642708E-2</c:v>
                </c:pt>
                <c:pt idx="12">
                  <c:v>2.7842227378190313E-2</c:v>
                </c:pt>
                <c:pt idx="13">
                  <c:v>4.8723897911832917E-2</c:v>
                </c:pt>
                <c:pt idx="14">
                  <c:v>3.2482598607888602E-2</c:v>
                </c:pt>
                <c:pt idx="15">
                  <c:v>4.6403712296983798E-2</c:v>
                </c:pt>
                <c:pt idx="16">
                  <c:v>2.7842227378190313E-2</c:v>
                </c:pt>
                <c:pt idx="17">
                  <c:v>3.7122969837586998E-2</c:v>
                </c:pt>
                <c:pt idx="18">
                  <c:v>4.1763341067285402E-2</c:v>
                </c:pt>
                <c:pt idx="19">
                  <c:v>2.32018561484919E-3</c:v>
                </c:pt>
                <c:pt idx="20">
                  <c:v>1.1600928074245901E-2</c:v>
                </c:pt>
                <c:pt idx="21">
                  <c:v>6.9605568445475618E-3</c:v>
                </c:pt>
                <c:pt idx="22">
                  <c:v>2.32018561484919E-3</c:v>
                </c:pt>
                <c:pt idx="23">
                  <c:v>4.64037122969838E-3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2.32018561484919E-3</c:v>
                </c:pt>
                <c:pt idx="28">
                  <c:v>0</c:v>
                </c:pt>
                <c:pt idx="29">
                  <c:v>2.32018561484919E-3</c:v>
                </c:pt>
                <c:pt idx="30">
                  <c:v>2.32018561484919E-3</c:v>
                </c:pt>
              </c:numCache>
            </c:numRef>
          </c:val>
        </c:ser>
        <c:ser>
          <c:idx val="6"/>
          <c:order val="6"/>
          <c:tx>
            <c:strRef>
              <c:f>'unc-25 A5_0.02_50%'!$H$104</c:f>
              <c:strCache>
                <c:ptCount val="1"/>
                <c:pt idx="0">
                  <c:v>unc-25_A5_40_30_03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H$105:$H$135</c:f>
              <c:numCache>
                <c:formatCode>General</c:formatCode>
                <c:ptCount val="31"/>
                <c:pt idx="1">
                  <c:v>8.7692307692307694E-2</c:v>
                </c:pt>
                <c:pt idx="2">
                  <c:v>7.8461538461538499E-2</c:v>
                </c:pt>
                <c:pt idx="3">
                  <c:v>6.1538461538461514E-2</c:v>
                </c:pt>
                <c:pt idx="4">
                  <c:v>4.4615384615384598E-2</c:v>
                </c:pt>
                <c:pt idx="5">
                  <c:v>4.0000000000000015E-2</c:v>
                </c:pt>
                <c:pt idx="6">
                  <c:v>4.3076923076923103E-2</c:v>
                </c:pt>
                <c:pt idx="7">
                  <c:v>3.2307692307692301E-2</c:v>
                </c:pt>
                <c:pt idx="8">
                  <c:v>3.0769230769230802E-2</c:v>
                </c:pt>
                <c:pt idx="9">
                  <c:v>2.9230769230769206E-2</c:v>
                </c:pt>
                <c:pt idx="10">
                  <c:v>3.3846153846153804E-2</c:v>
                </c:pt>
                <c:pt idx="11">
                  <c:v>5.0769230769230816E-2</c:v>
                </c:pt>
                <c:pt idx="12">
                  <c:v>5.3846153846153801E-2</c:v>
                </c:pt>
                <c:pt idx="13">
                  <c:v>4.9230769230769203E-2</c:v>
                </c:pt>
                <c:pt idx="14">
                  <c:v>3.6923076923076913E-2</c:v>
                </c:pt>
                <c:pt idx="15">
                  <c:v>3.3846153846153804E-2</c:v>
                </c:pt>
                <c:pt idx="16">
                  <c:v>2.9230769230769206E-2</c:v>
                </c:pt>
                <c:pt idx="17">
                  <c:v>1.3846153846153805E-2</c:v>
                </c:pt>
                <c:pt idx="18">
                  <c:v>1.6923076923076902E-2</c:v>
                </c:pt>
                <c:pt idx="19">
                  <c:v>9.2307692307692368E-3</c:v>
                </c:pt>
                <c:pt idx="20">
                  <c:v>6.1538461538461504E-3</c:v>
                </c:pt>
                <c:pt idx="21">
                  <c:v>9.2307692307692368E-3</c:v>
                </c:pt>
                <c:pt idx="22">
                  <c:v>1.5384615384615408E-3</c:v>
                </c:pt>
                <c:pt idx="23">
                  <c:v>3.0769230769230808E-3</c:v>
                </c:pt>
                <c:pt idx="24">
                  <c:v>4.6153846153846219E-3</c:v>
                </c:pt>
                <c:pt idx="25">
                  <c:v>0</c:v>
                </c:pt>
                <c:pt idx="26">
                  <c:v>0</c:v>
                </c:pt>
                <c:pt idx="27">
                  <c:v>1.5384615384615408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unc-25 A5_0.02_50%'!$I$104</c:f>
              <c:strCache>
                <c:ptCount val="1"/>
                <c:pt idx="0">
                  <c:v>unc-25_A5_40_30_04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I$105:$I$135</c:f>
              <c:numCache>
                <c:formatCode>General</c:formatCode>
                <c:ptCount val="31"/>
                <c:pt idx="1">
                  <c:v>8.4210526315789527E-2</c:v>
                </c:pt>
                <c:pt idx="2">
                  <c:v>6.8421052631578966E-2</c:v>
                </c:pt>
                <c:pt idx="3">
                  <c:v>4.9122807017543922E-2</c:v>
                </c:pt>
                <c:pt idx="4">
                  <c:v>4.9122807017543922E-2</c:v>
                </c:pt>
                <c:pt idx="5">
                  <c:v>3.3333333333333298E-2</c:v>
                </c:pt>
                <c:pt idx="6">
                  <c:v>2.6315789473684202E-2</c:v>
                </c:pt>
                <c:pt idx="7">
                  <c:v>1.05263157894737E-2</c:v>
                </c:pt>
                <c:pt idx="8">
                  <c:v>1.7543859649122813E-2</c:v>
                </c:pt>
                <c:pt idx="9">
                  <c:v>1.4035087719298199E-2</c:v>
                </c:pt>
                <c:pt idx="10">
                  <c:v>2.4561403508771899E-2</c:v>
                </c:pt>
                <c:pt idx="11">
                  <c:v>1.7543859649122813E-2</c:v>
                </c:pt>
                <c:pt idx="12">
                  <c:v>2.1052631578947399E-2</c:v>
                </c:pt>
                <c:pt idx="13">
                  <c:v>3.5087719298245605E-2</c:v>
                </c:pt>
                <c:pt idx="14">
                  <c:v>5.2631578947368404E-2</c:v>
                </c:pt>
                <c:pt idx="15">
                  <c:v>3.8596491228070198E-2</c:v>
                </c:pt>
                <c:pt idx="16">
                  <c:v>3.8596491228070198E-2</c:v>
                </c:pt>
                <c:pt idx="17">
                  <c:v>2.8070175438596506E-2</c:v>
                </c:pt>
                <c:pt idx="18">
                  <c:v>2.8070175438596506E-2</c:v>
                </c:pt>
                <c:pt idx="19">
                  <c:v>2.6315789473684202E-2</c:v>
                </c:pt>
                <c:pt idx="20">
                  <c:v>1.7543859649122813E-2</c:v>
                </c:pt>
                <c:pt idx="21">
                  <c:v>1.05263157894737E-2</c:v>
                </c:pt>
                <c:pt idx="22">
                  <c:v>1.7543859649122813E-2</c:v>
                </c:pt>
                <c:pt idx="23">
                  <c:v>3.508771929824561E-3</c:v>
                </c:pt>
                <c:pt idx="24">
                  <c:v>5.263157894736842E-3</c:v>
                </c:pt>
                <c:pt idx="25">
                  <c:v>5.263157894736842E-3</c:v>
                </c:pt>
                <c:pt idx="26">
                  <c:v>7.0175438596491221E-3</c:v>
                </c:pt>
                <c:pt idx="27">
                  <c:v>3.508771929824561E-3</c:v>
                </c:pt>
                <c:pt idx="28">
                  <c:v>0</c:v>
                </c:pt>
                <c:pt idx="29">
                  <c:v>0</c:v>
                </c:pt>
                <c:pt idx="30">
                  <c:v>5.263157894736842E-3</c:v>
                </c:pt>
              </c:numCache>
            </c:numRef>
          </c:val>
        </c:ser>
        <c:ser>
          <c:idx val="8"/>
          <c:order val="8"/>
          <c:tx>
            <c:strRef>
              <c:f>'unc-25 A5_0.02_50%'!$J$104</c:f>
              <c:strCache>
                <c:ptCount val="1"/>
                <c:pt idx="0">
                  <c:v>unc-25_A5_M102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J$105:$J$135</c:f>
              <c:numCache>
                <c:formatCode>General</c:formatCode>
                <c:ptCount val="31"/>
                <c:pt idx="1">
                  <c:v>5.5851063829787211E-2</c:v>
                </c:pt>
                <c:pt idx="2">
                  <c:v>6.1170212765957369E-2</c:v>
                </c:pt>
                <c:pt idx="3">
                  <c:v>5.31914893617021E-2</c:v>
                </c:pt>
                <c:pt idx="4">
                  <c:v>4.1223404255319097E-2</c:v>
                </c:pt>
                <c:pt idx="5">
                  <c:v>3.0585106382978709E-2</c:v>
                </c:pt>
                <c:pt idx="6">
                  <c:v>1.5957446808510599E-2</c:v>
                </c:pt>
                <c:pt idx="7">
                  <c:v>1.5957446808510599E-2</c:v>
                </c:pt>
                <c:pt idx="8">
                  <c:v>1.8617021276595706E-2</c:v>
                </c:pt>
                <c:pt idx="9">
                  <c:v>6.6489361702127703E-3</c:v>
                </c:pt>
                <c:pt idx="10">
                  <c:v>2.3936170212766002E-2</c:v>
                </c:pt>
                <c:pt idx="11">
                  <c:v>3.9893617021276619E-2</c:v>
                </c:pt>
                <c:pt idx="12">
                  <c:v>5.1861702127659601E-2</c:v>
                </c:pt>
                <c:pt idx="13">
                  <c:v>6.64893617021277E-2</c:v>
                </c:pt>
                <c:pt idx="14">
                  <c:v>8.2446808510638306E-2</c:v>
                </c:pt>
                <c:pt idx="15">
                  <c:v>5.5851063829787211E-2</c:v>
                </c:pt>
                <c:pt idx="16">
                  <c:v>6.1170212765957369E-2</c:v>
                </c:pt>
                <c:pt idx="17">
                  <c:v>4.3882978723404312E-2</c:v>
                </c:pt>
                <c:pt idx="18">
                  <c:v>2.260638297872342E-2</c:v>
                </c:pt>
                <c:pt idx="19">
                  <c:v>1.8617021276595706E-2</c:v>
                </c:pt>
                <c:pt idx="20">
                  <c:v>1.5957446808510599E-2</c:v>
                </c:pt>
                <c:pt idx="21">
                  <c:v>1.0638297872340394E-2</c:v>
                </c:pt>
                <c:pt idx="22">
                  <c:v>5.31914893617021E-3</c:v>
                </c:pt>
                <c:pt idx="23">
                  <c:v>1.3297872340425504E-2</c:v>
                </c:pt>
                <c:pt idx="24">
                  <c:v>2.6595744680851107E-3</c:v>
                </c:pt>
                <c:pt idx="25">
                  <c:v>5.31914893617021E-3</c:v>
                </c:pt>
                <c:pt idx="26">
                  <c:v>3.9893617021276619E-3</c:v>
                </c:pt>
                <c:pt idx="27">
                  <c:v>1.3297872340425506E-3</c:v>
                </c:pt>
                <c:pt idx="28">
                  <c:v>0</c:v>
                </c:pt>
                <c:pt idx="29">
                  <c:v>1.3297872340425506E-3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unc-25 A5_0.02_50%'!$K$104</c:f>
              <c:strCache>
                <c:ptCount val="1"/>
                <c:pt idx="0">
                  <c:v>unc-25_A5_M103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K$105:$K$135</c:f>
              <c:numCache>
                <c:formatCode>General</c:formatCode>
                <c:ptCount val="31"/>
                <c:pt idx="1">
                  <c:v>7.9953650057937448E-2</c:v>
                </c:pt>
                <c:pt idx="2">
                  <c:v>7.1842410196987311E-2</c:v>
                </c:pt>
                <c:pt idx="3">
                  <c:v>5.5619930475086912E-2</c:v>
                </c:pt>
                <c:pt idx="4">
                  <c:v>5.3302433371958328E-2</c:v>
                </c:pt>
                <c:pt idx="5">
                  <c:v>4.0556199304750885E-2</c:v>
                </c:pt>
                <c:pt idx="6">
                  <c:v>2.89687137891078E-2</c:v>
                </c:pt>
                <c:pt idx="7">
                  <c:v>2.4333719582850518E-2</c:v>
                </c:pt>
                <c:pt idx="8">
                  <c:v>1.5063731170336001E-2</c:v>
                </c:pt>
                <c:pt idx="9">
                  <c:v>1.7381228273464701E-2</c:v>
                </c:pt>
                <c:pt idx="10">
                  <c:v>2.7809965237543519E-2</c:v>
                </c:pt>
                <c:pt idx="11">
                  <c:v>3.0127462340672088E-2</c:v>
                </c:pt>
                <c:pt idx="12">
                  <c:v>3.5921205098493614E-2</c:v>
                </c:pt>
                <c:pt idx="13">
                  <c:v>3.9397450753186597E-2</c:v>
                </c:pt>
                <c:pt idx="14">
                  <c:v>4.4032444959443855E-2</c:v>
                </c:pt>
                <c:pt idx="15">
                  <c:v>4.4032444959443855E-2</c:v>
                </c:pt>
                <c:pt idx="16">
                  <c:v>5.0984936268829703E-2</c:v>
                </c:pt>
                <c:pt idx="17">
                  <c:v>3.2444959443800714E-2</c:v>
                </c:pt>
                <c:pt idx="18">
                  <c:v>2.7809965237543519E-2</c:v>
                </c:pt>
                <c:pt idx="19">
                  <c:v>1.9698725376593305E-2</c:v>
                </c:pt>
                <c:pt idx="20">
                  <c:v>1.6222479721900308E-2</c:v>
                </c:pt>
                <c:pt idx="21">
                  <c:v>8.1112398609501681E-3</c:v>
                </c:pt>
                <c:pt idx="22">
                  <c:v>1.1587485515643104E-2</c:v>
                </c:pt>
                <c:pt idx="23">
                  <c:v>1.0428736964078799E-2</c:v>
                </c:pt>
                <c:pt idx="24">
                  <c:v>3.4762456546929298E-3</c:v>
                </c:pt>
                <c:pt idx="25">
                  <c:v>0</c:v>
                </c:pt>
                <c:pt idx="26">
                  <c:v>3.4762456546929298E-3</c:v>
                </c:pt>
                <c:pt idx="27">
                  <c:v>2.3174971031286198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unc-25 A5_0.02_50%'!$L$104</c:f>
              <c:strCache>
                <c:ptCount val="1"/>
                <c:pt idx="0">
                  <c:v>unc-25_A5_M105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L$105:$L$135</c:f>
              <c:numCache>
                <c:formatCode>General</c:formatCode>
                <c:ptCount val="31"/>
                <c:pt idx="1">
                  <c:v>7.8025477707006394E-2</c:v>
                </c:pt>
                <c:pt idx="2">
                  <c:v>7.1656050955414011E-2</c:v>
                </c:pt>
                <c:pt idx="3">
                  <c:v>4.4585987261146522E-2</c:v>
                </c:pt>
                <c:pt idx="4">
                  <c:v>5.5732484076433136E-2</c:v>
                </c:pt>
                <c:pt idx="5">
                  <c:v>2.3885350318471311E-2</c:v>
                </c:pt>
                <c:pt idx="6">
                  <c:v>2.707006369426751E-2</c:v>
                </c:pt>
                <c:pt idx="7">
                  <c:v>1.1146496815286601E-2</c:v>
                </c:pt>
                <c:pt idx="8">
                  <c:v>1.5923566878980902E-2</c:v>
                </c:pt>
                <c:pt idx="9">
                  <c:v>1.4331210191082799E-2</c:v>
                </c:pt>
                <c:pt idx="10">
                  <c:v>2.3885350318471311E-2</c:v>
                </c:pt>
                <c:pt idx="11">
                  <c:v>2.2292993630573209E-2</c:v>
                </c:pt>
                <c:pt idx="12">
                  <c:v>4.9363057324840837E-2</c:v>
                </c:pt>
                <c:pt idx="13">
                  <c:v>5.4140127388534985E-2</c:v>
                </c:pt>
                <c:pt idx="14">
                  <c:v>5.7324840764331197E-2</c:v>
                </c:pt>
                <c:pt idx="15">
                  <c:v>5.4140127388534985E-2</c:v>
                </c:pt>
                <c:pt idx="16">
                  <c:v>5.4140127388534985E-2</c:v>
                </c:pt>
                <c:pt idx="17">
                  <c:v>3.5031847133758016E-2</c:v>
                </c:pt>
                <c:pt idx="18">
                  <c:v>3.0254777070063719E-2</c:v>
                </c:pt>
                <c:pt idx="19">
                  <c:v>2.07006369426752E-2</c:v>
                </c:pt>
                <c:pt idx="20">
                  <c:v>1.9108280254777107E-2</c:v>
                </c:pt>
                <c:pt idx="21">
                  <c:v>9.5541401273885294E-3</c:v>
                </c:pt>
                <c:pt idx="22">
                  <c:v>7.9617834394904528E-3</c:v>
                </c:pt>
                <c:pt idx="23">
                  <c:v>1.5923566878980901E-3</c:v>
                </c:pt>
                <c:pt idx="24">
                  <c:v>4.7770700636942734E-3</c:v>
                </c:pt>
                <c:pt idx="25">
                  <c:v>1.5923566878980901E-3</c:v>
                </c:pt>
                <c:pt idx="26">
                  <c:v>0</c:v>
                </c:pt>
                <c:pt idx="27">
                  <c:v>1.5923566878980901E-3</c:v>
                </c:pt>
                <c:pt idx="28">
                  <c:v>0</c:v>
                </c:pt>
                <c:pt idx="29">
                  <c:v>0</c:v>
                </c:pt>
                <c:pt idx="30">
                  <c:v>1.5923566878980901E-3</c:v>
                </c:pt>
              </c:numCache>
            </c:numRef>
          </c:val>
        </c:ser>
        <c:ser>
          <c:idx val="11"/>
          <c:order val="11"/>
          <c:tx>
            <c:strRef>
              <c:f>'unc-25 A5_0.02_50%'!$M$104</c:f>
              <c:strCache>
                <c:ptCount val="1"/>
                <c:pt idx="0">
                  <c:v>unc-25_A5_M108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M$105:$M$135</c:f>
              <c:numCache>
                <c:formatCode>General</c:formatCode>
                <c:ptCount val="31"/>
                <c:pt idx="1">
                  <c:v>7.9279279279279302E-2</c:v>
                </c:pt>
                <c:pt idx="2">
                  <c:v>7.0270270270270302E-2</c:v>
                </c:pt>
                <c:pt idx="3">
                  <c:v>5.4054054054054113E-2</c:v>
                </c:pt>
                <c:pt idx="4">
                  <c:v>4.5045045045045001E-2</c:v>
                </c:pt>
                <c:pt idx="5">
                  <c:v>2.8828828828828798E-2</c:v>
                </c:pt>
                <c:pt idx="6">
                  <c:v>3.0630630630630602E-2</c:v>
                </c:pt>
                <c:pt idx="7">
                  <c:v>1.4414414414414399E-2</c:v>
                </c:pt>
                <c:pt idx="8">
                  <c:v>2.1621621621621602E-2</c:v>
                </c:pt>
                <c:pt idx="9">
                  <c:v>1.62162162162162E-2</c:v>
                </c:pt>
                <c:pt idx="10">
                  <c:v>1.8018018018018007E-2</c:v>
                </c:pt>
                <c:pt idx="11">
                  <c:v>1.9819819819819808E-2</c:v>
                </c:pt>
                <c:pt idx="12">
                  <c:v>4.6846846846846819E-2</c:v>
                </c:pt>
                <c:pt idx="13">
                  <c:v>4.6846846846846819E-2</c:v>
                </c:pt>
                <c:pt idx="14">
                  <c:v>5.04504504504504E-2</c:v>
                </c:pt>
                <c:pt idx="15">
                  <c:v>3.9639639639639609E-2</c:v>
                </c:pt>
                <c:pt idx="16">
                  <c:v>6.8468468468468505E-2</c:v>
                </c:pt>
                <c:pt idx="17">
                  <c:v>3.24324324324324E-2</c:v>
                </c:pt>
                <c:pt idx="18">
                  <c:v>2.5225225225225214E-2</c:v>
                </c:pt>
                <c:pt idx="19">
                  <c:v>2.5225225225225214E-2</c:v>
                </c:pt>
                <c:pt idx="20">
                  <c:v>2.1621621621621602E-2</c:v>
                </c:pt>
                <c:pt idx="21">
                  <c:v>1.62162162162162E-2</c:v>
                </c:pt>
                <c:pt idx="22">
                  <c:v>1.0810810810810801E-2</c:v>
                </c:pt>
                <c:pt idx="23">
                  <c:v>9.0090090090090176E-3</c:v>
                </c:pt>
                <c:pt idx="24">
                  <c:v>1.8018018018018005E-3</c:v>
                </c:pt>
                <c:pt idx="25">
                  <c:v>3.6036036036036002E-3</c:v>
                </c:pt>
                <c:pt idx="26">
                  <c:v>1.8018018018018005E-3</c:v>
                </c:pt>
                <c:pt idx="27">
                  <c:v>1.8018018018018005E-3</c:v>
                </c:pt>
                <c:pt idx="28">
                  <c:v>0</c:v>
                </c:pt>
                <c:pt idx="29">
                  <c:v>1.8018018018018005E-3</c:v>
                </c:pt>
                <c:pt idx="30">
                  <c:v>1.8018018018018005E-3</c:v>
                </c:pt>
              </c:numCache>
            </c:numRef>
          </c:val>
        </c:ser>
        <c:ser>
          <c:idx val="12"/>
          <c:order val="12"/>
          <c:tx>
            <c:strRef>
              <c:f>'unc-25 A5_0.02_50%'!$N$104</c:f>
              <c:strCache>
                <c:ptCount val="1"/>
                <c:pt idx="0">
                  <c:v>unc-25_A5_M109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N$105:$N$135</c:f>
              <c:numCache>
                <c:formatCode>General</c:formatCode>
                <c:ptCount val="31"/>
                <c:pt idx="1">
                  <c:v>0.11347517730496498</c:v>
                </c:pt>
                <c:pt idx="2">
                  <c:v>8.1560283687943283E-2</c:v>
                </c:pt>
                <c:pt idx="3">
                  <c:v>7.6241134751772965E-2</c:v>
                </c:pt>
                <c:pt idx="4">
                  <c:v>4.9645390070921995E-2</c:v>
                </c:pt>
                <c:pt idx="5">
                  <c:v>4.2553191489361715E-2</c:v>
                </c:pt>
                <c:pt idx="6">
                  <c:v>3.3687943262411313E-2</c:v>
                </c:pt>
                <c:pt idx="7">
                  <c:v>1.9503546099290801E-2</c:v>
                </c:pt>
                <c:pt idx="8">
                  <c:v>1.77304964539007E-2</c:v>
                </c:pt>
                <c:pt idx="9">
                  <c:v>1.5957446808510599E-2</c:v>
                </c:pt>
                <c:pt idx="10">
                  <c:v>4.9645390070921995E-2</c:v>
                </c:pt>
                <c:pt idx="11">
                  <c:v>3.0141843971631208E-2</c:v>
                </c:pt>
                <c:pt idx="12">
                  <c:v>3.3687943262411313E-2</c:v>
                </c:pt>
                <c:pt idx="13">
                  <c:v>4.9645390070921995E-2</c:v>
                </c:pt>
                <c:pt idx="14">
                  <c:v>2.6595744680851106E-2</c:v>
                </c:pt>
                <c:pt idx="15">
                  <c:v>1.0638297872340394E-2</c:v>
                </c:pt>
                <c:pt idx="16">
                  <c:v>1.0638297872340394E-2</c:v>
                </c:pt>
                <c:pt idx="17">
                  <c:v>1.4184397163120598E-2</c:v>
                </c:pt>
                <c:pt idx="18">
                  <c:v>8.8652482269503691E-3</c:v>
                </c:pt>
                <c:pt idx="19">
                  <c:v>1.77304964539007E-3</c:v>
                </c:pt>
                <c:pt idx="20">
                  <c:v>1.0638297872340394E-2</c:v>
                </c:pt>
                <c:pt idx="21">
                  <c:v>3.5460992907801409E-3</c:v>
                </c:pt>
                <c:pt idx="22">
                  <c:v>0</c:v>
                </c:pt>
                <c:pt idx="23">
                  <c:v>3.5460992907801409E-3</c:v>
                </c:pt>
                <c:pt idx="24">
                  <c:v>0</c:v>
                </c:pt>
                <c:pt idx="25">
                  <c:v>1.77304964539007E-3</c:v>
                </c:pt>
                <c:pt idx="26">
                  <c:v>0</c:v>
                </c:pt>
                <c:pt idx="27">
                  <c:v>0</c:v>
                </c:pt>
                <c:pt idx="28">
                  <c:v>3.5460992907801409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unc-25 A5_0.02_50%'!$O$104</c:f>
              <c:strCache>
                <c:ptCount val="1"/>
                <c:pt idx="0">
                  <c:v>unc-25_A5_M110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O$105:$O$135</c:f>
              <c:numCache>
                <c:formatCode>General</c:formatCode>
                <c:ptCount val="31"/>
                <c:pt idx="1">
                  <c:v>7.0660522273425494E-2</c:v>
                </c:pt>
                <c:pt idx="2">
                  <c:v>5.8371735791090583E-2</c:v>
                </c:pt>
                <c:pt idx="3">
                  <c:v>5.22273425499232E-2</c:v>
                </c:pt>
                <c:pt idx="4">
                  <c:v>3.0721966205837198E-2</c:v>
                </c:pt>
                <c:pt idx="5">
                  <c:v>2.1505376344085999E-2</c:v>
                </c:pt>
                <c:pt idx="6">
                  <c:v>2.3041474654377898E-2</c:v>
                </c:pt>
                <c:pt idx="7">
                  <c:v>7.6804915514592899E-3</c:v>
                </c:pt>
                <c:pt idx="8">
                  <c:v>9.2165898617511503E-3</c:v>
                </c:pt>
                <c:pt idx="9">
                  <c:v>1.2288786482334899E-2</c:v>
                </c:pt>
                <c:pt idx="10">
                  <c:v>1.8433179723502308E-2</c:v>
                </c:pt>
                <c:pt idx="11">
                  <c:v>4.3010752688171984E-2</c:v>
                </c:pt>
                <c:pt idx="12">
                  <c:v>3.8402457757296497E-2</c:v>
                </c:pt>
                <c:pt idx="13">
                  <c:v>5.5299539170506902E-2</c:v>
                </c:pt>
                <c:pt idx="14">
                  <c:v>4.4546850998463901E-2</c:v>
                </c:pt>
                <c:pt idx="15">
                  <c:v>6.6052227342549924E-2</c:v>
                </c:pt>
                <c:pt idx="16">
                  <c:v>7.2196620583717425E-2</c:v>
                </c:pt>
                <c:pt idx="17">
                  <c:v>5.22273425499232E-2</c:v>
                </c:pt>
                <c:pt idx="18">
                  <c:v>4.7619047619047616E-2</c:v>
                </c:pt>
                <c:pt idx="19">
                  <c:v>1.3824884792626705E-2</c:v>
                </c:pt>
                <c:pt idx="20">
                  <c:v>1.8433179723502308E-2</c:v>
                </c:pt>
                <c:pt idx="21">
                  <c:v>1.6897081413210408E-2</c:v>
                </c:pt>
                <c:pt idx="22">
                  <c:v>1.2288786482334899E-2</c:v>
                </c:pt>
                <c:pt idx="23">
                  <c:v>1.0752688172042998E-2</c:v>
                </c:pt>
                <c:pt idx="24">
                  <c:v>7.6804915514592899E-3</c:v>
                </c:pt>
                <c:pt idx="25">
                  <c:v>1.5360983102918604E-3</c:v>
                </c:pt>
                <c:pt idx="26">
                  <c:v>4.6082949308755804E-3</c:v>
                </c:pt>
                <c:pt idx="27">
                  <c:v>1.5360983102918604E-3</c:v>
                </c:pt>
                <c:pt idx="28">
                  <c:v>1.5360983102918604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4"/>
          <c:order val="14"/>
          <c:tx>
            <c:strRef>
              <c:f>'unc-25 A5_0.02_50%'!$P$104</c:f>
              <c:strCache>
                <c:ptCount val="1"/>
                <c:pt idx="0">
                  <c:v>unc-25_A5_M111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P$105:$P$135</c:f>
              <c:numCache>
                <c:formatCode>General</c:formatCode>
                <c:ptCount val="31"/>
                <c:pt idx="1">
                  <c:v>8.1911262798634796E-2</c:v>
                </c:pt>
                <c:pt idx="2">
                  <c:v>5.2901023890785014E-2</c:v>
                </c:pt>
                <c:pt idx="3">
                  <c:v>5.4607508532423216E-2</c:v>
                </c:pt>
                <c:pt idx="4">
                  <c:v>3.2423208191126311E-2</c:v>
                </c:pt>
                <c:pt idx="5">
                  <c:v>3.2423208191126311E-2</c:v>
                </c:pt>
                <c:pt idx="6">
                  <c:v>2.0477815699658709E-2</c:v>
                </c:pt>
                <c:pt idx="7">
                  <c:v>1.7064846416382305E-2</c:v>
                </c:pt>
                <c:pt idx="8">
                  <c:v>3.2423208191126311E-2</c:v>
                </c:pt>
                <c:pt idx="9">
                  <c:v>2.9010238907849806E-2</c:v>
                </c:pt>
                <c:pt idx="10">
                  <c:v>2.9010238907849806E-2</c:v>
                </c:pt>
                <c:pt idx="11">
                  <c:v>2.5597269624573413E-2</c:v>
                </c:pt>
                <c:pt idx="12">
                  <c:v>4.436860068259392E-2</c:v>
                </c:pt>
                <c:pt idx="13">
                  <c:v>3.2423208191126311E-2</c:v>
                </c:pt>
                <c:pt idx="14">
                  <c:v>4.6075085324232087E-2</c:v>
                </c:pt>
                <c:pt idx="15">
                  <c:v>3.7542662116041001E-2</c:v>
                </c:pt>
                <c:pt idx="16">
                  <c:v>4.2662116040955621E-2</c:v>
                </c:pt>
                <c:pt idx="17">
                  <c:v>3.5836177474402722E-2</c:v>
                </c:pt>
                <c:pt idx="18">
                  <c:v>3.7542662116041001E-2</c:v>
                </c:pt>
                <c:pt idx="19">
                  <c:v>1.7064846416382305E-2</c:v>
                </c:pt>
                <c:pt idx="20">
                  <c:v>2.0477815699658709E-2</c:v>
                </c:pt>
                <c:pt idx="21">
                  <c:v>8.5324232081911335E-3</c:v>
                </c:pt>
                <c:pt idx="22">
                  <c:v>6.8259385665528976E-3</c:v>
                </c:pt>
                <c:pt idx="23">
                  <c:v>8.5324232081911335E-3</c:v>
                </c:pt>
                <c:pt idx="24">
                  <c:v>1.7064846416382305E-3</c:v>
                </c:pt>
                <c:pt idx="25">
                  <c:v>5.1194539249146834E-3</c:v>
                </c:pt>
                <c:pt idx="26">
                  <c:v>1.7064846416382305E-3</c:v>
                </c:pt>
                <c:pt idx="27">
                  <c:v>1.7064846416382305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5"/>
          <c:order val="15"/>
          <c:tx>
            <c:strRef>
              <c:f>'unc-25 A5_0.02_50%'!$Q$104</c:f>
              <c:strCache>
                <c:ptCount val="1"/>
                <c:pt idx="0">
                  <c:v>unc-25_REX_A5_01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Q$105:$Q$135</c:f>
              <c:numCache>
                <c:formatCode>General</c:formatCode>
                <c:ptCount val="31"/>
                <c:pt idx="1">
                  <c:v>9.3316519546027696E-2</c:v>
                </c:pt>
                <c:pt idx="2">
                  <c:v>7.6923076923076913E-2</c:v>
                </c:pt>
                <c:pt idx="3">
                  <c:v>6.4312736443884036E-2</c:v>
                </c:pt>
                <c:pt idx="4">
                  <c:v>3.6569987389659511E-2</c:v>
                </c:pt>
                <c:pt idx="5">
                  <c:v>3.1525851197982284E-2</c:v>
                </c:pt>
                <c:pt idx="6">
                  <c:v>2.2698612862547311E-2</c:v>
                </c:pt>
                <c:pt idx="7">
                  <c:v>2.143757881462801E-2</c:v>
                </c:pt>
                <c:pt idx="8">
                  <c:v>1.3871374527112205E-2</c:v>
                </c:pt>
                <c:pt idx="9">
                  <c:v>1.2610340479192898E-2</c:v>
                </c:pt>
                <c:pt idx="10">
                  <c:v>2.143757881462801E-2</c:v>
                </c:pt>
                <c:pt idx="11">
                  <c:v>3.6569987389659511E-2</c:v>
                </c:pt>
                <c:pt idx="12">
                  <c:v>2.648171500630522E-2</c:v>
                </c:pt>
                <c:pt idx="13">
                  <c:v>2.2698612862547311E-2</c:v>
                </c:pt>
                <c:pt idx="14">
                  <c:v>2.9003783102143802E-2</c:v>
                </c:pt>
                <c:pt idx="15">
                  <c:v>2.9003783102143802E-2</c:v>
                </c:pt>
                <c:pt idx="16">
                  <c:v>3.7831021437578813E-2</c:v>
                </c:pt>
                <c:pt idx="17">
                  <c:v>3.5308953341740203E-2</c:v>
                </c:pt>
                <c:pt idx="18">
                  <c:v>2.0176544766708701E-2</c:v>
                </c:pt>
                <c:pt idx="19">
                  <c:v>1.63934426229508E-2</c:v>
                </c:pt>
                <c:pt idx="20">
                  <c:v>1.8915510718789406E-2</c:v>
                </c:pt>
                <c:pt idx="21">
                  <c:v>1.2610340479192898E-2</c:v>
                </c:pt>
                <c:pt idx="22">
                  <c:v>1.13493064312736E-2</c:v>
                </c:pt>
                <c:pt idx="23">
                  <c:v>2.5220680958385889E-3</c:v>
                </c:pt>
                <c:pt idx="24">
                  <c:v>2.5220680958385889E-3</c:v>
                </c:pt>
                <c:pt idx="25">
                  <c:v>1.2610340479192899E-3</c:v>
                </c:pt>
                <c:pt idx="26">
                  <c:v>2.5220680958385889E-3</c:v>
                </c:pt>
                <c:pt idx="27">
                  <c:v>2.5220680958385889E-3</c:v>
                </c:pt>
                <c:pt idx="28">
                  <c:v>5.0441361916771814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6"/>
          <c:order val="16"/>
          <c:tx>
            <c:strRef>
              <c:f>'unc-25 A5_0.02_50%'!$R$104</c:f>
              <c:strCache>
                <c:ptCount val="1"/>
                <c:pt idx="0">
                  <c:v>unc-25_REX_A5_02</c:v>
                </c:pt>
              </c:strCache>
            </c:strRef>
          </c:tx>
          <c:marker>
            <c:symbol val="none"/>
          </c:marker>
          <c:cat>
            <c:numRef>
              <c:f>'unc-25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5_0.02_50%'!$R$105:$R$135</c:f>
              <c:numCache>
                <c:formatCode>General</c:formatCode>
                <c:ptCount val="31"/>
                <c:pt idx="1">
                  <c:v>0.10769230769230798</c:v>
                </c:pt>
                <c:pt idx="2">
                  <c:v>7.8846153846153802E-2</c:v>
                </c:pt>
                <c:pt idx="3">
                  <c:v>7.1153846153846234E-2</c:v>
                </c:pt>
                <c:pt idx="4">
                  <c:v>7.2115384615384595E-2</c:v>
                </c:pt>
                <c:pt idx="5">
                  <c:v>4.2307692307692324E-2</c:v>
                </c:pt>
                <c:pt idx="6">
                  <c:v>3.1730769230769201E-2</c:v>
                </c:pt>
                <c:pt idx="7">
                  <c:v>2.2115384615384606E-2</c:v>
                </c:pt>
                <c:pt idx="8">
                  <c:v>1.4423076923076898E-2</c:v>
                </c:pt>
                <c:pt idx="9">
                  <c:v>2.11538461538462E-2</c:v>
                </c:pt>
                <c:pt idx="10">
                  <c:v>1.3461538461538509E-2</c:v>
                </c:pt>
                <c:pt idx="11">
                  <c:v>1.6346153846153805E-2</c:v>
                </c:pt>
                <c:pt idx="12">
                  <c:v>3.2692307692307715E-2</c:v>
                </c:pt>
                <c:pt idx="13">
                  <c:v>2.7884615384615417E-2</c:v>
                </c:pt>
                <c:pt idx="14">
                  <c:v>2.6923076923076914E-2</c:v>
                </c:pt>
                <c:pt idx="15">
                  <c:v>2.6923076923076914E-2</c:v>
                </c:pt>
                <c:pt idx="16">
                  <c:v>2.6923076923076914E-2</c:v>
                </c:pt>
                <c:pt idx="17">
                  <c:v>3.0769230769230802E-2</c:v>
                </c:pt>
                <c:pt idx="18">
                  <c:v>2.3076923076923109E-2</c:v>
                </c:pt>
                <c:pt idx="19">
                  <c:v>1.5384615384615405E-2</c:v>
                </c:pt>
                <c:pt idx="20">
                  <c:v>1.2500000000000001E-2</c:v>
                </c:pt>
                <c:pt idx="21">
                  <c:v>1.3461538461538509E-2</c:v>
                </c:pt>
                <c:pt idx="22">
                  <c:v>8.6538461538461561E-3</c:v>
                </c:pt>
                <c:pt idx="23">
                  <c:v>8.6538461538461561E-3</c:v>
                </c:pt>
                <c:pt idx="24">
                  <c:v>2.88461538461538E-3</c:v>
                </c:pt>
                <c:pt idx="25">
                  <c:v>1.9230769230769212E-3</c:v>
                </c:pt>
                <c:pt idx="26">
                  <c:v>2.88461538461538E-3</c:v>
                </c:pt>
                <c:pt idx="27">
                  <c:v>2.88461538461538E-3</c:v>
                </c:pt>
                <c:pt idx="28">
                  <c:v>9.6153846153846278E-4</c:v>
                </c:pt>
                <c:pt idx="29">
                  <c:v>9.6153846153846278E-4</c:v>
                </c:pt>
                <c:pt idx="30">
                  <c:v>0</c:v>
                </c:pt>
              </c:numCache>
            </c:numRef>
          </c:val>
        </c:ser>
        <c:marker val="1"/>
        <c:axId val="165065088"/>
        <c:axId val="165066624"/>
      </c:lineChart>
      <c:catAx>
        <c:axId val="165065088"/>
        <c:scaling>
          <c:orientation val="minMax"/>
        </c:scaling>
        <c:axPos val="b"/>
        <c:numFmt formatCode="0.0_ " sourceLinked="1"/>
        <c:tickLblPos val="nextTo"/>
        <c:crossAx val="165066624"/>
        <c:crosses val="autoZero"/>
        <c:auto val="1"/>
        <c:lblAlgn val="ctr"/>
        <c:lblOffset val="100"/>
        <c:tickLblSkip val="5"/>
        <c:tickMarkSkip val="5"/>
      </c:catAx>
      <c:valAx>
        <c:axId val="165066624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5065088"/>
        <c:crosses val="autoZero"/>
        <c:crossBetween val="between"/>
      </c:valAx>
    </c:plotArea>
    <c:plotVisOnly val="1"/>
  </c:chart>
  <c:externalData r:id="rId1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nmr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5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nmr-1(ak4)_A5_0.02_50%'!$B$104</c:f>
              <c:strCache>
                <c:ptCount val="1"/>
                <c:pt idx="0">
                  <c:v>nmr-1(ak4)_A5_01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B$105:$B$135</c:f>
              <c:numCache>
                <c:formatCode>General</c:formatCode>
                <c:ptCount val="31"/>
                <c:pt idx="1">
                  <c:v>1.05263157894737E-2</c:v>
                </c:pt>
                <c:pt idx="2">
                  <c:v>0</c:v>
                </c:pt>
                <c:pt idx="3">
                  <c:v>0</c:v>
                </c:pt>
                <c:pt idx="4">
                  <c:v>5.263157894736842E-3</c:v>
                </c:pt>
                <c:pt idx="5">
                  <c:v>5.263157894736842E-3</c:v>
                </c:pt>
                <c:pt idx="6">
                  <c:v>0</c:v>
                </c:pt>
                <c:pt idx="7">
                  <c:v>0</c:v>
                </c:pt>
                <c:pt idx="8">
                  <c:v>1.05263157894737E-2</c:v>
                </c:pt>
                <c:pt idx="9">
                  <c:v>0</c:v>
                </c:pt>
                <c:pt idx="10">
                  <c:v>0</c:v>
                </c:pt>
                <c:pt idx="11">
                  <c:v>2.1052631578947399E-2</c:v>
                </c:pt>
                <c:pt idx="12">
                  <c:v>2.1052631578947399E-2</c:v>
                </c:pt>
                <c:pt idx="13">
                  <c:v>2.6315789473684202E-2</c:v>
                </c:pt>
                <c:pt idx="14">
                  <c:v>7.8947368421052572E-2</c:v>
                </c:pt>
                <c:pt idx="15">
                  <c:v>7.8947368421052572E-2</c:v>
                </c:pt>
                <c:pt idx="16">
                  <c:v>0.15263157894736801</c:v>
                </c:pt>
                <c:pt idx="17">
                  <c:v>0.13684210526315793</c:v>
                </c:pt>
                <c:pt idx="18">
                  <c:v>0.12631578947368394</c:v>
                </c:pt>
                <c:pt idx="19">
                  <c:v>8.4210526315789527E-2</c:v>
                </c:pt>
                <c:pt idx="20">
                  <c:v>7.8947368421052572E-2</c:v>
                </c:pt>
                <c:pt idx="21">
                  <c:v>4.2105263157894701E-2</c:v>
                </c:pt>
                <c:pt idx="22">
                  <c:v>3.1578947368421116E-2</c:v>
                </c:pt>
                <c:pt idx="23">
                  <c:v>3.1578947368421116E-2</c:v>
                </c:pt>
                <c:pt idx="24">
                  <c:v>5.263157894736842E-3</c:v>
                </c:pt>
                <c:pt idx="25">
                  <c:v>1.05263157894737E-2</c:v>
                </c:pt>
                <c:pt idx="26">
                  <c:v>1.05263157894737E-2</c:v>
                </c:pt>
                <c:pt idx="27">
                  <c:v>0</c:v>
                </c:pt>
                <c:pt idx="28">
                  <c:v>0</c:v>
                </c:pt>
                <c:pt idx="29">
                  <c:v>1.05263157894737E-2</c:v>
                </c:pt>
                <c:pt idx="30">
                  <c:v>5.263157894736842E-3</c:v>
                </c:pt>
              </c:numCache>
            </c:numRef>
          </c:val>
        </c:ser>
        <c:ser>
          <c:idx val="1"/>
          <c:order val="1"/>
          <c:tx>
            <c:strRef>
              <c:f>'nmr-1(ak4)_A5_0.02_50%'!$C$104</c:f>
              <c:strCache>
                <c:ptCount val="1"/>
                <c:pt idx="0">
                  <c:v>nmr-1(ak4)_A5_02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C$105:$C$135</c:f>
              <c:numCache>
                <c:formatCode>General</c:formatCode>
                <c:ptCount val="31"/>
                <c:pt idx="1">
                  <c:v>2.8985507246376802E-2</c:v>
                </c:pt>
                <c:pt idx="2">
                  <c:v>0</c:v>
                </c:pt>
                <c:pt idx="3">
                  <c:v>7.2463768115942021E-3</c:v>
                </c:pt>
                <c:pt idx="4">
                  <c:v>7.2463768115942021E-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1.4492753623188401E-2</c:v>
                </c:pt>
                <c:pt idx="11">
                  <c:v>3.6231884057971016E-2</c:v>
                </c:pt>
                <c:pt idx="12">
                  <c:v>5.7971014492753603E-2</c:v>
                </c:pt>
                <c:pt idx="13">
                  <c:v>7.2463768115942032E-2</c:v>
                </c:pt>
                <c:pt idx="14">
                  <c:v>8.6956521739130446E-2</c:v>
                </c:pt>
                <c:pt idx="15">
                  <c:v>0.18115942028985493</c:v>
                </c:pt>
                <c:pt idx="16">
                  <c:v>0.11594202898550703</c:v>
                </c:pt>
                <c:pt idx="17">
                  <c:v>0.13043478260869601</c:v>
                </c:pt>
                <c:pt idx="18">
                  <c:v>4.3478260869565202E-2</c:v>
                </c:pt>
                <c:pt idx="19">
                  <c:v>2.8985507246376802E-2</c:v>
                </c:pt>
                <c:pt idx="20">
                  <c:v>1.4492753623188401E-2</c:v>
                </c:pt>
                <c:pt idx="21">
                  <c:v>1.4492753623188401E-2</c:v>
                </c:pt>
                <c:pt idx="22">
                  <c:v>2.1739130434782601E-2</c:v>
                </c:pt>
                <c:pt idx="23">
                  <c:v>1.4492753623188401E-2</c:v>
                </c:pt>
                <c:pt idx="24">
                  <c:v>1.4492753623188401E-2</c:v>
                </c:pt>
                <c:pt idx="25">
                  <c:v>7.2463768115942021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7.2463768115942021E-3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nmr-1(ak4)_A5_0.02_50%'!$D$104</c:f>
              <c:strCache>
                <c:ptCount val="1"/>
                <c:pt idx="0">
                  <c:v>nmr-1(ak4)_A5_03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D$105:$D$135</c:f>
              <c:numCache>
                <c:formatCode>General</c:formatCode>
                <c:ptCount val="31"/>
                <c:pt idx="1">
                  <c:v>5.8823529411764714E-3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.1764705882352905E-2</c:v>
                </c:pt>
                <c:pt idx="7">
                  <c:v>0</c:v>
                </c:pt>
                <c:pt idx="8">
                  <c:v>0</c:v>
                </c:pt>
                <c:pt idx="9">
                  <c:v>1.1764705882352905E-2</c:v>
                </c:pt>
                <c:pt idx="10">
                  <c:v>0</c:v>
                </c:pt>
                <c:pt idx="11">
                  <c:v>0</c:v>
                </c:pt>
                <c:pt idx="12">
                  <c:v>5.8823529411764714E-3</c:v>
                </c:pt>
                <c:pt idx="13">
                  <c:v>1.7647058823529401E-2</c:v>
                </c:pt>
                <c:pt idx="14">
                  <c:v>2.9411764705882398E-2</c:v>
                </c:pt>
                <c:pt idx="15">
                  <c:v>5.2941176470588179E-2</c:v>
                </c:pt>
                <c:pt idx="16">
                  <c:v>0.2</c:v>
                </c:pt>
                <c:pt idx="17">
                  <c:v>0.123529411764706</c:v>
                </c:pt>
                <c:pt idx="18">
                  <c:v>0.17647058823529399</c:v>
                </c:pt>
                <c:pt idx="19">
                  <c:v>9.4117647058823528E-2</c:v>
                </c:pt>
                <c:pt idx="20">
                  <c:v>5.8823529411764698E-2</c:v>
                </c:pt>
                <c:pt idx="21">
                  <c:v>7.0588235294117604E-2</c:v>
                </c:pt>
                <c:pt idx="22">
                  <c:v>2.3529411764705889E-2</c:v>
                </c:pt>
                <c:pt idx="23">
                  <c:v>1.7647058823529401E-2</c:v>
                </c:pt>
                <c:pt idx="24">
                  <c:v>2.9411764705882398E-2</c:v>
                </c:pt>
                <c:pt idx="25">
                  <c:v>1.7647058823529401E-2</c:v>
                </c:pt>
                <c:pt idx="26">
                  <c:v>5.8823529411764714E-3</c:v>
                </c:pt>
                <c:pt idx="27">
                  <c:v>5.8823529411764714E-3</c:v>
                </c:pt>
                <c:pt idx="28">
                  <c:v>5.8823529411764714E-3</c:v>
                </c:pt>
                <c:pt idx="29">
                  <c:v>5.8823529411764714E-3</c:v>
                </c:pt>
                <c:pt idx="30">
                  <c:v>1.7647058823529401E-2</c:v>
                </c:pt>
              </c:numCache>
            </c:numRef>
          </c:val>
        </c:ser>
        <c:ser>
          <c:idx val="3"/>
          <c:order val="3"/>
          <c:tx>
            <c:strRef>
              <c:f>'nmr-1(ak4)_A5_0.02_50%'!$E$104</c:f>
              <c:strCache>
                <c:ptCount val="1"/>
                <c:pt idx="0">
                  <c:v>nmr-1(ak4)_A5_04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E$105:$E$135</c:f>
              <c:numCache>
                <c:formatCode>General</c:formatCode>
                <c:ptCount val="31"/>
                <c:pt idx="1">
                  <c:v>1.0362694300518104E-2</c:v>
                </c:pt>
                <c:pt idx="2">
                  <c:v>1.0362694300518104E-2</c:v>
                </c:pt>
                <c:pt idx="3">
                  <c:v>5.1813471502590736E-3</c:v>
                </c:pt>
                <c:pt idx="4">
                  <c:v>0</c:v>
                </c:pt>
                <c:pt idx="5">
                  <c:v>0</c:v>
                </c:pt>
                <c:pt idx="6">
                  <c:v>5.1813471502590736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5.1813471502590736E-3</c:v>
                </c:pt>
                <c:pt idx="12">
                  <c:v>1.5544041450777204E-2</c:v>
                </c:pt>
                <c:pt idx="13">
                  <c:v>2.0725388601036301E-2</c:v>
                </c:pt>
                <c:pt idx="14">
                  <c:v>4.1450777202072499E-2</c:v>
                </c:pt>
                <c:pt idx="15">
                  <c:v>9.8445595854922296E-2</c:v>
                </c:pt>
                <c:pt idx="16">
                  <c:v>0.11917098445595906</c:v>
                </c:pt>
                <c:pt idx="17">
                  <c:v>0.19689119170984501</c:v>
                </c:pt>
                <c:pt idx="18">
                  <c:v>0.14507772020725396</c:v>
                </c:pt>
                <c:pt idx="19">
                  <c:v>9.8445595854922296E-2</c:v>
                </c:pt>
                <c:pt idx="20">
                  <c:v>4.6632124352331626E-2</c:v>
                </c:pt>
                <c:pt idx="21">
                  <c:v>7.7720207253886023E-2</c:v>
                </c:pt>
                <c:pt idx="22">
                  <c:v>2.5906735751295307E-2</c:v>
                </c:pt>
                <c:pt idx="23">
                  <c:v>3.1088082901554407E-2</c:v>
                </c:pt>
                <c:pt idx="24">
                  <c:v>0</c:v>
                </c:pt>
                <c:pt idx="25">
                  <c:v>5.1813471502590736E-3</c:v>
                </c:pt>
                <c:pt idx="26">
                  <c:v>0</c:v>
                </c:pt>
                <c:pt idx="27">
                  <c:v>5.1813471502590736E-3</c:v>
                </c:pt>
                <c:pt idx="28">
                  <c:v>5.1813471502590736E-3</c:v>
                </c:pt>
                <c:pt idx="29">
                  <c:v>0</c:v>
                </c:pt>
                <c:pt idx="30">
                  <c:v>5.1813471502590736E-3</c:v>
                </c:pt>
              </c:numCache>
            </c:numRef>
          </c:val>
        </c:ser>
        <c:ser>
          <c:idx val="4"/>
          <c:order val="4"/>
          <c:tx>
            <c:strRef>
              <c:f>'nmr-1(ak4)_A5_0.02_50%'!$F$104</c:f>
              <c:strCache>
                <c:ptCount val="1"/>
                <c:pt idx="0">
                  <c:v>nmr-1(ak4)_A5_05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F$105:$F$135</c:f>
              <c:numCache>
                <c:formatCode>General</c:formatCode>
                <c:ptCount val="31"/>
              </c:numCache>
            </c:numRef>
          </c:val>
        </c:ser>
        <c:ser>
          <c:idx val="5"/>
          <c:order val="5"/>
          <c:tx>
            <c:strRef>
              <c:f>'nmr-1(ak4)_A5_0.02_50%'!$G$104</c:f>
              <c:strCache>
                <c:ptCount val="1"/>
                <c:pt idx="0">
                  <c:v>nmr-1(ak4)_A5_06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G$105:$G$135</c:f>
              <c:numCache>
                <c:formatCode>General</c:formatCode>
                <c:ptCount val="31"/>
                <c:pt idx="1">
                  <c:v>4.7846889952153117E-3</c:v>
                </c:pt>
                <c:pt idx="2">
                  <c:v>9.5693779904306216E-3</c:v>
                </c:pt>
                <c:pt idx="3">
                  <c:v>1.9138755980861205E-2</c:v>
                </c:pt>
                <c:pt idx="4">
                  <c:v>0</c:v>
                </c:pt>
                <c:pt idx="5">
                  <c:v>0</c:v>
                </c:pt>
                <c:pt idx="6">
                  <c:v>4.7846889952153117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9.5693779904306216E-3</c:v>
                </c:pt>
                <c:pt idx="11">
                  <c:v>0</c:v>
                </c:pt>
                <c:pt idx="12">
                  <c:v>4.7846889952153117E-3</c:v>
                </c:pt>
                <c:pt idx="13">
                  <c:v>1.9138755980861205E-2</c:v>
                </c:pt>
                <c:pt idx="14">
                  <c:v>5.7416267942583754E-2</c:v>
                </c:pt>
                <c:pt idx="15">
                  <c:v>9.0909090909090939E-2</c:v>
                </c:pt>
                <c:pt idx="16">
                  <c:v>0.12918660287081293</c:v>
                </c:pt>
                <c:pt idx="17">
                  <c:v>0.11961722488038302</c:v>
                </c:pt>
                <c:pt idx="18">
                  <c:v>0.16267942583732106</c:v>
                </c:pt>
                <c:pt idx="19">
                  <c:v>0.105263157894737</c:v>
                </c:pt>
                <c:pt idx="20">
                  <c:v>9.0909090909090939E-2</c:v>
                </c:pt>
                <c:pt idx="21">
                  <c:v>5.2631578947368404E-2</c:v>
                </c:pt>
                <c:pt idx="22">
                  <c:v>3.8277511961722514E-2</c:v>
                </c:pt>
                <c:pt idx="23">
                  <c:v>2.3923444976076597E-2</c:v>
                </c:pt>
                <c:pt idx="24">
                  <c:v>4.7846889952153117E-3</c:v>
                </c:pt>
                <c:pt idx="25">
                  <c:v>1.9138755980861205E-2</c:v>
                </c:pt>
                <c:pt idx="26">
                  <c:v>1.4354066985645893E-2</c:v>
                </c:pt>
                <c:pt idx="27">
                  <c:v>0</c:v>
                </c:pt>
                <c:pt idx="28">
                  <c:v>0</c:v>
                </c:pt>
                <c:pt idx="29">
                  <c:v>4.7846889952153117E-3</c:v>
                </c:pt>
                <c:pt idx="30">
                  <c:v>0</c:v>
                </c:pt>
              </c:numCache>
            </c:numRef>
          </c:val>
        </c:ser>
        <c:ser>
          <c:idx val="6"/>
          <c:order val="6"/>
          <c:tx>
            <c:strRef>
              <c:f>'nmr-1(ak4)_A5_0.02_50%'!$H$104</c:f>
              <c:strCache>
                <c:ptCount val="1"/>
                <c:pt idx="0">
                  <c:v>nmr-1(ak4)_A5_07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H$105:$H$135</c:f>
              <c:numCache>
                <c:formatCode>General</c:formatCode>
                <c:ptCount val="31"/>
                <c:pt idx="1">
                  <c:v>8.8888888888888941E-3</c:v>
                </c:pt>
                <c:pt idx="2">
                  <c:v>1.7777777777777802E-2</c:v>
                </c:pt>
                <c:pt idx="3">
                  <c:v>0</c:v>
                </c:pt>
                <c:pt idx="4">
                  <c:v>0</c:v>
                </c:pt>
                <c:pt idx="5">
                  <c:v>4.4444444444444418E-3</c:v>
                </c:pt>
                <c:pt idx="6">
                  <c:v>8.8888888888888941E-3</c:v>
                </c:pt>
                <c:pt idx="7">
                  <c:v>4.4444444444444418E-3</c:v>
                </c:pt>
                <c:pt idx="8">
                  <c:v>1.3333333333333301E-2</c:v>
                </c:pt>
                <c:pt idx="9">
                  <c:v>0</c:v>
                </c:pt>
                <c:pt idx="10">
                  <c:v>1.3333333333333301E-2</c:v>
                </c:pt>
                <c:pt idx="11">
                  <c:v>6.6666666666666693E-2</c:v>
                </c:pt>
                <c:pt idx="12">
                  <c:v>4.4444444444444418E-2</c:v>
                </c:pt>
                <c:pt idx="13">
                  <c:v>6.6666666666666693E-2</c:v>
                </c:pt>
                <c:pt idx="14">
                  <c:v>0.15111111111111106</c:v>
                </c:pt>
                <c:pt idx="15">
                  <c:v>0.12000000000000002</c:v>
                </c:pt>
                <c:pt idx="16">
                  <c:v>0.10666666666666705</c:v>
                </c:pt>
                <c:pt idx="17">
                  <c:v>9.7777777777777783E-2</c:v>
                </c:pt>
                <c:pt idx="18">
                  <c:v>6.6666666666666693E-2</c:v>
                </c:pt>
                <c:pt idx="19">
                  <c:v>5.7777777777777803E-2</c:v>
                </c:pt>
                <c:pt idx="20">
                  <c:v>4.4444444444444418E-2</c:v>
                </c:pt>
                <c:pt idx="21">
                  <c:v>1.3333333333333301E-2</c:v>
                </c:pt>
                <c:pt idx="22">
                  <c:v>4.4444444444444418E-3</c:v>
                </c:pt>
                <c:pt idx="23">
                  <c:v>4.4444444444444418E-3</c:v>
                </c:pt>
                <c:pt idx="24">
                  <c:v>8.8888888888888941E-3</c:v>
                </c:pt>
                <c:pt idx="25">
                  <c:v>8.8888888888888941E-3</c:v>
                </c:pt>
                <c:pt idx="26">
                  <c:v>4.4444444444444418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4.4444444444444418E-3</c:v>
                </c:pt>
              </c:numCache>
            </c:numRef>
          </c:val>
        </c:ser>
        <c:ser>
          <c:idx val="7"/>
          <c:order val="7"/>
          <c:tx>
            <c:strRef>
              <c:f>'nmr-1(ak4)_A5_0.02_50%'!$I$104</c:f>
              <c:strCache>
                <c:ptCount val="1"/>
                <c:pt idx="0">
                  <c:v>nmr-1(ak4)_A5_08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I$105:$I$135</c:f>
              <c:numCache>
                <c:formatCode>General</c:formatCode>
                <c:ptCount val="31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4.9504950495049514E-3</c:v>
                </c:pt>
                <c:pt idx="5">
                  <c:v>0</c:v>
                </c:pt>
                <c:pt idx="6">
                  <c:v>4.9504950495049514E-3</c:v>
                </c:pt>
                <c:pt idx="7">
                  <c:v>4.9504950495049514E-3</c:v>
                </c:pt>
                <c:pt idx="8">
                  <c:v>1.4851485148514901E-2</c:v>
                </c:pt>
                <c:pt idx="9">
                  <c:v>4.9504950495049514E-3</c:v>
                </c:pt>
                <c:pt idx="10">
                  <c:v>0</c:v>
                </c:pt>
                <c:pt idx="11">
                  <c:v>9.9009900990099063E-3</c:v>
                </c:pt>
                <c:pt idx="12">
                  <c:v>9.9009900990099063E-3</c:v>
                </c:pt>
                <c:pt idx="13">
                  <c:v>1.9801980198019809E-2</c:v>
                </c:pt>
                <c:pt idx="14">
                  <c:v>3.9603960396039611E-2</c:v>
                </c:pt>
                <c:pt idx="15">
                  <c:v>0.10891089108910898</c:v>
                </c:pt>
                <c:pt idx="16">
                  <c:v>0.17821782178217807</c:v>
                </c:pt>
                <c:pt idx="17">
                  <c:v>0.12376237623762404</c:v>
                </c:pt>
                <c:pt idx="18">
                  <c:v>0.15346534653465307</c:v>
                </c:pt>
                <c:pt idx="19">
                  <c:v>0.11881188118811903</c:v>
                </c:pt>
                <c:pt idx="20">
                  <c:v>0.10891089108910898</c:v>
                </c:pt>
                <c:pt idx="21">
                  <c:v>3.9603960396039611E-2</c:v>
                </c:pt>
                <c:pt idx="22">
                  <c:v>1.9801980198019809E-2</c:v>
                </c:pt>
                <c:pt idx="23">
                  <c:v>1.4851485148514901E-2</c:v>
                </c:pt>
                <c:pt idx="24">
                  <c:v>4.9504950495049514E-3</c:v>
                </c:pt>
                <c:pt idx="25">
                  <c:v>0</c:v>
                </c:pt>
                <c:pt idx="26">
                  <c:v>9.9009900990099063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8"/>
          <c:order val="8"/>
          <c:tx>
            <c:strRef>
              <c:f>'nmr-1(ak4)_A5_0.02_50%'!$J$104</c:f>
              <c:strCache>
                <c:ptCount val="1"/>
                <c:pt idx="0">
                  <c:v>nmr-1(ak4)_A5_09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J$105:$J$135</c:f>
              <c:numCache>
                <c:formatCode>General</c:formatCode>
                <c:ptCount val="31"/>
                <c:pt idx="1">
                  <c:v>1.0989010989011E-2</c:v>
                </c:pt>
                <c:pt idx="2">
                  <c:v>1.0989010989011E-2</c:v>
                </c:pt>
                <c:pt idx="3">
                  <c:v>5.4945054945054897E-3</c:v>
                </c:pt>
                <c:pt idx="4">
                  <c:v>0</c:v>
                </c:pt>
                <c:pt idx="5">
                  <c:v>0</c:v>
                </c:pt>
                <c:pt idx="6">
                  <c:v>5.4945054945054897E-3</c:v>
                </c:pt>
                <c:pt idx="7">
                  <c:v>0</c:v>
                </c:pt>
                <c:pt idx="8">
                  <c:v>0</c:v>
                </c:pt>
                <c:pt idx="9">
                  <c:v>1.6483516483516501E-2</c:v>
                </c:pt>
                <c:pt idx="10">
                  <c:v>0</c:v>
                </c:pt>
                <c:pt idx="11">
                  <c:v>3.8461538461538498E-2</c:v>
                </c:pt>
                <c:pt idx="12">
                  <c:v>7.1428571428571411E-2</c:v>
                </c:pt>
                <c:pt idx="13">
                  <c:v>9.8901098901098952E-2</c:v>
                </c:pt>
                <c:pt idx="14">
                  <c:v>0.15384615384615408</c:v>
                </c:pt>
                <c:pt idx="15">
                  <c:v>0.14835164835164794</c:v>
                </c:pt>
                <c:pt idx="16">
                  <c:v>0.16483516483516505</c:v>
                </c:pt>
                <c:pt idx="17">
                  <c:v>8.7912087912087877E-2</c:v>
                </c:pt>
                <c:pt idx="18">
                  <c:v>6.5934065934065894E-2</c:v>
                </c:pt>
                <c:pt idx="19">
                  <c:v>6.5934065934065894E-2</c:v>
                </c:pt>
                <c:pt idx="20">
                  <c:v>5.4945054945054897E-3</c:v>
                </c:pt>
                <c:pt idx="21">
                  <c:v>0</c:v>
                </c:pt>
                <c:pt idx="22">
                  <c:v>5.4945054945054897E-3</c:v>
                </c:pt>
                <c:pt idx="23">
                  <c:v>1.0989010989011E-2</c:v>
                </c:pt>
                <c:pt idx="24">
                  <c:v>5.4945054945054897E-3</c:v>
                </c:pt>
                <c:pt idx="25">
                  <c:v>0</c:v>
                </c:pt>
                <c:pt idx="26">
                  <c:v>0</c:v>
                </c:pt>
                <c:pt idx="27">
                  <c:v>5.4945054945054897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nmr-1(ak4)_A5_0.02_50%'!$K$104</c:f>
              <c:strCache>
                <c:ptCount val="1"/>
                <c:pt idx="0">
                  <c:v>nmr-1(ak4)_A5_10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K$105:$K$135</c:f>
              <c:numCache>
                <c:formatCode>General</c:formatCode>
                <c:ptCount val="31"/>
                <c:pt idx="1">
                  <c:v>1.6483516483516501E-2</c:v>
                </c:pt>
                <c:pt idx="2">
                  <c:v>5.4945054945054897E-3</c:v>
                </c:pt>
                <c:pt idx="3">
                  <c:v>5.4945054945054897E-3</c:v>
                </c:pt>
                <c:pt idx="4">
                  <c:v>1.0989010989011E-2</c:v>
                </c:pt>
                <c:pt idx="5">
                  <c:v>0</c:v>
                </c:pt>
                <c:pt idx="6">
                  <c:v>5.4945054945054897E-3</c:v>
                </c:pt>
                <c:pt idx="7">
                  <c:v>1.0989010989011E-2</c:v>
                </c:pt>
                <c:pt idx="8">
                  <c:v>0</c:v>
                </c:pt>
                <c:pt idx="9">
                  <c:v>0</c:v>
                </c:pt>
                <c:pt idx="10">
                  <c:v>5.4945054945054897E-3</c:v>
                </c:pt>
                <c:pt idx="11">
                  <c:v>1.0989010989011E-2</c:v>
                </c:pt>
                <c:pt idx="12">
                  <c:v>4.9450549450549414E-2</c:v>
                </c:pt>
                <c:pt idx="13">
                  <c:v>7.1428571428571411E-2</c:v>
                </c:pt>
                <c:pt idx="14">
                  <c:v>0.115384615384615</c:v>
                </c:pt>
                <c:pt idx="15">
                  <c:v>0.20879120879120908</c:v>
                </c:pt>
                <c:pt idx="16">
                  <c:v>0.16483516483516505</c:v>
                </c:pt>
                <c:pt idx="17">
                  <c:v>0.115384615384615</c:v>
                </c:pt>
                <c:pt idx="18">
                  <c:v>7.6923076923076913E-2</c:v>
                </c:pt>
                <c:pt idx="19">
                  <c:v>4.3956043956044015E-2</c:v>
                </c:pt>
                <c:pt idx="20">
                  <c:v>3.2967032967033016E-2</c:v>
                </c:pt>
                <c:pt idx="21">
                  <c:v>1.0989010989011E-2</c:v>
                </c:pt>
                <c:pt idx="22">
                  <c:v>1.0989010989011E-2</c:v>
                </c:pt>
                <c:pt idx="23">
                  <c:v>0</c:v>
                </c:pt>
                <c:pt idx="24">
                  <c:v>5.4945054945054897E-3</c:v>
                </c:pt>
                <c:pt idx="25">
                  <c:v>0</c:v>
                </c:pt>
                <c:pt idx="26">
                  <c:v>5.4945054945054897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5.4945054945054897E-3</c:v>
                </c:pt>
              </c:numCache>
            </c:numRef>
          </c:val>
        </c:ser>
        <c:ser>
          <c:idx val="10"/>
          <c:order val="10"/>
          <c:tx>
            <c:strRef>
              <c:f>'nmr-1(ak4)_A5_0.02_50%'!$L$104</c:f>
              <c:strCache>
                <c:ptCount val="1"/>
                <c:pt idx="0">
                  <c:v>nmr-1(ak4)_A5_11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L$105:$L$135</c:f>
              <c:numCache>
                <c:formatCode>General</c:formatCode>
                <c:ptCount val="31"/>
                <c:pt idx="1">
                  <c:v>2.0746887966805006E-2</c:v>
                </c:pt>
                <c:pt idx="2">
                  <c:v>2.4896265560166008E-2</c:v>
                </c:pt>
                <c:pt idx="3">
                  <c:v>2.0746887966805006E-2</c:v>
                </c:pt>
                <c:pt idx="4">
                  <c:v>1.6597510373444001E-2</c:v>
                </c:pt>
                <c:pt idx="5">
                  <c:v>8.29875518672199E-3</c:v>
                </c:pt>
                <c:pt idx="6">
                  <c:v>1.6597510373444001E-2</c:v>
                </c:pt>
                <c:pt idx="7">
                  <c:v>1.2448132780083001E-2</c:v>
                </c:pt>
                <c:pt idx="8">
                  <c:v>0</c:v>
                </c:pt>
                <c:pt idx="9">
                  <c:v>0</c:v>
                </c:pt>
                <c:pt idx="10">
                  <c:v>8.29875518672199E-3</c:v>
                </c:pt>
                <c:pt idx="11">
                  <c:v>2.4896265560166008E-2</c:v>
                </c:pt>
                <c:pt idx="12">
                  <c:v>3.3195020746887988E-2</c:v>
                </c:pt>
                <c:pt idx="13">
                  <c:v>4.5643153526970973E-2</c:v>
                </c:pt>
                <c:pt idx="14">
                  <c:v>6.2240663900414904E-2</c:v>
                </c:pt>
                <c:pt idx="15">
                  <c:v>7.4688796680497896E-2</c:v>
                </c:pt>
                <c:pt idx="16">
                  <c:v>0.13278008298755201</c:v>
                </c:pt>
                <c:pt idx="17">
                  <c:v>0.103734439834025</c:v>
                </c:pt>
                <c:pt idx="18">
                  <c:v>0.10788381742738598</c:v>
                </c:pt>
                <c:pt idx="19">
                  <c:v>5.3941908713692879E-2</c:v>
                </c:pt>
                <c:pt idx="20">
                  <c:v>3.734439834024901E-2</c:v>
                </c:pt>
                <c:pt idx="21">
                  <c:v>5.3941908713692879E-2</c:v>
                </c:pt>
                <c:pt idx="22">
                  <c:v>5.3941908713692879E-2</c:v>
                </c:pt>
                <c:pt idx="23">
                  <c:v>2.904564315352701E-2</c:v>
                </c:pt>
                <c:pt idx="24">
                  <c:v>8.29875518672199E-3</c:v>
                </c:pt>
                <c:pt idx="25">
                  <c:v>8.29875518672199E-3</c:v>
                </c:pt>
                <c:pt idx="26">
                  <c:v>4.1493775933610019E-3</c:v>
                </c:pt>
                <c:pt idx="27">
                  <c:v>8.29875518672199E-3</c:v>
                </c:pt>
                <c:pt idx="28">
                  <c:v>4.1493775933610019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nmr-1(ak4)_A5_0.02_50%'!$M$104</c:f>
              <c:strCache>
                <c:ptCount val="1"/>
                <c:pt idx="0">
                  <c:v>nmr-1(ak4)_A5_12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M$105:$M$135</c:f>
              <c:numCache>
                <c:formatCode>General</c:formatCode>
                <c:ptCount val="31"/>
                <c:pt idx="1">
                  <c:v>3.7037037037037017E-3</c:v>
                </c:pt>
                <c:pt idx="2">
                  <c:v>0</c:v>
                </c:pt>
                <c:pt idx="3">
                  <c:v>3.7037037037037017E-3</c:v>
                </c:pt>
                <c:pt idx="4">
                  <c:v>1.1111111111111101E-2</c:v>
                </c:pt>
                <c:pt idx="5">
                  <c:v>3.7037037037037017E-3</c:v>
                </c:pt>
                <c:pt idx="6">
                  <c:v>7.4074074074074103E-3</c:v>
                </c:pt>
                <c:pt idx="7">
                  <c:v>0</c:v>
                </c:pt>
                <c:pt idx="8">
                  <c:v>3.7037037037037017E-3</c:v>
                </c:pt>
                <c:pt idx="9">
                  <c:v>7.4074074074074103E-3</c:v>
                </c:pt>
                <c:pt idx="10">
                  <c:v>1.1111111111111101E-2</c:v>
                </c:pt>
                <c:pt idx="11">
                  <c:v>2.2222222222222202E-2</c:v>
                </c:pt>
                <c:pt idx="12">
                  <c:v>5.9259259259259296E-2</c:v>
                </c:pt>
                <c:pt idx="13">
                  <c:v>0.10370370370370405</c:v>
                </c:pt>
                <c:pt idx="14">
                  <c:v>9.2592592592592671E-2</c:v>
                </c:pt>
                <c:pt idx="15">
                  <c:v>0.15185185185185199</c:v>
                </c:pt>
                <c:pt idx="16">
                  <c:v>0.16666666666666693</c:v>
                </c:pt>
                <c:pt idx="17">
                  <c:v>0.1296296296296299</c:v>
                </c:pt>
                <c:pt idx="18">
                  <c:v>7.7777777777777807E-2</c:v>
                </c:pt>
                <c:pt idx="19">
                  <c:v>4.0740740740740702E-2</c:v>
                </c:pt>
                <c:pt idx="20">
                  <c:v>4.4444444444444418E-2</c:v>
                </c:pt>
                <c:pt idx="21">
                  <c:v>2.962962962962961E-2</c:v>
                </c:pt>
                <c:pt idx="22">
                  <c:v>3.7037037037037017E-3</c:v>
                </c:pt>
                <c:pt idx="23">
                  <c:v>1.48148148148148E-2</c:v>
                </c:pt>
                <c:pt idx="24">
                  <c:v>0</c:v>
                </c:pt>
                <c:pt idx="25">
                  <c:v>3.7037037037037017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nmr-1(ak4)_A5_0.02_50%'!$N$104</c:f>
              <c:strCache>
                <c:ptCount val="1"/>
                <c:pt idx="0">
                  <c:v>nmr-1(ak4)_A5_13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N$105:$N$135</c:f>
              <c:numCache>
                <c:formatCode>General</c:formatCode>
                <c:ptCount val="31"/>
                <c:pt idx="1">
                  <c:v>0</c:v>
                </c:pt>
                <c:pt idx="2">
                  <c:v>4.9019607843137358E-3</c:v>
                </c:pt>
                <c:pt idx="3">
                  <c:v>4.9019607843137358E-3</c:v>
                </c:pt>
                <c:pt idx="4">
                  <c:v>9.8039215686274508E-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4.9019607843137358E-3</c:v>
                </c:pt>
                <c:pt idx="9">
                  <c:v>4.9019607843137358E-3</c:v>
                </c:pt>
                <c:pt idx="10">
                  <c:v>0</c:v>
                </c:pt>
                <c:pt idx="11">
                  <c:v>2.9411764705882398E-2</c:v>
                </c:pt>
                <c:pt idx="12">
                  <c:v>2.9411764705882398E-2</c:v>
                </c:pt>
                <c:pt idx="13">
                  <c:v>4.9019607843137344E-2</c:v>
                </c:pt>
                <c:pt idx="14">
                  <c:v>9.8039215686274508E-2</c:v>
                </c:pt>
                <c:pt idx="15">
                  <c:v>9.31372549019608E-2</c:v>
                </c:pt>
                <c:pt idx="16">
                  <c:v>0.12745098039215699</c:v>
                </c:pt>
                <c:pt idx="17">
                  <c:v>0.10294117647058804</c:v>
                </c:pt>
                <c:pt idx="18">
                  <c:v>0.10294117647058804</c:v>
                </c:pt>
                <c:pt idx="19">
                  <c:v>0.12254901960784295</c:v>
                </c:pt>
                <c:pt idx="20">
                  <c:v>7.3529411764705899E-2</c:v>
                </c:pt>
                <c:pt idx="21">
                  <c:v>4.9019607843137344E-2</c:v>
                </c:pt>
                <c:pt idx="22">
                  <c:v>2.4509803921568599E-2</c:v>
                </c:pt>
                <c:pt idx="23">
                  <c:v>1.4705882352941199E-2</c:v>
                </c:pt>
                <c:pt idx="24">
                  <c:v>1.4705882352941199E-2</c:v>
                </c:pt>
                <c:pt idx="25">
                  <c:v>4.9019607843137358E-3</c:v>
                </c:pt>
                <c:pt idx="26">
                  <c:v>9.8039215686274508E-3</c:v>
                </c:pt>
                <c:pt idx="27">
                  <c:v>4.9019607843137358E-3</c:v>
                </c:pt>
                <c:pt idx="28">
                  <c:v>4.9019607843137358E-3</c:v>
                </c:pt>
                <c:pt idx="29">
                  <c:v>4.9019607843137358E-3</c:v>
                </c:pt>
                <c:pt idx="30">
                  <c:v>4.9019607843137358E-3</c:v>
                </c:pt>
              </c:numCache>
            </c:numRef>
          </c:val>
        </c:ser>
        <c:ser>
          <c:idx val="13"/>
          <c:order val="13"/>
          <c:tx>
            <c:strRef>
              <c:f>'nmr-1(ak4)_A5_0.02_50%'!$O$104</c:f>
              <c:strCache>
                <c:ptCount val="1"/>
                <c:pt idx="0">
                  <c:v>nmr-1(ak4)_A5_14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O$105:$O$135</c:f>
              <c:numCache>
                <c:formatCode>General</c:formatCode>
                <c:ptCount val="31"/>
                <c:pt idx="1">
                  <c:v>7.5471698113207504E-3</c:v>
                </c:pt>
                <c:pt idx="2">
                  <c:v>0</c:v>
                </c:pt>
                <c:pt idx="3">
                  <c:v>7.5471698113207504E-3</c:v>
                </c:pt>
                <c:pt idx="4">
                  <c:v>1.5094339622641499E-2</c:v>
                </c:pt>
                <c:pt idx="5">
                  <c:v>0</c:v>
                </c:pt>
                <c:pt idx="6">
                  <c:v>0</c:v>
                </c:pt>
                <c:pt idx="7">
                  <c:v>3.7735849056603826E-3</c:v>
                </c:pt>
                <c:pt idx="8">
                  <c:v>0</c:v>
                </c:pt>
                <c:pt idx="9">
                  <c:v>0</c:v>
                </c:pt>
                <c:pt idx="10">
                  <c:v>7.5471698113207504E-3</c:v>
                </c:pt>
                <c:pt idx="11">
                  <c:v>1.88679245283019E-2</c:v>
                </c:pt>
                <c:pt idx="12">
                  <c:v>3.0188679245282988E-2</c:v>
                </c:pt>
                <c:pt idx="13">
                  <c:v>7.5471698113207503E-2</c:v>
                </c:pt>
                <c:pt idx="14">
                  <c:v>0.10188679245283003</c:v>
                </c:pt>
                <c:pt idx="15">
                  <c:v>0.12452830188679199</c:v>
                </c:pt>
                <c:pt idx="16">
                  <c:v>0.113207547169811</c:v>
                </c:pt>
                <c:pt idx="17">
                  <c:v>0.12075471698113205</c:v>
                </c:pt>
                <c:pt idx="18">
                  <c:v>9.0566037735849175E-2</c:v>
                </c:pt>
                <c:pt idx="19">
                  <c:v>0.10943396226415103</c:v>
                </c:pt>
                <c:pt idx="20">
                  <c:v>4.1509433962264086E-2</c:v>
                </c:pt>
                <c:pt idx="21">
                  <c:v>3.3962264150943403E-2</c:v>
                </c:pt>
                <c:pt idx="22">
                  <c:v>3.0188679245282988E-2</c:v>
                </c:pt>
                <c:pt idx="23">
                  <c:v>1.1320754716981109E-2</c:v>
                </c:pt>
                <c:pt idx="24">
                  <c:v>1.5094339622641499E-2</c:v>
                </c:pt>
                <c:pt idx="25">
                  <c:v>0</c:v>
                </c:pt>
                <c:pt idx="26">
                  <c:v>3.7735849056603826E-3</c:v>
                </c:pt>
                <c:pt idx="27">
                  <c:v>1.1320754716981109E-2</c:v>
                </c:pt>
                <c:pt idx="28">
                  <c:v>7.5471698113207504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4"/>
          <c:order val="14"/>
          <c:tx>
            <c:strRef>
              <c:f>'nmr-1(ak4)_A5_0.02_50%'!$P$104</c:f>
              <c:strCache>
                <c:ptCount val="1"/>
                <c:pt idx="0">
                  <c:v>nmr-1(ak4)_A5_15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P$105:$P$135</c:f>
              <c:numCache>
                <c:formatCode>General</c:formatCode>
                <c:ptCount val="31"/>
                <c:pt idx="1">
                  <c:v>8.3682008368200847E-3</c:v>
                </c:pt>
                <c:pt idx="2">
                  <c:v>0</c:v>
                </c:pt>
                <c:pt idx="3">
                  <c:v>8.3682008368200847E-3</c:v>
                </c:pt>
                <c:pt idx="4">
                  <c:v>8.3682008368200847E-3</c:v>
                </c:pt>
                <c:pt idx="5">
                  <c:v>4.1841004184100397E-3</c:v>
                </c:pt>
                <c:pt idx="6">
                  <c:v>0</c:v>
                </c:pt>
                <c:pt idx="7">
                  <c:v>0</c:v>
                </c:pt>
                <c:pt idx="8">
                  <c:v>8.3682008368200847E-3</c:v>
                </c:pt>
                <c:pt idx="9">
                  <c:v>8.3682008368200847E-3</c:v>
                </c:pt>
                <c:pt idx="10">
                  <c:v>3.7656903765690412E-2</c:v>
                </c:pt>
                <c:pt idx="11">
                  <c:v>2.510460251046031E-2</c:v>
                </c:pt>
                <c:pt idx="12">
                  <c:v>6.2761506276150597E-2</c:v>
                </c:pt>
                <c:pt idx="13">
                  <c:v>0.12552301255230106</c:v>
                </c:pt>
                <c:pt idx="14">
                  <c:v>0.14644351464435101</c:v>
                </c:pt>
                <c:pt idx="15">
                  <c:v>0.15062761506276201</c:v>
                </c:pt>
                <c:pt idx="16">
                  <c:v>0.13807531380753099</c:v>
                </c:pt>
                <c:pt idx="17">
                  <c:v>7.5313807531380825E-2</c:v>
                </c:pt>
                <c:pt idx="18">
                  <c:v>0.10041841004184097</c:v>
                </c:pt>
                <c:pt idx="19">
                  <c:v>4.1841004184100396E-2</c:v>
                </c:pt>
                <c:pt idx="20">
                  <c:v>8.3682008368200847E-3</c:v>
                </c:pt>
                <c:pt idx="21">
                  <c:v>1.6736401673640201E-2</c:v>
                </c:pt>
                <c:pt idx="22">
                  <c:v>8.3682008368200847E-3</c:v>
                </c:pt>
                <c:pt idx="23">
                  <c:v>4.1841004184100397E-3</c:v>
                </c:pt>
                <c:pt idx="24">
                  <c:v>4.1841004184100397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4.1841004184100397E-3</c:v>
                </c:pt>
              </c:numCache>
            </c:numRef>
          </c:val>
        </c:ser>
        <c:ser>
          <c:idx val="15"/>
          <c:order val="15"/>
          <c:tx>
            <c:strRef>
              <c:f>'nmr-1(ak4)_A5_0.02_50%'!$Q$104</c:f>
              <c:strCache>
                <c:ptCount val="1"/>
                <c:pt idx="0">
                  <c:v>nmr-1(ak4)_A5_16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Q$105:$Q$135</c:f>
              <c:numCache>
                <c:formatCode>General</c:formatCode>
                <c:ptCount val="31"/>
                <c:pt idx="1">
                  <c:v>1.4218009478672999E-2</c:v>
                </c:pt>
                <c:pt idx="2">
                  <c:v>1.4218009478672999E-2</c:v>
                </c:pt>
                <c:pt idx="3">
                  <c:v>9.4786729857819947E-3</c:v>
                </c:pt>
                <c:pt idx="4">
                  <c:v>9.4786729857819947E-3</c:v>
                </c:pt>
                <c:pt idx="5">
                  <c:v>1.4218009478672999E-2</c:v>
                </c:pt>
                <c:pt idx="6">
                  <c:v>1.4218009478672999E-2</c:v>
                </c:pt>
                <c:pt idx="7">
                  <c:v>0</c:v>
                </c:pt>
                <c:pt idx="8">
                  <c:v>9.4786729857819947E-3</c:v>
                </c:pt>
                <c:pt idx="9">
                  <c:v>4.7393364928910052E-3</c:v>
                </c:pt>
                <c:pt idx="10">
                  <c:v>9.4786729857819947E-3</c:v>
                </c:pt>
                <c:pt idx="11">
                  <c:v>3.3175355450237004E-2</c:v>
                </c:pt>
                <c:pt idx="12">
                  <c:v>4.2654028436018995E-2</c:v>
                </c:pt>
                <c:pt idx="13">
                  <c:v>0.12322274881516604</c:v>
                </c:pt>
                <c:pt idx="14">
                  <c:v>6.6350710900473911E-2</c:v>
                </c:pt>
                <c:pt idx="15">
                  <c:v>0.10900473933649303</c:v>
                </c:pt>
                <c:pt idx="16">
                  <c:v>0.11848341232227498</c:v>
                </c:pt>
                <c:pt idx="17">
                  <c:v>0.127962085308057</c:v>
                </c:pt>
                <c:pt idx="18">
                  <c:v>5.6872037914691927E-2</c:v>
                </c:pt>
                <c:pt idx="19">
                  <c:v>4.7393364928909935E-2</c:v>
                </c:pt>
                <c:pt idx="20">
                  <c:v>4.2654028436018995E-2</c:v>
                </c:pt>
                <c:pt idx="21">
                  <c:v>1.4218009478672999E-2</c:v>
                </c:pt>
                <c:pt idx="22">
                  <c:v>9.4786729857819947E-3</c:v>
                </c:pt>
                <c:pt idx="23">
                  <c:v>2.3696682464455002E-2</c:v>
                </c:pt>
                <c:pt idx="24">
                  <c:v>1.8957345971564E-2</c:v>
                </c:pt>
                <c:pt idx="25">
                  <c:v>0</c:v>
                </c:pt>
                <c:pt idx="26">
                  <c:v>3.3175355450237004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4.7393364928910052E-3</c:v>
                </c:pt>
              </c:numCache>
            </c:numRef>
          </c:val>
        </c:ser>
        <c:ser>
          <c:idx val="16"/>
          <c:order val="16"/>
          <c:tx>
            <c:strRef>
              <c:f>'nmr-1(ak4)_A5_0.02_50%'!$R$104</c:f>
              <c:strCache>
                <c:ptCount val="1"/>
                <c:pt idx="0">
                  <c:v>nmr-1(ak4)_A5_17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R$105:$R$135</c:f>
              <c:numCache>
                <c:formatCode>General</c:formatCode>
                <c:ptCount val="31"/>
                <c:pt idx="1">
                  <c:v>1.8927444794952706E-2</c:v>
                </c:pt>
                <c:pt idx="2">
                  <c:v>2.8391167192429009E-2</c:v>
                </c:pt>
                <c:pt idx="3">
                  <c:v>1.8927444794952706E-2</c:v>
                </c:pt>
                <c:pt idx="4">
                  <c:v>1.2618296529968496E-2</c:v>
                </c:pt>
                <c:pt idx="5">
                  <c:v>1.5772870662460612E-2</c:v>
                </c:pt>
                <c:pt idx="6">
                  <c:v>1.2618296529968496E-2</c:v>
                </c:pt>
                <c:pt idx="7">
                  <c:v>1.5772870662460612E-2</c:v>
                </c:pt>
                <c:pt idx="8">
                  <c:v>9.4637223974763478E-3</c:v>
                </c:pt>
                <c:pt idx="9">
                  <c:v>1.2618296529968496E-2</c:v>
                </c:pt>
                <c:pt idx="10">
                  <c:v>3.1545741324921117E-3</c:v>
                </c:pt>
                <c:pt idx="11">
                  <c:v>2.5236593059936901E-2</c:v>
                </c:pt>
                <c:pt idx="12">
                  <c:v>9.4637223974763478E-3</c:v>
                </c:pt>
                <c:pt idx="13">
                  <c:v>4.1009463722397485E-2</c:v>
                </c:pt>
                <c:pt idx="14">
                  <c:v>7.5709779179810713E-2</c:v>
                </c:pt>
                <c:pt idx="15">
                  <c:v>0.123028391167192</c:v>
                </c:pt>
                <c:pt idx="16">
                  <c:v>0.11671924290220803</c:v>
                </c:pt>
                <c:pt idx="17">
                  <c:v>9.7791798107255523E-2</c:v>
                </c:pt>
                <c:pt idx="18">
                  <c:v>9.7791798107255523E-2</c:v>
                </c:pt>
                <c:pt idx="19">
                  <c:v>6.6246056782334375E-2</c:v>
                </c:pt>
                <c:pt idx="20">
                  <c:v>6.6246056782334375E-2</c:v>
                </c:pt>
                <c:pt idx="21">
                  <c:v>2.2082018927444817E-2</c:v>
                </c:pt>
                <c:pt idx="22">
                  <c:v>2.2082018927444817E-2</c:v>
                </c:pt>
                <c:pt idx="23">
                  <c:v>1.5772870662460612E-2</c:v>
                </c:pt>
                <c:pt idx="24">
                  <c:v>6.3091482649842321E-3</c:v>
                </c:pt>
                <c:pt idx="25">
                  <c:v>3.1545741324921117E-3</c:v>
                </c:pt>
                <c:pt idx="26">
                  <c:v>1.2618296529968496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nmr-1(ak4)_A5_0.02_50%'!$S$104</c:f>
              <c:strCache>
                <c:ptCount val="1"/>
                <c:pt idx="0">
                  <c:v>nmr-1(ak4)_A5_18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S$105:$S$135</c:f>
              <c:numCache>
                <c:formatCode>General</c:formatCode>
                <c:ptCount val="31"/>
                <c:pt idx="1">
                  <c:v>2.0725388601036301E-2</c:v>
                </c:pt>
                <c:pt idx="2">
                  <c:v>5.1813471502590736E-3</c:v>
                </c:pt>
                <c:pt idx="3">
                  <c:v>5.1813471502590736E-3</c:v>
                </c:pt>
                <c:pt idx="4">
                  <c:v>1.5544041450777204E-2</c:v>
                </c:pt>
                <c:pt idx="5">
                  <c:v>5.1813471502590736E-3</c:v>
                </c:pt>
                <c:pt idx="6">
                  <c:v>5.1813471502590736E-3</c:v>
                </c:pt>
                <c:pt idx="7">
                  <c:v>5.1813471502590736E-3</c:v>
                </c:pt>
                <c:pt idx="8">
                  <c:v>2.0725388601036301E-2</c:v>
                </c:pt>
                <c:pt idx="9">
                  <c:v>1.0362694300518104E-2</c:v>
                </c:pt>
                <c:pt idx="10">
                  <c:v>3.1088082901554407E-2</c:v>
                </c:pt>
                <c:pt idx="11">
                  <c:v>7.7720207253886023E-2</c:v>
                </c:pt>
                <c:pt idx="12">
                  <c:v>4.6632124352331626E-2</c:v>
                </c:pt>
                <c:pt idx="13">
                  <c:v>7.7720207253886023E-2</c:v>
                </c:pt>
                <c:pt idx="14">
                  <c:v>8.2901554404145025E-2</c:v>
                </c:pt>
                <c:pt idx="15">
                  <c:v>8.8082901554404097E-2</c:v>
                </c:pt>
                <c:pt idx="16">
                  <c:v>5.1813471502590719E-2</c:v>
                </c:pt>
                <c:pt idx="17">
                  <c:v>5.6994818652849701E-2</c:v>
                </c:pt>
                <c:pt idx="18">
                  <c:v>5.6994818652849701E-2</c:v>
                </c:pt>
                <c:pt idx="19">
                  <c:v>5.1813471502590719E-2</c:v>
                </c:pt>
                <c:pt idx="20">
                  <c:v>5.1813471502590719E-2</c:v>
                </c:pt>
                <c:pt idx="21">
                  <c:v>2.0725388601036301E-2</c:v>
                </c:pt>
                <c:pt idx="22">
                  <c:v>3.6269430051813517E-2</c:v>
                </c:pt>
                <c:pt idx="23">
                  <c:v>2.0725388601036301E-2</c:v>
                </c:pt>
                <c:pt idx="24">
                  <c:v>3.6269430051813517E-2</c:v>
                </c:pt>
                <c:pt idx="25">
                  <c:v>1.0362694300518104E-2</c:v>
                </c:pt>
                <c:pt idx="26">
                  <c:v>1.5544041450777204E-2</c:v>
                </c:pt>
                <c:pt idx="27">
                  <c:v>0</c:v>
                </c:pt>
                <c:pt idx="28">
                  <c:v>5.1813471502590736E-3</c:v>
                </c:pt>
                <c:pt idx="29">
                  <c:v>5.1813471502590736E-3</c:v>
                </c:pt>
                <c:pt idx="30">
                  <c:v>5.1813471502590736E-3</c:v>
                </c:pt>
              </c:numCache>
            </c:numRef>
          </c:val>
        </c:ser>
        <c:ser>
          <c:idx val="18"/>
          <c:order val="18"/>
          <c:tx>
            <c:strRef>
              <c:f>'nmr-1(ak4)_A5_0.02_50%'!$T$104</c:f>
              <c:strCache>
                <c:ptCount val="1"/>
                <c:pt idx="0">
                  <c:v>nmr-1(ak4)_A5_19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T$105:$T$135</c:f>
              <c:numCache>
                <c:formatCode>General</c:formatCode>
                <c:ptCount val="31"/>
                <c:pt idx="1">
                  <c:v>2.8037383177570117E-2</c:v>
                </c:pt>
                <c:pt idx="2">
                  <c:v>3.7383177570093525E-2</c:v>
                </c:pt>
                <c:pt idx="3">
                  <c:v>1.8691588785046703E-2</c:v>
                </c:pt>
                <c:pt idx="4">
                  <c:v>1.8691588785046703E-2</c:v>
                </c:pt>
                <c:pt idx="5">
                  <c:v>9.3457943925233673E-3</c:v>
                </c:pt>
                <c:pt idx="6">
                  <c:v>1.8691588785046703E-2</c:v>
                </c:pt>
                <c:pt idx="7">
                  <c:v>9.3457943925233673E-3</c:v>
                </c:pt>
                <c:pt idx="8">
                  <c:v>2.3364485981308386E-2</c:v>
                </c:pt>
                <c:pt idx="9">
                  <c:v>5.1401869158878497E-2</c:v>
                </c:pt>
                <c:pt idx="10">
                  <c:v>4.6728971962616821E-2</c:v>
                </c:pt>
                <c:pt idx="11">
                  <c:v>6.0747663551401918E-2</c:v>
                </c:pt>
                <c:pt idx="12">
                  <c:v>0.11214953271028003</c:v>
                </c:pt>
                <c:pt idx="13">
                  <c:v>4.2056074766355096E-2</c:v>
                </c:pt>
                <c:pt idx="14">
                  <c:v>7.4766355140186924E-2</c:v>
                </c:pt>
                <c:pt idx="15">
                  <c:v>7.0093457943925255E-2</c:v>
                </c:pt>
                <c:pt idx="16">
                  <c:v>4.6728971962616821E-2</c:v>
                </c:pt>
                <c:pt idx="17">
                  <c:v>5.6074766355140214E-2</c:v>
                </c:pt>
                <c:pt idx="18">
                  <c:v>5.1401869158878497E-2</c:v>
                </c:pt>
                <c:pt idx="19">
                  <c:v>1.8691588785046703E-2</c:v>
                </c:pt>
                <c:pt idx="20">
                  <c:v>3.7383177570093525E-2</c:v>
                </c:pt>
                <c:pt idx="21">
                  <c:v>3.7383177570093525E-2</c:v>
                </c:pt>
                <c:pt idx="22">
                  <c:v>4.6728971962616819E-3</c:v>
                </c:pt>
                <c:pt idx="23">
                  <c:v>9.3457943925233673E-3</c:v>
                </c:pt>
                <c:pt idx="24">
                  <c:v>9.3457943925233673E-3</c:v>
                </c:pt>
                <c:pt idx="25">
                  <c:v>9.3457943925233673E-3</c:v>
                </c:pt>
                <c:pt idx="26">
                  <c:v>0</c:v>
                </c:pt>
                <c:pt idx="27">
                  <c:v>9.3457943925233673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9"/>
          <c:order val="19"/>
          <c:tx>
            <c:strRef>
              <c:f>'nmr-1(ak4)_A5_0.02_50%'!$U$104</c:f>
              <c:strCache>
                <c:ptCount val="1"/>
                <c:pt idx="0">
                  <c:v>nmr-1(ak4)_A5_20</c:v>
                </c:pt>
              </c:strCache>
            </c:strRef>
          </c:tx>
          <c:marker>
            <c:symbol val="none"/>
          </c:marker>
          <c:cat>
            <c:numRef>
              <c:f>'nmr-1(ak4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5_0.02_50%'!$U$105:$U$135</c:f>
              <c:numCache>
                <c:formatCode>General</c:formatCode>
                <c:ptCount val="31"/>
                <c:pt idx="1">
                  <c:v>5.4054054054054118E-3</c:v>
                </c:pt>
                <c:pt idx="2">
                  <c:v>1.0810810810810801E-2</c:v>
                </c:pt>
                <c:pt idx="3">
                  <c:v>0</c:v>
                </c:pt>
                <c:pt idx="4">
                  <c:v>5.4054054054054118E-3</c:v>
                </c:pt>
                <c:pt idx="5">
                  <c:v>0</c:v>
                </c:pt>
                <c:pt idx="6">
                  <c:v>5.4054054054054118E-3</c:v>
                </c:pt>
                <c:pt idx="7">
                  <c:v>5.4054054054054118E-3</c:v>
                </c:pt>
                <c:pt idx="8">
                  <c:v>5.4054054054054118E-3</c:v>
                </c:pt>
                <c:pt idx="9">
                  <c:v>1.62162162162162E-2</c:v>
                </c:pt>
                <c:pt idx="10">
                  <c:v>0</c:v>
                </c:pt>
                <c:pt idx="11">
                  <c:v>2.1621621621621602E-2</c:v>
                </c:pt>
                <c:pt idx="12">
                  <c:v>2.1621621621621602E-2</c:v>
                </c:pt>
                <c:pt idx="13">
                  <c:v>3.24324324324324E-2</c:v>
                </c:pt>
                <c:pt idx="14">
                  <c:v>7.0270270270270302E-2</c:v>
                </c:pt>
                <c:pt idx="15">
                  <c:v>9.7297297297297303E-2</c:v>
                </c:pt>
                <c:pt idx="16">
                  <c:v>0.10270270270270303</c:v>
                </c:pt>
                <c:pt idx="17">
                  <c:v>0.11891891891891898</c:v>
                </c:pt>
                <c:pt idx="18">
                  <c:v>0.108108108108108</c:v>
                </c:pt>
                <c:pt idx="19">
                  <c:v>0.10270270270270303</c:v>
                </c:pt>
                <c:pt idx="20">
                  <c:v>5.4054054054054113E-2</c:v>
                </c:pt>
                <c:pt idx="21">
                  <c:v>4.86486486486487E-2</c:v>
                </c:pt>
                <c:pt idx="22">
                  <c:v>3.7837837837837812E-2</c:v>
                </c:pt>
                <c:pt idx="23">
                  <c:v>2.7027027027027015E-2</c:v>
                </c:pt>
                <c:pt idx="24">
                  <c:v>3.7837837837837812E-2</c:v>
                </c:pt>
                <c:pt idx="25">
                  <c:v>1.0810810810810801E-2</c:v>
                </c:pt>
                <c:pt idx="26">
                  <c:v>1.0810810810810801E-2</c:v>
                </c:pt>
                <c:pt idx="27">
                  <c:v>1.62162162162162E-2</c:v>
                </c:pt>
                <c:pt idx="28">
                  <c:v>0</c:v>
                </c:pt>
                <c:pt idx="29">
                  <c:v>0</c:v>
                </c:pt>
                <c:pt idx="30">
                  <c:v>5.4054054054054118E-3</c:v>
                </c:pt>
              </c:numCache>
            </c:numRef>
          </c:val>
        </c:ser>
        <c:marker val="1"/>
        <c:axId val="165286656"/>
        <c:axId val="165288192"/>
      </c:lineChart>
      <c:catAx>
        <c:axId val="165286656"/>
        <c:scaling>
          <c:orientation val="minMax"/>
        </c:scaling>
        <c:axPos val="b"/>
        <c:numFmt formatCode="0.0_ " sourceLinked="1"/>
        <c:tickLblPos val="nextTo"/>
        <c:crossAx val="165288192"/>
        <c:crosses val="autoZero"/>
        <c:auto val="1"/>
        <c:lblAlgn val="ctr"/>
        <c:lblOffset val="100"/>
        <c:tickLblSkip val="5"/>
        <c:tickMarkSkip val="5"/>
      </c:catAx>
      <c:valAx>
        <c:axId val="165288192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5286656"/>
        <c:crosses val="autoZero"/>
        <c:crossBetween val="between"/>
      </c:valAx>
    </c:plotArea>
    <c:plotVisOnly val="1"/>
  </c:chart>
  <c:externalData r:id="rId1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nmr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3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nmr-1(ak4)_A3_0.02_50%'!$B$104</c:f>
              <c:strCache>
                <c:ptCount val="1"/>
                <c:pt idx="0">
                  <c:v>nmr-1(ak4)_A3_01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B$105:$B$135</c:f>
              <c:numCache>
                <c:formatCode>General</c:formatCode>
                <c:ptCount val="31"/>
                <c:pt idx="1">
                  <c:v>5.2478134110787215E-2</c:v>
                </c:pt>
                <c:pt idx="2">
                  <c:v>1.45772594752187E-2</c:v>
                </c:pt>
                <c:pt idx="3">
                  <c:v>2.0408163265306107E-2</c:v>
                </c:pt>
                <c:pt idx="4">
                  <c:v>2.91545189504373E-3</c:v>
                </c:pt>
                <c:pt idx="5">
                  <c:v>2.91545189504373E-3</c:v>
                </c:pt>
                <c:pt idx="6">
                  <c:v>5.8309037900874635E-3</c:v>
                </c:pt>
                <c:pt idx="7">
                  <c:v>1.7492711370262405E-2</c:v>
                </c:pt>
                <c:pt idx="8">
                  <c:v>2.9154518950437285E-2</c:v>
                </c:pt>
                <c:pt idx="9">
                  <c:v>1.7492711370262405E-2</c:v>
                </c:pt>
                <c:pt idx="10">
                  <c:v>2.9154518950437285E-2</c:v>
                </c:pt>
                <c:pt idx="11">
                  <c:v>3.7900874635568502E-2</c:v>
                </c:pt>
                <c:pt idx="12">
                  <c:v>4.0816326530612221E-2</c:v>
                </c:pt>
                <c:pt idx="13">
                  <c:v>6.9970845481049607E-2</c:v>
                </c:pt>
                <c:pt idx="14">
                  <c:v>7.2886297376093354E-2</c:v>
                </c:pt>
                <c:pt idx="15">
                  <c:v>0.102040816326531</c:v>
                </c:pt>
                <c:pt idx="16">
                  <c:v>8.4548104956268202E-2</c:v>
                </c:pt>
                <c:pt idx="17">
                  <c:v>8.7463556851311824E-2</c:v>
                </c:pt>
                <c:pt idx="18">
                  <c:v>9.3294460641399485E-2</c:v>
                </c:pt>
                <c:pt idx="19">
                  <c:v>5.2478134110787215E-2</c:v>
                </c:pt>
                <c:pt idx="20">
                  <c:v>3.7900874635568502E-2</c:v>
                </c:pt>
                <c:pt idx="21">
                  <c:v>4.0816326530612221E-2</c:v>
                </c:pt>
                <c:pt idx="22">
                  <c:v>2.6239067055393618E-2</c:v>
                </c:pt>
                <c:pt idx="23">
                  <c:v>1.7492711370262405E-2</c:v>
                </c:pt>
                <c:pt idx="24">
                  <c:v>8.7463556851311974E-3</c:v>
                </c:pt>
                <c:pt idx="25">
                  <c:v>5.8309037900874635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"/>
          <c:order val="1"/>
          <c:tx>
            <c:strRef>
              <c:f>'nmr-1(ak4)_A3_0.02_50%'!$C$104</c:f>
              <c:strCache>
                <c:ptCount val="1"/>
                <c:pt idx="0">
                  <c:v>nmr-1(ak4)_A3_02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C$105:$C$135</c:f>
              <c:numCache>
                <c:formatCode>General</c:formatCode>
                <c:ptCount val="31"/>
                <c:pt idx="1">
                  <c:v>4.4117647058823539E-2</c:v>
                </c:pt>
                <c:pt idx="2">
                  <c:v>3.823529411764711E-2</c:v>
                </c:pt>
                <c:pt idx="3">
                  <c:v>1.1764705882352905E-2</c:v>
                </c:pt>
                <c:pt idx="4">
                  <c:v>2.3529411764705889E-2</c:v>
                </c:pt>
                <c:pt idx="5">
                  <c:v>1.4705882352941199E-2</c:v>
                </c:pt>
                <c:pt idx="6">
                  <c:v>5.8823529411764714E-3</c:v>
                </c:pt>
                <c:pt idx="7">
                  <c:v>8.8235294117647144E-3</c:v>
                </c:pt>
                <c:pt idx="8">
                  <c:v>2.6470588235294107E-2</c:v>
                </c:pt>
                <c:pt idx="9">
                  <c:v>2.3529411764705889E-2</c:v>
                </c:pt>
                <c:pt idx="10">
                  <c:v>1.7647058823529401E-2</c:v>
                </c:pt>
                <c:pt idx="11">
                  <c:v>2.6470588235294107E-2</c:v>
                </c:pt>
                <c:pt idx="12">
                  <c:v>4.4117647058823539E-2</c:v>
                </c:pt>
                <c:pt idx="13">
                  <c:v>7.3529411764705899E-2</c:v>
                </c:pt>
                <c:pt idx="14">
                  <c:v>7.3529411764705899E-2</c:v>
                </c:pt>
                <c:pt idx="15">
                  <c:v>9.7058823529411822E-2</c:v>
                </c:pt>
                <c:pt idx="16">
                  <c:v>0.13235294117647106</c:v>
                </c:pt>
                <c:pt idx="17">
                  <c:v>7.3529411764705899E-2</c:v>
                </c:pt>
                <c:pt idx="18">
                  <c:v>8.5294117647058784E-2</c:v>
                </c:pt>
                <c:pt idx="19">
                  <c:v>2.6470588235294107E-2</c:v>
                </c:pt>
                <c:pt idx="20">
                  <c:v>4.7058823529411813E-2</c:v>
                </c:pt>
                <c:pt idx="21">
                  <c:v>2.0588235294117598E-2</c:v>
                </c:pt>
                <c:pt idx="22">
                  <c:v>2.6470588235294107E-2</c:v>
                </c:pt>
                <c:pt idx="23">
                  <c:v>5.8823529411764714E-3</c:v>
                </c:pt>
                <c:pt idx="24">
                  <c:v>0</c:v>
                </c:pt>
                <c:pt idx="25">
                  <c:v>2.94117647058824E-3</c:v>
                </c:pt>
                <c:pt idx="26">
                  <c:v>2.94117647058824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5.8823529411764714E-3</c:v>
                </c:pt>
              </c:numCache>
            </c:numRef>
          </c:val>
        </c:ser>
        <c:ser>
          <c:idx val="2"/>
          <c:order val="2"/>
          <c:tx>
            <c:strRef>
              <c:f>'nmr-1(ak4)_A3_0.02_50%'!$D$104</c:f>
              <c:strCache>
                <c:ptCount val="1"/>
                <c:pt idx="0">
                  <c:v>nmr-1(ak4)_A3_03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D$105:$D$135</c:f>
              <c:numCache>
                <c:formatCode>General</c:formatCode>
                <c:ptCount val="31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4.8780487804878031E-3</c:v>
                </c:pt>
                <c:pt idx="5">
                  <c:v>9.756097560975615E-3</c:v>
                </c:pt>
                <c:pt idx="6">
                  <c:v>4.8780487804878031E-3</c:v>
                </c:pt>
                <c:pt idx="7">
                  <c:v>4.8780487804878031E-3</c:v>
                </c:pt>
                <c:pt idx="8">
                  <c:v>0</c:v>
                </c:pt>
                <c:pt idx="9">
                  <c:v>4.8780487804878031E-3</c:v>
                </c:pt>
                <c:pt idx="10">
                  <c:v>4.8780487804878031E-3</c:v>
                </c:pt>
                <c:pt idx="11">
                  <c:v>4.8780487804878031E-3</c:v>
                </c:pt>
                <c:pt idx="12">
                  <c:v>4.3902439024390227E-2</c:v>
                </c:pt>
                <c:pt idx="13">
                  <c:v>9.2682926829268278E-2</c:v>
                </c:pt>
                <c:pt idx="14">
                  <c:v>0.13170731707317099</c:v>
                </c:pt>
                <c:pt idx="15">
                  <c:v>0.19024390243902406</c:v>
                </c:pt>
                <c:pt idx="16">
                  <c:v>0.16585365853658496</c:v>
                </c:pt>
                <c:pt idx="17">
                  <c:v>0.10243902439024398</c:v>
                </c:pt>
                <c:pt idx="18">
                  <c:v>8.292682926829277E-2</c:v>
                </c:pt>
                <c:pt idx="19">
                  <c:v>2.4390243902439001E-2</c:v>
                </c:pt>
                <c:pt idx="20">
                  <c:v>3.4146341463414616E-2</c:v>
                </c:pt>
                <c:pt idx="21">
                  <c:v>9.756097560975615E-3</c:v>
                </c:pt>
                <c:pt idx="22">
                  <c:v>1.9512195121951202E-2</c:v>
                </c:pt>
                <c:pt idx="23">
                  <c:v>1.9512195121951202E-2</c:v>
                </c:pt>
                <c:pt idx="24">
                  <c:v>4.8780487804878031E-3</c:v>
                </c:pt>
                <c:pt idx="25">
                  <c:v>4.8780487804878031E-3</c:v>
                </c:pt>
                <c:pt idx="26">
                  <c:v>0</c:v>
                </c:pt>
                <c:pt idx="27">
                  <c:v>4.8780487804878031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nmr-1(ak4)_A3_0.02_50%'!$E$104</c:f>
              <c:strCache>
                <c:ptCount val="1"/>
                <c:pt idx="0">
                  <c:v>nmr-1(ak4)_A3_04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E$105:$E$135</c:f>
              <c:numCache>
                <c:formatCode>General</c:formatCode>
                <c:ptCount val="31"/>
                <c:pt idx="1">
                  <c:v>0</c:v>
                </c:pt>
                <c:pt idx="2">
                  <c:v>1.2345679012345704E-2</c:v>
                </c:pt>
                <c:pt idx="3">
                  <c:v>1.2345679012345704E-2</c:v>
                </c:pt>
                <c:pt idx="4">
                  <c:v>0</c:v>
                </c:pt>
                <c:pt idx="5">
                  <c:v>1.2345679012345704E-2</c:v>
                </c:pt>
                <c:pt idx="6">
                  <c:v>1.2345679012345704E-2</c:v>
                </c:pt>
                <c:pt idx="7">
                  <c:v>0</c:v>
                </c:pt>
                <c:pt idx="8">
                  <c:v>0</c:v>
                </c:pt>
                <c:pt idx="9">
                  <c:v>1.2345679012345704E-2</c:v>
                </c:pt>
                <c:pt idx="10">
                  <c:v>0</c:v>
                </c:pt>
                <c:pt idx="11">
                  <c:v>4.9382716049382734E-2</c:v>
                </c:pt>
                <c:pt idx="12">
                  <c:v>2.4691358024691409E-2</c:v>
                </c:pt>
                <c:pt idx="13">
                  <c:v>6.1728395061728399E-2</c:v>
                </c:pt>
                <c:pt idx="14">
                  <c:v>8.6419753086419679E-2</c:v>
                </c:pt>
                <c:pt idx="15">
                  <c:v>0.17283950617283905</c:v>
                </c:pt>
                <c:pt idx="16">
                  <c:v>0.12345679012345702</c:v>
                </c:pt>
                <c:pt idx="17">
                  <c:v>3.7037037037037014E-2</c:v>
                </c:pt>
                <c:pt idx="18">
                  <c:v>4.9382716049382734E-2</c:v>
                </c:pt>
                <c:pt idx="19">
                  <c:v>8.6419753086419679E-2</c:v>
                </c:pt>
                <c:pt idx="20">
                  <c:v>0.11111111111111099</c:v>
                </c:pt>
                <c:pt idx="21">
                  <c:v>2.4691358024691409E-2</c:v>
                </c:pt>
                <c:pt idx="22">
                  <c:v>2.4691358024691409E-2</c:v>
                </c:pt>
                <c:pt idx="23">
                  <c:v>2.4691358024691409E-2</c:v>
                </c:pt>
                <c:pt idx="24">
                  <c:v>0</c:v>
                </c:pt>
                <c:pt idx="25">
                  <c:v>1.2345679012345704E-2</c:v>
                </c:pt>
                <c:pt idx="26">
                  <c:v>1.2345679012345704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nmr-1(ak4)_A3_0.02_50%'!$F$104</c:f>
              <c:strCache>
                <c:ptCount val="1"/>
                <c:pt idx="0">
                  <c:v>nmr-1(ak4)_A3_05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F$105:$F$135</c:f>
              <c:numCache>
                <c:formatCode>General</c:formatCode>
                <c:ptCount val="31"/>
                <c:pt idx="1">
                  <c:v>8.5836909871244635E-3</c:v>
                </c:pt>
                <c:pt idx="2">
                  <c:v>4.2918454935622343E-3</c:v>
                </c:pt>
                <c:pt idx="3">
                  <c:v>4.2918454935622343E-3</c:v>
                </c:pt>
                <c:pt idx="4">
                  <c:v>8.5836909871244635E-3</c:v>
                </c:pt>
                <c:pt idx="5">
                  <c:v>1.2875536480686699E-2</c:v>
                </c:pt>
                <c:pt idx="6">
                  <c:v>0</c:v>
                </c:pt>
                <c:pt idx="7">
                  <c:v>4.2918454935622343E-3</c:v>
                </c:pt>
                <c:pt idx="8">
                  <c:v>4.2918454935622343E-3</c:v>
                </c:pt>
                <c:pt idx="9">
                  <c:v>8.5836909871244635E-3</c:v>
                </c:pt>
                <c:pt idx="10">
                  <c:v>0</c:v>
                </c:pt>
                <c:pt idx="11">
                  <c:v>1.2875536480686699E-2</c:v>
                </c:pt>
                <c:pt idx="12">
                  <c:v>1.7167381974248899E-2</c:v>
                </c:pt>
                <c:pt idx="13">
                  <c:v>5.5793991416309037E-2</c:v>
                </c:pt>
                <c:pt idx="14">
                  <c:v>9.4420600858369147E-2</c:v>
                </c:pt>
                <c:pt idx="15">
                  <c:v>0.15450643776824011</c:v>
                </c:pt>
                <c:pt idx="16">
                  <c:v>9.8712446351931341E-2</c:v>
                </c:pt>
                <c:pt idx="17">
                  <c:v>0.17167381974248894</c:v>
                </c:pt>
                <c:pt idx="18">
                  <c:v>9.8712446351931341E-2</c:v>
                </c:pt>
                <c:pt idx="19">
                  <c:v>5.5793991416309037E-2</c:v>
                </c:pt>
                <c:pt idx="20">
                  <c:v>3.4334763948497903E-2</c:v>
                </c:pt>
                <c:pt idx="21">
                  <c:v>4.7210300429184601E-2</c:v>
                </c:pt>
                <c:pt idx="22">
                  <c:v>2.5751072961373415E-2</c:v>
                </c:pt>
                <c:pt idx="23">
                  <c:v>3.0042918454935612E-2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4.2918454935622343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nmr-1(ak4)_A3_0.02_50%'!$G$104</c:f>
              <c:strCache>
                <c:ptCount val="1"/>
                <c:pt idx="0">
                  <c:v>nmr-1(ak4)_A3_06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G$105:$G$135</c:f>
              <c:numCache>
                <c:formatCode>General</c:formatCode>
                <c:ptCount val="31"/>
                <c:pt idx="1">
                  <c:v>1.0752688172042998E-2</c:v>
                </c:pt>
                <c:pt idx="2">
                  <c:v>5.3763440860215119E-3</c:v>
                </c:pt>
                <c:pt idx="3">
                  <c:v>1.0752688172042998E-2</c:v>
                </c:pt>
                <c:pt idx="4">
                  <c:v>1.0752688172042998E-2</c:v>
                </c:pt>
                <c:pt idx="5">
                  <c:v>5.3763440860215119E-3</c:v>
                </c:pt>
                <c:pt idx="6">
                  <c:v>5.3763440860215119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5.3763440860215119E-3</c:v>
                </c:pt>
                <c:pt idx="11">
                  <c:v>3.7634408602150511E-2</c:v>
                </c:pt>
                <c:pt idx="12">
                  <c:v>2.688172043010751E-2</c:v>
                </c:pt>
                <c:pt idx="13">
                  <c:v>3.7634408602150511E-2</c:v>
                </c:pt>
                <c:pt idx="14">
                  <c:v>0.10752688172043005</c:v>
                </c:pt>
                <c:pt idx="15">
                  <c:v>0.13978494623655893</c:v>
                </c:pt>
                <c:pt idx="16">
                  <c:v>0.12903225806451593</c:v>
                </c:pt>
                <c:pt idx="17">
                  <c:v>0.14516129032258099</c:v>
                </c:pt>
                <c:pt idx="18">
                  <c:v>8.6021505376344148E-2</c:v>
                </c:pt>
                <c:pt idx="19">
                  <c:v>5.9139784946236645E-2</c:v>
                </c:pt>
                <c:pt idx="20">
                  <c:v>5.3763440860215117E-2</c:v>
                </c:pt>
                <c:pt idx="21">
                  <c:v>3.7634408602150511E-2</c:v>
                </c:pt>
                <c:pt idx="22">
                  <c:v>2.1505376344085999E-2</c:v>
                </c:pt>
                <c:pt idx="23">
                  <c:v>2.1505376344085999E-2</c:v>
                </c:pt>
                <c:pt idx="24">
                  <c:v>1.0752688172042998E-2</c:v>
                </c:pt>
                <c:pt idx="25">
                  <c:v>5.3763440860215119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6"/>
          <c:order val="6"/>
          <c:tx>
            <c:strRef>
              <c:f>'nmr-1(ak4)_A3_0.02_50%'!$H$104</c:f>
              <c:strCache>
                <c:ptCount val="1"/>
                <c:pt idx="0">
                  <c:v>nmr-1(ak4)_A3_07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H$105:$H$135</c:f>
              <c:numCache>
                <c:formatCode>General</c:formatCode>
                <c:ptCount val="31"/>
                <c:pt idx="1">
                  <c:v>3.53356890459364E-3</c:v>
                </c:pt>
                <c:pt idx="2">
                  <c:v>0</c:v>
                </c:pt>
                <c:pt idx="3">
                  <c:v>0</c:v>
                </c:pt>
                <c:pt idx="4">
                  <c:v>3.53356890459364E-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53356890459364E-3</c:v>
                </c:pt>
                <c:pt idx="9">
                  <c:v>3.53356890459364E-3</c:v>
                </c:pt>
                <c:pt idx="10">
                  <c:v>1.41342756183746E-2</c:v>
                </c:pt>
                <c:pt idx="11">
                  <c:v>3.8869257950530006E-2</c:v>
                </c:pt>
                <c:pt idx="12">
                  <c:v>9.1872791519434602E-2</c:v>
                </c:pt>
                <c:pt idx="13">
                  <c:v>0.15547703180212016</c:v>
                </c:pt>
                <c:pt idx="14">
                  <c:v>0.18374558303886906</c:v>
                </c:pt>
                <c:pt idx="15">
                  <c:v>0.13074204946996507</c:v>
                </c:pt>
                <c:pt idx="16">
                  <c:v>0.11307420494699603</c:v>
                </c:pt>
                <c:pt idx="17">
                  <c:v>0.11307420494699603</c:v>
                </c:pt>
                <c:pt idx="18">
                  <c:v>5.6537102473498177E-2</c:v>
                </c:pt>
                <c:pt idx="19">
                  <c:v>3.8869257950530006E-2</c:v>
                </c:pt>
                <c:pt idx="20">
                  <c:v>1.7667844522968202E-2</c:v>
                </c:pt>
                <c:pt idx="21">
                  <c:v>7.0671378091872782E-3</c:v>
                </c:pt>
                <c:pt idx="22">
                  <c:v>1.41342756183746E-2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nmr-1(ak4)_A3_0.02_50%'!$I$104</c:f>
              <c:strCache>
                <c:ptCount val="1"/>
                <c:pt idx="0">
                  <c:v>nmr-1(ak4)_A3_08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I$105:$I$135</c:f>
              <c:numCache>
                <c:formatCode>General</c:formatCode>
                <c:ptCount val="31"/>
                <c:pt idx="1">
                  <c:v>9.9502487562189174E-3</c:v>
                </c:pt>
                <c:pt idx="2">
                  <c:v>0</c:v>
                </c:pt>
                <c:pt idx="3">
                  <c:v>4.9751243781094483E-3</c:v>
                </c:pt>
                <c:pt idx="4">
                  <c:v>1.4925373134328401E-2</c:v>
                </c:pt>
                <c:pt idx="5">
                  <c:v>4.9751243781094483E-3</c:v>
                </c:pt>
                <c:pt idx="6">
                  <c:v>4.9751243781094483E-3</c:v>
                </c:pt>
                <c:pt idx="7">
                  <c:v>0</c:v>
                </c:pt>
                <c:pt idx="8">
                  <c:v>9.9502487562189174E-3</c:v>
                </c:pt>
                <c:pt idx="9">
                  <c:v>4.9751243781094483E-3</c:v>
                </c:pt>
                <c:pt idx="10">
                  <c:v>2.48756218905473E-2</c:v>
                </c:pt>
                <c:pt idx="11">
                  <c:v>6.9651741293532299E-2</c:v>
                </c:pt>
                <c:pt idx="12">
                  <c:v>0.10447761194029903</c:v>
                </c:pt>
                <c:pt idx="13">
                  <c:v>0.144278606965174</c:v>
                </c:pt>
                <c:pt idx="14">
                  <c:v>0.1393034825870651</c:v>
                </c:pt>
                <c:pt idx="15">
                  <c:v>0.124378109452736</c:v>
                </c:pt>
                <c:pt idx="16">
                  <c:v>9.4527363184079741E-2</c:v>
                </c:pt>
                <c:pt idx="17">
                  <c:v>8.955223880597013E-2</c:v>
                </c:pt>
                <c:pt idx="18">
                  <c:v>2.9850746268656699E-2</c:v>
                </c:pt>
                <c:pt idx="19">
                  <c:v>4.47761194029851E-2</c:v>
                </c:pt>
                <c:pt idx="20">
                  <c:v>2.48756218905473E-2</c:v>
                </c:pt>
                <c:pt idx="21">
                  <c:v>9.9502487562189174E-3</c:v>
                </c:pt>
                <c:pt idx="22">
                  <c:v>4.9751243781094483E-3</c:v>
                </c:pt>
                <c:pt idx="23">
                  <c:v>4.9751243781094483E-3</c:v>
                </c:pt>
                <c:pt idx="24">
                  <c:v>4.9751243781094483E-3</c:v>
                </c:pt>
                <c:pt idx="25">
                  <c:v>0</c:v>
                </c:pt>
                <c:pt idx="26">
                  <c:v>4.9751243781094483E-3</c:v>
                </c:pt>
                <c:pt idx="27">
                  <c:v>4.9751243781094483E-3</c:v>
                </c:pt>
                <c:pt idx="28">
                  <c:v>4.9751243781094483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8"/>
          <c:order val="8"/>
          <c:tx>
            <c:strRef>
              <c:f>'nmr-1(ak4)_A3_0.02_50%'!$J$104</c:f>
              <c:strCache>
                <c:ptCount val="1"/>
                <c:pt idx="0">
                  <c:v>nmr-1(ak4)_A3_09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J$105:$J$135</c:f>
              <c:numCache>
                <c:formatCode>General</c:formatCode>
                <c:ptCount val="31"/>
                <c:pt idx="1">
                  <c:v>9.8684210526315801E-3</c:v>
                </c:pt>
                <c:pt idx="2">
                  <c:v>0</c:v>
                </c:pt>
                <c:pt idx="3">
                  <c:v>3.2894736842105309E-3</c:v>
                </c:pt>
                <c:pt idx="4">
                  <c:v>3.2894736842105309E-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6.5789473684210514E-3</c:v>
                </c:pt>
                <c:pt idx="10">
                  <c:v>3.2894736842105309E-3</c:v>
                </c:pt>
                <c:pt idx="11">
                  <c:v>3.6184210526315819E-2</c:v>
                </c:pt>
                <c:pt idx="12">
                  <c:v>4.6052631578947421E-2</c:v>
                </c:pt>
                <c:pt idx="13">
                  <c:v>0.115131578947368</c:v>
                </c:pt>
                <c:pt idx="14">
                  <c:v>0.15131578947368399</c:v>
                </c:pt>
                <c:pt idx="15">
                  <c:v>0.10197368421052599</c:v>
                </c:pt>
                <c:pt idx="16">
                  <c:v>0.14144736842105307</c:v>
                </c:pt>
                <c:pt idx="17">
                  <c:v>0.13815789473684201</c:v>
                </c:pt>
                <c:pt idx="18">
                  <c:v>6.25E-2</c:v>
                </c:pt>
                <c:pt idx="19">
                  <c:v>5.5921052631578885E-2</c:v>
                </c:pt>
                <c:pt idx="20">
                  <c:v>5.2631578947368404E-2</c:v>
                </c:pt>
                <c:pt idx="21">
                  <c:v>5.2631578947368404E-2</c:v>
                </c:pt>
                <c:pt idx="22">
                  <c:v>6.5789473684210514E-3</c:v>
                </c:pt>
                <c:pt idx="23">
                  <c:v>6.5789473684210514E-3</c:v>
                </c:pt>
                <c:pt idx="24">
                  <c:v>3.2894736842105309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nmr-1(ak4)_A3_0.02_50%'!$K$104</c:f>
              <c:strCache>
                <c:ptCount val="1"/>
                <c:pt idx="0">
                  <c:v>nmr-1(ak4)_A3_10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K$105:$K$135</c:f>
              <c:numCache>
                <c:formatCode>General</c:formatCode>
                <c:ptCount val="31"/>
                <c:pt idx="1">
                  <c:v>3.355704697986581E-3</c:v>
                </c:pt>
                <c:pt idx="2">
                  <c:v>3.355704697986581E-3</c:v>
                </c:pt>
                <c:pt idx="3">
                  <c:v>3.355704697986581E-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3.355704697986581E-3</c:v>
                </c:pt>
                <c:pt idx="8">
                  <c:v>0</c:v>
                </c:pt>
                <c:pt idx="9">
                  <c:v>0</c:v>
                </c:pt>
                <c:pt idx="10">
                  <c:v>6.711409395973156E-3</c:v>
                </c:pt>
                <c:pt idx="11">
                  <c:v>4.0268456375838896E-2</c:v>
                </c:pt>
                <c:pt idx="12">
                  <c:v>7.718120805369133E-2</c:v>
                </c:pt>
                <c:pt idx="13">
                  <c:v>9.3959731543624206E-2</c:v>
                </c:pt>
                <c:pt idx="14">
                  <c:v>0.15100671140939606</c:v>
                </c:pt>
                <c:pt idx="15">
                  <c:v>0.13087248322147699</c:v>
                </c:pt>
                <c:pt idx="16">
                  <c:v>0.13422818791946306</c:v>
                </c:pt>
                <c:pt idx="17">
                  <c:v>0.10402684563758405</c:v>
                </c:pt>
                <c:pt idx="18">
                  <c:v>0.10738255033557002</c:v>
                </c:pt>
                <c:pt idx="19">
                  <c:v>6.3758389261744999E-2</c:v>
                </c:pt>
                <c:pt idx="20">
                  <c:v>3.0201342281879227E-2</c:v>
                </c:pt>
                <c:pt idx="21">
                  <c:v>1.00671140939597E-2</c:v>
                </c:pt>
                <c:pt idx="22">
                  <c:v>6.711409395973156E-3</c:v>
                </c:pt>
                <c:pt idx="23">
                  <c:v>6.711409395973156E-3</c:v>
                </c:pt>
                <c:pt idx="24">
                  <c:v>6.711409395973156E-3</c:v>
                </c:pt>
                <c:pt idx="25">
                  <c:v>0</c:v>
                </c:pt>
                <c:pt idx="26">
                  <c:v>3.355704697986581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nmr-1(ak4)_A3_0.02_50%'!$L$104</c:f>
              <c:strCache>
                <c:ptCount val="1"/>
                <c:pt idx="0">
                  <c:v>nmr-1(ak4)_A3_11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L$105:$L$135</c:f>
              <c:numCache>
                <c:formatCode>General</c:formatCode>
                <c:ptCount val="31"/>
                <c:pt idx="1">
                  <c:v>4.2735042735042701E-2</c:v>
                </c:pt>
                <c:pt idx="2">
                  <c:v>2.8490028490028501E-2</c:v>
                </c:pt>
                <c:pt idx="3">
                  <c:v>1.9943019943019908E-2</c:v>
                </c:pt>
                <c:pt idx="4">
                  <c:v>1.1396011396011404E-2</c:v>
                </c:pt>
                <c:pt idx="5">
                  <c:v>1.9943019943019908E-2</c:v>
                </c:pt>
                <c:pt idx="6">
                  <c:v>8.5470085470085496E-3</c:v>
                </c:pt>
                <c:pt idx="7">
                  <c:v>8.5470085470085496E-3</c:v>
                </c:pt>
                <c:pt idx="8">
                  <c:v>1.4245014245014204E-2</c:v>
                </c:pt>
                <c:pt idx="9">
                  <c:v>8.5470085470085496E-3</c:v>
                </c:pt>
                <c:pt idx="10">
                  <c:v>5.6980056980057E-3</c:v>
                </c:pt>
                <c:pt idx="11">
                  <c:v>2.27920227920228E-2</c:v>
                </c:pt>
                <c:pt idx="12">
                  <c:v>3.1339031339031286E-2</c:v>
                </c:pt>
                <c:pt idx="13">
                  <c:v>5.1282051282051301E-2</c:v>
                </c:pt>
                <c:pt idx="14">
                  <c:v>6.5527065527065498E-2</c:v>
                </c:pt>
                <c:pt idx="15">
                  <c:v>8.2621082621082642E-2</c:v>
                </c:pt>
                <c:pt idx="16">
                  <c:v>9.6866096866096971E-2</c:v>
                </c:pt>
                <c:pt idx="17">
                  <c:v>8.54700854700855E-2</c:v>
                </c:pt>
                <c:pt idx="18">
                  <c:v>7.9772079772079799E-2</c:v>
                </c:pt>
                <c:pt idx="19">
                  <c:v>7.4074074074074098E-2</c:v>
                </c:pt>
                <c:pt idx="20">
                  <c:v>6.5527065527065498E-2</c:v>
                </c:pt>
                <c:pt idx="21">
                  <c:v>5.4131054131054096E-2</c:v>
                </c:pt>
                <c:pt idx="22">
                  <c:v>2.27920227920228E-2</c:v>
                </c:pt>
                <c:pt idx="23">
                  <c:v>1.7094017094017103E-2</c:v>
                </c:pt>
                <c:pt idx="24">
                  <c:v>8.5470085470085496E-3</c:v>
                </c:pt>
                <c:pt idx="25">
                  <c:v>1.7094017094017103E-2</c:v>
                </c:pt>
                <c:pt idx="26">
                  <c:v>5.6980056980057E-3</c:v>
                </c:pt>
                <c:pt idx="27">
                  <c:v>5.6980056980057E-3</c:v>
                </c:pt>
                <c:pt idx="28">
                  <c:v>2.8490028490028509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nmr-1(ak4)_A3_0.02_50%'!$M$104</c:f>
              <c:strCache>
                <c:ptCount val="1"/>
                <c:pt idx="0">
                  <c:v>nmr-1(ak4)_A3_12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M$105:$M$135</c:f>
              <c:numCache>
                <c:formatCode>General</c:formatCode>
                <c:ptCount val="31"/>
                <c:pt idx="1">
                  <c:v>4.0485829959514223E-3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4.0485829959514223E-3</c:v>
                </c:pt>
                <c:pt idx="11">
                  <c:v>1.6194331983805699E-2</c:v>
                </c:pt>
                <c:pt idx="12">
                  <c:v>6.0728744939271335E-2</c:v>
                </c:pt>
                <c:pt idx="13">
                  <c:v>0.11336032388664002</c:v>
                </c:pt>
                <c:pt idx="14">
                  <c:v>0.15789473684210512</c:v>
                </c:pt>
                <c:pt idx="15">
                  <c:v>0.13765182186234801</c:v>
                </c:pt>
                <c:pt idx="16">
                  <c:v>0.17004048582996012</c:v>
                </c:pt>
                <c:pt idx="17">
                  <c:v>0.12955465587044501</c:v>
                </c:pt>
                <c:pt idx="18">
                  <c:v>0.10931174089068803</c:v>
                </c:pt>
                <c:pt idx="19">
                  <c:v>5.2631578947368404E-2</c:v>
                </c:pt>
                <c:pt idx="20">
                  <c:v>1.2145748987854298E-2</c:v>
                </c:pt>
                <c:pt idx="21">
                  <c:v>8.0971659919028306E-3</c:v>
                </c:pt>
                <c:pt idx="22">
                  <c:v>1.2145748987854298E-2</c:v>
                </c:pt>
                <c:pt idx="23">
                  <c:v>0</c:v>
                </c:pt>
                <c:pt idx="24">
                  <c:v>8.0971659919028306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nmr-1(ak4)_A3_0.02_50%'!$N$104</c:f>
              <c:strCache>
                <c:ptCount val="1"/>
                <c:pt idx="0">
                  <c:v>nmr-1(ak4)_A3_13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N$105:$N$135</c:f>
              <c:numCache>
                <c:formatCode>General</c:formatCode>
                <c:ptCount val="31"/>
                <c:pt idx="1">
                  <c:v>7.6923076923076919E-3</c:v>
                </c:pt>
                <c:pt idx="2">
                  <c:v>0</c:v>
                </c:pt>
                <c:pt idx="3">
                  <c:v>7.6923076923076919E-3</c:v>
                </c:pt>
                <c:pt idx="4">
                  <c:v>3.8461538461538498E-3</c:v>
                </c:pt>
                <c:pt idx="5">
                  <c:v>0</c:v>
                </c:pt>
                <c:pt idx="6">
                  <c:v>3.8461538461538498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3.8461538461538498E-3</c:v>
                </c:pt>
                <c:pt idx="11">
                  <c:v>1.9230769230769208E-2</c:v>
                </c:pt>
                <c:pt idx="12">
                  <c:v>0.115384615384615</c:v>
                </c:pt>
                <c:pt idx="13">
                  <c:v>0.17692307692307693</c:v>
                </c:pt>
                <c:pt idx="14">
                  <c:v>0.17692307692307693</c:v>
                </c:pt>
                <c:pt idx="15">
                  <c:v>0.19230769230769201</c:v>
                </c:pt>
                <c:pt idx="16">
                  <c:v>9.2307692307692341E-2</c:v>
                </c:pt>
                <c:pt idx="17">
                  <c:v>8.8461538461538494E-2</c:v>
                </c:pt>
                <c:pt idx="18">
                  <c:v>3.461538461538461E-2</c:v>
                </c:pt>
                <c:pt idx="19">
                  <c:v>3.461538461538461E-2</c:v>
                </c:pt>
                <c:pt idx="20">
                  <c:v>7.6923076923076919E-3</c:v>
                </c:pt>
                <c:pt idx="21">
                  <c:v>1.1538461538461501E-2</c:v>
                </c:pt>
                <c:pt idx="22">
                  <c:v>0</c:v>
                </c:pt>
                <c:pt idx="23">
                  <c:v>3.8461538461538498E-3</c:v>
                </c:pt>
                <c:pt idx="24">
                  <c:v>3.8461538461538498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nmr-1(ak4)_A3_0.02_50%'!$O$104</c:f>
              <c:strCache>
                <c:ptCount val="1"/>
                <c:pt idx="0">
                  <c:v>nmr-1(ak4)_A3_14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O$105:$O$135</c:f>
              <c:numCache>
                <c:formatCode>General</c:formatCode>
                <c:ptCount val="31"/>
                <c:pt idx="1">
                  <c:v>5.8139534883720921E-3</c:v>
                </c:pt>
                <c:pt idx="2">
                  <c:v>4.0697674418604717E-2</c:v>
                </c:pt>
                <c:pt idx="3">
                  <c:v>5.8139534883720921E-3</c:v>
                </c:pt>
                <c:pt idx="4">
                  <c:v>3.4883720930232599E-2</c:v>
                </c:pt>
                <c:pt idx="5">
                  <c:v>1.1627906976744195E-2</c:v>
                </c:pt>
                <c:pt idx="6">
                  <c:v>1.7441860465116307E-2</c:v>
                </c:pt>
                <c:pt idx="7">
                  <c:v>5.8139534883720921E-3</c:v>
                </c:pt>
                <c:pt idx="8">
                  <c:v>0</c:v>
                </c:pt>
                <c:pt idx="9">
                  <c:v>2.32558139534884E-2</c:v>
                </c:pt>
                <c:pt idx="10">
                  <c:v>5.8139534883720921E-3</c:v>
                </c:pt>
                <c:pt idx="11">
                  <c:v>1.7441860465116307E-2</c:v>
                </c:pt>
                <c:pt idx="12">
                  <c:v>1.7441860465116307E-2</c:v>
                </c:pt>
                <c:pt idx="13">
                  <c:v>2.906976744186051E-2</c:v>
                </c:pt>
                <c:pt idx="14">
                  <c:v>9.8837209302325604E-2</c:v>
                </c:pt>
                <c:pt idx="15">
                  <c:v>0.13372093023255793</c:v>
                </c:pt>
                <c:pt idx="16">
                  <c:v>0.11046511627907002</c:v>
                </c:pt>
                <c:pt idx="17">
                  <c:v>0.104651162790698</c:v>
                </c:pt>
                <c:pt idx="18">
                  <c:v>6.3953488372092998E-2</c:v>
                </c:pt>
                <c:pt idx="19">
                  <c:v>4.6511627906976737E-2</c:v>
                </c:pt>
                <c:pt idx="20">
                  <c:v>3.4883720930232599E-2</c:v>
                </c:pt>
                <c:pt idx="21">
                  <c:v>5.8139534883720916E-2</c:v>
                </c:pt>
                <c:pt idx="22">
                  <c:v>1.1627906976744195E-2</c:v>
                </c:pt>
                <c:pt idx="23">
                  <c:v>0</c:v>
                </c:pt>
                <c:pt idx="24">
                  <c:v>1.1627906976744195E-2</c:v>
                </c:pt>
                <c:pt idx="25">
                  <c:v>0</c:v>
                </c:pt>
                <c:pt idx="26">
                  <c:v>5.8139534883720921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4"/>
          <c:order val="14"/>
          <c:tx>
            <c:strRef>
              <c:f>'nmr-1(ak4)_A3_0.02_50%'!$P$104</c:f>
              <c:strCache>
                <c:ptCount val="1"/>
                <c:pt idx="0">
                  <c:v>nmr-1(ak4)_A3_15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P$105:$P$135</c:f>
              <c:numCache>
                <c:formatCode>General</c:formatCode>
                <c:ptCount val="31"/>
                <c:pt idx="1">
                  <c:v>1.5625E-2</c:v>
                </c:pt>
                <c:pt idx="2">
                  <c:v>2.3437500000000007E-2</c:v>
                </c:pt>
                <c:pt idx="3">
                  <c:v>1.5625E-2</c:v>
                </c:pt>
                <c:pt idx="4">
                  <c:v>0</c:v>
                </c:pt>
                <c:pt idx="5">
                  <c:v>0</c:v>
                </c:pt>
                <c:pt idx="6">
                  <c:v>7.8125E-3</c:v>
                </c:pt>
                <c:pt idx="7">
                  <c:v>0</c:v>
                </c:pt>
                <c:pt idx="8">
                  <c:v>7.8125E-3</c:v>
                </c:pt>
                <c:pt idx="9">
                  <c:v>0</c:v>
                </c:pt>
                <c:pt idx="10">
                  <c:v>7.8125E-3</c:v>
                </c:pt>
                <c:pt idx="11">
                  <c:v>1.5625E-2</c:v>
                </c:pt>
                <c:pt idx="12">
                  <c:v>3.125E-2</c:v>
                </c:pt>
                <c:pt idx="13">
                  <c:v>3.90625E-2</c:v>
                </c:pt>
                <c:pt idx="14">
                  <c:v>0.1171875</c:v>
                </c:pt>
                <c:pt idx="15">
                  <c:v>0.140625</c:v>
                </c:pt>
                <c:pt idx="16">
                  <c:v>0.10156250000000003</c:v>
                </c:pt>
                <c:pt idx="17">
                  <c:v>0.125</c:v>
                </c:pt>
                <c:pt idx="18">
                  <c:v>0.10937500000000003</c:v>
                </c:pt>
                <c:pt idx="19">
                  <c:v>6.25E-2</c:v>
                </c:pt>
                <c:pt idx="20">
                  <c:v>4.6874999999999986E-2</c:v>
                </c:pt>
                <c:pt idx="21">
                  <c:v>5.4687500000000014E-2</c:v>
                </c:pt>
                <c:pt idx="22">
                  <c:v>3.125E-2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7.8125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5"/>
          <c:order val="15"/>
          <c:tx>
            <c:strRef>
              <c:f>'nmr-1(ak4)_A3_0.02_50%'!$Q$104</c:f>
              <c:strCache>
                <c:ptCount val="1"/>
                <c:pt idx="0">
                  <c:v>nmr-1(ak4)_A3_16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Q$105:$Q$135</c:f>
              <c:numCache>
                <c:formatCode>General</c:formatCode>
                <c:ptCount val="31"/>
                <c:pt idx="1">
                  <c:v>4.3290043290043316E-3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4.3290043290043316E-3</c:v>
                </c:pt>
                <c:pt idx="6">
                  <c:v>4.3290043290043316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8.6580086580086649E-3</c:v>
                </c:pt>
                <c:pt idx="11">
                  <c:v>2.5974025974026007E-2</c:v>
                </c:pt>
                <c:pt idx="12">
                  <c:v>6.9264069264069306E-2</c:v>
                </c:pt>
                <c:pt idx="13">
                  <c:v>0.112554112554113</c:v>
                </c:pt>
                <c:pt idx="14">
                  <c:v>0.18181818181818207</c:v>
                </c:pt>
                <c:pt idx="15">
                  <c:v>0.17316017316017299</c:v>
                </c:pt>
                <c:pt idx="16">
                  <c:v>0.18181818181818207</c:v>
                </c:pt>
                <c:pt idx="17">
                  <c:v>0.13419913419913407</c:v>
                </c:pt>
                <c:pt idx="18">
                  <c:v>4.3290043290043302E-2</c:v>
                </c:pt>
                <c:pt idx="19">
                  <c:v>1.7316017316017306E-2</c:v>
                </c:pt>
                <c:pt idx="20">
                  <c:v>2.1645021645021606E-2</c:v>
                </c:pt>
                <c:pt idx="21">
                  <c:v>1.2987012987013E-2</c:v>
                </c:pt>
                <c:pt idx="22">
                  <c:v>0</c:v>
                </c:pt>
                <c:pt idx="23">
                  <c:v>4.3290043290043316E-3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6"/>
          <c:order val="16"/>
          <c:tx>
            <c:strRef>
              <c:f>'nmr-1(ak4)_A3_0.02_50%'!$R$104</c:f>
              <c:strCache>
                <c:ptCount val="1"/>
                <c:pt idx="0">
                  <c:v>nmr-1(ak4)_A3_17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R$105:$R$135</c:f>
              <c:numCache>
                <c:formatCode>General</c:formatCode>
                <c:ptCount val="31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7.5187969924812035E-3</c:v>
                </c:pt>
                <c:pt idx="11">
                  <c:v>4.8872180451127803E-2</c:v>
                </c:pt>
                <c:pt idx="12">
                  <c:v>9.0225563909774473E-2</c:v>
                </c:pt>
                <c:pt idx="13">
                  <c:v>0.13157894736842099</c:v>
                </c:pt>
                <c:pt idx="14">
                  <c:v>0.13157894736842099</c:v>
                </c:pt>
                <c:pt idx="15">
                  <c:v>0.14285714285714307</c:v>
                </c:pt>
                <c:pt idx="16">
                  <c:v>0.13157894736842099</c:v>
                </c:pt>
                <c:pt idx="17">
                  <c:v>9.3984962406015046E-2</c:v>
                </c:pt>
                <c:pt idx="18">
                  <c:v>0.11278195488721802</c:v>
                </c:pt>
                <c:pt idx="19">
                  <c:v>3.7593984962405999E-2</c:v>
                </c:pt>
                <c:pt idx="20">
                  <c:v>3.0075187969924817E-2</c:v>
                </c:pt>
                <c:pt idx="21">
                  <c:v>3.0075187969924817E-2</c:v>
                </c:pt>
                <c:pt idx="22">
                  <c:v>3.7593984962406009E-3</c:v>
                </c:pt>
                <c:pt idx="23">
                  <c:v>3.7593984962406009E-3</c:v>
                </c:pt>
                <c:pt idx="24">
                  <c:v>3.7593984962406009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nmr-1(ak4)_A3_0.02_50%'!$S$104</c:f>
              <c:strCache>
                <c:ptCount val="1"/>
                <c:pt idx="0">
                  <c:v>nmr-1(ak4)_A3_18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S$105:$S$135</c:f>
              <c:numCache>
                <c:formatCode>General</c:formatCode>
                <c:ptCount val="31"/>
                <c:pt idx="1">
                  <c:v>1.68350168350168E-2</c:v>
                </c:pt>
                <c:pt idx="2">
                  <c:v>6.734006734006732E-3</c:v>
                </c:pt>
                <c:pt idx="3">
                  <c:v>3.3670033670033712E-3</c:v>
                </c:pt>
                <c:pt idx="4">
                  <c:v>6.734006734006732E-3</c:v>
                </c:pt>
                <c:pt idx="5">
                  <c:v>3.3670033670033712E-3</c:v>
                </c:pt>
                <c:pt idx="6">
                  <c:v>0</c:v>
                </c:pt>
                <c:pt idx="7">
                  <c:v>0</c:v>
                </c:pt>
                <c:pt idx="8">
                  <c:v>2.69360269360269E-2</c:v>
                </c:pt>
                <c:pt idx="9">
                  <c:v>0</c:v>
                </c:pt>
                <c:pt idx="10">
                  <c:v>3.3670033670033712E-3</c:v>
                </c:pt>
                <c:pt idx="11">
                  <c:v>6.734006734006732E-3</c:v>
                </c:pt>
                <c:pt idx="12">
                  <c:v>2.02020202020202E-2</c:v>
                </c:pt>
                <c:pt idx="13">
                  <c:v>7.7441077441077394E-2</c:v>
                </c:pt>
                <c:pt idx="14">
                  <c:v>0.104377104377104</c:v>
                </c:pt>
                <c:pt idx="15">
                  <c:v>0.11111111111111099</c:v>
                </c:pt>
                <c:pt idx="16">
                  <c:v>0.12121212121212104</c:v>
                </c:pt>
                <c:pt idx="17">
                  <c:v>8.7542087542087504E-2</c:v>
                </c:pt>
                <c:pt idx="18">
                  <c:v>7.0707070707070704E-2</c:v>
                </c:pt>
                <c:pt idx="19">
                  <c:v>0.117845117845118</c:v>
                </c:pt>
                <c:pt idx="20">
                  <c:v>7.7441077441077394E-2</c:v>
                </c:pt>
                <c:pt idx="21">
                  <c:v>4.7138047138047104E-2</c:v>
                </c:pt>
                <c:pt idx="22">
                  <c:v>2.69360269360269E-2</c:v>
                </c:pt>
                <c:pt idx="23">
                  <c:v>1.01010101010101E-2</c:v>
                </c:pt>
                <c:pt idx="24">
                  <c:v>1.01010101010101E-2</c:v>
                </c:pt>
                <c:pt idx="25">
                  <c:v>1.3468013468013504E-2</c:v>
                </c:pt>
                <c:pt idx="26">
                  <c:v>0</c:v>
                </c:pt>
                <c:pt idx="27">
                  <c:v>6.734006734006732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8"/>
          <c:order val="18"/>
          <c:tx>
            <c:strRef>
              <c:f>'nmr-1(ak4)_A3_0.02_50%'!$T$104</c:f>
              <c:strCache>
                <c:ptCount val="1"/>
                <c:pt idx="0">
                  <c:v>nmr-1(ak4)_A3_19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T$105:$T$135</c:f>
              <c:numCache>
                <c:formatCode>General</c:formatCode>
                <c:ptCount val="31"/>
                <c:pt idx="1">
                  <c:v>1.4440433212996401E-2</c:v>
                </c:pt>
                <c:pt idx="2">
                  <c:v>1.4440433212996401E-2</c:v>
                </c:pt>
                <c:pt idx="3">
                  <c:v>3.6101083032491002E-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3.6101083032491002E-3</c:v>
                </c:pt>
                <c:pt idx="8">
                  <c:v>0</c:v>
                </c:pt>
                <c:pt idx="9">
                  <c:v>0</c:v>
                </c:pt>
                <c:pt idx="10">
                  <c:v>1.8050541516245501E-2</c:v>
                </c:pt>
                <c:pt idx="11">
                  <c:v>1.4440433212996401E-2</c:v>
                </c:pt>
                <c:pt idx="12">
                  <c:v>7.2202166064981907E-2</c:v>
                </c:pt>
                <c:pt idx="13">
                  <c:v>0.11913357400722004</c:v>
                </c:pt>
                <c:pt idx="14">
                  <c:v>0.15523465703971101</c:v>
                </c:pt>
                <c:pt idx="15">
                  <c:v>0.162454873646209</c:v>
                </c:pt>
                <c:pt idx="16">
                  <c:v>0.14079422382671505</c:v>
                </c:pt>
                <c:pt idx="17">
                  <c:v>0.11191335740072197</c:v>
                </c:pt>
                <c:pt idx="18">
                  <c:v>4.6931407942238337E-2</c:v>
                </c:pt>
                <c:pt idx="19">
                  <c:v>5.7761732851985638E-2</c:v>
                </c:pt>
                <c:pt idx="20">
                  <c:v>1.8050541516245501E-2</c:v>
                </c:pt>
                <c:pt idx="21">
                  <c:v>7.2202166064982004E-3</c:v>
                </c:pt>
                <c:pt idx="22">
                  <c:v>1.4440433212996401E-2</c:v>
                </c:pt>
                <c:pt idx="23">
                  <c:v>3.6101083032491002E-3</c:v>
                </c:pt>
                <c:pt idx="24">
                  <c:v>1.0830324909747301E-2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9"/>
          <c:order val="19"/>
          <c:tx>
            <c:strRef>
              <c:f>'nmr-1(ak4)_A3_0.02_50%'!$U$104</c:f>
              <c:strCache>
                <c:ptCount val="1"/>
                <c:pt idx="0">
                  <c:v>nmr-1(ak4)_A3_20</c:v>
                </c:pt>
              </c:strCache>
            </c:strRef>
          </c:tx>
          <c:marker>
            <c:symbol val="none"/>
          </c:marker>
          <c:cat>
            <c:numRef>
              <c:f>'nmr-1(ak4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3_0.02_50%'!$U$105:$U$135</c:f>
              <c:numCache>
                <c:formatCode>General</c:formatCode>
                <c:ptCount val="31"/>
                <c:pt idx="1">
                  <c:v>9.7087378640776708E-3</c:v>
                </c:pt>
                <c:pt idx="2">
                  <c:v>0</c:v>
                </c:pt>
                <c:pt idx="3">
                  <c:v>4.8543689320388319E-3</c:v>
                </c:pt>
                <c:pt idx="4">
                  <c:v>4.8543689320388319E-3</c:v>
                </c:pt>
                <c:pt idx="5">
                  <c:v>4.8543689320388319E-3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4.8543689320388319E-3</c:v>
                </c:pt>
                <c:pt idx="12">
                  <c:v>6.7961165048543729E-2</c:v>
                </c:pt>
                <c:pt idx="13">
                  <c:v>0.111650485436893</c:v>
                </c:pt>
                <c:pt idx="14">
                  <c:v>0.111650485436893</c:v>
                </c:pt>
                <c:pt idx="15">
                  <c:v>0.13106796116504901</c:v>
                </c:pt>
                <c:pt idx="16">
                  <c:v>0.1941747572815529</c:v>
                </c:pt>
                <c:pt idx="17">
                  <c:v>0.15048543689320415</c:v>
                </c:pt>
                <c:pt idx="18">
                  <c:v>8.7378640776699032E-2</c:v>
                </c:pt>
                <c:pt idx="19">
                  <c:v>6.310679611650491E-2</c:v>
                </c:pt>
                <c:pt idx="20">
                  <c:v>2.4271844660194213E-2</c:v>
                </c:pt>
                <c:pt idx="21">
                  <c:v>9.7087378640776708E-3</c:v>
                </c:pt>
                <c:pt idx="22">
                  <c:v>1.4563106796116504E-2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marker val="1"/>
        <c:axId val="165417728"/>
        <c:axId val="165419264"/>
      </c:lineChart>
      <c:catAx>
        <c:axId val="165417728"/>
        <c:scaling>
          <c:orientation val="minMax"/>
        </c:scaling>
        <c:axPos val="b"/>
        <c:numFmt formatCode="0.0_ " sourceLinked="1"/>
        <c:tickLblPos val="nextTo"/>
        <c:crossAx val="165419264"/>
        <c:crosses val="autoZero"/>
        <c:auto val="1"/>
        <c:lblAlgn val="ctr"/>
        <c:lblOffset val="100"/>
        <c:tickLblSkip val="5"/>
        <c:tickMarkSkip val="5"/>
      </c:catAx>
      <c:valAx>
        <c:axId val="165419264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5417728"/>
        <c:crosses val="autoZero"/>
        <c:crossBetween val="between"/>
      </c:valAx>
    </c:plotArea>
    <c:plotVisOnly val="1"/>
  </c:chart>
  <c:externalData r:id="rId1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nmr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1</a:t>
            </a: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nmr-1(ak4)_A1_0.02_50%'!$B$104</c:f>
              <c:strCache>
                <c:ptCount val="1"/>
                <c:pt idx="0">
                  <c:v>nmr-1(ak4)_A1_01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B$105:$B$135</c:f>
              <c:numCache>
                <c:formatCode>General</c:formatCode>
                <c:ptCount val="31"/>
                <c:pt idx="1">
                  <c:v>5.5456171735241519E-2</c:v>
                </c:pt>
                <c:pt idx="2">
                  <c:v>5.1878354203935585E-2</c:v>
                </c:pt>
                <c:pt idx="3">
                  <c:v>7.1556350626118106E-2</c:v>
                </c:pt>
                <c:pt idx="4">
                  <c:v>6.6189624329159202E-2</c:v>
                </c:pt>
                <c:pt idx="5">
                  <c:v>4.2933810375670796E-2</c:v>
                </c:pt>
                <c:pt idx="6">
                  <c:v>6.4400715563506294E-2</c:v>
                </c:pt>
                <c:pt idx="7">
                  <c:v>6.2611806797853289E-2</c:v>
                </c:pt>
                <c:pt idx="8">
                  <c:v>5.9033989266547425E-2</c:v>
                </c:pt>
                <c:pt idx="9">
                  <c:v>4.83005366726297E-2</c:v>
                </c:pt>
                <c:pt idx="10">
                  <c:v>6.6189624329159202E-2</c:v>
                </c:pt>
                <c:pt idx="11">
                  <c:v>5.36672629695885E-2</c:v>
                </c:pt>
                <c:pt idx="12">
                  <c:v>5.0089445438282698E-2</c:v>
                </c:pt>
                <c:pt idx="13">
                  <c:v>4.6511627906976737E-2</c:v>
                </c:pt>
                <c:pt idx="14">
                  <c:v>3.0411449016100208E-2</c:v>
                </c:pt>
                <c:pt idx="15">
                  <c:v>2.8622540250447193E-2</c:v>
                </c:pt>
                <c:pt idx="16">
                  <c:v>3.0411449016100208E-2</c:v>
                </c:pt>
                <c:pt idx="17">
                  <c:v>2.6833631484794319E-2</c:v>
                </c:pt>
                <c:pt idx="18">
                  <c:v>1.7889087656529502E-2</c:v>
                </c:pt>
                <c:pt idx="19">
                  <c:v>1.0733452593917704E-2</c:v>
                </c:pt>
                <c:pt idx="20">
                  <c:v>1.4311270125223598E-2</c:v>
                </c:pt>
                <c:pt idx="21">
                  <c:v>1.4311270125223598E-2</c:v>
                </c:pt>
                <c:pt idx="22">
                  <c:v>1.2522361359570701E-2</c:v>
                </c:pt>
                <c:pt idx="23">
                  <c:v>5.3667262969588504E-3</c:v>
                </c:pt>
                <c:pt idx="24">
                  <c:v>5.3667262969588504E-3</c:v>
                </c:pt>
                <c:pt idx="25">
                  <c:v>1.7889087656529504E-3</c:v>
                </c:pt>
                <c:pt idx="26">
                  <c:v>0</c:v>
                </c:pt>
                <c:pt idx="27">
                  <c:v>0</c:v>
                </c:pt>
                <c:pt idx="28">
                  <c:v>1.7889087656529504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"/>
          <c:order val="1"/>
          <c:tx>
            <c:strRef>
              <c:f>'nmr-1(ak4)_A1_0.02_50%'!$C$104</c:f>
              <c:strCache>
                <c:ptCount val="1"/>
                <c:pt idx="0">
                  <c:v>nmr-1(ak4)_A1_02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C$105:$C$135</c:f>
              <c:numCache>
                <c:formatCode>General</c:formatCode>
                <c:ptCount val="31"/>
                <c:pt idx="1">
                  <c:v>4.4897959183673515E-2</c:v>
                </c:pt>
                <c:pt idx="2">
                  <c:v>6.3265306122449003E-2</c:v>
                </c:pt>
                <c:pt idx="3">
                  <c:v>4.2857142857142913E-2</c:v>
                </c:pt>
                <c:pt idx="4">
                  <c:v>5.7142857142857099E-2</c:v>
                </c:pt>
                <c:pt idx="5">
                  <c:v>4.8979591836734719E-2</c:v>
                </c:pt>
                <c:pt idx="6">
                  <c:v>4.2857142857142913E-2</c:v>
                </c:pt>
                <c:pt idx="7">
                  <c:v>5.1020408163265286E-2</c:v>
                </c:pt>
                <c:pt idx="8">
                  <c:v>6.938775510204083E-2</c:v>
                </c:pt>
                <c:pt idx="9">
                  <c:v>6.3265306122449003E-2</c:v>
                </c:pt>
                <c:pt idx="10">
                  <c:v>4.8979591836734719E-2</c:v>
                </c:pt>
                <c:pt idx="11">
                  <c:v>6.5306122448979598E-2</c:v>
                </c:pt>
                <c:pt idx="12">
                  <c:v>5.5102040816326525E-2</c:v>
                </c:pt>
                <c:pt idx="13">
                  <c:v>5.7142857142857099E-2</c:v>
                </c:pt>
                <c:pt idx="14">
                  <c:v>4.6938775510204082E-2</c:v>
                </c:pt>
                <c:pt idx="15">
                  <c:v>4.8979591836734719E-2</c:v>
                </c:pt>
                <c:pt idx="16">
                  <c:v>4.4897959183673515E-2</c:v>
                </c:pt>
                <c:pt idx="17">
                  <c:v>2.0408163265306107E-2</c:v>
                </c:pt>
                <c:pt idx="18">
                  <c:v>1.2244897959183699E-2</c:v>
                </c:pt>
                <c:pt idx="19">
                  <c:v>2.0408163265306107E-2</c:v>
                </c:pt>
                <c:pt idx="20">
                  <c:v>2.0408163265306107E-2</c:v>
                </c:pt>
                <c:pt idx="21">
                  <c:v>8.1632653061224497E-3</c:v>
                </c:pt>
                <c:pt idx="22">
                  <c:v>1.6326530612244903E-2</c:v>
                </c:pt>
                <c:pt idx="23">
                  <c:v>8.1632653061224497E-3</c:v>
                </c:pt>
                <c:pt idx="24">
                  <c:v>6.1224489795918399E-3</c:v>
                </c:pt>
                <c:pt idx="25">
                  <c:v>2.0408163265306098E-3</c:v>
                </c:pt>
                <c:pt idx="26">
                  <c:v>0</c:v>
                </c:pt>
                <c:pt idx="27">
                  <c:v>2.0408163265306098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nmr-1(ak4)_A1_0.02_50%'!$D$104</c:f>
              <c:strCache>
                <c:ptCount val="1"/>
                <c:pt idx="0">
                  <c:v>nmr-1(ak4)_A1_03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D$105:$D$135</c:f>
              <c:numCache>
                <c:formatCode>General</c:formatCode>
                <c:ptCount val="31"/>
                <c:pt idx="1">
                  <c:v>6.0653188180404383E-2</c:v>
                </c:pt>
                <c:pt idx="2">
                  <c:v>6.9984447900466623E-2</c:v>
                </c:pt>
                <c:pt idx="3">
                  <c:v>6.68740279937792E-2</c:v>
                </c:pt>
                <c:pt idx="4">
                  <c:v>5.7542768273716995E-2</c:v>
                </c:pt>
                <c:pt idx="5">
                  <c:v>7.7760497667185124E-2</c:v>
                </c:pt>
                <c:pt idx="6">
                  <c:v>6.2208398133748115E-2</c:v>
                </c:pt>
                <c:pt idx="7">
                  <c:v>4.9766718506998431E-2</c:v>
                </c:pt>
                <c:pt idx="8">
                  <c:v>4.0435458786936197E-2</c:v>
                </c:pt>
                <c:pt idx="9">
                  <c:v>5.909797822706072E-2</c:v>
                </c:pt>
                <c:pt idx="10">
                  <c:v>4.0435458786936197E-2</c:v>
                </c:pt>
                <c:pt idx="11">
                  <c:v>4.0435458786936197E-2</c:v>
                </c:pt>
                <c:pt idx="12">
                  <c:v>6.2208398133748115E-2</c:v>
                </c:pt>
                <c:pt idx="13">
                  <c:v>3.2659409020217717E-2</c:v>
                </c:pt>
                <c:pt idx="14">
                  <c:v>3.5769828926905098E-2</c:v>
                </c:pt>
                <c:pt idx="15">
                  <c:v>2.79937791601866E-2</c:v>
                </c:pt>
                <c:pt idx="16">
                  <c:v>3.2659409020217717E-2</c:v>
                </c:pt>
                <c:pt idx="17">
                  <c:v>2.4883359253499202E-2</c:v>
                </c:pt>
                <c:pt idx="18">
                  <c:v>2.3328149300155494E-2</c:v>
                </c:pt>
                <c:pt idx="19">
                  <c:v>1.8662519440124408E-2</c:v>
                </c:pt>
                <c:pt idx="20">
                  <c:v>2.4883359253499202E-2</c:v>
                </c:pt>
                <c:pt idx="21">
                  <c:v>9.3312597200622092E-3</c:v>
                </c:pt>
                <c:pt idx="22">
                  <c:v>6.2208398133748117E-3</c:v>
                </c:pt>
                <c:pt idx="23">
                  <c:v>4.6656298600311003E-3</c:v>
                </c:pt>
                <c:pt idx="24">
                  <c:v>3.1104199066874011E-3</c:v>
                </c:pt>
                <c:pt idx="25">
                  <c:v>1.5552099533437005E-3</c:v>
                </c:pt>
                <c:pt idx="26">
                  <c:v>0</c:v>
                </c:pt>
                <c:pt idx="27">
                  <c:v>4.6656298600311003E-3</c:v>
                </c:pt>
                <c:pt idx="28">
                  <c:v>1.5552099533437005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nmr-1(ak4)_A1_0.02_50%'!$E$104</c:f>
              <c:strCache>
                <c:ptCount val="1"/>
                <c:pt idx="0">
                  <c:v>nmr-1(ak4)_A1_04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E$105:$E$135</c:f>
              <c:numCache>
                <c:formatCode>General</c:formatCode>
                <c:ptCount val="31"/>
                <c:pt idx="1">
                  <c:v>3.8696537678207715E-2</c:v>
                </c:pt>
                <c:pt idx="2">
                  <c:v>6.313645621181263E-2</c:v>
                </c:pt>
                <c:pt idx="3">
                  <c:v>5.7026476578411422E-2</c:v>
                </c:pt>
                <c:pt idx="4">
                  <c:v>7.1283095723014306E-2</c:v>
                </c:pt>
                <c:pt idx="5">
                  <c:v>7.3319755600814704E-2</c:v>
                </c:pt>
                <c:pt idx="6">
                  <c:v>5.0916496945010256E-2</c:v>
                </c:pt>
                <c:pt idx="7">
                  <c:v>6.9246435845213922E-2</c:v>
                </c:pt>
                <c:pt idx="8">
                  <c:v>5.9063136456211834E-2</c:v>
                </c:pt>
                <c:pt idx="9">
                  <c:v>4.073319755600812E-2</c:v>
                </c:pt>
                <c:pt idx="10">
                  <c:v>5.4989816700610997E-2</c:v>
                </c:pt>
                <c:pt idx="11">
                  <c:v>4.6843177189409384E-2</c:v>
                </c:pt>
                <c:pt idx="12">
                  <c:v>5.7026476578411422E-2</c:v>
                </c:pt>
                <c:pt idx="13">
                  <c:v>3.25865580448065E-2</c:v>
                </c:pt>
                <c:pt idx="14">
                  <c:v>3.4623217922606912E-2</c:v>
                </c:pt>
                <c:pt idx="15">
                  <c:v>4.2769857433808622E-2</c:v>
                </c:pt>
                <c:pt idx="16">
                  <c:v>3.25865580448065E-2</c:v>
                </c:pt>
                <c:pt idx="17">
                  <c:v>2.0366598778004098E-2</c:v>
                </c:pt>
                <c:pt idx="18">
                  <c:v>3.4623217922606912E-2</c:v>
                </c:pt>
                <c:pt idx="19">
                  <c:v>1.2219959266802404E-2</c:v>
                </c:pt>
                <c:pt idx="20">
                  <c:v>2.6476578411405313E-2</c:v>
                </c:pt>
                <c:pt idx="21">
                  <c:v>8.1466395112016372E-3</c:v>
                </c:pt>
                <c:pt idx="22">
                  <c:v>1.0183299389002004E-2</c:v>
                </c:pt>
                <c:pt idx="23">
                  <c:v>4.0733197556008134E-3</c:v>
                </c:pt>
                <c:pt idx="24">
                  <c:v>4.0733197556008134E-3</c:v>
                </c:pt>
                <c:pt idx="25">
                  <c:v>2.0366598778004102E-3</c:v>
                </c:pt>
                <c:pt idx="26">
                  <c:v>2.0366598778004102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nmr-1(ak4)_A1_0.02_50%'!$F$104</c:f>
              <c:strCache>
                <c:ptCount val="1"/>
                <c:pt idx="0">
                  <c:v>nmr-1(ak4)_A1_05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F$105:$F$135</c:f>
              <c:numCache>
                <c:formatCode>General</c:formatCode>
                <c:ptCount val="31"/>
                <c:pt idx="1">
                  <c:v>5.4054054054054113E-2</c:v>
                </c:pt>
                <c:pt idx="2">
                  <c:v>6.0810810810810821E-2</c:v>
                </c:pt>
                <c:pt idx="3">
                  <c:v>6.7567567567567599E-2</c:v>
                </c:pt>
                <c:pt idx="4">
                  <c:v>4.7297297297297321E-2</c:v>
                </c:pt>
                <c:pt idx="5">
                  <c:v>5.7432432432432436E-2</c:v>
                </c:pt>
                <c:pt idx="6">
                  <c:v>6.5878378378378399E-2</c:v>
                </c:pt>
                <c:pt idx="7">
                  <c:v>6.5878378378378399E-2</c:v>
                </c:pt>
                <c:pt idx="8">
                  <c:v>4.7297297297297321E-2</c:v>
                </c:pt>
                <c:pt idx="9">
                  <c:v>5.4054054054054113E-2</c:v>
                </c:pt>
                <c:pt idx="10">
                  <c:v>4.5608108108108086E-2</c:v>
                </c:pt>
                <c:pt idx="11">
                  <c:v>4.0540540540540487E-2</c:v>
                </c:pt>
                <c:pt idx="12">
                  <c:v>4.5608108108108086E-2</c:v>
                </c:pt>
                <c:pt idx="13">
                  <c:v>5.2364864864864899E-2</c:v>
                </c:pt>
                <c:pt idx="14">
                  <c:v>3.7162162162162199E-2</c:v>
                </c:pt>
                <c:pt idx="15">
                  <c:v>4.5608108108108086E-2</c:v>
                </c:pt>
                <c:pt idx="16">
                  <c:v>3.7162162162162199E-2</c:v>
                </c:pt>
                <c:pt idx="17">
                  <c:v>2.7027027027027015E-2</c:v>
                </c:pt>
                <c:pt idx="18">
                  <c:v>2.1959459459459499E-2</c:v>
                </c:pt>
                <c:pt idx="19">
                  <c:v>2.0270270270270313E-2</c:v>
                </c:pt>
                <c:pt idx="20">
                  <c:v>1.5202702702702704E-2</c:v>
                </c:pt>
                <c:pt idx="21">
                  <c:v>2.1959459459459499E-2</c:v>
                </c:pt>
                <c:pt idx="22">
                  <c:v>6.7567567567567597E-3</c:v>
                </c:pt>
                <c:pt idx="23">
                  <c:v>8.4459459459459551E-3</c:v>
                </c:pt>
                <c:pt idx="24">
                  <c:v>1.6891891891891904E-3</c:v>
                </c:pt>
                <c:pt idx="25">
                  <c:v>1.6891891891891904E-3</c:v>
                </c:pt>
                <c:pt idx="26">
                  <c:v>0</c:v>
                </c:pt>
                <c:pt idx="27">
                  <c:v>1.6891891891891904E-3</c:v>
                </c:pt>
                <c:pt idx="28">
                  <c:v>0</c:v>
                </c:pt>
                <c:pt idx="29">
                  <c:v>1.6891891891891904E-3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nmr-1(ak4)_A1_0.02_50%'!$G$104</c:f>
              <c:strCache>
                <c:ptCount val="1"/>
                <c:pt idx="0">
                  <c:v>nmr-1(ak4)_A1_06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G$105:$G$135</c:f>
              <c:numCache>
                <c:formatCode>General</c:formatCode>
                <c:ptCount val="31"/>
                <c:pt idx="1">
                  <c:v>5.2631578947368404E-2</c:v>
                </c:pt>
                <c:pt idx="2">
                  <c:v>4.6558704453441319E-2</c:v>
                </c:pt>
                <c:pt idx="3">
                  <c:v>4.4534412955465626E-2</c:v>
                </c:pt>
                <c:pt idx="4">
                  <c:v>4.6558704453441319E-2</c:v>
                </c:pt>
                <c:pt idx="5">
                  <c:v>5.2631578947368404E-2</c:v>
                </c:pt>
                <c:pt idx="6">
                  <c:v>5.0607287449392718E-2</c:v>
                </c:pt>
                <c:pt idx="7">
                  <c:v>6.4777327935222742E-2</c:v>
                </c:pt>
                <c:pt idx="8">
                  <c:v>2.6315789473684202E-2</c:v>
                </c:pt>
                <c:pt idx="9">
                  <c:v>6.88259109311741E-2</c:v>
                </c:pt>
                <c:pt idx="10">
                  <c:v>3.8461538461538498E-2</c:v>
                </c:pt>
                <c:pt idx="11">
                  <c:v>5.2631578947368404E-2</c:v>
                </c:pt>
                <c:pt idx="12">
                  <c:v>7.08502024291498E-2</c:v>
                </c:pt>
                <c:pt idx="13">
                  <c:v>4.6558704453441319E-2</c:v>
                </c:pt>
                <c:pt idx="14">
                  <c:v>8.5020242914979852E-2</c:v>
                </c:pt>
                <c:pt idx="15">
                  <c:v>5.4655870445344097E-2</c:v>
                </c:pt>
                <c:pt idx="16">
                  <c:v>2.6315789473684202E-2</c:v>
                </c:pt>
                <c:pt idx="17">
                  <c:v>3.6437246963562812E-2</c:v>
                </c:pt>
                <c:pt idx="18">
                  <c:v>1.8218623481781399E-2</c:v>
                </c:pt>
                <c:pt idx="19">
                  <c:v>1.417004048583E-2</c:v>
                </c:pt>
                <c:pt idx="20">
                  <c:v>3.0364372469635609E-2</c:v>
                </c:pt>
                <c:pt idx="21">
                  <c:v>1.8218623481781399E-2</c:v>
                </c:pt>
                <c:pt idx="22">
                  <c:v>1.0121457489878501E-2</c:v>
                </c:pt>
                <c:pt idx="23">
                  <c:v>4.0485829959514223E-3</c:v>
                </c:pt>
                <c:pt idx="24">
                  <c:v>4.0485829959514223E-3</c:v>
                </c:pt>
                <c:pt idx="25">
                  <c:v>0</c:v>
                </c:pt>
                <c:pt idx="26">
                  <c:v>2.0242914979757111E-3</c:v>
                </c:pt>
                <c:pt idx="27">
                  <c:v>0</c:v>
                </c:pt>
                <c:pt idx="28">
                  <c:v>6.0728744939271334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6"/>
          <c:order val="6"/>
          <c:tx>
            <c:strRef>
              <c:f>'nmr-1(ak4)_A1_0.02_50%'!$H$104</c:f>
              <c:strCache>
                <c:ptCount val="1"/>
                <c:pt idx="0">
                  <c:v>nmr-1(ak4)_A1_07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H$105:$H$135</c:f>
              <c:numCache>
                <c:formatCode>General</c:formatCode>
                <c:ptCount val="31"/>
                <c:pt idx="1">
                  <c:v>6.4935064935064901E-2</c:v>
                </c:pt>
                <c:pt idx="2">
                  <c:v>4.2671614100185502E-2</c:v>
                </c:pt>
                <c:pt idx="3">
                  <c:v>3.3395176252319102E-2</c:v>
                </c:pt>
                <c:pt idx="4">
                  <c:v>4.8237476808905416E-2</c:v>
                </c:pt>
                <c:pt idx="5">
                  <c:v>6.3079777365491696E-2</c:v>
                </c:pt>
                <c:pt idx="6">
                  <c:v>4.8237476808905416E-2</c:v>
                </c:pt>
                <c:pt idx="7">
                  <c:v>5.9369202226345119E-2</c:v>
                </c:pt>
                <c:pt idx="8">
                  <c:v>6.8645640074211506E-2</c:v>
                </c:pt>
                <c:pt idx="9">
                  <c:v>3.8961038961039002E-2</c:v>
                </c:pt>
                <c:pt idx="10">
                  <c:v>7.0500927643784794E-2</c:v>
                </c:pt>
                <c:pt idx="11">
                  <c:v>5.5658627087198514E-2</c:v>
                </c:pt>
                <c:pt idx="12">
                  <c:v>5.1948051948052E-2</c:v>
                </c:pt>
                <c:pt idx="13">
                  <c:v>4.6382189239332114E-2</c:v>
                </c:pt>
                <c:pt idx="14">
                  <c:v>6.4935064935064901E-2</c:v>
                </c:pt>
                <c:pt idx="15">
                  <c:v>5.1948051948052E-2</c:v>
                </c:pt>
                <c:pt idx="16">
                  <c:v>3.7105751391465699E-2</c:v>
                </c:pt>
                <c:pt idx="17">
                  <c:v>1.4842300556586301E-2</c:v>
                </c:pt>
                <c:pt idx="18">
                  <c:v>2.4118738404452701E-2</c:v>
                </c:pt>
                <c:pt idx="19">
                  <c:v>9.2764378478664266E-3</c:v>
                </c:pt>
                <c:pt idx="20">
                  <c:v>2.9684601113172508E-2</c:v>
                </c:pt>
                <c:pt idx="21">
                  <c:v>5.5658627087198514E-3</c:v>
                </c:pt>
                <c:pt idx="22">
                  <c:v>1.1131725417439705E-2</c:v>
                </c:pt>
                <c:pt idx="23">
                  <c:v>1.2987012987013E-2</c:v>
                </c:pt>
                <c:pt idx="24">
                  <c:v>1.8552875695732817E-3</c:v>
                </c:pt>
                <c:pt idx="25">
                  <c:v>1.8552875695732817E-3</c:v>
                </c:pt>
                <c:pt idx="26">
                  <c:v>1.8552875695732817E-3</c:v>
                </c:pt>
                <c:pt idx="27">
                  <c:v>0</c:v>
                </c:pt>
                <c:pt idx="28">
                  <c:v>1.8552875695732817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nmr-1(ak4)_A1_0.02_50%'!$I$104</c:f>
              <c:strCache>
                <c:ptCount val="1"/>
                <c:pt idx="0">
                  <c:v>nmr-1(ak4)_A1_08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I$105:$I$135</c:f>
              <c:numCache>
                <c:formatCode>General</c:formatCode>
                <c:ptCount val="31"/>
                <c:pt idx="1">
                  <c:v>4.6082949308755797E-2</c:v>
                </c:pt>
                <c:pt idx="2">
                  <c:v>6.2211981566820319E-2</c:v>
                </c:pt>
                <c:pt idx="3">
                  <c:v>2.9953917050691208E-2</c:v>
                </c:pt>
                <c:pt idx="4">
                  <c:v>4.1474654377880185E-2</c:v>
                </c:pt>
                <c:pt idx="5">
                  <c:v>2.9953917050691208E-2</c:v>
                </c:pt>
                <c:pt idx="6">
                  <c:v>5.5299539170506902E-2</c:v>
                </c:pt>
                <c:pt idx="7">
                  <c:v>5.5299539170506902E-2</c:v>
                </c:pt>
                <c:pt idx="8">
                  <c:v>5.5299539170506902E-2</c:v>
                </c:pt>
                <c:pt idx="9">
                  <c:v>5.7603686635944729E-2</c:v>
                </c:pt>
                <c:pt idx="10">
                  <c:v>5.5299539170506902E-2</c:v>
                </c:pt>
                <c:pt idx="11">
                  <c:v>7.6036866359447022E-2</c:v>
                </c:pt>
                <c:pt idx="12">
                  <c:v>5.2995391705069096E-2</c:v>
                </c:pt>
                <c:pt idx="13">
                  <c:v>5.2995391705069096E-2</c:v>
                </c:pt>
                <c:pt idx="14">
                  <c:v>5.7603686635944729E-2</c:v>
                </c:pt>
                <c:pt idx="15">
                  <c:v>7.373271889400923E-2</c:v>
                </c:pt>
                <c:pt idx="16">
                  <c:v>4.8387096774193498E-2</c:v>
                </c:pt>
                <c:pt idx="17">
                  <c:v>2.3041474654377898E-2</c:v>
                </c:pt>
                <c:pt idx="18">
                  <c:v>2.0737327188940117E-2</c:v>
                </c:pt>
                <c:pt idx="19">
                  <c:v>1.3824884792626705E-2</c:v>
                </c:pt>
                <c:pt idx="20">
                  <c:v>2.5345622119815711E-2</c:v>
                </c:pt>
                <c:pt idx="21">
                  <c:v>1.1520737327188904E-2</c:v>
                </c:pt>
                <c:pt idx="22">
                  <c:v>6.9124423963133654E-3</c:v>
                </c:pt>
                <c:pt idx="23">
                  <c:v>6.9124423963133654E-3</c:v>
                </c:pt>
                <c:pt idx="24">
                  <c:v>2.3041474654377911E-3</c:v>
                </c:pt>
                <c:pt idx="25">
                  <c:v>2.3041474654377911E-3</c:v>
                </c:pt>
                <c:pt idx="26">
                  <c:v>2.3041474654377911E-3</c:v>
                </c:pt>
                <c:pt idx="27">
                  <c:v>0</c:v>
                </c:pt>
                <c:pt idx="28">
                  <c:v>2.3041474654377911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8"/>
          <c:order val="8"/>
          <c:tx>
            <c:strRef>
              <c:f>'nmr-1(ak4)_A1_0.02_50%'!$J$104</c:f>
              <c:strCache>
                <c:ptCount val="1"/>
                <c:pt idx="0">
                  <c:v>nmr-1(ak4)_A1_09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J$105:$J$135</c:f>
              <c:numCache>
                <c:formatCode>General</c:formatCode>
                <c:ptCount val="31"/>
                <c:pt idx="1">
                  <c:v>6.4631956912028735E-2</c:v>
                </c:pt>
                <c:pt idx="2">
                  <c:v>5.2064631956912057E-2</c:v>
                </c:pt>
                <c:pt idx="3">
                  <c:v>6.1041292639138198E-2</c:v>
                </c:pt>
                <c:pt idx="4">
                  <c:v>7.3608617594254896E-2</c:v>
                </c:pt>
                <c:pt idx="5">
                  <c:v>6.822262118491923E-2</c:v>
                </c:pt>
                <c:pt idx="6">
                  <c:v>5.7450628366247813E-2</c:v>
                </c:pt>
                <c:pt idx="7">
                  <c:v>4.4883303411131122E-2</c:v>
                </c:pt>
                <c:pt idx="8">
                  <c:v>5.0269299820466816E-2</c:v>
                </c:pt>
                <c:pt idx="9">
                  <c:v>7.3608617594254896E-2</c:v>
                </c:pt>
                <c:pt idx="10">
                  <c:v>5.2064631956912057E-2</c:v>
                </c:pt>
                <c:pt idx="11">
                  <c:v>5.9245960502692978E-2</c:v>
                </c:pt>
                <c:pt idx="12">
                  <c:v>4.3087971274685812E-2</c:v>
                </c:pt>
                <c:pt idx="13">
                  <c:v>4.1292639138240633E-2</c:v>
                </c:pt>
                <c:pt idx="14">
                  <c:v>3.4111310592459615E-2</c:v>
                </c:pt>
                <c:pt idx="15">
                  <c:v>2.69299820466786E-2</c:v>
                </c:pt>
                <c:pt idx="16">
                  <c:v>3.5906642728904814E-2</c:v>
                </c:pt>
                <c:pt idx="17">
                  <c:v>1.9748653500897703E-2</c:v>
                </c:pt>
                <c:pt idx="18">
                  <c:v>2.3339317773788209E-2</c:v>
                </c:pt>
                <c:pt idx="19">
                  <c:v>1.4362657091561901E-2</c:v>
                </c:pt>
                <c:pt idx="20">
                  <c:v>2.5134649910233401E-2</c:v>
                </c:pt>
                <c:pt idx="21">
                  <c:v>1.6157989228007208E-2</c:v>
                </c:pt>
                <c:pt idx="22">
                  <c:v>7.1813285457809732E-3</c:v>
                </c:pt>
                <c:pt idx="23">
                  <c:v>7.1813285457809732E-3</c:v>
                </c:pt>
                <c:pt idx="24">
                  <c:v>1.7953321364452409E-3</c:v>
                </c:pt>
                <c:pt idx="25">
                  <c:v>7.1813285457809732E-3</c:v>
                </c:pt>
                <c:pt idx="26">
                  <c:v>1.7953321364452409E-3</c:v>
                </c:pt>
                <c:pt idx="27">
                  <c:v>1.7953321364452409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nmr-1(ak4)_A1_0.02_50%'!$K$104</c:f>
              <c:strCache>
                <c:ptCount val="1"/>
                <c:pt idx="0">
                  <c:v>nmr-1(ak4)_A1_10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K$105:$K$135</c:f>
              <c:numCache>
                <c:formatCode>General</c:formatCode>
                <c:ptCount val="31"/>
                <c:pt idx="1">
                  <c:v>6.11510791366906E-2</c:v>
                </c:pt>
                <c:pt idx="2">
                  <c:v>4.4964028776978401E-2</c:v>
                </c:pt>
                <c:pt idx="3">
                  <c:v>6.4748201438848935E-2</c:v>
                </c:pt>
                <c:pt idx="4">
                  <c:v>5.0359712230215813E-2</c:v>
                </c:pt>
                <c:pt idx="5">
                  <c:v>6.11510791366906E-2</c:v>
                </c:pt>
                <c:pt idx="6">
                  <c:v>7.5539568345323702E-2</c:v>
                </c:pt>
                <c:pt idx="7">
                  <c:v>4.4964028776978401E-2</c:v>
                </c:pt>
                <c:pt idx="8">
                  <c:v>6.11510791366906E-2</c:v>
                </c:pt>
                <c:pt idx="9">
                  <c:v>3.5971223021582698E-2</c:v>
                </c:pt>
                <c:pt idx="10">
                  <c:v>5.2158273381295001E-2</c:v>
                </c:pt>
                <c:pt idx="11">
                  <c:v>5.7553956834532426E-2</c:v>
                </c:pt>
                <c:pt idx="12">
                  <c:v>4.8561151079136715E-2</c:v>
                </c:pt>
                <c:pt idx="13">
                  <c:v>5.2158273381295001E-2</c:v>
                </c:pt>
                <c:pt idx="14">
                  <c:v>5.5755395683453189E-2</c:v>
                </c:pt>
                <c:pt idx="15">
                  <c:v>5.2158273381295001E-2</c:v>
                </c:pt>
                <c:pt idx="16">
                  <c:v>4.1366906474820102E-2</c:v>
                </c:pt>
                <c:pt idx="17">
                  <c:v>3.2374100719424523E-2</c:v>
                </c:pt>
                <c:pt idx="18">
                  <c:v>1.9784172661870509E-2</c:v>
                </c:pt>
                <c:pt idx="19">
                  <c:v>3.41726618705036E-2</c:v>
                </c:pt>
                <c:pt idx="20">
                  <c:v>1.7985611510791401E-2</c:v>
                </c:pt>
                <c:pt idx="21">
                  <c:v>7.1942446043165515E-3</c:v>
                </c:pt>
                <c:pt idx="22">
                  <c:v>3.597122302158271E-3</c:v>
                </c:pt>
                <c:pt idx="23">
                  <c:v>1.79856115107914E-3</c:v>
                </c:pt>
                <c:pt idx="24">
                  <c:v>1.79856115107914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nmr-1(ak4)_A1_0.02_50%'!$L$104</c:f>
              <c:strCache>
                <c:ptCount val="1"/>
                <c:pt idx="0">
                  <c:v>nmr-1(ak4)_A1_11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L$105:$L$135</c:f>
              <c:numCache>
                <c:formatCode>General</c:formatCode>
                <c:ptCount val="31"/>
                <c:pt idx="1">
                  <c:v>4.9309664694280116E-2</c:v>
                </c:pt>
                <c:pt idx="2">
                  <c:v>5.7199211045364913E-2</c:v>
                </c:pt>
                <c:pt idx="3">
                  <c:v>5.3254437869822514E-2</c:v>
                </c:pt>
                <c:pt idx="4">
                  <c:v>7.8895463510848127E-2</c:v>
                </c:pt>
                <c:pt idx="5">
                  <c:v>6.1143984220907312E-2</c:v>
                </c:pt>
                <c:pt idx="6">
                  <c:v>7.2978303747534501E-2</c:v>
                </c:pt>
                <c:pt idx="7">
                  <c:v>4.1420118343195297E-2</c:v>
                </c:pt>
                <c:pt idx="8">
                  <c:v>3.5502958579881699E-2</c:v>
                </c:pt>
                <c:pt idx="9">
                  <c:v>5.1282051282051301E-2</c:v>
                </c:pt>
                <c:pt idx="10">
                  <c:v>4.3392504930966538E-2</c:v>
                </c:pt>
                <c:pt idx="11">
                  <c:v>5.5226824457593721E-2</c:v>
                </c:pt>
                <c:pt idx="12">
                  <c:v>2.3668639053254392E-2</c:v>
                </c:pt>
                <c:pt idx="13">
                  <c:v>4.7337278106508916E-2</c:v>
                </c:pt>
                <c:pt idx="14">
                  <c:v>4.9309664694280116E-2</c:v>
                </c:pt>
                <c:pt idx="15">
                  <c:v>3.35305719921105E-2</c:v>
                </c:pt>
                <c:pt idx="16">
                  <c:v>3.5502958579881699E-2</c:v>
                </c:pt>
                <c:pt idx="17">
                  <c:v>1.9723865877712011E-2</c:v>
                </c:pt>
                <c:pt idx="18">
                  <c:v>3.35305719921105E-2</c:v>
                </c:pt>
                <c:pt idx="19">
                  <c:v>1.9723865877712011E-2</c:v>
                </c:pt>
                <c:pt idx="20">
                  <c:v>2.3668639053254392E-2</c:v>
                </c:pt>
                <c:pt idx="21">
                  <c:v>1.7751479289940808E-2</c:v>
                </c:pt>
                <c:pt idx="22">
                  <c:v>1.5779092702169598E-2</c:v>
                </c:pt>
                <c:pt idx="23">
                  <c:v>9.8619329388560245E-3</c:v>
                </c:pt>
                <c:pt idx="24">
                  <c:v>5.9171597633136119E-3</c:v>
                </c:pt>
                <c:pt idx="25">
                  <c:v>9.8619329388560245E-3</c:v>
                </c:pt>
                <c:pt idx="26">
                  <c:v>5.9171597633136119E-3</c:v>
                </c:pt>
                <c:pt idx="27">
                  <c:v>3.9447731755424117E-3</c:v>
                </c:pt>
                <c:pt idx="28">
                  <c:v>3.9447731755424117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nmr-1(ak4)_A1_0.02_50%'!$M$104</c:f>
              <c:strCache>
                <c:ptCount val="1"/>
                <c:pt idx="0">
                  <c:v>nmr-1(ak4)_A1_12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M$105:$M$135</c:f>
              <c:numCache>
                <c:formatCode>General</c:formatCode>
                <c:ptCount val="31"/>
                <c:pt idx="1">
                  <c:v>2.7439024390243899E-2</c:v>
                </c:pt>
                <c:pt idx="2">
                  <c:v>3.3536585365853702E-2</c:v>
                </c:pt>
                <c:pt idx="3">
                  <c:v>3.9634146341463415E-2</c:v>
                </c:pt>
                <c:pt idx="4">
                  <c:v>4.2682926829268338E-2</c:v>
                </c:pt>
                <c:pt idx="5">
                  <c:v>3.3536585365853702E-2</c:v>
                </c:pt>
                <c:pt idx="6">
                  <c:v>3.9634146341463415E-2</c:v>
                </c:pt>
                <c:pt idx="7">
                  <c:v>1.5243902439024399E-2</c:v>
                </c:pt>
                <c:pt idx="8">
                  <c:v>2.1341463414634099E-2</c:v>
                </c:pt>
                <c:pt idx="9">
                  <c:v>4.8780487804878127E-2</c:v>
                </c:pt>
                <c:pt idx="10">
                  <c:v>4.5731707317073211E-2</c:v>
                </c:pt>
                <c:pt idx="11">
                  <c:v>3.9634146341463415E-2</c:v>
                </c:pt>
                <c:pt idx="12">
                  <c:v>5.4878048780487777E-2</c:v>
                </c:pt>
                <c:pt idx="13">
                  <c:v>7.6219512195122005E-2</c:v>
                </c:pt>
                <c:pt idx="14">
                  <c:v>6.4024390243902413E-2</c:v>
                </c:pt>
                <c:pt idx="15">
                  <c:v>8.84146341463415E-2</c:v>
                </c:pt>
                <c:pt idx="16">
                  <c:v>7.0121951219512202E-2</c:v>
                </c:pt>
                <c:pt idx="17">
                  <c:v>5.79268292682927E-2</c:v>
                </c:pt>
                <c:pt idx="18">
                  <c:v>5.4878048780487777E-2</c:v>
                </c:pt>
                <c:pt idx="19">
                  <c:v>3.9634146341463415E-2</c:v>
                </c:pt>
                <c:pt idx="20">
                  <c:v>3.6585365853658514E-2</c:v>
                </c:pt>
                <c:pt idx="21">
                  <c:v>2.1341463414634099E-2</c:v>
                </c:pt>
                <c:pt idx="22">
                  <c:v>3.0487804878048808E-3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6.0975609756097598E-3</c:v>
                </c:pt>
                <c:pt idx="27">
                  <c:v>3.0487804878048808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nmr-1(ak4)_A1_0.02_50%'!$N$104</c:f>
              <c:strCache>
                <c:ptCount val="1"/>
                <c:pt idx="0">
                  <c:v>nmr-1(ak4)_A1_13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N$105:$N$135</c:f>
              <c:numCache>
                <c:formatCode>General</c:formatCode>
                <c:ptCount val="31"/>
                <c:pt idx="1">
                  <c:v>3.9893617021276619E-2</c:v>
                </c:pt>
                <c:pt idx="2">
                  <c:v>4.5212765957446839E-2</c:v>
                </c:pt>
                <c:pt idx="3">
                  <c:v>2.6595744680851106E-2</c:v>
                </c:pt>
                <c:pt idx="4">
                  <c:v>2.1276595744680899E-2</c:v>
                </c:pt>
                <c:pt idx="5">
                  <c:v>4.5212765957446839E-2</c:v>
                </c:pt>
                <c:pt idx="6">
                  <c:v>2.6595744680851106E-2</c:v>
                </c:pt>
                <c:pt idx="7">
                  <c:v>3.1914893617021316E-2</c:v>
                </c:pt>
                <c:pt idx="8">
                  <c:v>3.1914893617021316E-2</c:v>
                </c:pt>
                <c:pt idx="9">
                  <c:v>4.5212765957446839E-2</c:v>
                </c:pt>
                <c:pt idx="10">
                  <c:v>3.1914893617021316E-2</c:v>
                </c:pt>
                <c:pt idx="11">
                  <c:v>5.31914893617021E-2</c:v>
                </c:pt>
                <c:pt idx="12">
                  <c:v>5.8510638297872314E-2</c:v>
                </c:pt>
                <c:pt idx="13">
                  <c:v>9.8404255319148898E-2</c:v>
                </c:pt>
                <c:pt idx="14">
                  <c:v>6.382978723404252E-2</c:v>
                </c:pt>
                <c:pt idx="15">
                  <c:v>7.9787234042553251E-2</c:v>
                </c:pt>
                <c:pt idx="16">
                  <c:v>5.5851063829787211E-2</c:v>
                </c:pt>
                <c:pt idx="17">
                  <c:v>6.64893617021277E-2</c:v>
                </c:pt>
                <c:pt idx="18">
                  <c:v>5.31914893617021E-2</c:v>
                </c:pt>
                <c:pt idx="19">
                  <c:v>2.9255319148936202E-2</c:v>
                </c:pt>
                <c:pt idx="20">
                  <c:v>2.6595744680851106E-2</c:v>
                </c:pt>
                <c:pt idx="21">
                  <c:v>5.31914893617021E-3</c:v>
                </c:pt>
                <c:pt idx="22">
                  <c:v>2.3936170212766002E-2</c:v>
                </c:pt>
                <c:pt idx="23">
                  <c:v>2.6595744680851107E-3</c:v>
                </c:pt>
                <c:pt idx="24">
                  <c:v>2.6595744680851107E-3</c:v>
                </c:pt>
                <c:pt idx="25">
                  <c:v>0</c:v>
                </c:pt>
                <c:pt idx="26">
                  <c:v>2.6595744680851107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nmr-1(ak4)_A1_0.02_50%'!$O$104</c:f>
              <c:strCache>
                <c:ptCount val="1"/>
                <c:pt idx="0">
                  <c:v>nmr-1(ak4)_A1_14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O$105:$O$135</c:f>
              <c:numCache>
                <c:formatCode>General</c:formatCode>
                <c:ptCount val="31"/>
                <c:pt idx="1">
                  <c:v>4.7945205479452066E-2</c:v>
                </c:pt>
                <c:pt idx="2">
                  <c:v>3.42465753424658E-2</c:v>
                </c:pt>
                <c:pt idx="3">
                  <c:v>4.4520547945205519E-2</c:v>
                </c:pt>
                <c:pt idx="4">
                  <c:v>3.42465753424658E-2</c:v>
                </c:pt>
                <c:pt idx="5">
                  <c:v>2.3972602739726002E-2</c:v>
                </c:pt>
                <c:pt idx="6">
                  <c:v>2.3972602739726002E-2</c:v>
                </c:pt>
                <c:pt idx="7">
                  <c:v>2.3972602739726002E-2</c:v>
                </c:pt>
                <c:pt idx="8">
                  <c:v>1.71232876712329E-2</c:v>
                </c:pt>
                <c:pt idx="9">
                  <c:v>5.8219178082191785E-2</c:v>
                </c:pt>
                <c:pt idx="10">
                  <c:v>5.1369863013698613E-2</c:v>
                </c:pt>
                <c:pt idx="11">
                  <c:v>6.8493150684931503E-2</c:v>
                </c:pt>
                <c:pt idx="12">
                  <c:v>6.8493150684931503E-2</c:v>
                </c:pt>
                <c:pt idx="13">
                  <c:v>8.9041095890411037E-2</c:v>
                </c:pt>
                <c:pt idx="14">
                  <c:v>7.8767123287671229E-2</c:v>
                </c:pt>
                <c:pt idx="15">
                  <c:v>8.9041095890411037E-2</c:v>
                </c:pt>
                <c:pt idx="16">
                  <c:v>4.7945205479452066E-2</c:v>
                </c:pt>
                <c:pt idx="17">
                  <c:v>4.4520547945205519E-2</c:v>
                </c:pt>
                <c:pt idx="18">
                  <c:v>3.7671232876712327E-2</c:v>
                </c:pt>
                <c:pt idx="19">
                  <c:v>3.7671232876712327E-2</c:v>
                </c:pt>
                <c:pt idx="20">
                  <c:v>2.0547945205479513E-2</c:v>
                </c:pt>
                <c:pt idx="21">
                  <c:v>2.0547945205479513E-2</c:v>
                </c:pt>
                <c:pt idx="22">
                  <c:v>1.0273972602739699E-2</c:v>
                </c:pt>
                <c:pt idx="23">
                  <c:v>6.849315068493152E-3</c:v>
                </c:pt>
                <c:pt idx="24">
                  <c:v>3.4246575342465808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4"/>
          <c:order val="14"/>
          <c:tx>
            <c:strRef>
              <c:f>'nmr-1(ak4)_A1_0.02_50%'!$P$104</c:f>
              <c:strCache>
                <c:ptCount val="1"/>
                <c:pt idx="0">
                  <c:v>nmr-1(ak4)_A1_15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P$105:$P$135</c:f>
              <c:numCache>
                <c:formatCode>General</c:formatCode>
                <c:ptCount val="31"/>
                <c:pt idx="1">
                  <c:v>3.4031413612565418E-2</c:v>
                </c:pt>
                <c:pt idx="2">
                  <c:v>3.4031413612565418E-2</c:v>
                </c:pt>
                <c:pt idx="3">
                  <c:v>1.3089005235602108E-2</c:v>
                </c:pt>
                <c:pt idx="4">
                  <c:v>2.3560209424083801E-2</c:v>
                </c:pt>
                <c:pt idx="5">
                  <c:v>1.8324607329842903E-2</c:v>
                </c:pt>
                <c:pt idx="6">
                  <c:v>1.8324607329842903E-2</c:v>
                </c:pt>
                <c:pt idx="7">
                  <c:v>2.0942408376963401E-2</c:v>
                </c:pt>
                <c:pt idx="8">
                  <c:v>1.8324607329842903E-2</c:v>
                </c:pt>
                <c:pt idx="9">
                  <c:v>3.9267015706806317E-2</c:v>
                </c:pt>
                <c:pt idx="10">
                  <c:v>3.1413612565445018E-2</c:v>
                </c:pt>
                <c:pt idx="11">
                  <c:v>4.9738219895288024E-2</c:v>
                </c:pt>
                <c:pt idx="12">
                  <c:v>4.7120418848167513E-2</c:v>
                </c:pt>
                <c:pt idx="13">
                  <c:v>0.10732984293193704</c:v>
                </c:pt>
                <c:pt idx="14">
                  <c:v>7.3298429319371722E-2</c:v>
                </c:pt>
                <c:pt idx="15">
                  <c:v>8.1151832460733028E-2</c:v>
                </c:pt>
                <c:pt idx="16">
                  <c:v>7.591623036649213E-2</c:v>
                </c:pt>
                <c:pt idx="17">
                  <c:v>7.591623036649213E-2</c:v>
                </c:pt>
                <c:pt idx="18">
                  <c:v>2.879581151832461E-2</c:v>
                </c:pt>
                <c:pt idx="19">
                  <c:v>6.2827225130889994E-2</c:v>
                </c:pt>
                <c:pt idx="20">
                  <c:v>4.1884816753926704E-2</c:v>
                </c:pt>
                <c:pt idx="21">
                  <c:v>2.3560209424083801E-2</c:v>
                </c:pt>
                <c:pt idx="22">
                  <c:v>1.8324607329842903E-2</c:v>
                </c:pt>
                <c:pt idx="23">
                  <c:v>1.5706806282722505E-2</c:v>
                </c:pt>
                <c:pt idx="24">
                  <c:v>0</c:v>
                </c:pt>
                <c:pt idx="25">
                  <c:v>1.0471204188481699E-2</c:v>
                </c:pt>
                <c:pt idx="26">
                  <c:v>2.6178010471204216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5"/>
          <c:order val="15"/>
          <c:tx>
            <c:strRef>
              <c:f>'nmr-1(ak4)_A1_0.02_50%'!$Q$104</c:f>
              <c:strCache>
                <c:ptCount val="1"/>
                <c:pt idx="0">
                  <c:v>nmr-1(ak4)_A1_16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Q$105:$Q$135</c:f>
              <c:numCache>
                <c:formatCode>General</c:formatCode>
                <c:ptCount val="31"/>
                <c:pt idx="1">
                  <c:v>7.1038251366120214E-2</c:v>
                </c:pt>
                <c:pt idx="2">
                  <c:v>6.0109289617486315E-2</c:v>
                </c:pt>
                <c:pt idx="3">
                  <c:v>5.4644808743169369E-2</c:v>
                </c:pt>
                <c:pt idx="4">
                  <c:v>4.3715846994535498E-2</c:v>
                </c:pt>
                <c:pt idx="5">
                  <c:v>4.91803278688525E-2</c:v>
                </c:pt>
                <c:pt idx="6">
                  <c:v>4.3715846994535498E-2</c:v>
                </c:pt>
                <c:pt idx="7">
                  <c:v>3.2786885245901599E-2</c:v>
                </c:pt>
                <c:pt idx="8">
                  <c:v>1.0928961748633904E-2</c:v>
                </c:pt>
                <c:pt idx="9">
                  <c:v>6.0109289617486315E-2</c:v>
                </c:pt>
                <c:pt idx="10">
                  <c:v>7.650273224043723E-2</c:v>
                </c:pt>
                <c:pt idx="11">
                  <c:v>3.8251366120218601E-2</c:v>
                </c:pt>
                <c:pt idx="12">
                  <c:v>5.4644808743169369E-2</c:v>
                </c:pt>
                <c:pt idx="13">
                  <c:v>4.91803278688525E-2</c:v>
                </c:pt>
                <c:pt idx="14">
                  <c:v>3.8251366120218601E-2</c:v>
                </c:pt>
                <c:pt idx="15">
                  <c:v>5.4644808743169369E-2</c:v>
                </c:pt>
                <c:pt idx="16">
                  <c:v>3.8251366120218601E-2</c:v>
                </c:pt>
                <c:pt idx="17">
                  <c:v>3.2786885245901599E-2</c:v>
                </c:pt>
                <c:pt idx="18">
                  <c:v>4.91803278688525E-2</c:v>
                </c:pt>
                <c:pt idx="19">
                  <c:v>2.1857923497267808E-2</c:v>
                </c:pt>
                <c:pt idx="20">
                  <c:v>2.7322404371584685E-2</c:v>
                </c:pt>
                <c:pt idx="21">
                  <c:v>1.63934426229508E-2</c:v>
                </c:pt>
                <c:pt idx="22">
                  <c:v>5.4644808743169382E-3</c:v>
                </c:pt>
                <c:pt idx="23">
                  <c:v>2.1857923497267808E-2</c:v>
                </c:pt>
                <c:pt idx="24">
                  <c:v>1.0928961748633904E-2</c:v>
                </c:pt>
                <c:pt idx="25">
                  <c:v>5.4644808743169382E-3</c:v>
                </c:pt>
                <c:pt idx="26">
                  <c:v>5.4644808743169382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6"/>
          <c:order val="16"/>
          <c:tx>
            <c:strRef>
              <c:f>'nmr-1(ak4)_A1_0.02_50%'!$R$104</c:f>
              <c:strCache>
                <c:ptCount val="1"/>
                <c:pt idx="0">
                  <c:v>nmr-1(ak4)_A1_17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R$105:$R$135</c:f>
              <c:numCache>
                <c:formatCode>General</c:formatCode>
                <c:ptCount val="31"/>
                <c:pt idx="1">
                  <c:v>4.8158640226628913E-2</c:v>
                </c:pt>
                <c:pt idx="2">
                  <c:v>1.4164305949008504E-2</c:v>
                </c:pt>
                <c:pt idx="3">
                  <c:v>1.4164305949008504E-2</c:v>
                </c:pt>
                <c:pt idx="4">
                  <c:v>1.6997167138810203E-2</c:v>
                </c:pt>
                <c:pt idx="5">
                  <c:v>3.6827195467422122E-2</c:v>
                </c:pt>
                <c:pt idx="6">
                  <c:v>2.2662889518413609E-2</c:v>
                </c:pt>
                <c:pt idx="7">
                  <c:v>2.2662889518413609E-2</c:v>
                </c:pt>
                <c:pt idx="8">
                  <c:v>1.1331444759206801E-2</c:v>
                </c:pt>
                <c:pt idx="9">
                  <c:v>2.5495750708215314E-2</c:v>
                </c:pt>
                <c:pt idx="10">
                  <c:v>3.1161473087818699E-2</c:v>
                </c:pt>
                <c:pt idx="11">
                  <c:v>5.6657223796033995E-2</c:v>
                </c:pt>
                <c:pt idx="12">
                  <c:v>6.2322946175637418E-2</c:v>
                </c:pt>
                <c:pt idx="13">
                  <c:v>7.365439093484423E-2</c:v>
                </c:pt>
                <c:pt idx="14">
                  <c:v>7.365439093484423E-2</c:v>
                </c:pt>
                <c:pt idx="15">
                  <c:v>9.0651558073654451E-2</c:v>
                </c:pt>
                <c:pt idx="16">
                  <c:v>5.9490084985835745E-2</c:v>
                </c:pt>
                <c:pt idx="17">
                  <c:v>7.648725212464591E-2</c:v>
                </c:pt>
                <c:pt idx="18">
                  <c:v>5.3824362606232287E-2</c:v>
                </c:pt>
                <c:pt idx="19">
                  <c:v>7.0821529745042494E-2</c:v>
                </c:pt>
                <c:pt idx="20">
                  <c:v>2.8328611898016991E-2</c:v>
                </c:pt>
                <c:pt idx="21">
                  <c:v>3.6827195467422122E-2</c:v>
                </c:pt>
                <c:pt idx="22">
                  <c:v>1.6997167138810203E-2</c:v>
                </c:pt>
                <c:pt idx="23">
                  <c:v>1.6997167138810203E-2</c:v>
                </c:pt>
                <c:pt idx="24">
                  <c:v>5.6657223796033997E-3</c:v>
                </c:pt>
                <c:pt idx="25">
                  <c:v>8.4985835694051035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nmr-1(ak4)_A1_0.02_50%'!$S$104</c:f>
              <c:strCache>
                <c:ptCount val="1"/>
                <c:pt idx="0">
                  <c:v>nmr-1(ak4)_A1_18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S$105:$S$135</c:f>
              <c:numCache>
                <c:formatCode>General</c:formatCode>
                <c:ptCount val="31"/>
                <c:pt idx="1">
                  <c:v>5.3949903660886284E-2</c:v>
                </c:pt>
                <c:pt idx="2">
                  <c:v>6.9364161849711059E-2</c:v>
                </c:pt>
                <c:pt idx="3">
                  <c:v>4.6242774566473979E-2</c:v>
                </c:pt>
                <c:pt idx="4">
                  <c:v>6.1657032755298713E-2</c:v>
                </c:pt>
                <c:pt idx="5">
                  <c:v>5.0096339113680236E-2</c:v>
                </c:pt>
                <c:pt idx="6">
                  <c:v>5.3949903660886284E-2</c:v>
                </c:pt>
                <c:pt idx="7">
                  <c:v>6.1657032755298713E-2</c:v>
                </c:pt>
                <c:pt idx="8">
                  <c:v>5.5876685934489419E-2</c:v>
                </c:pt>
                <c:pt idx="9">
                  <c:v>6.7437379576107903E-2</c:v>
                </c:pt>
                <c:pt idx="10">
                  <c:v>7.3217726396917093E-2</c:v>
                </c:pt>
                <c:pt idx="11">
                  <c:v>3.8535645472061723E-2</c:v>
                </c:pt>
                <c:pt idx="12">
                  <c:v>5.5876685934489419E-2</c:v>
                </c:pt>
                <c:pt idx="13">
                  <c:v>4.81695568400771E-2</c:v>
                </c:pt>
                <c:pt idx="14">
                  <c:v>5.2023121387283211E-2</c:v>
                </c:pt>
                <c:pt idx="15">
                  <c:v>3.8535645472061723E-2</c:v>
                </c:pt>
                <c:pt idx="16">
                  <c:v>3.6608863198458602E-2</c:v>
                </c:pt>
                <c:pt idx="17">
                  <c:v>4.046242774566472E-2</c:v>
                </c:pt>
                <c:pt idx="18">
                  <c:v>1.7341040462427702E-2</c:v>
                </c:pt>
                <c:pt idx="19">
                  <c:v>1.3487475915221604E-2</c:v>
                </c:pt>
                <c:pt idx="20">
                  <c:v>7.7071290944123357E-3</c:v>
                </c:pt>
                <c:pt idx="21">
                  <c:v>1.5414258188824699E-2</c:v>
                </c:pt>
                <c:pt idx="22">
                  <c:v>3.8535645472061726E-3</c:v>
                </c:pt>
                <c:pt idx="23">
                  <c:v>0</c:v>
                </c:pt>
                <c:pt idx="24">
                  <c:v>5.7803468208092517E-3</c:v>
                </c:pt>
                <c:pt idx="25">
                  <c:v>0</c:v>
                </c:pt>
                <c:pt idx="26">
                  <c:v>1.9267822736030809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8"/>
          <c:order val="18"/>
          <c:tx>
            <c:strRef>
              <c:f>'nmr-1(ak4)_A1_0.02_50%'!$T$104</c:f>
              <c:strCache>
                <c:ptCount val="1"/>
                <c:pt idx="0">
                  <c:v>nmr-1(ak4)_A1_20</c:v>
                </c:pt>
              </c:strCache>
            </c:strRef>
          </c:tx>
          <c:marker>
            <c:symbol val="none"/>
          </c:marker>
          <c:cat>
            <c:numRef>
              <c:f>'nmr-1(ak4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mr-1(ak4)_A1_0.02_50%'!$T$105:$T$135</c:f>
              <c:numCache>
                <c:formatCode>General</c:formatCode>
                <c:ptCount val="31"/>
                <c:pt idx="1">
                  <c:v>3.0000000000000002E-2</c:v>
                </c:pt>
                <c:pt idx="2">
                  <c:v>3.500000000000001E-2</c:v>
                </c:pt>
                <c:pt idx="3">
                  <c:v>3.7500000000000006E-2</c:v>
                </c:pt>
                <c:pt idx="4">
                  <c:v>2.5000000000000001E-2</c:v>
                </c:pt>
                <c:pt idx="5">
                  <c:v>4.7500000000000014E-2</c:v>
                </c:pt>
                <c:pt idx="6">
                  <c:v>2.2500000000000006E-2</c:v>
                </c:pt>
                <c:pt idx="7">
                  <c:v>2.2500000000000006E-2</c:v>
                </c:pt>
                <c:pt idx="8">
                  <c:v>2.7500000000000007E-2</c:v>
                </c:pt>
                <c:pt idx="9">
                  <c:v>3.2500000000000001E-2</c:v>
                </c:pt>
                <c:pt idx="10">
                  <c:v>3.7500000000000006E-2</c:v>
                </c:pt>
                <c:pt idx="11">
                  <c:v>4.5000000000000012E-2</c:v>
                </c:pt>
                <c:pt idx="12">
                  <c:v>8.5000000000000006E-2</c:v>
                </c:pt>
                <c:pt idx="13">
                  <c:v>6.0000000000000019E-2</c:v>
                </c:pt>
                <c:pt idx="14">
                  <c:v>6.7500000000000004E-2</c:v>
                </c:pt>
                <c:pt idx="15">
                  <c:v>0.10249999999999998</c:v>
                </c:pt>
                <c:pt idx="16">
                  <c:v>6.7500000000000004E-2</c:v>
                </c:pt>
                <c:pt idx="17">
                  <c:v>5.7500000000000016E-2</c:v>
                </c:pt>
                <c:pt idx="18">
                  <c:v>4.5000000000000012E-2</c:v>
                </c:pt>
                <c:pt idx="19">
                  <c:v>3.2500000000000001E-2</c:v>
                </c:pt>
                <c:pt idx="20">
                  <c:v>2.0000000000000007E-2</c:v>
                </c:pt>
                <c:pt idx="21">
                  <c:v>2.5000000000000001E-2</c:v>
                </c:pt>
                <c:pt idx="22">
                  <c:v>2.5000000000000001E-2</c:v>
                </c:pt>
                <c:pt idx="23">
                  <c:v>1.4999999999999998E-2</c:v>
                </c:pt>
                <c:pt idx="24">
                  <c:v>2.5000000000000009E-3</c:v>
                </c:pt>
                <c:pt idx="25">
                  <c:v>5.0000000000000018E-3</c:v>
                </c:pt>
                <c:pt idx="26">
                  <c:v>0</c:v>
                </c:pt>
                <c:pt idx="27">
                  <c:v>2.5000000000000009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marker val="1"/>
        <c:axId val="165683200"/>
        <c:axId val="165684736"/>
      </c:lineChart>
      <c:catAx>
        <c:axId val="165683200"/>
        <c:scaling>
          <c:orientation val="minMax"/>
        </c:scaling>
        <c:axPos val="b"/>
        <c:numFmt formatCode="0.0_ " sourceLinked="1"/>
        <c:tickLblPos val="nextTo"/>
        <c:crossAx val="165684736"/>
        <c:crosses val="autoZero"/>
        <c:auto val="1"/>
        <c:lblAlgn val="ctr"/>
        <c:lblOffset val="100"/>
        <c:tickLblSkip val="5"/>
        <c:tickMarkSkip val="5"/>
      </c:catAx>
      <c:valAx>
        <c:axId val="165684736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5683200"/>
        <c:crosses val="autoZero"/>
        <c:crossBetween val="between"/>
      </c:valAx>
    </c:plotArea>
    <c:plotVisOnly val="1"/>
  </c:chart>
  <c:externalData r:id="rId1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glr-1</a:t>
            </a:r>
            <a:r>
              <a:rPr lang="en-US" altLang="ja-JP" sz="1400" b="0" baseline="0" dirty="0">
                <a:latin typeface="Arial" pitchFamily="34" charset="0"/>
                <a:cs typeface="Arial" pitchFamily="34" charset="0"/>
              </a:rPr>
              <a:t> A5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glr-1(n2461)_A5_0.02_50%'!$B$104</c:f>
              <c:strCache>
                <c:ptCount val="1"/>
                <c:pt idx="0">
                  <c:v>glr-1(n2461)_A5_01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B$105:$B$135</c:f>
              <c:numCache>
                <c:formatCode>General</c:formatCode>
                <c:ptCount val="31"/>
                <c:pt idx="1">
                  <c:v>2.2727272727272717E-2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2.2727272727272717E-2</c:v>
                </c:pt>
                <c:pt idx="10">
                  <c:v>2.2727272727272717E-2</c:v>
                </c:pt>
                <c:pt idx="11">
                  <c:v>0</c:v>
                </c:pt>
                <c:pt idx="12">
                  <c:v>2.2727272727272717E-2</c:v>
                </c:pt>
                <c:pt idx="13">
                  <c:v>0</c:v>
                </c:pt>
                <c:pt idx="14">
                  <c:v>2.2727272727272717E-2</c:v>
                </c:pt>
                <c:pt idx="15">
                  <c:v>2.2727272727272717E-2</c:v>
                </c:pt>
                <c:pt idx="16">
                  <c:v>6.8181818181818205E-2</c:v>
                </c:pt>
                <c:pt idx="17">
                  <c:v>0.11363636363636398</c:v>
                </c:pt>
                <c:pt idx="18">
                  <c:v>0.11363636363636398</c:v>
                </c:pt>
                <c:pt idx="19">
                  <c:v>6.8181818181818205E-2</c:v>
                </c:pt>
                <c:pt idx="20">
                  <c:v>0.15909090909090906</c:v>
                </c:pt>
                <c:pt idx="21">
                  <c:v>4.5454545454545497E-2</c:v>
                </c:pt>
                <c:pt idx="22">
                  <c:v>2.2727272727272717E-2</c:v>
                </c:pt>
                <c:pt idx="23">
                  <c:v>9.0909090909090939E-2</c:v>
                </c:pt>
                <c:pt idx="24">
                  <c:v>4.5454545454545497E-2</c:v>
                </c:pt>
                <c:pt idx="25">
                  <c:v>2.2727272727272717E-2</c:v>
                </c:pt>
                <c:pt idx="26">
                  <c:v>2.2727272727272717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2.2727272727272717E-2</c:v>
                </c:pt>
              </c:numCache>
            </c:numRef>
          </c:val>
        </c:ser>
        <c:ser>
          <c:idx val="1"/>
          <c:order val="1"/>
          <c:tx>
            <c:strRef>
              <c:f>'glr-1(n2461)_A5_0.02_50%'!$C$104</c:f>
              <c:strCache>
                <c:ptCount val="1"/>
                <c:pt idx="0">
                  <c:v>glr-1(n2461)_A5_02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C$105:$C$135</c:f>
              <c:numCache>
                <c:formatCode>General</c:formatCode>
                <c:ptCount val="31"/>
                <c:pt idx="1">
                  <c:v>0</c:v>
                </c:pt>
                <c:pt idx="2">
                  <c:v>7.1428571428571418E-3</c:v>
                </c:pt>
                <c:pt idx="3">
                  <c:v>7.1428571428571418E-3</c:v>
                </c:pt>
                <c:pt idx="4">
                  <c:v>7.1428571428571418E-3</c:v>
                </c:pt>
                <c:pt idx="5">
                  <c:v>7.1428571428571418E-3</c:v>
                </c:pt>
                <c:pt idx="6">
                  <c:v>1.4285714285714301E-2</c:v>
                </c:pt>
                <c:pt idx="7">
                  <c:v>0</c:v>
                </c:pt>
                <c:pt idx="8">
                  <c:v>0</c:v>
                </c:pt>
                <c:pt idx="9">
                  <c:v>2.1428571428571408E-2</c:v>
                </c:pt>
                <c:pt idx="10">
                  <c:v>1.4285714285714301E-2</c:v>
                </c:pt>
                <c:pt idx="11">
                  <c:v>3.5714285714285698E-2</c:v>
                </c:pt>
                <c:pt idx="12">
                  <c:v>3.5714285714285698E-2</c:v>
                </c:pt>
                <c:pt idx="13">
                  <c:v>6.4285714285714293E-2</c:v>
                </c:pt>
                <c:pt idx="14">
                  <c:v>7.1428571428571411E-2</c:v>
                </c:pt>
                <c:pt idx="15">
                  <c:v>6.4285714285714293E-2</c:v>
                </c:pt>
                <c:pt idx="16">
                  <c:v>4.2857142857142913E-2</c:v>
                </c:pt>
                <c:pt idx="17">
                  <c:v>7.1428571428571411E-2</c:v>
                </c:pt>
                <c:pt idx="18">
                  <c:v>7.8571428571428598E-2</c:v>
                </c:pt>
                <c:pt idx="19">
                  <c:v>8.5714285714285701E-2</c:v>
                </c:pt>
                <c:pt idx="20">
                  <c:v>4.2857142857142913E-2</c:v>
                </c:pt>
                <c:pt idx="21">
                  <c:v>7.1428571428571411E-2</c:v>
                </c:pt>
                <c:pt idx="22">
                  <c:v>1.4285714285714301E-2</c:v>
                </c:pt>
                <c:pt idx="23">
                  <c:v>3.5714285714285698E-2</c:v>
                </c:pt>
                <c:pt idx="24">
                  <c:v>2.1428571428571408E-2</c:v>
                </c:pt>
                <c:pt idx="25">
                  <c:v>3.5714285714285698E-2</c:v>
                </c:pt>
                <c:pt idx="26">
                  <c:v>1.4285714285714301E-2</c:v>
                </c:pt>
                <c:pt idx="27">
                  <c:v>2.8571428571428602E-2</c:v>
                </c:pt>
                <c:pt idx="28">
                  <c:v>2.1428571428571408E-2</c:v>
                </c:pt>
                <c:pt idx="29">
                  <c:v>1.4285714285714301E-2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glr-1(n2461)_A5_0.02_50%'!$D$104</c:f>
              <c:strCache>
                <c:ptCount val="1"/>
                <c:pt idx="0">
                  <c:v>glr-1(n2461)_A5_03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D$105:$D$135</c:f>
              <c:numCache>
                <c:formatCode>General</c:formatCode>
                <c:ptCount val="31"/>
                <c:pt idx="1">
                  <c:v>2.0942408376963401E-2</c:v>
                </c:pt>
                <c:pt idx="2">
                  <c:v>5.235602094240845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5.235602094240845E-3</c:v>
                </c:pt>
                <c:pt idx="7">
                  <c:v>0</c:v>
                </c:pt>
                <c:pt idx="8">
                  <c:v>0</c:v>
                </c:pt>
                <c:pt idx="9">
                  <c:v>5.235602094240845E-3</c:v>
                </c:pt>
                <c:pt idx="10">
                  <c:v>1.0471204188481699E-2</c:v>
                </c:pt>
                <c:pt idx="11">
                  <c:v>2.0942408376963401E-2</c:v>
                </c:pt>
                <c:pt idx="12">
                  <c:v>3.1413612565445018E-2</c:v>
                </c:pt>
                <c:pt idx="13">
                  <c:v>3.6649214659685923E-2</c:v>
                </c:pt>
                <c:pt idx="14">
                  <c:v>6.2827225130889994E-2</c:v>
                </c:pt>
                <c:pt idx="15">
                  <c:v>0.10994764397905803</c:v>
                </c:pt>
                <c:pt idx="16">
                  <c:v>0.10994764397905803</c:v>
                </c:pt>
                <c:pt idx="17">
                  <c:v>0.146596858638743</c:v>
                </c:pt>
                <c:pt idx="18">
                  <c:v>0.10994764397905803</c:v>
                </c:pt>
                <c:pt idx="19">
                  <c:v>9.9476439790575896E-2</c:v>
                </c:pt>
                <c:pt idx="20">
                  <c:v>3.6649214659685923E-2</c:v>
                </c:pt>
                <c:pt idx="21">
                  <c:v>5.7591623036649234E-2</c:v>
                </c:pt>
                <c:pt idx="22">
                  <c:v>3.1413612565445018E-2</c:v>
                </c:pt>
                <c:pt idx="23">
                  <c:v>2.6178010471204216E-2</c:v>
                </c:pt>
                <c:pt idx="24">
                  <c:v>2.6178010471204216E-2</c:v>
                </c:pt>
                <c:pt idx="25">
                  <c:v>1.5706806282722505E-2</c:v>
                </c:pt>
                <c:pt idx="26">
                  <c:v>5.235602094240845E-3</c:v>
                </c:pt>
                <c:pt idx="27">
                  <c:v>0</c:v>
                </c:pt>
                <c:pt idx="28">
                  <c:v>5.235602094240845E-3</c:v>
                </c:pt>
                <c:pt idx="29">
                  <c:v>5.235602094240845E-3</c:v>
                </c:pt>
                <c:pt idx="30">
                  <c:v>1.0471204188481699E-2</c:v>
                </c:pt>
              </c:numCache>
            </c:numRef>
          </c:val>
        </c:ser>
        <c:ser>
          <c:idx val="3"/>
          <c:order val="3"/>
          <c:tx>
            <c:strRef>
              <c:f>'glr-1(n2461)_A5_0.02_50%'!$E$104</c:f>
              <c:strCache>
                <c:ptCount val="1"/>
                <c:pt idx="0">
                  <c:v>glr-1(n2461)_A5_04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E$105:$E$135</c:f>
              <c:numCache>
                <c:formatCode>General</c:formatCode>
                <c:ptCount val="31"/>
                <c:pt idx="1">
                  <c:v>0</c:v>
                </c:pt>
                <c:pt idx="2">
                  <c:v>5.4054054054054118E-3</c:v>
                </c:pt>
                <c:pt idx="3">
                  <c:v>1.0810810810810801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5.4054054054054118E-3</c:v>
                </c:pt>
                <c:pt idx="13">
                  <c:v>1.0810810810810801E-2</c:v>
                </c:pt>
                <c:pt idx="14">
                  <c:v>4.86486486486487E-2</c:v>
                </c:pt>
                <c:pt idx="15">
                  <c:v>0.10270270270270303</c:v>
                </c:pt>
                <c:pt idx="16">
                  <c:v>6.4864864864864896E-2</c:v>
                </c:pt>
                <c:pt idx="17">
                  <c:v>0.11351351351351402</c:v>
                </c:pt>
                <c:pt idx="18">
                  <c:v>0.15675675675675699</c:v>
                </c:pt>
                <c:pt idx="19">
                  <c:v>0.14594594594594607</c:v>
                </c:pt>
                <c:pt idx="20">
                  <c:v>9.7297297297297303E-2</c:v>
                </c:pt>
                <c:pt idx="21">
                  <c:v>5.9459459459459497E-2</c:v>
                </c:pt>
                <c:pt idx="22">
                  <c:v>4.3243243243243197E-2</c:v>
                </c:pt>
                <c:pt idx="23">
                  <c:v>3.7837837837837812E-2</c:v>
                </c:pt>
                <c:pt idx="24">
                  <c:v>3.7837837837837812E-2</c:v>
                </c:pt>
                <c:pt idx="25">
                  <c:v>1.62162162162162E-2</c:v>
                </c:pt>
                <c:pt idx="26">
                  <c:v>1.0810810810810801E-2</c:v>
                </c:pt>
                <c:pt idx="27">
                  <c:v>1.0810810810810801E-2</c:v>
                </c:pt>
                <c:pt idx="28">
                  <c:v>1.0810810810810801E-2</c:v>
                </c:pt>
                <c:pt idx="29">
                  <c:v>5.4054054054054118E-3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glr-1(n2461)_A5_0.02_50%'!$F$104</c:f>
              <c:strCache>
                <c:ptCount val="1"/>
                <c:pt idx="0">
                  <c:v>glr-1(n2461)_A5_05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F$105:$F$135</c:f>
              <c:numCache>
                <c:formatCode>General</c:formatCode>
                <c:ptCount val="31"/>
              </c:numCache>
            </c:numRef>
          </c:val>
        </c:ser>
        <c:ser>
          <c:idx val="5"/>
          <c:order val="5"/>
          <c:tx>
            <c:strRef>
              <c:f>'glr-1(n2461)_A5_0.02_50%'!$G$104</c:f>
              <c:strCache>
                <c:ptCount val="1"/>
                <c:pt idx="0">
                  <c:v>glr-1(n2461)_A5_06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G$105:$G$135</c:f>
              <c:numCache>
                <c:formatCode>General</c:formatCode>
                <c:ptCount val="31"/>
                <c:pt idx="1">
                  <c:v>8.5889570552147201E-2</c:v>
                </c:pt>
                <c:pt idx="2">
                  <c:v>3.680981595092022E-2</c:v>
                </c:pt>
                <c:pt idx="3">
                  <c:v>3.0674846625766916E-2</c:v>
                </c:pt>
                <c:pt idx="4">
                  <c:v>3.680981595092022E-2</c:v>
                </c:pt>
                <c:pt idx="5">
                  <c:v>1.2269938650306698E-2</c:v>
                </c:pt>
                <c:pt idx="6">
                  <c:v>1.2269938650306698E-2</c:v>
                </c:pt>
                <c:pt idx="7">
                  <c:v>1.84049079754601E-2</c:v>
                </c:pt>
                <c:pt idx="8">
                  <c:v>6.1349693251533735E-3</c:v>
                </c:pt>
                <c:pt idx="9">
                  <c:v>3.0674846625766916E-2</c:v>
                </c:pt>
                <c:pt idx="10">
                  <c:v>2.4539877300613518E-2</c:v>
                </c:pt>
                <c:pt idx="11">
                  <c:v>1.84049079754601E-2</c:v>
                </c:pt>
                <c:pt idx="12">
                  <c:v>1.2269938650306698E-2</c:v>
                </c:pt>
                <c:pt idx="13">
                  <c:v>2.4539877300613518E-2</c:v>
                </c:pt>
                <c:pt idx="14">
                  <c:v>4.9079754601227002E-2</c:v>
                </c:pt>
                <c:pt idx="15">
                  <c:v>4.2944785276073601E-2</c:v>
                </c:pt>
                <c:pt idx="16">
                  <c:v>6.7484662576687102E-2</c:v>
                </c:pt>
                <c:pt idx="17">
                  <c:v>3.0674846625766916E-2</c:v>
                </c:pt>
                <c:pt idx="18">
                  <c:v>7.3619631901840538E-2</c:v>
                </c:pt>
                <c:pt idx="19">
                  <c:v>1.2269938650306698E-2</c:v>
                </c:pt>
                <c:pt idx="20">
                  <c:v>3.680981595092022E-2</c:v>
                </c:pt>
                <c:pt idx="21">
                  <c:v>2.4539877300613518E-2</c:v>
                </c:pt>
                <c:pt idx="22">
                  <c:v>1.84049079754601E-2</c:v>
                </c:pt>
                <c:pt idx="23">
                  <c:v>1.84049079754601E-2</c:v>
                </c:pt>
                <c:pt idx="24">
                  <c:v>2.4539877300613518E-2</c:v>
                </c:pt>
                <c:pt idx="25">
                  <c:v>1.84049079754601E-2</c:v>
                </c:pt>
                <c:pt idx="26">
                  <c:v>6.1349693251533735E-3</c:v>
                </c:pt>
                <c:pt idx="27">
                  <c:v>6.1349693251533735E-3</c:v>
                </c:pt>
                <c:pt idx="28">
                  <c:v>6.1349693251533735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6"/>
          <c:order val="6"/>
          <c:tx>
            <c:strRef>
              <c:f>'glr-1(n2461)_A5_0.02_50%'!$H$104</c:f>
              <c:strCache>
                <c:ptCount val="1"/>
                <c:pt idx="0">
                  <c:v>glr-1(n2461)_A5_07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H$105:$H$135</c:f>
              <c:numCache>
                <c:formatCode>General</c:formatCode>
                <c:ptCount val="31"/>
                <c:pt idx="1">
                  <c:v>3.0075187969924817E-2</c:v>
                </c:pt>
                <c:pt idx="2">
                  <c:v>3.0075187969924817E-2</c:v>
                </c:pt>
                <c:pt idx="3">
                  <c:v>2.2556390977443608E-2</c:v>
                </c:pt>
                <c:pt idx="4">
                  <c:v>1.50375939849624E-2</c:v>
                </c:pt>
                <c:pt idx="5">
                  <c:v>7.5187969924812035E-3</c:v>
                </c:pt>
                <c:pt idx="6">
                  <c:v>7.5187969924812035E-3</c:v>
                </c:pt>
                <c:pt idx="7">
                  <c:v>0</c:v>
                </c:pt>
                <c:pt idx="8">
                  <c:v>1.50375939849624E-2</c:v>
                </c:pt>
                <c:pt idx="9">
                  <c:v>1.50375939849624E-2</c:v>
                </c:pt>
                <c:pt idx="10">
                  <c:v>1.50375939849624E-2</c:v>
                </c:pt>
                <c:pt idx="11">
                  <c:v>7.5187969924812035E-3</c:v>
                </c:pt>
                <c:pt idx="12">
                  <c:v>3.7593984962405999E-2</c:v>
                </c:pt>
                <c:pt idx="13">
                  <c:v>2.2556390977443608E-2</c:v>
                </c:pt>
                <c:pt idx="14">
                  <c:v>1.50375939849624E-2</c:v>
                </c:pt>
                <c:pt idx="15">
                  <c:v>5.2631578947368404E-2</c:v>
                </c:pt>
                <c:pt idx="16">
                  <c:v>3.7593984962405999E-2</c:v>
                </c:pt>
                <c:pt idx="17">
                  <c:v>3.0075187969924817E-2</c:v>
                </c:pt>
                <c:pt idx="18">
                  <c:v>5.2631578947368404E-2</c:v>
                </c:pt>
                <c:pt idx="19">
                  <c:v>8.2706766917293242E-2</c:v>
                </c:pt>
                <c:pt idx="20">
                  <c:v>4.5112781954887243E-2</c:v>
                </c:pt>
                <c:pt idx="21">
                  <c:v>6.0150375939849621E-2</c:v>
                </c:pt>
                <c:pt idx="22">
                  <c:v>6.0150375939849621E-2</c:v>
                </c:pt>
                <c:pt idx="23">
                  <c:v>6.7669172932330809E-2</c:v>
                </c:pt>
                <c:pt idx="24">
                  <c:v>3.0075187969924817E-2</c:v>
                </c:pt>
                <c:pt idx="25">
                  <c:v>2.2556390977443608E-2</c:v>
                </c:pt>
                <c:pt idx="26">
                  <c:v>2.2556390977443608E-2</c:v>
                </c:pt>
                <c:pt idx="27">
                  <c:v>4.5112781954887243E-2</c:v>
                </c:pt>
                <c:pt idx="28">
                  <c:v>2.2556390977443608E-2</c:v>
                </c:pt>
                <c:pt idx="29">
                  <c:v>3.0075187969924817E-2</c:v>
                </c:pt>
                <c:pt idx="30">
                  <c:v>7.5187969924812035E-3</c:v>
                </c:pt>
              </c:numCache>
            </c:numRef>
          </c:val>
        </c:ser>
        <c:ser>
          <c:idx val="7"/>
          <c:order val="7"/>
          <c:tx>
            <c:strRef>
              <c:f>'glr-1(n2461)_A5_0.02_50%'!$I$104</c:f>
              <c:strCache>
                <c:ptCount val="1"/>
                <c:pt idx="0">
                  <c:v>glr-1(n2461)_A5_08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I$105:$I$135</c:f>
              <c:numCache>
                <c:formatCode>General</c:formatCode>
                <c:ptCount val="31"/>
                <c:pt idx="1">
                  <c:v>2.7522935779816515E-2</c:v>
                </c:pt>
                <c:pt idx="2">
                  <c:v>5.5045871559633003E-2</c:v>
                </c:pt>
                <c:pt idx="3">
                  <c:v>9.1743119266055103E-3</c:v>
                </c:pt>
                <c:pt idx="4">
                  <c:v>1.8348623853211E-2</c:v>
                </c:pt>
                <c:pt idx="5">
                  <c:v>0</c:v>
                </c:pt>
                <c:pt idx="6">
                  <c:v>0</c:v>
                </c:pt>
                <c:pt idx="7">
                  <c:v>9.1743119266055103E-3</c:v>
                </c:pt>
                <c:pt idx="8">
                  <c:v>9.1743119266055103E-3</c:v>
                </c:pt>
                <c:pt idx="9">
                  <c:v>0</c:v>
                </c:pt>
                <c:pt idx="10">
                  <c:v>0</c:v>
                </c:pt>
                <c:pt idx="11">
                  <c:v>1.8348623853211E-2</c:v>
                </c:pt>
                <c:pt idx="12">
                  <c:v>9.1743119266055103E-3</c:v>
                </c:pt>
                <c:pt idx="13">
                  <c:v>9.1743119266055103E-3</c:v>
                </c:pt>
                <c:pt idx="14">
                  <c:v>6.4220183486238494E-2</c:v>
                </c:pt>
                <c:pt idx="15">
                  <c:v>9.1743119266055079E-2</c:v>
                </c:pt>
                <c:pt idx="16">
                  <c:v>6.4220183486238494E-2</c:v>
                </c:pt>
                <c:pt idx="17">
                  <c:v>4.5871559633027484E-2</c:v>
                </c:pt>
                <c:pt idx="18">
                  <c:v>4.5871559633027484E-2</c:v>
                </c:pt>
                <c:pt idx="19">
                  <c:v>4.5871559633027484E-2</c:v>
                </c:pt>
                <c:pt idx="20">
                  <c:v>6.4220183486238494E-2</c:v>
                </c:pt>
                <c:pt idx="21">
                  <c:v>3.6697247706422027E-2</c:v>
                </c:pt>
                <c:pt idx="22">
                  <c:v>4.5871559633027484E-2</c:v>
                </c:pt>
                <c:pt idx="23">
                  <c:v>1.8348623853211E-2</c:v>
                </c:pt>
                <c:pt idx="24">
                  <c:v>4.5871559633027484E-2</c:v>
                </c:pt>
                <c:pt idx="25">
                  <c:v>1.8348623853211E-2</c:v>
                </c:pt>
                <c:pt idx="26">
                  <c:v>9.1743119266055103E-3</c:v>
                </c:pt>
                <c:pt idx="27">
                  <c:v>1.8348623853211E-2</c:v>
                </c:pt>
                <c:pt idx="28">
                  <c:v>1.8348623853211E-2</c:v>
                </c:pt>
                <c:pt idx="29">
                  <c:v>2.7522935779816515E-2</c:v>
                </c:pt>
                <c:pt idx="30">
                  <c:v>9.1743119266055103E-3</c:v>
                </c:pt>
              </c:numCache>
            </c:numRef>
          </c:val>
        </c:ser>
        <c:ser>
          <c:idx val="8"/>
          <c:order val="8"/>
          <c:tx>
            <c:strRef>
              <c:f>'glr-1(n2461)_A5_0.02_50%'!$J$104</c:f>
              <c:strCache>
                <c:ptCount val="1"/>
                <c:pt idx="0">
                  <c:v>glr-1(n2461)_A5_09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J$105:$J$135</c:f>
              <c:numCache>
                <c:formatCode>General</c:formatCode>
                <c:ptCount val="31"/>
                <c:pt idx="1">
                  <c:v>2.4539877300613518E-2</c:v>
                </c:pt>
                <c:pt idx="2">
                  <c:v>2.4539877300613518E-2</c:v>
                </c:pt>
                <c:pt idx="3">
                  <c:v>1.2269938650306698E-2</c:v>
                </c:pt>
                <c:pt idx="4">
                  <c:v>1.2269938650306698E-2</c:v>
                </c:pt>
                <c:pt idx="5">
                  <c:v>6.1349693251533735E-3</c:v>
                </c:pt>
                <c:pt idx="6">
                  <c:v>3.0674846625766916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6.1349693251533735E-3</c:v>
                </c:pt>
                <c:pt idx="12">
                  <c:v>1.2269938650306698E-2</c:v>
                </c:pt>
                <c:pt idx="13">
                  <c:v>1.84049079754601E-2</c:v>
                </c:pt>
                <c:pt idx="14">
                  <c:v>1.2269938650306698E-2</c:v>
                </c:pt>
                <c:pt idx="15">
                  <c:v>3.0674846625766916E-2</c:v>
                </c:pt>
                <c:pt idx="16">
                  <c:v>4.2944785276073601E-2</c:v>
                </c:pt>
                <c:pt idx="17">
                  <c:v>8.5889570552147201E-2</c:v>
                </c:pt>
                <c:pt idx="18">
                  <c:v>6.7484662576687102E-2</c:v>
                </c:pt>
                <c:pt idx="19">
                  <c:v>9.2024539877300596E-2</c:v>
                </c:pt>
                <c:pt idx="20">
                  <c:v>6.7484662576687102E-2</c:v>
                </c:pt>
                <c:pt idx="21">
                  <c:v>9.8159509202454032E-2</c:v>
                </c:pt>
                <c:pt idx="22">
                  <c:v>6.7484662576687102E-2</c:v>
                </c:pt>
                <c:pt idx="23">
                  <c:v>3.680981595092022E-2</c:v>
                </c:pt>
                <c:pt idx="24">
                  <c:v>3.680981595092022E-2</c:v>
                </c:pt>
                <c:pt idx="25">
                  <c:v>3.680981595092022E-2</c:v>
                </c:pt>
                <c:pt idx="26">
                  <c:v>4.2944785276073601E-2</c:v>
                </c:pt>
                <c:pt idx="27">
                  <c:v>1.2269938650306698E-2</c:v>
                </c:pt>
                <c:pt idx="28">
                  <c:v>3.0674846625766916E-2</c:v>
                </c:pt>
                <c:pt idx="29">
                  <c:v>6.1349693251533735E-3</c:v>
                </c:pt>
                <c:pt idx="30">
                  <c:v>1.84049079754601E-2</c:v>
                </c:pt>
              </c:numCache>
            </c:numRef>
          </c:val>
        </c:ser>
        <c:ser>
          <c:idx val="9"/>
          <c:order val="9"/>
          <c:tx>
            <c:strRef>
              <c:f>'glr-1(n2461)_A5_0.02_50%'!$K$104</c:f>
              <c:strCache>
                <c:ptCount val="1"/>
                <c:pt idx="0">
                  <c:v>glr-1(n2461)_A5_10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K$105:$K$135</c:f>
              <c:numCache>
                <c:formatCode>General</c:formatCode>
                <c:ptCount val="31"/>
                <c:pt idx="1">
                  <c:v>2.02020202020202E-2</c:v>
                </c:pt>
                <c:pt idx="2">
                  <c:v>5.0505050505050483E-3</c:v>
                </c:pt>
                <c:pt idx="3">
                  <c:v>2.02020202020202E-2</c:v>
                </c:pt>
                <c:pt idx="4">
                  <c:v>3.03030303030303E-2</c:v>
                </c:pt>
                <c:pt idx="5">
                  <c:v>1.01010101010101E-2</c:v>
                </c:pt>
                <c:pt idx="6">
                  <c:v>1.01010101010101E-2</c:v>
                </c:pt>
                <c:pt idx="7">
                  <c:v>5.0505050505050483E-3</c:v>
                </c:pt>
                <c:pt idx="8">
                  <c:v>0</c:v>
                </c:pt>
                <c:pt idx="9">
                  <c:v>5.0505050505050483E-3</c:v>
                </c:pt>
                <c:pt idx="10">
                  <c:v>1.5151515151515204E-2</c:v>
                </c:pt>
                <c:pt idx="11">
                  <c:v>2.02020202020202E-2</c:v>
                </c:pt>
                <c:pt idx="12">
                  <c:v>2.02020202020202E-2</c:v>
                </c:pt>
                <c:pt idx="13">
                  <c:v>1.01010101010101E-2</c:v>
                </c:pt>
                <c:pt idx="14">
                  <c:v>1.5151515151515204E-2</c:v>
                </c:pt>
                <c:pt idx="15">
                  <c:v>4.0404040404040401E-2</c:v>
                </c:pt>
                <c:pt idx="16">
                  <c:v>4.0404040404040401E-2</c:v>
                </c:pt>
                <c:pt idx="17">
                  <c:v>3.5353535353535401E-2</c:v>
                </c:pt>
                <c:pt idx="18">
                  <c:v>7.5757575757575801E-2</c:v>
                </c:pt>
                <c:pt idx="19">
                  <c:v>5.555555555555558E-2</c:v>
                </c:pt>
                <c:pt idx="20">
                  <c:v>8.5858585858585898E-2</c:v>
                </c:pt>
                <c:pt idx="21">
                  <c:v>8.0808080808080801E-2</c:v>
                </c:pt>
                <c:pt idx="22">
                  <c:v>7.0707070707070704E-2</c:v>
                </c:pt>
                <c:pt idx="23">
                  <c:v>6.5656565656565705E-2</c:v>
                </c:pt>
                <c:pt idx="24">
                  <c:v>4.5454545454545497E-2</c:v>
                </c:pt>
                <c:pt idx="25">
                  <c:v>6.0606060606060601E-2</c:v>
                </c:pt>
                <c:pt idx="26">
                  <c:v>2.5252525252525308E-2</c:v>
                </c:pt>
                <c:pt idx="27">
                  <c:v>1.5151515151515204E-2</c:v>
                </c:pt>
                <c:pt idx="28">
                  <c:v>2.02020202020202E-2</c:v>
                </c:pt>
                <c:pt idx="29">
                  <c:v>1.01010101010101E-2</c:v>
                </c:pt>
                <c:pt idx="30">
                  <c:v>2.02020202020202E-2</c:v>
                </c:pt>
              </c:numCache>
            </c:numRef>
          </c:val>
        </c:ser>
        <c:ser>
          <c:idx val="10"/>
          <c:order val="10"/>
          <c:tx>
            <c:strRef>
              <c:f>'glr-1(n2461)_A5_0.02_50%'!$L$104</c:f>
              <c:strCache>
                <c:ptCount val="1"/>
                <c:pt idx="0">
                  <c:v>glr-1(n2461)_A5_11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L$105:$L$135</c:f>
              <c:numCache>
                <c:formatCode>General</c:formatCode>
                <c:ptCount val="31"/>
                <c:pt idx="1">
                  <c:v>2.2099447513812213E-2</c:v>
                </c:pt>
                <c:pt idx="2">
                  <c:v>1.1049723756906101E-2</c:v>
                </c:pt>
                <c:pt idx="3">
                  <c:v>1.6574585635359108E-2</c:v>
                </c:pt>
                <c:pt idx="4">
                  <c:v>1.6574585635359108E-2</c:v>
                </c:pt>
                <c:pt idx="5">
                  <c:v>5.5248618784530384E-3</c:v>
                </c:pt>
                <c:pt idx="6">
                  <c:v>0</c:v>
                </c:pt>
                <c:pt idx="7">
                  <c:v>0</c:v>
                </c:pt>
                <c:pt idx="8">
                  <c:v>5.5248618784530384E-3</c:v>
                </c:pt>
                <c:pt idx="9">
                  <c:v>5.5248618784530384E-3</c:v>
                </c:pt>
                <c:pt idx="10">
                  <c:v>1.1049723756906101E-2</c:v>
                </c:pt>
                <c:pt idx="11">
                  <c:v>3.8674033149171311E-2</c:v>
                </c:pt>
                <c:pt idx="12">
                  <c:v>2.2099447513812213E-2</c:v>
                </c:pt>
                <c:pt idx="13">
                  <c:v>4.9723756906077318E-2</c:v>
                </c:pt>
                <c:pt idx="14">
                  <c:v>5.5248618784530384E-2</c:v>
                </c:pt>
                <c:pt idx="15">
                  <c:v>7.18232044198895E-2</c:v>
                </c:pt>
                <c:pt idx="16">
                  <c:v>9.3922651933701695E-2</c:v>
                </c:pt>
                <c:pt idx="17">
                  <c:v>6.0773480662983416E-2</c:v>
                </c:pt>
                <c:pt idx="18">
                  <c:v>5.5248618784530384E-2</c:v>
                </c:pt>
                <c:pt idx="19">
                  <c:v>4.9723756906077318E-2</c:v>
                </c:pt>
                <c:pt idx="20">
                  <c:v>6.6298342541436503E-2</c:v>
                </c:pt>
                <c:pt idx="21">
                  <c:v>2.2099447513812213E-2</c:v>
                </c:pt>
                <c:pt idx="22">
                  <c:v>2.2099447513812213E-2</c:v>
                </c:pt>
                <c:pt idx="23">
                  <c:v>4.9723756906077318E-2</c:v>
                </c:pt>
                <c:pt idx="24">
                  <c:v>2.7624309392265206E-2</c:v>
                </c:pt>
                <c:pt idx="25">
                  <c:v>1.6574585635359108E-2</c:v>
                </c:pt>
                <c:pt idx="26">
                  <c:v>5.5248618784530384E-3</c:v>
                </c:pt>
                <c:pt idx="27">
                  <c:v>1.6574585635359108E-2</c:v>
                </c:pt>
                <c:pt idx="28">
                  <c:v>1.6574585635359108E-2</c:v>
                </c:pt>
                <c:pt idx="29">
                  <c:v>1.1049723756906101E-2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glr-1(n2461)_A5_0.02_50%'!$M$104</c:f>
              <c:strCache>
                <c:ptCount val="1"/>
                <c:pt idx="0">
                  <c:v>glr-1(n2461)_A5_12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M$105:$M$135</c:f>
              <c:numCache>
                <c:formatCode>General</c:formatCode>
                <c:ptCount val="31"/>
                <c:pt idx="1">
                  <c:v>0.12921348314606715</c:v>
                </c:pt>
                <c:pt idx="2">
                  <c:v>7.3033707865168523E-2</c:v>
                </c:pt>
                <c:pt idx="3">
                  <c:v>2.2471910112359623E-2</c:v>
                </c:pt>
                <c:pt idx="4">
                  <c:v>2.8089887640449406E-2</c:v>
                </c:pt>
                <c:pt idx="5">
                  <c:v>3.9325842696629212E-2</c:v>
                </c:pt>
                <c:pt idx="6">
                  <c:v>3.3707865168539311E-2</c:v>
                </c:pt>
                <c:pt idx="7">
                  <c:v>1.6853932584269701E-2</c:v>
                </c:pt>
                <c:pt idx="8">
                  <c:v>3.9325842696629212E-2</c:v>
                </c:pt>
                <c:pt idx="9">
                  <c:v>3.3707865168539311E-2</c:v>
                </c:pt>
                <c:pt idx="10">
                  <c:v>2.8089887640449406E-2</c:v>
                </c:pt>
                <c:pt idx="11">
                  <c:v>4.49438202247191E-2</c:v>
                </c:pt>
                <c:pt idx="12">
                  <c:v>1.6853932584269701E-2</c:v>
                </c:pt>
                <c:pt idx="13">
                  <c:v>2.8089887640449406E-2</c:v>
                </c:pt>
                <c:pt idx="14">
                  <c:v>2.8089887640449406E-2</c:v>
                </c:pt>
                <c:pt idx="15">
                  <c:v>5.0561797752809015E-2</c:v>
                </c:pt>
                <c:pt idx="16">
                  <c:v>3.9325842696629212E-2</c:v>
                </c:pt>
                <c:pt idx="17">
                  <c:v>2.8089887640449406E-2</c:v>
                </c:pt>
                <c:pt idx="18">
                  <c:v>2.8089887640449406E-2</c:v>
                </c:pt>
                <c:pt idx="19">
                  <c:v>2.2471910112359623E-2</c:v>
                </c:pt>
                <c:pt idx="20">
                  <c:v>0</c:v>
                </c:pt>
                <c:pt idx="21">
                  <c:v>0</c:v>
                </c:pt>
                <c:pt idx="22">
                  <c:v>5.6179775280898884E-3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glr-1(n2461)_A5_0.02_50%'!$N$104</c:f>
              <c:strCache>
                <c:ptCount val="1"/>
                <c:pt idx="0">
                  <c:v>glr-1(n2461)_A5_13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N$105:$N$135</c:f>
              <c:numCache>
                <c:formatCode>General</c:formatCode>
                <c:ptCount val="31"/>
                <c:pt idx="1">
                  <c:v>0.125581395348837</c:v>
                </c:pt>
                <c:pt idx="2">
                  <c:v>8.8372093023255799E-2</c:v>
                </c:pt>
                <c:pt idx="3">
                  <c:v>5.1162790697674397E-2</c:v>
                </c:pt>
                <c:pt idx="4">
                  <c:v>3.25581395348837E-2</c:v>
                </c:pt>
                <c:pt idx="5">
                  <c:v>3.7209302325581416E-2</c:v>
                </c:pt>
                <c:pt idx="6">
                  <c:v>1.8604651162790701E-2</c:v>
                </c:pt>
                <c:pt idx="7">
                  <c:v>9.3023255813953504E-3</c:v>
                </c:pt>
                <c:pt idx="8">
                  <c:v>2.7906976744186001E-2</c:v>
                </c:pt>
                <c:pt idx="9">
                  <c:v>1.8604651162790701E-2</c:v>
                </c:pt>
                <c:pt idx="10">
                  <c:v>2.32558139534884E-2</c:v>
                </c:pt>
                <c:pt idx="11">
                  <c:v>2.7906976744186001E-2</c:v>
                </c:pt>
                <c:pt idx="12">
                  <c:v>2.32558139534884E-2</c:v>
                </c:pt>
                <c:pt idx="13">
                  <c:v>3.25581395348837E-2</c:v>
                </c:pt>
                <c:pt idx="14">
                  <c:v>1.8604651162790701E-2</c:v>
                </c:pt>
                <c:pt idx="15">
                  <c:v>1.8604651162790701E-2</c:v>
                </c:pt>
                <c:pt idx="16">
                  <c:v>2.32558139534884E-2</c:v>
                </c:pt>
                <c:pt idx="17">
                  <c:v>9.3023255813953504E-3</c:v>
                </c:pt>
                <c:pt idx="18">
                  <c:v>2.32558139534884E-2</c:v>
                </c:pt>
                <c:pt idx="19">
                  <c:v>1.3953488372093001E-2</c:v>
                </c:pt>
                <c:pt idx="20">
                  <c:v>9.3023255813953504E-3</c:v>
                </c:pt>
                <c:pt idx="21">
                  <c:v>9.3023255813953504E-3</c:v>
                </c:pt>
                <c:pt idx="22">
                  <c:v>0</c:v>
                </c:pt>
                <c:pt idx="23">
                  <c:v>1.3953488372093001E-2</c:v>
                </c:pt>
                <c:pt idx="24">
                  <c:v>1.8604651162790701E-2</c:v>
                </c:pt>
                <c:pt idx="25">
                  <c:v>4.6511627906976735E-3</c:v>
                </c:pt>
                <c:pt idx="26">
                  <c:v>0</c:v>
                </c:pt>
                <c:pt idx="27">
                  <c:v>4.6511627906976735E-3</c:v>
                </c:pt>
                <c:pt idx="28">
                  <c:v>0</c:v>
                </c:pt>
                <c:pt idx="29">
                  <c:v>4.6511627906976735E-3</c:v>
                </c:pt>
                <c:pt idx="30">
                  <c:v>4.6511627906976735E-3</c:v>
                </c:pt>
              </c:numCache>
            </c:numRef>
          </c:val>
        </c:ser>
        <c:ser>
          <c:idx val="13"/>
          <c:order val="13"/>
          <c:tx>
            <c:strRef>
              <c:f>'glr-1(n2461)_A5_0.02_50%'!$O$104</c:f>
              <c:strCache>
                <c:ptCount val="1"/>
                <c:pt idx="0">
                  <c:v>glr-1(n2461)_A5_14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O$105:$O$135</c:f>
              <c:numCache>
                <c:formatCode>General</c:formatCode>
                <c:ptCount val="31"/>
                <c:pt idx="1">
                  <c:v>2.9850746268656699E-2</c:v>
                </c:pt>
                <c:pt idx="2">
                  <c:v>9.9502487562189174E-3</c:v>
                </c:pt>
                <c:pt idx="3">
                  <c:v>9.9502487562189174E-3</c:v>
                </c:pt>
                <c:pt idx="4">
                  <c:v>9.9502487562189174E-3</c:v>
                </c:pt>
                <c:pt idx="5">
                  <c:v>4.9751243781094483E-3</c:v>
                </c:pt>
                <c:pt idx="6">
                  <c:v>0</c:v>
                </c:pt>
                <c:pt idx="7">
                  <c:v>9.9502487562189174E-3</c:v>
                </c:pt>
                <c:pt idx="8">
                  <c:v>0</c:v>
                </c:pt>
                <c:pt idx="9">
                  <c:v>4.9751243781094483E-3</c:v>
                </c:pt>
                <c:pt idx="10">
                  <c:v>9.9502487562189174E-3</c:v>
                </c:pt>
                <c:pt idx="11">
                  <c:v>9.9502487562189174E-3</c:v>
                </c:pt>
                <c:pt idx="12">
                  <c:v>0</c:v>
                </c:pt>
                <c:pt idx="13">
                  <c:v>1.4925373134328401E-2</c:v>
                </c:pt>
                <c:pt idx="14">
                  <c:v>1.9900497512437811E-2</c:v>
                </c:pt>
                <c:pt idx="15">
                  <c:v>3.9800995024875621E-2</c:v>
                </c:pt>
                <c:pt idx="16">
                  <c:v>4.9751243781094495E-2</c:v>
                </c:pt>
                <c:pt idx="17">
                  <c:v>5.9701492537313432E-2</c:v>
                </c:pt>
                <c:pt idx="18">
                  <c:v>6.4676616915422924E-2</c:v>
                </c:pt>
                <c:pt idx="19">
                  <c:v>0.119402985074627</c:v>
                </c:pt>
                <c:pt idx="20">
                  <c:v>5.4726368159204015E-2</c:v>
                </c:pt>
                <c:pt idx="21">
                  <c:v>8.955223880597013E-2</c:v>
                </c:pt>
                <c:pt idx="22">
                  <c:v>8.45771144278607E-2</c:v>
                </c:pt>
                <c:pt idx="23">
                  <c:v>5.9701492537313432E-2</c:v>
                </c:pt>
                <c:pt idx="24">
                  <c:v>3.4825870646766212E-2</c:v>
                </c:pt>
                <c:pt idx="25">
                  <c:v>2.9850746268656699E-2</c:v>
                </c:pt>
                <c:pt idx="26">
                  <c:v>1.9900497512437811E-2</c:v>
                </c:pt>
                <c:pt idx="27">
                  <c:v>2.9850746268656699E-2</c:v>
                </c:pt>
                <c:pt idx="28">
                  <c:v>1.4925373134328401E-2</c:v>
                </c:pt>
                <c:pt idx="29">
                  <c:v>1.4925373134328401E-2</c:v>
                </c:pt>
                <c:pt idx="30">
                  <c:v>1.4925373134328401E-2</c:v>
                </c:pt>
              </c:numCache>
            </c:numRef>
          </c:val>
        </c:ser>
        <c:ser>
          <c:idx val="14"/>
          <c:order val="14"/>
          <c:tx>
            <c:strRef>
              <c:f>'glr-1(n2461)_A5_0.02_50%'!$P$104</c:f>
              <c:strCache>
                <c:ptCount val="1"/>
                <c:pt idx="0">
                  <c:v>glr-1(n2461)_A5_15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P$105:$P$135</c:f>
              <c:numCache>
                <c:formatCode>General</c:formatCode>
                <c:ptCount val="31"/>
                <c:pt idx="1">
                  <c:v>9.9009900990099063E-3</c:v>
                </c:pt>
                <c:pt idx="2">
                  <c:v>1.9801980198019809E-2</c:v>
                </c:pt>
                <c:pt idx="3">
                  <c:v>0</c:v>
                </c:pt>
                <c:pt idx="4">
                  <c:v>0</c:v>
                </c:pt>
                <c:pt idx="5">
                  <c:v>4.9504950495049514E-3</c:v>
                </c:pt>
                <c:pt idx="6">
                  <c:v>1.4851485148514901E-2</c:v>
                </c:pt>
                <c:pt idx="7">
                  <c:v>0</c:v>
                </c:pt>
                <c:pt idx="8">
                  <c:v>4.9504950495049514E-3</c:v>
                </c:pt>
                <c:pt idx="9">
                  <c:v>9.9009900990099063E-3</c:v>
                </c:pt>
                <c:pt idx="10">
                  <c:v>4.9504950495049514E-3</c:v>
                </c:pt>
                <c:pt idx="11">
                  <c:v>4.9504950495049514E-3</c:v>
                </c:pt>
                <c:pt idx="12">
                  <c:v>9.9009900990099063E-3</c:v>
                </c:pt>
                <c:pt idx="13">
                  <c:v>1.4851485148514901E-2</c:v>
                </c:pt>
                <c:pt idx="14">
                  <c:v>4.95049504950495E-2</c:v>
                </c:pt>
                <c:pt idx="15">
                  <c:v>7.9207920792079195E-2</c:v>
                </c:pt>
                <c:pt idx="16">
                  <c:v>8.910891089108916E-2</c:v>
                </c:pt>
                <c:pt idx="17">
                  <c:v>8.4158415841584205E-2</c:v>
                </c:pt>
                <c:pt idx="18">
                  <c:v>7.425742574257431E-2</c:v>
                </c:pt>
                <c:pt idx="19">
                  <c:v>9.900990099009907E-2</c:v>
                </c:pt>
                <c:pt idx="20">
                  <c:v>8.910891089108916E-2</c:v>
                </c:pt>
                <c:pt idx="21">
                  <c:v>8.910891089108916E-2</c:v>
                </c:pt>
                <c:pt idx="22">
                  <c:v>5.9405940594059396E-2</c:v>
                </c:pt>
                <c:pt idx="23">
                  <c:v>3.4653465346534698E-2</c:v>
                </c:pt>
                <c:pt idx="24">
                  <c:v>3.4653465346534698E-2</c:v>
                </c:pt>
                <c:pt idx="25">
                  <c:v>1.4851485148514901E-2</c:v>
                </c:pt>
                <c:pt idx="26">
                  <c:v>3.9603960396039611E-2</c:v>
                </c:pt>
                <c:pt idx="27">
                  <c:v>9.9009900990099063E-3</c:v>
                </c:pt>
                <c:pt idx="28">
                  <c:v>4.9504950495049514E-3</c:v>
                </c:pt>
                <c:pt idx="29">
                  <c:v>0</c:v>
                </c:pt>
                <c:pt idx="30">
                  <c:v>4.9504950495049514E-3</c:v>
                </c:pt>
              </c:numCache>
            </c:numRef>
          </c:val>
        </c:ser>
        <c:ser>
          <c:idx val="15"/>
          <c:order val="15"/>
          <c:tx>
            <c:strRef>
              <c:f>'glr-1(n2461)_A5_0.02_50%'!$Q$104</c:f>
              <c:strCache>
                <c:ptCount val="1"/>
                <c:pt idx="0">
                  <c:v>glr-1(n2461)_A5_16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Q$105:$Q$135</c:f>
              <c:numCache>
                <c:formatCode>General</c:formatCode>
                <c:ptCount val="31"/>
                <c:pt idx="1">
                  <c:v>2.6785714285714319E-2</c:v>
                </c:pt>
                <c:pt idx="2">
                  <c:v>2.6785714285714319E-2</c:v>
                </c:pt>
                <c:pt idx="3">
                  <c:v>4.4642857142857097E-3</c:v>
                </c:pt>
                <c:pt idx="4">
                  <c:v>2.23214285714286E-2</c:v>
                </c:pt>
                <c:pt idx="5">
                  <c:v>1.3392857142857107E-2</c:v>
                </c:pt>
                <c:pt idx="6">
                  <c:v>1.3392857142857107E-2</c:v>
                </c:pt>
                <c:pt idx="7">
                  <c:v>4.4642857142857097E-3</c:v>
                </c:pt>
                <c:pt idx="8">
                  <c:v>2.23214285714286E-2</c:v>
                </c:pt>
                <c:pt idx="9">
                  <c:v>8.9285714285714229E-3</c:v>
                </c:pt>
                <c:pt idx="10">
                  <c:v>1.3392857142857107E-2</c:v>
                </c:pt>
                <c:pt idx="11">
                  <c:v>4.4642857142857097E-3</c:v>
                </c:pt>
                <c:pt idx="12">
                  <c:v>8.9285714285714229E-3</c:v>
                </c:pt>
                <c:pt idx="13">
                  <c:v>8.9285714285714229E-3</c:v>
                </c:pt>
                <c:pt idx="14">
                  <c:v>4.4642857142857097E-3</c:v>
                </c:pt>
                <c:pt idx="15">
                  <c:v>2.23214285714286E-2</c:v>
                </c:pt>
                <c:pt idx="16">
                  <c:v>2.23214285714286E-2</c:v>
                </c:pt>
                <c:pt idx="17">
                  <c:v>2.6785714285714319E-2</c:v>
                </c:pt>
                <c:pt idx="18">
                  <c:v>2.6785714285714319E-2</c:v>
                </c:pt>
                <c:pt idx="19">
                  <c:v>7.5892857142857123E-2</c:v>
                </c:pt>
                <c:pt idx="20">
                  <c:v>0.111607142857143</c:v>
                </c:pt>
                <c:pt idx="21">
                  <c:v>8.4821428571428673E-2</c:v>
                </c:pt>
                <c:pt idx="22">
                  <c:v>5.3571428571428603E-2</c:v>
                </c:pt>
                <c:pt idx="23">
                  <c:v>4.0178571428571404E-2</c:v>
                </c:pt>
                <c:pt idx="24">
                  <c:v>5.3571428571428603E-2</c:v>
                </c:pt>
                <c:pt idx="25">
                  <c:v>5.3571428571428603E-2</c:v>
                </c:pt>
                <c:pt idx="26">
                  <c:v>3.5714285714285698E-2</c:v>
                </c:pt>
                <c:pt idx="27">
                  <c:v>3.125E-2</c:v>
                </c:pt>
                <c:pt idx="28">
                  <c:v>2.23214285714286E-2</c:v>
                </c:pt>
                <c:pt idx="29">
                  <c:v>4.4642857142857095E-2</c:v>
                </c:pt>
                <c:pt idx="30">
                  <c:v>1.7857142857142898E-2</c:v>
                </c:pt>
              </c:numCache>
            </c:numRef>
          </c:val>
        </c:ser>
        <c:ser>
          <c:idx val="16"/>
          <c:order val="16"/>
          <c:tx>
            <c:strRef>
              <c:f>'glr-1(n2461)_A5_0.02_50%'!$R$104</c:f>
              <c:strCache>
                <c:ptCount val="1"/>
                <c:pt idx="0">
                  <c:v>glr-1(n2461)_A5_17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R$105:$R$135</c:f>
              <c:numCache>
                <c:formatCode>General</c:formatCode>
                <c:ptCount val="31"/>
                <c:pt idx="1">
                  <c:v>5.6790123456790104E-2</c:v>
                </c:pt>
                <c:pt idx="2">
                  <c:v>3.7037037037037014E-2</c:v>
                </c:pt>
                <c:pt idx="3">
                  <c:v>3.4567901234567884E-2</c:v>
                </c:pt>
                <c:pt idx="4">
                  <c:v>7.4074074074074098E-2</c:v>
                </c:pt>
                <c:pt idx="5">
                  <c:v>4.9382716049382734E-2</c:v>
                </c:pt>
                <c:pt idx="6">
                  <c:v>5.6790123456790104E-2</c:v>
                </c:pt>
                <c:pt idx="7">
                  <c:v>6.4197530864197522E-2</c:v>
                </c:pt>
                <c:pt idx="8">
                  <c:v>7.4074074074074098E-2</c:v>
                </c:pt>
                <c:pt idx="9">
                  <c:v>7.6543209876543214E-2</c:v>
                </c:pt>
                <c:pt idx="10">
                  <c:v>7.160493827160487E-2</c:v>
                </c:pt>
                <c:pt idx="11">
                  <c:v>5.6790123456790104E-2</c:v>
                </c:pt>
                <c:pt idx="12">
                  <c:v>2.4691358024691409E-2</c:v>
                </c:pt>
                <c:pt idx="13">
                  <c:v>2.7160493827160501E-2</c:v>
                </c:pt>
                <c:pt idx="14">
                  <c:v>3.4567901234567884E-2</c:v>
                </c:pt>
                <c:pt idx="15">
                  <c:v>3.2098765432098803E-2</c:v>
                </c:pt>
                <c:pt idx="16">
                  <c:v>3.4567901234567884E-2</c:v>
                </c:pt>
                <c:pt idx="17">
                  <c:v>3.2098765432098803E-2</c:v>
                </c:pt>
                <c:pt idx="18">
                  <c:v>2.7160493827160501E-2</c:v>
                </c:pt>
                <c:pt idx="19">
                  <c:v>3.4567901234567884E-2</c:v>
                </c:pt>
                <c:pt idx="20">
                  <c:v>1.48148148148148E-2</c:v>
                </c:pt>
                <c:pt idx="21">
                  <c:v>9.8765432098765482E-3</c:v>
                </c:pt>
                <c:pt idx="22">
                  <c:v>1.2345679012345704E-2</c:v>
                </c:pt>
                <c:pt idx="23">
                  <c:v>9.8765432098765482E-3</c:v>
                </c:pt>
                <c:pt idx="24">
                  <c:v>4.9382716049382741E-3</c:v>
                </c:pt>
                <c:pt idx="25">
                  <c:v>2.469135802469141E-3</c:v>
                </c:pt>
                <c:pt idx="26">
                  <c:v>2.469135802469141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glr-1(n2461)_A5_0.02_50%'!$S$104</c:f>
              <c:strCache>
                <c:ptCount val="1"/>
                <c:pt idx="0">
                  <c:v>glr-1(n2461)_A5_18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S$105:$S$135</c:f>
              <c:numCache>
                <c:formatCode>General</c:formatCode>
                <c:ptCount val="31"/>
                <c:pt idx="1">
                  <c:v>3.5256410256410298E-2</c:v>
                </c:pt>
                <c:pt idx="2">
                  <c:v>3.2051282051282E-2</c:v>
                </c:pt>
                <c:pt idx="3">
                  <c:v>2.2435897435897415E-2</c:v>
                </c:pt>
                <c:pt idx="4">
                  <c:v>3.8461538461538498E-2</c:v>
                </c:pt>
                <c:pt idx="5">
                  <c:v>2.5641025641025609E-2</c:v>
                </c:pt>
                <c:pt idx="6">
                  <c:v>4.1666666666666699E-2</c:v>
                </c:pt>
                <c:pt idx="7">
                  <c:v>1.9230769230769208E-2</c:v>
                </c:pt>
                <c:pt idx="8">
                  <c:v>4.1666666666666699E-2</c:v>
                </c:pt>
                <c:pt idx="9">
                  <c:v>1.6025641025641E-2</c:v>
                </c:pt>
                <c:pt idx="10">
                  <c:v>2.2435897435897415E-2</c:v>
                </c:pt>
                <c:pt idx="11">
                  <c:v>2.5641025641025609E-2</c:v>
                </c:pt>
                <c:pt idx="12">
                  <c:v>3.2051282051282E-2</c:v>
                </c:pt>
                <c:pt idx="13">
                  <c:v>3.5256410256410298E-2</c:v>
                </c:pt>
                <c:pt idx="14">
                  <c:v>4.1666666666666699E-2</c:v>
                </c:pt>
                <c:pt idx="15">
                  <c:v>6.4102564102564111E-2</c:v>
                </c:pt>
                <c:pt idx="16">
                  <c:v>0.10576923076923106</c:v>
                </c:pt>
                <c:pt idx="17">
                  <c:v>3.8461538461538498E-2</c:v>
                </c:pt>
                <c:pt idx="18">
                  <c:v>8.9743589743589702E-2</c:v>
                </c:pt>
                <c:pt idx="19">
                  <c:v>4.4871794871794914E-2</c:v>
                </c:pt>
                <c:pt idx="20">
                  <c:v>4.4871794871794914E-2</c:v>
                </c:pt>
                <c:pt idx="21">
                  <c:v>3.5256410256410298E-2</c:v>
                </c:pt>
                <c:pt idx="22">
                  <c:v>3.5256410256410298E-2</c:v>
                </c:pt>
                <c:pt idx="23">
                  <c:v>1.6025641025641E-2</c:v>
                </c:pt>
                <c:pt idx="24">
                  <c:v>1.2820512820512801E-2</c:v>
                </c:pt>
                <c:pt idx="25">
                  <c:v>0</c:v>
                </c:pt>
                <c:pt idx="26">
                  <c:v>6.4102564102564118E-3</c:v>
                </c:pt>
                <c:pt idx="27">
                  <c:v>6.4102564102564118E-3</c:v>
                </c:pt>
                <c:pt idx="28">
                  <c:v>3.2051282051282107E-3</c:v>
                </c:pt>
                <c:pt idx="29">
                  <c:v>6.4102564102564118E-3</c:v>
                </c:pt>
                <c:pt idx="30">
                  <c:v>0</c:v>
                </c:pt>
              </c:numCache>
            </c:numRef>
          </c:val>
        </c:ser>
        <c:ser>
          <c:idx val="18"/>
          <c:order val="18"/>
          <c:tx>
            <c:strRef>
              <c:f>'glr-1(n2461)_A5_0.02_50%'!$T$104</c:f>
              <c:strCache>
                <c:ptCount val="1"/>
                <c:pt idx="0">
                  <c:v>glr-1(n2461)_A5_19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T$105:$T$135</c:f>
              <c:numCache>
                <c:formatCode>General</c:formatCode>
                <c:ptCount val="31"/>
                <c:pt idx="1">
                  <c:v>7.1856287425149726E-2</c:v>
                </c:pt>
                <c:pt idx="2">
                  <c:v>5.3892215568862312E-2</c:v>
                </c:pt>
                <c:pt idx="3">
                  <c:v>4.7904191616766512E-2</c:v>
                </c:pt>
                <c:pt idx="4">
                  <c:v>7.7844311377245512E-2</c:v>
                </c:pt>
                <c:pt idx="5">
                  <c:v>2.9940119760479014E-2</c:v>
                </c:pt>
                <c:pt idx="6">
                  <c:v>4.1916167664670698E-2</c:v>
                </c:pt>
                <c:pt idx="7">
                  <c:v>1.1976047904191595E-2</c:v>
                </c:pt>
                <c:pt idx="8">
                  <c:v>5.3892215568862312E-2</c:v>
                </c:pt>
                <c:pt idx="9">
                  <c:v>1.1976047904191595E-2</c:v>
                </c:pt>
                <c:pt idx="10">
                  <c:v>2.3952095808383197E-2</c:v>
                </c:pt>
                <c:pt idx="11">
                  <c:v>5.9880239520958122E-3</c:v>
                </c:pt>
                <c:pt idx="12">
                  <c:v>5.9880239520958122E-3</c:v>
                </c:pt>
                <c:pt idx="13">
                  <c:v>2.9940119760479014E-2</c:v>
                </c:pt>
                <c:pt idx="14">
                  <c:v>2.3952095808383197E-2</c:v>
                </c:pt>
                <c:pt idx="15">
                  <c:v>5.3892215568862312E-2</c:v>
                </c:pt>
                <c:pt idx="16">
                  <c:v>3.5928143712574814E-2</c:v>
                </c:pt>
                <c:pt idx="17">
                  <c:v>8.9820359281437154E-2</c:v>
                </c:pt>
                <c:pt idx="18">
                  <c:v>7.7844311377245512E-2</c:v>
                </c:pt>
                <c:pt idx="19">
                  <c:v>4.1916167664670698E-2</c:v>
                </c:pt>
                <c:pt idx="20">
                  <c:v>2.9940119760479014E-2</c:v>
                </c:pt>
                <c:pt idx="21">
                  <c:v>1.7964071856287407E-2</c:v>
                </c:pt>
                <c:pt idx="22">
                  <c:v>5.9880239520958122E-3</c:v>
                </c:pt>
                <c:pt idx="23">
                  <c:v>4.1916167664670698E-2</c:v>
                </c:pt>
                <c:pt idx="24">
                  <c:v>5.9880239520958122E-3</c:v>
                </c:pt>
                <c:pt idx="25">
                  <c:v>5.9880239520958122E-3</c:v>
                </c:pt>
                <c:pt idx="26">
                  <c:v>5.9880239520958122E-3</c:v>
                </c:pt>
                <c:pt idx="27">
                  <c:v>5.9880239520958122E-3</c:v>
                </c:pt>
                <c:pt idx="28">
                  <c:v>5.9880239520958122E-3</c:v>
                </c:pt>
                <c:pt idx="29">
                  <c:v>0</c:v>
                </c:pt>
                <c:pt idx="30">
                  <c:v>5.9880239520958122E-3</c:v>
                </c:pt>
              </c:numCache>
            </c:numRef>
          </c:val>
        </c:ser>
        <c:ser>
          <c:idx val="19"/>
          <c:order val="19"/>
          <c:tx>
            <c:strRef>
              <c:f>'glr-1(n2461)_A5_0.02_50%'!$U$104</c:f>
              <c:strCache>
                <c:ptCount val="1"/>
                <c:pt idx="0">
                  <c:v>glr-1(n2461)_A5_20</c:v>
                </c:pt>
              </c:strCache>
            </c:strRef>
          </c:tx>
          <c:marker>
            <c:symbol val="none"/>
          </c:marker>
          <c:cat>
            <c:numRef>
              <c:f>'glr-1(n246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5_0.02_50%'!$U$105:$U$135</c:f>
              <c:numCache>
                <c:formatCode>General</c:formatCode>
                <c:ptCount val="31"/>
                <c:pt idx="1">
                  <c:v>0</c:v>
                </c:pt>
                <c:pt idx="2">
                  <c:v>2.3391812865497099E-2</c:v>
                </c:pt>
                <c:pt idx="3">
                  <c:v>1.1695906432748499E-2</c:v>
                </c:pt>
                <c:pt idx="4">
                  <c:v>1.1695906432748499E-2</c:v>
                </c:pt>
                <c:pt idx="5">
                  <c:v>1.1695906432748499E-2</c:v>
                </c:pt>
                <c:pt idx="6">
                  <c:v>1.1695906432748499E-2</c:v>
                </c:pt>
                <c:pt idx="7">
                  <c:v>0</c:v>
                </c:pt>
                <c:pt idx="8">
                  <c:v>0</c:v>
                </c:pt>
                <c:pt idx="9">
                  <c:v>1.7543859649122813E-2</c:v>
                </c:pt>
                <c:pt idx="10">
                  <c:v>5.8479532163742704E-3</c:v>
                </c:pt>
                <c:pt idx="11">
                  <c:v>2.3391812865497099E-2</c:v>
                </c:pt>
                <c:pt idx="12">
                  <c:v>1.1695906432748499E-2</c:v>
                </c:pt>
                <c:pt idx="13">
                  <c:v>1.1695906432748499E-2</c:v>
                </c:pt>
                <c:pt idx="14">
                  <c:v>1.7543859649122813E-2</c:v>
                </c:pt>
                <c:pt idx="15">
                  <c:v>7.0175438596491196E-2</c:v>
                </c:pt>
                <c:pt idx="16">
                  <c:v>8.1871345029239859E-2</c:v>
                </c:pt>
                <c:pt idx="17">
                  <c:v>8.1871345029239859E-2</c:v>
                </c:pt>
                <c:pt idx="18">
                  <c:v>0.105263157894737</c:v>
                </c:pt>
                <c:pt idx="19">
                  <c:v>7.6023391812865521E-2</c:v>
                </c:pt>
                <c:pt idx="20">
                  <c:v>5.2631578947368404E-2</c:v>
                </c:pt>
                <c:pt idx="21">
                  <c:v>7.0175438596491196E-2</c:v>
                </c:pt>
                <c:pt idx="22">
                  <c:v>8.7719298245614002E-2</c:v>
                </c:pt>
                <c:pt idx="23">
                  <c:v>2.9239766081871312E-2</c:v>
                </c:pt>
                <c:pt idx="24">
                  <c:v>4.0935672514619895E-2</c:v>
                </c:pt>
                <c:pt idx="25">
                  <c:v>2.3391812865497099E-2</c:v>
                </c:pt>
                <c:pt idx="26">
                  <c:v>2.9239766081871312E-2</c:v>
                </c:pt>
                <c:pt idx="27">
                  <c:v>2.3391812865497099E-2</c:v>
                </c:pt>
                <c:pt idx="28">
                  <c:v>1.1695906432748499E-2</c:v>
                </c:pt>
                <c:pt idx="29">
                  <c:v>0</c:v>
                </c:pt>
                <c:pt idx="30">
                  <c:v>5.8479532163742704E-3</c:v>
                </c:pt>
              </c:numCache>
            </c:numRef>
          </c:val>
        </c:ser>
        <c:marker val="1"/>
        <c:axId val="165838848"/>
        <c:axId val="165840384"/>
      </c:lineChart>
      <c:catAx>
        <c:axId val="165838848"/>
        <c:scaling>
          <c:orientation val="minMax"/>
        </c:scaling>
        <c:axPos val="b"/>
        <c:numFmt formatCode="0.0_ " sourceLinked="1"/>
        <c:tickLblPos val="nextTo"/>
        <c:crossAx val="165840384"/>
        <c:crosses val="autoZero"/>
        <c:auto val="1"/>
        <c:lblAlgn val="ctr"/>
        <c:lblOffset val="100"/>
        <c:tickLblSkip val="5"/>
        <c:tickMarkSkip val="5"/>
      </c:catAx>
      <c:valAx>
        <c:axId val="165840384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5838848"/>
        <c:crosses val="autoZero"/>
        <c:crossBetween val="between"/>
      </c:valAx>
    </c:plotArea>
    <c:plotVisOnly val="1"/>
  </c:chart>
  <c:externalData r:id="rId1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glr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3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glr-1(n2461)_A3_0.02_50%'!$B$104</c:f>
              <c:strCache>
                <c:ptCount val="1"/>
                <c:pt idx="0">
                  <c:v>glr-1(n2461)_A3_01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B$105:$B$135</c:f>
              <c:numCache>
                <c:formatCode>General</c:formatCode>
                <c:ptCount val="31"/>
                <c:pt idx="1">
                  <c:v>9.6618357487922701E-3</c:v>
                </c:pt>
                <c:pt idx="2">
                  <c:v>4.8309178743961385E-3</c:v>
                </c:pt>
                <c:pt idx="3">
                  <c:v>1.4492753623188401E-2</c:v>
                </c:pt>
                <c:pt idx="4">
                  <c:v>9.6618357487922701E-3</c:v>
                </c:pt>
                <c:pt idx="5">
                  <c:v>9.6618357487922701E-3</c:v>
                </c:pt>
                <c:pt idx="6">
                  <c:v>0</c:v>
                </c:pt>
                <c:pt idx="7">
                  <c:v>0</c:v>
                </c:pt>
                <c:pt idx="8">
                  <c:v>4.8309178743961385E-3</c:v>
                </c:pt>
                <c:pt idx="9">
                  <c:v>9.6618357487922701E-3</c:v>
                </c:pt>
                <c:pt idx="10">
                  <c:v>4.8309178743961385E-3</c:v>
                </c:pt>
                <c:pt idx="11">
                  <c:v>9.6618357487922701E-3</c:v>
                </c:pt>
                <c:pt idx="12">
                  <c:v>1.9323671497584509E-2</c:v>
                </c:pt>
                <c:pt idx="13">
                  <c:v>6.7632850241545903E-2</c:v>
                </c:pt>
                <c:pt idx="14">
                  <c:v>0.10144927536231903</c:v>
                </c:pt>
                <c:pt idx="15">
                  <c:v>0.13043478260869601</c:v>
                </c:pt>
                <c:pt idx="16">
                  <c:v>0.13043478260869601</c:v>
                </c:pt>
                <c:pt idx="17">
                  <c:v>0.14492753623188401</c:v>
                </c:pt>
                <c:pt idx="18">
                  <c:v>0.11111111111111099</c:v>
                </c:pt>
                <c:pt idx="19">
                  <c:v>7.7294685990338244E-2</c:v>
                </c:pt>
                <c:pt idx="20">
                  <c:v>5.3140096618357481E-2</c:v>
                </c:pt>
                <c:pt idx="21">
                  <c:v>3.3816425120772903E-2</c:v>
                </c:pt>
                <c:pt idx="22">
                  <c:v>1.9323671497584509E-2</c:v>
                </c:pt>
                <c:pt idx="23">
                  <c:v>1.4492753623188401E-2</c:v>
                </c:pt>
                <c:pt idx="24">
                  <c:v>4.8309178743961385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"/>
          <c:order val="1"/>
          <c:tx>
            <c:strRef>
              <c:f>'glr-1(n2461)_A3_0.02_50%'!$C$104</c:f>
              <c:strCache>
                <c:ptCount val="1"/>
                <c:pt idx="0">
                  <c:v>glr-1(n2461)_A3_02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C$105:$C$135</c:f>
              <c:numCache>
                <c:formatCode>General</c:formatCode>
                <c:ptCount val="31"/>
                <c:pt idx="1">
                  <c:v>2.6666666666666707E-2</c:v>
                </c:pt>
                <c:pt idx="2">
                  <c:v>8.8888888888888941E-3</c:v>
                </c:pt>
                <c:pt idx="3">
                  <c:v>2.6666666666666707E-2</c:v>
                </c:pt>
                <c:pt idx="4">
                  <c:v>4.4444444444444418E-3</c:v>
                </c:pt>
                <c:pt idx="5">
                  <c:v>1.3333333333333301E-2</c:v>
                </c:pt>
                <c:pt idx="6">
                  <c:v>4.4444444444444418E-3</c:v>
                </c:pt>
                <c:pt idx="7">
                  <c:v>4.4444444444444418E-3</c:v>
                </c:pt>
                <c:pt idx="8">
                  <c:v>4.4444444444444418E-3</c:v>
                </c:pt>
                <c:pt idx="9">
                  <c:v>1.3333333333333301E-2</c:v>
                </c:pt>
                <c:pt idx="10">
                  <c:v>4.4444444444444418E-3</c:v>
                </c:pt>
                <c:pt idx="11">
                  <c:v>0</c:v>
                </c:pt>
                <c:pt idx="12">
                  <c:v>4.4444444444444418E-3</c:v>
                </c:pt>
                <c:pt idx="13">
                  <c:v>6.222222222222222E-2</c:v>
                </c:pt>
                <c:pt idx="14">
                  <c:v>7.1111111111111111E-2</c:v>
                </c:pt>
                <c:pt idx="15">
                  <c:v>0.12000000000000002</c:v>
                </c:pt>
                <c:pt idx="16">
                  <c:v>0.16</c:v>
                </c:pt>
                <c:pt idx="17">
                  <c:v>0.155555555555556</c:v>
                </c:pt>
                <c:pt idx="18">
                  <c:v>8.0000000000000029E-2</c:v>
                </c:pt>
                <c:pt idx="19">
                  <c:v>8.0000000000000029E-2</c:v>
                </c:pt>
                <c:pt idx="20">
                  <c:v>5.3333333333333337E-2</c:v>
                </c:pt>
                <c:pt idx="21">
                  <c:v>4.4444444444444418E-2</c:v>
                </c:pt>
                <c:pt idx="22">
                  <c:v>2.2222222222222202E-2</c:v>
                </c:pt>
                <c:pt idx="23">
                  <c:v>1.3333333333333301E-2</c:v>
                </c:pt>
                <c:pt idx="24">
                  <c:v>4.4444444444444418E-3</c:v>
                </c:pt>
                <c:pt idx="25">
                  <c:v>4.4444444444444418E-3</c:v>
                </c:pt>
                <c:pt idx="26">
                  <c:v>0</c:v>
                </c:pt>
                <c:pt idx="27">
                  <c:v>4.4444444444444418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glr-1(n2461)_A3_0.02_50%'!$D$104</c:f>
              <c:strCache>
                <c:ptCount val="1"/>
                <c:pt idx="0">
                  <c:v>glr-1(n2461)_A3_03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D$105:$D$135</c:f>
              <c:numCache>
                <c:formatCode>General</c:formatCode>
                <c:ptCount val="31"/>
                <c:pt idx="1">
                  <c:v>3.4782608695652202E-2</c:v>
                </c:pt>
                <c:pt idx="2">
                  <c:v>1.7391304347826101E-2</c:v>
                </c:pt>
                <c:pt idx="3">
                  <c:v>8.6956521739130453E-3</c:v>
                </c:pt>
                <c:pt idx="4">
                  <c:v>0</c:v>
                </c:pt>
                <c:pt idx="5">
                  <c:v>0</c:v>
                </c:pt>
                <c:pt idx="6">
                  <c:v>1.7391304347826101E-2</c:v>
                </c:pt>
                <c:pt idx="7">
                  <c:v>0</c:v>
                </c:pt>
                <c:pt idx="8">
                  <c:v>8.6956521739130453E-3</c:v>
                </c:pt>
                <c:pt idx="9">
                  <c:v>8.6956521739130453E-3</c:v>
                </c:pt>
                <c:pt idx="10">
                  <c:v>8.6956521739130453E-3</c:v>
                </c:pt>
                <c:pt idx="11">
                  <c:v>8.6956521739130453E-3</c:v>
                </c:pt>
                <c:pt idx="12">
                  <c:v>2.6086956521739115E-2</c:v>
                </c:pt>
                <c:pt idx="13">
                  <c:v>1.7391304347826101E-2</c:v>
                </c:pt>
                <c:pt idx="14">
                  <c:v>1.7391304347826101E-2</c:v>
                </c:pt>
                <c:pt idx="15">
                  <c:v>8.6956521739130453E-3</c:v>
                </c:pt>
                <c:pt idx="16">
                  <c:v>4.3478260869565202E-2</c:v>
                </c:pt>
                <c:pt idx="17">
                  <c:v>6.0869565217391314E-2</c:v>
                </c:pt>
                <c:pt idx="18">
                  <c:v>0.13043478260869601</c:v>
                </c:pt>
                <c:pt idx="19">
                  <c:v>0.13043478260869601</c:v>
                </c:pt>
                <c:pt idx="20">
                  <c:v>0.14782608695652205</c:v>
                </c:pt>
                <c:pt idx="21">
                  <c:v>9.5652173913043537E-2</c:v>
                </c:pt>
                <c:pt idx="22">
                  <c:v>4.3478260869565202E-2</c:v>
                </c:pt>
                <c:pt idx="23">
                  <c:v>6.0869565217391314E-2</c:v>
                </c:pt>
                <c:pt idx="24">
                  <c:v>5.217391304347832E-2</c:v>
                </c:pt>
                <c:pt idx="25">
                  <c:v>8.6956521739130453E-3</c:v>
                </c:pt>
                <c:pt idx="26">
                  <c:v>2.6086956521739115E-2</c:v>
                </c:pt>
                <c:pt idx="27">
                  <c:v>0</c:v>
                </c:pt>
                <c:pt idx="28">
                  <c:v>8.6956521739130453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glr-1(n2461)_A3_0.02_50%'!$E$104</c:f>
              <c:strCache>
                <c:ptCount val="1"/>
                <c:pt idx="0">
                  <c:v>glr-1(n2461)_A3_04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E$105:$E$135</c:f>
              <c:numCache>
                <c:formatCode>General</c:formatCode>
                <c:ptCount val="31"/>
                <c:pt idx="1">
                  <c:v>3.6423841059602606E-2</c:v>
                </c:pt>
                <c:pt idx="2">
                  <c:v>3.6423841059602606E-2</c:v>
                </c:pt>
                <c:pt idx="3">
                  <c:v>1.6556291390728502E-2</c:v>
                </c:pt>
                <c:pt idx="4">
                  <c:v>2.9801324503311313E-2</c:v>
                </c:pt>
                <c:pt idx="5">
                  <c:v>2.6490066225165608E-2</c:v>
                </c:pt>
                <c:pt idx="6">
                  <c:v>1.3245033112582804E-2</c:v>
                </c:pt>
                <c:pt idx="7">
                  <c:v>1.3245033112582804E-2</c:v>
                </c:pt>
                <c:pt idx="8">
                  <c:v>2.9801324503311313E-2</c:v>
                </c:pt>
                <c:pt idx="9">
                  <c:v>1.9867549668874208E-2</c:v>
                </c:pt>
                <c:pt idx="10">
                  <c:v>1.6556291390728502E-2</c:v>
                </c:pt>
                <c:pt idx="11">
                  <c:v>3.6423841059602606E-2</c:v>
                </c:pt>
                <c:pt idx="12">
                  <c:v>3.6423841059602606E-2</c:v>
                </c:pt>
                <c:pt idx="13">
                  <c:v>3.6423841059602606E-2</c:v>
                </c:pt>
                <c:pt idx="14">
                  <c:v>5.2980132450331119E-2</c:v>
                </c:pt>
                <c:pt idx="15">
                  <c:v>7.9470198675496706E-2</c:v>
                </c:pt>
                <c:pt idx="16">
                  <c:v>6.2913907284768228E-2</c:v>
                </c:pt>
                <c:pt idx="17">
                  <c:v>6.6225165562913871E-2</c:v>
                </c:pt>
                <c:pt idx="18">
                  <c:v>5.6291390728476796E-2</c:v>
                </c:pt>
                <c:pt idx="19">
                  <c:v>3.9735099337748297E-2</c:v>
                </c:pt>
                <c:pt idx="20">
                  <c:v>5.2980132450331119E-2</c:v>
                </c:pt>
                <c:pt idx="21">
                  <c:v>3.6423841059602606E-2</c:v>
                </c:pt>
                <c:pt idx="22">
                  <c:v>3.6423841059602606E-2</c:v>
                </c:pt>
                <c:pt idx="23">
                  <c:v>2.3178807947019899E-2</c:v>
                </c:pt>
                <c:pt idx="24">
                  <c:v>2.9801324503311313E-2</c:v>
                </c:pt>
                <c:pt idx="25">
                  <c:v>1.9867549668874208E-2</c:v>
                </c:pt>
                <c:pt idx="26">
                  <c:v>2.3178807947019899E-2</c:v>
                </c:pt>
                <c:pt idx="27">
                  <c:v>6.6225165562913864E-3</c:v>
                </c:pt>
                <c:pt idx="28">
                  <c:v>1.3245033112582804E-2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glr-1(n2461)_A3_0.02_50%'!$F$104</c:f>
              <c:strCache>
                <c:ptCount val="1"/>
                <c:pt idx="0">
                  <c:v>glr-1(n2461)_A3_05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F$105:$F$135</c:f>
              <c:numCache>
                <c:formatCode>General</c:formatCode>
                <c:ptCount val="31"/>
                <c:pt idx="1">
                  <c:v>3.0000000000000002E-2</c:v>
                </c:pt>
                <c:pt idx="2">
                  <c:v>1.3333333333333301E-2</c:v>
                </c:pt>
                <c:pt idx="3">
                  <c:v>1.6666666666666701E-2</c:v>
                </c:pt>
                <c:pt idx="4">
                  <c:v>2.6666666666666707E-2</c:v>
                </c:pt>
                <c:pt idx="5">
                  <c:v>1.3333333333333301E-2</c:v>
                </c:pt>
                <c:pt idx="6">
                  <c:v>3.6666666666666702E-2</c:v>
                </c:pt>
                <c:pt idx="7">
                  <c:v>1.6666666666666701E-2</c:v>
                </c:pt>
                <c:pt idx="8">
                  <c:v>1.6666666666666701E-2</c:v>
                </c:pt>
                <c:pt idx="9">
                  <c:v>1.3333333333333301E-2</c:v>
                </c:pt>
                <c:pt idx="10">
                  <c:v>1.3333333333333301E-2</c:v>
                </c:pt>
                <c:pt idx="11">
                  <c:v>1.3333333333333301E-2</c:v>
                </c:pt>
                <c:pt idx="12">
                  <c:v>3.0000000000000002E-2</c:v>
                </c:pt>
                <c:pt idx="13">
                  <c:v>0.05</c:v>
                </c:pt>
                <c:pt idx="14">
                  <c:v>4.3333333333333328E-2</c:v>
                </c:pt>
                <c:pt idx="15">
                  <c:v>9.0000000000000024E-2</c:v>
                </c:pt>
                <c:pt idx="16">
                  <c:v>0.103333333333333</c:v>
                </c:pt>
                <c:pt idx="17">
                  <c:v>6.6666666666666693E-2</c:v>
                </c:pt>
                <c:pt idx="18">
                  <c:v>8.3333333333333329E-2</c:v>
                </c:pt>
                <c:pt idx="19">
                  <c:v>4.6666666666666703E-2</c:v>
                </c:pt>
                <c:pt idx="20">
                  <c:v>9.3333333333333296E-2</c:v>
                </c:pt>
                <c:pt idx="21">
                  <c:v>4.3333333333333328E-2</c:v>
                </c:pt>
                <c:pt idx="22">
                  <c:v>4.0000000000000015E-2</c:v>
                </c:pt>
                <c:pt idx="23">
                  <c:v>4.0000000000000015E-2</c:v>
                </c:pt>
                <c:pt idx="24">
                  <c:v>1.6666666666666701E-2</c:v>
                </c:pt>
                <c:pt idx="25">
                  <c:v>6.6666666666666714E-3</c:v>
                </c:pt>
                <c:pt idx="26">
                  <c:v>0</c:v>
                </c:pt>
                <c:pt idx="27">
                  <c:v>6.6666666666666714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glr-1(n2461)_A3_0.02_50%'!$G$104</c:f>
              <c:strCache>
                <c:ptCount val="1"/>
                <c:pt idx="0">
                  <c:v>glr-1(n2461)_A3_06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G$105:$G$135</c:f>
              <c:numCache>
                <c:formatCode>General</c:formatCode>
                <c:ptCount val="31"/>
                <c:pt idx="1">
                  <c:v>2.0325203252032485E-2</c:v>
                </c:pt>
                <c:pt idx="2">
                  <c:v>8.1300813008130107E-3</c:v>
                </c:pt>
                <c:pt idx="3">
                  <c:v>8.1300813008130107E-3</c:v>
                </c:pt>
                <c:pt idx="4">
                  <c:v>4.0650406504065002E-3</c:v>
                </c:pt>
                <c:pt idx="5">
                  <c:v>4.0650406504065002E-3</c:v>
                </c:pt>
                <c:pt idx="6">
                  <c:v>8.1300813008130107E-3</c:v>
                </c:pt>
                <c:pt idx="7">
                  <c:v>2.0325203252032485E-2</c:v>
                </c:pt>
                <c:pt idx="8">
                  <c:v>4.0650406504065002E-3</c:v>
                </c:pt>
                <c:pt idx="9">
                  <c:v>0</c:v>
                </c:pt>
                <c:pt idx="10">
                  <c:v>1.21951219512195E-2</c:v>
                </c:pt>
                <c:pt idx="11">
                  <c:v>1.6260162601626001E-2</c:v>
                </c:pt>
                <c:pt idx="12">
                  <c:v>2.4390243902439001E-2</c:v>
                </c:pt>
                <c:pt idx="13">
                  <c:v>5.2845528455284584E-2</c:v>
                </c:pt>
                <c:pt idx="14">
                  <c:v>0.10162601626016303</c:v>
                </c:pt>
                <c:pt idx="15">
                  <c:v>0.13414634146341506</c:v>
                </c:pt>
                <c:pt idx="16">
                  <c:v>0.14634146341463405</c:v>
                </c:pt>
                <c:pt idx="17">
                  <c:v>8.1300813008130079E-2</c:v>
                </c:pt>
                <c:pt idx="18">
                  <c:v>9.7560975609756156E-2</c:v>
                </c:pt>
                <c:pt idx="19">
                  <c:v>6.0975609756097601E-2</c:v>
                </c:pt>
                <c:pt idx="20">
                  <c:v>4.4715447154471531E-2</c:v>
                </c:pt>
                <c:pt idx="21">
                  <c:v>2.8455284552845499E-2</c:v>
                </c:pt>
                <c:pt idx="22">
                  <c:v>1.6260162601626001E-2</c:v>
                </c:pt>
                <c:pt idx="23">
                  <c:v>1.6260162601626001E-2</c:v>
                </c:pt>
                <c:pt idx="24">
                  <c:v>1.21951219512195E-2</c:v>
                </c:pt>
                <c:pt idx="25">
                  <c:v>1.6260162601626001E-2</c:v>
                </c:pt>
                <c:pt idx="26">
                  <c:v>1.21951219512195E-2</c:v>
                </c:pt>
                <c:pt idx="27">
                  <c:v>4.0650406504065002E-3</c:v>
                </c:pt>
                <c:pt idx="28">
                  <c:v>0</c:v>
                </c:pt>
                <c:pt idx="29">
                  <c:v>8.1300813008130107E-3</c:v>
                </c:pt>
                <c:pt idx="30">
                  <c:v>4.0650406504065002E-3</c:v>
                </c:pt>
              </c:numCache>
            </c:numRef>
          </c:val>
        </c:ser>
        <c:ser>
          <c:idx val="6"/>
          <c:order val="6"/>
          <c:tx>
            <c:strRef>
              <c:f>'glr-1(n2461)_A3_0.02_50%'!$H$104</c:f>
              <c:strCache>
                <c:ptCount val="1"/>
                <c:pt idx="0">
                  <c:v>glr-1(n2461)_A3_07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H$105:$H$135</c:f>
              <c:numCache>
                <c:formatCode>General</c:formatCode>
                <c:ptCount val="31"/>
                <c:pt idx="1">
                  <c:v>2.510460251046031E-2</c:v>
                </c:pt>
                <c:pt idx="2">
                  <c:v>8.3682008368200847E-3</c:v>
                </c:pt>
                <c:pt idx="3">
                  <c:v>4.1841004184100396E-2</c:v>
                </c:pt>
                <c:pt idx="4">
                  <c:v>2.0920502092050198E-2</c:v>
                </c:pt>
                <c:pt idx="5">
                  <c:v>1.6736401673640201E-2</c:v>
                </c:pt>
                <c:pt idx="6">
                  <c:v>2.0920502092050198E-2</c:v>
                </c:pt>
                <c:pt idx="7">
                  <c:v>4.1841004184100397E-3</c:v>
                </c:pt>
                <c:pt idx="8">
                  <c:v>0</c:v>
                </c:pt>
                <c:pt idx="9">
                  <c:v>8.3682008368200847E-3</c:v>
                </c:pt>
                <c:pt idx="10">
                  <c:v>8.3682008368200847E-3</c:v>
                </c:pt>
                <c:pt idx="11">
                  <c:v>1.2552301255230104E-2</c:v>
                </c:pt>
                <c:pt idx="12">
                  <c:v>2.510460251046031E-2</c:v>
                </c:pt>
                <c:pt idx="13">
                  <c:v>3.7656903765690412E-2</c:v>
                </c:pt>
                <c:pt idx="14">
                  <c:v>0.10878661087866104</c:v>
                </c:pt>
                <c:pt idx="15">
                  <c:v>0.11715481171548102</c:v>
                </c:pt>
                <c:pt idx="16">
                  <c:v>9.2050209205020897E-2</c:v>
                </c:pt>
                <c:pt idx="17">
                  <c:v>0.13807531380753099</c:v>
                </c:pt>
                <c:pt idx="18">
                  <c:v>4.1841004184100396E-2</c:v>
                </c:pt>
                <c:pt idx="19">
                  <c:v>7.949790794979085E-2</c:v>
                </c:pt>
                <c:pt idx="20">
                  <c:v>6.2761506276150597E-2</c:v>
                </c:pt>
                <c:pt idx="21">
                  <c:v>5.8577405857740628E-2</c:v>
                </c:pt>
                <c:pt idx="22">
                  <c:v>1.6736401673640201E-2</c:v>
                </c:pt>
                <c:pt idx="23">
                  <c:v>1.6736401673640201E-2</c:v>
                </c:pt>
                <c:pt idx="24">
                  <c:v>8.3682008368200847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glr-1(n2461)_A3_0.02_50%'!$I$104</c:f>
              <c:strCache>
                <c:ptCount val="1"/>
                <c:pt idx="0">
                  <c:v>glr-1(n2461)_A3_08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I$105:$I$135</c:f>
              <c:numCache>
                <c:formatCode>General</c:formatCode>
                <c:ptCount val="31"/>
                <c:pt idx="1">
                  <c:v>3.5573122529644313E-2</c:v>
                </c:pt>
                <c:pt idx="2">
                  <c:v>1.9762845849802414E-2</c:v>
                </c:pt>
                <c:pt idx="3">
                  <c:v>3.5573122529644313E-2</c:v>
                </c:pt>
                <c:pt idx="4">
                  <c:v>1.9762845849802414E-2</c:v>
                </c:pt>
                <c:pt idx="5">
                  <c:v>3.5573122529644313E-2</c:v>
                </c:pt>
                <c:pt idx="6">
                  <c:v>1.9762845849802414E-2</c:v>
                </c:pt>
                <c:pt idx="7">
                  <c:v>3.5573122529644313E-2</c:v>
                </c:pt>
                <c:pt idx="8">
                  <c:v>1.9762845849802414E-2</c:v>
                </c:pt>
                <c:pt idx="9">
                  <c:v>7.9051383399209498E-3</c:v>
                </c:pt>
                <c:pt idx="10">
                  <c:v>7.9051383399209498E-3</c:v>
                </c:pt>
                <c:pt idx="11">
                  <c:v>3.5573122529644313E-2</c:v>
                </c:pt>
                <c:pt idx="12">
                  <c:v>2.7667984189723313E-2</c:v>
                </c:pt>
                <c:pt idx="13">
                  <c:v>5.1383399209486223E-2</c:v>
                </c:pt>
                <c:pt idx="14">
                  <c:v>7.9051383399209502E-2</c:v>
                </c:pt>
                <c:pt idx="15">
                  <c:v>7.5098814229249022E-2</c:v>
                </c:pt>
                <c:pt idx="16">
                  <c:v>6.3241106719367557E-2</c:v>
                </c:pt>
                <c:pt idx="17">
                  <c:v>7.1146245059288502E-2</c:v>
                </c:pt>
                <c:pt idx="18">
                  <c:v>9.8814229249011898E-2</c:v>
                </c:pt>
                <c:pt idx="19">
                  <c:v>5.1383399209486223E-2</c:v>
                </c:pt>
                <c:pt idx="20">
                  <c:v>5.1383399209486223E-2</c:v>
                </c:pt>
                <c:pt idx="21">
                  <c:v>4.3478260869565202E-2</c:v>
                </c:pt>
                <c:pt idx="22">
                  <c:v>3.1620553359683799E-2</c:v>
                </c:pt>
                <c:pt idx="23">
                  <c:v>1.58102766798419E-2</c:v>
                </c:pt>
                <c:pt idx="24">
                  <c:v>0</c:v>
                </c:pt>
                <c:pt idx="25">
                  <c:v>1.18577075098814E-2</c:v>
                </c:pt>
                <c:pt idx="26">
                  <c:v>3.9525691699604697E-3</c:v>
                </c:pt>
                <c:pt idx="27">
                  <c:v>7.9051383399209498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8"/>
          <c:order val="8"/>
          <c:tx>
            <c:strRef>
              <c:f>'glr-1(n2461)_A3_0.02_50%'!$J$104</c:f>
              <c:strCache>
                <c:ptCount val="1"/>
                <c:pt idx="0">
                  <c:v>glr-1(n2461)_A3_09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J$105:$J$135</c:f>
              <c:numCache>
                <c:formatCode>General</c:formatCode>
                <c:ptCount val="31"/>
                <c:pt idx="1">
                  <c:v>5.2208835341365487E-2</c:v>
                </c:pt>
                <c:pt idx="2">
                  <c:v>8.0321285140562207E-3</c:v>
                </c:pt>
                <c:pt idx="3">
                  <c:v>2.00803212851406E-2</c:v>
                </c:pt>
                <c:pt idx="4">
                  <c:v>3.2128514056224897E-2</c:v>
                </c:pt>
                <c:pt idx="5">
                  <c:v>2.40963855421687E-2</c:v>
                </c:pt>
                <c:pt idx="6">
                  <c:v>1.2048192771084298E-2</c:v>
                </c:pt>
                <c:pt idx="7">
                  <c:v>1.6064257028112403E-2</c:v>
                </c:pt>
                <c:pt idx="8">
                  <c:v>2.811244979919679E-2</c:v>
                </c:pt>
                <c:pt idx="9">
                  <c:v>3.2128514056224897E-2</c:v>
                </c:pt>
                <c:pt idx="10">
                  <c:v>1.2048192771084298E-2</c:v>
                </c:pt>
                <c:pt idx="11">
                  <c:v>1.6064257028112403E-2</c:v>
                </c:pt>
                <c:pt idx="12">
                  <c:v>4.4176706827309231E-2</c:v>
                </c:pt>
                <c:pt idx="13">
                  <c:v>2.40963855421687E-2</c:v>
                </c:pt>
                <c:pt idx="14">
                  <c:v>8.8353413654618504E-2</c:v>
                </c:pt>
                <c:pt idx="15">
                  <c:v>6.0240963855421721E-2</c:v>
                </c:pt>
                <c:pt idx="16">
                  <c:v>7.2289156626505965E-2</c:v>
                </c:pt>
                <c:pt idx="17">
                  <c:v>9.2369477911646597E-2</c:v>
                </c:pt>
                <c:pt idx="18">
                  <c:v>9.6385542168674732E-2</c:v>
                </c:pt>
                <c:pt idx="19">
                  <c:v>5.622489959839358E-2</c:v>
                </c:pt>
                <c:pt idx="20">
                  <c:v>6.8273092369477886E-2</c:v>
                </c:pt>
                <c:pt idx="21">
                  <c:v>3.6144578313252997E-2</c:v>
                </c:pt>
                <c:pt idx="22">
                  <c:v>3.2128514056224897E-2</c:v>
                </c:pt>
                <c:pt idx="23">
                  <c:v>1.6064257028112403E-2</c:v>
                </c:pt>
                <c:pt idx="24">
                  <c:v>1.6064257028112403E-2</c:v>
                </c:pt>
                <c:pt idx="25">
                  <c:v>4.0160642570281095E-3</c:v>
                </c:pt>
                <c:pt idx="26">
                  <c:v>1.2048192771084298E-2</c:v>
                </c:pt>
                <c:pt idx="27">
                  <c:v>0</c:v>
                </c:pt>
                <c:pt idx="28">
                  <c:v>0</c:v>
                </c:pt>
                <c:pt idx="29">
                  <c:v>4.0160642570281095E-3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glr-1(n2461)_A3_0.02_50%'!$K$104</c:f>
              <c:strCache>
                <c:ptCount val="1"/>
                <c:pt idx="0">
                  <c:v>glr-1(n2461)_A3_10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K$105:$K$135</c:f>
              <c:numCache>
                <c:formatCode>General</c:formatCode>
                <c:ptCount val="31"/>
                <c:pt idx="1">
                  <c:v>2.5862068965517199E-2</c:v>
                </c:pt>
                <c:pt idx="2">
                  <c:v>2.1551724137930991E-2</c:v>
                </c:pt>
                <c:pt idx="3">
                  <c:v>1.29310344827586E-2</c:v>
                </c:pt>
                <c:pt idx="4">
                  <c:v>8.6206896551724154E-3</c:v>
                </c:pt>
                <c:pt idx="5">
                  <c:v>3.4482758620689717E-2</c:v>
                </c:pt>
                <c:pt idx="6">
                  <c:v>1.7241379310344803E-2</c:v>
                </c:pt>
                <c:pt idx="7">
                  <c:v>1.29310344827586E-2</c:v>
                </c:pt>
                <c:pt idx="8">
                  <c:v>0</c:v>
                </c:pt>
                <c:pt idx="9">
                  <c:v>1.29310344827586E-2</c:v>
                </c:pt>
                <c:pt idx="10">
                  <c:v>8.6206896551724154E-3</c:v>
                </c:pt>
                <c:pt idx="11">
                  <c:v>8.6206896551724154E-3</c:v>
                </c:pt>
                <c:pt idx="12">
                  <c:v>2.1551724137930991E-2</c:v>
                </c:pt>
                <c:pt idx="13">
                  <c:v>3.0172413793103509E-2</c:v>
                </c:pt>
                <c:pt idx="14">
                  <c:v>7.7586206896551727E-2</c:v>
                </c:pt>
                <c:pt idx="15">
                  <c:v>0.13362068965517193</c:v>
                </c:pt>
                <c:pt idx="16">
                  <c:v>7.7586206896551727E-2</c:v>
                </c:pt>
                <c:pt idx="17">
                  <c:v>0.10775862068965503</c:v>
                </c:pt>
                <c:pt idx="18">
                  <c:v>0.10775862068965503</c:v>
                </c:pt>
                <c:pt idx="19">
                  <c:v>9.4827586206896561E-2</c:v>
                </c:pt>
                <c:pt idx="20">
                  <c:v>4.7413793103448343E-2</c:v>
                </c:pt>
                <c:pt idx="21">
                  <c:v>3.4482758620689717E-2</c:v>
                </c:pt>
                <c:pt idx="22">
                  <c:v>2.1551724137930991E-2</c:v>
                </c:pt>
                <c:pt idx="23">
                  <c:v>2.5862068965517199E-2</c:v>
                </c:pt>
                <c:pt idx="24">
                  <c:v>8.6206896551724154E-3</c:v>
                </c:pt>
                <c:pt idx="25">
                  <c:v>4.3103448275862077E-3</c:v>
                </c:pt>
                <c:pt idx="26">
                  <c:v>8.6206896551724154E-3</c:v>
                </c:pt>
                <c:pt idx="27">
                  <c:v>0</c:v>
                </c:pt>
                <c:pt idx="28">
                  <c:v>8.6206896551724154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glr-1(n2461)_A3_0.02_50%'!$L$104</c:f>
              <c:strCache>
                <c:ptCount val="1"/>
                <c:pt idx="0">
                  <c:v>glr-1(n2461)_A3_11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L$105:$L$135</c:f>
              <c:numCache>
                <c:formatCode>General</c:formatCode>
                <c:ptCount val="31"/>
                <c:pt idx="1">
                  <c:v>2.1276595744680899E-2</c:v>
                </c:pt>
                <c:pt idx="2">
                  <c:v>3.7234042553191522E-2</c:v>
                </c:pt>
                <c:pt idx="3">
                  <c:v>2.3936170212766002E-2</c:v>
                </c:pt>
                <c:pt idx="4">
                  <c:v>1.5957446808510599E-2</c:v>
                </c:pt>
                <c:pt idx="5">
                  <c:v>4.2553191489361715E-2</c:v>
                </c:pt>
                <c:pt idx="6">
                  <c:v>4.7872340425531915E-2</c:v>
                </c:pt>
                <c:pt idx="7">
                  <c:v>2.3936170212766002E-2</c:v>
                </c:pt>
                <c:pt idx="8">
                  <c:v>2.1276595744680899E-2</c:v>
                </c:pt>
                <c:pt idx="9">
                  <c:v>1.8617021276595706E-2</c:v>
                </c:pt>
                <c:pt idx="10">
                  <c:v>3.9893617021276619E-2</c:v>
                </c:pt>
                <c:pt idx="11">
                  <c:v>2.9255319148936202E-2</c:v>
                </c:pt>
                <c:pt idx="12">
                  <c:v>5.5851063829787211E-2</c:v>
                </c:pt>
                <c:pt idx="13">
                  <c:v>7.7127659574468099E-2</c:v>
                </c:pt>
                <c:pt idx="14">
                  <c:v>8.2446808510638306E-2</c:v>
                </c:pt>
                <c:pt idx="15">
                  <c:v>9.5744680851063829E-2</c:v>
                </c:pt>
                <c:pt idx="16">
                  <c:v>9.8404255319148898E-2</c:v>
                </c:pt>
                <c:pt idx="17">
                  <c:v>8.2446808510638306E-2</c:v>
                </c:pt>
                <c:pt idx="18">
                  <c:v>5.8510638297872314E-2</c:v>
                </c:pt>
                <c:pt idx="19">
                  <c:v>3.4574468085106405E-2</c:v>
                </c:pt>
                <c:pt idx="20">
                  <c:v>3.1914893617021316E-2</c:v>
                </c:pt>
                <c:pt idx="21">
                  <c:v>1.0638297872340394E-2</c:v>
                </c:pt>
                <c:pt idx="22">
                  <c:v>1.3297872340425504E-2</c:v>
                </c:pt>
                <c:pt idx="23">
                  <c:v>2.6595744680851107E-3</c:v>
                </c:pt>
                <c:pt idx="24">
                  <c:v>5.31914893617021E-3</c:v>
                </c:pt>
                <c:pt idx="25">
                  <c:v>0</c:v>
                </c:pt>
                <c:pt idx="26">
                  <c:v>0</c:v>
                </c:pt>
                <c:pt idx="27">
                  <c:v>2.6595744680851107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glr-1(n2461)_A3_0.02_50%'!$M$104</c:f>
              <c:strCache>
                <c:ptCount val="1"/>
                <c:pt idx="0">
                  <c:v>glr-1(n2461)_A3_12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M$105:$M$135</c:f>
              <c:numCache>
                <c:formatCode>General</c:formatCode>
                <c:ptCount val="31"/>
                <c:pt idx="1">
                  <c:v>9.3023255813953504E-3</c:v>
                </c:pt>
                <c:pt idx="2">
                  <c:v>4.6511627906976735E-3</c:v>
                </c:pt>
                <c:pt idx="3">
                  <c:v>1.8604651162790701E-2</c:v>
                </c:pt>
                <c:pt idx="4">
                  <c:v>9.3023255813953504E-3</c:v>
                </c:pt>
                <c:pt idx="5">
                  <c:v>4.6511627906976735E-3</c:v>
                </c:pt>
                <c:pt idx="6">
                  <c:v>1.3953488372093001E-2</c:v>
                </c:pt>
                <c:pt idx="7">
                  <c:v>9.3023255813953504E-3</c:v>
                </c:pt>
                <c:pt idx="8">
                  <c:v>4.6511627906976735E-3</c:v>
                </c:pt>
                <c:pt idx="9">
                  <c:v>9.3023255813953504E-3</c:v>
                </c:pt>
                <c:pt idx="10">
                  <c:v>0</c:v>
                </c:pt>
                <c:pt idx="11">
                  <c:v>4.6511627906976735E-3</c:v>
                </c:pt>
                <c:pt idx="12">
                  <c:v>1.8604651162790701E-2</c:v>
                </c:pt>
                <c:pt idx="13">
                  <c:v>2.7906976744186001E-2</c:v>
                </c:pt>
                <c:pt idx="14">
                  <c:v>4.1860465116279097E-2</c:v>
                </c:pt>
                <c:pt idx="15">
                  <c:v>6.9767441860465129E-2</c:v>
                </c:pt>
                <c:pt idx="16">
                  <c:v>6.9767441860465129E-2</c:v>
                </c:pt>
                <c:pt idx="17">
                  <c:v>0.12093023255814005</c:v>
                </c:pt>
                <c:pt idx="18">
                  <c:v>6.5116279069767399E-2</c:v>
                </c:pt>
                <c:pt idx="19">
                  <c:v>0.13023255813953497</c:v>
                </c:pt>
                <c:pt idx="20">
                  <c:v>0.10697674418604704</c:v>
                </c:pt>
                <c:pt idx="21">
                  <c:v>7.906976744186052E-2</c:v>
                </c:pt>
                <c:pt idx="22">
                  <c:v>5.5813953488372099E-2</c:v>
                </c:pt>
                <c:pt idx="23">
                  <c:v>3.7209302325581416E-2</c:v>
                </c:pt>
                <c:pt idx="24">
                  <c:v>3.25581395348837E-2</c:v>
                </c:pt>
                <c:pt idx="25">
                  <c:v>1.8604651162790701E-2</c:v>
                </c:pt>
                <c:pt idx="26">
                  <c:v>0</c:v>
                </c:pt>
                <c:pt idx="27">
                  <c:v>4.6511627906976735E-3</c:v>
                </c:pt>
                <c:pt idx="28">
                  <c:v>1.3953488372093001E-2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glr-1(n2461)_A3_0.02_50%'!$N$104</c:f>
              <c:strCache>
                <c:ptCount val="1"/>
                <c:pt idx="0">
                  <c:v>glr-1(n2461)_A3_13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N$105:$N$135</c:f>
              <c:numCache>
                <c:formatCode>General</c:formatCode>
                <c:ptCount val="31"/>
                <c:pt idx="1">
                  <c:v>1.4084507042253504E-2</c:v>
                </c:pt>
                <c:pt idx="2">
                  <c:v>3.5211267605633818E-2</c:v>
                </c:pt>
                <c:pt idx="3">
                  <c:v>7.0422535211267625E-3</c:v>
                </c:pt>
                <c:pt idx="4">
                  <c:v>2.8169014084506998E-2</c:v>
                </c:pt>
                <c:pt idx="5">
                  <c:v>2.8169014084506998E-2</c:v>
                </c:pt>
                <c:pt idx="6">
                  <c:v>1.7605633802816899E-2</c:v>
                </c:pt>
                <c:pt idx="7">
                  <c:v>1.0563380281690101E-2</c:v>
                </c:pt>
                <c:pt idx="8">
                  <c:v>1.0563380281690101E-2</c:v>
                </c:pt>
                <c:pt idx="9">
                  <c:v>1.0563380281690101E-2</c:v>
                </c:pt>
                <c:pt idx="10">
                  <c:v>7.0422535211267625E-3</c:v>
                </c:pt>
                <c:pt idx="11">
                  <c:v>7.0422535211267625E-3</c:v>
                </c:pt>
                <c:pt idx="12">
                  <c:v>2.1126760563380292E-2</c:v>
                </c:pt>
                <c:pt idx="13">
                  <c:v>3.8732394366197201E-2</c:v>
                </c:pt>
                <c:pt idx="14">
                  <c:v>8.4507042253521153E-2</c:v>
                </c:pt>
                <c:pt idx="15">
                  <c:v>9.5070422535211321E-2</c:v>
                </c:pt>
                <c:pt idx="16">
                  <c:v>0.17605633802816906</c:v>
                </c:pt>
                <c:pt idx="17">
                  <c:v>0.12676056338028197</c:v>
                </c:pt>
                <c:pt idx="18">
                  <c:v>7.0422535211267595E-2</c:v>
                </c:pt>
                <c:pt idx="19">
                  <c:v>4.9295774647887314E-2</c:v>
                </c:pt>
                <c:pt idx="20">
                  <c:v>5.9859154929577503E-2</c:v>
                </c:pt>
                <c:pt idx="21">
                  <c:v>4.5774647887323917E-2</c:v>
                </c:pt>
                <c:pt idx="22">
                  <c:v>2.1126760563380292E-2</c:v>
                </c:pt>
                <c:pt idx="23">
                  <c:v>7.0422535211267625E-3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3.5211267605633821E-3</c:v>
                </c:pt>
                <c:pt idx="28">
                  <c:v>0</c:v>
                </c:pt>
                <c:pt idx="29">
                  <c:v>3.5211267605633821E-3</c:v>
                </c:pt>
                <c:pt idx="30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glr-1(n2461)_A3_0.02_50%'!$O$104</c:f>
              <c:strCache>
                <c:ptCount val="1"/>
                <c:pt idx="0">
                  <c:v>glr-1(n2461)_A3_14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O$105:$O$135</c:f>
              <c:numCache>
                <c:formatCode>General</c:formatCode>
                <c:ptCount val="31"/>
                <c:pt idx="1">
                  <c:v>5.0251256281406984E-3</c:v>
                </c:pt>
                <c:pt idx="2">
                  <c:v>1.00502512562814E-2</c:v>
                </c:pt>
                <c:pt idx="3">
                  <c:v>5.0251256281406984E-3</c:v>
                </c:pt>
                <c:pt idx="4">
                  <c:v>1.00502512562814E-2</c:v>
                </c:pt>
                <c:pt idx="5">
                  <c:v>5.0251256281406984E-3</c:v>
                </c:pt>
                <c:pt idx="6">
                  <c:v>5.0251256281406984E-3</c:v>
                </c:pt>
                <c:pt idx="7">
                  <c:v>1.00502512562814E-2</c:v>
                </c:pt>
                <c:pt idx="8">
                  <c:v>5.0251256281406984E-3</c:v>
                </c:pt>
                <c:pt idx="9">
                  <c:v>0</c:v>
                </c:pt>
                <c:pt idx="10">
                  <c:v>1.00502512562814E-2</c:v>
                </c:pt>
                <c:pt idx="11">
                  <c:v>1.5075376884422099E-2</c:v>
                </c:pt>
                <c:pt idx="12">
                  <c:v>5.0251256281406984E-3</c:v>
                </c:pt>
                <c:pt idx="13">
                  <c:v>2.01005025125628E-2</c:v>
                </c:pt>
                <c:pt idx="14">
                  <c:v>6.5326633165829234E-2</c:v>
                </c:pt>
                <c:pt idx="15">
                  <c:v>5.0251256281406982E-2</c:v>
                </c:pt>
                <c:pt idx="16">
                  <c:v>8.5427135678391997E-2</c:v>
                </c:pt>
                <c:pt idx="17">
                  <c:v>8.0402010050251299E-2</c:v>
                </c:pt>
                <c:pt idx="18">
                  <c:v>0.15075376884422106</c:v>
                </c:pt>
                <c:pt idx="19">
                  <c:v>0.10552763819095498</c:v>
                </c:pt>
                <c:pt idx="20">
                  <c:v>7.0351758793969779E-2</c:v>
                </c:pt>
                <c:pt idx="21">
                  <c:v>8.5427135678391997E-2</c:v>
                </c:pt>
                <c:pt idx="22">
                  <c:v>4.0201005025125601E-2</c:v>
                </c:pt>
                <c:pt idx="23">
                  <c:v>4.0201005025125601E-2</c:v>
                </c:pt>
                <c:pt idx="24">
                  <c:v>3.0150753768844199E-2</c:v>
                </c:pt>
                <c:pt idx="25">
                  <c:v>2.01005025125628E-2</c:v>
                </c:pt>
                <c:pt idx="26">
                  <c:v>1.00502512562814E-2</c:v>
                </c:pt>
                <c:pt idx="27">
                  <c:v>5.0251256281406984E-3</c:v>
                </c:pt>
                <c:pt idx="28">
                  <c:v>5.0251256281406984E-3</c:v>
                </c:pt>
                <c:pt idx="29">
                  <c:v>5.0251256281406984E-3</c:v>
                </c:pt>
                <c:pt idx="30">
                  <c:v>5.0251256281406984E-3</c:v>
                </c:pt>
              </c:numCache>
            </c:numRef>
          </c:val>
        </c:ser>
        <c:ser>
          <c:idx val="14"/>
          <c:order val="14"/>
          <c:tx>
            <c:strRef>
              <c:f>'glr-1(n2461)_A3_0.02_50%'!$P$104</c:f>
              <c:strCache>
                <c:ptCount val="1"/>
                <c:pt idx="0">
                  <c:v>glr-1(n2461)_A3_15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P$105:$P$135</c:f>
              <c:numCache>
                <c:formatCode>General</c:formatCode>
                <c:ptCount val="31"/>
                <c:pt idx="1">
                  <c:v>3.6319612590799015E-2</c:v>
                </c:pt>
                <c:pt idx="2">
                  <c:v>3.8740920096852302E-2</c:v>
                </c:pt>
                <c:pt idx="3">
                  <c:v>4.1162227602905624E-2</c:v>
                </c:pt>
                <c:pt idx="4">
                  <c:v>3.8740920096852302E-2</c:v>
                </c:pt>
                <c:pt idx="5">
                  <c:v>3.8740920096852302E-2</c:v>
                </c:pt>
                <c:pt idx="6">
                  <c:v>4.6004842615012073E-2</c:v>
                </c:pt>
                <c:pt idx="7">
                  <c:v>5.084745762711862E-2</c:v>
                </c:pt>
                <c:pt idx="8">
                  <c:v>3.8740920096852302E-2</c:v>
                </c:pt>
                <c:pt idx="9">
                  <c:v>4.8426150121065395E-2</c:v>
                </c:pt>
                <c:pt idx="10">
                  <c:v>2.6634382566586012E-2</c:v>
                </c:pt>
                <c:pt idx="11">
                  <c:v>3.1476997578692531E-2</c:v>
                </c:pt>
                <c:pt idx="12">
                  <c:v>3.8740920096852302E-2</c:v>
                </c:pt>
                <c:pt idx="13">
                  <c:v>5.084745762711862E-2</c:v>
                </c:pt>
                <c:pt idx="14">
                  <c:v>4.35835351089588E-2</c:v>
                </c:pt>
                <c:pt idx="15">
                  <c:v>7.506053268765131E-2</c:v>
                </c:pt>
                <c:pt idx="16">
                  <c:v>4.6004842615012073E-2</c:v>
                </c:pt>
                <c:pt idx="17">
                  <c:v>5.32687651331719E-2</c:v>
                </c:pt>
                <c:pt idx="18">
                  <c:v>4.6004842615012073E-2</c:v>
                </c:pt>
                <c:pt idx="19">
                  <c:v>2.6634382566586012E-2</c:v>
                </c:pt>
                <c:pt idx="20">
                  <c:v>2.9055690072639202E-2</c:v>
                </c:pt>
                <c:pt idx="21">
                  <c:v>2.9055690072639202E-2</c:v>
                </c:pt>
                <c:pt idx="22">
                  <c:v>1.21065375302663E-2</c:v>
                </c:pt>
                <c:pt idx="23">
                  <c:v>9.6852300242130842E-3</c:v>
                </c:pt>
                <c:pt idx="24">
                  <c:v>1.21065375302663E-2</c:v>
                </c:pt>
                <c:pt idx="25">
                  <c:v>4.8426150121065404E-3</c:v>
                </c:pt>
                <c:pt idx="26">
                  <c:v>9.6852300242130842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5"/>
          <c:order val="15"/>
          <c:tx>
            <c:strRef>
              <c:f>'glr-1(n2461)_A3_0.02_50%'!$Q$104</c:f>
              <c:strCache>
                <c:ptCount val="1"/>
                <c:pt idx="0">
                  <c:v>glr-1(n2461)_A3_16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Q$105:$Q$135</c:f>
              <c:numCache>
                <c:formatCode>General</c:formatCode>
                <c:ptCount val="31"/>
                <c:pt idx="1">
                  <c:v>7.9051383399209498E-3</c:v>
                </c:pt>
                <c:pt idx="2">
                  <c:v>1.18577075098814E-2</c:v>
                </c:pt>
                <c:pt idx="3">
                  <c:v>1.58102766798419E-2</c:v>
                </c:pt>
                <c:pt idx="4">
                  <c:v>7.9051383399209498E-3</c:v>
                </c:pt>
                <c:pt idx="5">
                  <c:v>1.58102766798419E-2</c:v>
                </c:pt>
                <c:pt idx="6">
                  <c:v>0</c:v>
                </c:pt>
                <c:pt idx="7">
                  <c:v>3.9525691699604697E-3</c:v>
                </c:pt>
                <c:pt idx="8">
                  <c:v>3.9525691699604697E-3</c:v>
                </c:pt>
                <c:pt idx="9">
                  <c:v>3.9525691699604697E-3</c:v>
                </c:pt>
                <c:pt idx="10">
                  <c:v>0</c:v>
                </c:pt>
                <c:pt idx="11">
                  <c:v>2.3715415019762799E-2</c:v>
                </c:pt>
                <c:pt idx="12">
                  <c:v>3.1620553359683799E-2</c:v>
                </c:pt>
                <c:pt idx="13">
                  <c:v>8.3003952569170036E-2</c:v>
                </c:pt>
                <c:pt idx="14">
                  <c:v>0.118577075098814</c:v>
                </c:pt>
                <c:pt idx="15">
                  <c:v>0.158102766798419</c:v>
                </c:pt>
                <c:pt idx="16">
                  <c:v>0.110671936758893</c:v>
                </c:pt>
                <c:pt idx="17">
                  <c:v>0.14229249011857706</c:v>
                </c:pt>
                <c:pt idx="18">
                  <c:v>0.10671936758893302</c:v>
                </c:pt>
                <c:pt idx="19">
                  <c:v>5.9288537549407119E-2</c:v>
                </c:pt>
                <c:pt idx="20">
                  <c:v>1.9762845849802414E-2</c:v>
                </c:pt>
                <c:pt idx="21">
                  <c:v>3.1620553359683799E-2</c:v>
                </c:pt>
                <c:pt idx="22">
                  <c:v>1.18577075098814E-2</c:v>
                </c:pt>
                <c:pt idx="23">
                  <c:v>3.9525691699604697E-3</c:v>
                </c:pt>
                <c:pt idx="24">
                  <c:v>0</c:v>
                </c:pt>
                <c:pt idx="25">
                  <c:v>1.18577075098814E-2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6"/>
          <c:order val="16"/>
          <c:tx>
            <c:strRef>
              <c:f>'glr-1(n2461)_A3_0.02_50%'!$R$104</c:f>
              <c:strCache>
                <c:ptCount val="1"/>
                <c:pt idx="0">
                  <c:v>glr-1(n2461)_A3_17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R$105:$R$135</c:f>
              <c:numCache>
                <c:formatCode>General</c:formatCode>
                <c:ptCount val="31"/>
                <c:pt idx="1">
                  <c:v>2.1818181818181792E-2</c:v>
                </c:pt>
                <c:pt idx="2">
                  <c:v>2.5454545454545514E-2</c:v>
                </c:pt>
                <c:pt idx="3">
                  <c:v>2.1818181818181792E-2</c:v>
                </c:pt>
                <c:pt idx="4">
                  <c:v>1.45454545454545E-2</c:v>
                </c:pt>
                <c:pt idx="5">
                  <c:v>3.6363636363636398E-3</c:v>
                </c:pt>
                <c:pt idx="6">
                  <c:v>1.0909090909090898E-2</c:v>
                </c:pt>
                <c:pt idx="7">
                  <c:v>1.45454545454545E-2</c:v>
                </c:pt>
                <c:pt idx="8">
                  <c:v>1.8181818181818205E-2</c:v>
                </c:pt>
                <c:pt idx="9">
                  <c:v>7.2727272727272719E-3</c:v>
                </c:pt>
                <c:pt idx="10">
                  <c:v>1.0909090909090898E-2</c:v>
                </c:pt>
                <c:pt idx="11">
                  <c:v>7.2727272727272719E-3</c:v>
                </c:pt>
                <c:pt idx="12">
                  <c:v>2.5454545454545514E-2</c:v>
                </c:pt>
                <c:pt idx="13">
                  <c:v>4.3636363636363584E-2</c:v>
                </c:pt>
                <c:pt idx="14">
                  <c:v>6.9090909090909119E-2</c:v>
                </c:pt>
                <c:pt idx="15">
                  <c:v>8.3636363636363675E-2</c:v>
                </c:pt>
                <c:pt idx="16">
                  <c:v>0.18181818181818207</c:v>
                </c:pt>
                <c:pt idx="17">
                  <c:v>0.11272727272727304</c:v>
                </c:pt>
                <c:pt idx="18">
                  <c:v>7.6363636363636453E-2</c:v>
                </c:pt>
                <c:pt idx="19">
                  <c:v>6.9090909090909119E-2</c:v>
                </c:pt>
                <c:pt idx="20">
                  <c:v>5.8181818181818189E-2</c:v>
                </c:pt>
                <c:pt idx="21">
                  <c:v>4.0000000000000015E-2</c:v>
                </c:pt>
                <c:pt idx="22">
                  <c:v>1.8181818181818205E-2</c:v>
                </c:pt>
                <c:pt idx="23">
                  <c:v>1.0909090909090898E-2</c:v>
                </c:pt>
                <c:pt idx="24">
                  <c:v>1.0909090909090898E-2</c:v>
                </c:pt>
                <c:pt idx="25">
                  <c:v>0</c:v>
                </c:pt>
                <c:pt idx="26">
                  <c:v>3.6363636363636398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glr-1(n2461)_A3_0.02_50%'!$S$104</c:f>
              <c:strCache>
                <c:ptCount val="1"/>
                <c:pt idx="0">
                  <c:v>glr-1(n2461)_A3_18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S$105:$S$135</c:f>
              <c:numCache>
                <c:formatCode>General</c:formatCode>
                <c:ptCount val="31"/>
                <c:pt idx="1">
                  <c:v>5.0218340611353697E-2</c:v>
                </c:pt>
                <c:pt idx="2">
                  <c:v>3.0567685589519611E-2</c:v>
                </c:pt>
                <c:pt idx="3">
                  <c:v>2.6200873362445407E-2</c:v>
                </c:pt>
                <c:pt idx="4">
                  <c:v>2.8384279475982498E-2</c:v>
                </c:pt>
                <c:pt idx="5">
                  <c:v>3.4934497816593899E-2</c:v>
                </c:pt>
                <c:pt idx="6">
                  <c:v>3.2751091703056803E-2</c:v>
                </c:pt>
                <c:pt idx="7">
                  <c:v>4.1484716157205219E-2</c:v>
                </c:pt>
                <c:pt idx="8">
                  <c:v>3.9301310043668117E-2</c:v>
                </c:pt>
                <c:pt idx="9">
                  <c:v>3.0567685589519611E-2</c:v>
                </c:pt>
                <c:pt idx="10">
                  <c:v>2.8384279475982498E-2</c:v>
                </c:pt>
                <c:pt idx="11">
                  <c:v>5.2401746724890799E-2</c:v>
                </c:pt>
                <c:pt idx="12">
                  <c:v>3.4934497816593899E-2</c:v>
                </c:pt>
                <c:pt idx="13">
                  <c:v>2.1834061135371202E-2</c:v>
                </c:pt>
                <c:pt idx="14">
                  <c:v>4.5851528384279479E-2</c:v>
                </c:pt>
                <c:pt idx="15">
                  <c:v>6.3318777292576414E-2</c:v>
                </c:pt>
                <c:pt idx="16">
                  <c:v>7.2052401746724934E-2</c:v>
                </c:pt>
                <c:pt idx="17">
                  <c:v>5.6768558951965101E-2</c:v>
                </c:pt>
                <c:pt idx="18">
                  <c:v>3.9301310043668117E-2</c:v>
                </c:pt>
                <c:pt idx="19">
                  <c:v>3.9301310043668117E-2</c:v>
                </c:pt>
                <c:pt idx="20">
                  <c:v>5.2401746724890799E-2</c:v>
                </c:pt>
                <c:pt idx="21">
                  <c:v>3.4934497816593899E-2</c:v>
                </c:pt>
                <c:pt idx="22">
                  <c:v>1.9650655021834103E-2</c:v>
                </c:pt>
                <c:pt idx="23">
                  <c:v>2.1834061135371202E-2</c:v>
                </c:pt>
                <c:pt idx="24">
                  <c:v>2.1834061135371202E-2</c:v>
                </c:pt>
                <c:pt idx="25">
                  <c:v>4.3668122270742399E-3</c:v>
                </c:pt>
                <c:pt idx="26">
                  <c:v>6.5502183406113516E-3</c:v>
                </c:pt>
                <c:pt idx="27">
                  <c:v>8.7336244541484729E-3</c:v>
                </c:pt>
                <c:pt idx="28">
                  <c:v>6.5502183406113516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8"/>
          <c:order val="18"/>
          <c:tx>
            <c:strRef>
              <c:f>'glr-1(n2461)_A3_0.02_50%'!$T$104</c:f>
              <c:strCache>
                <c:ptCount val="1"/>
                <c:pt idx="0">
                  <c:v>glr-1(n2461)_A3_19</c:v>
                </c:pt>
              </c:strCache>
            </c:strRef>
          </c:tx>
          <c:marker>
            <c:symbol val="none"/>
          </c:marker>
          <c:cat>
            <c:numRef>
              <c:f>'glr-1(n246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3_0.02_50%'!$T$105:$T$135</c:f>
              <c:numCache>
                <c:formatCode>General</c:formatCode>
                <c:ptCount val="31"/>
                <c:pt idx="1">
                  <c:v>4.3478260869565202E-2</c:v>
                </c:pt>
                <c:pt idx="2">
                  <c:v>4.5454545454545497E-2</c:v>
                </c:pt>
                <c:pt idx="3">
                  <c:v>5.5335968379446619E-2</c:v>
                </c:pt>
                <c:pt idx="4">
                  <c:v>6.7193675889328147E-2</c:v>
                </c:pt>
                <c:pt idx="5">
                  <c:v>5.1383399209486223E-2</c:v>
                </c:pt>
                <c:pt idx="6">
                  <c:v>3.7549407114624518E-2</c:v>
                </c:pt>
                <c:pt idx="7">
                  <c:v>5.1383399209486223E-2</c:v>
                </c:pt>
                <c:pt idx="8">
                  <c:v>4.3478260869565202E-2</c:v>
                </c:pt>
                <c:pt idx="9">
                  <c:v>3.7549407114624518E-2</c:v>
                </c:pt>
                <c:pt idx="10">
                  <c:v>4.9407114624505914E-2</c:v>
                </c:pt>
                <c:pt idx="11">
                  <c:v>3.7549407114624518E-2</c:v>
                </c:pt>
                <c:pt idx="12">
                  <c:v>3.7549407114624518E-2</c:v>
                </c:pt>
                <c:pt idx="13">
                  <c:v>5.1383399209486223E-2</c:v>
                </c:pt>
                <c:pt idx="14">
                  <c:v>5.9288537549407119E-2</c:v>
                </c:pt>
                <c:pt idx="15">
                  <c:v>6.1264822134387387E-2</c:v>
                </c:pt>
                <c:pt idx="16">
                  <c:v>3.5573122529644313E-2</c:v>
                </c:pt>
                <c:pt idx="17">
                  <c:v>4.7430830039525737E-2</c:v>
                </c:pt>
                <c:pt idx="18">
                  <c:v>4.3478260869565202E-2</c:v>
                </c:pt>
                <c:pt idx="19">
                  <c:v>2.9644268774703615E-2</c:v>
                </c:pt>
                <c:pt idx="20">
                  <c:v>2.1739130434782601E-2</c:v>
                </c:pt>
                <c:pt idx="21">
                  <c:v>2.1739130434782601E-2</c:v>
                </c:pt>
                <c:pt idx="22">
                  <c:v>7.9051383399209498E-3</c:v>
                </c:pt>
                <c:pt idx="23">
                  <c:v>5.9288537549407119E-3</c:v>
                </c:pt>
                <c:pt idx="24">
                  <c:v>0</c:v>
                </c:pt>
                <c:pt idx="25">
                  <c:v>3.9525691699604697E-3</c:v>
                </c:pt>
                <c:pt idx="26">
                  <c:v>1.9762845849802418E-3</c:v>
                </c:pt>
                <c:pt idx="27">
                  <c:v>0</c:v>
                </c:pt>
                <c:pt idx="28">
                  <c:v>1.9762845849802418E-3</c:v>
                </c:pt>
                <c:pt idx="29">
                  <c:v>1.9762845849802418E-3</c:v>
                </c:pt>
                <c:pt idx="30">
                  <c:v>0</c:v>
                </c:pt>
              </c:numCache>
            </c:numRef>
          </c:val>
        </c:ser>
        <c:marker val="1"/>
        <c:axId val="165964800"/>
        <c:axId val="165987072"/>
      </c:lineChart>
      <c:catAx>
        <c:axId val="165964800"/>
        <c:scaling>
          <c:orientation val="minMax"/>
        </c:scaling>
        <c:axPos val="b"/>
        <c:numFmt formatCode="0.0_ " sourceLinked="1"/>
        <c:tickLblPos val="nextTo"/>
        <c:crossAx val="165987072"/>
        <c:crosses val="autoZero"/>
        <c:auto val="1"/>
        <c:lblAlgn val="ctr"/>
        <c:lblOffset val="100"/>
        <c:tickLblSkip val="5"/>
        <c:tickMarkSkip val="5"/>
      </c:catAx>
      <c:valAx>
        <c:axId val="165987072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5964800"/>
        <c:crosses val="autoZero"/>
        <c:crossBetween val="between"/>
      </c:valAx>
    </c:plotArea>
    <c:plotVisOnly val="1"/>
  </c:chart>
  <c:externalData r:id="rId1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glr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1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glr-1(n2461)_A1_0.02_50%'!$B$104</c:f>
              <c:strCache>
                <c:ptCount val="1"/>
                <c:pt idx="0">
                  <c:v>glr-1(n2461)_A1_01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B$105:$B$135</c:f>
              <c:numCache>
                <c:formatCode>General</c:formatCode>
                <c:ptCount val="31"/>
                <c:pt idx="1">
                  <c:v>5.1146384479717796E-2</c:v>
                </c:pt>
                <c:pt idx="2">
                  <c:v>2.9982363315696599E-2</c:v>
                </c:pt>
                <c:pt idx="3">
                  <c:v>5.8201058201058163E-2</c:v>
                </c:pt>
                <c:pt idx="4">
                  <c:v>5.6437389770723101E-2</c:v>
                </c:pt>
                <c:pt idx="5">
                  <c:v>4.9382716049382734E-2</c:v>
                </c:pt>
                <c:pt idx="6">
                  <c:v>6.7019400352733738E-2</c:v>
                </c:pt>
                <c:pt idx="7">
                  <c:v>5.1146384479717796E-2</c:v>
                </c:pt>
                <c:pt idx="8">
                  <c:v>4.4091710758377416E-2</c:v>
                </c:pt>
                <c:pt idx="9">
                  <c:v>5.29100529100529E-2</c:v>
                </c:pt>
                <c:pt idx="10">
                  <c:v>4.5855379188712485E-2</c:v>
                </c:pt>
                <c:pt idx="11">
                  <c:v>4.2328042328042312E-2</c:v>
                </c:pt>
                <c:pt idx="12">
                  <c:v>4.2328042328042312E-2</c:v>
                </c:pt>
                <c:pt idx="13">
                  <c:v>5.29100529100529E-2</c:v>
                </c:pt>
                <c:pt idx="14">
                  <c:v>5.6437389770723101E-2</c:v>
                </c:pt>
                <c:pt idx="15">
                  <c:v>3.7037037037037014E-2</c:v>
                </c:pt>
                <c:pt idx="16">
                  <c:v>4.4091710758377416E-2</c:v>
                </c:pt>
                <c:pt idx="17">
                  <c:v>2.1164021164021198E-2</c:v>
                </c:pt>
                <c:pt idx="18">
                  <c:v>2.6455026455026509E-2</c:v>
                </c:pt>
                <c:pt idx="19">
                  <c:v>3.1746031746031703E-2</c:v>
                </c:pt>
                <c:pt idx="20">
                  <c:v>2.8218694885361599E-2</c:v>
                </c:pt>
                <c:pt idx="21">
                  <c:v>1.7636684303351E-2</c:v>
                </c:pt>
                <c:pt idx="22">
                  <c:v>1.0582010582010601E-2</c:v>
                </c:pt>
                <c:pt idx="23">
                  <c:v>1.2345679012345704E-2</c:v>
                </c:pt>
                <c:pt idx="24">
                  <c:v>5.2910052910052898E-3</c:v>
                </c:pt>
                <c:pt idx="25">
                  <c:v>7.054673721340392E-3</c:v>
                </c:pt>
                <c:pt idx="26">
                  <c:v>3.5273368606701921E-3</c:v>
                </c:pt>
                <c:pt idx="27">
                  <c:v>1.7636684303351004E-3</c:v>
                </c:pt>
                <c:pt idx="28">
                  <c:v>1.7636684303351004E-3</c:v>
                </c:pt>
                <c:pt idx="29">
                  <c:v>0</c:v>
                </c:pt>
                <c:pt idx="30">
                  <c:v>1.7636684303351004E-3</c:v>
                </c:pt>
              </c:numCache>
            </c:numRef>
          </c:val>
        </c:ser>
        <c:ser>
          <c:idx val="1"/>
          <c:order val="1"/>
          <c:tx>
            <c:strRef>
              <c:f>'glr-1(n2461)_A1_0.02_50%'!$C$104</c:f>
              <c:strCache>
                <c:ptCount val="1"/>
                <c:pt idx="0">
                  <c:v>glr-1(n2461)_A1_02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C$105:$C$135</c:f>
              <c:numCache>
                <c:formatCode>General</c:formatCode>
                <c:ptCount val="31"/>
                <c:pt idx="1">
                  <c:v>6.2182741116751324E-2</c:v>
                </c:pt>
                <c:pt idx="2">
                  <c:v>6.7258883248731013E-2</c:v>
                </c:pt>
                <c:pt idx="3">
                  <c:v>6.9796954314720855E-2</c:v>
                </c:pt>
                <c:pt idx="4">
                  <c:v>8.3756345177665129E-2</c:v>
                </c:pt>
                <c:pt idx="5">
                  <c:v>6.8527918781725899E-2</c:v>
                </c:pt>
                <c:pt idx="6">
                  <c:v>7.3604060913705596E-2</c:v>
                </c:pt>
                <c:pt idx="7">
                  <c:v>7.1065989847715727E-2</c:v>
                </c:pt>
                <c:pt idx="8">
                  <c:v>4.8223350253807085E-2</c:v>
                </c:pt>
                <c:pt idx="9">
                  <c:v>5.583756345177672E-2</c:v>
                </c:pt>
                <c:pt idx="10">
                  <c:v>5.4568527918781737E-2</c:v>
                </c:pt>
                <c:pt idx="11">
                  <c:v>4.0609137055837616E-2</c:v>
                </c:pt>
                <c:pt idx="12">
                  <c:v>5.2030456852791937E-2</c:v>
                </c:pt>
                <c:pt idx="13">
                  <c:v>3.4263959390862901E-2</c:v>
                </c:pt>
                <c:pt idx="14">
                  <c:v>2.6649746192893408E-2</c:v>
                </c:pt>
                <c:pt idx="15">
                  <c:v>2.4111675126903608E-2</c:v>
                </c:pt>
                <c:pt idx="16">
                  <c:v>1.9035532994923901E-2</c:v>
                </c:pt>
                <c:pt idx="17">
                  <c:v>1.26903553299492E-2</c:v>
                </c:pt>
                <c:pt idx="18">
                  <c:v>2.2842639593908601E-2</c:v>
                </c:pt>
                <c:pt idx="19">
                  <c:v>1.26903553299492E-2</c:v>
                </c:pt>
                <c:pt idx="20">
                  <c:v>1.01522842639594E-2</c:v>
                </c:pt>
                <c:pt idx="21">
                  <c:v>1.1421319796954304E-2</c:v>
                </c:pt>
                <c:pt idx="22">
                  <c:v>0</c:v>
                </c:pt>
                <c:pt idx="23">
                  <c:v>8.8832487309644728E-3</c:v>
                </c:pt>
                <c:pt idx="24">
                  <c:v>3.8071065989847717E-3</c:v>
                </c:pt>
                <c:pt idx="25">
                  <c:v>1.2690355329949201E-3</c:v>
                </c:pt>
                <c:pt idx="26">
                  <c:v>3.8071065989847717E-3</c:v>
                </c:pt>
                <c:pt idx="27">
                  <c:v>1.2690355329949201E-3</c:v>
                </c:pt>
                <c:pt idx="28">
                  <c:v>3.8071065989847717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glr-1(n2461)_A1_0.02_50%'!$D$104</c:f>
              <c:strCache>
                <c:ptCount val="1"/>
                <c:pt idx="0">
                  <c:v>glr-1(n2461)_A1_03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D$105:$D$135</c:f>
              <c:numCache>
                <c:formatCode>General</c:formatCode>
                <c:ptCount val="31"/>
                <c:pt idx="1">
                  <c:v>6.0034305317324198E-2</c:v>
                </c:pt>
                <c:pt idx="2">
                  <c:v>6.0034305317324198E-2</c:v>
                </c:pt>
                <c:pt idx="3">
                  <c:v>6.17495711835334E-2</c:v>
                </c:pt>
                <c:pt idx="4">
                  <c:v>5.8319039451114912E-2</c:v>
                </c:pt>
                <c:pt idx="5">
                  <c:v>6.6895368782161166E-2</c:v>
                </c:pt>
                <c:pt idx="6">
                  <c:v>4.8027444253859304E-2</c:v>
                </c:pt>
                <c:pt idx="7">
                  <c:v>7.2041166380788974E-2</c:v>
                </c:pt>
                <c:pt idx="8">
                  <c:v>6.17495711835334E-2</c:v>
                </c:pt>
                <c:pt idx="9">
                  <c:v>6.0034305317324198E-2</c:v>
                </c:pt>
                <c:pt idx="10">
                  <c:v>5.1457975986277896E-2</c:v>
                </c:pt>
                <c:pt idx="11">
                  <c:v>4.1166380789022301E-2</c:v>
                </c:pt>
                <c:pt idx="12">
                  <c:v>3.7735849056603821E-2</c:v>
                </c:pt>
                <c:pt idx="13">
                  <c:v>5.1457975986277896E-2</c:v>
                </c:pt>
                <c:pt idx="14">
                  <c:v>3.0874785591766714E-2</c:v>
                </c:pt>
                <c:pt idx="15">
                  <c:v>2.9159519725557501E-2</c:v>
                </c:pt>
                <c:pt idx="16">
                  <c:v>2.4013722126929718E-2</c:v>
                </c:pt>
                <c:pt idx="17">
                  <c:v>1.88679245283019E-2</c:v>
                </c:pt>
                <c:pt idx="18">
                  <c:v>2.2298456260720398E-2</c:v>
                </c:pt>
                <c:pt idx="19">
                  <c:v>1.7152658662092601E-2</c:v>
                </c:pt>
                <c:pt idx="20">
                  <c:v>1.54373927958834E-2</c:v>
                </c:pt>
                <c:pt idx="21">
                  <c:v>1.88679245283019E-2</c:v>
                </c:pt>
                <c:pt idx="22">
                  <c:v>3.4305317324185218E-3</c:v>
                </c:pt>
                <c:pt idx="23">
                  <c:v>5.1457975986277903E-3</c:v>
                </c:pt>
                <c:pt idx="24">
                  <c:v>1.7152658662092605E-3</c:v>
                </c:pt>
                <c:pt idx="25">
                  <c:v>1.7152658662092605E-3</c:v>
                </c:pt>
                <c:pt idx="26">
                  <c:v>5.1457975986277903E-3</c:v>
                </c:pt>
                <c:pt idx="27">
                  <c:v>3.4305317324185218E-3</c:v>
                </c:pt>
                <c:pt idx="28">
                  <c:v>1.7152658662092605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glr-1(n2461)_A1_0.02_50%'!$E$104</c:f>
              <c:strCache>
                <c:ptCount val="1"/>
                <c:pt idx="0">
                  <c:v>glr-1(n2461)_A1_04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E$105:$E$135</c:f>
              <c:numCache>
                <c:formatCode>General</c:formatCode>
                <c:ptCount val="31"/>
                <c:pt idx="1">
                  <c:v>7.1808510638297907E-2</c:v>
                </c:pt>
                <c:pt idx="2">
                  <c:v>3.7234042553191522E-2</c:v>
                </c:pt>
                <c:pt idx="3">
                  <c:v>2.9255319148936202E-2</c:v>
                </c:pt>
                <c:pt idx="4">
                  <c:v>1.5957446808510599E-2</c:v>
                </c:pt>
                <c:pt idx="5">
                  <c:v>3.1914893617021316E-2</c:v>
                </c:pt>
                <c:pt idx="6">
                  <c:v>3.7234042553191522E-2</c:v>
                </c:pt>
                <c:pt idx="7">
                  <c:v>2.1276595744680899E-2</c:v>
                </c:pt>
                <c:pt idx="8">
                  <c:v>3.4574468085106405E-2</c:v>
                </c:pt>
                <c:pt idx="9">
                  <c:v>2.9255319148936202E-2</c:v>
                </c:pt>
                <c:pt idx="10">
                  <c:v>3.9893617021276619E-2</c:v>
                </c:pt>
                <c:pt idx="11">
                  <c:v>5.0531914893617018E-2</c:v>
                </c:pt>
                <c:pt idx="12">
                  <c:v>5.31914893617021E-2</c:v>
                </c:pt>
                <c:pt idx="13">
                  <c:v>5.0531914893617018E-2</c:v>
                </c:pt>
                <c:pt idx="14">
                  <c:v>9.3085106382978705E-2</c:v>
                </c:pt>
                <c:pt idx="15">
                  <c:v>6.382978723404252E-2</c:v>
                </c:pt>
                <c:pt idx="16">
                  <c:v>5.31914893617021E-2</c:v>
                </c:pt>
                <c:pt idx="17">
                  <c:v>4.7872340425531915E-2</c:v>
                </c:pt>
                <c:pt idx="18">
                  <c:v>5.5851063829787211E-2</c:v>
                </c:pt>
                <c:pt idx="19">
                  <c:v>3.9893617021276619E-2</c:v>
                </c:pt>
                <c:pt idx="20">
                  <c:v>3.1914893617021316E-2</c:v>
                </c:pt>
                <c:pt idx="21">
                  <c:v>2.3936170212766002E-2</c:v>
                </c:pt>
                <c:pt idx="22">
                  <c:v>1.0638297872340394E-2</c:v>
                </c:pt>
                <c:pt idx="23">
                  <c:v>1.0638297872340394E-2</c:v>
                </c:pt>
                <c:pt idx="24">
                  <c:v>1.0638297872340394E-2</c:v>
                </c:pt>
                <c:pt idx="25">
                  <c:v>2.6595744680851107E-3</c:v>
                </c:pt>
                <c:pt idx="26">
                  <c:v>2.6595744680851107E-3</c:v>
                </c:pt>
                <c:pt idx="27">
                  <c:v>0</c:v>
                </c:pt>
                <c:pt idx="28">
                  <c:v>2.6595744680851107E-3</c:v>
                </c:pt>
                <c:pt idx="29">
                  <c:v>0</c:v>
                </c:pt>
                <c:pt idx="30">
                  <c:v>2.6595744680851107E-3</c:v>
                </c:pt>
              </c:numCache>
            </c:numRef>
          </c:val>
        </c:ser>
        <c:ser>
          <c:idx val="4"/>
          <c:order val="4"/>
          <c:tx>
            <c:strRef>
              <c:f>'glr-1(n2461)_A1_0.02_50%'!$F$104</c:f>
              <c:strCache>
                <c:ptCount val="1"/>
                <c:pt idx="0">
                  <c:v>glr-1(n2461)_A1_05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F$105:$F$135</c:f>
              <c:numCache>
                <c:formatCode>General</c:formatCode>
                <c:ptCount val="31"/>
                <c:pt idx="1">
                  <c:v>6.2184873949579812E-2</c:v>
                </c:pt>
                <c:pt idx="2">
                  <c:v>7.0588235294117604E-2</c:v>
                </c:pt>
                <c:pt idx="3">
                  <c:v>7.731092436974793E-2</c:v>
                </c:pt>
                <c:pt idx="4">
                  <c:v>7.0588235294117604E-2</c:v>
                </c:pt>
                <c:pt idx="5">
                  <c:v>8.4033613445378186E-2</c:v>
                </c:pt>
                <c:pt idx="6">
                  <c:v>7.2268907563025203E-2</c:v>
                </c:pt>
                <c:pt idx="7">
                  <c:v>5.2100840336134498E-2</c:v>
                </c:pt>
                <c:pt idx="8">
                  <c:v>5.8823529411764698E-2</c:v>
                </c:pt>
                <c:pt idx="9">
                  <c:v>5.0420168067226885E-2</c:v>
                </c:pt>
                <c:pt idx="10">
                  <c:v>5.0420168067226885E-2</c:v>
                </c:pt>
                <c:pt idx="11">
                  <c:v>4.0336134453781536E-2</c:v>
                </c:pt>
                <c:pt idx="12">
                  <c:v>4.0336134453781536E-2</c:v>
                </c:pt>
                <c:pt idx="13">
                  <c:v>4.7058823529411813E-2</c:v>
                </c:pt>
                <c:pt idx="14">
                  <c:v>4.5378151260504179E-2</c:v>
                </c:pt>
                <c:pt idx="15">
                  <c:v>3.02521008403361E-2</c:v>
                </c:pt>
                <c:pt idx="16">
                  <c:v>2.6890756302521E-2</c:v>
                </c:pt>
                <c:pt idx="17">
                  <c:v>1.1764705882352905E-2</c:v>
                </c:pt>
                <c:pt idx="18">
                  <c:v>1.0084033613445401E-2</c:v>
                </c:pt>
                <c:pt idx="19">
                  <c:v>8.4033613445378061E-3</c:v>
                </c:pt>
                <c:pt idx="20">
                  <c:v>1.6806722689075605E-2</c:v>
                </c:pt>
                <c:pt idx="21">
                  <c:v>3.361344537815131E-3</c:v>
                </c:pt>
                <c:pt idx="22">
                  <c:v>6.7226890756302516E-3</c:v>
                </c:pt>
                <c:pt idx="23">
                  <c:v>1.680672268907561E-3</c:v>
                </c:pt>
                <c:pt idx="24">
                  <c:v>0</c:v>
                </c:pt>
                <c:pt idx="25">
                  <c:v>0</c:v>
                </c:pt>
                <c:pt idx="26">
                  <c:v>3.361344537815131E-3</c:v>
                </c:pt>
                <c:pt idx="27">
                  <c:v>1.680672268907561E-3</c:v>
                </c:pt>
                <c:pt idx="28">
                  <c:v>1.680672268907561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glr-1(n2461)_A1_0.02_50%'!$G$104</c:f>
              <c:strCache>
                <c:ptCount val="1"/>
                <c:pt idx="0">
                  <c:v>glr-1(n2461)_A1_06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G$105:$G$135</c:f>
              <c:numCache>
                <c:formatCode>General</c:formatCode>
                <c:ptCount val="31"/>
                <c:pt idx="1">
                  <c:v>4.6413502109704602E-2</c:v>
                </c:pt>
                <c:pt idx="2">
                  <c:v>5.9071729957805921E-2</c:v>
                </c:pt>
                <c:pt idx="3">
                  <c:v>4.6413502109704602E-2</c:v>
                </c:pt>
                <c:pt idx="4">
                  <c:v>7.1729957805907199E-2</c:v>
                </c:pt>
                <c:pt idx="5">
                  <c:v>4.2194092827004218E-2</c:v>
                </c:pt>
                <c:pt idx="6">
                  <c:v>4.2194092827004218E-2</c:v>
                </c:pt>
                <c:pt idx="7">
                  <c:v>4.8523206751054884E-2</c:v>
                </c:pt>
                <c:pt idx="8">
                  <c:v>6.5400843881856505E-2</c:v>
                </c:pt>
                <c:pt idx="9">
                  <c:v>4.2194092827004218E-2</c:v>
                </c:pt>
                <c:pt idx="10">
                  <c:v>3.7974683544303806E-2</c:v>
                </c:pt>
                <c:pt idx="11">
                  <c:v>3.5864978902953606E-2</c:v>
                </c:pt>
                <c:pt idx="12">
                  <c:v>5.0632911392405118E-2</c:v>
                </c:pt>
                <c:pt idx="13">
                  <c:v>5.9071729957805921E-2</c:v>
                </c:pt>
                <c:pt idx="14">
                  <c:v>4.4303797468354403E-2</c:v>
                </c:pt>
                <c:pt idx="15">
                  <c:v>5.4852320675105502E-2</c:v>
                </c:pt>
                <c:pt idx="16">
                  <c:v>3.5864978902953606E-2</c:v>
                </c:pt>
                <c:pt idx="17">
                  <c:v>4.8523206751054884E-2</c:v>
                </c:pt>
                <c:pt idx="18">
                  <c:v>2.7426160337552692E-2</c:v>
                </c:pt>
                <c:pt idx="19">
                  <c:v>1.4767932489451498E-2</c:v>
                </c:pt>
                <c:pt idx="20">
                  <c:v>3.37552742616034E-2</c:v>
                </c:pt>
                <c:pt idx="21">
                  <c:v>2.3206751054852294E-2</c:v>
                </c:pt>
                <c:pt idx="22">
                  <c:v>6.3291139240506319E-3</c:v>
                </c:pt>
                <c:pt idx="23">
                  <c:v>6.3291139240506319E-3</c:v>
                </c:pt>
                <c:pt idx="24">
                  <c:v>2.1097046413502112E-3</c:v>
                </c:pt>
                <c:pt idx="25">
                  <c:v>4.2194092827004225E-3</c:v>
                </c:pt>
                <c:pt idx="26">
                  <c:v>0</c:v>
                </c:pt>
                <c:pt idx="27">
                  <c:v>2.1097046413502112E-3</c:v>
                </c:pt>
                <c:pt idx="28">
                  <c:v>0</c:v>
                </c:pt>
                <c:pt idx="29">
                  <c:v>0</c:v>
                </c:pt>
                <c:pt idx="30">
                  <c:v>2.1097046413502112E-3</c:v>
                </c:pt>
              </c:numCache>
            </c:numRef>
          </c:val>
        </c:ser>
        <c:ser>
          <c:idx val="6"/>
          <c:order val="6"/>
          <c:tx>
            <c:strRef>
              <c:f>'glr-1(n2461)_A1_0.02_50%'!$H$104</c:f>
              <c:strCache>
                <c:ptCount val="1"/>
                <c:pt idx="0">
                  <c:v>glr-1(n2461)_A1_07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H$105:$H$135</c:f>
              <c:numCache>
                <c:formatCode>General</c:formatCode>
                <c:ptCount val="31"/>
                <c:pt idx="1">
                  <c:v>6.5459610027855233E-2</c:v>
                </c:pt>
                <c:pt idx="2">
                  <c:v>6.5459610027855233E-2</c:v>
                </c:pt>
                <c:pt idx="3">
                  <c:v>6.5459610027855233E-2</c:v>
                </c:pt>
                <c:pt idx="4">
                  <c:v>9.3314763231197806E-2</c:v>
                </c:pt>
                <c:pt idx="5">
                  <c:v>7.1030640668523701E-2</c:v>
                </c:pt>
                <c:pt idx="6">
                  <c:v>7.52089136490251E-2</c:v>
                </c:pt>
                <c:pt idx="7">
                  <c:v>7.1030640668523701E-2</c:v>
                </c:pt>
                <c:pt idx="8">
                  <c:v>4.1782729805013921E-2</c:v>
                </c:pt>
                <c:pt idx="9">
                  <c:v>5.4317548746518118E-2</c:v>
                </c:pt>
                <c:pt idx="10">
                  <c:v>3.2033426183844013E-2</c:v>
                </c:pt>
                <c:pt idx="11">
                  <c:v>4.1782729805013921E-2</c:v>
                </c:pt>
                <c:pt idx="12">
                  <c:v>4.1782729805013921E-2</c:v>
                </c:pt>
                <c:pt idx="13">
                  <c:v>3.7604456824512501E-2</c:v>
                </c:pt>
                <c:pt idx="14">
                  <c:v>2.78551532033426E-2</c:v>
                </c:pt>
                <c:pt idx="15">
                  <c:v>3.3426183844011088E-2</c:v>
                </c:pt>
                <c:pt idx="16">
                  <c:v>1.9498607242339806E-2</c:v>
                </c:pt>
                <c:pt idx="17">
                  <c:v>2.9247910863509721E-2</c:v>
                </c:pt>
                <c:pt idx="18">
                  <c:v>1.2534818941504199E-2</c:v>
                </c:pt>
                <c:pt idx="19">
                  <c:v>1.67130919220056E-2</c:v>
                </c:pt>
                <c:pt idx="20">
                  <c:v>8.3565459610027981E-3</c:v>
                </c:pt>
                <c:pt idx="21">
                  <c:v>9.7493036211699202E-3</c:v>
                </c:pt>
                <c:pt idx="22">
                  <c:v>2.7855153203342601E-3</c:v>
                </c:pt>
                <c:pt idx="23">
                  <c:v>4.1782729805013921E-3</c:v>
                </c:pt>
                <c:pt idx="24">
                  <c:v>6.9637883008356518E-3</c:v>
                </c:pt>
                <c:pt idx="25">
                  <c:v>5.571030640668522E-3</c:v>
                </c:pt>
                <c:pt idx="26">
                  <c:v>4.1782729805013921E-3</c:v>
                </c:pt>
                <c:pt idx="27">
                  <c:v>1.3927576601671305E-3</c:v>
                </c:pt>
                <c:pt idx="28">
                  <c:v>0</c:v>
                </c:pt>
                <c:pt idx="29">
                  <c:v>2.7855153203342601E-3</c:v>
                </c:pt>
                <c:pt idx="30">
                  <c:v>1.3927576601671305E-3</c:v>
                </c:pt>
              </c:numCache>
            </c:numRef>
          </c:val>
        </c:ser>
        <c:ser>
          <c:idx val="7"/>
          <c:order val="7"/>
          <c:tx>
            <c:strRef>
              <c:f>'glr-1(n2461)_A1_0.02_50%'!$I$104</c:f>
              <c:strCache>
                <c:ptCount val="1"/>
                <c:pt idx="0">
                  <c:v>glr-1(n2461)_A1_08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I$105:$I$135</c:f>
              <c:numCache>
                <c:formatCode>General</c:formatCode>
                <c:ptCount val="31"/>
                <c:pt idx="1">
                  <c:v>5.1612903225806521E-2</c:v>
                </c:pt>
                <c:pt idx="2">
                  <c:v>5.8064516129032316E-2</c:v>
                </c:pt>
                <c:pt idx="3">
                  <c:v>6.12903225806452E-2</c:v>
                </c:pt>
                <c:pt idx="4">
                  <c:v>4.6774193548387098E-2</c:v>
                </c:pt>
                <c:pt idx="5">
                  <c:v>4.8387096774193498E-2</c:v>
                </c:pt>
                <c:pt idx="6">
                  <c:v>0.05</c:v>
                </c:pt>
                <c:pt idx="7">
                  <c:v>4.8387096774193498E-2</c:v>
                </c:pt>
                <c:pt idx="8">
                  <c:v>5.322580645161288E-2</c:v>
                </c:pt>
                <c:pt idx="9">
                  <c:v>5.1612903225806521E-2</c:v>
                </c:pt>
                <c:pt idx="10">
                  <c:v>5.6451612903225819E-2</c:v>
                </c:pt>
                <c:pt idx="11">
                  <c:v>5.6451612903225819E-2</c:v>
                </c:pt>
                <c:pt idx="12">
                  <c:v>5.322580645161288E-2</c:v>
                </c:pt>
                <c:pt idx="13">
                  <c:v>4.8387096774193498E-2</c:v>
                </c:pt>
                <c:pt idx="14">
                  <c:v>3.5483870967741915E-2</c:v>
                </c:pt>
                <c:pt idx="15">
                  <c:v>4.1935483870967703E-2</c:v>
                </c:pt>
                <c:pt idx="16">
                  <c:v>3.7096774193548399E-2</c:v>
                </c:pt>
                <c:pt idx="17">
                  <c:v>3.7096774193548399E-2</c:v>
                </c:pt>
                <c:pt idx="18">
                  <c:v>4.1935483870967703E-2</c:v>
                </c:pt>
                <c:pt idx="19">
                  <c:v>2.4193548387096801E-2</c:v>
                </c:pt>
                <c:pt idx="20">
                  <c:v>9.677419354838717E-3</c:v>
                </c:pt>
                <c:pt idx="21">
                  <c:v>1.1290322580645199E-2</c:v>
                </c:pt>
                <c:pt idx="22">
                  <c:v>4.838709677419362E-3</c:v>
                </c:pt>
                <c:pt idx="23">
                  <c:v>1.1290322580645199E-2</c:v>
                </c:pt>
                <c:pt idx="24">
                  <c:v>8.0645161290322648E-3</c:v>
                </c:pt>
                <c:pt idx="25">
                  <c:v>3.2258064516129019E-3</c:v>
                </c:pt>
                <c:pt idx="26">
                  <c:v>3.2258064516129019E-3</c:v>
                </c:pt>
                <c:pt idx="27">
                  <c:v>0</c:v>
                </c:pt>
                <c:pt idx="28">
                  <c:v>1.6129032258064505E-3</c:v>
                </c:pt>
                <c:pt idx="29">
                  <c:v>0</c:v>
                </c:pt>
                <c:pt idx="30">
                  <c:v>1.6129032258064505E-3</c:v>
                </c:pt>
              </c:numCache>
            </c:numRef>
          </c:val>
        </c:ser>
        <c:ser>
          <c:idx val="8"/>
          <c:order val="8"/>
          <c:tx>
            <c:strRef>
              <c:f>'glr-1(n2461)_A1_0.02_50%'!$J$104</c:f>
              <c:strCache>
                <c:ptCount val="1"/>
                <c:pt idx="0">
                  <c:v>glr-1(n2461)_A1_09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J$105:$J$135</c:f>
              <c:numCache>
                <c:formatCode>General</c:formatCode>
                <c:ptCount val="31"/>
                <c:pt idx="1">
                  <c:v>6.3265306122449003E-2</c:v>
                </c:pt>
                <c:pt idx="2">
                  <c:v>4.2857142857142913E-2</c:v>
                </c:pt>
                <c:pt idx="3">
                  <c:v>5.1020408163265286E-2</c:v>
                </c:pt>
                <c:pt idx="4">
                  <c:v>5.3061224489795902E-2</c:v>
                </c:pt>
                <c:pt idx="5">
                  <c:v>3.4693877551020422E-2</c:v>
                </c:pt>
                <c:pt idx="6">
                  <c:v>3.8775510204081598E-2</c:v>
                </c:pt>
                <c:pt idx="7">
                  <c:v>5.1020408163265286E-2</c:v>
                </c:pt>
                <c:pt idx="8">
                  <c:v>6.7346938775510234E-2</c:v>
                </c:pt>
                <c:pt idx="9">
                  <c:v>4.4897959183673515E-2</c:v>
                </c:pt>
                <c:pt idx="10">
                  <c:v>3.673469387755101E-2</c:v>
                </c:pt>
                <c:pt idx="11">
                  <c:v>7.1428571428571411E-2</c:v>
                </c:pt>
                <c:pt idx="12">
                  <c:v>5.3061224489795902E-2</c:v>
                </c:pt>
                <c:pt idx="13">
                  <c:v>4.6938775510204082E-2</c:v>
                </c:pt>
                <c:pt idx="14">
                  <c:v>5.1020408163265286E-2</c:v>
                </c:pt>
                <c:pt idx="15">
                  <c:v>4.8979591836734719E-2</c:v>
                </c:pt>
                <c:pt idx="16">
                  <c:v>5.1020408163265286E-2</c:v>
                </c:pt>
                <c:pt idx="17">
                  <c:v>3.8775510204081598E-2</c:v>
                </c:pt>
                <c:pt idx="18">
                  <c:v>1.8367346938775498E-2</c:v>
                </c:pt>
                <c:pt idx="19">
                  <c:v>1.8367346938775498E-2</c:v>
                </c:pt>
                <c:pt idx="20">
                  <c:v>1.6326530612244903E-2</c:v>
                </c:pt>
                <c:pt idx="21">
                  <c:v>1.6326530612244903E-2</c:v>
                </c:pt>
                <c:pt idx="22">
                  <c:v>1.6326530612244903E-2</c:v>
                </c:pt>
                <c:pt idx="23">
                  <c:v>4.0816326530612223E-3</c:v>
                </c:pt>
                <c:pt idx="24">
                  <c:v>2.0408163265306098E-3</c:v>
                </c:pt>
                <c:pt idx="25">
                  <c:v>6.1224489795918399E-3</c:v>
                </c:pt>
                <c:pt idx="26">
                  <c:v>0</c:v>
                </c:pt>
                <c:pt idx="27">
                  <c:v>6.1224489795918399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glr-1(n2461)_A1_0.02_50%'!$K$104</c:f>
              <c:strCache>
                <c:ptCount val="1"/>
                <c:pt idx="0">
                  <c:v>glr-1(n2461)_A1_10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K$105:$K$135</c:f>
              <c:numCache>
                <c:formatCode>General</c:formatCode>
                <c:ptCount val="31"/>
                <c:pt idx="1">
                  <c:v>5.9548254620123219E-2</c:v>
                </c:pt>
                <c:pt idx="2">
                  <c:v>4.9281314168377797E-2</c:v>
                </c:pt>
                <c:pt idx="3">
                  <c:v>7.1868583162217697E-2</c:v>
                </c:pt>
                <c:pt idx="4">
                  <c:v>5.5441478439425103E-2</c:v>
                </c:pt>
                <c:pt idx="5">
                  <c:v>4.7227926078028719E-2</c:v>
                </c:pt>
                <c:pt idx="6">
                  <c:v>4.1067761806981518E-2</c:v>
                </c:pt>
                <c:pt idx="7">
                  <c:v>4.3121149897330589E-2</c:v>
                </c:pt>
                <c:pt idx="8">
                  <c:v>3.9014373716632404E-2</c:v>
                </c:pt>
                <c:pt idx="9">
                  <c:v>4.7227926078028719E-2</c:v>
                </c:pt>
                <c:pt idx="10">
                  <c:v>6.7761806981519498E-2</c:v>
                </c:pt>
                <c:pt idx="11">
                  <c:v>5.9548254620123219E-2</c:v>
                </c:pt>
                <c:pt idx="12">
                  <c:v>7.1868583162217697E-2</c:v>
                </c:pt>
                <c:pt idx="13">
                  <c:v>5.7494866529774098E-2</c:v>
                </c:pt>
                <c:pt idx="14">
                  <c:v>4.7227926078028719E-2</c:v>
                </c:pt>
                <c:pt idx="15">
                  <c:v>4.3121149897330589E-2</c:v>
                </c:pt>
                <c:pt idx="16">
                  <c:v>4.1067761806981518E-2</c:v>
                </c:pt>
                <c:pt idx="17">
                  <c:v>2.8747433264887094E-2</c:v>
                </c:pt>
                <c:pt idx="18">
                  <c:v>2.6694045174538002E-2</c:v>
                </c:pt>
                <c:pt idx="19">
                  <c:v>2.4640657084188899E-2</c:v>
                </c:pt>
                <c:pt idx="20">
                  <c:v>1.8480492813141701E-2</c:v>
                </c:pt>
                <c:pt idx="21">
                  <c:v>1.4373716632443499E-2</c:v>
                </c:pt>
                <c:pt idx="22">
                  <c:v>4.1067761806981521E-3</c:v>
                </c:pt>
                <c:pt idx="23">
                  <c:v>2.05338809034908E-3</c:v>
                </c:pt>
                <c:pt idx="24">
                  <c:v>2.05338809034908E-3</c:v>
                </c:pt>
                <c:pt idx="25">
                  <c:v>2.05338809034908E-3</c:v>
                </c:pt>
                <c:pt idx="26">
                  <c:v>4.1067761806981521E-3</c:v>
                </c:pt>
                <c:pt idx="27">
                  <c:v>2.05338809034908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glr-1(n2461)_A1_0.02_50%'!$L$104</c:f>
              <c:strCache>
                <c:ptCount val="1"/>
                <c:pt idx="0">
                  <c:v>glr-1(n2461)_A1_11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L$105:$L$135</c:f>
              <c:numCache>
                <c:formatCode>General</c:formatCode>
                <c:ptCount val="31"/>
                <c:pt idx="1">
                  <c:v>8.9080459770114903E-2</c:v>
                </c:pt>
                <c:pt idx="2">
                  <c:v>4.45402298850575E-2</c:v>
                </c:pt>
                <c:pt idx="3">
                  <c:v>4.5977011494252887E-2</c:v>
                </c:pt>
                <c:pt idx="4">
                  <c:v>6.1781609195402314E-2</c:v>
                </c:pt>
                <c:pt idx="5">
                  <c:v>6.8965517241379309E-2</c:v>
                </c:pt>
                <c:pt idx="6">
                  <c:v>6.8965517241379309E-2</c:v>
                </c:pt>
                <c:pt idx="7">
                  <c:v>7.1839080459770097E-2</c:v>
                </c:pt>
                <c:pt idx="8">
                  <c:v>5.1724137931034517E-2</c:v>
                </c:pt>
                <c:pt idx="9">
                  <c:v>7.0402298850574738E-2</c:v>
                </c:pt>
                <c:pt idx="10">
                  <c:v>5.0287356321839095E-2</c:v>
                </c:pt>
                <c:pt idx="11">
                  <c:v>4.3103448275862079E-2</c:v>
                </c:pt>
                <c:pt idx="12">
                  <c:v>3.5919540229885097E-2</c:v>
                </c:pt>
                <c:pt idx="13">
                  <c:v>6.1781609195402314E-2</c:v>
                </c:pt>
                <c:pt idx="14">
                  <c:v>2.5862068965517199E-2</c:v>
                </c:pt>
                <c:pt idx="15">
                  <c:v>3.0172413793103509E-2</c:v>
                </c:pt>
                <c:pt idx="16">
                  <c:v>1.5804597701149399E-2</c:v>
                </c:pt>
                <c:pt idx="17">
                  <c:v>3.1609195402298916E-2</c:v>
                </c:pt>
                <c:pt idx="18">
                  <c:v>1.7241379310344803E-2</c:v>
                </c:pt>
                <c:pt idx="19">
                  <c:v>1.86781609195402E-2</c:v>
                </c:pt>
                <c:pt idx="20">
                  <c:v>7.1839080459770114E-3</c:v>
                </c:pt>
                <c:pt idx="21">
                  <c:v>1.1494252873563199E-2</c:v>
                </c:pt>
                <c:pt idx="22">
                  <c:v>5.7471264367816117E-3</c:v>
                </c:pt>
                <c:pt idx="23">
                  <c:v>5.7471264367816117E-3</c:v>
                </c:pt>
                <c:pt idx="24">
                  <c:v>4.3103448275862077E-3</c:v>
                </c:pt>
                <c:pt idx="25">
                  <c:v>8.6206896551724154E-3</c:v>
                </c:pt>
                <c:pt idx="26">
                  <c:v>1.4367816091954001E-3</c:v>
                </c:pt>
                <c:pt idx="27">
                  <c:v>1.4367816091954001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glr-1(n2461)_A1_0.02_50%'!$M$104</c:f>
              <c:strCache>
                <c:ptCount val="1"/>
                <c:pt idx="0">
                  <c:v>glr-1(n2461)_A1_12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M$105:$M$135</c:f>
              <c:numCache>
                <c:formatCode>General</c:formatCode>
                <c:ptCount val="31"/>
                <c:pt idx="1">
                  <c:v>5.7939914163090099E-2</c:v>
                </c:pt>
                <c:pt idx="2">
                  <c:v>7.0815450643776826E-2</c:v>
                </c:pt>
                <c:pt idx="3">
                  <c:v>6.8669527896995694E-2</c:v>
                </c:pt>
                <c:pt idx="4">
                  <c:v>5.5793991416309037E-2</c:v>
                </c:pt>
                <c:pt idx="5">
                  <c:v>8.1545064377682511E-2</c:v>
                </c:pt>
                <c:pt idx="6">
                  <c:v>5.5793991416309037E-2</c:v>
                </c:pt>
                <c:pt idx="7">
                  <c:v>6.2231759656652397E-2</c:v>
                </c:pt>
                <c:pt idx="8">
                  <c:v>5.3648068669527864E-2</c:v>
                </c:pt>
                <c:pt idx="9">
                  <c:v>6.6523605150214604E-2</c:v>
                </c:pt>
                <c:pt idx="10">
                  <c:v>4.50643776824034E-2</c:v>
                </c:pt>
                <c:pt idx="11">
                  <c:v>4.50643776824034E-2</c:v>
                </c:pt>
                <c:pt idx="12">
                  <c:v>4.9356223175965719E-2</c:v>
                </c:pt>
                <c:pt idx="13">
                  <c:v>4.0772532188841235E-2</c:v>
                </c:pt>
                <c:pt idx="14">
                  <c:v>3.6480686695278999E-2</c:v>
                </c:pt>
                <c:pt idx="15">
                  <c:v>2.3605150214592301E-2</c:v>
                </c:pt>
                <c:pt idx="16">
                  <c:v>2.1459227467811218E-2</c:v>
                </c:pt>
                <c:pt idx="17">
                  <c:v>5.1502145922746816E-2</c:v>
                </c:pt>
                <c:pt idx="18">
                  <c:v>1.07296137339056E-2</c:v>
                </c:pt>
                <c:pt idx="19">
                  <c:v>8.5836909871244635E-3</c:v>
                </c:pt>
                <c:pt idx="20">
                  <c:v>1.2875536480686699E-2</c:v>
                </c:pt>
                <c:pt idx="21">
                  <c:v>8.5836909871244635E-3</c:v>
                </c:pt>
                <c:pt idx="22">
                  <c:v>2.1459227467811219E-3</c:v>
                </c:pt>
                <c:pt idx="23">
                  <c:v>4.2918454935622343E-3</c:v>
                </c:pt>
                <c:pt idx="24">
                  <c:v>1.07296137339056E-2</c:v>
                </c:pt>
                <c:pt idx="25">
                  <c:v>0</c:v>
                </c:pt>
                <c:pt idx="26">
                  <c:v>0</c:v>
                </c:pt>
                <c:pt idx="27">
                  <c:v>2.1459227467811219E-3</c:v>
                </c:pt>
                <c:pt idx="28">
                  <c:v>0</c:v>
                </c:pt>
                <c:pt idx="29">
                  <c:v>4.2918454935622343E-3</c:v>
                </c:pt>
                <c:pt idx="3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glr-1(n2461)_A1_0.02_50%'!$N$104</c:f>
              <c:strCache>
                <c:ptCount val="1"/>
                <c:pt idx="0">
                  <c:v>glr-1(n2461)_A1_13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N$105:$N$135</c:f>
              <c:numCache>
                <c:formatCode>General</c:formatCode>
                <c:ptCount val="31"/>
                <c:pt idx="1">
                  <c:v>8.3132530120481898E-2</c:v>
                </c:pt>
                <c:pt idx="2">
                  <c:v>6.8674698795180705E-2</c:v>
                </c:pt>
                <c:pt idx="3">
                  <c:v>7.3493975903614533E-2</c:v>
                </c:pt>
                <c:pt idx="4">
                  <c:v>9.3975903614457831E-2</c:v>
                </c:pt>
                <c:pt idx="5">
                  <c:v>8.3132530120481898E-2</c:v>
                </c:pt>
                <c:pt idx="6">
                  <c:v>8.0722891566265151E-2</c:v>
                </c:pt>
                <c:pt idx="7">
                  <c:v>0.102409638554217</c:v>
                </c:pt>
                <c:pt idx="8">
                  <c:v>6.1445783132530102E-2</c:v>
                </c:pt>
                <c:pt idx="9">
                  <c:v>6.1445783132530102E-2</c:v>
                </c:pt>
                <c:pt idx="10">
                  <c:v>5.54216867469879E-2</c:v>
                </c:pt>
                <c:pt idx="11">
                  <c:v>4.6987951807228916E-2</c:v>
                </c:pt>
                <c:pt idx="12">
                  <c:v>3.2530120481927723E-2</c:v>
                </c:pt>
                <c:pt idx="13">
                  <c:v>2.89156626506024E-2</c:v>
                </c:pt>
                <c:pt idx="14">
                  <c:v>1.2048192771084298E-2</c:v>
                </c:pt>
                <c:pt idx="15">
                  <c:v>1.44578313253012E-2</c:v>
                </c:pt>
                <c:pt idx="16">
                  <c:v>7.2289156626506E-3</c:v>
                </c:pt>
                <c:pt idx="17">
                  <c:v>4.8192771084337423E-3</c:v>
                </c:pt>
                <c:pt idx="18">
                  <c:v>2.4096385542168699E-3</c:v>
                </c:pt>
                <c:pt idx="19">
                  <c:v>8.4337349397590484E-3</c:v>
                </c:pt>
                <c:pt idx="20">
                  <c:v>7.2289156626506E-3</c:v>
                </c:pt>
                <c:pt idx="21">
                  <c:v>1.2048192771084295E-3</c:v>
                </c:pt>
                <c:pt idx="22">
                  <c:v>2.4096385542168699E-3</c:v>
                </c:pt>
                <c:pt idx="23">
                  <c:v>0</c:v>
                </c:pt>
                <c:pt idx="24">
                  <c:v>2.4096385542168699E-3</c:v>
                </c:pt>
                <c:pt idx="25">
                  <c:v>3.6144578313253009E-3</c:v>
                </c:pt>
                <c:pt idx="26">
                  <c:v>0</c:v>
                </c:pt>
                <c:pt idx="27">
                  <c:v>1.2048192771084295E-3</c:v>
                </c:pt>
                <c:pt idx="28">
                  <c:v>0</c:v>
                </c:pt>
                <c:pt idx="29">
                  <c:v>1.2048192771084295E-3</c:v>
                </c:pt>
                <c:pt idx="30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glr-1(n2461)_A1_0.02_50%'!$O$104</c:f>
              <c:strCache>
                <c:ptCount val="1"/>
                <c:pt idx="0">
                  <c:v>glr-1(n2461)_A1_14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O$105:$O$135</c:f>
              <c:numCache>
                <c:formatCode>General</c:formatCode>
                <c:ptCount val="31"/>
                <c:pt idx="1">
                  <c:v>4.6849757673667163E-2</c:v>
                </c:pt>
                <c:pt idx="2">
                  <c:v>4.5234248788368278E-2</c:v>
                </c:pt>
                <c:pt idx="3">
                  <c:v>5.3311793214862714E-2</c:v>
                </c:pt>
                <c:pt idx="4">
                  <c:v>6.4620355411954766E-2</c:v>
                </c:pt>
                <c:pt idx="5">
                  <c:v>7.2697899838449126E-2</c:v>
                </c:pt>
                <c:pt idx="6">
                  <c:v>5.65428109854604E-2</c:v>
                </c:pt>
                <c:pt idx="7">
                  <c:v>6.3004846526655875E-2</c:v>
                </c:pt>
                <c:pt idx="8">
                  <c:v>4.6849757673667163E-2</c:v>
                </c:pt>
                <c:pt idx="9">
                  <c:v>5.0080775444264897E-2</c:v>
                </c:pt>
                <c:pt idx="10">
                  <c:v>6.3004846526655875E-2</c:v>
                </c:pt>
                <c:pt idx="11">
                  <c:v>4.0387722132471729E-2</c:v>
                </c:pt>
                <c:pt idx="12">
                  <c:v>2.7463651050080799E-2</c:v>
                </c:pt>
                <c:pt idx="13">
                  <c:v>4.0387722132471729E-2</c:v>
                </c:pt>
                <c:pt idx="14">
                  <c:v>4.6849757673667163E-2</c:v>
                </c:pt>
                <c:pt idx="15">
                  <c:v>4.8465266558966102E-2</c:v>
                </c:pt>
                <c:pt idx="16">
                  <c:v>2.5848142164781908E-2</c:v>
                </c:pt>
                <c:pt idx="17">
                  <c:v>2.2617124394184198E-2</c:v>
                </c:pt>
                <c:pt idx="18">
                  <c:v>3.2310177705977411E-2</c:v>
                </c:pt>
                <c:pt idx="19">
                  <c:v>2.4232633279482999E-2</c:v>
                </c:pt>
                <c:pt idx="20">
                  <c:v>1.6155088852988702E-2</c:v>
                </c:pt>
                <c:pt idx="21">
                  <c:v>1.2924071082391001E-2</c:v>
                </c:pt>
                <c:pt idx="22">
                  <c:v>8.0775444264943545E-3</c:v>
                </c:pt>
                <c:pt idx="23">
                  <c:v>8.0775444264943545E-3</c:v>
                </c:pt>
                <c:pt idx="24">
                  <c:v>4.8465266558966116E-3</c:v>
                </c:pt>
                <c:pt idx="25">
                  <c:v>4.8465266558966116E-3</c:v>
                </c:pt>
                <c:pt idx="26">
                  <c:v>3.2310177705977415E-3</c:v>
                </c:pt>
                <c:pt idx="27">
                  <c:v>1.6155088852988701E-3</c:v>
                </c:pt>
                <c:pt idx="28">
                  <c:v>0</c:v>
                </c:pt>
                <c:pt idx="29">
                  <c:v>1.6155088852988701E-3</c:v>
                </c:pt>
                <c:pt idx="30">
                  <c:v>1.6155088852988701E-3</c:v>
                </c:pt>
              </c:numCache>
            </c:numRef>
          </c:val>
        </c:ser>
        <c:ser>
          <c:idx val="14"/>
          <c:order val="14"/>
          <c:tx>
            <c:strRef>
              <c:f>'glr-1(n2461)_A1_0.02_50%'!$P$104</c:f>
              <c:strCache>
                <c:ptCount val="1"/>
                <c:pt idx="0">
                  <c:v>glr-1(n2461)_A1_15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P$105:$P$135</c:f>
              <c:numCache>
                <c:formatCode>General</c:formatCode>
                <c:ptCount val="31"/>
                <c:pt idx="1">
                  <c:v>7.1428571428571411E-2</c:v>
                </c:pt>
                <c:pt idx="2">
                  <c:v>6.8322981366459604E-2</c:v>
                </c:pt>
                <c:pt idx="3">
                  <c:v>6.3664596273291907E-2</c:v>
                </c:pt>
                <c:pt idx="4">
                  <c:v>7.9192546583850901E-2</c:v>
                </c:pt>
                <c:pt idx="5">
                  <c:v>9.3167701863353991E-2</c:v>
                </c:pt>
                <c:pt idx="6">
                  <c:v>7.9192546583850901E-2</c:v>
                </c:pt>
                <c:pt idx="7">
                  <c:v>6.8322981366459604E-2</c:v>
                </c:pt>
                <c:pt idx="8">
                  <c:v>5.9006211180124238E-2</c:v>
                </c:pt>
                <c:pt idx="9">
                  <c:v>6.3664596273291907E-2</c:v>
                </c:pt>
                <c:pt idx="10">
                  <c:v>6.3664596273291907E-2</c:v>
                </c:pt>
                <c:pt idx="11">
                  <c:v>5.9006211180124238E-2</c:v>
                </c:pt>
                <c:pt idx="12">
                  <c:v>3.8819875776397512E-2</c:v>
                </c:pt>
                <c:pt idx="13">
                  <c:v>1.8633540372670801E-2</c:v>
                </c:pt>
                <c:pt idx="14">
                  <c:v>2.3291925465838508E-2</c:v>
                </c:pt>
                <c:pt idx="15">
                  <c:v>2.1739130434782601E-2</c:v>
                </c:pt>
                <c:pt idx="16">
                  <c:v>1.5527950310559004E-2</c:v>
                </c:pt>
                <c:pt idx="17">
                  <c:v>1.7080745341614901E-2</c:v>
                </c:pt>
                <c:pt idx="18">
                  <c:v>1.3975155279503108E-2</c:v>
                </c:pt>
                <c:pt idx="19">
                  <c:v>4.6583850931677002E-3</c:v>
                </c:pt>
                <c:pt idx="20">
                  <c:v>3.1055900621118019E-3</c:v>
                </c:pt>
                <c:pt idx="21">
                  <c:v>4.6583850931677002E-3</c:v>
                </c:pt>
                <c:pt idx="22">
                  <c:v>6.2111801242236038E-3</c:v>
                </c:pt>
                <c:pt idx="23">
                  <c:v>1.5527950310559005E-3</c:v>
                </c:pt>
                <c:pt idx="24">
                  <c:v>1.5527950310559005E-3</c:v>
                </c:pt>
                <c:pt idx="25">
                  <c:v>1.5527950310559005E-3</c:v>
                </c:pt>
                <c:pt idx="26">
                  <c:v>1.5527950310559005E-3</c:v>
                </c:pt>
                <c:pt idx="27">
                  <c:v>4.6583850931677002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5"/>
          <c:order val="15"/>
          <c:tx>
            <c:strRef>
              <c:f>'glr-1(n2461)_A1_0.02_50%'!$Q$104</c:f>
              <c:strCache>
                <c:ptCount val="1"/>
                <c:pt idx="0">
                  <c:v>glr-1(n2461)_A1_16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Q$105:$Q$135</c:f>
              <c:numCache>
                <c:formatCode>General</c:formatCode>
                <c:ptCount val="31"/>
                <c:pt idx="1">
                  <c:v>7.8740157480315001E-2</c:v>
                </c:pt>
                <c:pt idx="2">
                  <c:v>8.6614173228346525E-2</c:v>
                </c:pt>
                <c:pt idx="3">
                  <c:v>7.0866141732283519E-2</c:v>
                </c:pt>
                <c:pt idx="4">
                  <c:v>7.8740157480315001E-2</c:v>
                </c:pt>
                <c:pt idx="5">
                  <c:v>3.9370078740157501E-2</c:v>
                </c:pt>
                <c:pt idx="6">
                  <c:v>1.5748031496063006E-2</c:v>
                </c:pt>
                <c:pt idx="7">
                  <c:v>5.5118110236220513E-2</c:v>
                </c:pt>
                <c:pt idx="8">
                  <c:v>3.9370078740157501E-2</c:v>
                </c:pt>
                <c:pt idx="9">
                  <c:v>3.1496062992126005E-2</c:v>
                </c:pt>
                <c:pt idx="10">
                  <c:v>3.9370078740157501E-2</c:v>
                </c:pt>
                <c:pt idx="11">
                  <c:v>6.2992125984252009E-2</c:v>
                </c:pt>
                <c:pt idx="12">
                  <c:v>6.2992125984252009E-2</c:v>
                </c:pt>
                <c:pt idx="13">
                  <c:v>4.7244094488188997E-2</c:v>
                </c:pt>
                <c:pt idx="14">
                  <c:v>4.7244094488188997E-2</c:v>
                </c:pt>
                <c:pt idx="15">
                  <c:v>4.7244094488188997E-2</c:v>
                </c:pt>
                <c:pt idx="16">
                  <c:v>2.3622047244094498E-2</c:v>
                </c:pt>
                <c:pt idx="17">
                  <c:v>1.5748031496063006E-2</c:v>
                </c:pt>
                <c:pt idx="18">
                  <c:v>2.3622047244094498E-2</c:v>
                </c:pt>
                <c:pt idx="19">
                  <c:v>7.8740157480314977E-3</c:v>
                </c:pt>
                <c:pt idx="20">
                  <c:v>1.5748031496063006E-2</c:v>
                </c:pt>
                <c:pt idx="21">
                  <c:v>0</c:v>
                </c:pt>
                <c:pt idx="22">
                  <c:v>0</c:v>
                </c:pt>
                <c:pt idx="23">
                  <c:v>7.8740157480314977E-3</c:v>
                </c:pt>
                <c:pt idx="24">
                  <c:v>7.8740157480314977E-3</c:v>
                </c:pt>
                <c:pt idx="25">
                  <c:v>7.8740157480314977E-3</c:v>
                </c:pt>
                <c:pt idx="26">
                  <c:v>7.8740157480314977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6"/>
          <c:order val="16"/>
          <c:tx>
            <c:strRef>
              <c:f>'glr-1(n2461)_A1_0.02_50%'!$R$104</c:f>
              <c:strCache>
                <c:ptCount val="1"/>
                <c:pt idx="0">
                  <c:v>glr-1(n2461)_A1_17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R$105:$R$135</c:f>
              <c:numCache>
                <c:formatCode>General</c:formatCode>
                <c:ptCount val="31"/>
                <c:pt idx="1">
                  <c:v>6.9767441860465129E-2</c:v>
                </c:pt>
                <c:pt idx="2">
                  <c:v>5.6303549571603398E-2</c:v>
                </c:pt>
                <c:pt idx="3">
                  <c:v>7.4663402692778519E-2</c:v>
                </c:pt>
                <c:pt idx="4">
                  <c:v>5.2631578947368404E-2</c:v>
                </c:pt>
                <c:pt idx="5">
                  <c:v>8.6903304773561799E-2</c:v>
                </c:pt>
                <c:pt idx="6">
                  <c:v>6.8543451652386803E-2</c:v>
                </c:pt>
                <c:pt idx="7">
                  <c:v>8.3231334149326847E-2</c:v>
                </c:pt>
                <c:pt idx="8">
                  <c:v>5.3855569155446821E-2</c:v>
                </c:pt>
                <c:pt idx="9">
                  <c:v>6.1199510403916801E-2</c:v>
                </c:pt>
                <c:pt idx="10">
                  <c:v>4.7735618115055112E-2</c:v>
                </c:pt>
                <c:pt idx="11">
                  <c:v>3.9167686658506701E-2</c:v>
                </c:pt>
                <c:pt idx="12">
                  <c:v>4.8959608323133404E-2</c:v>
                </c:pt>
                <c:pt idx="13">
                  <c:v>4.0391676866585118E-2</c:v>
                </c:pt>
                <c:pt idx="14">
                  <c:v>3.5495716034271714E-2</c:v>
                </c:pt>
                <c:pt idx="15">
                  <c:v>2.5703794369645001E-2</c:v>
                </c:pt>
                <c:pt idx="16">
                  <c:v>2.2031823745410014E-2</c:v>
                </c:pt>
                <c:pt idx="17">
                  <c:v>2.4479804161566705E-2</c:v>
                </c:pt>
                <c:pt idx="18">
                  <c:v>1.2239902080783398E-2</c:v>
                </c:pt>
                <c:pt idx="19">
                  <c:v>1.1015911872704997E-2</c:v>
                </c:pt>
                <c:pt idx="20">
                  <c:v>7.3439412484700099E-3</c:v>
                </c:pt>
                <c:pt idx="21">
                  <c:v>1.1015911872704997E-2</c:v>
                </c:pt>
                <c:pt idx="22">
                  <c:v>1.2239902080783398E-3</c:v>
                </c:pt>
                <c:pt idx="23">
                  <c:v>3.671970624235011E-3</c:v>
                </c:pt>
                <c:pt idx="24">
                  <c:v>0</c:v>
                </c:pt>
                <c:pt idx="25">
                  <c:v>3.671970624235011E-3</c:v>
                </c:pt>
                <c:pt idx="26">
                  <c:v>2.447980416156671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2.447980416156671E-3</c:v>
                </c:pt>
              </c:numCache>
            </c:numRef>
          </c:val>
        </c:ser>
        <c:ser>
          <c:idx val="17"/>
          <c:order val="17"/>
          <c:tx>
            <c:strRef>
              <c:f>'glr-1(n2461)_A1_0.02_50%'!$S$104</c:f>
              <c:strCache>
                <c:ptCount val="1"/>
                <c:pt idx="0">
                  <c:v>glr-1(n2461)_A1_18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S$105:$S$135</c:f>
              <c:numCache>
                <c:formatCode>General</c:formatCode>
                <c:ptCount val="31"/>
                <c:pt idx="1">
                  <c:v>7.3899371069182401E-2</c:v>
                </c:pt>
                <c:pt idx="2">
                  <c:v>4.08805031446541E-2</c:v>
                </c:pt>
                <c:pt idx="3">
                  <c:v>6.7610062893081829E-2</c:v>
                </c:pt>
                <c:pt idx="4">
                  <c:v>5.3459119496855285E-2</c:v>
                </c:pt>
                <c:pt idx="5">
                  <c:v>6.7610062893081829E-2</c:v>
                </c:pt>
                <c:pt idx="6">
                  <c:v>7.3899371069182401E-2</c:v>
                </c:pt>
                <c:pt idx="7">
                  <c:v>6.9182389937106931E-2</c:v>
                </c:pt>
                <c:pt idx="8">
                  <c:v>5.0314465408804999E-2</c:v>
                </c:pt>
                <c:pt idx="9">
                  <c:v>5.5031446540880498E-2</c:v>
                </c:pt>
                <c:pt idx="10">
                  <c:v>4.8742138364779877E-2</c:v>
                </c:pt>
                <c:pt idx="11">
                  <c:v>6.2893081761006331E-2</c:v>
                </c:pt>
                <c:pt idx="12">
                  <c:v>3.7735849056603821E-2</c:v>
                </c:pt>
                <c:pt idx="13">
                  <c:v>2.8301886792452793E-2</c:v>
                </c:pt>
                <c:pt idx="14">
                  <c:v>3.4591194968553514E-2</c:v>
                </c:pt>
                <c:pt idx="15">
                  <c:v>4.8742138364779877E-2</c:v>
                </c:pt>
                <c:pt idx="16">
                  <c:v>1.4150943396226398E-2</c:v>
                </c:pt>
                <c:pt idx="17">
                  <c:v>2.6729559748427695E-2</c:v>
                </c:pt>
                <c:pt idx="18">
                  <c:v>1.4150943396226398E-2</c:v>
                </c:pt>
                <c:pt idx="19">
                  <c:v>1.88679245283019E-2</c:v>
                </c:pt>
                <c:pt idx="20">
                  <c:v>4.7169811320754698E-3</c:v>
                </c:pt>
                <c:pt idx="21">
                  <c:v>9.4339622641509396E-3</c:v>
                </c:pt>
                <c:pt idx="22">
                  <c:v>6.2893081761006336E-3</c:v>
                </c:pt>
                <c:pt idx="23">
                  <c:v>6.2893081761006336E-3</c:v>
                </c:pt>
                <c:pt idx="24">
                  <c:v>1.1006289308176103E-2</c:v>
                </c:pt>
                <c:pt idx="25">
                  <c:v>1.5723270440251608E-3</c:v>
                </c:pt>
                <c:pt idx="26">
                  <c:v>4.7169811320754698E-3</c:v>
                </c:pt>
                <c:pt idx="27">
                  <c:v>4.7169811320754698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8"/>
          <c:order val="18"/>
          <c:tx>
            <c:strRef>
              <c:f>'glr-1(n2461)_A1_0.02_50%'!$T$104</c:f>
              <c:strCache>
                <c:ptCount val="1"/>
                <c:pt idx="0">
                  <c:v>glr-1(n2461)_A1_19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T$105:$T$135</c:f>
              <c:numCache>
                <c:formatCode>General</c:formatCode>
                <c:ptCount val="31"/>
                <c:pt idx="1">
                  <c:v>5.9379217273954087E-2</c:v>
                </c:pt>
                <c:pt idx="2">
                  <c:v>7.5573549257759789E-2</c:v>
                </c:pt>
                <c:pt idx="3">
                  <c:v>6.7476383265856907E-2</c:v>
                </c:pt>
                <c:pt idx="4">
                  <c:v>8.7719298245614002E-2</c:v>
                </c:pt>
                <c:pt idx="5">
                  <c:v>8.0971659919028299E-2</c:v>
                </c:pt>
                <c:pt idx="6">
                  <c:v>7.9622132253711231E-2</c:v>
                </c:pt>
                <c:pt idx="7">
                  <c:v>7.5573549257759789E-2</c:v>
                </c:pt>
                <c:pt idx="8">
                  <c:v>7.1524966261808404E-2</c:v>
                </c:pt>
                <c:pt idx="9">
                  <c:v>3.7786774628879922E-2</c:v>
                </c:pt>
                <c:pt idx="10">
                  <c:v>5.8029689608637004E-2</c:v>
                </c:pt>
                <c:pt idx="11">
                  <c:v>4.8582995951417025E-2</c:v>
                </c:pt>
                <c:pt idx="12">
                  <c:v>4.4534412955465626E-2</c:v>
                </c:pt>
                <c:pt idx="13">
                  <c:v>3.1039136302294209E-2</c:v>
                </c:pt>
                <c:pt idx="14">
                  <c:v>2.5641025641025609E-2</c:v>
                </c:pt>
                <c:pt idx="15">
                  <c:v>1.8893387314439906E-2</c:v>
                </c:pt>
                <c:pt idx="16">
                  <c:v>1.0796221322537101E-2</c:v>
                </c:pt>
                <c:pt idx="17">
                  <c:v>1.3495276653171399E-2</c:v>
                </c:pt>
                <c:pt idx="18">
                  <c:v>1.6194331983805699E-2</c:v>
                </c:pt>
                <c:pt idx="19">
                  <c:v>8.0971659919028306E-3</c:v>
                </c:pt>
                <c:pt idx="20">
                  <c:v>1.0796221322537101E-2</c:v>
                </c:pt>
                <c:pt idx="21">
                  <c:v>5.3981106612685601E-3</c:v>
                </c:pt>
                <c:pt idx="22">
                  <c:v>2.6990553306342792E-3</c:v>
                </c:pt>
                <c:pt idx="23">
                  <c:v>1.34952766531714E-3</c:v>
                </c:pt>
                <c:pt idx="24">
                  <c:v>0</c:v>
                </c:pt>
                <c:pt idx="25">
                  <c:v>2.6990553306342792E-3</c:v>
                </c:pt>
                <c:pt idx="26">
                  <c:v>1.34952766531714E-3</c:v>
                </c:pt>
                <c:pt idx="27">
                  <c:v>2.6990553306342792E-3</c:v>
                </c:pt>
                <c:pt idx="28">
                  <c:v>2.6990553306342792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9"/>
          <c:order val="19"/>
          <c:tx>
            <c:strRef>
              <c:f>'glr-1(n2461)_A1_0.02_50%'!$U$104</c:f>
              <c:strCache>
                <c:ptCount val="1"/>
                <c:pt idx="0">
                  <c:v>glr-1(n2461)_A1_20</c:v>
                </c:pt>
              </c:strCache>
            </c:strRef>
          </c:tx>
          <c:marker>
            <c:symbol val="none"/>
          </c:marker>
          <c:cat>
            <c:numRef>
              <c:f>'glr-1(n246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glr-1(n2461)_A1_0.02_50%'!$U$105:$U$135</c:f>
              <c:numCache>
                <c:formatCode>General</c:formatCode>
                <c:ptCount val="31"/>
                <c:pt idx="1">
                  <c:v>6.4814814814814825E-2</c:v>
                </c:pt>
                <c:pt idx="2">
                  <c:v>5.29100529100529E-2</c:v>
                </c:pt>
                <c:pt idx="3">
                  <c:v>6.6137566137566106E-2</c:v>
                </c:pt>
                <c:pt idx="4">
                  <c:v>5.4232804232804223E-2</c:v>
                </c:pt>
                <c:pt idx="5">
                  <c:v>7.4074074074074098E-2</c:v>
                </c:pt>
                <c:pt idx="6">
                  <c:v>6.2169312169312201E-2</c:v>
                </c:pt>
                <c:pt idx="7">
                  <c:v>7.9365079365079402E-2</c:v>
                </c:pt>
                <c:pt idx="8">
                  <c:v>7.0105820105820102E-2</c:v>
                </c:pt>
                <c:pt idx="9">
                  <c:v>5.555555555555558E-2</c:v>
                </c:pt>
                <c:pt idx="10">
                  <c:v>5.29100529100529E-2</c:v>
                </c:pt>
                <c:pt idx="11">
                  <c:v>4.4973544973544999E-2</c:v>
                </c:pt>
                <c:pt idx="12">
                  <c:v>3.9682539682539715E-2</c:v>
                </c:pt>
                <c:pt idx="13">
                  <c:v>4.2328042328042312E-2</c:v>
                </c:pt>
                <c:pt idx="14">
                  <c:v>4.8941798941798897E-2</c:v>
                </c:pt>
                <c:pt idx="15">
                  <c:v>2.5132275132275117E-2</c:v>
                </c:pt>
                <c:pt idx="16">
                  <c:v>2.248677248677252E-2</c:v>
                </c:pt>
                <c:pt idx="17">
                  <c:v>2.1164021164021198E-2</c:v>
                </c:pt>
                <c:pt idx="18">
                  <c:v>1.7195767195767205E-2</c:v>
                </c:pt>
                <c:pt idx="19">
                  <c:v>9.2592592592592692E-3</c:v>
                </c:pt>
                <c:pt idx="20">
                  <c:v>1.1904761904761904E-2</c:v>
                </c:pt>
                <c:pt idx="21">
                  <c:v>6.6137566137566117E-3</c:v>
                </c:pt>
                <c:pt idx="22">
                  <c:v>3.9682539682539715E-3</c:v>
                </c:pt>
                <c:pt idx="23">
                  <c:v>5.2910052910052898E-3</c:v>
                </c:pt>
                <c:pt idx="24">
                  <c:v>0</c:v>
                </c:pt>
                <c:pt idx="25">
                  <c:v>5.2910052910052898E-3</c:v>
                </c:pt>
                <c:pt idx="26">
                  <c:v>2.6455026455026519E-3</c:v>
                </c:pt>
                <c:pt idx="27">
                  <c:v>0</c:v>
                </c:pt>
                <c:pt idx="28">
                  <c:v>3.9682539682539715E-3</c:v>
                </c:pt>
                <c:pt idx="29">
                  <c:v>1.3227513227513205E-3</c:v>
                </c:pt>
                <c:pt idx="30">
                  <c:v>0</c:v>
                </c:pt>
              </c:numCache>
            </c:numRef>
          </c:val>
        </c:ser>
        <c:marker val="1"/>
        <c:axId val="166124544"/>
        <c:axId val="166142720"/>
      </c:lineChart>
      <c:catAx>
        <c:axId val="166124544"/>
        <c:scaling>
          <c:orientation val="minMax"/>
        </c:scaling>
        <c:axPos val="b"/>
        <c:numFmt formatCode="0.0_ " sourceLinked="1"/>
        <c:tickLblPos val="nextTo"/>
        <c:crossAx val="166142720"/>
        <c:crosses val="autoZero"/>
        <c:auto val="1"/>
        <c:lblAlgn val="ctr"/>
        <c:lblOffset val="100"/>
        <c:tickLblSkip val="5"/>
        <c:tickMarkSkip val="5"/>
      </c:catAx>
      <c:valAx>
        <c:axId val="166142720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6124544"/>
        <c:crosses val="autoZero"/>
        <c:crossBetween val="between"/>
      </c:valAx>
    </c:plotArea>
    <c:plotVisOnly val="1"/>
  </c:chart>
  <c:externalData r:id="rId1"/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49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3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49 A3_0.02_50%'!$B$104</c:f>
              <c:strCache>
                <c:ptCount val="1"/>
                <c:pt idx="0">
                  <c:v>unc-49_REX_A3_01</c:v>
                </c:pt>
              </c:strCache>
            </c:strRef>
          </c:tx>
          <c:marker>
            <c:symbol val="none"/>
          </c:marker>
          <c:cat>
            <c:numRef>
              <c:f>'unc-49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3_0.02_50%'!$B$105:$B$135</c:f>
              <c:numCache>
                <c:formatCode>General</c:formatCode>
                <c:ptCount val="31"/>
                <c:pt idx="1">
                  <c:v>7.8823529411764695E-2</c:v>
                </c:pt>
                <c:pt idx="2">
                  <c:v>7.5294117647058803E-2</c:v>
                </c:pt>
                <c:pt idx="3">
                  <c:v>7.1764705882352897E-2</c:v>
                </c:pt>
                <c:pt idx="4">
                  <c:v>6.352941176470589E-2</c:v>
                </c:pt>
                <c:pt idx="5">
                  <c:v>3.6470588235294102E-2</c:v>
                </c:pt>
                <c:pt idx="6">
                  <c:v>2.9411764705882398E-2</c:v>
                </c:pt>
                <c:pt idx="7">
                  <c:v>2.0000000000000007E-2</c:v>
                </c:pt>
                <c:pt idx="8">
                  <c:v>2.3529411764705889E-2</c:v>
                </c:pt>
                <c:pt idx="9">
                  <c:v>4.0000000000000015E-2</c:v>
                </c:pt>
                <c:pt idx="10">
                  <c:v>2.9411764705882398E-2</c:v>
                </c:pt>
                <c:pt idx="11">
                  <c:v>4.11764705882353E-2</c:v>
                </c:pt>
                <c:pt idx="12">
                  <c:v>5.0588235294117614E-2</c:v>
                </c:pt>
                <c:pt idx="13">
                  <c:v>5.0588235294117614E-2</c:v>
                </c:pt>
                <c:pt idx="14">
                  <c:v>4.8235294117647112E-2</c:v>
                </c:pt>
                <c:pt idx="15">
                  <c:v>3.8823529411764715E-2</c:v>
                </c:pt>
                <c:pt idx="16">
                  <c:v>2.8235294117647108E-2</c:v>
                </c:pt>
                <c:pt idx="17">
                  <c:v>3.4117647058823523E-2</c:v>
                </c:pt>
                <c:pt idx="18">
                  <c:v>2.8235294117647108E-2</c:v>
                </c:pt>
                <c:pt idx="19">
                  <c:v>2.3529411764705889E-2</c:v>
                </c:pt>
                <c:pt idx="20">
                  <c:v>1.4117647058823493E-2</c:v>
                </c:pt>
                <c:pt idx="21">
                  <c:v>9.4117647058823539E-3</c:v>
                </c:pt>
                <c:pt idx="22">
                  <c:v>5.8823529411764714E-3</c:v>
                </c:pt>
                <c:pt idx="23">
                  <c:v>9.4117647058823539E-3</c:v>
                </c:pt>
                <c:pt idx="24">
                  <c:v>7.0588235294117719E-3</c:v>
                </c:pt>
                <c:pt idx="25">
                  <c:v>3.5294117647058816E-3</c:v>
                </c:pt>
                <c:pt idx="26">
                  <c:v>1.1764705882352905E-3</c:v>
                </c:pt>
                <c:pt idx="27">
                  <c:v>0</c:v>
                </c:pt>
                <c:pt idx="28">
                  <c:v>4.7058823529411821E-3</c:v>
                </c:pt>
                <c:pt idx="29">
                  <c:v>1.1764705882352905E-3</c:v>
                </c:pt>
                <c:pt idx="30">
                  <c:v>2.3529411764705902E-3</c:v>
                </c:pt>
              </c:numCache>
            </c:numRef>
          </c:val>
        </c:ser>
        <c:ser>
          <c:idx val="1"/>
          <c:order val="1"/>
          <c:tx>
            <c:strRef>
              <c:f>'unc-49 A3_0.02_50%'!$C$104</c:f>
              <c:strCache>
                <c:ptCount val="1"/>
                <c:pt idx="0">
                  <c:v>unc-49_REX_A3_02</c:v>
                </c:pt>
              </c:strCache>
            </c:strRef>
          </c:tx>
          <c:marker>
            <c:symbol val="none"/>
          </c:marker>
          <c:cat>
            <c:numRef>
              <c:f>'unc-49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3_0.02_50%'!$C$105:$C$135</c:f>
              <c:numCache>
                <c:formatCode>General</c:formatCode>
                <c:ptCount val="31"/>
                <c:pt idx="1">
                  <c:v>9.8393574297188799E-2</c:v>
                </c:pt>
                <c:pt idx="2">
                  <c:v>9.1030789825970487E-2</c:v>
                </c:pt>
                <c:pt idx="3">
                  <c:v>9.1700133868808584E-2</c:v>
                </c:pt>
                <c:pt idx="4">
                  <c:v>7.8313253012048237E-2</c:v>
                </c:pt>
                <c:pt idx="5">
                  <c:v>5.2878179384203486E-2</c:v>
                </c:pt>
                <c:pt idx="6">
                  <c:v>3.8152610441767099E-2</c:v>
                </c:pt>
                <c:pt idx="7">
                  <c:v>3.1459170013386911E-2</c:v>
                </c:pt>
                <c:pt idx="8">
                  <c:v>3.4136546184738999E-2</c:v>
                </c:pt>
                <c:pt idx="9">
                  <c:v>4.1499330655957185E-2</c:v>
                </c:pt>
                <c:pt idx="10">
                  <c:v>3.5475234270415011E-2</c:v>
                </c:pt>
                <c:pt idx="11">
                  <c:v>3.4805890227577012E-2</c:v>
                </c:pt>
                <c:pt idx="12">
                  <c:v>3.279785809906291E-2</c:v>
                </c:pt>
                <c:pt idx="13">
                  <c:v>3.4136546184738999E-2</c:v>
                </c:pt>
                <c:pt idx="14">
                  <c:v>3.3467202141900902E-2</c:v>
                </c:pt>
                <c:pt idx="15">
                  <c:v>3.2128514056224897E-2</c:v>
                </c:pt>
                <c:pt idx="16">
                  <c:v>2.2757697456492608E-2</c:v>
                </c:pt>
                <c:pt idx="17">
                  <c:v>1.67336010709505E-2</c:v>
                </c:pt>
                <c:pt idx="18">
                  <c:v>1.0040160642570305E-2</c:v>
                </c:pt>
                <c:pt idx="19">
                  <c:v>1.0709504685408305E-2</c:v>
                </c:pt>
                <c:pt idx="20">
                  <c:v>6.6934404283801917E-3</c:v>
                </c:pt>
                <c:pt idx="21">
                  <c:v>8.7014725568942443E-3</c:v>
                </c:pt>
                <c:pt idx="22">
                  <c:v>5.3547523427041515E-3</c:v>
                </c:pt>
                <c:pt idx="23">
                  <c:v>6.6934404283801926E-4</c:v>
                </c:pt>
                <c:pt idx="24">
                  <c:v>2.0080321285140608E-3</c:v>
                </c:pt>
                <c:pt idx="25">
                  <c:v>6.6934404283801926E-4</c:v>
                </c:pt>
                <c:pt idx="26">
                  <c:v>6.6934404283801926E-4</c:v>
                </c:pt>
                <c:pt idx="27">
                  <c:v>0</c:v>
                </c:pt>
                <c:pt idx="28">
                  <c:v>1.3386880856760409E-3</c:v>
                </c:pt>
                <c:pt idx="29">
                  <c:v>0</c:v>
                </c:pt>
                <c:pt idx="30">
                  <c:v>6.6934404283801926E-4</c:v>
                </c:pt>
              </c:numCache>
            </c:numRef>
          </c:val>
        </c:ser>
        <c:ser>
          <c:idx val="2"/>
          <c:order val="2"/>
          <c:tx>
            <c:strRef>
              <c:f>'unc-49 A3_0.02_50%'!$D$104</c:f>
              <c:strCache>
                <c:ptCount val="1"/>
                <c:pt idx="0">
                  <c:v>unc-49_REX_A3_03</c:v>
                </c:pt>
              </c:strCache>
            </c:strRef>
          </c:tx>
          <c:marker>
            <c:symbol val="none"/>
          </c:marker>
          <c:cat>
            <c:numRef>
              <c:f>'unc-49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3_0.02_50%'!$D$105:$D$135</c:f>
              <c:numCache>
                <c:formatCode>General</c:formatCode>
                <c:ptCount val="31"/>
                <c:pt idx="1">
                  <c:v>8.7826086956521693E-2</c:v>
                </c:pt>
                <c:pt idx="2">
                  <c:v>6.5217391304347824E-2</c:v>
                </c:pt>
                <c:pt idx="3">
                  <c:v>9.391304347826096E-2</c:v>
                </c:pt>
                <c:pt idx="4">
                  <c:v>5.6521739130434803E-2</c:v>
                </c:pt>
                <c:pt idx="5">
                  <c:v>5.6521739130434803E-2</c:v>
                </c:pt>
                <c:pt idx="6">
                  <c:v>3.5652173913043511E-2</c:v>
                </c:pt>
                <c:pt idx="7">
                  <c:v>3.4782608695652202E-2</c:v>
                </c:pt>
                <c:pt idx="8">
                  <c:v>4.521739130434782E-2</c:v>
                </c:pt>
                <c:pt idx="9">
                  <c:v>4.26086956521739E-2</c:v>
                </c:pt>
                <c:pt idx="10">
                  <c:v>4.6956521739130418E-2</c:v>
                </c:pt>
                <c:pt idx="11">
                  <c:v>4.0000000000000015E-2</c:v>
                </c:pt>
                <c:pt idx="12">
                  <c:v>4.0000000000000015E-2</c:v>
                </c:pt>
                <c:pt idx="13">
                  <c:v>4.0000000000000015E-2</c:v>
                </c:pt>
                <c:pt idx="14">
                  <c:v>3.1304347826087014E-2</c:v>
                </c:pt>
                <c:pt idx="15">
                  <c:v>2.5217391304347799E-2</c:v>
                </c:pt>
                <c:pt idx="16">
                  <c:v>2.5217391304347799E-2</c:v>
                </c:pt>
                <c:pt idx="17">
                  <c:v>1.7391304347826101E-2</c:v>
                </c:pt>
                <c:pt idx="18">
                  <c:v>1.39130434782609E-2</c:v>
                </c:pt>
                <c:pt idx="19">
                  <c:v>2.1739130434782601E-2</c:v>
                </c:pt>
                <c:pt idx="20">
                  <c:v>1.1304347826087004E-2</c:v>
                </c:pt>
                <c:pt idx="21">
                  <c:v>6.0869565217391321E-3</c:v>
                </c:pt>
                <c:pt idx="22">
                  <c:v>3.4782608695652201E-3</c:v>
                </c:pt>
                <c:pt idx="23">
                  <c:v>4.3478260869565201E-3</c:v>
                </c:pt>
                <c:pt idx="24">
                  <c:v>2.6086956521739111E-3</c:v>
                </c:pt>
                <c:pt idx="25">
                  <c:v>4.3478260869565201E-3</c:v>
                </c:pt>
                <c:pt idx="26">
                  <c:v>1.7391304347826105E-3</c:v>
                </c:pt>
                <c:pt idx="27">
                  <c:v>1.7391304347826105E-3</c:v>
                </c:pt>
                <c:pt idx="28">
                  <c:v>0</c:v>
                </c:pt>
                <c:pt idx="29">
                  <c:v>0</c:v>
                </c:pt>
                <c:pt idx="30">
                  <c:v>8.6956521739130449E-4</c:v>
                </c:pt>
              </c:numCache>
            </c:numRef>
          </c:val>
        </c:ser>
        <c:ser>
          <c:idx val="3"/>
          <c:order val="3"/>
          <c:tx>
            <c:strRef>
              <c:f>'unc-49 A3_0.02_50%'!$E$104</c:f>
              <c:strCache>
                <c:ptCount val="1"/>
                <c:pt idx="0">
                  <c:v>unc-49_REX_A3_04</c:v>
                </c:pt>
              </c:strCache>
            </c:strRef>
          </c:tx>
          <c:marker>
            <c:symbol val="none"/>
          </c:marker>
          <c:cat>
            <c:numRef>
              <c:f>'unc-49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3_0.02_50%'!$E$105:$E$135</c:f>
              <c:numCache>
                <c:formatCode>General</c:formatCode>
                <c:ptCount val="31"/>
                <c:pt idx="1">
                  <c:v>7.4242424242424235E-2</c:v>
                </c:pt>
                <c:pt idx="2">
                  <c:v>9.0151515151515094E-2</c:v>
                </c:pt>
                <c:pt idx="3">
                  <c:v>4.9242424242424226E-2</c:v>
                </c:pt>
                <c:pt idx="4">
                  <c:v>6.1363636363636433E-2</c:v>
                </c:pt>
                <c:pt idx="5">
                  <c:v>4.3939393939393903E-2</c:v>
                </c:pt>
                <c:pt idx="6">
                  <c:v>2.8030303030302999E-2</c:v>
                </c:pt>
                <c:pt idx="7">
                  <c:v>3.03030303030303E-2</c:v>
                </c:pt>
                <c:pt idx="8">
                  <c:v>2.5757575757575809E-2</c:v>
                </c:pt>
                <c:pt idx="9">
                  <c:v>3.03030303030303E-2</c:v>
                </c:pt>
                <c:pt idx="10">
                  <c:v>3.4848484848484886E-2</c:v>
                </c:pt>
                <c:pt idx="11">
                  <c:v>4.5454545454545497E-2</c:v>
                </c:pt>
                <c:pt idx="12">
                  <c:v>4.2424242424242399E-2</c:v>
                </c:pt>
                <c:pt idx="13">
                  <c:v>4.2424242424242399E-2</c:v>
                </c:pt>
                <c:pt idx="14">
                  <c:v>4.2424242424242399E-2</c:v>
                </c:pt>
                <c:pt idx="15">
                  <c:v>4.8484848484848485E-2</c:v>
                </c:pt>
                <c:pt idx="16">
                  <c:v>3.7121212121212117E-2</c:v>
                </c:pt>
                <c:pt idx="17">
                  <c:v>3.8636363636363615E-2</c:v>
                </c:pt>
                <c:pt idx="18">
                  <c:v>3.1060606060606108E-2</c:v>
                </c:pt>
                <c:pt idx="19">
                  <c:v>2.12121212121212E-2</c:v>
                </c:pt>
                <c:pt idx="20">
                  <c:v>1.5151515151515204E-2</c:v>
                </c:pt>
                <c:pt idx="21">
                  <c:v>1.3636363636363601E-2</c:v>
                </c:pt>
                <c:pt idx="22">
                  <c:v>1.5909090909090901E-2</c:v>
                </c:pt>
                <c:pt idx="23">
                  <c:v>7.575757575757582E-3</c:v>
                </c:pt>
                <c:pt idx="24">
                  <c:v>7.575757575757582E-3</c:v>
                </c:pt>
                <c:pt idx="25">
                  <c:v>3.0303030303030299E-3</c:v>
                </c:pt>
                <c:pt idx="26">
                  <c:v>1.5151515151515208E-3</c:v>
                </c:pt>
                <c:pt idx="27">
                  <c:v>7.5757575757575823E-4</c:v>
                </c:pt>
                <c:pt idx="28">
                  <c:v>7.5757575757575823E-4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unc-49 A3_0.02_50%'!$F$104</c:f>
              <c:strCache>
                <c:ptCount val="1"/>
                <c:pt idx="0">
                  <c:v>unc-49_REX_A3_05</c:v>
                </c:pt>
              </c:strCache>
            </c:strRef>
          </c:tx>
          <c:marker>
            <c:symbol val="none"/>
          </c:marker>
          <c:cat>
            <c:numRef>
              <c:f>'unc-49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3_0.02_50%'!$F$105:$F$135</c:f>
              <c:numCache>
                <c:formatCode>General</c:formatCode>
                <c:ptCount val="31"/>
                <c:pt idx="1">
                  <c:v>7.8930202217873419E-2</c:v>
                </c:pt>
                <c:pt idx="2">
                  <c:v>6.7840834964122632E-2</c:v>
                </c:pt>
                <c:pt idx="3">
                  <c:v>7.632093933463803E-2</c:v>
                </c:pt>
                <c:pt idx="4">
                  <c:v>5.936073059360733E-2</c:v>
                </c:pt>
                <c:pt idx="5">
                  <c:v>5.936073059360733E-2</c:v>
                </c:pt>
                <c:pt idx="6">
                  <c:v>5.0228310502283095E-2</c:v>
                </c:pt>
                <c:pt idx="7">
                  <c:v>4.1748206131767787E-2</c:v>
                </c:pt>
                <c:pt idx="8">
                  <c:v>5.6751467710371803E-2</c:v>
                </c:pt>
                <c:pt idx="9">
                  <c:v>5.3489889106327487E-2</c:v>
                </c:pt>
                <c:pt idx="10">
                  <c:v>5.8708414872798431E-2</c:v>
                </c:pt>
                <c:pt idx="11">
                  <c:v>4.9575994781474203E-2</c:v>
                </c:pt>
                <c:pt idx="12">
                  <c:v>4.9575994781474203E-2</c:v>
                </c:pt>
                <c:pt idx="13">
                  <c:v>4.0443574690149996E-2</c:v>
                </c:pt>
                <c:pt idx="14">
                  <c:v>3.6529680365296795E-2</c:v>
                </c:pt>
                <c:pt idx="15">
                  <c:v>3.4572733202870201E-2</c:v>
                </c:pt>
                <c:pt idx="16">
                  <c:v>2.8701891715590299E-2</c:v>
                </c:pt>
                <c:pt idx="17">
                  <c:v>2.2178734507501602E-2</c:v>
                </c:pt>
                <c:pt idx="18">
                  <c:v>1.63078930202218E-2</c:v>
                </c:pt>
                <c:pt idx="19">
                  <c:v>1.3046314416177401E-2</c:v>
                </c:pt>
                <c:pt idx="20">
                  <c:v>5.870841487279844E-3</c:v>
                </c:pt>
                <c:pt idx="21">
                  <c:v>7.8277886497064575E-3</c:v>
                </c:pt>
                <c:pt idx="22">
                  <c:v>5.2185257664709699E-3</c:v>
                </c:pt>
                <c:pt idx="23">
                  <c:v>1.9569471624266118E-3</c:v>
                </c:pt>
                <c:pt idx="24">
                  <c:v>1.3046314416177405E-3</c:v>
                </c:pt>
                <c:pt idx="25">
                  <c:v>1.9569471624266118E-3</c:v>
                </c:pt>
                <c:pt idx="26">
                  <c:v>6.5231572080887102E-4</c:v>
                </c:pt>
                <c:pt idx="27">
                  <c:v>6.5231572080887102E-4</c:v>
                </c:pt>
                <c:pt idx="28">
                  <c:v>1.3046314416177405E-3</c:v>
                </c:pt>
                <c:pt idx="29">
                  <c:v>1.3046314416177405E-3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unc-49 A3_0.02_50%'!$G$104</c:f>
              <c:strCache>
                <c:ptCount val="1"/>
                <c:pt idx="0">
                  <c:v>unc-49_REX_A3_06</c:v>
                </c:pt>
              </c:strCache>
            </c:strRef>
          </c:tx>
          <c:marker>
            <c:symbol val="none"/>
          </c:marker>
          <c:cat>
            <c:numRef>
              <c:f>'unc-49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3_0.02_50%'!$G$105:$G$135</c:f>
              <c:numCache>
                <c:formatCode>General</c:formatCode>
                <c:ptCount val="31"/>
                <c:pt idx="1">
                  <c:v>7.3078989790435298E-2</c:v>
                </c:pt>
                <c:pt idx="2">
                  <c:v>7.898979043524991E-2</c:v>
                </c:pt>
                <c:pt idx="3">
                  <c:v>8.5437936593229472E-2</c:v>
                </c:pt>
                <c:pt idx="4">
                  <c:v>7.0929607737775402E-2</c:v>
                </c:pt>
                <c:pt idx="5">
                  <c:v>5.7495969908651329E-2</c:v>
                </c:pt>
                <c:pt idx="6">
                  <c:v>5.3734551316496515E-2</c:v>
                </c:pt>
                <c:pt idx="7">
                  <c:v>4.8361096184846922E-2</c:v>
                </c:pt>
                <c:pt idx="8">
                  <c:v>3.4927458355722703E-2</c:v>
                </c:pt>
                <c:pt idx="9">
                  <c:v>4.8361096184846922E-2</c:v>
                </c:pt>
                <c:pt idx="10">
                  <c:v>4.9435787211176821E-2</c:v>
                </c:pt>
                <c:pt idx="11">
                  <c:v>4.9435787211176821E-2</c:v>
                </c:pt>
                <c:pt idx="12">
                  <c:v>4.1375604513702299E-2</c:v>
                </c:pt>
                <c:pt idx="13">
                  <c:v>4.2450295540032219E-2</c:v>
                </c:pt>
                <c:pt idx="14">
                  <c:v>3.65394948952176E-2</c:v>
                </c:pt>
                <c:pt idx="15">
                  <c:v>3.2778076303062897E-2</c:v>
                </c:pt>
                <c:pt idx="16">
                  <c:v>2.1493820526598609E-2</c:v>
                </c:pt>
                <c:pt idx="17">
                  <c:v>2.1493820526598609E-2</c:v>
                </c:pt>
                <c:pt idx="18">
                  <c:v>2.2031166039763617E-2</c:v>
                </c:pt>
                <c:pt idx="19">
                  <c:v>1.0209564750134299E-2</c:v>
                </c:pt>
                <c:pt idx="20">
                  <c:v>9.6722192369693791E-3</c:v>
                </c:pt>
                <c:pt idx="21">
                  <c:v>1.0209564750134299E-2</c:v>
                </c:pt>
                <c:pt idx="22">
                  <c:v>4.2987641053197235E-3</c:v>
                </c:pt>
                <c:pt idx="23">
                  <c:v>3.7614185921547609E-3</c:v>
                </c:pt>
                <c:pt idx="24">
                  <c:v>2.1493820526598609E-3</c:v>
                </c:pt>
                <c:pt idx="25">
                  <c:v>1.07469102632993E-3</c:v>
                </c:pt>
                <c:pt idx="26">
                  <c:v>1.07469102632993E-3</c:v>
                </c:pt>
                <c:pt idx="27">
                  <c:v>1.07469102632993E-3</c:v>
                </c:pt>
                <c:pt idx="28">
                  <c:v>5.3734551316496522E-4</c:v>
                </c:pt>
                <c:pt idx="29">
                  <c:v>1.07469102632993E-3</c:v>
                </c:pt>
                <c:pt idx="30">
                  <c:v>0</c:v>
                </c:pt>
              </c:numCache>
            </c:numRef>
          </c:val>
        </c:ser>
        <c:ser>
          <c:idx val="6"/>
          <c:order val="6"/>
          <c:tx>
            <c:strRef>
              <c:f>'unc-49 A3_0.02_50%'!$H$104</c:f>
              <c:strCache>
                <c:ptCount val="1"/>
                <c:pt idx="0">
                  <c:v>unc-49_REX_A3_07</c:v>
                </c:pt>
              </c:strCache>
            </c:strRef>
          </c:tx>
          <c:marker>
            <c:symbol val="none"/>
          </c:marker>
          <c:cat>
            <c:numRef>
              <c:f>'unc-49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3_0.02_50%'!$H$105:$H$135</c:f>
              <c:numCache>
                <c:formatCode>General</c:formatCode>
                <c:ptCount val="31"/>
                <c:pt idx="1">
                  <c:v>0.10376134889753599</c:v>
                </c:pt>
                <c:pt idx="2">
                  <c:v>9.468223086900128E-2</c:v>
                </c:pt>
                <c:pt idx="3">
                  <c:v>7.1335927367055796E-2</c:v>
                </c:pt>
                <c:pt idx="4">
                  <c:v>6.095979247730219E-2</c:v>
                </c:pt>
                <c:pt idx="5">
                  <c:v>5.4474708171206199E-2</c:v>
                </c:pt>
                <c:pt idx="6">
                  <c:v>4.15045395590143E-2</c:v>
                </c:pt>
                <c:pt idx="7">
                  <c:v>2.8534370946822308E-2</c:v>
                </c:pt>
                <c:pt idx="8">
                  <c:v>3.1128404669260701E-2</c:v>
                </c:pt>
                <c:pt idx="9">
                  <c:v>3.1128404669260701E-2</c:v>
                </c:pt>
                <c:pt idx="10">
                  <c:v>3.1128404669260701E-2</c:v>
                </c:pt>
                <c:pt idx="11">
                  <c:v>3.7613488975356699E-2</c:v>
                </c:pt>
                <c:pt idx="12">
                  <c:v>3.63164721141375E-2</c:v>
                </c:pt>
                <c:pt idx="13">
                  <c:v>3.8910505836575897E-2</c:v>
                </c:pt>
                <c:pt idx="14">
                  <c:v>2.7237354085603117E-2</c:v>
                </c:pt>
                <c:pt idx="15">
                  <c:v>2.7237354085603117E-2</c:v>
                </c:pt>
                <c:pt idx="16">
                  <c:v>2.4643320363164713E-2</c:v>
                </c:pt>
                <c:pt idx="17">
                  <c:v>1.5564202334630401E-2</c:v>
                </c:pt>
                <c:pt idx="18">
                  <c:v>1.2970168612192003E-2</c:v>
                </c:pt>
                <c:pt idx="19">
                  <c:v>9.0791180285343717E-3</c:v>
                </c:pt>
                <c:pt idx="20">
                  <c:v>1.1673151750972804E-2</c:v>
                </c:pt>
                <c:pt idx="21">
                  <c:v>5.1880674448767814E-3</c:v>
                </c:pt>
                <c:pt idx="22">
                  <c:v>5.1880674448767814E-3</c:v>
                </c:pt>
                <c:pt idx="23">
                  <c:v>2.5940337224383912E-3</c:v>
                </c:pt>
                <c:pt idx="24">
                  <c:v>5.1880674448767814E-3</c:v>
                </c:pt>
                <c:pt idx="25">
                  <c:v>2.5940337224383912E-3</c:v>
                </c:pt>
                <c:pt idx="26">
                  <c:v>5.1880674448767814E-3</c:v>
                </c:pt>
                <c:pt idx="27">
                  <c:v>0</c:v>
                </c:pt>
                <c:pt idx="28">
                  <c:v>0</c:v>
                </c:pt>
                <c:pt idx="29">
                  <c:v>1.2970168612192003E-3</c:v>
                </c:pt>
                <c:pt idx="30">
                  <c:v>2.5940337224383912E-3</c:v>
                </c:pt>
              </c:numCache>
            </c:numRef>
          </c:val>
        </c:ser>
        <c:ser>
          <c:idx val="7"/>
          <c:order val="7"/>
          <c:tx>
            <c:strRef>
              <c:f>'unc-49 A3_0.02_50%'!$I$104</c:f>
              <c:strCache>
                <c:ptCount val="1"/>
                <c:pt idx="0">
                  <c:v>unc-49_REX_A3_08</c:v>
                </c:pt>
              </c:strCache>
            </c:strRef>
          </c:tx>
          <c:marker>
            <c:symbol val="none"/>
          </c:marker>
          <c:cat>
            <c:numRef>
              <c:f>'unc-49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3_0.02_50%'!$I$105:$I$135</c:f>
              <c:numCache>
                <c:formatCode>General</c:formatCode>
                <c:ptCount val="31"/>
                <c:pt idx="1">
                  <c:v>9.1235632183908094E-2</c:v>
                </c:pt>
                <c:pt idx="2">
                  <c:v>8.1178160919540193E-2</c:v>
                </c:pt>
                <c:pt idx="3">
                  <c:v>8.7643678160919503E-2</c:v>
                </c:pt>
                <c:pt idx="4">
                  <c:v>6.9683908045977003E-2</c:v>
                </c:pt>
                <c:pt idx="5">
                  <c:v>5.6752873563218412E-2</c:v>
                </c:pt>
                <c:pt idx="6">
                  <c:v>4.9568965517241423E-2</c:v>
                </c:pt>
                <c:pt idx="7">
                  <c:v>3.9511494252873598E-2</c:v>
                </c:pt>
                <c:pt idx="8">
                  <c:v>5.8189655172413798E-2</c:v>
                </c:pt>
                <c:pt idx="9">
                  <c:v>4.9568965517241423E-2</c:v>
                </c:pt>
                <c:pt idx="10">
                  <c:v>4.0229885057471299E-2</c:v>
                </c:pt>
                <c:pt idx="11">
                  <c:v>4.8132183908046036E-2</c:v>
                </c:pt>
                <c:pt idx="12">
                  <c:v>5.4597701149425353E-2</c:v>
                </c:pt>
                <c:pt idx="13">
                  <c:v>3.6637931034482804E-2</c:v>
                </c:pt>
                <c:pt idx="14">
                  <c:v>3.1609195402298916E-2</c:v>
                </c:pt>
                <c:pt idx="15">
                  <c:v>2.2270114942528708E-2</c:v>
                </c:pt>
                <c:pt idx="16">
                  <c:v>1.86781609195402E-2</c:v>
                </c:pt>
                <c:pt idx="17">
                  <c:v>1.6522988505747103E-2</c:v>
                </c:pt>
                <c:pt idx="18">
                  <c:v>1.4367816091953999E-2</c:v>
                </c:pt>
                <c:pt idx="19">
                  <c:v>9.3390804597701226E-3</c:v>
                </c:pt>
                <c:pt idx="20">
                  <c:v>7.1839080459770114E-3</c:v>
                </c:pt>
                <c:pt idx="21">
                  <c:v>5.7471264367816117E-3</c:v>
                </c:pt>
                <c:pt idx="22">
                  <c:v>3.5919540229885109E-3</c:v>
                </c:pt>
                <c:pt idx="23">
                  <c:v>7.1839080459770125E-4</c:v>
                </c:pt>
                <c:pt idx="24">
                  <c:v>2.1551724137930991E-3</c:v>
                </c:pt>
                <c:pt idx="25">
                  <c:v>0</c:v>
                </c:pt>
                <c:pt idx="26">
                  <c:v>7.1839080459770125E-4</c:v>
                </c:pt>
                <c:pt idx="27">
                  <c:v>2.1551724137930991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8"/>
          <c:order val="8"/>
          <c:tx>
            <c:strRef>
              <c:f>'unc-49 A3_0.02_50%'!$J$104</c:f>
              <c:strCache>
                <c:ptCount val="1"/>
                <c:pt idx="0">
                  <c:v>unc-49_REX_A3_09</c:v>
                </c:pt>
              </c:strCache>
            </c:strRef>
          </c:tx>
          <c:marker>
            <c:symbol val="none"/>
          </c:marker>
          <c:cat>
            <c:numRef>
              <c:f>'unc-49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3_0.02_50%'!$J$105:$J$135</c:f>
              <c:numCache>
                <c:formatCode>General</c:formatCode>
                <c:ptCount val="31"/>
                <c:pt idx="1">
                  <c:v>8.7087087087087081E-2</c:v>
                </c:pt>
                <c:pt idx="2">
                  <c:v>8.1681681681681662E-2</c:v>
                </c:pt>
                <c:pt idx="3">
                  <c:v>6.7867867867867901E-2</c:v>
                </c:pt>
                <c:pt idx="4">
                  <c:v>6.0060060060060101E-2</c:v>
                </c:pt>
                <c:pt idx="5">
                  <c:v>5.8858858858858901E-2</c:v>
                </c:pt>
                <c:pt idx="6">
                  <c:v>5.7657657657657714E-2</c:v>
                </c:pt>
                <c:pt idx="7">
                  <c:v>6.2462462462462502E-2</c:v>
                </c:pt>
                <c:pt idx="8">
                  <c:v>4.5045045045045001E-2</c:v>
                </c:pt>
                <c:pt idx="9">
                  <c:v>5.9459459459459497E-2</c:v>
                </c:pt>
                <c:pt idx="10">
                  <c:v>5.4654654654654702E-2</c:v>
                </c:pt>
                <c:pt idx="11">
                  <c:v>4.6246246246246216E-2</c:v>
                </c:pt>
                <c:pt idx="12">
                  <c:v>3.36336336336336E-2</c:v>
                </c:pt>
                <c:pt idx="13">
                  <c:v>2.6426426426426401E-2</c:v>
                </c:pt>
                <c:pt idx="14">
                  <c:v>3.24324324324324E-2</c:v>
                </c:pt>
                <c:pt idx="15">
                  <c:v>2.7627627627627615E-2</c:v>
                </c:pt>
                <c:pt idx="16">
                  <c:v>2.1021021021021002E-2</c:v>
                </c:pt>
                <c:pt idx="17">
                  <c:v>2.1621621621621602E-2</c:v>
                </c:pt>
                <c:pt idx="18">
                  <c:v>1.4414414414414399E-2</c:v>
                </c:pt>
                <c:pt idx="19">
                  <c:v>1.3813813813813804E-2</c:v>
                </c:pt>
                <c:pt idx="20">
                  <c:v>1.2012012012012E-2</c:v>
                </c:pt>
                <c:pt idx="21">
                  <c:v>4.8048048048048003E-3</c:v>
                </c:pt>
                <c:pt idx="22">
                  <c:v>5.4054054054054118E-3</c:v>
                </c:pt>
                <c:pt idx="23">
                  <c:v>4.8048048048048003E-3</c:v>
                </c:pt>
                <c:pt idx="24">
                  <c:v>1.2012012012012001E-3</c:v>
                </c:pt>
                <c:pt idx="25">
                  <c:v>1.8018018018018005E-3</c:v>
                </c:pt>
                <c:pt idx="26">
                  <c:v>6.0060060060060101E-4</c:v>
                </c:pt>
                <c:pt idx="27">
                  <c:v>1.8018018018018005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unc-49 A3_0.02_50%'!$K$104</c:f>
              <c:strCache>
                <c:ptCount val="1"/>
                <c:pt idx="0">
                  <c:v>unc-49_REX_A3_10</c:v>
                </c:pt>
              </c:strCache>
            </c:strRef>
          </c:tx>
          <c:marker>
            <c:symbol val="none"/>
          </c:marker>
          <c:cat>
            <c:numRef>
              <c:f>'unc-49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3_0.02_50%'!$K$105:$K$135</c:f>
              <c:numCache>
                <c:formatCode>General</c:formatCode>
                <c:ptCount val="31"/>
                <c:pt idx="1">
                  <c:v>0.10977242302543504</c:v>
                </c:pt>
                <c:pt idx="2">
                  <c:v>6.8942436412315913E-2</c:v>
                </c:pt>
                <c:pt idx="3">
                  <c:v>8.5006693440428396E-2</c:v>
                </c:pt>
                <c:pt idx="4">
                  <c:v>5.555555555555558E-2</c:v>
                </c:pt>
                <c:pt idx="5">
                  <c:v>4.4176706827309231E-2</c:v>
                </c:pt>
                <c:pt idx="6">
                  <c:v>5.1539491298527404E-2</c:v>
                </c:pt>
                <c:pt idx="7">
                  <c:v>3.2128514056224897E-2</c:v>
                </c:pt>
                <c:pt idx="8">
                  <c:v>3.279785809906291E-2</c:v>
                </c:pt>
                <c:pt idx="9">
                  <c:v>4.2168674698795219E-2</c:v>
                </c:pt>
                <c:pt idx="10">
                  <c:v>5.1539491298527404E-2</c:v>
                </c:pt>
                <c:pt idx="11">
                  <c:v>4.551539491298532E-2</c:v>
                </c:pt>
                <c:pt idx="12">
                  <c:v>2.811244979919679E-2</c:v>
                </c:pt>
                <c:pt idx="13">
                  <c:v>3.4136546184738999E-2</c:v>
                </c:pt>
                <c:pt idx="14">
                  <c:v>3.0120481927710791E-2</c:v>
                </c:pt>
                <c:pt idx="15">
                  <c:v>2.811244979919679E-2</c:v>
                </c:pt>
                <c:pt idx="16">
                  <c:v>2.7443105756358815E-2</c:v>
                </c:pt>
                <c:pt idx="17">
                  <c:v>1.67336010709505E-2</c:v>
                </c:pt>
                <c:pt idx="18">
                  <c:v>1.4056224899598398E-2</c:v>
                </c:pt>
                <c:pt idx="19">
                  <c:v>1.67336010709505E-2</c:v>
                </c:pt>
                <c:pt idx="20">
                  <c:v>8.7014725568942443E-3</c:v>
                </c:pt>
                <c:pt idx="21">
                  <c:v>1.0709504685408305E-2</c:v>
                </c:pt>
                <c:pt idx="22">
                  <c:v>5.3547523427041515E-3</c:v>
                </c:pt>
                <c:pt idx="23">
                  <c:v>4.6854082998661313E-3</c:v>
                </c:pt>
                <c:pt idx="24">
                  <c:v>4.0160642570281095E-3</c:v>
                </c:pt>
                <c:pt idx="25">
                  <c:v>2.0080321285140608E-3</c:v>
                </c:pt>
                <c:pt idx="26">
                  <c:v>1.3386880856760409E-3</c:v>
                </c:pt>
                <c:pt idx="27">
                  <c:v>6.6934404283801926E-4</c:v>
                </c:pt>
                <c:pt idx="28">
                  <c:v>1.3386880856760409E-3</c:v>
                </c:pt>
                <c:pt idx="29">
                  <c:v>0</c:v>
                </c:pt>
                <c:pt idx="30">
                  <c:v>2.0080321285140608E-3</c:v>
                </c:pt>
              </c:numCache>
            </c:numRef>
          </c:val>
        </c:ser>
        <c:marker val="1"/>
        <c:axId val="166292480"/>
        <c:axId val="166306560"/>
      </c:lineChart>
      <c:catAx>
        <c:axId val="166292480"/>
        <c:scaling>
          <c:orientation val="minMax"/>
        </c:scaling>
        <c:axPos val="b"/>
        <c:numFmt formatCode="#,##0.0_);\(#,##0.0\)" sourceLinked="0"/>
        <c:tickLblPos val="nextTo"/>
        <c:crossAx val="166306560"/>
        <c:crosses val="autoZero"/>
        <c:auto val="1"/>
        <c:lblAlgn val="ctr"/>
        <c:lblOffset val="100"/>
        <c:tickLblSkip val="5"/>
        <c:tickMarkSkip val="5"/>
      </c:catAx>
      <c:valAx>
        <c:axId val="166306560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6292480"/>
        <c:crosses val="autoZero"/>
        <c:crossBetween val="between"/>
      </c:valAx>
    </c:plotArea>
    <c:plotVisOnly val="1"/>
  </c:chart>
  <c:externalData r:id="rId1"/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49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L4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49 L4_0.02_50%'!$B$104</c:f>
              <c:strCache>
                <c:ptCount val="1"/>
                <c:pt idx="0">
                  <c:v>unc-49_L4_0601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B$105:$B$135</c:f>
              <c:numCache>
                <c:formatCode>General</c:formatCode>
                <c:ptCount val="31"/>
              </c:numCache>
            </c:numRef>
          </c:val>
        </c:ser>
        <c:ser>
          <c:idx val="1"/>
          <c:order val="1"/>
          <c:tx>
            <c:strRef>
              <c:f>'unc-49 L4_0.02_50%'!$C$104</c:f>
              <c:strCache>
                <c:ptCount val="1"/>
                <c:pt idx="0">
                  <c:v>unc-49_L4_0602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C$105:$C$135</c:f>
              <c:numCache>
                <c:formatCode>General</c:formatCode>
                <c:ptCount val="31"/>
                <c:pt idx="1">
                  <c:v>3.4532374100719417E-2</c:v>
                </c:pt>
                <c:pt idx="2">
                  <c:v>2.8776978417266213E-2</c:v>
                </c:pt>
                <c:pt idx="3">
                  <c:v>1.7266187050359701E-2</c:v>
                </c:pt>
                <c:pt idx="4">
                  <c:v>8.6330935251798593E-3</c:v>
                </c:pt>
                <c:pt idx="5">
                  <c:v>1.58273381294964E-2</c:v>
                </c:pt>
                <c:pt idx="6">
                  <c:v>1.4388489208633106E-2</c:v>
                </c:pt>
                <c:pt idx="7">
                  <c:v>1.2949640287769801E-2</c:v>
                </c:pt>
                <c:pt idx="8">
                  <c:v>2.3021582733812992E-2</c:v>
                </c:pt>
                <c:pt idx="9">
                  <c:v>1.58273381294964E-2</c:v>
                </c:pt>
                <c:pt idx="10">
                  <c:v>1.58273381294964E-2</c:v>
                </c:pt>
                <c:pt idx="11">
                  <c:v>2.7338129496402901E-2</c:v>
                </c:pt>
                <c:pt idx="12">
                  <c:v>4.3165467625899304E-2</c:v>
                </c:pt>
                <c:pt idx="13">
                  <c:v>4.7482014388489223E-2</c:v>
                </c:pt>
                <c:pt idx="14">
                  <c:v>4.4604316546762585E-2</c:v>
                </c:pt>
                <c:pt idx="15">
                  <c:v>6.1870503597122296E-2</c:v>
                </c:pt>
                <c:pt idx="16">
                  <c:v>6.330935251798557E-2</c:v>
                </c:pt>
                <c:pt idx="17">
                  <c:v>7.6258992805755405E-2</c:v>
                </c:pt>
                <c:pt idx="18">
                  <c:v>6.9064748201438833E-2</c:v>
                </c:pt>
                <c:pt idx="19">
                  <c:v>6.1870503597122296E-2</c:v>
                </c:pt>
                <c:pt idx="20">
                  <c:v>6.0431654676258995E-2</c:v>
                </c:pt>
                <c:pt idx="21">
                  <c:v>6.0431654676258995E-2</c:v>
                </c:pt>
                <c:pt idx="22">
                  <c:v>3.5971223021582698E-2</c:v>
                </c:pt>
                <c:pt idx="23">
                  <c:v>2.7338129496402901E-2</c:v>
                </c:pt>
                <c:pt idx="24">
                  <c:v>2.8776978417266213E-2</c:v>
                </c:pt>
                <c:pt idx="25">
                  <c:v>1.1510791366906505E-2</c:v>
                </c:pt>
                <c:pt idx="26">
                  <c:v>1.7266187050359701E-2</c:v>
                </c:pt>
                <c:pt idx="27">
                  <c:v>1.4388489208633106E-2</c:v>
                </c:pt>
                <c:pt idx="28">
                  <c:v>1.0071942446043198E-2</c:v>
                </c:pt>
                <c:pt idx="29">
                  <c:v>1.4388489208633109E-3</c:v>
                </c:pt>
                <c:pt idx="30">
                  <c:v>5.7553956834532436E-3</c:v>
                </c:pt>
              </c:numCache>
            </c:numRef>
          </c:val>
        </c:ser>
        <c:ser>
          <c:idx val="2"/>
          <c:order val="2"/>
          <c:tx>
            <c:strRef>
              <c:f>'unc-49 L4_0.02_50%'!$D$104</c:f>
              <c:strCache>
                <c:ptCount val="1"/>
                <c:pt idx="0">
                  <c:v>unc-49_L4_06021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D$105:$D$135</c:f>
              <c:numCache>
                <c:formatCode>General</c:formatCode>
                <c:ptCount val="31"/>
                <c:pt idx="1">
                  <c:v>7.650273224043723E-2</c:v>
                </c:pt>
                <c:pt idx="2">
                  <c:v>9.4262295081967207E-2</c:v>
                </c:pt>
                <c:pt idx="3">
                  <c:v>6.4207650273224004E-2</c:v>
                </c:pt>
                <c:pt idx="4">
                  <c:v>7.1038251366120214E-2</c:v>
                </c:pt>
                <c:pt idx="5">
                  <c:v>4.3715846994535498E-2</c:v>
                </c:pt>
                <c:pt idx="6">
                  <c:v>4.3715846994535498E-2</c:v>
                </c:pt>
                <c:pt idx="7">
                  <c:v>3.0054644808743206E-2</c:v>
                </c:pt>
                <c:pt idx="8">
                  <c:v>3.1420765027322412E-2</c:v>
                </c:pt>
                <c:pt idx="9">
                  <c:v>2.86885245901639E-2</c:v>
                </c:pt>
                <c:pt idx="10">
                  <c:v>2.7322404371584685E-2</c:v>
                </c:pt>
                <c:pt idx="11">
                  <c:v>5.6010928961748627E-2</c:v>
                </c:pt>
                <c:pt idx="12">
                  <c:v>5.0546448087431702E-2</c:v>
                </c:pt>
                <c:pt idx="13">
                  <c:v>4.6448087431693999E-2</c:v>
                </c:pt>
                <c:pt idx="14">
                  <c:v>4.0983606557377004E-2</c:v>
                </c:pt>
                <c:pt idx="15">
                  <c:v>4.6448087431693999E-2</c:v>
                </c:pt>
                <c:pt idx="16">
                  <c:v>3.9617486338797789E-2</c:v>
                </c:pt>
                <c:pt idx="17">
                  <c:v>3.1420765027322412E-2</c:v>
                </c:pt>
                <c:pt idx="18">
                  <c:v>2.1857923497267808E-2</c:v>
                </c:pt>
                <c:pt idx="19">
                  <c:v>2.7322404371584685E-2</c:v>
                </c:pt>
                <c:pt idx="20">
                  <c:v>1.5027322404371598E-2</c:v>
                </c:pt>
                <c:pt idx="21">
                  <c:v>1.2295081967213101E-2</c:v>
                </c:pt>
                <c:pt idx="22">
                  <c:v>4.0983606557377103E-3</c:v>
                </c:pt>
                <c:pt idx="23">
                  <c:v>1.0928961748633904E-2</c:v>
                </c:pt>
                <c:pt idx="24">
                  <c:v>8.1967213114754103E-3</c:v>
                </c:pt>
                <c:pt idx="25">
                  <c:v>9.5628415300546572E-3</c:v>
                </c:pt>
                <c:pt idx="26">
                  <c:v>5.4644808743169382E-3</c:v>
                </c:pt>
                <c:pt idx="27">
                  <c:v>1.36612021857923E-3</c:v>
                </c:pt>
                <c:pt idx="28">
                  <c:v>1.36612021857923E-3</c:v>
                </c:pt>
                <c:pt idx="29">
                  <c:v>1.36612021857923E-3</c:v>
                </c:pt>
                <c:pt idx="30">
                  <c:v>2.7322404371584691E-3</c:v>
                </c:pt>
              </c:numCache>
            </c:numRef>
          </c:val>
        </c:ser>
        <c:ser>
          <c:idx val="3"/>
          <c:order val="3"/>
          <c:tx>
            <c:strRef>
              <c:f>'unc-49 L4_0.02_50%'!$E$104</c:f>
              <c:strCache>
                <c:ptCount val="1"/>
                <c:pt idx="0">
                  <c:v>unc-49_L4_06022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E$105:$E$135</c:f>
              <c:numCache>
                <c:formatCode>General</c:formatCode>
                <c:ptCount val="31"/>
                <c:pt idx="1">
                  <c:v>6.0653188180404383E-2</c:v>
                </c:pt>
                <c:pt idx="2">
                  <c:v>5.7542768273716995E-2</c:v>
                </c:pt>
                <c:pt idx="3">
                  <c:v>5.4432348367029613E-2</c:v>
                </c:pt>
                <c:pt idx="4">
                  <c:v>4.0435458786936197E-2</c:v>
                </c:pt>
                <c:pt idx="5">
                  <c:v>4.9766718506998431E-2</c:v>
                </c:pt>
                <c:pt idx="6">
                  <c:v>2.17729393468118E-2</c:v>
                </c:pt>
                <c:pt idx="7">
                  <c:v>2.3328149300155494E-2</c:v>
                </c:pt>
                <c:pt idx="8">
                  <c:v>2.0217729393468088E-2</c:v>
                </c:pt>
                <c:pt idx="9">
                  <c:v>2.3328149300155494E-2</c:v>
                </c:pt>
                <c:pt idx="10">
                  <c:v>2.4883359253499202E-2</c:v>
                </c:pt>
                <c:pt idx="11">
                  <c:v>3.8880248833592514E-2</c:v>
                </c:pt>
                <c:pt idx="12">
                  <c:v>2.79937791601866E-2</c:v>
                </c:pt>
                <c:pt idx="13">
                  <c:v>3.7325038880248802E-2</c:v>
                </c:pt>
                <c:pt idx="14">
                  <c:v>3.42146189735614E-2</c:v>
                </c:pt>
                <c:pt idx="15">
                  <c:v>5.2877138413685798E-2</c:v>
                </c:pt>
                <c:pt idx="16">
                  <c:v>4.5101088646967297E-2</c:v>
                </c:pt>
                <c:pt idx="17">
                  <c:v>3.42146189735614E-2</c:v>
                </c:pt>
                <c:pt idx="18">
                  <c:v>3.2659409020217717E-2</c:v>
                </c:pt>
                <c:pt idx="19">
                  <c:v>4.1990668740279895E-2</c:v>
                </c:pt>
                <c:pt idx="20">
                  <c:v>2.0217729393468088E-2</c:v>
                </c:pt>
                <c:pt idx="21">
                  <c:v>2.0217729393468088E-2</c:v>
                </c:pt>
                <c:pt idx="22">
                  <c:v>2.0217729393468088E-2</c:v>
                </c:pt>
                <c:pt idx="23">
                  <c:v>2.3328149300155494E-2</c:v>
                </c:pt>
                <c:pt idx="24">
                  <c:v>9.3312597200622092E-3</c:v>
                </c:pt>
                <c:pt idx="25">
                  <c:v>6.2208398133748117E-3</c:v>
                </c:pt>
                <c:pt idx="26">
                  <c:v>1.39968895800933E-2</c:v>
                </c:pt>
                <c:pt idx="27">
                  <c:v>6.2208398133748117E-3</c:v>
                </c:pt>
                <c:pt idx="28">
                  <c:v>6.2208398133748117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unc-49 L4_0.02_50%'!$F$104</c:f>
              <c:strCache>
                <c:ptCount val="1"/>
                <c:pt idx="0">
                  <c:v>unc-49_L4_06023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F$105:$F$135</c:f>
              <c:numCache>
                <c:formatCode>General</c:formatCode>
                <c:ptCount val="31"/>
                <c:pt idx="1">
                  <c:v>7.5067024128686335E-2</c:v>
                </c:pt>
                <c:pt idx="2">
                  <c:v>5.0938337801608627E-2</c:v>
                </c:pt>
                <c:pt idx="3">
                  <c:v>6.4343163538873996E-2</c:v>
                </c:pt>
                <c:pt idx="4">
                  <c:v>6.7024128686327095E-2</c:v>
                </c:pt>
                <c:pt idx="5">
                  <c:v>6.4343163538873996E-2</c:v>
                </c:pt>
                <c:pt idx="6">
                  <c:v>4.825737265415548E-2</c:v>
                </c:pt>
                <c:pt idx="7">
                  <c:v>3.7533512064343216E-2</c:v>
                </c:pt>
                <c:pt idx="8">
                  <c:v>8.042895442359253E-3</c:v>
                </c:pt>
                <c:pt idx="9">
                  <c:v>1.0723860589812305E-2</c:v>
                </c:pt>
                <c:pt idx="10">
                  <c:v>3.2171581769436998E-2</c:v>
                </c:pt>
                <c:pt idx="11">
                  <c:v>2.4128686327077688E-2</c:v>
                </c:pt>
                <c:pt idx="12">
                  <c:v>3.2171581769436998E-2</c:v>
                </c:pt>
                <c:pt idx="13">
                  <c:v>2.4128686327077688E-2</c:v>
                </c:pt>
                <c:pt idx="14">
                  <c:v>2.949061662198391E-2</c:v>
                </c:pt>
                <c:pt idx="15">
                  <c:v>3.7533512064343216E-2</c:v>
                </c:pt>
                <c:pt idx="16">
                  <c:v>2.1447721179624717E-2</c:v>
                </c:pt>
                <c:pt idx="17">
                  <c:v>1.8766756032171601E-2</c:v>
                </c:pt>
                <c:pt idx="18">
                  <c:v>1.3404825737265411E-2</c:v>
                </c:pt>
                <c:pt idx="19">
                  <c:v>1.8766756032171601E-2</c:v>
                </c:pt>
                <c:pt idx="20">
                  <c:v>1.0723860589812305E-2</c:v>
                </c:pt>
                <c:pt idx="21">
                  <c:v>2.680965147453081E-3</c:v>
                </c:pt>
                <c:pt idx="22">
                  <c:v>1.6085790884718506E-2</c:v>
                </c:pt>
                <c:pt idx="23">
                  <c:v>1.6085790884718506E-2</c:v>
                </c:pt>
                <c:pt idx="24">
                  <c:v>8.042895442359253E-3</c:v>
                </c:pt>
                <c:pt idx="25">
                  <c:v>5.3619302949061715E-3</c:v>
                </c:pt>
                <c:pt idx="26">
                  <c:v>0</c:v>
                </c:pt>
                <c:pt idx="27">
                  <c:v>2.680965147453081E-3</c:v>
                </c:pt>
                <c:pt idx="28">
                  <c:v>5.3619302949061715E-3</c:v>
                </c:pt>
                <c:pt idx="29">
                  <c:v>2.680965147453081E-3</c:v>
                </c:pt>
                <c:pt idx="30">
                  <c:v>8.042895442359253E-3</c:v>
                </c:pt>
              </c:numCache>
            </c:numRef>
          </c:val>
        </c:ser>
        <c:ser>
          <c:idx val="5"/>
          <c:order val="5"/>
          <c:tx>
            <c:strRef>
              <c:f>'unc-49 L4_0.02_50%'!$G$104</c:f>
              <c:strCache>
                <c:ptCount val="1"/>
                <c:pt idx="0">
                  <c:v>unc-49_L4_06024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G$105:$G$135</c:f>
              <c:numCache>
                <c:formatCode>General</c:formatCode>
                <c:ptCount val="31"/>
                <c:pt idx="1">
                  <c:v>6.1135371179039298E-2</c:v>
                </c:pt>
                <c:pt idx="2">
                  <c:v>4.8034934497816636E-2</c:v>
                </c:pt>
                <c:pt idx="3">
                  <c:v>3.7117903930131001E-2</c:v>
                </c:pt>
                <c:pt idx="4">
                  <c:v>3.0567685589519611E-2</c:v>
                </c:pt>
                <c:pt idx="5">
                  <c:v>2.8384279475982498E-2</c:v>
                </c:pt>
                <c:pt idx="6">
                  <c:v>1.52838427947598E-2</c:v>
                </c:pt>
                <c:pt idx="7">
                  <c:v>2.1834061135371202E-2</c:v>
                </c:pt>
                <c:pt idx="8">
                  <c:v>1.0917030567685601E-2</c:v>
                </c:pt>
                <c:pt idx="9">
                  <c:v>1.0917030567685601E-2</c:v>
                </c:pt>
                <c:pt idx="10">
                  <c:v>1.7467248908296894E-2</c:v>
                </c:pt>
                <c:pt idx="11">
                  <c:v>1.9650655021834103E-2</c:v>
                </c:pt>
                <c:pt idx="12">
                  <c:v>2.4017467248908301E-2</c:v>
                </c:pt>
                <c:pt idx="13">
                  <c:v>2.6200873362445407E-2</c:v>
                </c:pt>
                <c:pt idx="14">
                  <c:v>3.9301310043668117E-2</c:v>
                </c:pt>
                <c:pt idx="15">
                  <c:v>3.7117903930131001E-2</c:v>
                </c:pt>
                <c:pt idx="16">
                  <c:v>3.4934497816593899E-2</c:v>
                </c:pt>
                <c:pt idx="17">
                  <c:v>3.9301310043668117E-2</c:v>
                </c:pt>
                <c:pt idx="18">
                  <c:v>5.4585152838427999E-2</c:v>
                </c:pt>
                <c:pt idx="19">
                  <c:v>3.7117903930131001E-2</c:v>
                </c:pt>
                <c:pt idx="20">
                  <c:v>2.8384279475982498E-2</c:v>
                </c:pt>
                <c:pt idx="21">
                  <c:v>4.3668122270742384E-2</c:v>
                </c:pt>
                <c:pt idx="22">
                  <c:v>3.0567685589519611E-2</c:v>
                </c:pt>
                <c:pt idx="23">
                  <c:v>2.4017467248908301E-2</c:v>
                </c:pt>
                <c:pt idx="24">
                  <c:v>2.1834061135371202E-2</c:v>
                </c:pt>
                <c:pt idx="25">
                  <c:v>2.6200873362445407E-2</c:v>
                </c:pt>
                <c:pt idx="26">
                  <c:v>2.8384279475982498E-2</c:v>
                </c:pt>
                <c:pt idx="27">
                  <c:v>1.52838427947598E-2</c:v>
                </c:pt>
                <c:pt idx="28">
                  <c:v>2.1834061135371202E-2</c:v>
                </c:pt>
                <c:pt idx="29">
                  <c:v>8.7336244541484729E-3</c:v>
                </c:pt>
                <c:pt idx="30">
                  <c:v>8.7336244541484729E-3</c:v>
                </c:pt>
              </c:numCache>
            </c:numRef>
          </c:val>
        </c:ser>
        <c:ser>
          <c:idx val="6"/>
          <c:order val="6"/>
          <c:tx>
            <c:strRef>
              <c:f>'unc-49 L4_0.02_50%'!$H$104</c:f>
              <c:strCache>
                <c:ptCount val="1"/>
                <c:pt idx="0">
                  <c:v>unc-49_L4_06025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H$105:$H$135</c:f>
              <c:numCache>
                <c:formatCode>General</c:formatCode>
                <c:ptCount val="31"/>
                <c:pt idx="1">
                  <c:v>0.10334788937408998</c:v>
                </c:pt>
                <c:pt idx="2">
                  <c:v>7.2780203784570632E-2</c:v>
                </c:pt>
                <c:pt idx="3">
                  <c:v>6.5502183406113509E-2</c:v>
                </c:pt>
                <c:pt idx="4">
                  <c:v>6.8413391557496428E-2</c:v>
                </c:pt>
                <c:pt idx="5">
                  <c:v>4.0756914119359514E-2</c:v>
                </c:pt>
                <c:pt idx="6">
                  <c:v>3.0567685589519611E-2</c:v>
                </c:pt>
                <c:pt idx="7">
                  <c:v>2.7656477438136807E-2</c:v>
                </c:pt>
                <c:pt idx="8">
                  <c:v>2.3289665211062599E-2</c:v>
                </c:pt>
                <c:pt idx="9">
                  <c:v>2.1834061135371202E-2</c:v>
                </c:pt>
                <c:pt idx="10">
                  <c:v>2.474526928675401E-2</c:v>
                </c:pt>
                <c:pt idx="11">
                  <c:v>2.9112081513828197E-2</c:v>
                </c:pt>
                <c:pt idx="12">
                  <c:v>2.1834061135371202E-2</c:v>
                </c:pt>
                <c:pt idx="13">
                  <c:v>2.1834061135371202E-2</c:v>
                </c:pt>
                <c:pt idx="14">
                  <c:v>2.9112081513828197E-2</c:v>
                </c:pt>
                <c:pt idx="15">
                  <c:v>2.7656477438136807E-2</c:v>
                </c:pt>
                <c:pt idx="16">
                  <c:v>2.474526928675401E-2</c:v>
                </c:pt>
                <c:pt idx="17">
                  <c:v>1.60116448326055E-2</c:v>
                </c:pt>
                <c:pt idx="18">
                  <c:v>2.0378457059679802E-2</c:v>
                </c:pt>
                <c:pt idx="19">
                  <c:v>2.1834061135371202E-2</c:v>
                </c:pt>
                <c:pt idx="20">
                  <c:v>2.3289665211062599E-2</c:v>
                </c:pt>
                <c:pt idx="21">
                  <c:v>1.4556040756914098E-2</c:v>
                </c:pt>
                <c:pt idx="22">
                  <c:v>1.3100436681222703E-2</c:v>
                </c:pt>
                <c:pt idx="23">
                  <c:v>8.7336244541484729E-3</c:v>
                </c:pt>
                <c:pt idx="24">
                  <c:v>7.2780203784570622E-3</c:v>
                </c:pt>
                <c:pt idx="25">
                  <c:v>8.7336244541484729E-3</c:v>
                </c:pt>
                <c:pt idx="26">
                  <c:v>4.3668122270742399E-3</c:v>
                </c:pt>
                <c:pt idx="27">
                  <c:v>8.7336244541484729E-3</c:v>
                </c:pt>
                <c:pt idx="28">
                  <c:v>4.3668122270742399E-3</c:v>
                </c:pt>
                <c:pt idx="29">
                  <c:v>1.4556040756914101E-3</c:v>
                </c:pt>
                <c:pt idx="30">
                  <c:v>5.8224163027656498E-3</c:v>
                </c:pt>
              </c:numCache>
            </c:numRef>
          </c:val>
        </c:ser>
        <c:ser>
          <c:idx val="7"/>
          <c:order val="7"/>
          <c:tx>
            <c:strRef>
              <c:f>'unc-49 L4_0.02_50%'!$I$104</c:f>
              <c:strCache>
                <c:ptCount val="1"/>
                <c:pt idx="0">
                  <c:v>unc-49_L4_06026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I$105:$I$135</c:f>
              <c:numCache>
                <c:formatCode>General</c:formatCode>
                <c:ptCount val="31"/>
                <c:pt idx="1">
                  <c:v>5.8504875406283879E-2</c:v>
                </c:pt>
                <c:pt idx="2">
                  <c:v>5.417118093174432E-2</c:v>
                </c:pt>
                <c:pt idx="3">
                  <c:v>4.2253521126760597E-2</c:v>
                </c:pt>
                <c:pt idx="4">
                  <c:v>5.417118093174432E-2</c:v>
                </c:pt>
                <c:pt idx="5">
                  <c:v>4.1170097508125704E-2</c:v>
                </c:pt>
                <c:pt idx="6">
                  <c:v>4.4420368364030301E-2</c:v>
                </c:pt>
                <c:pt idx="7">
                  <c:v>4.6587215601300087E-2</c:v>
                </c:pt>
                <c:pt idx="8">
                  <c:v>2.3835319609967518E-2</c:v>
                </c:pt>
                <c:pt idx="9">
                  <c:v>3.1419284940411699E-2</c:v>
                </c:pt>
                <c:pt idx="10">
                  <c:v>2.8169014084506998E-2</c:v>
                </c:pt>
                <c:pt idx="11">
                  <c:v>2.2751895991332597E-2</c:v>
                </c:pt>
                <c:pt idx="12">
                  <c:v>4.3336944745395421E-2</c:v>
                </c:pt>
                <c:pt idx="13">
                  <c:v>4.5503791982665229E-2</c:v>
                </c:pt>
                <c:pt idx="14">
                  <c:v>6.1755146262188476E-2</c:v>
                </c:pt>
                <c:pt idx="15">
                  <c:v>3.3586132177681499E-2</c:v>
                </c:pt>
                <c:pt idx="16">
                  <c:v>5.8504875406283879E-2</c:v>
                </c:pt>
                <c:pt idx="17">
                  <c:v>4.3336944745395421E-2</c:v>
                </c:pt>
                <c:pt idx="18">
                  <c:v>3.0335861321776809E-2</c:v>
                </c:pt>
                <c:pt idx="19">
                  <c:v>2.4918743228602398E-2</c:v>
                </c:pt>
                <c:pt idx="20">
                  <c:v>3.683640303358611E-2</c:v>
                </c:pt>
                <c:pt idx="21">
                  <c:v>2.3835319609967518E-2</c:v>
                </c:pt>
                <c:pt idx="22">
                  <c:v>1.7334777898158203E-2</c:v>
                </c:pt>
                <c:pt idx="23">
                  <c:v>1.4084507042253504E-2</c:v>
                </c:pt>
                <c:pt idx="24">
                  <c:v>7.5839653304442022E-3</c:v>
                </c:pt>
                <c:pt idx="25">
                  <c:v>1.1917659804983704E-2</c:v>
                </c:pt>
                <c:pt idx="26">
                  <c:v>3.2502708559046609E-3</c:v>
                </c:pt>
                <c:pt idx="27">
                  <c:v>3.2502708559046609E-3</c:v>
                </c:pt>
                <c:pt idx="28">
                  <c:v>2.1668472372697702E-3</c:v>
                </c:pt>
                <c:pt idx="29">
                  <c:v>2.1668472372697702E-3</c:v>
                </c:pt>
                <c:pt idx="30">
                  <c:v>1.0834236186348894E-3</c:v>
                </c:pt>
              </c:numCache>
            </c:numRef>
          </c:val>
        </c:ser>
        <c:ser>
          <c:idx val="8"/>
          <c:order val="8"/>
          <c:tx>
            <c:strRef>
              <c:f>'unc-49 L4_0.02_50%'!$J$104</c:f>
              <c:strCache>
                <c:ptCount val="1"/>
                <c:pt idx="0">
                  <c:v>unc-49_L4_0603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J$105:$J$135</c:f>
              <c:numCache>
                <c:formatCode>General</c:formatCode>
                <c:ptCount val="31"/>
                <c:pt idx="1">
                  <c:v>0.13286713286713311</c:v>
                </c:pt>
                <c:pt idx="2">
                  <c:v>0.11888111888111905</c:v>
                </c:pt>
                <c:pt idx="3">
                  <c:v>4.8951048951049E-2</c:v>
                </c:pt>
                <c:pt idx="4">
                  <c:v>2.797202797202801E-2</c:v>
                </c:pt>
                <c:pt idx="5">
                  <c:v>2.0979020979021008E-2</c:v>
                </c:pt>
                <c:pt idx="6">
                  <c:v>6.9930069930069921E-3</c:v>
                </c:pt>
                <c:pt idx="7">
                  <c:v>2.0979020979021008E-2</c:v>
                </c:pt>
                <c:pt idx="8">
                  <c:v>6.9930069930069921E-3</c:v>
                </c:pt>
                <c:pt idx="9">
                  <c:v>1.3986013986014E-2</c:v>
                </c:pt>
                <c:pt idx="10">
                  <c:v>1.3986013986014E-2</c:v>
                </c:pt>
                <c:pt idx="11">
                  <c:v>0</c:v>
                </c:pt>
                <c:pt idx="12">
                  <c:v>6.9930069930069921E-3</c:v>
                </c:pt>
                <c:pt idx="13">
                  <c:v>6.9930069930069921E-3</c:v>
                </c:pt>
                <c:pt idx="14">
                  <c:v>4.8951048951049E-2</c:v>
                </c:pt>
                <c:pt idx="15">
                  <c:v>6.9930069930069921E-3</c:v>
                </c:pt>
                <c:pt idx="16">
                  <c:v>6.9930069930069921E-3</c:v>
                </c:pt>
                <c:pt idx="17">
                  <c:v>0</c:v>
                </c:pt>
                <c:pt idx="18">
                  <c:v>1.3986013986014E-2</c:v>
                </c:pt>
                <c:pt idx="19">
                  <c:v>0</c:v>
                </c:pt>
                <c:pt idx="20">
                  <c:v>0</c:v>
                </c:pt>
                <c:pt idx="21">
                  <c:v>6.9930069930069921E-3</c:v>
                </c:pt>
                <c:pt idx="22">
                  <c:v>6.9930069930069921E-3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6.9930069930069921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unc-49 L4_0.02_50%'!$K$104</c:f>
              <c:strCache>
                <c:ptCount val="1"/>
                <c:pt idx="0">
                  <c:v>unc-49_L4_0604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K$105:$K$135</c:f>
              <c:numCache>
                <c:formatCode>General</c:formatCode>
                <c:ptCount val="31"/>
                <c:pt idx="1">
                  <c:v>5.3333333333333337E-2</c:v>
                </c:pt>
                <c:pt idx="2">
                  <c:v>9.3333333333333296E-2</c:v>
                </c:pt>
                <c:pt idx="3">
                  <c:v>2.6666666666666707E-2</c:v>
                </c:pt>
                <c:pt idx="4">
                  <c:v>2.6666666666666707E-2</c:v>
                </c:pt>
                <c:pt idx="5">
                  <c:v>0</c:v>
                </c:pt>
                <c:pt idx="6">
                  <c:v>4.0000000000000015E-2</c:v>
                </c:pt>
                <c:pt idx="7">
                  <c:v>2.6666666666666707E-2</c:v>
                </c:pt>
                <c:pt idx="8">
                  <c:v>2.6666666666666707E-2</c:v>
                </c:pt>
                <c:pt idx="9">
                  <c:v>2.6666666666666707E-2</c:v>
                </c:pt>
                <c:pt idx="10">
                  <c:v>1.3333333333333301E-2</c:v>
                </c:pt>
                <c:pt idx="11">
                  <c:v>1.3333333333333301E-2</c:v>
                </c:pt>
                <c:pt idx="12">
                  <c:v>1.3333333333333301E-2</c:v>
                </c:pt>
                <c:pt idx="13">
                  <c:v>0</c:v>
                </c:pt>
                <c:pt idx="14">
                  <c:v>6.6666666666666693E-2</c:v>
                </c:pt>
                <c:pt idx="15">
                  <c:v>2.6666666666666707E-2</c:v>
                </c:pt>
                <c:pt idx="16">
                  <c:v>4.0000000000000015E-2</c:v>
                </c:pt>
                <c:pt idx="17">
                  <c:v>2.6666666666666707E-2</c:v>
                </c:pt>
                <c:pt idx="18">
                  <c:v>1.3333333333333301E-2</c:v>
                </c:pt>
                <c:pt idx="19">
                  <c:v>4.0000000000000015E-2</c:v>
                </c:pt>
                <c:pt idx="20">
                  <c:v>0</c:v>
                </c:pt>
                <c:pt idx="21">
                  <c:v>4.0000000000000015E-2</c:v>
                </c:pt>
                <c:pt idx="22">
                  <c:v>1.3333333333333301E-2</c:v>
                </c:pt>
                <c:pt idx="23">
                  <c:v>1.3333333333333301E-2</c:v>
                </c:pt>
                <c:pt idx="24">
                  <c:v>0</c:v>
                </c:pt>
                <c:pt idx="25">
                  <c:v>1.3333333333333301E-2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unc-49 L4_0.02_50%'!$L$104</c:f>
              <c:strCache>
                <c:ptCount val="1"/>
                <c:pt idx="0">
                  <c:v>unc-49_L4_0605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L$105:$L$135</c:f>
              <c:numCache>
                <c:formatCode>General</c:formatCode>
                <c:ptCount val="31"/>
                <c:pt idx="1">
                  <c:v>7.9365079365079402E-2</c:v>
                </c:pt>
                <c:pt idx="2">
                  <c:v>6.3492063492063502E-2</c:v>
                </c:pt>
                <c:pt idx="3">
                  <c:v>8.9947089947089942E-2</c:v>
                </c:pt>
                <c:pt idx="4">
                  <c:v>4.2328042328042312E-2</c:v>
                </c:pt>
                <c:pt idx="5">
                  <c:v>2.6455026455026509E-2</c:v>
                </c:pt>
                <c:pt idx="6">
                  <c:v>0</c:v>
                </c:pt>
                <c:pt idx="7">
                  <c:v>2.1164021164021198E-2</c:v>
                </c:pt>
                <c:pt idx="8">
                  <c:v>1.58730158730159E-2</c:v>
                </c:pt>
                <c:pt idx="9">
                  <c:v>2.6455026455026509E-2</c:v>
                </c:pt>
                <c:pt idx="10">
                  <c:v>2.6455026455026509E-2</c:v>
                </c:pt>
                <c:pt idx="11">
                  <c:v>2.6455026455026509E-2</c:v>
                </c:pt>
                <c:pt idx="12">
                  <c:v>2.1164021164021198E-2</c:v>
                </c:pt>
                <c:pt idx="13">
                  <c:v>2.1164021164021198E-2</c:v>
                </c:pt>
                <c:pt idx="14">
                  <c:v>4.7619047619047616E-2</c:v>
                </c:pt>
                <c:pt idx="15">
                  <c:v>2.1164021164021198E-2</c:v>
                </c:pt>
                <c:pt idx="16">
                  <c:v>1.0582010582010601E-2</c:v>
                </c:pt>
                <c:pt idx="17">
                  <c:v>1.58730158730159E-2</c:v>
                </c:pt>
                <c:pt idx="18">
                  <c:v>2.1164021164021198E-2</c:v>
                </c:pt>
                <c:pt idx="19">
                  <c:v>1.0582010582010601E-2</c:v>
                </c:pt>
                <c:pt idx="20">
                  <c:v>1.58730158730159E-2</c:v>
                </c:pt>
                <c:pt idx="21">
                  <c:v>0</c:v>
                </c:pt>
                <c:pt idx="22">
                  <c:v>2.6455026455026509E-2</c:v>
                </c:pt>
                <c:pt idx="23">
                  <c:v>5.2910052910052898E-3</c:v>
                </c:pt>
                <c:pt idx="24">
                  <c:v>0</c:v>
                </c:pt>
                <c:pt idx="25">
                  <c:v>5.2910052910052898E-3</c:v>
                </c:pt>
                <c:pt idx="26">
                  <c:v>0</c:v>
                </c:pt>
                <c:pt idx="27">
                  <c:v>1.0582010582010601E-2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unc-49 L4_0.02_50%'!$M$104</c:f>
              <c:strCache>
                <c:ptCount val="1"/>
                <c:pt idx="0">
                  <c:v>unc-49_L4_0606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M$105:$M$135</c:f>
              <c:numCache>
                <c:formatCode>General</c:formatCode>
                <c:ptCount val="31"/>
                <c:pt idx="1">
                  <c:v>7.1428571428571411E-2</c:v>
                </c:pt>
                <c:pt idx="2">
                  <c:v>3.5714285714285698E-2</c:v>
                </c:pt>
                <c:pt idx="3">
                  <c:v>3.5714285714285698E-2</c:v>
                </c:pt>
                <c:pt idx="4">
                  <c:v>0</c:v>
                </c:pt>
                <c:pt idx="5">
                  <c:v>3.5714285714285698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3.5714285714285698E-2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3.5714285714285698E-2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3.5714285714285698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unc-49 L4_0.02_50%'!$N$104</c:f>
              <c:strCache>
                <c:ptCount val="1"/>
                <c:pt idx="0">
                  <c:v>unc-49_L4_0607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N$105:$N$135</c:f>
              <c:numCache>
                <c:formatCode>General</c:formatCode>
                <c:ptCount val="31"/>
                <c:pt idx="1">
                  <c:v>6.5134099616858204E-2</c:v>
                </c:pt>
                <c:pt idx="2">
                  <c:v>5.1724137931034517E-2</c:v>
                </c:pt>
                <c:pt idx="3">
                  <c:v>4.9808429118773923E-2</c:v>
                </c:pt>
                <c:pt idx="4">
                  <c:v>5.7471264367816112E-2</c:v>
                </c:pt>
                <c:pt idx="5">
                  <c:v>4.2145593869731802E-2</c:v>
                </c:pt>
                <c:pt idx="6">
                  <c:v>3.0651340996168609E-2</c:v>
                </c:pt>
                <c:pt idx="7">
                  <c:v>4.40613026819923E-2</c:v>
                </c:pt>
                <c:pt idx="8">
                  <c:v>1.7241379310344803E-2</c:v>
                </c:pt>
                <c:pt idx="9">
                  <c:v>2.8735632183908007E-2</c:v>
                </c:pt>
                <c:pt idx="10">
                  <c:v>2.6819923371647507E-2</c:v>
                </c:pt>
                <c:pt idx="11">
                  <c:v>1.7241379310344803E-2</c:v>
                </c:pt>
                <c:pt idx="12">
                  <c:v>3.4482758620689717E-2</c:v>
                </c:pt>
                <c:pt idx="13">
                  <c:v>3.2567049808429116E-2</c:v>
                </c:pt>
                <c:pt idx="14">
                  <c:v>3.2567049808429116E-2</c:v>
                </c:pt>
                <c:pt idx="15">
                  <c:v>4.5977011494252887E-2</c:v>
                </c:pt>
                <c:pt idx="16">
                  <c:v>5.1724137931034517E-2</c:v>
                </c:pt>
                <c:pt idx="17">
                  <c:v>4.2145593869731802E-2</c:v>
                </c:pt>
                <c:pt idx="18">
                  <c:v>3.2567049808429116E-2</c:v>
                </c:pt>
                <c:pt idx="19">
                  <c:v>2.2988505747126402E-2</c:v>
                </c:pt>
                <c:pt idx="20">
                  <c:v>3.2567049808429116E-2</c:v>
                </c:pt>
                <c:pt idx="21">
                  <c:v>1.34099616858238E-2</c:v>
                </c:pt>
                <c:pt idx="22">
                  <c:v>2.2988505747126402E-2</c:v>
                </c:pt>
                <c:pt idx="23">
                  <c:v>2.1072796934865901E-2</c:v>
                </c:pt>
                <c:pt idx="24">
                  <c:v>1.1494252873563199E-2</c:v>
                </c:pt>
                <c:pt idx="25">
                  <c:v>2.1072796934865901E-2</c:v>
                </c:pt>
                <c:pt idx="26">
                  <c:v>5.7471264367816117E-3</c:v>
                </c:pt>
                <c:pt idx="27">
                  <c:v>3.8314176245210709E-3</c:v>
                </c:pt>
                <c:pt idx="28">
                  <c:v>3.8314176245210709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unc-49 L4_0.02_50%'!$O$104</c:f>
              <c:strCache>
                <c:ptCount val="1"/>
                <c:pt idx="0">
                  <c:v>unc-49_L4_0608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O$105:$O$135</c:f>
              <c:numCache>
                <c:formatCode>General</c:formatCode>
                <c:ptCount val="31"/>
                <c:pt idx="1">
                  <c:v>4.3956043956044015E-2</c:v>
                </c:pt>
                <c:pt idx="2">
                  <c:v>2.7472527472527521E-2</c:v>
                </c:pt>
                <c:pt idx="3">
                  <c:v>2.5641025641025609E-2</c:v>
                </c:pt>
                <c:pt idx="4">
                  <c:v>1.8315018315018305E-2</c:v>
                </c:pt>
                <c:pt idx="5">
                  <c:v>3.2967032967033016E-2</c:v>
                </c:pt>
                <c:pt idx="6">
                  <c:v>1.6483516483516501E-2</c:v>
                </c:pt>
                <c:pt idx="7">
                  <c:v>1.6483516483516501E-2</c:v>
                </c:pt>
                <c:pt idx="8">
                  <c:v>2.3809523809523808E-2</c:v>
                </c:pt>
                <c:pt idx="9">
                  <c:v>1.8315018315018305E-2</c:v>
                </c:pt>
                <c:pt idx="10">
                  <c:v>1.0989010989011E-2</c:v>
                </c:pt>
                <c:pt idx="11">
                  <c:v>3.6630036630036604E-2</c:v>
                </c:pt>
                <c:pt idx="12">
                  <c:v>5.4945054945054896E-2</c:v>
                </c:pt>
                <c:pt idx="13">
                  <c:v>8.2417582417582402E-2</c:v>
                </c:pt>
                <c:pt idx="14">
                  <c:v>0.10256410256410303</c:v>
                </c:pt>
                <c:pt idx="15">
                  <c:v>0.10439560439560402</c:v>
                </c:pt>
                <c:pt idx="16">
                  <c:v>7.3260073260073305E-2</c:v>
                </c:pt>
                <c:pt idx="17">
                  <c:v>4.5787545787545798E-2</c:v>
                </c:pt>
                <c:pt idx="18">
                  <c:v>4.3956043956044015E-2</c:v>
                </c:pt>
                <c:pt idx="19">
                  <c:v>5.3113553113553098E-2</c:v>
                </c:pt>
                <c:pt idx="20">
                  <c:v>3.1135531135531094E-2</c:v>
                </c:pt>
                <c:pt idx="21">
                  <c:v>2.5641025641025609E-2</c:v>
                </c:pt>
                <c:pt idx="22">
                  <c:v>1.4652014652014699E-2</c:v>
                </c:pt>
                <c:pt idx="23">
                  <c:v>1.4652014652014699E-2</c:v>
                </c:pt>
                <c:pt idx="24">
                  <c:v>7.3260073260073303E-3</c:v>
                </c:pt>
                <c:pt idx="25">
                  <c:v>9.1575091575091649E-3</c:v>
                </c:pt>
                <c:pt idx="26">
                  <c:v>3.6630036630036608E-3</c:v>
                </c:pt>
                <c:pt idx="27">
                  <c:v>1.8315018315018308E-3</c:v>
                </c:pt>
                <c:pt idx="28">
                  <c:v>5.4945054945054897E-3</c:v>
                </c:pt>
                <c:pt idx="29">
                  <c:v>3.6630036630036608E-3</c:v>
                </c:pt>
                <c:pt idx="30">
                  <c:v>3.6630036630036608E-3</c:v>
                </c:pt>
              </c:numCache>
            </c:numRef>
          </c:val>
        </c:ser>
        <c:ser>
          <c:idx val="14"/>
          <c:order val="14"/>
          <c:tx>
            <c:strRef>
              <c:f>'unc-49 L4_0.02_50%'!$P$104</c:f>
              <c:strCache>
                <c:ptCount val="1"/>
                <c:pt idx="0">
                  <c:v>unc-49_L4_0609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P$105:$P$135</c:f>
              <c:numCache>
                <c:formatCode>General</c:formatCode>
                <c:ptCount val="31"/>
                <c:pt idx="1">
                  <c:v>0.10840707964601802</c:v>
                </c:pt>
                <c:pt idx="2">
                  <c:v>7.3008849557522099E-2</c:v>
                </c:pt>
                <c:pt idx="3">
                  <c:v>5.7522123893805323E-2</c:v>
                </c:pt>
                <c:pt idx="4">
                  <c:v>6.6371681415929223E-2</c:v>
                </c:pt>
                <c:pt idx="5">
                  <c:v>5.0884955752212399E-2</c:v>
                </c:pt>
                <c:pt idx="6">
                  <c:v>3.9823008849557501E-2</c:v>
                </c:pt>
                <c:pt idx="7">
                  <c:v>2.4336283185840701E-2</c:v>
                </c:pt>
                <c:pt idx="8">
                  <c:v>3.5398230088495602E-2</c:v>
                </c:pt>
                <c:pt idx="9">
                  <c:v>2.212389380530971E-2</c:v>
                </c:pt>
                <c:pt idx="10">
                  <c:v>1.3274336283185801E-2</c:v>
                </c:pt>
                <c:pt idx="11">
                  <c:v>1.5486725663716809E-2</c:v>
                </c:pt>
                <c:pt idx="12">
                  <c:v>1.9911504424778806E-2</c:v>
                </c:pt>
                <c:pt idx="13">
                  <c:v>1.1061946902654895E-2</c:v>
                </c:pt>
                <c:pt idx="14">
                  <c:v>2.212389380530971E-2</c:v>
                </c:pt>
                <c:pt idx="15">
                  <c:v>1.9911504424778806E-2</c:v>
                </c:pt>
                <c:pt idx="16">
                  <c:v>2.8761061946902686E-2</c:v>
                </c:pt>
                <c:pt idx="17">
                  <c:v>6.6371681415929229E-3</c:v>
                </c:pt>
                <c:pt idx="18">
                  <c:v>3.09734513274336E-2</c:v>
                </c:pt>
                <c:pt idx="19">
                  <c:v>3.3185840707964612E-2</c:v>
                </c:pt>
                <c:pt idx="20">
                  <c:v>8.8495575221238972E-3</c:v>
                </c:pt>
                <c:pt idx="21">
                  <c:v>1.3274336283185801E-2</c:v>
                </c:pt>
                <c:pt idx="22">
                  <c:v>1.7699115044247801E-2</c:v>
                </c:pt>
                <c:pt idx="23">
                  <c:v>8.8495575221238972E-3</c:v>
                </c:pt>
                <c:pt idx="24">
                  <c:v>1.1061946902654895E-2</c:v>
                </c:pt>
                <c:pt idx="25">
                  <c:v>6.6371681415929229E-3</c:v>
                </c:pt>
                <c:pt idx="26">
                  <c:v>1.1061946902654895E-2</c:v>
                </c:pt>
                <c:pt idx="27">
                  <c:v>2.2123893805309713E-3</c:v>
                </c:pt>
                <c:pt idx="28">
                  <c:v>2.2123893805309713E-3</c:v>
                </c:pt>
                <c:pt idx="29">
                  <c:v>1.1061946902654895E-2</c:v>
                </c:pt>
                <c:pt idx="30">
                  <c:v>4.4247787610619503E-3</c:v>
                </c:pt>
              </c:numCache>
            </c:numRef>
          </c:val>
        </c:ser>
        <c:ser>
          <c:idx val="15"/>
          <c:order val="15"/>
          <c:tx>
            <c:strRef>
              <c:f>'unc-49 L4_0.02_50%'!$Q$104</c:f>
              <c:strCache>
                <c:ptCount val="1"/>
                <c:pt idx="0">
                  <c:v>unc-49_L4_0611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Q$105:$Q$135</c:f>
              <c:numCache>
                <c:formatCode>General</c:formatCode>
                <c:ptCount val="31"/>
                <c:pt idx="1">
                  <c:v>5.5800293685756217E-2</c:v>
                </c:pt>
                <c:pt idx="2">
                  <c:v>6.3142437591776804E-2</c:v>
                </c:pt>
                <c:pt idx="3">
                  <c:v>5.4331864904552114E-2</c:v>
                </c:pt>
                <c:pt idx="4">
                  <c:v>3.6710719530102798E-2</c:v>
                </c:pt>
                <c:pt idx="5">
                  <c:v>5.1395007342143924E-2</c:v>
                </c:pt>
                <c:pt idx="6">
                  <c:v>3.37738619676946E-2</c:v>
                </c:pt>
                <c:pt idx="7">
                  <c:v>3.5242290748898709E-2</c:v>
                </c:pt>
                <c:pt idx="8">
                  <c:v>2.0558002936857597E-2</c:v>
                </c:pt>
                <c:pt idx="9">
                  <c:v>3.8179148311306914E-2</c:v>
                </c:pt>
                <c:pt idx="10">
                  <c:v>3.5242290748898709E-2</c:v>
                </c:pt>
                <c:pt idx="11">
                  <c:v>4.8458149779735685E-2</c:v>
                </c:pt>
                <c:pt idx="12">
                  <c:v>3.37738619676946E-2</c:v>
                </c:pt>
                <c:pt idx="13">
                  <c:v>5.5800293685756217E-2</c:v>
                </c:pt>
                <c:pt idx="14">
                  <c:v>4.5521292217327501E-2</c:v>
                </c:pt>
                <c:pt idx="15">
                  <c:v>5.7268722466960395E-2</c:v>
                </c:pt>
                <c:pt idx="16">
                  <c:v>5.2863436123348047E-2</c:v>
                </c:pt>
                <c:pt idx="17">
                  <c:v>4.8458149779735685E-2</c:v>
                </c:pt>
                <c:pt idx="18">
                  <c:v>2.7900146842878108E-2</c:v>
                </c:pt>
                <c:pt idx="19">
                  <c:v>3.0837004405286306E-2</c:v>
                </c:pt>
                <c:pt idx="20">
                  <c:v>1.3215859030837008E-2</c:v>
                </c:pt>
                <c:pt idx="21">
                  <c:v>1.4684287812041098E-2</c:v>
                </c:pt>
                <c:pt idx="22">
                  <c:v>7.3421439060205622E-3</c:v>
                </c:pt>
                <c:pt idx="23">
                  <c:v>7.3421439060205622E-3</c:v>
                </c:pt>
                <c:pt idx="24">
                  <c:v>1.46842878120411E-3</c:v>
                </c:pt>
                <c:pt idx="25">
                  <c:v>2.93685756240822E-3</c:v>
                </c:pt>
                <c:pt idx="26">
                  <c:v>1.46842878120411E-3</c:v>
                </c:pt>
                <c:pt idx="27">
                  <c:v>2.93685756240822E-3</c:v>
                </c:pt>
                <c:pt idx="28">
                  <c:v>0</c:v>
                </c:pt>
                <c:pt idx="29">
                  <c:v>2.93685756240822E-3</c:v>
                </c:pt>
                <c:pt idx="30">
                  <c:v>0</c:v>
                </c:pt>
              </c:numCache>
            </c:numRef>
          </c:val>
        </c:ser>
        <c:ser>
          <c:idx val="16"/>
          <c:order val="16"/>
          <c:tx>
            <c:strRef>
              <c:f>'unc-49 L4_0.02_50%'!$R$104</c:f>
              <c:strCache>
                <c:ptCount val="1"/>
                <c:pt idx="0">
                  <c:v>unc-49_L4_0612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R$105:$R$135</c:f>
              <c:numCache>
                <c:formatCode>General</c:formatCode>
                <c:ptCount val="31"/>
                <c:pt idx="1">
                  <c:v>7.4162679425837347E-2</c:v>
                </c:pt>
                <c:pt idx="2">
                  <c:v>5.7416267942583754E-2</c:v>
                </c:pt>
                <c:pt idx="3">
                  <c:v>4.9043062200956895E-2</c:v>
                </c:pt>
                <c:pt idx="4">
                  <c:v>5.0239234449760813E-2</c:v>
                </c:pt>
                <c:pt idx="5">
                  <c:v>2.6315789473684202E-2</c:v>
                </c:pt>
                <c:pt idx="6">
                  <c:v>2.3923444976076597E-2</c:v>
                </c:pt>
                <c:pt idx="7">
                  <c:v>2.0334928229665108E-2</c:v>
                </c:pt>
                <c:pt idx="8">
                  <c:v>2.0334928229665108E-2</c:v>
                </c:pt>
                <c:pt idx="9">
                  <c:v>2.3923444976076597E-2</c:v>
                </c:pt>
                <c:pt idx="10">
                  <c:v>3.3492822966507199E-2</c:v>
                </c:pt>
                <c:pt idx="11">
                  <c:v>4.4258373205741622E-2</c:v>
                </c:pt>
                <c:pt idx="12">
                  <c:v>4.3062200956937836E-2</c:v>
                </c:pt>
                <c:pt idx="13">
                  <c:v>5.0239234449760813E-2</c:v>
                </c:pt>
                <c:pt idx="14">
                  <c:v>4.3062200956937836E-2</c:v>
                </c:pt>
                <c:pt idx="15">
                  <c:v>3.9473684210526314E-2</c:v>
                </c:pt>
                <c:pt idx="16">
                  <c:v>3.7081339712918722E-2</c:v>
                </c:pt>
                <c:pt idx="17">
                  <c:v>4.0669856459330099E-2</c:v>
                </c:pt>
                <c:pt idx="18">
                  <c:v>3.1100478468899517E-2</c:v>
                </c:pt>
                <c:pt idx="19">
                  <c:v>2.6315789473684202E-2</c:v>
                </c:pt>
                <c:pt idx="20">
                  <c:v>1.55502392344498E-2</c:v>
                </c:pt>
                <c:pt idx="21">
                  <c:v>2.3923444976076597E-2</c:v>
                </c:pt>
                <c:pt idx="22">
                  <c:v>1.7942583732057409E-2</c:v>
                </c:pt>
                <c:pt idx="23">
                  <c:v>1.3157894736842101E-2</c:v>
                </c:pt>
                <c:pt idx="24">
                  <c:v>9.5693779904306216E-3</c:v>
                </c:pt>
                <c:pt idx="25">
                  <c:v>8.3732057416267946E-3</c:v>
                </c:pt>
                <c:pt idx="26">
                  <c:v>8.3732057416267946E-3</c:v>
                </c:pt>
                <c:pt idx="27">
                  <c:v>7.1770334928229736E-3</c:v>
                </c:pt>
                <c:pt idx="28">
                  <c:v>7.1770334928229736E-3</c:v>
                </c:pt>
                <c:pt idx="29">
                  <c:v>5.9808612440191439E-3</c:v>
                </c:pt>
                <c:pt idx="30">
                  <c:v>3.5885167464114829E-3</c:v>
                </c:pt>
              </c:numCache>
            </c:numRef>
          </c:val>
        </c:ser>
        <c:ser>
          <c:idx val="17"/>
          <c:order val="17"/>
          <c:tx>
            <c:strRef>
              <c:f>'unc-49 L4_0.02_50%'!$S$104</c:f>
              <c:strCache>
                <c:ptCount val="1"/>
                <c:pt idx="0">
                  <c:v>unc-49_L4_0613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S$105:$S$135</c:f>
              <c:numCache>
                <c:formatCode>General</c:formatCode>
                <c:ptCount val="31"/>
                <c:pt idx="1">
                  <c:v>0.17021276595744705</c:v>
                </c:pt>
                <c:pt idx="2">
                  <c:v>8.5106382978723472E-2</c:v>
                </c:pt>
                <c:pt idx="3">
                  <c:v>8.5106382978723472E-2</c:v>
                </c:pt>
                <c:pt idx="4">
                  <c:v>4.2553191489361715E-2</c:v>
                </c:pt>
                <c:pt idx="5">
                  <c:v>4.2553191489361715E-2</c:v>
                </c:pt>
                <c:pt idx="6">
                  <c:v>2.1276595744680899E-2</c:v>
                </c:pt>
                <c:pt idx="7">
                  <c:v>0</c:v>
                </c:pt>
                <c:pt idx="8">
                  <c:v>2.1276595744680899E-2</c:v>
                </c:pt>
                <c:pt idx="9">
                  <c:v>0</c:v>
                </c:pt>
                <c:pt idx="10">
                  <c:v>0</c:v>
                </c:pt>
                <c:pt idx="11">
                  <c:v>2.1276595744680899E-2</c:v>
                </c:pt>
                <c:pt idx="12">
                  <c:v>0</c:v>
                </c:pt>
                <c:pt idx="13">
                  <c:v>2.1276595744680899E-2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4.2553191489361715E-2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8"/>
          <c:order val="18"/>
          <c:tx>
            <c:strRef>
              <c:f>'unc-49 L4_0.02_50%'!$T$104</c:f>
              <c:strCache>
                <c:ptCount val="1"/>
                <c:pt idx="0">
                  <c:v>unc-49_L4_0614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T$105:$T$135</c:f>
              <c:numCache>
                <c:formatCode>General</c:formatCode>
                <c:ptCount val="31"/>
                <c:pt idx="1">
                  <c:v>4.9723756906077318E-2</c:v>
                </c:pt>
                <c:pt idx="2">
                  <c:v>4.9723756906077318E-2</c:v>
                </c:pt>
                <c:pt idx="3">
                  <c:v>3.729281767955802E-2</c:v>
                </c:pt>
                <c:pt idx="4">
                  <c:v>3.4530386740331501E-2</c:v>
                </c:pt>
                <c:pt idx="5">
                  <c:v>4.1436464088397816E-2</c:v>
                </c:pt>
                <c:pt idx="6">
                  <c:v>3.0386740331491694E-2</c:v>
                </c:pt>
                <c:pt idx="7">
                  <c:v>2.0718232044198894E-2</c:v>
                </c:pt>
                <c:pt idx="8">
                  <c:v>3.3149171270718203E-2</c:v>
                </c:pt>
                <c:pt idx="9">
                  <c:v>3.4530386740331501E-2</c:v>
                </c:pt>
                <c:pt idx="10">
                  <c:v>2.7624309392265206E-2</c:v>
                </c:pt>
                <c:pt idx="11">
                  <c:v>6.2154696132596735E-2</c:v>
                </c:pt>
                <c:pt idx="12">
                  <c:v>4.2817679558011135E-2</c:v>
                </c:pt>
                <c:pt idx="13">
                  <c:v>5.9392265193370236E-2</c:v>
                </c:pt>
                <c:pt idx="14">
                  <c:v>7.18232044198895E-2</c:v>
                </c:pt>
                <c:pt idx="15">
                  <c:v>6.3535911602209894E-2</c:v>
                </c:pt>
                <c:pt idx="16">
                  <c:v>6.0773480662983416E-2</c:v>
                </c:pt>
                <c:pt idx="17">
                  <c:v>4.1436464088397816E-2</c:v>
                </c:pt>
                <c:pt idx="18">
                  <c:v>3.4530386740331501E-2</c:v>
                </c:pt>
                <c:pt idx="19">
                  <c:v>4.005524861878447E-2</c:v>
                </c:pt>
                <c:pt idx="20">
                  <c:v>2.2099447513812213E-2</c:v>
                </c:pt>
                <c:pt idx="21">
                  <c:v>1.5193370165745901E-2</c:v>
                </c:pt>
                <c:pt idx="22">
                  <c:v>2.0718232044198894E-2</c:v>
                </c:pt>
                <c:pt idx="23">
                  <c:v>1.1049723756906101E-2</c:v>
                </c:pt>
                <c:pt idx="24">
                  <c:v>2.7624309392265201E-3</c:v>
                </c:pt>
                <c:pt idx="25">
                  <c:v>1.3812154696132613E-3</c:v>
                </c:pt>
                <c:pt idx="26">
                  <c:v>1.3812154696132613E-3</c:v>
                </c:pt>
                <c:pt idx="27">
                  <c:v>4.1436464088397814E-3</c:v>
                </c:pt>
                <c:pt idx="28">
                  <c:v>0</c:v>
                </c:pt>
                <c:pt idx="29">
                  <c:v>0</c:v>
                </c:pt>
                <c:pt idx="30">
                  <c:v>4.1436464088397814E-3</c:v>
                </c:pt>
              </c:numCache>
            </c:numRef>
          </c:val>
        </c:ser>
        <c:ser>
          <c:idx val="19"/>
          <c:order val="19"/>
          <c:tx>
            <c:strRef>
              <c:f>'unc-49 L4_0.02_50%'!$U$104</c:f>
              <c:strCache>
                <c:ptCount val="1"/>
                <c:pt idx="0">
                  <c:v>unc-49_L4_0615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U$105:$U$135</c:f>
              <c:numCache>
                <c:formatCode>General</c:formatCode>
                <c:ptCount val="31"/>
                <c:pt idx="1">
                  <c:v>5.2901023890785014E-2</c:v>
                </c:pt>
                <c:pt idx="2">
                  <c:v>5.9726962457337919E-2</c:v>
                </c:pt>
                <c:pt idx="3">
                  <c:v>5.4607508532423216E-2</c:v>
                </c:pt>
                <c:pt idx="4">
                  <c:v>5.9726962457337919E-2</c:v>
                </c:pt>
                <c:pt idx="5">
                  <c:v>4.6075085324232087E-2</c:v>
                </c:pt>
                <c:pt idx="6">
                  <c:v>4.2662116040955621E-2</c:v>
                </c:pt>
                <c:pt idx="7">
                  <c:v>2.2184300341296901E-2</c:v>
                </c:pt>
                <c:pt idx="8">
                  <c:v>2.3890784982935197E-2</c:v>
                </c:pt>
                <c:pt idx="9">
                  <c:v>3.0716723549488085E-2</c:v>
                </c:pt>
                <c:pt idx="10">
                  <c:v>2.5597269624573413E-2</c:v>
                </c:pt>
                <c:pt idx="11">
                  <c:v>2.3890784982935197E-2</c:v>
                </c:pt>
                <c:pt idx="12">
                  <c:v>3.9249146757679231E-2</c:v>
                </c:pt>
                <c:pt idx="13">
                  <c:v>6.3139931740614302E-2</c:v>
                </c:pt>
                <c:pt idx="14">
                  <c:v>6.1433447098976114E-2</c:v>
                </c:pt>
                <c:pt idx="15">
                  <c:v>4.436860068259392E-2</c:v>
                </c:pt>
                <c:pt idx="16">
                  <c:v>2.0477815699658709E-2</c:v>
                </c:pt>
                <c:pt idx="17">
                  <c:v>4.6075085324232087E-2</c:v>
                </c:pt>
                <c:pt idx="18">
                  <c:v>3.5836177474402722E-2</c:v>
                </c:pt>
                <c:pt idx="19">
                  <c:v>3.7542662116041001E-2</c:v>
                </c:pt>
                <c:pt idx="20">
                  <c:v>1.87713310580205E-2</c:v>
                </c:pt>
                <c:pt idx="21">
                  <c:v>8.5324232081911335E-3</c:v>
                </c:pt>
                <c:pt idx="22">
                  <c:v>1.87713310580205E-2</c:v>
                </c:pt>
                <c:pt idx="23">
                  <c:v>6.8259385665528976E-3</c:v>
                </c:pt>
                <c:pt idx="24">
                  <c:v>1.7064846416382305E-2</c:v>
                </c:pt>
                <c:pt idx="25">
                  <c:v>5.1194539249146834E-3</c:v>
                </c:pt>
                <c:pt idx="26">
                  <c:v>3.412969283276451E-3</c:v>
                </c:pt>
                <c:pt idx="27">
                  <c:v>5.1194539249146834E-3</c:v>
                </c:pt>
                <c:pt idx="28">
                  <c:v>5.1194539249146834E-3</c:v>
                </c:pt>
                <c:pt idx="29">
                  <c:v>5.1194539249146834E-3</c:v>
                </c:pt>
                <c:pt idx="30">
                  <c:v>0</c:v>
                </c:pt>
              </c:numCache>
            </c:numRef>
          </c:val>
        </c:ser>
        <c:ser>
          <c:idx val="20"/>
          <c:order val="20"/>
          <c:tx>
            <c:strRef>
              <c:f>'unc-49 L4_0.02_50%'!$V$104</c:f>
              <c:strCache>
                <c:ptCount val="1"/>
                <c:pt idx="0">
                  <c:v>unc-49_L4_0616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V$105:$V$135</c:f>
              <c:numCache>
                <c:formatCode>General</c:formatCode>
                <c:ptCount val="31"/>
                <c:pt idx="1">
                  <c:v>6.25E-2</c:v>
                </c:pt>
                <c:pt idx="2">
                  <c:v>0</c:v>
                </c:pt>
                <c:pt idx="3">
                  <c:v>6.25E-2</c:v>
                </c:pt>
                <c:pt idx="4">
                  <c:v>8.3333333333333329E-2</c:v>
                </c:pt>
                <c:pt idx="5">
                  <c:v>0</c:v>
                </c:pt>
                <c:pt idx="6">
                  <c:v>4.1666666666666699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2.0833333333333311E-2</c:v>
                </c:pt>
                <c:pt idx="13">
                  <c:v>2.0833333333333311E-2</c:v>
                </c:pt>
                <c:pt idx="14">
                  <c:v>2.0833333333333311E-2</c:v>
                </c:pt>
                <c:pt idx="15">
                  <c:v>2.0833333333333311E-2</c:v>
                </c:pt>
                <c:pt idx="16">
                  <c:v>0</c:v>
                </c:pt>
                <c:pt idx="17">
                  <c:v>4.1666666666666699E-2</c:v>
                </c:pt>
                <c:pt idx="18">
                  <c:v>2.0833333333333311E-2</c:v>
                </c:pt>
                <c:pt idx="19">
                  <c:v>2.0833333333333311E-2</c:v>
                </c:pt>
                <c:pt idx="20">
                  <c:v>2.0833333333333311E-2</c:v>
                </c:pt>
                <c:pt idx="21">
                  <c:v>0</c:v>
                </c:pt>
                <c:pt idx="22">
                  <c:v>0</c:v>
                </c:pt>
                <c:pt idx="23">
                  <c:v>4.1666666666666699E-2</c:v>
                </c:pt>
                <c:pt idx="24">
                  <c:v>2.0833333333333311E-2</c:v>
                </c:pt>
                <c:pt idx="25">
                  <c:v>0</c:v>
                </c:pt>
                <c:pt idx="26">
                  <c:v>2.0833333333333311E-2</c:v>
                </c:pt>
                <c:pt idx="27">
                  <c:v>2.0833333333333311E-2</c:v>
                </c:pt>
                <c:pt idx="28">
                  <c:v>2.0833333333333311E-2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1"/>
          <c:order val="21"/>
          <c:tx>
            <c:strRef>
              <c:f>'unc-49 L4_0.02_50%'!$W$104</c:f>
              <c:strCache>
                <c:ptCount val="1"/>
                <c:pt idx="0">
                  <c:v>unc-49_L4_0617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W$105:$W$135</c:f>
              <c:numCache>
                <c:formatCode>General</c:formatCode>
                <c:ptCount val="31"/>
                <c:pt idx="1">
                  <c:v>6.8728522336769807E-2</c:v>
                </c:pt>
                <c:pt idx="2">
                  <c:v>8.2474226804123682E-2</c:v>
                </c:pt>
                <c:pt idx="3">
                  <c:v>7.2164948453608199E-2</c:v>
                </c:pt>
                <c:pt idx="4">
                  <c:v>6.18556701030928E-2</c:v>
                </c:pt>
                <c:pt idx="5">
                  <c:v>4.4673539518900303E-2</c:v>
                </c:pt>
                <c:pt idx="6">
                  <c:v>3.4364261168384903E-2</c:v>
                </c:pt>
                <c:pt idx="7">
                  <c:v>3.09278350515464E-2</c:v>
                </c:pt>
                <c:pt idx="8">
                  <c:v>3.7800687285223421E-2</c:v>
                </c:pt>
                <c:pt idx="9">
                  <c:v>2.0618556701030889E-2</c:v>
                </c:pt>
                <c:pt idx="10">
                  <c:v>1.71821305841924E-2</c:v>
                </c:pt>
                <c:pt idx="11">
                  <c:v>2.7491408934707907E-2</c:v>
                </c:pt>
                <c:pt idx="12">
                  <c:v>1.3745704467354004E-2</c:v>
                </c:pt>
                <c:pt idx="13">
                  <c:v>2.0618556701030889E-2</c:v>
                </c:pt>
                <c:pt idx="14">
                  <c:v>3.09278350515464E-2</c:v>
                </c:pt>
                <c:pt idx="15">
                  <c:v>2.0618556701030889E-2</c:v>
                </c:pt>
                <c:pt idx="16">
                  <c:v>2.0618556701030889E-2</c:v>
                </c:pt>
                <c:pt idx="17">
                  <c:v>1.0309278350515504E-2</c:v>
                </c:pt>
                <c:pt idx="18">
                  <c:v>1.3745704467354004E-2</c:v>
                </c:pt>
                <c:pt idx="19">
                  <c:v>2.405498281786941E-2</c:v>
                </c:pt>
                <c:pt idx="20">
                  <c:v>6.8728522336769802E-3</c:v>
                </c:pt>
                <c:pt idx="21">
                  <c:v>1.71821305841924E-2</c:v>
                </c:pt>
                <c:pt idx="22">
                  <c:v>6.8728522336769802E-3</c:v>
                </c:pt>
                <c:pt idx="23">
                  <c:v>3.4364261168384901E-3</c:v>
                </c:pt>
                <c:pt idx="24">
                  <c:v>2.0618556701030889E-2</c:v>
                </c:pt>
                <c:pt idx="25">
                  <c:v>1.71821305841924E-2</c:v>
                </c:pt>
                <c:pt idx="26">
                  <c:v>6.8728522336769802E-3</c:v>
                </c:pt>
                <c:pt idx="27">
                  <c:v>3.4364261168384901E-3</c:v>
                </c:pt>
                <c:pt idx="28">
                  <c:v>0</c:v>
                </c:pt>
                <c:pt idx="29">
                  <c:v>6.8728522336769802E-3</c:v>
                </c:pt>
                <c:pt idx="30">
                  <c:v>0</c:v>
                </c:pt>
              </c:numCache>
            </c:numRef>
          </c:val>
        </c:ser>
        <c:ser>
          <c:idx val="22"/>
          <c:order val="22"/>
          <c:tx>
            <c:strRef>
              <c:f>'unc-49 L4_0.02_50%'!$X$104</c:f>
              <c:strCache>
                <c:ptCount val="1"/>
                <c:pt idx="0">
                  <c:v>unc-49_L4_0618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X$105:$X$135</c:f>
              <c:numCache>
                <c:formatCode>General</c:formatCode>
                <c:ptCount val="31"/>
                <c:pt idx="1">
                  <c:v>7.3047858942065488E-2</c:v>
                </c:pt>
                <c:pt idx="2">
                  <c:v>5.5415617128463518E-2</c:v>
                </c:pt>
                <c:pt idx="3">
                  <c:v>7.8085642317380397E-2</c:v>
                </c:pt>
                <c:pt idx="4">
                  <c:v>6.0453400503778315E-2</c:v>
                </c:pt>
                <c:pt idx="5">
                  <c:v>3.7783375314861513E-2</c:v>
                </c:pt>
                <c:pt idx="6">
                  <c:v>4.2821158690176282E-2</c:v>
                </c:pt>
                <c:pt idx="7">
                  <c:v>2.7707808564231717E-2</c:v>
                </c:pt>
                <c:pt idx="8">
                  <c:v>2.5188916876574319E-2</c:v>
                </c:pt>
                <c:pt idx="9">
                  <c:v>3.0226700251889199E-2</c:v>
                </c:pt>
                <c:pt idx="10">
                  <c:v>2.5188916876574319E-2</c:v>
                </c:pt>
                <c:pt idx="11">
                  <c:v>1.0075566750629698E-2</c:v>
                </c:pt>
                <c:pt idx="12">
                  <c:v>3.0226700251889199E-2</c:v>
                </c:pt>
                <c:pt idx="13">
                  <c:v>3.2745591939546598E-2</c:v>
                </c:pt>
                <c:pt idx="14">
                  <c:v>1.0075566750629698E-2</c:v>
                </c:pt>
                <c:pt idx="15">
                  <c:v>2.0151133501259407E-2</c:v>
                </c:pt>
                <c:pt idx="16">
                  <c:v>2.0151133501259407E-2</c:v>
                </c:pt>
                <c:pt idx="17">
                  <c:v>2.7707808564231717E-2</c:v>
                </c:pt>
                <c:pt idx="18">
                  <c:v>3.7783375314861513E-2</c:v>
                </c:pt>
                <c:pt idx="19">
                  <c:v>2.0151133501259407E-2</c:v>
                </c:pt>
                <c:pt idx="20">
                  <c:v>2.2670025188916913E-2</c:v>
                </c:pt>
                <c:pt idx="21">
                  <c:v>1.5113350125944598E-2</c:v>
                </c:pt>
                <c:pt idx="22">
                  <c:v>2.2670025188916913E-2</c:v>
                </c:pt>
                <c:pt idx="23">
                  <c:v>1.0075566750629698E-2</c:v>
                </c:pt>
                <c:pt idx="24">
                  <c:v>1.5113350125944598E-2</c:v>
                </c:pt>
                <c:pt idx="25">
                  <c:v>1.5113350125944598E-2</c:v>
                </c:pt>
                <c:pt idx="26">
                  <c:v>1.2594458438287204E-2</c:v>
                </c:pt>
                <c:pt idx="27">
                  <c:v>5.0377833753148631E-3</c:v>
                </c:pt>
                <c:pt idx="28">
                  <c:v>7.556675062972292E-3</c:v>
                </c:pt>
                <c:pt idx="29">
                  <c:v>2.518891687657432E-3</c:v>
                </c:pt>
                <c:pt idx="30">
                  <c:v>0</c:v>
                </c:pt>
              </c:numCache>
            </c:numRef>
          </c:val>
        </c:ser>
        <c:ser>
          <c:idx val="23"/>
          <c:order val="23"/>
          <c:tx>
            <c:strRef>
              <c:f>'unc-49 L4_0.02_50%'!$Y$104</c:f>
              <c:strCache>
                <c:ptCount val="1"/>
                <c:pt idx="0">
                  <c:v>unc-49_L4_0619</c:v>
                </c:pt>
              </c:strCache>
            </c:strRef>
          </c:tx>
          <c:marker>
            <c:symbol val="none"/>
          </c:marker>
          <c:cat>
            <c:numRef>
              <c:f>'unc-49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L4_0.02_50%'!$Y$105:$Y$135</c:f>
              <c:numCache>
                <c:formatCode>General</c:formatCode>
                <c:ptCount val="31"/>
              </c:numCache>
            </c:numRef>
          </c:val>
        </c:ser>
        <c:marker val="1"/>
        <c:axId val="166447360"/>
        <c:axId val="166469632"/>
      </c:lineChart>
      <c:catAx>
        <c:axId val="166447360"/>
        <c:scaling>
          <c:orientation val="minMax"/>
        </c:scaling>
        <c:axPos val="b"/>
        <c:numFmt formatCode="0.0_ " sourceLinked="1"/>
        <c:tickLblPos val="nextTo"/>
        <c:crossAx val="166469632"/>
        <c:crosses val="autoZero"/>
        <c:auto val="1"/>
        <c:lblAlgn val="ctr"/>
        <c:lblOffset val="100"/>
        <c:tickLblSkip val="5"/>
        <c:tickMarkSkip val="5"/>
      </c:catAx>
      <c:valAx>
        <c:axId val="166469632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6447360"/>
        <c:crosses val="autoZero"/>
        <c:crossBetween val="between"/>
      </c:valAx>
    </c:plotArea>
    <c:plotVisOnly val="1"/>
  </c:chart>
  <c:externalData r:id="rId1"/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49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2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49 A2_0.02_50%'!$B$104</c:f>
              <c:strCache>
                <c:ptCount val="1"/>
                <c:pt idx="0">
                  <c:v>unc-49_REX_A2_01</c:v>
                </c:pt>
              </c:strCache>
            </c:strRef>
          </c:tx>
          <c:marker>
            <c:symbol val="none"/>
          </c:marker>
          <c:cat>
            <c:numRef>
              <c:f>'unc-49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2_0.02_50%'!$B$105:$B$135</c:f>
              <c:numCache>
                <c:formatCode>General</c:formatCode>
                <c:ptCount val="31"/>
                <c:pt idx="1">
                  <c:v>6.4542483660130726E-2</c:v>
                </c:pt>
                <c:pt idx="2">
                  <c:v>5.2287581699346421E-2</c:v>
                </c:pt>
                <c:pt idx="3">
                  <c:v>5.6372549019607802E-2</c:v>
                </c:pt>
                <c:pt idx="4">
                  <c:v>5.7189542483660073E-2</c:v>
                </c:pt>
                <c:pt idx="5">
                  <c:v>5.0653594771241817E-2</c:v>
                </c:pt>
                <c:pt idx="6">
                  <c:v>3.9215686274509803E-2</c:v>
                </c:pt>
                <c:pt idx="7">
                  <c:v>3.9215686274509803E-2</c:v>
                </c:pt>
                <c:pt idx="8">
                  <c:v>2.8594771241830082E-2</c:v>
                </c:pt>
                <c:pt idx="9">
                  <c:v>3.0228758169934599E-2</c:v>
                </c:pt>
                <c:pt idx="10">
                  <c:v>3.9215686274509803E-2</c:v>
                </c:pt>
                <c:pt idx="11">
                  <c:v>4.738562091503274E-2</c:v>
                </c:pt>
                <c:pt idx="12">
                  <c:v>4.5751633986928136E-2</c:v>
                </c:pt>
                <c:pt idx="13">
                  <c:v>5.0653594771241817E-2</c:v>
                </c:pt>
                <c:pt idx="14">
                  <c:v>4.9836601307189525E-2</c:v>
                </c:pt>
                <c:pt idx="15">
                  <c:v>4.2483660130719018E-2</c:v>
                </c:pt>
                <c:pt idx="16">
                  <c:v>3.3496732026143811E-2</c:v>
                </c:pt>
                <c:pt idx="17">
                  <c:v>4.1666666666666699E-2</c:v>
                </c:pt>
                <c:pt idx="18">
                  <c:v>2.7777777777777821E-2</c:v>
                </c:pt>
                <c:pt idx="19">
                  <c:v>2.5326797385620908E-2</c:v>
                </c:pt>
                <c:pt idx="20">
                  <c:v>1.4705882352941199E-2</c:v>
                </c:pt>
                <c:pt idx="21">
                  <c:v>1.30718954248366E-2</c:v>
                </c:pt>
                <c:pt idx="22">
                  <c:v>1.2254901960784298E-2</c:v>
                </c:pt>
                <c:pt idx="23">
                  <c:v>1.3888888888888907E-2</c:v>
                </c:pt>
                <c:pt idx="24">
                  <c:v>5.7189542483660075E-3</c:v>
                </c:pt>
                <c:pt idx="25">
                  <c:v>5.7189542483660075E-3</c:v>
                </c:pt>
                <c:pt idx="26">
                  <c:v>3.2679738562091526E-3</c:v>
                </c:pt>
                <c:pt idx="27">
                  <c:v>2.4509803921568601E-3</c:v>
                </c:pt>
                <c:pt idx="28">
                  <c:v>2.4509803921568601E-3</c:v>
                </c:pt>
                <c:pt idx="29">
                  <c:v>2.4509803921568601E-3</c:v>
                </c:pt>
                <c:pt idx="30">
                  <c:v>0</c:v>
                </c:pt>
              </c:numCache>
            </c:numRef>
          </c:val>
        </c:ser>
        <c:ser>
          <c:idx val="1"/>
          <c:order val="1"/>
          <c:tx>
            <c:strRef>
              <c:f>'unc-49 A2_0.02_50%'!$C$104</c:f>
              <c:strCache>
                <c:ptCount val="1"/>
                <c:pt idx="0">
                  <c:v>unc-49_REX_A2_02</c:v>
                </c:pt>
              </c:strCache>
            </c:strRef>
          </c:tx>
          <c:marker>
            <c:symbol val="none"/>
          </c:marker>
          <c:cat>
            <c:numRef>
              <c:f>'unc-49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2_0.02_50%'!$C$105:$C$135</c:f>
              <c:numCache>
                <c:formatCode>General</c:formatCode>
                <c:ptCount val="31"/>
                <c:pt idx="1">
                  <c:v>0.11568123393316203</c:v>
                </c:pt>
                <c:pt idx="2">
                  <c:v>0.10796915167095103</c:v>
                </c:pt>
                <c:pt idx="3">
                  <c:v>7.4550128534704399E-2</c:v>
                </c:pt>
                <c:pt idx="4">
                  <c:v>5.2056555269922887E-2</c:v>
                </c:pt>
                <c:pt idx="5">
                  <c:v>3.0205655526992305E-2</c:v>
                </c:pt>
                <c:pt idx="6">
                  <c:v>2.9562982005141392E-2</c:v>
                </c:pt>
                <c:pt idx="7">
                  <c:v>2.2493573264781509E-2</c:v>
                </c:pt>
                <c:pt idx="8">
                  <c:v>8.9974293059126038E-3</c:v>
                </c:pt>
                <c:pt idx="9">
                  <c:v>1.9280205655527006E-2</c:v>
                </c:pt>
                <c:pt idx="10">
                  <c:v>2.1208226221079717E-2</c:v>
                </c:pt>
                <c:pt idx="11">
                  <c:v>2.8277634961439601E-2</c:v>
                </c:pt>
                <c:pt idx="12">
                  <c:v>2.1208226221079717E-2</c:v>
                </c:pt>
                <c:pt idx="13">
                  <c:v>2.63496143958869E-2</c:v>
                </c:pt>
                <c:pt idx="14">
                  <c:v>2.1850899742930599E-2</c:v>
                </c:pt>
                <c:pt idx="15">
                  <c:v>3.0848329048843208E-2</c:v>
                </c:pt>
                <c:pt idx="16">
                  <c:v>2.37789203084833E-2</c:v>
                </c:pt>
                <c:pt idx="17">
                  <c:v>2.2493573264781509E-2</c:v>
                </c:pt>
                <c:pt idx="18">
                  <c:v>1.9280205655527006E-2</c:v>
                </c:pt>
                <c:pt idx="19">
                  <c:v>1.6709511568123406E-2</c:v>
                </c:pt>
                <c:pt idx="20">
                  <c:v>1.0282776349614407E-2</c:v>
                </c:pt>
                <c:pt idx="21">
                  <c:v>7.7120822622108003E-3</c:v>
                </c:pt>
                <c:pt idx="22">
                  <c:v>7.7120822622108003E-3</c:v>
                </c:pt>
                <c:pt idx="23">
                  <c:v>3.213367609254501E-3</c:v>
                </c:pt>
                <c:pt idx="24">
                  <c:v>1.9280205655527014E-3</c:v>
                </c:pt>
                <c:pt idx="25">
                  <c:v>2.570694087403601E-3</c:v>
                </c:pt>
                <c:pt idx="26">
                  <c:v>6.4267352185090002E-4</c:v>
                </c:pt>
                <c:pt idx="27">
                  <c:v>2.570694087403601E-3</c:v>
                </c:pt>
                <c:pt idx="28">
                  <c:v>0</c:v>
                </c:pt>
                <c:pt idx="29">
                  <c:v>1.2853470437018009E-3</c:v>
                </c:pt>
                <c:pt idx="30">
                  <c:v>6.4267352185090002E-4</c:v>
                </c:pt>
              </c:numCache>
            </c:numRef>
          </c:val>
        </c:ser>
        <c:ser>
          <c:idx val="2"/>
          <c:order val="2"/>
          <c:tx>
            <c:strRef>
              <c:f>'unc-49 A2_0.02_50%'!$D$104</c:f>
              <c:strCache>
                <c:ptCount val="1"/>
                <c:pt idx="0">
                  <c:v>unc-49_REX_A2_03</c:v>
                </c:pt>
              </c:strCache>
            </c:strRef>
          </c:tx>
          <c:marker>
            <c:symbol val="none"/>
          </c:marker>
          <c:cat>
            <c:numRef>
              <c:f>'unc-49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2_0.02_50%'!$D$105:$D$135</c:f>
              <c:numCache>
                <c:formatCode>General</c:formatCode>
                <c:ptCount val="31"/>
                <c:pt idx="1">
                  <c:v>9.8337292161520234E-2</c:v>
                </c:pt>
                <c:pt idx="2">
                  <c:v>8.4085510688836143E-2</c:v>
                </c:pt>
                <c:pt idx="3">
                  <c:v>8.2660332541567738E-2</c:v>
                </c:pt>
                <c:pt idx="4">
                  <c:v>7.1733966745843231E-2</c:v>
                </c:pt>
                <c:pt idx="5">
                  <c:v>6.2707838479809999E-2</c:v>
                </c:pt>
                <c:pt idx="6">
                  <c:v>4.3230403800475103E-2</c:v>
                </c:pt>
                <c:pt idx="7">
                  <c:v>3.94299287410926E-2</c:v>
                </c:pt>
                <c:pt idx="8">
                  <c:v>4.60807600950119E-2</c:v>
                </c:pt>
                <c:pt idx="9">
                  <c:v>4.2755344418052295E-2</c:v>
                </c:pt>
                <c:pt idx="10">
                  <c:v>4.988123515439432E-2</c:v>
                </c:pt>
                <c:pt idx="11">
                  <c:v>5.1781472684085485E-2</c:v>
                </c:pt>
                <c:pt idx="12">
                  <c:v>4.1805225653206712E-2</c:v>
                </c:pt>
                <c:pt idx="13">
                  <c:v>3.75296912114014E-2</c:v>
                </c:pt>
                <c:pt idx="14">
                  <c:v>3.0878859857482198E-2</c:v>
                </c:pt>
                <c:pt idx="15">
                  <c:v>2.2802850356294507E-2</c:v>
                </c:pt>
                <c:pt idx="16">
                  <c:v>1.9952494061757708E-2</c:v>
                </c:pt>
                <c:pt idx="17">
                  <c:v>1.8052256532066498E-2</c:v>
                </c:pt>
                <c:pt idx="18">
                  <c:v>1.18764845605701E-2</c:v>
                </c:pt>
                <c:pt idx="19">
                  <c:v>6.6508313539192397E-3</c:v>
                </c:pt>
                <c:pt idx="20">
                  <c:v>1.18764845605701E-2</c:v>
                </c:pt>
                <c:pt idx="21">
                  <c:v>8.0760095011876577E-3</c:v>
                </c:pt>
                <c:pt idx="22">
                  <c:v>5.2256532066508321E-3</c:v>
                </c:pt>
                <c:pt idx="23">
                  <c:v>4.7505938242280322E-3</c:v>
                </c:pt>
                <c:pt idx="24">
                  <c:v>1.900237529691212E-3</c:v>
                </c:pt>
                <c:pt idx="25">
                  <c:v>1.900237529691212E-3</c:v>
                </c:pt>
                <c:pt idx="26">
                  <c:v>1.42517814726841E-3</c:v>
                </c:pt>
                <c:pt idx="27">
                  <c:v>1.42517814726841E-3</c:v>
                </c:pt>
                <c:pt idx="28">
                  <c:v>9.5011876484560646E-4</c:v>
                </c:pt>
                <c:pt idx="29">
                  <c:v>4.7505938242280323E-4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unc-49 A2_0.02_50%'!$E$104</c:f>
              <c:strCache>
                <c:ptCount val="1"/>
                <c:pt idx="0">
                  <c:v>unc-49_REX_A2_04</c:v>
                </c:pt>
              </c:strCache>
            </c:strRef>
          </c:tx>
          <c:marker>
            <c:symbol val="none"/>
          </c:marker>
          <c:cat>
            <c:numRef>
              <c:f>'unc-49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2_0.02_50%'!$E$105:$E$135</c:f>
              <c:numCache>
                <c:formatCode>General</c:formatCode>
                <c:ptCount val="31"/>
                <c:pt idx="1">
                  <c:v>7.3929961089494206E-2</c:v>
                </c:pt>
                <c:pt idx="2">
                  <c:v>5.2529182879377384E-2</c:v>
                </c:pt>
                <c:pt idx="3">
                  <c:v>8.171206225680934E-2</c:v>
                </c:pt>
                <c:pt idx="4">
                  <c:v>7.9766536964980539E-2</c:v>
                </c:pt>
                <c:pt idx="5">
                  <c:v>5.6420233463034986E-2</c:v>
                </c:pt>
                <c:pt idx="6">
                  <c:v>5.2529182879377384E-2</c:v>
                </c:pt>
                <c:pt idx="7">
                  <c:v>5.83657587548638E-2</c:v>
                </c:pt>
                <c:pt idx="8">
                  <c:v>4.2801556420233512E-2</c:v>
                </c:pt>
                <c:pt idx="9">
                  <c:v>4.4747081712062313E-2</c:v>
                </c:pt>
                <c:pt idx="10">
                  <c:v>7.1984435797665405E-2</c:v>
                </c:pt>
                <c:pt idx="11">
                  <c:v>6.0311284046692643E-2</c:v>
                </c:pt>
                <c:pt idx="12">
                  <c:v>5.6420233463034986E-2</c:v>
                </c:pt>
                <c:pt idx="13">
                  <c:v>6.2256809338521416E-2</c:v>
                </c:pt>
                <c:pt idx="14">
                  <c:v>2.91828793774319E-2</c:v>
                </c:pt>
                <c:pt idx="15">
                  <c:v>3.5019455252918302E-2</c:v>
                </c:pt>
                <c:pt idx="16">
                  <c:v>2.91828793774319E-2</c:v>
                </c:pt>
                <c:pt idx="17">
                  <c:v>2.3346303501945501E-2</c:v>
                </c:pt>
                <c:pt idx="18">
                  <c:v>1.36186770428016E-2</c:v>
                </c:pt>
                <c:pt idx="19">
                  <c:v>9.7276264591439707E-3</c:v>
                </c:pt>
                <c:pt idx="20">
                  <c:v>3.8910505836575902E-3</c:v>
                </c:pt>
                <c:pt idx="21">
                  <c:v>3.8910505836575902E-3</c:v>
                </c:pt>
                <c:pt idx="22">
                  <c:v>7.7821011673151804E-3</c:v>
                </c:pt>
                <c:pt idx="23">
                  <c:v>3.8910505836575902E-3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unc-49 A2_0.02_50%'!$F$104</c:f>
              <c:strCache>
                <c:ptCount val="1"/>
                <c:pt idx="0">
                  <c:v>unc-49_REX_A2_05</c:v>
                </c:pt>
              </c:strCache>
            </c:strRef>
          </c:tx>
          <c:marker>
            <c:symbol val="none"/>
          </c:marker>
          <c:cat>
            <c:numRef>
              <c:f>'unc-49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2_0.02_50%'!$F$105:$F$135</c:f>
              <c:numCache>
                <c:formatCode>General</c:formatCode>
                <c:ptCount val="31"/>
                <c:pt idx="1">
                  <c:v>5.3603603603603597E-2</c:v>
                </c:pt>
                <c:pt idx="2">
                  <c:v>5.9009009009009003E-2</c:v>
                </c:pt>
                <c:pt idx="3">
                  <c:v>5.7207207207207199E-2</c:v>
                </c:pt>
                <c:pt idx="4">
                  <c:v>5.9009009009009003E-2</c:v>
                </c:pt>
                <c:pt idx="5">
                  <c:v>4.8198198198198199E-2</c:v>
                </c:pt>
                <c:pt idx="6">
                  <c:v>3.9189189189189205E-2</c:v>
                </c:pt>
                <c:pt idx="7">
                  <c:v>4.2342342342342312E-2</c:v>
                </c:pt>
                <c:pt idx="8">
                  <c:v>3.69369369369369E-2</c:v>
                </c:pt>
                <c:pt idx="9">
                  <c:v>4.1441441441441414E-2</c:v>
                </c:pt>
                <c:pt idx="10">
                  <c:v>5.9459459459459497E-2</c:v>
                </c:pt>
                <c:pt idx="11">
                  <c:v>5.7207207207207199E-2</c:v>
                </c:pt>
                <c:pt idx="12">
                  <c:v>5.8558558558558578E-2</c:v>
                </c:pt>
                <c:pt idx="13">
                  <c:v>5.6306306306306321E-2</c:v>
                </c:pt>
                <c:pt idx="14">
                  <c:v>5.4954954954955011E-2</c:v>
                </c:pt>
                <c:pt idx="15">
                  <c:v>3.69369369369369E-2</c:v>
                </c:pt>
                <c:pt idx="16">
                  <c:v>4.2792792792792821E-2</c:v>
                </c:pt>
                <c:pt idx="17">
                  <c:v>3.2882882882882915E-2</c:v>
                </c:pt>
                <c:pt idx="18">
                  <c:v>2.6126126126126099E-2</c:v>
                </c:pt>
                <c:pt idx="19">
                  <c:v>1.5315315315315305E-2</c:v>
                </c:pt>
                <c:pt idx="20">
                  <c:v>1.48648648648649E-2</c:v>
                </c:pt>
                <c:pt idx="21">
                  <c:v>1.3063063063063101E-2</c:v>
                </c:pt>
                <c:pt idx="22">
                  <c:v>1.0360360360360404E-2</c:v>
                </c:pt>
                <c:pt idx="23">
                  <c:v>4.5045045045045001E-3</c:v>
                </c:pt>
                <c:pt idx="24">
                  <c:v>1.8018018018018005E-3</c:v>
                </c:pt>
                <c:pt idx="25">
                  <c:v>9.0090090090090189E-4</c:v>
                </c:pt>
                <c:pt idx="26">
                  <c:v>1.8018018018018005E-3</c:v>
                </c:pt>
                <c:pt idx="27">
                  <c:v>0</c:v>
                </c:pt>
                <c:pt idx="28">
                  <c:v>9.0090090090090189E-4</c:v>
                </c:pt>
                <c:pt idx="29">
                  <c:v>9.0090090090090189E-4</c:v>
                </c:pt>
                <c:pt idx="30">
                  <c:v>4.5045045045045002E-4</c:v>
                </c:pt>
              </c:numCache>
            </c:numRef>
          </c:val>
        </c:ser>
        <c:ser>
          <c:idx val="5"/>
          <c:order val="5"/>
          <c:tx>
            <c:strRef>
              <c:f>'unc-49 A2_0.02_50%'!$G$104</c:f>
              <c:strCache>
                <c:ptCount val="1"/>
                <c:pt idx="0">
                  <c:v>unc-49_REX_A2_06</c:v>
                </c:pt>
              </c:strCache>
            </c:strRef>
          </c:tx>
          <c:marker>
            <c:symbol val="none"/>
          </c:marker>
          <c:cat>
            <c:numRef>
              <c:f>'unc-49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2_0.02_50%'!$G$105:$G$135</c:f>
              <c:numCache>
                <c:formatCode>General</c:formatCode>
                <c:ptCount val="31"/>
                <c:pt idx="1">
                  <c:v>8.9036055923473176E-2</c:v>
                </c:pt>
                <c:pt idx="2">
                  <c:v>8.4621044885945504E-2</c:v>
                </c:pt>
                <c:pt idx="3">
                  <c:v>8.2413539367181765E-2</c:v>
                </c:pt>
                <c:pt idx="4">
                  <c:v>7.358351729212663E-2</c:v>
                </c:pt>
                <c:pt idx="5">
                  <c:v>5.2244297277409896E-2</c:v>
                </c:pt>
                <c:pt idx="6">
                  <c:v>4.1206769683590883E-2</c:v>
                </c:pt>
                <c:pt idx="7">
                  <c:v>4.0470934510669597E-2</c:v>
                </c:pt>
                <c:pt idx="8">
                  <c:v>2.6490066225165608E-2</c:v>
                </c:pt>
                <c:pt idx="9">
                  <c:v>4.0470934510669597E-2</c:v>
                </c:pt>
                <c:pt idx="10">
                  <c:v>3.752759381898451E-2</c:v>
                </c:pt>
                <c:pt idx="11">
                  <c:v>5.0772626931567338E-2</c:v>
                </c:pt>
                <c:pt idx="12">
                  <c:v>2.7961736571008099E-2</c:v>
                </c:pt>
                <c:pt idx="13">
                  <c:v>2.6490066225165608E-2</c:v>
                </c:pt>
                <c:pt idx="14">
                  <c:v>3.0905077262693217E-2</c:v>
                </c:pt>
                <c:pt idx="15">
                  <c:v>2.2075055187638009E-2</c:v>
                </c:pt>
                <c:pt idx="16">
                  <c:v>1.69242089771891E-2</c:v>
                </c:pt>
                <c:pt idx="17">
                  <c:v>1.5452538631346604E-2</c:v>
                </c:pt>
                <c:pt idx="18">
                  <c:v>9.5658572479764541E-3</c:v>
                </c:pt>
                <c:pt idx="19">
                  <c:v>1.3980868285504008E-2</c:v>
                </c:pt>
                <c:pt idx="20">
                  <c:v>1.0301692420897698E-2</c:v>
                </c:pt>
                <c:pt idx="21">
                  <c:v>5.8866813833701346E-3</c:v>
                </c:pt>
                <c:pt idx="22">
                  <c:v>2.9433406916850608E-3</c:v>
                </c:pt>
                <c:pt idx="23">
                  <c:v>5.8866813833701346E-3</c:v>
                </c:pt>
                <c:pt idx="24">
                  <c:v>2.2075055187638008E-3</c:v>
                </c:pt>
                <c:pt idx="25">
                  <c:v>7.3583517292126639E-4</c:v>
                </c:pt>
                <c:pt idx="26">
                  <c:v>1.47167034584253E-3</c:v>
                </c:pt>
                <c:pt idx="27">
                  <c:v>7.3583517292126639E-4</c:v>
                </c:pt>
                <c:pt idx="28">
                  <c:v>7.3583517292126639E-4</c:v>
                </c:pt>
                <c:pt idx="29">
                  <c:v>7.3583517292126639E-4</c:v>
                </c:pt>
                <c:pt idx="30">
                  <c:v>7.3583517292126639E-4</c:v>
                </c:pt>
              </c:numCache>
            </c:numRef>
          </c:val>
        </c:ser>
        <c:ser>
          <c:idx val="6"/>
          <c:order val="6"/>
          <c:tx>
            <c:strRef>
              <c:f>'unc-49 A2_0.02_50%'!$H$104</c:f>
              <c:strCache>
                <c:ptCount val="1"/>
                <c:pt idx="0">
                  <c:v>unc-49_REX_A2_07</c:v>
                </c:pt>
              </c:strCache>
            </c:strRef>
          </c:tx>
          <c:marker>
            <c:symbol val="none"/>
          </c:marker>
          <c:cat>
            <c:numRef>
              <c:f>'unc-49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2_0.02_50%'!$H$105:$H$135</c:f>
              <c:numCache>
                <c:formatCode>General</c:formatCode>
                <c:ptCount val="31"/>
                <c:pt idx="1">
                  <c:v>7.3580939032936235E-2</c:v>
                </c:pt>
                <c:pt idx="2">
                  <c:v>5.1156271899089015E-2</c:v>
                </c:pt>
                <c:pt idx="3">
                  <c:v>7.4281709880869004E-2</c:v>
                </c:pt>
                <c:pt idx="4">
                  <c:v>5.8864751226349016E-2</c:v>
                </c:pt>
                <c:pt idx="5">
                  <c:v>5.0455501051156315E-2</c:v>
                </c:pt>
                <c:pt idx="6">
                  <c:v>3.4337771548703613E-2</c:v>
                </c:pt>
                <c:pt idx="7">
                  <c:v>3.0133146461107214E-2</c:v>
                </c:pt>
                <c:pt idx="8">
                  <c:v>3.223545900490541E-2</c:v>
                </c:pt>
                <c:pt idx="9">
                  <c:v>3.7140854940434502E-2</c:v>
                </c:pt>
                <c:pt idx="10">
                  <c:v>4.0644709180098083E-2</c:v>
                </c:pt>
                <c:pt idx="11">
                  <c:v>6.0967063770147198E-2</c:v>
                </c:pt>
                <c:pt idx="12">
                  <c:v>6.377014716187808E-2</c:v>
                </c:pt>
                <c:pt idx="13">
                  <c:v>5.5360896986685421E-2</c:v>
                </c:pt>
                <c:pt idx="14">
                  <c:v>4.5550105115627203E-2</c:v>
                </c:pt>
                <c:pt idx="15">
                  <c:v>3.9243167484232712E-2</c:v>
                </c:pt>
                <c:pt idx="16">
                  <c:v>4.6250875963559861E-2</c:v>
                </c:pt>
                <c:pt idx="17">
                  <c:v>3.223545900490541E-2</c:v>
                </c:pt>
                <c:pt idx="18">
                  <c:v>2.7330063069376315E-2</c:v>
                </c:pt>
                <c:pt idx="19">
                  <c:v>2.0322354590049094E-2</c:v>
                </c:pt>
                <c:pt idx="20">
                  <c:v>1.2613875262789108E-2</c:v>
                </c:pt>
                <c:pt idx="21">
                  <c:v>8.4092501751927094E-3</c:v>
                </c:pt>
                <c:pt idx="22">
                  <c:v>4.2046250875963599E-3</c:v>
                </c:pt>
                <c:pt idx="23">
                  <c:v>7.0077084793272598E-3</c:v>
                </c:pt>
                <c:pt idx="24">
                  <c:v>1.4015416958654491E-3</c:v>
                </c:pt>
                <c:pt idx="25">
                  <c:v>4.905395935529082E-3</c:v>
                </c:pt>
                <c:pt idx="26">
                  <c:v>7.0077084793272618E-4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unc-49 A2_0.02_50%'!$I$104</c:f>
              <c:strCache>
                <c:ptCount val="1"/>
                <c:pt idx="0">
                  <c:v>unc-49_REX_A2_08</c:v>
                </c:pt>
              </c:strCache>
            </c:strRef>
          </c:tx>
          <c:marker>
            <c:symbol val="none"/>
          </c:marker>
          <c:cat>
            <c:numRef>
              <c:f>'unc-49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2_0.02_50%'!$I$105:$I$135</c:f>
              <c:numCache>
                <c:formatCode>General</c:formatCode>
                <c:ptCount val="31"/>
                <c:pt idx="1">
                  <c:v>8.7121212121212141E-2</c:v>
                </c:pt>
                <c:pt idx="2">
                  <c:v>7.7380952380952397E-2</c:v>
                </c:pt>
                <c:pt idx="3">
                  <c:v>6.9805194805194828E-2</c:v>
                </c:pt>
                <c:pt idx="4">
                  <c:v>6.1147186147186096E-2</c:v>
                </c:pt>
                <c:pt idx="5">
                  <c:v>5.1948051948052E-2</c:v>
                </c:pt>
                <c:pt idx="6">
                  <c:v>4.3831168831168797E-2</c:v>
                </c:pt>
                <c:pt idx="7">
                  <c:v>4.11255411255411E-2</c:v>
                </c:pt>
                <c:pt idx="8">
                  <c:v>3.3008658008657994E-2</c:v>
                </c:pt>
                <c:pt idx="9">
                  <c:v>2.5432900432900411E-2</c:v>
                </c:pt>
                <c:pt idx="10">
                  <c:v>3.7337662337662302E-2</c:v>
                </c:pt>
                <c:pt idx="11">
                  <c:v>4.3290043290043302E-2</c:v>
                </c:pt>
                <c:pt idx="12">
                  <c:v>3.9502164502164511E-2</c:v>
                </c:pt>
                <c:pt idx="13">
                  <c:v>3.7878787878787915E-2</c:v>
                </c:pt>
                <c:pt idx="14">
                  <c:v>3.4632034632034597E-2</c:v>
                </c:pt>
                <c:pt idx="15">
                  <c:v>2.9761904761904802E-2</c:v>
                </c:pt>
                <c:pt idx="16">
                  <c:v>2.2186147186147209E-2</c:v>
                </c:pt>
                <c:pt idx="17">
                  <c:v>2.7056277056277118E-2</c:v>
                </c:pt>
                <c:pt idx="18">
                  <c:v>1.7857142857142898E-2</c:v>
                </c:pt>
                <c:pt idx="19">
                  <c:v>2.002164502164501E-2</c:v>
                </c:pt>
                <c:pt idx="20">
                  <c:v>1.4069264069264099E-2</c:v>
                </c:pt>
                <c:pt idx="21">
                  <c:v>1.2987012987013E-2</c:v>
                </c:pt>
                <c:pt idx="22">
                  <c:v>1.1363636363636404E-2</c:v>
                </c:pt>
                <c:pt idx="23">
                  <c:v>7.575757575757582E-3</c:v>
                </c:pt>
                <c:pt idx="24">
                  <c:v>5.9523809523809503E-3</c:v>
                </c:pt>
                <c:pt idx="25">
                  <c:v>4.8701298701298718E-3</c:v>
                </c:pt>
                <c:pt idx="26">
                  <c:v>2.164502164502161E-3</c:v>
                </c:pt>
                <c:pt idx="27">
                  <c:v>3.7878787878787919E-3</c:v>
                </c:pt>
                <c:pt idx="28">
                  <c:v>5.4112554112554123E-4</c:v>
                </c:pt>
                <c:pt idx="29">
                  <c:v>2.705627705627712E-3</c:v>
                </c:pt>
                <c:pt idx="30">
                  <c:v>1.0822510822510805E-3</c:v>
                </c:pt>
              </c:numCache>
            </c:numRef>
          </c:val>
        </c:ser>
        <c:ser>
          <c:idx val="8"/>
          <c:order val="8"/>
          <c:tx>
            <c:strRef>
              <c:f>'unc-49 A2_0.02_50%'!$J$104</c:f>
              <c:strCache>
                <c:ptCount val="1"/>
                <c:pt idx="0">
                  <c:v>unc-49_REX_A2_09</c:v>
                </c:pt>
              </c:strCache>
            </c:strRef>
          </c:tx>
          <c:marker>
            <c:symbol val="none"/>
          </c:marker>
          <c:cat>
            <c:numRef>
              <c:f>'unc-49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2_0.02_50%'!$J$105:$J$135</c:f>
              <c:numCache>
                <c:formatCode>General</c:formatCode>
                <c:ptCount val="31"/>
                <c:pt idx="1">
                  <c:v>8.7251575375666551E-2</c:v>
                </c:pt>
                <c:pt idx="2">
                  <c:v>9.5492001938923904E-2</c:v>
                </c:pt>
                <c:pt idx="3">
                  <c:v>8.4827920504120261E-2</c:v>
                </c:pt>
                <c:pt idx="4">
                  <c:v>7.0285991274842502E-2</c:v>
                </c:pt>
                <c:pt idx="5">
                  <c:v>5.9621909840038831E-2</c:v>
                </c:pt>
                <c:pt idx="6">
                  <c:v>4.2656325739214698E-2</c:v>
                </c:pt>
                <c:pt idx="7">
                  <c:v>4.5564711585070312E-2</c:v>
                </c:pt>
                <c:pt idx="8">
                  <c:v>3.7324285021812897E-2</c:v>
                </c:pt>
                <c:pt idx="9">
                  <c:v>3.6839554047503602E-2</c:v>
                </c:pt>
                <c:pt idx="10">
                  <c:v>4.0232670867668421E-2</c:v>
                </c:pt>
                <c:pt idx="11">
                  <c:v>3.9747939893359202E-2</c:v>
                </c:pt>
                <c:pt idx="12">
                  <c:v>3.7809015996122214E-2</c:v>
                </c:pt>
                <c:pt idx="13">
                  <c:v>3.4415899175957297E-2</c:v>
                </c:pt>
                <c:pt idx="14">
                  <c:v>2.1328162869607398E-2</c:v>
                </c:pt>
                <c:pt idx="15">
                  <c:v>2.0843431895298092E-2</c:v>
                </c:pt>
                <c:pt idx="16">
                  <c:v>2.3751817741153706E-2</c:v>
                </c:pt>
                <c:pt idx="17">
                  <c:v>1.4057198254968501E-2</c:v>
                </c:pt>
                <c:pt idx="18">
                  <c:v>1.5026660203587006E-2</c:v>
                </c:pt>
                <c:pt idx="19">
                  <c:v>8.2404265632573942E-3</c:v>
                </c:pt>
                <c:pt idx="20">
                  <c:v>8.7251575375666586E-3</c:v>
                </c:pt>
                <c:pt idx="21">
                  <c:v>7.2709646146388836E-3</c:v>
                </c:pt>
                <c:pt idx="22">
                  <c:v>4.3625787687833302E-3</c:v>
                </c:pt>
                <c:pt idx="23">
                  <c:v>4.8473097430925833E-3</c:v>
                </c:pt>
                <c:pt idx="24">
                  <c:v>4.3625787687833302E-3</c:v>
                </c:pt>
                <c:pt idx="25">
                  <c:v>2.9083858458555517E-3</c:v>
                </c:pt>
                <c:pt idx="26">
                  <c:v>9.6946194861851698E-4</c:v>
                </c:pt>
                <c:pt idx="27">
                  <c:v>9.6946194861851698E-4</c:v>
                </c:pt>
                <c:pt idx="28">
                  <c:v>2.4236548715462912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unc-49 A2_0.02_50%'!$K$104</c:f>
              <c:strCache>
                <c:ptCount val="1"/>
                <c:pt idx="0">
                  <c:v>unc-49_REX_A2_10</c:v>
                </c:pt>
              </c:strCache>
            </c:strRef>
          </c:tx>
          <c:marker>
            <c:symbol val="none"/>
          </c:marker>
          <c:cat>
            <c:numRef>
              <c:f>'unc-49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2_0.02_50%'!$K$105:$K$135</c:f>
              <c:numCache>
                <c:formatCode>General</c:formatCode>
                <c:ptCount val="31"/>
                <c:pt idx="1">
                  <c:v>7.4801061007957623E-2</c:v>
                </c:pt>
                <c:pt idx="2">
                  <c:v>8.0636604774535783E-2</c:v>
                </c:pt>
                <c:pt idx="3">
                  <c:v>7.5331564986737432E-2</c:v>
                </c:pt>
                <c:pt idx="4">
                  <c:v>6.206896551724142E-2</c:v>
                </c:pt>
                <c:pt idx="5">
                  <c:v>5.8355437665782502E-2</c:v>
                </c:pt>
                <c:pt idx="6">
                  <c:v>5.6233421750663114E-2</c:v>
                </c:pt>
                <c:pt idx="7">
                  <c:v>4.0848806366047687E-2</c:v>
                </c:pt>
                <c:pt idx="8">
                  <c:v>4.0848806366047687E-2</c:v>
                </c:pt>
                <c:pt idx="9">
                  <c:v>4.6684350132626E-2</c:v>
                </c:pt>
                <c:pt idx="10">
                  <c:v>4.13793103448276E-2</c:v>
                </c:pt>
                <c:pt idx="11">
                  <c:v>4.5623342175066285E-2</c:v>
                </c:pt>
                <c:pt idx="12">
                  <c:v>4.8806366047745423E-2</c:v>
                </c:pt>
                <c:pt idx="13">
                  <c:v>3.9787798408488097E-2</c:v>
                </c:pt>
                <c:pt idx="14">
                  <c:v>2.8116710875331598E-2</c:v>
                </c:pt>
                <c:pt idx="15">
                  <c:v>3.2360742705570315E-2</c:v>
                </c:pt>
                <c:pt idx="16">
                  <c:v>2.5994694960212197E-2</c:v>
                </c:pt>
                <c:pt idx="17">
                  <c:v>2.4403183023872711E-2</c:v>
                </c:pt>
                <c:pt idx="18">
                  <c:v>1.9628647214854106E-2</c:v>
                </c:pt>
                <c:pt idx="19">
                  <c:v>1.3793103448275905E-2</c:v>
                </c:pt>
                <c:pt idx="20">
                  <c:v>1.1140583554376703E-2</c:v>
                </c:pt>
                <c:pt idx="21">
                  <c:v>9.5490716180371259E-3</c:v>
                </c:pt>
                <c:pt idx="22">
                  <c:v>7.4270557029177718E-3</c:v>
                </c:pt>
                <c:pt idx="23">
                  <c:v>4.7745358090185699E-3</c:v>
                </c:pt>
                <c:pt idx="24">
                  <c:v>3.183023872679052E-3</c:v>
                </c:pt>
                <c:pt idx="25">
                  <c:v>5.3050397877984099E-3</c:v>
                </c:pt>
                <c:pt idx="26">
                  <c:v>5.3050397877984102E-4</c:v>
                </c:pt>
                <c:pt idx="27">
                  <c:v>1.5915119363395206E-3</c:v>
                </c:pt>
                <c:pt idx="28">
                  <c:v>1.5915119363395206E-3</c:v>
                </c:pt>
                <c:pt idx="29">
                  <c:v>1.0610079575596801E-3</c:v>
                </c:pt>
                <c:pt idx="30">
                  <c:v>0</c:v>
                </c:pt>
              </c:numCache>
            </c:numRef>
          </c:val>
        </c:ser>
        <c:marker val="1"/>
        <c:axId val="166533376"/>
        <c:axId val="166555648"/>
      </c:lineChart>
      <c:catAx>
        <c:axId val="166533376"/>
        <c:scaling>
          <c:orientation val="minMax"/>
        </c:scaling>
        <c:axPos val="b"/>
        <c:numFmt formatCode="0.0_ " sourceLinked="1"/>
        <c:tickLblPos val="nextTo"/>
        <c:crossAx val="166555648"/>
        <c:crosses val="autoZero"/>
        <c:auto val="1"/>
        <c:lblAlgn val="ctr"/>
        <c:lblOffset val="100"/>
        <c:tickLblSkip val="5"/>
        <c:tickMarkSkip val="5"/>
      </c:catAx>
      <c:valAx>
        <c:axId val="166555648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6533376"/>
        <c:crosses val="autoZero"/>
        <c:crossBetween val="between"/>
      </c:valAx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25</a:t>
            </a:r>
            <a:r>
              <a:rPr lang="en-US" altLang="ja-JP" sz="1400" b="0" baseline="0" dirty="0">
                <a:latin typeface="Arial" pitchFamily="34" charset="0"/>
                <a:cs typeface="Arial" pitchFamily="34" charset="0"/>
              </a:rPr>
              <a:t> A3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25 A3_0.02_50%'!$B$104</c:f>
              <c:strCache>
                <c:ptCount val="1"/>
                <c:pt idx="0">
                  <c:v>unc-25_A3_40_30_01</c:v>
                </c:pt>
              </c:strCache>
            </c:strRef>
          </c:tx>
          <c:marker>
            <c:symbol val="none"/>
          </c:marker>
          <c:cat>
            <c:numRef>
              <c:f>'unc-25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3_0.02_50%'!$B$105:$B$135</c:f>
              <c:numCache>
                <c:formatCode>General</c:formatCode>
                <c:ptCount val="31"/>
                <c:pt idx="1">
                  <c:v>7.032057911065151E-2</c:v>
                </c:pt>
                <c:pt idx="2">
                  <c:v>5.6876938986556415E-2</c:v>
                </c:pt>
                <c:pt idx="3">
                  <c:v>4.7569803516028998E-2</c:v>
                </c:pt>
                <c:pt idx="4">
                  <c:v>4.1365046535677387E-2</c:v>
                </c:pt>
                <c:pt idx="5">
                  <c:v>3.4126163391933785E-2</c:v>
                </c:pt>
                <c:pt idx="6">
                  <c:v>2.4819027921406406E-2</c:v>
                </c:pt>
                <c:pt idx="7">
                  <c:v>1.5511892450878998E-2</c:v>
                </c:pt>
                <c:pt idx="8">
                  <c:v>1.9648397104446699E-2</c:v>
                </c:pt>
                <c:pt idx="9">
                  <c:v>1.6546018614270908E-2</c:v>
                </c:pt>
                <c:pt idx="10">
                  <c:v>2.5853154084798307E-2</c:v>
                </c:pt>
                <c:pt idx="11">
                  <c:v>3.8262668045501595E-2</c:v>
                </c:pt>
                <c:pt idx="12">
                  <c:v>6.2047569803516021E-2</c:v>
                </c:pt>
                <c:pt idx="13">
                  <c:v>6.7218200620475704E-2</c:v>
                </c:pt>
                <c:pt idx="14">
                  <c:v>8.4798345398138672E-2</c:v>
                </c:pt>
                <c:pt idx="15">
                  <c:v>4.1365046535677387E-2</c:v>
                </c:pt>
                <c:pt idx="16">
                  <c:v>5.3774560496380602E-2</c:v>
                </c:pt>
                <c:pt idx="17">
                  <c:v>4.1365046535677387E-2</c:v>
                </c:pt>
                <c:pt idx="18">
                  <c:v>3.2057911065149922E-2</c:v>
                </c:pt>
                <c:pt idx="19">
                  <c:v>2.8955532574974113E-2</c:v>
                </c:pt>
                <c:pt idx="20">
                  <c:v>1.6546018614270908E-2</c:v>
                </c:pt>
                <c:pt idx="21">
                  <c:v>1.24095139607032E-2</c:v>
                </c:pt>
                <c:pt idx="22">
                  <c:v>7.2388831437435438E-3</c:v>
                </c:pt>
                <c:pt idx="23">
                  <c:v>6.2047569803516025E-3</c:v>
                </c:pt>
                <c:pt idx="24">
                  <c:v>1.0341261633919304E-3</c:v>
                </c:pt>
                <c:pt idx="25">
                  <c:v>1.0341261633919304E-3</c:v>
                </c:pt>
                <c:pt idx="26">
                  <c:v>1.0341261633919304E-3</c:v>
                </c:pt>
                <c:pt idx="27">
                  <c:v>2.06825232678387E-3</c:v>
                </c:pt>
                <c:pt idx="28">
                  <c:v>0</c:v>
                </c:pt>
                <c:pt idx="29">
                  <c:v>1.0341261633919304E-3</c:v>
                </c:pt>
                <c:pt idx="30">
                  <c:v>1.0341261633919304E-3</c:v>
                </c:pt>
              </c:numCache>
            </c:numRef>
          </c:val>
        </c:ser>
        <c:ser>
          <c:idx val="1"/>
          <c:order val="1"/>
          <c:tx>
            <c:strRef>
              <c:f>'unc-25 A3_0.02_50%'!$C$104</c:f>
              <c:strCache>
                <c:ptCount val="1"/>
                <c:pt idx="0">
                  <c:v>unc-25_A3_40_30_03</c:v>
                </c:pt>
              </c:strCache>
            </c:strRef>
          </c:tx>
          <c:marker>
            <c:symbol val="none"/>
          </c:marker>
          <c:cat>
            <c:numRef>
              <c:f>'unc-25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3_0.02_50%'!$C$105:$C$135</c:f>
              <c:numCache>
                <c:formatCode>General</c:formatCode>
                <c:ptCount val="31"/>
                <c:pt idx="1">
                  <c:v>7.4309978768577506E-2</c:v>
                </c:pt>
                <c:pt idx="2">
                  <c:v>5.2016985138004235E-2</c:v>
                </c:pt>
                <c:pt idx="3">
                  <c:v>4.3524416135881101E-2</c:v>
                </c:pt>
                <c:pt idx="4">
                  <c:v>3.3970276008492603E-2</c:v>
                </c:pt>
                <c:pt idx="5">
                  <c:v>3.3970276008492603E-2</c:v>
                </c:pt>
                <c:pt idx="6">
                  <c:v>2.5477707006369421E-2</c:v>
                </c:pt>
                <c:pt idx="7">
                  <c:v>2.2292993630573209E-2</c:v>
                </c:pt>
                <c:pt idx="8">
                  <c:v>1.5923566878980902E-2</c:v>
                </c:pt>
                <c:pt idx="9">
                  <c:v>2.0169851380042493E-2</c:v>
                </c:pt>
                <c:pt idx="10">
                  <c:v>4.3524416135881101E-2</c:v>
                </c:pt>
                <c:pt idx="11">
                  <c:v>5.4140127388534985E-2</c:v>
                </c:pt>
                <c:pt idx="12">
                  <c:v>5.8386411889596646E-2</c:v>
                </c:pt>
                <c:pt idx="13">
                  <c:v>7.7494692144373753E-2</c:v>
                </c:pt>
                <c:pt idx="14">
                  <c:v>7.1125265392781301E-2</c:v>
                </c:pt>
                <c:pt idx="15">
                  <c:v>7.5371549893842898E-2</c:v>
                </c:pt>
                <c:pt idx="16">
                  <c:v>5.8386411889596646E-2</c:v>
                </c:pt>
                <c:pt idx="17">
                  <c:v>3.3970276008492603E-2</c:v>
                </c:pt>
                <c:pt idx="18">
                  <c:v>3.0785562632696401E-2</c:v>
                </c:pt>
                <c:pt idx="19">
                  <c:v>1.9108280254777107E-2</c:v>
                </c:pt>
                <c:pt idx="20">
                  <c:v>1.4861995753715504E-2</c:v>
                </c:pt>
                <c:pt idx="21">
                  <c:v>1.3800424628450108E-2</c:v>
                </c:pt>
                <c:pt idx="22">
                  <c:v>5.3078556263269575E-3</c:v>
                </c:pt>
                <c:pt idx="23">
                  <c:v>2.1231422505307912E-3</c:v>
                </c:pt>
                <c:pt idx="24">
                  <c:v>4.2462845010615719E-3</c:v>
                </c:pt>
                <c:pt idx="25">
                  <c:v>0</c:v>
                </c:pt>
                <c:pt idx="26">
                  <c:v>2.1231422505307912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unc-25 A3_0.02_50%'!$D$104</c:f>
              <c:strCache>
                <c:ptCount val="1"/>
                <c:pt idx="0">
                  <c:v>unc-25_A3_40_30_2</c:v>
                </c:pt>
              </c:strCache>
            </c:strRef>
          </c:tx>
          <c:marker>
            <c:symbol val="none"/>
          </c:marker>
          <c:cat>
            <c:numRef>
              <c:f>'unc-25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3_0.02_50%'!$D$105:$D$135</c:f>
              <c:numCache>
                <c:formatCode>General</c:formatCode>
                <c:ptCount val="31"/>
                <c:pt idx="1">
                  <c:v>9.0361445783132557E-2</c:v>
                </c:pt>
                <c:pt idx="2">
                  <c:v>6.0240963855421721E-2</c:v>
                </c:pt>
                <c:pt idx="3">
                  <c:v>5.7228915662650572E-2</c:v>
                </c:pt>
                <c:pt idx="4">
                  <c:v>5.1204819277108383E-2</c:v>
                </c:pt>
                <c:pt idx="5">
                  <c:v>3.5140562248995998E-2</c:v>
                </c:pt>
                <c:pt idx="6">
                  <c:v>2.7108433734939798E-2</c:v>
                </c:pt>
                <c:pt idx="7">
                  <c:v>2.3092369477911608E-2</c:v>
                </c:pt>
                <c:pt idx="8">
                  <c:v>1.1044176706827308E-2</c:v>
                </c:pt>
                <c:pt idx="9">
                  <c:v>1.4056224899598398E-2</c:v>
                </c:pt>
                <c:pt idx="10">
                  <c:v>1.8072289156626498E-2</c:v>
                </c:pt>
                <c:pt idx="11">
                  <c:v>2.3092369477911608E-2</c:v>
                </c:pt>
                <c:pt idx="12">
                  <c:v>4.1164658634538213E-2</c:v>
                </c:pt>
                <c:pt idx="13">
                  <c:v>5.2208835341365487E-2</c:v>
                </c:pt>
                <c:pt idx="14">
                  <c:v>5.5220883534136504E-2</c:v>
                </c:pt>
                <c:pt idx="15">
                  <c:v>4.9196787148594434E-2</c:v>
                </c:pt>
                <c:pt idx="16">
                  <c:v>4.0160642570281097E-2</c:v>
                </c:pt>
                <c:pt idx="17">
                  <c:v>4.5180722891566313E-2</c:v>
                </c:pt>
                <c:pt idx="18">
                  <c:v>3.3132530120481903E-2</c:v>
                </c:pt>
                <c:pt idx="19">
                  <c:v>2.2088353413654616E-2</c:v>
                </c:pt>
                <c:pt idx="20">
                  <c:v>1.8072289156626498E-2</c:v>
                </c:pt>
                <c:pt idx="21">
                  <c:v>1.5060240963855399E-2</c:v>
                </c:pt>
                <c:pt idx="22">
                  <c:v>1.1044176706827308E-2</c:v>
                </c:pt>
                <c:pt idx="23">
                  <c:v>1.3052208835341398E-2</c:v>
                </c:pt>
                <c:pt idx="24">
                  <c:v>6.0240963855421733E-3</c:v>
                </c:pt>
                <c:pt idx="25">
                  <c:v>4.0160642570281095E-3</c:v>
                </c:pt>
                <c:pt idx="26">
                  <c:v>4.0160642570281095E-3</c:v>
                </c:pt>
                <c:pt idx="27">
                  <c:v>1.0040160642570308E-3</c:v>
                </c:pt>
                <c:pt idx="28">
                  <c:v>2.0080321285140608E-3</c:v>
                </c:pt>
                <c:pt idx="29">
                  <c:v>0</c:v>
                </c:pt>
                <c:pt idx="30">
                  <c:v>2.0080321285140608E-3</c:v>
                </c:pt>
              </c:numCache>
            </c:numRef>
          </c:val>
        </c:ser>
        <c:ser>
          <c:idx val="3"/>
          <c:order val="3"/>
          <c:tx>
            <c:strRef>
              <c:f>'unc-25 A3_0.02_50%'!$E$104</c:f>
              <c:strCache>
                <c:ptCount val="1"/>
                <c:pt idx="0">
                  <c:v>unc-25_A3_40_30_4</c:v>
                </c:pt>
              </c:strCache>
            </c:strRef>
          </c:tx>
          <c:marker>
            <c:symbol val="none"/>
          </c:marker>
          <c:cat>
            <c:numRef>
              <c:f>'unc-25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3_0.02_50%'!$E$105:$E$135</c:f>
              <c:numCache>
                <c:formatCode>General</c:formatCode>
                <c:ptCount val="31"/>
                <c:pt idx="1">
                  <c:v>5.7522123893805323E-2</c:v>
                </c:pt>
                <c:pt idx="2">
                  <c:v>5.7522123893805323E-2</c:v>
                </c:pt>
                <c:pt idx="3">
                  <c:v>4.1592920353982321E-2</c:v>
                </c:pt>
                <c:pt idx="4">
                  <c:v>4.690265486725663E-2</c:v>
                </c:pt>
                <c:pt idx="5">
                  <c:v>3.4513274336283199E-2</c:v>
                </c:pt>
                <c:pt idx="6">
                  <c:v>2.9203539823008801E-2</c:v>
                </c:pt>
                <c:pt idx="7">
                  <c:v>1.9469026548672608E-2</c:v>
                </c:pt>
                <c:pt idx="8">
                  <c:v>2.1238938053097314E-2</c:v>
                </c:pt>
                <c:pt idx="9">
                  <c:v>1.8584070796460211E-2</c:v>
                </c:pt>
                <c:pt idx="10">
                  <c:v>2.8318584070796484E-2</c:v>
                </c:pt>
                <c:pt idx="11">
                  <c:v>2.8318584070796484E-2</c:v>
                </c:pt>
                <c:pt idx="12">
                  <c:v>4.4247787610619496E-2</c:v>
                </c:pt>
                <c:pt idx="13">
                  <c:v>6.0176991150442533E-2</c:v>
                </c:pt>
                <c:pt idx="14">
                  <c:v>6.6371681415929223E-2</c:v>
                </c:pt>
                <c:pt idx="15">
                  <c:v>6.7256637168141647E-2</c:v>
                </c:pt>
                <c:pt idx="16">
                  <c:v>5.6637168141592885E-2</c:v>
                </c:pt>
                <c:pt idx="17">
                  <c:v>4.7787610619469019E-2</c:v>
                </c:pt>
                <c:pt idx="18">
                  <c:v>2.7433628318584116E-2</c:v>
                </c:pt>
                <c:pt idx="19">
                  <c:v>3.6283185840708006E-2</c:v>
                </c:pt>
                <c:pt idx="20">
                  <c:v>1.7699115044247801E-2</c:v>
                </c:pt>
                <c:pt idx="21">
                  <c:v>1.4159292035398192E-2</c:v>
                </c:pt>
                <c:pt idx="22">
                  <c:v>1.4159292035398192E-2</c:v>
                </c:pt>
                <c:pt idx="23">
                  <c:v>1.50442477876106E-2</c:v>
                </c:pt>
                <c:pt idx="24">
                  <c:v>6.1946902654867299E-3</c:v>
                </c:pt>
                <c:pt idx="25">
                  <c:v>5.3097345132743423E-3</c:v>
                </c:pt>
                <c:pt idx="26">
                  <c:v>8.8495575221238969E-4</c:v>
                </c:pt>
                <c:pt idx="27">
                  <c:v>1.7699115044247805E-3</c:v>
                </c:pt>
                <c:pt idx="28">
                  <c:v>0</c:v>
                </c:pt>
                <c:pt idx="29">
                  <c:v>0</c:v>
                </c:pt>
                <c:pt idx="30">
                  <c:v>8.8495575221238969E-4</c:v>
                </c:pt>
              </c:numCache>
            </c:numRef>
          </c:val>
        </c:ser>
        <c:ser>
          <c:idx val="4"/>
          <c:order val="4"/>
          <c:tx>
            <c:strRef>
              <c:f>'unc-25 A3_0.02_50%'!$F$104</c:f>
              <c:strCache>
                <c:ptCount val="1"/>
                <c:pt idx="0">
                  <c:v>unc-25_REX_A3_01</c:v>
                </c:pt>
              </c:strCache>
            </c:strRef>
          </c:tx>
          <c:marker>
            <c:symbol val="none"/>
          </c:marker>
          <c:cat>
            <c:numRef>
              <c:f>'unc-25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3_0.02_50%'!$F$105:$F$135</c:f>
              <c:numCache>
                <c:formatCode>General</c:formatCode>
                <c:ptCount val="31"/>
                <c:pt idx="1">
                  <c:v>5.6170886075949396E-2</c:v>
                </c:pt>
                <c:pt idx="2">
                  <c:v>4.7468354430379799E-2</c:v>
                </c:pt>
                <c:pt idx="3">
                  <c:v>5.2215189873417701E-2</c:v>
                </c:pt>
                <c:pt idx="4">
                  <c:v>3.0854430379746799E-2</c:v>
                </c:pt>
                <c:pt idx="5">
                  <c:v>1.9778481012658208E-2</c:v>
                </c:pt>
                <c:pt idx="6">
                  <c:v>1.3449367088607601E-2</c:v>
                </c:pt>
                <c:pt idx="7">
                  <c:v>1.02848101265823E-2</c:v>
                </c:pt>
                <c:pt idx="8">
                  <c:v>1.1075949367088601E-2</c:v>
                </c:pt>
                <c:pt idx="9">
                  <c:v>4.7468354430379714E-3</c:v>
                </c:pt>
                <c:pt idx="10">
                  <c:v>7.9113924050632951E-3</c:v>
                </c:pt>
                <c:pt idx="11">
                  <c:v>1.4240506329113901E-2</c:v>
                </c:pt>
                <c:pt idx="12">
                  <c:v>2.5316455696202493E-2</c:v>
                </c:pt>
                <c:pt idx="13">
                  <c:v>3.3227848101265806E-2</c:v>
                </c:pt>
                <c:pt idx="14">
                  <c:v>5.3797468354430431E-2</c:v>
                </c:pt>
                <c:pt idx="15">
                  <c:v>6.8037974683544333E-2</c:v>
                </c:pt>
                <c:pt idx="16">
                  <c:v>8.2278481012658181E-2</c:v>
                </c:pt>
                <c:pt idx="17">
                  <c:v>7.3575949367088569E-2</c:v>
                </c:pt>
                <c:pt idx="18">
                  <c:v>7.0411392405063319E-2</c:v>
                </c:pt>
                <c:pt idx="19">
                  <c:v>5.6170886075949396E-2</c:v>
                </c:pt>
                <c:pt idx="20">
                  <c:v>4.6677215189873382E-2</c:v>
                </c:pt>
                <c:pt idx="21">
                  <c:v>2.5316455696202493E-2</c:v>
                </c:pt>
                <c:pt idx="22">
                  <c:v>1.3449367088607601E-2</c:v>
                </c:pt>
                <c:pt idx="23">
                  <c:v>1.5031645569620299E-2</c:v>
                </c:pt>
                <c:pt idx="24">
                  <c:v>1.02848101265823E-2</c:v>
                </c:pt>
                <c:pt idx="25">
                  <c:v>3.9556962025316519E-3</c:v>
                </c:pt>
                <c:pt idx="26">
                  <c:v>3.9556962025316519E-3</c:v>
                </c:pt>
                <c:pt idx="27">
                  <c:v>3.164556962025322E-3</c:v>
                </c:pt>
                <c:pt idx="28">
                  <c:v>1.5822784810126606E-3</c:v>
                </c:pt>
                <c:pt idx="29">
                  <c:v>7.9113924050632964E-4</c:v>
                </c:pt>
                <c:pt idx="30">
                  <c:v>1.5822784810126606E-3</c:v>
                </c:pt>
              </c:numCache>
            </c:numRef>
          </c:val>
        </c:ser>
        <c:ser>
          <c:idx val="5"/>
          <c:order val="5"/>
          <c:tx>
            <c:strRef>
              <c:f>'unc-25 A3_0.02_50%'!$G$104</c:f>
              <c:strCache>
                <c:ptCount val="1"/>
                <c:pt idx="0">
                  <c:v>unc-25_REX_A3_03</c:v>
                </c:pt>
              </c:strCache>
            </c:strRef>
          </c:tx>
          <c:marker>
            <c:symbol val="none"/>
          </c:marker>
          <c:cat>
            <c:numRef>
              <c:f>'unc-25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3_0.02_50%'!$G$105:$G$135</c:f>
              <c:numCache>
                <c:formatCode>General</c:formatCode>
                <c:ptCount val="31"/>
                <c:pt idx="1">
                  <c:v>7.3596358118361196E-2</c:v>
                </c:pt>
                <c:pt idx="2">
                  <c:v>5.8421851289833099E-2</c:v>
                </c:pt>
                <c:pt idx="3">
                  <c:v>5.0075872534142585E-2</c:v>
                </c:pt>
                <c:pt idx="4">
                  <c:v>4.0971168437025779E-2</c:v>
                </c:pt>
                <c:pt idx="5">
                  <c:v>4.2488619119878626E-2</c:v>
                </c:pt>
                <c:pt idx="6">
                  <c:v>3.4901365705614612E-2</c:v>
                </c:pt>
                <c:pt idx="7">
                  <c:v>2.3520485584218494E-2</c:v>
                </c:pt>
                <c:pt idx="8">
                  <c:v>1.5933232169954497E-2</c:v>
                </c:pt>
                <c:pt idx="9">
                  <c:v>1.2898330804248898E-2</c:v>
                </c:pt>
                <c:pt idx="10">
                  <c:v>1.44157814871017E-2</c:v>
                </c:pt>
                <c:pt idx="11">
                  <c:v>1.7450682852807299E-2</c:v>
                </c:pt>
                <c:pt idx="12">
                  <c:v>2.04855842185129E-2</c:v>
                </c:pt>
                <c:pt idx="13">
                  <c:v>2.5796661608497688E-2</c:v>
                </c:pt>
                <c:pt idx="14">
                  <c:v>4.3247344461304967E-2</c:v>
                </c:pt>
                <c:pt idx="15">
                  <c:v>4.4006069802731439E-2</c:v>
                </c:pt>
                <c:pt idx="16">
                  <c:v>4.2488619119878626E-2</c:v>
                </c:pt>
                <c:pt idx="17">
                  <c:v>5.3869499241274717E-2</c:v>
                </c:pt>
                <c:pt idx="18">
                  <c:v>5.0075872534142585E-2</c:v>
                </c:pt>
                <c:pt idx="19">
                  <c:v>4.5523520485584203E-2</c:v>
                </c:pt>
                <c:pt idx="20">
                  <c:v>4.4764795144157821E-2</c:v>
                </c:pt>
                <c:pt idx="21">
                  <c:v>2.8072837632776914E-2</c:v>
                </c:pt>
                <c:pt idx="22">
                  <c:v>3.4901365705614612E-2</c:v>
                </c:pt>
                <c:pt idx="23">
                  <c:v>1.66919575113809E-2</c:v>
                </c:pt>
                <c:pt idx="24">
                  <c:v>1.3657056145675301E-2</c:v>
                </c:pt>
                <c:pt idx="25">
                  <c:v>1.1380880121396101E-2</c:v>
                </c:pt>
                <c:pt idx="26">
                  <c:v>6.0698027314112319E-3</c:v>
                </c:pt>
                <c:pt idx="27">
                  <c:v>6.8285280728376304E-3</c:v>
                </c:pt>
                <c:pt idx="28">
                  <c:v>3.0349013657056112E-3</c:v>
                </c:pt>
                <c:pt idx="29">
                  <c:v>2.2761760242792101E-3</c:v>
                </c:pt>
                <c:pt idx="30">
                  <c:v>3.7936267071320227E-3</c:v>
                </c:pt>
              </c:numCache>
            </c:numRef>
          </c:val>
        </c:ser>
        <c:ser>
          <c:idx val="6"/>
          <c:order val="6"/>
          <c:tx>
            <c:strRef>
              <c:f>'unc-25 A3_0.02_50%'!$H$104</c:f>
              <c:strCache>
                <c:ptCount val="1"/>
                <c:pt idx="0">
                  <c:v>unc-25_REX_A3_04</c:v>
                </c:pt>
              </c:strCache>
            </c:strRef>
          </c:tx>
          <c:marker>
            <c:symbol val="none"/>
          </c:marker>
          <c:cat>
            <c:numRef>
              <c:f>'unc-25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3_0.02_50%'!$H$105:$H$135</c:f>
              <c:numCache>
                <c:formatCode>General</c:formatCode>
                <c:ptCount val="31"/>
                <c:pt idx="1">
                  <c:v>7.3614557485525201E-2</c:v>
                </c:pt>
                <c:pt idx="2">
                  <c:v>5.789909015715472E-2</c:v>
                </c:pt>
                <c:pt idx="3">
                  <c:v>5.789909015715472E-2</c:v>
                </c:pt>
                <c:pt idx="4">
                  <c:v>4.6319272125723718E-2</c:v>
                </c:pt>
                <c:pt idx="5">
                  <c:v>3.6393713813068711E-2</c:v>
                </c:pt>
                <c:pt idx="6">
                  <c:v>2.646815550041361E-2</c:v>
                </c:pt>
                <c:pt idx="7">
                  <c:v>1.81968569065343E-2</c:v>
                </c:pt>
                <c:pt idx="8">
                  <c:v>1.6542597187758506E-2</c:v>
                </c:pt>
                <c:pt idx="9">
                  <c:v>9.0984284532671603E-3</c:v>
                </c:pt>
                <c:pt idx="10">
                  <c:v>1.1579818031430903E-2</c:v>
                </c:pt>
                <c:pt idx="11">
                  <c:v>1.81968569065343E-2</c:v>
                </c:pt>
                <c:pt idx="12">
                  <c:v>2.646815550041361E-2</c:v>
                </c:pt>
                <c:pt idx="13">
                  <c:v>3.3912324234904888E-2</c:v>
                </c:pt>
                <c:pt idx="14">
                  <c:v>4.2183622828784115E-2</c:v>
                </c:pt>
                <c:pt idx="15">
                  <c:v>4.3837882547559978E-2</c:v>
                </c:pt>
                <c:pt idx="16">
                  <c:v>5.0454921422663418E-2</c:v>
                </c:pt>
                <c:pt idx="17">
                  <c:v>4.4665012406947903E-2</c:v>
                </c:pt>
                <c:pt idx="18">
                  <c:v>5.3763440860215117E-2</c:v>
                </c:pt>
                <c:pt idx="19">
                  <c:v>3.9702233250620299E-2</c:v>
                </c:pt>
                <c:pt idx="20">
                  <c:v>3.3085194375516998E-2</c:v>
                </c:pt>
                <c:pt idx="21">
                  <c:v>3.3912324234904888E-2</c:v>
                </c:pt>
                <c:pt idx="22">
                  <c:v>2.4813895781637708E-2</c:v>
                </c:pt>
                <c:pt idx="23">
                  <c:v>1.2406947890818899E-2</c:v>
                </c:pt>
                <c:pt idx="24">
                  <c:v>1.5715467328370598E-2</c:v>
                </c:pt>
                <c:pt idx="25">
                  <c:v>1.4061207609594699E-2</c:v>
                </c:pt>
                <c:pt idx="26">
                  <c:v>6.6170388751033904E-3</c:v>
                </c:pt>
                <c:pt idx="27">
                  <c:v>3.3085194375517008E-3</c:v>
                </c:pt>
                <c:pt idx="28">
                  <c:v>0</c:v>
                </c:pt>
                <c:pt idx="29">
                  <c:v>2.4813895781637717E-3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unc-25 A3_0.02_50%'!$I$104</c:f>
              <c:strCache>
                <c:ptCount val="1"/>
                <c:pt idx="0">
                  <c:v>unc-25_REX_A3_05</c:v>
                </c:pt>
              </c:strCache>
            </c:strRef>
          </c:tx>
          <c:marker>
            <c:symbol val="none"/>
          </c:marker>
          <c:cat>
            <c:numRef>
              <c:f>'unc-25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3_0.02_50%'!$I$105:$I$135</c:f>
              <c:numCache>
                <c:formatCode>General</c:formatCode>
                <c:ptCount val="31"/>
                <c:pt idx="1">
                  <c:v>8.1403508771929783E-2</c:v>
                </c:pt>
                <c:pt idx="2">
                  <c:v>6.8070175438596503E-2</c:v>
                </c:pt>
                <c:pt idx="3">
                  <c:v>6.1052631578947421E-2</c:v>
                </c:pt>
                <c:pt idx="4">
                  <c:v>5.75438596491228E-2</c:v>
                </c:pt>
                <c:pt idx="5">
                  <c:v>5.6842105263157867E-2</c:v>
                </c:pt>
                <c:pt idx="6">
                  <c:v>3.2280701754386E-2</c:v>
                </c:pt>
                <c:pt idx="7">
                  <c:v>1.8947368421052605E-2</c:v>
                </c:pt>
                <c:pt idx="8">
                  <c:v>2.52631578947368E-2</c:v>
                </c:pt>
                <c:pt idx="9">
                  <c:v>2.52631578947368E-2</c:v>
                </c:pt>
                <c:pt idx="10">
                  <c:v>2.9473684210526308E-2</c:v>
                </c:pt>
                <c:pt idx="11">
                  <c:v>3.5789473684210517E-2</c:v>
                </c:pt>
                <c:pt idx="12">
                  <c:v>3.719298245614041E-2</c:v>
                </c:pt>
                <c:pt idx="13">
                  <c:v>4.7719298245614022E-2</c:v>
                </c:pt>
                <c:pt idx="14">
                  <c:v>4.0000000000000015E-2</c:v>
                </c:pt>
                <c:pt idx="15">
                  <c:v>5.1929824561403479E-2</c:v>
                </c:pt>
                <c:pt idx="16">
                  <c:v>3.8596491228070198E-2</c:v>
                </c:pt>
                <c:pt idx="17">
                  <c:v>3.43859649122807E-2</c:v>
                </c:pt>
                <c:pt idx="18">
                  <c:v>3.8596491228070198E-2</c:v>
                </c:pt>
                <c:pt idx="19">
                  <c:v>2.0350877192982494E-2</c:v>
                </c:pt>
                <c:pt idx="20">
                  <c:v>1.7543859649122813E-2</c:v>
                </c:pt>
                <c:pt idx="21">
                  <c:v>1.54385964912281E-2</c:v>
                </c:pt>
                <c:pt idx="22">
                  <c:v>1.2631578947368407E-2</c:v>
                </c:pt>
                <c:pt idx="23">
                  <c:v>4.2105263157894719E-3</c:v>
                </c:pt>
                <c:pt idx="24">
                  <c:v>3.508771929824561E-3</c:v>
                </c:pt>
                <c:pt idx="25">
                  <c:v>4.2105263157894719E-3</c:v>
                </c:pt>
                <c:pt idx="26">
                  <c:v>1.4035087719298201E-3</c:v>
                </c:pt>
                <c:pt idx="27">
                  <c:v>4.9122807017543922E-3</c:v>
                </c:pt>
                <c:pt idx="28">
                  <c:v>7.0175438596491223E-4</c:v>
                </c:pt>
                <c:pt idx="29">
                  <c:v>0</c:v>
                </c:pt>
                <c:pt idx="30">
                  <c:v>7.0175438596491223E-4</c:v>
                </c:pt>
              </c:numCache>
            </c:numRef>
          </c:val>
        </c:ser>
        <c:ser>
          <c:idx val="8"/>
          <c:order val="8"/>
          <c:tx>
            <c:strRef>
              <c:f>'unc-25 A3_0.02_50%'!$J$104</c:f>
              <c:strCache>
                <c:ptCount val="1"/>
                <c:pt idx="0">
                  <c:v>unc-25_REX_A3_06</c:v>
                </c:pt>
              </c:strCache>
            </c:strRef>
          </c:tx>
          <c:marker>
            <c:symbol val="none"/>
          </c:marker>
          <c:cat>
            <c:numRef>
              <c:f>'unc-25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3_0.02_50%'!$J$105:$J$135</c:f>
              <c:numCache>
                <c:formatCode>General</c:formatCode>
                <c:ptCount val="31"/>
                <c:pt idx="1">
                  <c:v>0.10023866348448703</c:v>
                </c:pt>
                <c:pt idx="2">
                  <c:v>9.2283214001591007E-2</c:v>
                </c:pt>
                <c:pt idx="3">
                  <c:v>6.1256961018297501E-2</c:v>
                </c:pt>
                <c:pt idx="4">
                  <c:v>4.8528241845664302E-2</c:v>
                </c:pt>
                <c:pt idx="5">
                  <c:v>3.4208432776451914E-2</c:v>
                </c:pt>
                <c:pt idx="6">
                  <c:v>1.9888623707239508E-2</c:v>
                </c:pt>
                <c:pt idx="7">
                  <c:v>1.9093078758949902E-2</c:v>
                </c:pt>
                <c:pt idx="8">
                  <c:v>1.67064439140811E-2</c:v>
                </c:pt>
                <c:pt idx="9">
                  <c:v>1.1137629276054101E-2</c:v>
                </c:pt>
                <c:pt idx="10">
                  <c:v>1.4319809069212406E-2</c:v>
                </c:pt>
                <c:pt idx="11">
                  <c:v>1.9888623707239508E-2</c:v>
                </c:pt>
                <c:pt idx="12">
                  <c:v>2.4661893396976907E-2</c:v>
                </c:pt>
                <c:pt idx="13">
                  <c:v>3.0230708035004009E-2</c:v>
                </c:pt>
                <c:pt idx="14">
                  <c:v>3.5003977724741418E-2</c:v>
                </c:pt>
                <c:pt idx="15">
                  <c:v>4.6141607000795497E-2</c:v>
                </c:pt>
                <c:pt idx="16">
                  <c:v>3.3412887828162298E-2</c:v>
                </c:pt>
                <c:pt idx="17">
                  <c:v>3.7390612569610217E-2</c:v>
                </c:pt>
                <c:pt idx="18">
                  <c:v>2.8639618138424812E-2</c:v>
                </c:pt>
                <c:pt idx="19">
                  <c:v>2.7048528241845692E-2</c:v>
                </c:pt>
                <c:pt idx="20">
                  <c:v>1.4319809069212406E-2</c:v>
                </c:pt>
                <c:pt idx="21">
                  <c:v>1.8297533810660307E-2</c:v>
                </c:pt>
                <c:pt idx="22">
                  <c:v>1.0342084327764501E-2</c:v>
                </c:pt>
                <c:pt idx="23">
                  <c:v>6.3643595863166315E-3</c:v>
                </c:pt>
                <c:pt idx="24">
                  <c:v>6.3643595863166315E-3</c:v>
                </c:pt>
                <c:pt idx="25">
                  <c:v>3.9777247414478937E-3</c:v>
                </c:pt>
                <c:pt idx="26">
                  <c:v>2.38663484486874E-3</c:v>
                </c:pt>
                <c:pt idx="27">
                  <c:v>1.59108989657916E-3</c:v>
                </c:pt>
                <c:pt idx="28">
                  <c:v>7.9554494828957851E-4</c:v>
                </c:pt>
                <c:pt idx="29">
                  <c:v>1.59108989657916E-3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unc-25 A3_0.02_50%'!$K$104</c:f>
              <c:strCache>
                <c:ptCount val="1"/>
                <c:pt idx="0">
                  <c:v>unc-25_REX_A3_08</c:v>
                </c:pt>
              </c:strCache>
            </c:strRef>
          </c:tx>
          <c:marker>
            <c:symbol val="none"/>
          </c:marker>
          <c:cat>
            <c:numRef>
              <c:f>'unc-25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3_0.02_50%'!$K$105:$K$135</c:f>
              <c:numCache>
                <c:formatCode>General</c:formatCode>
                <c:ptCount val="31"/>
                <c:pt idx="1">
                  <c:v>7.1736011477761832E-2</c:v>
                </c:pt>
                <c:pt idx="2">
                  <c:v>6.1692969870875199E-2</c:v>
                </c:pt>
                <c:pt idx="3">
                  <c:v>5.5236728837876635E-2</c:v>
                </c:pt>
                <c:pt idx="4">
                  <c:v>3.8020086083213799E-2</c:v>
                </c:pt>
                <c:pt idx="5">
                  <c:v>3.3715925394548103E-2</c:v>
                </c:pt>
                <c:pt idx="6">
                  <c:v>2.4390243902439001E-2</c:v>
                </c:pt>
                <c:pt idx="7">
                  <c:v>1.5064562410329999E-2</c:v>
                </c:pt>
                <c:pt idx="8">
                  <c:v>1.9368723098995708E-2</c:v>
                </c:pt>
                <c:pt idx="9">
                  <c:v>2.5107604017216602E-2</c:v>
                </c:pt>
                <c:pt idx="10">
                  <c:v>2.1520803443328601E-2</c:v>
                </c:pt>
                <c:pt idx="11">
                  <c:v>4.232424677187948E-2</c:v>
                </c:pt>
                <c:pt idx="12">
                  <c:v>5.9540889526542302E-2</c:v>
                </c:pt>
                <c:pt idx="13">
                  <c:v>7.1736011477761832E-2</c:v>
                </c:pt>
                <c:pt idx="14">
                  <c:v>6.81492109038737E-2</c:v>
                </c:pt>
                <c:pt idx="15">
                  <c:v>6.81492109038737E-2</c:v>
                </c:pt>
                <c:pt idx="16">
                  <c:v>6.81492109038737E-2</c:v>
                </c:pt>
                <c:pt idx="17">
                  <c:v>4.0172166427546598E-2</c:v>
                </c:pt>
                <c:pt idx="18">
                  <c:v>4.0172166427546598E-2</c:v>
                </c:pt>
                <c:pt idx="19">
                  <c:v>2.86944045911047E-2</c:v>
                </c:pt>
                <c:pt idx="20">
                  <c:v>1.8651362984218101E-2</c:v>
                </c:pt>
                <c:pt idx="21">
                  <c:v>9.3256814921090503E-3</c:v>
                </c:pt>
                <c:pt idx="22">
                  <c:v>7.8909612625538035E-3</c:v>
                </c:pt>
                <c:pt idx="23">
                  <c:v>8.6083213773314182E-3</c:v>
                </c:pt>
                <c:pt idx="24">
                  <c:v>4.30416068866571E-3</c:v>
                </c:pt>
                <c:pt idx="25">
                  <c:v>2.8694404591104701E-3</c:v>
                </c:pt>
                <c:pt idx="26">
                  <c:v>1.4347202295552401E-3</c:v>
                </c:pt>
                <c:pt idx="27">
                  <c:v>7.173601147776184E-4</c:v>
                </c:pt>
                <c:pt idx="28">
                  <c:v>0</c:v>
                </c:pt>
                <c:pt idx="29">
                  <c:v>7.173601147776184E-4</c:v>
                </c:pt>
                <c:pt idx="30">
                  <c:v>0</c:v>
                </c:pt>
              </c:numCache>
            </c:numRef>
          </c:val>
        </c:ser>
        <c:marker val="1"/>
        <c:axId val="162037120"/>
        <c:axId val="162071680"/>
      </c:lineChart>
      <c:catAx>
        <c:axId val="162037120"/>
        <c:scaling>
          <c:orientation val="minMax"/>
        </c:scaling>
        <c:axPos val="b"/>
        <c:numFmt formatCode="0.0_ " sourceLinked="1"/>
        <c:tickLblPos val="nextTo"/>
        <c:crossAx val="162071680"/>
        <c:crosses val="autoZero"/>
        <c:auto val="1"/>
        <c:lblAlgn val="ctr"/>
        <c:lblOffset val="100"/>
        <c:tickLblSkip val="5"/>
        <c:tickMarkSkip val="5"/>
      </c:catAx>
      <c:valAx>
        <c:axId val="162071680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2037120"/>
        <c:crosses val="autoZero"/>
        <c:crossBetween val="between"/>
      </c:valAx>
    </c:plotArea>
    <c:plotVisOnly val="1"/>
  </c:chart>
  <c:externalData r:id="rId1"/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49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1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49 A1_0.02_50%'!$B$104</c:f>
              <c:strCache>
                <c:ptCount val="1"/>
                <c:pt idx="0">
                  <c:v>unc-49_REX_A1_01</c:v>
                </c:pt>
              </c:strCache>
            </c:strRef>
          </c:tx>
          <c:marker>
            <c:symbol val="none"/>
          </c:marker>
          <c:cat>
            <c:numRef>
              <c:f>'unc-49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1_0.02_50%'!$B$105:$B$135</c:f>
              <c:numCache>
                <c:formatCode>General</c:formatCode>
                <c:ptCount val="31"/>
                <c:pt idx="1">
                  <c:v>0.10453762205628908</c:v>
                </c:pt>
                <c:pt idx="2">
                  <c:v>0.10568638713383099</c:v>
                </c:pt>
                <c:pt idx="3">
                  <c:v>8.3285468121769166E-2</c:v>
                </c:pt>
                <c:pt idx="4">
                  <c:v>7.0649052268811005E-2</c:v>
                </c:pt>
                <c:pt idx="5">
                  <c:v>3.8483630097645001E-2</c:v>
                </c:pt>
                <c:pt idx="6">
                  <c:v>3.9632395175186713E-2</c:v>
                </c:pt>
                <c:pt idx="7">
                  <c:v>3.15910396323952E-2</c:v>
                </c:pt>
                <c:pt idx="8">
                  <c:v>3.2739804709936801E-2</c:v>
                </c:pt>
                <c:pt idx="9">
                  <c:v>2.9293509477311915E-2</c:v>
                </c:pt>
                <c:pt idx="10">
                  <c:v>3.3888569787478499E-2</c:v>
                </c:pt>
                <c:pt idx="11">
                  <c:v>3.6186099942561702E-2</c:v>
                </c:pt>
                <c:pt idx="12">
                  <c:v>3.446295232624931E-2</c:v>
                </c:pt>
                <c:pt idx="13">
                  <c:v>3.2739804709936801E-2</c:v>
                </c:pt>
                <c:pt idx="14">
                  <c:v>2.4124066628374508E-2</c:v>
                </c:pt>
                <c:pt idx="15">
                  <c:v>2.1252153934520398E-2</c:v>
                </c:pt>
                <c:pt idx="16">
                  <c:v>2.3549684089603701E-2</c:v>
                </c:pt>
                <c:pt idx="17">
                  <c:v>1.5508328546812207E-2</c:v>
                </c:pt>
                <c:pt idx="18">
                  <c:v>1.43595634692705E-2</c:v>
                </c:pt>
                <c:pt idx="19">
                  <c:v>4.5950603101665719E-3</c:v>
                </c:pt>
                <c:pt idx="20">
                  <c:v>9.7645031591039669E-3</c:v>
                </c:pt>
                <c:pt idx="21">
                  <c:v>9.1901206203331403E-3</c:v>
                </c:pt>
                <c:pt idx="22">
                  <c:v>5.1694428489373898E-3</c:v>
                </c:pt>
                <c:pt idx="23">
                  <c:v>5.1694428489373898E-3</c:v>
                </c:pt>
                <c:pt idx="24">
                  <c:v>1.72314761631246E-3</c:v>
                </c:pt>
                <c:pt idx="25">
                  <c:v>1.72314761631246E-3</c:v>
                </c:pt>
                <c:pt idx="26">
                  <c:v>1.1487650775416404E-3</c:v>
                </c:pt>
                <c:pt idx="27">
                  <c:v>1.1487650775416404E-3</c:v>
                </c:pt>
                <c:pt idx="28">
                  <c:v>0</c:v>
                </c:pt>
                <c:pt idx="29">
                  <c:v>5.7438253877082127E-4</c:v>
                </c:pt>
                <c:pt idx="30">
                  <c:v>0</c:v>
                </c:pt>
              </c:numCache>
            </c:numRef>
          </c:val>
        </c:ser>
        <c:ser>
          <c:idx val="1"/>
          <c:order val="1"/>
          <c:tx>
            <c:strRef>
              <c:f>'unc-49 A1_0.02_50%'!$C$104</c:f>
              <c:strCache>
                <c:ptCount val="1"/>
                <c:pt idx="0">
                  <c:v>unc-49_REX_A1_02</c:v>
                </c:pt>
              </c:strCache>
            </c:strRef>
          </c:tx>
          <c:marker>
            <c:symbol val="none"/>
          </c:marker>
          <c:cat>
            <c:numRef>
              <c:f>'unc-49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1_0.02_50%'!$C$105:$C$135</c:f>
              <c:numCache>
                <c:formatCode>General</c:formatCode>
                <c:ptCount val="31"/>
                <c:pt idx="1">
                  <c:v>7.5989445910290193E-2</c:v>
                </c:pt>
                <c:pt idx="2">
                  <c:v>8.2321899736147827E-2</c:v>
                </c:pt>
                <c:pt idx="3">
                  <c:v>6.8601583113456502E-2</c:v>
                </c:pt>
                <c:pt idx="4">
                  <c:v>6.332453825857523E-2</c:v>
                </c:pt>
                <c:pt idx="5">
                  <c:v>7.0712401055409047E-2</c:v>
                </c:pt>
                <c:pt idx="6">
                  <c:v>4.5910290237467018E-2</c:v>
                </c:pt>
                <c:pt idx="7">
                  <c:v>4.9604221635883919E-2</c:v>
                </c:pt>
                <c:pt idx="8">
                  <c:v>4.5382585751978913E-2</c:v>
                </c:pt>
                <c:pt idx="9">
                  <c:v>5.2770448548812701E-2</c:v>
                </c:pt>
                <c:pt idx="10">
                  <c:v>4.6965699208443325E-2</c:v>
                </c:pt>
                <c:pt idx="11">
                  <c:v>4.4854881266490801E-2</c:v>
                </c:pt>
                <c:pt idx="12">
                  <c:v>4.9076517150395821E-2</c:v>
                </c:pt>
                <c:pt idx="13">
                  <c:v>4.01055408970976E-2</c:v>
                </c:pt>
                <c:pt idx="14">
                  <c:v>2.9023746701847E-2</c:v>
                </c:pt>
                <c:pt idx="15">
                  <c:v>2.7968337730870714E-2</c:v>
                </c:pt>
                <c:pt idx="16">
                  <c:v>2.1635883905013215E-2</c:v>
                </c:pt>
                <c:pt idx="17">
                  <c:v>1.4775725593667506E-2</c:v>
                </c:pt>
                <c:pt idx="18">
                  <c:v>1.5303430079155701E-2</c:v>
                </c:pt>
                <c:pt idx="19">
                  <c:v>1.2137203166226894E-2</c:v>
                </c:pt>
                <c:pt idx="20">
                  <c:v>1.2664907651714999E-2</c:v>
                </c:pt>
                <c:pt idx="21">
                  <c:v>6.8601583113456514E-3</c:v>
                </c:pt>
                <c:pt idx="22">
                  <c:v>6.8601583113456514E-3</c:v>
                </c:pt>
                <c:pt idx="23">
                  <c:v>2.1108179419525117E-3</c:v>
                </c:pt>
                <c:pt idx="24">
                  <c:v>3.6939313984168921E-3</c:v>
                </c:pt>
                <c:pt idx="25">
                  <c:v>1.0554089709762509E-3</c:v>
                </c:pt>
                <c:pt idx="26">
                  <c:v>1.0554089709762509E-3</c:v>
                </c:pt>
                <c:pt idx="27">
                  <c:v>1.5831134564643801E-3</c:v>
                </c:pt>
                <c:pt idx="28">
                  <c:v>2.1108179419525117E-3</c:v>
                </c:pt>
                <c:pt idx="29">
                  <c:v>5.2770448548812717E-4</c:v>
                </c:pt>
                <c:pt idx="30">
                  <c:v>1.0554089709762509E-3</c:v>
                </c:pt>
              </c:numCache>
            </c:numRef>
          </c:val>
        </c:ser>
        <c:ser>
          <c:idx val="2"/>
          <c:order val="2"/>
          <c:tx>
            <c:strRef>
              <c:f>'unc-49 A1_0.02_50%'!$D$104</c:f>
              <c:strCache>
                <c:ptCount val="1"/>
                <c:pt idx="0">
                  <c:v>unc-49_REX_A1_03</c:v>
                </c:pt>
              </c:strCache>
            </c:strRef>
          </c:tx>
          <c:marker>
            <c:symbol val="none"/>
          </c:marker>
          <c:cat>
            <c:numRef>
              <c:f>'unc-49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1_0.02_50%'!$D$105:$D$135</c:f>
              <c:numCache>
                <c:formatCode>General</c:formatCode>
                <c:ptCount val="31"/>
                <c:pt idx="1">
                  <c:v>7.4979287489643734E-2</c:v>
                </c:pt>
                <c:pt idx="2">
                  <c:v>8.7821043910522034E-2</c:v>
                </c:pt>
                <c:pt idx="3">
                  <c:v>7.9121789560894801E-2</c:v>
                </c:pt>
                <c:pt idx="4">
                  <c:v>8.1607290803645427E-2</c:v>
                </c:pt>
                <c:pt idx="5">
                  <c:v>7.0836785418392723E-2</c:v>
                </c:pt>
                <c:pt idx="6">
                  <c:v>7.0422535211267595E-2</c:v>
                </c:pt>
                <c:pt idx="7">
                  <c:v>5.8409279204639598E-2</c:v>
                </c:pt>
                <c:pt idx="8">
                  <c:v>5.9237779618889798E-2</c:v>
                </c:pt>
                <c:pt idx="9">
                  <c:v>6.4208782104391099E-2</c:v>
                </c:pt>
                <c:pt idx="10">
                  <c:v>6.2551781275890603E-2</c:v>
                </c:pt>
                <c:pt idx="11">
                  <c:v>4.2667771333885718E-2</c:v>
                </c:pt>
                <c:pt idx="12">
                  <c:v>3.0240265120132601E-2</c:v>
                </c:pt>
                <c:pt idx="13">
                  <c:v>3.1897265948633013E-2</c:v>
                </c:pt>
                <c:pt idx="14">
                  <c:v>2.2783761391880701E-2</c:v>
                </c:pt>
                <c:pt idx="15">
                  <c:v>1.90555095277548E-2</c:v>
                </c:pt>
                <c:pt idx="16">
                  <c:v>1.2427506213753105E-2</c:v>
                </c:pt>
                <c:pt idx="17">
                  <c:v>1.1184755592377806E-2</c:v>
                </c:pt>
                <c:pt idx="18">
                  <c:v>9.1135045567522881E-3</c:v>
                </c:pt>
                <c:pt idx="19">
                  <c:v>4.5567522783761414E-3</c:v>
                </c:pt>
                <c:pt idx="20">
                  <c:v>7.0422535211267625E-3</c:v>
                </c:pt>
                <c:pt idx="21">
                  <c:v>3.3140016570008309E-3</c:v>
                </c:pt>
                <c:pt idx="22">
                  <c:v>2.07125103562552E-3</c:v>
                </c:pt>
                <c:pt idx="23">
                  <c:v>2.4855012427506219E-3</c:v>
                </c:pt>
                <c:pt idx="24">
                  <c:v>1.6570008285004105E-3</c:v>
                </c:pt>
                <c:pt idx="25">
                  <c:v>2.07125103562552E-3</c:v>
                </c:pt>
                <c:pt idx="26">
                  <c:v>8.2850041425020751E-4</c:v>
                </c:pt>
                <c:pt idx="27">
                  <c:v>4.1425020712510403E-4</c:v>
                </c:pt>
                <c:pt idx="28">
                  <c:v>8.2850041425020751E-4</c:v>
                </c:pt>
                <c:pt idx="29">
                  <c:v>4.1425020712510403E-4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unc-49 A1_0.02_50%'!$E$104</c:f>
              <c:strCache>
                <c:ptCount val="1"/>
                <c:pt idx="0">
                  <c:v>unc-49_REX_A1_04</c:v>
                </c:pt>
              </c:strCache>
            </c:strRef>
          </c:tx>
          <c:marker>
            <c:symbol val="none"/>
          </c:marker>
          <c:cat>
            <c:numRef>
              <c:f>'unc-49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1_0.02_50%'!$E$105:$E$135</c:f>
              <c:numCache>
                <c:formatCode>General</c:formatCode>
                <c:ptCount val="31"/>
                <c:pt idx="1">
                  <c:v>0.11147236414305597</c:v>
                </c:pt>
                <c:pt idx="2">
                  <c:v>9.4287041337668395E-2</c:v>
                </c:pt>
                <c:pt idx="3">
                  <c:v>8.2210868555504024E-2</c:v>
                </c:pt>
                <c:pt idx="4">
                  <c:v>6.9670227589410119E-2</c:v>
                </c:pt>
                <c:pt idx="5">
                  <c:v>5.6665118439386895E-2</c:v>
                </c:pt>
                <c:pt idx="6">
                  <c:v>4.6446818392940084E-2</c:v>
                </c:pt>
                <c:pt idx="7">
                  <c:v>3.6228518346493301E-2</c:v>
                </c:pt>
                <c:pt idx="8">
                  <c:v>4.9233627496516531E-2</c:v>
                </c:pt>
                <c:pt idx="9">
                  <c:v>4.2731072921504902E-2</c:v>
                </c:pt>
                <c:pt idx="10">
                  <c:v>4.2266604737575521E-2</c:v>
                </c:pt>
                <c:pt idx="11">
                  <c:v>3.6228518346493301E-2</c:v>
                </c:pt>
                <c:pt idx="12">
                  <c:v>2.6939154667905207E-2</c:v>
                </c:pt>
                <c:pt idx="13">
                  <c:v>1.8114259173246602E-2</c:v>
                </c:pt>
                <c:pt idx="14">
                  <c:v>1.8578727357176E-2</c:v>
                </c:pt>
                <c:pt idx="15">
                  <c:v>1.3469577333952607E-2</c:v>
                </c:pt>
                <c:pt idx="16">
                  <c:v>1.0682768230376201E-2</c:v>
                </c:pt>
                <c:pt idx="17">
                  <c:v>6.0380863910822116E-3</c:v>
                </c:pt>
                <c:pt idx="18">
                  <c:v>6.9670227589410114E-3</c:v>
                </c:pt>
                <c:pt idx="19">
                  <c:v>5.10915002322341E-3</c:v>
                </c:pt>
                <c:pt idx="20">
                  <c:v>3.7157454714352102E-3</c:v>
                </c:pt>
                <c:pt idx="21">
                  <c:v>3.7157454714352102E-3</c:v>
                </c:pt>
                <c:pt idx="22">
                  <c:v>4.6446818392940101E-4</c:v>
                </c:pt>
                <c:pt idx="23">
                  <c:v>2.7868091035764099E-3</c:v>
                </c:pt>
                <c:pt idx="24">
                  <c:v>1.8578727357176006E-3</c:v>
                </c:pt>
                <c:pt idx="25">
                  <c:v>4.6446818392940101E-4</c:v>
                </c:pt>
                <c:pt idx="26">
                  <c:v>4.6446818392940101E-4</c:v>
                </c:pt>
                <c:pt idx="27">
                  <c:v>4.6446818392940101E-4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unc-49 A1_0.02_50%'!$F$104</c:f>
              <c:strCache>
                <c:ptCount val="1"/>
                <c:pt idx="0">
                  <c:v>unc-49_REX_A1_05</c:v>
                </c:pt>
              </c:strCache>
            </c:strRef>
          </c:tx>
          <c:marker>
            <c:symbol val="none"/>
          </c:marker>
          <c:cat>
            <c:numRef>
              <c:f>'unc-49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1_0.02_50%'!$F$105:$F$135</c:f>
              <c:numCache>
                <c:formatCode>General</c:formatCode>
                <c:ptCount val="31"/>
                <c:pt idx="1">
                  <c:v>6.5206051121544109E-2</c:v>
                </c:pt>
                <c:pt idx="2">
                  <c:v>6.4684402712571712E-2</c:v>
                </c:pt>
                <c:pt idx="3">
                  <c:v>7.3030777256129428E-2</c:v>
                </c:pt>
                <c:pt idx="4">
                  <c:v>6.3119457485654701E-2</c:v>
                </c:pt>
                <c:pt idx="5">
                  <c:v>5.9467918622848233E-2</c:v>
                </c:pt>
                <c:pt idx="6">
                  <c:v>4.7470005216484083E-2</c:v>
                </c:pt>
                <c:pt idx="7">
                  <c:v>4.17318727177882E-2</c:v>
                </c:pt>
                <c:pt idx="8">
                  <c:v>4.2775169535732897E-2</c:v>
                </c:pt>
                <c:pt idx="9">
                  <c:v>4.9034950443401226E-2</c:v>
                </c:pt>
                <c:pt idx="10">
                  <c:v>4.69483568075117E-2</c:v>
                </c:pt>
                <c:pt idx="11">
                  <c:v>5.3729786124152301E-2</c:v>
                </c:pt>
                <c:pt idx="12">
                  <c:v>4.3296817944705336E-2</c:v>
                </c:pt>
                <c:pt idx="13">
                  <c:v>4.64267083985394E-2</c:v>
                </c:pt>
                <c:pt idx="14">
                  <c:v>3.7037037037037014E-2</c:v>
                </c:pt>
                <c:pt idx="15">
                  <c:v>3.0255607720396517E-2</c:v>
                </c:pt>
                <c:pt idx="16">
                  <c:v>2.3474178403755909E-2</c:v>
                </c:pt>
                <c:pt idx="17">
                  <c:v>2.55607720396453E-2</c:v>
                </c:pt>
                <c:pt idx="18">
                  <c:v>2.1909233176838801E-2</c:v>
                </c:pt>
                <c:pt idx="19">
                  <c:v>1.30412102243088E-2</c:v>
                </c:pt>
                <c:pt idx="20">
                  <c:v>1.1997913406364099E-2</c:v>
                </c:pt>
                <c:pt idx="21">
                  <c:v>1.5127803860198201E-2</c:v>
                </c:pt>
                <c:pt idx="22">
                  <c:v>7.8247261345852897E-3</c:v>
                </c:pt>
                <c:pt idx="23">
                  <c:v>3.6515388628064727E-3</c:v>
                </c:pt>
                <c:pt idx="24">
                  <c:v>5.7381324986958823E-3</c:v>
                </c:pt>
                <c:pt idx="25">
                  <c:v>3.1298904538341202E-3</c:v>
                </c:pt>
                <c:pt idx="26">
                  <c:v>1.5649452269170605E-3</c:v>
                </c:pt>
                <c:pt idx="27">
                  <c:v>2.0865936358894109E-3</c:v>
                </c:pt>
                <c:pt idx="28">
                  <c:v>1.04329681794471E-3</c:v>
                </c:pt>
                <c:pt idx="29">
                  <c:v>1.04329681794471E-3</c:v>
                </c:pt>
                <c:pt idx="30">
                  <c:v>5.2164840897235337E-4</c:v>
                </c:pt>
              </c:numCache>
            </c:numRef>
          </c:val>
        </c:ser>
        <c:ser>
          <c:idx val="5"/>
          <c:order val="5"/>
          <c:tx>
            <c:strRef>
              <c:f>'unc-49 A1_0.02_50%'!$G$104</c:f>
              <c:strCache>
                <c:ptCount val="1"/>
                <c:pt idx="0">
                  <c:v>unc-49_REX_A1_06</c:v>
                </c:pt>
              </c:strCache>
            </c:strRef>
          </c:tx>
          <c:marker>
            <c:symbol val="none"/>
          </c:marker>
          <c:cat>
            <c:numRef>
              <c:f>'unc-49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1_0.02_50%'!$G$105:$G$135</c:f>
              <c:numCache>
                <c:formatCode>General</c:formatCode>
                <c:ptCount val="31"/>
                <c:pt idx="1">
                  <c:v>8.1462475946119328E-2</c:v>
                </c:pt>
                <c:pt idx="2">
                  <c:v>7.4406670942912145E-2</c:v>
                </c:pt>
                <c:pt idx="3">
                  <c:v>8.3386786401539389E-2</c:v>
                </c:pt>
                <c:pt idx="4">
                  <c:v>6.4143681847338041E-2</c:v>
                </c:pt>
                <c:pt idx="5">
                  <c:v>5.83707504810776E-2</c:v>
                </c:pt>
                <c:pt idx="6">
                  <c:v>4.7466324567030121E-2</c:v>
                </c:pt>
                <c:pt idx="7">
                  <c:v>4.6183450930083414E-2</c:v>
                </c:pt>
                <c:pt idx="8">
                  <c:v>4.3617703656189895E-2</c:v>
                </c:pt>
                <c:pt idx="9">
                  <c:v>4.6824887748556802E-2</c:v>
                </c:pt>
                <c:pt idx="10">
                  <c:v>5.2597819114817222E-2</c:v>
                </c:pt>
                <c:pt idx="11">
                  <c:v>5.1314945477870397E-2</c:v>
                </c:pt>
                <c:pt idx="12">
                  <c:v>3.9769082745349599E-2</c:v>
                </c:pt>
                <c:pt idx="13">
                  <c:v>3.0788967286722313E-2</c:v>
                </c:pt>
                <c:pt idx="14">
                  <c:v>2.8864656831302082E-2</c:v>
                </c:pt>
                <c:pt idx="15">
                  <c:v>2.1167415009621601E-2</c:v>
                </c:pt>
                <c:pt idx="16">
                  <c:v>1.79602309172547E-2</c:v>
                </c:pt>
                <c:pt idx="17">
                  <c:v>1.7318794098781301E-2</c:v>
                </c:pt>
                <c:pt idx="18">
                  <c:v>1.2187299550994193E-2</c:v>
                </c:pt>
                <c:pt idx="19">
                  <c:v>7.055805003207182E-3</c:v>
                </c:pt>
                <c:pt idx="20">
                  <c:v>1.0262989095574101E-2</c:v>
                </c:pt>
                <c:pt idx="21">
                  <c:v>7.6972418216805626E-3</c:v>
                </c:pt>
                <c:pt idx="22">
                  <c:v>5.13149454778704E-3</c:v>
                </c:pt>
                <c:pt idx="23">
                  <c:v>5.13149454778704E-3</c:v>
                </c:pt>
                <c:pt idx="24">
                  <c:v>1.9243104554201407E-3</c:v>
                </c:pt>
                <c:pt idx="25">
                  <c:v>1.9243104554201407E-3</c:v>
                </c:pt>
                <c:pt idx="26">
                  <c:v>1.2828736369467609E-3</c:v>
                </c:pt>
                <c:pt idx="27">
                  <c:v>6.4143681847338065E-4</c:v>
                </c:pt>
                <c:pt idx="28">
                  <c:v>0</c:v>
                </c:pt>
                <c:pt idx="29">
                  <c:v>3.2071840923669024E-3</c:v>
                </c:pt>
                <c:pt idx="30">
                  <c:v>6.4143681847338065E-4</c:v>
                </c:pt>
              </c:numCache>
            </c:numRef>
          </c:val>
        </c:ser>
        <c:ser>
          <c:idx val="6"/>
          <c:order val="6"/>
          <c:tx>
            <c:strRef>
              <c:f>'unc-49 A1_0.02_50%'!$H$104</c:f>
              <c:strCache>
                <c:ptCount val="1"/>
                <c:pt idx="0">
                  <c:v>unc-49_REX_A1_07</c:v>
                </c:pt>
              </c:strCache>
            </c:strRef>
          </c:tx>
          <c:marker>
            <c:symbol val="none"/>
          </c:marker>
          <c:cat>
            <c:numRef>
              <c:f>'unc-49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1_0.02_50%'!$H$105:$H$135</c:f>
              <c:numCache>
                <c:formatCode>General</c:formatCode>
                <c:ptCount val="31"/>
                <c:pt idx="1">
                  <c:v>6.9948186528497394E-2</c:v>
                </c:pt>
                <c:pt idx="2">
                  <c:v>6.6062176165803094E-2</c:v>
                </c:pt>
                <c:pt idx="3">
                  <c:v>6.5414507772020694E-2</c:v>
                </c:pt>
                <c:pt idx="4">
                  <c:v>4.9222797927461127E-2</c:v>
                </c:pt>
                <c:pt idx="5">
                  <c:v>4.6632124352331626E-2</c:v>
                </c:pt>
                <c:pt idx="6">
                  <c:v>4.2098445595854884E-2</c:v>
                </c:pt>
                <c:pt idx="7">
                  <c:v>3.6269430051813517E-2</c:v>
                </c:pt>
                <c:pt idx="8">
                  <c:v>2.3963730569948199E-2</c:v>
                </c:pt>
                <c:pt idx="9">
                  <c:v>2.9145077720207309E-2</c:v>
                </c:pt>
                <c:pt idx="10">
                  <c:v>2.3963730569948199E-2</c:v>
                </c:pt>
                <c:pt idx="11">
                  <c:v>3.8212435233160598E-2</c:v>
                </c:pt>
                <c:pt idx="12">
                  <c:v>3.7564766839378198E-2</c:v>
                </c:pt>
                <c:pt idx="13">
                  <c:v>3.6269430051813517E-2</c:v>
                </c:pt>
                <c:pt idx="14">
                  <c:v>3.4974093264248697E-2</c:v>
                </c:pt>
                <c:pt idx="15">
                  <c:v>2.9145077720207309E-2</c:v>
                </c:pt>
                <c:pt idx="16">
                  <c:v>3.3031088082901602E-2</c:v>
                </c:pt>
                <c:pt idx="17">
                  <c:v>3.3678756476683898E-2</c:v>
                </c:pt>
                <c:pt idx="18">
                  <c:v>2.3316062176165799E-2</c:v>
                </c:pt>
                <c:pt idx="19">
                  <c:v>2.0725388601036301E-2</c:v>
                </c:pt>
                <c:pt idx="20">
                  <c:v>2.2020725388601E-2</c:v>
                </c:pt>
                <c:pt idx="21">
                  <c:v>2.0077720207253905E-2</c:v>
                </c:pt>
                <c:pt idx="22">
                  <c:v>1.3601036269430109E-2</c:v>
                </c:pt>
                <c:pt idx="23">
                  <c:v>1.4896373056994795E-2</c:v>
                </c:pt>
                <c:pt idx="24">
                  <c:v>1.0362694300518104E-2</c:v>
                </c:pt>
                <c:pt idx="25">
                  <c:v>6.4766839378238355E-3</c:v>
                </c:pt>
                <c:pt idx="26">
                  <c:v>7.7720207253886052E-3</c:v>
                </c:pt>
                <c:pt idx="27">
                  <c:v>2.5906735751295299E-3</c:v>
                </c:pt>
                <c:pt idx="28">
                  <c:v>4.5336787564766818E-3</c:v>
                </c:pt>
                <c:pt idx="29">
                  <c:v>3.8860103626943017E-3</c:v>
                </c:pt>
                <c:pt idx="30">
                  <c:v>6.4766839378238355E-4</c:v>
                </c:pt>
              </c:numCache>
            </c:numRef>
          </c:val>
        </c:ser>
        <c:ser>
          <c:idx val="7"/>
          <c:order val="7"/>
          <c:tx>
            <c:strRef>
              <c:f>'unc-49 A1_0.02_50%'!$I$104</c:f>
              <c:strCache>
                <c:ptCount val="1"/>
                <c:pt idx="0">
                  <c:v>unc-49_REX_A1_08</c:v>
                </c:pt>
              </c:strCache>
            </c:strRef>
          </c:tx>
          <c:marker>
            <c:symbol val="none"/>
          </c:marker>
          <c:cat>
            <c:numRef>
              <c:f>'unc-49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1_0.02_50%'!$I$105:$I$135</c:f>
              <c:numCache>
                <c:formatCode>General</c:formatCode>
                <c:ptCount val="31"/>
                <c:pt idx="1">
                  <c:v>7.7581863979848911E-2</c:v>
                </c:pt>
                <c:pt idx="2">
                  <c:v>7.0528967254408104E-2</c:v>
                </c:pt>
                <c:pt idx="3">
                  <c:v>6.8010075566750566E-2</c:v>
                </c:pt>
                <c:pt idx="4">
                  <c:v>7.5566750629722901E-2</c:v>
                </c:pt>
                <c:pt idx="5">
                  <c:v>6.4987405541561724E-2</c:v>
                </c:pt>
                <c:pt idx="6">
                  <c:v>5.5919395465994989E-2</c:v>
                </c:pt>
                <c:pt idx="7">
                  <c:v>5.94458438287154E-2</c:v>
                </c:pt>
                <c:pt idx="8">
                  <c:v>5.1385390428211629E-2</c:v>
                </c:pt>
                <c:pt idx="9">
                  <c:v>6.2972292191435825E-2</c:v>
                </c:pt>
                <c:pt idx="10">
                  <c:v>5.8438287153652416E-2</c:v>
                </c:pt>
                <c:pt idx="11">
                  <c:v>5.1385390428211629E-2</c:v>
                </c:pt>
                <c:pt idx="12">
                  <c:v>4.1309823677581882E-2</c:v>
                </c:pt>
                <c:pt idx="13">
                  <c:v>3.5264483627204003E-2</c:v>
                </c:pt>
                <c:pt idx="14">
                  <c:v>2.5692695214105801E-2</c:v>
                </c:pt>
                <c:pt idx="15">
                  <c:v>2.0151133501259407E-2</c:v>
                </c:pt>
                <c:pt idx="16">
                  <c:v>2.1158690176322398E-2</c:v>
                </c:pt>
                <c:pt idx="17">
                  <c:v>1.4105793450881598E-2</c:v>
                </c:pt>
                <c:pt idx="18">
                  <c:v>1.4105793450881598E-2</c:v>
                </c:pt>
                <c:pt idx="19">
                  <c:v>1.3602015113350106E-2</c:v>
                </c:pt>
                <c:pt idx="20">
                  <c:v>8.0604534005037833E-3</c:v>
                </c:pt>
                <c:pt idx="21">
                  <c:v>6.5491183879093223E-3</c:v>
                </c:pt>
                <c:pt idx="22">
                  <c:v>4.0302267002518934E-3</c:v>
                </c:pt>
                <c:pt idx="23">
                  <c:v>2.0151133501259411E-3</c:v>
                </c:pt>
                <c:pt idx="24">
                  <c:v>2.0151133501259411E-3</c:v>
                </c:pt>
                <c:pt idx="25">
                  <c:v>5.0377833753148635E-4</c:v>
                </c:pt>
                <c:pt idx="26">
                  <c:v>0</c:v>
                </c:pt>
                <c:pt idx="27">
                  <c:v>1.5113350125944599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8"/>
          <c:order val="8"/>
          <c:tx>
            <c:strRef>
              <c:f>'unc-49 A1_0.02_50%'!$J$104</c:f>
              <c:strCache>
                <c:ptCount val="1"/>
                <c:pt idx="0">
                  <c:v>unc-49_REX_A1_09</c:v>
                </c:pt>
              </c:strCache>
            </c:strRef>
          </c:tx>
          <c:marker>
            <c:symbol val="none"/>
          </c:marker>
          <c:cat>
            <c:numRef>
              <c:f>'unc-49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1_0.02_50%'!$J$105:$J$135</c:f>
              <c:numCache>
                <c:formatCode>General</c:formatCode>
                <c:ptCount val="31"/>
                <c:pt idx="1">
                  <c:v>7.8493647912885753E-2</c:v>
                </c:pt>
                <c:pt idx="2">
                  <c:v>7.8947368421052572E-2</c:v>
                </c:pt>
                <c:pt idx="3">
                  <c:v>7.2595281306715123E-2</c:v>
                </c:pt>
                <c:pt idx="4">
                  <c:v>7.0326678765880196E-2</c:v>
                </c:pt>
                <c:pt idx="5">
                  <c:v>5.3992740471869298E-2</c:v>
                </c:pt>
                <c:pt idx="6">
                  <c:v>4.4464609800363028E-2</c:v>
                </c:pt>
                <c:pt idx="7">
                  <c:v>4.3103448275862079E-2</c:v>
                </c:pt>
                <c:pt idx="8">
                  <c:v>4.1742286751361199E-2</c:v>
                </c:pt>
                <c:pt idx="9">
                  <c:v>5.7622504537205112E-2</c:v>
                </c:pt>
                <c:pt idx="10">
                  <c:v>5.8529945553538985E-2</c:v>
                </c:pt>
                <c:pt idx="11">
                  <c:v>5.4900181488203317E-2</c:v>
                </c:pt>
                <c:pt idx="12">
                  <c:v>4.8548094373865695E-2</c:v>
                </c:pt>
                <c:pt idx="13">
                  <c:v>3.8566243194192398E-2</c:v>
                </c:pt>
                <c:pt idx="14">
                  <c:v>3.9927404718693299E-2</c:v>
                </c:pt>
                <c:pt idx="15">
                  <c:v>2.2232304900181507E-2</c:v>
                </c:pt>
                <c:pt idx="16">
                  <c:v>1.5880217785843899E-2</c:v>
                </c:pt>
                <c:pt idx="17">
                  <c:v>1.0435571687840305E-2</c:v>
                </c:pt>
                <c:pt idx="18">
                  <c:v>1.4972776769510003E-2</c:v>
                </c:pt>
                <c:pt idx="19">
                  <c:v>7.259528130671513E-3</c:v>
                </c:pt>
                <c:pt idx="20">
                  <c:v>4.9909255898366598E-3</c:v>
                </c:pt>
                <c:pt idx="21">
                  <c:v>3.1760435571687802E-3</c:v>
                </c:pt>
                <c:pt idx="22">
                  <c:v>2.2686025408348511E-3</c:v>
                </c:pt>
                <c:pt idx="23">
                  <c:v>9.0744101633393837E-4</c:v>
                </c:pt>
                <c:pt idx="24">
                  <c:v>4.5372050816696935E-4</c:v>
                </c:pt>
                <c:pt idx="25">
                  <c:v>4.5372050816696935E-4</c:v>
                </c:pt>
                <c:pt idx="26">
                  <c:v>0</c:v>
                </c:pt>
                <c:pt idx="27">
                  <c:v>4.5372050816696935E-4</c:v>
                </c:pt>
                <c:pt idx="28">
                  <c:v>0</c:v>
                </c:pt>
                <c:pt idx="29">
                  <c:v>4.5372050816696935E-4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unc-49 A1_0.02_50%'!$K$104</c:f>
              <c:strCache>
                <c:ptCount val="1"/>
                <c:pt idx="0">
                  <c:v>unc-49_REX_A1_10</c:v>
                </c:pt>
              </c:strCache>
            </c:strRef>
          </c:tx>
          <c:marker>
            <c:symbol val="none"/>
          </c:marker>
          <c:cat>
            <c:numRef>
              <c:f>'unc-49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1_0.02_50%'!$K$105:$K$135</c:f>
              <c:numCache>
                <c:formatCode>General</c:formatCode>
                <c:ptCount val="31"/>
                <c:pt idx="1">
                  <c:v>9.5106186518928881E-2</c:v>
                </c:pt>
                <c:pt idx="2">
                  <c:v>9.8337950138504229E-2</c:v>
                </c:pt>
                <c:pt idx="3">
                  <c:v>7.7562326869806131E-2</c:v>
                </c:pt>
                <c:pt idx="4">
                  <c:v>6.8328716528162498E-2</c:v>
                </c:pt>
                <c:pt idx="5">
                  <c:v>5.30932594644506E-2</c:v>
                </c:pt>
                <c:pt idx="6">
                  <c:v>3.6011080332410003E-2</c:v>
                </c:pt>
                <c:pt idx="7">
                  <c:v>3.8781163434903017E-2</c:v>
                </c:pt>
                <c:pt idx="8">
                  <c:v>3.047091412742382E-2</c:v>
                </c:pt>
                <c:pt idx="9">
                  <c:v>3.5087719298245605E-2</c:v>
                </c:pt>
                <c:pt idx="10">
                  <c:v>3.6472760849492206E-2</c:v>
                </c:pt>
                <c:pt idx="11">
                  <c:v>2.7239150507848611E-2</c:v>
                </c:pt>
                <c:pt idx="12">
                  <c:v>3.0932594644505998E-2</c:v>
                </c:pt>
                <c:pt idx="13">
                  <c:v>2.3084025854109E-2</c:v>
                </c:pt>
                <c:pt idx="14">
                  <c:v>2.5392428439519901E-2</c:v>
                </c:pt>
                <c:pt idx="15">
                  <c:v>2.2622345337026808E-2</c:v>
                </c:pt>
                <c:pt idx="16">
                  <c:v>2.0313942751615913E-2</c:v>
                </c:pt>
                <c:pt idx="17">
                  <c:v>1.06186518928901E-2</c:v>
                </c:pt>
                <c:pt idx="18">
                  <c:v>1.5697137580794097E-2</c:v>
                </c:pt>
                <c:pt idx="19">
                  <c:v>1.1080332409972301E-2</c:v>
                </c:pt>
                <c:pt idx="20">
                  <c:v>9.233610341643576E-3</c:v>
                </c:pt>
                <c:pt idx="21">
                  <c:v>5.0784856879039714E-3</c:v>
                </c:pt>
                <c:pt idx="22">
                  <c:v>6.4635272391505103E-3</c:v>
                </c:pt>
                <c:pt idx="23">
                  <c:v>1.8467220683287212E-3</c:v>
                </c:pt>
                <c:pt idx="24">
                  <c:v>3.6934441366574312E-3</c:v>
                </c:pt>
                <c:pt idx="25">
                  <c:v>3.2317636195752508E-3</c:v>
                </c:pt>
                <c:pt idx="26">
                  <c:v>1.8467220683287212E-3</c:v>
                </c:pt>
                <c:pt idx="27">
                  <c:v>4.6168051708217901E-4</c:v>
                </c:pt>
                <c:pt idx="28">
                  <c:v>2.3084025854109001E-3</c:v>
                </c:pt>
                <c:pt idx="29">
                  <c:v>9.2336103416435801E-4</c:v>
                </c:pt>
                <c:pt idx="30">
                  <c:v>0</c:v>
                </c:pt>
              </c:numCache>
            </c:numRef>
          </c:val>
        </c:ser>
        <c:marker val="1"/>
        <c:axId val="166619392"/>
        <c:axId val="166633472"/>
      </c:lineChart>
      <c:catAx>
        <c:axId val="166619392"/>
        <c:scaling>
          <c:orientation val="minMax"/>
        </c:scaling>
        <c:axPos val="b"/>
        <c:numFmt formatCode="0.0_ " sourceLinked="1"/>
        <c:tickLblPos val="nextTo"/>
        <c:crossAx val="166633472"/>
        <c:crosses val="autoZero"/>
        <c:auto val="1"/>
        <c:lblAlgn val="ctr"/>
        <c:lblOffset val="100"/>
        <c:tickLblSkip val="5"/>
        <c:tickMarkSkip val="5"/>
      </c:catAx>
      <c:valAx>
        <c:axId val="166633472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6619392"/>
        <c:crosses val="autoZero"/>
        <c:crossBetween val="between"/>
      </c:valAx>
    </c:plotArea>
    <c:plotVisOnly val="1"/>
  </c:chart>
  <c:externalData r:id="rId1"/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49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5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49 A5_0.02_50%'!$B$104</c:f>
              <c:strCache>
                <c:ptCount val="1"/>
                <c:pt idx="0">
                  <c:v>unc-49_A5_40_30_03</c:v>
                </c:pt>
              </c:strCache>
            </c:strRef>
          </c:tx>
          <c:marker>
            <c:symbol val="none"/>
          </c:marker>
          <c:cat>
            <c:numRef>
              <c:f>'unc-49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5_0.02_50%'!$B$105:$B$135</c:f>
              <c:numCache>
                <c:formatCode>General</c:formatCode>
                <c:ptCount val="31"/>
                <c:pt idx="1">
                  <c:v>0.13501646542261306</c:v>
                </c:pt>
                <c:pt idx="2">
                  <c:v>0.117453347969265</c:v>
                </c:pt>
                <c:pt idx="3">
                  <c:v>6.6959385290889073E-2</c:v>
                </c:pt>
                <c:pt idx="4">
                  <c:v>3.6223929747530199E-2</c:v>
                </c:pt>
                <c:pt idx="5">
                  <c:v>3.2930845225027421E-2</c:v>
                </c:pt>
                <c:pt idx="6">
                  <c:v>1.9758507135016506E-2</c:v>
                </c:pt>
                <c:pt idx="7">
                  <c:v>1.3172338090011001E-2</c:v>
                </c:pt>
                <c:pt idx="8">
                  <c:v>1.9758507135016506E-2</c:v>
                </c:pt>
                <c:pt idx="9">
                  <c:v>1.4270032930845198E-2</c:v>
                </c:pt>
                <c:pt idx="10">
                  <c:v>1.20746432491767E-2</c:v>
                </c:pt>
                <c:pt idx="11">
                  <c:v>2.0856201975850707E-2</c:v>
                </c:pt>
                <c:pt idx="12">
                  <c:v>1.3172338090011001E-2</c:v>
                </c:pt>
                <c:pt idx="13">
                  <c:v>1.7563117453348001E-2</c:v>
                </c:pt>
                <c:pt idx="14">
                  <c:v>1.6465422612513707E-2</c:v>
                </c:pt>
                <c:pt idx="15">
                  <c:v>1.0976948408342499E-2</c:v>
                </c:pt>
                <c:pt idx="16">
                  <c:v>6.5861690450054917E-3</c:v>
                </c:pt>
                <c:pt idx="17">
                  <c:v>6.5861690450054917E-3</c:v>
                </c:pt>
                <c:pt idx="18">
                  <c:v>1.3172338090011001E-2</c:v>
                </c:pt>
                <c:pt idx="19">
                  <c:v>1.4270032930845198E-2</c:v>
                </c:pt>
                <c:pt idx="20">
                  <c:v>6.5861690450054917E-3</c:v>
                </c:pt>
                <c:pt idx="21">
                  <c:v>5.4884742041712417E-3</c:v>
                </c:pt>
                <c:pt idx="22">
                  <c:v>7.6838638858397436E-3</c:v>
                </c:pt>
                <c:pt idx="23">
                  <c:v>3.293084522502742E-3</c:v>
                </c:pt>
                <c:pt idx="24">
                  <c:v>1.0976948408342499E-3</c:v>
                </c:pt>
                <c:pt idx="25">
                  <c:v>2.1953896816685001E-3</c:v>
                </c:pt>
                <c:pt idx="26">
                  <c:v>1.0976948408342499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"/>
          <c:order val="1"/>
          <c:tx>
            <c:strRef>
              <c:f>'unc-49 A5_0.02_50%'!$C$104</c:f>
              <c:strCache>
                <c:ptCount val="1"/>
                <c:pt idx="0">
                  <c:v>unc-49_A5_40_30_04</c:v>
                </c:pt>
              </c:strCache>
            </c:strRef>
          </c:tx>
          <c:marker>
            <c:symbol val="none"/>
          </c:marker>
          <c:cat>
            <c:numRef>
              <c:f>'unc-49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5_0.02_50%'!$C$105:$C$135</c:f>
              <c:numCache>
                <c:formatCode>General</c:formatCode>
                <c:ptCount val="31"/>
                <c:pt idx="1">
                  <c:v>0.10986964618249502</c:v>
                </c:pt>
                <c:pt idx="2">
                  <c:v>0.12476722532588504</c:v>
                </c:pt>
                <c:pt idx="3">
                  <c:v>9.2178770949720684E-2</c:v>
                </c:pt>
                <c:pt idx="4">
                  <c:v>6.6108007448789599E-2</c:v>
                </c:pt>
                <c:pt idx="5">
                  <c:v>4.934823091247674E-2</c:v>
                </c:pt>
                <c:pt idx="6">
                  <c:v>3.7243947858473028E-2</c:v>
                </c:pt>
                <c:pt idx="7">
                  <c:v>3.7243947858473028E-2</c:v>
                </c:pt>
                <c:pt idx="8">
                  <c:v>3.2588454376163901E-2</c:v>
                </c:pt>
                <c:pt idx="9">
                  <c:v>4.0968342644320296E-2</c:v>
                </c:pt>
                <c:pt idx="10">
                  <c:v>3.5381750465549311E-2</c:v>
                </c:pt>
                <c:pt idx="11">
                  <c:v>2.327746741154561E-2</c:v>
                </c:pt>
                <c:pt idx="12">
                  <c:v>2.8864059590316592E-2</c:v>
                </c:pt>
                <c:pt idx="13">
                  <c:v>2.1415270018622017E-2</c:v>
                </c:pt>
                <c:pt idx="14">
                  <c:v>1.0242085661080109E-2</c:v>
                </c:pt>
                <c:pt idx="15">
                  <c:v>2.234636871508381E-2</c:v>
                </c:pt>
                <c:pt idx="16">
                  <c:v>1.5828677839851001E-2</c:v>
                </c:pt>
                <c:pt idx="17">
                  <c:v>8.3798882681564244E-3</c:v>
                </c:pt>
                <c:pt idx="18">
                  <c:v>1.6759776536312807E-2</c:v>
                </c:pt>
                <c:pt idx="19">
                  <c:v>6.5176908752327721E-3</c:v>
                </c:pt>
                <c:pt idx="20">
                  <c:v>7.448789571694603E-3</c:v>
                </c:pt>
                <c:pt idx="21">
                  <c:v>1.8621973929236505E-3</c:v>
                </c:pt>
                <c:pt idx="22">
                  <c:v>5.5865921787709516E-3</c:v>
                </c:pt>
                <c:pt idx="23">
                  <c:v>9.3109869646182571E-4</c:v>
                </c:pt>
                <c:pt idx="24">
                  <c:v>2.793296089385481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9.3109869646182571E-4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unc-49 A5_0.02_50%'!$D$104</c:f>
              <c:strCache>
                <c:ptCount val="1"/>
                <c:pt idx="0">
                  <c:v>unc-49_REX_A5_01</c:v>
                </c:pt>
              </c:strCache>
            </c:strRef>
          </c:tx>
          <c:marker>
            <c:symbol val="none"/>
          </c:marker>
          <c:cat>
            <c:numRef>
              <c:f>'unc-49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5_0.02_50%'!$D$105:$D$135</c:f>
              <c:numCache>
                <c:formatCode>General</c:formatCode>
                <c:ptCount val="31"/>
                <c:pt idx="1">
                  <c:v>8.1471747700394156E-2</c:v>
                </c:pt>
                <c:pt idx="2">
                  <c:v>8.6070959264126196E-2</c:v>
                </c:pt>
                <c:pt idx="3">
                  <c:v>6.1103810775295697E-2</c:v>
                </c:pt>
                <c:pt idx="4">
                  <c:v>7.7529566360052607E-2</c:v>
                </c:pt>
                <c:pt idx="5">
                  <c:v>5.9132720105124825E-2</c:v>
                </c:pt>
                <c:pt idx="6">
                  <c:v>5.3219448094612383E-2</c:v>
                </c:pt>
                <c:pt idx="7">
                  <c:v>5.65045992115637E-2</c:v>
                </c:pt>
                <c:pt idx="8">
                  <c:v>4.9934296977661011E-2</c:v>
                </c:pt>
                <c:pt idx="9">
                  <c:v>6.3731931668856823E-2</c:v>
                </c:pt>
                <c:pt idx="10">
                  <c:v>5.1905387647831813E-2</c:v>
                </c:pt>
                <c:pt idx="11">
                  <c:v>4.8620236530880399E-2</c:v>
                </c:pt>
                <c:pt idx="12">
                  <c:v>5.0591327201051313E-2</c:v>
                </c:pt>
                <c:pt idx="13">
                  <c:v>2.890932982917211E-2</c:v>
                </c:pt>
                <c:pt idx="14">
                  <c:v>2.1681997371879123E-2</c:v>
                </c:pt>
                <c:pt idx="15">
                  <c:v>2.2339027595269418E-2</c:v>
                </c:pt>
                <c:pt idx="16">
                  <c:v>1.7082785808147209E-2</c:v>
                </c:pt>
                <c:pt idx="17">
                  <c:v>7.8843626806833142E-3</c:v>
                </c:pt>
                <c:pt idx="18">
                  <c:v>1.1826544021025004E-2</c:v>
                </c:pt>
                <c:pt idx="19">
                  <c:v>3.2851511169513818E-3</c:v>
                </c:pt>
                <c:pt idx="20">
                  <c:v>3.9421813403416623E-3</c:v>
                </c:pt>
                <c:pt idx="21">
                  <c:v>8.5413929040735869E-3</c:v>
                </c:pt>
                <c:pt idx="22">
                  <c:v>1.3140604467805508E-3</c:v>
                </c:pt>
                <c:pt idx="23">
                  <c:v>4.5992115637319315E-3</c:v>
                </c:pt>
                <c:pt idx="24">
                  <c:v>3.2851511169513818E-3</c:v>
                </c:pt>
                <c:pt idx="25">
                  <c:v>3.2851511169513818E-3</c:v>
                </c:pt>
                <c:pt idx="26">
                  <c:v>6.570302233902764E-4</c:v>
                </c:pt>
                <c:pt idx="27">
                  <c:v>6.570302233902764E-4</c:v>
                </c:pt>
                <c:pt idx="28">
                  <c:v>1.3140604467805508E-3</c:v>
                </c:pt>
                <c:pt idx="29">
                  <c:v>6.570302233902764E-4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unc-49 A5_0.02_50%'!$E$104</c:f>
              <c:strCache>
                <c:ptCount val="1"/>
                <c:pt idx="0">
                  <c:v>unc-49_REX_A5_02</c:v>
                </c:pt>
              </c:strCache>
            </c:strRef>
          </c:tx>
          <c:marker>
            <c:symbol val="none"/>
          </c:marker>
          <c:cat>
            <c:numRef>
              <c:f>'unc-49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5_0.02_50%'!$E$105:$E$135</c:f>
              <c:numCache>
                <c:formatCode>General</c:formatCode>
                <c:ptCount val="31"/>
                <c:pt idx="1">
                  <c:v>8.4196307969383238E-2</c:v>
                </c:pt>
                <c:pt idx="2">
                  <c:v>8.6447546150382706E-2</c:v>
                </c:pt>
                <c:pt idx="3">
                  <c:v>7.9243583971184195E-2</c:v>
                </c:pt>
                <c:pt idx="4">
                  <c:v>7.5191355245385005E-2</c:v>
                </c:pt>
                <c:pt idx="5">
                  <c:v>7.2489869428185499E-2</c:v>
                </c:pt>
                <c:pt idx="6">
                  <c:v>5.5830706888788821E-2</c:v>
                </c:pt>
                <c:pt idx="7">
                  <c:v>4.4574515983791099E-2</c:v>
                </c:pt>
                <c:pt idx="8">
                  <c:v>4.5024763619990985E-2</c:v>
                </c:pt>
                <c:pt idx="9">
                  <c:v>4.6375506528590696E-2</c:v>
                </c:pt>
                <c:pt idx="10">
                  <c:v>5.8081945069788386E-2</c:v>
                </c:pt>
                <c:pt idx="11">
                  <c:v>5.3579468707789277E-2</c:v>
                </c:pt>
                <c:pt idx="12">
                  <c:v>3.8271049076992317E-2</c:v>
                </c:pt>
                <c:pt idx="13">
                  <c:v>3.7820801440792404E-2</c:v>
                </c:pt>
                <c:pt idx="14">
                  <c:v>4.1873030166591614E-2</c:v>
                </c:pt>
                <c:pt idx="15">
                  <c:v>2.9266096352994094E-2</c:v>
                </c:pt>
                <c:pt idx="16">
                  <c:v>1.8460153084196306E-2</c:v>
                </c:pt>
                <c:pt idx="17">
                  <c:v>1.3507429085997308E-2</c:v>
                </c:pt>
                <c:pt idx="18">
                  <c:v>8.1044574515983792E-3</c:v>
                </c:pt>
                <c:pt idx="19">
                  <c:v>9.9054479963980278E-3</c:v>
                </c:pt>
                <c:pt idx="20">
                  <c:v>6.7537145429986513E-3</c:v>
                </c:pt>
                <c:pt idx="21">
                  <c:v>6.7537145429986513E-3</c:v>
                </c:pt>
                <c:pt idx="22">
                  <c:v>1.3507429085997309E-3</c:v>
                </c:pt>
                <c:pt idx="23">
                  <c:v>1.3507429085997309E-3</c:v>
                </c:pt>
                <c:pt idx="24">
                  <c:v>3.1517334533993717E-3</c:v>
                </c:pt>
                <c:pt idx="25">
                  <c:v>4.5024763619991016E-4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4.5024763619991016E-4</c:v>
                </c:pt>
              </c:numCache>
            </c:numRef>
          </c:val>
        </c:ser>
        <c:ser>
          <c:idx val="4"/>
          <c:order val="4"/>
          <c:tx>
            <c:strRef>
              <c:f>'unc-49 A5_0.02_50%'!$F$104</c:f>
              <c:strCache>
                <c:ptCount val="1"/>
                <c:pt idx="0">
                  <c:v>unc-49_REX_A5_03</c:v>
                </c:pt>
              </c:strCache>
            </c:strRef>
          </c:tx>
          <c:marker>
            <c:symbol val="none"/>
          </c:marker>
          <c:cat>
            <c:numRef>
              <c:f>'unc-49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5_0.02_50%'!$F$105:$F$135</c:f>
              <c:numCache>
                <c:formatCode>General</c:formatCode>
                <c:ptCount val="31"/>
                <c:pt idx="1">
                  <c:v>0.10224719101123603</c:v>
                </c:pt>
                <c:pt idx="2">
                  <c:v>8.5955056179775322E-2</c:v>
                </c:pt>
                <c:pt idx="3">
                  <c:v>8.4269662921348298E-2</c:v>
                </c:pt>
                <c:pt idx="4">
                  <c:v>8.0337078651685434E-2</c:v>
                </c:pt>
                <c:pt idx="5">
                  <c:v>5.3370786516853896E-2</c:v>
                </c:pt>
                <c:pt idx="6">
                  <c:v>5.0561797752809015E-2</c:v>
                </c:pt>
                <c:pt idx="7">
                  <c:v>5.1123595505618E-2</c:v>
                </c:pt>
                <c:pt idx="8">
                  <c:v>4.7191011235955115E-2</c:v>
                </c:pt>
                <c:pt idx="9">
                  <c:v>4.5505617977528119E-2</c:v>
                </c:pt>
                <c:pt idx="10">
                  <c:v>3.9887640449438211E-2</c:v>
                </c:pt>
                <c:pt idx="11">
                  <c:v>4.2134831460674184E-2</c:v>
                </c:pt>
                <c:pt idx="12">
                  <c:v>3.14606741573034E-2</c:v>
                </c:pt>
                <c:pt idx="13">
                  <c:v>3.0898876404494409E-2</c:v>
                </c:pt>
                <c:pt idx="14">
                  <c:v>2.5280898876404518E-2</c:v>
                </c:pt>
                <c:pt idx="15">
                  <c:v>1.23595505617978E-2</c:v>
                </c:pt>
                <c:pt idx="16">
                  <c:v>1.1235955056179799E-2</c:v>
                </c:pt>
                <c:pt idx="17">
                  <c:v>1.2921348314606701E-2</c:v>
                </c:pt>
                <c:pt idx="18">
                  <c:v>8.4269662921348295E-3</c:v>
                </c:pt>
                <c:pt idx="19">
                  <c:v>4.4943820224719114E-3</c:v>
                </c:pt>
                <c:pt idx="20">
                  <c:v>5.056179775280902E-3</c:v>
                </c:pt>
                <c:pt idx="21">
                  <c:v>3.9325842696629216E-3</c:v>
                </c:pt>
                <c:pt idx="22">
                  <c:v>1.68539325842697E-3</c:v>
                </c:pt>
                <c:pt idx="23">
                  <c:v>1.68539325842697E-3</c:v>
                </c:pt>
                <c:pt idx="24">
                  <c:v>2.2471910112359626E-3</c:v>
                </c:pt>
                <c:pt idx="25">
                  <c:v>1.12359550561798E-3</c:v>
                </c:pt>
                <c:pt idx="26">
                  <c:v>5.6179775280898881E-4</c:v>
                </c:pt>
                <c:pt idx="27">
                  <c:v>5.6179775280898881E-4</c:v>
                </c:pt>
                <c:pt idx="28">
                  <c:v>5.6179775280898881E-4</c:v>
                </c:pt>
                <c:pt idx="29">
                  <c:v>0</c:v>
                </c:pt>
                <c:pt idx="30">
                  <c:v>1.12359550561798E-3</c:v>
                </c:pt>
              </c:numCache>
            </c:numRef>
          </c:val>
        </c:ser>
        <c:ser>
          <c:idx val="5"/>
          <c:order val="5"/>
          <c:tx>
            <c:strRef>
              <c:f>'unc-49 A5_0.02_50%'!$G$104</c:f>
              <c:strCache>
                <c:ptCount val="1"/>
                <c:pt idx="0">
                  <c:v>unc-49_REX_A5_04</c:v>
                </c:pt>
              </c:strCache>
            </c:strRef>
          </c:tx>
          <c:marker>
            <c:symbol val="none"/>
          </c:marker>
          <c:cat>
            <c:numRef>
              <c:f>'unc-49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5_0.02_50%'!$G$105:$G$135</c:f>
              <c:numCache>
                <c:formatCode>General</c:formatCode>
                <c:ptCount val="31"/>
                <c:pt idx="1">
                  <c:v>0.10585452395032502</c:v>
                </c:pt>
                <c:pt idx="2">
                  <c:v>9.4618568894145508E-2</c:v>
                </c:pt>
                <c:pt idx="3">
                  <c:v>7.3920756948551214E-2</c:v>
                </c:pt>
                <c:pt idx="4">
                  <c:v>8.3382613837965622E-2</c:v>
                </c:pt>
                <c:pt idx="5">
                  <c:v>6.6232998225901812E-2</c:v>
                </c:pt>
                <c:pt idx="6">
                  <c:v>6.6824364281490203E-2</c:v>
                </c:pt>
                <c:pt idx="7">
                  <c:v>6.3867534003548235E-2</c:v>
                </c:pt>
                <c:pt idx="8">
                  <c:v>5.6771141336487287E-2</c:v>
                </c:pt>
                <c:pt idx="9">
                  <c:v>5.2040212891779986E-2</c:v>
                </c:pt>
                <c:pt idx="10">
                  <c:v>5.2040212891779986E-2</c:v>
                </c:pt>
                <c:pt idx="11">
                  <c:v>3.3116499112950885E-2</c:v>
                </c:pt>
                <c:pt idx="12">
                  <c:v>3.1933767001774124E-2</c:v>
                </c:pt>
                <c:pt idx="13">
                  <c:v>2.6611472501478415E-2</c:v>
                </c:pt>
                <c:pt idx="14">
                  <c:v>1.7740981667652308E-2</c:v>
                </c:pt>
                <c:pt idx="15">
                  <c:v>1.5966883500887007E-2</c:v>
                </c:pt>
                <c:pt idx="16">
                  <c:v>1.1235955056179799E-2</c:v>
                </c:pt>
                <c:pt idx="17">
                  <c:v>7.6877587226493235E-3</c:v>
                </c:pt>
                <c:pt idx="18">
                  <c:v>7.0963926670609117E-3</c:v>
                </c:pt>
                <c:pt idx="19">
                  <c:v>2.3654642223536401E-3</c:v>
                </c:pt>
                <c:pt idx="20">
                  <c:v>4.1395623891188737E-3</c:v>
                </c:pt>
                <c:pt idx="21">
                  <c:v>1.774098166765231E-3</c:v>
                </c:pt>
                <c:pt idx="22">
                  <c:v>2.9568302779420519E-3</c:v>
                </c:pt>
                <c:pt idx="23">
                  <c:v>2.3654642223536401E-3</c:v>
                </c:pt>
                <c:pt idx="24">
                  <c:v>0</c:v>
                </c:pt>
                <c:pt idx="25">
                  <c:v>0</c:v>
                </c:pt>
                <c:pt idx="26">
                  <c:v>5.9136605558840949E-4</c:v>
                </c:pt>
                <c:pt idx="27">
                  <c:v>0</c:v>
                </c:pt>
                <c:pt idx="28">
                  <c:v>0</c:v>
                </c:pt>
                <c:pt idx="29">
                  <c:v>1.1827321111768209E-3</c:v>
                </c:pt>
                <c:pt idx="30">
                  <c:v>0</c:v>
                </c:pt>
              </c:numCache>
            </c:numRef>
          </c:val>
        </c:ser>
        <c:ser>
          <c:idx val="6"/>
          <c:order val="6"/>
          <c:tx>
            <c:strRef>
              <c:f>'unc-49 A5_0.02_50%'!$H$104</c:f>
              <c:strCache>
                <c:ptCount val="1"/>
                <c:pt idx="0">
                  <c:v>unc-49_REX_A5_05</c:v>
                </c:pt>
              </c:strCache>
            </c:strRef>
          </c:tx>
          <c:marker>
            <c:symbol val="none"/>
          </c:marker>
          <c:cat>
            <c:numRef>
              <c:f>'unc-49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5_0.02_50%'!$H$105:$H$135</c:f>
              <c:numCache>
                <c:formatCode>General</c:formatCode>
                <c:ptCount val="31"/>
                <c:pt idx="1">
                  <c:v>9.2413793103448272E-2</c:v>
                </c:pt>
                <c:pt idx="2">
                  <c:v>8.8275862068965538E-2</c:v>
                </c:pt>
                <c:pt idx="3">
                  <c:v>8.9655172413793172E-2</c:v>
                </c:pt>
                <c:pt idx="4">
                  <c:v>6.8275862068965465E-2</c:v>
                </c:pt>
                <c:pt idx="5">
                  <c:v>5.2413793103448354E-2</c:v>
                </c:pt>
                <c:pt idx="6">
                  <c:v>4.13793103448276E-2</c:v>
                </c:pt>
                <c:pt idx="7">
                  <c:v>3.9310344827586198E-2</c:v>
                </c:pt>
                <c:pt idx="8">
                  <c:v>3.7931034482758613E-2</c:v>
                </c:pt>
                <c:pt idx="9">
                  <c:v>4.2068965517241416E-2</c:v>
                </c:pt>
                <c:pt idx="10">
                  <c:v>4.344827586206898E-2</c:v>
                </c:pt>
                <c:pt idx="11">
                  <c:v>3.7241379310344817E-2</c:v>
                </c:pt>
                <c:pt idx="12">
                  <c:v>3.8620689655172395E-2</c:v>
                </c:pt>
                <c:pt idx="13">
                  <c:v>3.0344827586206918E-2</c:v>
                </c:pt>
                <c:pt idx="14">
                  <c:v>3.2413793103448302E-2</c:v>
                </c:pt>
                <c:pt idx="15">
                  <c:v>1.7931034482758602E-2</c:v>
                </c:pt>
                <c:pt idx="16">
                  <c:v>1.6551724137931007E-2</c:v>
                </c:pt>
                <c:pt idx="17">
                  <c:v>1.51724137931034E-2</c:v>
                </c:pt>
                <c:pt idx="18">
                  <c:v>1.3793103448275905E-2</c:v>
                </c:pt>
                <c:pt idx="19">
                  <c:v>1.7241379310344803E-2</c:v>
                </c:pt>
                <c:pt idx="20">
                  <c:v>1.03448275862069E-2</c:v>
                </c:pt>
                <c:pt idx="21">
                  <c:v>8.9655172413793203E-3</c:v>
                </c:pt>
                <c:pt idx="22">
                  <c:v>5.5172413793103418E-3</c:v>
                </c:pt>
                <c:pt idx="23">
                  <c:v>4.1379310344827596E-3</c:v>
                </c:pt>
                <c:pt idx="24">
                  <c:v>4.8275862068965459E-3</c:v>
                </c:pt>
                <c:pt idx="25">
                  <c:v>2.0689655172413815E-3</c:v>
                </c:pt>
                <c:pt idx="26">
                  <c:v>4.8275862068965459E-3</c:v>
                </c:pt>
                <c:pt idx="27">
                  <c:v>0</c:v>
                </c:pt>
                <c:pt idx="28">
                  <c:v>2.7586206896551709E-3</c:v>
                </c:pt>
                <c:pt idx="29">
                  <c:v>2.7586206896551709E-3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unc-49 A5_0.02_50%'!$I$104</c:f>
              <c:strCache>
                <c:ptCount val="1"/>
                <c:pt idx="0">
                  <c:v>unc-49_REX_A5_06</c:v>
                </c:pt>
              </c:strCache>
            </c:strRef>
          </c:tx>
          <c:marker>
            <c:symbol val="none"/>
          </c:marker>
          <c:cat>
            <c:numRef>
              <c:f>'unc-49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5_0.02_50%'!$I$105:$I$135</c:f>
              <c:numCache>
                <c:formatCode>General</c:formatCode>
                <c:ptCount val="31"/>
                <c:pt idx="1">
                  <c:v>0.12232415902140703</c:v>
                </c:pt>
                <c:pt idx="2">
                  <c:v>8.5626911314984705E-2</c:v>
                </c:pt>
                <c:pt idx="3">
                  <c:v>6.4220183486238494E-2</c:v>
                </c:pt>
                <c:pt idx="4">
                  <c:v>2.7522935779816515E-2</c:v>
                </c:pt>
                <c:pt idx="5">
                  <c:v>4.4342507645259904E-2</c:v>
                </c:pt>
                <c:pt idx="6">
                  <c:v>1.5290519877675801E-2</c:v>
                </c:pt>
                <c:pt idx="7">
                  <c:v>1.6819571865443406E-2</c:v>
                </c:pt>
                <c:pt idx="8">
                  <c:v>1.9877675840978607E-2</c:v>
                </c:pt>
                <c:pt idx="9">
                  <c:v>1.9877675840978607E-2</c:v>
                </c:pt>
                <c:pt idx="10">
                  <c:v>3.5168195718654399E-2</c:v>
                </c:pt>
                <c:pt idx="11">
                  <c:v>5.6574923547400603E-2</c:v>
                </c:pt>
                <c:pt idx="12">
                  <c:v>3.5168195718654399E-2</c:v>
                </c:pt>
                <c:pt idx="13">
                  <c:v>4.5871559633027484E-2</c:v>
                </c:pt>
                <c:pt idx="14">
                  <c:v>3.5168195718654399E-2</c:v>
                </c:pt>
                <c:pt idx="15">
                  <c:v>1.8348623853211E-2</c:v>
                </c:pt>
                <c:pt idx="16">
                  <c:v>2.9051987767584109E-2</c:v>
                </c:pt>
                <c:pt idx="17">
                  <c:v>1.9877675840978607E-2</c:v>
                </c:pt>
                <c:pt idx="18">
                  <c:v>1.5290519877675801E-2</c:v>
                </c:pt>
                <c:pt idx="19">
                  <c:v>3.0581039755351708E-3</c:v>
                </c:pt>
                <c:pt idx="20">
                  <c:v>6.1162079510703416E-3</c:v>
                </c:pt>
                <c:pt idx="21">
                  <c:v>4.5871559633027499E-3</c:v>
                </c:pt>
                <c:pt idx="22">
                  <c:v>1.5290519877675804E-3</c:v>
                </c:pt>
                <c:pt idx="23">
                  <c:v>3.0581039755351708E-3</c:v>
                </c:pt>
                <c:pt idx="24">
                  <c:v>3.0581039755351708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8"/>
          <c:order val="8"/>
          <c:tx>
            <c:strRef>
              <c:f>'unc-49 A5_0.02_50%'!$J$104</c:f>
              <c:strCache>
                <c:ptCount val="1"/>
                <c:pt idx="0">
                  <c:v>unc-49_REX_A5_09</c:v>
                </c:pt>
              </c:strCache>
            </c:strRef>
          </c:tx>
          <c:marker>
            <c:symbol val="none"/>
          </c:marker>
          <c:cat>
            <c:numRef>
              <c:f>'unc-49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5_0.02_50%'!$J$105:$J$135</c:f>
              <c:numCache>
                <c:formatCode>General</c:formatCode>
                <c:ptCount val="31"/>
                <c:pt idx="1">
                  <c:v>7.1428571428571411E-2</c:v>
                </c:pt>
                <c:pt idx="2">
                  <c:v>8.1904761904761883E-2</c:v>
                </c:pt>
                <c:pt idx="3">
                  <c:v>6.4761904761904812E-2</c:v>
                </c:pt>
                <c:pt idx="4">
                  <c:v>6.2857142857142903E-2</c:v>
                </c:pt>
                <c:pt idx="5">
                  <c:v>6.380952380952383E-2</c:v>
                </c:pt>
                <c:pt idx="6">
                  <c:v>4.4761904761904801E-2</c:v>
                </c:pt>
                <c:pt idx="7">
                  <c:v>4.7619047619047616E-2</c:v>
                </c:pt>
                <c:pt idx="8">
                  <c:v>5.2380952380952396E-2</c:v>
                </c:pt>
                <c:pt idx="9">
                  <c:v>4.3809523809523819E-2</c:v>
                </c:pt>
                <c:pt idx="10">
                  <c:v>5.2380952380952396E-2</c:v>
                </c:pt>
                <c:pt idx="11">
                  <c:v>4.2857142857142913E-2</c:v>
                </c:pt>
                <c:pt idx="12">
                  <c:v>5.2380952380952396E-2</c:v>
                </c:pt>
                <c:pt idx="13">
                  <c:v>4.5714285714285714E-2</c:v>
                </c:pt>
                <c:pt idx="14">
                  <c:v>3.6190476190476203E-2</c:v>
                </c:pt>
                <c:pt idx="15">
                  <c:v>3.1428571428571417E-2</c:v>
                </c:pt>
                <c:pt idx="16">
                  <c:v>2.6666666666666707E-2</c:v>
                </c:pt>
                <c:pt idx="17">
                  <c:v>2.6666666666666707E-2</c:v>
                </c:pt>
                <c:pt idx="18">
                  <c:v>1.3333333333333301E-2</c:v>
                </c:pt>
                <c:pt idx="19">
                  <c:v>1.3333333333333301E-2</c:v>
                </c:pt>
                <c:pt idx="20">
                  <c:v>5.7142857142857099E-3</c:v>
                </c:pt>
                <c:pt idx="21">
                  <c:v>1.9047619047619013E-3</c:v>
                </c:pt>
                <c:pt idx="22">
                  <c:v>6.6666666666666714E-3</c:v>
                </c:pt>
                <c:pt idx="23">
                  <c:v>1.9047619047619013E-3</c:v>
                </c:pt>
                <c:pt idx="24">
                  <c:v>9.5238095238095238E-4</c:v>
                </c:pt>
                <c:pt idx="25">
                  <c:v>2.8571428571428602E-3</c:v>
                </c:pt>
                <c:pt idx="26">
                  <c:v>9.5238095238095238E-4</c:v>
                </c:pt>
                <c:pt idx="27">
                  <c:v>1.9047619047619013E-3</c:v>
                </c:pt>
                <c:pt idx="28">
                  <c:v>0</c:v>
                </c:pt>
                <c:pt idx="29">
                  <c:v>9.5238095238095238E-4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unc-49 A5_0.02_50%'!$K$104</c:f>
              <c:strCache>
                <c:ptCount val="1"/>
                <c:pt idx="0">
                  <c:v>unc-49_REX_A5_10</c:v>
                </c:pt>
              </c:strCache>
            </c:strRef>
          </c:tx>
          <c:marker>
            <c:symbol val="none"/>
          </c:marker>
          <c:cat>
            <c:numRef>
              <c:f>'unc-49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49 A5_0.02_50%'!$K$105:$K$135</c:f>
              <c:numCache>
                <c:formatCode>General</c:formatCode>
                <c:ptCount val="31"/>
                <c:pt idx="1">
                  <c:v>0.11173184357541906</c:v>
                </c:pt>
                <c:pt idx="2">
                  <c:v>7.9143389199255093E-2</c:v>
                </c:pt>
                <c:pt idx="3">
                  <c:v>8.2867783985102403E-2</c:v>
                </c:pt>
                <c:pt idx="4">
                  <c:v>7.2625698324022409E-2</c:v>
                </c:pt>
                <c:pt idx="5">
                  <c:v>5.3072625698324001E-2</c:v>
                </c:pt>
                <c:pt idx="6">
                  <c:v>5.4003724394785818E-2</c:v>
                </c:pt>
                <c:pt idx="7">
                  <c:v>5.1210428305400402E-2</c:v>
                </c:pt>
                <c:pt idx="8">
                  <c:v>4.748603351955312E-2</c:v>
                </c:pt>
                <c:pt idx="9">
                  <c:v>4.3761638733705817E-2</c:v>
                </c:pt>
                <c:pt idx="10">
                  <c:v>4.934823091247674E-2</c:v>
                </c:pt>
                <c:pt idx="11">
                  <c:v>5.4934823091247718E-2</c:v>
                </c:pt>
                <c:pt idx="12">
                  <c:v>3.4450651769087501E-2</c:v>
                </c:pt>
                <c:pt idx="13">
                  <c:v>3.1657355679702112E-2</c:v>
                </c:pt>
                <c:pt idx="14">
                  <c:v>3.3519553072625698E-2</c:v>
                </c:pt>
                <c:pt idx="15">
                  <c:v>1.9553072625698303E-2</c:v>
                </c:pt>
                <c:pt idx="16">
                  <c:v>1.2104283054003698E-2</c:v>
                </c:pt>
                <c:pt idx="17">
                  <c:v>1.6759776536312807E-2</c:v>
                </c:pt>
                <c:pt idx="18">
                  <c:v>8.3798882681564244E-3</c:v>
                </c:pt>
                <c:pt idx="19">
                  <c:v>5.5865921787709516E-3</c:v>
                </c:pt>
                <c:pt idx="20">
                  <c:v>7.448789571694603E-3</c:v>
                </c:pt>
                <c:pt idx="21">
                  <c:v>9.3109869646182571E-4</c:v>
                </c:pt>
                <c:pt idx="22">
                  <c:v>5.5865921787709516E-3</c:v>
                </c:pt>
                <c:pt idx="23">
                  <c:v>1.8621973929236505E-3</c:v>
                </c:pt>
                <c:pt idx="24">
                  <c:v>0</c:v>
                </c:pt>
                <c:pt idx="25">
                  <c:v>9.3109869646182571E-4</c:v>
                </c:pt>
                <c:pt idx="26">
                  <c:v>9.3109869646182571E-4</c:v>
                </c:pt>
                <c:pt idx="27">
                  <c:v>9.3109869646182571E-4</c:v>
                </c:pt>
                <c:pt idx="28">
                  <c:v>9.3109869646182571E-4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marker val="1"/>
        <c:axId val="166725888"/>
        <c:axId val="166735872"/>
      </c:lineChart>
      <c:catAx>
        <c:axId val="166725888"/>
        <c:scaling>
          <c:orientation val="minMax"/>
        </c:scaling>
        <c:axPos val="b"/>
        <c:numFmt formatCode="0.0_ " sourceLinked="1"/>
        <c:tickLblPos val="nextTo"/>
        <c:crossAx val="166735872"/>
        <c:crosses val="autoZero"/>
        <c:auto val="1"/>
        <c:lblAlgn val="ctr"/>
        <c:lblOffset val="100"/>
        <c:tickLblSkip val="5"/>
        <c:tickMarkSkip val="5"/>
      </c:catAx>
      <c:valAx>
        <c:axId val="166735872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6725888"/>
        <c:crosses val="autoZero"/>
        <c:crossBetween val="between"/>
      </c:valAx>
    </c:plotArea>
    <c:plotVisOnly val="1"/>
  </c:chart>
  <c:externalData r:id="rId1"/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cat-2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5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cat-2(CB1112)_A5_0.02_50%'!$B$104</c:f>
              <c:strCache>
                <c:ptCount val="1"/>
                <c:pt idx="0">
                  <c:v>cat-2(CB1112)_A5_01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B$105:$B$135</c:f>
              <c:numCache>
                <c:formatCode>General</c:formatCode>
                <c:ptCount val="31"/>
                <c:pt idx="1">
                  <c:v>2.31660231660232E-2</c:v>
                </c:pt>
                <c:pt idx="2">
                  <c:v>7.7220077220077222E-3</c:v>
                </c:pt>
                <c:pt idx="3">
                  <c:v>3.8610038610038602E-3</c:v>
                </c:pt>
                <c:pt idx="4">
                  <c:v>3.8610038610038602E-3</c:v>
                </c:pt>
                <c:pt idx="5">
                  <c:v>1.5444015444015408E-2</c:v>
                </c:pt>
                <c:pt idx="6">
                  <c:v>1.9305019305019308E-2</c:v>
                </c:pt>
                <c:pt idx="7">
                  <c:v>1.5444015444015408E-2</c:v>
                </c:pt>
                <c:pt idx="8">
                  <c:v>1.9305019305019308E-2</c:v>
                </c:pt>
                <c:pt idx="9">
                  <c:v>3.8610038610038602E-3</c:v>
                </c:pt>
                <c:pt idx="10">
                  <c:v>3.8610038610038602E-3</c:v>
                </c:pt>
                <c:pt idx="11">
                  <c:v>7.7220077220077222E-3</c:v>
                </c:pt>
                <c:pt idx="12">
                  <c:v>3.8610038610038602E-3</c:v>
                </c:pt>
                <c:pt idx="13">
                  <c:v>3.47490347490347E-2</c:v>
                </c:pt>
                <c:pt idx="14">
                  <c:v>3.0888030888030899E-2</c:v>
                </c:pt>
                <c:pt idx="15">
                  <c:v>7.3359073359073421E-2</c:v>
                </c:pt>
                <c:pt idx="16">
                  <c:v>0.13127413127413101</c:v>
                </c:pt>
                <c:pt idx="17">
                  <c:v>0.10424710424710402</c:v>
                </c:pt>
                <c:pt idx="18">
                  <c:v>0.10038610038610005</c:v>
                </c:pt>
                <c:pt idx="19">
                  <c:v>8.4942084942084883E-2</c:v>
                </c:pt>
                <c:pt idx="20">
                  <c:v>8.8803088803088806E-2</c:v>
                </c:pt>
                <c:pt idx="21">
                  <c:v>5.0193050193050197E-2</c:v>
                </c:pt>
                <c:pt idx="22">
                  <c:v>4.2471042471042476E-2</c:v>
                </c:pt>
                <c:pt idx="23">
                  <c:v>3.0888030888030899E-2</c:v>
                </c:pt>
                <c:pt idx="24">
                  <c:v>2.7027027027027015E-2</c:v>
                </c:pt>
                <c:pt idx="25">
                  <c:v>3.47490347490347E-2</c:v>
                </c:pt>
                <c:pt idx="26">
                  <c:v>7.7220077220077222E-3</c:v>
                </c:pt>
                <c:pt idx="27">
                  <c:v>1.5444015444015408E-2</c:v>
                </c:pt>
                <c:pt idx="28">
                  <c:v>3.8610038610038602E-3</c:v>
                </c:pt>
                <c:pt idx="29">
                  <c:v>3.8610038610038602E-3</c:v>
                </c:pt>
                <c:pt idx="30">
                  <c:v>0</c:v>
                </c:pt>
              </c:numCache>
            </c:numRef>
          </c:val>
        </c:ser>
        <c:ser>
          <c:idx val="1"/>
          <c:order val="1"/>
          <c:tx>
            <c:strRef>
              <c:f>'cat-2(CB1112)_A5_0.02_50%'!$C$104</c:f>
              <c:strCache>
                <c:ptCount val="1"/>
                <c:pt idx="0">
                  <c:v>cat-2(CB1112)_A5_02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C$105:$C$135</c:f>
              <c:numCache>
                <c:formatCode>General</c:formatCode>
                <c:ptCount val="31"/>
                <c:pt idx="1">
                  <c:v>1.6949152542372906E-2</c:v>
                </c:pt>
                <c:pt idx="2">
                  <c:v>5.6497175141242903E-3</c:v>
                </c:pt>
                <c:pt idx="3">
                  <c:v>0</c:v>
                </c:pt>
                <c:pt idx="4">
                  <c:v>2.2598870056497199E-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5.6497175141242903E-3</c:v>
                </c:pt>
                <c:pt idx="10">
                  <c:v>0</c:v>
                </c:pt>
                <c:pt idx="11">
                  <c:v>5.6497175141242903E-3</c:v>
                </c:pt>
                <c:pt idx="12">
                  <c:v>1.6949152542372906E-2</c:v>
                </c:pt>
                <c:pt idx="13">
                  <c:v>1.6949152542372906E-2</c:v>
                </c:pt>
                <c:pt idx="14">
                  <c:v>3.3898305084745811E-2</c:v>
                </c:pt>
                <c:pt idx="15">
                  <c:v>8.4745762711864472E-2</c:v>
                </c:pt>
                <c:pt idx="16">
                  <c:v>0.12429378531073405</c:v>
                </c:pt>
                <c:pt idx="17">
                  <c:v>7.3446327683615809E-2</c:v>
                </c:pt>
                <c:pt idx="18">
                  <c:v>0.11864406779661005</c:v>
                </c:pt>
                <c:pt idx="19">
                  <c:v>0.13559322033898297</c:v>
                </c:pt>
                <c:pt idx="20">
                  <c:v>6.7796610169491553E-2</c:v>
                </c:pt>
                <c:pt idx="21">
                  <c:v>8.4745762711864472E-2</c:v>
                </c:pt>
                <c:pt idx="22">
                  <c:v>6.7796610169491553E-2</c:v>
                </c:pt>
                <c:pt idx="23">
                  <c:v>2.2598870056497199E-2</c:v>
                </c:pt>
                <c:pt idx="24">
                  <c:v>2.824858757062151E-2</c:v>
                </c:pt>
                <c:pt idx="25">
                  <c:v>2.824858757062151E-2</c:v>
                </c:pt>
                <c:pt idx="26">
                  <c:v>5.6497175141242903E-3</c:v>
                </c:pt>
                <c:pt idx="27">
                  <c:v>5.6497175141242903E-3</c:v>
                </c:pt>
                <c:pt idx="28">
                  <c:v>0</c:v>
                </c:pt>
                <c:pt idx="29">
                  <c:v>1.12994350282486E-2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cat-2(CB1112)_A5_0.02_50%'!$D$104</c:f>
              <c:strCache>
                <c:ptCount val="1"/>
                <c:pt idx="0">
                  <c:v>cat-2(CB1112)_A5_03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D$105:$D$135</c:f>
              <c:numCache>
                <c:formatCode>General</c:formatCode>
                <c:ptCount val="31"/>
                <c:pt idx="1">
                  <c:v>4.3824701195219098E-2</c:v>
                </c:pt>
                <c:pt idx="2">
                  <c:v>2.7888446215139407E-2</c:v>
                </c:pt>
                <c:pt idx="3">
                  <c:v>1.5936254980079698E-2</c:v>
                </c:pt>
                <c:pt idx="4">
                  <c:v>1.9920318725099601E-2</c:v>
                </c:pt>
                <c:pt idx="5">
                  <c:v>2.7888446215139407E-2</c:v>
                </c:pt>
                <c:pt idx="6">
                  <c:v>1.1952191235059804E-2</c:v>
                </c:pt>
                <c:pt idx="7">
                  <c:v>1.9920318725099601E-2</c:v>
                </c:pt>
                <c:pt idx="8">
                  <c:v>1.5936254980079698E-2</c:v>
                </c:pt>
                <c:pt idx="9">
                  <c:v>3.984063745019922E-3</c:v>
                </c:pt>
                <c:pt idx="10">
                  <c:v>1.5936254980079698E-2</c:v>
                </c:pt>
                <c:pt idx="11">
                  <c:v>3.1872509960159411E-2</c:v>
                </c:pt>
                <c:pt idx="12">
                  <c:v>3.9840637450199216E-2</c:v>
                </c:pt>
                <c:pt idx="13">
                  <c:v>5.9760956175298821E-2</c:v>
                </c:pt>
                <c:pt idx="14">
                  <c:v>7.569721115537853E-2</c:v>
                </c:pt>
                <c:pt idx="15">
                  <c:v>6.3745019920318724E-2</c:v>
                </c:pt>
                <c:pt idx="16">
                  <c:v>0.10358565737051803</c:v>
                </c:pt>
                <c:pt idx="17">
                  <c:v>0.10756972111553803</c:v>
                </c:pt>
                <c:pt idx="18">
                  <c:v>7.569721115537853E-2</c:v>
                </c:pt>
                <c:pt idx="19">
                  <c:v>4.7808764940239036E-2</c:v>
                </c:pt>
                <c:pt idx="20">
                  <c:v>5.5776892430278904E-2</c:v>
                </c:pt>
                <c:pt idx="21">
                  <c:v>5.5776892430278904E-2</c:v>
                </c:pt>
                <c:pt idx="22">
                  <c:v>1.1952191235059804E-2</c:v>
                </c:pt>
                <c:pt idx="23">
                  <c:v>3.585657370517932E-2</c:v>
                </c:pt>
                <c:pt idx="24">
                  <c:v>7.968127490039844E-3</c:v>
                </c:pt>
                <c:pt idx="25">
                  <c:v>7.968127490039844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cat-2(CB1112)_A5_0.02_50%'!$E$104</c:f>
              <c:strCache>
                <c:ptCount val="1"/>
                <c:pt idx="0">
                  <c:v>cat-2(CB1112)_A5_04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E$105:$E$135</c:f>
              <c:numCache>
                <c:formatCode>General</c:formatCode>
                <c:ptCount val="31"/>
                <c:pt idx="1">
                  <c:v>1.6042780748663114E-2</c:v>
                </c:pt>
                <c:pt idx="2">
                  <c:v>2.1390374331550797E-2</c:v>
                </c:pt>
                <c:pt idx="3">
                  <c:v>5.3475935828877002E-3</c:v>
                </c:pt>
                <c:pt idx="4">
                  <c:v>5.3475935828877002E-3</c:v>
                </c:pt>
                <c:pt idx="5">
                  <c:v>1.06951871657754E-2</c:v>
                </c:pt>
                <c:pt idx="6">
                  <c:v>0</c:v>
                </c:pt>
                <c:pt idx="7">
                  <c:v>5.3475935828877002E-3</c:v>
                </c:pt>
                <c:pt idx="8">
                  <c:v>2.6737967914438505E-2</c:v>
                </c:pt>
                <c:pt idx="9">
                  <c:v>0</c:v>
                </c:pt>
                <c:pt idx="10">
                  <c:v>5.3475935828877002E-3</c:v>
                </c:pt>
                <c:pt idx="11">
                  <c:v>5.3475935828877002E-3</c:v>
                </c:pt>
                <c:pt idx="12">
                  <c:v>2.6737967914438505E-2</c:v>
                </c:pt>
                <c:pt idx="13">
                  <c:v>5.3475935828877004E-2</c:v>
                </c:pt>
                <c:pt idx="14">
                  <c:v>6.4171122994652399E-2</c:v>
                </c:pt>
                <c:pt idx="15">
                  <c:v>6.9518716577540093E-2</c:v>
                </c:pt>
                <c:pt idx="16">
                  <c:v>9.6256684491978578E-2</c:v>
                </c:pt>
                <c:pt idx="17">
                  <c:v>0.10695187165775398</c:v>
                </c:pt>
                <c:pt idx="18">
                  <c:v>0.12834224598930499</c:v>
                </c:pt>
                <c:pt idx="19">
                  <c:v>8.5561497326203245E-2</c:v>
                </c:pt>
                <c:pt idx="20">
                  <c:v>0.10695187165775398</c:v>
                </c:pt>
                <c:pt idx="21">
                  <c:v>2.6737967914438505E-2</c:v>
                </c:pt>
                <c:pt idx="22">
                  <c:v>3.7433155080213928E-2</c:v>
                </c:pt>
                <c:pt idx="23">
                  <c:v>1.6042780748663114E-2</c:v>
                </c:pt>
                <c:pt idx="24">
                  <c:v>1.6042780748663114E-2</c:v>
                </c:pt>
                <c:pt idx="25">
                  <c:v>1.06951871657754E-2</c:v>
                </c:pt>
                <c:pt idx="26">
                  <c:v>1.06951871657754E-2</c:v>
                </c:pt>
                <c:pt idx="27">
                  <c:v>5.3475935828877002E-3</c:v>
                </c:pt>
                <c:pt idx="28">
                  <c:v>0</c:v>
                </c:pt>
                <c:pt idx="29">
                  <c:v>1.06951871657754E-2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cat-2(CB1112)_A5_0.02_50%'!$F$104</c:f>
              <c:strCache>
                <c:ptCount val="1"/>
                <c:pt idx="0">
                  <c:v>cat-2(CB1112)_A5_05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F$105:$F$135</c:f>
              <c:numCache>
                <c:formatCode>General</c:formatCode>
                <c:ptCount val="31"/>
                <c:pt idx="1">
                  <c:v>5.5555555555555601E-3</c:v>
                </c:pt>
                <c:pt idx="2">
                  <c:v>5.5555555555555601E-3</c:v>
                </c:pt>
                <c:pt idx="3">
                  <c:v>5.5555555555555601E-3</c:v>
                </c:pt>
                <c:pt idx="4">
                  <c:v>1.1111111111111101E-2</c:v>
                </c:pt>
                <c:pt idx="5">
                  <c:v>5.5555555555555601E-3</c:v>
                </c:pt>
                <c:pt idx="6">
                  <c:v>0</c:v>
                </c:pt>
                <c:pt idx="7">
                  <c:v>0</c:v>
                </c:pt>
                <c:pt idx="8">
                  <c:v>5.5555555555555601E-3</c:v>
                </c:pt>
                <c:pt idx="9">
                  <c:v>0</c:v>
                </c:pt>
                <c:pt idx="10">
                  <c:v>5.5555555555555601E-3</c:v>
                </c:pt>
                <c:pt idx="11">
                  <c:v>1.1111111111111101E-2</c:v>
                </c:pt>
                <c:pt idx="12">
                  <c:v>1.6666666666666701E-2</c:v>
                </c:pt>
                <c:pt idx="13">
                  <c:v>2.7777777777777821E-2</c:v>
                </c:pt>
                <c:pt idx="14">
                  <c:v>6.6666666666666693E-2</c:v>
                </c:pt>
                <c:pt idx="15">
                  <c:v>6.6666666666666693E-2</c:v>
                </c:pt>
                <c:pt idx="16">
                  <c:v>0.1444444444444441</c:v>
                </c:pt>
                <c:pt idx="17">
                  <c:v>0.155555555555556</c:v>
                </c:pt>
                <c:pt idx="18">
                  <c:v>0.11111111111111099</c:v>
                </c:pt>
                <c:pt idx="19">
                  <c:v>0.11666666666666703</c:v>
                </c:pt>
                <c:pt idx="20">
                  <c:v>7.7777777777777807E-2</c:v>
                </c:pt>
                <c:pt idx="21">
                  <c:v>3.8888888888888903E-2</c:v>
                </c:pt>
                <c:pt idx="22">
                  <c:v>2.7777777777777821E-2</c:v>
                </c:pt>
                <c:pt idx="23">
                  <c:v>2.2222222222222202E-2</c:v>
                </c:pt>
                <c:pt idx="24">
                  <c:v>1.1111111111111101E-2</c:v>
                </c:pt>
                <c:pt idx="25">
                  <c:v>1.6666666666666701E-2</c:v>
                </c:pt>
                <c:pt idx="26">
                  <c:v>1.1111111111111101E-2</c:v>
                </c:pt>
                <c:pt idx="27">
                  <c:v>5.5555555555555601E-3</c:v>
                </c:pt>
                <c:pt idx="28">
                  <c:v>5.5555555555555601E-3</c:v>
                </c:pt>
                <c:pt idx="29">
                  <c:v>1.1111111111111101E-2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cat-2(CB1112)_A5_0.02_50%'!$G$104</c:f>
              <c:strCache>
                <c:ptCount val="1"/>
                <c:pt idx="0">
                  <c:v>cat-2(CB1112)_A5_06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G$105:$G$135</c:f>
              <c:numCache>
                <c:formatCode>General</c:formatCode>
                <c:ptCount val="31"/>
                <c:pt idx="1">
                  <c:v>1.7937219730941697E-2</c:v>
                </c:pt>
                <c:pt idx="2">
                  <c:v>0</c:v>
                </c:pt>
                <c:pt idx="3">
                  <c:v>8.9686098654708502E-3</c:v>
                </c:pt>
                <c:pt idx="4">
                  <c:v>4.4843049327354303E-3</c:v>
                </c:pt>
                <c:pt idx="5">
                  <c:v>0</c:v>
                </c:pt>
                <c:pt idx="6">
                  <c:v>4.4843049327354303E-3</c:v>
                </c:pt>
                <c:pt idx="7">
                  <c:v>8.9686098654708502E-3</c:v>
                </c:pt>
                <c:pt idx="8">
                  <c:v>1.3452914798206301E-2</c:v>
                </c:pt>
                <c:pt idx="9">
                  <c:v>1.3452914798206301E-2</c:v>
                </c:pt>
                <c:pt idx="10">
                  <c:v>8.9686098654708502E-3</c:v>
                </c:pt>
                <c:pt idx="11">
                  <c:v>4.9327354260089704E-2</c:v>
                </c:pt>
                <c:pt idx="12">
                  <c:v>4.9327354260089704E-2</c:v>
                </c:pt>
                <c:pt idx="13">
                  <c:v>7.6233183856502199E-2</c:v>
                </c:pt>
                <c:pt idx="14">
                  <c:v>7.6233183856502199E-2</c:v>
                </c:pt>
                <c:pt idx="15">
                  <c:v>0.10762331838565004</c:v>
                </c:pt>
                <c:pt idx="16">
                  <c:v>0.13004484304932706</c:v>
                </c:pt>
                <c:pt idx="17">
                  <c:v>0.12107623318385703</c:v>
                </c:pt>
                <c:pt idx="18">
                  <c:v>8.5201793721973104E-2</c:v>
                </c:pt>
                <c:pt idx="19">
                  <c:v>6.7264573991031432E-2</c:v>
                </c:pt>
                <c:pt idx="20">
                  <c:v>2.2421524663677108E-2</c:v>
                </c:pt>
                <c:pt idx="21">
                  <c:v>2.6905829596412602E-2</c:v>
                </c:pt>
                <c:pt idx="22">
                  <c:v>1.7937219730941697E-2</c:v>
                </c:pt>
                <c:pt idx="23">
                  <c:v>1.3452914798206301E-2</c:v>
                </c:pt>
                <c:pt idx="24">
                  <c:v>1.7937219730941697E-2</c:v>
                </c:pt>
                <c:pt idx="25">
                  <c:v>4.4843049327354303E-3</c:v>
                </c:pt>
                <c:pt idx="26">
                  <c:v>0</c:v>
                </c:pt>
                <c:pt idx="27">
                  <c:v>4.4843049327354303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6"/>
          <c:order val="6"/>
          <c:tx>
            <c:strRef>
              <c:f>'cat-2(CB1112)_A5_0.02_50%'!$H$104</c:f>
              <c:strCache>
                <c:ptCount val="1"/>
                <c:pt idx="0">
                  <c:v>cat-2(CB1112)_A5_07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H$105:$H$135</c:f>
              <c:numCache>
                <c:formatCode>General</c:formatCode>
                <c:ptCount val="31"/>
                <c:pt idx="1">
                  <c:v>1.1235955056179799E-2</c:v>
                </c:pt>
                <c:pt idx="2">
                  <c:v>1.1235955056179799E-2</c:v>
                </c:pt>
                <c:pt idx="3">
                  <c:v>2.2471910112359623E-2</c:v>
                </c:pt>
                <c:pt idx="4">
                  <c:v>2.2471910112359623E-2</c:v>
                </c:pt>
                <c:pt idx="5">
                  <c:v>1.1235955056179799E-2</c:v>
                </c:pt>
                <c:pt idx="6">
                  <c:v>1.1235955056179799E-2</c:v>
                </c:pt>
                <c:pt idx="7">
                  <c:v>1.1235955056179799E-2</c:v>
                </c:pt>
                <c:pt idx="8">
                  <c:v>0</c:v>
                </c:pt>
                <c:pt idx="9">
                  <c:v>0</c:v>
                </c:pt>
                <c:pt idx="10">
                  <c:v>3.3707865168539311E-2</c:v>
                </c:pt>
                <c:pt idx="11">
                  <c:v>6.7415730337078733E-2</c:v>
                </c:pt>
                <c:pt idx="12">
                  <c:v>4.49438202247191E-2</c:v>
                </c:pt>
                <c:pt idx="13">
                  <c:v>0.15730337078651699</c:v>
                </c:pt>
                <c:pt idx="14">
                  <c:v>7.8651685393258397E-2</c:v>
                </c:pt>
                <c:pt idx="15">
                  <c:v>8.98876404494382E-2</c:v>
                </c:pt>
                <c:pt idx="16">
                  <c:v>0.11235955056179797</c:v>
                </c:pt>
                <c:pt idx="17">
                  <c:v>0.11235955056179797</c:v>
                </c:pt>
                <c:pt idx="18">
                  <c:v>4.49438202247191E-2</c:v>
                </c:pt>
                <c:pt idx="19">
                  <c:v>4.49438202247191E-2</c:v>
                </c:pt>
                <c:pt idx="20">
                  <c:v>4.49438202247191E-2</c:v>
                </c:pt>
                <c:pt idx="21">
                  <c:v>1.1235955056179799E-2</c:v>
                </c:pt>
                <c:pt idx="22">
                  <c:v>2.2471910112359623E-2</c:v>
                </c:pt>
                <c:pt idx="23">
                  <c:v>0</c:v>
                </c:pt>
                <c:pt idx="24">
                  <c:v>0</c:v>
                </c:pt>
                <c:pt idx="25">
                  <c:v>1.1235955056179799E-2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cat-2(CB1112)_A5_0.02_50%'!$I$104</c:f>
              <c:strCache>
                <c:ptCount val="1"/>
                <c:pt idx="0">
                  <c:v>cat-2(CB1112)_A5_08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I$105:$I$135</c:f>
              <c:numCache>
                <c:formatCode>General</c:formatCode>
                <c:ptCount val="31"/>
                <c:pt idx="1">
                  <c:v>5.7471264367816117E-3</c:v>
                </c:pt>
                <c:pt idx="2">
                  <c:v>1.1494252873563199E-2</c:v>
                </c:pt>
                <c:pt idx="3">
                  <c:v>5.7471264367816117E-3</c:v>
                </c:pt>
                <c:pt idx="4">
                  <c:v>0</c:v>
                </c:pt>
                <c:pt idx="5">
                  <c:v>1.1494252873563199E-2</c:v>
                </c:pt>
                <c:pt idx="6">
                  <c:v>0</c:v>
                </c:pt>
                <c:pt idx="7">
                  <c:v>1.1494252873563199E-2</c:v>
                </c:pt>
                <c:pt idx="8">
                  <c:v>2.2988505747126402E-2</c:v>
                </c:pt>
                <c:pt idx="9">
                  <c:v>1.7241379310344803E-2</c:v>
                </c:pt>
                <c:pt idx="10">
                  <c:v>2.2988505747126402E-2</c:v>
                </c:pt>
                <c:pt idx="11">
                  <c:v>2.2988505747126402E-2</c:v>
                </c:pt>
                <c:pt idx="12">
                  <c:v>4.0229885057471299E-2</c:v>
                </c:pt>
                <c:pt idx="13">
                  <c:v>8.6206896551724144E-2</c:v>
                </c:pt>
                <c:pt idx="14">
                  <c:v>9.1954022988505732E-2</c:v>
                </c:pt>
                <c:pt idx="15">
                  <c:v>0.10344827586206902</c:v>
                </c:pt>
                <c:pt idx="16">
                  <c:v>0.10344827586206902</c:v>
                </c:pt>
                <c:pt idx="17">
                  <c:v>8.6206896551724144E-2</c:v>
                </c:pt>
                <c:pt idx="18">
                  <c:v>8.6206896551724144E-2</c:v>
                </c:pt>
                <c:pt idx="19">
                  <c:v>4.0229885057471299E-2</c:v>
                </c:pt>
                <c:pt idx="20">
                  <c:v>6.8965517241379309E-2</c:v>
                </c:pt>
                <c:pt idx="21">
                  <c:v>5.7471264367816117E-3</c:v>
                </c:pt>
                <c:pt idx="22">
                  <c:v>2.2988505747126402E-2</c:v>
                </c:pt>
                <c:pt idx="23">
                  <c:v>2.8735632183908007E-2</c:v>
                </c:pt>
                <c:pt idx="24">
                  <c:v>2.8735632183908007E-2</c:v>
                </c:pt>
                <c:pt idx="25">
                  <c:v>5.7471264367816117E-3</c:v>
                </c:pt>
                <c:pt idx="26">
                  <c:v>1.1494252873563199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8"/>
          <c:order val="8"/>
          <c:tx>
            <c:strRef>
              <c:f>'cat-2(CB1112)_A5_0.02_50%'!$J$104</c:f>
              <c:strCache>
                <c:ptCount val="1"/>
                <c:pt idx="0">
                  <c:v>cat-2(CB1112)_A5_09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J$105:$J$135</c:f>
              <c:numCache>
                <c:formatCode>General</c:formatCode>
                <c:ptCount val="31"/>
                <c:pt idx="1">
                  <c:v>2.2222222222222202E-2</c:v>
                </c:pt>
                <c:pt idx="2">
                  <c:v>0</c:v>
                </c:pt>
                <c:pt idx="3">
                  <c:v>1.3333333333333301E-2</c:v>
                </c:pt>
                <c:pt idx="4">
                  <c:v>0</c:v>
                </c:pt>
                <c:pt idx="5">
                  <c:v>0</c:v>
                </c:pt>
                <c:pt idx="6">
                  <c:v>8.8888888888888941E-3</c:v>
                </c:pt>
                <c:pt idx="7">
                  <c:v>1.3333333333333301E-2</c:v>
                </c:pt>
                <c:pt idx="8">
                  <c:v>0</c:v>
                </c:pt>
                <c:pt idx="9">
                  <c:v>8.8888888888888941E-3</c:v>
                </c:pt>
                <c:pt idx="10">
                  <c:v>1.3333333333333301E-2</c:v>
                </c:pt>
                <c:pt idx="11">
                  <c:v>8.8888888888888941E-3</c:v>
                </c:pt>
                <c:pt idx="12">
                  <c:v>5.3333333333333337E-2</c:v>
                </c:pt>
                <c:pt idx="13">
                  <c:v>5.3333333333333337E-2</c:v>
                </c:pt>
                <c:pt idx="14">
                  <c:v>0.12000000000000002</c:v>
                </c:pt>
                <c:pt idx="15">
                  <c:v>9.3333333333333296E-2</c:v>
                </c:pt>
                <c:pt idx="16">
                  <c:v>0.10222222222222209</c:v>
                </c:pt>
                <c:pt idx="17">
                  <c:v>0.12000000000000002</c:v>
                </c:pt>
                <c:pt idx="18">
                  <c:v>6.6666666666666693E-2</c:v>
                </c:pt>
                <c:pt idx="19">
                  <c:v>8.8888888888888934E-2</c:v>
                </c:pt>
                <c:pt idx="20">
                  <c:v>7.1111111111111111E-2</c:v>
                </c:pt>
                <c:pt idx="21">
                  <c:v>3.1111111111111114E-2</c:v>
                </c:pt>
                <c:pt idx="22">
                  <c:v>3.1111111111111114E-2</c:v>
                </c:pt>
                <c:pt idx="23">
                  <c:v>8.8888888888888941E-3</c:v>
                </c:pt>
                <c:pt idx="24">
                  <c:v>2.2222222222222202E-2</c:v>
                </c:pt>
                <c:pt idx="25">
                  <c:v>0</c:v>
                </c:pt>
                <c:pt idx="26">
                  <c:v>2.2222222222222202E-2</c:v>
                </c:pt>
                <c:pt idx="27">
                  <c:v>0</c:v>
                </c:pt>
                <c:pt idx="28">
                  <c:v>4.4444444444444418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cat-2(CB1112)_A5_0.02_50%'!$K$104</c:f>
              <c:strCache>
                <c:ptCount val="1"/>
                <c:pt idx="0">
                  <c:v>cat-2(CB1112)_A5_10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K$105:$K$135</c:f>
              <c:numCache>
                <c:formatCode>General</c:formatCode>
                <c:ptCount val="31"/>
                <c:pt idx="1">
                  <c:v>1.3452914798206301E-2</c:v>
                </c:pt>
                <c:pt idx="2">
                  <c:v>0</c:v>
                </c:pt>
                <c:pt idx="3">
                  <c:v>4.4843049327354303E-3</c:v>
                </c:pt>
                <c:pt idx="4">
                  <c:v>4.4843049327354303E-3</c:v>
                </c:pt>
                <c:pt idx="5">
                  <c:v>0</c:v>
                </c:pt>
                <c:pt idx="6">
                  <c:v>4.4843049327354303E-3</c:v>
                </c:pt>
                <c:pt idx="7">
                  <c:v>2.6905829596412602E-2</c:v>
                </c:pt>
                <c:pt idx="8">
                  <c:v>1.7937219730941697E-2</c:v>
                </c:pt>
                <c:pt idx="9">
                  <c:v>2.2421524663677108E-2</c:v>
                </c:pt>
                <c:pt idx="10">
                  <c:v>1.3452914798206301E-2</c:v>
                </c:pt>
                <c:pt idx="11">
                  <c:v>0</c:v>
                </c:pt>
                <c:pt idx="12">
                  <c:v>0</c:v>
                </c:pt>
                <c:pt idx="13">
                  <c:v>2.6905829596412602E-2</c:v>
                </c:pt>
                <c:pt idx="14">
                  <c:v>6.2780269058296048E-2</c:v>
                </c:pt>
                <c:pt idx="15">
                  <c:v>9.865470852017949E-2</c:v>
                </c:pt>
                <c:pt idx="16">
                  <c:v>7.6233183856502199E-2</c:v>
                </c:pt>
                <c:pt idx="17">
                  <c:v>0.11659192825112104</c:v>
                </c:pt>
                <c:pt idx="18">
                  <c:v>0.10313901345291503</c:v>
                </c:pt>
                <c:pt idx="19">
                  <c:v>0.11659192825112104</c:v>
                </c:pt>
                <c:pt idx="20">
                  <c:v>8.0717488789237735E-2</c:v>
                </c:pt>
                <c:pt idx="21">
                  <c:v>4.4843049327354299E-2</c:v>
                </c:pt>
                <c:pt idx="22">
                  <c:v>4.0358744394618812E-2</c:v>
                </c:pt>
                <c:pt idx="23">
                  <c:v>1.7937219730941697E-2</c:v>
                </c:pt>
                <c:pt idx="24">
                  <c:v>1.7937219730941697E-2</c:v>
                </c:pt>
                <c:pt idx="25">
                  <c:v>4.4843049327354303E-3</c:v>
                </c:pt>
                <c:pt idx="26">
                  <c:v>2.2421524663677108E-2</c:v>
                </c:pt>
                <c:pt idx="27">
                  <c:v>4.4843049327354303E-3</c:v>
                </c:pt>
                <c:pt idx="28">
                  <c:v>4.4843049327354303E-3</c:v>
                </c:pt>
                <c:pt idx="29">
                  <c:v>4.4843049327354303E-3</c:v>
                </c:pt>
                <c:pt idx="3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cat-2(CB1112)_A5_0.02_50%'!$L$104</c:f>
              <c:strCache>
                <c:ptCount val="1"/>
                <c:pt idx="0">
                  <c:v>cat-2(CB1112)_A5_11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L$105:$L$135</c:f>
              <c:numCache>
                <c:formatCode>General</c:formatCode>
                <c:ptCount val="31"/>
                <c:pt idx="1">
                  <c:v>0</c:v>
                </c:pt>
                <c:pt idx="2">
                  <c:v>1.2461059190031204E-2</c:v>
                </c:pt>
                <c:pt idx="3">
                  <c:v>1.2461059190031204E-2</c:v>
                </c:pt>
                <c:pt idx="4">
                  <c:v>1.8691588785046703E-2</c:v>
                </c:pt>
                <c:pt idx="5">
                  <c:v>3.1152647975077907E-3</c:v>
                </c:pt>
                <c:pt idx="6">
                  <c:v>2.1806853582554513E-2</c:v>
                </c:pt>
                <c:pt idx="7">
                  <c:v>2.4922118380062301E-2</c:v>
                </c:pt>
                <c:pt idx="8">
                  <c:v>9.3457943925233673E-3</c:v>
                </c:pt>
                <c:pt idx="9">
                  <c:v>9.3457943925233673E-3</c:v>
                </c:pt>
                <c:pt idx="10">
                  <c:v>0</c:v>
                </c:pt>
                <c:pt idx="11">
                  <c:v>1.2461059190031204E-2</c:v>
                </c:pt>
                <c:pt idx="12">
                  <c:v>6.2305295950155822E-3</c:v>
                </c:pt>
                <c:pt idx="13">
                  <c:v>6.5420560747663503E-2</c:v>
                </c:pt>
                <c:pt idx="14">
                  <c:v>0.11526479750778799</c:v>
                </c:pt>
                <c:pt idx="15">
                  <c:v>0.10903426791277303</c:v>
                </c:pt>
                <c:pt idx="16">
                  <c:v>0.10280373831775701</c:v>
                </c:pt>
                <c:pt idx="17">
                  <c:v>0.12461059190031203</c:v>
                </c:pt>
                <c:pt idx="18">
                  <c:v>9.6573208722741402E-2</c:v>
                </c:pt>
                <c:pt idx="19">
                  <c:v>8.0996884735202543E-2</c:v>
                </c:pt>
                <c:pt idx="20">
                  <c:v>5.2959501557632412E-2</c:v>
                </c:pt>
                <c:pt idx="21">
                  <c:v>5.2959501557632412E-2</c:v>
                </c:pt>
                <c:pt idx="22">
                  <c:v>2.4922118380062301E-2</c:v>
                </c:pt>
                <c:pt idx="23">
                  <c:v>9.3457943925233673E-3</c:v>
                </c:pt>
                <c:pt idx="24">
                  <c:v>1.2461059190031204E-2</c:v>
                </c:pt>
                <c:pt idx="25">
                  <c:v>3.1152647975077907E-3</c:v>
                </c:pt>
                <c:pt idx="26">
                  <c:v>3.1152647975077907E-3</c:v>
                </c:pt>
                <c:pt idx="27">
                  <c:v>6.2305295950155822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cat-2(CB1112)_A5_0.02_50%'!$M$104</c:f>
              <c:strCache>
                <c:ptCount val="1"/>
                <c:pt idx="0">
                  <c:v>cat-2(CB1112)_A5_12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M$105:$M$135</c:f>
              <c:numCache>
                <c:formatCode>General</c:formatCode>
                <c:ptCount val="31"/>
                <c:pt idx="1">
                  <c:v>1.6949152542372906E-2</c:v>
                </c:pt>
                <c:pt idx="2">
                  <c:v>0</c:v>
                </c:pt>
                <c:pt idx="3">
                  <c:v>1.6949152542372906E-2</c:v>
                </c:pt>
                <c:pt idx="4">
                  <c:v>0</c:v>
                </c:pt>
                <c:pt idx="5">
                  <c:v>5.6497175141242903E-3</c:v>
                </c:pt>
                <c:pt idx="6">
                  <c:v>1.6949152542372906E-2</c:v>
                </c:pt>
                <c:pt idx="7">
                  <c:v>5.6497175141242903E-3</c:v>
                </c:pt>
                <c:pt idx="8">
                  <c:v>5.6497175141242903E-3</c:v>
                </c:pt>
                <c:pt idx="9">
                  <c:v>0</c:v>
                </c:pt>
                <c:pt idx="10">
                  <c:v>1.6949152542372906E-2</c:v>
                </c:pt>
                <c:pt idx="11">
                  <c:v>2.824858757062151E-2</c:v>
                </c:pt>
                <c:pt idx="12">
                  <c:v>3.9548022598870115E-2</c:v>
                </c:pt>
                <c:pt idx="13">
                  <c:v>9.03954802259887E-2</c:v>
                </c:pt>
                <c:pt idx="14">
                  <c:v>0.129943502824859</c:v>
                </c:pt>
                <c:pt idx="15">
                  <c:v>0.19209039548022608</c:v>
                </c:pt>
                <c:pt idx="16">
                  <c:v>0.13559322033898297</c:v>
                </c:pt>
                <c:pt idx="17">
                  <c:v>0.10169491525423703</c:v>
                </c:pt>
                <c:pt idx="18">
                  <c:v>6.7796610169491553E-2</c:v>
                </c:pt>
                <c:pt idx="19">
                  <c:v>2.824858757062151E-2</c:v>
                </c:pt>
                <c:pt idx="20">
                  <c:v>3.3898305084745811E-2</c:v>
                </c:pt>
                <c:pt idx="21">
                  <c:v>5.6497175141242903E-3</c:v>
                </c:pt>
                <c:pt idx="22">
                  <c:v>1.12994350282486E-2</c:v>
                </c:pt>
                <c:pt idx="23">
                  <c:v>1.12994350282486E-2</c:v>
                </c:pt>
                <c:pt idx="24">
                  <c:v>0</c:v>
                </c:pt>
                <c:pt idx="25">
                  <c:v>0</c:v>
                </c:pt>
                <c:pt idx="26">
                  <c:v>5.6497175141242903E-3</c:v>
                </c:pt>
                <c:pt idx="27">
                  <c:v>0</c:v>
                </c:pt>
                <c:pt idx="28">
                  <c:v>0</c:v>
                </c:pt>
                <c:pt idx="29">
                  <c:v>5.6497175141242903E-3</c:v>
                </c:pt>
                <c:pt idx="3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cat-2(CB1112)_A5_0.02_50%'!$N$104</c:f>
              <c:strCache>
                <c:ptCount val="1"/>
                <c:pt idx="0">
                  <c:v>cat-2(CB1112)_A5_13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N$105:$N$135</c:f>
              <c:numCache>
                <c:formatCode>General</c:formatCode>
                <c:ptCount val="31"/>
                <c:pt idx="1">
                  <c:v>1.3392857142857107E-2</c:v>
                </c:pt>
                <c:pt idx="2">
                  <c:v>4.4642857142857097E-3</c:v>
                </c:pt>
                <c:pt idx="3">
                  <c:v>0</c:v>
                </c:pt>
                <c:pt idx="4">
                  <c:v>8.9285714285714229E-3</c:v>
                </c:pt>
                <c:pt idx="5">
                  <c:v>4.4642857142857097E-3</c:v>
                </c:pt>
                <c:pt idx="6">
                  <c:v>0</c:v>
                </c:pt>
                <c:pt idx="7">
                  <c:v>0</c:v>
                </c:pt>
                <c:pt idx="8">
                  <c:v>4.4642857142857097E-3</c:v>
                </c:pt>
                <c:pt idx="9">
                  <c:v>8.9285714285714229E-3</c:v>
                </c:pt>
                <c:pt idx="10">
                  <c:v>8.9285714285714229E-3</c:v>
                </c:pt>
                <c:pt idx="11">
                  <c:v>8.9285714285714229E-3</c:v>
                </c:pt>
                <c:pt idx="12">
                  <c:v>4.4642857142857095E-2</c:v>
                </c:pt>
                <c:pt idx="13">
                  <c:v>5.8035714285714302E-2</c:v>
                </c:pt>
                <c:pt idx="14">
                  <c:v>0.10267857142857104</c:v>
                </c:pt>
                <c:pt idx="15">
                  <c:v>0.16071428571428606</c:v>
                </c:pt>
                <c:pt idx="16">
                  <c:v>0.14285714285714307</c:v>
                </c:pt>
                <c:pt idx="17">
                  <c:v>0.125</c:v>
                </c:pt>
                <c:pt idx="18">
                  <c:v>0.111607142857143</c:v>
                </c:pt>
                <c:pt idx="19">
                  <c:v>7.1428571428571411E-2</c:v>
                </c:pt>
                <c:pt idx="20">
                  <c:v>3.125E-2</c:v>
                </c:pt>
                <c:pt idx="21">
                  <c:v>1.3392857142857107E-2</c:v>
                </c:pt>
                <c:pt idx="22">
                  <c:v>1.7857142857142898E-2</c:v>
                </c:pt>
                <c:pt idx="23">
                  <c:v>1.7857142857142898E-2</c:v>
                </c:pt>
                <c:pt idx="24">
                  <c:v>4.4642857142857097E-3</c:v>
                </c:pt>
                <c:pt idx="25">
                  <c:v>4.4642857142857097E-3</c:v>
                </c:pt>
                <c:pt idx="26">
                  <c:v>0</c:v>
                </c:pt>
                <c:pt idx="27">
                  <c:v>4.4642857142857097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cat-2(CB1112)_A5_0.02_50%'!$O$104</c:f>
              <c:strCache>
                <c:ptCount val="1"/>
                <c:pt idx="0">
                  <c:v>cat-2(CB1112)_A5_14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O$105:$O$135</c:f>
              <c:numCache>
                <c:formatCode>General</c:formatCode>
                <c:ptCount val="31"/>
                <c:pt idx="1">
                  <c:v>4.4843049327354303E-3</c:v>
                </c:pt>
                <c:pt idx="2">
                  <c:v>0</c:v>
                </c:pt>
                <c:pt idx="3">
                  <c:v>0</c:v>
                </c:pt>
                <c:pt idx="4">
                  <c:v>4.4843049327354303E-3</c:v>
                </c:pt>
                <c:pt idx="5">
                  <c:v>0</c:v>
                </c:pt>
                <c:pt idx="6">
                  <c:v>1.3452914798206301E-2</c:v>
                </c:pt>
                <c:pt idx="7">
                  <c:v>0</c:v>
                </c:pt>
                <c:pt idx="8">
                  <c:v>4.4843049327354303E-3</c:v>
                </c:pt>
                <c:pt idx="9">
                  <c:v>4.4843049327354303E-3</c:v>
                </c:pt>
                <c:pt idx="10">
                  <c:v>4.4843049327354303E-3</c:v>
                </c:pt>
                <c:pt idx="11">
                  <c:v>4.4843049327354299E-2</c:v>
                </c:pt>
                <c:pt idx="12">
                  <c:v>5.3811659192825115E-2</c:v>
                </c:pt>
                <c:pt idx="13">
                  <c:v>7.6233183856502199E-2</c:v>
                </c:pt>
                <c:pt idx="14">
                  <c:v>0.13452914798206306</c:v>
                </c:pt>
                <c:pt idx="15">
                  <c:v>0.15246636771300406</c:v>
                </c:pt>
                <c:pt idx="16">
                  <c:v>0.13452914798206306</c:v>
                </c:pt>
                <c:pt idx="17">
                  <c:v>0.12107623318385703</c:v>
                </c:pt>
                <c:pt idx="18">
                  <c:v>7.6233183856502199E-2</c:v>
                </c:pt>
                <c:pt idx="19">
                  <c:v>4.4843049327354299E-2</c:v>
                </c:pt>
                <c:pt idx="20">
                  <c:v>5.8295964125560498E-2</c:v>
                </c:pt>
                <c:pt idx="21">
                  <c:v>1.3452914798206301E-2</c:v>
                </c:pt>
                <c:pt idx="22">
                  <c:v>4.4843049327354303E-3</c:v>
                </c:pt>
                <c:pt idx="23">
                  <c:v>8.9686098654708502E-3</c:v>
                </c:pt>
                <c:pt idx="24">
                  <c:v>4.4843049327354303E-3</c:v>
                </c:pt>
                <c:pt idx="25">
                  <c:v>4.4843049327354303E-3</c:v>
                </c:pt>
                <c:pt idx="26">
                  <c:v>4.4843049327354303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4.4843049327354303E-3</c:v>
                </c:pt>
              </c:numCache>
            </c:numRef>
          </c:val>
        </c:ser>
        <c:ser>
          <c:idx val="14"/>
          <c:order val="14"/>
          <c:tx>
            <c:strRef>
              <c:f>'cat-2(CB1112)_A5_0.02_50%'!$P$104</c:f>
              <c:strCache>
                <c:ptCount val="1"/>
                <c:pt idx="0">
                  <c:v>cat-2(CB1112)_A5_15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P$105:$P$135</c:f>
              <c:numCache>
                <c:formatCode>General</c:formatCode>
                <c:ptCount val="31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.1494252873563199E-2</c:v>
                </c:pt>
                <c:pt idx="5">
                  <c:v>2.2988505747126402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3.4482758620689717E-2</c:v>
                </c:pt>
                <c:pt idx="14">
                  <c:v>8.04597701149425E-2</c:v>
                </c:pt>
                <c:pt idx="15">
                  <c:v>5.7471264367816112E-2</c:v>
                </c:pt>
                <c:pt idx="16">
                  <c:v>0.14942528735632213</c:v>
                </c:pt>
                <c:pt idx="17">
                  <c:v>0.13793103448275906</c:v>
                </c:pt>
                <c:pt idx="18">
                  <c:v>0.12643678160919505</c:v>
                </c:pt>
                <c:pt idx="19">
                  <c:v>0.11494252873563203</c:v>
                </c:pt>
                <c:pt idx="20">
                  <c:v>9.1954022988505732E-2</c:v>
                </c:pt>
                <c:pt idx="21">
                  <c:v>4.5977011494252887E-2</c:v>
                </c:pt>
                <c:pt idx="22">
                  <c:v>2.2988505747126402E-2</c:v>
                </c:pt>
                <c:pt idx="23">
                  <c:v>2.2988505747126402E-2</c:v>
                </c:pt>
                <c:pt idx="24">
                  <c:v>2.2988505747126402E-2</c:v>
                </c:pt>
                <c:pt idx="25">
                  <c:v>1.1494252873563199E-2</c:v>
                </c:pt>
                <c:pt idx="26">
                  <c:v>1.1494252873563199E-2</c:v>
                </c:pt>
                <c:pt idx="27">
                  <c:v>1.1494252873563199E-2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5"/>
          <c:order val="15"/>
          <c:tx>
            <c:strRef>
              <c:f>'cat-2(CB1112)_A5_0.02_50%'!$Q$104</c:f>
              <c:strCache>
                <c:ptCount val="1"/>
                <c:pt idx="0">
                  <c:v>cat-2(CB1112)_A5_16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Q$105:$Q$135</c:f>
              <c:numCache>
                <c:formatCode>General</c:formatCode>
                <c:ptCount val="31"/>
                <c:pt idx="1">
                  <c:v>9.6045197740112997E-2</c:v>
                </c:pt>
                <c:pt idx="2">
                  <c:v>3.9548022598870115E-2</c:v>
                </c:pt>
                <c:pt idx="3">
                  <c:v>5.6497175141242903E-2</c:v>
                </c:pt>
                <c:pt idx="4">
                  <c:v>3.3898305084745811E-2</c:v>
                </c:pt>
                <c:pt idx="5">
                  <c:v>4.5197740112994399E-2</c:v>
                </c:pt>
                <c:pt idx="6">
                  <c:v>3.3898305084745811E-2</c:v>
                </c:pt>
                <c:pt idx="7">
                  <c:v>2.2598870056497199E-2</c:v>
                </c:pt>
                <c:pt idx="8">
                  <c:v>1.12994350282486E-2</c:v>
                </c:pt>
                <c:pt idx="9">
                  <c:v>2.824858757062151E-2</c:v>
                </c:pt>
                <c:pt idx="10">
                  <c:v>2.2598870056497199E-2</c:v>
                </c:pt>
                <c:pt idx="11">
                  <c:v>2.824858757062151E-2</c:v>
                </c:pt>
                <c:pt idx="12">
                  <c:v>2.824858757062151E-2</c:v>
                </c:pt>
                <c:pt idx="13">
                  <c:v>6.21468926553672E-2</c:v>
                </c:pt>
                <c:pt idx="14">
                  <c:v>2.824858757062151E-2</c:v>
                </c:pt>
                <c:pt idx="15">
                  <c:v>1.12994350282486E-2</c:v>
                </c:pt>
                <c:pt idx="16">
                  <c:v>4.5197740112994399E-2</c:v>
                </c:pt>
                <c:pt idx="17">
                  <c:v>2.824858757062151E-2</c:v>
                </c:pt>
                <c:pt idx="18">
                  <c:v>2.2598870056497199E-2</c:v>
                </c:pt>
                <c:pt idx="19">
                  <c:v>1.6949152542372906E-2</c:v>
                </c:pt>
                <c:pt idx="20">
                  <c:v>1.12994350282486E-2</c:v>
                </c:pt>
                <c:pt idx="21">
                  <c:v>2.824858757062151E-2</c:v>
                </c:pt>
                <c:pt idx="22">
                  <c:v>2.2598870056497199E-2</c:v>
                </c:pt>
                <c:pt idx="23">
                  <c:v>2.824858757062151E-2</c:v>
                </c:pt>
                <c:pt idx="24">
                  <c:v>2.2598870056497199E-2</c:v>
                </c:pt>
                <c:pt idx="25">
                  <c:v>1.6949152542372906E-2</c:v>
                </c:pt>
                <c:pt idx="26">
                  <c:v>5.6497175141242903E-3</c:v>
                </c:pt>
                <c:pt idx="27">
                  <c:v>1.12994350282486E-2</c:v>
                </c:pt>
                <c:pt idx="28">
                  <c:v>5.6497175141242903E-3</c:v>
                </c:pt>
                <c:pt idx="29">
                  <c:v>0</c:v>
                </c:pt>
                <c:pt idx="30">
                  <c:v>1.12994350282486E-2</c:v>
                </c:pt>
              </c:numCache>
            </c:numRef>
          </c:val>
        </c:ser>
        <c:ser>
          <c:idx val="16"/>
          <c:order val="16"/>
          <c:tx>
            <c:strRef>
              <c:f>'cat-2(CB1112)_A5_0.02_50%'!$R$104</c:f>
              <c:strCache>
                <c:ptCount val="1"/>
                <c:pt idx="0">
                  <c:v>cat-2(CB1112)_A5_17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R$105:$R$135</c:f>
              <c:numCache>
                <c:formatCode>General</c:formatCode>
                <c:ptCount val="31"/>
                <c:pt idx="1">
                  <c:v>1.6042780748663114E-2</c:v>
                </c:pt>
                <c:pt idx="2">
                  <c:v>1.6042780748663114E-2</c:v>
                </c:pt>
                <c:pt idx="3">
                  <c:v>5.3475935828877002E-3</c:v>
                </c:pt>
                <c:pt idx="4">
                  <c:v>1.06951871657754E-2</c:v>
                </c:pt>
                <c:pt idx="5">
                  <c:v>1.6042780748663114E-2</c:v>
                </c:pt>
                <c:pt idx="6">
                  <c:v>1.6042780748663114E-2</c:v>
                </c:pt>
                <c:pt idx="7">
                  <c:v>1.06951871657754E-2</c:v>
                </c:pt>
                <c:pt idx="8">
                  <c:v>1.06951871657754E-2</c:v>
                </c:pt>
                <c:pt idx="9">
                  <c:v>2.1390374331550797E-2</c:v>
                </c:pt>
                <c:pt idx="10">
                  <c:v>1.06951871657754E-2</c:v>
                </c:pt>
                <c:pt idx="11">
                  <c:v>1.06951871657754E-2</c:v>
                </c:pt>
                <c:pt idx="12">
                  <c:v>3.2085561497326213E-2</c:v>
                </c:pt>
                <c:pt idx="13">
                  <c:v>3.7433155080213928E-2</c:v>
                </c:pt>
                <c:pt idx="14">
                  <c:v>7.4866310160427829E-2</c:v>
                </c:pt>
                <c:pt idx="15">
                  <c:v>0.12834224598930499</c:v>
                </c:pt>
                <c:pt idx="16">
                  <c:v>0.15508021390374294</c:v>
                </c:pt>
                <c:pt idx="17">
                  <c:v>8.0213903743315482E-2</c:v>
                </c:pt>
                <c:pt idx="18">
                  <c:v>6.4171122994652399E-2</c:v>
                </c:pt>
                <c:pt idx="19">
                  <c:v>5.3475935828877004E-2</c:v>
                </c:pt>
                <c:pt idx="20">
                  <c:v>5.3475935828877004E-2</c:v>
                </c:pt>
                <c:pt idx="21">
                  <c:v>5.8823529411764698E-2</c:v>
                </c:pt>
                <c:pt idx="22">
                  <c:v>3.7433155080213928E-2</c:v>
                </c:pt>
                <c:pt idx="23">
                  <c:v>5.3475935828877002E-3</c:v>
                </c:pt>
                <c:pt idx="24">
                  <c:v>5.3475935828877002E-3</c:v>
                </c:pt>
                <c:pt idx="25">
                  <c:v>1.06951871657754E-2</c:v>
                </c:pt>
                <c:pt idx="26">
                  <c:v>5.3475935828877002E-3</c:v>
                </c:pt>
                <c:pt idx="27">
                  <c:v>0</c:v>
                </c:pt>
                <c:pt idx="28">
                  <c:v>0</c:v>
                </c:pt>
                <c:pt idx="29">
                  <c:v>5.3475935828877002E-3</c:v>
                </c:pt>
                <c:pt idx="30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cat-2(CB1112)_A5_0.02_50%'!$S$104</c:f>
              <c:strCache>
                <c:ptCount val="1"/>
                <c:pt idx="0">
                  <c:v>cat-2(CB1112)_A5_18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S$105:$S$135</c:f>
              <c:numCache>
                <c:formatCode>General</c:formatCode>
                <c:ptCount val="31"/>
                <c:pt idx="1">
                  <c:v>2.9787234042553207E-2</c:v>
                </c:pt>
                <c:pt idx="2">
                  <c:v>2.1276595744680899E-2</c:v>
                </c:pt>
                <c:pt idx="3">
                  <c:v>8.5106382978723475E-3</c:v>
                </c:pt>
                <c:pt idx="4">
                  <c:v>2.1276595744680899E-2</c:v>
                </c:pt>
                <c:pt idx="5">
                  <c:v>1.2765957446808501E-2</c:v>
                </c:pt>
                <c:pt idx="6">
                  <c:v>1.2765957446808501E-2</c:v>
                </c:pt>
                <c:pt idx="7">
                  <c:v>4.255319148936172E-3</c:v>
                </c:pt>
                <c:pt idx="8">
                  <c:v>0</c:v>
                </c:pt>
                <c:pt idx="9">
                  <c:v>4.255319148936172E-3</c:v>
                </c:pt>
                <c:pt idx="10">
                  <c:v>4.255319148936172E-3</c:v>
                </c:pt>
                <c:pt idx="11">
                  <c:v>4.255319148936172E-3</c:v>
                </c:pt>
                <c:pt idx="12">
                  <c:v>3.4042553191489397E-2</c:v>
                </c:pt>
                <c:pt idx="13">
                  <c:v>3.4042553191489397E-2</c:v>
                </c:pt>
                <c:pt idx="14">
                  <c:v>7.2340425531914901E-2</c:v>
                </c:pt>
                <c:pt idx="15">
                  <c:v>8.0851063829787226E-2</c:v>
                </c:pt>
                <c:pt idx="16">
                  <c:v>0.1276595744680849</c:v>
                </c:pt>
                <c:pt idx="17">
                  <c:v>0.13191489361702111</c:v>
                </c:pt>
                <c:pt idx="18">
                  <c:v>8.5106382978723472E-2</c:v>
                </c:pt>
                <c:pt idx="19">
                  <c:v>8.5106382978723472E-2</c:v>
                </c:pt>
                <c:pt idx="20">
                  <c:v>5.5319148936170202E-2</c:v>
                </c:pt>
                <c:pt idx="21">
                  <c:v>7.2340425531914901E-2</c:v>
                </c:pt>
                <c:pt idx="22">
                  <c:v>2.5531914893617006E-2</c:v>
                </c:pt>
                <c:pt idx="23">
                  <c:v>4.255319148936172E-3</c:v>
                </c:pt>
                <c:pt idx="24">
                  <c:v>1.7021276595744698E-2</c:v>
                </c:pt>
                <c:pt idx="25">
                  <c:v>4.255319148936172E-3</c:v>
                </c:pt>
                <c:pt idx="26">
                  <c:v>0</c:v>
                </c:pt>
                <c:pt idx="27">
                  <c:v>0</c:v>
                </c:pt>
                <c:pt idx="28">
                  <c:v>4.255319148936172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8"/>
          <c:order val="18"/>
          <c:tx>
            <c:strRef>
              <c:f>'cat-2(CB1112)_A5_0.02_50%'!$T$104</c:f>
              <c:strCache>
                <c:ptCount val="1"/>
                <c:pt idx="0">
                  <c:v>cat-2(CB1112)_A5_19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T$105:$T$135</c:f>
              <c:numCache>
                <c:formatCode>General</c:formatCode>
                <c:ptCount val="31"/>
                <c:pt idx="1">
                  <c:v>7.1910112359550596E-2</c:v>
                </c:pt>
                <c:pt idx="2">
                  <c:v>5.8426966292134813E-2</c:v>
                </c:pt>
                <c:pt idx="3">
                  <c:v>4.49438202247191E-2</c:v>
                </c:pt>
                <c:pt idx="4">
                  <c:v>3.8202247191011202E-2</c:v>
                </c:pt>
                <c:pt idx="5">
                  <c:v>5.1685393258426998E-2</c:v>
                </c:pt>
                <c:pt idx="6">
                  <c:v>6.9662921348314658E-2</c:v>
                </c:pt>
                <c:pt idx="7">
                  <c:v>5.8426966292134813E-2</c:v>
                </c:pt>
                <c:pt idx="8">
                  <c:v>5.1685393258426998E-2</c:v>
                </c:pt>
                <c:pt idx="9">
                  <c:v>4.9438202247191011E-2</c:v>
                </c:pt>
                <c:pt idx="10">
                  <c:v>4.7191011235955115E-2</c:v>
                </c:pt>
                <c:pt idx="11">
                  <c:v>5.3932584269662902E-2</c:v>
                </c:pt>
                <c:pt idx="12">
                  <c:v>6.0674157303370779E-2</c:v>
                </c:pt>
                <c:pt idx="13">
                  <c:v>3.8202247191011202E-2</c:v>
                </c:pt>
                <c:pt idx="14">
                  <c:v>5.3932584269662902E-2</c:v>
                </c:pt>
                <c:pt idx="15">
                  <c:v>4.9438202247191011E-2</c:v>
                </c:pt>
                <c:pt idx="16">
                  <c:v>4.0449438202247202E-2</c:v>
                </c:pt>
                <c:pt idx="17">
                  <c:v>3.14606741573034E-2</c:v>
                </c:pt>
                <c:pt idx="18">
                  <c:v>1.57303370786517E-2</c:v>
                </c:pt>
                <c:pt idx="19">
                  <c:v>2.4719101123595499E-2</c:v>
                </c:pt>
                <c:pt idx="20">
                  <c:v>1.7977528089887607E-2</c:v>
                </c:pt>
                <c:pt idx="21">
                  <c:v>1.1235955056179799E-2</c:v>
                </c:pt>
                <c:pt idx="22">
                  <c:v>2.2471910112359626E-3</c:v>
                </c:pt>
                <c:pt idx="23">
                  <c:v>0</c:v>
                </c:pt>
                <c:pt idx="24">
                  <c:v>2.2471910112359626E-3</c:v>
                </c:pt>
                <c:pt idx="25">
                  <c:v>0</c:v>
                </c:pt>
                <c:pt idx="26">
                  <c:v>2.2471910112359626E-3</c:v>
                </c:pt>
                <c:pt idx="27">
                  <c:v>0</c:v>
                </c:pt>
                <c:pt idx="28">
                  <c:v>0</c:v>
                </c:pt>
                <c:pt idx="29">
                  <c:v>2.2471910112359626E-3</c:v>
                </c:pt>
                <c:pt idx="30">
                  <c:v>0</c:v>
                </c:pt>
              </c:numCache>
            </c:numRef>
          </c:val>
        </c:ser>
        <c:ser>
          <c:idx val="19"/>
          <c:order val="19"/>
          <c:tx>
            <c:strRef>
              <c:f>'cat-2(CB1112)_A5_0.02_50%'!$U$104</c:f>
              <c:strCache>
                <c:ptCount val="1"/>
                <c:pt idx="0">
                  <c:v>cat-2(CB1112)_A5_20</c:v>
                </c:pt>
              </c:strCache>
            </c:strRef>
          </c:tx>
          <c:marker>
            <c:symbol val="none"/>
          </c:marker>
          <c:cat>
            <c:numRef>
              <c:f>'cat-2(CB1112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5_0.02_50%'!$U$105:$U$135</c:f>
              <c:numCache>
                <c:formatCode>General</c:formatCode>
                <c:ptCount val="31"/>
                <c:pt idx="1">
                  <c:v>1.3761467889908304E-2</c:v>
                </c:pt>
                <c:pt idx="2">
                  <c:v>9.1743119266055103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9.1743119266055103E-3</c:v>
                </c:pt>
                <c:pt idx="7">
                  <c:v>9.1743119266055103E-3</c:v>
                </c:pt>
                <c:pt idx="8">
                  <c:v>0</c:v>
                </c:pt>
                <c:pt idx="9">
                  <c:v>4.5871559633027499E-3</c:v>
                </c:pt>
                <c:pt idx="10">
                  <c:v>9.1743119266055103E-3</c:v>
                </c:pt>
                <c:pt idx="11">
                  <c:v>9.1743119266055103E-3</c:v>
                </c:pt>
                <c:pt idx="12">
                  <c:v>4.5871559633027499E-3</c:v>
                </c:pt>
                <c:pt idx="13">
                  <c:v>3.2110091743119309E-2</c:v>
                </c:pt>
                <c:pt idx="14">
                  <c:v>3.6697247706422027E-2</c:v>
                </c:pt>
                <c:pt idx="15">
                  <c:v>9.1743119266055079E-2</c:v>
                </c:pt>
                <c:pt idx="16">
                  <c:v>0.11467889908256895</c:v>
                </c:pt>
                <c:pt idx="17">
                  <c:v>0.11926605504587204</c:v>
                </c:pt>
                <c:pt idx="18">
                  <c:v>0.123853211009174</c:v>
                </c:pt>
                <c:pt idx="19">
                  <c:v>0.123853211009174</c:v>
                </c:pt>
                <c:pt idx="20">
                  <c:v>8.256880733944956E-2</c:v>
                </c:pt>
                <c:pt idx="21">
                  <c:v>4.128440366972478E-2</c:v>
                </c:pt>
                <c:pt idx="22">
                  <c:v>5.0458715596330313E-2</c:v>
                </c:pt>
                <c:pt idx="23">
                  <c:v>2.7522935779816515E-2</c:v>
                </c:pt>
                <c:pt idx="24">
                  <c:v>1.8348623853211E-2</c:v>
                </c:pt>
                <c:pt idx="25">
                  <c:v>9.1743119266055103E-3</c:v>
                </c:pt>
                <c:pt idx="26">
                  <c:v>4.5871559633027499E-3</c:v>
                </c:pt>
                <c:pt idx="27">
                  <c:v>4.5871559633027499E-3</c:v>
                </c:pt>
                <c:pt idx="28">
                  <c:v>9.1743119266055103E-3</c:v>
                </c:pt>
                <c:pt idx="29">
                  <c:v>4.5871559633027499E-3</c:v>
                </c:pt>
                <c:pt idx="30">
                  <c:v>4.5871559633027499E-3</c:v>
                </c:pt>
              </c:numCache>
            </c:numRef>
          </c:val>
        </c:ser>
        <c:marker val="1"/>
        <c:axId val="168102528"/>
        <c:axId val="168124800"/>
      </c:lineChart>
      <c:catAx>
        <c:axId val="168102528"/>
        <c:scaling>
          <c:orientation val="minMax"/>
        </c:scaling>
        <c:axPos val="b"/>
        <c:numFmt formatCode="0.0_ " sourceLinked="1"/>
        <c:tickLblPos val="nextTo"/>
        <c:crossAx val="168124800"/>
        <c:crosses val="autoZero"/>
        <c:auto val="1"/>
        <c:lblAlgn val="ctr"/>
        <c:lblOffset val="100"/>
        <c:tickLblSkip val="5"/>
        <c:tickMarkSkip val="5"/>
      </c:catAx>
      <c:valAx>
        <c:axId val="168124800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8102528"/>
        <c:crosses val="autoZero"/>
        <c:crossBetween val="between"/>
      </c:valAx>
    </c:plotArea>
    <c:plotVisOnly val="1"/>
  </c:chart>
  <c:externalData r:id="rId1"/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cat-2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3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cat-2(CB1112)_A3_0.02_50%'!$B$104</c:f>
              <c:strCache>
                <c:ptCount val="1"/>
                <c:pt idx="0">
                  <c:v>cat-2(CB1112)_A3_01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B$105:$B$135</c:f>
              <c:numCache>
                <c:formatCode>General</c:formatCode>
                <c:ptCount val="31"/>
                <c:pt idx="1">
                  <c:v>1.3157894736842101E-2</c:v>
                </c:pt>
                <c:pt idx="2">
                  <c:v>6.5789473684210514E-3</c:v>
                </c:pt>
                <c:pt idx="3">
                  <c:v>1.9736842105263205E-2</c:v>
                </c:pt>
                <c:pt idx="4">
                  <c:v>0</c:v>
                </c:pt>
                <c:pt idx="5">
                  <c:v>6.5789473684210514E-3</c:v>
                </c:pt>
                <c:pt idx="6">
                  <c:v>0</c:v>
                </c:pt>
                <c:pt idx="7">
                  <c:v>0</c:v>
                </c:pt>
                <c:pt idx="8">
                  <c:v>6.5789473684210514E-3</c:v>
                </c:pt>
                <c:pt idx="9">
                  <c:v>0</c:v>
                </c:pt>
                <c:pt idx="10">
                  <c:v>0</c:v>
                </c:pt>
                <c:pt idx="11">
                  <c:v>1.3157894736842101E-2</c:v>
                </c:pt>
                <c:pt idx="12">
                  <c:v>1.3157894736842101E-2</c:v>
                </c:pt>
                <c:pt idx="13">
                  <c:v>3.9473684210526314E-2</c:v>
                </c:pt>
                <c:pt idx="14">
                  <c:v>5.2631578947368404E-2</c:v>
                </c:pt>
                <c:pt idx="15">
                  <c:v>4.6052631578947421E-2</c:v>
                </c:pt>
                <c:pt idx="16">
                  <c:v>9.8684210526315805E-2</c:v>
                </c:pt>
                <c:pt idx="17">
                  <c:v>7.2368421052631651E-2</c:v>
                </c:pt>
                <c:pt idx="18">
                  <c:v>9.8684210526315805E-2</c:v>
                </c:pt>
                <c:pt idx="19">
                  <c:v>9.8684210526315805E-2</c:v>
                </c:pt>
                <c:pt idx="20">
                  <c:v>0.125</c:v>
                </c:pt>
                <c:pt idx="21">
                  <c:v>7.8947368421052572E-2</c:v>
                </c:pt>
                <c:pt idx="22">
                  <c:v>4.6052631578947421E-2</c:v>
                </c:pt>
                <c:pt idx="23">
                  <c:v>5.2631578947368404E-2</c:v>
                </c:pt>
                <c:pt idx="24">
                  <c:v>3.2894736842105317E-2</c:v>
                </c:pt>
                <c:pt idx="25">
                  <c:v>1.9736842105263205E-2</c:v>
                </c:pt>
                <c:pt idx="26">
                  <c:v>1.3157894736842101E-2</c:v>
                </c:pt>
                <c:pt idx="27">
                  <c:v>1.3157894736842101E-2</c:v>
                </c:pt>
                <c:pt idx="28">
                  <c:v>0</c:v>
                </c:pt>
                <c:pt idx="29">
                  <c:v>1.3157894736842101E-2</c:v>
                </c:pt>
                <c:pt idx="30">
                  <c:v>1.3157894736842101E-2</c:v>
                </c:pt>
              </c:numCache>
            </c:numRef>
          </c:val>
        </c:ser>
        <c:ser>
          <c:idx val="1"/>
          <c:order val="1"/>
          <c:tx>
            <c:strRef>
              <c:f>'cat-2(CB1112)_A3_0.02_50%'!$C$104</c:f>
              <c:strCache>
                <c:ptCount val="1"/>
                <c:pt idx="0">
                  <c:v>cat-2(CB1112)_A3_02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C$105:$C$135</c:f>
              <c:numCache>
                <c:formatCode>General</c:formatCode>
                <c:ptCount val="31"/>
                <c:pt idx="1">
                  <c:v>0</c:v>
                </c:pt>
                <c:pt idx="2">
                  <c:v>0</c:v>
                </c:pt>
                <c:pt idx="3">
                  <c:v>5.7803468208092517E-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1560693641618505E-2</c:v>
                </c:pt>
                <c:pt idx="9">
                  <c:v>5.7803468208092517E-3</c:v>
                </c:pt>
                <c:pt idx="10">
                  <c:v>5.2023121387283211E-2</c:v>
                </c:pt>
                <c:pt idx="11">
                  <c:v>4.6242774566473979E-2</c:v>
                </c:pt>
                <c:pt idx="12">
                  <c:v>0.14450867052023106</c:v>
                </c:pt>
                <c:pt idx="13">
                  <c:v>0.19075144508670505</c:v>
                </c:pt>
                <c:pt idx="14">
                  <c:v>0.179190751445087</c:v>
                </c:pt>
                <c:pt idx="15">
                  <c:v>0.12138728323699402</c:v>
                </c:pt>
                <c:pt idx="16">
                  <c:v>8.0924855491329564E-2</c:v>
                </c:pt>
                <c:pt idx="17">
                  <c:v>8.6705202312138713E-2</c:v>
                </c:pt>
                <c:pt idx="18">
                  <c:v>2.8901734104046197E-2</c:v>
                </c:pt>
                <c:pt idx="19">
                  <c:v>2.8901734104046197E-2</c:v>
                </c:pt>
                <c:pt idx="20">
                  <c:v>5.7803468208092517E-3</c:v>
                </c:pt>
                <c:pt idx="21">
                  <c:v>5.7803468208092517E-3</c:v>
                </c:pt>
                <c:pt idx="22">
                  <c:v>0</c:v>
                </c:pt>
                <c:pt idx="23">
                  <c:v>5.7803468208092517E-3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cat-2(CB1112)_A3_0.02_50%'!$D$104</c:f>
              <c:strCache>
                <c:ptCount val="1"/>
                <c:pt idx="0">
                  <c:v>cat-2(CB1112)_A3_04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D$105:$D$135</c:f>
              <c:numCache>
                <c:formatCode>General</c:formatCode>
                <c:ptCount val="31"/>
                <c:pt idx="1">
                  <c:v>9.8522167487684765E-3</c:v>
                </c:pt>
                <c:pt idx="2">
                  <c:v>9.8522167487684765E-3</c:v>
                </c:pt>
                <c:pt idx="3">
                  <c:v>4.9261083743842417E-3</c:v>
                </c:pt>
                <c:pt idx="4">
                  <c:v>1.9704433497536908E-2</c:v>
                </c:pt>
                <c:pt idx="5">
                  <c:v>1.9704433497536908E-2</c:v>
                </c:pt>
                <c:pt idx="6">
                  <c:v>0</c:v>
                </c:pt>
                <c:pt idx="7">
                  <c:v>0</c:v>
                </c:pt>
                <c:pt idx="8">
                  <c:v>4.9261083743842417E-3</c:v>
                </c:pt>
                <c:pt idx="9">
                  <c:v>0</c:v>
                </c:pt>
                <c:pt idx="10">
                  <c:v>4.9261083743842417E-3</c:v>
                </c:pt>
                <c:pt idx="11">
                  <c:v>4.9261083743842417E-3</c:v>
                </c:pt>
                <c:pt idx="12">
                  <c:v>0</c:v>
                </c:pt>
                <c:pt idx="13">
                  <c:v>3.9408866995073899E-2</c:v>
                </c:pt>
                <c:pt idx="14">
                  <c:v>4.9261083743842415E-2</c:v>
                </c:pt>
                <c:pt idx="15">
                  <c:v>7.3891625615763623E-2</c:v>
                </c:pt>
                <c:pt idx="16">
                  <c:v>0.10344827586206902</c:v>
                </c:pt>
                <c:pt idx="17">
                  <c:v>0.12807881773398988</c:v>
                </c:pt>
                <c:pt idx="18">
                  <c:v>0.13793103448275906</c:v>
                </c:pt>
                <c:pt idx="19">
                  <c:v>9.3596059113300559E-2</c:v>
                </c:pt>
                <c:pt idx="20">
                  <c:v>6.8965517241379309E-2</c:v>
                </c:pt>
                <c:pt idx="21">
                  <c:v>5.4187192118226618E-2</c:v>
                </c:pt>
                <c:pt idx="22">
                  <c:v>3.9408866995073899E-2</c:v>
                </c:pt>
                <c:pt idx="23">
                  <c:v>2.9556650246305397E-2</c:v>
                </c:pt>
                <c:pt idx="24">
                  <c:v>2.9556650246305397E-2</c:v>
                </c:pt>
                <c:pt idx="25">
                  <c:v>9.8522167487684765E-3</c:v>
                </c:pt>
                <c:pt idx="26">
                  <c:v>1.47783251231527E-2</c:v>
                </c:pt>
                <c:pt idx="27">
                  <c:v>0</c:v>
                </c:pt>
                <c:pt idx="28">
                  <c:v>1.47783251231527E-2</c:v>
                </c:pt>
                <c:pt idx="29">
                  <c:v>9.8522167487684765E-3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cat-2(CB1112)_A3_0.02_50%'!$E$104</c:f>
              <c:strCache>
                <c:ptCount val="1"/>
                <c:pt idx="0">
                  <c:v>cat-2(CB1112)_A3_05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E$105:$E$135</c:f>
              <c:numCache>
                <c:formatCode>General</c:formatCode>
                <c:ptCount val="31"/>
                <c:pt idx="1">
                  <c:v>0</c:v>
                </c:pt>
                <c:pt idx="2">
                  <c:v>4.3103448275862077E-3</c:v>
                </c:pt>
                <c:pt idx="3">
                  <c:v>0</c:v>
                </c:pt>
                <c:pt idx="4">
                  <c:v>0</c:v>
                </c:pt>
                <c:pt idx="5">
                  <c:v>4.3103448275862077E-3</c:v>
                </c:pt>
                <c:pt idx="6">
                  <c:v>0</c:v>
                </c:pt>
                <c:pt idx="7">
                  <c:v>0</c:v>
                </c:pt>
                <c:pt idx="8">
                  <c:v>4.3103448275862077E-3</c:v>
                </c:pt>
                <c:pt idx="9">
                  <c:v>1.7241379310344803E-2</c:v>
                </c:pt>
                <c:pt idx="10">
                  <c:v>4.3103448275862079E-2</c:v>
                </c:pt>
                <c:pt idx="11">
                  <c:v>5.6034482758620718E-2</c:v>
                </c:pt>
                <c:pt idx="12">
                  <c:v>0.11206896551724101</c:v>
                </c:pt>
                <c:pt idx="13">
                  <c:v>0.18103448275862111</c:v>
                </c:pt>
                <c:pt idx="14">
                  <c:v>0.15517241379310301</c:v>
                </c:pt>
                <c:pt idx="15">
                  <c:v>0.13793103448275906</c:v>
                </c:pt>
                <c:pt idx="16">
                  <c:v>7.3275862068965456E-2</c:v>
                </c:pt>
                <c:pt idx="17">
                  <c:v>8.6206896551724144E-2</c:v>
                </c:pt>
                <c:pt idx="18">
                  <c:v>3.8793103448275912E-2</c:v>
                </c:pt>
                <c:pt idx="19">
                  <c:v>3.8793103448275912E-2</c:v>
                </c:pt>
                <c:pt idx="20">
                  <c:v>1.7241379310344803E-2</c:v>
                </c:pt>
                <c:pt idx="21">
                  <c:v>4.3103448275862077E-3</c:v>
                </c:pt>
                <c:pt idx="22">
                  <c:v>0</c:v>
                </c:pt>
                <c:pt idx="23">
                  <c:v>4.3103448275862077E-3</c:v>
                </c:pt>
                <c:pt idx="24">
                  <c:v>8.6206896551724154E-3</c:v>
                </c:pt>
                <c:pt idx="25">
                  <c:v>0</c:v>
                </c:pt>
                <c:pt idx="26">
                  <c:v>0</c:v>
                </c:pt>
                <c:pt idx="27">
                  <c:v>4.3103448275862077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cat-2(CB1112)_A3_0.02_50%'!$F$104</c:f>
              <c:strCache>
                <c:ptCount val="1"/>
                <c:pt idx="0">
                  <c:v>cat-2(CB1112)_A3_06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F$105:$F$135</c:f>
              <c:numCache>
                <c:formatCode>General</c:formatCode>
                <c:ptCount val="31"/>
                <c:pt idx="1">
                  <c:v>0</c:v>
                </c:pt>
                <c:pt idx="2">
                  <c:v>0</c:v>
                </c:pt>
                <c:pt idx="3">
                  <c:v>4.3668122270742399E-3</c:v>
                </c:pt>
                <c:pt idx="4">
                  <c:v>0</c:v>
                </c:pt>
                <c:pt idx="5">
                  <c:v>4.3668122270742399E-3</c:v>
                </c:pt>
                <c:pt idx="6">
                  <c:v>8.7336244541484729E-3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8.7336244541484729E-3</c:v>
                </c:pt>
                <c:pt idx="11">
                  <c:v>1.3100436681222703E-2</c:v>
                </c:pt>
                <c:pt idx="12">
                  <c:v>6.1135371179039298E-2</c:v>
                </c:pt>
                <c:pt idx="13">
                  <c:v>0.117903930131004</c:v>
                </c:pt>
                <c:pt idx="14">
                  <c:v>0.15720524017467211</c:v>
                </c:pt>
                <c:pt idx="15">
                  <c:v>0.13973799126637607</c:v>
                </c:pt>
                <c:pt idx="16">
                  <c:v>0.10043668122270702</c:v>
                </c:pt>
                <c:pt idx="17">
                  <c:v>0.11353711790392999</c:v>
                </c:pt>
                <c:pt idx="18">
                  <c:v>9.6069868995633273E-2</c:v>
                </c:pt>
                <c:pt idx="19">
                  <c:v>7.4235807860262001E-2</c:v>
                </c:pt>
                <c:pt idx="20">
                  <c:v>3.4934497816593899E-2</c:v>
                </c:pt>
                <c:pt idx="21">
                  <c:v>3.0567685589519611E-2</c:v>
                </c:pt>
                <c:pt idx="22">
                  <c:v>0</c:v>
                </c:pt>
                <c:pt idx="23">
                  <c:v>1.3100436681222703E-2</c:v>
                </c:pt>
                <c:pt idx="24">
                  <c:v>0</c:v>
                </c:pt>
                <c:pt idx="25">
                  <c:v>4.3668122270742399E-3</c:v>
                </c:pt>
                <c:pt idx="26">
                  <c:v>4.3668122270742399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cat-2(CB1112)_A3_0.02_50%'!$G$104</c:f>
              <c:strCache>
                <c:ptCount val="1"/>
                <c:pt idx="0">
                  <c:v>cat-2(CB1112)_A3_07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G$105:$G$135</c:f>
              <c:numCache>
                <c:formatCode>General</c:formatCode>
                <c:ptCount val="31"/>
                <c:pt idx="1">
                  <c:v>5.0251256281406984E-3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5.0251256281406984E-3</c:v>
                </c:pt>
                <c:pt idx="7">
                  <c:v>1.5075376884422099E-2</c:v>
                </c:pt>
                <c:pt idx="8">
                  <c:v>0</c:v>
                </c:pt>
                <c:pt idx="9">
                  <c:v>0</c:v>
                </c:pt>
                <c:pt idx="10">
                  <c:v>5.0251256281406984E-3</c:v>
                </c:pt>
                <c:pt idx="11">
                  <c:v>2.5125628140703501E-2</c:v>
                </c:pt>
                <c:pt idx="12">
                  <c:v>7.0351758793969779E-2</c:v>
                </c:pt>
                <c:pt idx="13">
                  <c:v>0.17587939698492505</c:v>
                </c:pt>
                <c:pt idx="14">
                  <c:v>0.16582914572864293</c:v>
                </c:pt>
                <c:pt idx="15">
                  <c:v>0.17085427135678397</c:v>
                </c:pt>
                <c:pt idx="16">
                  <c:v>0.135678391959799</c:v>
                </c:pt>
                <c:pt idx="17">
                  <c:v>0.10552763819095498</c:v>
                </c:pt>
                <c:pt idx="18">
                  <c:v>5.0251256281406982E-2</c:v>
                </c:pt>
                <c:pt idx="19">
                  <c:v>2.5125628140703501E-2</c:v>
                </c:pt>
                <c:pt idx="20">
                  <c:v>2.01005025125628E-2</c:v>
                </c:pt>
                <c:pt idx="21">
                  <c:v>5.0251256281406984E-3</c:v>
                </c:pt>
                <c:pt idx="22">
                  <c:v>1.00502512562814E-2</c:v>
                </c:pt>
                <c:pt idx="23">
                  <c:v>0</c:v>
                </c:pt>
                <c:pt idx="24">
                  <c:v>0</c:v>
                </c:pt>
                <c:pt idx="25">
                  <c:v>5.0251256281406984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6"/>
          <c:order val="6"/>
          <c:tx>
            <c:strRef>
              <c:f>'cat-2(CB1112)_A3_0.02_50%'!$H$104</c:f>
              <c:strCache>
                <c:ptCount val="1"/>
                <c:pt idx="0">
                  <c:v>cat-2(CB1112)_A3_08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H$105:$H$135</c:f>
              <c:numCache>
                <c:formatCode>General</c:formatCode>
                <c:ptCount val="31"/>
                <c:pt idx="1">
                  <c:v>1.304347826086961E-2</c:v>
                </c:pt>
                <c:pt idx="2">
                  <c:v>1.304347826086961E-2</c:v>
                </c:pt>
                <c:pt idx="3">
                  <c:v>1.304347826086961E-2</c:v>
                </c:pt>
                <c:pt idx="4">
                  <c:v>4.3478260869565201E-3</c:v>
                </c:pt>
                <c:pt idx="5">
                  <c:v>4.3478260869565201E-3</c:v>
                </c:pt>
                <c:pt idx="6">
                  <c:v>0</c:v>
                </c:pt>
                <c:pt idx="7">
                  <c:v>4.3478260869565201E-3</c:v>
                </c:pt>
                <c:pt idx="8">
                  <c:v>8.6956521739130453E-3</c:v>
                </c:pt>
                <c:pt idx="9">
                  <c:v>0</c:v>
                </c:pt>
                <c:pt idx="10">
                  <c:v>0</c:v>
                </c:pt>
                <c:pt idx="11">
                  <c:v>4.3478260869565201E-3</c:v>
                </c:pt>
                <c:pt idx="12">
                  <c:v>2.6086956521739115E-2</c:v>
                </c:pt>
                <c:pt idx="13">
                  <c:v>5.6521739130434803E-2</c:v>
                </c:pt>
                <c:pt idx="14">
                  <c:v>7.3913043478260901E-2</c:v>
                </c:pt>
                <c:pt idx="15">
                  <c:v>0.11304347826087002</c:v>
                </c:pt>
                <c:pt idx="16">
                  <c:v>0.16521739130434807</c:v>
                </c:pt>
                <c:pt idx="17">
                  <c:v>0.13043478260869601</c:v>
                </c:pt>
                <c:pt idx="18">
                  <c:v>8.6956521739130446E-2</c:v>
                </c:pt>
                <c:pt idx="19">
                  <c:v>8.2608695652173894E-2</c:v>
                </c:pt>
                <c:pt idx="20">
                  <c:v>4.3478260869565202E-2</c:v>
                </c:pt>
                <c:pt idx="21">
                  <c:v>4.3478260869565202E-2</c:v>
                </c:pt>
                <c:pt idx="22">
                  <c:v>1.7391304347826101E-2</c:v>
                </c:pt>
                <c:pt idx="23">
                  <c:v>2.1739130434782601E-2</c:v>
                </c:pt>
                <c:pt idx="24">
                  <c:v>8.6956521739130453E-3</c:v>
                </c:pt>
                <c:pt idx="25">
                  <c:v>1.304347826086961E-2</c:v>
                </c:pt>
                <c:pt idx="26">
                  <c:v>1.304347826086961E-2</c:v>
                </c:pt>
                <c:pt idx="27">
                  <c:v>4.3478260869565201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cat-2(CB1112)_A3_0.02_50%'!$I$104</c:f>
              <c:strCache>
                <c:ptCount val="1"/>
                <c:pt idx="0">
                  <c:v>cat-2(CB1112)_A3_09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I$105:$I$135</c:f>
              <c:numCache>
                <c:formatCode>General</c:formatCode>
                <c:ptCount val="31"/>
                <c:pt idx="1">
                  <c:v>8.6580086580086649E-3</c:v>
                </c:pt>
                <c:pt idx="2">
                  <c:v>8.6580086580086649E-3</c:v>
                </c:pt>
                <c:pt idx="3">
                  <c:v>8.6580086580086649E-3</c:v>
                </c:pt>
                <c:pt idx="4">
                  <c:v>4.3290043290043316E-3</c:v>
                </c:pt>
                <c:pt idx="5">
                  <c:v>1.7316017316017306E-2</c:v>
                </c:pt>
                <c:pt idx="6">
                  <c:v>8.6580086580086649E-3</c:v>
                </c:pt>
                <c:pt idx="7">
                  <c:v>4.3290043290043316E-3</c:v>
                </c:pt>
                <c:pt idx="8">
                  <c:v>8.6580086580086649E-3</c:v>
                </c:pt>
                <c:pt idx="9">
                  <c:v>4.3290043290043316E-3</c:v>
                </c:pt>
                <c:pt idx="10">
                  <c:v>8.6580086580086649E-3</c:v>
                </c:pt>
                <c:pt idx="11">
                  <c:v>3.4632034632034597E-2</c:v>
                </c:pt>
                <c:pt idx="12">
                  <c:v>5.627705627705628E-2</c:v>
                </c:pt>
                <c:pt idx="13">
                  <c:v>9.5238095238095247E-2</c:v>
                </c:pt>
                <c:pt idx="14">
                  <c:v>0.15151515151515207</c:v>
                </c:pt>
                <c:pt idx="15">
                  <c:v>0.16017316017316</c:v>
                </c:pt>
                <c:pt idx="16">
                  <c:v>0.14285714285714307</c:v>
                </c:pt>
                <c:pt idx="17">
                  <c:v>0.10822510822510806</c:v>
                </c:pt>
                <c:pt idx="18">
                  <c:v>6.9264069264069306E-2</c:v>
                </c:pt>
                <c:pt idx="19">
                  <c:v>2.5974025974026007E-2</c:v>
                </c:pt>
                <c:pt idx="20">
                  <c:v>2.1645021645021606E-2</c:v>
                </c:pt>
                <c:pt idx="21">
                  <c:v>1.7316017316017306E-2</c:v>
                </c:pt>
                <c:pt idx="22">
                  <c:v>8.6580086580086649E-3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8"/>
          <c:order val="8"/>
          <c:tx>
            <c:strRef>
              <c:f>'cat-2(CB1112)_A3_0.02_50%'!$J$104</c:f>
              <c:strCache>
                <c:ptCount val="1"/>
                <c:pt idx="0">
                  <c:v>cat-2(CB1112)_A3_10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J$105:$J$135</c:f>
              <c:numCache>
                <c:formatCode>General</c:formatCode>
                <c:ptCount val="31"/>
                <c:pt idx="1">
                  <c:v>1.9011406844106505E-2</c:v>
                </c:pt>
                <c:pt idx="2">
                  <c:v>2.2813688212927802E-2</c:v>
                </c:pt>
                <c:pt idx="3">
                  <c:v>3.8022813688212919E-3</c:v>
                </c:pt>
                <c:pt idx="4">
                  <c:v>0</c:v>
                </c:pt>
                <c:pt idx="5">
                  <c:v>1.1406844106463901E-2</c:v>
                </c:pt>
                <c:pt idx="6">
                  <c:v>3.8022813688212919E-3</c:v>
                </c:pt>
                <c:pt idx="7">
                  <c:v>0</c:v>
                </c:pt>
                <c:pt idx="8">
                  <c:v>1.1406844106463901E-2</c:v>
                </c:pt>
                <c:pt idx="9">
                  <c:v>7.6045627376425916E-3</c:v>
                </c:pt>
                <c:pt idx="10">
                  <c:v>3.8022813688212919E-3</c:v>
                </c:pt>
                <c:pt idx="11">
                  <c:v>1.1406844106463901E-2</c:v>
                </c:pt>
                <c:pt idx="12">
                  <c:v>2.6615969581749013E-2</c:v>
                </c:pt>
                <c:pt idx="13">
                  <c:v>4.9429657794676812E-2</c:v>
                </c:pt>
                <c:pt idx="14">
                  <c:v>0.12167300380228104</c:v>
                </c:pt>
                <c:pt idx="15">
                  <c:v>0.14448669201520906</c:v>
                </c:pt>
                <c:pt idx="16">
                  <c:v>9.8859315589353666E-2</c:v>
                </c:pt>
                <c:pt idx="17">
                  <c:v>6.84410646387833E-2</c:v>
                </c:pt>
                <c:pt idx="18">
                  <c:v>9.8859315589353666E-2</c:v>
                </c:pt>
                <c:pt idx="19">
                  <c:v>0.10646387832699603</c:v>
                </c:pt>
                <c:pt idx="20">
                  <c:v>6.4638783269962002E-2</c:v>
                </c:pt>
                <c:pt idx="21">
                  <c:v>2.6615969581749013E-2</c:v>
                </c:pt>
                <c:pt idx="22">
                  <c:v>1.1406844106463901E-2</c:v>
                </c:pt>
                <c:pt idx="23">
                  <c:v>1.9011406844106505E-2</c:v>
                </c:pt>
                <c:pt idx="24">
                  <c:v>3.8022813688212919E-3</c:v>
                </c:pt>
                <c:pt idx="25">
                  <c:v>0</c:v>
                </c:pt>
                <c:pt idx="26">
                  <c:v>1.5209125475285206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cat-2(CB1112)_A3_0.02_50%'!$K$104</c:f>
              <c:strCache>
                <c:ptCount val="1"/>
                <c:pt idx="0">
                  <c:v>cat-2(CB1112)_A3_11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K$105:$K$135</c:f>
              <c:numCache>
                <c:formatCode>General</c:formatCode>
                <c:ptCount val="31"/>
                <c:pt idx="1">
                  <c:v>3.5573122529644313E-2</c:v>
                </c:pt>
                <c:pt idx="2">
                  <c:v>1.58102766798419E-2</c:v>
                </c:pt>
                <c:pt idx="3">
                  <c:v>2.3715415019762799E-2</c:v>
                </c:pt>
                <c:pt idx="4">
                  <c:v>2.3715415019762799E-2</c:v>
                </c:pt>
                <c:pt idx="5">
                  <c:v>1.9762845849802414E-2</c:v>
                </c:pt>
                <c:pt idx="6">
                  <c:v>3.9525691699604697E-3</c:v>
                </c:pt>
                <c:pt idx="7">
                  <c:v>1.9762845849802414E-2</c:v>
                </c:pt>
                <c:pt idx="8">
                  <c:v>7.9051383399209498E-3</c:v>
                </c:pt>
                <c:pt idx="9">
                  <c:v>7.9051383399209498E-3</c:v>
                </c:pt>
                <c:pt idx="10">
                  <c:v>2.3715415019762799E-2</c:v>
                </c:pt>
                <c:pt idx="11">
                  <c:v>7.9051383399209498E-3</c:v>
                </c:pt>
                <c:pt idx="12">
                  <c:v>1.58102766798419E-2</c:v>
                </c:pt>
                <c:pt idx="13">
                  <c:v>2.3715415019762799E-2</c:v>
                </c:pt>
                <c:pt idx="14">
                  <c:v>8.3003952569170036E-2</c:v>
                </c:pt>
                <c:pt idx="15">
                  <c:v>0.110671936758893</c:v>
                </c:pt>
                <c:pt idx="16">
                  <c:v>5.9288537549407119E-2</c:v>
                </c:pt>
                <c:pt idx="17">
                  <c:v>7.9051383399209502E-2</c:v>
                </c:pt>
                <c:pt idx="18">
                  <c:v>8.3003952569170036E-2</c:v>
                </c:pt>
                <c:pt idx="19">
                  <c:v>5.9288537549407119E-2</c:v>
                </c:pt>
                <c:pt idx="20">
                  <c:v>0.110671936758893</c:v>
                </c:pt>
                <c:pt idx="21">
                  <c:v>6.3241106719367557E-2</c:v>
                </c:pt>
                <c:pt idx="22">
                  <c:v>1.18577075098814E-2</c:v>
                </c:pt>
                <c:pt idx="23">
                  <c:v>2.3715415019762799E-2</c:v>
                </c:pt>
                <c:pt idx="24">
                  <c:v>1.58102766798419E-2</c:v>
                </c:pt>
                <c:pt idx="25">
                  <c:v>1.18577075098814E-2</c:v>
                </c:pt>
                <c:pt idx="26">
                  <c:v>3.9525691699604697E-3</c:v>
                </c:pt>
                <c:pt idx="27">
                  <c:v>0</c:v>
                </c:pt>
                <c:pt idx="28">
                  <c:v>3.9525691699604697E-3</c:v>
                </c:pt>
                <c:pt idx="29">
                  <c:v>0</c:v>
                </c:pt>
                <c:pt idx="30">
                  <c:v>3.9525691699604697E-3</c:v>
                </c:pt>
              </c:numCache>
            </c:numRef>
          </c:val>
        </c:ser>
        <c:ser>
          <c:idx val="10"/>
          <c:order val="10"/>
          <c:tx>
            <c:strRef>
              <c:f>'cat-2(CB1112)_A3_0.02_50%'!$L$104</c:f>
              <c:strCache>
                <c:ptCount val="1"/>
                <c:pt idx="0">
                  <c:v>cat-2(CB1112)_A3_12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L$105:$L$135</c:f>
              <c:numCache>
                <c:formatCode>General</c:formatCode>
                <c:ptCount val="31"/>
                <c:pt idx="1">
                  <c:v>2.6239067055393618E-2</c:v>
                </c:pt>
                <c:pt idx="2">
                  <c:v>1.45772594752187E-2</c:v>
                </c:pt>
                <c:pt idx="3">
                  <c:v>2.91545189504373E-3</c:v>
                </c:pt>
                <c:pt idx="4">
                  <c:v>2.91545189504373E-3</c:v>
                </c:pt>
                <c:pt idx="5">
                  <c:v>5.8309037900874635E-3</c:v>
                </c:pt>
                <c:pt idx="6">
                  <c:v>2.91545189504373E-3</c:v>
                </c:pt>
                <c:pt idx="7">
                  <c:v>5.8309037900874635E-3</c:v>
                </c:pt>
                <c:pt idx="8">
                  <c:v>2.91545189504373E-3</c:v>
                </c:pt>
                <c:pt idx="9">
                  <c:v>8.7463556851311974E-3</c:v>
                </c:pt>
                <c:pt idx="10">
                  <c:v>0</c:v>
                </c:pt>
                <c:pt idx="11">
                  <c:v>1.45772594752187E-2</c:v>
                </c:pt>
                <c:pt idx="12">
                  <c:v>2.0408163265306107E-2</c:v>
                </c:pt>
                <c:pt idx="13">
                  <c:v>3.2069970845481001E-2</c:v>
                </c:pt>
                <c:pt idx="14">
                  <c:v>5.8309037900874619E-2</c:v>
                </c:pt>
                <c:pt idx="15">
                  <c:v>9.3294460641399485E-2</c:v>
                </c:pt>
                <c:pt idx="16">
                  <c:v>0.14868804664723007</c:v>
                </c:pt>
                <c:pt idx="17">
                  <c:v>0.13994169096209907</c:v>
                </c:pt>
                <c:pt idx="18">
                  <c:v>0.13119533527696806</c:v>
                </c:pt>
                <c:pt idx="19">
                  <c:v>9.6209912536443135E-2</c:v>
                </c:pt>
                <c:pt idx="20">
                  <c:v>6.1224489795918401E-2</c:v>
                </c:pt>
                <c:pt idx="21">
                  <c:v>3.498542274052481E-2</c:v>
                </c:pt>
                <c:pt idx="22">
                  <c:v>2.3323615160349899E-2</c:v>
                </c:pt>
                <c:pt idx="23">
                  <c:v>1.7492711370262405E-2</c:v>
                </c:pt>
                <c:pt idx="24">
                  <c:v>1.7492711370262405E-2</c:v>
                </c:pt>
                <c:pt idx="25">
                  <c:v>8.7463556851311974E-3</c:v>
                </c:pt>
                <c:pt idx="26">
                  <c:v>2.91545189504373E-3</c:v>
                </c:pt>
                <c:pt idx="27">
                  <c:v>0</c:v>
                </c:pt>
                <c:pt idx="28">
                  <c:v>0</c:v>
                </c:pt>
                <c:pt idx="29">
                  <c:v>2.91545189504373E-3</c:v>
                </c:pt>
                <c:pt idx="30">
                  <c:v>2.91545189504373E-3</c:v>
                </c:pt>
              </c:numCache>
            </c:numRef>
          </c:val>
        </c:ser>
        <c:ser>
          <c:idx val="11"/>
          <c:order val="11"/>
          <c:tx>
            <c:strRef>
              <c:f>'cat-2(CB1112)_A3_0.02_50%'!$M$104</c:f>
              <c:strCache>
                <c:ptCount val="1"/>
                <c:pt idx="0">
                  <c:v>cat-2(CB1112)_A3_13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M$105:$M$135</c:f>
              <c:numCache>
                <c:formatCode>General</c:formatCode>
                <c:ptCount val="31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4.7619047619047597E-3</c:v>
                </c:pt>
                <c:pt idx="8">
                  <c:v>0</c:v>
                </c:pt>
                <c:pt idx="9">
                  <c:v>4.7619047619047597E-3</c:v>
                </c:pt>
                <c:pt idx="10">
                  <c:v>5.2380952380952396E-2</c:v>
                </c:pt>
                <c:pt idx="11">
                  <c:v>7.6190476190476197E-2</c:v>
                </c:pt>
                <c:pt idx="12">
                  <c:v>0.15714285714285706</c:v>
                </c:pt>
                <c:pt idx="13">
                  <c:v>0.19047619047618999</c:v>
                </c:pt>
                <c:pt idx="14">
                  <c:v>0.16666666666666693</c:v>
                </c:pt>
                <c:pt idx="15">
                  <c:v>0.13333333333333305</c:v>
                </c:pt>
                <c:pt idx="16">
                  <c:v>9.0476190476190502E-2</c:v>
                </c:pt>
                <c:pt idx="17">
                  <c:v>8.0952380952381026E-2</c:v>
                </c:pt>
                <c:pt idx="18">
                  <c:v>3.8095238095238099E-2</c:v>
                </c:pt>
                <c:pt idx="19">
                  <c:v>4.7619047619047597E-3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cat-2(CB1112)_A3_0.02_50%'!$N$104</c:f>
              <c:strCache>
                <c:ptCount val="1"/>
                <c:pt idx="0">
                  <c:v>cat-2(CB1112)_A3_14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N$105:$N$135</c:f>
              <c:numCache>
                <c:formatCode>General</c:formatCode>
                <c:ptCount val="31"/>
                <c:pt idx="1">
                  <c:v>1.0489510489510504E-2</c:v>
                </c:pt>
                <c:pt idx="2">
                  <c:v>6.9930069930069921E-3</c:v>
                </c:pt>
                <c:pt idx="3">
                  <c:v>3.4965034965035E-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3.4965034965035E-3</c:v>
                </c:pt>
                <c:pt idx="10">
                  <c:v>1.7482517482517508E-2</c:v>
                </c:pt>
                <c:pt idx="11">
                  <c:v>6.6433566433566404E-2</c:v>
                </c:pt>
                <c:pt idx="12">
                  <c:v>8.3916083916083961E-2</c:v>
                </c:pt>
                <c:pt idx="13">
                  <c:v>0.11888111888111905</c:v>
                </c:pt>
                <c:pt idx="14">
                  <c:v>0.13986013986014006</c:v>
                </c:pt>
                <c:pt idx="15">
                  <c:v>0.19230769230769201</c:v>
                </c:pt>
                <c:pt idx="16">
                  <c:v>0.125874125874126</c:v>
                </c:pt>
                <c:pt idx="17">
                  <c:v>8.3916083916083961E-2</c:v>
                </c:pt>
                <c:pt idx="18">
                  <c:v>6.2937062937062901E-2</c:v>
                </c:pt>
                <c:pt idx="19">
                  <c:v>3.1468531468531499E-2</c:v>
                </c:pt>
                <c:pt idx="20">
                  <c:v>2.797202797202801E-2</c:v>
                </c:pt>
                <c:pt idx="21">
                  <c:v>1.0489510489510504E-2</c:v>
                </c:pt>
                <c:pt idx="22">
                  <c:v>6.9930069930069921E-3</c:v>
                </c:pt>
                <c:pt idx="23">
                  <c:v>0</c:v>
                </c:pt>
                <c:pt idx="24">
                  <c:v>3.4965034965035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cat-2(CB1112)_A3_0.02_50%'!$O$104</c:f>
              <c:strCache>
                <c:ptCount val="1"/>
                <c:pt idx="0">
                  <c:v>cat-2(CB1112)_A3_15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O$105:$O$135</c:f>
              <c:numCache>
                <c:formatCode>General</c:formatCode>
                <c:ptCount val="31"/>
                <c:pt idx="1">
                  <c:v>1.3157894736842101E-2</c:v>
                </c:pt>
                <c:pt idx="2">
                  <c:v>0</c:v>
                </c:pt>
                <c:pt idx="3">
                  <c:v>4.3859649122806998E-3</c:v>
                </c:pt>
                <c:pt idx="4">
                  <c:v>4.3859649122806998E-3</c:v>
                </c:pt>
                <c:pt idx="5">
                  <c:v>4.3859649122806998E-3</c:v>
                </c:pt>
                <c:pt idx="6">
                  <c:v>4.3859649122806998E-3</c:v>
                </c:pt>
                <c:pt idx="7">
                  <c:v>1.3157894736842101E-2</c:v>
                </c:pt>
                <c:pt idx="8">
                  <c:v>0</c:v>
                </c:pt>
                <c:pt idx="9">
                  <c:v>1.3157894736842101E-2</c:v>
                </c:pt>
                <c:pt idx="10">
                  <c:v>3.5087719298245605E-2</c:v>
                </c:pt>
                <c:pt idx="11">
                  <c:v>0.100877192982456</c:v>
                </c:pt>
                <c:pt idx="12">
                  <c:v>0.100877192982456</c:v>
                </c:pt>
                <c:pt idx="13">
                  <c:v>0.15789473684210512</c:v>
                </c:pt>
                <c:pt idx="14">
                  <c:v>0.12280701754385999</c:v>
                </c:pt>
                <c:pt idx="15">
                  <c:v>0.105263157894737</c:v>
                </c:pt>
                <c:pt idx="16">
                  <c:v>0.140350877192982</c:v>
                </c:pt>
                <c:pt idx="17">
                  <c:v>7.8947368421052572E-2</c:v>
                </c:pt>
                <c:pt idx="18">
                  <c:v>3.0701754385964911E-2</c:v>
                </c:pt>
                <c:pt idx="19">
                  <c:v>2.6315789473684202E-2</c:v>
                </c:pt>
                <c:pt idx="20">
                  <c:v>2.1929824561403508E-2</c:v>
                </c:pt>
                <c:pt idx="21">
                  <c:v>8.7719298245613996E-3</c:v>
                </c:pt>
                <c:pt idx="22">
                  <c:v>0</c:v>
                </c:pt>
                <c:pt idx="23">
                  <c:v>0</c:v>
                </c:pt>
                <c:pt idx="24">
                  <c:v>4.3859649122806998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4"/>
          <c:order val="14"/>
          <c:tx>
            <c:strRef>
              <c:f>'cat-2(CB1112)_A3_0.02_50%'!$P$104</c:f>
              <c:strCache>
                <c:ptCount val="1"/>
                <c:pt idx="0">
                  <c:v>cat-2(CB1112)_A3_16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P$105:$P$135</c:f>
              <c:numCache>
                <c:formatCode>General</c:formatCode>
                <c:ptCount val="31"/>
                <c:pt idx="1">
                  <c:v>6.3583815028901702E-2</c:v>
                </c:pt>
                <c:pt idx="2">
                  <c:v>2.6011560693641602E-2</c:v>
                </c:pt>
                <c:pt idx="3">
                  <c:v>3.1791907514450927E-2</c:v>
                </c:pt>
                <c:pt idx="4">
                  <c:v>5.7803468208092517E-3</c:v>
                </c:pt>
                <c:pt idx="5">
                  <c:v>2.0231213872832408E-2</c:v>
                </c:pt>
                <c:pt idx="6">
                  <c:v>1.7341040462427702E-2</c:v>
                </c:pt>
                <c:pt idx="7">
                  <c:v>2.8901734104046198E-3</c:v>
                </c:pt>
                <c:pt idx="8">
                  <c:v>8.6705202312138702E-3</c:v>
                </c:pt>
                <c:pt idx="9">
                  <c:v>2.8901734104046198E-3</c:v>
                </c:pt>
                <c:pt idx="10">
                  <c:v>1.1560693641618505E-2</c:v>
                </c:pt>
                <c:pt idx="11">
                  <c:v>1.1560693641618505E-2</c:v>
                </c:pt>
                <c:pt idx="12">
                  <c:v>1.7341040462427702E-2</c:v>
                </c:pt>
                <c:pt idx="13">
                  <c:v>4.6242774566473979E-2</c:v>
                </c:pt>
                <c:pt idx="14">
                  <c:v>6.6473988439306422E-2</c:v>
                </c:pt>
                <c:pt idx="15">
                  <c:v>0.10115606936416198</c:v>
                </c:pt>
                <c:pt idx="16">
                  <c:v>6.9364161849711059E-2</c:v>
                </c:pt>
                <c:pt idx="17">
                  <c:v>0.11849710982659002</c:v>
                </c:pt>
                <c:pt idx="18">
                  <c:v>6.9364161849711059E-2</c:v>
                </c:pt>
                <c:pt idx="19">
                  <c:v>8.9595375722543377E-2</c:v>
                </c:pt>
                <c:pt idx="20">
                  <c:v>6.0693641618497114E-2</c:v>
                </c:pt>
                <c:pt idx="21">
                  <c:v>4.3352601156069419E-2</c:v>
                </c:pt>
                <c:pt idx="22">
                  <c:v>1.4450867052023099E-2</c:v>
                </c:pt>
                <c:pt idx="23">
                  <c:v>1.7341040462427702E-2</c:v>
                </c:pt>
                <c:pt idx="24">
                  <c:v>2.6011560693641602E-2</c:v>
                </c:pt>
                <c:pt idx="25">
                  <c:v>1.4450867052023099E-2</c:v>
                </c:pt>
                <c:pt idx="26">
                  <c:v>5.7803468208092517E-3</c:v>
                </c:pt>
                <c:pt idx="27">
                  <c:v>0</c:v>
                </c:pt>
                <c:pt idx="28">
                  <c:v>0</c:v>
                </c:pt>
                <c:pt idx="29">
                  <c:v>2.8901734104046198E-3</c:v>
                </c:pt>
                <c:pt idx="30">
                  <c:v>0</c:v>
                </c:pt>
              </c:numCache>
            </c:numRef>
          </c:val>
        </c:ser>
        <c:ser>
          <c:idx val="15"/>
          <c:order val="15"/>
          <c:tx>
            <c:strRef>
              <c:f>'cat-2(CB1112)_A3_0.02_50%'!$Q$104</c:f>
              <c:strCache>
                <c:ptCount val="1"/>
                <c:pt idx="0">
                  <c:v>cat-2(CB1112)_A3_17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Q$105:$Q$135</c:f>
              <c:numCache>
                <c:formatCode>General</c:formatCode>
                <c:ptCount val="31"/>
                <c:pt idx="1">
                  <c:v>1.1406844106463901E-2</c:v>
                </c:pt>
                <c:pt idx="2">
                  <c:v>3.8022813688212919E-3</c:v>
                </c:pt>
                <c:pt idx="3">
                  <c:v>3.8022813688212919E-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8022813688212919E-3</c:v>
                </c:pt>
                <c:pt idx="9">
                  <c:v>3.8022813688212919E-3</c:v>
                </c:pt>
                <c:pt idx="10">
                  <c:v>0</c:v>
                </c:pt>
                <c:pt idx="11">
                  <c:v>2.2813688212927802E-2</c:v>
                </c:pt>
                <c:pt idx="12">
                  <c:v>5.7034220532319421E-2</c:v>
                </c:pt>
                <c:pt idx="13">
                  <c:v>8.3650190114068476E-2</c:v>
                </c:pt>
                <c:pt idx="14">
                  <c:v>0.15589353612167306</c:v>
                </c:pt>
                <c:pt idx="15">
                  <c:v>0.14448669201520906</c:v>
                </c:pt>
                <c:pt idx="16">
                  <c:v>0.14448669201520906</c:v>
                </c:pt>
                <c:pt idx="17">
                  <c:v>9.1254752851711002E-2</c:v>
                </c:pt>
                <c:pt idx="18">
                  <c:v>0.11406844106463904</c:v>
                </c:pt>
                <c:pt idx="19">
                  <c:v>6.0836501901140747E-2</c:v>
                </c:pt>
                <c:pt idx="20">
                  <c:v>3.0418250950570307E-2</c:v>
                </c:pt>
                <c:pt idx="21">
                  <c:v>1.5209125475285206E-2</c:v>
                </c:pt>
                <c:pt idx="22">
                  <c:v>1.1406844106463901E-2</c:v>
                </c:pt>
                <c:pt idx="23">
                  <c:v>1.5209125475285206E-2</c:v>
                </c:pt>
                <c:pt idx="24">
                  <c:v>0</c:v>
                </c:pt>
                <c:pt idx="25">
                  <c:v>3.8022813688212919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3.8022813688212919E-3</c:v>
                </c:pt>
                <c:pt idx="30">
                  <c:v>0</c:v>
                </c:pt>
              </c:numCache>
            </c:numRef>
          </c:val>
        </c:ser>
        <c:ser>
          <c:idx val="16"/>
          <c:order val="16"/>
          <c:tx>
            <c:strRef>
              <c:f>'cat-2(CB1112)_A3_0.02_50%'!$R$104</c:f>
              <c:strCache>
                <c:ptCount val="1"/>
                <c:pt idx="0">
                  <c:v>cat-2(CB1112)_A3_18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R$105:$R$135</c:f>
              <c:numCache>
                <c:formatCode>General</c:formatCode>
                <c:ptCount val="31"/>
                <c:pt idx="1">
                  <c:v>2.2727272727272717E-2</c:v>
                </c:pt>
                <c:pt idx="2">
                  <c:v>1.9480519480519508E-2</c:v>
                </c:pt>
                <c:pt idx="3">
                  <c:v>2.2727272727272717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9.74025974025974E-3</c:v>
                </c:pt>
                <c:pt idx="9">
                  <c:v>6.4935064935064922E-3</c:v>
                </c:pt>
                <c:pt idx="10">
                  <c:v>0</c:v>
                </c:pt>
                <c:pt idx="11">
                  <c:v>2.2727272727272717E-2</c:v>
                </c:pt>
                <c:pt idx="12">
                  <c:v>7.1428571428571411E-2</c:v>
                </c:pt>
                <c:pt idx="13">
                  <c:v>8.7662337662337692E-2</c:v>
                </c:pt>
                <c:pt idx="14">
                  <c:v>0.107142857142857</c:v>
                </c:pt>
                <c:pt idx="15">
                  <c:v>8.1168831168831224E-2</c:v>
                </c:pt>
                <c:pt idx="16">
                  <c:v>9.415584415584427E-2</c:v>
                </c:pt>
                <c:pt idx="17">
                  <c:v>9.7402597402597338E-2</c:v>
                </c:pt>
                <c:pt idx="18">
                  <c:v>0.10064935064935097</c:v>
                </c:pt>
                <c:pt idx="19">
                  <c:v>8.1168831168831224E-2</c:v>
                </c:pt>
                <c:pt idx="20">
                  <c:v>4.5454545454545497E-2</c:v>
                </c:pt>
                <c:pt idx="21">
                  <c:v>3.5714285714285698E-2</c:v>
                </c:pt>
                <c:pt idx="22">
                  <c:v>3.2467532467532499E-2</c:v>
                </c:pt>
                <c:pt idx="23">
                  <c:v>6.4935064935064922E-3</c:v>
                </c:pt>
                <c:pt idx="24">
                  <c:v>9.74025974025974E-3</c:v>
                </c:pt>
                <c:pt idx="25">
                  <c:v>6.4935064935064922E-3</c:v>
                </c:pt>
                <c:pt idx="26">
                  <c:v>3.2467532467532517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cat-2(CB1112)_A3_0.02_50%'!$S$104</c:f>
              <c:strCache>
                <c:ptCount val="1"/>
                <c:pt idx="0">
                  <c:v>cat-2(CB1112)_A3_19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S$105:$S$135</c:f>
              <c:numCache>
                <c:formatCode>General</c:formatCode>
                <c:ptCount val="31"/>
                <c:pt idx="1">
                  <c:v>4.7619047619047616E-2</c:v>
                </c:pt>
                <c:pt idx="2">
                  <c:v>1.8518518518518507E-2</c:v>
                </c:pt>
                <c:pt idx="3">
                  <c:v>3.7037037037037014E-2</c:v>
                </c:pt>
                <c:pt idx="4">
                  <c:v>2.6455026455026509E-2</c:v>
                </c:pt>
                <c:pt idx="5">
                  <c:v>1.3227513227513204E-2</c:v>
                </c:pt>
                <c:pt idx="6">
                  <c:v>3.4391534391534397E-2</c:v>
                </c:pt>
                <c:pt idx="7">
                  <c:v>2.6455026455026509E-2</c:v>
                </c:pt>
                <c:pt idx="8">
                  <c:v>2.6455026455026509E-2</c:v>
                </c:pt>
                <c:pt idx="9">
                  <c:v>3.4391534391534397E-2</c:v>
                </c:pt>
                <c:pt idx="10">
                  <c:v>1.3227513227513204E-2</c:v>
                </c:pt>
                <c:pt idx="11">
                  <c:v>2.3809523809523808E-2</c:v>
                </c:pt>
                <c:pt idx="12">
                  <c:v>2.3809523809523808E-2</c:v>
                </c:pt>
                <c:pt idx="13">
                  <c:v>5.0264550264550283E-2</c:v>
                </c:pt>
                <c:pt idx="14">
                  <c:v>6.6137566137566106E-2</c:v>
                </c:pt>
                <c:pt idx="15">
                  <c:v>6.6137566137566106E-2</c:v>
                </c:pt>
                <c:pt idx="16">
                  <c:v>7.4074074074074098E-2</c:v>
                </c:pt>
                <c:pt idx="17">
                  <c:v>7.1428571428571411E-2</c:v>
                </c:pt>
                <c:pt idx="18">
                  <c:v>7.6719576719576701E-2</c:v>
                </c:pt>
                <c:pt idx="19">
                  <c:v>7.4074074074074098E-2</c:v>
                </c:pt>
                <c:pt idx="20">
                  <c:v>5.555555555555558E-2</c:v>
                </c:pt>
                <c:pt idx="21">
                  <c:v>4.2328042328042312E-2</c:v>
                </c:pt>
                <c:pt idx="22">
                  <c:v>1.8518518518518507E-2</c:v>
                </c:pt>
                <c:pt idx="23">
                  <c:v>1.3227513227513204E-2</c:v>
                </c:pt>
                <c:pt idx="24">
                  <c:v>1.3227513227513204E-2</c:v>
                </c:pt>
                <c:pt idx="25">
                  <c:v>7.9365079365079413E-3</c:v>
                </c:pt>
                <c:pt idx="26">
                  <c:v>2.6455026455026519E-3</c:v>
                </c:pt>
                <c:pt idx="27">
                  <c:v>2.6455026455026519E-3</c:v>
                </c:pt>
                <c:pt idx="28">
                  <c:v>7.9365079365079413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8"/>
          <c:order val="18"/>
          <c:tx>
            <c:strRef>
              <c:f>'cat-2(CB1112)_A3_0.02_50%'!$T$104</c:f>
              <c:strCache>
                <c:ptCount val="1"/>
                <c:pt idx="0">
                  <c:v>cat-2(CB1112)_A3_20</c:v>
                </c:pt>
              </c:strCache>
            </c:strRef>
          </c:tx>
          <c:marker>
            <c:symbol val="none"/>
          </c:marker>
          <c:cat>
            <c:numRef>
              <c:f>'cat-2(CB1112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3_0.02_50%'!$T$105:$T$135</c:f>
              <c:numCache>
                <c:formatCode>General</c:formatCode>
                <c:ptCount val="31"/>
                <c:pt idx="1">
                  <c:v>3.9867109634551499E-2</c:v>
                </c:pt>
                <c:pt idx="2">
                  <c:v>1.6611295681063103E-2</c:v>
                </c:pt>
                <c:pt idx="3">
                  <c:v>1.32890365448505E-2</c:v>
                </c:pt>
                <c:pt idx="4">
                  <c:v>6.6445182724252476E-3</c:v>
                </c:pt>
                <c:pt idx="5">
                  <c:v>6.6445182724252476E-3</c:v>
                </c:pt>
                <c:pt idx="6">
                  <c:v>9.9667774086378731E-3</c:v>
                </c:pt>
                <c:pt idx="7">
                  <c:v>3.3222591362126199E-3</c:v>
                </c:pt>
                <c:pt idx="8">
                  <c:v>3.3222591362126199E-3</c:v>
                </c:pt>
                <c:pt idx="9">
                  <c:v>0</c:v>
                </c:pt>
                <c:pt idx="10">
                  <c:v>9.9667774086378731E-3</c:v>
                </c:pt>
                <c:pt idx="11">
                  <c:v>2.6578073089701008E-2</c:v>
                </c:pt>
                <c:pt idx="12">
                  <c:v>4.9833887043189418E-2</c:v>
                </c:pt>
                <c:pt idx="13">
                  <c:v>7.6411960132890394E-2</c:v>
                </c:pt>
                <c:pt idx="14">
                  <c:v>8.9700996677740938E-2</c:v>
                </c:pt>
                <c:pt idx="15">
                  <c:v>0.11960132890365405</c:v>
                </c:pt>
                <c:pt idx="16">
                  <c:v>0.112956810631229</c:v>
                </c:pt>
                <c:pt idx="17">
                  <c:v>0.116279069767442</c:v>
                </c:pt>
                <c:pt idx="18">
                  <c:v>8.9700996677740938E-2</c:v>
                </c:pt>
                <c:pt idx="19">
                  <c:v>6.6445182724252469E-2</c:v>
                </c:pt>
                <c:pt idx="20">
                  <c:v>4.6511627906976737E-2</c:v>
                </c:pt>
                <c:pt idx="21">
                  <c:v>3.3222591362126193E-2</c:v>
                </c:pt>
                <c:pt idx="22">
                  <c:v>2.32558139534884E-2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marker val="1"/>
        <c:axId val="168216448"/>
        <c:axId val="168217984"/>
      </c:lineChart>
      <c:catAx>
        <c:axId val="168216448"/>
        <c:scaling>
          <c:orientation val="minMax"/>
        </c:scaling>
        <c:axPos val="b"/>
        <c:numFmt formatCode="0.0_ " sourceLinked="1"/>
        <c:tickLblPos val="nextTo"/>
        <c:crossAx val="168217984"/>
        <c:crosses val="autoZero"/>
        <c:auto val="1"/>
        <c:lblAlgn val="ctr"/>
        <c:lblOffset val="100"/>
        <c:tickLblSkip val="5"/>
        <c:tickMarkSkip val="5"/>
      </c:catAx>
      <c:valAx>
        <c:axId val="168217984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8216448"/>
        <c:crosses val="autoZero"/>
        <c:crossBetween val="between"/>
      </c:valAx>
    </c:plotArea>
    <c:plotVisOnly val="1"/>
  </c:chart>
  <c:externalData r:id="rId1"/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cat-2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1</a:t>
            </a: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cat-2(CB1112)_A1_0.02_50%'!$B$104</c:f>
              <c:strCache>
                <c:ptCount val="1"/>
                <c:pt idx="0">
                  <c:v>cat-2(CB1112)_A1_01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B$105:$B$135</c:f>
              <c:numCache>
                <c:formatCode>General</c:formatCode>
                <c:ptCount val="31"/>
                <c:pt idx="1">
                  <c:v>4.8465266558966102E-2</c:v>
                </c:pt>
                <c:pt idx="2">
                  <c:v>3.8772213247172914E-2</c:v>
                </c:pt>
                <c:pt idx="3">
                  <c:v>6.3004846526655875E-2</c:v>
                </c:pt>
                <c:pt idx="4">
                  <c:v>6.1389337641356997E-2</c:v>
                </c:pt>
                <c:pt idx="5">
                  <c:v>4.6849757673667163E-2</c:v>
                </c:pt>
                <c:pt idx="6">
                  <c:v>5.8158319870759284E-2</c:v>
                </c:pt>
                <c:pt idx="7">
                  <c:v>6.6235864297253602E-2</c:v>
                </c:pt>
                <c:pt idx="8">
                  <c:v>5.8158319870759284E-2</c:v>
                </c:pt>
                <c:pt idx="9">
                  <c:v>5.65428109854604E-2</c:v>
                </c:pt>
                <c:pt idx="10">
                  <c:v>6.3004846526655875E-2</c:v>
                </c:pt>
                <c:pt idx="11">
                  <c:v>6.1389337641356997E-2</c:v>
                </c:pt>
                <c:pt idx="12">
                  <c:v>3.7156704361874002E-2</c:v>
                </c:pt>
                <c:pt idx="13">
                  <c:v>4.0387722132471729E-2</c:v>
                </c:pt>
                <c:pt idx="14">
                  <c:v>2.1001615508885317E-2</c:v>
                </c:pt>
                <c:pt idx="15">
                  <c:v>2.4232633279482999E-2</c:v>
                </c:pt>
                <c:pt idx="16">
                  <c:v>2.4232633279482999E-2</c:v>
                </c:pt>
                <c:pt idx="17">
                  <c:v>3.7156704361874002E-2</c:v>
                </c:pt>
                <c:pt idx="18">
                  <c:v>3.0694668820678499E-2</c:v>
                </c:pt>
                <c:pt idx="19">
                  <c:v>2.2617124394184198E-2</c:v>
                </c:pt>
                <c:pt idx="20">
                  <c:v>1.2924071082391001E-2</c:v>
                </c:pt>
                <c:pt idx="21">
                  <c:v>1.2924071082391001E-2</c:v>
                </c:pt>
                <c:pt idx="22">
                  <c:v>6.4620355411954778E-3</c:v>
                </c:pt>
                <c:pt idx="23">
                  <c:v>9.6930533117932146E-3</c:v>
                </c:pt>
                <c:pt idx="24">
                  <c:v>4.8465266558966116E-3</c:v>
                </c:pt>
                <c:pt idx="25">
                  <c:v>1.6155088852988701E-3</c:v>
                </c:pt>
                <c:pt idx="26">
                  <c:v>9.6930533117932146E-3</c:v>
                </c:pt>
                <c:pt idx="27">
                  <c:v>3.2310177705977415E-3</c:v>
                </c:pt>
                <c:pt idx="28">
                  <c:v>4.8465266558966116E-3</c:v>
                </c:pt>
                <c:pt idx="29">
                  <c:v>3.2310177705977415E-3</c:v>
                </c:pt>
                <c:pt idx="30">
                  <c:v>1.6155088852988701E-3</c:v>
                </c:pt>
              </c:numCache>
            </c:numRef>
          </c:val>
        </c:ser>
        <c:ser>
          <c:idx val="1"/>
          <c:order val="1"/>
          <c:tx>
            <c:strRef>
              <c:f>'cat-2(CB1112)_A1_0.02_50%'!$C$104</c:f>
              <c:strCache>
                <c:ptCount val="1"/>
                <c:pt idx="0">
                  <c:v>cat-2(CB1112)_A1_02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C$105:$C$135</c:f>
              <c:numCache>
                <c:formatCode>General</c:formatCode>
                <c:ptCount val="31"/>
                <c:pt idx="1">
                  <c:v>7.3608617594254896E-2</c:v>
                </c:pt>
                <c:pt idx="2">
                  <c:v>7.3608617594254896E-2</c:v>
                </c:pt>
                <c:pt idx="3">
                  <c:v>6.6427289048474003E-2</c:v>
                </c:pt>
                <c:pt idx="4">
                  <c:v>7.5403949730700234E-2</c:v>
                </c:pt>
                <c:pt idx="5">
                  <c:v>5.9245960502692978E-2</c:v>
                </c:pt>
                <c:pt idx="6">
                  <c:v>5.5655296229802496E-2</c:v>
                </c:pt>
                <c:pt idx="7">
                  <c:v>5.3859964093357297E-2</c:v>
                </c:pt>
                <c:pt idx="8">
                  <c:v>5.5655296229802496E-2</c:v>
                </c:pt>
                <c:pt idx="9">
                  <c:v>6.1041292639138198E-2</c:v>
                </c:pt>
                <c:pt idx="10">
                  <c:v>4.3087971274685812E-2</c:v>
                </c:pt>
                <c:pt idx="11">
                  <c:v>3.9497307001795316E-2</c:v>
                </c:pt>
                <c:pt idx="12">
                  <c:v>4.1292639138240633E-2</c:v>
                </c:pt>
                <c:pt idx="13">
                  <c:v>3.5906642728904814E-2</c:v>
                </c:pt>
                <c:pt idx="14">
                  <c:v>3.4111310592459615E-2</c:v>
                </c:pt>
                <c:pt idx="15">
                  <c:v>3.9497307001795316E-2</c:v>
                </c:pt>
                <c:pt idx="16">
                  <c:v>2.1543985637342899E-2</c:v>
                </c:pt>
                <c:pt idx="17">
                  <c:v>2.3339317773788209E-2</c:v>
                </c:pt>
                <c:pt idx="18">
                  <c:v>2.5134649910233401E-2</c:v>
                </c:pt>
                <c:pt idx="19">
                  <c:v>2.1543985637342899E-2</c:v>
                </c:pt>
                <c:pt idx="20">
                  <c:v>1.4362657091561901E-2</c:v>
                </c:pt>
                <c:pt idx="21">
                  <c:v>8.9766606822262191E-3</c:v>
                </c:pt>
                <c:pt idx="22">
                  <c:v>3.5906642728904818E-3</c:v>
                </c:pt>
                <c:pt idx="23">
                  <c:v>5.3859964093357299E-3</c:v>
                </c:pt>
                <c:pt idx="24">
                  <c:v>7.1813285457809732E-3</c:v>
                </c:pt>
                <c:pt idx="25">
                  <c:v>3.5906642728904818E-3</c:v>
                </c:pt>
                <c:pt idx="26">
                  <c:v>0</c:v>
                </c:pt>
                <c:pt idx="27">
                  <c:v>3.5906642728904818E-3</c:v>
                </c:pt>
                <c:pt idx="28">
                  <c:v>3.5906642728904818E-3</c:v>
                </c:pt>
                <c:pt idx="29">
                  <c:v>1.7953321364452409E-3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cat-2(CB1112)_A1_0.02_50%'!$D$104</c:f>
              <c:strCache>
                <c:ptCount val="1"/>
                <c:pt idx="0">
                  <c:v>cat-2(CB1112)_A1_03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D$105:$D$135</c:f>
              <c:numCache>
                <c:formatCode>General</c:formatCode>
                <c:ptCount val="31"/>
                <c:pt idx="1">
                  <c:v>6.2402496099844038E-2</c:v>
                </c:pt>
                <c:pt idx="2">
                  <c:v>7.1762870514820623E-2</c:v>
                </c:pt>
                <c:pt idx="3">
                  <c:v>8.5803432137285529E-2</c:v>
                </c:pt>
                <c:pt idx="4">
                  <c:v>4.9921996879875211E-2</c:v>
                </c:pt>
                <c:pt idx="5">
                  <c:v>6.0842433697347917E-2</c:v>
                </c:pt>
                <c:pt idx="6">
                  <c:v>6.2402496099844038E-2</c:v>
                </c:pt>
                <c:pt idx="7">
                  <c:v>3.1201248049922019E-2</c:v>
                </c:pt>
                <c:pt idx="8">
                  <c:v>6.8642745709828396E-2</c:v>
                </c:pt>
                <c:pt idx="9">
                  <c:v>4.5241809672386862E-2</c:v>
                </c:pt>
                <c:pt idx="10">
                  <c:v>4.8361934477379104E-2</c:v>
                </c:pt>
                <c:pt idx="11">
                  <c:v>4.0561622464898597E-2</c:v>
                </c:pt>
                <c:pt idx="12">
                  <c:v>4.5241809672386862E-2</c:v>
                </c:pt>
                <c:pt idx="13">
                  <c:v>4.9921996879875211E-2</c:v>
                </c:pt>
                <c:pt idx="14">
                  <c:v>2.9641185647425919E-2</c:v>
                </c:pt>
                <c:pt idx="15">
                  <c:v>2.9641185647425919E-2</c:v>
                </c:pt>
                <c:pt idx="16">
                  <c:v>2.0280811232449299E-2</c:v>
                </c:pt>
                <c:pt idx="17">
                  <c:v>2.6521060842433698E-2</c:v>
                </c:pt>
                <c:pt idx="18">
                  <c:v>2.0280811232449299E-2</c:v>
                </c:pt>
                <c:pt idx="19">
                  <c:v>1.8720748829953206E-2</c:v>
                </c:pt>
                <c:pt idx="20">
                  <c:v>1.8720748829953206E-2</c:v>
                </c:pt>
                <c:pt idx="21">
                  <c:v>7.8003120124805021E-3</c:v>
                </c:pt>
                <c:pt idx="22">
                  <c:v>1.0920436817472701E-2</c:v>
                </c:pt>
                <c:pt idx="23">
                  <c:v>9.3603744149766046E-3</c:v>
                </c:pt>
                <c:pt idx="24">
                  <c:v>9.3603744149766046E-3</c:v>
                </c:pt>
                <c:pt idx="25">
                  <c:v>3.120124804992202E-3</c:v>
                </c:pt>
                <c:pt idx="26">
                  <c:v>4.680187207488298E-3</c:v>
                </c:pt>
                <c:pt idx="27">
                  <c:v>4.680187207488298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cat-2(CB1112)_A1_0.02_50%'!$E$104</c:f>
              <c:strCache>
                <c:ptCount val="1"/>
                <c:pt idx="0">
                  <c:v>cat-2(CB1112)_A1_04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E$105:$E$135</c:f>
              <c:numCache>
                <c:formatCode>General</c:formatCode>
                <c:ptCount val="31"/>
                <c:pt idx="1">
                  <c:v>6.0031595576619301E-2</c:v>
                </c:pt>
                <c:pt idx="2">
                  <c:v>4.1074249605055277E-2</c:v>
                </c:pt>
                <c:pt idx="3">
                  <c:v>4.1074249605055277E-2</c:v>
                </c:pt>
                <c:pt idx="4">
                  <c:v>6.1611374407582895E-2</c:v>
                </c:pt>
                <c:pt idx="5">
                  <c:v>4.7393364928909935E-2</c:v>
                </c:pt>
                <c:pt idx="6">
                  <c:v>6.4770932069510331E-2</c:v>
                </c:pt>
                <c:pt idx="7">
                  <c:v>5.6872037914691927E-2</c:v>
                </c:pt>
                <c:pt idx="8">
                  <c:v>4.5813586097946335E-2</c:v>
                </c:pt>
                <c:pt idx="9">
                  <c:v>5.5292259083728319E-2</c:v>
                </c:pt>
                <c:pt idx="10">
                  <c:v>4.2654028436018995E-2</c:v>
                </c:pt>
                <c:pt idx="11">
                  <c:v>5.2132701421800917E-2</c:v>
                </c:pt>
                <c:pt idx="12">
                  <c:v>6.4770932069510331E-2</c:v>
                </c:pt>
                <c:pt idx="13">
                  <c:v>3.4755134281200598E-2</c:v>
                </c:pt>
                <c:pt idx="14">
                  <c:v>3.7914691943128E-2</c:v>
                </c:pt>
                <c:pt idx="15">
                  <c:v>3.4755134281200598E-2</c:v>
                </c:pt>
                <c:pt idx="16">
                  <c:v>2.8436018957346001E-2</c:v>
                </c:pt>
                <c:pt idx="17">
                  <c:v>1.8957345971564E-2</c:v>
                </c:pt>
                <c:pt idx="18">
                  <c:v>3.0015797788309619E-2</c:v>
                </c:pt>
                <c:pt idx="19">
                  <c:v>2.05371248025276E-2</c:v>
                </c:pt>
                <c:pt idx="20">
                  <c:v>2.6856240126382311E-2</c:v>
                </c:pt>
                <c:pt idx="21">
                  <c:v>1.5797788309636705E-2</c:v>
                </c:pt>
                <c:pt idx="22">
                  <c:v>1.4218009478672999E-2</c:v>
                </c:pt>
                <c:pt idx="23">
                  <c:v>1.5797788309636705E-2</c:v>
                </c:pt>
                <c:pt idx="24">
                  <c:v>4.7393364928910052E-3</c:v>
                </c:pt>
                <c:pt idx="25">
                  <c:v>1.5797788309636705E-3</c:v>
                </c:pt>
                <c:pt idx="26">
                  <c:v>6.319115323854662E-3</c:v>
                </c:pt>
                <c:pt idx="27">
                  <c:v>1.1058451816745701E-2</c:v>
                </c:pt>
                <c:pt idx="28">
                  <c:v>4.7393364928910052E-3</c:v>
                </c:pt>
                <c:pt idx="29">
                  <c:v>1.5797788309636705E-3</c:v>
                </c:pt>
                <c:pt idx="30">
                  <c:v>1.5797788309636705E-3</c:v>
                </c:pt>
              </c:numCache>
            </c:numRef>
          </c:val>
        </c:ser>
        <c:ser>
          <c:idx val="4"/>
          <c:order val="4"/>
          <c:tx>
            <c:strRef>
              <c:f>'cat-2(CB1112)_A1_0.02_50%'!$F$104</c:f>
              <c:strCache>
                <c:ptCount val="1"/>
                <c:pt idx="0">
                  <c:v>cat-2(CB1112)_A1_05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F$105:$F$135</c:f>
              <c:numCache>
                <c:formatCode>General</c:formatCode>
                <c:ptCount val="31"/>
                <c:pt idx="1">
                  <c:v>8.1118881118881103E-2</c:v>
                </c:pt>
                <c:pt idx="2">
                  <c:v>7.1328671328671323E-2</c:v>
                </c:pt>
                <c:pt idx="3">
                  <c:v>6.8531468531468506E-2</c:v>
                </c:pt>
                <c:pt idx="4">
                  <c:v>5.7342657342657324E-2</c:v>
                </c:pt>
                <c:pt idx="5">
                  <c:v>6.9930069930069894E-2</c:v>
                </c:pt>
                <c:pt idx="6">
                  <c:v>6.8531468531468506E-2</c:v>
                </c:pt>
                <c:pt idx="7">
                  <c:v>6.7132867132867119E-2</c:v>
                </c:pt>
                <c:pt idx="8">
                  <c:v>5.5944055944055895E-2</c:v>
                </c:pt>
                <c:pt idx="9">
                  <c:v>3.7762237762237805E-2</c:v>
                </c:pt>
                <c:pt idx="10">
                  <c:v>3.3566433566433594E-2</c:v>
                </c:pt>
                <c:pt idx="11">
                  <c:v>4.6153846153846198E-2</c:v>
                </c:pt>
                <c:pt idx="12">
                  <c:v>5.0349650349650402E-2</c:v>
                </c:pt>
                <c:pt idx="13">
                  <c:v>2.377622377622381E-2</c:v>
                </c:pt>
                <c:pt idx="14">
                  <c:v>4.1958041958042015E-2</c:v>
                </c:pt>
                <c:pt idx="15">
                  <c:v>2.797202797202801E-2</c:v>
                </c:pt>
                <c:pt idx="16">
                  <c:v>2.377622377622381E-2</c:v>
                </c:pt>
                <c:pt idx="17">
                  <c:v>1.6783216783216801E-2</c:v>
                </c:pt>
                <c:pt idx="18">
                  <c:v>2.5174825174825208E-2</c:v>
                </c:pt>
                <c:pt idx="19">
                  <c:v>1.1188811188811204E-2</c:v>
                </c:pt>
                <c:pt idx="20">
                  <c:v>1.5384615384615405E-2</c:v>
                </c:pt>
                <c:pt idx="21">
                  <c:v>9.7902097902097893E-3</c:v>
                </c:pt>
                <c:pt idx="22">
                  <c:v>2.7972027972028015E-3</c:v>
                </c:pt>
                <c:pt idx="23">
                  <c:v>5.5944055944055901E-3</c:v>
                </c:pt>
                <c:pt idx="24">
                  <c:v>6.9930069930069921E-3</c:v>
                </c:pt>
                <c:pt idx="25">
                  <c:v>5.5944055944055901E-3</c:v>
                </c:pt>
                <c:pt idx="26">
                  <c:v>2.7972027972028015E-3</c:v>
                </c:pt>
                <c:pt idx="27">
                  <c:v>0</c:v>
                </c:pt>
                <c:pt idx="28">
                  <c:v>1.3986013986014001E-3</c:v>
                </c:pt>
                <c:pt idx="29">
                  <c:v>2.7972027972028015E-3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cat-2(CB1112)_A1_0.02_50%'!$G$104</c:f>
              <c:strCache>
                <c:ptCount val="1"/>
                <c:pt idx="0">
                  <c:v>cat-2(CB1112)_A1_06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G$105:$G$135</c:f>
              <c:numCache>
                <c:formatCode>General</c:formatCode>
                <c:ptCount val="31"/>
                <c:pt idx="1">
                  <c:v>8.1159420289855122E-2</c:v>
                </c:pt>
                <c:pt idx="2">
                  <c:v>6.0869565217391314E-2</c:v>
                </c:pt>
                <c:pt idx="3">
                  <c:v>4.6376811594202899E-2</c:v>
                </c:pt>
                <c:pt idx="4">
                  <c:v>6.3768115942029024E-2</c:v>
                </c:pt>
                <c:pt idx="5">
                  <c:v>5.5072463768115899E-2</c:v>
                </c:pt>
                <c:pt idx="6">
                  <c:v>6.6666666666666693E-2</c:v>
                </c:pt>
                <c:pt idx="7">
                  <c:v>5.7971014492753603E-2</c:v>
                </c:pt>
                <c:pt idx="8">
                  <c:v>6.3768115942029024E-2</c:v>
                </c:pt>
                <c:pt idx="9">
                  <c:v>4.9275362318840603E-2</c:v>
                </c:pt>
                <c:pt idx="10">
                  <c:v>6.3768115942029024E-2</c:v>
                </c:pt>
                <c:pt idx="11">
                  <c:v>4.3478260869565202E-2</c:v>
                </c:pt>
                <c:pt idx="12">
                  <c:v>3.1884057971014512E-2</c:v>
                </c:pt>
                <c:pt idx="13">
                  <c:v>4.3478260869565202E-2</c:v>
                </c:pt>
                <c:pt idx="14">
                  <c:v>3.7681159420289913E-2</c:v>
                </c:pt>
                <c:pt idx="15">
                  <c:v>2.3188405797101491E-2</c:v>
                </c:pt>
                <c:pt idx="16">
                  <c:v>4.0579710144927499E-2</c:v>
                </c:pt>
                <c:pt idx="17">
                  <c:v>1.15942028985507E-2</c:v>
                </c:pt>
                <c:pt idx="18">
                  <c:v>2.3188405797101491E-2</c:v>
                </c:pt>
                <c:pt idx="19">
                  <c:v>8.6956521739130453E-3</c:v>
                </c:pt>
                <c:pt idx="20">
                  <c:v>1.7391304347826101E-2</c:v>
                </c:pt>
                <c:pt idx="21">
                  <c:v>8.6956521739130453E-3</c:v>
                </c:pt>
                <c:pt idx="22">
                  <c:v>8.6956521739130453E-3</c:v>
                </c:pt>
                <c:pt idx="23">
                  <c:v>1.15942028985507E-2</c:v>
                </c:pt>
                <c:pt idx="24">
                  <c:v>5.7971014492753598E-3</c:v>
                </c:pt>
                <c:pt idx="25">
                  <c:v>2.8985507246376808E-3</c:v>
                </c:pt>
                <c:pt idx="26">
                  <c:v>0</c:v>
                </c:pt>
                <c:pt idx="27">
                  <c:v>8.6956521739130453E-3</c:v>
                </c:pt>
                <c:pt idx="28">
                  <c:v>0</c:v>
                </c:pt>
                <c:pt idx="29">
                  <c:v>2.8985507246376808E-3</c:v>
                </c:pt>
                <c:pt idx="30">
                  <c:v>0</c:v>
                </c:pt>
              </c:numCache>
            </c:numRef>
          </c:val>
        </c:ser>
        <c:ser>
          <c:idx val="6"/>
          <c:order val="6"/>
          <c:tx>
            <c:strRef>
              <c:f>'cat-2(CB1112)_A1_0.02_50%'!$H$104</c:f>
              <c:strCache>
                <c:ptCount val="1"/>
                <c:pt idx="0">
                  <c:v>cat-2(CB1112)_A1_07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H$105:$H$135</c:f>
              <c:numCache>
                <c:formatCode>General</c:formatCode>
                <c:ptCount val="31"/>
                <c:pt idx="1">
                  <c:v>6.5250379362670696E-2</c:v>
                </c:pt>
                <c:pt idx="2">
                  <c:v>4.2488619119878626E-2</c:v>
                </c:pt>
                <c:pt idx="3">
                  <c:v>5.7663125948406738E-2</c:v>
                </c:pt>
                <c:pt idx="4">
                  <c:v>6.676783004552353E-2</c:v>
                </c:pt>
                <c:pt idx="5">
                  <c:v>6.5250379362670696E-2</c:v>
                </c:pt>
                <c:pt idx="6">
                  <c:v>7.2837632776934821E-2</c:v>
                </c:pt>
                <c:pt idx="7">
                  <c:v>5.1593323216995404E-2</c:v>
                </c:pt>
                <c:pt idx="8">
                  <c:v>6.0698027314112321E-2</c:v>
                </c:pt>
                <c:pt idx="9">
                  <c:v>4.4006069802731439E-2</c:v>
                </c:pt>
                <c:pt idx="10">
                  <c:v>4.0971168437025779E-2</c:v>
                </c:pt>
                <c:pt idx="11">
                  <c:v>4.8558421851289821E-2</c:v>
                </c:pt>
                <c:pt idx="12">
                  <c:v>3.4901365705614612E-2</c:v>
                </c:pt>
                <c:pt idx="13">
                  <c:v>3.0349013657056112E-2</c:v>
                </c:pt>
                <c:pt idx="14">
                  <c:v>3.6418816388467411E-2</c:v>
                </c:pt>
                <c:pt idx="15">
                  <c:v>2.8831562974203313E-2</c:v>
                </c:pt>
                <c:pt idx="16">
                  <c:v>2.7314112291350508E-2</c:v>
                </c:pt>
                <c:pt idx="17">
                  <c:v>1.9726858877086507E-2</c:v>
                </c:pt>
                <c:pt idx="18">
                  <c:v>3.9453717754173029E-2</c:v>
                </c:pt>
                <c:pt idx="19">
                  <c:v>3.9453717754173029E-2</c:v>
                </c:pt>
                <c:pt idx="20">
                  <c:v>2.2761760242792101E-2</c:v>
                </c:pt>
                <c:pt idx="21">
                  <c:v>2.1244309559939313E-2</c:v>
                </c:pt>
                <c:pt idx="22">
                  <c:v>9.104704097116844E-3</c:v>
                </c:pt>
                <c:pt idx="23">
                  <c:v>7.5872534142640453E-3</c:v>
                </c:pt>
                <c:pt idx="24">
                  <c:v>6.0698027314112319E-3</c:v>
                </c:pt>
                <c:pt idx="25">
                  <c:v>6.0698027314112319E-3</c:v>
                </c:pt>
                <c:pt idx="26">
                  <c:v>9.104704097116844E-3</c:v>
                </c:pt>
                <c:pt idx="27">
                  <c:v>4.5523520485584203E-3</c:v>
                </c:pt>
                <c:pt idx="28">
                  <c:v>1.5174506828528104E-3</c:v>
                </c:pt>
                <c:pt idx="29">
                  <c:v>3.0349013657056112E-3</c:v>
                </c:pt>
                <c:pt idx="30">
                  <c:v>1.5174506828528104E-3</c:v>
                </c:pt>
              </c:numCache>
            </c:numRef>
          </c:val>
        </c:ser>
        <c:ser>
          <c:idx val="7"/>
          <c:order val="7"/>
          <c:tx>
            <c:strRef>
              <c:f>'cat-2(CB1112)_A1_0.02_50%'!$I$104</c:f>
              <c:strCache>
                <c:ptCount val="1"/>
                <c:pt idx="0">
                  <c:v>cat-2(CB1112)_A1_08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I$105:$I$135</c:f>
              <c:numCache>
                <c:formatCode>General</c:formatCode>
                <c:ptCount val="31"/>
                <c:pt idx="1">
                  <c:v>6.3095238095238121E-2</c:v>
                </c:pt>
                <c:pt idx="2">
                  <c:v>7.1428571428571411E-2</c:v>
                </c:pt>
                <c:pt idx="3">
                  <c:v>6.1904761904761914E-2</c:v>
                </c:pt>
                <c:pt idx="4">
                  <c:v>7.8571428571428598E-2</c:v>
                </c:pt>
                <c:pt idx="5">
                  <c:v>7.5000000000000011E-2</c:v>
                </c:pt>
                <c:pt idx="6">
                  <c:v>8.0952380952381026E-2</c:v>
                </c:pt>
                <c:pt idx="7">
                  <c:v>5.1190476190476217E-2</c:v>
                </c:pt>
                <c:pt idx="8">
                  <c:v>5.5952380952381038E-2</c:v>
                </c:pt>
                <c:pt idx="9">
                  <c:v>4.6428571428571402E-2</c:v>
                </c:pt>
                <c:pt idx="10">
                  <c:v>5.1190476190476217E-2</c:v>
                </c:pt>
                <c:pt idx="11">
                  <c:v>3.2142857142857098E-2</c:v>
                </c:pt>
                <c:pt idx="12">
                  <c:v>4.8809523809523817E-2</c:v>
                </c:pt>
                <c:pt idx="13">
                  <c:v>3.5714285714285698E-2</c:v>
                </c:pt>
                <c:pt idx="14">
                  <c:v>3.0952380952380999E-2</c:v>
                </c:pt>
                <c:pt idx="15">
                  <c:v>2.3809523809523808E-2</c:v>
                </c:pt>
                <c:pt idx="16">
                  <c:v>1.6666666666666701E-2</c:v>
                </c:pt>
                <c:pt idx="17">
                  <c:v>2.0238095238095201E-2</c:v>
                </c:pt>
                <c:pt idx="18">
                  <c:v>2.7380952380952402E-2</c:v>
                </c:pt>
                <c:pt idx="19">
                  <c:v>1.6666666666666701E-2</c:v>
                </c:pt>
                <c:pt idx="20">
                  <c:v>9.5238095238095229E-3</c:v>
                </c:pt>
                <c:pt idx="21">
                  <c:v>1.1904761904761904E-2</c:v>
                </c:pt>
                <c:pt idx="22">
                  <c:v>9.5238095238095229E-3</c:v>
                </c:pt>
                <c:pt idx="23">
                  <c:v>3.5714285714285709E-3</c:v>
                </c:pt>
                <c:pt idx="24">
                  <c:v>2.3809523809523807E-3</c:v>
                </c:pt>
                <c:pt idx="25">
                  <c:v>5.9523809523809503E-3</c:v>
                </c:pt>
                <c:pt idx="26">
                  <c:v>3.5714285714285709E-3</c:v>
                </c:pt>
                <c:pt idx="27">
                  <c:v>3.5714285714285709E-3</c:v>
                </c:pt>
                <c:pt idx="28">
                  <c:v>0</c:v>
                </c:pt>
                <c:pt idx="29">
                  <c:v>1.1904761904761901E-3</c:v>
                </c:pt>
                <c:pt idx="30">
                  <c:v>0</c:v>
                </c:pt>
              </c:numCache>
            </c:numRef>
          </c:val>
        </c:ser>
        <c:ser>
          <c:idx val="8"/>
          <c:order val="8"/>
          <c:tx>
            <c:strRef>
              <c:f>'cat-2(CB1112)_A1_0.02_50%'!$J$104</c:f>
              <c:strCache>
                <c:ptCount val="1"/>
                <c:pt idx="0">
                  <c:v>cat-2(CB1112)_A1_09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J$105:$J$135</c:f>
              <c:numCache>
                <c:formatCode>General</c:formatCode>
                <c:ptCount val="31"/>
                <c:pt idx="1">
                  <c:v>6.6499372647427807E-2</c:v>
                </c:pt>
                <c:pt idx="2">
                  <c:v>5.6461731493099097E-2</c:v>
                </c:pt>
                <c:pt idx="3">
                  <c:v>7.9046424090338838E-2</c:v>
                </c:pt>
                <c:pt idx="4">
                  <c:v>8.1555834378921055E-2</c:v>
                </c:pt>
                <c:pt idx="5">
                  <c:v>7.0263488080301112E-2</c:v>
                </c:pt>
                <c:pt idx="6">
                  <c:v>7.9046424090338838E-2</c:v>
                </c:pt>
                <c:pt idx="7">
                  <c:v>7.9046424090338838E-2</c:v>
                </c:pt>
                <c:pt idx="8">
                  <c:v>6.1480552070263483E-2</c:v>
                </c:pt>
                <c:pt idx="9">
                  <c:v>4.3914680050188226E-2</c:v>
                </c:pt>
                <c:pt idx="10">
                  <c:v>4.0150564617314886E-2</c:v>
                </c:pt>
                <c:pt idx="11">
                  <c:v>4.3914680050188226E-2</c:v>
                </c:pt>
                <c:pt idx="12">
                  <c:v>3.6386449184441699E-2</c:v>
                </c:pt>
                <c:pt idx="13">
                  <c:v>3.2622333751568401E-2</c:v>
                </c:pt>
                <c:pt idx="14">
                  <c:v>2.2584692597239699E-2</c:v>
                </c:pt>
                <c:pt idx="15">
                  <c:v>1.5056461731493101E-2</c:v>
                </c:pt>
                <c:pt idx="16">
                  <c:v>2.5094102885821812E-2</c:v>
                </c:pt>
                <c:pt idx="17">
                  <c:v>2.3839397741530714E-2</c:v>
                </c:pt>
                <c:pt idx="18">
                  <c:v>3.0112923462986201E-2</c:v>
                </c:pt>
                <c:pt idx="19">
                  <c:v>1.6311166875784201E-2</c:v>
                </c:pt>
                <c:pt idx="20">
                  <c:v>1.5056461731493101E-2</c:v>
                </c:pt>
                <c:pt idx="21">
                  <c:v>1.1292346298619801E-2</c:v>
                </c:pt>
                <c:pt idx="22">
                  <c:v>2.5094102885821817E-3</c:v>
                </c:pt>
                <c:pt idx="23">
                  <c:v>2.5094102885821817E-3</c:v>
                </c:pt>
                <c:pt idx="24">
                  <c:v>3.7641154328732717E-3</c:v>
                </c:pt>
                <c:pt idx="25">
                  <c:v>1.2547051442910909E-3</c:v>
                </c:pt>
                <c:pt idx="26">
                  <c:v>3.7641154328732717E-3</c:v>
                </c:pt>
                <c:pt idx="27">
                  <c:v>5.0188205771643703E-3</c:v>
                </c:pt>
                <c:pt idx="28">
                  <c:v>0</c:v>
                </c:pt>
                <c:pt idx="29">
                  <c:v>2.5094102885821817E-3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cat-2(CB1112)_A1_0.02_50%'!$K$104</c:f>
              <c:strCache>
                <c:ptCount val="1"/>
                <c:pt idx="0">
                  <c:v>cat-2(CB1112)_A1_10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K$105:$K$135</c:f>
              <c:numCache>
                <c:formatCode>General</c:formatCode>
                <c:ptCount val="31"/>
                <c:pt idx="1">
                  <c:v>5.1244509516837476E-2</c:v>
                </c:pt>
                <c:pt idx="2">
                  <c:v>6.1493411420205021E-2</c:v>
                </c:pt>
                <c:pt idx="3">
                  <c:v>4.68521229868228E-2</c:v>
                </c:pt>
                <c:pt idx="4">
                  <c:v>4.39238653001464E-2</c:v>
                </c:pt>
                <c:pt idx="5">
                  <c:v>4.68521229868228E-2</c:v>
                </c:pt>
                <c:pt idx="6">
                  <c:v>5.4172767203513918E-2</c:v>
                </c:pt>
                <c:pt idx="7">
                  <c:v>6.5885797950219635E-2</c:v>
                </c:pt>
                <c:pt idx="8">
                  <c:v>4.39238653001464E-2</c:v>
                </c:pt>
                <c:pt idx="9">
                  <c:v>5.5636896046852104E-2</c:v>
                </c:pt>
                <c:pt idx="10">
                  <c:v>4.68521229868228E-2</c:v>
                </c:pt>
                <c:pt idx="11">
                  <c:v>4.8316251830161139E-2</c:v>
                </c:pt>
                <c:pt idx="12">
                  <c:v>4.8316251830161139E-2</c:v>
                </c:pt>
                <c:pt idx="13">
                  <c:v>4.0995607613470014E-2</c:v>
                </c:pt>
                <c:pt idx="14">
                  <c:v>2.3426061493411397E-2</c:v>
                </c:pt>
                <c:pt idx="15">
                  <c:v>3.6603221083455331E-2</c:v>
                </c:pt>
                <c:pt idx="16">
                  <c:v>3.6603221083455331E-2</c:v>
                </c:pt>
                <c:pt idx="17">
                  <c:v>3.0746705710102507E-2</c:v>
                </c:pt>
                <c:pt idx="18">
                  <c:v>3.6603221083455331E-2</c:v>
                </c:pt>
                <c:pt idx="19">
                  <c:v>2.7818448023426118E-2</c:v>
                </c:pt>
                <c:pt idx="20">
                  <c:v>2.3426061493411397E-2</c:v>
                </c:pt>
                <c:pt idx="21">
                  <c:v>1.31771595900439E-2</c:v>
                </c:pt>
                <c:pt idx="22">
                  <c:v>1.0248901903367504E-2</c:v>
                </c:pt>
                <c:pt idx="23">
                  <c:v>1.0248901903367504E-2</c:v>
                </c:pt>
                <c:pt idx="24">
                  <c:v>7.3206442166910716E-3</c:v>
                </c:pt>
                <c:pt idx="25">
                  <c:v>8.7847730600292794E-3</c:v>
                </c:pt>
                <c:pt idx="26">
                  <c:v>1.4641288433382106E-3</c:v>
                </c:pt>
                <c:pt idx="27">
                  <c:v>4.3923865300146414E-3</c:v>
                </c:pt>
                <c:pt idx="28">
                  <c:v>5.8565153733528604E-3</c:v>
                </c:pt>
                <c:pt idx="29">
                  <c:v>7.3206442166910716E-3</c:v>
                </c:pt>
                <c:pt idx="3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cat-2(CB1112)_A1_0.02_50%'!$L$104</c:f>
              <c:strCache>
                <c:ptCount val="1"/>
                <c:pt idx="0">
                  <c:v>cat-2(CB1112)_A1_11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L$105:$L$135</c:f>
              <c:numCache>
                <c:formatCode>General</c:formatCode>
                <c:ptCount val="31"/>
                <c:pt idx="1">
                  <c:v>6.3311688311688333E-2</c:v>
                </c:pt>
                <c:pt idx="2">
                  <c:v>5.681818181818183E-2</c:v>
                </c:pt>
                <c:pt idx="3">
                  <c:v>4.5454545454545497E-2</c:v>
                </c:pt>
                <c:pt idx="4">
                  <c:v>7.1428571428571411E-2</c:v>
                </c:pt>
                <c:pt idx="5">
                  <c:v>7.46753246753247E-2</c:v>
                </c:pt>
                <c:pt idx="6">
                  <c:v>8.4415584415584374E-2</c:v>
                </c:pt>
                <c:pt idx="7">
                  <c:v>5.1948051948052E-2</c:v>
                </c:pt>
                <c:pt idx="8">
                  <c:v>5.3571428571428603E-2</c:v>
                </c:pt>
                <c:pt idx="9">
                  <c:v>4.3831168831168797E-2</c:v>
                </c:pt>
                <c:pt idx="10">
                  <c:v>3.5714285714285698E-2</c:v>
                </c:pt>
                <c:pt idx="11">
                  <c:v>4.2207792207792215E-2</c:v>
                </c:pt>
                <c:pt idx="12">
                  <c:v>5.8441558441558378E-2</c:v>
                </c:pt>
                <c:pt idx="13">
                  <c:v>3.4090909090909102E-2</c:v>
                </c:pt>
                <c:pt idx="14">
                  <c:v>3.0844155844155802E-2</c:v>
                </c:pt>
                <c:pt idx="15">
                  <c:v>2.922077922077921E-2</c:v>
                </c:pt>
                <c:pt idx="16">
                  <c:v>2.75974025974026E-2</c:v>
                </c:pt>
                <c:pt idx="17">
                  <c:v>1.1363636363636404E-2</c:v>
                </c:pt>
                <c:pt idx="18">
                  <c:v>1.7857142857142898E-2</c:v>
                </c:pt>
                <c:pt idx="19">
                  <c:v>2.4350649350649397E-2</c:v>
                </c:pt>
                <c:pt idx="20">
                  <c:v>2.2727272727272717E-2</c:v>
                </c:pt>
                <c:pt idx="21">
                  <c:v>1.4610389610389601E-2</c:v>
                </c:pt>
                <c:pt idx="22">
                  <c:v>6.4935064935064922E-3</c:v>
                </c:pt>
                <c:pt idx="23">
                  <c:v>3.2467532467532517E-3</c:v>
                </c:pt>
                <c:pt idx="24">
                  <c:v>4.8701298701298718E-3</c:v>
                </c:pt>
                <c:pt idx="25">
                  <c:v>8.1168831168831231E-3</c:v>
                </c:pt>
                <c:pt idx="26">
                  <c:v>3.2467532467532517E-3</c:v>
                </c:pt>
                <c:pt idx="27">
                  <c:v>6.4935064935064922E-3</c:v>
                </c:pt>
                <c:pt idx="28">
                  <c:v>3.2467532467532517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cat-2(CB1112)_A1_0.02_50%'!$M$104</c:f>
              <c:strCache>
                <c:ptCount val="1"/>
                <c:pt idx="0">
                  <c:v>cat-2(CB1112)_A1_12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M$105:$M$135</c:f>
              <c:numCache>
                <c:formatCode>General</c:formatCode>
                <c:ptCount val="31"/>
                <c:pt idx="1">
                  <c:v>4.3046357615893996E-2</c:v>
                </c:pt>
                <c:pt idx="2">
                  <c:v>7.2847682119205323E-2</c:v>
                </c:pt>
                <c:pt idx="3">
                  <c:v>6.12582781456954E-2</c:v>
                </c:pt>
                <c:pt idx="4">
                  <c:v>8.1125827814569507E-2</c:v>
                </c:pt>
                <c:pt idx="5">
                  <c:v>8.2781456953642432E-2</c:v>
                </c:pt>
                <c:pt idx="6">
                  <c:v>8.4437086092715191E-2</c:v>
                </c:pt>
                <c:pt idx="7">
                  <c:v>4.6357615894039722E-2</c:v>
                </c:pt>
                <c:pt idx="8">
                  <c:v>4.8013245033112599E-2</c:v>
                </c:pt>
                <c:pt idx="9">
                  <c:v>4.6357615894039722E-2</c:v>
                </c:pt>
                <c:pt idx="10">
                  <c:v>4.4701986754966921E-2</c:v>
                </c:pt>
                <c:pt idx="11">
                  <c:v>5.7947019867549715E-2</c:v>
                </c:pt>
                <c:pt idx="12">
                  <c:v>5.2980132450331119E-2</c:v>
                </c:pt>
                <c:pt idx="13">
                  <c:v>3.9735099337748297E-2</c:v>
                </c:pt>
                <c:pt idx="14">
                  <c:v>2.483443708609271E-2</c:v>
                </c:pt>
                <c:pt idx="15">
                  <c:v>3.6423841059602606E-2</c:v>
                </c:pt>
                <c:pt idx="16">
                  <c:v>1.6556291390728502E-2</c:v>
                </c:pt>
                <c:pt idx="17">
                  <c:v>2.8145695364238391E-2</c:v>
                </c:pt>
                <c:pt idx="18">
                  <c:v>1.9867549668874208E-2</c:v>
                </c:pt>
                <c:pt idx="19">
                  <c:v>1.1589403973509899E-2</c:v>
                </c:pt>
                <c:pt idx="20">
                  <c:v>9.9337748344370969E-3</c:v>
                </c:pt>
                <c:pt idx="21">
                  <c:v>4.9668874172185415E-3</c:v>
                </c:pt>
                <c:pt idx="22">
                  <c:v>9.9337748344370969E-3</c:v>
                </c:pt>
                <c:pt idx="23">
                  <c:v>0</c:v>
                </c:pt>
                <c:pt idx="24">
                  <c:v>1.6556291390728505E-3</c:v>
                </c:pt>
                <c:pt idx="25">
                  <c:v>3.3112582781457001E-3</c:v>
                </c:pt>
                <c:pt idx="26">
                  <c:v>4.9668874172185415E-3</c:v>
                </c:pt>
                <c:pt idx="27">
                  <c:v>6.6225165562913864E-3</c:v>
                </c:pt>
                <c:pt idx="28">
                  <c:v>1.6556291390728505E-3</c:v>
                </c:pt>
                <c:pt idx="29">
                  <c:v>0</c:v>
                </c:pt>
                <c:pt idx="30">
                  <c:v>3.3112582781457001E-3</c:v>
                </c:pt>
              </c:numCache>
            </c:numRef>
          </c:val>
        </c:ser>
        <c:ser>
          <c:idx val="12"/>
          <c:order val="12"/>
          <c:tx>
            <c:strRef>
              <c:f>'cat-2(CB1112)_A1_0.02_50%'!$N$104</c:f>
              <c:strCache>
                <c:ptCount val="1"/>
                <c:pt idx="0">
                  <c:v>cat-2(CB1112)_A1_13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N$105:$N$135</c:f>
              <c:numCache>
                <c:formatCode>General</c:formatCode>
                <c:ptCount val="31"/>
                <c:pt idx="1">
                  <c:v>7.6411960132890394E-2</c:v>
                </c:pt>
                <c:pt idx="2">
                  <c:v>7.5304540420819494E-2</c:v>
                </c:pt>
                <c:pt idx="3">
                  <c:v>7.6411960132890394E-2</c:v>
                </c:pt>
                <c:pt idx="4">
                  <c:v>7.8626799557032112E-2</c:v>
                </c:pt>
                <c:pt idx="5">
                  <c:v>7.9734219269103027E-2</c:v>
                </c:pt>
                <c:pt idx="6">
                  <c:v>7.9734219269103027E-2</c:v>
                </c:pt>
                <c:pt idx="7">
                  <c:v>7.7519379844961225E-2</c:v>
                </c:pt>
                <c:pt idx="8">
                  <c:v>5.8693244739756414E-2</c:v>
                </c:pt>
                <c:pt idx="9">
                  <c:v>4.9833887043189418E-2</c:v>
                </c:pt>
                <c:pt idx="10">
                  <c:v>3.5437430786268015E-2</c:v>
                </c:pt>
                <c:pt idx="11">
                  <c:v>5.6478405315614578E-2</c:v>
                </c:pt>
                <c:pt idx="12">
                  <c:v>3.6544850498338902E-2</c:v>
                </c:pt>
                <c:pt idx="13">
                  <c:v>4.09745293466224E-2</c:v>
                </c:pt>
                <c:pt idx="14">
                  <c:v>2.4363233665559206E-2</c:v>
                </c:pt>
                <c:pt idx="15">
                  <c:v>1.6611295681063103E-2</c:v>
                </c:pt>
                <c:pt idx="16">
                  <c:v>1.6611295681063103E-2</c:v>
                </c:pt>
                <c:pt idx="17">
                  <c:v>1.6611295681063103E-2</c:v>
                </c:pt>
                <c:pt idx="18">
                  <c:v>1.6611295681063103E-2</c:v>
                </c:pt>
                <c:pt idx="19">
                  <c:v>1.2181616832779598E-2</c:v>
                </c:pt>
                <c:pt idx="20">
                  <c:v>6.6445182724252476E-3</c:v>
                </c:pt>
                <c:pt idx="21">
                  <c:v>6.6445182724252476E-3</c:v>
                </c:pt>
                <c:pt idx="22">
                  <c:v>3.3222591362126199E-3</c:v>
                </c:pt>
                <c:pt idx="23">
                  <c:v>1.10741971207087E-3</c:v>
                </c:pt>
                <c:pt idx="24">
                  <c:v>1.10741971207087E-3</c:v>
                </c:pt>
                <c:pt idx="25">
                  <c:v>0</c:v>
                </c:pt>
                <c:pt idx="26">
                  <c:v>1.10741971207087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cat-2(CB1112)_A1_0.02_50%'!$O$104</c:f>
              <c:strCache>
                <c:ptCount val="1"/>
                <c:pt idx="0">
                  <c:v>cat-2(CB1112)_A1_14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O$105:$O$135</c:f>
              <c:numCache>
                <c:formatCode>General</c:formatCode>
                <c:ptCount val="31"/>
                <c:pt idx="1">
                  <c:v>6.6433566433566404E-2</c:v>
                </c:pt>
                <c:pt idx="2">
                  <c:v>5.4195804195804199E-2</c:v>
                </c:pt>
                <c:pt idx="3">
                  <c:v>5.7692307692307716E-2</c:v>
                </c:pt>
                <c:pt idx="4">
                  <c:v>6.2937062937062901E-2</c:v>
                </c:pt>
                <c:pt idx="5">
                  <c:v>5.2447552447552385E-2</c:v>
                </c:pt>
                <c:pt idx="6">
                  <c:v>5.4195804195804199E-2</c:v>
                </c:pt>
                <c:pt idx="7">
                  <c:v>6.6433566433566404E-2</c:v>
                </c:pt>
                <c:pt idx="8">
                  <c:v>4.7202797202797221E-2</c:v>
                </c:pt>
                <c:pt idx="9">
                  <c:v>5.9440559440559398E-2</c:v>
                </c:pt>
                <c:pt idx="10">
                  <c:v>5.0699300699300696E-2</c:v>
                </c:pt>
                <c:pt idx="11">
                  <c:v>2.972027972027971E-2</c:v>
                </c:pt>
                <c:pt idx="12">
                  <c:v>4.3706293706293725E-2</c:v>
                </c:pt>
                <c:pt idx="13">
                  <c:v>5.0699300699300696E-2</c:v>
                </c:pt>
                <c:pt idx="14">
                  <c:v>2.6223776223776214E-2</c:v>
                </c:pt>
                <c:pt idx="15">
                  <c:v>5.4195804195804199E-2</c:v>
                </c:pt>
                <c:pt idx="16">
                  <c:v>2.797202797202801E-2</c:v>
                </c:pt>
                <c:pt idx="17">
                  <c:v>2.4475524475524518E-2</c:v>
                </c:pt>
                <c:pt idx="18">
                  <c:v>3.3216783216783195E-2</c:v>
                </c:pt>
                <c:pt idx="19">
                  <c:v>1.3986013986014E-2</c:v>
                </c:pt>
                <c:pt idx="20">
                  <c:v>1.2237762237762203E-2</c:v>
                </c:pt>
                <c:pt idx="21">
                  <c:v>6.9930069930069921E-3</c:v>
                </c:pt>
                <c:pt idx="22">
                  <c:v>8.7412587412587367E-3</c:v>
                </c:pt>
                <c:pt idx="23">
                  <c:v>1.0489510489510504E-2</c:v>
                </c:pt>
                <c:pt idx="24">
                  <c:v>5.2447552447552484E-3</c:v>
                </c:pt>
                <c:pt idx="25">
                  <c:v>5.2447552447552484E-3</c:v>
                </c:pt>
                <c:pt idx="26">
                  <c:v>1.7482517482517509E-3</c:v>
                </c:pt>
                <c:pt idx="27">
                  <c:v>1.7482517482517509E-3</c:v>
                </c:pt>
                <c:pt idx="28">
                  <c:v>3.4965034965035E-3</c:v>
                </c:pt>
                <c:pt idx="29">
                  <c:v>1.7482517482517509E-3</c:v>
                </c:pt>
                <c:pt idx="30">
                  <c:v>0</c:v>
                </c:pt>
              </c:numCache>
            </c:numRef>
          </c:val>
        </c:ser>
        <c:ser>
          <c:idx val="14"/>
          <c:order val="14"/>
          <c:tx>
            <c:strRef>
              <c:f>'cat-2(CB1112)_A1_0.02_50%'!$P$104</c:f>
              <c:strCache>
                <c:ptCount val="1"/>
                <c:pt idx="0">
                  <c:v>cat-2(CB1112)_A1_15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P$105:$P$135</c:f>
              <c:numCache>
                <c:formatCode>General</c:formatCode>
                <c:ptCount val="31"/>
                <c:pt idx="1">
                  <c:v>7.4683544303797506E-2</c:v>
                </c:pt>
                <c:pt idx="2">
                  <c:v>6.4556962025316522E-2</c:v>
                </c:pt>
                <c:pt idx="3">
                  <c:v>7.7215189873417703E-2</c:v>
                </c:pt>
                <c:pt idx="4">
                  <c:v>6.3291139240506333E-2</c:v>
                </c:pt>
                <c:pt idx="5">
                  <c:v>7.9746835443038025E-2</c:v>
                </c:pt>
                <c:pt idx="6">
                  <c:v>6.8354430379746825E-2</c:v>
                </c:pt>
                <c:pt idx="7">
                  <c:v>7.2151898734177169E-2</c:v>
                </c:pt>
                <c:pt idx="8">
                  <c:v>6.3291139240506333E-2</c:v>
                </c:pt>
                <c:pt idx="9">
                  <c:v>5.9493670886075933E-2</c:v>
                </c:pt>
                <c:pt idx="10">
                  <c:v>4.4303797468354403E-2</c:v>
                </c:pt>
                <c:pt idx="11">
                  <c:v>3.5443037974683518E-2</c:v>
                </c:pt>
                <c:pt idx="12">
                  <c:v>3.5443037974683518E-2</c:v>
                </c:pt>
                <c:pt idx="13">
                  <c:v>4.05063291139241E-2</c:v>
                </c:pt>
                <c:pt idx="14">
                  <c:v>3.1645569620253215E-2</c:v>
                </c:pt>
                <c:pt idx="15">
                  <c:v>2.5316455696202493E-2</c:v>
                </c:pt>
                <c:pt idx="16">
                  <c:v>1.0126582278481001E-2</c:v>
                </c:pt>
                <c:pt idx="17">
                  <c:v>1.8987341772151899E-2</c:v>
                </c:pt>
                <c:pt idx="18">
                  <c:v>2.0253164556962001E-2</c:v>
                </c:pt>
                <c:pt idx="19">
                  <c:v>1.3924050632911408E-2</c:v>
                </c:pt>
                <c:pt idx="20">
                  <c:v>1.3924050632911408E-2</c:v>
                </c:pt>
                <c:pt idx="21">
                  <c:v>1.1392405063291101E-2</c:v>
                </c:pt>
                <c:pt idx="22">
                  <c:v>5.0632911392405116E-3</c:v>
                </c:pt>
                <c:pt idx="23">
                  <c:v>5.0632911392405116E-3</c:v>
                </c:pt>
                <c:pt idx="24">
                  <c:v>5.0632911392405116E-3</c:v>
                </c:pt>
                <c:pt idx="25">
                  <c:v>2.5316455696202493E-3</c:v>
                </c:pt>
                <c:pt idx="26">
                  <c:v>3.7974683544303809E-3</c:v>
                </c:pt>
                <c:pt idx="27">
                  <c:v>0</c:v>
                </c:pt>
                <c:pt idx="28">
                  <c:v>1.2658227848101301E-3</c:v>
                </c:pt>
                <c:pt idx="29">
                  <c:v>2.5316455696202493E-3</c:v>
                </c:pt>
                <c:pt idx="30">
                  <c:v>0</c:v>
                </c:pt>
              </c:numCache>
            </c:numRef>
          </c:val>
        </c:ser>
        <c:ser>
          <c:idx val="15"/>
          <c:order val="15"/>
          <c:tx>
            <c:strRef>
              <c:f>'cat-2(CB1112)_A1_0.02_50%'!$Q$104</c:f>
              <c:strCache>
                <c:ptCount val="1"/>
                <c:pt idx="0">
                  <c:v>cat-2(CB1112)_A1_16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Q$105:$Q$135</c:f>
              <c:numCache>
                <c:formatCode>General</c:formatCode>
                <c:ptCount val="31"/>
                <c:pt idx="1">
                  <c:v>7.2033898305084706E-2</c:v>
                </c:pt>
                <c:pt idx="2">
                  <c:v>5.084745762711862E-2</c:v>
                </c:pt>
                <c:pt idx="3">
                  <c:v>5.7203389830508516E-2</c:v>
                </c:pt>
                <c:pt idx="4">
                  <c:v>8.4745762711864472E-2</c:v>
                </c:pt>
                <c:pt idx="5">
                  <c:v>8.4745762711864472E-2</c:v>
                </c:pt>
                <c:pt idx="6">
                  <c:v>7.4152542372881394E-2</c:v>
                </c:pt>
                <c:pt idx="7">
                  <c:v>6.5677966101694907E-2</c:v>
                </c:pt>
                <c:pt idx="8">
                  <c:v>5.084745762711862E-2</c:v>
                </c:pt>
                <c:pt idx="9">
                  <c:v>3.3898305084745811E-2</c:v>
                </c:pt>
                <c:pt idx="10">
                  <c:v>3.3898305084745811E-2</c:v>
                </c:pt>
                <c:pt idx="11">
                  <c:v>3.8135593220338999E-2</c:v>
                </c:pt>
                <c:pt idx="12">
                  <c:v>5.2966101694915321E-2</c:v>
                </c:pt>
                <c:pt idx="13">
                  <c:v>4.6610169491525397E-2</c:v>
                </c:pt>
                <c:pt idx="14">
                  <c:v>3.1779661016949214E-2</c:v>
                </c:pt>
                <c:pt idx="15">
                  <c:v>1.0593220338983101E-2</c:v>
                </c:pt>
                <c:pt idx="16">
                  <c:v>2.7542372881355921E-2</c:v>
                </c:pt>
                <c:pt idx="17">
                  <c:v>2.1186440677966111E-2</c:v>
                </c:pt>
                <c:pt idx="18">
                  <c:v>1.9067796610169507E-2</c:v>
                </c:pt>
                <c:pt idx="19">
                  <c:v>3.1779661016949214E-2</c:v>
                </c:pt>
                <c:pt idx="20">
                  <c:v>1.6949152542372906E-2</c:v>
                </c:pt>
                <c:pt idx="21">
                  <c:v>8.4745762711864476E-3</c:v>
                </c:pt>
                <c:pt idx="22">
                  <c:v>1.27118644067797E-2</c:v>
                </c:pt>
                <c:pt idx="23">
                  <c:v>4.2372881355932238E-3</c:v>
                </c:pt>
                <c:pt idx="24">
                  <c:v>4.2372881355932238E-3</c:v>
                </c:pt>
                <c:pt idx="25">
                  <c:v>6.3559322033898318E-3</c:v>
                </c:pt>
                <c:pt idx="26">
                  <c:v>2.118644067796611E-3</c:v>
                </c:pt>
                <c:pt idx="27">
                  <c:v>4.2372881355932238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6"/>
          <c:order val="16"/>
          <c:tx>
            <c:strRef>
              <c:f>'cat-2(CB1112)_A1_0.02_50%'!$R$104</c:f>
              <c:strCache>
                <c:ptCount val="1"/>
                <c:pt idx="0">
                  <c:v>cat-2(CB1112)_A1_17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R$105:$R$135</c:f>
              <c:numCache>
                <c:formatCode>General</c:formatCode>
                <c:ptCount val="31"/>
                <c:pt idx="1">
                  <c:v>4.8484848484848485E-2</c:v>
                </c:pt>
                <c:pt idx="2">
                  <c:v>5.0505050505050483E-2</c:v>
                </c:pt>
                <c:pt idx="3">
                  <c:v>4.64646464646465E-2</c:v>
                </c:pt>
                <c:pt idx="4">
                  <c:v>9.2929292929292973E-2</c:v>
                </c:pt>
                <c:pt idx="5">
                  <c:v>7.6767676767676804E-2</c:v>
                </c:pt>
                <c:pt idx="6">
                  <c:v>6.2626262626262599E-2</c:v>
                </c:pt>
                <c:pt idx="7">
                  <c:v>8.4848484848484895E-2</c:v>
                </c:pt>
                <c:pt idx="8">
                  <c:v>6.4646464646464633E-2</c:v>
                </c:pt>
                <c:pt idx="9">
                  <c:v>5.0505050505050483E-2</c:v>
                </c:pt>
                <c:pt idx="10">
                  <c:v>5.2525252525252482E-2</c:v>
                </c:pt>
                <c:pt idx="11">
                  <c:v>3.8383838383838402E-2</c:v>
                </c:pt>
                <c:pt idx="12">
                  <c:v>5.0505050505050483E-2</c:v>
                </c:pt>
                <c:pt idx="13">
                  <c:v>3.2323232323232302E-2</c:v>
                </c:pt>
                <c:pt idx="14">
                  <c:v>2.4242424242424197E-2</c:v>
                </c:pt>
                <c:pt idx="15">
                  <c:v>2.02020202020202E-2</c:v>
                </c:pt>
                <c:pt idx="16">
                  <c:v>1.01010101010101E-2</c:v>
                </c:pt>
                <c:pt idx="17">
                  <c:v>4.0404040404040401E-2</c:v>
                </c:pt>
                <c:pt idx="18">
                  <c:v>3.2323232323232302E-2</c:v>
                </c:pt>
                <c:pt idx="19">
                  <c:v>1.61616161616162E-2</c:v>
                </c:pt>
                <c:pt idx="20">
                  <c:v>1.2121212121212099E-2</c:v>
                </c:pt>
                <c:pt idx="21">
                  <c:v>1.8181818181818205E-2</c:v>
                </c:pt>
                <c:pt idx="22">
                  <c:v>8.0808080808080808E-3</c:v>
                </c:pt>
                <c:pt idx="23">
                  <c:v>4.0404040404040404E-3</c:v>
                </c:pt>
                <c:pt idx="24">
                  <c:v>4.0404040404040404E-3</c:v>
                </c:pt>
                <c:pt idx="25">
                  <c:v>2.0202020202020202E-3</c:v>
                </c:pt>
                <c:pt idx="26">
                  <c:v>4.0404040404040404E-3</c:v>
                </c:pt>
                <c:pt idx="27">
                  <c:v>2.0202020202020202E-3</c:v>
                </c:pt>
                <c:pt idx="28">
                  <c:v>2.0202020202020202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cat-2(CB1112)_A1_0.02_50%'!$S$104</c:f>
              <c:strCache>
                <c:ptCount val="1"/>
                <c:pt idx="0">
                  <c:v>cat-2(CB1112)_A1_18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S$105:$S$135</c:f>
              <c:numCache>
                <c:formatCode>General</c:formatCode>
                <c:ptCount val="31"/>
                <c:pt idx="1">
                  <c:v>7.8597339782345801E-2</c:v>
                </c:pt>
                <c:pt idx="2">
                  <c:v>6.5296251511487324E-2</c:v>
                </c:pt>
                <c:pt idx="3">
                  <c:v>5.8041112454655382E-2</c:v>
                </c:pt>
                <c:pt idx="4">
                  <c:v>9.1898428053204334E-2</c:v>
                </c:pt>
                <c:pt idx="5">
                  <c:v>5.5622732769044697E-2</c:v>
                </c:pt>
                <c:pt idx="6">
                  <c:v>7.0133010882708624E-2</c:v>
                </c:pt>
                <c:pt idx="7">
                  <c:v>5.9250302297460686E-2</c:v>
                </c:pt>
                <c:pt idx="8">
                  <c:v>6.0459492140265997E-2</c:v>
                </c:pt>
                <c:pt idx="9">
                  <c:v>6.4087061668681999E-2</c:v>
                </c:pt>
                <c:pt idx="10">
                  <c:v>5.0785973397823515E-2</c:v>
                </c:pt>
                <c:pt idx="11">
                  <c:v>4.9576783555018121E-2</c:v>
                </c:pt>
                <c:pt idx="12">
                  <c:v>3.5066505441354298E-2</c:v>
                </c:pt>
                <c:pt idx="13">
                  <c:v>3.9903264812575612E-2</c:v>
                </c:pt>
                <c:pt idx="14">
                  <c:v>1.45102781136638E-2</c:v>
                </c:pt>
                <c:pt idx="15">
                  <c:v>2.4183796856106398E-2</c:v>
                </c:pt>
                <c:pt idx="16">
                  <c:v>2.1765417170495807E-2</c:v>
                </c:pt>
                <c:pt idx="17">
                  <c:v>1.8137847642079801E-2</c:v>
                </c:pt>
                <c:pt idx="18">
                  <c:v>2.1765417170495807E-2</c:v>
                </c:pt>
                <c:pt idx="19">
                  <c:v>1.45102781136638E-2</c:v>
                </c:pt>
                <c:pt idx="20">
                  <c:v>1.0882708585247904E-2</c:v>
                </c:pt>
                <c:pt idx="21">
                  <c:v>9.6735187424425561E-3</c:v>
                </c:pt>
                <c:pt idx="22">
                  <c:v>3.6275695284159627E-3</c:v>
                </c:pt>
                <c:pt idx="23">
                  <c:v>4.8367593712212815E-3</c:v>
                </c:pt>
                <c:pt idx="24">
                  <c:v>3.6275695284159627E-3</c:v>
                </c:pt>
                <c:pt idx="25">
                  <c:v>4.8367593712212815E-3</c:v>
                </c:pt>
                <c:pt idx="26">
                  <c:v>4.8367593712212815E-3</c:v>
                </c:pt>
                <c:pt idx="27">
                  <c:v>1.2091898428053199E-3</c:v>
                </c:pt>
                <c:pt idx="28">
                  <c:v>2.4183796856106399E-3</c:v>
                </c:pt>
                <c:pt idx="29">
                  <c:v>1.2091898428053199E-3</c:v>
                </c:pt>
                <c:pt idx="30">
                  <c:v>0</c:v>
                </c:pt>
              </c:numCache>
            </c:numRef>
          </c:val>
        </c:ser>
        <c:ser>
          <c:idx val="18"/>
          <c:order val="18"/>
          <c:tx>
            <c:strRef>
              <c:f>'cat-2(CB1112)_A1_0.02_50%'!$T$104</c:f>
              <c:strCache>
                <c:ptCount val="1"/>
                <c:pt idx="0">
                  <c:v>cat-2(CB1112)_A1_19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T$105:$T$135</c:f>
              <c:numCache>
                <c:formatCode>General</c:formatCode>
                <c:ptCount val="31"/>
                <c:pt idx="1">
                  <c:v>6.9526627218934933E-2</c:v>
                </c:pt>
                <c:pt idx="2">
                  <c:v>5.9171597633136119E-2</c:v>
                </c:pt>
                <c:pt idx="3">
                  <c:v>7.3964497041420121E-2</c:v>
                </c:pt>
                <c:pt idx="4">
                  <c:v>6.3609467455621321E-2</c:v>
                </c:pt>
                <c:pt idx="5">
                  <c:v>8.431952662721888E-2</c:v>
                </c:pt>
                <c:pt idx="6">
                  <c:v>6.9526627218934933E-2</c:v>
                </c:pt>
                <c:pt idx="7">
                  <c:v>5.3254437869822514E-2</c:v>
                </c:pt>
                <c:pt idx="8">
                  <c:v>4.5857988165680499E-2</c:v>
                </c:pt>
                <c:pt idx="9">
                  <c:v>4.8816568047337319E-2</c:v>
                </c:pt>
                <c:pt idx="10">
                  <c:v>4.5857988165680499E-2</c:v>
                </c:pt>
                <c:pt idx="11">
                  <c:v>5.3254437869822514E-2</c:v>
                </c:pt>
                <c:pt idx="12">
                  <c:v>4.1420118343195297E-2</c:v>
                </c:pt>
                <c:pt idx="13">
                  <c:v>3.9940828402366915E-2</c:v>
                </c:pt>
                <c:pt idx="14">
                  <c:v>2.6627218934911209E-2</c:v>
                </c:pt>
                <c:pt idx="15">
                  <c:v>1.1834319526627201E-2</c:v>
                </c:pt>
                <c:pt idx="16">
                  <c:v>3.2544378698224921E-2</c:v>
                </c:pt>
                <c:pt idx="17">
                  <c:v>2.2189349112426017E-2</c:v>
                </c:pt>
                <c:pt idx="18">
                  <c:v>3.6982248520710123E-2</c:v>
                </c:pt>
                <c:pt idx="19">
                  <c:v>2.2189349112426017E-2</c:v>
                </c:pt>
                <c:pt idx="20">
                  <c:v>1.6272189349112415E-2</c:v>
                </c:pt>
                <c:pt idx="21">
                  <c:v>1.3313609467455604E-2</c:v>
                </c:pt>
                <c:pt idx="22">
                  <c:v>4.4378698224852116E-3</c:v>
                </c:pt>
                <c:pt idx="23">
                  <c:v>0</c:v>
                </c:pt>
                <c:pt idx="24">
                  <c:v>5.9171597633136119E-3</c:v>
                </c:pt>
                <c:pt idx="25">
                  <c:v>5.9171597633136119E-3</c:v>
                </c:pt>
                <c:pt idx="26">
                  <c:v>5.9171597633136119E-3</c:v>
                </c:pt>
                <c:pt idx="27">
                  <c:v>4.4378698224852116E-3</c:v>
                </c:pt>
                <c:pt idx="28">
                  <c:v>1.4792899408284004E-3</c:v>
                </c:pt>
                <c:pt idx="29">
                  <c:v>2.9585798816568008E-3</c:v>
                </c:pt>
                <c:pt idx="30">
                  <c:v>0</c:v>
                </c:pt>
              </c:numCache>
            </c:numRef>
          </c:val>
        </c:ser>
        <c:ser>
          <c:idx val="19"/>
          <c:order val="19"/>
          <c:tx>
            <c:strRef>
              <c:f>'cat-2(CB1112)_A1_0.02_50%'!$U$104</c:f>
              <c:strCache>
                <c:ptCount val="1"/>
                <c:pt idx="0">
                  <c:v>cat-2(CB1112)_A1_20</c:v>
                </c:pt>
              </c:strCache>
            </c:strRef>
          </c:tx>
          <c:marker>
            <c:symbol val="none"/>
          </c:marker>
          <c:cat>
            <c:numRef>
              <c:f>'cat-2(CB1112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2(CB1112)_A1_0.02_50%'!$U$105:$U$135</c:f>
              <c:numCache>
                <c:formatCode>General</c:formatCode>
                <c:ptCount val="31"/>
                <c:pt idx="1">
                  <c:v>5.4166666666666717E-2</c:v>
                </c:pt>
                <c:pt idx="2">
                  <c:v>5.6944444444444402E-2</c:v>
                </c:pt>
                <c:pt idx="3">
                  <c:v>8.6111111111111041E-2</c:v>
                </c:pt>
                <c:pt idx="4">
                  <c:v>8.1944444444444431E-2</c:v>
                </c:pt>
                <c:pt idx="5">
                  <c:v>6.9444444444444434E-2</c:v>
                </c:pt>
                <c:pt idx="6">
                  <c:v>5.555555555555558E-2</c:v>
                </c:pt>
                <c:pt idx="7">
                  <c:v>7.0833333333333331E-2</c:v>
                </c:pt>
                <c:pt idx="8">
                  <c:v>7.0833333333333331E-2</c:v>
                </c:pt>
                <c:pt idx="9">
                  <c:v>3.7500000000000006E-2</c:v>
                </c:pt>
                <c:pt idx="10">
                  <c:v>5.4166666666666717E-2</c:v>
                </c:pt>
                <c:pt idx="11">
                  <c:v>3.6111111111111115E-2</c:v>
                </c:pt>
                <c:pt idx="12">
                  <c:v>4.1666666666666699E-2</c:v>
                </c:pt>
                <c:pt idx="13">
                  <c:v>2.7777777777777821E-2</c:v>
                </c:pt>
                <c:pt idx="14">
                  <c:v>2.9166666666666691E-2</c:v>
                </c:pt>
                <c:pt idx="15">
                  <c:v>3.19444444444444E-2</c:v>
                </c:pt>
                <c:pt idx="16">
                  <c:v>3.19444444444444E-2</c:v>
                </c:pt>
                <c:pt idx="17">
                  <c:v>2.2222222222222202E-2</c:v>
                </c:pt>
                <c:pt idx="18">
                  <c:v>1.9444444444444403E-2</c:v>
                </c:pt>
                <c:pt idx="19">
                  <c:v>2.2222222222222202E-2</c:v>
                </c:pt>
                <c:pt idx="20">
                  <c:v>1.3888888888888907E-2</c:v>
                </c:pt>
                <c:pt idx="21">
                  <c:v>6.9444444444444432E-3</c:v>
                </c:pt>
                <c:pt idx="22">
                  <c:v>4.1666666666666701E-3</c:v>
                </c:pt>
                <c:pt idx="23">
                  <c:v>4.1666666666666701E-3</c:v>
                </c:pt>
                <c:pt idx="24">
                  <c:v>4.1666666666666701E-3</c:v>
                </c:pt>
                <c:pt idx="25">
                  <c:v>6.9444444444444432E-3</c:v>
                </c:pt>
                <c:pt idx="26">
                  <c:v>0</c:v>
                </c:pt>
                <c:pt idx="27">
                  <c:v>4.1666666666666701E-3</c:v>
                </c:pt>
                <c:pt idx="28">
                  <c:v>4.1666666666666701E-3</c:v>
                </c:pt>
                <c:pt idx="29">
                  <c:v>2.7777777777777827E-3</c:v>
                </c:pt>
                <c:pt idx="30">
                  <c:v>0</c:v>
                </c:pt>
              </c:numCache>
            </c:numRef>
          </c:val>
        </c:ser>
        <c:marker val="1"/>
        <c:axId val="168380288"/>
        <c:axId val="168381824"/>
      </c:lineChart>
      <c:catAx>
        <c:axId val="168380288"/>
        <c:scaling>
          <c:orientation val="minMax"/>
        </c:scaling>
        <c:axPos val="b"/>
        <c:numFmt formatCode="0.0_ " sourceLinked="1"/>
        <c:tickLblPos val="nextTo"/>
        <c:crossAx val="168381824"/>
        <c:crosses val="autoZero"/>
        <c:auto val="1"/>
        <c:lblAlgn val="ctr"/>
        <c:lblOffset val="100"/>
        <c:tickLblSkip val="5"/>
        <c:tickMarkSkip val="5"/>
      </c:catAx>
      <c:valAx>
        <c:axId val="168381824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8380288"/>
        <c:crosses val="autoZero"/>
        <c:crossBetween val="between"/>
      </c:valAx>
    </c:plotArea>
    <c:plotVisOnly val="1"/>
  </c:chart>
  <c:externalData r:id="rId1"/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cat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5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cat-1(CB1111)_A5_0.02_50%'!$B$104</c:f>
              <c:strCache>
                <c:ptCount val="1"/>
                <c:pt idx="0">
                  <c:v>cat-1(CB1111)_A5_01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B$105:$B$135</c:f>
              <c:numCache>
                <c:formatCode>General</c:formatCode>
                <c:ptCount val="31"/>
              </c:numCache>
            </c:numRef>
          </c:val>
        </c:ser>
        <c:ser>
          <c:idx val="1"/>
          <c:order val="1"/>
          <c:tx>
            <c:strRef>
              <c:f>'cat-1(CB1111)_A5_0.02_50%'!$C$104</c:f>
              <c:strCache>
                <c:ptCount val="1"/>
                <c:pt idx="0">
                  <c:v>cat-1(CB1111)_A5_02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C$105:$C$135</c:f>
              <c:numCache>
                <c:formatCode>General</c:formatCode>
                <c:ptCount val="31"/>
                <c:pt idx="1">
                  <c:v>5.1282051282051301E-2</c:v>
                </c:pt>
                <c:pt idx="2">
                  <c:v>8.9743589743589702E-2</c:v>
                </c:pt>
                <c:pt idx="3">
                  <c:v>2.5641025641025609E-2</c:v>
                </c:pt>
                <c:pt idx="4">
                  <c:v>5.1282051282051301E-2</c:v>
                </c:pt>
                <c:pt idx="5">
                  <c:v>2.5641025641025609E-2</c:v>
                </c:pt>
                <c:pt idx="6">
                  <c:v>3.8461538461538498E-2</c:v>
                </c:pt>
                <c:pt idx="7">
                  <c:v>1.2820512820512801E-2</c:v>
                </c:pt>
                <c:pt idx="8">
                  <c:v>0</c:v>
                </c:pt>
                <c:pt idx="9">
                  <c:v>1.2820512820512801E-2</c:v>
                </c:pt>
                <c:pt idx="10">
                  <c:v>3.8461538461538498E-2</c:v>
                </c:pt>
                <c:pt idx="11">
                  <c:v>2.5641025641025609E-2</c:v>
                </c:pt>
                <c:pt idx="12">
                  <c:v>1.2820512820512801E-2</c:v>
                </c:pt>
                <c:pt idx="13">
                  <c:v>1.2820512820512801E-2</c:v>
                </c:pt>
                <c:pt idx="14">
                  <c:v>3.8461538461538498E-2</c:v>
                </c:pt>
                <c:pt idx="15">
                  <c:v>6.4102564102564111E-2</c:v>
                </c:pt>
                <c:pt idx="16">
                  <c:v>3.8461538461538498E-2</c:v>
                </c:pt>
                <c:pt idx="17">
                  <c:v>2.5641025641025609E-2</c:v>
                </c:pt>
                <c:pt idx="18">
                  <c:v>1.2820512820512801E-2</c:v>
                </c:pt>
                <c:pt idx="19">
                  <c:v>2.5641025641025609E-2</c:v>
                </c:pt>
                <c:pt idx="20">
                  <c:v>1.2820512820512801E-2</c:v>
                </c:pt>
                <c:pt idx="21">
                  <c:v>0</c:v>
                </c:pt>
                <c:pt idx="22">
                  <c:v>1.2820512820512801E-2</c:v>
                </c:pt>
                <c:pt idx="23">
                  <c:v>1.2820512820512801E-2</c:v>
                </c:pt>
                <c:pt idx="24">
                  <c:v>0</c:v>
                </c:pt>
                <c:pt idx="25">
                  <c:v>1.2820512820512801E-2</c:v>
                </c:pt>
                <c:pt idx="26">
                  <c:v>0</c:v>
                </c:pt>
                <c:pt idx="27">
                  <c:v>2.5641025641025609E-2</c:v>
                </c:pt>
                <c:pt idx="28">
                  <c:v>2.5641025641025609E-2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cat-1(CB1111)_A5_0.02_50%'!$D$104</c:f>
              <c:strCache>
                <c:ptCount val="1"/>
                <c:pt idx="0">
                  <c:v>cat-1(CB1111)_A5_03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D$105:$D$135</c:f>
              <c:numCache>
                <c:formatCode>General</c:formatCode>
                <c:ptCount val="31"/>
                <c:pt idx="1">
                  <c:v>2.8301886792452793E-2</c:v>
                </c:pt>
                <c:pt idx="2">
                  <c:v>1.2578616352201295E-2</c:v>
                </c:pt>
                <c:pt idx="3">
                  <c:v>4.40251572327044E-2</c:v>
                </c:pt>
                <c:pt idx="4">
                  <c:v>4.08805031446541E-2</c:v>
                </c:pt>
                <c:pt idx="5">
                  <c:v>2.515723270440251E-2</c:v>
                </c:pt>
                <c:pt idx="6">
                  <c:v>2.8301886792452793E-2</c:v>
                </c:pt>
                <c:pt idx="7">
                  <c:v>1.88679245283019E-2</c:v>
                </c:pt>
                <c:pt idx="8">
                  <c:v>1.57232704402516E-2</c:v>
                </c:pt>
                <c:pt idx="9">
                  <c:v>1.88679245283019E-2</c:v>
                </c:pt>
                <c:pt idx="10">
                  <c:v>2.2012578616352207E-2</c:v>
                </c:pt>
                <c:pt idx="11">
                  <c:v>2.8301886792452793E-2</c:v>
                </c:pt>
                <c:pt idx="12">
                  <c:v>5.0314465408804999E-2</c:v>
                </c:pt>
                <c:pt idx="13">
                  <c:v>6.6037735849056631E-2</c:v>
                </c:pt>
                <c:pt idx="14">
                  <c:v>0.10062893081761003</c:v>
                </c:pt>
                <c:pt idx="15">
                  <c:v>9.7484276729559782E-2</c:v>
                </c:pt>
                <c:pt idx="16">
                  <c:v>0.110062893081761</c:v>
                </c:pt>
                <c:pt idx="17">
                  <c:v>6.6037735849056631E-2</c:v>
                </c:pt>
                <c:pt idx="18">
                  <c:v>5.0314465408804999E-2</c:v>
                </c:pt>
                <c:pt idx="19">
                  <c:v>4.40251572327044E-2</c:v>
                </c:pt>
                <c:pt idx="20">
                  <c:v>3.4591194968553514E-2</c:v>
                </c:pt>
                <c:pt idx="21">
                  <c:v>1.88679245283019E-2</c:v>
                </c:pt>
                <c:pt idx="22">
                  <c:v>1.57232704402516E-2</c:v>
                </c:pt>
                <c:pt idx="23">
                  <c:v>0</c:v>
                </c:pt>
                <c:pt idx="24">
                  <c:v>1.2578616352201295E-2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cat-1(CB1111)_A5_0.02_50%'!$E$104</c:f>
              <c:strCache>
                <c:ptCount val="1"/>
                <c:pt idx="0">
                  <c:v>cat-1(CB1111)_A5_04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E$105:$E$135</c:f>
              <c:numCache>
                <c:formatCode>General</c:formatCode>
                <c:ptCount val="31"/>
                <c:pt idx="1">
                  <c:v>8.4432717678100233E-2</c:v>
                </c:pt>
                <c:pt idx="2">
                  <c:v>9.762532981530346E-2</c:v>
                </c:pt>
                <c:pt idx="3">
                  <c:v>7.9155672823219031E-2</c:v>
                </c:pt>
                <c:pt idx="4">
                  <c:v>8.1794195250659674E-2</c:v>
                </c:pt>
                <c:pt idx="5">
                  <c:v>0.10026385224274402</c:v>
                </c:pt>
                <c:pt idx="6">
                  <c:v>6.5963060686015804E-2</c:v>
                </c:pt>
                <c:pt idx="7">
                  <c:v>3.9577836411609522E-2</c:v>
                </c:pt>
                <c:pt idx="8">
                  <c:v>5.2770448548812701E-2</c:v>
                </c:pt>
                <c:pt idx="9">
                  <c:v>3.9577836411609522E-2</c:v>
                </c:pt>
                <c:pt idx="10">
                  <c:v>6.0686015831134629E-2</c:v>
                </c:pt>
                <c:pt idx="11">
                  <c:v>3.9577836411609522E-2</c:v>
                </c:pt>
                <c:pt idx="12">
                  <c:v>5.8047493403693903E-2</c:v>
                </c:pt>
                <c:pt idx="13">
                  <c:v>6.332453825857523E-2</c:v>
                </c:pt>
                <c:pt idx="14">
                  <c:v>3.9577836411609522E-2</c:v>
                </c:pt>
                <c:pt idx="15">
                  <c:v>1.0554089709762505E-2</c:v>
                </c:pt>
                <c:pt idx="16">
                  <c:v>1.0554089709762505E-2</c:v>
                </c:pt>
                <c:pt idx="17">
                  <c:v>1.3192612137203198E-2</c:v>
                </c:pt>
                <c:pt idx="18">
                  <c:v>1.0554089709762505E-2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cat-1(CB1111)_A5_0.02_50%'!$F$104</c:f>
              <c:strCache>
                <c:ptCount val="1"/>
                <c:pt idx="0">
                  <c:v>cat-1(CB1111)_A5_05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F$105:$F$135</c:f>
              <c:numCache>
                <c:formatCode>General</c:formatCode>
                <c:ptCount val="31"/>
                <c:pt idx="1">
                  <c:v>2.3880597014925408E-2</c:v>
                </c:pt>
                <c:pt idx="2">
                  <c:v>3.582089552238811E-2</c:v>
                </c:pt>
                <c:pt idx="3">
                  <c:v>2.3880597014925408E-2</c:v>
                </c:pt>
                <c:pt idx="4">
                  <c:v>4.1791044776119397E-2</c:v>
                </c:pt>
                <c:pt idx="5">
                  <c:v>2.6865671641791E-2</c:v>
                </c:pt>
                <c:pt idx="6">
                  <c:v>5.6716417910447854E-2</c:v>
                </c:pt>
                <c:pt idx="7">
                  <c:v>4.7761194029850719E-2</c:v>
                </c:pt>
                <c:pt idx="8">
                  <c:v>4.7761194029850719E-2</c:v>
                </c:pt>
                <c:pt idx="9">
                  <c:v>3.582089552238811E-2</c:v>
                </c:pt>
                <c:pt idx="10">
                  <c:v>4.1791044776119397E-2</c:v>
                </c:pt>
                <c:pt idx="11">
                  <c:v>4.47761194029851E-2</c:v>
                </c:pt>
                <c:pt idx="12">
                  <c:v>4.1791044776119397E-2</c:v>
                </c:pt>
                <c:pt idx="13">
                  <c:v>3.2835820895522415E-2</c:v>
                </c:pt>
                <c:pt idx="14">
                  <c:v>4.47761194029851E-2</c:v>
                </c:pt>
                <c:pt idx="15">
                  <c:v>5.0746268656716421E-2</c:v>
                </c:pt>
                <c:pt idx="16">
                  <c:v>5.9701492537313432E-2</c:v>
                </c:pt>
                <c:pt idx="17">
                  <c:v>7.7611940298507501E-2</c:v>
                </c:pt>
                <c:pt idx="18">
                  <c:v>5.0746268656716421E-2</c:v>
                </c:pt>
                <c:pt idx="19">
                  <c:v>5.9701492537313432E-2</c:v>
                </c:pt>
                <c:pt idx="20">
                  <c:v>2.9850746268656699E-2</c:v>
                </c:pt>
                <c:pt idx="21">
                  <c:v>2.6865671641791E-2</c:v>
                </c:pt>
                <c:pt idx="22">
                  <c:v>3.2835820895522415E-2</c:v>
                </c:pt>
                <c:pt idx="23">
                  <c:v>1.7910447761194E-2</c:v>
                </c:pt>
                <c:pt idx="24">
                  <c:v>2.9850746268656699E-3</c:v>
                </c:pt>
                <c:pt idx="25">
                  <c:v>2.9850746268656699E-3</c:v>
                </c:pt>
                <c:pt idx="26">
                  <c:v>5.9701492537313433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cat-1(CB1111)_A5_0.02_50%'!$G$104</c:f>
              <c:strCache>
                <c:ptCount val="1"/>
                <c:pt idx="0">
                  <c:v>cat-1(CB1111)_A5_06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G$105:$G$135</c:f>
              <c:numCache>
                <c:formatCode>General</c:formatCode>
                <c:ptCount val="31"/>
                <c:pt idx="1">
                  <c:v>7.629427792915533E-2</c:v>
                </c:pt>
                <c:pt idx="2">
                  <c:v>9.2643051771117188E-2</c:v>
                </c:pt>
                <c:pt idx="3">
                  <c:v>5.9945504087193499E-2</c:v>
                </c:pt>
                <c:pt idx="4">
                  <c:v>5.4495912806539523E-2</c:v>
                </c:pt>
                <c:pt idx="5">
                  <c:v>5.4495912806539523E-2</c:v>
                </c:pt>
                <c:pt idx="6">
                  <c:v>4.9046321525885631E-2</c:v>
                </c:pt>
                <c:pt idx="7">
                  <c:v>4.3596730245231641E-2</c:v>
                </c:pt>
                <c:pt idx="8">
                  <c:v>3.5422343324250712E-2</c:v>
                </c:pt>
                <c:pt idx="9">
                  <c:v>2.7247956403269817E-2</c:v>
                </c:pt>
                <c:pt idx="10">
                  <c:v>5.177111716621248E-2</c:v>
                </c:pt>
                <c:pt idx="11">
                  <c:v>5.4495912806539523E-2</c:v>
                </c:pt>
                <c:pt idx="12">
                  <c:v>7.9019073569482304E-2</c:v>
                </c:pt>
                <c:pt idx="13">
                  <c:v>7.3569482288828314E-2</c:v>
                </c:pt>
                <c:pt idx="14">
                  <c:v>7.3569482288828314E-2</c:v>
                </c:pt>
                <c:pt idx="15">
                  <c:v>4.9046321525885631E-2</c:v>
                </c:pt>
                <c:pt idx="16">
                  <c:v>1.6348773841961903E-2</c:v>
                </c:pt>
                <c:pt idx="17">
                  <c:v>1.08991825613079E-2</c:v>
                </c:pt>
                <c:pt idx="18">
                  <c:v>5.4495912806539534E-3</c:v>
                </c:pt>
                <c:pt idx="19">
                  <c:v>2.7247956403269819E-3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2.7247956403269819E-3</c:v>
                </c:pt>
                <c:pt idx="30">
                  <c:v>2.7247956403269819E-3</c:v>
                </c:pt>
              </c:numCache>
            </c:numRef>
          </c:val>
        </c:ser>
        <c:ser>
          <c:idx val="6"/>
          <c:order val="6"/>
          <c:tx>
            <c:strRef>
              <c:f>'cat-1(CB1111)_A5_0.02_50%'!$H$104</c:f>
              <c:strCache>
                <c:ptCount val="1"/>
                <c:pt idx="0">
                  <c:v>cat-1(CB1111)_A5_07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H$105:$H$135</c:f>
              <c:numCache>
                <c:formatCode>General</c:formatCode>
                <c:ptCount val="31"/>
              </c:numCache>
            </c:numRef>
          </c:val>
        </c:ser>
        <c:ser>
          <c:idx val="7"/>
          <c:order val="7"/>
          <c:tx>
            <c:strRef>
              <c:f>'cat-1(CB1111)_A5_0.02_50%'!$I$104</c:f>
              <c:strCache>
                <c:ptCount val="1"/>
                <c:pt idx="0">
                  <c:v>cat-1(CB1111)_A5_08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I$105:$I$135</c:f>
              <c:numCache>
                <c:formatCode>General</c:formatCode>
                <c:ptCount val="31"/>
                <c:pt idx="1">
                  <c:v>8.1632653061224497E-2</c:v>
                </c:pt>
                <c:pt idx="2">
                  <c:v>6.1224489795918401E-2</c:v>
                </c:pt>
                <c:pt idx="3">
                  <c:v>7.4829931972789129E-2</c:v>
                </c:pt>
                <c:pt idx="4">
                  <c:v>0.102040816326531</c:v>
                </c:pt>
                <c:pt idx="5">
                  <c:v>2.7210884353741489E-2</c:v>
                </c:pt>
                <c:pt idx="6">
                  <c:v>4.0816326530612221E-2</c:v>
                </c:pt>
                <c:pt idx="7">
                  <c:v>2.0408163265306107E-2</c:v>
                </c:pt>
                <c:pt idx="8">
                  <c:v>5.4421768707482977E-2</c:v>
                </c:pt>
                <c:pt idx="9">
                  <c:v>4.7619047619047616E-2</c:v>
                </c:pt>
                <c:pt idx="10">
                  <c:v>3.4013605442176915E-2</c:v>
                </c:pt>
                <c:pt idx="11">
                  <c:v>6.1224489795918401E-2</c:v>
                </c:pt>
                <c:pt idx="12">
                  <c:v>2.0408163265306107E-2</c:v>
                </c:pt>
                <c:pt idx="13">
                  <c:v>4.7619047619047616E-2</c:v>
                </c:pt>
                <c:pt idx="14">
                  <c:v>2.0408163265306107E-2</c:v>
                </c:pt>
                <c:pt idx="15">
                  <c:v>2.7210884353741489E-2</c:v>
                </c:pt>
                <c:pt idx="16">
                  <c:v>3.4013605442176915E-2</c:v>
                </c:pt>
                <c:pt idx="17">
                  <c:v>2.7210884353741489E-2</c:v>
                </c:pt>
                <c:pt idx="18">
                  <c:v>2.0408163265306107E-2</c:v>
                </c:pt>
                <c:pt idx="19">
                  <c:v>6.8027210884353722E-3</c:v>
                </c:pt>
                <c:pt idx="20">
                  <c:v>1.3605442176870696E-2</c:v>
                </c:pt>
                <c:pt idx="21">
                  <c:v>0</c:v>
                </c:pt>
                <c:pt idx="22">
                  <c:v>1.3605442176870696E-2</c:v>
                </c:pt>
                <c:pt idx="23">
                  <c:v>6.8027210884353722E-3</c:v>
                </c:pt>
                <c:pt idx="24">
                  <c:v>6.8027210884353722E-3</c:v>
                </c:pt>
                <c:pt idx="25">
                  <c:v>6.8027210884353722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8"/>
          <c:order val="8"/>
          <c:tx>
            <c:strRef>
              <c:f>'cat-1(CB1111)_A5_0.02_50%'!$J$104</c:f>
              <c:strCache>
                <c:ptCount val="1"/>
                <c:pt idx="0">
                  <c:v>cat-1(CB1111)_A5_10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J$105:$J$135</c:f>
              <c:numCache>
                <c:formatCode>General</c:formatCode>
                <c:ptCount val="31"/>
                <c:pt idx="1">
                  <c:v>4.065040650406497E-2</c:v>
                </c:pt>
                <c:pt idx="2">
                  <c:v>2.4390243902439001E-2</c:v>
                </c:pt>
                <c:pt idx="3">
                  <c:v>1.21951219512195E-2</c:v>
                </c:pt>
                <c:pt idx="4">
                  <c:v>1.21951219512195E-2</c:v>
                </c:pt>
                <c:pt idx="5">
                  <c:v>1.21951219512195E-2</c:v>
                </c:pt>
                <c:pt idx="6">
                  <c:v>1.21951219512195E-2</c:v>
                </c:pt>
                <c:pt idx="7">
                  <c:v>8.1300813008130107E-3</c:v>
                </c:pt>
                <c:pt idx="8">
                  <c:v>1.21951219512195E-2</c:v>
                </c:pt>
                <c:pt idx="9">
                  <c:v>8.1300813008130107E-3</c:v>
                </c:pt>
                <c:pt idx="10">
                  <c:v>2.4390243902439001E-2</c:v>
                </c:pt>
                <c:pt idx="11">
                  <c:v>1.6260162601626001E-2</c:v>
                </c:pt>
                <c:pt idx="12">
                  <c:v>4.4715447154471531E-2</c:v>
                </c:pt>
                <c:pt idx="13">
                  <c:v>1.6260162601626001E-2</c:v>
                </c:pt>
                <c:pt idx="14">
                  <c:v>5.2845528455284584E-2</c:v>
                </c:pt>
                <c:pt idx="15">
                  <c:v>9.3495934959349644E-2</c:v>
                </c:pt>
                <c:pt idx="16">
                  <c:v>0.12195121951219498</c:v>
                </c:pt>
                <c:pt idx="17">
                  <c:v>0.12601626016260206</c:v>
                </c:pt>
                <c:pt idx="18">
                  <c:v>0.10162601626016303</c:v>
                </c:pt>
                <c:pt idx="19">
                  <c:v>8.9430894308943132E-2</c:v>
                </c:pt>
                <c:pt idx="20">
                  <c:v>6.910569105691064E-2</c:v>
                </c:pt>
                <c:pt idx="21">
                  <c:v>4.065040650406497E-2</c:v>
                </c:pt>
                <c:pt idx="22">
                  <c:v>1.6260162601626001E-2</c:v>
                </c:pt>
                <c:pt idx="23">
                  <c:v>4.0650406504065002E-3</c:v>
                </c:pt>
                <c:pt idx="24">
                  <c:v>0</c:v>
                </c:pt>
                <c:pt idx="25">
                  <c:v>0</c:v>
                </c:pt>
                <c:pt idx="26">
                  <c:v>4.0650406504065002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cat-1(CB1111)_A5_0.02_50%'!$K$104</c:f>
              <c:strCache>
                <c:ptCount val="1"/>
                <c:pt idx="0">
                  <c:v>cat-1(CB1111)_A5_11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K$105:$K$135</c:f>
              <c:numCache>
                <c:formatCode>General</c:formatCode>
                <c:ptCount val="31"/>
                <c:pt idx="1">
                  <c:v>3.3962264150943403E-2</c:v>
                </c:pt>
                <c:pt idx="2">
                  <c:v>1.5094339622641499E-2</c:v>
                </c:pt>
                <c:pt idx="3">
                  <c:v>1.1320754716981109E-2</c:v>
                </c:pt>
                <c:pt idx="4">
                  <c:v>3.7735849056603821E-2</c:v>
                </c:pt>
                <c:pt idx="5">
                  <c:v>2.6415094339622597E-2</c:v>
                </c:pt>
                <c:pt idx="6">
                  <c:v>1.88679245283019E-2</c:v>
                </c:pt>
                <c:pt idx="7">
                  <c:v>3.7735849056603826E-3</c:v>
                </c:pt>
                <c:pt idx="8">
                  <c:v>1.88679245283019E-2</c:v>
                </c:pt>
                <c:pt idx="9">
                  <c:v>1.5094339622641499E-2</c:v>
                </c:pt>
                <c:pt idx="10">
                  <c:v>0</c:v>
                </c:pt>
                <c:pt idx="11">
                  <c:v>2.2641509433962315E-2</c:v>
                </c:pt>
                <c:pt idx="12">
                  <c:v>1.1320754716981109E-2</c:v>
                </c:pt>
                <c:pt idx="13">
                  <c:v>3.7735849056603821E-2</c:v>
                </c:pt>
                <c:pt idx="14">
                  <c:v>8.3018867924528297E-2</c:v>
                </c:pt>
                <c:pt idx="15">
                  <c:v>7.5471698113207503E-2</c:v>
                </c:pt>
                <c:pt idx="16">
                  <c:v>9.0566037735849175E-2</c:v>
                </c:pt>
                <c:pt idx="17">
                  <c:v>0.135849056603774</c:v>
                </c:pt>
                <c:pt idx="18">
                  <c:v>0.12075471698113205</c:v>
                </c:pt>
                <c:pt idx="19">
                  <c:v>6.4150943396226429E-2</c:v>
                </c:pt>
                <c:pt idx="20">
                  <c:v>4.1509433962264086E-2</c:v>
                </c:pt>
                <c:pt idx="21">
                  <c:v>4.9056603773584902E-2</c:v>
                </c:pt>
                <c:pt idx="22">
                  <c:v>2.6415094339622597E-2</c:v>
                </c:pt>
                <c:pt idx="23">
                  <c:v>1.88679245283019E-2</c:v>
                </c:pt>
                <c:pt idx="24">
                  <c:v>0</c:v>
                </c:pt>
                <c:pt idx="25">
                  <c:v>3.7735849056603826E-3</c:v>
                </c:pt>
                <c:pt idx="26">
                  <c:v>7.5471698113207504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cat-1(CB1111)_A5_0.02_50%'!$L$104</c:f>
              <c:strCache>
                <c:ptCount val="1"/>
                <c:pt idx="0">
                  <c:v>cat-1(CB1111)_A5_12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L$105:$L$135</c:f>
              <c:numCache>
                <c:formatCode>General</c:formatCode>
                <c:ptCount val="31"/>
                <c:pt idx="1">
                  <c:v>4.2168674698795219E-2</c:v>
                </c:pt>
                <c:pt idx="2">
                  <c:v>3.3132530120481903E-2</c:v>
                </c:pt>
                <c:pt idx="3">
                  <c:v>6.9277108433734899E-2</c:v>
                </c:pt>
                <c:pt idx="4">
                  <c:v>4.5180722891566313E-2</c:v>
                </c:pt>
                <c:pt idx="5">
                  <c:v>3.3132530120481903E-2</c:v>
                </c:pt>
                <c:pt idx="6">
                  <c:v>3.0120481927710791E-2</c:v>
                </c:pt>
                <c:pt idx="7">
                  <c:v>3.0120481927710791E-2</c:v>
                </c:pt>
                <c:pt idx="8">
                  <c:v>3.3132530120481903E-2</c:v>
                </c:pt>
                <c:pt idx="9">
                  <c:v>1.8072289156626498E-2</c:v>
                </c:pt>
                <c:pt idx="10">
                  <c:v>6.0240963855421733E-3</c:v>
                </c:pt>
                <c:pt idx="11">
                  <c:v>3.0120481927710791E-2</c:v>
                </c:pt>
                <c:pt idx="12">
                  <c:v>1.8072289156626498E-2</c:v>
                </c:pt>
                <c:pt idx="13">
                  <c:v>4.8192771084337421E-2</c:v>
                </c:pt>
                <c:pt idx="14">
                  <c:v>7.8313253012048237E-2</c:v>
                </c:pt>
                <c:pt idx="15">
                  <c:v>5.1204819277108383E-2</c:v>
                </c:pt>
                <c:pt idx="16">
                  <c:v>5.4216867469879498E-2</c:v>
                </c:pt>
                <c:pt idx="17">
                  <c:v>4.5180722891566313E-2</c:v>
                </c:pt>
                <c:pt idx="18">
                  <c:v>4.8192771084337421E-2</c:v>
                </c:pt>
                <c:pt idx="19">
                  <c:v>4.5180722891566313E-2</c:v>
                </c:pt>
                <c:pt idx="20">
                  <c:v>3.6144578313252997E-2</c:v>
                </c:pt>
                <c:pt idx="21">
                  <c:v>3.3132530120481903E-2</c:v>
                </c:pt>
                <c:pt idx="22">
                  <c:v>1.8072289156626498E-2</c:v>
                </c:pt>
                <c:pt idx="23">
                  <c:v>3.9156626506024098E-2</c:v>
                </c:pt>
                <c:pt idx="24">
                  <c:v>1.5060240963855399E-2</c:v>
                </c:pt>
                <c:pt idx="25">
                  <c:v>6.0240963855421733E-3</c:v>
                </c:pt>
                <c:pt idx="26">
                  <c:v>6.0240963855421733E-3</c:v>
                </c:pt>
                <c:pt idx="27">
                  <c:v>3.0120481927710797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cat-1(CB1111)_A5_0.02_50%'!$M$104</c:f>
              <c:strCache>
                <c:ptCount val="1"/>
                <c:pt idx="0">
                  <c:v>cat-1(CB1111)_A5_13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M$105:$M$135</c:f>
              <c:numCache>
                <c:formatCode>General</c:formatCode>
                <c:ptCount val="31"/>
                <c:pt idx="1">
                  <c:v>0.12307692307692306</c:v>
                </c:pt>
                <c:pt idx="2">
                  <c:v>1.5384615384615405E-2</c:v>
                </c:pt>
                <c:pt idx="3">
                  <c:v>1.5384615384615405E-2</c:v>
                </c:pt>
                <c:pt idx="4">
                  <c:v>4.6153846153846198E-2</c:v>
                </c:pt>
                <c:pt idx="5">
                  <c:v>1.5384615384615405E-2</c:v>
                </c:pt>
                <c:pt idx="6">
                  <c:v>1.5384615384615405E-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3.0769230769230802E-2</c:v>
                </c:pt>
                <c:pt idx="13">
                  <c:v>0</c:v>
                </c:pt>
                <c:pt idx="14">
                  <c:v>4.6153846153846198E-2</c:v>
                </c:pt>
                <c:pt idx="15">
                  <c:v>7.6923076923076913E-2</c:v>
                </c:pt>
                <c:pt idx="16">
                  <c:v>0.10769230769230798</c:v>
                </c:pt>
                <c:pt idx="17">
                  <c:v>0.10769230769230798</c:v>
                </c:pt>
                <c:pt idx="18">
                  <c:v>6.1538461538461514E-2</c:v>
                </c:pt>
                <c:pt idx="19">
                  <c:v>7.6923076923076913E-2</c:v>
                </c:pt>
                <c:pt idx="20">
                  <c:v>7.6923076923076913E-2</c:v>
                </c:pt>
                <c:pt idx="21">
                  <c:v>1.5384615384615405E-2</c:v>
                </c:pt>
                <c:pt idx="22">
                  <c:v>0</c:v>
                </c:pt>
                <c:pt idx="23">
                  <c:v>1.5384615384615405E-2</c:v>
                </c:pt>
                <c:pt idx="24">
                  <c:v>0</c:v>
                </c:pt>
                <c:pt idx="25">
                  <c:v>1.5384615384615405E-2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cat-1(CB1111)_A5_0.02_50%'!$N$104</c:f>
              <c:strCache>
                <c:ptCount val="1"/>
                <c:pt idx="0">
                  <c:v>cat-1(CB1111)_A5_14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N$105:$N$135</c:f>
              <c:numCache>
                <c:formatCode>General</c:formatCode>
                <c:ptCount val="31"/>
                <c:pt idx="1">
                  <c:v>2.0000000000000007E-2</c:v>
                </c:pt>
                <c:pt idx="2">
                  <c:v>3.0000000000000002E-2</c:v>
                </c:pt>
                <c:pt idx="3">
                  <c:v>2.0000000000000007E-2</c:v>
                </c:pt>
                <c:pt idx="4">
                  <c:v>2.0000000000000007E-2</c:v>
                </c:pt>
                <c:pt idx="5">
                  <c:v>5.0000000000000018E-3</c:v>
                </c:pt>
                <c:pt idx="6">
                  <c:v>2.5000000000000001E-2</c:v>
                </c:pt>
                <c:pt idx="7">
                  <c:v>5.0000000000000018E-3</c:v>
                </c:pt>
                <c:pt idx="8">
                  <c:v>2.5000000000000001E-2</c:v>
                </c:pt>
                <c:pt idx="9">
                  <c:v>2.5000000000000001E-2</c:v>
                </c:pt>
                <c:pt idx="10">
                  <c:v>3.0000000000000002E-2</c:v>
                </c:pt>
                <c:pt idx="11">
                  <c:v>2.0000000000000007E-2</c:v>
                </c:pt>
                <c:pt idx="12">
                  <c:v>5.5000000000000014E-2</c:v>
                </c:pt>
                <c:pt idx="13">
                  <c:v>4.5000000000000012E-2</c:v>
                </c:pt>
                <c:pt idx="14">
                  <c:v>6.0000000000000019E-2</c:v>
                </c:pt>
                <c:pt idx="15">
                  <c:v>4.5000000000000012E-2</c:v>
                </c:pt>
                <c:pt idx="16">
                  <c:v>0.1</c:v>
                </c:pt>
                <c:pt idx="17">
                  <c:v>0.1</c:v>
                </c:pt>
                <c:pt idx="18">
                  <c:v>0.1</c:v>
                </c:pt>
                <c:pt idx="19">
                  <c:v>6.0000000000000019E-2</c:v>
                </c:pt>
                <c:pt idx="20">
                  <c:v>4.5000000000000012E-2</c:v>
                </c:pt>
                <c:pt idx="21">
                  <c:v>2.0000000000000007E-2</c:v>
                </c:pt>
                <c:pt idx="22">
                  <c:v>1.4999999999999998E-2</c:v>
                </c:pt>
                <c:pt idx="23">
                  <c:v>1.0000000000000004E-2</c:v>
                </c:pt>
                <c:pt idx="24">
                  <c:v>2.0000000000000007E-2</c:v>
                </c:pt>
                <c:pt idx="25">
                  <c:v>5.0000000000000018E-3</c:v>
                </c:pt>
                <c:pt idx="26">
                  <c:v>1.0000000000000004E-2</c:v>
                </c:pt>
                <c:pt idx="27">
                  <c:v>1.0000000000000004E-2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cat-1(CB1111)_A5_0.02_50%'!$O$104</c:f>
              <c:strCache>
                <c:ptCount val="1"/>
                <c:pt idx="0">
                  <c:v>cat-1(CB1111)_A5_15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O$105:$O$135</c:f>
              <c:numCache>
                <c:formatCode>General</c:formatCode>
                <c:ptCount val="31"/>
                <c:pt idx="1">
                  <c:v>2.824858757062151E-2</c:v>
                </c:pt>
                <c:pt idx="2">
                  <c:v>1.12994350282486E-2</c:v>
                </c:pt>
                <c:pt idx="3">
                  <c:v>5.6497175141242903E-3</c:v>
                </c:pt>
                <c:pt idx="4">
                  <c:v>5.6497175141242903E-3</c:v>
                </c:pt>
                <c:pt idx="5">
                  <c:v>1.6949152542372906E-2</c:v>
                </c:pt>
                <c:pt idx="6">
                  <c:v>0</c:v>
                </c:pt>
                <c:pt idx="7">
                  <c:v>5.6497175141242903E-3</c:v>
                </c:pt>
                <c:pt idx="8">
                  <c:v>1.6949152542372906E-2</c:v>
                </c:pt>
                <c:pt idx="9">
                  <c:v>0</c:v>
                </c:pt>
                <c:pt idx="10">
                  <c:v>0</c:v>
                </c:pt>
                <c:pt idx="11">
                  <c:v>1.12994350282486E-2</c:v>
                </c:pt>
                <c:pt idx="12">
                  <c:v>1.12994350282486E-2</c:v>
                </c:pt>
                <c:pt idx="13">
                  <c:v>2.2598870056497199E-2</c:v>
                </c:pt>
                <c:pt idx="14">
                  <c:v>4.5197740112994399E-2</c:v>
                </c:pt>
                <c:pt idx="15">
                  <c:v>0.12429378531073405</c:v>
                </c:pt>
                <c:pt idx="16">
                  <c:v>0.129943502824859</c:v>
                </c:pt>
                <c:pt idx="17">
                  <c:v>0.10734463276836199</c:v>
                </c:pt>
                <c:pt idx="18">
                  <c:v>3.3898305084745811E-2</c:v>
                </c:pt>
                <c:pt idx="19">
                  <c:v>7.3446327683615809E-2</c:v>
                </c:pt>
                <c:pt idx="20">
                  <c:v>0.11299435028248603</c:v>
                </c:pt>
                <c:pt idx="21">
                  <c:v>9.6045197740112997E-2</c:v>
                </c:pt>
                <c:pt idx="22">
                  <c:v>5.084745762711862E-2</c:v>
                </c:pt>
                <c:pt idx="23">
                  <c:v>3.3898305084745811E-2</c:v>
                </c:pt>
                <c:pt idx="24">
                  <c:v>1.12994350282486E-2</c:v>
                </c:pt>
                <c:pt idx="25">
                  <c:v>1.6949152542372906E-2</c:v>
                </c:pt>
                <c:pt idx="26">
                  <c:v>0</c:v>
                </c:pt>
                <c:pt idx="27">
                  <c:v>1.12994350282486E-2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4"/>
          <c:order val="14"/>
          <c:tx>
            <c:strRef>
              <c:f>'cat-1(CB1111)_A5_0.02_50%'!$P$104</c:f>
              <c:strCache>
                <c:ptCount val="1"/>
                <c:pt idx="0">
                  <c:v>cat-1(CB1111)_A5_16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P$105:$P$135</c:f>
              <c:numCache>
                <c:formatCode>General</c:formatCode>
                <c:ptCount val="31"/>
                <c:pt idx="1">
                  <c:v>5.1948051948052E-2</c:v>
                </c:pt>
                <c:pt idx="2">
                  <c:v>6.4935064935064901E-2</c:v>
                </c:pt>
                <c:pt idx="3">
                  <c:v>5.1948051948052E-2</c:v>
                </c:pt>
                <c:pt idx="4">
                  <c:v>0</c:v>
                </c:pt>
                <c:pt idx="5">
                  <c:v>1.2987012987013E-2</c:v>
                </c:pt>
                <c:pt idx="6">
                  <c:v>2.5974025974026007E-2</c:v>
                </c:pt>
                <c:pt idx="7">
                  <c:v>1.2987012987013E-2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3.8961038961039002E-2</c:v>
                </c:pt>
                <c:pt idx="12">
                  <c:v>2.5974025974026007E-2</c:v>
                </c:pt>
                <c:pt idx="13">
                  <c:v>1.2987012987013E-2</c:v>
                </c:pt>
                <c:pt idx="14">
                  <c:v>5.1948051948052E-2</c:v>
                </c:pt>
                <c:pt idx="15">
                  <c:v>0</c:v>
                </c:pt>
                <c:pt idx="16">
                  <c:v>2.5974025974026007E-2</c:v>
                </c:pt>
                <c:pt idx="17">
                  <c:v>6.4935064935064901E-2</c:v>
                </c:pt>
                <c:pt idx="18">
                  <c:v>6.4935064935064901E-2</c:v>
                </c:pt>
                <c:pt idx="19">
                  <c:v>7.7922077922077934E-2</c:v>
                </c:pt>
                <c:pt idx="20">
                  <c:v>6.4935064935064901E-2</c:v>
                </c:pt>
                <c:pt idx="21">
                  <c:v>5.1948051948052E-2</c:v>
                </c:pt>
                <c:pt idx="22">
                  <c:v>3.8961038961039002E-2</c:v>
                </c:pt>
                <c:pt idx="23">
                  <c:v>2.5974025974026007E-2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1.2987012987013E-2</c:v>
                </c:pt>
                <c:pt idx="29">
                  <c:v>0</c:v>
                </c:pt>
                <c:pt idx="30">
                  <c:v>1.2987012987013E-2</c:v>
                </c:pt>
              </c:numCache>
            </c:numRef>
          </c:val>
        </c:ser>
        <c:ser>
          <c:idx val="15"/>
          <c:order val="15"/>
          <c:tx>
            <c:strRef>
              <c:f>'cat-1(CB1111)_A5_0.02_50%'!$Q$104</c:f>
              <c:strCache>
                <c:ptCount val="1"/>
                <c:pt idx="0">
                  <c:v>cat-1(CB1111)_A5_17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Q$105:$Q$135</c:f>
              <c:numCache>
                <c:formatCode>General</c:formatCode>
                <c:ptCount val="31"/>
                <c:pt idx="1">
                  <c:v>7.4626865671641798E-2</c:v>
                </c:pt>
                <c:pt idx="2">
                  <c:v>3.7313432835820899E-2</c:v>
                </c:pt>
                <c:pt idx="3">
                  <c:v>6.7164179104477598E-2</c:v>
                </c:pt>
                <c:pt idx="4">
                  <c:v>5.22388059701493E-2</c:v>
                </c:pt>
                <c:pt idx="5">
                  <c:v>3.7313432835820899E-2</c:v>
                </c:pt>
                <c:pt idx="6">
                  <c:v>2.9850746268656699E-2</c:v>
                </c:pt>
                <c:pt idx="7">
                  <c:v>1.4925373134328401E-2</c:v>
                </c:pt>
                <c:pt idx="8">
                  <c:v>2.2388059701492494E-2</c:v>
                </c:pt>
                <c:pt idx="9">
                  <c:v>2.2388059701492494E-2</c:v>
                </c:pt>
                <c:pt idx="10">
                  <c:v>7.4626865671641816E-3</c:v>
                </c:pt>
                <c:pt idx="11">
                  <c:v>2.2388059701492494E-2</c:v>
                </c:pt>
                <c:pt idx="12">
                  <c:v>7.4626865671641816E-3</c:v>
                </c:pt>
                <c:pt idx="13">
                  <c:v>2.2388059701492494E-2</c:v>
                </c:pt>
                <c:pt idx="14">
                  <c:v>1.4925373134328401E-2</c:v>
                </c:pt>
                <c:pt idx="15">
                  <c:v>2.9850746268656699E-2</c:v>
                </c:pt>
                <c:pt idx="16">
                  <c:v>5.22388059701493E-2</c:v>
                </c:pt>
                <c:pt idx="17">
                  <c:v>2.9850746268656699E-2</c:v>
                </c:pt>
                <c:pt idx="18">
                  <c:v>5.22388059701493E-2</c:v>
                </c:pt>
                <c:pt idx="19">
                  <c:v>4.47761194029851E-2</c:v>
                </c:pt>
                <c:pt idx="20">
                  <c:v>5.9701492537313432E-2</c:v>
                </c:pt>
                <c:pt idx="21">
                  <c:v>1.4925373134328401E-2</c:v>
                </c:pt>
                <c:pt idx="22">
                  <c:v>1.4925373134328401E-2</c:v>
                </c:pt>
                <c:pt idx="23">
                  <c:v>7.4626865671641816E-3</c:v>
                </c:pt>
                <c:pt idx="24">
                  <c:v>0</c:v>
                </c:pt>
                <c:pt idx="25">
                  <c:v>2.9850746268656699E-2</c:v>
                </c:pt>
                <c:pt idx="26">
                  <c:v>7.4626865671641816E-3</c:v>
                </c:pt>
                <c:pt idx="27">
                  <c:v>7.4626865671641816E-3</c:v>
                </c:pt>
                <c:pt idx="28">
                  <c:v>7.4626865671641816E-3</c:v>
                </c:pt>
                <c:pt idx="29">
                  <c:v>0</c:v>
                </c:pt>
                <c:pt idx="30">
                  <c:v>1.4925373134328401E-2</c:v>
                </c:pt>
              </c:numCache>
            </c:numRef>
          </c:val>
        </c:ser>
        <c:ser>
          <c:idx val="16"/>
          <c:order val="16"/>
          <c:tx>
            <c:strRef>
              <c:f>'cat-1(CB1111)_A5_0.02_50%'!$R$104</c:f>
              <c:strCache>
                <c:ptCount val="1"/>
                <c:pt idx="0">
                  <c:v>cat-1(CB1111)_A5_18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R$105:$R$135</c:f>
              <c:numCache>
                <c:formatCode>General</c:formatCode>
                <c:ptCount val="31"/>
                <c:pt idx="1">
                  <c:v>5.0179211469534087E-2</c:v>
                </c:pt>
                <c:pt idx="2">
                  <c:v>1.4336917562723992E-2</c:v>
                </c:pt>
                <c:pt idx="3">
                  <c:v>2.8673835125448008E-2</c:v>
                </c:pt>
                <c:pt idx="4">
                  <c:v>3.5842293906810006E-2</c:v>
                </c:pt>
                <c:pt idx="5">
                  <c:v>1.4336917562723992E-2</c:v>
                </c:pt>
                <c:pt idx="6">
                  <c:v>2.5089605734767002E-2</c:v>
                </c:pt>
                <c:pt idx="7">
                  <c:v>3.9426523297490988E-2</c:v>
                </c:pt>
                <c:pt idx="8">
                  <c:v>1.0752688172042998E-2</c:v>
                </c:pt>
                <c:pt idx="9">
                  <c:v>2.1505376344085999E-2</c:v>
                </c:pt>
                <c:pt idx="10">
                  <c:v>3.9426523297490988E-2</c:v>
                </c:pt>
                <c:pt idx="11">
                  <c:v>2.1505376344085999E-2</c:v>
                </c:pt>
                <c:pt idx="12">
                  <c:v>3.9426523297490988E-2</c:v>
                </c:pt>
                <c:pt idx="13">
                  <c:v>5.0179211469534087E-2</c:v>
                </c:pt>
                <c:pt idx="14">
                  <c:v>7.8853046594982101E-2</c:v>
                </c:pt>
                <c:pt idx="15">
                  <c:v>5.3763440860215117E-2</c:v>
                </c:pt>
                <c:pt idx="16">
                  <c:v>7.5268817204301119E-2</c:v>
                </c:pt>
                <c:pt idx="17">
                  <c:v>8.960573476702513E-2</c:v>
                </c:pt>
                <c:pt idx="18">
                  <c:v>7.5268817204301119E-2</c:v>
                </c:pt>
                <c:pt idx="19">
                  <c:v>5.7347670250896134E-2</c:v>
                </c:pt>
                <c:pt idx="20">
                  <c:v>4.3010752688171984E-2</c:v>
                </c:pt>
                <c:pt idx="21">
                  <c:v>2.5089605734767002E-2</c:v>
                </c:pt>
                <c:pt idx="22">
                  <c:v>3.2258064516129011E-2</c:v>
                </c:pt>
                <c:pt idx="23">
                  <c:v>2.1505376344085999E-2</c:v>
                </c:pt>
                <c:pt idx="24">
                  <c:v>0</c:v>
                </c:pt>
                <c:pt idx="25">
                  <c:v>3.584229390681001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cat-1(CB1111)_A5_0.02_50%'!$S$104</c:f>
              <c:strCache>
                <c:ptCount val="1"/>
                <c:pt idx="0">
                  <c:v>cat-1(CB1111)_A5_19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S$105:$S$135</c:f>
              <c:numCache>
                <c:formatCode>General</c:formatCode>
                <c:ptCount val="31"/>
                <c:pt idx="1">
                  <c:v>1.2944983818770201E-2</c:v>
                </c:pt>
                <c:pt idx="2">
                  <c:v>9.7087378640776708E-3</c:v>
                </c:pt>
                <c:pt idx="3">
                  <c:v>2.2653721682847908E-2</c:v>
                </c:pt>
                <c:pt idx="4">
                  <c:v>9.7087378640776708E-3</c:v>
                </c:pt>
                <c:pt idx="5">
                  <c:v>9.7087378640776708E-3</c:v>
                </c:pt>
                <c:pt idx="6">
                  <c:v>6.4724919093851118E-3</c:v>
                </c:pt>
                <c:pt idx="7">
                  <c:v>6.4724919093851118E-3</c:v>
                </c:pt>
                <c:pt idx="8">
                  <c:v>3.2362459546925598E-3</c:v>
                </c:pt>
                <c:pt idx="9">
                  <c:v>6.4724919093851118E-3</c:v>
                </c:pt>
                <c:pt idx="10">
                  <c:v>1.2944983818770201E-2</c:v>
                </c:pt>
                <c:pt idx="11">
                  <c:v>2.5889967637540513E-2</c:v>
                </c:pt>
                <c:pt idx="12">
                  <c:v>4.8543689320388314E-2</c:v>
                </c:pt>
                <c:pt idx="13">
                  <c:v>7.7669902912621422E-2</c:v>
                </c:pt>
                <c:pt idx="14">
                  <c:v>0.12297734627831702</c:v>
                </c:pt>
                <c:pt idx="15">
                  <c:v>0.148867313915858</c:v>
                </c:pt>
                <c:pt idx="16">
                  <c:v>0.103559870550162</c:v>
                </c:pt>
                <c:pt idx="17">
                  <c:v>0.12297734627831702</c:v>
                </c:pt>
                <c:pt idx="18">
                  <c:v>8.7378640776699032E-2</c:v>
                </c:pt>
                <c:pt idx="19">
                  <c:v>4.8543689320388314E-2</c:v>
                </c:pt>
                <c:pt idx="20">
                  <c:v>4.8543689320388314E-2</c:v>
                </c:pt>
                <c:pt idx="21">
                  <c:v>2.2653721682847908E-2</c:v>
                </c:pt>
                <c:pt idx="22">
                  <c:v>9.7087378640776708E-3</c:v>
                </c:pt>
                <c:pt idx="23">
                  <c:v>9.7087378640776708E-3</c:v>
                </c:pt>
                <c:pt idx="24">
                  <c:v>0</c:v>
                </c:pt>
                <c:pt idx="25">
                  <c:v>9.7087378640776708E-3</c:v>
                </c:pt>
                <c:pt idx="26">
                  <c:v>0</c:v>
                </c:pt>
                <c:pt idx="27">
                  <c:v>0</c:v>
                </c:pt>
                <c:pt idx="28">
                  <c:v>3.2362459546925598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8"/>
          <c:order val="18"/>
          <c:tx>
            <c:strRef>
              <c:f>'cat-1(CB1111)_A5_0.02_50%'!$T$104</c:f>
              <c:strCache>
                <c:ptCount val="1"/>
                <c:pt idx="0">
                  <c:v>cat-1(CB1111)_A5_20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T$105:$T$135</c:f>
              <c:numCache>
                <c:formatCode>General</c:formatCode>
                <c:ptCount val="31"/>
                <c:pt idx="1">
                  <c:v>4.7619047619047616E-2</c:v>
                </c:pt>
                <c:pt idx="2">
                  <c:v>2.3809523809523808E-2</c:v>
                </c:pt>
                <c:pt idx="3">
                  <c:v>7.1428571428571411E-2</c:v>
                </c:pt>
                <c:pt idx="4">
                  <c:v>2.3809523809523808E-2</c:v>
                </c:pt>
                <c:pt idx="5">
                  <c:v>9.5238095238095247E-2</c:v>
                </c:pt>
                <c:pt idx="6">
                  <c:v>2.3809523809523808E-2</c:v>
                </c:pt>
                <c:pt idx="7">
                  <c:v>2.3809523809523808E-2</c:v>
                </c:pt>
                <c:pt idx="8">
                  <c:v>0</c:v>
                </c:pt>
                <c:pt idx="9">
                  <c:v>4.7619047619047616E-2</c:v>
                </c:pt>
                <c:pt idx="10">
                  <c:v>4.7619047619047616E-2</c:v>
                </c:pt>
                <c:pt idx="11">
                  <c:v>0</c:v>
                </c:pt>
                <c:pt idx="12">
                  <c:v>0</c:v>
                </c:pt>
                <c:pt idx="13">
                  <c:v>4.7619047619047616E-2</c:v>
                </c:pt>
                <c:pt idx="14">
                  <c:v>2.3809523809523808E-2</c:v>
                </c:pt>
                <c:pt idx="15">
                  <c:v>0</c:v>
                </c:pt>
                <c:pt idx="16">
                  <c:v>4.7619047619047616E-2</c:v>
                </c:pt>
                <c:pt idx="17">
                  <c:v>4.7619047619047616E-2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2.3809523809523808E-2</c:v>
                </c:pt>
                <c:pt idx="22">
                  <c:v>0</c:v>
                </c:pt>
                <c:pt idx="23">
                  <c:v>2.3809523809523808E-2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2.3809523809523808E-2</c:v>
                </c:pt>
                <c:pt idx="30">
                  <c:v>0</c:v>
                </c:pt>
              </c:numCache>
            </c:numRef>
          </c:val>
        </c:ser>
        <c:ser>
          <c:idx val="19"/>
          <c:order val="19"/>
          <c:tx>
            <c:strRef>
              <c:f>'cat-1(CB1111)_A5_0.02_50%'!$U$104</c:f>
              <c:strCache>
                <c:ptCount val="1"/>
                <c:pt idx="0">
                  <c:v>cat-1(CB1111)_A5_21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U$105:$U$135</c:f>
              <c:numCache>
                <c:formatCode>General</c:formatCode>
                <c:ptCount val="31"/>
                <c:pt idx="1">
                  <c:v>0.155555555555556</c:v>
                </c:pt>
                <c:pt idx="2">
                  <c:v>6.6666666666666693E-2</c:v>
                </c:pt>
                <c:pt idx="3">
                  <c:v>3.7037037037037014E-2</c:v>
                </c:pt>
                <c:pt idx="4">
                  <c:v>2.962962962962961E-2</c:v>
                </c:pt>
                <c:pt idx="5">
                  <c:v>1.48148148148148E-2</c:v>
                </c:pt>
                <c:pt idx="6">
                  <c:v>7.4074074074074103E-3</c:v>
                </c:pt>
                <c:pt idx="7">
                  <c:v>2.2222222222222202E-2</c:v>
                </c:pt>
                <c:pt idx="8">
                  <c:v>2.2222222222222202E-2</c:v>
                </c:pt>
                <c:pt idx="9">
                  <c:v>7.4074074074074103E-3</c:v>
                </c:pt>
                <c:pt idx="10">
                  <c:v>1.48148148148148E-2</c:v>
                </c:pt>
                <c:pt idx="11">
                  <c:v>2.2222222222222202E-2</c:v>
                </c:pt>
                <c:pt idx="12">
                  <c:v>2.962962962962961E-2</c:v>
                </c:pt>
                <c:pt idx="13">
                  <c:v>3.7037037037037014E-2</c:v>
                </c:pt>
                <c:pt idx="14">
                  <c:v>7.4074074074074103E-3</c:v>
                </c:pt>
                <c:pt idx="15">
                  <c:v>1.48148148148148E-2</c:v>
                </c:pt>
                <c:pt idx="16">
                  <c:v>2.962962962962961E-2</c:v>
                </c:pt>
                <c:pt idx="17">
                  <c:v>1.48148148148148E-2</c:v>
                </c:pt>
                <c:pt idx="18">
                  <c:v>2.962962962962961E-2</c:v>
                </c:pt>
                <c:pt idx="19">
                  <c:v>1.48148148148148E-2</c:v>
                </c:pt>
                <c:pt idx="20">
                  <c:v>1.48148148148148E-2</c:v>
                </c:pt>
                <c:pt idx="21">
                  <c:v>0</c:v>
                </c:pt>
                <c:pt idx="22">
                  <c:v>0</c:v>
                </c:pt>
                <c:pt idx="23">
                  <c:v>7.4074074074074103E-3</c:v>
                </c:pt>
                <c:pt idx="24">
                  <c:v>7.4074074074074103E-3</c:v>
                </c:pt>
                <c:pt idx="25">
                  <c:v>2.2222222222222202E-2</c:v>
                </c:pt>
                <c:pt idx="26">
                  <c:v>1.48148148148148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0"/>
          <c:order val="20"/>
          <c:tx>
            <c:strRef>
              <c:f>'cat-1(CB1111)_A5_0.02_50%'!$V$104</c:f>
              <c:strCache>
                <c:ptCount val="1"/>
                <c:pt idx="0">
                  <c:v>cat-1(CB1111)_A5_22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V$105:$V$135</c:f>
              <c:numCache>
                <c:formatCode>General</c:formatCode>
                <c:ptCount val="31"/>
                <c:pt idx="1">
                  <c:v>3.8888888888888903E-2</c:v>
                </c:pt>
                <c:pt idx="2">
                  <c:v>3.8888888888888903E-2</c:v>
                </c:pt>
                <c:pt idx="3">
                  <c:v>6.1111111111111102E-2</c:v>
                </c:pt>
                <c:pt idx="4">
                  <c:v>3.3333333333333298E-2</c:v>
                </c:pt>
                <c:pt idx="5">
                  <c:v>1.1111111111111101E-2</c:v>
                </c:pt>
                <c:pt idx="6">
                  <c:v>1.1111111111111101E-2</c:v>
                </c:pt>
                <c:pt idx="7">
                  <c:v>1.1111111111111101E-2</c:v>
                </c:pt>
                <c:pt idx="8">
                  <c:v>2.2222222222222202E-2</c:v>
                </c:pt>
                <c:pt idx="9">
                  <c:v>4.4444444444444418E-2</c:v>
                </c:pt>
                <c:pt idx="10">
                  <c:v>1.6666666666666701E-2</c:v>
                </c:pt>
                <c:pt idx="11">
                  <c:v>3.8888888888888903E-2</c:v>
                </c:pt>
                <c:pt idx="12">
                  <c:v>5.555555555555558E-2</c:v>
                </c:pt>
                <c:pt idx="13">
                  <c:v>6.1111111111111102E-2</c:v>
                </c:pt>
                <c:pt idx="14">
                  <c:v>5.555555555555558E-2</c:v>
                </c:pt>
                <c:pt idx="15">
                  <c:v>6.6666666666666693E-2</c:v>
                </c:pt>
                <c:pt idx="16">
                  <c:v>7.7777777777777807E-2</c:v>
                </c:pt>
                <c:pt idx="17">
                  <c:v>3.3333333333333298E-2</c:v>
                </c:pt>
                <c:pt idx="18">
                  <c:v>6.1111111111111102E-2</c:v>
                </c:pt>
                <c:pt idx="19">
                  <c:v>5.555555555555558E-2</c:v>
                </c:pt>
                <c:pt idx="20">
                  <c:v>1.6666666666666701E-2</c:v>
                </c:pt>
                <c:pt idx="21">
                  <c:v>2.7777777777777821E-2</c:v>
                </c:pt>
                <c:pt idx="22">
                  <c:v>5.5555555555555601E-3</c:v>
                </c:pt>
                <c:pt idx="23">
                  <c:v>2.2222222222222202E-2</c:v>
                </c:pt>
                <c:pt idx="24">
                  <c:v>1.1111111111111101E-2</c:v>
                </c:pt>
                <c:pt idx="25">
                  <c:v>5.5555555555555601E-3</c:v>
                </c:pt>
                <c:pt idx="26">
                  <c:v>1.1111111111111101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1"/>
          <c:order val="21"/>
          <c:tx>
            <c:strRef>
              <c:f>'cat-1(CB1111)_A5_0.02_50%'!$W$104</c:f>
              <c:strCache>
                <c:ptCount val="1"/>
                <c:pt idx="0">
                  <c:v>cat-1(CB1111)_A5_23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W$105:$W$135</c:f>
              <c:numCache>
                <c:formatCode>General</c:formatCode>
                <c:ptCount val="31"/>
                <c:pt idx="1">
                  <c:v>6.7484662576687102E-2</c:v>
                </c:pt>
                <c:pt idx="2">
                  <c:v>7.3619631901840538E-2</c:v>
                </c:pt>
                <c:pt idx="3">
                  <c:v>4.9079754601227002E-2</c:v>
                </c:pt>
                <c:pt idx="4">
                  <c:v>0</c:v>
                </c:pt>
                <c:pt idx="5">
                  <c:v>1.2269938650306698E-2</c:v>
                </c:pt>
                <c:pt idx="6">
                  <c:v>1.2269938650306698E-2</c:v>
                </c:pt>
                <c:pt idx="7">
                  <c:v>1.84049079754601E-2</c:v>
                </c:pt>
                <c:pt idx="8">
                  <c:v>1.2269938650306698E-2</c:v>
                </c:pt>
                <c:pt idx="9">
                  <c:v>1.2269938650306698E-2</c:v>
                </c:pt>
                <c:pt idx="10">
                  <c:v>2.4539877300613518E-2</c:v>
                </c:pt>
                <c:pt idx="11">
                  <c:v>1.2269938650306698E-2</c:v>
                </c:pt>
                <c:pt idx="12">
                  <c:v>3.0674846625766916E-2</c:v>
                </c:pt>
                <c:pt idx="13">
                  <c:v>4.9079754601227002E-2</c:v>
                </c:pt>
                <c:pt idx="14">
                  <c:v>7.3619631901840538E-2</c:v>
                </c:pt>
                <c:pt idx="15">
                  <c:v>8.5889570552147201E-2</c:v>
                </c:pt>
                <c:pt idx="16">
                  <c:v>7.9754601226993932E-2</c:v>
                </c:pt>
                <c:pt idx="17">
                  <c:v>4.9079754601227002E-2</c:v>
                </c:pt>
                <c:pt idx="18">
                  <c:v>5.5214723926380417E-2</c:v>
                </c:pt>
                <c:pt idx="19">
                  <c:v>5.5214723926380417E-2</c:v>
                </c:pt>
                <c:pt idx="20">
                  <c:v>3.0674846625766916E-2</c:v>
                </c:pt>
                <c:pt idx="21">
                  <c:v>1.84049079754601E-2</c:v>
                </c:pt>
                <c:pt idx="22">
                  <c:v>2.4539877300613518E-2</c:v>
                </c:pt>
                <c:pt idx="23">
                  <c:v>1.84049079754601E-2</c:v>
                </c:pt>
                <c:pt idx="24">
                  <c:v>0</c:v>
                </c:pt>
                <c:pt idx="25">
                  <c:v>6.1349693251533735E-3</c:v>
                </c:pt>
                <c:pt idx="26">
                  <c:v>1.84049079754601E-2</c:v>
                </c:pt>
                <c:pt idx="27">
                  <c:v>0</c:v>
                </c:pt>
                <c:pt idx="28">
                  <c:v>6.1349693251533735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2"/>
          <c:order val="22"/>
          <c:tx>
            <c:strRef>
              <c:f>'cat-1(CB1111)_A5_0.02_50%'!$X$104</c:f>
              <c:strCache>
                <c:ptCount val="1"/>
                <c:pt idx="0">
                  <c:v>cat-1(CB1111)_A5_24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X$105:$X$135</c:f>
              <c:numCache>
                <c:formatCode>General</c:formatCode>
                <c:ptCount val="31"/>
                <c:pt idx="1">
                  <c:v>2.3474178403755909E-2</c:v>
                </c:pt>
                <c:pt idx="2">
                  <c:v>3.2863849765258211E-2</c:v>
                </c:pt>
                <c:pt idx="3">
                  <c:v>3.2863849765258211E-2</c:v>
                </c:pt>
                <c:pt idx="4">
                  <c:v>3.2863849765258211E-2</c:v>
                </c:pt>
                <c:pt idx="5">
                  <c:v>9.3896713615023528E-3</c:v>
                </c:pt>
                <c:pt idx="6">
                  <c:v>4.6948356807511703E-3</c:v>
                </c:pt>
                <c:pt idx="7">
                  <c:v>9.3896713615023528E-3</c:v>
                </c:pt>
                <c:pt idx="8">
                  <c:v>1.4084507042253504E-2</c:v>
                </c:pt>
                <c:pt idx="9">
                  <c:v>0</c:v>
                </c:pt>
                <c:pt idx="10">
                  <c:v>2.3474178403755909E-2</c:v>
                </c:pt>
                <c:pt idx="11">
                  <c:v>2.8169014084506998E-2</c:v>
                </c:pt>
                <c:pt idx="12">
                  <c:v>1.4084507042253504E-2</c:v>
                </c:pt>
                <c:pt idx="13">
                  <c:v>7.5117370892018823E-2</c:v>
                </c:pt>
                <c:pt idx="14">
                  <c:v>0.10328638497652604</c:v>
                </c:pt>
                <c:pt idx="15">
                  <c:v>9.3896713615023525E-2</c:v>
                </c:pt>
                <c:pt idx="16">
                  <c:v>0.13145539906103307</c:v>
                </c:pt>
                <c:pt idx="17">
                  <c:v>5.6338028169014086E-2</c:v>
                </c:pt>
                <c:pt idx="18">
                  <c:v>7.9812206572770023E-2</c:v>
                </c:pt>
                <c:pt idx="19">
                  <c:v>8.4507042253521153E-2</c:v>
                </c:pt>
                <c:pt idx="20">
                  <c:v>3.2863849765258211E-2</c:v>
                </c:pt>
                <c:pt idx="21">
                  <c:v>1.8779342723004699E-2</c:v>
                </c:pt>
                <c:pt idx="22">
                  <c:v>9.3896713615023528E-3</c:v>
                </c:pt>
                <c:pt idx="23">
                  <c:v>1.4084507042253504E-2</c:v>
                </c:pt>
                <c:pt idx="24">
                  <c:v>4.6948356807511703E-3</c:v>
                </c:pt>
                <c:pt idx="25">
                  <c:v>4.6948356807511703E-3</c:v>
                </c:pt>
                <c:pt idx="26">
                  <c:v>4.6948356807511703E-3</c:v>
                </c:pt>
                <c:pt idx="27">
                  <c:v>4.6948356807511703E-3</c:v>
                </c:pt>
                <c:pt idx="28">
                  <c:v>4.6948356807511703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3"/>
          <c:order val="23"/>
          <c:tx>
            <c:strRef>
              <c:f>'cat-1(CB1111)_A5_0.02_50%'!$Y$104</c:f>
              <c:strCache>
                <c:ptCount val="1"/>
                <c:pt idx="0">
                  <c:v>cat-1(CB1111)_A5_25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Y$105:$Y$135</c:f>
              <c:numCache>
                <c:formatCode>General</c:formatCode>
                <c:ptCount val="31"/>
                <c:pt idx="1">
                  <c:v>1.1235955056179799E-2</c:v>
                </c:pt>
                <c:pt idx="2">
                  <c:v>0</c:v>
                </c:pt>
                <c:pt idx="3">
                  <c:v>1.1235955056179799E-2</c:v>
                </c:pt>
                <c:pt idx="4">
                  <c:v>5.6179775280898884E-3</c:v>
                </c:pt>
                <c:pt idx="5">
                  <c:v>0</c:v>
                </c:pt>
                <c:pt idx="6">
                  <c:v>0</c:v>
                </c:pt>
                <c:pt idx="7">
                  <c:v>1.1235955056179799E-2</c:v>
                </c:pt>
                <c:pt idx="8">
                  <c:v>0</c:v>
                </c:pt>
                <c:pt idx="9">
                  <c:v>3.9325842696629212E-2</c:v>
                </c:pt>
                <c:pt idx="10">
                  <c:v>2.8089887640449406E-2</c:v>
                </c:pt>
                <c:pt idx="11">
                  <c:v>3.3707865168539311E-2</c:v>
                </c:pt>
                <c:pt idx="12">
                  <c:v>2.8089887640449406E-2</c:v>
                </c:pt>
                <c:pt idx="13">
                  <c:v>6.7415730337078733E-2</c:v>
                </c:pt>
                <c:pt idx="14">
                  <c:v>6.7415730337078733E-2</c:v>
                </c:pt>
                <c:pt idx="15">
                  <c:v>8.98876404494382E-2</c:v>
                </c:pt>
                <c:pt idx="16">
                  <c:v>0.10112359550561803</c:v>
                </c:pt>
                <c:pt idx="17">
                  <c:v>8.4269662921348298E-2</c:v>
                </c:pt>
                <c:pt idx="18">
                  <c:v>0.10112359550561803</c:v>
                </c:pt>
                <c:pt idx="19">
                  <c:v>7.3033707865168523E-2</c:v>
                </c:pt>
                <c:pt idx="20">
                  <c:v>6.1797752808988818E-2</c:v>
                </c:pt>
                <c:pt idx="21">
                  <c:v>3.9325842696629212E-2</c:v>
                </c:pt>
                <c:pt idx="22">
                  <c:v>4.49438202247191E-2</c:v>
                </c:pt>
                <c:pt idx="23">
                  <c:v>2.2471910112359623E-2</c:v>
                </c:pt>
                <c:pt idx="24">
                  <c:v>5.6179775280898884E-3</c:v>
                </c:pt>
                <c:pt idx="25">
                  <c:v>1.1235955056179799E-2</c:v>
                </c:pt>
                <c:pt idx="26">
                  <c:v>2.2471910112359623E-2</c:v>
                </c:pt>
                <c:pt idx="27">
                  <c:v>5.6179775280898884E-3</c:v>
                </c:pt>
                <c:pt idx="28">
                  <c:v>0</c:v>
                </c:pt>
                <c:pt idx="29">
                  <c:v>1.1235955056179799E-2</c:v>
                </c:pt>
                <c:pt idx="30">
                  <c:v>0</c:v>
                </c:pt>
              </c:numCache>
            </c:numRef>
          </c:val>
        </c:ser>
        <c:ser>
          <c:idx val="24"/>
          <c:order val="24"/>
          <c:tx>
            <c:strRef>
              <c:f>'cat-1(CB1111)_A5_0.02_50%'!$Z$104</c:f>
              <c:strCache>
                <c:ptCount val="1"/>
                <c:pt idx="0">
                  <c:v>cat-1(CB1111)_A5_26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Z$105:$Z$135</c:f>
              <c:numCache>
                <c:formatCode>General</c:formatCode>
                <c:ptCount val="31"/>
                <c:pt idx="1">
                  <c:v>2.4896265560166008E-2</c:v>
                </c:pt>
                <c:pt idx="2">
                  <c:v>8.29875518672199E-3</c:v>
                </c:pt>
                <c:pt idx="3">
                  <c:v>2.4896265560166008E-2</c:v>
                </c:pt>
                <c:pt idx="4">
                  <c:v>3.734439834024901E-2</c:v>
                </c:pt>
                <c:pt idx="5">
                  <c:v>4.1493775933610019E-3</c:v>
                </c:pt>
                <c:pt idx="6">
                  <c:v>1.2448132780083001E-2</c:v>
                </c:pt>
                <c:pt idx="7">
                  <c:v>8.29875518672199E-3</c:v>
                </c:pt>
                <c:pt idx="8">
                  <c:v>1.2448132780083001E-2</c:v>
                </c:pt>
                <c:pt idx="9">
                  <c:v>2.4896265560166008E-2</c:v>
                </c:pt>
                <c:pt idx="10">
                  <c:v>2.904564315352701E-2</c:v>
                </c:pt>
                <c:pt idx="11">
                  <c:v>3.3195020746887988E-2</c:v>
                </c:pt>
                <c:pt idx="12">
                  <c:v>5.8091286307053902E-2</c:v>
                </c:pt>
                <c:pt idx="13">
                  <c:v>4.1493775933610019E-2</c:v>
                </c:pt>
                <c:pt idx="14">
                  <c:v>8.7136929460580895E-2</c:v>
                </c:pt>
                <c:pt idx="15">
                  <c:v>9.5435684647302899E-2</c:v>
                </c:pt>
                <c:pt idx="16">
                  <c:v>0.12448132780083</c:v>
                </c:pt>
                <c:pt idx="17">
                  <c:v>9.9585062240663991E-2</c:v>
                </c:pt>
                <c:pt idx="18">
                  <c:v>9.5435684647302899E-2</c:v>
                </c:pt>
                <c:pt idx="19">
                  <c:v>3.734439834024901E-2</c:v>
                </c:pt>
                <c:pt idx="20">
                  <c:v>4.1493775933610019E-2</c:v>
                </c:pt>
                <c:pt idx="21">
                  <c:v>2.904564315352701E-2</c:v>
                </c:pt>
                <c:pt idx="22">
                  <c:v>8.29875518672199E-3</c:v>
                </c:pt>
                <c:pt idx="23">
                  <c:v>2.4896265560166008E-2</c:v>
                </c:pt>
                <c:pt idx="24">
                  <c:v>8.29875518672199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5"/>
          <c:order val="25"/>
          <c:tx>
            <c:strRef>
              <c:f>'cat-1(CB1111)_A5_0.02_50%'!$AA$104</c:f>
              <c:strCache>
                <c:ptCount val="1"/>
                <c:pt idx="0">
                  <c:v>cat-1(CB1111)_A5_27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AA$105:$AA$135</c:f>
              <c:numCache>
                <c:formatCode>General</c:formatCode>
                <c:ptCount val="31"/>
                <c:pt idx="1">
                  <c:v>4.8076923076923114E-3</c:v>
                </c:pt>
                <c:pt idx="2">
                  <c:v>9.6153846153846281E-3</c:v>
                </c:pt>
                <c:pt idx="3">
                  <c:v>9.6153846153846281E-3</c:v>
                </c:pt>
                <c:pt idx="4">
                  <c:v>1.4423076923076898E-2</c:v>
                </c:pt>
                <c:pt idx="5">
                  <c:v>9.6153846153846281E-3</c:v>
                </c:pt>
                <c:pt idx="6">
                  <c:v>0</c:v>
                </c:pt>
                <c:pt idx="7">
                  <c:v>4.8076923076923114E-3</c:v>
                </c:pt>
                <c:pt idx="8">
                  <c:v>4.8076923076923114E-3</c:v>
                </c:pt>
                <c:pt idx="9">
                  <c:v>4.8076923076923114E-3</c:v>
                </c:pt>
                <c:pt idx="10">
                  <c:v>1.4423076923076898E-2</c:v>
                </c:pt>
                <c:pt idx="11">
                  <c:v>4.8076923076923114E-3</c:v>
                </c:pt>
                <c:pt idx="12">
                  <c:v>4.8076923076923114E-3</c:v>
                </c:pt>
                <c:pt idx="13">
                  <c:v>1.4423076923076898E-2</c:v>
                </c:pt>
                <c:pt idx="14">
                  <c:v>2.8846153846153799E-2</c:v>
                </c:pt>
                <c:pt idx="15">
                  <c:v>4.3269230769230796E-2</c:v>
                </c:pt>
                <c:pt idx="16">
                  <c:v>6.7307692307692332E-2</c:v>
                </c:pt>
                <c:pt idx="17">
                  <c:v>9.1346153846153771E-2</c:v>
                </c:pt>
                <c:pt idx="18">
                  <c:v>0.13461538461538505</c:v>
                </c:pt>
                <c:pt idx="19">
                  <c:v>0.10096153846153805</c:v>
                </c:pt>
                <c:pt idx="20">
                  <c:v>7.6923076923076913E-2</c:v>
                </c:pt>
                <c:pt idx="21">
                  <c:v>6.25E-2</c:v>
                </c:pt>
                <c:pt idx="22">
                  <c:v>5.2884615384615419E-2</c:v>
                </c:pt>
                <c:pt idx="23">
                  <c:v>0.10096153846153805</c:v>
                </c:pt>
                <c:pt idx="24">
                  <c:v>4.8076923076923114E-2</c:v>
                </c:pt>
                <c:pt idx="25">
                  <c:v>2.8846153846153799E-2</c:v>
                </c:pt>
                <c:pt idx="26">
                  <c:v>2.4038461538461502E-2</c:v>
                </c:pt>
                <c:pt idx="27">
                  <c:v>4.8076923076923114E-3</c:v>
                </c:pt>
                <c:pt idx="28">
                  <c:v>4.8076923076923114E-3</c:v>
                </c:pt>
                <c:pt idx="29">
                  <c:v>9.6153846153846281E-3</c:v>
                </c:pt>
                <c:pt idx="30">
                  <c:v>4.8076923076923114E-3</c:v>
                </c:pt>
              </c:numCache>
            </c:numRef>
          </c:val>
        </c:ser>
        <c:ser>
          <c:idx val="26"/>
          <c:order val="26"/>
          <c:tx>
            <c:strRef>
              <c:f>'cat-1(CB1111)_A5_0.02_50%'!$AB$104</c:f>
              <c:strCache>
                <c:ptCount val="1"/>
                <c:pt idx="0">
                  <c:v>cat-1(CB1111)_A5_28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AB$105:$AB$135</c:f>
              <c:numCache>
                <c:formatCode>General</c:formatCode>
                <c:ptCount val="31"/>
                <c:pt idx="1">
                  <c:v>1.2500000000000001E-2</c:v>
                </c:pt>
                <c:pt idx="2">
                  <c:v>4.1666666666666701E-3</c:v>
                </c:pt>
                <c:pt idx="3">
                  <c:v>1.2500000000000001E-2</c:v>
                </c:pt>
                <c:pt idx="4">
                  <c:v>8.3333333333333297E-3</c:v>
                </c:pt>
                <c:pt idx="5">
                  <c:v>8.3333333333333297E-3</c:v>
                </c:pt>
                <c:pt idx="6">
                  <c:v>0</c:v>
                </c:pt>
                <c:pt idx="7">
                  <c:v>1.2500000000000001E-2</c:v>
                </c:pt>
                <c:pt idx="8">
                  <c:v>4.1666666666666701E-3</c:v>
                </c:pt>
                <c:pt idx="9">
                  <c:v>4.1666666666666701E-3</c:v>
                </c:pt>
                <c:pt idx="10">
                  <c:v>1.2500000000000001E-2</c:v>
                </c:pt>
                <c:pt idx="11">
                  <c:v>2.0833333333333311E-2</c:v>
                </c:pt>
                <c:pt idx="12">
                  <c:v>2.5000000000000001E-2</c:v>
                </c:pt>
                <c:pt idx="13">
                  <c:v>3.3333333333333298E-2</c:v>
                </c:pt>
                <c:pt idx="14">
                  <c:v>2.5000000000000001E-2</c:v>
                </c:pt>
                <c:pt idx="15">
                  <c:v>8.3333333333333329E-2</c:v>
                </c:pt>
                <c:pt idx="16">
                  <c:v>0.108333333333333</c:v>
                </c:pt>
                <c:pt idx="17">
                  <c:v>9.5833333333333298E-2</c:v>
                </c:pt>
                <c:pt idx="18">
                  <c:v>0.12916666666666696</c:v>
                </c:pt>
                <c:pt idx="19">
                  <c:v>0.12916666666666696</c:v>
                </c:pt>
                <c:pt idx="20">
                  <c:v>0.108333333333333</c:v>
                </c:pt>
                <c:pt idx="21">
                  <c:v>3.7500000000000006E-2</c:v>
                </c:pt>
                <c:pt idx="22">
                  <c:v>4.1666666666666699E-2</c:v>
                </c:pt>
                <c:pt idx="23">
                  <c:v>2.9166666666666691E-2</c:v>
                </c:pt>
                <c:pt idx="24">
                  <c:v>8.3333333333333297E-3</c:v>
                </c:pt>
                <c:pt idx="25">
                  <c:v>4.1666666666666701E-3</c:v>
                </c:pt>
                <c:pt idx="26">
                  <c:v>4.1666666666666701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7"/>
          <c:order val="27"/>
          <c:tx>
            <c:strRef>
              <c:f>'cat-1(CB1111)_A5_0.02_50%'!$AC$104</c:f>
              <c:strCache>
                <c:ptCount val="1"/>
                <c:pt idx="0">
                  <c:v>cat-1(CB1111)_A5_29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AC$105:$AC$135</c:f>
              <c:numCache>
                <c:formatCode>General</c:formatCode>
                <c:ptCount val="31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8.6206896551724154E-3</c:v>
                </c:pt>
                <c:pt idx="12">
                  <c:v>1.7241379310344803E-2</c:v>
                </c:pt>
                <c:pt idx="13">
                  <c:v>6.8965517241379309E-2</c:v>
                </c:pt>
                <c:pt idx="14">
                  <c:v>3.4482758620689717E-2</c:v>
                </c:pt>
                <c:pt idx="15">
                  <c:v>0.12931034482758599</c:v>
                </c:pt>
                <c:pt idx="16">
                  <c:v>0.15517241379310301</c:v>
                </c:pt>
                <c:pt idx="17">
                  <c:v>0.15517241379310301</c:v>
                </c:pt>
                <c:pt idx="18">
                  <c:v>0.10344827586206902</c:v>
                </c:pt>
                <c:pt idx="19">
                  <c:v>0.10344827586206902</c:v>
                </c:pt>
                <c:pt idx="20">
                  <c:v>6.8965517241379309E-2</c:v>
                </c:pt>
                <c:pt idx="21">
                  <c:v>6.0344827586206899E-2</c:v>
                </c:pt>
                <c:pt idx="22">
                  <c:v>1.7241379310344803E-2</c:v>
                </c:pt>
                <c:pt idx="23">
                  <c:v>2.5862068965517199E-2</c:v>
                </c:pt>
                <c:pt idx="24">
                  <c:v>2.5862068965517199E-2</c:v>
                </c:pt>
                <c:pt idx="25">
                  <c:v>0</c:v>
                </c:pt>
                <c:pt idx="26">
                  <c:v>2.5862068965517199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8"/>
          <c:order val="28"/>
          <c:tx>
            <c:strRef>
              <c:f>'cat-1(CB1111)_A5_0.02_50%'!$AD$104</c:f>
              <c:strCache>
                <c:ptCount val="1"/>
                <c:pt idx="0">
                  <c:v>cat-1(CB1111)_A5_30</c:v>
                </c:pt>
              </c:strCache>
            </c:strRef>
          </c:tx>
          <c:marker>
            <c:symbol val="none"/>
          </c:marker>
          <c:cat>
            <c:numRef>
              <c:f>'cat-1(CB1111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5_0.02_50%'!$AD$105:$AD$135</c:f>
              <c:numCache>
                <c:formatCode>General</c:formatCode>
                <c:ptCount val="31"/>
                <c:pt idx="1">
                  <c:v>0.11111111111111099</c:v>
                </c:pt>
                <c:pt idx="2">
                  <c:v>0.11695906432748497</c:v>
                </c:pt>
                <c:pt idx="3">
                  <c:v>9.3567251461988327E-2</c:v>
                </c:pt>
                <c:pt idx="4">
                  <c:v>1.7543859649122813E-2</c:v>
                </c:pt>
                <c:pt idx="5">
                  <c:v>3.5087719298245605E-2</c:v>
                </c:pt>
                <c:pt idx="6">
                  <c:v>1.7543859649122813E-2</c:v>
                </c:pt>
                <c:pt idx="7">
                  <c:v>2.9239766081871312E-2</c:v>
                </c:pt>
                <c:pt idx="8">
                  <c:v>1.7543859649122813E-2</c:v>
                </c:pt>
                <c:pt idx="9">
                  <c:v>0</c:v>
                </c:pt>
                <c:pt idx="10">
                  <c:v>2.9239766081871312E-2</c:v>
                </c:pt>
                <c:pt idx="11">
                  <c:v>5.8479532163742704E-3</c:v>
                </c:pt>
                <c:pt idx="12">
                  <c:v>1.1695906432748499E-2</c:v>
                </c:pt>
                <c:pt idx="13">
                  <c:v>3.5087719298245605E-2</c:v>
                </c:pt>
                <c:pt idx="14">
                  <c:v>1.1695906432748499E-2</c:v>
                </c:pt>
                <c:pt idx="15">
                  <c:v>5.2631578947368404E-2</c:v>
                </c:pt>
                <c:pt idx="16">
                  <c:v>4.6783625730994101E-2</c:v>
                </c:pt>
                <c:pt idx="17">
                  <c:v>2.3391812865497099E-2</c:v>
                </c:pt>
                <c:pt idx="18">
                  <c:v>1.7543859649122813E-2</c:v>
                </c:pt>
                <c:pt idx="19">
                  <c:v>1.7543859649122813E-2</c:v>
                </c:pt>
                <c:pt idx="20">
                  <c:v>0</c:v>
                </c:pt>
                <c:pt idx="21">
                  <c:v>5.8479532163742704E-3</c:v>
                </c:pt>
                <c:pt idx="22">
                  <c:v>5.8479532163742704E-3</c:v>
                </c:pt>
                <c:pt idx="23">
                  <c:v>5.8479532163742704E-3</c:v>
                </c:pt>
                <c:pt idx="24">
                  <c:v>1.1695906432748499E-2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marker val="1"/>
        <c:axId val="168584704"/>
        <c:axId val="168586240"/>
      </c:lineChart>
      <c:catAx>
        <c:axId val="168584704"/>
        <c:scaling>
          <c:orientation val="minMax"/>
        </c:scaling>
        <c:axPos val="b"/>
        <c:numFmt formatCode="0.0_ " sourceLinked="1"/>
        <c:tickLblPos val="nextTo"/>
        <c:crossAx val="168586240"/>
        <c:crosses val="autoZero"/>
        <c:auto val="1"/>
        <c:lblAlgn val="ctr"/>
        <c:lblOffset val="100"/>
        <c:tickLblSkip val="5"/>
        <c:tickMarkSkip val="5"/>
      </c:catAx>
      <c:valAx>
        <c:axId val="168586240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8584704"/>
        <c:crosses val="autoZero"/>
        <c:crossBetween val="between"/>
      </c:valAx>
    </c:plotArea>
    <c:plotVisOnly val="1"/>
  </c:chart>
  <c:externalData r:id="rId1"/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cat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3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cat-1(CB1111)_A3_0.02_50%'!$B$104</c:f>
              <c:strCache>
                <c:ptCount val="1"/>
                <c:pt idx="0">
                  <c:v>cat-1(CB1111)_A3_01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B$105:$B$135</c:f>
              <c:numCache>
                <c:formatCode>General</c:formatCode>
                <c:ptCount val="31"/>
                <c:pt idx="1">
                  <c:v>1.9841269841269809E-2</c:v>
                </c:pt>
                <c:pt idx="2">
                  <c:v>1.1904761904761904E-2</c:v>
                </c:pt>
                <c:pt idx="3">
                  <c:v>3.9682539682539715E-3</c:v>
                </c:pt>
                <c:pt idx="4">
                  <c:v>3.9682539682539715E-3</c:v>
                </c:pt>
                <c:pt idx="5">
                  <c:v>1.9841269841269809E-2</c:v>
                </c:pt>
                <c:pt idx="6">
                  <c:v>0</c:v>
                </c:pt>
                <c:pt idx="7">
                  <c:v>7.9365079365079413E-3</c:v>
                </c:pt>
                <c:pt idx="8">
                  <c:v>0</c:v>
                </c:pt>
                <c:pt idx="9">
                  <c:v>3.9682539682539715E-3</c:v>
                </c:pt>
                <c:pt idx="10">
                  <c:v>2.3809523809523808E-2</c:v>
                </c:pt>
                <c:pt idx="11">
                  <c:v>5.1587301587301598E-2</c:v>
                </c:pt>
                <c:pt idx="12">
                  <c:v>8.7301587301587255E-2</c:v>
                </c:pt>
                <c:pt idx="13">
                  <c:v>0.126984126984127</c:v>
                </c:pt>
                <c:pt idx="14">
                  <c:v>0.15873015873015905</c:v>
                </c:pt>
                <c:pt idx="15">
                  <c:v>0.18650793650793715</c:v>
                </c:pt>
                <c:pt idx="16">
                  <c:v>9.5238095238095247E-2</c:v>
                </c:pt>
                <c:pt idx="17">
                  <c:v>7.1428571428571411E-2</c:v>
                </c:pt>
                <c:pt idx="18">
                  <c:v>6.7460317460317498E-2</c:v>
                </c:pt>
                <c:pt idx="19">
                  <c:v>7.9365079365079413E-3</c:v>
                </c:pt>
                <c:pt idx="20">
                  <c:v>3.1746031746031703E-2</c:v>
                </c:pt>
                <c:pt idx="21">
                  <c:v>3.9682539682539715E-3</c:v>
                </c:pt>
                <c:pt idx="22">
                  <c:v>0</c:v>
                </c:pt>
                <c:pt idx="23">
                  <c:v>3.9682539682539715E-3</c:v>
                </c:pt>
                <c:pt idx="24">
                  <c:v>3.9682539682539715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"/>
          <c:order val="1"/>
          <c:tx>
            <c:strRef>
              <c:f>'cat-1(CB1111)_A3_0.02_50%'!$C$104</c:f>
              <c:strCache>
                <c:ptCount val="1"/>
                <c:pt idx="0">
                  <c:v>cat-1(CB1111)_A3_02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C$105:$C$135</c:f>
              <c:numCache>
                <c:formatCode>General</c:formatCode>
                <c:ptCount val="31"/>
                <c:pt idx="1">
                  <c:v>3.8596491228070198E-2</c:v>
                </c:pt>
                <c:pt idx="2">
                  <c:v>2.8070175438596506E-2</c:v>
                </c:pt>
                <c:pt idx="3">
                  <c:v>2.1052631578947399E-2</c:v>
                </c:pt>
                <c:pt idx="4">
                  <c:v>1.7543859649122813E-2</c:v>
                </c:pt>
                <c:pt idx="5">
                  <c:v>2.4561403508771899E-2</c:v>
                </c:pt>
                <c:pt idx="6">
                  <c:v>2.1052631578947399E-2</c:v>
                </c:pt>
                <c:pt idx="7">
                  <c:v>4.2105263157894701E-2</c:v>
                </c:pt>
                <c:pt idx="8">
                  <c:v>2.1052631578947399E-2</c:v>
                </c:pt>
                <c:pt idx="9">
                  <c:v>4.5614035087719301E-2</c:v>
                </c:pt>
                <c:pt idx="10">
                  <c:v>2.8070175438596506E-2</c:v>
                </c:pt>
                <c:pt idx="11">
                  <c:v>2.4561403508771899E-2</c:v>
                </c:pt>
                <c:pt idx="12">
                  <c:v>7.368421052631581E-2</c:v>
                </c:pt>
                <c:pt idx="13">
                  <c:v>9.4736842105263286E-2</c:v>
                </c:pt>
                <c:pt idx="14">
                  <c:v>8.4210526315789527E-2</c:v>
                </c:pt>
                <c:pt idx="15">
                  <c:v>8.0701754385964899E-2</c:v>
                </c:pt>
                <c:pt idx="16">
                  <c:v>8.4210526315789527E-2</c:v>
                </c:pt>
                <c:pt idx="17">
                  <c:v>7.368421052631581E-2</c:v>
                </c:pt>
                <c:pt idx="18">
                  <c:v>7.0175438596491196E-2</c:v>
                </c:pt>
                <c:pt idx="19">
                  <c:v>2.4561403508771899E-2</c:v>
                </c:pt>
                <c:pt idx="20">
                  <c:v>7.0175438596491221E-3</c:v>
                </c:pt>
                <c:pt idx="21">
                  <c:v>1.05263157894737E-2</c:v>
                </c:pt>
                <c:pt idx="22">
                  <c:v>1.7543859649122813E-2</c:v>
                </c:pt>
                <c:pt idx="23">
                  <c:v>2.4561403508771899E-2</c:v>
                </c:pt>
                <c:pt idx="24">
                  <c:v>3.508771929824561E-3</c:v>
                </c:pt>
                <c:pt idx="25">
                  <c:v>0</c:v>
                </c:pt>
                <c:pt idx="26">
                  <c:v>1.05263157894737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cat-1(CB1111)_A3_0.02_50%'!$D$104</c:f>
              <c:strCache>
                <c:ptCount val="1"/>
                <c:pt idx="0">
                  <c:v>cat-1(CB1111)_A3_03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D$105:$D$135</c:f>
              <c:numCache>
                <c:formatCode>General</c:formatCode>
                <c:ptCount val="31"/>
                <c:pt idx="1">
                  <c:v>2.0408163265306107E-2</c:v>
                </c:pt>
                <c:pt idx="2">
                  <c:v>4.0816326530612223E-3</c:v>
                </c:pt>
                <c:pt idx="3">
                  <c:v>0</c:v>
                </c:pt>
                <c:pt idx="4">
                  <c:v>0</c:v>
                </c:pt>
                <c:pt idx="5">
                  <c:v>4.0816326530612223E-3</c:v>
                </c:pt>
                <c:pt idx="6">
                  <c:v>0</c:v>
                </c:pt>
                <c:pt idx="7">
                  <c:v>4.0816326530612223E-3</c:v>
                </c:pt>
                <c:pt idx="8">
                  <c:v>4.0816326530612223E-3</c:v>
                </c:pt>
                <c:pt idx="9">
                  <c:v>0</c:v>
                </c:pt>
                <c:pt idx="10">
                  <c:v>1.2244897959183699E-2</c:v>
                </c:pt>
                <c:pt idx="11">
                  <c:v>3.673469387755101E-2</c:v>
                </c:pt>
                <c:pt idx="12">
                  <c:v>5.3061224489795902E-2</c:v>
                </c:pt>
                <c:pt idx="13">
                  <c:v>6.938775510204083E-2</c:v>
                </c:pt>
                <c:pt idx="14">
                  <c:v>0.14285714285714307</c:v>
                </c:pt>
                <c:pt idx="15">
                  <c:v>0.17959183673469406</c:v>
                </c:pt>
                <c:pt idx="16">
                  <c:v>0.14285714285714307</c:v>
                </c:pt>
                <c:pt idx="17">
                  <c:v>0.122448979591837</c:v>
                </c:pt>
                <c:pt idx="18">
                  <c:v>5.3061224489795902E-2</c:v>
                </c:pt>
                <c:pt idx="19">
                  <c:v>7.346938775510202E-2</c:v>
                </c:pt>
                <c:pt idx="20">
                  <c:v>2.4489795918367314E-2</c:v>
                </c:pt>
                <c:pt idx="21">
                  <c:v>1.2244897959183699E-2</c:v>
                </c:pt>
                <c:pt idx="22">
                  <c:v>1.2244897959183699E-2</c:v>
                </c:pt>
                <c:pt idx="23">
                  <c:v>8.1632653061224497E-3</c:v>
                </c:pt>
                <c:pt idx="24">
                  <c:v>4.0816326530612223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cat-1(CB1111)_A3_0.02_50%'!$E$104</c:f>
              <c:strCache>
                <c:ptCount val="1"/>
                <c:pt idx="0">
                  <c:v>cat-1(CB1111)_A3_04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E$105:$E$135</c:f>
              <c:numCache>
                <c:formatCode>General</c:formatCode>
                <c:ptCount val="31"/>
                <c:pt idx="1">
                  <c:v>1.2987012987013E-2</c:v>
                </c:pt>
                <c:pt idx="2">
                  <c:v>1.7316017316017306E-2</c:v>
                </c:pt>
                <c:pt idx="3">
                  <c:v>1.2987012987013E-2</c:v>
                </c:pt>
                <c:pt idx="4">
                  <c:v>2.1645021645021606E-2</c:v>
                </c:pt>
                <c:pt idx="5">
                  <c:v>4.3290043290043316E-3</c:v>
                </c:pt>
                <c:pt idx="6">
                  <c:v>4.3290043290043316E-3</c:v>
                </c:pt>
                <c:pt idx="7">
                  <c:v>2.5974025974026007E-2</c:v>
                </c:pt>
                <c:pt idx="8">
                  <c:v>1.2987012987013E-2</c:v>
                </c:pt>
                <c:pt idx="9">
                  <c:v>1.7316017316017306E-2</c:v>
                </c:pt>
                <c:pt idx="10">
                  <c:v>4.3290043290043316E-3</c:v>
                </c:pt>
                <c:pt idx="11">
                  <c:v>4.3290043290043316E-3</c:v>
                </c:pt>
                <c:pt idx="12">
                  <c:v>3.03030303030303E-2</c:v>
                </c:pt>
                <c:pt idx="13">
                  <c:v>6.0606060606060601E-2</c:v>
                </c:pt>
                <c:pt idx="14">
                  <c:v>9.0909090909090939E-2</c:v>
                </c:pt>
                <c:pt idx="15">
                  <c:v>0.10822510822510806</c:v>
                </c:pt>
                <c:pt idx="16">
                  <c:v>0.11688311688311702</c:v>
                </c:pt>
                <c:pt idx="17">
                  <c:v>7.7922077922077934E-2</c:v>
                </c:pt>
                <c:pt idx="18">
                  <c:v>9.5238095238095247E-2</c:v>
                </c:pt>
                <c:pt idx="19">
                  <c:v>9.0909090909090939E-2</c:v>
                </c:pt>
                <c:pt idx="20">
                  <c:v>7.3593073593073599E-2</c:v>
                </c:pt>
                <c:pt idx="21">
                  <c:v>3.4632034632034597E-2</c:v>
                </c:pt>
                <c:pt idx="22">
                  <c:v>2.1645021645021606E-2</c:v>
                </c:pt>
                <c:pt idx="23">
                  <c:v>2.5974025974026007E-2</c:v>
                </c:pt>
                <c:pt idx="24">
                  <c:v>8.6580086580086649E-3</c:v>
                </c:pt>
                <c:pt idx="25">
                  <c:v>4.3290043290043316E-3</c:v>
                </c:pt>
                <c:pt idx="26">
                  <c:v>4.3290043290043316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cat-1(CB1111)_A3_0.02_50%'!$F$104</c:f>
              <c:strCache>
                <c:ptCount val="1"/>
                <c:pt idx="0">
                  <c:v>cat-1(CB1111)_A3_05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F$105:$F$135</c:f>
              <c:numCache>
                <c:formatCode>General</c:formatCode>
                <c:ptCount val="31"/>
                <c:pt idx="1">
                  <c:v>4.2145593869731802E-2</c:v>
                </c:pt>
                <c:pt idx="2">
                  <c:v>2.6819923371647507E-2</c:v>
                </c:pt>
                <c:pt idx="3">
                  <c:v>1.1494252873563199E-2</c:v>
                </c:pt>
                <c:pt idx="4">
                  <c:v>4.5977011494252887E-2</c:v>
                </c:pt>
                <c:pt idx="5">
                  <c:v>1.5325670498084304E-2</c:v>
                </c:pt>
                <c:pt idx="6">
                  <c:v>3.0651340996168609E-2</c:v>
                </c:pt>
                <c:pt idx="7">
                  <c:v>3.4482758620689717E-2</c:v>
                </c:pt>
                <c:pt idx="8">
                  <c:v>3.0651340996168609E-2</c:v>
                </c:pt>
                <c:pt idx="9">
                  <c:v>1.5325670498084304E-2</c:v>
                </c:pt>
                <c:pt idx="10">
                  <c:v>2.2988505747126402E-2</c:v>
                </c:pt>
                <c:pt idx="11">
                  <c:v>2.6819923371647507E-2</c:v>
                </c:pt>
                <c:pt idx="12">
                  <c:v>3.4482758620689717E-2</c:v>
                </c:pt>
                <c:pt idx="13">
                  <c:v>5.3639846743294972E-2</c:v>
                </c:pt>
                <c:pt idx="14">
                  <c:v>5.3639846743294972E-2</c:v>
                </c:pt>
                <c:pt idx="15">
                  <c:v>8.04597701149425E-2</c:v>
                </c:pt>
                <c:pt idx="16">
                  <c:v>0.10727969348659006</c:v>
                </c:pt>
                <c:pt idx="17">
                  <c:v>6.1302681992337245E-2</c:v>
                </c:pt>
                <c:pt idx="18">
                  <c:v>4.9808429118773923E-2</c:v>
                </c:pt>
                <c:pt idx="19">
                  <c:v>5.7471264367816112E-2</c:v>
                </c:pt>
                <c:pt idx="20">
                  <c:v>3.8314176245210697E-2</c:v>
                </c:pt>
                <c:pt idx="21">
                  <c:v>2.2988505747126402E-2</c:v>
                </c:pt>
                <c:pt idx="22">
                  <c:v>7.6628352490421495E-3</c:v>
                </c:pt>
                <c:pt idx="23">
                  <c:v>2.6819923371647507E-2</c:v>
                </c:pt>
                <c:pt idx="24">
                  <c:v>1.1494252873563199E-2</c:v>
                </c:pt>
                <c:pt idx="25">
                  <c:v>3.8314176245210709E-3</c:v>
                </c:pt>
                <c:pt idx="26">
                  <c:v>3.8314176245210709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cat-1(CB1111)_A3_0.02_50%'!$G$104</c:f>
              <c:strCache>
                <c:ptCount val="1"/>
                <c:pt idx="0">
                  <c:v>cat-1(CB1111)_A3_06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G$105:$G$135</c:f>
              <c:numCache>
                <c:formatCode>General</c:formatCode>
                <c:ptCount val="31"/>
                <c:pt idx="1">
                  <c:v>2.7777777777777821E-2</c:v>
                </c:pt>
                <c:pt idx="2">
                  <c:v>3.9682539682539715E-2</c:v>
                </c:pt>
                <c:pt idx="3">
                  <c:v>4.3650793650793614E-2</c:v>
                </c:pt>
                <c:pt idx="4">
                  <c:v>2.7777777777777821E-2</c:v>
                </c:pt>
                <c:pt idx="5">
                  <c:v>5.555555555555558E-2</c:v>
                </c:pt>
                <c:pt idx="6">
                  <c:v>1.9841269841269809E-2</c:v>
                </c:pt>
                <c:pt idx="7">
                  <c:v>1.9841269841269809E-2</c:v>
                </c:pt>
                <c:pt idx="8">
                  <c:v>2.3809523809523808E-2</c:v>
                </c:pt>
                <c:pt idx="9">
                  <c:v>3.1746031746031703E-2</c:v>
                </c:pt>
                <c:pt idx="10">
                  <c:v>1.58730158730159E-2</c:v>
                </c:pt>
                <c:pt idx="11">
                  <c:v>1.58730158730159E-2</c:v>
                </c:pt>
                <c:pt idx="12">
                  <c:v>2.3809523809523808E-2</c:v>
                </c:pt>
                <c:pt idx="13">
                  <c:v>4.7619047619047616E-2</c:v>
                </c:pt>
                <c:pt idx="14">
                  <c:v>7.1428571428571411E-2</c:v>
                </c:pt>
                <c:pt idx="15">
                  <c:v>7.9365079365079402E-2</c:v>
                </c:pt>
                <c:pt idx="16">
                  <c:v>4.3650793650793614E-2</c:v>
                </c:pt>
                <c:pt idx="17">
                  <c:v>0.11111111111111099</c:v>
                </c:pt>
                <c:pt idx="18">
                  <c:v>7.1428571428571411E-2</c:v>
                </c:pt>
                <c:pt idx="19">
                  <c:v>6.7460317460317498E-2</c:v>
                </c:pt>
                <c:pt idx="20">
                  <c:v>3.9682539682539715E-2</c:v>
                </c:pt>
                <c:pt idx="21">
                  <c:v>2.7777777777777821E-2</c:v>
                </c:pt>
                <c:pt idx="22">
                  <c:v>1.58730158730159E-2</c:v>
                </c:pt>
                <c:pt idx="23">
                  <c:v>0</c:v>
                </c:pt>
                <c:pt idx="24">
                  <c:v>0</c:v>
                </c:pt>
                <c:pt idx="25">
                  <c:v>1.1904761904761904E-2</c:v>
                </c:pt>
                <c:pt idx="26">
                  <c:v>3.9682539682539715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6"/>
          <c:order val="6"/>
          <c:tx>
            <c:strRef>
              <c:f>'cat-1(CB1111)_A3_0.02_50%'!$H$104</c:f>
              <c:strCache>
                <c:ptCount val="1"/>
                <c:pt idx="0">
                  <c:v>cat-1(CB1111)_A3_07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H$105:$H$135</c:f>
              <c:numCache>
                <c:formatCode>General</c:formatCode>
                <c:ptCount val="31"/>
                <c:pt idx="1">
                  <c:v>2.7343750000000007E-2</c:v>
                </c:pt>
                <c:pt idx="2">
                  <c:v>3.125E-2</c:v>
                </c:pt>
                <c:pt idx="3">
                  <c:v>1.9531250000000003E-2</c:v>
                </c:pt>
                <c:pt idx="4">
                  <c:v>2.7343750000000007E-2</c:v>
                </c:pt>
                <c:pt idx="5">
                  <c:v>1.9531250000000003E-2</c:v>
                </c:pt>
                <c:pt idx="6">
                  <c:v>7.8125E-3</c:v>
                </c:pt>
                <c:pt idx="7">
                  <c:v>1.9531250000000003E-2</c:v>
                </c:pt>
                <c:pt idx="8">
                  <c:v>3.125E-2</c:v>
                </c:pt>
                <c:pt idx="9">
                  <c:v>1.1718750000000003E-2</c:v>
                </c:pt>
                <c:pt idx="10">
                  <c:v>1.5625E-2</c:v>
                </c:pt>
                <c:pt idx="11">
                  <c:v>1.5625E-2</c:v>
                </c:pt>
                <c:pt idx="12">
                  <c:v>2.7343750000000007E-2</c:v>
                </c:pt>
                <c:pt idx="13">
                  <c:v>3.90625E-2</c:v>
                </c:pt>
                <c:pt idx="14">
                  <c:v>9.7656250000000028E-2</c:v>
                </c:pt>
                <c:pt idx="15">
                  <c:v>0.12890625000000006</c:v>
                </c:pt>
                <c:pt idx="16">
                  <c:v>9.7656250000000028E-2</c:v>
                </c:pt>
                <c:pt idx="17">
                  <c:v>0.13671875000000006</c:v>
                </c:pt>
                <c:pt idx="18">
                  <c:v>6.25E-2</c:v>
                </c:pt>
                <c:pt idx="19">
                  <c:v>4.6874999999999986E-2</c:v>
                </c:pt>
                <c:pt idx="20">
                  <c:v>4.2968750000000014E-2</c:v>
                </c:pt>
                <c:pt idx="21">
                  <c:v>7.8125E-3</c:v>
                </c:pt>
                <c:pt idx="22">
                  <c:v>1.1718750000000003E-2</c:v>
                </c:pt>
                <c:pt idx="23">
                  <c:v>3.90625E-3</c:v>
                </c:pt>
                <c:pt idx="24">
                  <c:v>3.90625E-3</c:v>
                </c:pt>
                <c:pt idx="25">
                  <c:v>3.90625E-3</c:v>
                </c:pt>
                <c:pt idx="26">
                  <c:v>0</c:v>
                </c:pt>
                <c:pt idx="27">
                  <c:v>0</c:v>
                </c:pt>
                <c:pt idx="28">
                  <c:v>3.90625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cat-1(CB1111)_A3_0.02_50%'!$I$104</c:f>
              <c:strCache>
                <c:ptCount val="1"/>
                <c:pt idx="0">
                  <c:v>cat-1(CB1111)_A3_08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I$105:$I$135</c:f>
              <c:numCache>
                <c:formatCode>General</c:formatCode>
                <c:ptCount val="31"/>
                <c:pt idx="1">
                  <c:v>2.2292993630573209E-2</c:v>
                </c:pt>
                <c:pt idx="2">
                  <c:v>4.777070063694272E-2</c:v>
                </c:pt>
                <c:pt idx="3">
                  <c:v>3.5031847133758016E-2</c:v>
                </c:pt>
                <c:pt idx="4">
                  <c:v>3.1847133757961811E-2</c:v>
                </c:pt>
                <c:pt idx="5">
                  <c:v>4.1401273885350302E-2</c:v>
                </c:pt>
                <c:pt idx="6">
                  <c:v>2.8662420382165599E-2</c:v>
                </c:pt>
                <c:pt idx="7">
                  <c:v>3.8216560509554097E-2</c:v>
                </c:pt>
                <c:pt idx="8">
                  <c:v>2.2292993630573209E-2</c:v>
                </c:pt>
                <c:pt idx="9">
                  <c:v>1.2738853503184698E-2</c:v>
                </c:pt>
                <c:pt idx="10">
                  <c:v>9.5541401273885294E-3</c:v>
                </c:pt>
                <c:pt idx="11">
                  <c:v>3.5031847133758016E-2</c:v>
                </c:pt>
                <c:pt idx="12">
                  <c:v>2.8662420382165599E-2</c:v>
                </c:pt>
                <c:pt idx="13">
                  <c:v>3.8216560509554097E-2</c:v>
                </c:pt>
                <c:pt idx="14">
                  <c:v>6.6878980891719703E-2</c:v>
                </c:pt>
                <c:pt idx="15">
                  <c:v>7.0063694267515922E-2</c:v>
                </c:pt>
                <c:pt idx="16">
                  <c:v>7.6433121019108333E-2</c:v>
                </c:pt>
                <c:pt idx="17">
                  <c:v>9.8726114649681507E-2</c:v>
                </c:pt>
                <c:pt idx="18">
                  <c:v>5.7324840764331197E-2</c:v>
                </c:pt>
                <c:pt idx="19">
                  <c:v>6.3694267515923594E-2</c:v>
                </c:pt>
                <c:pt idx="20">
                  <c:v>2.2292993630573209E-2</c:v>
                </c:pt>
                <c:pt idx="21">
                  <c:v>4.1401273885350302E-2</c:v>
                </c:pt>
                <c:pt idx="22">
                  <c:v>2.2292993630573209E-2</c:v>
                </c:pt>
                <c:pt idx="23">
                  <c:v>2.2292993630573209E-2</c:v>
                </c:pt>
                <c:pt idx="24">
                  <c:v>1.2738853503184698E-2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8"/>
          <c:order val="8"/>
          <c:tx>
            <c:strRef>
              <c:f>'cat-1(CB1111)_A3_0.02_50%'!$J$104</c:f>
              <c:strCache>
                <c:ptCount val="1"/>
                <c:pt idx="0">
                  <c:v>cat-1(CB1111)_A3_09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J$105:$J$135</c:f>
              <c:numCache>
                <c:formatCode>General</c:formatCode>
                <c:ptCount val="31"/>
                <c:pt idx="1">
                  <c:v>4.9222797927461127E-2</c:v>
                </c:pt>
                <c:pt idx="2">
                  <c:v>3.3678756476683898E-2</c:v>
                </c:pt>
                <c:pt idx="3">
                  <c:v>4.9222797927461127E-2</c:v>
                </c:pt>
                <c:pt idx="4">
                  <c:v>4.9222797927461127E-2</c:v>
                </c:pt>
                <c:pt idx="5">
                  <c:v>5.1813471502590719E-2</c:v>
                </c:pt>
                <c:pt idx="6">
                  <c:v>5.4404145077720185E-2</c:v>
                </c:pt>
                <c:pt idx="7">
                  <c:v>2.5906735751295307E-2</c:v>
                </c:pt>
                <c:pt idx="8">
                  <c:v>5.9585492227979313E-2</c:v>
                </c:pt>
                <c:pt idx="9">
                  <c:v>4.1450777202072499E-2</c:v>
                </c:pt>
                <c:pt idx="10">
                  <c:v>3.6269430051813517E-2</c:v>
                </c:pt>
                <c:pt idx="11">
                  <c:v>3.6269430051813517E-2</c:v>
                </c:pt>
                <c:pt idx="12">
                  <c:v>5.1813471502590719E-2</c:v>
                </c:pt>
                <c:pt idx="13">
                  <c:v>6.2176165803108814E-2</c:v>
                </c:pt>
                <c:pt idx="14">
                  <c:v>4.4041450777202083E-2</c:v>
                </c:pt>
                <c:pt idx="15">
                  <c:v>4.6632124352331626E-2</c:v>
                </c:pt>
                <c:pt idx="16">
                  <c:v>8.2901554404145025E-2</c:v>
                </c:pt>
                <c:pt idx="17">
                  <c:v>4.6632124352331626E-2</c:v>
                </c:pt>
                <c:pt idx="18">
                  <c:v>3.3678756476683898E-2</c:v>
                </c:pt>
                <c:pt idx="19">
                  <c:v>2.8497409326424899E-2</c:v>
                </c:pt>
                <c:pt idx="20">
                  <c:v>2.0725388601036301E-2</c:v>
                </c:pt>
                <c:pt idx="21">
                  <c:v>1.5544041450777204E-2</c:v>
                </c:pt>
                <c:pt idx="22">
                  <c:v>1.81347150259067E-2</c:v>
                </c:pt>
                <c:pt idx="23">
                  <c:v>5.1813471502590736E-3</c:v>
                </c:pt>
                <c:pt idx="24">
                  <c:v>2.5906735751295299E-3</c:v>
                </c:pt>
                <c:pt idx="25">
                  <c:v>2.5906735751295299E-3</c:v>
                </c:pt>
                <c:pt idx="26">
                  <c:v>0</c:v>
                </c:pt>
                <c:pt idx="27">
                  <c:v>0</c:v>
                </c:pt>
                <c:pt idx="28">
                  <c:v>2.5906735751295299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cat-1(CB1111)_A3_0.02_50%'!$K$104</c:f>
              <c:strCache>
                <c:ptCount val="1"/>
                <c:pt idx="0">
                  <c:v>cat-1(CB1111)_A3_10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K$105:$K$135</c:f>
              <c:numCache>
                <c:formatCode>General</c:formatCode>
                <c:ptCount val="31"/>
                <c:pt idx="1">
                  <c:v>1.1363636363636404E-2</c:v>
                </c:pt>
                <c:pt idx="2">
                  <c:v>1.1363636363636404E-2</c:v>
                </c:pt>
                <c:pt idx="3">
                  <c:v>1.5151515151515204E-2</c:v>
                </c:pt>
                <c:pt idx="4">
                  <c:v>1.5151515151515204E-2</c:v>
                </c:pt>
                <c:pt idx="5">
                  <c:v>3.7878787878787919E-3</c:v>
                </c:pt>
                <c:pt idx="6">
                  <c:v>7.575757575757582E-3</c:v>
                </c:pt>
                <c:pt idx="7">
                  <c:v>7.575757575757582E-3</c:v>
                </c:pt>
                <c:pt idx="8">
                  <c:v>1.1363636363636404E-2</c:v>
                </c:pt>
                <c:pt idx="9">
                  <c:v>3.7878787878787919E-3</c:v>
                </c:pt>
                <c:pt idx="10">
                  <c:v>0</c:v>
                </c:pt>
                <c:pt idx="11">
                  <c:v>1.1363636363636404E-2</c:v>
                </c:pt>
                <c:pt idx="12">
                  <c:v>2.6515151515151499E-2</c:v>
                </c:pt>
                <c:pt idx="13">
                  <c:v>3.03030303030303E-2</c:v>
                </c:pt>
                <c:pt idx="14">
                  <c:v>6.8181818181818205E-2</c:v>
                </c:pt>
                <c:pt idx="15">
                  <c:v>9.4696969696969766E-2</c:v>
                </c:pt>
                <c:pt idx="16">
                  <c:v>0.12121212121212104</c:v>
                </c:pt>
                <c:pt idx="17">
                  <c:v>0.170454545454545</c:v>
                </c:pt>
                <c:pt idx="18">
                  <c:v>0.13257575757575796</c:v>
                </c:pt>
                <c:pt idx="19">
                  <c:v>8.3333333333333329E-2</c:v>
                </c:pt>
                <c:pt idx="20">
                  <c:v>6.0606060606060601E-2</c:v>
                </c:pt>
                <c:pt idx="21">
                  <c:v>5.3030303030302997E-2</c:v>
                </c:pt>
                <c:pt idx="22">
                  <c:v>1.8939393939393898E-2</c:v>
                </c:pt>
                <c:pt idx="23">
                  <c:v>0</c:v>
                </c:pt>
                <c:pt idx="24">
                  <c:v>1.1363636363636404E-2</c:v>
                </c:pt>
                <c:pt idx="25">
                  <c:v>0</c:v>
                </c:pt>
                <c:pt idx="26">
                  <c:v>3.7878787878787919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cat-1(CB1111)_A3_0.02_50%'!$L$104</c:f>
              <c:strCache>
                <c:ptCount val="1"/>
                <c:pt idx="0">
                  <c:v>cat-1(CB1111)_A3_11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L$105:$L$135</c:f>
              <c:numCache>
                <c:formatCode>General</c:formatCode>
                <c:ptCount val="31"/>
                <c:pt idx="1">
                  <c:v>1.4018691588784996E-2</c:v>
                </c:pt>
                <c:pt idx="2">
                  <c:v>0</c:v>
                </c:pt>
                <c:pt idx="3">
                  <c:v>0</c:v>
                </c:pt>
                <c:pt idx="4">
                  <c:v>4.6728971962616819E-3</c:v>
                </c:pt>
                <c:pt idx="5">
                  <c:v>9.3457943925233673E-3</c:v>
                </c:pt>
                <c:pt idx="6">
                  <c:v>4.6728971962616819E-3</c:v>
                </c:pt>
                <c:pt idx="7">
                  <c:v>4.6728971962616819E-3</c:v>
                </c:pt>
                <c:pt idx="8">
                  <c:v>4.6728971962616819E-3</c:v>
                </c:pt>
                <c:pt idx="9">
                  <c:v>4.6728971962616819E-3</c:v>
                </c:pt>
                <c:pt idx="10">
                  <c:v>2.8037383177570117E-2</c:v>
                </c:pt>
                <c:pt idx="11">
                  <c:v>4.6728971962616821E-2</c:v>
                </c:pt>
                <c:pt idx="12">
                  <c:v>6.0747663551401918E-2</c:v>
                </c:pt>
                <c:pt idx="13">
                  <c:v>0.11214953271028003</c:v>
                </c:pt>
                <c:pt idx="14">
                  <c:v>0.11682242990654203</c:v>
                </c:pt>
                <c:pt idx="15">
                  <c:v>0.12616822429906493</c:v>
                </c:pt>
                <c:pt idx="16">
                  <c:v>0.18691588785046717</c:v>
                </c:pt>
                <c:pt idx="17">
                  <c:v>7.0093457943925255E-2</c:v>
                </c:pt>
                <c:pt idx="18">
                  <c:v>0.10280373831775701</c:v>
                </c:pt>
                <c:pt idx="19">
                  <c:v>3.27102803738318E-2</c:v>
                </c:pt>
                <c:pt idx="20">
                  <c:v>1.8691588785046703E-2</c:v>
                </c:pt>
                <c:pt idx="21">
                  <c:v>1.4018691588784996E-2</c:v>
                </c:pt>
                <c:pt idx="22">
                  <c:v>1.4018691588784996E-2</c:v>
                </c:pt>
                <c:pt idx="23">
                  <c:v>4.6728971962616819E-3</c:v>
                </c:pt>
                <c:pt idx="24">
                  <c:v>0</c:v>
                </c:pt>
                <c:pt idx="25">
                  <c:v>4.6728971962616819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cat-1(CB1111)_A3_0.02_50%'!$M$104</c:f>
              <c:strCache>
                <c:ptCount val="1"/>
                <c:pt idx="0">
                  <c:v>cat-1(CB1111)_A3_12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M$105:$M$135</c:f>
              <c:numCache>
                <c:formatCode>General</c:formatCode>
                <c:ptCount val="31"/>
                <c:pt idx="1">
                  <c:v>1.2048192771084298E-2</c:v>
                </c:pt>
                <c:pt idx="2">
                  <c:v>0</c:v>
                </c:pt>
                <c:pt idx="3">
                  <c:v>0</c:v>
                </c:pt>
                <c:pt idx="4">
                  <c:v>4.0160642570281095E-3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8.0321285140562207E-3</c:v>
                </c:pt>
                <c:pt idx="9">
                  <c:v>2.00803212851406E-2</c:v>
                </c:pt>
                <c:pt idx="10">
                  <c:v>2.00803212851406E-2</c:v>
                </c:pt>
                <c:pt idx="11">
                  <c:v>2.00803212851406E-2</c:v>
                </c:pt>
                <c:pt idx="12">
                  <c:v>6.4257028112449793E-2</c:v>
                </c:pt>
                <c:pt idx="13">
                  <c:v>0.100401606425703</c:v>
                </c:pt>
                <c:pt idx="14">
                  <c:v>0.11646586345381503</c:v>
                </c:pt>
                <c:pt idx="15">
                  <c:v>0.160642570281124</c:v>
                </c:pt>
                <c:pt idx="16">
                  <c:v>0.1285140562249</c:v>
                </c:pt>
                <c:pt idx="17">
                  <c:v>0.104417670682731</c:v>
                </c:pt>
                <c:pt idx="18">
                  <c:v>8.4337349397590466E-2</c:v>
                </c:pt>
                <c:pt idx="19">
                  <c:v>4.8192771084337421E-2</c:v>
                </c:pt>
                <c:pt idx="20">
                  <c:v>2.40963855421687E-2</c:v>
                </c:pt>
                <c:pt idx="21">
                  <c:v>2.00803212851406E-2</c:v>
                </c:pt>
                <c:pt idx="22">
                  <c:v>2.811244979919679E-2</c:v>
                </c:pt>
                <c:pt idx="23">
                  <c:v>1.2048192771084298E-2</c:v>
                </c:pt>
                <c:pt idx="24">
                  <c:v>8.0321285140562207E-3</c:v>
                </c:pt>
                <c:pt idx="25">
                  <c:v>4.0160642570281095E-3</c:v>
                </c:pt>
                <c:pt idx="26">
                  <c:v>0</c:v>
                </c:pt>
                <c:pt idx="27">
                  <c:v>8.0321285140562207E-3</c:v>
                </c:pt>
                <c:pt idx="28">
                  <c:v>4.0160642570281095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cat-1(CB1111)_A3_0.02_50%'!$N$104</c:f>
              <c:strCache>
                <c:ptCount val="1"/>
                <c:pt idx="0">
                  <c:v>cat-1(CB1111)_A3_13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N$105:$N$135</c:f>
              <c:numCache>
                <c:formatCode>General</c:formatCode>
                <c:ptCount val="31"/>
                <c:pt idx="1">
                  <c:v>1.5789473684210506E-2</c:v>
                </c:pt>
                <c:pt idx="2">
                  <c:v>1.05263157894737E-2</c:v>
                </c:pt>
                <c:pt idx="3">
                  <c:v>1.5789473684210506E-2</c:v>
                </c:pt>
                <c:pt idx="4">
                  <c:v>5.263157894736842E-3</c:v>
                </c:pt>
                <c:pt idx="5">
                  <c:v>5.263157894736842E-3</c:v>
                </c:pt>
                <c:pt idx="6">
                  <c:v>1.5789473684210506E-2</c:v>
                </c:pt>
                <c:pt idx="7">
                  <c:v>5.263157894736842E-3</c:v>
                </c:pt>
                <c:pt idx="8">
                  <c:v>1.5789473684210506E-2</c:v>
                </c:pt>
                <c:pt idx="9">
                  <c:v>1.05263157894737E-2</c:v>
                </c:pt>
                <c:pt idx="10">
                  <c:v>1.05263157894737E-2</c:v>
                </c:pt>
                <c:pt idx="11">
                  <c:v>1.5789473684210506E-2</c:v>
                </c:pt>
                <c:pt idx="12">
                  <c:v>2.1052631578947399E-2</c:v>
                </c:pt>
                <c:pt idx="13">
                  <c:v>5.2631578947368404E-2</c:v>
                </c:pt>
                <c:pt idx="14">
                  <c:v>0.12105263157894702</c:v>
                </c:pt>
                <c:pt idx="15">
                  <c:v>0.105263157894737</c:v>
                </c:pt>
                <c:pt idx="16">
                  <c:v>0.105263157894737</c:v>
                </c:pt>
                <c:pt idx="17">
                  <c:v>8.9473684210526233E-2</c:v>
                </c:pt>
                <c:pt idx="18">
                  <c:v>0.110526315789474</c:v>
                </c:pt>
                <c:pt idx="19">
                  <c:v>8.4210526315789527E-2</c:v>
                </c:pt>
                <c:pt idx="20">
                  <c:v>3.1578947368421116E-2</c:v>
                </c:pt>
                <c:pt idx="21">
                  <c:v>4.2105263157894701E-2</c:v>
                </c:pt>
                <c:pt idx="22">
                  <c:v>2.1052631578947399E-2</c:v>
                </c:pt>
                <c:pt idx="23">
                  <c:v>5.263157894736842E-3</c:v>
                </c:pt>
                <c:pt idx="24">
                  <c:v>1.05263157894737E-2</c:v>
                </c:pt>
                <c:pt idx="25">
                  <c:v>1.05263157894737E-2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5.263157894736842E-3</c:v>
                </c:pt>
                <c:pt idx="30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cat-1(CB1111)_A3_0.02_50%'!$O$104</c:f>
              <c:strCache>
                <c:ptCount val="1"/>
                <c:pt idx="0">
                  <c:v>cat-1(CB1111)_A3_14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O$105:$O$135</c:f>
              <c:numCache>
                <c:formatCode>General</c:formatCode>
                <c:ptCount val="31"/>
                <c:pt idx="1">
                  <c:v>5.8139534883720921E-3</c:v>
                </c:pt>
                <c:pt idx="2">
                  <c:v>1.7441860465116307E-2</c:v>
                </c:pt>
                <c:pt idx="3">
                  <c:v>0</c:v>
                </c:pt>
                <c:pt idx="4">
                  <c:v>5.8139534883720921E-3</c:v>
                </c:pt>
                <c:pt idx="5">
                  <c:v>5.8139534883720921E-3</c:v>
                </c:pt>
                <c:pt idx="6">
                  <c:v>5.8139534883720921E-3</c:v>
                </c:pt>
                <c:pt idx="7">
                  <c:v>5.8139534883720921E-3</c:v>
                </c:pt>
                <c:pt idx="8">
                  <c:v>5.8139534883720921E-3</c:v>
                </c:pt>
                <c:pt idx="9">
                  <c:v>1.1627906976744195E-2</c:v>
                </c:pt>
                <c:pt idx="10">
                  <c:v>5.8139534883720921E-3</c:v>
                </c:pt>
                <c:pt idx="11">
                  <c:v>2.32558139534884E-2</c:v>
                </c:pt>
                <c:pt idx="12">
                  <c:v>4.6511627906976737E-2</c:v>
                </c:pt>
                <c:pt idx="13">
                  <c:v>5.2325581395348819E-2</c:v>
                </c:pt>
                <c:pt idx="14">
                  <c:v>7.5581395348837233E-2</c:v>
                </c:pt>
                <c:pt idx="15">
                  <c:v>0.14534883720930206</c:v>
                </c:pt>
                <c:pt idx="16">
                  <c:v>9.8837209302325604E-2</c:v>
                </c:pt>
                <c:pt idx="17">
                  <c:v>0.104651162790698</c:v>
                </c:pt>
                <c:pt idx="18">
                  <c:v>9.3023255813953501E-2</c:v>
                </c:pt>
                <c:pt idx="19">
                  <c:v>8.1395348837209336E-2</c:v>
                </c:pt>
                <c:pt idx="20">
                  <c:v>4.0697674418604717E-2</c:v>
                </c:pt>
                <c:pt idx="21">
                  <c:v>4.0697674418604717E-2</c:v>
                </c:pt>
                <c:pt idx="22">
                  <c:v>1.1627906976744195E-2</c:v>
                </c:pt>
                <c:pt idx="23">
                  <c:v>1.1627906976744195E-2</c:v>
                </c:pt>
                <c:pt idx="24">
                  <c:v>5.8139534883720921E-3</c:v>
                </c:pt>
                <c:pt idx="25">
                  <c:v>1.1627906976744195E-2</c:v>
                </c:pt>
                <c:pt idx="26">
                  <c:v>1.7441860465116307E-2</c:v>
                </c:pt>
                <c:pt idx="27">
                  <c:v>5.8139534883720921E-3</c:v>
                </c:pt>
                <c:pt idx="28">
                  <c:v>0</c:v>
                </c:pt>
                <c:pt idx="29">
                  <c:v>1.1627906976744195E-2</c:v>
                </c:pt>
                <c:pt idx="30">
                  <c:v>0</c:v>
                </c:pt>
              </c:numCache>
            </c:numRef>
          </c:val>
        </c:ser>
        <c:ser>
          <c:idx val="14"/>
          <c:order val="14"/>
          <c:tx>
            <c:strRef>
              <c:f>'cat-1(CB1111)_A3_0.02_50%'!$P$104</c:f>
              <c:strCache>
                <c:ptCount val="1"/>
                <c:pt idx="0">
                  <c:v>cat-1(CB1111)_A3_15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P$105:$P$135</c:f>
              <c:numCache>
                <c:formatCode>General</c:formatCode>
                <c:ptCount val="31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.6363636363636398E-3</c:v>
                </c:pt>
                <c:pt idx="6">
                  <c:v>0</c:v>
                </c:pt>
                <c:pt idx="7">
                  <c:v>3.6363636363636398E-3</c:v>
                </c:pt>
                <c:pt idx="8">
                  <c:v>0</c:v>
                </c:pt>
                <c:pt idx="9">
                  <c:v>3.6363636363636398E-3</c:v>
                </c:pt>
                <c:pt idx="10">
                  <c:v>2.5454545454545514E-2</c:v>
                </c:pt>
                <c:pt idx="11">
                  <c:v>7.6363636363636453E-2</c:v>
                </c:pt>
                <c:pt idx="12">
                  <c:v>8.3636363636363675E-2</c:v>
                </c:pt>
                <c:pt idx="13">
                  <c:v>0.123636363636364</c:v>
                </c:pt>
                <c:pt idx="14">
                  <c:v>0.14181818181818207</c:v>
                </c:pt>
                <c:pt idx="15">
                  <c:v>0.19636363636363593</c:v>
                </c:pt>
                <c:pt idx="16">
                  <c:v>0.11636363636363603</c:v>
                </c:pt>
                <c:pt idx="17">
                  <c:v>6.9090909090909119E-2</c:v>
                </c:pt>
                <c:pt idx="18">
                  <c:v>6.9090909090909119E-2</c:v>
                </c:pt>
                <c:pt idx="19">
                  <c:v>3.2727272727272723E-2</c:v>
                </c:pt>
                <c:pt idx="20">
                  <c:v>2.5454545454545514E-2</c:v>
                </c:pt>
                <c:pt idx="21">
                  <c:v>1.0909090909090898E-2</c:v>
                </c:pt>
                <c:pt idx="22">
                  <c:v>0</c:v>
                </c:pt>
                <c:pt idx="23">
                  <c:v>0</c:v>
                </c:pt>
                <c:pt idx="24">
                  <c:v>3.6363636363636398E-3</c:v>
                </c:pt>
                <c:pt idx="25">
                  <c:v>3.6363636363636398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5"/>
          <c:order val="15"/>
          <c:tx>
            <c:strRef>
              <c:f>'cat-1(CB1111)_A3_0.02_50%'!$Q$104</c:f>
              <c:strCache>
                <c:ptCount val="1"/>
                <c:pt idx="0">
                  <c:v>cat-1(CB1111)_A3_16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Q$105:$Q$135</c:f>
              <c:numCache>
                <c:formatCode>General</c:formatCode>
                <c:ptCount val="31"/>
                <c:pt idx="1">
                  <c:v>3.355704697986581E-3</c:v>
                </c:pt>
                <c:pt idx="2">
                  <c:v>6.711409395973156E-3</c:v>
                </c:pt>
                <c:pt idx="3">
                  <c:v>3.355704697986581E-3</c:v>
                </c:pt>
                <c:pt idx="4">
                  <c:v>0</c:v>
                </c:pt>
                <c:pt idx="5">
                  <c:v>3.355704697986581E-3</c:v>
                </c:pt>
                <c:pt idx="6">
                  <c:v>3.355704697986581E-3</c:v>
                </c:pt>
                <c:pt idx="7">
                  <c:v>0</c:v>
                </c:pt>
                <c:pt idx="8">
                  <c:v>0</c:v>
                </c:pt>
                <c:pt idx="9">
                  <c:v>1.00671140939597E-2</c:v>
                </c:pt>
                <c:pt idx="10">
                  <c:v>1.3422818791946301E-2</c:v>
                </c:pt>
                <c:pt idx="11">
                  <c:v>3.35570469798658E-2</c:v>
                </c:pt>
                <c:pt idx="12">
                  <c:v>7.718120805369133E-2</c:v>
                </c:pt>
                <c:pt idx="13">
                  <c:v>0.12416107382550304</c:v>
                </c:pt>
                <c:pt idx="14">
                  <c:v>0.12080536912751701</c:v>
                </c:pt>
                <c:pt idx="15">
                  <c:v>0.12416107382550304</c:v>
                </c:pt>
                <c:pt idx="16">
                  <c:v>0.11073825503355703</c:v>
                </c:pt>
                <c:pt idx="17">
                  <c:v>0.12751677852349005</c:v>
                </c:pt>
                <c:pt idx="18">
                  <c:v>9.7315436241610695E-2</c:v>
                </c:pt>
                <c:pt idx="19">
                  <c:v>4.6979865771812061E-2</c:v>
                </c:pt>
                <c:pt idx="20">
                  <c:v>3.35570469798658E-2</c:v>
                </c:pt>
                <c:pt idx="21">
                  <c:v>3.0201342281879227E-2</c:v>
                </c:pt>
                <c:pt idx="22">
                  <c:v>6.711409395973156E-3</c:v>
                </c:pt>
                <c:pt idx="23">
                  <c:v>3.355704697986581E-3</c:v>
                </c:pt>
                <c:pt idx="24">
                  <c:v>0</c:v>
                </c:pt>
                <c:pt idx="25">
                  <c:v>3.355704697986581E-3</c:v>
                </c:pt>
                <c:pt idx="26">
                  <c:v>3.355704697986581E-3</c:v>
                </c:pt>
                <c:pt idx="27">
                  <c:v>0</c:v>
                </c:pt>
                <c:pt idx="28">
                  <c:v>0</c:v>
                </c:pt>
                <c:pt idx="29">
                  <c:v>3.355704697986581E-3</c:v>
                </c:pt>
                <c:pt idx="30">
                  <c:v>0</c:v>
                </c:pt>
              </c:numCache>
            </c:numRef>
          </c:val>
        </c:ser>
        <c:ser>
          <c:idx val="16"/>
          <c:order val="16"/>
          <c:tx>
            <c:strRef>
              <c:f>'cat-1(CB1111)_A3_0.02_50%'!$R$104</c:f>
              <c:strCache>
                <c:ptCount val="1"/>
                <c:pt idx="0">
                  <c:v>cat-1(CB1111)_A3_17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R$105:$R$135</c:f>
              <c:numCache>
                <c:formatCode>General</c:formatCode>
                <c:ptCount val="31"/>
                <c:pt idx="1">
                  <c:v>3.4843205574912927E-3</c:v>
                </c:pt>
                <c:pt idx="2">
                  <c:v>3.4843205574912927E-3</c:v>
                </c:pt>
                <c:pt idx="3">
                  <c:v>0</c:v>
                </c:pt>
                <c:pt idx="4">
                  <c:v>0</c:v>
                </c:pt>
                <c:pt idx="5">
                  <c:v>3.4843205574912927E-3</c:v>
                </c:pt>
                <c:pt idx="6">
                  <c:v>0</c:v>
                </c:pt>
                <c:pt idx="7">
                  <c:v>3.4843205574912927E-3</c:v>
                </c:pt>
                <c:pt idx="8">
                  <c:v>0</c:v>
                </c:pt>
                <c:pt idx="9">
                  <c:v>3.4843205574912927E-3</c:v>
                </c:pt>
                <c:pt idx="10">
                  <c:v>2.0905923344947692E-2</c:v>
                </c:pt>
                <c:pt idx="11">
                  <c:v>5.9233449477351902E-2</c:v>
                </c:pt>
                <c:pt idx="12">
                  <c:v>8.7108013937282208E-2</c:v>
                </c:pt>
                <c:pt idx="13">
                  <c:v>0.101045296167247</c:v>
                </c:pt>
                <c:pt idx="14">
                  <c:v>0.18118466898954688</c:v>
                </c:pt>
                <c:pt idx="15">
                  <c:v>0.13240418118466907</c:v>
                </c:pt>
                <c:pt idx="16">
                  <c:v>0.101045296167247</c:v>
                </c:pt>
                <c:pt idx="17">
                  <c:v>0.10452961672473902</c:v>
                </c:pt>
                <c:pt idx="18">
                  <c:v>9.0592334494773524E-2</c:v>
                </c:pt>
                <c:pt idx="19">
                  <c:v>4.1811846689895481E-2</c:v>
                </c:pt>
                <c:pt idx="20">
                  <c:v>2.4390243902439001E-2</c:v>
                </c:pt>
                <c:pt idx="21">
                  <c:v>1.0452961672473898E-2</c:v>
                </c:pt>
                <c:pt idx="22">
                  <c:v>6.9686411149825853E-3</c:v>
                </c:pt>
                <c:pt idx="23">
                  <c:v>3.4843205574912927E-3</c:v>
                </c:pt>
                <c:pt idx="24">
                  <c:v>0</c:v>
                </c:pt>
                <c:pt idx="25">
                  <c:v>0</c:v>
                </c:pt>
                <c:pt idx="26">
                  <c:v>3.4843205574912927E-3</c:v>
                </c:pt>
                <c:pt idx="27">
                  <c:v>3.4843205574912927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cat-1(CB1111)_A3_0.02_50%'!$S$104</c:f>
              <c:strCache>
                <c:ptCount val="1"/>
                <c:pt idx="0">
                  <c:v>cat-1(CB1111)_A3_18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S$105:$S$135</c:f>
              <c:numCache>
                <c:formatCode>General</c:formatCode>
                <c:ptCount val="31"/>
                <c:pt idx="1">
                  <c:v>3.8910505836575902E-3</c:v>
                </c:pt>
                <c:pt idx="2">
                  <c:v>0</c:v>
                </c:pt>
                <c:pt idx="3">
                  <c:v>0</c:v>
                </c:pt>
                <c:pt idx="4">
                  <c:v>3.8910505836575902E-3</c:v>
                </c:pt>
                <c:pt idx="5">
                  <c:v>0</c:v>
                </c:pt>
                <c:pt idx="6">
                  <c:v>3.8910505836575902E-3</c:v>
                </c:pt>
                <c:pt idx="7">
                  <c:v>1.1673151750972804E-2</c:v>
                </c:pt>
                <c:pt idx="8">
                  <c:v>7.7821011673151804E-3</c:v>
                </c:pt>
                <c:pt idx="9">
                  <c:v>1.1673151750972804E-2</c:v>
                </c:pt>
                <c:pt idx="10">
                  <c:v>7.7821011673151804E-3</c:v>
                </c:pt>
                <c:pt idx="11">
                  <c:v>4.2801556420233512E-2</c:v>
                </c:pt>
                <c:pt idx="12">
                  <c:v>7.3929961089494206E-2</c:v>
                </c:pt>
                <c:pt idx="13">
                  <c:v>0.10505836575875498</c:v>
                </c:pt>
                <c:pt idx="14">
                  <c:v>0.11284046692607</c:v>
                </c:pt>
                <c:pt idx="15">
                  <c:v>0.15953307392996099</c:v>
                </c:pt>
                <c:pt idx="16">
                  <c:v>0.15175097276264601</c:v>
                </c:pt>
                <c:pt idx="17">
                  <c:v>0.10116731517509697</c:v>
                </c:pt>
                <c:pt idx="18">
                  <c:v>5.0583657587548618E-2</c:v>
                </c:pt>
                <c:pt idx="19">
                  <c:v>6.6147859922178989E-2</c:v>
                </c:pt>
                <c:pt idx="20">
                  <c:v>2.3346303501945501E-2</c:v>
                </c:pt>
                <c:pt idx="21">
                  <c:v>3.5019455252918302E-2</c:v>
                </c:pt>
                <c:pt idx="22">
                  <c:v>0</c:v>
                </c:pt>
                <c:pt idx="23">
                  <c:v>1.1673151750972804E-2</c:v>
                </c:pt>
                <c:pt idx="24">
                  <c:v>0</c:v>
                </c:pt>
                <c:pt idx="25">
                  <c:v>1.1673151750972804E-2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8"/>
          <c:order val="18"/>
          <c:tx>
            <c:strRef>
              <c:f>'cat-1(CB1111)_A3_0.02_50%'!$T$104</c:f>
              <c:strCache>
                <c:ptCount val="1"/>
                <c:pt idx="0">
                  <c:v>cat-1(CB1111)_A3_19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T$105:$T$135</c:f>
              <c:numCache>
                <c:formatCode>General</c:formatCode>
                <c:ptCount val="31"/>
                <c:pt idx="1">
                  <c:v>1.1799410029498499E-2</c:v>
                </c:pt>
                <c:pt idx="2">
                  <c:v>2.9498525073746299E-3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9498525073746299E-3</c:v>
                </c:pt>
                <c:pt idx="7">
                  <c:v>5.8997050147492625E-3</c:v>
                </c:pt>
                <c:pt idx="8">
                  <c:v>2.9498525073746299E-3</c:v>
                </c:pt>
                <c:pt idx="9">
                  <c:v>5.8997050147492625E-3</c:v>
                </c:pt>
                <c:pt idx="10">
                  <c:v>2.9498525073746299E-3</c:v>
                </c:pt>
                <c:pt idx="11">
                  <c:v>5.8997050147492625E-3</c:v>
                </c:pt>
                <c:pt idx="12">
                  <c:v>2.6548672566371709E-2</c:v>
                </c:pt>
                <c:pt idx="13">
                  <c:v>7.9646017699115002E-2</c:v>
                </c:pt>
                <c:pt idx="14">
                  <c:v>0.10324483775811204</c:v>
                </c:pt>
                <c:pt idx="15">
                  <c:v>0.13864306784660799</c:v>
                </c:pt>
                <c:pt idx="16">
                  <c:v>0.13274336283185806</c:v>
                </c:pt>
                <c:pt idx="17">
                  <c:v>0.17109144542772911</c:v>
                </c:pt>
                <c:pt idx="18">
                  <c:v>7.9646017699115002E-2</c:v>
                </c:pt>
                <c:pt idx="19">
                  <c:v>7.0796460176991122E-2</c:v>
                </c:pt>
                <c:pt idx="20">
                  <c:v>4.1297935103244802E-2</c:v>
                </c:pt>
                <c:pt idx="21">
                  <c:v>3.244837758112093E-2</c:v>
                </c:pt>
                <c:pt idx="22">
                  <c:v>4.1297935103244802E-2</c:v>
                </c:pt>
                <c:pt idx="23">
                  <c:v>1.1799410029498499E-2</c:v>
                </c:pt>
                <c:pt idx="24">
                  <c:v>1.1799410029498499E-2</c:v>
                </c:pt>
                <c:pt idx="25">
                  <c:v>5.8997050147492625E-3</c:v>
                </c:pt>
                <c:pt idx="26">
                  <c:v>0</c:v>
                </c:pt>
                <c:pt idx="27">
                  <c:v>2.9498525073746299E-3</c:v>
                </c:pt>
                <c:pt idx="28">
                  <c:v>2.9498525073746299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9"/>
          <c:order val="19"/>
          <c:tx>
            <c:strRef>
              <c:f>'cat-1(CB1111)_A3_0.02_50%'!$U$104</c:f>
              <c:strCache>
                <c:ptCount val="1"/>
                <c:pt idx="0">
                  <c:v>cat-1(CB1111)_A3_20</c:v>
                </c:pt>
              </c:strCache>
            </c:strRef>
          </c:tx>
          <c:marker>
            <c:symbol val="none"/>
          </c:marker>
          <c:cat>
            <c:numRef>
              <c:f>'cat-1(CB1111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3_0.02_50%'!$U$105:$U$135</c:f>
              <c:numCache>
                <c:formatCode>General</c:formatCode>
                <c:ptCount val="31"/>
                <c:pt idx="1">
                  <c:v>3.7542662116041001E-2</c:v>
                </c:pt>
                <c:pt idx="2">
                  <c:v>1.3651877133105804E-2</c:v>
                </c:pt>
                <c:pt idx="3">
                  <c:v>1.0238907849829398E-2</c:v>
                </c:pt>
                <c:pt idx="4">
                  <c:v>6.8259385665528976E-3</c:v>
                </c:pt>
                <c:pt idx="5">
                  <c:v>1.0238907849829398E-2</c:v>
                </c:pt>
                <c:pt idx="6">
                  <c:v>0</c:v>
                </c:pt>
                <c:pt idx="7">
                  <c:v>6.8259385665528976E-3</c:v>
                </c:pt>
                <c:pt idx="8">
                  <c:v>1.0238907849829398E-2</c:v>
                </c:pt>
                <c:pt idx="9">
                  <c:v>6.8259385665528976E-3</c:v>
                </c:pt>
                <c:pt idx="10">
                  <c:v>6.8259385665528976E-3</c:v>
                </c:pt>
                <c:pt idx="11">
                  <c:v>6.8259385665528976E-3</c:v>
                </c:pt>
                <c:pt idx="12">
                  <c:v>1.0238907849829398E-2</c:v>
                </c:pt>
                <c:pt idx="13">
                  <c:v>1.0238907849829398E-2</c:v>
                </c:pt>
                <c:pt idx="14">
                  <c:v>2.3890784982935197E-2</c:v>
                </c:pt>
                <c:pt idx="15">
                  <c:v>4.0955631399317419E-2</c:v>
                </c:pt>
                <c:pt idx="16">
                  <c:v>7.8498293515358433E-2</c:v>
                </c:pt>
                <c:pt idx="17">
                  <c:v>0.112627986348123</c:v>
                </c:pt>
                <c:pt idx="18">
                  <c:v>6.1433447098976114E-2</c:v>
                </c:pt>
                <c:pt idx="19">
                  <c:v>0.119453924914676</c:v>
                </c:pt>
                <c:pt idx="20">
                  <c:v>0.10580204778157005</c:v>
                </c:pt>
                <c:pt idx="21">
                  <c:v>5.8020477815699717E-2</c:v>
                </c:pt>
                <c:pt idx="22">
                  <c:v>7.16723549488055E-2</c:v>
                </c:pt>
                <c:pt idx="23">
                  <c:v>4.0955631399317419E-2</c:v>
                </c:pt>
                <c:pt idx="24">
                  <c:v>3.4129692832764499E-2</c:v>
                </c:pt>
                <c:pt idx="25">
                  <c:v>2.3890784982935197E-2</c:v>
                </c:pt>
                <c:pt idx="26">
                  <c:v>3.4129692832764499E-2</c:v>
                </c:pt>
                <c:pt idx="27">
                  <c:v>6.8259385665528976E-3</c:v>
                </c:pt>
                <c:pt idx="28">
                  <c:v>6.8259385665528976E-3</c:v>
                </c:pt>
                <c:pt idx="29">
                  <c:v>3.412969283276451E-3</c:v>
                </c:pt>
                <c:pt idx="30">
                  <c:v>3.412969283276451E-3</c:v>
                </c:pt>
              </c:numCache>
            </c:numRef>
          </c:val>
        </c:ser>
        <c:marker val="1"/>
        <c:axId val="168707584"/>
        <c:axId val="168709120"/>
      </c:lineChart>
      <c:catAx>
        <c:axId val="168707584"/>
        <c:scaling>
          <c:orientation val="minMax"/>
        </c:scaling>
        <c:axPos val="b"/>
        <c:numFmt formatCode="0.0_ " sourceLinked="1"/>
        <c:tickLblPos val="nextTo"/>
        <c:crossAx val="168709120"/>
        <c:crosses val="autoZero"/>
        <c:auto val="1"/>
        <c:lblAlgn val="ctr"/>
        <c:lblOffset val="100"/>
        <c:tickLblSkip val="5"/>
        <c:tickMarkSkip val="5"/>
      </c:catAx>
      <c:valAx>
        <c:axId val="168709120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8707584"/>
        <c:crosses val="autoZero"/>
        <c:crossBetween val="between"/>
      </c:valAx>
    </c:plotArea>
    <c:plotVisOnly val="1"/>
  </c:chart>
  <c:externalData r:id="rId1"/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cat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1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cat-1(CB1111)_A1_0.02_50%'!$B$104</c:f>
              <c:strCache>
                <c:ptCount val="1"/>
                <c:pt idx="0">
                  <c:v>cat-1(CB1111)_A1_01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B$105:$B$135</c:f>
              <c:numCache>
                <c:formatCode>General</c:formatCode>
                <c:ptCount val="31"/>
                <c:pt idx="1">
                  <c:v>4.1237113402061883E-2</c:v>
                </c:pt>
                <c:pt idx="2">
                  <c:v>6.18556701030928E-2</c:v>
                </c:pt>
                <c:pt idx="3">
                  <c:v>6.18556701030928E-2</c:v>
                </c:pt>
                <c:pt idx="4">
                  <c:v>4.1237113402061883E-2</c:v>
                </c:pt>
                <c:pt idx="5">
                  <c:v>1.0309278350515504E-2</c:v>
                </c:pt>
                <c:pt idx="6">
                  <c:v>1.0309278350515504E-2</c:v>
                </c:pt>
                <c:pt idx="7">
                  <c:v>3.09278350515464E-2</c:v>
                </c:pt>
                <c:pt idx="8">
                  <c:v>3.09278350515464E-2</c:v>
                </c:pt>
                <c:pt idx="9">
                  <c:v>3.09278350515464E-2</c:v>
                </c:pt>
                <c:pt idx="10">
                  <c:v>2.0618556701030889E-2</c:v>
                </c:pt>
                <c:pt idx="11">
                  <c:v>3.09278350515464E-2</c:v>
                </c:pt>
                <c:pt idx="12">
                  <c:v>1.0309278350515504E-2</c:v>
                </c:pt>
                <c:pt idx="13">
                  <c:v>4.1237113402061883E-2</c:v>
                </c:pt>
                <c:pt idx="14">
                  <c:v>3.09278350515464E-2</c:v>
                </c:pt>
                <c:pt idx="15">
                  <c:v>3.09278350515464E-2</c:v>
                </c:pt>
                <c:pt idx="16">
                  <c:v>6.18556701030928E-2</c:v>
                </c:pt>
                <c:pt idx="17">
                  <c:v>5.1546391752577303E-2</c:v>
                </c:pt>
                <c:pt idx="18">
                  <c:v>4.1237113402061883E-2</c:v>
                </c:pt>
                <c:pt idx="19">
                  <c:v>5.1546391752577303E-2</c:v>
                </c:pt>
                <c:pt idx="20">
                  <c:v>4.1237113402061883E-2</c:v>
                </c:pt>
                <c:pt idx="21">
                  <c:v>2.0618556701030889E-2</c:v>
                </c:pt>
                <c:pt idx="22">
                  <c:v>1.0309278350515504E-2</c:v>
                </c:pt>
                <c:pt idx="23">
                  <c:v>3.09278350515464E-2</c:v>
                </c:pt>
                <c:pt idx="24">
                  <c:v>0</c:v>
                </c:pt>
                <c:pt idx="25">
                  <c:v>0</c:v>
                </c:pt>
                <c:pt idx="26">
                  <c:v>1.0309278350515504E-2</c:v>
                </c:pt>
                <c:pt idx="27">
                  <c:v>1.0309278350515504E-2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"/>
          <c:order val="1"/>
          <c:tx>
            <c:strRef>
              <c:f>'cat-1(CB1111)_A1_0.02_50%'!$C$104</c:f>
              <c:strCache>
                <c:ptCount val="1"/>
                <c:pt idx="0">
                  <c:v>cat-1(CB1111)_A1_02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C$105:$C$135</c:f>
              <c:numCache>
                <c:formatCode>General</c:formatCode>
                <c:ptCount val="31"/>
                <c:pt idx="1">
                  <c:v>4.7101449275362285E-2</c:v>
                </c:pt>
                <c:pt idx="2">
                  <c:v>5.7971014492753603E-2</c:v>
                </c:pt>
                <c:pt idx="3">
                  <c:v>2.8985507246376802E-2</c:v>
                </c:pt>
                <c:pt idx="4">
                  <c:v>3.2608695652173912E-2</c:v>
                </c:pt>
                <c:pt idx="5">
                  <c:v>3.6231884057971016E-2</c:v>
                </c:pt>
                <c:pt idx="6">
                  <c:v>5.4347826086956499E-2</c:v>
                </c:pt>
                <c:pt idx="7">
                  <c:v>6.5217391304347824E-2</c:v>
                </c:pt>
                <c:pt idx="8">
                  <c:v>3.9855072463768113E-2</c:v>
                </c:pt>
                <c:pt idx="9">
                  <c:v>3.6231884057971016E-2</c:v>
                </c:pt>
                <c:pt idx="10">
                  <c:v>5.0724637681159403E-2</c:v>
                </c:pt>
                <c:pt idx="11">
                  <c:v>7.2463768115942032E-2</c:v>
                </c:pt>
                <c:pt idx="12">
                  <c:v>5.4347826086956499E-2</c:v>
                </c:pt>
                <c:pt idx="13">
                  <c:v>3.2608695652173912E-2</c:v>
                </c:pt>
                <c:pt idx="14">
                  <c:v>2.8985507246376802E-2</c:v>
                </c:pt>
                <c:pt idx="15">
                  <c:v>3.6231884057971016E-2</c:v>
                </c:pt>
                <c:pt idx="16">
                  <c:v>4.3478260869565202E-2</c:v>
                </c:pt>
                <c:pt idx="17">
                  <c:v>2.8985507246376802E-2</c:v>
                </c:pt>
                <c:pt idx="18">
                  <c:v>2.1739130434782601E-2</c:v>
                </c:pt>
                <c:pt idx="19">
                  <c:v>2.5362318840579712E-2</c:v>
                </c:pt>
                <c:pt idx="20">
                  <c:v>3.6231884057971011E-3</c:v>
                </c:pt>
                <c:pt idx="21">
                  <c:v>2.5362318840579712E-2</c:v>
                </c:pt>
                <c:pt idx="22">
                  <c:v>1.4492753623188401E-2</c:v>
                </c:pt>
                <c:pt idx="23">
                  <c:v>1.0869565217391306E-2</c:v>
                </c:pt>
                <c:pt idx="24">
                  <c:v>1.0869565217391306E-2</c:v>
                </c:pt>
                <c:pt idx="25">
                  <c:v>1.0869565217391306E-2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3.6231884057971011E-3</c:v>
                </c:pt>
              </c:numCache>
            </c:numRef>
          </c:val>
        </c:ser>
        <c:ser>
          <c:idx val="2"/>
          <c:order val="2"/>
          <c:tx>
            <c:strRef>
              <c:f>'cat-1(CB1111)_A1_0.02_50%'!$D$104</c:f>
              <c:strCache>
                <c:ptCount val="1"/>
                <c:pt idx="0">
                  <c:v>cat-1(CB1111)_A1_03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D$105:$D$135</c:f>
              <c:numCache>
                <c:formatCode>General</c:formatCode>
                <c:ptCount val="31"/>
                <c:pt idx="1">
                  <c:v>0.10638297872340402</c:v>
                </c:pt>
                <c:pt idx="2">
                  <c:v>9.5744680851063829E-2</c:v>
                </c:pt>
                <c:pt idx="3">
                  <c:v>7.4468085106383031E-2</c:v>
                </c:pt>
                <c:pt idx="4">
                  <c:v>3.1914893617021316E-2</c:v>
                </c:pt>
                <c:pt idx="5">
                  <c:v>6.382978723404252E-2</c:v>
                </c:pt>
                <c:pt idx="6">
                  <c:v>5.31914893617021E-2</c:v>
                </c:pt>
                <c:pt idx="7">
                  <c:v>4.2553191489361715E-2</c:v>
                </c:pt>
                <c:pt idx="8">
                  <c:v>3.1914893617021316E-2</c:v>
                </c:pt>
                <c:pt idx="9">
                  <c:v>1.0638297872340394E-2</c:v>
                </c:pt>
                <c:pt idx="10">
                  <c:v>2.1276595744680899E-2</c:v>
                </c:pt>
                <c:pt idx="11">
                  <c:v>6.382978723404252E-2</c:v>
                </c:pt>
                <c:pt idx="12">
                  <c:v>5.31914893617021E-2</c:v>
                </c:pt>
                <c:pt idx="13">
                  <c:v>3.1914893617021316E-2</c:v>
                </c:pt>
                <c:pt idx="14">
                  <c:v>3.1914893617021316E-2</c:v>
                </c:pt>
                <c:pt idx="15">
                  <c:v>2.1276595744680899E-2</c:v>
                </c:pt>
                <c:pt idx="16">
                  <c:v>1.0638297872340394E-2</c:v>
                </c:pt>
                <c:pt idx="17">
                  <c:v>3.1914893617021316E-2</c:v>
                </c:pt>
                <c:pt idx="18">
                  <c:v>2.1276595744680899E-2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1.0638297872340394E-2</c:v>
                </c:pt>
                <c:pt idx="23">
                  <c:v>1.0638297872340394E-2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cat-1(CB1111)_A1_0.02_50%'!$E$104</c:f>
              <c:strCache>
                <c:ptCount val="1"/>
                <c:pt idx="0">
                  <c:v>cat-1(CB1111)_A1_04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E$105:$E$135</c:f>
              <c:numCache>
                <c:formatCode>General</c:formatCode>
                <c:ptCount val="31"/>
                <c:pt idx="1">
                  <c:v>7.2289156626505965E-2</c:v>
                </c:pt>
                <c:pt idx="2">
                  <c:v>6.6265060240963902E-2</c:v>
                </c:pt>
                <c:pt idx="3">
                  <c:v>7.8313253012048237E-2</c:v>
                </c:pt>
                <c:pt idx="4">
                  <c:v>3.6144578313252997E-2</c:v>
                </c:pt>
                <c:pt idx="5">
                  <c:v>9.0361445783132557E-2</c:v>
                </c:pt>
                <c:pt idx="6">
                  <c:v>5.4216867469879498E-2</c:v>
                </c:pt>
                <c:pt idx="7">
                  <c:v>7.2289156626505965E-2</c:v>
                </c:pt>
                <c:pt idx="8">
                  <c:v>5.4216867469879498E-2</c:v>
                </c:pt>
                <c:pt idx="9">
                  <c:v>5.4216867469879498E-2</c:v>
                </c:pt>
                <c:pt idx="10">
                  <c:v>4.2168674698795219E-2</c:v>
                </c:pt>
                <c:pt idx="11">
                  <c:v>5.4216867469879498E-2</c:v>
                </c:pt>
                <c:pt idx="12">
                  <c:v>4.2168674698795219E-2</c:v>
                </c:pt>
                <c:pt idx="13">
                  <c:v>6.0240963855421721E-2</c:v>
                </c:pt>
                <c:pt idx="14">
                  <c:v>4.2168674698795219E-2</c:v>
                </c:pt>
                <c:pt idx="15">
                  <c:v>3.0120481927710791E-2</c:v>
                </c:pt>
                <c:pt idx="16">
                  <c:v>1.2048192771084298E-2</c:v>
                </c:pt>
                <c:pt idx="17">
                  <c:v>1.8072289156626498E-2</c:v>
                </c:pt>
                <c:pt idx="18">
                  <c:v>1.2048192771084298E-2</c:v>
                </c:pt>
                <c:pt idx="19">
                  <c:v>1.2048192771084298E-2</c:v>
                </c:pt>
                <c:pt idx="20">
                  <c:v>0</c:v>
                </c:pt>
                <c:pt idx="21">
                  <c:v>1.2048192771084298E-2</c:v>
                </c:pt>
                <c:pt idx="22">
                  <c:v>1.8072289156626498E-2</c:v>
                </c:pt>
                <c:pt idx="23">
                  <c:v>0</c:v>
                </c:pt>
                <c:pt idx="24">
                  <c:v>0</c:v>
                </c:pt>
                <c:pt idx="25">
                  <c:v>6.0240963855421733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cat-1(CB1111)_A1_0.02_50%'!$F$104</c:f>
              <c:strCache>
                <c:ptCount val="1"/>
                <c:pt idx="0">
                  <c:v>cat-1(CB1111)_A1_05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F$105:$F$135</c:f>
              <c:numCache>
                <c:formatCode>General</c:formatCode>
                <c:ptCount val="31"/>
                <c:pt idx="1">
                  <c:v>7.4433656957928848E-2</c:v>
                </c:pt>
                <c:pt idx="2">
                  <c:v>3.8834951456310711E-2</c:v>
                </c:pt>
                <c:pt idx="3">
                  <c:v>6.1488673139158623E-2</c:v>
                </c:pt>
                <c:pt idx="4">
                  <c:v>5.1779935275080895E-2</c:v>
                </c:pt>
                <c:pt idx="5">
                  <c:v>4.5307443365695803E-2</c:v>
                </c:pt>
                <c:pt idx="6">
                  <c:v>5.8252427184466014E-2</c:v>
                </c:pt>
                <c:pt idx="7">
                  <c:v>5.8252427184466014E-2</c:v>
                </c:pt>
                <c:pt idx="8">
                  <c:v>5.5016181229773524E-2</c:v>
                </c:pt>
                <c:pt idx="9">
                  <c:v>7.1197411003236247E-2</c:v>
                </c:pt>
                <c:pt idx="10">
                  <c:v>6.4724919093851113E-2</c:v>
                </c:pt>
                <c:pt idx="11">
                  <c:v>3.5598705501618109E-2</c:v>
                </c:pt>
                <c:pt idx="12">
                  <c:v>4.2071197411003215E-2</c:v>
                </c:pt>
                <c:pt idx="13">
                  <c:v>4.5307443365695803E-2</c:v>
                </c:pt>
                <c:pt idx="14">
                  <c:v>5.8252427184466014E-2</c:v>
                </c:pt>
                <c:pt idx="15">
                  <c:v>4.2071197411003215E-2</c:v>
                </c:pt>
                <c:pt idx="16">
                  <c:v>1.6181229773462806E-2</c:v>
                </c:pt>
                <c:pt idx="17">
                  <c:v>4.2071197411003215E-2</c:v>
                </c:pt>
                <c:pt idx="18">
                  <c:v>2.2653721682847908E-2</c:v>
                </c:pt>
                <c:pt idx="19">
                  <c:v>6.4724919093851118E-3</c:v>
                </c:pt>
                <c:pt idx="20">
                  <c:v>9.7087378640776708E-3</c:v>
                </c:pt>
                <c:pt idx="21">
                  <c:v>9.7087378640776708E-3</c:v>
                </c:pt>
                <c:pt idx="22">
                  <c:v>9.7087378640776708E-3</c:v>
                </c:pt>
                <c:pt idx="23">
                  <c:v>0</c:v>
                </c:pt>
                <c:pt idx="24">
                  <c:v>9.7087378640776708E-3</c:v>
                </c:pt>
                <c:pt idx="25">
                  <c:v>3.2362459546925598E-3</c:v>
                </c:pt>
                <c:pt idx="26">
                  <c:v>0</c:v>
                </c:pt>
                <c:pt idx="27">
                  <c:v>0</c:v>
                </c:pt>
                <c:pt idx="28">
                  <c:v>3.2362459546925598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cat-1(CB1111)_A1_0.02_50%'!$G$104</c:f>
              <c:strCache>
                <c:ptCount val="1"/>
                <c:pt idx="0">
                  <c:v>cat-1(CB1111)_A1_06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G$105:$G$135</c:f>
              <c:numCache>
                <c:formatCode>General</c:formatCode>
                <c:ptCount val="31"/>
                <c:pt idx="1">
                  <c:v>8.8989441930618432E-2</c:v>
                </c:pt>
                <c:pt idx="2">
                  <c:v>5.1282051282051301E-2</c:v>
                </c:pt>
                <c:pt idx="3">
                  <c:v>7.5414781297134248E-2</c:v>
                </c:pt>
                <c:pt idx="4">
                  <c:v>5.4298642533936729E-2</c:v>
                </c:pt>
                <c:pt idx="5">
                  <c:v>5.8823529411764698E-2</c:v>
                </c:pt>
                <c:pt idx="6">
                  <c:v>6.4856711915535548E-2</c:v>
                </c:pt>
                <c:pt idx="7">
                  <c:v>7.2398190045248945E-2</c:v>
                </c:pt>
                <c:pt idx="8">
                  <c:v>6.9381598793363503E-2</c:v>
                </c:pt>
                <c:pt idx="9">
                  <c:v>5.4298642533936729E-2</c:v>
                </c:pt>
                <c:pt idx="10">
                  <c:v>6.6365007541478102E-2</c:v>
                </c:pt>
                <c:pt idx="11">
                  <c:v>2.7149321266968299E-2</c:v>
                </c:pt>
                <c:pt idx="12">
                  <c:v>3.4690799396681793E-2</c:v>
                </c:pt>
                <c:pt idx="13">
                  <c:v>3.31825037707391E-2</c:v>
                </c:pt>
                <c:pt idx="14">
                  <c:v>4.9773755656108629E-2</c:v>
                </c:pt>
                <c:pt idx="15">
                  <c:v>2.5641025641025609E-2</c:v>
                </c:pt>
                <c:pt idx="16">
                  <c:v>2.4132730015082999E-2</c:v>
                </c:pt>
                <c:pt idx="17">
                  <c:v>2.4132730015082999E-2</c:v>
                </c:pt>
                <c:pt idx="18">
                  <c:v>1.0558069381598799E-2</c:v>
                </c:pt>
                <c:pt idx="19">
                  <c:v>1.5082956259426801E-2</c:v>
                </c:pt>
                <c:pt idx="20">
                  <c:v>1.9607843137254902E-2</c:v>
                </c:pt>
                <c:pt idx="21">
                  <c:v>1.5082956259426801E-2</c:v>
                </c:pt>
                <c:pt idx="22">
                  <c:v>7.5414781297134231E-3</c:v>
                </c:pt>
                <c:pt idx="23">
                  <c:v>3.0165912518853727E-3</c:v>
                </c:pt>
                <c:pt idx="24">
                  <c:v>1.5082956259426801E-3</c:v>
                </c:pt>
                <c:pt idx="25">
                  <c:v>1.5082956259426801E-3</c:v>
                </c:pt>
                <c:pt idx="26">
                  <c:v>3.0165912518853727E-3</c:v>
                </c:pt>
                <c:pt idx="27">
                  <c:v>3.0165912518853727E-3</c:v>
                </c:pt>
                <c:pt idx="28">
                  <c:v>0</c:v>
                </c:pt>
                <c:pt idx="29">
                  <c:v>1.5082956259426801E-3</c:v>
                </c:pt>
                <c:pt idx="30">
                  <c:v>0</c:v>
                </c:pt>
              </c:numCache>
            </c:numRef>
          </c:val>
        </c:ser>
        <c:ser>
          <c:idx val="6"/>
          <c:order val="6"/>
          <c:tx>
            <c:strRef>
              <c:f>'cat-1(CB1111)_A1_0.02_50%'!$H$104</c:f>
              <c:strCache>
                <c:ptCount val="1"/>
                <c:pt idx="0">
                  <c:v>cat-1(CB1111)_A1_07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H$105:$H$135</c:f>
              <c:numCache>
                <c:formatCode>General</c:formatCode>
                <c:ptCount val="31"/>
                <c:pt idx="1">
                  <c:v>6.0344827586206899E-2</c:v>
                </c:pt>
                <c:pt idx="2">
                  <c:v>6.0344827586206899E-2</c:v>
                </c:pt>
                <c:pt idx="3">
                  <c:v>8.1896551724137928E-2</c:v>
                </c:pt>
                <c:pt idx="4">
                  <c:v>5.1724137931034517E-2</c:v>
                </c:pt>
                <c:pt idx="5">
                  <c:v>4.7413793103448343E-2</c:v>
                </c:pt>
                <c:pt idx="6">
                  <c:v>2.1551724137930991E-2</c:v>
                </c:pt>
                <c:pt idx="7">
                  <c:v>5.6034482758620718E-2</c:v>
                </c:pt>
                <c:pt idx="8">
                  <c:v>2.1551724137930991E-2</c:v>
                </c:pt>
                <c:pt idx="9">
                  <c:v>4.3103448275862079E-2</c:v>
                </c:pt>
                <c:pt idx="10">
                  <c:v>4.7413793103448343E-2</c:v>
                </c:pt>
                <c:pt idx="11">
                  <c:v>1.7241379310344803E-2</c:v>
                </c:pt>
                <c:pt idx="12">
                  <c:v>6.465517241379308E-2</c:v>
                </c:pt>
                <c:pt idx="13">
                  <c:v>3.8793103448275912E-2</c:v>
                </c:pt>
                <c:pt idx="14">
                  <c:v>6.0344827586206899E-2</c:v>
                </c:pt>
                <c:pt idx="15">
                  <c:v>2.5862068965517199E-2</c:v>
                </c:pt>
                <c:pt idx="16">
                  <c:v>3.4482758620689717E-2</c:v>
                </c:pt>
                <c:pt idx="17">
                  <c:v>4.3103448275862079E-2</c:v>
                </c:pt>
                <c:pt idx="18">
                  <c:v>1.7241379310344803E-2</c:v>
                </c:pt>
                <c:pt idx="19">
                  <c:v>2.1551724137930991E-2</c:v>
                </c:pt>
                <c:pt idx="20">
                  <c:v>8.6206896551724154E-3</c:v>
                </c:pt>
                <c:pt idx="21">
                  <c:v>0</c:v>
                </c:pt>
                <c:pt idx="22">
                  <c:v>1.29310344827586E-2</c:v>
                </c:pt>
                <c:pt idx="23">
                  <c:v>8.6206896551724154E-3</c:v>
                </c:pt>
                <c:pt idx="24">
                  <c:v>0</c:v>
                </c:pt>
                <c:pt idx="25">
                  <c:v>0</c:v>
                </c:pt>
                <c:pt idx="26">
                  <c:v>8.6206896551724154E-3</c:v>
                </c:pt>
                <c:pt idx="27">
                  <c:v>8.6206896551724154E-3</c:v>
                </c:pt>
                <c:pt idx="28">
                  <c:v>0</c:v>
                </c:pt>
                <c:pt idx="29">
                  <c:v>0</c:v>
                </c:pt>
                <c:pt idx="30">
                  <c:v>8.6206896551724154E-3</c:v>
                </c:pt>
              </c:numCache>
            </c:numRef>
          </c:val>
        </c:ser>
        <c:ser>
          <c:idx val="7"/>
          <c:order val="7"/>
          <c:tx>
            <c:strRef>
              <c:f>'cat-1(CB1111)_A1_0.02_50%'!$I$104</c:f>
              <c:strCache>
                <c:ptCount val="1"/>
                <c:pt idx="0">
                  <c:v>cat-1(CB1111)_A1_08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I$105:$I$135</c:f>
              <c:numCache>
                <c:formatCode>General</c:formatCode>
                <c:ptCount val="31"/>
                <c:pt idx="1">
                  <c:v>5.1823416506717901E-2</c:v>
                </c:pt>
                <c:pt idx="2">
                  <c:v>7.2936660268714024E-2</c:v>
                </c:pt>
                <c:pt idx="3">
                  <c:v>5.1823416506717901E-2</c:v>
                </c:pt>
                <c:pt idx="4">
                  <c:v>6.3339731285988493E-2</c:v>
                </c:pt>
                <c:pt idx="5">
                  <c:v>6.71785028790787E-2</c:v>
                </c:pt>
                <c:pt idx="6">
                  <c:v>7.2936660268714024E-2</c:v>
                </c:pt>
                <c:pt idx="7">
                  <c:v>6.3339731285988493E-2</c:v>
                </c:pt>
                <c:pt idx="8">
                  <c:v>4.7984644913627625E-2</c:v>
                </c:pt>
                <c:pt idx="9">
                  <c:v>5.3742802303262976E-2</c:v>
                </c:pt>
                <c:pt idx="10">
                  <c:v>5.9500959692898314E-2</c:v>
                </c:pt>
                <c:pt idx="11">
                  <c:v>5.9500959692898314E-2</c:v>
                </c:pt>
                <c:pt idx="12">
                  <c:v>3.2629558541266805E-2</c:v>
                </c:pt>
                <c:pt idx="13">
                  <c:v>3.8387715930902101E-2</c:v>
                </c:pt>
                <c:pt idx="14">
                  <c:v>3.4548944337811902E-2</c:v>
                </c:pt>
                <c:pt idx="15">
                  <c:v>2.8790786948176592E-2</c:v>
                </c:pt>
                <c:pt idx="16">
                  <c:v>3.4548944337811902E-2</c:v>
                </c:pt>
                <c:pt idx="17">
                  <c:v>2.1113243761996209E-2</c:v>
                </c:pt>
                <c:pt idx="18">
                  <c:v>2.1113243761996209E-2</c:v>
                </c:pt>
                <c:pt idx="19">
                  <c:v>1.9193857965451103E-2</c:v>
                </c:pt>
                <c:pt idx="20">
                  <c:v>1.7274472168905999E-2</c:v>
                </c:pt>
                <c:pt idx="21">
                  <c:v>1.3435700575815701E-2</c:v>
                </c:pt>
                <c:pt idx="22">
                  <c:v>9.5969289827255271E-3</c:v>
                </c:pt>
                <c:pt idx="23">
                  <c:v>5.7581573896353221E-3</c:v>
                </c:pt>
                <c:pt idx="24">
                  <c:v>0</c:v>
                </c:pt>
                <c:pt idx="25">
                  <c:v>1.9193857965451105E-3</c:v>
                </c:pt>
                <c:pt idx="26">
                  <c:v>1.9193857965451105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8"/>
          <c:order val="8"/>
          <c:tx>
            <c:strRef>
              <c:f>'cat-1(CB1111)_A1_0.02_50%'!$J$104</c:f>
              <c:strCache>
                <c:ptCount val="1"/>
                <c:pt idx="0">
                  <c:v>cat-1(CB1111)_A1_09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J$105:$J$135</c:f>
              <c:numCache>
                <c:formatCode>General</c:formatCode>
                <c:ptCount val="31"/>
                <c:pt idx="1">
                  <c:v>5.4285714285714312E-2</c:v>
                </c:pt>
                <c:pt idx="2">
                  <c:v>5.4285714285714312E-2</c:v>
                </c:pt>
                <c:pt idx="3">
                  <c:v>2.8571428571428602E-2</c:v>
                </c:pt>
                <c:pt idx="4">
                  <c:v>6.8571428571428603E-2</c:v>
                </c:pt>
                <c:pt idx="5">
                  <c:v>5.4285714285714312E-2</c:v>
                </c:pt>
                <c:pt idx="6">
                  <c:v>5.4285714285714312E-2</c:v>
                </c:pt>
                <c:pt idx="7">
                  <c:v>3.1428571428571417E-2</c:v>
                </c:pt>
                <c:pt idx="8">
                  <c:v>5.14285714285714E-2</c:v>
                </c:pt>
                <c:pt idx="9">
                  <c:v>4.5714285714285714E-2</c:v>
                </c:pt>
                <c:pt idx="10">
                  <c:v>6.5714285714285725E-2</c:v>
                </c:pt>
                <c:pt idx="11">
                  <c:v>5.14285714285714E-2</c:v>
                </c:pt>
                <c:pt idx="12">
                  <c:v>5.7142857142857099E-2</c:v>
                </c:pt>
                <c:pt idx="13">
                  <c:v>4.2857142857142913E-2</c:v>
                </c:pt>
                <c:pt idx="14">
                  <c:v>5.7142857142857099E-2</c:v>
                </c:pt>
                <c:pt idx="15">
                  <c:v>4.2857142857142913E-2</c:v>
                </c:pt>
                <c:pt idx="16">
                  <c:v>2.8571428571428602E-2</c:v>
                </c:pt>
                <c:pt idx="17">
                  <c:v>3.1428571428571417E-2</c:v>
                </c:pt>
                <c:pt idx="18">
                  <c:v>2.0000000000000007E-2</c:v>
                </c:pt>
                <c:pt idx="19">
                  <c:v>3.1428571428571417E-2</c:v>
                </c:pt>
                <c:pt idx="20">
                  <c:v>1.1428571428571404E-2</c:v>
                </c:pt>
                <c:pt idx="21">
                  <c:v>2.0000000000000007E-2</c:v>
                </c:pt>
                <c:pt idx="22">
                  <c:v>8.5714285714285701E-3</c:v>
                </c:pt>
                <c:pt idx="23">
                  <c:v>1.1428571428571404E-2</c:v>
                </c:pt>
                <c:pt idx="24">
                  <c:v>2.8571428571428602E-3</c:v>
                </c:pt>
                <c:pt idx="25">
                  <c:v>0</c:v>
                </c:pt>
                <c:pt idx="26">
                  <c:v>2.8571428571428602E-3</c:v>
                </c:pt>
                <c:pt idx="27">
                  <c:v>5.7142857142857099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cat-1(CB1111)_A1_0.02_50%'!$K$104</c:f>
              <c:strCache>
                <c:ptCount val="1"/>
                <c:pt idx="0">
                  <c:v>cat-1(CB1111)_A1_10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K$105:$K$135</c:f>
              <c:numCache>
                <c:formatCode>General</c:formatCode>
                <c:ptCount val="31"/>
                <c:pt idx="1">
                  <c:v>7.9173838209982805E-2</c:v>
                </c:pt>
                <c:pt idx="2">
                  <c:v>8.2616179001721191E-2</c:v>
                </c:pt>
                <c:pt idx="3">
                  <c:v>6.1962134251290921E-2</c:v>
                </c:pt>
                <c:pt idx="4">
                  <c:v>6.5404475043029334E-2</c:v>
                </c:pt>
                <c:pt idx="5">
                  <c:v>5.5077452667814081E-2</c:v>
                </c:pt>
                <c:pt idx="6">
                  <c:v>5.1635111876075696E-2</c:v>
                </c:pt>
                <c:pt idx="7">
                  <c:v>6.1962134251290921E-2</c:v>
                </c:pt>
                <c:pt idx="8">
                  <c:v>8.0895008605852053E-2</c:v>
                </c:pt>
                <c:pt idx="9">
                  <c:v>3.4423407917383811E-2</c:v>
                </c:pt>
                <c:pt idx="10">
                  <c:v>3.0981067125645412E-2</c:v>
                </c:pt>
                <c:pt idx="11">
                  <c:v>5.1635111876075696E-2</c:v>
                </c:pt>
                <c:pt idx="12">
                  <c:v>4.1308089500860602E-2</c:v>
                </c:pt>
                <c:pt idx="13">
                  <c:v>4.4750430292599022E-2</c:v>
                </c:pt>
                <c:pt idx="14">
                  <c:v>3.9586919104991403E-2</c:v>
                </c:pt>
                <c:pt idx="15">
                  <c:v>2.2375215146299518E-2</c:v>
                </c:pt>
                <c:pt idx="16">
                  <c:v>2.0654044750430301E-2</c:v>
                </c:pt>
                <c:pt idx="17">
                  <c:v>3.0981067125645412E-2</c:v>
                </c:pt>
                <c:pt idx="18">
                  <c:v>1.7211703958691899E-2</c:v>
                </c:pt>
                <c:pt idx="19">
                  <c:v>1.7211703958691899E-2</c:v>
                </c:pt>
                <c:pt idx="20">
                  <c:v>8.6058519793459545E-3</c:v>
                </c:pt>
                <c:pt idx="21">
                  <c:v>1.2048192771084298E-2</c:v>
                </c:pt>
                <c:pt idx="22">
                  <c:v>0</c:v>
                </c:pt>
                <c:pt idx="23">
                  <c:v>5.1635111876075701E-3</c:v>
                </c:pt>
                <c:pt idx="24">
                  <c:v>3.4423407917383809E-3</c:v>
                </c:pt>
                <c:pt idx="25">
                  <c:v>3.4423407917383809E-3</c:v>
                </c:pt>
                <c:pt idx="26">
                  <c:v>0</c:v>
                </c:pt>
                <c:pt idx="27">
                  <c:v>1.7211703958691898E-3</c:v>
                </c:pt>
                <c:pt idx="28">
                  <c:v>1.7211703958691898E-3</c:v>
                </c:pt>
                <c:pt idx="29">
                  <c:v>1.7211703958691898E-3</c:v>
                </c:pt>
                <c:pt idx="3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cat-1(CB1111)_A1_0.02_50%'!$L$104</c:f>
              <c:strCache>
                <c:ptCount val="1"/>
                <c:pt idx="0">
                  <c:v>cat-1(CB1111)_A1_12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L$105:$L$135</c:f>
              <c:numCache>
                <c:formatCode>General</c:formatCode>
                <c:ptCount val="31"/>
                <c:pt idx="1">
                  <c:v>4.4289044289044302E-2</c:v>
                </c:pt>
                <c:pt idx="2">
                  <c:v>2.3310023310023301E-2</c:v>
                </c:pt>
                <c:pt idx="3">
                  <c:v>1.6317016317016302E-2</c:v>
                </c:pt>
                <c:pt idx="4">
                  <c:v>4.8951048951049E-2</c:v>
                </c:pt>
                <c:pt idx="5">
                  <c:v>1.6317016317016302E-2</c:v>
                </c:pt>
                <c:pt idx="6">
                  <c:v>2.797202797202801E-2</c:v>
                </c:pt>
                <c:pt idx="7">
                  <c:v>2.797202797202801E-2</c:v>
                </c:pt>
                <c:pt idx="8">
                  <c:v>4.1958041958042015E-2</c:v>
                </c:pt>
                <c:pt idx="9">
                  <c:v>2.3310023310023301E-2</c:v>
                </c:pt>
                <c:pt idx="10">
                  <c:v>3.729603729603731E-2</c:v>
                </c:pt>
                <c:pt idx="11">
                  <c:v>4.4289044289044302E-2</c:v>
                </c:pt>
                <c:pt idx="12">
                  <c:v>5.3613053613053602E-2</c:v>
                </c:pt>
                <c:pt idx="13">
                  <c:v>6.5268065268065306E-2</c:v>
                </c:pt>
                <c:pt idx="14">
                  <c:v>7.6923076923076913E-2</c:v>
                </c:pt>
                <c:pt idx="15">
                  <c:v>4.1958041958042015E-2</c:v>
                </c:pt>
                <c:pt idx="16">
                  <c:v>6.0606060606060601E-2</c:v>
                </c:pt>
                <c:pt idx="17">
                  <c:v>5.5944055944055895E-2</c:v>
                </c:pt>
                <c:pt idx="18">
                  <c:v>4.6620046620046603E-2</c:v>
                </c:pt>
                <c:pt idx="19">
                  <c:v>3.9627039627039611E-2</c:v>
                </c:pt>
                <c:pt idx="20">
                  <c:v>3.2634032634032605E-2</c:v>
                </c:pt>
                <c:pt idx="21">
                  <c:v>4.1958041958042015E-2</c:v>
                </c:pt>
                <c:pt idx="22">
                  <c:v>3.03030303030303E-2</c:v>
                </c:pt>
                <c:pt idx="23">
                  <c:v>1.3986013986014E-2</c:v>
                </c:pt>
                <c:pt idx="24">
                  <c:v>2.3310023310023301E-2</c:v>
                </c:pt>
                <c:pt idx="25">
                  <c:v>1.1655011655011701E-2</c:v>
                </c:pt>
                <c:pt idx="26">
                  <c:v>6.9930069930069921E-3</c:v>
                </c:pt>
                <c:pt idx="27">
                  <c:v>9.324009324009324E-3</c:v>
                </c:pt>
                <c:pt idx="28">
                  <c:v>9.324009324009324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cat-1(CB1111)_A1_0.02_50%'!$M$104</c:f>
              <c:strCache>
                <c:ptCount val="1"/>
                <c:pt idx="0">
                  <c:v>cat-1(CB1111)_A1_13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M$105:$M$135</c:f>
              <c:numCache>
                <c:formatCode>General</c:formatCode>
                <c:ptCount val="31"/>
                <c:pt idx="1">
                  <c:v>7.3275862068965456E-2</c:v>
                </c:pt>
                <c:pt idx="2">
                  <c:v>4.0948275862068978E-2</c:v>
                </c:pt>
                <c:pt idx="3">
                  <c:v>3.8793103448275912E-2</c:v>
                </c:pt>
                <c:pt idx="4">
                  <c:v>6.0344827586206899E-2</c:v>
                </c:pt>
                <c:pt idx="5">
                  <c:v>3.0172413793103509E-2</c:v>
                </c:pt>
                <c:pt idx="6">
                  <c:v>5.8189655172413798E-2</c:v>
                </c:pt>
                <c:pt idx="7">
                  <c:v>6.465517241379308E-2</c:v>
                </c:pt>
                <c:pt idx="8">
                  <c:v>6.0344827586206899E-2</c:v>
                </c:pt>
                <c:pt idx="9">
                  <c:v>5.3879310344827597E-2</c:v>
                </c:pt>
                <c:pt idx="10">
                  <c:v>5.3879310344827597E-2</c:v>
                </c:pt>
                <c:pt idx="11">
                  <c:v>3.8793103448275912E-2</c:v>
                </c:pt>
                <c:pt idx="12">
                  <c:v>7.7586206896551727E-2</c:v>
                </c:pt>
                <c:pt idx="13">
                  <c:v>4.9568965517241423E-2</c:v>
                </c:pt>
                <c:pt idx="14">
                  <c:v>4.7413793103448343E-2</c:v>
                </c:pt>
                <c:pt idx="15">
                  <c:v>4.7413793103448343E-2</c:v>
                </c:pt>
                <c:pt idx="16">
                  <c:v>3.6637931034482804E-2</c:v>
                </c:pt>
                <c:pt idx="17">
                  <c:v>2.5862068965517199E-2</c:v>
                </c:pt>
                <c:pt idx="18">
                  <c:v>1.7241379310344803E-2</c:v>
                </c:pt>
                <c:pt idx="19">
                  <c:v>1.5086206896551699E-2</c:v>
                </c:pt>
                <c:pt idx="20">
                  <c:v>1.9396551724137911E-2</c:v>
                </c:pt>
                <c:pt idx="21">
                  <c:v>1.0775862068965504E-2</c:v>
                </c:pt>
                <c:pt idx="22">
                  <c:v>1.29310344827586E-2</c:v>
                </c:pt>
                <c:pt idx="23">
                  <c:v>1.29310344827586E-2</c:v>
                </c:pt>
                <c:pt idx="24">
                  <c:v>1.0775862068965504E-2</c:v>
                </c:pt>
                <c:pt idx="25">
                  <c:v>2.1551724137930991E-3</c:v>
                </c:pt>
                <c:pt idx="26">
                  <c:v>0</c:v>
                </c:pt>
                <c:pt idx="27">
                  <c:v>0</c:v>
                </c:pt>
                <c:pt idx="28">
                  <c:v>2.1551724137930991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cat-1(CB1111)_A1_0.02_50%'!$N$104</c:f>
              <c:strCache>
                <c:ptCount val="1"/>
                <c:pt idx="0">
                  <c:v>cat-1(CB1111)_A1_14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N$105:$N$135</c:f>
              <c:numCache>
                <c:formatCode>General</c:formatCode>
                <c:ptCount val="31"/>
                <c:pt idx="1">
                  <c:v>4.5081967213114804E-2</c:v>
                </c:pt>
                <c:pt idx="2">
                  <c:v>3.2786885245901599E-2</c:v>
                </c:pt>
                <c:pt idx="3">
                  <c:v>3.2786885245901599E-2</c:v>
                </c:pt>
                <c:pt idx="4">
                  <c:v>4.3032786885245929E-2</c:v>
                </c:pt>
                <c:pt idx="5">
                  <c:v>3.8934426229508198E-2</c:v>
                </c:pt>
                <c:pt idx="6">
                  <c:v>4.0983606557377004E-2</c:v>
                </c:pt>
                <c:pt idx="7">
                  <c:v>5.9426229508196732E-2</c:v>
                </c:pt>
                <c:pt idx="8">
                  <c:v>6.1475409836065614E-2</c:v>
                </c:pt>
                <c:pt idx="9">
                  <c:v>5.7377049180327898E-2</c:v>
                </c:pt>
                <c:pt idx="10">
                  <c:v>5.7377049180327898E-2</c:v>
                </c:pt>
                <c:pt idx="11">
                  <c:v>5.3278688524590202E-2</c:v>
                </c:pt>
                <c:pt idx="12">
                  <c:v>4.3032786885245929E-2</c:v>
                </c:pt>
                <c:pt idx="13">
                  <c:v>4.3032786885245929E-2</c:v>
                </c:pt>
                <c:pt idx="14">
                  <c:v>3.483606557377053E-2</c:v>
                </c:pt>
                <c:pt idx="15">
                  <c:v>4.5081967213114804E-2</c:v>
                </c:pt>
                <c:pt idx="16">
                  <c:v>4.3032786885245929E-2</c:v>
                </c:pt>
                <c:pt idx="17">
                  <c:v>5.1229508196721285E-2</c:v>
                </c:pt>
                <c:pt idx="18">
                  <c:v>2.6639344262295118E-2</c:v>
                </c:pt>
                <c:pt idx="19">
                  <c:v>3.07377049180328E-2</c:v>
                </c:pt>
                <c:pt idx="20">
                  <c:v>2.0491803278688499E-2</c:v>
                </c:pt>
                <c:pt idx="21">
                  <c:v>2.4590163934426198E-2</c:v>
                </c:pt>
                <c:pt idx="22">
                  <c:v>2.0491803278688499E-2</c:v>
                </c:pt>
                <c:pt idx="23">
                  <c:v>1.2295081967213101E-2</c:v>
                </c:pt>
                <c:pt idx="24">
                  <c:v>8.1967213114754103E-3</c:v>
                </c:pt>
                <c:pt idx="25">
                  <c:v>1.4344262295082004E-2</c:v>
                </c:pt>
                <c:pt idx="26">
                  <c:v>4.0983606557377103E-3</c:v>
                </c:pt>
                <c:pt idx="27">
                  <c:v>4.0983606557377103E-3</c:v>
                </c:pt>
                <c:pt idx="28">
                  <c:v>2.0491803278688508E-3</c:v>
                </c:pt>
                <c:pt idx="29">
                  <c:v>6.1475409836065599E-3</c:v>
                </c:pt>
                <c:pt idx="30">
                  <c:v>2.0491803278688508E-3</c:v>
                </c:pt>
              </c:numCache>
            </c:numRef>
          </c:val>
        </c:ser>
        <c:ser>
          <c:idx val="13"/>
          <c:order val="13"/>
          <c:tx>
            <c:strRef>
              <c:f>'cat-1(CB1111)_A1_0.02_50%'!$O$104</c:f>
              <c:strCache>
                <c:ptCount val="1"/>
                <c:pt idx="0">
                  <c:v>cat-1(CB1111)_A1_15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O$105:$O$135</c:f>
              <c:numCache>
                <c:formatCode>General</c:formatCode>
                <c:ptCount val="31"/>
                <c:pt idx="1">
                  <c:v>5.3304904051172719E-2</c:v>
                </c:pt>
                <c:pt idx="2">
                  <c:v>3.8379530916844401E-2</c:v>
                </c:pt>
                <c:pt idx="3">
                  <c:v>5.7569296375266504E-2</c:v>
                </c:pt>
                <c:pt idx="4">
                  <c:v>5.7569296375266504E-2</c:v>
                </c:pt>
                <c:pt idx="5">
                  <c:v>3.4115138592750498E-2</c:v>
                </c:pt>
                <c:pt idx="6">
                  <c:v>4.2643923240938221E-2</c:v>
                </c:pt>
                <c:pt idx="7">
                  <c:v>4.47761194029851E-2</c:v>
                </c:pt>
                <c:pt idx="8">
                  <c:v>4.0511727078891321E-2</c:v>
                </c:pt>
                <c:pt idx="9">
                  <c:v>5.1172707889125812E-2</c:v>
                </c:pt>
                <c:pt idx="10">
                  <c:v>5.7569296375266504E-2</c:v>
                </c:pt>
                <c:pt idx="11">
                  <c:v>4.6908315565031979E-2</c:v>
                </c:pt>
                <c:pt idx="12">
                  <c:v>7.249466950959492E-2</c:v>
                </c:pt>
                <c:pt idx="13">
                  <c:v>4.47761194029851E-2</c:v>
                </c:pt>
                <c:pt idx="14">
                  <c:v>6.1833688699360304E-2</c:v>
                </c:pt>
                <c:pt idx="15">
                  <c:v>2.5586353944562889E-2</c:v>
                </c:pt>
                <c:pt idx="16">
                  <c:v>3.8379530916844401E-2</c:v>
                </c:pt>
                <c:pt idx="17">
                  <c:v>3.4115138592750498E-2</c:v>
                </c:pt>
                <c:pt idx="18">
                  <c:v>3.6247334754797411E-2</c:v>
                </c:pt>
                <c:pt idx="19">
                  <c:v>2.3454157782516007E-2</c:v>
                </c:pt>
                <c:pt idx="20">
                  <c:v>8.5287846481876348E-3</c:v>
                </c:pt>
                <c:pt idx="21">
                  <c:v>2.1321961620469117E-2</c:v>
                </c:pt>
                <c:pt idx="22">
                  <c:v>2.3454157782516007E-2</c:v>
                </c:pt>
                <c:pt idx="23">
                  <c:v>8.5287846481876348E-3</c:v>
                </c:pt>
                <c:pt idx="24">
                  <c:v>8.5287846481876348E-3</c:v>
                </c:pt>
                <c:pt idx="25">
                  <c:v>1.06609808102345E-2</c:v>
                </c:pt>
                <c:pt idx="26">
                  <c:v>6.3965884861407222E-3</c:v>
                </c:pt>
                <c:pt idx="27">
                  <c:v>6.3965884861407222E-3</c:v>
                </c:pt>
                <c:pt idx="28">
                  <c:v>0</c:v>
                </c:pt>
                <c:pt idx="29">
                  <c:v>2.1321961620469117E-3</c:v>
                </c:pt>
                <c:pt idx="30">
                  <c:v>2.1321961620469117E-3</c:v>
                </c:pt>
              </c:numCache>
            </c:numRef>
          </c:val>
        </c:ser>
        <c:ser>
          <c:idx val="14"/>
          <c:order val="14"/>
          <c:tx>
            <c:strRef>
              <c:f>'cat-1(CB1111)_A1_0.02_50%'!$P$104</c:f>
              <c:strCache>
                <c:ptCount val="1"/>
                <c:pt idx="0">
                  <c:v>cat-1(CB1111)_A1_16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P$105:$P$135</c:f>
              <c:numCache>
                <c:formatCode>General</c:formatCode>
                <c:ptCount val="31"/>
                <c:pt idx="1">
                  <c:v>5.622489959839358E-2</c:v>
                </c:pt>
                <c:pt idx="2">
                  <c:v>4.4176706827309231E-2</c:v>
                </c:pt>
                <c:pt idx="3">
                  <c:v>2.811244979919679E-2</c:v>
                </c:pt>
                <c:pt idx="4">
                  <c:v>5.4216867469879498E-2</c:v>
                </c:pt>
                <c:pt idx="5">
                  <c:v>4.2168674698795219E-2</c:v>
                </c:pt>
                <c:pt idx="6">
                  <c:v>3.6144578313252997E-2</c:v>
                </c:pt>
                <c:pt idx="7">
                  <c:v>5.0200803212851398E-2</c:v>
                </c:pt>
                <c:pt idx="8">
                  <c:v>5.0200803212851398E-2</c:v>
                </c:pt>
                <c:pt idx="9">
                  <c:v>5.0200803212851398E-2</c:v>
                </c:pt>
                <c:pt idx="10">
                  <c:v>3.2128514056224897E-2</c:v>
                </c:pt>
                <c:pt idx="11">
                  <c:v>3.6144578313252997E-2</c:v>
                </c:pt>
                <c:pt idx="12">
                  <c:v>3.2128514056224897E-2</c:v>
                </c:pt>
                <c:pt idx="13">
                  <c:v>5.622489959839358E-2</c:v>
                </c:pt>
                <c:pt idx="14">
                  <c:v>5.2208835341365487E-2</c:v>
                </c:pt>
                <c:pt idx="15">
                  <c:v>5.622489959839358E-2</c:v>
                </c:pt>
                <c:pt idx="16">
                  <c:v>3.6144578313252997E-2</c:v>
                </c:pt>
                <c:pt idx="17">
                  <c:v>2.811244979919679E-2</c:v>
                </c:pt>
                <c:pt idx="18">
                  <c:v>5.0200803212851398E-2</c:v>
                </c:pt>
                <c:pt idx="19">
                  <c:v>3.0120481927710791E-2</c:v>
                </c:pt>
                <c:pt idx="20">
                  <c:v>1.8072289156626498E-2</c:v>
                </c:pt>
                <c:pt idx="21">
                  <c:v>2.6104417670682702E-2</c:v>
                </c:pt>
                <c:pt idx="22">
                  <c:v>2.6104417670682702E-2</c:v>
                </c:pt>
                <c:pt idx="23">
                  <c:v>1.2048192771084298E-2</c:v>
                </c:pt>
                <c:pt idx="24">
                  <c:v>8.0321285140562207E-3</c:v>
                </c:pt>
                <c:pt idx="25">
                  <c:v>1.2048192771084298E-2</c:v>
                </c:pt>
                <c:pt idx="26">
                  <c:v>6.0240963855421733E-3</c:v>
                </c:pt>
                <c:pt idx="27">
                  <c:v>2.0080321285140608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5"/>
          <c:order val="15"/>
          <c:tx>
            <c:strRef>
              <c:f>'cat-1(CB1111)_A1_0.02_50%'!$Q$104</c:f>
              <c:strCache>
                <c:ptCount val="1"/>
                <c:pt idx="0">
                  <c:v>cat-1(CB1111)_A1_17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Q$105:$Q$135</c:f>
              <c:numCache>
                <c:formatCode>General</c:formatCode>
                <c:ptCount val="31"/>
                <c:pt idx="1">
                  <c:v>4.1420118343195297E-2</c:v>
                </c:pt>
                <c:pt idx="2">
                  <c:v>2.3668639053254392E-2</c:v>
                </c:pt>
                <c:pt idx="3">
                  <c:v>3.2544378698224921E-2</c:v>
                </c:pt>
                <c:pt idx="4">
                  <c:v>3.2544378698224921E-2</c:v>
                </c:pt>
                <c:pt idx="5">
                  <c:v>4.7337278106508916E-2</c:v>
                </c:pt>
                <c:pt idx="6">
                  <c:v>4.1420118343195297E-2</c:v>
                </c:pt>
                <c:pt idx="7">
                  <c:v>4.7337278106508916E-2</c:v>
                </c:pt>
                <c:pt idx="8">
                  <c:v>3.8461538461538498E-2</c:v>
                </c:pt>
                <c:pt idx="9">
                  <c:v>3.8461538461538498E-2</c:v>
                </c:pt>
                <c:pt idx="10">
                  <c:v>4.7337278106508916E-2</c:v>
                </c:pt>
                <c:pt idx="11">
                  <c:v>2.9585798816568001E-2</c:v>
                </c:pt>
                <c:pt idx="12">
                  <c:v>5.3254437869822514E-2</c:v>
                </c:pt>
                <c:pt idx="13">
                  <c:v>6.8047337278106509E-2</c:v>
                </c:pt>
                <c:pt idx="14">
                  <c:v>4.7337278106508916E-2</c:v>
                </c:pt>
                <c:pt idx="15">
                  <c:v>4.1420118343195297E-2</c:v>
                </c:pt>
                <c:pt idx="16">
                  <c:v>6.2130177514792898E-2</c:v>
                </c:pt>
                <c:pt idx="17">
                  <c:v>3.5502958579881699E-2</c:v>
                </c:pt>
                <c:pt idx="18">
                  <c:v>5.6213017751479313E-2</c:v>
                </c:pt>
                <c:pt idx="19">
                  <c:v>4.7337278106508916E-2</c:v>
                </c:pt>
                <c:pt idx="20">
                  <c:v>2.9585798816568001E-2</c:v>
                </c:pt>
                <c:pt idx="21">
                  <c:v>1.4792899408284E-2</c:v>
                </c:pt>
                <c:pt idx="22">
                  <c:v>2.6627218934911209E-2</c:v>
                </c:pt>
                <c:pt idx="23">
                  <c:v>1.4792899408284E-2</c:v>
                </c:pt>
                <c:pt idx="24">
                  <c:v>1.7751479289940808E-2</c:v>
                </c:pt>
                <c:pt idx="25">
                  <c:v>5.9171597633136119E-3</c:v>
                </c:pt>
                <c:pt idx="26">
                  <c:v>1.1834319526627201E-2</c:v>
                </c:pt>
                <c:pt idx="27">
                  <c:v>2.9585798816568008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6"/>
          <c:order val="16"/>
          <c:tx>
            <c:strRef>
              <c:f>'cat-1(CB1111)_A1_0.02_50%'!$R$104</c:f>
              <c:strCache>
                <c:ptCount val="1"/>
                <c:pt idx="0">
                  <c:v>cat-1(CB1111)_A1_18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R$105:$R$135</c:f>
              <c:numCache>
                <c:formatCode>General</c:formatCode>
                <c:ptCount val="31"/>
                <c:pt idx="1">
                  <c:v>2.5139664804469299E-2</c:v>
                </c:pt>
                <c:pt idx="2">
                  <c:v>1.9553072625698303E-2</c:v>
                </c:pt>
                <c:pt idx="3">
                  <c:v>2.5139664804469299E-2</c:v>
                </c:pt>
                <c:pt idx="4">
                  <c:v>2.5139664804469299E-2</c:v>
                </c:pt>
                <c:pt idx="5">
                  <c:v>3.91061452513966E-2</c:v>
                </c:pt>
                <c:pt idx="6">
                  <c:v>3.6312849162011204E-2</c:v>
                </c:pt>
                <c:pt idx="7">
                  <c:v>2.234636871508381E-2</c:v>
                </c:pt>
                <c:pt idx="8">
                  <c:v>3.91061452513966E-2</c:v>
                </c:pt>
                <c:pt idx="9">
                  <c:v>2.234636871508381E-2</c:v>
                </c:pt>
                <c:pt idx="10">
                  <c:v>3.0726256983240198E-2</c:v>
                </c:pt>
                <c:pt idx="11">
                  <c:v>5.5865921787709501E-2</c:v>
                </c:pt>
                <c:pt idx="12">
                  <c:v>3.91061452513966E-2</c:v>
                </c:pt>
                <c:pt idx="13">
                  <c:v>5.5865921787709501E-2</c:v>
                </c:pt>
                <c:pt idx="14">
                  <c:v>7.2625698324022409E-2</c:v>
                </c:pt>
                <c:pt idx="15">
                  <c:v>7.2625698324022409E-2</c:v>
                </c:pt>
                <c:pt idx="16">
                  <c:v>5.5865921787709501E-2</c:v>
                </c:pt>
                <c:pt idx="17">
                  <c:v>5.8659217877095E-2</c:v>
                </c:pt>
                <c:pt idx="18">
                  <c:v>5.3072625698324001E-2</c:v>
                </c:pt>
                <c:pt idx="19">
                  <c:v>5.0279329608938585E-2</c:v>
                </c:pt>
                <c:pt idx="20">
                  <c:v>2.234636871508381E-2</c:v>
                </c:pt>
                <c:pt idx="21">
                  <c:v>3.91061452513966E-2</c:v>
                </c:pt>
                <c:pt idx="22">
                  <c:v>3.0726256983240198E-2</c:v>
                </c:pt>
                <c:pt idx="23">
                  <c:v>2.234636871508381E-2</c:v>
                </c:pt>
                <c:pt idx="24">
                  <c:v>1.3966480446927408E-2</c:v>
                </c:pt>
                <c:pt idx="25">
                  <c:v>8.3798882681564244E-3</c:v>
                </c:pt>
                <c:pt idx="26">
                  <c:v>5.5865921787709516E-3</c:v>
                </c:pt>
                <c:pt idx="27">
                  <c:v>2.793296089385481E-3</c:v>
                </c:pt>
                <c:pt idx="28">
                  <c:v>0</c:v>
                </c:pt>
                <c:pt idx="29">
                  <c:v>2.793296089385481E-3</c:v>
                </c:pt>
                <c:pt idx="30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cat-1(CB1111)_A1_0.02_50%'!$S$104</c:f>
              <c:strCache>
                <c:ptCount val="1"/>
                <c:pt idx="0">
                  <c:v>cat-1(CB1111)_A1_19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S$105:$S$135</c:f>
              <c:numCache>
                <c:formatCode>General</c:formatCode>
                <c:ptCount val="31"/>
                <c:pt idx="1">
                  <c:v>5.3712480252764636E-2</c:v>
                </c:pt>
                <c:pt idx="2">
                  <c:v>3.94944707740916E-2</c:v>
                </c:pt>
                <c:pt idx="3">
                  <c:v>5.0552922590837317E-2</c:v>
                </c:pt>
                <c:pt idx="4">
                  <c:v>5.845181674565559E-2</c:v>
                </c:pt>
                <c:pt idx="5">
                  <c:v>6.3191153238546599E-2</c:v>
                </c:pt>
                <c:pt idx="6">
                  <c:v>5.2132701421800917E-2</c:v>
                </c:pt>
                <c:pt idx="7">
                  <c:v>4.5813586097946335E-2</c:v>
                </c:pt>
                <c:pt idx="8">
                  <c:v>4.7393364928909935E-2</c:v>
                </c:pt>
                <c:pt idx="9">
                  <c:v>5.5292259083728319E-2</c:v>
                </c:pt>
                <c:pt idx="10">
                  <c:v>6.951026856240132E-2</c:v>
                </c:pt>
                <c:pt idx="11">
                  <c:v>5.2132701421800917E-2</c:v>
                </c:pt>
                <c:pt idx="12">
                  <c:v>4.7393364928909935E-2</c:v>
                </c:pt>
                <c:pt idx="13">
                  <c:v>5.3712480252764636E-2</c:v>
                </c:pt>
                <c:pt idx="14">
                  <c:v>3.94944707740916E-2</c:v>
                </c:pt>
                <c:pt idx="15">
                  <c:v>5.3712480252764636E-2</c:v>
                </c:pt>
                <c:pt idx="16">
                  <c:v>4.4233807266982603E-2</c:v>
                </c:pt>
                <c:pt idx="17">
                  <c:v>2.6856240126382311E-2</c:v>
                </c:pt>
                <c:pt idx="18">
                  <c:v>2.3696682464455002E-2</c:v>
                </c:pt>
                <c:pt idx="19">
                  <c:v>1.8957345971564E-2</c:v>
                </c:pt>
                <c:pt idx="20">
                  <c:v>1.26382306477093E-2</c:v>
                </c:pt>
                <c:pt idx="21">
                  <c:v>1.5797788309636705E-2</c:v>
                </c:pt>
                <c:pt idx="22">
                  <c:v>3.1595576619273323E-3</c:v>
                </c:pt>
                <c:pt idx="23">
                  <c:v>9.4786729857819947E-3</c:v>
                </c:pt>
                <c:pt idx="24">
                  <c:v>4.7393364928910052E-3</c:v>
                </c:pt>
                <c:pt idx="25">
                  <c:v>4.7393364928910052E-3</c:v>
                </c:pt>
                <c:pt idx="26">
                  <c:v>1.5797788309636705E-3</c:v>
                </c:pt>
                <c:pt idx="27">
                  <c:v>1.5797788309636705E-3</c:v>
                </c:pt>
                <c:pt idx="28">
                  <c:v>1.5797788309636705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8"/>
          <c:order val="18"/>
          <c:tx>
            <c:strRef>
              <c:f>'cat-1(CB1111)_A1_0.02_50%'!$T$104</c:f>
              <c:strCache>
                <c:ptCount val="1"/>
                <c:pt idx="0">
                  <c:v>cat-1(CB1111)_A1_20</c:v>
                </c:pt>
              </c:strCache>
            </c:strRef>
          </c:tx>
          <c:marker>
            <c:symbol val="none"/>
          </c:marker>
          <c:cat>
            <c:numRef>
              <c:f>'cat-1(CB1111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cat-1(CB1111)_A1_0.02_50%'!$T$105:$T$135</c:f>
              <c:numCache>
                <c:formatCode>General</c:formatCode>
                <c:ptCount val="31"/>
                <c:pt idx="1">
                  <c:v>7.8260869565217397E-2</c:v>
                </c:pt>
                <c:pt idx="2">
                  <c:v>4.8695652173913001E-2</c:v>
                </c:pt>
                <c:pt idx="3">
                  <c:v>6.6086956521739099E-2</c:v>
                </c:pt>
                <c:pt idx="4">
                  <c:v>5.5652173913043515E-2</c:v>
                </c:pt>
                <c:pt idx="5">
                  <c:v>5.0434782608695702E-2</c:v>
                </c:pt>
                <c:pt idx="6">
                  <c:v>5.0434782608695702E-2</c:v>
                </c:pt>
                <c:pt idx="7">
                  <c:v>3.8260869565217404E-2</c:v>
                </c:pt>
                <c:pt idx="8">
                  <c:v>5.3913043478260883E-2</c:v>
                </c:pt>
                <c:pt idx="9">
                  <c:v>5.9130434782608737E-2</c:v>
                </c:pt>
                <c:pt idx="10">
                  <c:v>4.8695652173913001E-2</c:v>
                </c:pt>
                <c:pt idx="11">
                  <c:v>3.6521739130434799E-2</c:v>
                </c:pt>
                <c:pt idx="12">
                  <c:v>3.3043478260869612E-2</c:v>
                </c:pt>
                <c:pt idx="13">
                  <c:v>4.8695652173913001E-2</c:v>
                </c:pt>
                <c:pt idx="14">
                  <c:v>4.3478260869565202E-2</c:v>
                </c:pt>
                <c:pt idx="15">
                  <c:v>2.7826086956521699E-2</c:v>
                </c:pt>
                <c:pt idx="16">
                  <c:v>3.3043478260869612E-2</c:v>
                </c:pt>
                <c:pt idx="17">
                  <c:v>3.8260869565217404E-2</c:v>
                </c:pt>
                <c:pt idx="18">
                  <c:v>1.7391304347826101E-2</c:v>
                </c:pt>
                <c:pt idx="19">
                  <c:v>2.4347826086956507E-2</c:v>
                </c:pt>
                <c:pt idx="20">
                  <c:v>1.56521739130435E-2</c:v>
                </c:pt>
                <c:pt idx="21">
                  <c:v>1.7391304347826101E-2</c:v>
                </c:pt>
                <c:pt idx="22">
                  <c:v>1.56521739130435E-2</c:v>
                </c:pt>
                <c:pt idx="23">
                  <c:v>1.04347826086957E-2</c:v>
                </c:pt>
                <c:pt idx="24">
                  <c:v>6.956521739130442E-3</c:v>
                </c:pt>
                <c:pt idx="25">
                  <c:v>1.7391304347826105E-3</c:v>
                </c:pt>
                <c:pt idx="26">
                  <c:v>1.04347826086957E-2</c:v>
                </c:pt>
                <c:pt idx="27">
                  <c:v>1.7391304347826105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marker val="1"/>
        <c:axId val="168936192"/>
        <c:axId val="168937728"/>
      </c:lineChart>
      <c:catAx>
        <c:axId val="168936192"/>
        <c:scaling>
          <c:orientation val="minMax"/>
        </c:scaling>
        <c:axPos val="b"/>
        <c:numFmt formatCode="0.0_ " sourceLinked="1"/>
        <c:tickLblPos val="nextTo"/>
        <c:crossAx val="168937728"/>
        <c:crosses val="autoZero"/>
        <c:auto val="1"/>
        <c:lblAlgn val="ctr"/>
        <c:lblOffset val="100"/>
        <c:tickLblSkip val="5"/>
        <c:tickMarkSkip val="5"/>
      </c:catAx>
      <c:valAx>
        <c:axId val="168937728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8936192"/>
        <c:crosses val="autoZero"/>
        <c:crossBetween val="between"/>
      </c:valAx>
    </c:plotArea>
    <c:plotVisOnly val="1"/>
  </c:chart>
  <c:externalData r:id="rId1"/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tph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3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tph-1(mg280)_A3_0.02_50%'!$B$104</c:f>
              <c:strCache>
                <c:ptCount val="1"/>
                <c:pt idx="0">
                  <c:v>tph-1(mg280)_A3_01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B$105:$B$135</c:f>
              <c:numCache>
                <c:formatCode>General</c:formatCode>
                <c:ptCount val="31"/>
                <c:pt idx="1">
                  <c:v>6.382978723404252E-2</c:v>
                </c:pt>
                <c:pt idx="2">
                  <c:v>2.1276595744680899E-2</c:v>
                </c:pt>
                <c:pt idx="3">
                  <c:v>4.7872340425531915E-2</c:v>
                </c:pt>
                <c:pt idx="4">
                  <c:v>3.1914893617021316E-2</c:v>
                </c:pt>
                <c:pt idx="5">
                  <c:v>1.0638297872340394E-2</c:v>
                </c:pt>
                <c:pt idx="6">
                  <c:v>2.6595744680851106E-2</c:v>
                </c:pt>
                <c:pt idx="7">
                  <c:v>3.1914893617021316E-2</c:v>
                </c:pt>
                <c:pt idx="8">
                  <c:v>3.1914893617021316E-2</c:v>
                </c:pt>
                <c:pt idx="9">
                  <c:v>1.0638297872340394E-2</c:v>
                </c:pt>
                <c:pt idx="10">
                  <c:v>1.0638297872340394E-2</c:v>
                </c:pt>
                <c:pt idx="11">
                  <c:v>4.2553191489361715E-2</c:v>
                </c:pt>
                <c:pt idx="12">
                  <c:v>2.6595744680851106E-2</c:v>
                </c:pt>
                <c:pt idx="13">
                  <c:v>3.7234042553191522E-2</c:v>
                </c:pt>
                <c:pt idx="14">
                  <c:v>2.6595744680851106E-2</c:v>
                </c:pt>
                <c:pt idx="15">
                  <c:v>6.914893617021281E-2</c:v>
                </c:pt>
                <c:pt idx="16">
                  <c:v>2.6595744680851106E-2</c:v>
                </c:pt>
                <c:pt idx="17">
                  <c:v>5.8510638297872314E-2</c:v>
                </c:pt>
                <c:pt idx="18">
                  <c:v>2.6595744680851106E-2</c:v>
                </c:pt>
                <c:pt idx="19">
                  <c:v>3.1914893617021316E-2</c:v>
                </c:pt>
                <c:pt idx="20">
                  <c:v>6.382978723404252E-2</c:v>
                </c:pt>
                <c:pt idx="21">
                  <c:v>2.1276595744680899E-2</c:v>
                </c:pt>
                <c:pt idx="22">
                  <c:v>3.1914893617021316E-2</c:v>
                </c:pt>
                <c:pt idx="23">
                  <c:v>1.5957446808510599E-2</c:v>
                </c:pt>
                <c:pt idx="24">
                  <c:v>1.5957446808510599E-2</c:v>
                </c:pt>
                <c:pt idx="25">
                  <c:v>5.31914893617021E-3</c:v>
                </c:pt>
                <c:pt idx="26">
                  <c:v>5.31914893617021E-3</c:v>
                </c:pt>
                <c:pt idx="27">
                  <c:v>1.5957446808510599E-2</c:v>
                </c:pt>
                <c:pt idx="28">
                  <c:v>1.0638297872340394E-2</c:v>
                </c:pt>
                <c:pt idx="29">
                  <c:v>2.6595744680851106E-2</c:v>
                </c:pt>
                <c:pt idx="30">
                  <c:v>0</c:v>
                </c:pt>
              </c:numCache>
            </c:numRef>
          </c:val>
        </c:ser>
        <c:ser>
          <c:idx val="1"/>
          <c:order val="1"/>
          <c:tx>
            <c:strRef>
              <c:f>'tph-1(mg280)_A3_0.02_50%'!$C$104</c:f>
              <c:strCache>
                <c:ptCount val="1"/>
                <c:pt idx="0">
                  <c:v>tph-1(mg280)_A3_02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C$105:$C$135</c:f>
              <c:numCache>
                <c:formatCode>General</c:formatCode>
                <c:ptCount val="31"/>
                <c:pt idx="1">
                  <c:v>6.6666666666666693E-2</c:v>
                </c:pt>
                <c:pt idx="2">
                  <c:v>5.8333333333333334E-2</c:v>
                </c:pt>
                <c:pt idx="3">
                  <c:v>3.3333333333333298E-2</c:v>
                </c:pt>
                <c:pt idx="4">
                  <c:v>4.1666666666666699E-2</c:v>
                </c:pt>
                <c:pt idx="5">
                  <c:v>0</c:v>
                </c:pt>
                <c:pt idx="6">
                  <c:v>8.3333333333333297E-3</c:v>
                </c:pt>
                <c:pt idx="7">
                  <c:v>1.6666666666666701E-2</c:v>
                </c:pt>
                <c:pt idx="8">
                  <c:v>3.3333333333333298E-2</c:v>
                </c:pt>
                <c:pt idx="9">
                  <c:v>1.6666666666666701E-2</c:v>
                </c:pt>
                <c:pt idx="10">
                  <c:v>3.3333333333333298E-2</c:v>
                </c:pt>
                <c:pt idx="11">
                  <c:v>6.6666666666666693E-2</c:v>
                </c:pt>
                <c:pt idx="12">
                  <c:v>3.3333333333333298E-2</c:v>
                </c:pt>
                <c:pt idx="13">
                  <c:v>4.1666666666666699E-2</c:v>
                </c:pt>
                <c:pt idx="14">
                  <c:v>5.8333333333333334E-2</c:v>
                </c:pt>
                <c:pt idx="15">
                  <c:v>6.6666666666666693E-2</c:v>
                </c:pt>
                <c:pt idx="16">
                  <c:v>5.8333333333333334E-2</c:v>
                </c:pt>
                <c:pt idx="17">
                  <c:v>0.05</c:v>
                </c:pt>
                <c:pt idx="18">
                  <c:v>8.3333333333333297E-3</c:v>
                </c:pt>
                <c:pt idx="19">
                  <c:v>3.3333333333333298E-2</c:v>
                </c:pt>
                <c:pt idx="20">
                  <c:v>2.5000000000000001E-2</c:v>
                </c:pt>
                <c:pt idx="21">
                  <c:v>1.6666666666666701E-2</c:v>
                </c:pt>
                <c:pt idx="22">
                  <c:v>2.5000000000000001E-2</c:v>
                </c:pt>
                <c:pt idx="23">
                  <c:v>1.6666666666666701E-2</c:v>
                </c:pt>
                <c:pt idx="24">
                  <c:v>8.3333333333333297E-3</c:v>
                </c:pt>
                <c:pt idx="25">
                  <c:v>1.6666666666666701E-2</c:v>
                </c:pt>
                <c:pt idx="26">
                  <c:v>0</c:v>
                </c:pt>
                <c:pt idx="27">
                  <c:v>2.5000000000000001E-2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tph-1(mg280)_A3_0.02_50%'!$D$104</c:f>
              <c:strCache>
                <c:ptCount val="1"/>
                <c:pt idx="0">
                  <c:v>tph-1(mg280)_A3_03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D$105:$D$135</c:f>
              <c:numCache>
                <c:formatCode>General</c:formatCode>
                <c:ptCount val="31"/>
                <c:pt idx="1">
                  <c:v>0</c:v>
                </c:pt>
                <c:pt idx="2">
                  <c:v>2.6548672566371709E-2</c:v>
                </c:pt>
                <c:pt idx="3">
                  <c:v>8.8495575221238972E-3</c:v>
                </c:pt>
                <c:pt idx="4">
                  <c:v>8.8495575221238972E-3</c:v>
                </c:pt>
                <c:pt idx="5">
                  <c:v>6.1946902654867297E-2</c:v>
                </c:pt>
                <c:pt idx="6">
                  <c:v>3.5398230088495602E-2</c:v>
                </c:pt>
                <c:pt idx="7">
                  <c:v>8.8495575221238972E-3</c:v>
                </c:pt>
                <c:pt idx="8">
                  <c:v>1.7699115044247801E-2</c:v>
                </c:pt>
                <c:pt idx="9">
                  <c:v>2.6548672566371709E-2</c:v>
                </c:pt>
                <c:pt idx="10">
                  <c:v>8.8495575221238972E-3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2.6548672566371709E-2</c:v>
                </c:pt>
                <c:pt idx="15">
                  <c:v>8.8495575221238972E-3</c:v>
                </c:pt>
                <c:pt idx="16">
                  <c:v>1.7699115044247801E-2</c:v>
                </c:pt>
                <c:pt idx="17">
                  <c:v>3.5398230088495602E-2</c:v>
                </c:pt>
                <c:pt idx="18">
                  <c:v>2.6548672566371709E-2</c:v>
                </c:pt>
                <c:pt idx="19">
                  <c:v>8.8495575221238972E-3</c:v>
                </c:pt>
                <c:pt idx="20">
                  <c:v>3.5398230088495602E-2</c:v>
                </c:pt>
                <c:pt idx="21">
                  <c:v>3.5398230088495602E-2</c:v>
                </c:pt>
                <c:pt idx="22">
                  <c:v>5.3097345132743404E-2</c:v>
                </c:pt>
                <c:pt idx="23">
                  <c:v>2.6548672566371709E-2</c:v>
                </c:pt>
                <c:pt idx="24">
                  <c:v>4.4247787610619496E-2</c:v>
                </c:pt>
                <c:pt idx="25">
                  <c:v>4.4247787610619496E-2</c:v>
                </c:pt>
                <c:pt idx="26">
                  <c:v>2.6548672566371709E-2</c:v>
                </c:pt>
                <c:pt idx="27">
                  <c:v>0</c:v>
                </c:pt>
                <c:pt idx="28">
                  <c:v>5.3097345132743404E-2</c:v>
                </c:pt>
                <c:pt idx="29">
                  <c:v>4.4247787610619496E-2</c:v>
                </c:pt>
                <c:pt idx="30">
                  <c:v>7.9646017699115002E-2</c:v>
                </c:pt>
              </c:numCache>
            </c:numRef>
          </c:val>
        </c:ser>
        <c:ser>
          <c:idx val="3"/>
          <c:order val="3"/>
          <c:tx>
            <c:strRef>
              <c:f>'tph-1(mg280)_A3_0.02_50%'!$E$104</c:f>
              <c:strCache>
                <c:ptCount val="1"/>
                <c:pt idx="0">
                  <c:v>tph-1(mg280)_A3_04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E$105:$E$135</c:f>
              <c:numCache>
                <c:formatCode>General</c:formatCode>
                <c:ptCount val="31"/>
                <c:pt idx="1">
                  <c:v>4.40251572327044E-2</c:v>
                </c:pt>
                <c:pt idx="2">
                  <c:v>3.1446540880503131E-2</c:v>
                </c:pt>
                <c:pt idx="3">
                  <c:v>6.2893081761006336E-3</c:v>
                </c:pt>
                <c:pt idx="4">
                  <c:v>2.515723270440251E-2</c:v>
                </c:pt>
                <c:pt idx="5">
                  <c:v>1.2578616352201295E-2</c:v>
                </c:pt>
                <c:pt idx="6">
                  <c:v>3.7735849056603821E-2</c:v>
                </c:pt>
                <c:pt idx="7">
                  <c:v>3.1446540880503131E-2</c:v>
                </c:pt>
                <c:pt idx="8">
                  <c:v>4.40251572327044E-2</c:v>
                </c:pt>
                <c:pt idx="9">
                  <c:v>3.1446540880503131E-2</c:v>
                </c:pt>
                <c:pt idx="10">
                  <c:v>2.515723270440251E-2</c:v>
                </c:pt>
                <c:pt idx="11">
                  <c:v>3.1446540880503131E-2</c:v>
                </c:pt>
                <c:pt idx="12">
                  <c:v>5.0314465408804999E-2</c:v>
                </c:pt>
                <c:pt idx="13">
                  <c:v>5.0314465408804999E-2</c:v>
                </c:pt>
                <c:pt idx="14">
                  <c:v>7.5471698113207503E-2</c:v>
                </c:pt>
                <c:pt idx="15">
                  <c:v>7.5471698113207503E-2</c:v>
                </c:pt>
                <c:pt idx="16">
                  <c:v>5.0314465408804999E-2</c:v>
                </c:pt>
                <c:pt idx="17">
                  <c:v>7.5471698113207503E-2</c:v>
                </c:pt>
                <c:pt idx="18">
                  <c:v>6.2893081761006331E-2</c:v>
                </c:pt>
                <c:pt idx="19">
                  <c:v>6.2893081761006331E-2</c:v>
                </c:pt>
                <c:pt idx="20">
                  <c:v>2.515723270440251E-2</c:v>
                </c:pt>
                <c:pt idx="21">
                  <c:v>1.2578616352201295E-2</c:v>
                </c:pt>
                <c:pt idx="22">
                  <c:v>1.88679245283019E-2</c:v>
                </c:pt>
                <c:pt idx="23">
                  <c:v>1.88679245283019E-2</c:v>
                </c:pt>
                <c:pt idx="24">
                  <c:v>3.1446540880503131E-2</c:v>
                </c:pt>
                <c:pt idx="25">
                  <c:v>6.2893081761006336E-3</c:v>
                </c:pt>
                <c:pt idx="26">
                  <c:v>6.2893081761006336E-3</c:v>
                </c:pt>
                <c:pt idx="27">
                  <c:v>6.2893081761006336E-3</c:v>
                </c:pt>
                <c:pt idx="28">
                  <c:v>6.2893081761006336E-3</c:v>
                </c:pt>
                <c:pt idx="29">
                  <c:v>6.2893081761006336E-3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tph-1(mg280)_A3_0.02_50%'!$F$104</c:f>
              <c:strCache>
                <c:ptCount val="1"/>
                <c:pt idx="0">
                  <c:v>tph-1(mg280)_A3_05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F$105:$F$135</c:f>
              <c:numCache>
                <c:formatCode>General</c:formatCode>
                <c:ptCount val="31"/>
                <c:pt idx="1">
                  <c:v>8.1818181818181734E-2</c:v>
                </c:pt>
                <c:pt idx="2">
                  <c:v>9.0909090909090939E-2</c:v>
                </c:pt>
                <c:pt idx="3">
                  <c:v>6.3636363636363602E-2</c:v>
                </c:pt>
                <c:pt idx="4">
                  <c:v>5.4545454545454487E-2</c:v>
                </c:pt>
                <c:pt idx="5">
                  <c:v>4.5454545454545497E-2</c:v>
                </c:pt>
                <c:pt idx="6">
                  <c:v>1.8181818181818205E-2</c:v>
                </c:pt>
                <c:pt idx="7">
                  <c:v>9.0909090909090991E-3</c:v>
                </c:pt>
                <c:pt idx="8">
                  <c:v>1.8181818181818205E-2</c:v>
                </c:pt>
                <c:pt idx="9">
                  <c:v>1.8181818181818205E-2</c:v>
                </c:pt>
                <c:pt idx="10">
                  <c:v>9.0909090909090991E-3</c:v>
                </c:pt>
                <c:pt idx="11">
                  <c:v>0</c:v>
                </c:pt>
                <c:pt idx="12">
                  <c:v>0</c:v>
                </c:pt>
                <c:pt idx="13">
                  <c:v>9.0909090909090991E-3</c:v>
                </c:pt>
                <c:pt idx="14">
                  <c:v>9.0909090909090991E-3</c:v>
                </c:pt>
                <c:pt idx="15">
                  <c:v>2.7272727272727313E-2</c:v>
                </c:pt>
                <c:pt idx="16">
                  <c:v>1.8181818181818205E-2</c:v>
                </c:pt>
                <c:pt idx="17">
                  <c:v>1.8181818181818205E-2</c:v>
                </c:pt>
                <c:pt idx="18">
                  <c:v>2.7272727272727313E-2</c:v>
                </c:pt>
                <c:pt idx="19">
                  <c:v>2.7272727272727313E-2</c:v>
                </c:pt>
                <c:pt idx="20">
                  <c:v>4.5454545454545497E-2</c:v>
                </c:pt>
                <c:pt idx="21">
                  <c:v>4.5454545454545497E-2</c:v>
                </c:pt>
                <c:pt idx="22">
                  <c:v>0</c:v>
                </c:pt>
                <c:pt idx="23">
                  <c:v>5.4545454545454487E-2</c:v>
                </c:pt>
                <c:pt idx="24">
                  <c:v>3.6363636363636397E-2</c:v>
                </c:pt>
                <c:pt idx="25">
                  <c:v>4.5454545454545497E-2</c:v>
                </c:pt>
                <c:pt idx="26">
                  <c:v>1.8181818181818205E-2</c:v>
                </c:pt>
                <c:pt idx="27">
                  <c:v>9.0909090909090991E-3</c:v>
                </c:pt>
                <c:pt idx="28">
                  <c:v>9.0909090909090991E-3</c:v>
                </c:pt>
                <c:pt idx="29">
                  <c:v>0</c:v>
                </c:pt>
                <c:pt idx="30">
                  <c:v>9.0909090909090991E-3</c:v>
                </c:pt>
              </c:numCache>
            </c:numRef>
          </c:val>
        </c:ser>
        <c:ser>
          <c:idx val="5"/>
          <c:order val="5"/>
          <c:tx>
            <c:strRef>
              <c:f>'tph-1(mg280)_A3_0.02_50%'!$G$104</c:f>
              <c:strCache>
                <c:ptCount val="1"/>
                <c:pt idx="0">
                  <c:v>tph-1(mg280)_A3_06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G$105:$G$135</c:f>
              <c:numCache>
                <c:formatCode>General</c:formatCode>
                <c:ptCount val="31"/>
                <c:pt idx="1">
                  <c:v>1.2383900928792598E-2</c:v>
                </c:pt>
                <c:pt idx="2">
                  <c:v>1.8575851393188913E-2</c:v>
                </c:pt>
                <c:pt idx="3">
                  <c:v>3.4055727554179613E-2</c:v>
                </c:pt>
                <c:pt idx="4">
                  <c:v>2.7863777089783322E-2</c:v>
                </c:pt>
                <c:pt idx="5">
                  <c:v>2.1671826625387011E-2</c:v>
                </c:pt>
                <c:pt idx="6">
                  <c:v>1.2383900928792598E-2</c:v>
                </c:pt>
                <c:pt idx="7">
                  <c:v>2.4767801857585092E-2</c:v>
                </c:pt>
                <c:pt idx="8">
                  <c:v>1.54798761609907E-2</c:v>
                </c:pt>
                <c:pt idx="9">
                  <c:v>1.54798761609907E-2</c:v>
                </c:pt>
                <c:pt idx="10">
                  <c:v>2.1671826625387011E-2</c:v>
                </c:pt>
                <c:pt idx="11">
                  <c:v>2.7863777089783322E-2</c:v>
                </c:pt>
                <c:pt idx="12">
                  <c:v>3.09597523219814E-2</c:v>
                </c:pt>
                <c:pt idx="13">
                  <c:v>4.0247678018575886E-2</c:v>
                </c:pt>
                <c:pt idx="14">
                  <c:v>3.4055727554179613E-2</c:v>
                </c:pt>
                <c:pt idx="15">
                  <c:v>6.19195046439628E-2</c:v>
                </c:pt>
                <c:pt idx="16">
                  <c:v>6.19195046439628E-2</c:v>
                </c:pt>
                <c:pt idx="17">
                  <c:v>5.8823529411764698E-2</c:v>
                </c:pt>
                <c:pt idx="18">
                  <c:v>6.5015479876161034E-2</c:v>
                </c:pt>
                <c:pt idx="19">
                  <c:v>8.0495356037151702E-2</c:v>
                </c:pt>
                <c:pt idx="20">
                  <c:v>7.4303405572755402E-2</c:v>
                </c:pt>
                <c:pt idx="21">
                  <c:v>5.8823529411764698E-2</c:v>
                </c:pt>
                <c:pt idx="22">
                  <c:v>3.7151702786377722E-2</c:v>
                </c:pt>
                <c:pt idx="23">
                  <c:v>3.09597523219814E-2</c:v>
                </c:pt>
                <c:pt idx="24">
                  <c:v>2.7863777089783322E-2</c:v>
                </c:pt>
                <c:pt idx="25">
                  <c:v>1.2383900928792598E-2</c:v>
                </c:pt>
                <c:pt idx="26">
                  <c:v>3.09597523219814E-3</c:v>
                </c:pt>
                <c:pt idx="27">
                  <c:v>6.1919504643962895E-3</c:v>
                </c:pt>
                <c:pt idx="28">
                  <c:v>3.09597523219814E-3</c:v>
                </c:pt>
                <c:pt idx="29">
                  <c:v>9.2879256965944269E-3</c:v>
                </c:pt>
                <c:pt idx="30">
                  <c:v>6.1919504643962895E-3</c:v>
                </c:pt>
              </c:numCache>
            </c:numRef>
          </c:val>
        </c:ser>
        <c:ser>
          <c:idx val="6"/>
          <c:order val="6"/>
          <c:tx>
            <c:strRef>
              <c:f>'tph-1(mg280)_A3_0.02_50%'!$H$104</c:f>
              <c:strCache>
                <c:ptCount val="1"/>
                <c:pt idx="0">
                  <c:v>tph-1(mg280)_A3_07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H$105:$H$135</c:f>
              <c:numCache>
                <c:formatCode>General</c:formatCode>
                <c:ptCount val="31"/>
                <c:pt idx="1">
                  <c:v>9.1743119266055103E-3</c:v>
                </c:pt>
                <c:pt idx="2">
                  <c:v>9.1743119266055103E-3</c:v>
                </c:pt>
                <c:pt idx="3">
                  <c:v>2.7522935779816515E-2</c:v>
                </c:pt>
                <c:pt idx="4">
                  <c:v>9.1743119266055103E-3</c:v>
                </c:pt>
                <c:pt idx="5">
                  <c:v>1.8348623853211E-2</c:v>
                </c:pt>
                <c:pt idx="6">
                  <c:v>9.1743119266055103E-3</c:v>
                </c:pt>
                <c:pt idx="7">
                  <c:v>0</c:v>
                </c:pt>
                <c:pt idx="8">
                  <c:v>0</c:v>
                </c:pt>
                <c:pt idx="9">
                  <c:v>1.8348623853211E-2</c:v>
                </c:pt>
                <c:pt idx="10">
                  <c:v>0</c:v>
                </c:pt>
                <c:pt idx="11">
                  <c:v>1.8348623853211E-2</c:v>
                </c:pt>
                <c:pt idx="12">
                  <c:v>2.7522935779816515E-2</c:v>
                </c:pt>
                <c:pt idx="13">
                  <c:v>0</c:v>
                </c:pt>
                <c:pt idx="14">
                  <c:v>9.1743119266055103E-3</c:v>
                </c:pt>
                <c:pt idx="15">
                  <c:v>1.8348623853211E-2</c:v>
                </c:pt>
                <c:pt idx="16">
                  <c:v>2.7522935779816515E-2</c:v>
                </c:pt>
                <c:pt idx="17">
                  <c:v>1.8348623853211E-2</c:v>
                </c:pt>
                <c:pt idx="18">
                  <c:v>6.4220183486238494E-2</c:v>
                </c:pt>
                <c:pt idx="19">
                  <c:v>6.4220183486238494E-2</c:v>
                </c:pt>
                <c:pt idx="20">
                  <c:v>3.6697247706422027E-2</c:v>
                </c:pt>
                <c:pt idx="21">
                  <c:v>6.4220183486238494E-2</c:v>
                </c:pt>
                <c:pt idx="22">
                  <c:v>8.256880733944956E-2</c:v>
                </c:pt>
                <c:pt idx="23">
                  <c:v>0.10091743119266094</c:v>
                </c:pt>
                <c:pt idx="24">
                  <c:v>4.5871559633027484E-2</c:v>
                </c:pt>
                <c:pt idx="25">
                  <c:v>3.6697247706422027E-2</c:v>
                </c:pt>
                <c:pt idx="26">
                  <c:v>2.7522935779816515E-2</c:v>
                </c:pt>
                <c:pt idx="27">
                  <c:v>3.6697247706422027E-2</c:v>
                </c:pt>
                <c:pt idx="28">
                  <c:v>1.8348623853211E-2</c:v>
                </c:pt>
                <c:pt idx="29">
                  <c:v>1.8348623853211E-2</c:v>
                </c:pt>
                <c:pt idx="30">
                  <c:v>1.8348623853211E-2</c:v>
                </c:pt>
              </c:numCache>
            </c:numRef>
          </c:val>
        </c:ser>
        <c:ser>
          <c:idx val="7"/>
          <c:order val="7"/>
          <c:tx>
            <c:strRef>
              <c:f>'tph-1(mg280)_A3_0.02_50%'!$I$104</c:f>
              <c:strCache>
                <c:ptCount val="1"/>
                <c:pt idx="0">
                  <c:v>tph-1(mg280)_A3_08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I$105:$I$135</c:f>
              <c:numCache>
                <c:formatCode>General</c:formatCode>
                <c:ptCount val="31"/>
                <c:pt idx="1">
                  <c:v>3.7558685446009404E-2</c:v>
                </c:pt>
                <c:pt idx="2">
                  <c:v>9.3896713615023525E-2</c:v>
                </c:pt>
                <c:pt idx="3">
                  <c:v>7.0422535211267595E-2</c:v>
                </c:pt>
                <c:pt idx="4">
                  <c:v>6.103286384976532E-2</c:v>
                </c:pt>
                <c:pt idx="5">
                  <c:v>5.1643192488262865E-2</c:v>
                </c:pt>
                <c:pt idx="6">
                  <c:v>4.69483568075117E-2</c:v>
                </c:pt>
                <c:pt idx="7">
                  <c:v>3.2863849765258211E-2</c:v>
                </c:pt>
                <c:pt idx="8">
                  <c:v>2.8169014084506998E-2</c:v>
                </c:pt>
                <c:pt idx="9">
                  <c:v>4.69483568075117E-2</c:v>
                </c:pt>
                <c:pt idx="10">
                  <c:v>2.8169014084506998E-2</c:v>
                </c:pt>
                <c:pt idx="11">
                  <c:v>1.8779342723004699E-2</c:v>
                </c:pt>
                <c:pt idx="12">
                  <c:v>3.7558685446009404E-2</c:v>
                </c:pt>
                <c:pt idx="13">
                  <c:v>1.8779342723004699E-2</c:v>
                </c:pt>
                <c:pt idx="14">
                  <c:v>2.8169014084506998E-2</c:v>
                </c:pt>
                <c:pt idx="15">
                  <c:v>1.8779342723004699E-2</c:v>
                </c:pt>
                <c:pt idx="16">
                  <c:v>0</c:v>
                </c:pt>
                <c:pt idx="17">
                  <c:v>3.2863849765258211E-2</c:v>
                </c:pt>
                <c:pt idx="18">
                  <c:v>1.8779342723004699E-2</c:v>
                </c:pt>
                <c:pt idx="19">
                  <c:v>2.3474178403755909E-2</c:v>
                </c:pt>
                <c:pt idx="20">
                  <c:v>2.8169014084506998E-2</c:v>
                </c:pt>
                <c:pt idx="21">
                  <c:v>2.3474178403755909E-2</c:v>
                </c:pt>
                <c:pt idx="22">
                  <c:v>2.3474178403755909E-2</c:v>
                </c:pt>
                <c:pt idx="23">
                  <c:v>2.3474178403755909E-2</c:v>
                </c:pt>
                <c:pt idx="24">
                  <c:v>0</c:v>
                </c:pt>
                <c:pt idx="25">
                  <c:v>9.3896713615023528E-3</c:v>
                </c:pt>
                <c:pt idx="26">
                  <c:v>1.8779342723004699E-2</c:v>
                </c:pt>
                <c:pt idx="27">
                  <c:v>1.4084507042253504E-2</c:v>
                </c:pt>
                <c:pt idx="28">
                  <c:v>0</c:v>
                </c:pt>
                <c:pt idx="29">
                  <c:v>9.3896713615023528E-3</c:v>
                </c:pt>
                <c:pt idx="30">
                  <c:v>4.6948356807511703E-3</c:v>
                </c:pt>
              </c:numCache>
            </c:numRef>
          </c:val>
        </c:ser>
        <c:ser>
          <c:idx val="8"/>
          <c:order val="8"/>
          <c:tx>
            <c:strRef>
              <c:f>'tph-1(mg280)_A3_0.02_50%'!$J$104</c:f>
              <c:strCache>
                <c:ptCount val="1"/>
                <c:pt idx="0">
                  <c:v>tph-1(mg280)_A3_09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J$105:$J$135</c:f>
              <c:numCache>
                <c:formatCode>General</c:formatCode>
                <c:ptCount val="31"/>
                <c:pt idx="1">
                  <c:v>9.160305343511449E-2</c:v>
                </c:pt>
                <c:pt idx="2">
                  <c:v>8.396946564885506E-2</c:v>
                </c:pt>
                <c:pt idx="3">
                  <c:v>3.8167938931297683E-2</c:v>
                </c:pt>
                <c:pt idx="4">
                  <c:v>3.8167938931297683E-2</c:v>
                </c:pt>
                <c:pt idx="5">
                  <c:v>3.8167938931297683E-2</c:v>
                </c:pt>
                <c:pt idx="6">
                  <c:v>1.5267175572519104E-2</c:v>
                </c:pt>
                <c:pt idx="7">
                  <c:v>3.0534351145038191E-2</c:v>
                </c:pt>
                <c:pt idx="8">
                  <c:v>2.2900763358778602E-2</c:v>
                </c:pt>
                <c:pt idx="9">
                  <c:v>1.5267175572519104E-2</c:v>
                </c:pt>
                <c:pt idx="10">
                  <c:v>2.2900763358778602E-2</c:v>
                </c:pt>
                <c:pt idx="11">
                  <c:v>2.2900763358778602E-2</c:v>
                </c:pt>
                <c:pt idx="12">
                  <c:v>7.6335877862595417E-3</c:v>
                </c:pt>
                <c:pt idx="13">
                  <c:v>1.5267175572519104E-2</c:v>
                </c:pt>
                <c:pt idx="14">
                  <c:v>2.2900763358778602E-2</c:v>
                </c:pt>
                <c:pt idx="15">
                  <c:v>1.5267175572519104E-2</c:v>
                </c:pt>
                <c:pt idx="16">
                  <c:v>7.6335877862595417E-3</c:v>
                </c:pt>
                <c:pt idx="17">
                  <c:v>1.5267175572519104E-2</c:v>
                </c:pt>
                <c:pt idx="18">
                  <c:v>0</c:v>
                </c:pt>
                <c:pt idx="19">
                  <c:v>5.3435114503816813E-2</c:v>
                </c:pt>
                <c:pt idx="20">
                  <c:v>2.2900763358778602E-2</c:v>
                </c:pt>
                <c:pt idx="21">
                  <c:v>4.58015267175573E-2</c:v>
                </c:pt>
                <c:pt idx="22">
                  <c:v>3.0534351145038191E-2</c:v>
                </c:pt>
                <c:pt idx="23">
                  <c:v>7.6335877862595417E-3</c:v>
                </c:pt>
                <c:pt idx="24">
                  <c:v>0</c:v>
                </c:pt>
                <c:pt idx="25">
                  <c:v>7.6335877862595417E-3</c:v>
                </c:pt>
                <c:pt idx="26">
                  <c:v>1.5267175572519104E-2</c:v>
                </c:pt>
                <c:pt idx="27">
                  <c:v>1.5267175572519104E-2</c:v>
                </c:pt>
                <c:pt idx="28">
                  <c:v>2.2900763358778602E-2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tph-1(mg280)_A3_0.02_50%'!$K$104</c:f>
              <c:strCache>
                <c:ptCount val="1"/>
                <c:pt idx="0">
                  <c:v>tph-1(mg280)_A3_10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K$105:$K$135</c:f>
              <c:numCache>
                <c:formatCode>General</c:formatCode>
                <c:ptCount val="31"/>
              </c:numCache>
            </c:numRef>
          </c:val>
        </c:ser>
        <c:ser>
          <c:idx val="10"/>
          <c:order val="10"/>
          <c:tx>
            <c:strRef>
              <c:f>'tph-1(mg280)_A3_0.02_50%'!$L$104</c:f>
              <c:strCache>
                <c:ptCount val="1"/>
                <c:pt idx="0">
                  <c:v>tph-1(mg280)_A3_11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L$105:$L$135</c:f>
              <c:numCache>
                <c:formatCode>General</c:formatCode>
                <c:ptCount val="31"/>
                <c:pt idx="1">
                  <c:v>0.16666666666666693</c:v>
                </c:pt>
                <c:pt idx="2">
                  <c:v>0.16666666666666693</c:v>
                </c:pt>
                <c:pt idx="3">
                  <c:v>0</c:v>
                </c:pt>
                <c:pt idx="4">
                  <c:v>0</c:v>
                </c:pt>
                <c:pt idx="5">
                  <c:v>2.7777777777777821E-2</c:v>
                </c:pt>
                <c:pt idx="6">
                  <c:v>5.555555555555558E-2</c:v>
                </c:pt>
                <c:pt idx="7">
                  <c:v>2.7777777777777821E-2</c:v>
                </c:pt>
                <c:pt idx="8">
                  <c:v>0</c:v>
                </c:pt>
                <c:pt idx="9">
                  <c:v>0</c:v>
                </c:pt>
                <c:pt idx="10">
                  <c:v>2.7777777777777821E-2</c:v>
                </c:pt>
                <c:pt idx="11">
                  <c:v>0</c:v>
                </c:pt>
                <c:pt idx="12">
                  <c:v>2.7777777777777821E-2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2.7777777777777821E-2</c:v>
                </c:pt>
                <c:pt idx="19">
                  <c:v>2.7777777777777821E-2</c:v>
                </c:pt>
                <c:pt idx="20">
                  <c:v>5.555555555555558E-2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tph-1(mg280)_A3_0.02_50%'!$M$104</c:f>
              <c:strCache>
                <c:ptCount val="1"/>
                <c:pt idx="0">
                  <c:v>tph-1(mg280)_A3_12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M$105:$M$135</c:f>
              <c:numCache>
                <c:formatCode>General</c:formatCode>
                <c:ptCount val="31"/>
                <c:pt idx="1">
                  <c:v>3.8759689922480599E-2</c:v>
                </c:pt>
                <c:pt idx="2">
                  <c:v>5.4263565891472902E-2</c:v>
                </c:pt>
                <c:pt idx="3">
                  <c:v>7.7519379844961231E-3</c:v>
                </c:pt>
                <c:pt idx="4">
                  <c:v>1.5503875968992208E-2</c:v>
                </c:pt>
                <c:pt idx="5">
                  <c:v>2.32558139534884E-2</c:v>
                </c:pt>
                <c:pt idx="6">
                  <c:v>0</c:v>
                </c:pt>
                <c:pt idx="7">
                  <c:v>3.1007751937984492E-2</c:v>
                </c:pt>
                <c:pt idx="8">
                  <c:v>0</c:v>
                </c:pt>
                <c:pt idx="9">
                  <c:v>2.32558139534884E-2</c:v>
                </c:pt>
                <c:pt idx="10">
                  <c:v>3.8759689922480599E-2</c:v>
                </c:pt>
                <c:pt idx="11">
                  <c:v>0</c:v>
                </c:pt>
                <c:pt idx="12">
                  <c:v>4.6511627906976737E-2</c:v>
                </c:pt>
                <c:pt idx="13">
                  <c:v>5.4263565891472902E-2</c:v>
                </c:pt>
                <c:pt idx="14">
                  <c:v>4.6511627906976737E-2</c:v>
                </c:pt>
                <c:pt idx="15">
                  <c:v>8.5271317829457405E-2</c:v>
                </c:pt>
                <c:pt idx="16">
                  <c:v>5.4263565891472902E-2</c:v>
                </c:pt>
                <c:pt idx="17">
                  <c:v>3.8759689922480599E-2</c:v>
                </c:pt>
                <c:pt idx="18">
                  <c:v>5.4263565891472902E-2</c:v>
                </c:pt>
                <c:pt idx="19">
                  <c:v>3.8759689922480599E-2</c:v>
                </c:pt>
                <c:pt idx="20">
                  <c:v>4.6511627906976737E-2</c:v>
                </c:pt>
                <c:pt idx="21">
                  <c:v>6.9767441860465129E-2</c:v>
                </c:pt>
                <c:pt idx="22">
                  <c:v>2.32558139534884E-2</c:v>
                </c:pt>
                <c:pt idx="23">
                  <c:v>3.8759689922480599E-2</c:v>
                </c:pt>
                <c:pt idx="24">
                  <c:v>3.1007751937984492E-2</c:v>
                </c:pt>
                <c:pt idx="25">
                  <c:v>2.32558139534884E-2</c:v>
                </c:pt>
                <c:pt idx="26">
                  <c:v>1.5503875968992208E-2</c:v>
                </c:pt>
                <c:pt idx="27">
                  <c:v>7.7519379844961231E-3</c:v>
                </c:pt>
                <c:pt idx="28">
                  <c:v>1.5503875968992208E-2</c:v>
                </c:pt>
                <c:pt idx="29">
                  <c:v>0</c:v>
                </c:pt>
                <c:pt idx="30">
                  <c:v>7.7519379844961231E-3</c:v>
                </c:pt>
              </c:numCache>
            </c:numRef>
          </c:val>
        </c:ser>
        <c:ser>
          <c:idx val="12"/>
          <c:order val="12"/>
          <c:tx>
            <c:strRef>
              <c:f>'tph-1(mg280)_A3_0.02_50%'!$N$104</c:f>
              <c:strCache>
                <c:ptCount val="1"/>
                <c:pt idx="0">
                  <c:v>tph-1(mg280)_A3_13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N$105:$N$135</c:f>
              <c:numCache>
                <c:formatCode>General</c:formatCode>
                <c:ptCount val="31"/>
                <c:pt idx="1">
                  <c:v>6.3636363636363602E-2</c:v>
                </c:pt>
                <c:pt idx="2">
                  <c:v>5.7575757575757579E-2</c:v>
                </c:pt>
                <c:pt idx="3">
                  <c:v>4.8484848484848485E-2</c:v>
                </c:pt>
                <c:pt idx="4">
                  <c:v>7.5757575757575801E-2</c:v>
                </c:pt>
                <c:pt idx="5">
                  <c:v>3.6363636363636397E-2</c:v>
                </c:pt>
                <c:pt idx="6">
                  <c:v>5.1515151515151486E-2</c:v>
                </c:pt>
                <c:pt idx="7">
                  <c:v>4.8484848484848485E-2</c:v>
                </c:pt>
                <c:pt idx="8">
                  <c:v>3.9393939393939398E-2</c:v>
                </c:pt>
                <c:pt idx="9">
                  <c:v>3.6363636363636397E-2</c:v>
                </c:pt>
                <c:pt idx="10">
                  <c:v>3.9393939393939398E-2</c:v>
                </c:pt>
                <c:pt idx="11">
                  <c:v>3.9393939393939398E-2</c:v>
                </c:pt>
                <c:pt idx="12">
                  <c:v>3.6363636363636397E-2</c:v>
                </c:pt>
                <c:pt idx="13">
                  <c:v>3.3333333333333298E-2</c:v>
                </c:pt>
                <c:pt idx="14">
                  <c:v>5.1515151515151486E-2</c:v>
                </c:pt>
                <c:pt idx="15">
                  <c:v>5.1515151515151486E-2</c:v>
                </c:pt>
                <c:pt idx="16">
                  <c:v>4.2424242424242399E-2</c:v>
                </c:pt>
                <c:pt idx="17">
                  <c:v>3.6363636363636397E-2</c:v>
                </c:pt>
                <c:pt idx="18">
                  <c:v>3.03030303030303E-2</c:v>
                </c:pt>
                <c:pt idx="19">
                  <c:v>2.12121212121212E-2</c:v>
                </c:pt>
                <c:pt idx="20">
                  <c:v>1.5151515151515204E-2</c:v>
                </c:pt>
                <c:pt idx="21">
                  <c:v>2.7272727272727313E-2</c:v>
                </c:pt>
                <c:pt idx="22">
                  <c:v>1.8181818181818205E-2</c:v>
                </c:pt>
                <c:pt idx="23">
                  <c:v>6.0606060606060597E-3</c:v>
                </c:pt>
                <c:pt idx="24">
                  <c:v>6.0606060606060597E-3</c:v>
                </c:pt>
                <c:pt idx="25">
                  <c:v>0</c:v>
                </c:pt>
                <c:pt idx="26">
                  <c:v>9.0909090909090991E-3</c:v>
                </c:pt>
                <c:pt idx="27">
                  <c:v>0</c:v>
                </c:pt>
                <c:pt idx="28">
                  <c:v>3.0303030303030299E-3</c:v>
                </c:pt>
                <c:pt idx="29">
                  <c:v>1.2121212121212099E-2</c:v>
                </c:pt>
                <c:pt idx="30">
                  <c:v>3.0303030303030299E-3</c:v>
                </c:pt>
              </c:numCache>
            </c:numRef>
          </c:val>
        </c:ser>
        <c:ser>
          <c:idx val="13"/>
          <c:order val="13"/>
          <c:tx>
            <c:strRef>
              <c:f>'tph-1(mg280)_A3_0.02_50%'!$O$104</c:f>
              <c:strCache>
                <c:ptCount val="1"/>
                <c:pt idx="0">
                  <c:v>tph-1(mg280)_A3_14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O$105:$O$135</c:f>
              <c:numCache>
                <c:formatCode>General</c:formatCode>
                <c:ptCount val="31"/>
                <c:pt idx="1">
                  <c:v>6.1497326203208628E-2</c:v>
                </c:pt>
                <c:pt idx="2">
                  <c:v>5.0802139037433233E-2</c:v>
                </c:pt>
                <c:pt idx="3">
                  <c:v>3.7433155080213928E-2</c:v>
                </c:pt>
                <c:pt idx="4">
                  <c:v>8.2887700534759384E-2</c:v>
                </c:pt>
                <c:pt idx="5">
                  <c:v>6.9518716577540093E-2</c:v>
                </c:pt>
                <c:pt idx="6">
                  <c:v>7.4866310160427829E-2</c:v>
                </c:pt>
                <c:pt idx="7">
                  <c:v>5.0802139037433233E-2</c:v>
                </c:pt>
                <c:pt idx="8">
                  <c:v>4.5454545454545497E-2</c:v>
                </c:pt>
                <c:pt idx="9">
                  <c:v>4.0106951871657803E-2</c:v>
                </c:pt>
                <c:pt idx="10">
                  <c:v>3.4759358288770116E-2</c:v>
                </c:pt>
                <c:pt idx="11">
                  <c:v>4.2780748663101602E-2</c:v>
                </c:pt>
                <c:pt idx="12">
                  <c:v>4.2780748663101602E-2</c:v>
                </c:pt>
                <c:pt idx="13">
                  <c:v>3.4759358288770116E-2</c:v>
                </c:pt>
                <c:pt idx="14">
                  <c:v>2.9411764705882398E-2</c:v>
                </c:pt>
                <c:pt idx="15">
                  <c:v>4.5454545454545497E-2</c:v>
                </c:pt>
                <c:pt idx="16">
                  <c:v>2.6737967914438505E-2</c:v>
                </c:pt>
                <c:pt idx="17">
                  <c:v>1.06951871657754E-2</c:v>
                </c:pt>
                <c:pt idx="18">
                  <c:v>1.06951871657754E-2</c:v>
                </c:pt>
                <c:pt idx="19">
                  <c:v>1.8716577540107006E-2</c:v>
                </c:pt>
                <c:pt idx="20">
                  <c:v>2.1390374331550797E-2</c:v>
                </c:pt>
                <c:pt idx="21">
                  <c:v>2.1390374331550797E-2</c:v>
                </c:pt>
                <c:pt idx="22">
                  <c:v>5.3475935828877002E-3</c:v>
                </c:pt>
                <c:pt idx="23">
                  <c:v>1.06951871657754E-2</c:v>
                </c:pt>
                <c:pt idx="24">
                  <c:v>1.6042780748663114E-2</c:v>
                </c:pt>
                <c:pt idx="25">
                  <c:v>1.06951871657754E-2</c:v>
                </c:pt>
                <c:pt idx="26">
                  <c:v>8.0213903743315499E-3</c:v>
                </c:pt>
                <c:pt idx="27">
                  <c:v>5.3475935828877002E-3</c:v>
                </c:pt>
                <c:pt idx="28">
                  <c:v>5.3475935828877002E-3</c:v>
                </c:pt>
                <c:pt idx="29">
                  <c:v>8.0213903743315499E-3</c:v>
                </c:pt>
                <c:pt idx="30">
                  <c:v>2.673796791443851E-3</c:v>
                </c:pt>
              </c:numCache>
            </c:numRef>
          </c:val>
        </c:ser>
        <c:ser>
          <c:idx val="14"/>
          <c:order val="14"/>
          <c:tx>
            <c:strRef>
              <c:f>'tph-1(mg280)_A3_0.02_50%'!$P$104</c:f>
              <c:strCache>
                <c:ptCount val="1"/>
                <c:pt idx="0">
                  <c:v>tph-1(mg280)_A3_15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P$105:$P$135</c:f>
              <c:numCache>
                <c:formatCode>General</c:formatCode>
                <c:ptCount val="31"/>
                <c:pt idx="1">
                  <c:v>2.2598870056497199E-2</c:v>
                </c:pt>
                <c:pt idx="2">
                  <c:v>3.3898305084745811E-2</c:v>
                </c:pt>
                <c:pt idx="3">
                  <c:v>5.084745762711862E-2</c:v>
                </c:pt>
                <c:pt idx="4">
                  <c:v>6.21468926553672E-2</c:v>
                </c:pt>
                <c:pt idx="5">
                  <c:v>2.824858757062151E-2</c:v>
                </c:pt>
                <c:pt idx="6">
                  <c:v>3.3898305084745811E-2</c:v>
                </c:pt>
                <c:pt idx="7">
                  <c:v>2.2598870056497199E-2</c:v>
                </c:pt>
                <c:pt idx="8">
                  <c:v>5.084745762711862E-2</c:v>
                </c:pt>
                <c:pt idx="9">
                  <c:v>3.3898305084745811E-2</c:v>
                </c:pt>
                <c:pt idx="10">
                  <c:v>2.824858757062151E-2</c:v>
                </c:pt>
                <c:pt idx="11">
                  <c:v>2.824858757062151E-2</c:v>
                </c:pt>
                <c:pt idx="12">
                  <c:v>3.3898305084745811E-2</c:v>
                </c:pt>
                <c:pt idx="13">
                  <c:v>5.6497175141242903E-2</c:v>
                </c:pt>
                <c:pt idx="14">
                  <c:v>2.824858757062151E-2</c:v>
                </c:pt>
                <c:pt idx="15">
                  <c:v>3.9548022598870115E-2</c:v>
                </c:pt>
                <c:pt idx="16">
                  <c:v>4.5197740112994399E-2</c:v>
                </c:pt>
                <c:pt idx="17">
                  <c:v>5.6497175141242903E-2</c:v>
                </c:pt>
                <c:pt idx="18">
                  <c:v>3.3898305084745811E-2</c:v>
                </c:pt>
                <c:pt idx="19">
                  <c:v>2.824858757062151E-2</c:v>
                </c:pt>
                <c:pt idx="20">
                  <c:v>3.3898305084745811E-2</c:v>
                </c:pt>
                <c:pt idx="21">
                  <c:v>1.12994350282486E-2</c:v>
                </c:pt>
                <c:pt idx="22">
                  <c:v>1.6949152542372906E-2</c:v>
                </c:pt>
                <c:pt idx="23">
                  <c:v>2.2598870056497199E-2</c:v>
                </c:pt>
                <c:pt idx="24">
                  <c:v>1.6949152542372906E-2</c:v>
                </c:pt>
                <c:pt idx="25">
                  <c:v>2.2598870056497199E-2</c:v>
                </c:pt>
                <c:pt idx="26">
                  <c:v>5.6497175141242903E-3</c:v>
                </c:pt>
                <c:pt idx="27">
                  <c:v>5.6497175141242903E-3</c:v>
                </c:pt>
                <c:pt idx="28">
                  <c:v>2.824858757062151E-2</c:v>
                </c:pt>
                <c:pt idx="29">
                  <c:v>1.12994350282486E-2</c:v>
                </c:pt>
                <c:pt idx="30">
                  <c:v>5.6497175141242903E-3</c:v>
                </c:pt>
              </c:numCache>
            </c:numRef>
          </c:val>
        </c:ser>
        <c:ser>
          <c:idx val="15"/>
          <c:order val="15"/>
          <c:tx>
            <c:strRef>
              <c:f>'tph-1(mg280)_A3_0.02_50%'!$Q$104</c:f>
              <c:strCache>
                <c:ptCount val="1"/>
                <c:pt idx="0">
                  <c:v>tph-1(mg280)_A3_16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Q$105:$Q$135</c:f>
              <c:numCache>
                <c:formatCode>General</c:formatCode>
                <c:ptCount val="31"/>
                <c:pt idx="1">
                  <c:v>9.9601593625498031E-2</c:v>
                </c:pt>
                <c:pt idx="2">
                  <c:v>5.5776892430278904E-2</c:v>
                </c:pt>
                <c:pt idx="3">
                  <c:v>7.9681274900398433E-2</c:v>
                </c:pt>
                <c:pt idx="4">
                  <c:v>7.1713147410358599E-2</c:v>
                </c:pt>
                <c:pt idx="5">
                  <c:v>5.5776892430278904E-2</c:v>
                </c:pt>
                <c:pt idx="6">
                  <c:v>7.1713147410358599E-2</c:v>
                </c:pt>
                <c:pt idx="7">
                  <c:v>3.9840637450199216E-2</c:v>
                </c:pt>
                <c:pt idx="8">
                  <c:v>2.3904382470119518E-2</c:v>
                </c:pt>
                <c:pt idx="9">
                  <c:v>3.1872509960159411E-2</c:v>
                </c:pt>
                <c:pt idx="10">
                  <c:v>3.585657370517932E-2</c:v>
                </c:pt>
                <c:pt idx="11">
                  <c:v>3.1872509960159411E-2</c:v>
                </c:pt>
                <c:pt idx="12">
                  <c:v>3.9840637450199216E-2</c:v>
                </c:pt>
                <c:pt idx="13">
                  <c:v>4.3824701195219098E-2</c:v>
                </c:pt>
                <c:pt idx="14">
                  <c:v>1.1952191235059804E-2</c:v>
                </c:pt>
                <c:pt idx="15">
                  <c:v>3.1872509960159411E-2</c:v>
                </c:pt>
                <c:pt idx="16">
                  <c:v>1.5936254980079698E-2</c:v>
                </c:pt>
                <c:pt idx="17">
                  <c:v>1.5936254980079698E-2</c:v>
                </c:pt>
                <c:pt idx="18">
                  <c:v>2.3904382470119518E-2</c:v>
                </c:pt>
                <c:pt idx="19">
                  <c:v>1.9920318725099601E-2</c:v>
                </c:pt>
                <c:pt idx="20">
                  <c:v>1.1952191235059804E-2</c:v>
                </c:pt>
                <c:pt idx="21">
                  <c:v>7.968127490039844E-3</c:v>
                </c:pt>
                <c:pt idx="22">
                  <c:v>1.5936254980079698E-2</c:v>
                </c:pt>
                <c:pt idx="23">
                  <c:v>7.968127490039844E-3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3.984063745019922E-3</c:v>
                </c:pt>
                <c:pt idx="28">
                  <c:v>0</c:v>
                </c:pt>
                <c:pt idx="29">
                  <c:v>3.984063745019922E-3</c:v>
                </c:pt>
                <c:pt idx="30">
                  <c:v>0</c:v>
                </c:pt>
              </c:numCache>
            </c:numRef>
          </c:val>
        </c:ser>
        <c:ser>
          <c:idx val="16"/>
          <c:order val="16"/>
          <c:tx>
            <c:strRef>
              <c:f>'tph-1(mg280)_A3_0.02_50%'!$R$104</c:f>
              <c:strCache>
                <c:ptCount val="1"/>
                <c:pt idx="0">
                  <c:v>tph-1(mg280)_A3_17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R$105:$R$135</c:f>
              <c:numCache>
                <c:formatCode>General</c:formatCode>
                <c:ptCount val="31"/>
                <c:pt idx="1">
                  <c:v>4.0816326530612223E-3</c:v>
                </c:pt>
                <c:pt idx="2">
                  <c:v>1.2244897959183699E-2</c:v>
                </c:pt>
                <c:pt idx="3">
                  <c:v>4.0816326530612223E-3</c:v>
                </c:pt>
                <c:pt idx="4">
                  <c:v>8.1632653061224497E-3</c:v>
                </c:pt>
                <c:pt idx="5">
                  <c:v>0</c:v>
                </c:pt>
                <c:pt idx="6">
                  <c:v>4.0816326530612223E-3</c:v>
                </c:pt>
                <c:pt idx="7">
                  <c:v>4.0816326530612223E-3</c:v>
                </c:pt>
                <c:pt idx="8">
                  <c:v>8.1632653061224497E-3</c:v>
                </c:pt>
                <c:pt idx="9">
                  <c:v>1.6326530612244903E-2</c:v>
                </c:pt>
                <c:pt idx="10">
                  <c:v>8.1632653061224497E-3</c:v>
                </c:pt>
                <c:pt idx="11">
                  <c:v>1.2244897959183699E-2</c:v>
                </c:pt>
                <c:pt idx="12">
                  <c:v>2.0408163265306107E-2</c:v>
                </c:pt>
                <c:pt idx="13">
                  <c:v>1.6326530612244903E-2</c:v>
                </c:pt>
                <c:pt idx="14">
                  <c:v>4.0816326530612221E-2</c:v>
                </c:pt>
                <c:pt idx="15">
                  <c:v>3.673469387755101E-2</c:v>
                </c:pt>
                <c:pt idx="16">
                  <c:v>8.9795918367346975E-2</c:v>
                </c:pt>
                <c:pt idx="17">
                  <c:v>8.9795918367346975E-2</c:v>
                </c:pt>
                <c:pt idx="18">
                  <c:v>7.346938775510202E-2</c:v>
                </c:pt>
                <c:pt idx="19">
                  <c:v>8.9795918367346975E-2</c:v>
                </c:pt>
                <c:pt idx="20">
                  <c:v>8.5714285714285701E-2</c:v>
                </c:pt>
                <c:pt idx="21">
                  <c:v>8.5714285714285701E-2</c:v>
                </c:pt>
                <c:pt idx="22">
                  <c:v>6.1224489795918401E-2</c:v>
                </c:pt>
                <c:pt idx="23">
                  <c:v>4.4897959183673515E-2</c:v>
                </c:pt>
                <c:pt idx="24">
                  <c:v>3.673469387755101E-2</c:v>
                </c:pt>
                <c:pt idx="25">
                  <c:v>3.2653061224489806E-2</c:v>
                </c:pt>
                <c:pt idx="26">
                  <c:v>8.1632653061224497E-3</c:v>
                </c:pt>
                <c:pt idx="27">
                  <c:v>2.4489795918367314E-2</c:v>
                </c:pt>
                <c:pt idx="28">
                  <c:v>4.0816326530612223E-3</c:v>
                </c:pt>
                <c:pt idx="29">
                  <c:v>4.0816326530612223E-3</c:v>
                </c:pt>
                <c:pt idx="30">
                  <c:v>8.1632653061224497E-3</c:v>
                </c:pt>
              </c:numCache>
            </c:numRef>
          </c:val>
        </c:ser>
        <c:ser>
          <c:idx val="17"/>
          <c:order val="17"/>
          <c:tx>
            <c:strRef>
              <c:f>'tph-1(mg280)_A3_0.02_50%'!$S$104</c:f>
              <c:strCache>
                <c:ptCount val="1"/>
                <c:pt idx="0">
                  <c:v>tph-1(mg280)_A3_18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S$105:$S$135</c:f>
              <c:numCache>
                <c:formatCode>General</c:formatCode>
                <c:ptCount val="31"/>
                <c:pt idx="1">
                  <c:v>0.125</c:v>
                </c:pt>
                <c:pt idx="2">
                  <c:v>0.10576923076923106</c:v>
                </c:pt>
                <c:pt idx="3">
                  <c:v>3.8461538461538498E-2</c:v>
                </c:pt>
                <c:pt idx="4">
                  <c:v>4.8076923076923114E-2</c:v>
                </c:pt>
                <c:pt idx="5">
                  <c:v>2.8846153846153799E-2</c:v>
                </c:pt>
                <c:pt idx="6">
                  <c:v>3.8461538461538498E-2</c:v>
                </c:pt>
                <c:pt idx="7">
                  <c:v>9.6153846153846281E-3</c:v>
                </c:pt>
                <c:pt idx="8">
                  <c:v>9.6153846153846281E-3</c:v>
                </c:pt>
                <c:pt idx="9">
                  <c:v>9.6153846153846281E-3</c:v>
                </c:pt>
                <c:pt idx="10">
                  <c:v>0</c:v>
                </c:pt>
                <c:pt idx="11">
                  <c:v>9.6153846153846281E-3</c:v>
                </c:pt>
                <c:pt idx="12">
                  <c:v>1.9230769230769208E-2</c:v>
                </c:pt>
                <c:pt idx="13">
                  <c:v>2.8846153846153799E-2</c:v>
                </c:pt>
                <c:pt idx="14">
                  <c:v>1.9230769230769208E-2</c:v>
                </c:pt>
                <c:pt idx="15">
                  <c:v>4.8076923076923114E-2</c:v>
                </c:pt>
                <c:pt idx="16">
                  <c:v>1.9230769230769208E-2</c:v>
                </c:pt>
                <c:pt idx="17">
                  <c:v>2.8846153846153799E-2</c:v>
                </c:pt>
                <c:pt idx="18">
                  <c:v>3.8461538461538498E-2</c:v>
                </c:pt>
                <c:pt idx="19">
                  <c:v>0</c:v>
                </c:pt>
                <c:pt idx="20">
                  <c:v>0</c:v>
                </c:pt>
                <c:pt idx="21">
                  <c:v>9.6153846153846281E-3</c:v>
                </c:pt>
                <c:pt idx="22">
                  <c:v>9.6153846153846281E-3</c:v>
                </c:pt>
                <c:pt idx="23">
                  <c:v>1.9230769230769208E-2</c:v>
                </c:pt>
                <c:pt idx="24">
                  <c:v>1.9230769230769208E-2</c:v>
                </c:pt>
                <c:pt idx="25">
                  <c:v>9.6153846153846281E-3</c:v>
                </c:pt>
                <c:pt idx="26">
                  <c:v>0</c:v>
                </c:pt>
                <c:pt idx="27">
                  <c:v>9.6153846153846281E-3</c:v>
                </c:pt>
                <c:pt idx="28">
                  <c:v>0</c:v>
                </c:pt>
                <c:pt idx="29">
                  <c:v>9.6153846153846281E-3</c:v>
                </c:pt>
                <c:pt idx="30">
                  <c:v>9.6153846153846281E-3</c:v>
                </c:pt>
              </c:numCache>
            </c:numRef>
          </c:val>
        </c:ser>
        <c:ser>
          <c:idx val="18"/>
          <c:order val="18"/>
          <c:tx>
            <c:strRef>
              <c:f>'tph-1(mg280)_A3_0.02_50%'!$T$104</c:f>
              <c:strCache>
                <c:ptCount val="1"/>
                <c:pt idx="0">
                  <c:v>tph-1(mg280)_A3_19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T$105:$T$135</c:f>
              <c:numCache>
                <c:formatCode>General</c:formatCode>
                <c:ptCount val="31"/>
                <c:pt idx="1">
                  <c:v>4.6052631578947421E-2</c:v>
                </c:pt>
                <c:pt idx="2">
                  <c:v>4.2763157894736836E-2</c:v>
                </c:pt>
                <c:pt idx="3">
                  <c:v>4.2763157894736836E-2</c:v>
                </c:pt>
                <c:pt idx="4">
                  <c:v>6.5789473684210509E-2</c:v>
                </c:pt>
                <c:pt idx="5">
                  <c:v>6.25E-2</c:v>
                </c:pt>
                <c:pt idx="6">
                  <c:v>5.5921052631578885E-2</c:v>
                </c:pt>
                <c:pt idx="7">
                  <c:v>4.2763157894736836E-2</c:v>
                </c:pt>
                <c:pt idx="8">
                  <c:v>3.2894736842105317E-2</c:v>
                </c:pt>
                <c:pt idx="9">
                  <c:v>5.2631578947368404E-2</c:v>
                </c:pt>
                <c:pt idx="10">
                  <c:v>3.6184210526315819E-2</c:v>
                </c:pt>
                <c:pt idx="11">
                  <c:v>5.5921052631578885E-2</c:v>
                </c:pt>
                <c:pt idx="12">
                  <c:v>4.2763157894736836E-2</c:v>
                </c:pt>
                <c:pt idx="13">
                  <c:v>2.9605263157894714E-2</c:v>
                </c:pt>
                <c:pt idx="14">
                  <c:v>3.6184210526315819E-2</c:v>
                </c:pt>
                <c:pt idx="15">
                  <c:v>4.2763157894736836E-2</c:v>
                </c:pt>
                <c:pt idx="16">
                  <c:v>2.9605263157894714E-2</c:v>
                </c:pt>
                <c:pt idx="17">
                  <c:v>3.6184210526315819E-2</c:v>
                </c:pt>
                <c:pt idx="18">
                  <c:v>2.9605263157894714E-2</c:v>
                </c:pt>
                <c:pt idx="19">
                  <c:v>1.3157894736842101E-2</c:v>
                </c:pt>
                <c:pt idx="20">
                  <c:v>2.9605263157894714E-2</c:v>
                </c:pt>
                <c:pt idx="21">
                  <c:v>1.9736842105263205E-2</c:v>
                </c:pt>
                <c:pt idx="22">
                  <c:v>2.6315789473684202E-2</c:v>
                </c:pt>
                <c:pt idx="23">
                  <c:v>2.9605263157894714E-2</c:v>
                </c:pt>
                <c:pt idx="24">
                  <c:v>1.3157894736842101E-2</c:v>
                </c:pt>
                <c:pt idx="25">
                  <c:v>6.5789473684210514E-3</c:v>
                </c:pt>
                <c:pt idx="26">
                  <c:v>3.2894736842105309E-3</c:v>
                </c:pt>
                <c:pt idx="27">
                  <c:v>3.2894736842105309E-3</c:v>
                </c:pt>
                <c:pt idx="28">
                  <c:v>0</c:v>
                </c:pt>
                <c:pt idx="29">
                  <c:v>0</c:v>
                </c:pt>
                <c:pt idx="30">
                  <c:v>6.5789473684210514E-3</c:v>
                </c:pt>
              </c:numCache>
            </c:numRef>
          </c:val>
        </c:ser>
        <c:ser>
          <c:idx val="19"/>
          <c:order val="19"/>
          <c:tx>
            <c:strRef>
              <c:f>'tph-1(mg280)_A3_0.02_50%'!$U$104</c:f>
              <c:strCache>
                <c:ptCount val="1"/>
                <c:pt idx="0">
                  <c:v>tph-1(mg280)_A3_20</c:v>
                </c:pt>
              </c:strCache>
            </c:strRef>
          </c:tx>
          <c:marker>
            <c:symbol val="none"/>
          </c:marker>
          <c:cat>
            <c:numRef>
              <c:f>'tph-1(mg280)_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3_0.02_50%'!$U$105:$U$135</c:f>
              <c:numCache>
                <c:formatCode>General</c:formatCode>
                <c:ptCount val="31"/>
                <c:pt idx="1">
                  <c:v>2.9850746268656699E-2</c:v>
                </c:pt>
                <c:pt idx="2">
                  <c:v>2.48756218905473E-2</c:v>
                </c:pt>
                <c:pt idx="3">
                  <c:v>2.9850746268656699E-2</c:v>
                </c:pt>
                <c:pt idx="4">
                  <c:v>1.4925373134328401E-2</c:v>
                </c:pt>
                <c:pt idx="5">
                  <c:v>1.4925373134328401E-2</c:v>
                </c:pt>
                <c:pt idx="6">
                  <c:v>4.9751243781094483E-3</c:v>
                </c:pt>
                <c:pt idx="7">
                  <c:v>0</c:v>
                </c:pt>
                <c:pt idx="8">
                  <c:v>2.48756218905473E-2</c:v>
                </c:pt>
                <c:pt idx="9">
                  <c:v>9.9502487562189174E-3</c:v>
                </c:pt>
                <c:pt idx="10">
                  <c:v>2.48756218905473E-2</c:v>
                </c:pt>
                <c:pt idx="11">
                  <c:v>2.9850746268656699E-2</c:v>
                </c:pt>
                <c:pt idx="12">
                  <c:v>1.4925373134328401E-2</c:v>
                </c:pt>
                <c:pt idx="13">
                  <c:v>3.4825870646766212E-2</c:v>
                </c:pt>
                <c:pt idx="14">
                  <c:v>4.47761194029851E-2</c:v>
                </c:pt>
                <c:pt idx="15">
                  <c:v>3.9800995024875621E-2</c:v>
                </c:pt>
                <c:pt idx="16">
                  <c:v>4.47761194029851E-2</c:v>
                </c:pt>
                <c:pt idx="17">
                  <c:v>3.9800995024875621E-2</c:v>
                </c:pt>
                <c:pt idx="18">
                  <c:v>6.4676616915422924E-2</c:v>
                </c:pt>
                <c:pt idx="19">
                  <c:v>4.47761194029851E-2</c:v>
                </c:pt>
                <c:pt idx="20">
                  <c:v>8.955223880597013E-2</c:v>
                </c:pt>
                <c:pt idx="21">
                  <c:v>4.9751243781094495E-2</c:v>
                </c:pt>
                <c:pt idx="22">
                  <c:v>5.9701492537313432E-2</c:v>
                </c:pt>
                <c:pt idx="23">
                  <c:v>3.4825870646766212E-2</c:v>
                </c:pt>
                <c:pt idx="24">
                  <c:v>3.4825870646766212E-2</c:v>
                </c:pt>
                <c:pt idx="25">
                  <c:v>1.4925373134328401E-2</c:v>
                </c:pt>
                <c:pt idx="26">
                  <c:v>4.47761194029851E-2</c:v>
                </c:pt>
                <c:pt idx="27">
                  <c:v>2.48756218905473E-2</c:v>
                </c:pt>
                <c:pt idx="28">
                  <c:v>9.9502487562189174E-3</c:v>
                </c:pt>
                <c:pt idx="29">
                  <c:v>0</c:v>
                </c:pt>
                <c:pt idx="30">
                  <c:v>1.9900497512437811E-2</c:v>
                </c:pt>
              </c:numCache>
            </c:numRef>
          </c:val>
        </c:ser>
        <c:marker val="1"/>
        <c:axId val="171094784"/>
        <c:axId val="171096320"/>
      </c:lineChart>
      <c:catAx>
        <c:axId val="171094784"/>
        <c:scaling>
          <c:orientation val="minMax"/>
        </c:scaling>
        <c:axPos val="b"/>
        <c:numFmt formatCode="0.0_ " sourceLinked="1"/>
        <c:tickLblPos val="nextTo"/>
        <c:crossAx val="171096320"/>
        <c:crosses val="autoZero"/>
        <c:auto val="1"/>
        <c:lblAlgn val="ctr"/>
        <c:lblOffset val="100"/>
        <c:tickLblSkip val="5"/>
        <c:tickMarkSkip val="5"/>
      </c:catAx>
      <c:valAx>
        <c:axId val="171096320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71094784"/>
        <c:crosses val="autoZero"/>
        <c:crossBetween val="between"/>
      </c:valAx>
    </c:plotArea>
    <c:plotVisOnly val="1"/>
  </c:chart>
  <c:externalData r:id="rId1"/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 b="0">
                <a:latin typeface="Arial" pitchFamily="34" charset="0"/>
                <a:cs typeface="Arial" pitchFamily="34" charset="0"/>
              </a:defRPr>
            </a:pPr>
            <a:r>
              <a:rPr lang="en-US" sz="1400" b="0" i="1" dirty="0">
                <a:latin typeface="Arial" pitchFamily="34" charset="0"/>
                <a:cs typeface="Arial" pitchFamily="34" charset="0"/>
              </a:rPr>
              <a:t>tph-1</a:t>
            </a:r>
            <a:r>
              <a:rPr lang="en-US" sz="1400" b="0" dirty="0">
                <a:latin typeface="Arial" pitchFamily="34" charset="0"/>
                <a:cs typeface="Arial" pitchFamily="34" charset="0"/>
              </a:rPr>
              <a:t> A5</a:t>
            </a:r>
            <a:endParaRPr lang="ja-JP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tph-1(mg280)_A5_0.02_50%'!$B$104</c:f>
              <c:strCache>
                <c:ptCount val="1"/>
                <c:pt idx="0">
                  <c:v>tph-1(mg280)_A5_01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B$105:$B$135</c:f>
              <c:numCache>
                <c:formatCode>General</c:formatCode>
                <c:ptCount val="31"/>
                <c:pt idx="1">
                  <c:v>3.2258064516129011E-2</c:v>
                </c:pt>
                <c:pt idx="2">
                  <c:v>3.2258064516129011E-2</c:v>
                </c:pt>
                <c:pt idx="3">
                  <c:v>3.2258064516129011E-2</c:v>
                </c:pt>
                <c:pt idx="4">
                  <c:v>3.2258064516129011E-2</c:v>
                </c:pt>
                <c:pt idx="5">
                  <c:v>0</c:v>
                </c:pt>
                <c:pt idx="6">
                  <c:v>3.2258064516129011E-2</c:v>
                </c:pt>
                <c:pt idx="7">
                  <c:v>3.2258064516129011E-2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3.2258064516129011E-2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3.2258064516129011E-2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3.2258064516129011E-2</c:v>
                </c:pt>
                <c:pt idx="28">
                  <c:v>0</c:v>
                </c:pt>
                <c:pt idx="29">
                  <c:v>0</c:v>
                </c:pt>
                <c:pt idx="30">
                  <c:v>3.2258064516129011E-2</c:v>
                </c:pt>
              </c:numCache>
            </c:numRef>
          </c:val>
        </c:ser>
        <c:ser>
          <c:idx val="1"/>
          <c:order val="1"/>
          <c:tx>
            <c:strRef>
              <c:f>'tph-1(mg280)_A5_0.02_50%'!$C$104</c:f>
              <c:strCache>
                <c:ptCount val="1"/>
                <c:pt idx="0">
                  <c:v>tph-1(mg280)_A5_02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C$105:$C$135</c:f>
              <c:numCache>
                <c:formatCode>General</c:formatCode>
                <c:ptCount val="31"/>
                <c:pt idx="1">
                  <c:v>0.11363636363636398</c:v>
                </c:pt>
                <c:pt idx="2">
                  <c:v>4.5454545454545497E-2</c:v>
                </c:pt>
                <c:pt idx="3">
                  <c:v>9.0909090909090939E-2</c:v>
                </c:pt>
                <c:pt idx="4">
                  <c:v>9.0909090909090939E-2</c:v>
                </c:pt>
                <c:pt idx="5">
                  <c:v>4.5454545454545497E-2</c:v>
                </c:pt>
                <c:pt idx="6">
                  <c:v>0</c:v>
                </c:pt>
                <c:pt idx="7">
                  <c:v>0</c:v>
                </c:pt>
                <c:pt idx="8">
                  <c:v>2.2727272727272717E-2</c:v>
                </c:pt>
                <c:pt idx="9">
                  <c:v>2.2727272727272717E-2</c:v>
                </c:pt>
                <c:pt idx="10">
                  <c:v>0</c:v>
                </c:pt>
                <c:pt idx="11">
                  <c:v>0</c:v>
                </c:pt>
                <c:pt idx="12">
                  <c:v>2.2727272727272717E-2</c:v>
                </c:pt>
                <c:pt idx="13">
                  <c:v>0</c:v>
                </c:pt>
                <c:pt idx="14">
                  <c:v>2.2727272727272717E-2</c:v>
                </c:pt>
                <c:pt idx="15">
                  <c:v>0</c:v>
                </c:pt>
                <c:pt idx="16">
                  <c:v>0</c:v>
                </c:pt>
                <c:pt idx="17">
                  <c:v>2.2727272727272717E-2</c:v>
                </c:pt>
                <c:pt idx="18">
                  <c:v>2.2727272727272717E-2</c:v>
                </c:pt>
                <c:pt idx="19">
                  <c:v>4.5454545454545497E-2</c:v>
                </c:pt>
                <c:pt idx="20">
                  <c:v>2.2727272727272717E-2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2.2727272727272717E-2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tph-1(mg280)_A5_0.02_50%'!$D$104</c:f>
              <c:strCache>
                <c:ptCount val="1"/>
                <c:pt idx="0">
                  <c:v>tph-1(mg280)_A5_03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D$105:$D$135</c:f>
              <c:numCache>
                <c:formatCode>General</c:formatCode>
                <c:ptCount val="31"/>
                <c:pt idx="1">
                  <c:v>0.214285714285714</c:v>
                </c:pt>
                <c:pt idx="2">
                  <c:v>0.107142857142857</c:v>
                </c:pt>
                <c:pt idx="3">
                  <c:v>3.5714285714285698E-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3.5714285714285698E-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tph-1(mg280)_A5_0.02_50%'!$E$104</c:f>
              <c:strCache>
                <c:ptCount val="1"/>
                <c:pt idx="0">
                  <c:v>tph-1(mg280)_A5_04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E$105:$E$135</c:f>
              <c:numCache>
                <c:formatCode>General</c:formatCode>
                <c:ptCount val="31"/>
              </c:numCache>
            </c:numRef>
          </c:val>
        </c:ser>
        <c:ser>
          <c:idx val="4"/>
          <c:order val="4"/>
          <c:tx>
            <c:strRef>
              <c:f>'tph-1(mg280)_A5_0.02_50%'!$F$104</c:f>
              <c:strCache>
                <c:ptCount val="1"/>
                <c:pt idx="0">
                  <c:v>tph-1(mg280)_A5_05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F$105:$F$135</c:f>
              <c:numCache>
                <c:formatCode>General</c:formatCode>
                <c:ptCount val="31"/>
                <c:pt idx="1">
                  <c:v>6.0606060606060601E-2</c:v>
                </c:pt>
                <c:pt idx="2">
                  <c:v>0.16666666666666693</c:v>
                </c:pt>
                <c:pt idx="3">
                  <c:v>4.5454545454545497E-2</c:v>
                </c:pt>
                <c:pt idx="4">
                  <c:v>3.03030303030303E-2</c:v>
                </c:pt>
                <c:pt idx="5">
                  <c:v>4.5454545454545497E-2</c:v>
                </c:pt>
                <c:pt idx="6">
                  <c:v>3.03030303030303E-2</c:v>
                </c:pt>
                <c:pt idx="7">
                  <c:v>0</c:v>
                </c:pt>
                <c:pt idx="8">
                  <c:v>3.03030303030303E-2</c:v>
                </c:pt>
                <c:pt idx="9">
                  <c:v>1.5151515151515204E-2</c:v>
                </c:pt>
                <c:pt idx="10">
                  <c:v>0</c:v>
                </c:pt>
                <c:pt idx="11">
                  <c:v>1.5151515151515204E-2</c:v>
                </c:pt>
                <c:pt idx="12">
                  <c:v>3.03030303030303E-2</c:v>
                </c:pt>
                <c:pt idx="13">
                  <c:v>1.5151515151515204E-2</c:v>
                </c:pt>
                <c:pt idx="14">
                  <c:v>0</c:v>
                </c:pt>
                <c:pt idx="15">
                  <c:v>1.5151515151515204E-2</c:v>
                </c:pt>
                <c:pt idx="16">
                  <c:v>0</c:v>
                </c:pt>
                <c:pt idx="17">
                  <c:v>3.03030303030303E-2</c:v>
                </c:pt>
                <c:pt idx="18">
                  <c:v>1.5151515151515204E-2</c:v>
                </c:pt>
                <c:pt idx="19">
                  <c:v>0</c:v>
                </c:pt>
                <c:pt idx="20">
                  <c:v>0</c:v>
                </c:pt>
                <c:pt idx="21">
                  <c:v>3.03030303030303E-2</c:v>
                </c:pt>
                <c:pt idx="22">
                  <c:v>4.5454545454545497E-2</c:v>
                </c:pt>
                <c:pt idx="23">
                  <c:v>1.5151515151515204E-2</c:v>
                </c:pt>
                <c:pt idx="24">
                  <c:v>0</c:v>
                </c:pt>
                <c:pt idx="25">
                  <c:v>3.03030303030303E-2</c:v>
                </c:pt>
                <c:pt idx="26">
                  <c:v>1.5151515151515204E-2</c:v>
                </c:pt>
                <c:pt idx="27">
                  <c:v>3.03030303030303E-2</c:v>
                </c:pt>
                <c:pt idx="28">
                  <c:v>0</c:v>
                </c:pt>
                <c:pt idx="29">
                  <c:v>0</c:v>
                </c:pt>
                <c:pt idx="30">
                  <c:v>3.03030303030303E-2</c:v>
                </c:pt>
              </c:numCache>
            </c:numRef>
          </c:val>
        </c:ser>
        <c:ser>
          <c:idx val="5"/>
          <c:order val="5"/>
          <c:tx>
            <c:strRef>
              <c:f>'tph-1(mg280)_A5_0.02_50%'!$G$104</c:f>
              <c:strCache>
                <c:ptCount val="1"/>
                <c:pt idx="0">
                  <c:v>tph-1(mg280)_A5_06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G$105:$G$135</c:f>
              <c:numCache>
                <c:formatCode>General</c:formatCode>
                <c:ptCount val="31"/>
                <c:pt idx="1">
                  <c:v>5.7692307692307716E-2</c:v>
                </c:pt>
                <c:pt idx="2">
                  <c:v>9.615384615384627E-2</c:v>
                </c:pt>
                <c:pt idx="3">
                  <c:v>4.4871794871794914E-2</c:v>
                </c:pt>
                <c:pt idx="4">
                  <c:v>6.4102564102564111E-2</c:v>
                </c:pt>
                <c:pt idx="5">
                  <c:v>3.8461538461538498E-2</c:v>
                </c:pt>
                <c:pt idx="6">
                  <c:v>5.1282051282051301E-2</c:v>
                </c:pt>
                <c:pt idx="7">
                  <c:v>1.2820512820512801E-2</c:v>
                </c:pt>
                <c:pt idx="8">
                  <c:v>1.9230769230769208E-2</c:v>
                </c:pt>
                <c:pt idx="9">
                  <c:v>1.2820512820512801E-2</c:v>
                </c:pt>
                <c:pt idx="10">
                  <c:v>2.5641025641025609E-2</c:v>
                </c:pt>
                <c:pt idx="11">
                  <c:v>1.9230769230769208E-2</c:v>
                </c:pt>
                <c:pt idx="12">
                  <c:v>1.2820512820512801E-2</c:v>
                </c:pt>
                <c:pt idx="13">
                  <c:v>6.4102564102564118E-3</c:v>
                </c:pt>
                <c:pt idx="14">
                  <c:v>1.2820512820512801E-2</c:v>
                </c:pt>
                <c:pt idx="15">
                  <c:v>3.8461538461538498E-2</c:v>
                </c:pt>
                <c:pt idx="16">
                  <c:v>2.5641025641025609E-2</c:v>
                </c:pt>
                <c:pt idx="17">
                  <c:v>1.2820512820512801E-2</c:v>
                </c:pt>
                <c:pt idx="18">
                  <c:v>4.4871794871794914E-2</c:v>
                </c:pt>
                <c:pt idx="19">
                  <c:v>6.4102564102564118E-3</c:v>
                </c:pt>
                <c:pt idx="20">
                  <c:v>1.9230769230769208E-2</c:v>
                </c:pt>
                <c:pt idx="21">
                  <c:v>3.2051282051282E-2</c:v>
                </c:pt>
                <c:pt idx="22">
                  <c:v>1.2820512820512801E-2</c:v>
                </c:pt>
                <c:pt idx="23">
                  <c:v>1.9230769230769208E-2</c:v>
                </c:pt>
                <c:pt idx="24">
                  <c:v>6.4102564102564118E-3</c:v>
                </c:pt>
                <c:pt idx="25">
                  <c:v>1.9230769230769208E-2</c:v>
                </c:pt>
                <c:pt idx="26">
                  <c:v>6.4102564102564118E-3</c:v>
                </c:pt>
                <c:pt idx="27">
                  <c:v>1.2820512820512801E-2</c:v>
                </c:pt>
                <c:pt idx="28">
                  <c:v>6.4102564102564118E-3</c:v>
                </c:pt>
                <c:pt idx="29">
                  <c:v>6.4102564102564118E-3</c:v>
                </c:pt>
                <c:pt idx="30">
                  <c:v>0</c:v>
                </c:pt>
              </c:numCache>
            </c:numRef>
          </c:val>
        </c:ser>
        <c:ser>
          <c:idx val="6"/>
          <c:order val="6"/>
          <c:tx>
            <c:strRef>
              <c:f>'tph-1(mg280)_A5_0.02_50%'!$H$104</c:f>
              <c:strCache>
                <c:ptCount val="1"/>
                <c:pt idx="0">
                  <c:v>tph-1(mg280)_A5_07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H$105:$H$135</c:f>
              <c:numCache>
                <c:formatCode>General</c:formatCode>
                <c:ptCount val="31"/>
                <c:pt idx="1">
                  <c:v>0.21311475409836106</c:v>
                </c:pt>
                <c:pt idx="2">
                  <c:v>6.557377049180331E-2</c:v>
                </c:pt>
                <c:pt idx="3">
                  <c:v>4.91803278688525E-2</c:v>
                </c:pt>
                <c:pt idx="4">
                  <c:v>1.63934426229508E-2</c:v>
                </c:pt>
                <c:pt idx="5">
                  <c:v>1.63934426229508E-2</c:v>
                </c:pt>
                <c:pt idx="6">
                  <c:v>4.91803278688525E-2</c:v>
                </c:pt>
                <c:pt idx="7">
                  <c:v>1.63934426229508E-2</c:v>
                </c:pt>
                <c:pt idx="8">
                  <c:v>1.63934426229508E-2</c:v>
                </c:pt>
                <c:pt idx="9">
                  <c:v>3.2786885245901599E-2</c:v>
                </c:pt>
                <c:pt idx="10">
                  <c:v>1.63934426229508E-2</c:v>
                </c:pt>
                <c:pt idx="11">
                  <c:v>0</c:v>
                </c:pt>
                <c:pt idx="12">
                  <c:v>1.63934426229508E-2</c:v>
                </c:pt>
                <c:pt idx="13">
                  <c:v>1.63934426229508E-2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3.2786885245901599E-2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1.63934426229508E-2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tph-1(mg280)_A5_0.02_50%'!$I$104</c:f>
              <c:strCache>
                <c:ptCount val="1"/>
                <c:pt idx="0">
                  <c:v>tph-1(mg280)_A5_08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I$105:$I$135</c:f>
              <c:numCache>
                <c:formatCode>General</c:formatCode>
                <c:ptCount val="31"/>
              </c:numCache>
            </c:numRef>
          </c:val>
        </c:ser>
        <c:ser>
          <c:idx val="8"/>
          <c:order val="8"/>
          <c:tx>
            <c:strRef>
              <c:f>'tph-1(mg280)_A5_0.02_50%'!$J$104</c:f>
              <c:strCache>
                <c:ptCount val="1"/>
                <c:pt idx="0">
                  <c:v>tph-1(mg280)_A5_10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J$105:$J$135</c:f>
              <c:numCache>
                <c:formatCode>General</c:formatCode>
                <c:ptCount val="31"/>
                <c:pt idx="1">
                  <c:v>0.106918238993711</c:v>
                </c:pt>
                <c:pt idx="2">
                  <c:v>8.17610062893082E-2</c:v>
                </c:pt>
                <c:pt idx="3">
                  <c:v>5.0314465408804999E-2</c:v>
                </c:pt>
                <c:pt idx="4">
                  <c:v>3.1446540880503131E-2</c:v>
                </c:pt>
                <c:pt idx="5">
                  <c:v>4.40251572327044E-2</c:v>
                </c:pt>
                <c:pt idx="6">
                  <c:v>4.40251572327044E-2</c:v>
                </c:pt>
                <c:pt idx="7">
                  <c:v>3.1446540880503131E-2</c:v>
                </c:pt>
                <c:pt idx="8">
                  <c:v>3.1446540880503131E-2</c:v>
                </c:pt>
                <c:pt idx="9">
                  <c:v>1.2578616352201295E-2</c:v>
                </c:pt>
                <c:pt idx="10">
                  <c:v>3.1446540880503131E-2</c:v>
                </c:pt>
                <c:pt idx="11">
                  <c:v>3.7735849056603821E-2</c:v>
                </c:pt>
                <c:pt idx="12">
                  <c:v>4.40251572327044E-2</c:v>
                </c:pt>
                <c:pt idx="13">
                  <c:v>2.515723270440251E-2</c:v>
                </c:pt>
                <c:pt idx="14">
                  <c:v>2.515723270440251E-2</c:v>
                </c:pt>
                <c:pt idx="15">
                  <c:v>1.2578616352201295E-2</c:v>
                </c:pt>
                <c:pt idx="16">
                  <c:v>5.6603773584905696E-2</c:v>
                </c:pt>
                <c:pt idx="17">
                  <c:v>3.7735849056603821E-2</c:v>
                </c:pt>
                <c:pt idx="18">
                  <c:v>2.515723270440251E-2</c:v>
                </c:pt>
                <c:pt idx="19">
                  <c:v>1.2578616352201295E-2</c:v>
                </c:pt>
                <c:pt idx="20">
                  <c:v>1.2578616352201295E-2</c:v>
                </c:pt>
                <c:pt idx="21">
                  <c:v>1.88679245283019E-2</c:v>
                </c:pt>
                <c:pt idx="22">
                  <c:v>1.88679245283019E-2</c:v>
                </c:pt>
                <c:pt idx="23">
                  <c:v>1.88679245283019E-2</c:v>
                </c:pt>
                <c:pt idx="24">
                  <c:v>1.2578616352201295E-2</c:v>
                </c:pt>
                <c:pt idx="25">
                  <c:v>1.2578616352201295E-2</c:v>
                </c:pt>
                <c:pt idx="26">
                  <c:v>6.2893081761006336E-3</c:v>
                </c:pt>
                <c:pt idx="27">
                  <c:v>0</c:v>
                </c:pt>
                <c:pt idx="28">
                  <c:v>6.2893081761006336E-3</c:v>
                </c:pt>
                <c:pt idx="29">
                  <c:v>1.2578616352201295E-2</c:v>
                </c:pt>
                <c:pt idx="30">
                  <c:v>6.2893081761006336E-3</c:v>
                </c:pt>
              </c:numCache>
            </c:numRef>
          </c:val>
        </c:ser>
        <c:ser>
          <c:idx val="9"/>
          <c:order val="9"/>
          <c:tx>
            <c:strRef>
              <c:f>'tph-1(mg280)_A5_0.02_50%'!$K$104</c:f>
              <c:strCache>
                <c:ptCount val="1"/>
                <c:pt idx="0">
                  <c:v>tph-1(mg280)_A5_11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K$105:$K$135</c:f>
              <c:numCache>
                <c:formatCode>General</c:formatCode>
                <c:ptCount val="31"/>
                <c:pt idx="1">
                  <c:v>0.12173913043478303</c:v>
                </c:pt>
                <c:pt idx="2">
                  <c:v>7.8260869565217397E-2</c:v>
                </c:pt>
                <c:pt idx="3">
                  <c:v>5.217391304347832E-2</c:v>
                </c:pt>
                <c:pt idx="4">
                  <c:v>3.4782608695652202E-2</c:v>
                </c:pt>
                <c:pt idx="5">
                  <c:v>5.217391304347832E-2</c:v>
                </c:pt>
                <c:pt idx="6">
                  <c:v>2.6086956521739115E-2</c:v>
                </c:pt>
                <c:pt idx="7">
                  <c:v>1.7391304347826101E-2</c:v>
                </c:pt>
                <c:pt idx="8">
                  <c:v>6.9565217391304321E-2</c:v>
                </c:pt>
                <c:pt idx="9">
                  <c:v>1.7391304347826101E-2</c:v>
                </c:pt>
                <c:pt idx="10">
                  <c:v>1.7391304347826101E-2</c:v>
                </c:pt>
                <c:pt idx="11">
                  <c:v>2.6086956521739115E-2</c:v>
                </c:pt>
                <c:pt idx="12">
                  <c:v>8.6956521739130453E-3</c:v>
                </c:pt>
                <c:pt idx="13">
                  <c:v>4.3478260869565202E-2</c:v>
                </c:pt>
                <c:pt idx="14">
                  <c:v>1.7391304347826101E-2</c:v>
                </c:pt>
                <c:pt idx="15">
                  <c:v>1.7391304347826101E-2</c:v>
                </c:pt>
                <c:pt idx="16">
                  <c:v>8.6956521739130453E-3</c:v>
                </c:pt>
                <c:pt idx="17">
                  <c:v>4.3478260869565202E-2</c:v>
                </c:pt>
                <c:pt idx="18">
                  <c:v>1.7391304347826101E-2</c:v>
                </c:pt>
                <c:pt idx="19">
                  <c:v>2.6086956521739115E-2</c:v>
                </c:pt>
                <c:pt idx="20">
                  <c:v>0</c:v>
                </c:pt>
                <c:pt idx="21">
                  <c:v>1.7391304347826101E-2</c:v>
                </c:pt>
                <c:pt idx="22">
                  <c:v>8.6956521739130453E-3</c:v>
                </c:pt>
                <c:pt idx="23">
                  <c:v>0</c:v>
                </c:pt>
                <c:pt idx="24">
                  <c:v>1.7391304347826101E-2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tph-1(mg280)_A5_0.02_50%'!$L$104</c:f>
              <c:strCache>
                <c:ptCount val="1"/>
                <c:pt idx="0">
                  <c:v>tph-1(mg280)_A5_12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L$105:$L$135</c:f>
              <c:numCache>
                <c:formatCode>General</c:formatCode>
                <c:ptCount val="31"/>
                <c:pt idx="1">
                  <c:v>8.0645161290322648E-2</c:v>
                </c:pt>
                <c:pt idx="2">
                  <c:v>8.0645161290322648E-2</c:v>
                </c:pt>
                <c:pt idx="3">
                  <c:v>0.14516129032258099</c:v>
                </c:pt>
                <c:pt idx="4">
                  <c:v>6.4516129032258132E-2</c:v>
                </c:pt>
                <c:pt idx="5">
                  <c:v>9.6774193548387122E-2</c:v>
                </c:pt>
                <c:pt idx="6">
                  <c:v>1.6129032258064505E-2</c:v>
                </c:pt>
                <c:pt idx="7">
                  <c:v>3.2258064516129011E-2</c:v>
                </c:pt>
                <c:pt idx="8">
                  <c:v>3.2258064516129011E-2</c:v>
                </c:pt>
                <c:pt idx="9">
                  <c:v>0</c:v>
                </c:pt>
                <c:pt idx="10">
                  <c:v>3.2258064516129011E-2</c:v>
                </c:pt>
                <c:pt idx="11">
                  <c:v>1.6129032258064505E-2</c:v>
                </c:pt>
                <c:pt idx="12">
                  <c:v>0</c:v>
                </c:pt>
                <c:pt idx="13">
                  <c:v>0</c:v>
                </c:pt>
                <c:pt idx="14">
                  <c:v>8.0645161290322648E-2</c:v>
                </c:pt>
                <c:pt idx="15">
                  <c:v>0</c:v>
                </c:pt>
                <c:pt idx="16">
                  <c:v>1.6129032258064505E-2</c:v>
                </c:pt>
                <c:pt idx="17">
                  <c:v>1.6129032258064505E-2</c:v>
                </c:pt>
                <c:pt idx="18">
                  <c:v>1.6129032258064505E-2</c:v>
                </c:pt>
                <c:pt idx="19">
                  <c:v>1.6129032258064505E-2</c:v>
                </c:pt>
                <c:pt idx="20">
                  <c:v>0</c:v>
                </c:pt>
                <c:pt idx="21">
                  <c:v>0</c:v>
                </c:pt>
                <c:pt idx="22">
                  <c:v>1.6129032258064505E-2</c:v>
                </c:pt>
                <c:pt idx="23">
                  <c:v>0</c:v>
                </c:pt>
                <c:pt idx="24">
                  <c:v>1.6129032258064505E-2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1.6129032258064505E-2</c:v>
                </c:pt>
              </c:numCache>
            </c:numRef>
          </c:val>
        </c:ser>
        <c:ser>
          <c:idx val="11"/>
          <c:order val="11"/>
          <c:tx>
            <c:strRef>
              <c:f>'tph-1(mg280)_A5_0.02_50%'!$M$104</c:f>
              <c:strCache>
                <c:ptCount val="1"/>
                <c:pt idx="0">
                  <c:v>tph-1(mg280)_A5_13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M$105:$M$135</c:f>
              <c:numCache>
                <c:formatCode>General</c:formatCode>
                <c:ptCount val="31"/>
                <c:pt idx="1">
                  <c:v>9.7560975609756156E-2</c:v>
                </c:pt>
                <c:pt idx="2">
                  <c:v>9.7560975609756156E-2</c:v>
                </c:pt>
                <c:pt idx="3">
                  <c:v>9.7560975609756156E-2</c:v>
                </c:pt>
                <c:pt idx="4">
                  <c:v>4.8780487804878127E-2</c:v>
                </c:pt>
                <c:pt idx="5">
                  <c:v>2.4390243902439001E-2</c:v>
                </c:pt>
                <c:pt idx="6">
                  <c:v>0</c:v>
                </c:pt>
                <c:pt idx="7">
                  <c:v>0</c:v>
                </c:pt>
                <c:pt idx="8">
                  <c:v>2.4390243902439001E-2</c:v>
                </c:pt>
                <c:pt idx="9">
                  <c:v>4.8780487804878127E-2</c:v>
                </c:pt>
                <c:pt idx="10">
                  <c:v>0</c:v>
                </c:pt>
                <c:pt idx="11">
                  <c:v>4.8780487804878127E-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2.4390243902439001E-2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2.4390243902439001E-2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tph-1(mg280)_A5_0.02_50%'!$N$104</c:f>
              <c:strCache>
                <c:ptCount val="1"/>
                <c:pt idx="0">
                  <c:v>tph-1(mg280)_A5_14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N$105:$N$135</c:f>
              <c:numCache>
                <c:formatCode>General</c:formatCode>
                <c:ptCount val="31"/>
                <c:pt idx="1">
                  <c:v>0.15068493150684906</c:v>
                </c:pt>
                <c:pt idx="2">
                  <c:v>0.12328767123287702</c:v>
                </c:pt>
                <c:pt idx="3">
                  <c:v>6.8493150684931503E-2</c:v>
                </c:pt>
                <c:pt idx="4">
                  <c:v>2.7397260273972608E-2</c:v>
                </c:pt>
                <c:pt idx="5">
                  <c:v>4.1095890410958895E-2</c:v>
                </c:pt>
                <c:pt idx="6">
                  <c:v>4.1095890410958895E-2</c:v>
                </c:pt>
                <c:pt idx="7">
                  <c:v>1.3698630136986301E-2</c:v>
                </c:pt>
                <c:pt idx="8">
                  <c:v>1.3698630136986301E-2</c:v>
                </c:pt>
                <c:pt idx="9">
                  <c:v>1.3698630136986301E-2</c:v>
                </c:pt>
                <c:pt idx="10">
                  <c:v>4.1095890410958895E-2</c:v>
                </c:pt>
                <c:pt idx="11">
                  <c:v>1.3698630136986301E-2</c:v>
                </c:pt>
                <c:pt idx="12">
                  <c:v>1.3698630136986301E-2</c:v>
                </c:pt>
                <c:pt idx="13">
                  <c:v>2.7397260273972608E-2</c:v>
                </c:pt>
                <c:pt idx="14">
                  <c:v>1.3698630136986301E-2</c:v>
                </c:pt>
                <c:pt idx="15">
                  <c:v>1.3698630136986301E-2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1.3698630136986301E-2</c:v>
                </c:pt>
                <c:pt idx="20">
                  <c:v>1.3698630136986301E-2</c:v>
                </c:pt>
                <c:pt idx="21">
                  <c:v>0</c:v>
                </c:pt>
                <c:pt idx="22">
                  <c:v>0</c:v>
                </c:pt>
                <c:pt idx="23">
                  <c:v>1.3698630136986301E-2</c:v>
                </c:pt>
                <c:pt idx="24">
                  <c:v>0</c:v>
                </c:pt>
                <c:pt idx="25">
                  <c:v>0</c:v>
                </c:pt>
                <c:pt idx="26">
                  <c:v>1.3698630136986301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tph-1(mg280)_A5_0.02_50%'!$O$104</c:f>
              <c:strCache>
                <c:ptCount val="1"/>
                <c:pt idx="0">
                  <c:v>tph-1(mg280)_A5_15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O$105:$O$135</c:f>
              <c:numCache>
                <c:formatCode>General</c:formatCode>
                <c:ptCount val="31"/>
                <c:pt idx="1">
                  <c:v>5.1020408163265286E-2</c:v>
                </c:pt>
                <c:pt idx="2">
                  <c:v>6.1224489795918401E-2</c:v>
                </c:pt>
                <c:pt idx="3">
                  <c:v>4.0816326530612221E-2</c:v>
                </c:pt>
                <c:pt idx="4">
                  <c:v>2.0408163265306107E-2</c:v>
                </c:pt>
                <c:pt idx="5">
                  <c:v>3.0612244897959207E-2</c:v>
                </c:pt>
                <c:pt idx="6">
                  <c:v>2.0408163265306107E-2</c:v>
                </c:pt>
                <c:pt idx="7">
                  <c:v>5.1020408163265286E-2</c:v>
                </c:pt>
                <c:pt idx="8">
                  <c:v>1.0204081632653106E-2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2.0408163265306107E-2</c:v>
                </c:pt>
                <c:pt idx="13">
                  <c:v>1.0204081632653106E-2</c:v>
                </c:pt>
                <c:pt idx="14">
                  <c:v>0</c:v>
                </c:pt>
                <c:pt idx="15">
                  <c:v>1.0204081632653106E-2</c:v>
                </c:pt>
                <c:pt idx="16">
                  <c:v>1.0204081632653106E-2</c:v>
                </c:pt>
                <c:pt idx="17">
                  <c:v>2.0408163265306107E-2</c:v>
                </c:pt>
                <c:pt idx="18">
                  <c:v>2.0408163265306107E-2</c:v>
                </c:pt>
                <c:pt idx="19">
                  <c:v>3.0612244897959207E-2</c:v>
                </c:pt>
                <c:pt idx="20">
                  <c:v>6.1224489795918401E-2</c:v>
                </c:pt>
                <c:pt idx="21">
                  <c:v>7.1428571428571411E-2</c:v>
                </c:pt>
                <c:pt idx="22">
                  <c:v>3.0612244897959207E-2</c:v>
                </c:pt>
                <c:pt idx="23">
                  <c:v>2.0408163265306107E-2</c:v>
                </c:pt>
                <c:pt idx="24">
                  <c:v>6.1224489795918401E-2</c:v>
                </c:pt>
                <c:pt idx="25">
                  <c:v>3.0612244897959207E-2</c:v>
                </c:pt>
                <c:pt idx="26">
                  <c:v>0</c:v>
                </c:pt>
                <c:pt idx="27">
                  <c:v>3.0612244897959207E-2</c:v>
                </c:pt>
                <c:pt idx="28">
                  <c:v>3.0612244897959207E-2</c:v>
                </c:pt>
                <c:pt idx="29">
                  <c:v>1.0204081632653106E-2</c:v>
                </c:pt>
                <c:pt idx="30">
                  <c:v>1.0204081632653106E-2</c:v>
                </c:pt>
              </c:numCache>
            </c:numRef>
          </c:val>
        </c:ser>
        <c:ser>
          <c:idx val="14"/>
          <c:order val="14"/>
          <c:tx>
            <c:strRef>
              <c:f>'tph-1(mg280)_A5_0.02_50%'!$P$104</c:f>
              <c:strCache>
                <c:ptCount val="1"/>
                <c:pt idx="0">
                  <c:v>tph-1(mg280)_A5_16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P$105:$P$135</c:f>
              <c:numCache>
                <c:formatCode>General</c:formatCode>
                <c:ptCount val="31"/>
                <c:pt idx="1">
                  <c:v>3.03030303030303E-2</c:v>
                </c:pt>
                <c:pt idx="2">
                  <c:v>3.7878787878787915E-2</c:v>
                </c:pt>
                <c:pt idx="3">
                  <c:v>1.5151515151515204E-2</c:v>
                </c:pt>
                <c:pt idx="4">
                  <c:v>3.03030303030303E-2</c:v>
                </c:pt>
                <c:pt idx="5">
                  <c:v>1.5151515151515204E-2</c:v>
                </c:pt>
                <c:pt idx="6">
                  <c:v>2.2727272727272717E-2</c:v>
                </c:pt>
                <c:pt idx="7">
                  <c:v>2.2727272727272717E-2</c:v>
                </c:pt>
                <c:pt idx="8">
                  <c:v>3.03030303030303E-2</c:v>
                </c:pt>
                <c:pt idx="9">
                  <c:v>0</c:v>
                </c:pt>
                <c:pt idx="10">
                  <c:v>1.5151515151515204E-2</c:v>
                </c:pt>
                <c:pt idx="11">
                  <c:v>3.03030303030303E-2</c:v>
                </c:pt>
                <c:pt idx="12">
                  <c:v>1.5151515151515204E-2</c:v>
                </c:pt>
                <c:pt idx="13">
                  <c:v>7.575757575757582E-3</c:v>
                </c:pt>
                <c:pt idx="14">
                  <c:v>2.2727272727272717E-2</c:v>
                </c:pt>
                <c:pt idx="15">
                  <c:v>6.8181818181818205E-2</c:v>
                </c:pt>
                <c:pt idx="16">
                  <c:v>7.5757575757575801E-2</c:v>
                </c:pt>
                <c:pt idx="17">
                  <c:v>3.7878787878787915E-2</c:v>
                </c:pt>
                <c:pt idx="18">
                  <c:v>5.3030303030302997E-2</c:v>
                </c:pt>
                <c:pt idx="19">
                  <c:v>6.0606060606060601E-2</c:v>
                </c:pt>
                <c:pt idx="20">
                  <c:v>7.5757575757575801E-2</c:v>
                </c:pt>
                <c:pt idx="21">
                  <c:v>5.3030303030302997E-2</c:v>
                </c:pt>
                <c:pt idx="22">
                  <c:v>2.2727272727272717E-2</c:v>
                </c:pt>
                <c:pt idx="23">
                  <c:v>2.2727272727272717E-2</c:v>
                </c:pt>
                <c:pt idx="24">
                  <c:v>2.2727272727272717E-2</c:v>
                </c:pt>
                <c:pt idx="25">
                  <c:v>0</c:v>
                </c:pt>
                <c:pt idx="26">
                  <c:v>2.2727272727272717E-2</c:v>
                </c:pt>
                <c:pt idx="27">
                  <c:v>0</c:v>
                </c:pt>
                <c:pt idx="28">
                  <c:v>1.5151515151515204E-2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5"/>
          <c:order val="15"/>
          <c:tx>
            <c:strRef>
              <c:f>'tph-1(mg280)_A5_0.02_50%'!$Q$104</c:f>
              <c:strCache>
                <c:ptCount val="1"/>
                <c:pt idx="0">
                  <c:v>tph-1(mg280)_A5_17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Q$105:$Q$135</c:f>
              <c:numCache>
                <c:formatCode>General</c:formatCode>
                <c:ptCount val="31"/>
                <c:pt idx="1">
                  <c:v>6.2937062937062901E-2</c:v>
                </c:pt>
                <c:pt idx="2">
                  <c:v>6.2937062937062901E-2</c:v>
                </c:pt>
                <c:pt idx="3">
                  <c:v>2.797202797202801E-2</c:v>
                </c:pt>
                <c:pt idx="4">
                  <c:v>4.1958041958042015E-2</c:v>
                </c:pt>
                <c:pt idx="5">
                  <c:v>2.0979020979021008E-2</c:v>
                </c:pt>
                <c:pt idx="6">
                  <c:v>2.0979020979021008E-2</c:v>
                </c:pt>
                <c:pt idx="7">
                  <c:v>3.4965034965034995E-2</c:v>
                </c:pt>
                <c:pt idx="8">
                  <c:v>4.8951048951049E-2</c:v>
                </c:pt>
                <c:pt idx="9">
                  <c:v>2.797202797202801E-2</c:v>
                </c:pt>
                <c:pt idx="10">
                  <c:v>2.797202797202801E-2</c:v>
                </c:pt>
                <c:pt idx="11">
                  <c:v>1.3986013986014E-2</c:v>
                </c:pt>
                <c:pt idx="12">
                  <c:v>3.4965034965034995E-2</c:v>
                </c:pt>
                <c:pt idx="13">
                  <c:v>2.0979020979021008E-2</c:v>
                </c:pt>
                <c:pt idx="14">
                  <c:v>2.0979020979021008E-2</c:v>
                </c:pt>
                <c:pt idx="15">
                  <c:v>2.0979020979021008E-2</c:v>
                </c:pt>
                <c:pt idx="16">
                  <c:v>3.4965034965034995E-2</c:v>
                </c:pt>
                <c:pt idx="17">
                  <c:v>3.4965034965034995E-2</c:v>
                </c:pt>
                <c:pt idx="18">
                  <c:v>5.5944055944055895E-2</c:v>
                </c:pt>
                <c:pt idx="19">
                  <c:v>3.4965034965034995E-2</c:v>
                </c:pt>
                <c:pt idx="20">
                  <c:v>2.0979020979021008E-2</c:v>
                </c:pt>
                <c:pt idx="21">
                  <c:v>1.3986013986014E-2</c:v>
                </c:pt>
                <c:pt idx="22">
                  <c:v>1.3986013986014E-2</c:v>
                </c:pt>
                <c:pt idx="23">
                  <c:v>6.9930069930069921E-3</c:v>
                </c:pt>
                <c:pt idx="24">
                  <c:v>2.797202797202801E-2</c:v>
                </c:pt>
                <c:pt idx="25">
                  <c:v>6.9930069930069921E-3</c:v>
                </c:pt>
                <c:pt idx="26">
                  <c:v>1.3986013986014E-2</c:v>
                </c:pt>
                <c:pt idx="27">
                  <c:v>6.9930069930069921E-3</c:v>
                </c:pt>
                <c:pt idx="28">
                  <c:v>2.0979020979021008E-2</c:v>
                </c:pt>
                <c:pt idx="29">
                  <c:v>6.9930069930069921E-3</c:v>
                </c:pt>
                <c:pt idx="30">
                  <c:v>6.9930069930069921E-3</c:v>
                </c:pt>
              </c:numCache>
            </c:numRef>
          </c:val>
        </c:ser>
        <c:ser>
          <c:idx val="16"/>
          <c:order val="16"/>
          <c:tx>
            <c:strRef>
              <c:f>'tph-1(mg280)_A5_0.02_50%'!$R$104</c:f>
              <c:strCache>
                <c:ptCount val="1"/>
                <c:pt idx="0">
                  <c:v>tph-1(mg280)_A5_18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R$105:$R$135</c:f>
              <c:numCache>
                <c:formatCode>General</c:formatCode>
                <c:ptCount val="31"/>
                <c:pt idx="1">
                  <c:v>0.104347826086957</c:v>
                </c:pt>
                <c:pt idx="2">
                  <c:v>7.8260869565217397E-2</c:v>
                </c:pt>
                <c:pt idx="3">
                  <c:v>9.5652173913043537E-2</c:v>
                </c:pt>
                <c:pt idx="4">
                  <c:v>4.3478260869565202E-2</c:v>
                </c:pt>
                <c:pt idx="5">
                  <c:v>7.8260869565217397E-2</c:v>
                </c:pt>
                <c:pt idx="6">
                  <c:v>4.3478260869565202E-2</c:v>
                </c:pt>
                <c:pt idx="7">
                  <c:v>2.6086956521739115E-2</c:v>
                </c:pt>
                <c:pt idx="8">
                  <c:v>2.6086956521739115E-2</c:v>
                </c:pt>
                <c:pt idx="9">
                  <c:v>0</c:v>
                </c:pt>
                <c:pt idx="10">
                  <c:v>3.4782608695652202E-2</c:v>
                </c:pt>
                <c:pt idx="11">
                  <c:v>8.6956521739130453E-3</c:v>
                </c:pt>
                <c:pt idx="12">
                  <c:v>3.4782608695652202E-2</c:v>
                </c:pt>
                <c:pt idx="13">
                  <c:v>2.6086956521739115E-2</c:v>
                </c:pt>
                <c:pt idx="14">
                  <c:v>8.6956521739130453E-3</c:v>
                </c:pt>
                <c:pt idx="15">
                  <c:v>8.6956521739130453E-3</c:v>
                </c:pt>
                <c:pt idx="16">
                  <c:v>0</c:v>
                </c:pt>
                <c:pt idx="17">
                  <c:v>8.6956521739130453E-3</c:v>
                </c:pt>
                <c:pt idx="18">
                  <c:v>1.7391304347826101E-2</c:v>
                </c:pt>
                <c:pt idx="19">
                  <c:v>2.6086956521739115E-2</c:v>
                </c:pt>
                <c:pt idx="20">
                  <c:v>1.7391304347826101E-2</c:v>
                </c:pt>
                <c:pt idx="21">
                  <c:v>2.6086956521739115E-2</c:v>
                </c:pt>
                <c:pt idx="22">
                  <c:v>1.7391304347826101E-2</c:v>
                </c:pt>
                <c:pt idx="23">
                  <c:v>1.7391304347826101E-2</c:v>
                </c:pt>
                <c:pt idx="24">
                  <c:v>0</c:v>
                </c:pt>
                <c:pt idx="25">
                  <c:v>1.7391304347826101E-2</c:v>
                </c:pt>
                <c:pt idx="26">
                  <c:v>8.6956521739130453E-3</c:v>
                </c:pt>
                <c:pt idx="27">
                  <c:v>0</c:v>
                </c:pt>
                <c:pt idx="28">
                  <c:v>0</c:v>
                </c:pt>
                <c:pt idx="29">
                  <c:v>8.6956521739130453E-3</c:v>
                </c:pt>
                <c:pt idx="30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tph-1(mg280)_A5_0.02_50%'!$S$104</c:f>
              <c:strCache>
                <c:ptCount val="1"/>
                <c:pt idx="0">
                  <c:v>tph-1(mg280)_A5_19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S$105:$S$135</c:f>
              <c:numCache>
                <c:formatCode>General</c:formatCode>
                <c:ptCount val="31"/>
                <c:pt idx="1">
                  <c:v>6.3670411985018729E-2</c:v>
                </c:pt>
                <c:pt idx="2">
                  <c:v>5.2434456928839031E-2</c:v>
                </c:pt>
                <c:pt idx="3">
                  <c:v>5.9925093632958802E-2</c:v>
                </c:pt>
                <c:pt idx="4">
                  <c:v>5.6179775280898875E-2</c:v>
                </c:pt>
                <c:pt idx="5">
                  <c:v>3.7453183520599322E-2</c:v>
                </c:pt>
                <c:pt idx="6">
                  <c:v>3.7453183520599322E-2</c:v>
                </c:pt>
                <c:pt idx="7">
                  <c:v>2.2471910112359623E-2</c:v>
                </c:pt>
                <c:pt idx="8">
                  <c:v>2.9962546816479401E-2</c:v>
                </c:pt>
                <c:pt idx="9">
                  <c:v>4.49438202247191E-2</c:v>
                </c:pt>
                <c:pt idx="10">
                  <c:v>2.6217228464419519E-2</c:v>
                </c:pt>
                <c:pt idx="11">
                  <c:v>4.8689138576778965E-2</c:v>
                </c:pt>
                <c:pt idx="12">
                  <c:v>3.3707865168539311E-2</c:v>
                </c:pt>
                <c:pt idx="13">
                  <c:v>3.3707865168539311E-2</c:v>
                </c:pt>
                <c:pt idx="14">
                  <c:v>1.1235955056179799E-2</c:v>
                </c:pt>
                <c:pt idx="15">
                  <c:v>4.49438202247191E-2</c:v>
                </c:pt>
                <c:pt idx="16">
                  <c:v>3.3707865168539311E-2</c:v>
                </c:pt>
                <c:pt idx="17">
                  <c:v>5.6179775280898875E-2</c:v>
                </c:pt>
                <c:pt idx="18">
                  <c:v>3.3707865168539311E-2</c:v>
                </c:pt>
                <c:pt idx="19">
                  <c:v>3.3707865168539311E-2</c:v>
                </c:pt>
                <c:pt idx="20">
                  <c:v>1.1235955056179799E-2</c:v>
                </c:pt>
                <c:pt idx="21">
                  <c:v>2.9962546816479401E-2</c:v>
                </c:pt>
                <c:pt idx="22">
                  <c:v>1.4981273408239701E-2</c:v>
                </c:pt>
                <c:pt idx="23">
                  <c:v>2.9962546816479401E-2</c:v>
                </c:pt>
                <c:pt idx="24">
                  <c:v>2.9962546816479401E-2</c:v>
                </c:pt>
                <c:pt idx="25">
                  <c:v>2.6217228464419519E-2</c:v>
                </c:pt>
                <c:pt idx="26">
                  <c:v>3.7453183520599321E-3</c:v>
                </c:pt>
                <c:pt idx="27">
                  <c:v>7.4906367041198537E-3</c:v>
                </c:pt>
                <c:pt idx="28">
                  <c:v>0</c:v>
                </c:pt>
                <c:pt idx="29">
                  <c:v>7.4906367041198537E-3</c:v>
                </c:pt>
                <c:pt idx="30">
                  <c:v>0</c:v>
                </c:pt>
              </c:numCache>
            </c:numRef>
          </c:val>
        </c:ser>
        <c:ser>
          <c:idx val="18"/>
          <c:order val="18"/>
          <c:tx>
            <c:strRef>
              <c:f>'tph-1(mg280)_A5_0.02_50%'!$T$104</c:f>
              <c:strCache>
                <c:ptCount val="1"/>
                <c:pt idx="0">
                  <c:v>tph-1(mg280)_A5_20</c:v>
                </c:pt>
              </c:strCache>
            </c:strRef>
          </c:tx>
          <c:marker>
            <c:symbol val="none"/>
          </c:marker>
          <c:cat>
            <c:numRef>
              <c:f>'tph-1(mg280)_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5_0.02_50%'!$T$105:$T$135</c:f>
              <c:numCache>
                <c:formatCode>General</c:formatCode>
                <c:ptCount val="31"/>
                <c:pt idx="1">
                  <c:v>9.3750000000000042E-2</c:v>
                </c:pt>
                <c:pt idx="2">
                  <c:v>0</c:v>
                </c:pt>
                <c:pt idx="3">
                  <c:v>0.125</c:v>
                </c:pt>
                <c:pt idx="4">
                  <c:v>3.125E-2</c:v>
                </c:pt>
                <c:pt idx="5">
                  <c:v>6.25E-2</c:v>
                </c:pt>
                <c:pt idx="6">
                  <c:v>9.3750000000000042E-2</c:v>
                </c:pt>
                <c:pt idx="7">
                  <c:v>3.125E-2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3.125E-2</c:v>
                </c:pt>
                <c:pt idx="12">
                  <c:v>0</c:v>
                </c:pt>
                <c:pt idx="13">
                  <c:v>3.125E-2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3.125E-2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3.125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marker val="1"/>
        <c:axId val="171999232"/>
        <c:axId val="172000768"/>
      </c:lineChart>
      <c:catAx>
        <c:axId val="171999232"/>
        <c:scaling>
          <c:orientation val="minMax"/>
        </c:scaling>
        <c:axPos val="b"/>
        <c:numFmt formatCode="0.0_ " sourceLinked="1"/>
        <c:tickLblPos val="nextTo"/>
        <c:crossAx val="172000768"/>
        <c:crosses val="autoZero"/>
        <c:auto val="1"/>
        <c:lblAlgn val="ctr"/>
        <c:lblOffset val="100"/>
        <c:tickLblSkip val="5"/>
        <c:tickMarkSkip val="5"/>
      </c:catAx>
      <c:valAx>
        <c:axId val="172000768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71999232"/>
        <c:crosses val="autoZero"/>
        <c:crossBetween val="between"/>
      </c:valAx>
    </c:plotArea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25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A1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25 A1_0.02_50%'!$B$104</c:f>
              <c:strCache>
                <c:ptCount val="1"/>
                <c:pt idx="0">
                  <c:v>control_unc-25_A1_001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B$105:$B$135</c:f>
              <c:numCache>
                <c:formatCode>General</c:formatCode>
                <c:ptCount val="31"/>
                <c:pt idx="1">
                  <c:v>4.991192014092783E-2</c:v>
                </c:pt>
                <c:pt idx="2">
                  <c:v>5.7545507927187302E-2</c:v>
                </c:pt>
                <c:pt idx="3">
                  <c:v>5.0499119201409301E-2</c:v>
                </c:pt>
                <c:pt idx="4">
                  <c:v>4.4627128596594179E-2</c:v>
                </c:pt>
                <c:pt idx="5">
                  <c:v>4.2865531415149725E-2</c:v>
                </c:pt>
                <c:pt idx="6">
                  <c:v>3.6406341749853216E-2</c:v>
                </c:pt>
                <c:pt idx="7">
                  <c:v>4.5214327657075712E-2</c:v>
                </c:pt>
                <c:pt idx="8">
                  <c:v>2.7598355842630692E-2</c:v>
                </c:pt>
                <c:pt idx="9">
                  <c:v>2.6423957721667612E-2</c:v>
                </c:pt>
                <c:pt idx="10">
                  <c:v>4.3452730475631231E-2</c:v>
                </c:pt>
                <c:pt idx="11">
                  <c:v>4.8737522019964799E-2</c:v>
                </c:pt>
                <c:pt idx="12">
                  <c:v>4.8737522019964799E-2</c:v>
                </c:pt>
                <c:pt idx="13">
                  <c:v>5.5783910745742821E-2</c:v>
                </c:pt>
                <c:pt idx="14">
                  <c:v>6.1655901350557797E-2</c:v>
                </c:pt>
                <c:pt idx="15">
                  <c:v>6.3417498532002334E-2</c:v>
                </c:pt>
                <c:pt idx="16">
                  <c:v>5.1086318261890785E-2</c:v>
                </c:pt>
                <c:pt idx="17">
                  <c:v>4.3452730475631231E-2</c:v>
                </c:pt>
                <c:pt idx="18">
                  <c:v>3.1708749266001202E-2</c:v>
                </c:pt>
                <c:pt idx="19">
                  <c:v>2.2900763358778602E-2</c:v>
                </c:pt>
                <c:pt idx="20">
                  <c:v>2.4075161479741609E-2</c:v>
                </c:pt>
                <c:pt idx="21">
                  <c:v>1.5267175572519104E-2</c:v>
                </c:pt>
                <c:pt idx="22">
                  <c:v>7.6335877862595417E-3</c:v>
                </c:pt>
                <c:pt idx="23">
                  <c:v>6.4591896652965415E-3</c:v>
                </c:pt>
                <c:pt idx="24">
                  <c:v>7.6335877862595417E-3</c:v>
                </c:pt>
                <c:pt idx="25">
                  <c:v>2.348796241926012E-3</c:v>
                </c:pt>
                <c:pt idx="26">
                  <c:v>1.7615971814445104E-3</c:v>
                </c:pt>
                <c:pt idx="27">
                  <c:v>5.8719906048150332E-4</c:v>
                </c:pt>
                <c:pt idx="28">
                  <c:v>0</c:v>
                </c:pt>
                <c:pt idx="29">
                  <c:v>0</c:v>
                </c:pt>
                <c:pt idx="30">
                  <c:v>5.8719906048150332E-4</c:v>
                </c:pt>
              </c:numCache>
            </c:numRef>
          </c:val>
        </c:ser>
        <c:ser>
          <c:idx val="1"/>
          <c:order val="1"/>
          <c:tx>
            <c:strRef>
              <c:f>'unc-25 A1_0.02_50%'!$C$104</c:f>
              <c:strCache>
                <c:ptCount val="1"/>
                <c:pt idx="0">
                  <c:v>control_unc-25_A1_002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C$105:$C$135</c:f>
              <c:numCache>
                <c:formatCode>General</c:formatCode>
                <c:ptCount val="31"/>
                <c:pt idx="1">
                  <c:v>6.0559796437658998E-2</c:v>
                </c:pt>
                <c:pt idx="2">
                  <c:v>4.22391857506361E-2</c:v>
                </c:pt>
                <c:pt idx="3">
                  <c:v>5.0381679389312997E-2</c:v>
                </c:pt>
                <c:pt idx="4">
                  <c:v>4.7837150127226516E-2</c:v>
                </c:pt>
                <c:pt idx="5">
                  <c:v>5.39440203562341E-2</c:v>
                </c:pt>
                <c:pt idx="6">
                  <c:v>4.5292620865140035E-2</c:v>
                </c:pt>
                <c:pt idx="7">
                  <c:v>4.9363867684478417E-2</c:v>
                </c:pt>
                <c:pt idx="8">
                  <c:v>3.6132315521628523E-2</c:v>
                </c:pt>
                <c:pt idx="9">
                  <c:v>3.7150127226463124E-2</c:v>
                </c:pt>
                <c:pt idx="10">
                  <c:v>3.7150127226463124E-2</c:v>
                </c:pt>
                <c:pt idx="11">
                  <c:v>4.12213740458015E-2</c:v>
                </c:pt>
                <c:pt idx="12">
                  <c:v>4.4783715012722637E-2</c:v>
                </c:pt>
                <c:pt idx="13">
                  <c:v>5.6488549618320602E-2</c:v>
                </c:pt>
                <c:pt idx="14">
                  <c:v>5.6488549618320602E-2</c:v>
                </c:pt>
                <c:pt idx="15">
                  <c:v>5.0381679389312997E-2</c:v>
                </c:pt>
                <c:pt idx="16">
                  <c:v>5.4961832061068701E-2</c:v>
                </c:pt>
                <c:pt idx="17">
                  <c:v>4.8854961832061117E-2</c:v>
                </c:pt>
                <c:pt idx="18">
                  <c:v>3.7150127226463124E-2</c:v>
                </c:pt>
                <c:pt idx="19">
                  <c:v>3.1552162849872799E-2</c:v>
                </c:pt>
                <c:pt idx="20">
                  <c:v>2.2391857506361319E-2</c:v>
                </c:pt>
                <c:pt idx="21">
                  <c:v>1.3231552162849899E-2</c:v>
                </c:pt>
                <c:pt idx="22">
                  <c:v>9.160305343511449E-3</c:v>
                </c:pt>
                <c:pt idx="23">
                  <c:v>5.5979643765903296E-3</c:v>
                </c:pt>
                <c:pt idx="24">
                  <c:v>5.0890585241730336E-3</c:v>
                </c:pt>
                <c:pt idx="25">
                  <c:v>2.035623409669209E-3</c:v>
                </c:pt>
                <c:pt idx="26">
                  <c:v>2.5445292620865124E-3</c:v>
                </c:pt>
                <c:pt idx="27">
                  <c:v>1.5267175572519105E-3</c:v>
                </c:pt>
                <c:pt idx="28">
                  <c:v>0</c:v>
                </c:pt>
                <c:pt idx="29">
                  <c:v>5.0890585241730334E-4</c:v>
                </c:pt>
                <c:pt idx="30">
                  <c:v>5.0890585241730334E-4</c:v>
                </c:pt>
              </c:numCache>
            </c:numRef>
          </c:val>
        </c:ser>
        <c:ser>
          <c:idx val="2"/>
          <c:order val="2"/>
          <c:tx>
            <c:strRef>
              <c:f>'unc-25 A1_0.02_50%'!$D$104</c:f>
              <c:strCache>
                <c:ptCount val="1"/>
                <c:pt idx="0">
                  <c:v>control_unc-25_A1_003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D$105:$D$135</c:f>
              <c:numCache>
                <c:formatCode>General</c:formatCode>
                <c:ptCount val="31"/>
                <c:pt idx="1">
                  <c:v>3.4658511722731898E-2</c:v>
                </c:pt>
                <c:pt idx="2">
                  <c:v>3.1600407747196697E-2</c:v>
                </c:pt>
                <c:pt idx="3">
                  <c:v>3.3639143730886799E-2</c:v>
                </c:pt>
                <c:pt idx="4">
                  <c:v>2.2426095820591206E-2</c:v>
                </c:pt>
                <c:pt idx="5">
                  <c:v>1.8348623853211E-2</c:v>
                </c:pt>
                <c:pt idx="6">
                  <c:v>2.4464831804281294E-2</c:v>
                </c:pt>
                <c:pt idx="7">
                  <c:v>1.9367991845056106E-2</c:v>
                </c:pt>
                <c:pt idx="8">
                  <c:v>1.2232415902140695E-2</c:v>
                </c:pt>
                <c:pt idx="9">
                  <c:v>3.3639143730886799E-2</c:v>
                </c:pt>
                <c:pt idx="10">
                  <c:v>3.3639143730886799E-2</c:v>
                </c:pt>
                <c:pt idx="11">
                  <c:v>6.9317023445463838E-2</c:v>
                </c:pt>
                <c:pt idx="12">
                  <c:v>9.0723751274210007E-2</c:v>
                </c:pt>
                <c:pt idx="13">
                  <c:v>8.3588175331294673E-2</c:v>
                </c:pt>
                <c:pt idx="14">
                  <c:v>8.3588175331294673E-2</c:v>
                </c:pt>
                <c:pt idx="15">
                  <c:v>9.1743119266055079E-2</c:v>
                </c:pt>
                <c:pt idx="16">
                  <c:v>7.4413863404689098E-2</c:v>
                </c:pt>
                <c:pt idx="17">
                  <c:v>5.4026503567788001E-2</c:v>
                </c:pt>
                <c:pt idx="18">
                  <c:v>4.0774719673802202E-2</c:v>
                </c:pt>
                <c:pt idx="19">
                  <c:v>2.0387359836901101E-2</c:v>
                </c:pt>
                <c:pt idx="20">
                  <c:v>2.4464831804281294E-2</c:v>
                </c:pt>
                <c:pt idx="21">
                  <c:v>1.5290519877675801E-2</c:v>
                </c:pt>
                <c:pt idx="22">
                  <c:v>6.1162079510703416E-3</c:v>
                </c:pt>
                <c:pt idx="23">
                  <c:v>8.1549439347604526E-3</c:v>
                </c:pt>
                <c:pt idx="24">
                  <c:v>3.0581039755351708E-3</c:v>
                </c:pt>
                <c:pt idx="25">
                  <c:v>0</c:v>
                </c:pt>
                <c:pt idx="26">
                  <c:v>1.0193679918450605E-3</c:v>
                </c:pt>
                <c:pt idx="27">
                  <c:v>2.0387359836901101E-3</c:v>
                </c:pt>
                <c:pt idx="28">
                  <c:v>1.0193679918450605E-3</c:v>
                </c:pt>
                <c:pt idx="29">
                  <c:v>0</c:v>
                </c:pt>
                <c:pt idx="30">
                  <c:v>1.0193679918450605E-3</c:v>
                </c:pt>
              </c:numCache>
            </c:numRef>
          </c:val>
        </c:ser>
        <c:ser>
          <c:idx val="3"/>
          <c:order val="3"/>
          <c:tx>
            <c:strRef>
              <c:f>'unc-25 A1_0.02_50%'!$E$104</c:f>
              <c:strCache>
                <c:ptCount val="1"/>
                <c:pt idx="0">
                  <c:v>control_unc-25_A1_004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E$105:$E$135</c:f>
              <c:numCache>
                <c:formatCode>General</c:formatCode>
                <c:ptCount val="31"/>
                <c:pt idx="1">
                  <c:v>4.1315345699831398E-2</c:v>
                </c:pt>
                <c:pt idx="2">
                  <c:v>3.70994940978078E-2</c:v>
                </c:pt>
                <c:pt idx="3">
                  <c:v>2.9510961214165299E-2</c:v>
                </c:pt>
                <c:pt idx="4">
                  <c:v>2.6981450252951102E-2</c:v>
                </c:pt>
                <c:pt idx="5">
                  <c:v>2.6981450252951102E-2</c:v>
                </c:pt>
                <c:pt idx="6">
                  <c:v>2.8667790893760502E-2</c:v>
                </c:pt>
                <c:pt idx="7">
                  <c:v>1.5177065767284999E-2</c:v>
                </c:pt>
                <c:pt idx="8">
                  <c:v>2.4451939291736901E-2</c:v>
                </c:pt>
                <c:pt idx="9">
                  <c:v>2.6138279932546398E-2</c:v>
                </c:pt>
                <c:pt idx="10">
                  <c:v>2.6981450252951102E-2</c:v>
                </c:pt>
                <c:pt idx="11">
                  <c:v>5.1433389544687999E-2</c:v>
                </c:pt>
                <c:pt idx="12">
                  <c:v>5.2276559865092699E-2</c:v>
                </c:pt>
                <c:pt idx="13">
                  <c:v>6.7453625632377723E-2</c:v>
                </c:pt>
                <c:pt idx="14">
                  <c:v>7.4198988195615503E-2</c:v>
                </c:pt>
                <c:pt idx="15">
                  <c:v>7.335581787521081E-2</c:v>
                </c:pt>
                <c:pt idx="16">
                  <c:v>7.7571669477234401E-2</c:v>
                </c:pt>
                <c:pt idx="17">
                  <c:v>6.5767284991568337E-2</c:v>
                </c:pt>
                <c:pt idx="18">
                  <c:v>5.2276559865092699E-2</c:v>
                </c:pt>
                <c:pt idx="19">
                  <c:v>3.9629005059021914E-2</c:v>
                </c:pt>
                <c:pt idx="20">
                  <c:v>3.4569983136593603E-2</c:v>
                </c:pt>
                <c:pt idx="21">
                  <c:v>1.6863406408094399E-2</c:v>
                </c:pt>
                <c:pt idx="22">
                  <c:v>1.9392917369308607E-2</c:v>
                </c:pt>
                <c:pt idx="23">
                  <c:v>1.3490725126475504E-2</c:v>
                </c:pt>
                <c:pt idx="24">
                  <c:v>5.059021922428332E-3</c:v>
                </c:pt>
                <c:pt idx="25">
                  <c:v>5.059021922428332E-3</c:v>
                </c:pt>
                <c:pt idx="26">
                  <c:v>4.215851602023612E-3</c:v>
                </c:pt>
                <c:pt idx="27">
                  <c:v>3.3726812816188899E-3</c:v>
                </c:pt>
                <c:pt idx="28">
                  <c:v>0</c:v>
                </c:pt>
                <c:pt idx="29">
                  <c:v>8.4317032040472247E-4</c:v>
                </c:pt>
                <c:pt idx="30">
                  <c:v>8.4317032040472247E-4</c:v>
                </c:pt>
              </c:numCache>
            </c:numRef>
          </c:val>
        </c:ser>
        <c:ser>
          <c:idx val="4"/>
          <c:order val="4"/>
          <c:tx>
            <c:strRef>
              <c:f>'unc-25 A1_0.02_50%'!$F$104</c:f>
              <c:strCache>
                <c:ptCount val="1"/>
                <c:pt idx="0">
                  <c:v>control_unc-25_A1_005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F$105:$F$135</c:f>
              <c:numCache>
                <c:formatCode>General</c:formatCode>
                <c:ptCount val="31"/>
                <c:pt idx="1">
                  <c:v>3.4334763948497903E-2</c:v>
                </c:pt>
                <c:pt idx="2">
                  <c:v>3.4334763948497903E-2</c:v>
                </c:pt>
                <c:pt idx="3">
                  <c:v>3.4334763948497903E-2</c:v>
                </c:pt>
                <c:pt idx="4">
                  <c:v>3.5944206008583716E-2</c:v>
                </c:pt>
                <c:pt idx="5">
                  <c:v>3.3798283261802585E-2</c:v>
                </c:pt>
                <c:pt idx="6">
                  <c:v>3.2725321888412005E-2</c:v>
                </c:pt>
                <c:pt idx="7">
                  <c:v>4.2381974248927021E-2</c:v>
                </c:pt>
                <c:pt idx="8">
                  <c:v>3.862660944206011E-2</c:v>
                </c:pt>
                <c:pt idx="9">
                  <c:v>4.2918454935622338E-2</c:v>
                </c:pt>
                <c:pt idx="10">
                  <c:v>4.50643776824034E-2</c:v>
                </c:pt>
                <c:pt idx="11">
                  <c:v>5.901287553648072E-2</c:v>
                </c:pt>
                <c:pt idx="12">
                  <c:v>7.832618025751073E-2</c:v>
                </c:pt>
                <c:pt idx="13">
                  <c:v>7.0815450643776826E-2</c:v>
                </c:pt>
                <c:pt idx="14">
                  <c:v>8.4227467811158793E-2</c:v>
                </c:pt>
                <c:pt idx="15">
                  <c:v>7.8862660944206062E-2</c:v>
                </c:pt>
                <c:pt idx="16">
                  <c:v>4.9892703862660918E-2</c:v>
                </c:pt>
                <c:pt idx="17">
                  <c:v>4.6673819742489284E-2</c:v>
                </c:pt>
                <c:pt idx="18">
                  <c:v>4.0772532188841235E-2</c:v>
                </c:pt>
                <c:pt idx="19">
                  <c:v>2.3068669527896997E-2</c:v>
                </c:pt>
                <c:pt idx="20">
                  <c:v>1.6630901287553606E-2</c:v>
                </c:pt>
                <c:pt idx="21">
                  <c:v>8.0472103004291789E-3</c:v>
                </c:pt>
                <c:pt idx="22">
                  <c:v>9.120171673819736E-3</c:v>
                </c:pt>
                <c:pt idx="23">
                  <c:v>6.974248927038634E-3</c:v>
                </c:pt>
                <c:pt idx="24">
                  <c:v>3.7553648068669528E-3</c:v>
                </c:pt>
                <c:pt idx="25">
                  <c:v>3.2188841201716699E-3</c:v>
                </c:pt>
                <c:pt idx="26">
                  <c:v>2.1459227467811219E-3</c:v>
                </c:pt>
                <c:pt idx="27">
                  <c:v>1.0729613733905601E-3</c:v>
                </c:pt>
                <c:pt idx="28">
                  <c:v>5.3648068669527875E-4</c:v>
                </c:pt>
                <c:pt idx="29">
                  <c:v>1.6094420600858408E-3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unc-25 A1_0.02_50%'!$G$104</c:f>
              <c:strCache>
                <c:ptCount val="1"/>
                <c:pt idx="0">
                  <c:v>control_unc-25_A1_006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G$105:$G$135</c:f>
              <c:numCache>
                <c:formatCode>General</c:formatCode>
                <c:ptCount val="31"/>
                <c:pt idx="1">
                  <c:v>2.9812606473594506E-2</c:v>
                </c:pt>
                <c:pt idx="2">
                  <c:v>2.55536626916525E-2</c:v>
                </c:pt>
                <c:pt idx="3">
                  <c:v>2.1294718909710408E-2</c:v>
                </c:pt>
                <c:pt idx="4">
                  <c:v>1.9591141396933607E-2</c:v>
                </c:pt>
                <c:pt idx="5">
                  <c:v>1.7887563884156701E-2</c:v>
                </c:pt>
                <c:pt idx="6">
                  <c:v>1.3628620102214701E-2</c:v>
                </c:pt>
                <c:pt idx="7">
                  <c:v>1.87393526405451E-2</c:v>
                </c:pt>
                <c:pt idx="8">
                  <c:v>1.87393526405451E-2</c:v>
                </c:pt>
                <c:pt idx="9">
                  <c:v>2.8960817717206114E-2</c:v>
                </c:pt>
                <c:pt idx="10">
                  <c:v>3.83304940374787E-2</c:v>
                </c:pt>
                <c:pt idx="11">
                  <c:v>4.17376490630324E-2</c:v>
                </c:pt>
                <c:pt idx="12">
                  <c:v>8.1771720613287927E-2</c:v>
                </c:pt>
                <c:pt idx="13">
                  <c:v>0.109028960817717</c:v>
                </c:pt>
                <c:pt idx="14">
                  <c:v>0.11243611584327103</c:v>
                </c:pt>
                <c:pt idx="15">
                  <c:v>8.1771720613287927E-2</c:v>
                </c:pt>
                <c:pt idx="16">
                  <c:v>8.0919931856899496E-2</c:v>
                </c:pt>
                <c:pt idx="17">
                  <c:v>5.7921635434412318E-2</c:v>
                </c:pt>
                <c:pt idx="18">
                  <c:v>5.4514480408858618E-2</c:v>
                </c:pt>
                <c:pt idx="19">
                  <c:v>3.918228279386711E-2</c:v>
                </c:pt>
                <c:pt idx="20">
                  <c:v>1.87393526405451E-2</c:v>
                </c:pt>
                <c:pt idx="21">
                  <c:v>1.7887563884156701E-2</c:v>
                </c:pt>
                <c:pt idx="22">
                  <c:v>1.7035775127768306E-2</c:v>
                </c:pt>
                <c:pt idx="23">
                  <c:v>5.1107325383304885E-3</c:v>
                </c:pt>
                <c:pt idx="24">
                  <c:v>4.2589437819420834E-3</c:v>
                </c:pt>
                <c:pt idx="25">
                  <c:v>2.5553662691652499E-3</c:v>
                </c:pt>
                <c:pt idx="26">
                  <c:v>2.5553662691652499E-3</c:v>
                </c:pt>
                <c:pt idx="27">
                  <c:v>3.4071550255536601E-3</c:v>
                </c:pt>
                <c:pt idx="28">
                  <c:v>0</c:v>
                </c:pt>
                <c:pt idx="29">
                  <c:v>8.5178875638841644E-4</c:v>
                </c:pt>
                <c:pt idx="30">
                  <c:v>8.5178875638841644E-4</c:v>
                </c:pt>
              </c:numCache>
            </c:numRef>
          </c:val>
        </c:ser>
        <c:ser>
          <c:idx val="6"/>
          <c:order val="6"/>
          <c:tx>
            <c:strRef>
              <c:f>'unc-25 A1_0.02_50%'!$H$104</c:f>
              <c:strCache>
                <c:ptCount val="1"/>
                <c:pt idx="0">
                  <c:v>control_unc-25_A1_007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H$105:$H$135</c:f>
              <c:numCache>
                <c:formatCode>General</c:formatCode>
                <c:ptCount val="31"/>
                <c:pt idx="1">
                  <c:v>2.9946524064171101E-2</c:v>
                </c:pt>
                <c:pt idx="2">
                  <c:v>3.1016042780748706E-2</c:v>
                </c:pt>
                <c:pt idx="3">
                  <c:v>1.8181818181818205E-2</c:v>
                </c:pt>
                <c:pt idx="4">
                  <c:v>2.6737967914438505E-2</c:v>
                </c:pt>
                <c:pt idx="5">
                  <c:v>1.2834224598930501E-2</c:v>
                </c:pt>
                <c:pt idx="6">
                  <c:v>1.06951871657754E-2</c:v>
                </c:pt>
                <c:pt idx="7">
                  <c:v>1.1764705882352905E-2</c:v>
                </c:pt>
                <c:pt idx="8">
                  <c:v>1.3903743315508005E-2</c:v>
                </c:pt>
                <c:pt idx="9">
                  <c:v>5.3475935828877002E-3</c:v>
                </c:pt>
                <c:pt idx="10">
                  <c:v>9.6256684491978599E-3</c:v>
                </c:pt>
                <c:pt idx="11">
                  <c:v>1.8181818181818205E-2</c:v>
                </c:pt>
                <c:pt idx="12">
                  <c:v>2.8877005347593607E-2</c:v>
                </c:pt>
                <c:pt idx="13">
                  <c:v>4.4919786096256721E-2</c:v>
                </c:pt>
                <c:pt idx="14">
                  <c:v>7.5935828877005396E-2</c:v>
                </c:pt>
                <c:pt idx="15">
                  <c:v>7.9144385026737998E-2</c:v>
                </c:pt>
                <c:pt idx="16">
                  <c:v>0.11764705882352898</c:v>
                </c:pt>
                <c:pt idx="17">
                  <c:v>8.5561497326203245E-2</c:v>
                </c:pt>
                <c:pt idx="18">
                  <c:v>6.8449197860962596E-2</c:v>
                </c:pt>
                <c:pt idx="19">
                  <c:v>8.1283422459893007E-2</c:v>
                </c:pt>
                <c:pt idx="20">
                  <c:v>4.4919786096256721E-2</c:v>
                </c:pt>
                <c:pt idx="21">
                  <c:v>3.5294117647058802E-2</c:v>
                </c:pt>
                <c:pt idx="22">
                  <c:v>2.1390374331550797E-2</c:v>
                </c:pt>
                <c:pt idx="23">
                  <c:v>2.6737967914438505E-2</c:v>
                </c:pt>
                <c:pt idx="24">
                  <c:v>1.6042780748663114E-2</c:v>
                </c:pt>
                <c:pt idx="25">
                  <c:v>7.4866310160427822E-3</c:v>
                </c:pt>
                <c:pt idx="26">
                  <c:v>1.06951871657754E-2</c:v>
                </c:pt>
                <c:pt idx="27">
                  <c:v>5.3475935828877002E-3</c:v>
                </c:pt>
                <c:pt idx="28">
                  <c:v>4.2780748663101597E-3</c:v>
                </c:pt>
                <c:pt idx="29">
                  <c:v>1.0695187165775401E-3</c:v>
                </c:pt>
                <c:pt idx="30">
                  <c:v>1.0695187165775401E-3</c:v>
                </c:pt>
              </c:numCache>
            </c:numRef>
          </c:val>
        </c:ser>
        <c:ser>
          <c:idx val="7"/>
          <c:order val="7"/>
          <c:tx>
            <c:strRef>
              <c:f>'unc-25 A1_0.02_50%'!$I$104</c:f>
              <c:strCache>
                <c:ptCount val="1"/>
                <c:pt idx="0">
                  <c:v>control_unc-25_A1_008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I$105:$I$135</c:f>
              <c:numCache>
                <c:formatCode>General</c:formatCode>
                <c:ptCount val="31"/>
                <c:pt idx="1">
                  <c:v>3.094777562862672E-2</c:v>
                </c:pt>
                <c:pt idx="2">
                  <c:v>3.3526756931012286E-2</c:v>
                </c:pt>
                <c:pt idx="3">
                  <c:v>3.3526756931012286E-2</c:v>
                </c:pt>
                <c:pt idx="4">
                  <c:v>3.6105738233397799E-2</c:v>
                </c:pt>
                <c:pt idx="5">
                  <c:v>4.1908446163765295E-2</c:v>
                </c:pt>
                <c:pt idx="6">
                  <c:v>3.9974210186976118E-2</c:v>
                </c:pt>
                <c:pt idx="7">
                  <c:v>3.2882011605415921E-2</c:v>
                </c:pt>
                <c:pt idx="8">
                  <c:v>3.094777562862672E-2</c:v>
                </c:pt>
                <c:pt idx="9">
                  <c:v>3.6105738233397799E-2</c:v>
                </c:pt>
                <c:pt idx="10">
                  <c:v>2.9658284977433901E-2</c:v>
                </c:pt>
                <c:pt idx="11">
                  <c:v>2.5145067698259211E-2</c:v>
                </c:pt>
                <c:pt idx="12">
                  <c:v>3.3526756931012286E-2</c:v>
                </c:pt>
                <c:pt idx="13">
                  <c:v>4.3842682140554499E-2</c:v>
                </c:pt>
                <c:pt idx="14">
                  <c:v>5.6737588652482303E-2</c:v>
                </c:pt>
                <c:pt idx="15">
                  <c:v>5.9316569954867837E-2</c:v>
                </c:pt>
                <c:pt idx="16">
                  <c:v>6.8987749838813728E-2</c:v>
                </c:pt>
                <c:pt idx="17">
                  <c:v>9.4777562862669376E-2</c:v>
                </c:pt>
                <c:pt idx="18">
                  <c:v>5.4158607350096734E-2</c:v>
                </c:pt>
                <c:pt idx="19">
                  <c:v>4.2553191489361715E-2</c:v>
                </c:pt>
                <c:pt idx="20">
                  <c:v>3.54609929078014E-2</c:v>
                </c:pt>
                <c:pt idx="21">
                  <c:v>3.1592520954223102E-2</c:v>
                </c:pt>
                <c:pt idx="22">
                  <c:v>2.1276595744680899E-2</c:v>
                </c:pt>
                <c:pt idx="23">
                  <c:v>1.8052869116698903E-2</c:v>
                </c:pt>
                <c:pt idx="24">
                  <c:v>8.3816892327530663E-3</c:v>
                </c:pt>
                <c:pt idx="25">
                  <c:v>7.0921985815602818E-3</c:v>
                </c:pt>
                <c:pt idx="26">
                  <c:v>3.8684719535783409E-3</c:v>
                </c:pt>
                <c:pt idx="27">
                  <c:v>3.2237266279819534E-3</c:v>
                </c:pt>
                <c:pt idx="28">
                  <c:v>6.4474532559638932E-4</c:v>
                </c:pt>
                <c:pt idx="29">
                  <c:v>2.5789813023855616E-3</c:v>
                </c:pt>
                <c:pt idx="30">
                  <c:v>6.4474532559638932E-4</c:v>
                </c:pt>
              </c:numCache>
            </c:numRef>
          </c:val>
        </c:ser>
        <c:ser>
          <c:idx val="8"/>
          <c:order val="8"/>
          <c:tx>
            <c:strRef>
              <c:f>'unc-25 A1_0.02_50%'!$J$104</c:f>
              <c:strCache>
                <c:ptCount val="1"/>
                <c:pt idx="0">
                  <c:v>unc-25_A1_M101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J$105:$J$135</c:f>
              <c:numCache>
                <c:formatCode>General</c:formatCode>
                <c:ptCount val="31"/>
                <c:pt idx="1">
                  <c:v>3.8212815990593806E-2</c:v>
                </c:pt>
                <c:pt idx="2">
                  <c:v>5.4673721340388011E-2</c:v>
                </c:pt>
                <c:pt idx="3">
                  <c:v>5.29100529100529E-2</c:v>
                </c:pt>
                <c:pt idx="4">
                  <c:v>5.3497942386831317E-2</c:v>
                </c:pt>
                <c:pt idx="5">
                  <c:v>3.4097589653145202E-2</c:v>
                </c:pt>
                <c:pt idx="6">
                  <c:v>4.6443268665490874E-2</c:v>
                </c:pt>
                <c:pt idx="7">
                  <c:v>3.5273368606701931E-2</c:v>
                </c:pt>
                <c:pt idx="8">
                  <c:v>4.2328042328042312E-2</c:v>
                </c:pt>
                <c:pt idx="9">
                  <c:v>5.2322163433274498E-2</c:v>
                </c:pt>
                <c:pt idx="10">
                  <c:v>6.4079952968841919E-2</c:v>
                </c:pt>
                <c:pt idx="11">
                  <c:v>6.1140505584949961E-2</c:v>
                </c:pt>
                <c:pt idx="12">
                  <c:v>6.5843621399177002E-2</c:v>
                </c:pt>
                <c:pt idx="13">
                  <c:v>6.4079952968841919E-2</c:v>
                </c:pt>
                <c:pt idx="14">
                  <c:v>6.3492063492063502E-2</c:v>
                </c:pt>
                <c:pt idx="15">
                  <c:v>6.5843621399177002E-2</c:v>
                </c:pt>
                <c:pt idx="16">
                  <c:v>4.1152263374485583E-2</c:v>
                </c:pt>
                <c:pt idx="17">
                  <c:v>3.8212815990593806E-2</c:v>
                </c:pt>
                <c:pt idx="18">
                  <c:v>3.2921810699588501E-2</c:v>
                </c:pt>
                <c:pt idx="19">
                  <c:v>1.7636684303351E-2</c:v>
                </c:pt>
                <c:pt idx="20">
                  <c:v>9.4062316284538507E-3</c:v>
                </c:pt>
                <c:pt idx="21">
                  <c:v>9.9941211052322187E-3</c:v>
                </c:pt>
                <c:pt idx="22">
                  <c:v>1.0582010582010601E-2</c:v>
                </c:pt>
                <c:pt idx="23">
                  <c:v>5.2910052910052898E-3</c:v>
                </c:pt>
                <c:pt idx="24">
                  <c:v>1.7636684303351004E-3</c:v>
                </c:pt>
                <c:pt idx="25">
                  <c:v>2.3515579071134601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unc-25 A1_0.02_50%'!$K$104</c:f>
              <c:strCache>
                <c:ptCount val="1"/>
                <c:pt idx="0">
                  <c:v>unc-25_A1_M102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K$105:$K$135</c:f>
              <c:numCache>
                <c:formatCode>General</c:formatCode>
                <c:ptCount val="31"/>
                <c:pt idx="1">
                  <c:v>6.0031595576619301E-2</c:v>
                </c:pt>
                <c:pt idx="2">
                  <c:v>4.8183254344391815E-2</c:v>
                </c:pt>
                <c:pt idx="3">
                  <c:v>5.2922590837282825E-2</c:v>
                </c:pt>
                <c:pt idx="4">
                  <c:v>4.7393364928909935E-2</c:v>
                </c:pt>
                <c:pt idx="5">
                  <c:v>3.7124802527646113E-2</c:v>
                </c:pt>
                <c:pt idx="6">
                  <c:v>4.1864139020537101E-2</c:v>
                </c:pt>
                <c:pt idx="7">
                  <c:v>2.6856240126382311E-2</c:v>
                </c:pt>
                <c:pt idx="8">
                  <c:v>2.2116903633491301E-2</c:v>
                </c:pt>
                <c:pt idx="9">
                  <c:v>2.2116903633491301E-2</c:v>
                </c:pt>
                <c:pt idx="10">
                  <c:v>1.9747235387045807E-2</c:v>
                </c:pt>
                <c:pt idx="11">
                  <c:v>2.7646129541864115E-2</c:v>
                </c:pt>
                <c:pt idx="12">
                  <c:v>2.8436018957346001E-2</c:v>
                </c:pt>
                <c:pt idx="13">
                  <c:v>3.5545023696682498E-2</c:v>
                </c:pt>
                <c:pt idx="14">
                  <c:v>4.4233807266982603E-2</c:v>
                </c:pt>
                <c:pt idx="15">
                  <c:v>4.1864139020537101E-2</c:v>
                </c:pt>
                <c:pt idx="16">
                  <c:v>6.4770932069510331E-2</c:v>
                </c:pt>
                <c:pt idx="17">
                  <c:v>4.8183254344391815E-2</c:v>
                </c:pt>
                <c:pt idx="18">
                  <c:v>4.2654028436018995E-2</c:v>
                </c:pt>
                <c:pt idx="19">
                  <c:v>3.7124802527646113E-2</c:v>
                </c:pt>
                <c:pt idx="20">
                  <c:v>4.1074249605055277E-2</c:v>
                </c:pt>
                <c:pt idx="21">
                  <c:v>2.6066350710900507E-2</c:v>
                </c:pt>
                <c:pt idx="22">
                  <c:v>2.7646129541864115E-2</c:v>
                </c:pt>
                <c:pt idx="23">
                  <c:v>1.5797788309636705E-2</c:v>
                </c:pt>
                <c:pt idx="24">
                  <c:v>8.6887835703001598E-3</c:v>
                </c:pt>
                <c:pt idx="25">
                  <c:v>5.5292259083728323E-3</c:v>
                </c:pt>
                <c:pt idx="26">
                  <c:v>3.9494470774091616E-3</c:v>
                </c:pt>
                <c:pt idx="27">
                  <c:v>7.10900473933649E-3</c:v>
                </c:pt>
                <c:pt idx="28">
                  <c:v>2.3696682464455008E-3</c:v>
                </c:pt>
                <c:pt idx="29">
                  <c:v>2.3696682464455008E-3</c:v>
                </c:pt>
                <c:pt idx="30">
                  <c:v>7.898894154818334E-4</c:v>
                </c:pt>
              </c:numCache>
            </c:numRef>
          </c:val>
        </c:ser>
        <c:ser>
          <c:idx val="10"/>
          <c:order val="10"/>
          <c:tx>
            <c:strRef>
              <c:f>'unc-25 A1_0.02_50%'!$L$104</c:f>
              <c:strCache>
                <c:ptCount val="1"/>
                <c:pt idx="0">
                  <c:v>unc-25_A1_M104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L$105:$L$135</c:f>
              <c:numCache>
                <c:formatCode>General</c:formatCode>
                <c:ptCount val="31"/>
                <c:pt idx="1">
                  <c:v>4.6941678520625883E-2</c:v>
                </c:pt>
                <c:pt idx="2">
                  <c:v>6.6145092460881877E-2</c:v>
                </c:pt>
                <c:pt idx="3">
                  <c:v>4.3385490753911821E-2</c:v>
                </c:pt>
                <c:pt idx="4">
                  <c:v>4.90753911806543E-2</c:v>
                </c:pt>
                <c:pt idx="5">
                  <c:v>3.769559032716932E-2</c:v>
                </c:pt>
                <c:pt idx="6">
                  <c:v>3.8406827880512112E-2</c:v>
                </c:pt>
                <c:pt idx="7">
                  <c:v>3.6273115220483619E-2</c:v>
                </c:pt>
                <c:pt idx="8">
                  <c:v>3.1294452347083897E-2</c:v>
                </c:pt>
                <c:pt idx="9">
                  <c:v>3.3428165007112397E-2</c:v>
                </c:pt>
                <c:pt idx="10">
                  <c:v>4.9786628733997237E-2</c:v>
                </c:pt>
                <c:pt idx="11">
                  <c:v>6.2588904694167793E-2</c:v>
                </c:pt>
                <c:pt idx="12">
                  <c:v>6.3300142247510696E-2</c:v>
                </c:pt>
                <c:pt idx="13">
                  <c:v>6.5433854907539113E-2</c:v>
                </c:pt>
                <c:pt idx="14">
                  <c:v>6.2588904694167793E-2</c:v>
                </c:pt>
                <c:pt idx="15">
                  <c:v>5.6187766714082495E-2</c:v>
                </c:pt>
                <c:pt idx="16">
                  <c:v>3.9829302987197716E-2</c:v>
                </c:pt>
                <c:pt idx="17">
                  <c:v>3.9829302987197716E-2</c:v>
                </c:pt>
                <c:pt idx="18">
                  <c:v>4.4807965860597404E-2</c:v>
                </c:pt>
                <c:pt idx="19">
                  <c:v>1.9914651493598903E-2</c:v>
                </c:pt>
                <c:pt idx="20">
                  <c:v>1.4935988620199098E-2</c:v>
                </c:pt>
                <c:pt idx="21">
                  <c:v>1.6358463726884799E-2</c:v>
                </c:pt>
                <c:pt idx="22">
                  <c:v>9.2460881934566096E-3</c:v>
                </c:pt>
                <c:pt idx="23">
                  <c:v>3.5561877667140817E-3</c:v>
                </c:pt>
                <c:pt idx="24">
                  <c:v>2.8449502133712709E-3</c:v>
                </c:pt>
                <c:pt idx="25">
                  <c:v>7.1123755334281719E-4</c:v>
                </c:pt>
                <c:pt idx="26">
                  <c:v>7.1123755334281719E-4</c:v>
                </c:pt>
                <c:pt idx="27">
                  <c:v>7.1123755334281719E-4</c:v>
                </c:pt>
                <c:pt idx="28">
                  <c:v>0</c:v>
                </c:pt>
                <c:pt idx="29">
                  <c:v>7.1123755334281719E-4</c:v>
                </c:pt>
                <c:pt idx="30">
                  <c:v>1.4224751066856305E-3</c:v>
                </c:pt>
              </c:numCache>
            </c:numRef>
          </c:val>
        </c:ser>
        <c:ser>
          <c:idx val="11"/>
          <c:order val="11"/>
          <c:tx>
            <c:strRef>
              <c:f>'unc-25 A1_0.02_50%'!$M$104</c:f>
              <c:strCache>
                <c:ptCount val="1"/>
                <c:pt idx="0">
                  <c:v>unc-25_A1_M106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M$105:$M$135</c:f>
              <c:numCache>
                <c:formatCode>General</c:formatCode>
                <c:ptCount val="31"/>
                <c:pt idx="1">
                  <c:v>7.8249336870026498E-2</c:v>
                </c:pt>
                <c:pt idx="2">
                  <c:v>6.1671087533156498E-2</c:v>
                </c:pt>
                <c:pt idx="3">
                  <c:v>5.8355437665782502E-2</c:v>
                </c:pt>
                <c:pt idx="4">
                  <c:v>5.5702917771883319E-2</c:v>
                </c:pt>
                <c:pt idx="5">
                  <c:v>4.1777188328912487E-2</c:v>
                </c:pt>
                <c:pt idx="6">
                  <c:v>4.5755968169761296E-2</c:v>
                </c:pt>
                <c:pt idx="7">
                  <c:v>3.7798408488063713E-2</c:v>
                </c:pt>
                <c:pt idx="8">
                  <c:v>2.7188328912466801E-2</c:v>
                </c:pt>
                <c:pt idx="9">
                  <c:v>2.9177718832891202E-2</c:v>
                </c:pt>
                <c:pt idx="10">
                  <c:v>3.7135278514588921E-2</c:v>
                </c:pt>
                <c:pt idx="11">
                  <c:v>4.4429708222811712E-2</c:v>
                </c:pt>
                <c:pt idx="12">
                  <c:v>3.7135278514588921E-2</c:v>
                </c:pt>
                <c:pt idx="13">
                  <c:v>4.3103448275862079E-2</c:v>
                </c:pt>
                <c:pt idx="14">
                  <c:v>4.1777188328912487E-2</c:v>
                </c:pt>
                <c:pt idx="15">
                  <c:v>5.1061007957559704E-2</c:v>
                </c:pt>
                <c:pt idx="16">
                  <c:v>5.2387267904509337E-2</c:v>
                </c:pt>
                <c:pt idx="17">
                  <c:v>4.6419098143236116E-2</c:v>
                </c:pt>
                <c:pt idx="18">
                  <c:v>3.0503978779840814E-2</c:v>
                </c:pt>
                <c:pt idx="19">
                  <c:v>2.3209549071618006E-2</c:v>
                </c:pt>
                <c:pt idx="20">
                  <c:v>1.8567639257294401E-2</c:v>
                </c:pt>
                <c:pt idx="21">
                  <c:v>1.657824933687E-2</c:v>
                </c:pt>
                <c:pt idx="22">
                  <c:v>1.25994694960212E-2</c:v>
                </c:pt>
                <c:pt idx="23">
                  <c:v>7.2944297082228136E-3</c:v>
                </c:pt>
                <c:pt idx="24">
                  <c:v>9.2838196286472146E-3</c:v>
                </c:pt>
                <c:pt idx="25">
                  <c:v>6.6312997347480153E-3</c:v>
                </c:pt>
                <c:pt idx="26">
                  <c:v>3.9787798408488098E-3</c:v>
                </c:pt>
                <c:pt idx="27">
                  <c:v>7.2944297082228136E-3</c:v>
                </c:pt>
                <c:pt idx="28">
                  <c:v>6.6312997347480146E-4</c:v>
                </c:pt>
                <c:pt idx="29">
                  <c:v>6.6312997347480146E-4</c:v>
                </c:pt>
                <c:pt idx="30">
                  <c:v>6.6312997347480146E-4</c:v>
                </c:pt>
              </c:numCache>
            </c:numRef>
          </c:val>
        </c:ser>
        <c:ser>
          <c:idx val="12"/>
          <c:order val="12"/>
          <c:tx>
            <c:strRef>
              <c:f>'unc-25 A1_0.02_50%'!$N$104</c:f>
              <c:strCache>
                <c:ptCount val="1"/>
                <c:pt idx="0">
                  <c:v>unc-25_REX_A1_01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N$105:$N$135</c:f>
              <c:numCache>
                <c:formatCode>General</c:formatCode>
                <c:ptCount val="31"/>
                <c:pt idx="1">
                  <c:v>4.39706862091939E-2</c:v>
                </c:pt>
                <c:pt idx="2">
                  <c:v>4.0639573617588298E-2</c:v>
                </c:pt>
                <c:pt idx="3">
                  <c:v>2.99800133244504E-2</c:v>
                </c:pt>
                <c:pt idx="4">
                  <c:v>2.4650233177881401E-2</c:v>
                </c:pt>
                <c:pt idx="5">
                  <c:v>1.46568954030646E-2</c:v>
                </c:pt>
                <c:pt idx="6">
                  <c:v>1.5323117921385699E-2</c:v>
                </c:pt>
                <c:pt idx="7">
                  <c:v>1.0659560293137905E-2</c:v>
                </c:pt>
                <c:pt idx="8">
                  <c:v>1.0659560293137905E-2</c:v>
                </c:pt>
                <c:pt idx="9">
                  <c:v>7.9946702198534329E-3</c:v>
                </c:pt>
                <c:pt idx="10">
                  <c:v>1.1325782811459E-2</c:v>
                </c:pt>
                <c:pt idx="11">
                  <c:v>1.9320453031312513E-2</c:v>
                </c:pt>
                <c:pt idx="12">
                  <c:v>2.99800133244504E-2</c:v>
                </c:pt>
                <c:pt idx="13">
                  <c:v>3.3311125916055999E-2</c:v>
                </c:pt>
                <c:pt idx="14">
                  <c:v>7.3950699533644235E-2</c:v>
                </c:pt>
                <c:pt idx="15">
                  <c:v>6.0626249167221896E-2</c:v>
                </c:pt>
                <c:pt idx="16">
                  <c:v>8.4610259826782205E-2</c:v>
                </c:pt>
                <c:pt idx="17">
                  <c:v>7.5283144570286495E-2</c:v>
                </c:pt>
                <c:pt idx="18">
                  <c:v>7.5283144570286495E-2</c:v>
                </c:pt>
                <c:pt idx="19">
                  <c:v>6.0626249167221896E-2</c:v>
                </c:pt>
                <c:pt idx="20">
                  <c:v>5.3297801465689479E-2</c:v>
                </c:pt>
                <c:pt idx="21">
                  <c:v>5.1965356429047302E-2</c:v>
                </c:pt>
                <c:pt idx="22">
                  <c:v>2.99800133244504E-2</c:v>
                </c:pt>
                <c:pt idx="23">
                  <c:v>2.4650233177881401E-2</c:v>
                </c:pt>
                <c:pt idx="24">
                  <c:v>1.7988007994670201E-2</c:v>
                </c:pt>
                <c:pt idx="25">
                  <c:v>1.3324450366422408E-2</c:v>
                </c:pt>
                <c:pt idx="26">
                  <c:v>6.6622251832111935E-3</c:v>
                </c:pt>
                <c:pt idx="27">
                  <c:v>3.9973351099267217E-3</c:v>
                </c:pt>
                <c:pt idx="28">
                  <c:v>4.6635576282478284E-3</c:v>
                </c:pt>
                <c:pt idx="29">
                  <c:v>3.3311125916056002E-3</c:v>
                </c:pt>
                <c:pt idx="30">
                  <c:v>6.6622251832111948E-4</c:v>
                </c:pt>
              </c:numCache>
            </c:numRef>
          </c:val>
        </c:ser>
        <c:ser>
          <c:idx val="13"/>
          <c:order val="13"/>
          <c:tx>
            <c:strRef>
              <c:f>'unc-25 A1_0.02_50%'!$O$104</c:f>
              <c:strCache>
                <c:ptCount val="1"/>
                <c:pt idx="0">
                  <c:v>unc-25_REX_A1_02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O$105:$O$135</c:f>
              <c:numCache>
                <c:formatCode>General</c:formatCode>
                <c:ptCount val="31"/>
                <c:pt idx="1">
                  <c:v>5.0775740479548699E-2</c:v>
                </c:pt>
                <c:pt idx="2">
                  <c:v>4.9365303244005621E-2</c:v>
                </c:pt>
                <c:pt idx="3">
                  <c:v>3.9492242595204521E-2</c:v>
                </c:pt>
                <c:pt idx="4">
                  <c:v>4.3723554301833618E-2</c:v>
                </c:pt>
                <c:pt idx="5">
                  <c:v>3.8081805359661512E-2</c:v>
                </c:pt>
                <c:pt idx="6">
                  <c:v>2.1861777150916809E-2</c:v>
                </c:pt>
                <c:pt idx="7">
                  <c:v>1.5514809590973204E-2</c:v>
                </c:pt>
                <c:pt idx="8">
                  <c:v>1.5514809590973204E-2</c:v>
                </c:pt>
                <c:pt idx="9">
                  <c:v>1.1988716502115701E-2</c:v>
                </c:pt>
                <c:pt idx="10">
                  <c:v>1.9040902679830701E-2</c:v>
                </c:pt>
                <c:pt idx="11">
                  <c:v>2.3977433004231292E-2</c:v>
                </c:pt>
                <c:pt idx="12">
                  <c:v>3.9492242595204521E-2</c:v>
                </c:pt>
                <c:pt idx="13">
                  <c:v>4.9365303244005621E-2</c:v>
                </c:pt>
                <c:pt idx="14">
                  <c:v>7.1932299012693934E-2</c:v>
                </c:pt>
                <c:pt idx="15">
                  <c:v>6.4880112834978826E-2</c:v>
                </c:pt>
                <c:pt idx="16">
                  <c:v>7.8279266572637465E-2</c:v>
                </c:pt>
                <c:pt idx="17">
                  <c:v>5.9238363892806817E-2</c:v>
                </c:pt>
                <c:pt idx="18">
                  <c:v>5.8533145275035295E-2</c:v>
                </c:pt>
                <c:pt idx="19">
                  <c:v>4.3018335684062083E-2</c:v>
                </c:pt>
                <c:pt idx="20">
                  <c:v>4.5839210155148129E-2</c:v>
                </c:pt>
                <c:pt idx="21">
                  <c:v>2.9619181946403401E-2</c:v>
                </c:pt>
                <c:pt idx="22">
                  <c:v>2.0451339915373817E-2</c:v>
                </c:pt>
                <c:pt idx="23">
                  <c:v>1.3399153737658704E-2</c:v>
                </c:pt>
                <c:pt idx="24">
                  <c:v>8.4626234132581142E-3</c:v>
                </c:pt>
                <c:pt idx="25">
                  <c:v>3.5260930888575521E-3</c:v>
                </c:pt>
                <c:pt idx="26">
                  <c:v>5.6417489421720732E-3</c:v>
                </c:pt>
                <c:pt idx="27">
                  <c:v>7.0521861777150905E-4</c:v>
                </c:pt>
                <c:pt idx="28">
                  <c:v>4.9365303244005634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4"/>
          <c:order val="14"/>
          <c:tx>
            <c:strRef>
              <c:f>'unc-25 A1_0.02_50%'!$P$104</c:f>
              <c:strCache>
                <c:ptCount val="1"/>
                <c:pt idx="0">
                  <c:v>unc-25_REX_A1_04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P$105:$P$135</c:f>
              <c:numCache>
                <c:formatCode>General</c:formatCode>
                <c:ptCount val="31"/>
                <c:pt idx="1">
                  <c:v>5.83775587566338E-2</c:v>
                </c:pt>
                <c:pt idx="2">
                  <c:v>5.1554207733131199E-2</c:v>
                </c:pt>
                <c:pt idx="3">
                  <c:v>3.1084154662623209E-2</c:v>
                </c:pt>
                <c:pt idx="4">
                  <c:v>2.7293404094010602E-2</c:v>
                </c:pt>
                <c:pt idx="5">
                  <c:v>2.5018953752843107E-2</c:v>
                </c:pt>
                <c:pt idx="6">
                  <c:v>1.5921152388172908E-2</c:v>
                </c:pt>
                <c:pt idx="7">
                  <c:v>1.2888551933282805E-2</c:v>
                </c:pt>
                <c:pt idx="8">
                  <c:v>6.0652009097801416E-3</c:v>
                </c:pt>
                <c:pt idx="9">
                  <c:v>1.1372251705837805E-2</c:v>
                </c:pt>
                <c:pt idx="10">
                  <c:v>9.0978013646701959E-3</c:v>
                </c:pt>
                <c:pt idx="11">
                  <c:v>7.5815011372251722E-3</c:v>
                </c:pt>
                <c:pt idx="12">
                  <c:v>5.3070507960576198E-3</c:v>
                </c:pt>
                <c:pt idx="13">
                  <c:v>1.2130401819560306E-2</c:v>
                </c:pt>
                <c:pt idx="14">
                  <c:v>3.7907505686125928E-2</c:v>
                </c:pt>
                <c:pt idx="15">
                  <c:v>3.6391205458680811E-2</c:v>
                </c:pt>
                <c:pt idx="16">
                  <c:v>6.1410159211523901E-2</c:v>
                </c:pt>
                <c:pt idx="17">
                  <c:v>5.6103108415466299E-2</c:v>
                </c:pt>
                <c:pt idx="18">
                  <c:v>7.9605761940864314E-2</c:v>
                </c:pt>
                <c:pt idx="19">
                  <c:v>6.9749810462471598E-2</c:v>
                </c:pt>
                <c:pt idx="20">
                  <c:v>6.9749810462471598E-2</c:v>
                </c:pt>
                <c:pt idx="21">
                  <c:v>6.1410159211523901E-2</c:v>
                </c:pt>
                <c:pt idx="22">
                  <c:v>4.700530705079612E-2</c:v>
                </c:pt>
                <c:pt idx="23">
                  <c:v>3.7907505686125928E-2</c:v>
                </c:pt>
                <c:pt idx="24">
                  <c:v>1.7437452615617906E-2</c:v>
                </c:pt>
                <c:pt idx="25">
                  <c:v>1.2888551933282805E-2</c:v>
                </c:pt>
                <c:pt idx="26">
                  <c:v>8.3396512509476984E-3</c:v>
                </c:pt>
                <c:pt idx="27">
                  <c:v>6.0652009097801416E-3</c:v>
                </c:pt>
                <c:pt idx="28">
                  <c:v>2.2744503411675512E-3</c:v>
                </c:pt>
                <c:pt idx="29">
                  <c:v>3.0326004548900691E-3</c:v>
                </c:pt>
                <c:pt idx="30">
                  <c:v>3.7907505686125926E-3</c:v>
                </c:pt>
              </c:numCache>
            </c:numRef>
          </c:val>
        </c:ser>
        <c:ser>
          <c:idx val="15"/>
          <c:order val="15"/>
          <c:tx>
            <c:strRef>
              <c:f>'unc-25 A1_0.02_50%'!$Q$104</c:f>
              <c:strCache>
                <c:ptCount val="1"/>
                <c:pt idx="0">
                  <c:v>unc-25_REX_A1_06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Q$105:$Q$135</c:f>
              <c:numCache>
                <c:formatCode>General</c:formatCode>
                <c:ptCount val="31"/>
                <c:pt idx="1">
                  <c:v>5.6502242152466402E-2</c:v>
                </c:pt>
                <c:pt idx="2">
                  <c:v>4.9327354260089704E-2</c:v>
                </c:pt>
                <c:pt idx="3">
                  <c:v>5.3811659192825115E-2</c:v>
                </c:pt>
                <c:pt idx="4">
                  <c:v>3.4080717488789228E-2</c:v>
                </c:pt>
                <c:pt idx="5">
                  <c:v>2.6905829596412602E-2</c:v>
                </c:pt>
                <c:pt idx="6">
                  <c:v>2.1524663677130004E-2</c:v>
                </c:pt>
                <c:pt idx="7">
                  <c:v>1.6143497757847503E-2</c:v>
                </c:pt>
                <c:pt idx="8">
                  <c:v>8.0717488789237742E-3</c:v>
                </c:pt>
                <c:pt idx="9">
                  <c:v>8.9686098654708502E-3</c:v>
                </c:pt>
                <c:pt idx="10">
                  <c:v>8.9686098654708502E-3</c:v>
                </c:pt>
                <c:pt idx="11">
                  <c:v>1.0762331838565007E-2</c:v>
                </c:pt>
                <c:pt idx="12">
                  <c:v>1.1659192825112101E-2</c:v>
                </c:pt>
                <c:pt idx="13">
                  <c:v>1.4349775784753403E-2</c:v>
                </c:pt>
                <c:pt idx="14">
                  <c:v>1.9730941704035901E-2</c:v>
                </c:pt>
                <c:pt idx="15">
                  <c:v>4.0358744394618812E-2</c:v>
                </c:pt>
                <c:pt idx="16">
                  <c:v>6.2780269058296048E-2</c:v>
                </c:pt>
                <c:pt idx="17">
                  <c:v>6.7264573991031432E-2</c:v>
                </c:pt>
                <c:pt idx="18">
                  <c:v>8.699551569506736E-2</c:v>
                </c:pt>
                <c:pt idx="19">
                  <c:v>6.9955156950672601E-2</c:v>
                </c:pt>
                <c:pt idx="20">
                  <c:v>5.3811659192825115E-2</c:v>
                </c:pt>
                <c:pt idx="21">
                  <c:v>4.9327354260089704E-2</c:v>
                </c:pt>
                <c:pt idx="22">
                  <c:v>3.8565022421524715E-2</c:v>
                </c:pt>
                <c:pt idx="23">
                  <c:v>3.9461883408071712E-2</c:v>
                </c:pt>
                <c:pt idx="24">
                  <c:v>1.4349775784753403E-2</c:v>
                </c:pt>
                <c:pt idx="25">
                  <c:v>8.0717488789237742E-3</c:v>
                </c:pt>
                <c:pt idx="26">
                  <c:v>8.9686098654708502E-3</c:v>
                </c:pt>
                <c:pt idx="27">
                  <c:v>2.6905829596412601E-3</c:v>
                </c:pt>
                <c:pt idx="28">
                  <c:v>3.5874439461883417E-3</c:v>
                </c:pt>
                <c:pt idx="29">
                  <c:v>7.1748878923766817E-3</c:v>
                </c:pt>
                <c:pt idx="30">
                  <c:v>4.4843049327354303E-3</c:v>
                </c:pt>
              </c:numCache>
            </c:numRef>
          </c:val>
        </c:ser>
        <c:ser>
          <c:idx val="16"/>
          <c:order val="16"/>
          <c:tx>
            <c:strRef>
              <c:f>'unc-25 A1_0.02_50%'!$R$104</c:f>
              <c:strCache>
                <c:ptCount val="1"/>
                <c:pt idx="0">
                  <c:v>unc-25_REX_A1_07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R$105:$R$135</c:f>
              <c:numCache>
                <c:formatCode>General</c:formatCode>
                <c:ptCount val="31"/>
                <c:pt idx="1">
                  <c:v>3.6257309941520516E-2</c:v>
                </c:pt>
                <c:pt idx="2">
                  <c:v>3.2748538011695902E-2</c:v>
                </c:pt>
                <c:pt idx="3">
                  <c:v>2.4561403508771899E-2</c:v>
                </c:pt>
                <c:pt idx="4">
                  <c:v>1.7543859649122813E-2</c:v>
                </c:pt>
                <c:pt idx="5">
                  <c:v>1.6374269005847999E-2</c:v>
                </c:pt>
                <c:pt idx="6">
                  <c:v>1.4035087719298199E-2</c:v>
                </c:pt>
                <c:pt idx="7">
                  <c:v>7.0175438596491221E-3</c:v>
                </c:pt>
                <c:pt idx="8">
                  <c:v>9.3567251461988306E-3</c:v>
                </c:pt>
                <c:pt idx="9">
                  <c:v>7.0175438596491221E-3</c:v>
                </c:pt>
                <c:pt idx="10">
                  <c:v>7.0175438596491221E-3</c:v>
                </c:pt>
                <c:pt idx="11">
                  <c:v>1.4035087719298199E-2</c:v>
                </c:pt>
                <c:pt idx="12">
                  <c:v>2.4561403508771899E-2</c:v>
                </c:pt>
                <c:pt idx="13">
                  <c:v>3.9766081871344998E-2</c:v>
                </c:pt>
                <c:pt idx="14">
                  <c:v>5.3801169590643301E-2</c:v>
                </c:pt>
                <c:pt idx="15">
                  <c:v>7.368421052631581E-2</c:v>
                </c:pt>
                <c:pt idx="16">
                  <c:v>0.10994152046783603</c:v>
                </c:pt>
                <c:pt idx="17">
                  <c:v>0.11111111111111099</c:v>
                </c:pt>
                <c:pt idx="18">
                  <c:v>5.9649122807017486E-2</c:v>
                </c:pt>
                <c:pt idx="19">
                  <c:v>8.3040935672514596E-2</c:v>
                </c:pt>
                <c:pt idx="20">
                  <c:v>5.8479532163742701E-2</c:v>
                </c:pt>
                <c:pt idx="21">
                  <c:v>5.4970760233918115E-2</c:v>
                </c:pt>
                <c:pt idx="22">
                  <c:v>3.5087719298245605E-2</c:v>
                </c:pt>
                <c:pt idx="23">
                  <c:v>1.2865497076023399E-2</c:v>
                </c:pt>
                <c:pt idx="24">
                  <c:v>1.5204678362573104E-2</c:v>
                </c:pt>
                <c:pt idx="25">
                  <c:v>3.508771929824561E-3</c:v>
                </c:pt>
                <c:pt idx="26">
                  <c:v>4.6783625730994222E-3</c:v>
                </c:pt>
                <c:pt idx="27">
                  <c:v>4.6783625730994222E-3</c:v>
                </c:pt>
                <c:pt idx="28">
                  <c:v>3.508771929824561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7"/>
          <c:order val="17"/>
          <c:tx>
            <c:strRef>
              <c:f>'unc-25 A1_0.02_50%'!$S$104</c:f>
              <c:strCache>
                <c:ptCount val="1"/>
                <c:pt idx="0">
                  <c:v>unc-25_REX_A1_09</c:v>
                </c:pt>
              </c:strCache>
            </c:strRef>
          </c:tx>
          <c:marker>
            <c:symbol val="none"/>
          </c:marker>
          <c:cat>
            <c:numRef>
              <c:f>'unc-25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A1_0.02_50%'!$S$105:$S$135</c:f>
              <c:numCache>
                <c:formatCode>General</c:formatCode>
                <c:ptCount val="31"/>
                <c:pt idx="1">
                  <c:v>3.6276522929500316E-2</c:v>
                </c:pt>
                <c:pt idx="2">
                  <c:v>3.4223134839151299E-2</c:v>
                </c:pt>
                <c:pt idx="3">
                  <c:v>3.6276522929500316E-2</c:v>
                </c:pt>
                <c:pt idx="4">
                  <c:v>2.7378507871321012E-2</c:v>
                </c:pt>
                <c:pt idx="5">
                  <c:v>2.8062970568104008E-2</c:v>
                </c:pt>
                <c:pt idx="6">
                  <c:v>1.9164955509924701E-2</c:v>
                </c:pt>
                <c:pt idx="7">
                  <c:v>1.9849418206707711E-2</c:v>
                </c:pt>
                <c:pt idx="8">
                  <c:v>1.3689253935660501E-2</c:v>
                </c:pt>
                <c:pt idx="9">
                  <c:v>1.7111567419575601E-2</c:v>
                </c:pt>
                <c:pt idx="10">
                  <c:v>1.23203285420945E-2</c:v>
                </c:pt>
                <c:pt idx="11">
                  <c:v>1.4373716632443499E-2</c:v>
                </c:pt>
                <c:pt idx="12">
                  <c:v>2.1218343600273817E-2</c:v>
                </c:pt>
                <c:pt idx="13">
                  <c:v>2.5325119780971905E-2</c:v>
                </c:pt>
                <c:pt idx="14">
                  <c:v>4.3805612594113599E-2</c:v>
                </c:pt>
                <c:pt idx="15">
                  <c:v>5.6125941136208099E-2</c:v>
                </c:pt>
                <c:pt idx="16">
                  <c:v>7.6659822039698802E-2</c:v>
                </c:pt>
                <c:pt idx="17">
                  <c:v>6.297056810403831E-2</c:v>
                </c:pt>
                <c:pt idx="18">
                  <c:v>7.3237508555783704E-2</c:v>
                </c:pt>
                <c:pt idx="19">
                  <c:v>6.7077344284736509E-2</c:v>
                </c:pt>
                <c:pt idx="20">
                  <c:v>6.9815195071868633E-2</c:v>
                </c:pt>
                <c:pt idx="21">
                  <c:v>5.4757015742642023E-2</c:v>
                </c:pt>
                <c:pt idx="22">
                  <c:v>3.9014373716632404E-2</c:v>
                </c:pt>
                <c:pt idx="23">
                  <c:v>2.5325119780971905E-2</c:v>
                </c:pt>
                <c:pt idx="24">
                  <c:v>1.6427104722792601E-2</c:v>
                </c:pt>
                <c:pt idx="25">
                  <c:v>1.3004791238877508E-2</c:v>
                </c:pt>
                <c:pt idx="26">
                  <c:v>9.5824777549623538E-3</c:v>
                </c:pt>
                <c:pt idx="27">
                  <c:v>5.4757015742642034E-3</c:v>
                </c:pt>
                <c:pt idx="28">
                  <c:v>6.1601642710472282E-3</c:v>
                </c:pt>
                <c:pt idx="29">
                  <c:v>1.3689253935660504E-3</c:v>
                </c:pt>
                <c:pt idx="30">
                  <c:v>6.8446269678302499E-4</c:v>
                </c:pt>
              </c:numCache>
            </c:numRef>
          </c:val>
        </c:ser>
        <c:marker val="1"/>
        <c:axId val="162203520"/>
        <c:axId val="162205056"/>
      </c:lineChart>
      <c:catAx>
        <c:axId val="162203520"/>
        <c:scaling>
          <c:orientation val="minMax"/>
        </c:scaling>
        <c:axPos val="b"/>
        <c:numFmt formatCode="0.0_ " sourceLinked="1"/>
        <c:tickLblPos val="nextTo"/>
        <c:crossAx val="162205056"/>
        <c:crosses val="autoZero"/>
        <c:auto val="1"/>
        <c:lblAlgn val="ctr"/>
        <c:lblOffset val="100"/>
        <c:tickLblSkip val="5"/>
        <c:tickMarkSkip val="5"/>
      </c:catAx>
      <c:valAx>
        <c:axId val="162205056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2203520"/>
        <c:crosses val="autoZero"/>
        <c:crossBetween val="between"/>
      </c:valAx>
    </c:plotArea>
    <c:plotVisOnly val="1"/>
  </c:chart>
  <c:externalData r:id="rId1"/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tph-1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400" b="0" dirty="0" smtClean="0">
                <a:latin typeface="Arial" pitchFamily="34" charset="0"/>
                <a:cs typeface="Arial" pitchFamily="34" charset="0"/>
              </a:rPr>
              <a:t>A1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tph-1(mg280)_A1_0.02_50%'!$B$104</c:f>
              <c:strCache>
                <c:ptCount val="1"/>
                <c:pt idx="0">
                  <c:v>thp-1(mg280)_A1_01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B$105:$B$135</c:f>
              <c:numCache>
                <c:formatCode>General</c:formatCode>
                <c:ptCount val="31"/>
                <c:pt idx="1">
                  <c:v>9.2307692307692341E-2</c:v>
                </c:pt>
                <c:pt idx="2">
                  <c:v>6.1538461538461514E-2</c:v>
                </c:pt>
                <c:pt idx="3">
                  <c:v>6.1538461538461514E-2</c:v>
                </c:pt>
                <c:pt idx="4">
                  <c:v>6.9230769230769221E-2</c:v>
                </c:pt>
                <c:pt idx="5">
                  <c:v>0.1</c:v>
                </c:pt>
                <c:pt idx="6">
                  <c:v>3.8461538461538498E-2</c:v>
                </c:pt>
                <c:pt idx="7">
                  <c:v>7.6923076923076913E-2</c:v>
                </c:pt>
                <c:pt idx="8">
                  <c:v>7.6923076923076913E-2</c:v>
                </c:pt>
                <c:pt idx="9">
                  <c:v>3.8461538461538498E-2</c:v>
                </c:pt>
                <c:pt idx="10">
                  <c:v>4.6153846153846198E-2</c:v>
                </c:pt>
                <c:pt idx="11">
                  <c:v>1.5384615384615405E-2</c:v>
                </c:pt>
                <c:pt idx="12">
                  <c:v>2.3076923076923109E-2</c:v>
                </c:pt>
                <c:pt idx="13">
                  <c:v>3.8461538461538498E-2</c:v>
                </c:pt>
                <c:pt idx="14">
                  <c:v>7.6923076923076919E-3</c:v>
                </c:pt>
                <c:pt idx="15">
                  <c:v>4.6153846153846198E-2</c:v>
                </c:pt>
                <c:pt idx="16">
                  <c:v>0</c:v>
                </c:pt>
                <c:pt idx="17">
                  <c:v>3.0769230769230802E-2</c:v>
                </c:pt>
                <c:pt idx="18">
                  <c:v>1.5384615384615405E-2</c:v>
                </c:pt>
                <c:pt idx="19">
                  <c:v>7.6923076923076919E-3</c:v>
                </c:pt>
                <c:pt idx="20">
                  <c:v>7.6923076923076919E-3</c:v>
                </c:pt>
                <c:pt idx="21">
                  <c:v>0</c:v>
                </c:pt>
                <c:pt idx="22">
                  <c:v>0</c:v>
                </c:pt>
                <c:pt idx="23">
                  <c:v>7.6923076923076919E-3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"/>
          <c:order val="1"/>
          <c:tx>
            <c:strRef>
              <c:f>'tph-1(mg280)_A1_0.02_50%'!$C$104</c:f>
              <c:strCache>
                <c:ptCount val="1"/>
                <c:pt idx="0">
                  <c:v>thp-1(mg280)_A1_02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C$105:$C$135</c:f>
              <c:numCache>
                <c:formatCode>General</c:formatCode>
                <c:ptCount val="31"/>
                <c:pt idx="1">
                  <c:v>5.6603773584905696E-2</c:v>
                </c:pt>
                <c:pt idx="2">
                  <c:v>7.0754716981132129E-2</c:v>
                </c:pt>
                <c:pt idx="3">
                  <c:v>4.2452830188679215E-2</c:v>
                </c:pt>
                <c:pt idx="4">
                  <c:v>5.6603773584905696E-2</c:v>
                </c:pt>
                <c:pt idx="5">
                  <c:v>5.6603773584905696E-2</c:v>
                </c:pt>
                <c:pt idx="6">
                  <c:v>5.6603773584905696E-2</c:v>
                </c:pt>
                <c:pt idx="7">
                  <c:v>3.7735849056603821E-2</c:v>
                </c:pt>
                <c:pt idx="8">
                  <c:v>4.71698113207547E-2</c:v>
                </c:pt>
                <c:pt idx="9">
                  <c:v>3.3018867924528301E-2</c:v>
                </c:pt>
                <c:pt idx="10">
                  <c:v>5.1886792452830226E-2</c:v>
                </c:pt>
                <c:pt idx="11">
                  <c:v>5.1886792452830226E-2</c:v>
                </c:pt>
                <c:pt idx="12">
                  <c:v>3.3018867924528301E-2</c:v>
                </c:pt>
                <c:pt idx="13">
                  <c:v>4.2452830188679215E-2</c:v>
                </c:pt>
                <c:pt idx="14">
                  <c:v>4.2452830188679215E-2</c:v>
                </c:pt>
                <c:pt idx="15">
                  <c:v>4.7169811320754698E-3</c:v>
                </c:pt>
                <c:pt idx="16">
                  <c:v>4.2452830188679215E-2</c:v>
                </c:pt>
                <c:pt idx="17">
                  <c:v>3.7735849056603821E-2</c:v>
                </c:pt>
                <c:pt idx="18">
                  <c:v>3.3018867924528301E-2</c:v>
                </c:pt>
                <c:pt idx="19">
                  <c:v>3.3018867924528301E-2</c:v>
                </c:pt>
                <c:pt idx="20">
                  <c:v>2.3584905660377402E-2</c:v>
                </c:pt>
                <c:pt idx="21">
                  <c:v>9.4339622641509396E-3</c:v>
                </c:pt>
                <c:pt idx="22">
                  <c:v>0</c:v>
                </c:pt>
                <c:pt idx="23">
                  <c:v>2.3584905660377402E-2</c:v>
                </c:pt>
                <c:pt idx="24">
                  <c:v>1.4150943396226398E-2</c:v>
                </c:pt>
                <c:pt idx="25">
                  <c:v>1.88679245283019E-2</c:v>
                </c:pt>
                <c:pt idx="26">
                  <c:v>4.7169811320754698E-3</c:v>
                </c:pt>
                <c:pt idx="27">
                  <c:v>1.88679245283019E-2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tph-1(mg280)_A1_0.02_50%'!$D$104</c:f>
              <c:strCache>
                <c:ptCount val="1"/>
                <c:pt idx="0">
                  <c:v>thp-1(mg280)_A1_03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D$105:$D$135</c:f>
              <c:numCache>
                <c:formatCode>General</c:formatCode>
                <c:ptCount val="31"/>
                <c:pt idx="1">
                  <c:v>7.8534031413612634E-2</c:v>
                </c:pt>
                <c:pt idx="2">
                  <c:v>0.10471204188481703</c:v>
                </c:pt>
                <c:pt idx="3">
                  <c:v>8.3769633507853436E-2</c:v>
                </c:pt>
                <c:pt idx="4">
                  <c:v>0.10994764397905803</c:v>
                </c:pt>
                <c:pt idx="5">
                  <c:v>9.4240837696335081E-2</c:v>
                </c:pt>
                <c:pt idx="6">
                  <c:v>8.9005235602094224E-2</c:v>
                </c:pt>
                <c:pt idx="7">
                  <c:v>6.8062827225130934E-2</c:v>
                </c:pt>
                <c:pt idx="8">
                  <c:v>1.5706806282722505E-2</c:v>
                </c:pt>
                <c:pt idx="9">
                  <c:v>4.7120418848167513E-2</c:v>
                </c:pt>
                <c:pt idx="10">
                  <c:v>3.1413612565445018E-2</c:v>
                </c:pt>
                <c:pt idx="11">
                  <c:v>2.0942408376963401E-2</c:v>
                </c:pt>
                <c:pt idx="12">
                  <c:v>1.5706806282722505E-2</c:v>
                </c:pt>
                <c:pt idx="13">
                  <c:v>3.1413612565445018E-2</c:v>
                </c:pt>
                <c:pt idx="14">
                  <c:v>2.0942408376963401E-2</c:v>
                </c:pt>
                <c:pt idx="15">
                  <c:v>5.235602094240845E-3</c:v>
                </c:pt>
                <c:pt idx="16">
                  <c:v>2.6178010471204216E-2</c:v>
                </c:pt>
                <c:pt idx="17">
                  <c:v>0</c:v>
                </c:pt>
                <c:pt idx="18">
                  <c:v>1.0471204188481699E-2</c:v>
                </c:pt>
                <c:pt idx="19">
                  <c:v>5.235602094240845E-3</c:v>
                </c:pt>
                <c:pt idx="20">
                  <c:v>1.0471204188481699E-2</c:v>
                </c:pt>
                <c:pt idx="21">
                  <c:v>1.0471204188481699E-2</c:v>
                </c:pt>
                <c:pt idx="22">
                  <c:v>5.235602094240845E-3</c:v>
                </c:pt>
                <c:pt idx="23">
                  <c:v>5.235602094240845E-3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5.235602094240845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tph-1(mg280)_A1_0.02_50%'!$E$104</c:f>
              <c:strCache>
                <c:ptCount val="1"/>
                <c:pt idx="0">
                  <c:v>thp-1(mg280)_A1_04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E$105:$E$135</c:f>
              <c:numCache>
                <c:formatCode>General</c:formatCode>
                <c:ptCount val="31"/>
                <c:pt idx="1">
                  <c:v>8.1300813008130079E-2</c:v>
                </c:pt>
                <c:pt idx="2">
                  <c:v>5.2845528455284584E-2</c:v>
                </c:pt>
                <c:pt idx="3">
                  <c:v>6.0975609756097601E-2</c:v>
                </c:pt>
                <c:pt idx="4">
                  <c:v>7.7235772357723623E-2</c:v>
                </c:pt>
                <c:pt idx="5">
                  <c:v>5.6910569105691103E-2</c:v>
                </c:pt>
                <c:pt idx="6">
                  <c:v>4.065040650406497E-2</c:v>
                </c:pt>
                <c:pt idx="7">
                  <c:v>6.0975609756097601E-2</c:v>
                </c:pt>
                <c:pt idx="8">
                  <c:v>4.8780487804878127E-2</c:v>
                </c:pt>
                <c:pt idx="9">
                  <c:v>6.0975609756097601E-2</c:v>
                </c:pt>
                <c:pt idx="10">
                  <c:v>4.065040650406497E-2</c:v>
                </c:pt>
                <c:pt idx="11">
                  <c:v>3.2520325203252001E-2</c:v>
                </c:pt>
                <c:pt idx="12">
                  <c:v>6.0975609756097601E-2</c:v>
                </c:pt>
                <c:pt idx="13">
                  <c:v>6.910569105691064E-2</c:v>
                </c:pt>
                <c:pt idx="14">
                  <c:v>2.0325203252032485E-2</c:v>
                </c:pt>
                <c:pt idx="15">
                  <c:v>3.2520325203252001E-2</c:v>
                </c:pt>
                <c:pt idx="16">
                  <c:v>8.1300813008130107E-3</c:v>
                </c:pt>
                <c:pt idx="17">
                  <c:v>2.8455284552845499E-2</c:v>
                </c:pt>
                <c:pt idx="18">
                  <c:v>1.6260162601626001E-2</c:v>
                </c:pt>
                <c:pt idx="19">
                  <c:v>2.0325203252032485E-2</c:v>
                </c:pt>
                <c:pt idx="20">
                  <c:v>0</c:v>
                </c:pt>
                <c:pt idx="21">
                  <c:v>1.21951219512195E-2</c:v>
                </c:pt>
                <c:pt idx="22">
                  <c:v>0</c:v>
                </c:pt>
                <c:pt idx="23">
                  <c:v>1.21951219512195E-2</c:v>
                </c:pt>
                <c:pt idx="24">
                  <c:v>4.0650406504065002E-3</c:v>
                </c:pt>
                <c:pt idx="25">
                  <c:v>4.0650406504065002E-3</c:v>
                </c:pt>
                <c:pt idx="26">
                  <c:v>1.21951219512195E-2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4.0650406504065002E-3</c:v>
                </c:pt>
              </c:numCache>
            </c:numRef>
          </c:val>
        </c:ser>
        <c:ser>
          <c:idx val="4"/>
          <c:order val="4"/>
          <c:tx>
            <c:strRef>
              <c:f>'tph-1(mg280)_A1_0.02_50%'!$F$104</c:f>
              <c:strCache>
                <c:ptCount val="1"/>
                <c:pt idx="0">
                  <c:v>thp-1(mg280)_A1_05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F$105:$F$135</c:f>
              <c:numCache>
                <c:formatCode>General</c:formatCode>
                <c:ptCount val="31"/>
                <c:pt idx="1">
                  <c:v>7.3619631901840538E-2</c:v>
                </c:pt>
                <c:pt idx="2">
                  <c:v>6.5439672801636026E-2</c:v>
                </c:pt>
                <c:pt idx="3">
                  <c:v>4.7034764826175919E-2</c:v>
                </c:pt>
                <c:pt idx="4">
                  <c:v>5.72597137014315E-2</c:v>
                </c:pt>
                <c:pt idx="5">
                  <c:v>0.10020449897750502</c:v>
                </c:pt>
                <c:pt idx="6">
                  <c:v>9.8159509202454032E-2</c:v>
                </c:pt>
                <c:pt idx="7">
                  <c:v>8.5889570552147201E-2</c:v>
                </c:pt>
                <c:pt idx="8">
                  <c:v>5.5214723926380417E-2</c:v>
                </c:pt>
                <c:pt idx="9">
                  <c:v>5.1124744376278078E-2</c:v>
                </c:pt>
                <c:pt idx="10">
                  <c:v>3.680981595092022E-2</c:v>
                </c:pt>
                <c:pt idx="11">
                  <c:v>4.2944785276073601E-2</c:v>
                </c:pt>
                <c:pt idx="12">
                  <c:v>4.2944785276073601E-2</c:v>
                </c:pt>
                <c:pt idx="13">
                  <c:v>2.8629856850715701E-2</c:v>
                </c:pt>
                <c:pt idx="14">
                  <c:v>2.4539877300613518E-2</c:v>
                </c:pt>
                <c:pt idx="15">
                  <c:v>1.2269938650306698E-2</c:v>
                </c:pt>
                <c:pt idx="16">
                  <c:v>2.0449897750511214E-2</c:v>
                </c:pt>
                <c:pt idx="17">
                  <c:v>1.4314928425357899E-2</c:v>
                </c:pt>
                <c:pt idx="18">
                  <c:v>6.1349693251533735E-3</c:v>
                </c:pt>
                <c:pt idx="19">
                  <c:v>1.2269938650306698E-2</c:v>
                </c:pt>
                <c:pt idx="20">
                  <c:v>8.1799591002044997E-3</c:v>
                </c:pt>
                <c:pt idx="21">
                  <c:v>4.0899795501022499E-3</c:v>
                </c:pt>
                <c:pt idx="22">
                  <c:v>2.044989775051121E-3</c:v>
                </c:pt>
                <c:pt idx="23">
                  <c:v>8.1799591002044997E-3</c:v>
                </c:pt>
                <c:pt idx="24">
                  <c:v>2.044989775051121E-3</c:v>
                </c:pt>
                <c:pt idx="25">
                  <c:v>6.1349693251533735E-3</c:v>
                </c:pt>
                <c:pt idx="26">
                  <c:v>2.044989775051121E-3</c:v>
                </c:pt>
                <c:pt idx="27">
                  <c:v>0</c:v>
                </c:pt>
                <c:pt idx="28">
                  <c:v>2.044989775051121E-3</c:v>
                </c:pt>
                <c:pt idx="29">
                  <c:v>2.044989775051121E-3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tph-1(mg280)_A1_0.02_50%'!$G$104</c:f>
              <c:strCache>
                <c:ptCount val="1"/>
                <c:pt idx="0">
                  <c:v>thp-1(mg280)_A1_06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G$105:$G$135</c:f>
              <c:numCache>
                <c:formatCode>General</c:formatCode>
                <c:ptCount val="31"/>
                <c:pt idx="1">
                  <c:v>6.6176470588235309E-2</c:v>
                </c:pt>
                <c:pt idx="2">
                  <c:v>5.1470588235294081E-2</c:v>
                </c:pt>
                <c:pt idx="3">
                  <c:v>3.6764705882352901E-2</c:v>
                </c:pt>
                <c:pt idx="4">
                  <c:v>5.1470588235294081E-2</c:v>
                </c:pt>
                <c:pt idx="5">
                  <c:v>4.4117647058823539E-2</c:v>
                </c:pt>
                <c:pt idx="6">
                  <c:v>2.2058823529411808E-2</c:v>
                </c:pt>
                <c:pt idx="7">
                  <c:v>1.4705882352941199E-2</c:v>
                </c:pt>
                <c:pt idx="8">
                  <c:v>3.6764705882352901E-2</c:v>
                </c:pt>
                <c:pt idx="9">
                  <c:v>2.9411764705882398E-2</c:v>
                </c:pt>
                <c:pt idx="10">
                  <c:v>2.2058823529411808E-2</c:v>
                </c:pt>
                <c:pt idx="11">
                  <c:v>4.4117647058823539E-2</c:v>
                </c:pt>
                <c:pt idx="12">
                  <c:v>4.4117647058823539E-2</c:v>
                </c:pt>
                <c:pt idx="13">
                  <c:v>1.4705882352941199E-2</c:v>
                </c:pt>
                <c:pt idx="14">
                  <c:v>4.4117647058823539E-2</c:v>
                </c:pt>
                <c:pt idx="15">
                  <c:v>2.9411764705882398E-2</c:v>
                </c:pt>
                <c:pt idx="16">
                  <c:v>2.2058823529411808E-2</c:v>
                </c:pt>
                <c:pt idx="17">
                  <c:v>4.4117647058823539E-2</c:v>
                </c:pt>
                <c:pt idx="18">
                  <c:v>2.2058823529411808E-2</c:v>
                </c:pt>
                <c:pt idx="19">
                  <c:v>0</c:v>
                </c:pt>
                <c:pt idx="20">
                  <c:v>1.4705882352941199E-2</c:v>
                </c:pt>
                <c:pt idx="21">
                  <c:v>2.2058823529411808E-2</c:v>
                </c:pt>
                <c:pt idx="22">
                  <c:v>2.2058823529411808E-2</c:v>
                </c:pt>
                <c:pt idx="23">
                  <c:v>0</c:v>
                </c:pt>
                <c:pt idx="24">
                  <c:v>7.3529411764705899E-3</c:v>
                </c:pt>
                <c:pt idx="25">
                  <c:v>2.2058823529411808E-2</c:v>
                </c:pt>
                <c:pt idx="26">
                  <c:v>7.3529411764705899E-3</c:v>
                </c:pt>
                <c:pt idx="27">
                  <c:v>7.3529411764705899E-3</c:v>
                </c:pt>
                <c:pt idx="28">
                  <c:v>7.3529411764705899E-3</c:v>
                </c:pt>
                <c:pt idx="29">
                  <c:v>1.4705882352941199E-2</c:v>
                </c:pt>
                <c:pt idx="30">
                  <c:v>0</c:v>
                </c:pt>
              </c:numCache>
            </c:numRef>
          </c:val>
        </c:ser>
        <c:ser>
          <c:idx val="6"/>
          <c:order val="6"/>
          <c:tx>
            <c:strRef>
              <c:f>'tph-1(mg280)_A1_0.02_50%'!$H$104</c:f>
              <c:strCache>
                <c:ptCount val="1"/>
                <c:pt idx="0">
                  <c:v>thp-1(mg280)_A1_07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H$105:$H$135</c:f>
              <c:numCache>
                <c:formatCode>General</c:formatCode>
                <c:ptCount val="31"/>
                <c:pt idx="1">
                  <c:v>0.11004784688995201</c:v>
                </c:pt>
                <c:pt idx="2">
                  <c:v>8.1339712918660281E-2</c:v>
                </c:pt>
                <c:pt idx="3">
                  <c:v>0.10047846889952194</c:v>
                </c:pt>
                <c:pt idx="4">
                  <c:v>6.2200956937799014E-2</c:v>
                </c:pt>
                <c:pt idx="5">
                  <c:v>4.7846889952153117E-2</c:v>
                </c:pt>
                <c:pt idx="6">
                  <c:v>6.6985645933014398E-2</c:v>
                </c:pt>
                <c:pt idx="7">
                  <c:v>3.3492822966507199E-2</c:v>
                </c:pt>
                <c:pt idx="8">
                  <c:v>5.7416267942583754E-2</c:v>
                </c:pt>
                <c:pt idx="9">
                  <c:v>3.8277511961722514E-2</c:v>
                </c:pt>
                <c:pt idx="10">
                  <c:v>3.8277511961722514E-2</c:v>
                </c:pt>
                <c:pt idx="11">
                  <c:v>2.8708133971291894E-2</c:v>
                </c:pt>
                <c:pt idx="12">
                  <c:v>3.3492822966507199E-2</c:v>
                </c:pt>
                <c:pt idx="13">
                  <c:v>1.4354066985645893E-2</c:v>
                </c:pt>
                <c:pt idx="14">
                  <c:v>0</c:v>
                </c:pt>
                <c:pt idx="15">
                  <c:v>2.8708133971291894E-2</c:v>
                </c:pt>
                <c:pt idx="16">
                  <c:v>9.5693779904306216E-3</c:v>
                </c:pt>
                <c:pt idx="17">
                  <c:v>1.9138755980861205E-2</c:v>
                </c:pt>
                <c:pt idx="18">
                  <c:v>1.4354066985645893E-2</c:v>
                </c:pt>
                <c:pt idx="19">
                  <c:v>0</c:v>
                </c:pt>
                <c:pt idx="20">
                  <c:v>4.7846889952153117E-3</c:v>
                </c:pt>
                <c:pt idx="21">
                  <c:v>4.7846889952153117E-3</c:v>
                </c:pt>
                <c:pt idx="22">
                  <c:v>4.7846889952153117E-3</c:v>
                </c:pt>
                <c:pt idx="23">
                  <c:v>1.4354066985645893E-2</c:v>
                </c:pt>
                <c:pt idx="24">
                  <c:v>4.7846889952153117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4.7846889952153117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tph-1(mg280)_A1_0.02_50%'!$I$104</c:f>
              <c:strCache>
                <c:ptCount val="1"/>
                <c:pt idx="0">
                  <c:v>thp-1(mg280)_A1_08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I$105:$I$135</c:f>
              <c:numCache>
                <c:formatCode>General</c:formatCode>
                <c:ptCount val="31"/>
                <c:pt idx="1">
                  <c:v>7.1065989847715727E-2</c:v>
                </c:pt>
                <c:pt idx="2">
                  <c:v>4.0609137055837616E-2</c:v>
                </c:pt>
                <c:pt idx="3">
                  <c:v>2.5380710659898501E-2</c:v>
                </c:pt>
                <c:pt idx="4">
                  <c:v>5.837563451776652E-2</c:v>
                </c:pt>
                <c:pt idx="5">
                  <c:v>6.0913705583756313E-2</c:v>
                </c:pt>
                <c:pt idx="6">
                  <c:v>5.076142131979703E-2</c:v>
                </c:pt>
                <c:pt idx="7">
                  <c:v>6.8527918781725899E-2</c:v>
                </c:pt>
                <c:pt idx="8">
                  <c:v>4.5685279187817299E-2</c:v>
                </c:pt>
                <c:pt idx="9">
                  <c:v>5.3299492385786802E-2</c:v>
                </c:pt>
                <c:pt idx="10">
                  <c:v>4.5685279187817299E-2</c:v>
                </c:pt>
                <c:pt idx="11">
                  <c:v>3.8071065989847712E-2</c:v>
                </c:pt>
                <c:pt idx="12">
                  <c:v>5.3299492385786802E-2</c:v>
                </c:pt>
                <c:pt idx="13">
                  <c:v>3.5532994923857898E-2</c:v>
                </c:pt>
                <c:pt idx="14">
                  <c:v>3.5532994923857898E-2</c:v>
                </c:pt>
                <c:pt idx="15">
                  <c:v>4.0609137055837616E-2</c:v>
                </c:pt>
                <c:pt idx="16">
                  <c:v>4.0609137055837616E-2</c:v>
                </c:pt>
                <c:pt idx="17">
                  <c:v>1.5228426395939104E-2</c:v>
                </c:pt>
                <c:pt idx="18">
                  <c:v>2.2842639593908601E-2</c:v>
                </c:pt>
                <c:pt idx="19">
                  <c:v>3.0456852791878201E-2</c:v>
                </c:pt>
                <c:pt idx="20">
                  <c:v>2.7918781725888294E-2</c:v>
                </c:pt>
                <c:pt idx="21">
                  <c:v>1.7766497461928901E-2</c:v>
                </c:pt>
                <c:pt idx="22">
                  <c:v>7.6142131979695417E-3</c:v>
                </c:pt>
                <c:pt idx="23">
                  <c:v>5.0761421319797037E-3</c:v>
                </c:pt>
                <c:pt idx="24">
                  <c:v>1.5228426395939104E-2</c:v>
                </c:pt>
                <c:pt idx="25">
                  <c:v>7.6142131979695417E-3</c:v>
                </c:pt>
                <c:pt idx="26">
                  <c:v>2.538071065989851E-3</c:v>
                </c:pt>
                <c:pt idx="27">
                  <c:v>2.538071065989851E-3</c:v>
                </c:pt>
                <c:pt idx="28">
                  <c:v>0</c:v>
                </c:pt>
                <c:pt idx="29">
                  <c:v>5.0761421319797037E-3</c:v>
                </c:pt>
                <c:pt idx="30">
                  <c:v>2.538071065989851E-3</c:v>
                </c:pt>
              </c:numCache>
            </c:numRef>
          </c:val>
        </c:ser>
        <c:ser>
          <c:idx val="8"/>
          <c:order val="8"/>
          <c:tx>
            <c:strRef>
              <c:f>'tph-1(mg280)_A1_0.02_50%'!$J$104</c:f>
              <c:strCache>
                <c:ptCount val="1"/>
                <c:pt idx="0">
                  <c:v>thp-1(mg280)_A1_09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J$105:$J$135</c:f>
              <c:numCache>
                <c:formatCode>General</c:formatCode>
                <c:ptCount val="31"/>
                <c:pt idx="1">
                  <c:v>4.0229885057471299E-2</c:v>
                </c:pt>
                <c:pt idx="2">
                  <c:v>7.4712643678160925E-2</c:v>
                </c:pt>
                <c:pt idx="3">
                  <c:v>2.2988505747126402E-2</c:v>
                </c:pt>
                <c:pt idx="4">
                  <c:v>8.04597701149425E-2</c:v>
                </c:pt>
                <c:pt idx="5">
                  <c:v>5.7471264367816112E-2</c:v>
                </c:pt>
                <c:pt idx="6">
                  <c:v>2.2988505747126402E-2</c:v>
                </c:pt>
                <c:pt idx="7">
                  <c:v>5.1724137931034517E-2</c:v>
                </c:pt>
                <c:pt idx="8">
                  <c:v>4.0229885057471299E-2</c:v>
                </c:pt>
                <c:pt idx="9">
                  <c:v>4.5977011494252887E-2</c:v>
                </c:pt>
                <c:pt idx="10">
                  <c:v>1.7241379310344803E-2</c:v>
                </c:pt>
                <c:pt idx="11">
                  <c:v>5.7471264367816112E-2</c:v>
                </c:pt>
                <c:pt idx="12">
                  <c:v>4.5977011494252887E-2</c:v>
                </c:pt>
                <c:pt idx="13">
                  <c:v>4.0229885057471299E-2</c:v>
                </c:pt>
                <c:pt idx="14">
                  <c:v>4.0229885057471299E-2</c:v>
                </c:pt>
                <c:pt idx="15">
                  <c:v>2.8735632183908007E-2</c:v>
                </c:pt>
                <c:pt idx="16">
                  <c:v>2.8735632183908007E-2</c:v>
                </c:pt>
                <c:pt idx="17">
                  <c:v>0</c:v>
                </c:pt>
                <c:pt idx="18">
                  <c:v>1.7241379310344803E-2</c:v>
                </c:pt>
                <c:pt idx="19">
                  <c:v>2.2988505747126402E-2</c:v>
                </c:pt>
                <c:pt idx="20">
                  <c:v>1.1494252873563199E-2</c:v>
                </c:pt>
                <c:pt idx="21">
                  <c:v>2.2988505747126402E-2</c:v>
                </c:pt>
                <c:pt idx="22">
                  <c:v>5.7471264367816117E-3</c:v>
                </c:pt>
                <c:pt idx="23">
                  <c:v>1.7241379310344803E-2</c:v>
                </c:pt>
                <c:pt idx="24">
                  <c:v>4.0229885057471299E-2</c:v>
                </c:pt>
                <c:pt idx="25">
                  <c:v>0</c:v>
                </c:pt>
                <c:pt idx="26">
                  <c:v>5.7471264367816117E-3</c:v>
                </c:pt>
                <c:pt idx="27">
                  <c:v>5.7471264367816117E-3</c:v>
                </c:pt>
                <c:pt idx="28">
                  <c:v>1.1494252873563199E-2</c:v>
                </c:pt>
                <c:pt idx="29">
                  <c:v>5.7471264367816117E-3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tph-1(mg280)_A1_0.02_50%'!$K$104</c:f>
              <c:strCache>
                <c:ptCount val="1"/>
                <c:pt idx="0">
                  <c:v>thp-1(mg280)_A1_10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K$105:$K$135</c:f>
              <c:numCache>
                <c:formatCode>General</c:formatCode>
                <c:ptCount val="31"/>
                <c:pt idx="1">
                  <c:v>5.7851239669421503E-2</c:v>
                </c:pt>
                <c:pt idx="2">
                  <c:v>5.7851239669421503E-2</c:v>
                </c:pt>
                <c:pt idx="3">
                  <c:v>2.4793388429752112E-2</c:v>
                </c:pt>
                <c:pt idx="4">
                  <c:v>4.132231404958682E-2</c:v>
                </c:pt>
                <c:pt idx="5">
                  <c:v>5.7851239669421503E-2</c:v>
                </c:pt>
                <c:pt idx="6">
                  <c:v>3.3057851239669402E-2</c:v>
                </c:pt>
                <c:pt idx="7">
                  <c:v>3.3057851239669402E-2</c:v>
                </c:pt>
                <c:pt idx="8">
                  <c:v>6.6115702479338803E-2</c:v>
                </c:pt>
                <c:pt idx="9">
                  <c:v>3.3057851239669402E-2</c:v>
                </c:pt>
                <c:pt idx="10">
                  <c:v>4.9586776859504127E-2</c:v>
                </c:pt>
                <c:pt idx="11">
                  <c:v>0</c:v>
                </c:pt>
                <c:pt idx="12">
                  <c:v>4.9586776859504127E-2</c:v>
                </c:pt>
                <c:pt idx="13">
                  <c:v>4.132231404958682E-2</c:v>
                </c:pt>
                <c:pt idx="14">
                  <c:v>3.3057851239669402E-2</c:v>
                </c:pt>
                <c:pt idx="15">
                  <c:v>4.132231404958682E-2</c:v>
                </c:pt>
                <c:pt idx="16">
                  <c:v>1.6528925619834708E-2</c:v>
                </c:pt>
                <c:pt idx="17">
                  <c:v>1.6528925619834708E-2</c:v>
                </c:pt>
                <c:pt idx="18">
                  <c:v>2.4793388429752112E-2</c:v>
                </c:pt>
                <c:pt idx="19">
                  <c:v>3.3057851239669402E-2</c:v>
                </c:pt>
                <c:pt idx="20">
                  <c:v>1.6528925619834708E-2</c:v>
                </c:pt>
                <c:pt idx="21">
                  <c:v>2.4793388429752112E-2</c:v>
                </c:pt>
                <c:pt idx="22">
                  <c:v>2.4793388429752112E-2</c:v>
                </c:pt>
                <c:pt idx="23">
                  <c:v>0</c:v>
                </c:pt>
                <c:pt idx="24">
                  <c:v>2.4793388429752112E-2</c:v>
                </c:pt>
                <c:pt idx="25">
                  <c:v>2.4793388429752112E-2</c:v>
                </c:pt>
                <c:pt idx="26">
                  <c:v>8.2644628099173643E-3</c:v>
                </c:pt>
                <c:pt idx="27">
                  <c:v>1.6528925619834708E-2</c:v>
                </c:pt>
                <c:pt idx="28">
                  <c:v>0</c:v>
                </c:pt>
                <c:pt idx="29">
                  <c:v>8.2644628099173643E-3</c:v>
                </c:pt>
                <c:pt idx="30">
                  <c:v>1.6528925619834708E-2</c:v>
                </c:pt>
              </c:numCache>
            </c:numRef>
          </c:val>
        </c:ser>
        <c:ser>
          <c:idx val="10"/>
          <c:order val="10"/>
          <c:tx>
            <c:strRef>
              <c:f>'tph-1(mg280)_A1_0.02_50%'!$L$104</c:f>
              <c:strCache>
                <c:ptCount val="1"/>
                <c:pt idx="0">
                  <c:v>tph-1(mg280)_A1_11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L$105:$L$135</c:f>
              <c:numCache>
                <c:formatCode>General</c:formatCode>
                <c:ptCount val="31"/>
                <c:pt idx="1">
                  <c:v>2.8037383177570117E-2</c:v>
                </c:pt>
                <c:pt idx="2">
                  <c:v>5.6074766355140214E-2</c:v>
                </c:pt>
                <c:pt idx="3">
                  <c:v>5.6074766355140214E-2</c:v>
                </c:pt>
                <c:pt idx="4">
                  <c:v>8.4112149532710304E-2</c:v>
                </c:pt>
                <c:pt idx="5">
                  <c:v>5.6074766355140214E-2</c:v>
                </c:pt>
                <c:pt idx="6">
                  <c:v>8.4112149532710304E-2</c:v>
                </c:pt>
                <c:pt idx="7">
                  <c:v>9.3457943925233673E-3</c:v>
                </c:pt>
                <c:pt idx="8">
                  <c:v>1.8691588785046703E-2</c:v>
                </c:pt>
                <c:pt idx="9">
                  <c:v>6.5420560747663503E-2</c:v>
                </c:pt>
                <c:pt idx="10">
                  <c:v>6.5420560747663503E-2</c:v>
                </c:pt>
                <c:pt idx="11">
                  <c:v>5.6074766355140214E-2</c:v>
                </c:pt>
                <c:pt idx="12">
                  <c:v>8.4112149532710304E-2</c:v>
                </c:pt>
                <c:pt idx="13">
                  <c:v>2.8037383177570117E-2</c:v>
                </c:pt>
                <c:pt idx="14">
                  <c:v>9.3457943925233673E-3</c:v>
                </c:pt>
                <c:pt idx="15">
                  <c:v>3.7383177570093525E-2</c:v>
                </c:pt>
                <c:pt idx="16">
                  <c:v>2.8037383177570117E-2</c:v>
                </c:pt>
                <c:pt idx="17">
                  <c:v>0</c:v>
                </c:pt>
                <c:pt idx="18">
                  <c:v>1.8691588785046703E-2</c:v>
                </c:pt>
                <c:pt idx="19">
                  <c:v>9.3457943925233673E-3</c:v>
                </c:pt>
                <c:pt idx="20">
                  <c:v>0</c:v>
                </c:pt>
                <c:pt idx="21">
                  <c:v>1.8691588785046703E-2</c:v>
                </c:pt>
                <c:pt idx="22">
                  <c:v>1.8691588785046703E-2</c:v>
                </c:pt>
                <c:pt idx="23">
                  <c:v>0</c:v>
                </c:pt>
                <c:pt idx="24">
                  <c:v>1.8691588785046703E-2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9.3457943925233673E-3</c:v>
                </c:pt>
                <c:pt idx="30">
                  <c:v>9.3457943925233673E-3</c:v>
                </c:pt>
              </c:numCache>
            </c:numRef>
          </c:val>
        </c:ser>
        <c:ser>
          <c:idx val="11"/>
          <c:order val="11"/>
          <c:tx>
            <c:strRef>
              <c:f>'tph-1(mg280)_A1_0.02_50%'!$M$104</c:f>
              <c:strCache>
                <c:ptCount val="1"/>
                <c:pt idx="0">
                  <c:v>tph-1(mg280)_A1_12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M$105:$M$135</c:f>
              <c:numCache>
                <c:formatCode>General</c:formatCode>
                <c:ptCount val="31"/>
                <c:pt idx="1">
                  <c:v>4.1666666666666699E-2</c:v>
                </c:pt>
                <c:pt idx="2">
                  <c:v>9.1666666666666757E-2</c:v>
                </c:pt>
                <c:pt idx="3">
                  <c:v>6.6666666666666693E-2</c:v>
                </c:pt>
                <c:pt idx="4">
                  <c:v>3.3333333333333298E-2</c:v>
                </c:pt>
                <c:pt idx="5">
                  <c:v>5.8333333333333334E-2</c:v>
                </c:pt>
                <c:pt idx="6">
                  <c:v>4.1666666666666699E-2</c:v>
                </c:pt>
                <c:pt idx="7">
                  <c:v>6.6666666666666693E-2</c:v>
                </c:pt>
                <c:pt idx="8">
                  <c:v>0.05</c:v>
                </c:pt>
                <c:pt idx="9">
                  <c:v>0.05</c:v>
                </c:pt>
                <c:pt idx="10">
                  <c:v>4.1666666666666699E-2</c:v>
                </c:pt>
                <c:pt idx="11">
                  <c:v>2.5000000000000001E-2</c:v>
                </c:pt>
                <c:pt idx="12">
                  <c:v>8.3333333333333297E-3</c:v>
                </c:pt>
                <c:pt idx="13">
                  <c:v>2.5000000000000001E-2</c:v>
                </c:pt>
                <c:pt idx="14">
                  <c:v>1.6666666666666701E-2</c:v>
                </c:pt>
                <c:pt idx="15">
                  <c:v>4.1666666666666699E-2</c:v>
                </c:pt>
                <c:pt idx="16">
                  <c:v>3.3333333333333298E-2</c:v>
                </c:pt>
                <c:pt idx="17">
                  <c:v>2.5000000000000001E-2</c:v>
                </c:pt>
                <c:pt idx="18">
                  <c:v>0</c:v>
                </c:pt>
                <c:pt idx="19">
                  <c:v>0</c:v>
                </c:pt>
                <c:pt idx="20">
                  <c:v>1.6666666666666701E-2</c:v>
                </c:pt>
                <c:pt idx="21">
                  <c:v>8.3333333333333297E-3</c:v>
                </c:pt>
                <c:pt idx="22">
                  <c:v>8.3333333333333297E-3</c:v>
                </c:pt>
                <c:pt idx="23">
                  <c:v>1.6666666666666701E-2</c:v>
                </c:pt>
                <c:pt idx="24">
                  <c:v>8.3333333333333297E-3</c:v>
                </c:pt>
                <c:pt idx="25">
                  <c:v>2.5000000000000001E-2</c:v>
                </c:pt>
                <c:pt idx="26">
                  <c:v>0</c:v>
                </c:pt>
                <c:pt idx="27">
                  <c:v>8.3333333333333297E-3</c:v>
                </c:pt>
                <c:pt idx="28">
                  <c:v>0</c:v>
                </c:pt>
                <c:pt idx="29">
                  <c:v>8.3333333333333297E-3</c:v>
                </c:pt>
                <c:pt idx="30">
                  <c:v>8.3333333333333297E-3</c:v>
                </c:pt>
              </c:numCache>
            </c:numRef>
          </c:val>
        </c:ser>
        <c:ser>
          <c:idx val="12"/>
          <c:order val="12"/>
          <c:tx>
            <c:strRef>
              <c:f>'tph-1(mg280)_A1_0.02_50%'!$N$104</c:f>
              <c:strCache>
                <c:ptCount val="1"/>
                <c:pt idx="0">
                  <c:v>tph-1(mg280)_A1_13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N$105:$N$135</c:f>
              <c:numCache>
                <c:formatCode>General</c:formatCode>
                <c:ptCount val="31"/>
                <c:pt idx="1">
                  <c:v>7.373271889400923E-2</c:v>
                </c:pt>
                <c:pt idx="2">
                  <c:v>7.83410138248848E-2</c:v>
                </c:pt>
                <c:pt idx="3">
                  <c:v>4.6082949308755797E-2</c:v>
                </c:pt>
                <c:pt idx="4">
                  <c:v>6.4516129032258132E-2</c:v>
                </c:pt>
                <c:pt idx="5">
                  <c:v>7.373271889400923E-2</c:v>
                </c:pt>
                <c:pt idx="6">
                  <c:v>5.9907834101382514E-2</c:v>
                </c:pt>
                <c:pt idx="7">
                  <c:v>7.373271889400923E-2</c:v>
                </c:pt>
                <c:pt idx="8">
                  <c:v>5.0691244239631325E-2</c:v>
                </c:pt>
                <c:pt idx="9">
                  <c:v>4.6082949308755797E-2</c:v>
                </c:pt>
                <c:pt idx="10">
                  <c:v>2.7649769585253527E-2</c:v>
                </c:pt>
                <c:pt idx="11">
                  <c:v>5.0691244239631325E-2</c:v>
                </c:pt>
                <c:pt idx="12">
                  <c:v>3.2258064516129011E-2</c:v>
                </c:pt>
                <c:pt idx="13">
                  <c:v>6.9124423963133647E-2</c:v>
                </c:pt>
                <c:pt idx="14">
                  <c:v>2.3041474654377898E-2</c:v>
                </c:pt>
                <c:pt idx="15">
                  <c:v>2.7649769585253527E-2</c:v>
                </c:pt>
                <c:pt idx="16">
                  <c:v>1.8433179723502308E-2</c:v>
                </c:pt>
                <c:pt idx="17">
                  <c:v>4.6082949308755804E-3</c:v>
                </c:pt>
                <c:pt idx="18">
                  <c:v>1.3824884792626705E-2</c:v>
                </c:pt>
                <c:pt idx="19">
                  <c:v>4.6082949308755804E-3</c:v>
                </c:pt>
                <c:pt idx="20">
                  <c:v>9.2165898617511503E-3</c:v>
                </c:pt>
                <c:pt idx="21">
                  <c:v>1.3824884792626705E-2</c:v>
                </c:pt>
                <c:pt idx="22">
                  <c:v>9.2165898617511503E-3</c:v>
                </c:pt>
                <c:pt idx="23">
                  <c:v>4.6082949308755804E-3</c:v>
                </c:pt>
                <c:pt idx="24">
                  <c:v>4.6082949308755804E-3</c:v>
                </c:pt>
                <c:pt idx="25">
                  <c:v>9.2165898617511503E-3</c:v>
                </c:pt>
                <c:pt idx="26">
                  <c:v>0</c:v>
                </c:pt>
                <c:pt idx="27">
                  <c:v>4.6082949308755804E-3</c:v>
                </c:pt>
                <c:pt idx="28">
                  <c:v>4.6082949308755804E-3</c:v>
                </c:pt>
                <c:pt idx="29">
                  <c:v>1.3824884792626705E-2</c:v>
                </c:pt>
                <c:pt idx="30">
                  <c:v>4.6082949308755804E-3</c:v>
                </c:pt>
              </c:numCache>
            </c:numRef>
          </c:val>
        </c:ser>
        <c:ser>
          <c:idx val="13"/>
          <c:order val="13"/>
          <c:tx>
            <c:strRef>
              <c:f>'tph-1(mg280)_A1_0.02_50%'!$O$104</c:f>
              <c:strCache>
                <c:ptCount val="1"/>
                <c:pt idx="0">
                  <c:v>tph-1(mg280)_A1_14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O$105:$O$135</c:f>
              <c:numCache>
                <c:formatCode>General</c:formatCode>
                <c:ptCount val="31"/>
                <c:pt idx="1">
                  <c:v>5.555555555555558E-2</c:v>
                </c:pt>
                <c:pt idx="2">
                  <c:v>3.5714285714285698E-2</c:v>
                </c:pt>
                <c:pt idx="3">
                  <c:v>3.9682539682539715E-2</c:v>
                </c:pt>
                <c:pt idx="4">
                  <c:v>2.7777777777777821E-2</c:v>
                </c:pt>
                <c:pt idx="5">
                  <c:v>7.1428571428571411E-2</c:v>
                </c:pt>
                <c:pt idx="6">
                  <c:v>4.3650793650793614E-2</c:v>
                </c:pt>
                <c:pt idx="7">
                  <c:v>3.5714285714285698E-2</c:v>
                </c:pt>
                <c:pt idx="8">
                  <c:v>6.7460317460317498E-2</c:v>
                </c:pt>
                <c:pt idx="9">
                  <c:v>4.3650793650793614E-2</c:v>
                </c:pt>
                <c:pt idx="10">
                  <c:v>1.9841269841269809E-2</c:v>
                </c:pt>
                <c:pt idx="11">
                  <c:v>3.9682539682539715E-2</c:v>
                </c:pt>
                <c:pt idx="12">
                  <c:v>3.1746031746031703E-2</c:v>
                </c:pt>
                <c:pt idx="13">
                  <c:v>4.7619047619047616E-2</c:v>
                </c:pt>
                <c:pt idx="14">
                  <c:v>3.5714285714285698E-2</c:v>
                </c:pt>
                <c:pt idx="15">
                  <c:v>3.9682539682539715E-2</c:v>
                </c:pt>
                <c:pt idx="16">
                  <c:v>4.3650793650793614E-2</c:v>
                </c:pt>
                <c:pt idx="17">
                  <c:v>4.7619047619047616E-2</c:v>
                </c:pt>
                <c:pt idx="18">
                  <c:v>3.9682539682539715E-2</c:v>
                </c:pt>
                <c:pt idx="19">
                  <c:v>4.3650793650793614E-2</c:v>
                </c:pt>
                <c:pt idx="20">
                  <c:v>1.9841269841269809E-2</c:v>
                </c:pt>
                <c:pt idx="21">
                  <c:v>2.3809523809523808E-2</c:v>
                </c:pt>
                <c:pt idx="22">
                  <c:v>7.9365079365079413E-3</c:v>
                </c:pt>
                <c:pt idx="23">
                  <c:v>3.9682539682539715E-3</c:v>
                </c:pt>
                <c:pt idx="24">
                  <c:v>1.58730158730159E-2</c:v>
                </c:pt>
                <c:pt idx="25">
                  <c:v>7.9365079365079413E-3</c:v>
                </c:pt>
                <c:pt idx="26">
                  <c:v>7.9365079365079413E-3</c:v>
                </c:pt>
                <c:pt idx="27">
                  <c:v>7.9365079365079413E-3</c:v>
                </c:pt>
                <c:pt idx="28">
                  <c:v>3.9682539682539715E-3</c:v>
                </c:pt>
                <c:pt idx="29">
                  <c:v>7.9365079365079413E-3</c:v>
                </c:pt>
                <c:pt idx="30">
                  <c:v>0</c:v>
                </c:pt>
              </c:numCache>
            </c:numRef>
          </c:val>
        </c:ser>
        <c:ser>
          <c:idx val="14"/>
          <c:order val="14"/>
          <c:tx>
            <c:strRef>
              <c:f>'tph-1(mg280)_A1_0.02_50%'!$P$104</c:f>
              <c:strCache>
                <c:ptCount val="1"/>
                <c:pt idx="0">
                  <c:v>tph-1(mg280)_A1_15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P$105:$P$135</c:f>
              <c:numCache>
                <c:formatCode>General</c:formatCode>
                <c:ptCount val="31"/>
                <c:pt idx="1">
                  <c:v>9.7701149425287431E-2</c:v>
                </c:pt>
                <c:pt idx="2">
                  <c:v>6.8965517241379309E-2</c:v>
                </c:pt>
                <c:pt idx="3">
                  <c:v>7.7586206896551727E-2</c:v>
                </c:pt>
                <c:pt idx="4">
                  <c:v>0.10344827586206902</c:v>
                </c:pt>
                <c:pt idx="5">
                  <c:v>6.0344827586206899E-2</c:v>
                </c:pt>
                <c:pt idx="6">
                  <c:v>5.1724137931034517E-2</c:v>
                </c:pt>
                <c:pt idx="7">
                  <c:v>4.5977011494252887E-2</c:v>
                </c:pt>
                <c:pt idx="8">
                  <c:v>6.6091954022988494E-2</c:v>
                </c:pt>
                <c:pt idx="9">
                  <c:v>2.8735632183908007E-2</c:v>
                </c:pt>
                <c:pt idx="10">
                  <c:v>4.3103448275862079E-2</c:v>
                </c:pt>
                <c:pt idx="11">
                  <c:v>2.8735632183908007E-2</c:v>
                </c:pt>
                <c:pt idx="12">
                  <c:v>2.5862068965517199E-2</c:v>
                </c:pt>
                <c:pt idx="13">
                  <c:v>2.8735632183908007E-2</c:v>
                </c:pt>
                <c:pt idx="14">
                  <c:v>2.2988505747126402E-2</c:v>
                </c:pt>
                <c:pt idx="15">
                  <c:v>1.4367816091953999E-2</c:v>
                </c:pt>
                <c:pt idx="16">
                  <c:v>2.5862068965517199E-2</c:v>
                </c:pt>
                <c:pt idx="17">
                  <c:v>2.8735632183908015E-3</c:v>
                </c:pt>
                <c:pt idx="18">
                  <c:v>2.8735632183908015E-3</c:v>
                </c:pt>
                <c:pt idx="19">
                  <c:v>8.6206896551724154E-3</c:v>
                </c:pt>
                <c:pt idx="20">
                  <c:v>1.1494252873563199E-2</c:v>
                </c:pt>
                <c:pt idx="21">
                  <c:v>1.7241379310344803E-2</c:v>
                </c:pt>
                <c:pt idx="22">
                  <c:v>5.7471264367816117E-3</c:v>
                </c:pt>
                <c:pt idx="23">
                  <c:v>2.8735632183908015E-3</c:v>
                </c:pt>
                <c:pt idx="24">
                  <c:v>5.7471264367816117E-3</c:v>
                </c:pt>
                <c:pt idx="25">
                  <c:v>1.1494252873563199E-2</c:v>
                </c:pt>
                <c:pt idx="26">
                  <c:v>0</c:v>
                </c:pt>
                <c:pt idx="27">
                  <c:v>0</c:v>
                </c:pt>
                <c:pt idx="28">
                  <c:v>5.7471264367816117E-3</c:v>
                </c:pt>
                <c:pt idx="29">
                  <c:v>5.7471264367816117E-3</c:v>
                </c:pt>
                <c:pt idx="30">
                  <c:v>2.8735632183908015E-3</c:v>
                </c:pt>
              </c:numCache>
            </c:numRef>
          </c:val>
        </c:ser>
        <c:ser>
          <c:idx val="15"/>
          <c:order val="15"/>
          <c:tx>
            <c:strRef>
              <c:f>'tph-1(mg280)_A1_0.02_50%'!$Q$104</c:f>
              <c:strCache>
                <c:ptCount val="1"/>
                <c:pt idx="0">
                  <c:v>tph-1(mg280)_A1_16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Q$105:$Q$135</c:f>
              <c:numCache>
                <c:formatCode>General</c:formatCode>
                <c:ptCount val="31"/>
                <c:pt idx="1">
                  <c:v>9.8726114649681507E-2</c:v>
                </c:pt>
                <c:pt idx="2">
                  <c:v>5.7324840764331197E-2</c:v>
                </c:pt>
                <c:pt idx="3">
                  <c:v>6.3694267515923594E-2</c:v>
                </c:pt>
                <c:pt idx="4">
                  <c:v>6.6878980891719703E-2</c:v>
                </c:pt>
                <c:pt idx="5">
                  <c:v>8.2802547770700605E-2</c:v>
                </c:pt>
                <c:pt idx="6">
                  <c:v>6.6878980891719703E-2</c:v>
                </c:pt>
                <c:pt idx="7">
                  <c:v>6.0509554140127403E-2</c:v>
                </c:pt>
                <c:pt idx="8">
                  <c:v>3.5031847133758016E-2</c:v>
                </c:pt>
                <c:pt idx="9">
                  <c:v>4.1401273885350302E-2</c:v>
                </c:pt>
                <c:pt idx="10">
                  <c:v>2.5477707006369421E-2</c:v>
                </c:pt>
                <c:pt idx="11">
                  <c:v>3.1847133757961811E-2</c:v>
                </c:pt>
                <c:pt idx="12">
                  <c:v>2.8662420382165599E-2</c:v>
                </c:pt>
                <c:pt idx="13">
                  <c:v>3.1847133757961811E-2</c:v>
                </c:pt>
                <c:pt idx="14">
                  <c:v>3.5031847133758016E-2</c:v>
                </c:pt>
                <c:pt idx="15">
                  <c:v>3.1847133757961811E-2</c:v>
                </c:pt>
                <c:pt idx="16">
                  <c:v>3.5031847133758016E-2</c:v>
                </c:pt>
                <c:pt idx="17">
                  <c:v>1.5923566878980902E-2</c:v>
                </c:pt>
                <c:pt idx="18">
                  <c:v>1.9108280254777107E-2</c:v>
                </c:pt>
                <c:pt idx="19">
                  <c:v>2.2292993630573209E-2</c:v>
                </c:pt>
                <c:pt idx="20">
                  <c:v>1.9108280254777107E-2</c:v>
                </c:pt>
                <c:pt idx="21">
                  <c:v>6.3694267515923622E-3</c:v>
                </c:pt>
                <c:pt idx="22">
                  <c:v>6.3694267515923622E-3</c:v>
                </c:pt>
                <c:pt idx="23">
                  <c:v>0</c:v>
                </c:pt>
                <c:pt idx="24">
                  <c:v>6.3694267515923622E-3</c:v>
                </c:pt>
                <c:pt idx="25">
                  <c:v>9.5541401273885294E-3</c:v>
                </c:pt>
                <c:pt idx="26">
                  <c:v>0</c:v>
                </c:pt>
                <c:pt idx="27">
                  <c:v>3.1847133757961815E-3</c:v>
                </c:pt>
                <c:pt idx="28">
                  <c:v>3.1847133757961815E-3</c:v>
                </c:pt>
                <c:pt idx="29">
                  <c:v>0</c:v>
                </c:pt>
                <c:pt idx="30">
                  <c:v>3.1847133757961815E-3</c:v>
                </c:pt>
              </c:numCache>
            </c:numRef>
          </c:val>
        </c:ser>
        <c:ser>
          <c:idx val="16"/>
          <c:order val="16"/>
          <c:tx>
            <c:strRef>
              <c:f>'tph-1(mg280)_A1_0.02_50%'!$R$104</c:f>
              <c:strCache>
                <c:ptCount val="1"/>
                <c:pt idx="0">
                  <c:v>tph-1(mg280)_A1_17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R$105:$R$135</c:f>
              <c:numCache>
                <c:formatCode>General</c:formatCode>
                <c:ptCount val="31"/>
                <c:pt idx="1">
                  <c:v>8.0213903743315482E-2</c:v>
                </c:pt>
                <c:pt idx="2">
                  <c:v>7.4866310160427829E-2</c:v>
                </c:pt>
                <c:pt idx="3">
                  <c:v>4.2780748663101602E-2</c:v>
                </c:pt>
                <c:pt idx="4">
                  <c:v>6.9518716577540093E-2</c:v>
                </c:pt>
                <c:pt idx="5">
                  <c:v>4.8128342245989282E-2</c:v>
                </c:pt>
                <c:pt idx="6">
                  <c:v>3.2085561497326213E-2</c:v>
                </c:pt>
                <c:pt idx="7">
                  <c:v>4.8128342245989282E-2</c:v>
                </c:pt>
                <c:pt idx="8">
                  <c:v>4.8128342245989282E-2</c:v>
                </c:pt>
                <c:pt idx="9">
                  <c:v>3.7433155080213928E-2</c:v>
                </c:pt>
                <c:pt idx="10">
                  <c:v>3.7433155080213928E-2</c:v>
                </c:pt>
                <c:pt idx="11">
                  <c:v>2.1390374331550797E-2</c:v>
                </c:pt>
                <c:pt idx="12">
                  <c:v>3.2085561497326213E-2</c:v>
                </c:pt>
                <c:pt idx="13">
                  <c:v>2.1390374331550797E-2</c:v>
                </c:pt>
                <c:pt idx="14">
                  <c:v>4.2780748663101602E-2</c:v>
                </c:pt>
                <c:pt idx="15">
                  <c:v>1.6042780748663114E-2</c:v>
                </c:pt>
                <c:pt idx="16">
                  <c:v>5.3475935828877002E-3</c:v>
                </c:pt>
                <c:pt idx="17">
                  <c:v>2.6737967914438505E-2</c:v>
                </c:pt>
                <c:pt idx="18">
                  <c:v>2.1390374331550797E-2</c:v>
                </c:pt>
                <c:pt idx="19">
                  <c:v>2.1390374331550797E-2</c:v>
                </c:pt>
                <c:pt idx="20">
                  <c:v>3.2085561497326213E-2</c:v>
                </c:pt>
                <c:pt idx="21">
                  <c:v>1.6042780748663114E-2</c:v>
                </c:pt>
                <c:pt idx="22">
                  <c:v>5.3475935828877002E-3</c:v>
                </c:pt>
                <c:pt idx="23">
                  <c:v>1.6042780748663114E-2</c:v>
                </c:pt>
                <c:pt idx="24">
                  <c:v>5.3475935828877002E-3</c:v>
                </c:pt>
                <c:pt idx="25">
                  <c:v>2.1390374331550797E-2</c:v>
                </c:pt>
                <c:pt idx="26">
                  <c:v>1.06951871657754E-2</c:v>
                </c:pt>
                <c:pt idx="27">
                  <c:v>5.3475935828877002E-3</c:v>
                </c:pt>
                <c:pt idx="28">
                  <c:v>1.06951871657754E-2</c:v>
                </c:pt>
                <c:pt idx="29">
                  <c:v>0</c:v>
                </c:pt>
                <c:pt idx="30">
                  <c:v>5.3475935828877002E-3</c:v>
                </c:pt>
              </c:numCache>
            </c:numRef>
          </c:val>
        </c:ser>
        <c:ser>
          <c:idx val="17"/>
          <c:order val="17"/>
          <c:tx>
            <c:strRef>
              <c:f>'tph-1(mg280)_A1_0.02_50%'!$S$104</c:f>
              <c:strCache>
                <c:ptCount val="1"/>
                <c:pt idx="0">
                  <c:v>tph-1(mg280)_A1_18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S$105:$S$135</c:f>
              <c:numCache>
                <c:formatCode>General</c:formatCode>
                <c:ptCount val="31"/>
                <c:pt idx="1">
                  <c:v>6.9767441860465129E-2</c:v>
                </c:pt>
                <c:pt idx="2">
                  <c:v>8.1395348837209336E-2</c:v>
                </c:pt>
                <c:pt idx="3">
                  <c:v>8.7209302325581398E-2</c:v>
                </c:pt>
                <c:pt idx="4">
                  <c:v>5.8139534883720916E-2</c:v>
                </c:pt>
                <c:pt idx="5">
                  <c:v>6.3953488372092998E-2</c:v>
                </c:pt>
                <c:pt idx="6">
                  <c:v>4.941860465116283E-2</c:v>
                </c:pt>
                <c:pt idx="7">
                  <c:v>4.0697674418604717E-2</c:v>
                </c:pt>
                <c:pt idx="8">
                  <c:v>3.1976744186046499E-2</c:v>
                </c:pt>
                <c:pt idx="9">
                  <c:v>3.7790697674418602E-2</c:v>
                </c:pt>
                <c:pt idx="10">
                  <c:v>4.6511627906976737E-2</c:v>
                </c:pt>
                <c:pt idx="11">
                  <c:v>4.0697674418604717E-2</c:v>
                </c:pt>
                <c:pt idx="12">
                  <c:v>4.3604651162790699E-2</c:v>
                </c:pt>
                <c:pt idx="13">
                  <c:v>2.32558139534884E-2</c:v>
                </c:pt>
                <c:pt idx="14">
                  <c:v>3.7790697674418602E-2</c:v>
                </c:pt>
                <c:pt idx="15">
                  <c:v>3.4883720930232599E-2</c:v>
                </c:pt>
                <c:pt idx="16">
                  <c:v>1.7441860465116307E-2</c:v>
                </c:pt>
                <c:pt idx="17">
                  <c:v>5.8139534883720921E-3</c:v>
                </c:pt>
                <c:pt idx="18">
                  <c:v>4.3604651162790699E-2</c:v>
                </c:pt>
                <c:pt idx="19">
                  <c:v>2.32558139534884E-2</c:v>
                </c:pt>
                <c:pt idx="20">
                  <c:v>8.7209302325581446E-3</c:v>
                </c:pt>
                <c:pt idx="21">
                  <c:v>8.7209302325581446E-3</c:v>
                </c:pt>
                <c:pt idx="22">
                  <c:v>1.1627906976744195E-2</c:v>
                </c:pt>
                <c:pt idx="23">
                  <c:v>8.7209302325581446E-3</c:v>
                </c:pt>
                <c:pt idx="24">
                  <c:v>5.8139534883720921E-3</c:v>
                </c:pt>
                <c:pt idx="25">
                  <c:v>1.4534883720930199E-2</c:v>
                </c:pt>
                <c:pt idx="26">
                  <c:v>0</c:v>
                </c:pt>
                <c:pt idx="27">
                  <c:v>1.1627906976744195E-2</c:v>
                </c:pt>
                <c:pt idx="28">
                  <c:v>8.7209302325581446E-3</c:v>
                </c:pt>
                <c:pt idx="29">
                  <c:v>2.9069767441860512E-3</c:v>
                </c:pt>
                <c:pt idx="30">
                  <c:v>2.9069767441860512E-3</c:v>
                </c:pt>
              </c:numCache>
            </c:numRef>
          </c:val>
        </c:ser>
        <c:ser>
          <c:idx val="18"/>
          <c:order val="18"/>
          <c:tx>
            <c:strRef>
              <c:f>'tph-1(mg280)_A1_0.02_50%'!$T$104</c:f>
              <c:strCache>
                <c:ptCount val="1"/>
                <c:pt idx="0">
                  <c:v>tph-1(mg280)_A1_19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T$105:$T$135</c:f>
              <c:numCache>
                <c:formatCode>General</c:formatCode>
                <c:ptCount val="31"/>
                <c:pt idx="1">
                  <c:v>5.1948051948052E-2</c:v>
                </c:pt>
                <c:pt idx="2">
                  <c:v>3.2467532467532499E-2</c:v>
                </c:pt>
                <c:pt idx="3">
                  <c:v>5.1948051948052E-2</c:v>
                </c:pt>
                <c:pt idx="4">
                  <c:v>2.8138528138528091E-2</c:v>
                </c:pt>
                <c:pt idx="5">
                  <c:v>5.627705627705628E-2</c:v>
                </c:pt>
                <c:pt idx="6">
                  <c:v>4.9783549783549812E-2</c:v>
                </c:pt>
                <c:pt idx="7">
                  <c:v>8.6580086580086646E-2</c:v>
                </c:pt>
                <c:pt idx="8">
                  <c:v>3.6796536796536793E-2</c:v>
                </c:pt>
                <c:pt idx="9">
                  <c:v>4.3290043290043302E-2</c:v>
                </c:pt>
                <c:pt idx="10">
                  <c:v>5.8441558441558378E-2</c:v>
                </c:pt>
                <c:pt idx="11">
                  <c:v>3.8961038961039002E-2</c:v>
                </c:pt>
                <c:pt idx="12">
                  <c:v>3.6796536796536793E-2</c:v>
                </c:pt>
                <c:pt idx="13">
                  <c:v>3.8961038961039002E-2</c:v>
                </c:pt>
                <c:pt idx="14">
                  <c:v>4.9783549783549812E-2</c:v>
                </c:pt>
                <c:pt idx="15">
                  <c:v>4.9783549783549812E-2</c:v>
                </c:pt>
                <c:pt idx="16">
                  <c:v>3.4632034632034597E-2</c:v>
                </c:pt>
                <c:pt idx="17">
                  <c:v>3.6796536796536793E-2</c:v>
                </c:pt>
                <c:pt idx="18">
                  <c:v>3.03030303030303E-2</c:v>
                </c:pt>
                <c:pt idx="19">
                  <c:v>2.5974025974026007E-2</c:v>
                </c:pt>
                <c:pt idx="20">
                  <c:v>1.2987012987013E-2</c:v>
                </c:pt>
                <c:pt idx="21">
                  <c:v>2.5974025974026007E-2</c:v>
                </c:pt>
                <c:pt idx="22">
                  <c:v>1.9480519480519508E-2</c:v>
                </c:pt>
                <c:pt idx="23">
                  <c:v>1.0822510822510801E-2</c:v>
                </c:pt>
                <c:pt idx="24">
                  <c:v>1.0822510822510801E-2</c:v>
                </c:pt>
                <c:pt idx="25">
                  <c:v>6.4935064935064922E-3</c:v>
                </c:pt>
                <c:pt idx="26">
                  <c:v>6.4935064935064922E-3</c:v>
                </c:pt>
                <c:pt idx="27">
                  <c:v>6.4935064935064922E-3</c:v>
                </c:pt>
                <c:pt idx="28">
                  <c:v>8.6580086580086649E-3</c:v>
                </c:pt>
                <c:pt idx="29">
                  <c:v>2.164502164502161E-3</c:v>
                </c:pt>
                <c:pt idx="30">
                  <c:v>2.164502164502161E-3</c:v>
                </c:pt>
              </c:numCache>
            </c:numRef>
          </c:val>
        </c:ser>
        <c:ser>
          <c:idx val="19"/>
          <c:order val="19"/>
          <c:tx>
            <c:strRef>
              <c:f>'tph-1(mg280)_A1_0.02_50%'!$U$104</c:f>
              <c:strCache>
                <c:ptCount val="1"/>
                <c:pt idx="0">
                  <c:v>tph-1(mg280)_A1_20</c:v>
                </c:pt>
              </c:strCache>
            </c:strRef>
          </c:tx>
          <c:marker>
            <c:symbol val="none"/>
          </c:marker>
          <c:cat>
            <c:numRef>
              <c:f>'tph-1(mg280)_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tph-1(mg280)_A1_0.02_50%'!$U$105:$U$135</c:f>
              <c:numCache>
                <c:formatCode>General</c:formatCode>
                <c:ptCount val="31"/>
                <c:pt idx="1">
                  <c:v>3.1818181818181801E-2</c:v>
                </c:pt>
                <c:pt idx="2">
                  <c:v>2.7272727272727313E-2</c:v>
                </c:pt>
                <c:pt idx="3">
                  <c:v>4.0909090909090902E-2</c:v>
                </c:pt>
                <c:pt idx="4">
                  <c:v>6.3636363636363602E-2</c:v>
                </c:pt>
                <c:pt idx="5">
                  <c:v>3.1818181818181801E-2</c:v>
                </c:pt>
                <c:pt idx="6">
                  <c:v>6.8181818181818205E-2</c:v>
                </c:pt>
                <c:pt idx="7">
                  <c:v>6.3636363636363602E-2</c:v>
                </c:pt>
                <c:pt idx="8">
                  <c:v>2.7272727272727313E-2</c:v>
                </c:pt>
                <c:pt idx="9">
                  <c:v>4.5454545454545497E-2</c:v>
                </c:pt>
                <c:pt idx="10">
                  <c:v>8.1818181818181734E-2</c:v>
                </c:pt>
                <c:pt idx="11">
                  <c:v>4.0909090909090902E-2</c:v>
                </c:pt>
                <c:pt idx="12">
                  <c:v>3.6363636363636397E-2</c:v>
                </c:pt>
                <c:pt idx="13">
                  <c:v>4.0909090909090902E-2</c:v>
                </c:pt>
                <c:pt idx="14">
                  <c:v>2.2727272727272717E-2</c:v>
                </c:pt>
                <c:pt idx="15">
                  <c:v>3.6363636363636397E-2</c:v>
                </c:pt>
                <c:pt idx="16">
                  <c:v>4.0909090909090902E-2</c:v>
                </c:pt>
                <c:pt idx="17">
                  <c:v>2.7272727272727313E-2</c:v>
                </c:pt>
                <c:pt idx="18">
                  <c:v>3.6363636363636397E-2</c:v>
                </c:pt>
                <c:pt idx="19">
                  <c:v>3.6363636363636397E-2</c:v>
                </c:pt>
                <c:pt idx="20">
                  <c:v>1.3636363636363601E-2</c:v>
                </c:pt>
                <c:pt idx="21">
                  <c:v>1.3636363636363601E-2</c:v>
                </c:pt>
                <c:pt idx="22">
                  <c:v>3.1818181818181801E-2</c:v>
                </c:pt>
                <c:pt idx="23">
                  <c:v>4.5454545454545504E-3</c:v>
                </c:pt>
                <c:pt idx="24">
                  <c:v>9.0909090909090991E-3</c:v>
                </c:pt>
                <c:pt idx="25">
                  <c:v>4.5454545454545504E-3</c:v>
                </c:pt>
                <c:pt idx="26">
                  <c:v>1.8181818181818205E-2</c:v>
                </c:pt>
                <c:pt idx="27">
                  <c:v>9.0909090909090991E-3</c:v>
                </c:pt>
                <c:pt idx="28">
                  <c:v>9.0909090909090991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marker val="1"/>
        <c:axId val="172986368"/>
        <c:axId val="172987904"/>
      </c:lineChart>
      <c:catAx>
        <c:axId val="172986368"/>
        <c:scaling>
          <c:orientation val="minMax"/>
        </c:scaling>
        <c:axPos val="b"/>
        <c:numFmt formatCode="0.0_ " sourceLinked="1"/>
        <c:tickLblPos val="nextTo"/>
        <c:crossAx val="172987904"/>
        <c:crosses val="autoZero"/>
        <c:auto val="1"/>
        <c:lblAlgn val="ctr"/>
        <c:lblOffset val="100"/>
        <c:tickLblSkip val="5"/>
        <c:tickMarkSkip val="5"/>
      </c:catAx>
      <c:valAx>
        <c:axId val="172987904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72986368"/>
        <c:crosses val="autoZero"/>
        <c:crossBetween val="between"/>
      </c:valAx>
    </c:plotArea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 i="1" dirty="0">
                <a:latin typeface="Arial" pitchFamily="34" charset="0"/>
                <a:cs typeface="Arial" pitchFamily="34" charset="0"/>
              </a:rPr>
              <a:t>unc-25</a:t>
            </a:r>
            <a:r>
              <a:rPr lang="en-US" altLang="ja-JP" sz="1400" b="0" dirty="0">
                <a:latin typeface="Arial" pitchFamily="34" charset="0"/>
                <a:cs typeface="Arial" pitchFamily="34" charset="0"/>
              </a:rPr>
              <a:t> L4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unc-25 L4_0.02_50%'!$B$104</c:f>
              <c:strCache>
                <c:ptCount val="1"/>
                <c:pt idx="0">
                  <c:v>unc-25_L4_06001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B$105:$B$135</c:f>
              <c:numCache>
                <c:formatCode>General</c:formatCode>
                <c:ptCount val="31"/>
                <c:pt idx="1">
                  <c:v>3.4482758620689717E-2</c:v>
                </c:pt>
                <c:pt idx="2">
                  <c:v>1.4146772767462405E-2</c:v>
                </c:pt>
                <c:pt idx="3">
                  <c:v>2.0335985853227202E-2</c:v>
                </c:pt>
                <c:pt idx="4">
                  <c:v>1.9451812555260801E-2</c:v>
                </c:pt>
                <c:pt idx="5">
                  <c:v>1.5030946065428798E-2</c:v>
                </c:pt>
                <c:pt idx="6">
                  <c:v>1.4146772767462405E-2</c:v>
                </c:pt>
                <c:pt idx="7">
                  <c:v>1.2378426171529594E-2</c:v>
                </c:pt>
                <c:pt idx="8">
                  <c:v>1.3262599469496004E-2</c:v>
                </c:pt>
                <c:pt idx="9">
                  <c:v>1.7683465959328001E-2</c:v>
                </c:pt>
                <c:pt idx="10">
                  <c:v>2.3872679045092798E-2</c:v>
                </c:pt>
                <c:pt idx="11">
                  <c:v>3.2714412024756917E-2</c:v>
                </c:pt>
                <c:pt idx="12">
                  <c:v>5.4818744473916915E-2</c:v>
                </c:pt>
                <c:pt idx="13">
                  <c:v>8.04597701149425E-2</c:v>
                </c:pt>
                <c:pt idx="14">
                  <c:v>9.7259062776304236E-2</c:v>
                </c:pt>
                <c:pt idx="15">
                  <c:v>0.11582670203359906</c:v>
                </c:pt>
                <c:pt idx="16">
                  <c:v>9.6374889478337805E-2</c:v>
                </c:pt>
                <c:pt idx="17">
                  <c:v>7.7807250221043345E-2</c:v>
                </c:pt>
                <c:pt idx="18">
                  <c:v>6.8081343943412906E-2</c:v>
                </c:pt>
                <c:pt idx="19">
                  <c:v>5.1282051282051301E-2</c:v>
                </c:pt>
                <c:pt idx="20">
                  <c:v>4.5092838196286504E-2</c:v>
                </c:pt>
                <c:pt idx="21">
                  <c:v>2.1220159151193598E-2</c:v>
                </c:pt>
                <c:pt idx="22">
                  <c:v>1.8567639257294401E-2</c:v>
                </c:pt>
                <c:pt idx="23">
                  <c:v>1.1494252873563199E-2</c:v>
                </c:pt>
                <c:pt idx="24">
                  <c:v>9.7259062776304233E-3</c:v>
                </c:pt>
                <c:pt idx="25">
                  <c:v>2.6525198938991998E-3</c:v>
                </c:pt>
                <c:pt idx="26">
                  <c:v>1.7683465959328008E-3</c:v>
                </c:pt>
                <c:pt idx="27">
                  <c:v>2.6525198938991998E-3</c:v>
                </c:pt>
                <c:pt idx="28">
                  <c:v>0</c:v>
                </c:pt>
                <c:pt idx="29">
                  <c:v>8.841732979664018E-4</c:v>
                </c:pt>
                <c:pt idx="30">
                  <c:v>8.841732979664018E-4</c:v>
                </c:pt>
              </c:numCache>
            </c:numRef>
          </c:val>
        </c:ser>
        <c:ser>
          <c:idx val="1"/>
          <c:order val="1"/>
          <c:tx>
            <c:strRef>
              <c:f>'unc-25 L4_0.02_50%'!$C$104</c:f>
              <c:strCache>
                <c:ptCount val="1"/>
                <c:pt idx="0">
                  <c:v>unc-25_L4_06002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C$105:$C$135</c:f>
              <c:numCache>
                <c:formatCode>General</c:formatCode>
                <c:ptCount val="31"/>
                <c:pt idx="1">
                  <c:v>2.4008350730688889E-2</c:v>
                </c:pt>
                <c:pt idx="2">
                  <c:v>2.6096033402922807E-2</c:v>
                </c:pt>
                <c:pt idx="3">
                  <c:v>1.4613778705636701E-2</c:v>
                </c:pt>
                <c:pt idx="4">
                  <c:v>1.4613778705636701E-2</c:v>
                </c:pt>
                <c:pt idx="5">
                  <c:v>1.1482254697286009E-2</c:v>
                </c:pt>
                <c:pt idx="6">
                  <c:v>1.6701461377870607E-2</c:v>
                </c:pt>
                <c:pt idx="7">
                  <c:v>1.3569937369519801E-2</c:v>
                </c:pt>
                <c:pt idx="8">
                  <c:v>1.5657620041753702E-2</c:v>
                </c:pt>
                <c:pt idx="9">
                  <c:v>1.87891440501044E-2</c:v>
                </c:pt>
                <c:pt idx="10">
                  <c:v>2.5052192066805808E-2</c:v>
                </c:pt>
                <c:pt idx="11">
                  <c:v>3.4446764091857998E-2</c:v>
                </c:pt>
                <c:pt idx="12">
                  <c:v>6.4718162839248444E-2</c:v>
                </c:pt>
                <c:pt idx="13">
                  <c:v>8.3507306889352872E-2</c:v>
                </c:pt>
                <c:pt idx="14">
                  <c:v>7.6200417536534421E-2</c:v>
                </c:pt>
                <c:pt idx="15">
                  <c:v>8.8726513569937451E-2</c:v>
                </c:pt>
                <c:pt idx="16">
                  <c:v>8.3507306889352872E-2</c:v>
                </c:pt>
                <c:pt idx="17">
                  <c:v>6.7849686847599233E-2</c:v>
                </c:pt>
                <c:pt idx="18">
                  <c:v>8.0375782881002097E-2</c:v>
                </c:pt>
                <c:pt idx="19">
                  <c:v>5.7411273486430117E-2</c:v>
                </c:pt>
                <c:pt idx="20">
                  <c:v>4.0709812108559479E-2</c:v>
                </c:pt>
                <c:pt idx="21">
                  <c:v>2.9227557411273513E-2</c:v>
                </c:pt>
                <c:pt idx="22">
                  <c:v>2.9227557411273513E-2</c:v>
                </c:pt>
                <c:pt idx="23">
                  <c:v>1.6701461377870607E-2</c:v>
                </c:pt>
                <c:pt idx="24">
                  <c:v>1.1482254697286009E-2</c:v>
                </c:pt>
                <c:pt idx="25">
                  <c:v>6.2630480167014599E-3</c:v>
                </c:pt>
                <c:pt idx="26">
                  <c:v>3.1315240083507321E-3</c:v>
                </c:pt>
                <c:pt idx="27">
                  <c:v>1.0438413361169101E-3</c:v>
                </c:pt>
                <c:pt idx="28">
                  <c:v>1.0438413361169101E-3</c:v>
                </c:pt>
                <c:pt idx="29">
                  <c:v>1.0438413361169101E-3</c:v>
                </c:pt>
                <c:pt idx="30">
                  <c:v>2.0876826722338207E-3</c:v>
                </c:pt>
              </c:numCache>
            </c:numRef>
          </c:val>
        </c:ser>
        <c:ser>
          <c:idx val="2"/>
          <c:order val="2"/>
          <c:tx>
            <c:strRef>
              <c:f>'unc-25 L4_0.02_50%'!$D$104</c:f>
              <c:strCache>
                <c:ptCount val="1"/>
                <c:pt idx="0">
                  <c:v>unc-25_L4_06003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D$105:$D$135</c:f>
              <c:numCache>
                <c:formatCode>General</c:formatCode>
                <c:ptCount val="31"/>
                <c:pt idx="1">
                  <c:v>4.3151969981238304E-2</c:v>
                </c:pt>
                <c:pt idx="2">
                  <c:v>2.626641651031901E-2</c:v>
                </c:pt>
                <c:pt idx="3">
                  <c:v>1.1257035647279505E-2</c:v>
                </c:pt>
                <c:pt idx="4">
                  <c:v>1.1257035647279505E-2</c:v>
                </c:pt>
                <c:pt idx="5">
                  <c:v>9.3808630393996343E-3</c:v>
                </c:pt>
                <c:pt idx="6">
                  <c:v>1.1257035647279505E-2</c:v>
                </c:pt>
                <c:pt idx="7">
                  <c:v>5.6285178236397697E-3</c:v>
                </c:pt>
                <c:pt idx="8">
                  <c:v>7.5046904315197033E-3</c:v>
                </c:pt>
                <c:pt idx="9">
                  <c:v>7.5046904315197033E-3</c:v>
                </c:pt>
                <c:pt idx="10">
                  <c:v>1.31332082551595E-2</c:v>
                </c:pt>
                <c:pt idx="11">
                  <c:v>2.2514071294559092E-2</c:v>
                </c:pt>
                <c:pt idx="12">
                  <c:v>4.6904315196998086E-2</c:v>
                </c:pt>
                <c:pt idx="13">
                  <c:v>5.6285178236397684E-2</c:v>
                </c:pt>
                <c:pt idx="14">
                  <c:v>6.3789868667917374E-2</c:v>
                </c:pt>
                <c:pt idx="15">
                  <c:v>8.8180112570356503E-2</c:v>
                </c:pt>
                <c:pt idx="16">
                  <c:v>7.3170731707317097E-2</c:v>
                </c:pt>
                <c:pt idx="17">
                  <c:v>8.0675422138836883E-2</c:v>
                </c:pt>
                <c:pt idx="18">
                  <c:v>7.3170731707317097E-2</c:v>
                </c:pt>
                <c:pt idx="19">
                  <c:v>5.8161350844277704E-2</c:v>
                </c:pt>
                <c:pt idx="20">
                  <c:v>5.8161350844277704E-2</c:v>
                </c:pt>
                <c:pt idx="21">
                  <c:v>4.5028142589118178E-2</c:v>
                </c:pt>
                <c:pt idx="22">
                  <c:v>2.2514071294559092E-2</c:v>
                </c:pt>
                <c:pt idx="23">
                  <c:v>1.87617260787993E-2</c:v>
                </c:pt>
                <c:pt idx="24">
                  <c:v>1.31332082551595E-2</c:v>
                </c:pt>
                <c:pt idx="25">
                  <c:v>1.87617260787993E-2</c:v>
                </c:pt>
                <c:pt idx="26">
                  <c:v>7.5046904315197033E-3</c:v>
                </c:pt>
                <c:pt idx="27">
                  <c:v>7.5046904315197033E-3</c:v>
                </c:pt>
                <c:pt idx="28">
                  <c:v>1.8761726078799204E-3</c:v>
                </c:pt>
                <c:pt idx="29">
                  <c:v>1.8761726078799204E-3</c:v>
                </c:pt>
                <c:pt idx="30">
                  <c:v>5.6285178236397697E-3</c:v>
                </c:pt>
              </c:numCache>
            </c:numRef>
          </c:val>
        </c:ser>
        <c:ser>
          <c:idx val="3"/>
          <c:order val="3"/>
          <c:tx>
            <c:strRef>
              <c:f>'unc-25 L4_0.02_50%'!$E$104</c:f>
              <c:strCache>
                <c:ptCount val="1"/>
                <c:pt idx="0">
                  <c:v>unc-25_L4_06004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E$105:$E$135</c:f>
              <c:numCache>
                <c:formatCode>General</c:formatCode>
                <c:ptCount val="31"/>
                <c:pt idx="1">
                  <c:v>1.6560509554140106E-2</c:v>
                </c:pt>
                <c:pt idx="2">
                  <c:v>1.6560509554140106E-2</c:v>
                </c:pt>
                <c:pt idx="3">
                  <c:v>1.5286624203821701E-2</c:v>
                </c:pt>
                <c:pt idx="4">
                  <c:v>6.3694267515923622E-3</c:v>
                </c:pt>
                <c:pt idx="5">
                  <c:v>1.2738853503184698E-2</c:v>
                </c:pt>
                <c:pt idx="6">
                  <c:v>3.821656050955411E-3</c:v>
                </c:pt>
                <c:pt idx="7">
                  <c:v>5.095541401273892E-3</c:v>
                </c:pt>
                <c:pt idx="8">
                  <c:v>6.3694267515923622E-3</c:v>
                </c:pt>
                <c:pt idx="9">
                  <c:v>8.9171974522293061E-3</c:v>
                </c:pt>
                <c:pt idx="10">
                  <c:v>7.6433121019108341E-3</c:v>
                </c:pt>
                <c:pt idx="11">
                  <c:v>1.6560509554140106E-2</c:v>
                </c:pt>
                <c:pt idx="12">
                  <c:v>2.9299363057324817E-2</c:v>
                </c:pt>
                <c:pt idx="13">
                  <c:v>5.0955414012738919E-2</c:v>
                </c:pt>
                <c:pt idx="14">
                  <c:v>8.2802547770700605E-2</c:v>
                </c:pt>
                <c:pt idx="15">
                  <c:v>0.118471337579618</c:v>
                </c:pt>
                <c:pt idx="16">
                  <c:v>0.12229299363057303</c:v>
                </c:pt>
                <c:pt idx="17">
                  <c:v>0.11337579617834398</c:v>
                </c:pt>
                <c:pt idx="18">
                  <c:v>8.7898089171974503E-2</c:v>
                </c:pt>
                <c:pt idx="19">
                  <c:v>6.6242038216560495E-2</c:v>
                </c:pt>
                <c:pt idx="20">
                  <c:v>4.7133757961783415E-2</c:v>
                </c:pt>
                <c:pt idx="21">
                  <c:v>2.4203821656051002E-2</c:v>
                </c:pt>
                <c:pt idx="22">
                  <c:v>2.9299363057324817E-2</c:v>
                </c:pt>
                <c:pt idx="23">
                  <c:v>1.9108280254777107E-2</c:v>
                </c:pt>
                <c:pt idx="24">
                  <c:v>1.5286624203821701E-2</c:v>
                </c:pt>
                <c:pt idx="25">
                  <c:v>7.6433121019108341E-3</c:v>
                </c:pt>
                <c:pt idx="26">
                  <c:v>1.0191082802547798E-2</c:v>
                </c:pt>
                <c:pt idx="27">
                  <c:v>3.821656050955411E-3</c:v>
                </c:pt>
                <c:pt idx="28">
                  <c:v>2.5477707006369421E-3</c:v>
                </c:pt>
                <c:pt idx="29">
                  <c:v>0</c:v>
                </c:pt>
                <c:pt idx="30">
                  <c:v>1.27388535031847E-3</c:v>
                </c:pt>
              </c:numCache>
            </c:numRef>
          </c:val>
        </c:ser>
        <c:ser>
          <c:idx val="4"/>
          <c:order val="4"/>
          <c:tx>
            <c:strRef>
              <c:f>'unc-25 L4_0.02_50%'!$F$104</c:f>
              <c:strCache>
                <c:ptCount val="1"/>
                <c:pt idx="0">
                  <c:v>unc-25_L4_06005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F$105:$F$135</c:f>
              <c:numCache>
                <c:formatCode>General</c:formatCode>
                <c:ptCount val="31"/>
              </c:numCache>
            </c:numRef>
          </c:val>
        </c:ser>
        <c:ser>
          <c:idx val="5"/>
          <c:order val="5"/>
          <c:tx>
            <c:strRef>
              <c:f>'unc-25 L4_0.02_50%'!$G$104</c:f>
              <c:strCache>
                <c:ptCount val="1"/>
                <c:pt idx="0">
                  <c:v>unc-25_L4_06006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G$105:$G$135</c:f>
              <c:numCache>
                <c:formatCode>General</c:formatCode>
                <c:ptCount val="31"/>
              </c:numCache>
            </c:numRef>
          </c:val>
        </c:ser>
        <c:ser>
          <c:idx val="6"/>
          <c:order val="6"/>
          <c:tx>
            <c:strRef>
              <c:f>'unc-25 L4_0.02_50%'!$H$104</c:f>
              <c:strCache>
                <c:ptCount val="1"/>
                <c:pt idx="0">
                  <c:v>unc-25_L4_06007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H$105:$H$135</c:f>
              <c:numCache>
                <c:formatCode>General</c:formatCode>
                <c:ptCount val="31"/>
                <c:pt idx="1">
                  <c:v>2.5000000000000001E-2</c:v>
                </c:pt>
                <c:pt idx="2">
                  <c:v>1.44736842105263E-2</c:v>
                </c:pt>
                <c:pt idx="3">
                  <c:v>2.5000000000000001E-2</c:v>
                </c:pt>
                <c:pt idx="4">
                  <c:v>1.7105263157894693E-2</c:v>
                </c:pt>
                <c:pt idx="5">
                  <c:v>6.5789473684210514E-3</c:v>
                </c:pt>
                <c:pt idx="6">
                  <c:v>6.5789473684210514E-3</c:v>
                </c:pt>
                <c:pt idx="7">
                  <c:v>1.3157894736842101E-2</c:v>
                </c:pt>
                <c:pt idx="8">
                  <c:v>1.5789473684210506E-2</c:v>
                </c:pt>
                <c:pt idx="9">
                  <c:v>3.9473684210526317E-3</c:v>
                </c:pt>
                <c:pt idx="10">
                  <c:v>1.3157894736842101E-2</c:v>
                </c:pt>
                <c:pt idx="11">
                  <c:v>2.1052631578947399E-2</c:v>
                </c:pt>
                <c:pt idx="12">
                  <c:v>2.763157894736841E-2</c:v>
                </c:pt>
                <c:pt idx="13">
                  <c:v>0.05</c:v>
                </c:pt>
                <c:pt idx="14">
                  <c:v>7.6315789473684198E-2</c:v>
                </c:pt>
                <c:pt idx="15">
                  <c:v>9.0789473684210503E-2</c:v>
                </c:pt>
                <c:pt idx="16">
                  <c:v>9.0789473684210503E-2</c:v>
                </c:pt>
                <c:pt idx="17">
                  <c:v>0.10921052631578899</c:v>
                </c:pt>
                <c:pt idx="18">
                  <c:v>9.4736842105263286E-2</c:v>
                </c:pt>
                <c:pt idx="19">
                  <c:v>7.1052631578947423E-2</c:v>
                </c:pt>
                <c:pt idx="20">
                  <c:v>5.9210526315789512E-2</c:v>
                </c:pt>
                <c:pt idx="21">
                  <c:v>4.7368421052631671E-2</c:v>
                </c:pt>
                <c:pt idx="22">
                  <c:v>2.1052631578947399E-2</c:v>
                </c:pt>
                <c:pt idx="23">
                  <c:v>1.7105263157894693E-2</c:v>
                </c:pt>
                <c:pt idx="24">
                  <c:v>1.5789473684210506E-2</c:v>
                </c:pt>
                <c:pt idx="25">
                  <c:v>6.5789473684210514E-3</c:v>
                </c:pt>
                <c:pt idx="26">
                  <c:v>1.3157894736842101E-2</c:v>
                </c:pt>
                <c:pt idx="27">
                  <c:v>7.8947368421052565E-3</c:v>
                </c:pt>
                <c:pt idx="28">
                  <c:v>5.263157894736842E-3</c:v>
                </c:pt>
                <c:pt idx="29">
                  <c:v>3.9473684210526317E-3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unc-25 L4_0.02_50%'!$I$104</c:f>
              <c:strCache>
                <c:ptCount val="1"/>
                <c:pt idx="0">
                  <c:v>unc-25_L4_06008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I$105:$I$135</c:f>
              <c:numCache>
                <c:formatCode>General</c:formatCode>
                <c:ptCount val="31"/>
                <c:pt idx="1">
                  <c:v>3.3333333333333298E-2</c:v>
                </c:pt>
                <c:pt idx="2">
                  <c:v>3.7037037037037014E-2</c:v>
                </c:pt>
                <c:pt idx="3">
                  <c:v>1.48148148148148E-2</c:v>
                </c:pt>
                <c:pt idx="4">
                  <c:v>7.4074074074074103E-3</c:v>
                </c:pt>
                <c:pt idx="5">
                  <c:v>1.1111111111111101E-2</c:v>
                </c:pt>
                <c:pt idx="6">
                  <c:v>1.1111111111111101E-2</c:v>
                </c:pt>
                <c:pt idx="7">
                  <c:v>7.4074074074074103E-3</c:v>
                </c:pt>
                <c:pt idx="8">
                  <c:v>3.7037037037037017E-3</c:v>
                </c:pt>
                <c:pt idx="9">
                  <c:v>0</c:v>
                </c:pt>
                <c:pt idx="10">
                  <c:v>1.1111111111111101E-2</c:v>
                </c:pt>
                <c:pt idx="11">
                  <c:v>7.4074074074074103E-3</c:v>
                </c:pt>
                <c:pt idx="12">
                  <c:v>2.962962962962961E-2</c:v>
                </c:pt>
                <c:pt idx="13">
                  <c:v>1.1111111111111101E-2</c:v>
                </c:pt>
                <c:pt idx="14">
                  <c:v>5.9259259259259296E-2</c:v>
                </c:pt>
                <c:pt idx="15">
                  <c:v>6.2962962962962998E-2</c:v>
                </c:pt>
                <c:pt idx="16">
                  <c:v>7.7777777777777807E-2</c:v>
                </c:pt>
                <c:pt idx="17">
                  <c:v>0.10740740740740698</c:v>
                </c:pt>
                <c:pt idx="18">
                  <c:v>0.10370370370370405</c:v>
                </c:pt>
                <c:pt idx="19">
                  <c:v>5.9259259259259296E-2</c:v>
                </c:pt>
                <c:pt idx="20">
                  <c:v>9.2592592592592671E-2</c:v>
                </c:pt>
                <c:pt idx="21">
                  <c:v>4.0740740740740702E-2</c:v>
                </c:pt>
                <c:pt idx="22">
                  <c:v>1.48148148148148E-2</c:v>
                </c:pt>
                <c:pt idx="23">
                  <c:v>1.48148148148148E-2</c:v>
                </c:pt>
                <c:pt idx="24">
                  <c:v>2.962962962962961E-2</c:v>
                </c:pt>
                <c:pt idx="25">
                  <c:v>1.1111111111111101E-2</c:v>
                </c:pt>
                <c:pt idx="26">
                  <c:v>2.5925925925925915E-2</c:v>
                </c:pt>
                <c:pt idx="27">
                  <c:v>3.7037037037037017E-3</c:v>
                </c:pt>
                <c:pt idx="28">
                  <c:v>7.4074074074074103E-3</c:v>
                </c:pt>
                <c:pt idx="29">
                  <c:v>3.7037037037037017E-3</c:v>
                </c:pt>
                <c:pt idx="30">
                  <c:v>1.1111111111111101E-2</c:v>
                </c:pt>
              </c:numCache>
            </c:numRef>
          </c:val>
        </c:ser>
        <c:ser>
          <c:idx val="8"/>
          <c:order val="8"/>
          <c:tx>
            <c:strRef>
              <c:f>'unc-25 L4_0.02_50%'!$J$104</c:f>
              <c:strCache>
                <c:ptCount val="1"/>
                <c:pt idx="0">
                  <c:v>unc-25_L4_06009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J$105:$J$135</c:f>
              <c:numCache>
                <c:formatCode>General</c:formatCode>
                <c:ptCount val="31"/>
                <c:pt idx="1">
                  <c:v>0.10344827586206902</c:v>
                </c:pt>
                <c:pt idx="2">
                  <c:v>5.1724137931034517E-2</c:v>
                </c:pt>
                <c:pt idx="3">
                  <c:v>1.7241379310344803E-2</c:v>
                </c:pt>
                <c:pt idx="4">
                  <c:v>3.4482758620689717E-2</c:v>
                </c:pt>
                <c:pt idx="5">
                  <c:v>5.1724137931034517E-2</c:v>
                </c:pt>
                <c:pt idx="6">
                  <c:v>3.4482758620689717E-2</c:v>
                </c:pt>
                <c:pt idx="7">
                  <c:v>5.1724137931034517E-2</c:v>
                </c:pt>
                <c:pt idx="8">
                  <c:v>1.7241379310344803E-2</c:v>
                </c:pt>
                <c:pt idx="9">
                  <c:v>1.7241379310344803E-2</c:v>
                </c:pt>
                <c:pt idx="10">
                  <c:v>0</c:v>
                </c:pt>
                <c:pt idx="11">
                  <c:v>3.4482758620689717E-2</c:v>
                </c:pt>
                <c:pt idx="12">
                  <c:v>0</c:v>
                </c:pt>
                <c:pt idx="13">
                  <c:v>5.1724137931034517E-2</c:v>
                </c:pt>
                <c:pt idx="14">
                  <c:v>1.7241379310344803E-2</c:v>
                </c:pt>
                <c:pt idx="15">
                  <c:v>1.7241379310344803E-2</c:v>
                </c:pt>
                <c:pt idx="16">
                  <c:v>0</c:v>
                </c:pt>
                <c:pt idx="17">
                  <c:v>0</c:v>
                </c:pt>
                <c:pt idx="18">
                  <c:v>1.7241379310344803E-2</c:v>
                </c:pt>
                <c:pt idx="19">
                  <c:v>5.1724137931034517E-2</c:v>
                </c:pt>
                <c:pt idx="20">
                  <c:v>3.4482758620689717E-2</c:v>
                </c:pt>
                <c:pt idx="21">
                  <c:v>1.7241379310344803E-2</c:v>
                </c:pt>
                <c:pt idx="22">
                  <c:v>0</c:v>
                </c:pt>
                <c:pt idx="23">
                  <c:v>0</c:v>
                </c:pt>
                <c:pt idx="24">
                  <c:v>1.7241379310344803E-2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3.4482758620689717E-2</c:v>
                </c:pt>
                <c:pt idx="29">
                  <c:v>0</c:v>
                </c:pt>
                <c:pt idx="30">
                  <c:v>1.7241379310344803E-2</c:v>
                </c:pt>
              </c:numCache>
            </c:numRef>
          </c:val>
        </c:ser>
        <c:ser>
          <c:idx val="9"/>
          <c:order val="9"/>
          <c:tx>
            <c:strRef>
              <c:f>'unc-25 L4_0.02_50%'!$K$104</c:f>
              <c:strCache>
                <c:ptCount val="1"/>
                <c:pt idx="0">
                  <c:v>unc-25_L4_06011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K$105:$K$135</c:f>
              <c:numCache>
                <c:formatCode>General</c:formatCode>
                <c:ptCount val="31"/>
                <c:pt idx="1">
                  <c:v>1.9955654101995603E-2</c:v>
                </c:pt>
                <c:pt idx="2">
                  <c:v>3.2150776053215098E-2</c:v>
                </c:pt>
                <c:pt idx="3">
                  <c:v>1.4412416851441194E-2</c:v>
                </c:pt>
                <c:pt idx="4">
                  <c:v>1.3303769401330405E-2</c:v>
                </c:pt>
                <c:pt idx="5">
                  <c:v>8.8691796008869266E-3</c:v>
                </c:pt>
                <c:pt idx="6">
                  <c:v>1.1086474501108601E-2</c:v>
                </c:pt>
                <c:pt idx="7">
                  <c:v>1.1086474501108601E-2</c:v>
                </c:pt>
                <c:pt idx="8">
                  <c:v>1.4412416851441194E-2</c:v>
                </c:pt>
                <c:pt idx="9">
                  <c:v>2.5498891352549902E-2</c:v>
                </c:pt>
                <c:pt idx="10">
                  <c:v>2.6607538802660809E-2</c:v>
                </c:pt>
                <c:pt idx="11">
                  <c:v>4.1019955654101999E-2</c:v>
                </c:pt>
                <c:pt idx="12">
                  <c:v>6.4301552106430196E-2</c:v>
                </c:pt>
                <c:pt idx="13">
                  <c:v>8.5365853658536633E-2</c:v>
                </c:pt>
                <c:pt idx="14">
                  <c:v>7.3170731707317097E-2</c:v>
                </c:pt>
                <c:pt idx="15">
                  <c:v>9.9778270509977784E-2</c:v>
                </c:pt>
                <c:pt idx="16">
                  <c:v>9.866962305986704E-2</c:v>
                </c:pt>
                <c:pt idx="17">
                  <c:v>6.9844789356984502E-2</c:v>
                </c:pt>
                <c:pt idx="18">
                  <c:v>6.9844789356984502E-2</c:v>
                </c:pt>
                <c:pt idx="19">
                  <c:v>4.8780487804878127E-2</c:v>
                </c:pt>
                <c:pt idx="20">
                  <c:v>3.6585365853658514E-2</c:v>
                </c:pt>
                <c:pt idx="21">
                  <c:v>2.88248337028825E-2</c:v>
                </c:pt>
                <c:pt idx="22">
                  <c:v>2.2172949002217314E-2</c:v>
                </c:pt>
                <c:pt idx="23">
                  <c:v>1.6629711751663008E-2</c:v>
                </c:pt>
                <c:pt idx="24">
                  <c:v>1.3303769401330405E-2</c:v>
                </c:pt>
                <c:pt idx="25">
                  <c:v>6.6518847006651902E-3</c:v>
                </c:pt>
                <c:pt idx="26">
                  <c:v>2.2172949002217312E-3</c:v>
                </c:pt>
                <c:pt idx="27">
                  <c:v>9.977827050997784E-3</c:v>
                </c:pt>
                <c:pt idx="28">
                  <c:v>0</c:v>
                </c:pt>
                <c:pt idx="29">
                  <c:v>1.1086474501108604E-3</c:v>
                </c:pt>
                <c:pt idx="3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unc-25 L4_0.02_50%'!$L$104</c:f>
              <c:strCache>
                <c:ptCount val="1"/>
                <c:pt idx="0">
                  <c:v>unc-25_L4_06012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L$105:$L$135</c:f>
              <c:numCache>
                <c:formatCode>General</c:formatCode>
                <c:ptCount val="31"/>
                <c:pt idx="1">
                  <c:v>2.567394094993581E-2</c:v>
                </c:pt>
                <c:pt idx="2">
                  <c:v>1.9255455712451908E-2</c:v>
                </c:pt>
                <c:pt idx="3">
                  <c:v>2.3106546854942189E-2</c:v>
                </c:pt>
                <c:pt idx="4">
                  <c:v>2.0539152759948699E-2</c:v>
                </c:pt>
                <c:pt idx="5">
                  <c:v>1.6688061617458311E-2</c:v>
                </c:pt>
                <c:pt idx="6">
                  <c:v>1.15532734274711E-2</c:v>
                </c:pt>
                <c:pt idx="7">
                  <c:v>7.7021822849807423E-3</c:v>
                </c:pt>
                <c:pt idx="8">
                  <c:v>1.0269576379974299E-2</c:v>
                </c:pt>
                <c:pt idx="9">
                  <c:v>1.0269576379974299E-2</c:v>
                </c:pt>
                <c:pt idx="10">
                  <c:v>2.3106546854942189E-2</c:v>
                </c:pt>
                <c:pt idx="11">
                  <c:v>5.7766367137355626E-2</c:v>
                </c:pt>
                <c:pt idx="12">
                  <c:v>7.1887034659820326E-2</c:v>
                </c:pt>
                <c:pt idx="13">
                  <c:v>9.6277278562259344E-2</c:v>
                </c:pt>
                <c:pt idx="14">
                  <c:v>0.101412066752246</c:v>
                </c:pt>
                <c:pt idx="15">
                  <c:v>0.10654685494223404</c:v>
                </c:pt>
                <c:pt idx="16">
                  <c:v>9.8844672657252983E-2</c:v>
                </c:pt>
                <c:pt idx="17">
                  <c:v>6.4184852374839479E-2</c:v>
                </c:pt>
                <c:pt idx="18">
                  <c:v>7.1887034659820326E-2</c:v>
                </c:pt>
                <c:pt idx="19">
                  <c:v>4.23620025673941E-2</c:v>
                </c:pt>
                <c:pt idx="20">
                  <c:v>3.4659820282413413E-2</c:v>
                </c:pt>
                <c:pt idx="21">
                  <c:v>2.0539152759948699E-2</c:v>
                </c:pt>
                <c:pt idx="22">
                  <c:v>1.2836970474967901E-2</c:v>
                </c:pt>
                <c:pt idx="23">
                  <c:v>1.0269576379974299E-2</c:v>
                </c:pt>
                <c:pt idx="24">
                  <c:v>5.1347881899871635E-3</c:v>
                </c:pt>
                <c:pt idx="25">
                  <c:v>5.1347881899871635E-3</c:v>
                </c:pt>
                <c:pt idx="26">
                  <c:v>1.2836970474967904E-3</c:v>
                </c:pt>
                <c:pt idx="27">
                  <c:v>0</c:v>
                </c:pt>
                <c:pt idx="28">
                  <c:v>2.5673940949935818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unc-25 L4_0.02_50%'!$M$104</c:f>
              <c:strCache>
                <c:ptCount val="1"/>
                <c:pt idx="0">
                  <c:v>unc-25_L4_06013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M$105:$M$135</c:f>
              <c:numCache>
                <c:formatCode>General</c:formatCode>
                <c:ptCount val="31"/>
                <c:pt idx="1">
                  <c:v>2.7131782945736406E-2</c:v>
                </c:pt>
                <c:pt idx="2">
                  <c:v>1.7441860465116307E-2</c:v>
                </c:pt>
                <c:pt idx="3">
                  <c:v>1.9379844961240299E-2</c:v>
                </c:pt>
                <c:pt idx="4">
                  <c:v>1.7441860465116307E-2</c:v>
                </c:pt>
                <c:pt idx="5">
                  <c:v>1.3565891472868205E-2</c:v>
                </c:pt>
                <c:pt idx="6">
                  <c:v>1.1627906976744195E-2</c:v>
                </c:pt>
                <c:pt idx="7">
                  <c:v>2.7131782945736406E-2</c:v>
                </c:pt>
                <c:pt idx="8">
                  <c:v>2.131782945736431E-2</c:v>
                </c:pt>
                <c:pt idx="9">
                  <c:v>9.6899224806201497E-3</c:v>
                </c:pt>
                <c:pt idx="10">
                  <c:v>1.9379844961240299E-2</c:v>
                </c:pt>
                <c:pt idx="11">
                  <c:v>2.131782945736431E-2</c:v>
                </c:pt>
                <c:pt idx="12">
                  <c:v>5.6201550387596881E-2</c:v>
                </c:pt>
                <c:pt idx="13">
                  <c:v>5.6201550387596881E-2</c:v>
                </c:pt>
                <c:pt idx="14">
                  <c:v>9.3023255813953501E-2</c:v>
                </c:pt>
                <c:pt idx="15">
                  <c:v>8.1395348837209336E-2</c:v>
                </c:pt>
                <c:pt idx="16">
                  <c:v>0.12015503875969002</c:v>
                </c:pt>
                <c:pt idx="17">
                  <c:v>6.7829457364341122E-2</c:v>
                </c:pt>
                <c:pt idx="18">
                  <c:v>5.6201550387596881E-2</c:v>
                </c:pt>
                <c:pt idx="19">
                  <c:v>5.4263565891472902E-2</c:v>
                </c:pt>
                <c:pt idx="20">
                  <c:v>3.4883720930232599E-2</c:v>
                </c:pt>
                <c:pt idx="21">
                  <c:v>3.1007751937984492E-2</c:v>
                </c:pt>
                <c:pt idx="22">
                  <c:v>2.5193798449612406E-2</c:v>
                </c:pt>
                <c:pt idx="23">
                  <c:v>9.6899224806201497E-3</c:v>
                </c:pt>
                <c:pt idx="24">
                  <c:v>3.4883720930232599E-2</c:v>
                </c:pt>
                <c:pt idx="25">
                  <c:v>9.6899224806201497E-3</c:v>
                </c:pt>
                <c:pt idx="26">
                  <c:v>5.8139534883720921E-3</c:v>
                </c:pt>
                <c:pt idx="27">
                  <c:v>1.9379844961240301E-3</c:v>
                </c:pt>
                <c:pt idx="28">
                  <c:v>7.7519379844961231E-3</c:v>
                </c:pt>
                <c:pt idx="29">
                  <c:v>3.8759689922480598E-3</c:v>
                </c:pt>
                <c:pt idx="3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unc-25 L4_0.02_50%'!$N$104</c:f>
              <c:strCache>
                <c:ptCount val="1"/>
                <c:pt idx="0">
                  <c:v>unc-25_L4_06014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N$105:$N$135</c:f>
              <c:numCache>
                <c:formatCode>General</c:formatCode>
                <c:ptCount val="31"/>
                <c:pt idx="1">
                  <c:v>3.2941176470588217E-2</c:v>
                </c:pt>
                <c:pt idx="2">
                  <c:v>3.176470588235291E-2</c:v>
                </c:pt>
                <c:pt idx="3">
                  <c:v>2.1176470588235314E-2</c:v>
                </c:pt>
                <c:pt idx="4">
                  <c:v>2.7058823529411809E-2</c:v>
                </c:pt>
                <c:pt idx="5">
                  <c:v>1.2941176470588204E-2</c:v>
                </c:pt>
                <c:pt idx="6">
                  <c:v>1.1764705882352905E-2</c:v>
                </c:pt>
                <c:pt idx="7">
                  <c:v>9.4117647058823539E-3</c:v>
                </c:pt>
                <c:pt idx="8">
                  <c:v>1.8823529411764711E-2</c:v>
                </c:pt>
                <c:pt idx="9">
                  <c:v>1.2941176470588204E-2</c:v>
                </c:pt>
                <c:pt idx="10">
                  <c:v>1.5294117647058804E-2</c:v>
                </c:pt>
                <c:pt idx="11">
                  <c:v>2.3529411764705889E-2</c:v>
                </c:pt>
                <c:pt idx="12">
                  <c:v>2.0000000000000007E-2</c:v>
                </c:pt>
                <c:pt idx="13">
                  <c:v>5.1764705882352886E-2</c:v>
                </c:pt>
                <c:pt idx="14">
                  <c:v>7.0588235294117604E-2</c:v>
                </c:pt>
                <c:pt idx="15">
                  <c:v>8.5882352941176507E-2</c:v>
                </c:pt>
                <c:pt idx="16">
                  <c:v>0.10588235294117603</c:v>
                </c:pt>
                <c:pt idx="17">
                  <c:v>8.5882352941176507E-2</c:v>
                </c:pt>
                <c:pt idx="18">
                  <c:v>7.5294117647058803E-2</c:v>
                </c:pt>
                <c:pt idx="19">
                  <c:v>8.0000000000000029E-2</c:v>
                </c:pt>
                <c:pt idx="20">
                  <c:v>4.588235294117652E-2</c:v>
                </c:pt>
                <c:pt idx="21">
                  <c:v>3.4117647058823523E-2</c:v>
                </c:pt>
                <c:pt idx="22">
                  <c:v>2.9411764705882398E-2</c:v>
                </c:pt>
                <c:pt idx="23">
                  <c:v>1.5294117647058804E-2</c:v>
                </c:pt>
                <c:pt idx="24">
                  <c:v>1.4117647058823493E-2</c:v>
                </c:pt>
                <c:pt idx="25">
                  <c:v>1.0588235294117607E-2</c:v>
                </c:pt>
                <c:pt idx="26">
                  <c:v>4.7058823529411821E-3</c:v>
                </c:pt>
                <c:pt idx="27">
                  <c:v>7.0588235294117719E-3</c:v>
                </c:pt>
                <c:pt idx="28">
                  <c:v>1.1764705882352905E-3</c:v>
                </c:pt>
                <c:pt idx="29">
                  <c:v>1.1764705882352905E-3</c:v>
                </c:pt>
                <c:pt idx="30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unc-25 L4_0.02_50%'!$O$104</c:f>
              <c:strCache>
                <c:ptCount val="1"/>
                <c:pt idx="0">
                  <c:v>unc-25_L4_06015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O$105:$O$135</c:f>
              <c:numCache>
                <c:formatCode>General</c:formatCode>
                <c:ptCount val="31"/>
              </c:numCache>
            </c:numRef>
          </c:val>
        </c:ser>
        <c:ser>
          <c:idx val="14"/>
          <c:order val="14"/>
          <c:tx>
            <c:strRef>
              <c:f>'unc-25 L4_0.02_50%'!$P$104</c:f>
              <c:strCache>
                <c:ptCount val="1"/>
                <c:pt idx="0">
                  <c:v>unc-25_L4_06016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P$105:$P$135</c:f>
              <c:numCache>
                <c:formatCode>General</c:formatCode>
                <c:ptCount val="31"/>
                <c:pt idx="1">
                  <c:v>6.7542213883677329E-2</c:v>
                </c:pt>
                <c:pt idx="2">
                  <c:v>3.5647279549718615E-2</c:v>
                </c:pt>
                <c:pt idx="3">
                  <c:v>4.5028142589118178E-2</c:v>
                </c:pt>
                <c:pt idx="4">
                  <c:v>5.2532833020637923E-2</c:v>
                </c:pt>
                <c:pt idx="5">
                  <c:v>3.7523452157598502E-2</c:v>
                </c:pt>
                <c:pt idx="6">
                  <c:v>4.5028142589118178E-2</c:v>
                </c:pt>
                <c:pt idx="7">
                  <c:v>3.9399624765478397E-2</c:v>
                </c:pt>
                <c:pt idx="8">
                  <c:v>2.0637898686679222E-2</c:v>
                </c:pt>
                <c:pt idx="9">
                  <c:v>2.8142589118198884E-2</c:v>
                </c:pt>
                <c:pt idx="10">
                  <c:v>1.87617260787993E-2</c:v>
                </c:pt>
                <c:pt idx="11">
                  <c:v>2.0637898686679222E-2</c:v>
                </c:pt>
                <c:pt idx="12">
                  <c:v>3.5647279549718615E-2</c:v>
                </c:pt>
                <c:pt idx="13">
                  <c:v>3.9399624765478397E-2</c:v>
                </c:pt>
                <c:pt idx="14">
                  <c:v>4.1275797373358285E-2</c:v>
                </c:pt>
                <c:pt idx="15">
                  <c:v>4.3151969981238304E-2</c:v>
                </c:pt>
                <c:pt idx="16">
                  <c:v>3.5647279549718615E-2</c:v>
                </c:pt>
                <c:pt idx="17">
                  <c:v>6.5666041275797393E-2</c:v>
                </c:pt>
                <c:pt idx="18">
                  <c:v>1.87617260787993E-2</c:v>
                </c:pt>
                <c:pt idx="19">
                  <c:v>4.8780487804878127E-2</c:v>
                </c:pt>
                <c:pt idx="20">
                  <c:v>3.0018761726078799E-2</c:v>
                </c:pt>
                <c:pt idx="21">
                  <c:v>3.9399624765478397E-2</c:v>
                </c:pt>
                <c:pt idx="22">
                  <c:v>2.626641651031901E-2</c:v>
                </c:pt>
                <c:pt idx="23">
                  <c:v>3.0018761726078799E-2</c:v>
                </c:pt>
                <c:pt idx="24">
                  <c:v>1.87617260787993E-2</c:v>
                </c:pt>
                <c:pt idx="25">
                  <c:v>1.31332082551595E-2</c:v>
                </c:pt>
                <c:pt idx="26">
                  <c:v>3.7523452157598499E-3</c:v>
                </c:pt>
                <c:pt idx="27">
                  <c:v>5.6285178236397697E-3</c:v>
                </c:pt>
                <c:pt idx="28">
                  <c:v>3.7523452157598499E-3</c:v>
                </c:pt>
                <c:pt idx="29">
                  <c:v>0</c:v>
                </c:pt>
                <c:pt idx="30">
                  <c:v>3.7523452157598499E-3</c:v>
                </c:pt>
              </c:numCache>
            </c:numRef>
          </c:val>
        </c:ser>
        <c:ser>
          <c:idx val="15"/>
          <c:order val="15"/>
          <c:tx>
            <c:strRef>
              <c:f>'unc-25 L4_0.02_50%'!$Q$104</c:f>
              <c:strCache>
                <c:ptCount val="1"/>
                <c:pt idx="0">
                  <c:v>unc-25_L4_06017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Q$105:$Q$135</c:f>
              <c:numCache>
                <c:formatCode>General</c:formatCode>
                <c:ptCount val="31"/>
                <c:pt idx="1">
                  <c:v>2.1712907117008406E-2</c:v>
                </c:pt>
                <c:pt idx="2">
                  <c:v>1.9300361881785306E-2</c:v>
                </c:pt>
                <c:pt idx="3">
                  <c:v>1.5681544028950507E-2</c:v>
                </c:pt>
                <c:pt idx="4">
                  <c:v>1.5681544028950507E-2</c:v>
                </c:pt>
                <c:pt idx="5">
                  <c:v>1.6887816646562113E-2</c:v>
                </c:pt>
                <c:pt idx="6">
                  <c:v>1.20627261761158E-2</c:v>
                </c:pt>
                <c:pt idx="7">
                  <c:v>1.3268998793727404E-2</c:v>
                </c:pt>
                <c:pt idx="8">
                  <c:v>1.0856453558504198E-2</c:v>
                </c:pt>
                <c:pt idx="9">
                  <c:v>1.3268998793727404E-2</c:v>
                </c:pt>
                <c:pt idx="10">
                  <c:v>1.9300361881785306E-2</c:v>
                </c:pt>
                <c:pt idx="11">
                  <c:v>1.20627261761158E-2</c:v>
                </c:pt>
                <c:pt idx="12">
                  <c:v>1.8094089264173701E-2</c:v>
                </c:pt>
                <c:pt idx="13">
                  <c:v>4.101326899879372E-2</c:v>
                </c:pt>
                <c:pt idx="14">
                  <c:v>6.8757539203860102E-2</c:v>
                </c:pt>
                <c:pt idx="15">
                  <c:v>9.7708082026537996E-2</c:v>
                </c:pt>
                <c:pt idx="16">
                  <c:v>9.0470446320868508E-2</c:v>
                </c:pt>
                <c:pt idx="17">
                  <c:v>0.10735826296743102</c:v>
                </c:pt>
                <c:pt idx="18">
                  <c:v>9.891435464414966E-2</c:v>
                </c:pt>
                <c:pt idx="19">
                  <c:v>7.1170084439083195E-2</c:v>
                </c:pt>
                <c:pt idx="20">
                  <c:v>6.1519903498190601E-2</c:v>
                </c:pt>
                <c:pt idx="21">
                  <c:v>3.3775633293124205E-2</c:v>
                </c:pt>
                <c:pt idx="22">
                  <c:v>3.6188178528347402E-2</c:v>
                </c:pt>
                <c:pt idx="23">
                  <c:v>2.1712907117008406E-2</c:v>
                </c:pt>
                <c:pt idx="24">
                  <c:v>1.4475271411339001E-2</c:v>
                </c:pt>
                <c:pt idx="25">
                  <c:v>4.8250904704463197E-3</c:v>
                </c:pt>
                <c:pt idx="26">
                  <c:v>8.4439083232810599E-3</c:v>
                </c:pt>
                <c:pt idx="27">
                  <c:v>7.2376357056694821E-3</c:v>
                </c:pt>
                <c:pt idx="28">
                  <c:v>7.2376357056694821E-3</c:v>
                </c:pt>
                <c:pt idx="29">
                  <c:v>3.6188178528347411E-3</c:v>
                </c:pt>
                <c:pt idx="30">
                  <c:v>1.2062726176115801E-3</c:v>
                </c:pt>
              </c:numCache>
            </c:numRef>
          </c:val>
        </c:ser>
        <c:ser>
          <c:idx val="16"/>
          <c:order val="16"/>
          <c:tx>
            <c:strRef>
              <c:f>'unc-25 L4_0.02_50%'!$R$104</c:f>
              <c:strCache>
                <c:ptCount val="1"/>
                <c:pt idx="0">
                  <c:v>unc-25_L4_06018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R$105:$R$135</c:f>
              <c:numCache>
                <c:formatCode>General</c:formatCode>
                <c:ptCount val="31"/>
              </c:numCache>
            </c:numRef>
          </c:val>
        </c:ser>
        <c:ser>
          <c:idx val="17"/>
          <c:order val="17"/>
          <c:tx>
            <c:strRef>
              <c:f>'unc-25 L4_0.02_50%'!$S$104</c:f>
              <c:strCache>
                <c:ptCount val="1"/>
                <c:pt idx="0">
                  <c:v>unc-25_L4_06019</c:v>
                </c:pt>
              </c:strCache>
            </c:strRef>
          </c:tx>
          <c:marker>
            <c:symbol val="none"/>
          </c:marker>
          <c:cat>
            <c:numRef>
              <c:f>'unc-25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unc-25 L4_0.02_50%'!$S$105:$S$135</c:f>
              <c:numCache>
                <c:formatCode>General</c:formatCode>
                <c:ptCount val="31"/>
                <c:pt idx="1">
                  <c:v>1.8367346938775498E-2</c:v>
                </c:pt>
                <c:pt idx="2">
                  <c:v>1.2244897959183699E-2</c:v>
                </c:pt>
                <c:pt idx="3">
                  <c:v>3.673469387755101E-2</c:v>
                </c:pt>
                <c:pt idx="4">
                  <c:v>1.6326530612244903E-2</c:v>
                </c:pt>
                <c:pt idx="5">
                  <c:v>1.4285714285714301E-2</c:v>
                </c:pt>
                <c:pt idx="6">
                  <c:v>1.4285714285714301E-2</c:v>
                </c:pt>
                <c:pt idx="7">
                  <c:v>8.1632653061224497E-3</c:v>
                </c:pt>
                <c:pt idx="8">
                  <c:v>2.2448979591836699E-2</c:v>
                </c:pt>
                <c:pt idx="9">
                  <c:v>1.6326530612244903E-2</c:v>
                </c:pt>
                <c:pt idx="10">
                  <c:v>1.2244897959183699E-2</c:v>
                </c:pt>
                <c:pt idx="11">
                  <c:v>2.4489795918367314E-2</c:v>
                </c:pt>
                <c:pt idx="12">
                  <c:v>3.4693877551020422E-2</c:v>
                </c:pt>
                <c:pt idx="13">
                  <c:v>3.2653061224489806E-2</c:v>
                </c:pt>
                <c:pt idx="14">
                  <c:v>4.2857142857142913E-2</c:v>
                </c:pt>
                <c:pt idx="15">
                  <c:v>3.673469387755101E-2</c:v>
                </c:pt>
                <c:pt idx="16">
                  <c:v>6.1224489795918401E-2</c:v>
                </c:pt>
                <c:pt idx="17">
                  <c:v>4.0816326530612221E-2</c:v>
                </c:pt>
                <c:pt idx="18">
                  <c:v>5.1020408163265286E-2</c:v>
                </c:pt>
                <c:pt idx="19">
                  <c:v>6.7346938775510234E-2</c:v>
                </c:pt>
                <c:pt idx="20">
                  <c:v>6.5306122448979598E-2</c:v>
                </c:pt>
                <c:pt idx="21">
                  <c:v>5.5102040816326525E-2</c:v>
                </c:pt>
                <c:pt idx="22">
                  <c:v>5.7142857142857099E-2</c:v>
                </c:pt>
                <c:pt idx="23">
                  <c:v>2.4489795918367314E-2</c:v>
                </c:pt>
                <c:pt idx="24">
                  <c:v>2.8571428571428602E-2</c:v>
                </c:pt>
                <c:pt idx="25">
                  <c:v>2.0408163265306107E-2</c:v>
                </c:pt>
                <c:pt idx="26">
                  <c:v>3.4693877551020422E-2</c:v>
                </c:pt>
                <c:pt idx="27">
                  <c:v>1.6326530612244903E-2</c:v>
                </c:pt>
                <c:pt idx="28">
                  <c:v>1.0204081632653106E-2</c:v>
                </c:pt>
                <c:pt idx="29">
                  <c:v>8.1632653061224497E-3</c:v>
                </c:pt>
                <c:pt idx="30">
                  <c:v>8.1632653061224497E-3</c:v>
                </c:pt>
              </c:numCache>
            </c:numRef>
          </c:val>
        </c:ser>
        <c:marker val="1"/>
        <c:axId val="162312576"/>
        <c:axId val="162314112"/>
      </c:lineChart>
      <c:catAx>
        <c:axId val="162312576"/>
        <c:scaling>
          <c:orientation val="minMax"/>
        </c:scaling>
        <c:axPos val="b"/>
        <c:numFmt formatCode="0.0_ " sourceLinked="1"/>
        <c:tickLblPos val="nextTo"/>
        <c:crossAx val="162314112"/>
        <c:crosses val="autoZero"/>
        <c:auto val="1"/>
        <c:lblAlgn val="ctr"/>
        <c:lblOffset val="100"/>
        <c:tickLblSkip val="5"/>
        <c:tickMarkSkip val="5"/>
      </c:catAx>
      <c:valAx>
        <c:axId val="162314112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2312576"/>
        <c:crosses val="autoZero"/>
        <c:crossBetween val="between"/>
      </c:valAx>
    </c:plotArea>
    <c:plotVisOnly val="1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>
                <a:latin typeface="Arial" pitchFamily="34" charset="0"/>
                <a:cs typeface="Arial" pitchFamily="34" charset="0"/>
              </a:rPr>
              <a:t>w.t. A3</a:t>
            </a:r>
            <a:endParaRPr lang="ja-JP" altLang="en-US" sz="1400" b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N2 A3_0.02_50%'!$B$104</c:f>
              <c:strCache>
                <c:ptCount val="1"/>
                <c:pt idx="0">
                  <c:v>N2_A3_40_30_03</c:v>
                </c:pt>
              </c:strCache>
            </c:strRef>
          </c:tx>
          <c:marker>
            <c:symbol val="none"/>
          </c:marker>
          <c:cat>
            <c:numRef>
              <c:f>'N2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3_0.02_50%'!$B$105:$B$135</c:f>
              <c:numCache>
                <c:formatCode>General</c:formatCode>
                <c:ptCount val="31"/>
                <c:pt idx="1">
                  <c:v>1.9817073170731701E-2</c:v>
                </c:pt>
                <c:pt idx="2">
                  <c:v>3.9634146341463415E-2</c:v>
                </c:pt>
                <c:pt idx="3">
                  <c:v>1.9817073170731701E-2</c:v>
                </c:pt>
                <c:pt idx="4">
                  <c:v>1.6768292682926799E-2</c:v>
                </c:pt>
                <c:pt idx="5">
                  <c:v>6.0975609756097598E-3</c:v>
                </c:pt>
                <c:pt idx="6">
                  <c:v>7.6219512195122002E-3</c:v>
                </c:pt>
                <c:pt idx="7">
                  <c:v>1.5243902439024399E-2</c:v>
                </c:pt>
                <c:pt idx="8">
                  <c:v>1.3719512195122E-2</c:v>
                </c:pt>
                <c:pt idx="9">
                  <c:v>1.21951219512195E-2</c:v>
                </c:pt>
                <c:pt idx="10">
                  <c:v>2.4390243902439001E-2</c:v>
                </c:pt>
                <c:pt idx="11">
                  <c:v>3.2012195121951206E-2</c:v>
                </c:pt>
                <c:pt idx="12">
                  <c:v>4.7256097560975603E-2</c:v>
                </c:pt>
                <c:pt idx="13">
                  <c:v>8.6890243902439032E-2</c:v>
                </c:pt>
                <c:pt idx="14">
                  <c:v>9.7560975609756156E-2</c:v>
                </c:pt>
                <c:pt idx="15">
                  <c:v>0.12804878048780508</c:v>
                </c:pt>
                <c:pt idx="16">
                  <c:v>8.0792682926829298E-2</c:v>
                </c:pt>
                <c:pt idx="17">
                  <c:v>8.6890243902439032E-2</c:v>
                </c:pt>
                <c:pt idx="18">
                  <c:v>5.79268292682927E-2</c:v>
                </c:pt>
                <c:pt idx="19">
                  <c:v>3.8109756097561003E-2</c:v>
                </c:pt>
                <c:pt idx="20">
                  <c:v>2.7439024390243899E-2</c:v>
                </c:pt>
                <c:pt idx="21">
                  <c:v>1.0670731707317105E-2</c:v>
                </c:pt>
                <c:pt idx="22">
                  <c:v>6.0975609756097598E-3</c:v>
                </c:pt>
                <c:pt idx="23">
                  <c:v>4.573170731707322E-3</c:v>
                </c:pt>
                <c:pt idx="24">
                  <c:v>3.0487804878048808E-3</c:v>
                </c:pt>
                <c:pt idx="25">
                  <c:v>1.5243902439024399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"/>
          <c:order val="1"/>
          <c:tx>
            <c:strRef>
              <c:f>'N2 A3_0.02_50%'!$C$104</c:f>
              <c:strCache>
                <c:ptCount val="1"/>
                <c:pt idx="0">
                  <c:v>N2_A3_40_30_2</c:v>
                </c:pt>
              </c:strCache>
            </c:strRef>
          </c:tx>
          <c:marker>
            <c:symbol val="none"/>
          </c:marker>
          <c:cat>
            <c:numRef>
              <c:f>'N2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3_0.02_50%'!$C$105:$C$135</c:f>
              <c:numCache>
                <c:formatCode>General</c:formatCode>
                <c:ptCount val="31"/>
                <c:pt idx="1">
                  <c:v>5.1813471502590719E-2</c:v>
                </c:pt>
                <c:pt idx="2">
                  <c:v>4.7927461139896432E-2</c:v>
                </c:pt>
                <c:pt idx="3">
                  <c:v>4.4041450777202083E-2</c:v>
                </c:pt>
                <c:pt idx="4">
                  <c:v>4.533678756476682E-2</c:v>
                </c:pt>
                <c:pt idx="5">
                  <c:v>2.8497409326424899E-2</c:v>
                </c:pt>
                <c:pt idx="6">
                  <c:v>3.1088082901554407E-2</c:v>
                </c:pt>
                <c:pt idx="7">
                  <c:v>2.4611398963730602E-2</c:v>
                </c:pt>
                <c:pt idx="8">
                  <c:v>4.0155440414507797E-2</c:v>
                </c:pt>
                <c:pt idx="9">
                  <c:v>2.9792746113989601E-2</c:v>
                </c:pt>
                <c:pt idx="10">
                  <c:v>2.4611398963730602E-2</c:v>
                </c:pt>
                <c:pt idx="11">
                  <c:v>2.8497409326424899E-2</c:v>
                </c:pt>
                <c:pt idx="12">
                  <c:v>3.6269430051813517E-2</c:v>
                </c:pt>
                <c:pt idx="13">
                  <c:v>3.2383419689119231E-2</c:v>
                </c:pt>
                <c:pt idx="14">
                  <c:v>4.533678756476682E-2</c:v>
                </c:pt>
                <c:pt idx="15">
                  <c:v>5.6994818652849701E-2</c:v>
                </c:pt>
                <c:pt idx="16">
                  <c:v>9.4559585492228038E-2</c:v>
                </c:pt>
                <c:pt idx="17">
                  <c:v>7.6424870466321196E-2</c:v>
                </c:pt>
                <c:pt idx="18">
                  <c:v>6.2176165803108814E-2</c:v>
                </c:pt>
                <c:pt idx="19">
                  <c:v>6.6062176165803094E-2</c:v>
                </c:pt>
                <c:pt idx="20">
                  <c:v>3.8860103626943011E-2</c:v>
                </c:pt>
                <c:pt idx="21">
                  <c:v>2.3316062176165799E-2</c:v>
                </c:pt>
                <c:pt idx="22">
                  <c:v>1.9430051813471506E-2</c:v>
                </c:pt>
                <c:pt idx="23">
                  <c:v>1.0362694300518104E-2</c:v>
                </c:pt>
                <c:pt idx="24">
                  <c:v>3.8860103626943017E-3</c:v>
                </c:pt>
                <c:pt idx="25">
                  <c:v>1.2953367875647699E-3</c:v>
                </c:pt>
                <c:pt idx="26">
                  <c:v>3.8860103626943017E-3</c:v>
                </c:pt>
                <c:pt idx="27">
                  <c:v>1.2953367875647699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N2 A3_0.02_50%'!$D$104</c:f>
              <c:strCache>
                <c:ptCount val="1"/>
                <c:pt idx="0">
                  <c:v>N2_REX_A3_01</c:v>
                </c:pt>
              </c:strCache>
            </c:strRef>
          </c:tx>
          <c:marker>
            <c:symbol val="none"/>
          </c:marker>
          <c:cat>
            <c:numRef>
              <c:f>'N2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3_0.02_50%'!$D$105:$D$135</c:f>
              <c:numCache>
                <c:formatCode>General</c:formatCode>
                <c:ptCount val="31"/>
                <c:pt idx="1">
                  <c:v>1.7456359102244402E-2</c:v>
                </c:pt>
                <c:pt idx="2">
                  <c:v>1.49625935162095E-2</c:v>
                </c:pt>
                <c:pt idx="3">
                  <c:v>1.9950124688279308E-2</c:v>
                </c:pt>
                <c:pt idx="4">
                  <c:v>1.2468827930174599E-2</c:v>
                </c:pt>
                <c:pt idx="5">
                  <c:v>4.9875311720698322E-3</c:v>
                </c:pt>
                <c:pt idx="6">
                  <c:v>9.9750623441396541E-3</c:v>
                </c:pt>
                <c:pt idx="7">
                  <c:v>9.9750623441396541E-3</c:v>
                </c:pt>
                <c:pt idx="8">
                  <c:v>4.9875311720698322E-3</c:v>
                </c:pt>
                <c:pt idx="9">
                  <c:v>9.9750623441396541E-3</c:v>
                </c:pt>
                <c:pt idx="10">
                  <c:v>7.481296758104744E-3</c:v>
                </c:pt>
                <c:pt idx="11">
                  <c:v>2.4937655860349107E-2</c:v>
                </c:pt>
                <c:pt idx="12">
                  <c:v>3.2418952618453921E-2</c:v>
                </c:pt>
                <c:pt idx="13">
                  <c:v>0.10723192019950099</c:v>
                </c:pt>
                <c:pt idx="14">
                  <c:v>0.14713216957606007</c:v>
                </c:pt>
                <c:pt idx="15">
                  <c:v>0.14713216957606007</c:v>
                </c:pt>
                <c:pt idx="16">
                  <c:v>0.12219451371571104</c:v>
                </c:pt>
                <c:pt idx="17">
                  <c:v>9.4763092269326735E-2</c:v>
                </c:pt>
                <c:pt idx="18">
                  <c:v>7.481296758104744E-2</c:v>
                </c:pt>
                <c:pt idx="19">
                  <c:v>3.7406483790523699E-2</c:v>
                </c:pt>
                <c:pt idx="20">
                  <c:v>3.4912718204488803E-2</c:v>
                </c:pt>
                <c:pt idx="21">
                  <c:v>1.9950124688279308E-2</c:v>
                </c:pt>
                <c:pt idx="22">
                  <c:v>9.9750623441396541E-3</c:v>
                </c:pt>
                <c:pt idx="23">
                  <c:v>7.481296758104744E-3</c:v>
                </c:pt>
                <c:pt idx="24">
                  <c:v>2.4937655860349109E-3</c:v>
                </c:pt>
                <c:pt idx="25">
                  <c:v>0</c:v>
                </c:pt>
                <c:pt idx="26">
                  <c:v>2.4937655860349109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N2 A3_0.02_50%'!$E$104</c:f>
              <c:strCache>
                <c:ptCount val="1"/>
                <c:pt idx="0">
                  <c:v>N2_REX_A3_02</c:v>
                </c:pt>
              </c:strCache>
            </c:strRef>
          </c:tx>
          <c:marker>
            <c:symbol val="none"/>
          </c:marker>
          <c:cat>
            <c:numRef>
              <c:f>'N2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3_0.02_50%'!$E$105:$E$135</c:f>
              <c:numCache>
                <c:formatCode>General</c:formatCode>
                <c:ptCount val="31"/>
                <c:pt idx="1">
                  <c:v>7.943262411347525E-2</c:v>
                </c:pt>
                <c:pt idx="2">
                  <c:v>5.1063829787233998E-2</c:v>
                </c:pt>
                <c:pt idx="3">
                  <c:v>3.8297872340425511E-2</c:v>
                </c:pt>
                <c:pt idx="4">
                  <c:v>2.4113475177305006E-2</c:v>
                </c:pt>
                <c:pt idx="5">
                  <c:v>2.5531914893617006E-2</c:v>
                </c:pt>
                <c:pt idx="6">
                  <c:v>1.9858156028368806E-2</c:v>
                </c:pt>
                <c:pt idx="7">
                  <c:v>5.6737588652482317E-3</c:v>
                </c:pt>
                <c:pt idx="8">
                  <c:v>9.9290780141844028E-3</c:v>
                </c:pt>
                <c:pt idx="9">
                  <c:v>1.7021276595744698E-2</c:v>
                </c:pt>
                <c:pt idx="10">
                  <c:v>2.1276595744680899E-2</c:v>
                </c:pt>
                <c:pt idx="11">
                  <c:v>3.54609929078014E-2</c:v>
                </c:pt>
                <c:pt idx="12">
                  <c:v>3.9716312056737604E-2</c:v>
                </c:pt>
                <c:pt idx="13">
                  <c:v>6.6666666666666693E-2</c:v>
                </c:pt>
                <c:pt idx="14">
                  <c:v>9.0780141843971582E-2</c:v>
                </c:pt>
                <c:pt idx="15">
                  <c:v>8.7943262411347492E-2</c:v>
                </c:pt>
                <c:pt idx="16">
                  <c:v>6.0992907801418444E-2</c:v>
                </c:pt>
                <c:pt idx="17">
                  <c:v>5.2482269503546126E-2</c:v>
                </c:pt>
                <c:pt idx="18">
                  <c:v>3.4042553191489397E-2</c:v>
                </c:pt>
                <c:pt idx="19">
                  <c:v>1.5602836879432603E-2</c:v>
                </c:pt>
                <c:pt idx="20">
                  <c:v>9.9290780141844028E-3</c:v>
                </c:pt>
                <c:pt idx="21">
                  <c:v>9.9290780141844028E-3</c:v>
                </c:pt>
                <c:pt idx="22">
                  <c:v>2.8368794326241093E-3</c:v>
                </c:pt>
                <c:pt idx="23">
                  <c:v>1.4184397163120599E-3</c:v>
                </c:pt>
                <c:pt idx="24">
                  <c:v>1.4184397163120599E-3</c:v>
                </c:pt>
                <c:pt idx="25">
                  <c:v>2.8368794326241093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N2 A3_0.02_50%'!$F$104</c:f>
              <c:strCache>
                <c:ptCount val="1"/>
                <c:pt idx="0">
                  <c:v>N2_REX_A3_03</c:v>
                </c:pt>
              </c:strCache>
            </c:strRef>
          </c:tx>
          <c:marker>
            <c:symbol val="none"/>
          </c:marker>
          <c:cat>
            <c:numRef>
              <c:f>'N2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3_0.02_50%'!$F$105:$F$135</c:f>
              <c:numCache>
                <c:formatCode>General</c:formatCode>
                <c:ptCount val="31"/>
                <c:pt idx="1">
                  <c:v>5.0080775444264897E-2</c:v>
                </c:pt>
                <c:pt idx="2">
                  <c:v>4.6849757673667163E-2</c:v>
                </c:pt>
                <c:pt idx="3">
                  <c:v>2.5848142164781908E-2</c:v>
                </c:pt>
                <c:pt idx="4">
                  <c:v>2.5848142164781908E-2</c:v>
                </c:pt>
                <c:pt idx="5">
                  <c:v>6.4620355411954778E-3</c:v>
                </c:pt>
                <c:pt idx="6">
                  <c:v>1.2924071082391001E-2</c:v>
                </c:pt>
                <c:pt idx="7">
                  <c:v>8.0775444264943545E-3</c:v>
                </c:pt>
                <c:pt idx="8">
                  <c:v>1.1308562197092101E-2</c:v>
                </c:pt>
                <c:pt idx="9">
                  <c:v>4.8465266558966116E-3</c:v>
                </c:pt>
                <c:pt idx="10">
                  <c:v>2.4232633279482999E-2</c:v>
                </c:pt>
                <c:pt idx="11">
                  <c:v>8.0775444264943545E-3</c:v>
                </c:pt>
                <c:pt idx="12">
                  <c:v>3.2310177705977411E-2</c:v>
                </c:pt>
                <c:pt idx="13">
                  <c:v>6.9466882067851413E-2</c:v>
                </c:pt>
                <c:pt idx="14">
                  <c:v>8.5621970920840174E-2</c:v>
                </c:pt>
                <c:pt idx="15">
                  <c:v>0.10339256865912801</c:v>
                </c:pt>
                <c:pt idx="16">
                  <c:v>0.10016155088853006</c:v>
                </c:pt>
                <c:pt idx="17">
                  <c:v>7.7544426494345731E-2</c:v>
                </c:pt>
                <c:pt idx="18">
                  <c:v>7.5928917609046923E-2</c:v>
                </c:pt>
                <c:pt idx="19">
                  <c:v>3.2310177705977411E-2</c:v>
                </c:pt>
                <c:pt idx="20">
                  <c:v>2.7463651050080799E-2</c:v>
                </c:pt>
                <c:pt idx="21">
                  <c:v>2.7463651050080799E-2</c:v>
                </c:pt>
                <c:pt idx="22">
                  <c:v>8.0775444264943545E-3</c:v>
                </c:pt>
                <c:pt idx="23">
                  <c:v>1.6155088852988701E-3</c:v>
                </c:pt>
                <c:pt idx="24">
                  <c:v>1.6155088852988701E-3</c:v>
                </c:pt>
                <c:pt idx="25">
                  <c:v>0</c:v>
                </c:pt>
                <c:pt idx="26">
                  <c:v>3.2310177705977415E-3</c:v>
                </c:pt>
                <c:pt idx="27">
                  <c:v>1.6155088852988701E-3</c:v>
                </c:pt>
                <c:pt idx="28">
                  <c:v>1.6155088852988701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N2 A3_0.02_50%'!$G$104</c:f>
              <c:strCache>
                <c:ptCount val="1"/>
                <c:pt idx="0">
                  <c:v>N2_REX_A3_04</c:v>
                </c:pt>
              </c:strCache>
            </c:strRef>
          </c:tx>
          <c:marker>
            <c:symbol val="none"/>
          </c:marker>
          <c:cat>
            <c:numRef>
              <c:f>'N2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3_0.02_50%'!$G$105:$G$135</c:f>
              <c:numCache>
                <c:formatCode>General</c:formatCode>
                <c:ptCount val="31"/>
                <c:pt idx="1">
                  <c:v>9.3681917211328999E-2</c:v>
                </c:pt>
                <c:pt idx="2">
                  <c:v>9.6949891067538083E-2</c:v>
                </c:pt>
                <c:pt idx="3">
                  <c:v>5.4466230936819258E-2</c:v>
                </c:pt>
                <c:pt idx="4">
                  <c:v>3.8126361655773398E-2</c:v>
                </c:pt>
                <c:pt idx="5">
                  <c:v>3.8126361655773398E-2</c:v>
                </c:pt>
                <c:pt idx="6">
                  <c:v>2.9411764705882398E-2</c:v>
                </c:pt>
                <c:pt idx="7">
                  <c:v>3.2679738562091512E-2</c:v>
                </c:pt>
                <c:pt idx="8">
                  <c:v>2.1786492374727701E-2</c:v>
                </c:pt>
                <c:pt idx="9">
                  <c:v>2.0697167755991314E-2</c:v>
                </c:pt>
                <c:pt idx="10">
                  <c:v>3.9215686274509803E-2</c:v>
                </c:pt>
                <c:pt idx="11">
                  <c:v>4.9019607843137344E-2</c:v>
                </c:pt>
                <c:pt idx="12">
                  <c:v>3.9215686274509803E-2</c:v>
                </c:pt>
                <c:pt idx="13">
                  <c:v>5.555555555555558E-2</c:v>
                </c:pt>
                <c:pt idx="14">
                  <c:v>5.555555555555558E-2</c:v>
                </c:pt>
                <c:pt idx="15">
                  <c:v>3.7037037037037014E-2</c:v>
                </c:pt>
                <c:pt idx="16">
                  <c:v>5.6644880174291881E-2</c:v>
                </c:pt>
                <c:pt idx="17">
                  <c:v>2.6143790849673214E-2</c:v>
                </c:pt>
                <c:pt idx="18">
                  <c:v>1.9607843137254902E-2</c:v>
                </c:pt>
                <c:pt idx="19">
                  <c:v>7.6252723311546833E-3</c:v>
                </c:pt>
                <c:pt idx="20">
                  <c:v>9.8039215686274508E-3</c:v>
                </c:pt>
                <c:pt idx="21">
                  <c:v>3.2679738562091526E-3</c:v>
                </c:pt>
                <c:pt idx="22">
                  <c:v>2.1786492374727701E-3</c:v>
                </c:pt>
                <c:pt idx="23">
                  <c:v>2.1786492374727701E-3</c:v>
                </c:pt>
                <c:pt idx="24">
                  <c:v>1.0893246187363799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6"/>
          <c:order val="6"/>
          <c:tx>
            <c:strRef>
              <c:f>'N2 A3_0.02_50%'!$H$104</c:f>
              <c:strCache>
                <c:ptCount val="1"/>
                <c:pt idx="0">
                  <c:v>N2_REX_A3_05</c:v>
                </c:pt>
              </c:strCache>
            </c:strRef>
          </c:tx>
          <c:marker>
            <c:symbol val="none"/>
          </c:marker>
          <c:cat>
            <c:numRef>
              <c:f>'N2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3_0.02_50%'!$H$105:$H$135</c:f>
              <c:numCache>
                <c:formatCode>General</c:formatCode>
                <c:ptCount val="31"/>
                <c:pt idx="1">
                  <c:v>9.3750000000000042E-2</c:v>
                </c:pt>
                <c:pt idx="2">
                  <c:v>8.3881578947368432E-2</c:v>
                </c:pt>
                <c:pt idx="3">
                  <c:v>6.7434210526315833E-2</c:v>
                </c:pt>
                <c:pt idx="4">
                  <c:v>3.2894736842105317E-2</c:v>
                </c:pt>
                <c:pt idx="5">
                  <c:v>1.9736842105263205E-2</c:v>
                </c:pt>
                <c:pt idx="6">
                  <c:v>1.6447368421052603E-2</c:v>
                </c:pt>
                <c:pt idx="7">
                  <c:v>4.9342105263157883E-3</c:v>
                </c:pt>
                <c:pt idx="8">
                  <c:v>2.3026315789473721E-2</c:v>
                </c:pt>
                <c:pt idx="9">
                  <c:v>3.7828947368421122E-2</c:v>
                </c:pt>
                <c:pt idx="10">
                  <c:v>2.4671052631578899E-2</c:v>
                </c:pt>
                <c:pt idx="11">
                  <c:v>3.6184210526315819E-2</c:v>
                </c:pt>
                <c:pt idx="12">
                  <c:v>7.5657894736842118E-2</c:v>
                </c:pt>
                <c:pt idx="13">
                  <c:v>7.5657894736842118E-2</c:v>
                </c:pt>
                <c:pt idx="14">
                  <c:v>6.25E-2</c:v>
                </c:pt>
                <c:pt idx="15">
                  <c:v>6.0855263157894704E-2</c:v>
                </c:pt>
                <c:pt idx="16">
                  <c:v>3.2894736842105317E-2</c:v>
                </c:pt>
                <c:pt idx="17">
                  <c:v>1.6447368421052603E-2</c:v>
                </c:pt>
                <c:pt idx="18">
                  <c:v>9.8684210526315801E-3</c:v>
                </c:pt>
                <c:pt idx="19">
                  <c:v>0</c:v>
                </c:pt>
                <c:pt idx="20">
                  <c:v>0</c:v>
                </c:pt>
                <c:pt idx="21">
                  <c:v>4.9342105263157883E-3</c:v>
                </c:pt>
                <c:pt idx="22">
                  <c:v>3.2894736842105309E-3</c:v>
                </c:pt>
                <c:pt idx="23">
                  <c:v>1.6447368421052605E-3</c:v>
                </c:pt>
                <c:pt idx="24">
                  <c:v>0</c:v>
                </c:pt>
                <c:pt idx="25">
                  <c:v>1.6447368421052605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N2 A3_0.02_50%'!$I$104</c:f>
              <c:strCache>
                <c:ptCount val="1"/>
                <c:pt idx="0">
                  <c:v>N2_REX_A3_07</c:v>
                </c:pt>
              </c:strCache>
            </c:strRef>
          </c:tx>
          <c:marker>
            <c:symbol val="none"/>
          </c:marker>
          <c:cat>
            <c:numRef>
              <c:f>'N2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3_0.02_50%'!$I$105:$I$135</c:f>
              <c:numCache>
                <c:formatCode>General</c:formatCode>
                <c:ptCount val="31"/>
                <c:pt idx="1">
                  <c:v>7.7348066298342497E-2</c:v>
                </c:pt>
                <c:pt idx="2">
                  <c:v>7.18232044198895E-2</c:v>
                </c:pt>
                <c:pt idx="3">
                  <c:v>5.5248618784530384E-2</c:v>
                </c:pt>
                <c:pt idx="4">
                  <c:v>4.6566692975532821E-2</c:v>
                </c:pt>
                <c:pt idx="5">
                  <c:v>3.2359905288082115E-2</c:v>
                </c:pt>
                <c:pt idx="6">
                  <c:v>2.6045777426992919E-2</c:v>
                </c:pt>
                <c:pt idx="7">
                  <c:v>3.0781373322809818E-2</c:v>
                </c:pt>
                <c:pt idx="8">
                  <c:v>3.0781373322809818E-2</c:v>
                </c:pt>
                <c:pt idx="9">
                  <c:v>2.8413575374901308E-2</c:v>
                </c:pt>
                <c:pt idx="10">
                  <c:v>3.0781373322809818E-2</c:v>
                </c:pt>
                <c:pt idx="11">
                  <c:v>4.2620363062351979E-2</c:v>
                </c:pt>
                <c:pt idx="12">
                  <c:v>3.4727703235990497E-2</c:v>
                </c:pt>
                <c:pt idx="13">
                  <c:v>4.340962904498822E-2</c:v>
                </c:pt>
                <c:pt idx="14">
                  <c:v>5.2880820836621933E-2</c:v>
                </c:pt>
                <c:pt idx="15">
                  <c:v>6.1562746645619615E-2</c:v>
                </c:pt>
                <c:pt idx="16">
                  <c:v>6.3930544593527996E-2</c:v>
                </c:pt>
                <c:pt idx="17">
                  <c:v>5.0513022888713517E-2</c:v>
                </c:pt>
                <c:pt idx="18">
                  <c:v>3.5516969218626702E-2</c:v>
                </c:pt>
                <c:pt idx="19">
                  <c:v>2.6045777426992919E-2</c:v>
                </c:pt>
                <c:pt idx="20">
                  <c:v>2.5256511444356707E-2</c:v>
                </c:pt>
                <c:pt idx="21">
                  <c:v>7.8926598263614808E-3</c:v>
                </c:pt>
                <c:pt idx="22">
                  <c:v>8.6819258089976294E-3</c:v>
                </c:pt>
                <c:pt idx="23">
                  <c:v>3.1570639305445909E-3</c:v>
                </c:pt>
                <c:pt idx="24">
                  <c:v>0</c:v>
                </c:pt>
                <c:pt idx="25">
                  <c:v>2.3677979479084519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7.8926598263614816E-4</c:v>
                </c:pt>
              </c:numCache>
            </c:numRef>
          </c:val>
        </c:ser>
        <c:ser>
          <c:idx val="8"/>
          <c:order val="8"/>
          <c:tx>
            <c:strRef>
              <c:f>'N2 A3_0.02_50%'!$J$104</c:f>
              <c:strCache>
                <c:ptCount val="1"/>
                <c:pt idx="0">
                  <c:v>N2_REX_A3_08</c:v>
                </c:pt>
              </c:strCache>
            </c:strRef>
          </c:tx>
          <c:marker>
            <c:symbol val="none"/>
          </c:marker>
          <c:cat>
            <c:numRef>
              <c:f>'N2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3_0.02_50%'!$J$105:$J$135</c:f>
              <c:numCache>
                <c:formatCode>General</c:formatCode>
                <c:ptCount val="31"/>
                <c:pt idx="1">
                  <c:v>4.1666666666666699E-2</c:v>
                </c:pt>
                <c:pt idx="2">
                  <c:v>5.5208333333333318E-2</c:v>
                </c:pt>
                <c:pt idx="3">
                  <c:v>4.3749999999999997E-2</c:v>
                </c:pt>
                <c:pt idx="4">
                  <c:v>2.0833333333333311E-2</c:v>
                </c:pt>
                <c:pt idx="5">
                  <c:v>2.0833333333333311E-2</c:v>
                </c:pt>
                <c:pt idx="6">
                  <c:v>1.7708333333333305E-2</c:v>
                </c:pt>
                <c:pt idx="7">
                  <c:v>9.3750000000000066E-3</c:v>
                </c:pt>
                <c:pt idx="8">
                  <c:v>1.2500000000000001E-2</c:v>
                </c:pt>
                <c:pt idx="9">
                  <c:v>1.1458333333333301E-2</c:v>
                </c:pt>
                <c:pt idx="10">
                  <c:v>2.6041666666666713E-2</c:v>
                </c:pt>
                <c:pt idx="11">
                  <c:v>2.2916666666666707E-2</c:v>
                </c:pt>
                <c:pt idx="12">
                  <c:v>0.05</c:v>
                </c:pt>
                <c:pt idx="13">
                  <c:v>6.1458333333333316E-2</c:v>
                </c:pt>
                <c:pt idx="14">
                  <c:v>8.3333333333333329E-2</c:v>
                </c:pt>
                <c:pt idx="15">
                  <c:v>9.7916666666666707E-2</c:v>
                </c:pt>
                <c:pt idx="16">
                  <c:v>8.4375000000000006E-2</c:v>
                </c:pt>
                <c:pt idx="17">
                  <c:v>6.458333333333334E-2</c:v>
                </c:pt>
                <c:pt idx="18">
                  <c:v>4.6874999999999986E-2</c:v>
                </c:pt>
                <c:pt idx="19">
                  <c:v>2.5000000000000001E-2</c:v>
                </c:pt>
                <c:pt idx="20">
                  <c:v>2.0833333333333311E-2</c:v>
                </c:pt>
                <c:pt idx="21">
                  <c:v>1.5625E-2</c:v>
                </c:pt>
                <c:pt idx="22">
                  <c:v>6.2500000000000021E-3</c:v>
                </c:pt>
                <c:pt idx="23">
                  <c:v>1.0416666666666701E-3</c:v>
                </c:pt>
                <c:pt idx="24">
                  <c:v>4.1666666666666701E-3</c:v>
                </c:pt>
                <c:pt idx="25">
                  <c:v>0</c:v>
                </c:pt>
                <c:pt idx="26">
                  <c:v>1.0416666666666701E-3</c:v>
                </c:pt>
                <c:pt idx="27">
                  <c:v>1.0416666666666701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N2 A3_0.02_50%'!$K$104</c:f>
              <c:strCache>
                <c:ptCount val="1"/>
                <c:pt idx="0">
                  <c:v>N2_REX_A3_09</c:v>
                </c:pt>
              </c:strCache>
            </c:strRef>
          </c:tx>
          <c:marker>
            <c:symbol val="none"/>
          </c:marker>
          <c:cat>
            <c:numRef>
              <c:f>'N2 A3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3_0.02_50%'!$K$105:$K$135</c:f>
              <c:numCache>
                <c:formatCode>General</c:formatCode>
                <c:ptCount val="31"/>
                <c:pt idx="1">
                  <c:v>6.25E-2</c:v>
                </c:pt>
                <c:pt idx="2">
                  <c:v>6.4759036144578327E-2</c:v>
                </c:pt>
                <c:pt idx="3">
                  <c:v>5.6475903614457777E-2</c:v>
                </c:pt>
                <c:pt idx="4">
                  <c:v>5.7228915662650572E-2</c:v>
                </c:pt>
                <c:pt idx="5">
                  <c:v>4.1415662650602404E-2</c:v>
                </c:pt>
                <c:pt idx="6">
                  <c:v>3.3885542168674718E-2</c:v>
                </c:pt>
                <c:pt idx="7">
                  <c:v>3.1626506024096397E-2</c:v>
                </c:pt>
                <c:pt idx="8">
                  <c:v>2.3343373493975909E-2</c:v>
                </c:pt>
                <c:pt idx="9">
                  <c:v>3.0120481927710791E-2</c:v>
                </c:pt>
                <c:pt idx="10">
                  <c:v>4.7439759036144599E-2</c:v>
                </c:pt>
                <c:pt idx="11">
                  <c:v>3.3132530120481903E-2</c:v>
                </c:pt>
                <c:pt idx="12">
                  <c:v>5.4216867469879498E-2</c:v>
                </c:pt>
                <c:pt idx="13">
                  <c:v>5.1204819277108383E-2</c:v>
                </c:pt>
                <c:pt idx="14">
                  <c:v>5.0451807228915714E-2</c:v>
                </c:pt>
                <c:pt idx="15">
                  <c:v>7.2289156626505965E-2</c:v>
                </c:pt>
                <c:pt idx="16">
                  <c:v>6.4759036144578327E-2</c:v>
                </c:pt>
                <c:pt idx="17">
                  <c:v>3.3132530120481903E-2</c:v>
                </c:pt>
                <c:pt idx="18">
                  <c:v>3.9909638554216899E-2</c:v>
                </c:pt>
                <c:pt idx="19">
                  <c:v>1.6566265060241E-2</c:v>
                </c:pt>
                <c:pt idx="20">
                  <c:v>1.73192771084337E-2</c:v>
                </c:pt>
                <c:pt idx="21">
                  <c:v>1.1295180722891599E-2</c:v>
                </c:pt>
                <c:pt idx="22">
                  <c:v>3.0120481927710797E-3</c:v>
                </c:pt>
                <c:pt idx="23">
                  <c:v>7.5301204819277134E-4</c:v>
                </c:pt>
                <c:pt idx="24">
                  <c:v>7.5301204819277134E-4</c:v>
                </c:pt>
                <c:pt idx="25">
                  <c:v>1.5060240963855401E-3</c:v>
                </c:pt>
                <c:pt idx="26">
                  <c:v>1.5060240963855401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marker val="1"/>
        <c:axId val="162382208"/>
        <c:axId val="162383744"/>
      </c:lineChart>
      <c:catAx>
        <c:axId val="162382208"/>
        <c:scaling>
          <c:orientation val="minMax"/>
        </c:scaling>
        <c:axPos val="b"/>
        <c:numFmt formatCode="0.0_ " sourceLinked="1"/>
        <c:tickLblPos val="nextTo"/>
        <c:crossAx val="162383744"/>
        <c:crosses val="autoZero"/>
        <c:auto val="1"/>
        <c:lblAlgn val="ctr"/>
        <c:lblOffset val="100"/>
        <c:tickLblSkip val="5"/>
        <c:tickMarkSkip val="5"/>
      </c:catAx>
      <c:valAx>
        <c:axId val="162383744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2382208"/>
        <c:crosses val="autoZero"/>
        <c:crossBetween val="between"/>
      </c:valAx>
    </c:plotArea>
    <c:plotVisOnly val="1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/>
            </a:pPr>
            <a:r>
              <a:rPr lang="en-US" altLang="ja-JP" sz="1400" b="0" dirty="0" err="1" smtClean="0">
                <a:latin typeface="Arial" pitchFamily="34" charset="0"/>
                <a:cs typeface="Arial" pitchFamily="34" charset="0"/>
              </a:rPr>
              <a:t>w.t</a:t>
            </a:r>
            <a:r>
              <a:rPr lang="en-US" altLang="ja-JP" sz="1400" b="0" dirty="0" smtClean="0">
                <a:latin typeface="Arial" pitchFamily="34" charset="0"/>
                <a:cs typeface="Arial" pitchFamily="34" charset="0"/>
              </a:rPr>
              <a:t>. A2</a:t>
            </a:r>
            <a:endParaRPr lang="ja-JP" altLang="en-US" sz="1400" b="0" dirty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N2 A2_0.02_50%'!$B$104</c:f>
              <c:strCache>
                <c:ptCount val="1"/>
                <c:pt idx="0">
                  <c:v>N2_A2_40_30_02</c:v>
                </c:pt>
              </c:strCache>
            </c:strRef>
          </c:tx>
          <c:marker>
            <c:symbol val="none"/>
          </c:marker>
          <c:cat>
            <c:numRef>
              <c:f>'N2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2_0.02_50%'!$B$105:$B$135</c:f>
              <c:numCache>
                <c:formatCode>General</c:formatCode>
                <c:ptCount val="31"/>
                <c:pt idx="1">
                  <c:v>0.10512129380053906</c:v>
                </c:pt>
                <c:pt idx="2">
                  <c:v>7.0080862533692695E-2</c:v>
                </c:pt>
                <c:pt idx="3">
                  <c:v>4.8517520215633429E-2</c:v>
                </c:pt>
                <c:pt idx="4">
                  <c:v>3.7735849056603821E-2</c:v>
                </c:pt>
                <c:pt idx="5">
                  <c:v>2.9649595687331512E-2</c:v>
                </c:pt>
                <c:pt idx="6">
                  <c:v>1.88679245283019E-2</c:v>
                </c:pt>
                <c:pt idx="7">
                  <c:v>1.3477088948787106E-2</c:v>
                </c:pt>
                <c:pt idx="8">
                  <c:v>2.1563342318059318E-2</c:v>
                </c:pt>
                <c:pt idx="9">
                  <c:v>3.5040431266846403E-2</c:v>
                </c:pt>
                <c:pt idx="10">
                  <c:v>2.9649595687331512E-2</c:v>
                </c:pt>
                <c:pt idx="11">
                  <c:v>4.0431266846361218E-2</c:v>
                </c:pt>
                <c:pt idx="12">
                  <c:v>4.0431266846361218E-2</c:v>
                </c:pt>
                <c:pt idx="13">
                  <c:v>5.1212938005390812E-2</c:v>
                </c:pt>
                <c:pt idx="14">
                  <c:v>6.7385444743935333E-2</c:v>
                </c:pt>
                <c:pt idx="15">
                  <c:v>5.92991913746631E-2</c:v>
                </c:pt>
                <c:pt idx="16">
                  <c:v>5.92991913746631E-2</c:v>
                </c:pt>
                <c:pt idx="17">
                  <c:v>5.6603773584905696E-2</c:v>
                </c:pt>
                <c:pt idx="18">
                  <c:v>2.9649595687331512E-2</c:v>
                </c:pt>
                <c:pt idx="19">
                  <c:v>2.6954177897574118E-2</c:v>
                </c:pt>
                <c:pt idx="20">
                  <c:v>8.0862533692722394E-3</c:v>
                </c:pt>
                <c:pt idx="21">
                  <c:v>0</c:v>
                </c:pt>
                <c:pt idx="22">
                  <c:v>0</c:v>
                </c:pt>
                <c:pt idx="23">
                  <c:v>2.6954177897574112E-3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"/>
          <c:order val="1"/>
          <c:tx>
            <c:strRef>
              <c:f>'N2 A2_0.02_50%'!$C$104</c:f>
              <c:strCache>
                <c:ptCount val="1"/>
                <c:pt idx="0">
                  <c:v>N2_A2_40_30_03</c:v>
                </c:pt>
              </c:strCache>
            </c:strRef>
          </c:tx>
          <c:marker>
            <c:symbol val="none"/>
          </c:marker>
          <c:cat>
            <c:numRef>
              <c:f>'N2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2_0.02_50%'!$C$105:$C$135</c:f>
              <c:numCache>
                <c:formatCode>General</c:formatCode>
                <c:ptCount val="31"/>
                <c:pt idx="1">
                  <c:v>3.9408866995073899E-2</c:v>
                </c:pt>
                <c:pt idx="2">
                  <c:v>2.6272577996715913E-2</c:v>
                </c:pt>
                <c:pt idx="3">
                  <c:v>3.2840722495894911E-2</c:v>
                </c:pt>
                <c:pt idx="4">
                  <c:v>2.2988505747126402E-2</c:v>
                </c:pt>
                <c:pt idx="5">
                  <c:v>1.8062397372742199E-2</c:v>
                </c:pt>
                <c:pt idx="6">
                  <c:v>1.9704433497536908E-2</c:v>
                </c:pt>
                <c:pt idx="7">
                  <c:v>6.56814449917898E-3</c:v>
                </c:pt>
                <c:pt idx="8">
                  <c:v>1.6420361247947511E-2</c:v>
                </c:pt>
                <c:pt idx="9">
                  <c:v>2.13464696223317E-2</c:v>
                </c:pt>
                <c:pt idx="10">
                  <c:v>2.2988505747126402E-2</c:v>
                </c:pt>
                <c:pt idx="11">
                  <c:v>3.9408866995073899E-2</c:v>
                </c:pt>
                <c:pt idx="12">
                  <c:v>5.4187192118226618E-2</c:v>
                </c:pt>
                <c:pt idx="13">
                  <c:v>9.0311986863710961E-2</c:v>
                </c:pt>
                <c:pt idx="14">
                  <c:v>9.6880131362890004E-2</c:v>
                </c:pt>
                <c:pt idx="15">
                  <c:v>0.11330049261083695</c:v>
                </c:pt>
                <c:pt idx="16">
                  <c:v>9.1954022988505732E-2</c:v>
                </c:pt>
                <c:pt idx="17">
                  <c:v>7.7175697865352999E-2</c:v>
                </c:pt>
                <c:pt idx="18">
                  <c:v>6.8965517241379309E-2</c:v>
                </c:pt>
                <c:pt idx="19">
                  <c:v>4.9261083743842415E-2</c:v>
                </c:pt>
                <c:pt idx="20">
                  <c:v>1.6420361247947511E-2</c:v>
                </c:pt>
                <c:pt idx="21">
                  <c:v>1.3136288998358E-2</c:v>
                </c:pt>
                <c:pt idx="22">
                  <c:v>8.2101806239737261E-3</c:v>
                </c:pt>
                <c:pt idx="23">
                  <c:v>9.8522167487684765E-3</c:v>
                </c:pt>
                <c:pt idx="24">
                  <c:v>4.9261083743842417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N2 A2_0.02_50%'!$D$104</c:f>
              <c:strCache>
                <c:ptCount val="1"/>
                <c:pt idx="0">
                  <c:v>N2_A2_40_30_04</c:v>
                </c:pt>
              </c:strCache>
            </c:strRef>
          </c:tx>
          <c:marker>
            <c:symbol val="none"/>
          </c:marker>
          <c:cat>
            <c:numRef>
              <c:f>'N2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2_0.02_50%'!$D$105:$D$135</c:f>
              <c:numCache>
                <c:formatCode>General</c:formatCode>
                <c:ptCount val="31"/>
                <c:pt idx="1">
                  <c:v>6.0000000000000019E-2</c:v>
                </c:pt>
                <c:pt idx="2">
                  <c:v>4.2857142857142913E-2</c:v>
                </c:pt>
                <c:pt idx="3">
                  <c:v>6.0000000000000019E-2</c:v>
                </c:pt>
                <c:pt idx="4">
                  <c:v>2.0000000000000007E-2</c:v>
                </c:pt>
                <c:pt idx="5">
                  <c:v>5.7142857142857099E-3</c:v>
                </c:pt>
                <c:pt idx="6">
                  <c:v>1.7142857142857109E-2</c:v>
                </c:pt>
                <c:pt idx="7">
                  <c:v>8.5714285714285701E-3</c:v>
                </c:pt>
                <c:pt idx="8">
                  <c:v>3.1428571428571417E-2</c:v>
                </c:pt>
                <c:pt idx="9">
                  <c:v>5.7142857142857099E-3</c:v>
                </c:pt>
                <c:pt idx="10">
                  <c:v>2.57142857142857E-2</c:v>
                </c:pt>
                <c:pt idx="11">
                  <c:v>5.14285714285714E-2</c:v>
                </c:pt>
                <c:pt idx="12">
                  <c:v>6.2857142857142903E-2</c:v>
                </c:pt>
                <c:pt idx="13">
                  <c:v>6.2857142857142903E-2</c:v>
                </c:pt>
                <c:pt idx="14">
                  <c:v>5.14285714285714E-2</c:v>
                </c:pt>
                <c:pt idx="15">
                  <c:v>0.10285714285714298</c:v>
                </c:pt>
                <c:pt idx="16">
                  <c:v>5.4285714285714312E-2</c:v>
                </c:pt>
                <c:pt idx="17">
                  <c:v>3.1428571428571417E-2</c:v>
                </c:pt>
                <c:pt idx="18">
                  <c:v>4.5714285714285714E-2</c:v>
                </c:pt>
                <c:pt idx="19">
                  <c:v>2.2857142857142906E-2</c:v>
                </c:pt>
                <c:pt idx="20">
                  <c:v>2.57142857142857E-2</c:v>
                </c:pt>
                <c:pt idx="21">
                  <c:v>8.5714285714285701E-3</c:v>
                </c:pt>
                <c:pt idx="22">
                  <c:v>2.8571428571428602E-3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3"/>
          <c:order val="3"/>
          <c:tx>
            <c:strRef>
              <c:f>'N2 A2_0.02_50%'!$E$104</c:f>
              <c:strCache>
                <c:ptCount val="1"/>
                <c:pt idx="0">
                  <c:v>N2_REX_A2_01</c:v>
                </c:pt>
              </c:strCache>
            </c:strRef>
          </c:tx>
          <c:marker>
            <c:symbol val="none"/>
          </c:marker>
          <c:cat>
            <c:numRef>
              <c:f>'N2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2_0.02_50%'!$E$105:$E$135</c:f>
              <c:numCache>
                <c:formatCode>General</c:formatCode>
                <c:ptCount val="31"/>
                <c:pt idx="1">
                  <c:v>5.4614964500273103E-2</c:v>
                </c:pt>
                <c:pt idx="2">
                  <c:v>4.5876570180229399E-2</c:v>
                </c:pt>
                <c:pt idx="3">
                  <c:v>6.8268705625341319E-2</c:v>
                </c:pt>
                <c:pt idx="4">
                  <c:v>6.2261059530311316E-2</c:v>
                </c:pt>
                <c:pt idx="5">
                  <c:v>5.5707263790278502E-2</c:v>
                </c:pt>
                <c:pt idx="6">
                  <c:v>5.4614964500273103E-2</c:v>
                </c:pt>
                <c:pt idx="7">
                  <c:v>6.1168760240305813E-2</c:v>
                </c:pt>
                <c:pt idx="8">
                  <c:v>5.2430365920262199E-2</c:v>
                </c:pt>
                <c:pt idx="9">
                  <c:v>4.8607318405243002E-2</c:v>
                </c:pt>
                <c:pt idx="10">
                  <c:v>6.3899508465319485E-2</c:v>
                </c:pt>
                <c:pt idx="11">
                  <c:v>6.0076460950300434E-2</c:v>
                </c:pt>
                <c:pt idx="12">
                  <c:v>6.3899508465319485E-2</c:v>
                </c:pt>
                <c:pt idx="13">
                  <c:v>5.2430365920262199E-2</c:v>
                </c:pt>
                <c:pt idx="14">
                  <c:v>4.8607318405243002E-2</c:v>
                </c:pt>
                <c:pt idx="15">
                  <c:v>4.1507373020207496E-2</c:v>
                </c:pt>
                <c:pt idx="16">
                  <c:v>3.6045876570180213E-2</c:v>
                </c:pt>
                <c:pt idx="17">
                  <c:v>2.2392135445112007E-2</c:v>
                </c:pt>
                <c:pt idx="18">
                  <c:v>2.0207536865101006E-2</c:v>
                </c:pt>
                <c:pt idx="19">
                  <c:v>1.4199890770070995E-2</c:v>
                </c:pt>
                <c:pt idx="20">
                  <c:v>7.6460950300382318E-3</c:v>
                </c:pt>
                <c:pt idx="21">
                  <c:v>5.461496450027312E-3</c:v>
                </c:pt>
                <c:pt idx="22">
                  <c:v>3.8230475150191202E-3</c:v>
                </c:pt>
                <c:pt idx="23">
                  <c:v>1.6384489350081909E-3</c:v>
                </c:pt>
                <c:pt idx="24">
                  <c:v>1.0922992900054595E-3</c:v>
                </c:pt>
                <c:pt idx="25">
                  <c:v>1.0922992900054595E-3</c:v>
                </c:pt>
                <c:pt idx="26">
                  <c:v>1.6384489350081909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N2 A2_0.02_50%'!$F$104</c:f>
              <c:strCache>
                <c:ptCount val="1"/>
                <c:pt idx="0">
                  <c:v>N2_REX_A2_02</c:v>
                </c:pt>
              </c:strCache>
            </c:strRef>
          </c:tx>
          <c:marker>
            <c:symbol val="none"/>
          </c:marker>
          <c:cat>
            <c:numRef>
              <c:f>'N2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2_0.02_50%'!$F$105:$F$135</c:f>
              <c:numCache>
                <c:formatCode>General</c:formatCode>
                <c:ptCount val="31"/>
                <c:pt idx="1">
                  <c:v>3.4149117814456516E-2</c:v>
                </c:pt>
                <c:pt idx="2">
                  <c:v>3.3010813887307915E-2</c:v>
                </c:pt>
                <c:pt idx="3">
                  <c:v>3.6425725668753614E-2</c:v>
                </c:pt>
                <c:pt idx="4">
                  <c:v>3.5287421741604999E-2</c:v>
                </c:pt>
                <c:pt idx="5">
                  <c:v>3.4149117814456516E-2</c:v>
                </c:pt>
                <c:pt idx="6">
                  <c:v>3.4718269778030698E-2</c:v>
                </c:pt>
                <c:pt idx="7">
                  <c:v>3.8702333523050712E-2</c:v>
                </c:pt>
                <c:pt idx="8">
                  <c:v>2.5042686397268085E-2</c:v>
                </c:pt>
                <c:pt idx="9">
                  <c:v>3.9840637450199216E-2</c:v>
                </c:pt>
                <c:pt idx="10">
                  <c:v>5.2931132612407499E-2</c:v>
                </c:pt>
                <c:pt idx="11">
                  <c:v>6.9436539556061522E-2</c:v>
                </c:pt>
                <c:pt idx="12">
                  <c:v>7.569721115537853E-2</c:v>
                </c:pt>
                <c:pt idx="13">
                  <c:v>9.391007398975533E-2</c:v>
                </c:pt>
                <c:pt idx="14">
                  <c:v>8.9356858281161161E-2</c:v>
                </c:pt>
                <c:pt idx="15">
                  <c:v>7.569721115537853E-2</c:v>
                </c:pt>
                <c:pt idx="16">
                  <c:v>5.5776892430278904E-2</c:v>
                </c:pt>
                <c:pt idx="17">
                  <c:v>4.5532157085941917E-2</c:v>
                </c:pt>
                <c:pt idx="18">
                  <c:v>3.1872509960159411E-2</c:v>
                </c:pt>
                <c:pt idx="19">
                  <c:v>2.5042686397268085E-2</c:v>
                </c:pt>
                <c:pt idx="20">
                  <c:v>1.4797951052931099E-2</c:v>
                </c:pt>
                <c:pt idx="21">
                  <c:v>7.968127490039844E-3</c:v>
                </c:pt>
                <c:pt idx="22">
                  <c:v>5.1223676721684703E-3</c:v>
                </c:pt>
                <c:pt idx="23">
                  <c:v>2.2766078542971009E-3</c:v>
                </c:pt>
                <c:pt idx="24">
                  <c:v>2.8457598178713707E-3</c:v>
                </c:pt>
                <c:pt idx="25">
                  <c:v>0</c:v>
                </c:pt>
                <c:pt idx="26">
                  <c:v>5.6915196357427424E-4</c:v>
                </c:pt>
                <c:pt idx="27">
                  <c:v>0</c:v>
                </c:pt>
                <c:pt idx="28">
                  <c:v>5.6915196357427424E-4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N2 A2_0.02_50%'!$G$104</c:f>
              <c:strCache>
                <c:ptCount val="1"/>
                <c:pt idx="0">
                  <c:v>N2_REX_A2_03</c:v>
                </c:pt>
              </c:strCache>
            </c:strRef>
          </c:tx>
          <c:marker>
            <c:symbol val="none"/>
          </c:marker>
          <c:cat>
            <c:numRef>
              <c:f>'N2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2_0.02_50%'!$G$105:$G$135</c:f>
              <c:numCache>
                <c:formatCode>General</c:formatCode>
                <c:ptCount val="31"/>
                <c:pt idx="1">
                  <c:v>5.2410901467505218E-2</c:v>
                </c:pt>
                <c:pt idx="2">
                  <c:v>4.2627533193570898E-2</c:v>
                </c:pt>
                <c:pt idx="3">
                  <c:v>4.751921733053812E-2</c:v>
                </c:pt>
                <c:pt idx="4">
                  <c:v>3.1446540880503131E-2</c:v>
                </c:pt>
                <c:pt idx="5">
                  <c:v>3.9832285115304011E-2</c:v>
                </c:pt>
                <c:pt idx="6">
                  <c:v>3.1446540880503131E-2</c:v>
                </c:pt>
                <c:pt idx="7">
                  <c:v>3.0747728860936401E-2</c:v>
                </c:pt>
                <c:pt idx="8">
                  <c:v>3.1446540880503131E-2</c:v>
                </c:pt>
                <c:pt idx="9">
                  <c:v>4.2627533193570898E-2</c:v>
                </c:pt>
                <c:pt idx="10">
                  <c:v>4.8916841369671615E-2</c:v>
                </c:pt>
                <c:pt idx="11">
                  <c:v>5.9399021663172617E-2</c:v>
                </c:pt>
                <c:pt idx="12">
                  <c:v>7.4074074074074098E-2</c:v>
                </c:pt>
                <c:pt idx="13">
                  <c:v>7.9664570230608023E-2</c:v>
                </c:pt>
                <c:pt idx="14">
                  <c:v>8.5953878406708595E-2</c:v>
                </c:pt>
                <c:pt idx="15">
                  <c:v>7.0580013976240433E-2</c:v>
                </c:pt>
                <c:pt idx="16">
                  <c:v>6.9881201956673744E-2</c:v>
                </c:pt>
                <c:pt idx="17">
                  <c:v>4.0531097134870714E-2</c:v>
                </c:pt>
                <c:pt idx="18">
                  <c:v>2.9350104821802891E-2</c:v>
                </c:pt>
                <c:pt idx="19">
                  <c:v>2.0265548567435402E-2</c:v>
                </c:pt>
                <c:pt idx="20">
                  <c:v>1.1879804332634504E-2</c:v>
                </c:pt>
                <c:pt idx="21">
                  <c:v>4.1928721174004204E-3</c:v>
                </c:pt>
                <c:pt idx="22">
                  <c:v>4.1928721174004204E-3</c:v>
                </c:pt>
                <c:pt idx="23">
                  <c:v>2.0964360587002111E-3</c:v>
                </c:pt>
                <c:pt idx="24">
                  <c:v>2.0964360587002111E-3</c:v>
                </c:pt>
                <c:pt idx="25">
                  <c:v>6.988120195667376E-4</c:v>
                </c:pt>
                <c:pt idx="26">
                  <c:v>0</c:v>
                </c:pt>
                <c:pt idx="27">
                  <c:v>1.39762403913347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6"/>
          <c:order val="6"/>
          <c:tx>
            <c:strRef>
              <c:f>'N2 A2_0.02_50%'!$H$104</c:f>
              <c:strCache>
                <c:ptCount val="1"/>
                <c:pt idx="0">
                  <c:v>N2_REX_A2_04</c:v>
                </c:pt>
              </c:strCache>
            </c:strRef>
          </c:tx>
          <c:marker>
            <c:symbol val="none"/>
          </c:marker>
          <c:cat>
            <c:numRef>
              <c:f>'N2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2_0.02_50%'!$H$105:$H$135</c:f>
              <c:numCache>
                <c:formatCode>General</c:formatCode>
                <c:ptCount val="31"/>
                <c:pt idx="1">
                  <c:v>4.1296060991105513E-2</c:v>
                </c:pt>
                <c:pt idx="2">
                  <c:v>5.8449809402795379E-2</c:v>
                </c:pt>
                <c:pt idx="3">
                  <c:v>5.0190597204574312E-2</c:v>
                </c:pt>
                <c:pt idx="4">
                  <c:v>4.8284625158831029E-2</c:v>
                </c:pt>
                <c:pt idx="5">
                  <c:v>5.6543837357052096E-2</c:v>
                </c:pt>
                <c:pt idx="6">
                  <c:v>5.1461245235069883E-2</c:v>
                </c:pt>
                <c:pt idx="7">
                  <c:v>4.7013977128335535E-2</c:v>
                </c:pt>
                <c:pt idx="8">
                  <c:v>5.5273189326556497E-2</c:v>
                </c:pt>
                <c:pt idx="9">
                  <c:v>4.3837357052096626E-2</c:v>
                </c:pt>
                <c:pt idx="10">
                  <c:v>4.5108005082592086E-2</c:v>
                </c:pt>
                <c:pt idx="11">
                  <c:v>5.4002541296061017E-2</c:v>
                </c:pt>
                <c:pt idx="12">
                  <c:v>6.9250317662007579E-2</c:v>
                </c:pt>
                <c:pt idx="13">
                  <c:v>6.2261753494282084E-2</c:v>
                </c:pt>
                <c:pt idx="14">
                  <c:v>5.9720457433291026E-2</c:v>
                </c:pt>
                <c:pt idx="15">
                  <c:v>5.9085133418043237E-2</c:v>
                </c:pt>
                <c:pt idx="16">
                  <c:v>4.1931385006353177E-2</c:v>
                </c:pt>
                <c:pt idx="17">
                  <c:v>3.1130876747141007E-2</c:v>
                </c:pt>
                <c:pt idx="18">
                  <c:v>2.1601016518424422E-2</c:v>
                </c:pt>
                <c:pt idx="19">
                  <c:v>1.4612452350698898E-2</c:v>
                </c:pt>
                <c:pt idx="20">
                  <c:v>9.5298602287166544E-3</c:v>
                </c:pt>
                <c:pt idx="21">
                  <c:v>8.2592121982210942E-3</c:v>
                </c:pt>
                <c:pt idx="22">
                  <c:v>3.8119440914866601E-3</c:v>
                </c:pt>
                <c:pt idx="23">
                  <c:v>2.5412960609911112E-3</c:v>
                </c:pt>
                <c:pt idx="24">
                  <c:v>0</c:v>
                </c:pt>
                <c:pt idx="25">
                  <c:v>6.3532401524777629E-4</c:v>
                </c:pt>
                <c:pt idx="26">
                  <c:v>6.3532401524777629E-4</c:v>
                </c:pt>
                <c:pt idx="27">
                  <c:v>6.3532401524777629E-4</c:v>
                </c:pt>
                <c:pt idx="28">
                  <c:v>6.3532401524777629E-4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N2 A2_0.02_50%'!$I$104</c:f>
              <c:strCache>
                <c:ptCount val="1"/>
                <c:pt idx="0">
                  <c:v>N2_REX_A2_08</c:v>
                </c:pt>
              </c:strCache>
            </c:strRef>
          </c:tx>
          <c:marker>
            <c:symbol val="none"/>
          </c:marker>
          <c:cat>
            <c:numRef>
              <c:f>'N2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2_0.02_50%'!$I$105:$I$135</c:f>
              <c:numCache>
                <c:formatCode>General</c:formatCode>
                <c:ptCount val="31"/>
                <c:pt idx="1">
                  <c:v>4.0312093628088436E-2</c:v>
                </c:pt>
                <c:pt idx="2">
                  <c:v>2.9908972691807499E-2</c:v>
                </c:pt>
                <c:pt idx="3">
                  <c:v>3.6410923276983115E-2</c:v>
                </c:pt>
                <c:pt idx="4">
                  <c:v>1.8205461638491505E-2</c:v>
                </c:pt>
                <c:pt idx="5">
                  <c:v>2.86085825747724E-2</c:v>
                </c:pt>
                <c:pt idx="6">
                  <c:v>1.43042912873862E-2</c:v>
                </c:pt>
                <c:pt idx="7">
                  <c:v>1.0403120936280904E-2</c:v>
                </c:pt>
                <c:pt idx="8">
                  <c:v>9.102730819245777E-3</c:v>
                </c:pt>
                <c:pt idx="9">
                  <c:v>1.9505851755526708E-2</c:v>
                </c:pt>
                <c:pt idx="10">
                  <c:v>4.4213263979193819E-2</c:v>
                </c:pt>
                <c:pt idx="11">
                  <c:v>6.1118335500650184E-2</c:v>
                </c:pt>
                <c:pt idx="12">
                  <c:v>7.5422626788036434E-2</c:v>
                </c:pt>
                <c:pt idx="13">
                  <c:v>8.4525357607282275E-2</c:v>
                </c:pt>
                <c:pt idx="14">
                  <c:v>8.8426527958387555E-2</c:v>
                </c:pt>
                <c:pt idx="15">
                  <c:v>8.4525357607282275E-2</c:v>
                </c:pt>
                <c:pt idx="16">
                  <c:v>6.1118335500650184E-2</c:v>
                </c:pt>
                <c:pt idx="17">
                  <c:v>4.9414824447334235E-2</c:v>
                </c:pt>
                <c:pt idx="18">
                  <c:v>4.4213263979193819E-2</c:v>
                </c:pt>
                <c:pt idx="19">
                  <c:v>3.2509752925877815E-2</c:v>
                </c:pt>
                <c:pt idx="20">
                  <c:v>2.2106631989596892E-2</c:v>
                </c:pt>
                <c:pt idx="21">
                  <c:v>1.1703511053316008E-2</c:v>
                </c:pt>
                <c:pt idx="22">
                  <c:v>1.1703511053316008E-2</c:v>
                </c:pt>
                <c:pt idx="23">
                  <c:v>9.102730819245777E-3</c:v>
                </c:pt>
                <c:pt idx="24">
                  <c:v>2.6007802340702207E-3</c:v>
                </c:pt>
                <c:pt idx="25">
                  <c:v>2.6007802340702207E-3</c:v>
                </c:pt>
                <c:pt idx="26">
                  <c:v>1.3003901170351099E-3</c:v>
                </c:pt>
                <c:pt idx="27">
                  <c:v>1.3003901170351099E-3</c:v>
                </c:pt>
                <c:pt idx="28">
                  <c:v>2.6007802340702207E-3</c:v>
                </c:pt>
                <c:pt idx="29">
                  <c:v>0</c:v>
                </c:pt>
                <c:pt idx="30">
                  <c:v>1.3003901170351099E-3</c:v>
                </c:pt>
              </c:numCache>
            </c:numRef>
          </c:val>
        </c:ser>
        <c:ser>
          <c:idx val="8"/>
          <c:order val="8"/>
          <c:tx>
            <c:strRef>
              <c:f>'N2 A2_0.02_50%'!$J$104</c:f>
              <c:strCache>
                <c:ptCount val="1"/>
                <c:pt idx="0">
                  <c:v>N2_REX_A2_09</c:v>
                </c:pt>
              </c:strCache>
            </c:strRef>
          </c:tx>
          <c:marker>
            <c:symbol val="none"/>
          </c:marker>
          <c:cat>
            <c:numRef>
              <c:f>'N2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2_0.02_50%'!$J$105:$J$135</c:f>
              <c:numCache>
                <c:formatCode>General</c:formatCode>
                <c:ptCount val="31"/>
                <c:pt idx="1">
                  <c:v>2.3715415019762799E-2</c:v>
                </c:pt>
                <c:pt idx="2">
                  <c:v>1.6600790513834007E-2</c:v>
                </c:pt>
                <c:pt idx="3">
                  <c:v>2.5296442687747007E-2</c:v>
                </c:pt>
                <c:pt idx="4">
                  <c:v>1.8972332015810306E-2</c:v>
                </c:pt>
                <c:pt idx="5">
                  <c:v>1.5019762845849795E-2</c:v>
                </c:pt>
                <c:pt idx="6">
                  <c:v>1.18577075098814E-2</c:v>
                </c:pt>
                <c:pt idx="7">
                  <c:v>6.3241106719367562E-3</c:v>
                </c:pt>
                <c:pt idx="8">
                  <c:v>1.1067193675889301E-2</c:v>
                </c:pt>
                <c:pt idx="9">
                  <c:v>1.8972332015810306E-2</c:v>
                </c:pt>
                <c:pt idx="10">
                  <c:v>2.0553359683794511E-2</c:v>
                </c:pt>
                <c:pt idx="11">
                  <c:v>4.031620553359682E-2</c:v>
                </c:pt>
                <c:pt idx="12">
                  <c:v>7.35177865612648E-2</c:v>
                </c:pt>
                <c:pt idx="13">
                  <c:v>0.10988142292490102</c:v>
                </c:pt>
                <c:pt idx="14">
                  <c:v>0.132806324110672</c:v>
                </c:pt>
                <c:pt idx="15">
                  <c:v>0.111462450592885</c:v>
                </c:pt>
                <c:pt idx="16">
                  <c:v>0.10988142292490102</c:v>
                </c:pt>
                <c:pt idx="17">
                  <c:v>7.272727272727271E-2</c:v>
                </c:pt>
                <c:pt idx="18">
                  <c:v>6.1660079051383404E-2</c:v>
                </c:pt>
                <c:pt idx="19">
                  <c:v>4.1106719367588897E-2</c:v>
                </c:pt>
                <c:pt idx="20">
                  <c:v>2.450592885375491E-2</c:v>
                </c:pt>
                <c:pt idx="21">
                  <c:v>7.11462450592885E-3</c:v>
                </c:pt>
                <c:pt idx="22">
                  <c:v>5.5335968379446624E-3</c:v>
                </c:pt>
                <c:pt idx="23">
                  <c:v>3.1620553359683798E-3</c:v>
                </c:pt>
                <c:pt idx="24">
                  <c:v>2.37154150197628E-3</c:v>
                </c:pt>
                <c:pt idx="25">
                  <c:v>3.1620553359683798E-3</c:v>
                </c:pt>
                <c:pt idx="26">
                  <c:v>7.9051383399209518E-4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N2 A2_0.02_50%'!$K$104</c:f>
              <c:strCache>
                <c:ptCount val="1"/>
                <c:pt idx="0">
                  <c:v>N2_REX_A2_10</c:v>
                </c:pt>
              </c:strCache>
            </c:strRef>
          </c:tx>
          <c:marker>
            <c:symbol val="none"/>
          </c:marker>
          <c:cat>
            <c:numRef>
              <c:f>'N2 A2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2_0.02_50%'!$K$105:$K$135</c:f>
              <c:numCache>
                <c:formatCode>General</c:formatCode>
                <c:ptCount val="31"/>
                <c:pt idx="1">
                  <c:v>2.5056947608200517E-2</c:v>
                </c:pt>
                <c:pt idx="2">
                  <c:v>2.9612756264236893E-2</c:v>
                </c:pt>
                <c:pt idx="3">
                  <c:v>1.8223234624145802E-2</c:v>
                </c:pt>
                <c:pt idx="4">
                  <c:v>1.3667425968109305E-2</c:v>
                </c:pt>
                <c:pt idx="5">
                  <c:v>1.1389521640091107E-2</c:v>
                </c:pt>
                <c:pt idx="6">
                  <c:v>4.555808656036448E-3</c:v>
                </c:pt>
                <c:pt idx="7">
                  <c:v>4.555808656036448E-3</c:v>
                </c:pt>
                <c:pt idx="8">
                  <c:v>9.1116173120728908E-3</c:v>
                </c:pt>
                <c:pt idx="9">
                  <c:v>1.8223234624145802E-2</c:v>
                </c:pt>
                <c:pt idx="10">
                  <c:v>3.1890660592255114E-2</c:v>
                </c:pt>
                <c:pt idx="11">
                  <c:v>4.7835990888382723E-2</c:v>
                </c:pt>
                <c:pt idx="12">
                  <c:v>5.4669703872437414E-2</c:v>
                </c:pt>
                <c:pt idx="13">
                  <c:v>7.7448747152619596E-2</c:v>
                </c:pt>
                <c:pt idx="14">
                  <c:v>0.12300683371298403</c:v>
                </c:pt>
                <c:pt idx="15">
                  <c:v>0.12528473804100199</c:v>
                </c:pt>
                <c:pt idx="16">
                  <c:v>0.12984054669703901</c:v>
                </c:pt>
                <c:pt idx="17">
                  <c:v>7.2892938496583126E-2</c:v>
                </c:pt>
                <c:pt idx="18">
                  <c:v>7.9726651480637831E-2</c:v>
                </c:pt>
                <c:pt idx="19">
                  <c:v>4.7835990888382723E-2</c:v>
                </c:pt>
                <c:pt idx="20">
                  <c:v>2.5056947608200517E-2</c:v>
                </c:pt>
                <c:pt idx="21">
                  <c:v>1.5945330296127609E-2</c:v>
                </c:pt>
                <c:pt idx="22">
                  <c:v>4.555808656036448E-3</c:v>
                </c:pt>
                <c:pt idx="23">
                  <c:v>4.555808656036448E-3</c:v>
                </c:pt>
                <c:pt idx="24">
                  <c:v>0</c:v>
                </c:pt>
                <c:pt idx="25">
                  <c:v>0</c:v>
                </c:pt>
                <c:pt idx="26">
                  <c:v>2.277904328018221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2.277904328018221E-3</c:v>
                </c:pt>
              </c:numCache>
            </c:numRef>
          </c:val>
        </c:ser>
        <c:marker val="1"/>
        <c:axId val="162439552"/>
        <c:axId val="162441088"/>
      </c:lineChart>
      <c:catAx>
        <c:axId val="162439552"/>
        <c:scaling>
          <c:orientation val="minMax"/>
        </c:scaling>
        <c:axPos val="b"/>
        <c:numFmt formatCode="0.0_ " sourceLinked="1"/>
        <c:tickLblPos val="nextTo"/>
        <c:crossAx val="162441088"/>
        <c:crosses val="autoZero"/>
        <c:auto val="1"/>
        <c:lblAlgn val="ctr"/>
        <c:lblOffset val="100"/>
        <c:tickLblSkip val="5"/>
        <c:tickMarkSkip val="5"/>
      </c:catAx>
      <c:valAx>
        <c:axId val="162441088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2439552"/>
        <c:crosses val="autoZero"/>
        <c:crossBetween val="between"/>
      </c:valAx>
    </c:plotArea>
    <c:plotVisOnly val="1"/>
  </c:chart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>
                <a:latin typeface="Arial" pitchFamily="34" charset="0"/>
                <a:cs typeface="Arial" pitchFamily="34" charset="0"/>
              </a:rPr>
              <a:t>w.t. L4</a:t>
            </a:r>
            <a:endParaRPr lang="ja-JP" altLang="en-US" sz="1400" b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N2 L4_0.02_50%'!$B$104</c:f>
              <c:strCache>
                <c:ptCount val="1"/>
                <c:pt idx="0">
                  <c:v>N2_L4_0601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B$105:$B$135</c:f>
              <c:numCache>
                <c:formatCode>General</c:formatCode>
                <c:ptCount val="31"/>
              </c:numCache>
            </c:numRef>
          </c:val>
        </c:ser>
        <c:ser>
          <c:idx val="1"/>
          <c:order val="1"/>
          <c:tx>
            <c:strRef>
              <c:f>'N2 L4_0.02_50%'!$C$104</c:f>
              <c:strCache>
                <c:ptCount val="1"/>
                <c:pt idx="0">
                  <c:v>N2_L4_0602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C$105:$C$135</c:f>
              <c:numCache>
                <c:formatCode>General</c:formatCode>
                <c:ptCount val="31"/>
                <c:pt idx="1">
                  <c:v>4.29268292682927E-2</c:v>
                </c:pt>
                <c:pt idx="2">
                  <c:v>5.073170731707323E-2</c:v>
                </c:pt>
                <c:pt idx="3">
                  <c:v>4.3902439024390227E-2</c:v>
                </c:pt>
                <c:pt idx="4">
                  <c:v>3.0243902439024421E-2</c:v>
                </c:pt>
                <c:pt idx="5">
                  <c:v>4.29268292682927E-2</c:v>
                </c:pt>
                <c:pt idx="6">
                  <c:v>3.121951219512201E-2</c:v>
                </c:pt>
                <c:pt idx="7">
                  <c:v>3.9024390243902397E-2</c:v>
                </c:pt>
                <c:pt idx="8">
                  <c:v>4.0000000000000015E-2</c:v>
                </c:pt>
                <c:pt idx="9">
                  <c:v>4.1951219512195083E-2</c:v>
                </c:pt>
                <c:pt idx="10">
                  <c:v>5.75609756097561E-2</c:v>
                </c:pt>
                <c:pt idx="11">
                  <c:v>3.9024390243902397E-2</c:v>
                </c:pt>
                <c:pt idx="12">
                  <c:v>5.9512195121951238E-2</c:v>
                </c:pt>
                <c:pt idx="13">
                  <c:v>5.4634146341463401E-2</c:v>
                </c:pt>
                <c:pt idx="14">
                  <c:v>6.7317073170731753E-2</c:v>
                </c:pt>
                <c:pt idx="15">
                  <c:v>6.4390243902439026E-2</c:v>
                </c:pt>
                <c:pt idx="16">
                  <c:v>5.5609756097560969E-2</c:v>
                </c:pt>
                <c:pt idx="17">
                  <c:v>4.1951219512195083E-2</c:v>
                </c:pt>
                <c:pt idx="18">
                  <c:v>4.0975609756097583E-2</c:v>
                </c:pt>
                <c:pt idx="19">
                  <c:v>2.9268292682926814E-2</c:v>
                </c:pt>
                <c:pt idx="20">
                  <c:v>2.9268292682926814E-2</c:v>
                </c:pt>
                <c:pt idx="21">
                  <c:v>2.1463414634146302E-2</c:v>
                </c:pt>
                <c:pt idx="22">
                  <c:v>1.26829268292683E-2</c:v>
                </c:pt>
                <c:pt idx="23">
                  <c:v>5.8536585365853702E-3</c:v>
                </c:pt>
                <c:pt idx="24">
                  <c:v>4.8780487804878031E-3</c:v>
                </c:pt>
                <c:pt idx="25">
                  <c:v>3.90243902439024E-3</c:v>
                </c:pt>
                <c:pt idx="26">
                  <c:v>5.8536585365853702E-3</c:v>
                </c:pt>
                <c:pt idx="27">
                  <c:v>1.9512195121951204E-3</c:v>
                </c:pt>
                <c:pt idx="28">
                  <c:v>9.7560975609756173E-4</c:v>
                </c:pt>
                <c:pt idx="29">
                  <c:v>9.7560975609756173E-4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N2 L4_0.02_50%'!$D$104</c:f>
              <c:strCache>
                <c:ptCount val="1"/>
                <c:pt idx="0">
                  <c:v>N2_L4_0603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D$105:$D$135</c:f>
              <c:numCache>
                <c:formatCode>General</c:formatCode>
                <c:ptCount val="31"/>
                <c:pt idx="1">
                  <c:v>5.3140096618357481E-2</c:v>
                </c:pt>
                <c:pt idx="2">
                  <c:v>5.3140096618357481E-2</c:v>
                </c:pt>
                <c:pt idx="3">
                  <c:v>7.7294685990338244E-2</c:v>
                </c:pt>
                <c:pt idx="4">
                  <c:v>3.8647342995169122E-2</c:v>
                </c:pt>
                <c:pt idx="5">
                  <c:v>2.8985507246376802E-2</c:v>
                </c:pt>
                <c:pt idx="6">
                  <c:v>2.8985507246376802E-2</c:v>
                </c:pt>
                <c:pt idx="7">
                  <c:v>3.8647342995169122E-2</c:v>
                </c:pt>
                <c:pt idx="8">
                  <c:v>1.9323671497584509E-2</c:v>
                </c:pt>
                <c:pt idx="9">
                  <c:v>4.8309178743961385E-3</c:v>
                </c:pt>
                <c:pt idx="10">
                  <c:v>2.8985507246376802E-2</c:v>
                </c:pt>
                <c:pt idx="11">
                  <c:v>3.8647342995169122E-2</c:v>
                </c:pt>
                <c:pt idx="12">
                  <c:v>8.2125603864734303E-2</c:v>
                </c:pt>
                <c:pt idx="13">
                  <c:v>6.2801932367149801E-2</c:v>
                </c:pt>
                <c:pt idx="14">
                  <c:v>5.7971014492753603E-2</c:v>
                </c:pt>
                <c:pt idx="15">
                  <c:v>3.8647342995169122E-2</c:v>
                </c:pt>
                <c:pt idx="16">
                  <c:v>1.4492753623188401E-2</c:v>
                </c:pt>
                <c:pt idx="17">
                  <c:v>5.7971014492753603E-2</c:v>
                </c:pt>
                <c:pt idx="18">
                  <c:v>1.9323671497584509E-2</c:v>
                </c:pt>
                <c:pt idx="19">
                  <c:v>4.8309178743961385E-3</c:v>
                </c:pt>
                <c:pt idx="20">
                  <c:v>4.8309178743961385E-3</c:v>
                </c:pt>
                <c:pt idx="21">
                  <c:v>2.4154589371980683E-2</c:v>
                </c:pt>
                <c:pt idx="22">
                  <c:v>4.8309178743961385E-3</c:v>
                </c:pt>
                <c:pt idx="23">
                  <c:v>9.6618357487922701E-3</c:v>
                </c:pt>
                <c:pt idx="24">
                  <c:v>1.4492753623188401E-2</c:v>
                </c:pt>
                <c:pt idx="25">
                  <c:v>0</c:v>
                </c:pt>
                <c:pt idx="26">
                  <c:v>0</c:v>
                </c:pt>
                <c:pt idx="27">
                  <c:v>4.8309178743961385E-3</c:v>
                </c:pt>
                <c:pt idx="28">
                  <c:v>4.8309178743961385E-3</c:v>
                </c:pt>
                <c:pt idx="29">
                  <c:v>0</c:v>
                </c:pt>
                <c:pt idx="30">
                  <c:v>4.8309178743961385E-3</c:v>
                </c:pt>
              </c:numCache>
            </c:numRef>
          </c:val>
        </c:ser>
        <c:ser>
          <c:idx val="3"/>
          <c:order val="3"/>
          <c:tx>
            <c:strRef>
              <c:f>'N2 L4_0.02_50%'!$E$104</c:f>
              <c:strCache>
                <c:ptCount val="1"/>
                <c:pt idx="0">
                  <c:v>N2_L4_0604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E$105:$E$135</c:f>
              <c:numCache>
                <c:formatCode>General</c:formatCode>
                <c:ptCount val="31"/>
                <c:pt idx="1">
                  <c:v>3.7988826815642501E-2</c:v>
                </c:pt>
                <c:pt idx="2">
                  <c:v>4.1340782122904984E-2</c:v>
                </c:pt>
                <c:pt idx="3">
                  <c:v>5.5865921787709501E-2</c:v>
                </c:pt>
                <c:pt idx="4">
                  <c:v>3.7988826815642501E-2</c:v>
                </c:pt>
                <c:pt idx="5">
                  <c:v>4.4692737430167627E-2</c:v>
                </c:pt>
                <c:pt idx="6">
                  <c:v>4.8044692737430221E-2</c:v>
                </c:pt>
                <c:pt idx="7">
                  <c:v>3.91061452513966E-2</c:v>
                </c:pt>
                <c:pt idx="8">
                  <c:v>3.6871508379888313E-2</c:v>
                </c:pt>
                <c:pt idx="9">
                  <c:v>4.6927374301675984E-2</c:v>
                </c:pt>
                <c:pt idx="10">
                  <c:v>6.9273743016759801E-2</c:v>
                </c:pt>
                <c:pt idx="11">
                  <c:v>5.4748603351955319E-2</c:v>
                </c:pt>
                <c:pt idx="12">
                  <c:v>4.9162011173184417E-2</c:v>
                </c:pt>
                <c:pt idx="13">
                  <c:v>6.0335195530726318E-2</c:v>
                </c:pt>
                <c:pt idx="14">
                  <c:v>4.2458100558659201E-2</c:v>
                </c:pt>
                <c:pt idx="15">
                  <c:v>4.2458100558659201E-2</c:v>
                </c:pt>
                <c:pt idx="16">
                  <c:v>5.1396648044692718E-2</c:v>
                </c:pt>
                <c:pt idx="17">
                  <c:v>3.7988826815642501E-2</c:v>
                </c:pt>
                <c:pt idx="18">
                  <c:v>4.6927374301675984E-2</c:v>
                </c:pt>
                <c:pt idx="19">
                  <c:v>2.7932960893854705E-2</c:v>
                </c:pt>
                <c:pt idx="20">
                  <c:v>1.7877094972066999E-2</c:v>
                </c:pt>
                <c:pt idx="21">
                  <c:v>1.7877094972066999E-2</c:v>
                </c:pt>
                <c:pt idx="22">
                  <c:v>2.1229050279329607E-2</c:v>
                </c:pt>
                <c:pt idx="23">
                  <c:v>1.0055865921787701E-2</c:v>
                </c:pt>
                <c:pt idx="24">
                  <c:v>3.3519553072625702E-3</c:v>
                </c:pt>
                <c:pt idx="25">
                  <c:v>6.7039106145251404E-3</c:v>
                </c:pt>
                <c:pt idx="26">
                  <c:v>2.234636871508381E-3</c:v>
                </c:pt>
                <c:pt idx="27">
                  <c:v>3.3519553072625702E-3</c:v>
                </c:pt>
                <c:pt idx="28">
                  <c:v>2.234636871508381E-3</c:v>
                </c:pt>
                <c:pt idx="29">
                  <c:v>1.1173184357541901E-3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N2 L4_0.02_50%'!$F$104</c:f>
              <c:strCache>
                <c:ptCount val="1"/>
                <c:pt idx="0">
                  <c:v>N2_L4_0605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F$105:$F$135</c:f>
              <c:numCache>
                <c:formatCode>General</c:formatCode>
                <c:ptCount val="31"/>
                <c:pt idx="1">
                  <c:v>4.6511627906976737E-2</c:v>
                </c:pt>
                <c:pt idx="2">
                  <c:v>4.3927648578811387E-2</c:v>
                </c:pt>
                <c:pt idx="3">
                  <c:v>4.134366925064601E-2</c:v>
                </c:pt>
                <c:pt idx="4">
                  <c:v>4.52196382428941E-2</c:v>
                </c:pt>
                <c:pt idx="5">
                  <c:v>4.5865633074935429E-2</c:v>
                </c:pt>
                <c:pt idx="6">
                  <c:v>6.0077519379844985E-2</c:v>
                </c:pt>
                <c:pt idx="7">
                  <c:v>4.3927648578811387E-2</c:v>
                </c:pt>
                <c:pt idx="8">
                  <c:v>5.4263565891472902E-2</c:v>
                </c:pt>
                <c:pt idx="9">
                  <c:v>6.3307493540051732E-2</c:v>
                </c:pt>
                <c:pt idx="10">
                  <c:v>5.4263565891472902E-2</c:v>
                </c:pt>
                <c:pt idx="11">
                  <c:v>6.1369509043927621E-2</c:v>
                </c:pt>
                <c:pt idx="12">
                  <c:v>5.9431524547803635E-2</c:v>
                </c:pt>
                <c:pt idx="13">
                  <c:v>6.2661498708010313E-2</c:v>
                </c:pt>
                <c:pt idx="14">
                  <c:v>5.8139534883720916E-2</c:v>
                </c:pt>
                <c:pt idx="15">
                  <c:v>5.0387596899224819E-2</c:v>
                </c:pt>
                <c:pt idx="16">
                  <c:v>3.8113695090439298E-2</c:v>
                </c:pt>
                <c:pt idx="17">
                  <c:v>3.2299741602067215E-2</c:v>
                </c:pt>
                <c:pt idx="18">
                  <c:v>2.97157622739018E-2</c:v>
                </c:pt>
                <c:pt idx="19">
                  <c:v>2.1963824289405708E-2</c:v>
                </c:pt>
                <c:pt idx="20">
                  <c:v>1.5503875968992208E-2</c:v>
                </c:pt>
                <c:pt idx="21">
                  <c:v>1.48578811369509E-2</c:v>
                </c:pt>
                <c:pt idx="22">
                  <c:v>1.0335917312661499E-2</c:v>
                </c:pt>
                <c:pt idx="23">
                  <c:v>9.0439276485788107E-3</c:v>
                </c:pt>
                <c:pt idx="24">
                  <c:v>2.5839793281653726E-3</c:v>
                </c:pt>
                <c:pt idx="25">
                  <c:v>6.4599483204134435E-4</c:v>
                </c:pt>
                <c:pt idx="26">
                  <c:v>0</c:v>
                </c:pt>
                <c:pt idx="27">
                  <c:v>6.4599483204134435E-4</c:v>
                </c:pt>
                <c:pt idx="28">
                  <c:v>6.4599483204134435E-4</c:v>
                </c:pt>
                <c:pt idx="29">
                  <c:v>6.4599483204134435E-4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N2 L4_0.02_50%'!$G$104</c:f>
              <c:strCache>
                <c:ptCount val="1"/>
                <c:pt idx="0">
                  <c:v>N2_L4_0606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G$105:$G$135</c:f>
              <c:numCache>
                <c:formatCode>General</c:formatCode>
                <c:ptCount val="31"/>
                <c:pt idx="1">
                  <c:v>3.9309683604985601E-2</c:v>
                </c:pt>
                <c:pt idx="2">
                  <c:v>2.6845637583892617E-2</c:v>
                </c:pt>
                <c:pt idx="3">
                  <c:v>3.5474592521572416E-2</c:v>
                </c:pt>
                <c:pt idx="4">
                  <c:v>3.1639501438159211E-2</c:v>
                </c:pt>
                <c:pt idx="5">
                  <c:v>4.2186001917545533E-2</c:v>
                </c:pt>
                <c:pt idx="6">
                  <c:v>2.8763183125599199E-2</c:v>
                </c:pt>
                <c:pt idx="7">
                  <c:v>3.35570469798658E-2</c:v>
                </c:pt>
                <c:pt idx="8">
                  <c:v>4.4103547459252199E-2</c:v>
                </c:pt>
                <c:pt idx="9">
                  <c:v>4.6021093000958795E-2</c:v>
                </c:pt>
                <c:pt idx="10">
                  <c:v>3.6433365292425718E-2</c:v>
                </c:pt>
                <c:pt idx="11">
                  <c:v>4.7938638542665404E-2</c:v>
                </c:pt>
                <c:pt idx="12">
                  <c:v>4.9856184084372014E-2</c:v>
                </c:pt>
                <c:pt idx="13">
                  <c:v>5.7526366251198516E-2</c:v>
                </c:pt>
                <c:pt idx="14">
                  <c:v>3.9309683604985601E-2</c:v>
                </c:pt>
                <c:pt idx="15">
                  <c:v>5.7526366251198516E-2</c:v>
                </c:pt>
                <c:pt idx="16">
                  <c:v>5.0814956855225336E-2</c:v>
                </c:pt>
                <c:pt idx="17">
                  <c:v>4.7938638542665404E-2</c:v>
                </c:pt>
                <c:pt idx="18">
                  <c:v>4.9856184084372014E-2</c:v>
                </c:pt>
                <c:pt idx="19">
                  <c:v>3.0680728667305809E-2</c:v>
                </c:pt>
                <c:pt idx="20">
                  <c:v>3.2598274209012498E-2</c:v>
                </c:pt>
                <c:pt idx="21">
                  <c:v>2.492809204218599E-2</c:v>
                </c:pt>
                <c:pt idx="22">
                  <c:v>2.6845637583892617E-2</c:v>
                </c:pt>
                <c:pt idx="23">
                  <c:v>1.5340364333652904E-2</c:v>
                </c:pt>
                <c:pt idx="24">
                  <c:v>1.9175455417066209E-2</c:v>
                </c:pt>
                <c:pt idx="25">
                  <c:v>1.3422818791946301E-2</c:v>
                </c:pt>
                <c:pt idx="26">
                  <c:v>7.67018216682646E-3</c:v>
                </c:pt>
                <c:pt idx="27">
                  <c:v>7.67018216682646E-3</c:v>
                </c:pt>
                <c:pt idx="28">
                  <c:v>5.7526366251198519E-3</c:v>
                </c:pt>
                <c:pt idx="29">
                  <c:v>1.9175455417066213E-3</c:v>
                </c:pt>
                <c:pt idx="30">
                  <c:v>9.5877277085330804E-4</c:v>
                </c:pt>
              </c:numCache>
            </c:numRef>
          </c:val>
        </c:ser>
        <c:ser>
          <c:idx val="6"/>
          <c:order val="6"/>
          <c:tx>
            <c:strRef>
              <c:f>'N2 L4_0.02_50%'!$H$104</c:f>
              <c:strCache>
                <c:ptCount val="1"/>
                <c:pt idx="0">
                  <c:v>N2_L4_0607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H$105:$H$135</c:f>
              <c:numCache>
                <c:formatCode>General</c:formatCode>
                <c:ptCount val="31"/>
              </c:numCache>
            </c:numRef>
          </c:val>
        </c:ser>
        <c:ser>
          <c:idx val="7"/>
          <c:order val="7"/>
          <c:tx>
            <c:strRef>
              <c:f>'N2 L4_0.02_50%'!$I$104</c:f>
              <c:strCache>
                <c:ptCount val="1"/>
                <c:pt idx="0">
                  <c:v>N2_L4_0608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I$105:$I$135</c:f>
              <c:numCache>
                <c:formatCode>General</c:formatCode>
                <c:ptCount val="31"/>
                <c:pt idx="1">
                  <c:v>5.8111380145278502E-2</c:v>
                </c:pt>
                <c:pt idx="2">
                  <c:v>4.35835351089588E-2</c:v>
                </c:pt>
                <c:pt idx="3">
                  <c:v>4.8426150121065395E-2</c:v>
                </c:pt>
                <c:pt idx="4">
                  <c:v>3.1476997578692531E-2</c:v>
                </c:pt>
                <c:pt idx="5">
                  <c:v>4.1162227602905624E-2</c:v>
                </c:pt>
                <c:pt idx="6">
                  <c:v>2.1791767554479417E-2</c:v>
                </c:pt>
                <c:pt idx="7">
                  <c:v>2.9055690072639202E-2</c:v>
                </c:pt>
                <c:pt idx="8">
                  <c:v>2.1791767554479417E-2</c:v>
                </c:pt>
                <c:pt idx="9">
                  <c:v>3.8740920096852302E-2</c:v>
                </c:pt>
                <c:pt idx="10">
                  <c:v>6.0532687651331754E-2</c:v>
                </c:pt>
                <c:pt idx="11">
                  <c:v>3.8740920096852302E-2</c:v>
                </c:pt>
                <c:pt idx="12">
                  <c:v>4.1162227602905624E-2</c:v>
                </c:pt>
                <c:pt idx="13">
                  <c:v>4.6004842615012073E-2</c:v>
                </c:pt>
                <c:pt idx="14">
                  <c:v>5.5690072639225222E-2</c:v>
                </c:pt>
                <c:pt idx="15">
                  <c:v>3.3898305084745811E-2</c:v>
                </c:pt>
                <c:pt idx="16">
                  <c:v>4.1162227602905624E-2</c:v>
                </c:pt>
                <c:pt idx="17">
                  <c:v>4.8426150121065395E-2</c:v>
                </c:pt>
                <c:pt idx="18">
                  <c:v>5.8111380145278502E-2</c:v>
                </c:pt>
                <c:pt idx="19">
                  <c:v>2.1791767554479417E-2</c:v>
                </c:pt>
                <c:pt idx="20">
                  <c:v>4.1162227602905624E-2</c:v>
                </c:pt>
                <c:pt idx="21">
                  <c:v>2.6634382566586012E-2</c:v>
                </c:pt>
                <c:pt idx="22">
                  <c:v>1.21065375302663E-2</c:v>
                </c:pt>
                <c:pt idx="23">
                  <c:v>2.6634382566586012E-2</c:v>
                </c:pt>
                <c:pt idx="24">
                  <c:v>7.2639225181598101E-3</c:v>
                </c:pt>
                <c:pt idx="25">
                  <c:v>1.21065375302663E-2</c:v>
                </c:pt>
                <c:pt idx="26">
                  <c:v>2.421307506053271E-3</c:v>
                </c:pt>
                <c:pt idx="27">
                  <c:v>4.8426150121065404E-3</c:v>
                </c:pt>
                <c:pt idx="28">
                  <c:v>2.421307506053271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8"/>
          <c:order val="8"/>
          <c:tx>
            <c:strRef>
              <c:f>'N2 L4_0.02_50%'!$J$104</c:f>
              <c:strCache>
                <c:ptCount val="1"/>
                <c:pt idx="0">
                  <c:v>N2_L4_0609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J$105:$J$135</c:f>
              <c:numCache>
                <c:formatCode>General</c:formatCode>
                <c:ptCount val="31"/>
                <c:pt idx="1">
                  <c:v>5.6159420289855086E-2</c:v>
                </c:pt>
                <c:pt idx="2">
                  <c:v>3.6231884057971016E-2</c:v>
                </c:pt>
                <c:pt idx="3">
                  <c:v>3.4420289855072499E-2</c:v>
                </c:pt>
                <c:pt idx="4">
                  <c:v>2.8985507246376802E-2</c:v>
                </c:pt>
                <c:pt idx="5">
                  <c:v>1.8115942028985497E-2</c:v>
                </c:pt>
                <c:pt idx="6">
                  <c:v>1.6304347826087001E-2</c:v>
                </c:pt>
                <c:pt idx="7">
                  <c:v>1.9927536231884108E-2</c:v>
                </c:pt>
                <c:pt idx="8">
                  <c:v>1.8115942028985497E-2</c:v>
                </c:pt>
                <c:pt idx="9">
                  <c:v>2.8985507246376802E-2</c:v>
                </c:pt>
                <c:pt idx="10">
                  <c:v>2.1739130434782601E-2</c:v>
                </c:pt>
                <c:pt idx="11">
                  <c:v>2.7173913043478312E-2</c:v>
                </c:pt>
                <c:pt idx="12">
                  <c:v>2.5362318840579712E-2</c:v>
                </c:pt>
                <c:pt idx="13">
                  <c:v>1.8115942028985497E-2</c:v>
                </c:pt>
                <c:pt idx="14">
                  <c:v>2.1739130434782601E-2</c:v>
                </c:pt>
                <c:pt idx="15">
                  <c:v>1.4492753623188401E-2</c:v>
                </c:pt>
                <c:pt idx="16">
                  <c:v>4.1666666666666699E-2</c:v>
                </c:pt>
                <c:pt idx="17">
                  <c:v>3.6231884057971016E-2</c:v>
                </c:pt>
                <c:pt idx="18">
                  <c:v>6.3405797101449321E-2</c:v>
                </c:pt>
                <c:pt idx="19">
                  <c:v>5.4347826086956499E-2</c:v>
                </c:pt>
                <c:pt idx="20">
                  <c:v>6.15942028985507E-2</c:v>
                </c:pt>
                <c:pt idx="21">
                  <c:v>5.0724637681159403E-2</c:v>
                </c:pt>
                <c:pt idx="22">
                  <c:v>4.8913043478260886E-2</c:v>
                </c:pt>
                <c:pt idx="23">
                  <c:v>5.0724637681159403E-2</c:v>
                </c:pt>
                <c:pt idx="24">
                  <c:v>3.9855072463768113E-2</c:v>
                </c:pt>
                <c:pt idx="25">
                  <c:v>1.9927536231884108E-2</c:v>
                </c:pt>
                <c:pt idx="26">
                  <c:v>2.8985507246376802E-2</c:v>
                </c:pt>
                <c:pt idx="27">
                  <c:v>1.2681159420289901E-2</c:v>
                </c:pt>
                <c:pt idx="28">
                  <c:v>1.6304347826087001E-2</c:v>
                </c:pt>
                <c:pt idx="29">
                  <c:v>1.6304347826087001E-2</c:v>
                </c:pt>
                <c:pt idx="30">
                  <c:v>1.0869565217391306E-2</c:v>
                </c:pt>
              </c:numCache>
            </c:numRef>
          </c:val>
        </c:ser>
        <c:ser>
          <c:idx val="9"/>
          <c:order val="9"/>
          <c:tx>
            <c:strRef>
              <c:f>'N2 L4_0.02_50%'!$K$104</c:f>
              <c:strCache>
                <c:ptCount val="1"/>
                <c:pt idx="0">
                  <c:v>N2_L4_0611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K$105:$K$135</c:f>
              <c:numCache>
                <c:formatCode>General</c:formatCode>
                <c:ptCount val="31"/>
                <c:pt idx="1">
                  <c:v>2.86885245901639E-2</c:v>
                </c:pt>
                <c:pt idx="2">
                  <c:v>3.6885245901639323E-2</c:v>
                </c:pt>
                <c:pt idx="3">
                  <c:v>4.5081967213114804E-2</c:v>
                </c:pt>
                <c:pt idx="4">
                  <c:v>2.86885245901639E-2</c:v>
                </c:pt>
                <c:pt idx="5">
                  <c:v>3.6885245901639323E-2</c:v>
                </c:pt>
                <c:pt idx="6">
                  <c:v>3.2786885245901599E-2</c:v>
                </c:pt>
                <c:pt idx="7">
                  <c:v>3.2786885245901599E-2</c:v>
                </c:pt>
                <c:pt idx="8">
                  <c:v>2.0491803278688499E-2</c:v>
                </c:pt>
                <c:pt idx="9">
                  <c:v>2.0491803278688499E-2</c:v>
                </c:pt>
                <c:pt idx="10">
                  <c:v>1.63934426229508E-2</c:v>
                </c:pt>
                <c:pt idx="11">
                  <c:v>3.6885245901639323E-2</c:v>
                </c:pt>
                <c:pt idx="12">
                  <c:v>3.6885245901639323E-2</c:v>
                </c:pt>
                <c:pt idx="13">
                  <c:v>6.1475409836065614E-2</c:v>
                </c:pt>
                <c:pt idx="14">
                  <c:v>2.86885245901639E-2</c:v>
                </c:pt>
                <c:pt idx="15">
                  <c:v>7.3770491803278743E-2</c:v>
                </c:pt>
                <c:pt idx="16">
                  <c:v>6.1475409836065614E-2</c:v>
                </c:pt>
                <c:pt idx="17">
                  <c:v>4.5081967213114804E-2</c:v>
                </c:pt>
                <c:pt idx="18">
                  <c:v>4.91803278688525E-2</c:v>
                </c:pt>
                <c:pt idx="19">
                  <c:v>4.91803278688525E-2</c:v>
                </c:pt>
                <c:pt idx="20">
                  <c:v>1.2295081967213101E-2</c:v>
                </c:pt>
                <c:pt idx="21">
                  <c:v>2.4590163934426198E-2</c:v>
                </c:pt>
                <c:pt idx="22">
                  <c:v>4.5081967213114804E-2</c:v>
                </c:pt>
                <c:pt idx="23">
                  <c:v>4.0983606557377103E-3</c:v>
                </c:pt>
                <c:pt idx="24">
                  <c:v>1.2295081967213101E-2</c:v>
                </c:pt>
                <c:pt idx="25">
                  <c:v>1.2295081967213101E-2</c:v>
                </c:pt>
                <c:pt idx="26">
                  <c:v>8.1967213114754103E-3</c:v>
                </c:pt>
                <c:pt idx="27">
                  <c:v>4.0983606557377103E-3</c:v>
                </c:pt>
                <c:pt idx="28">
                  <c:v>0</c:v>
                </c:pt>
                <c:pt idx="29">
                  <c:v>0</c:v>
                </c:pt>
                <c:pt idx="30">
                  <c:v>4.0983606557377103E-3</c:v>
                </c:pt>
              </c:numCache>
            </c:numRef>
          </c:val>
        </c:ser>
        <c:ser>
          <c:idx val="10"/>
          <c:order val="10"/>
          <c:tx>
            <c:strRef>
              <c:f>'N2 L4_0.02_50%'!$L$104</c:f>
              <c:strCache>
                <c:ptCount val="1"/>
                <c:pt idx="0">
                  <c:v>N2_L4_0612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L$105:$L$135</c:f>
              <c:numCache>
                <c:formatCode>General</c:formatCode>
                <c:ptCount val="31"/>
                <c:pt idx="1">
                  <c:v>4.1139240506329083E-2</c:v>
                </c:pt>
                <c:pt idx="2">
                  <c:v>2.5316455696202493E-2</c:v>
                </c:pt>
                <c:pt idx="3">
                  <c:v>3.1645569620253215E-2</c:v>
                </c:pt>
                <c:pt idx="4">
                  <c:v>1.8987341772151899E-2</c:v>
                </c:pt>
                <c:pt idx="5">
                  <c:v>2.2151898734177201E-2</c:v>
                </c:pt>
                <c:pt idx="6">
                  <c:v>2.2151898734177201E-2</c:v>
                </c:pt>
                <c:pt idx="7">
                  <c:v>2.2151898734177201E-2</c:v>
                </c:pt>
                <c:pt idx="8">
                  <c:v>1.5822784810126601E-2</c:v>
                </c:pt>
                <c:pt idx="9">
                  <c:v>5.3797468354430431E-2</c:v>
                </c:pt>
                <c:pt idx="10">
                  <c:v>2.5316455696202493E-2</c:v>
                </c:pt>
                <c:pt idx="11">
                  <c:v>3.1645569620253215E-2</c:v>
                </c:pt>
                <c:pt idx="12">
                  <c:v>3.7974683544303806E-2</c:v>
                </c:pt>
                <c:pt idx="13">
                  <c:v>3.4810126582278514E-2</c:v>
                </c:pt>
                <c:pt idx="14">
                  <c:v>6.3291139240506333E-2</c:v>
                </c:pt>
                <c:pt idx="15">
                  <c:v>7.9113924050632944E-2</c:v>
                </c:pt>
                <c:pt idx="16">
                  <c:v>3.1645569620253215E-2</c:v>
                </c:pt>
                <c:pt idx="17">
                  <c:v>5.6962025316455701E-2</c:v>
                </c:pt>
                <c:pt idx="18">
                  <c:v>6.6455696202531625E-2</c:v>
                </c:pt>
                <c:pt idx="19">
                  <c:v>6.6455696202531625E-2</c:v>
                </c:pt>
                <c:pt idx="20">
                  <c:v>3.4810126582278514E-2</c:v>
                </c:pt>
                <c:pt idx="21">
                  <c:v>4.1139240506329083E-2</c:v>
                </c:pt>
                <c:pt idx="22">
                  <c:v>2.8481012658227816E-2</c:v>
                </c:pt>
                <c:pt idx="23">
                  <c:v>9.4936708860759531E-3</c:v>
                </c:pt>
                <c:pt idx="24">
                  <c:v>2.2151898734177201E-2</c:v>
                </c:pt>
                <c:pt idx="25">
                  <c:v>9.4936708860759531E-3</c:v>
                </c:pt>
                <c:pt idx="26">
                  <c:v>1.2658227848101299E-2</c:v>
                </c:pt>
                <c:pt idx="27">
                  <c:v>9.4936708860759531E-3</c:v>
                </c:pt>
                <c:pt idx="28">
                  <c:v>9.4936708860759531E-3</c:v>
                </c:pt>
                <c:pt idx="29">
                  <c:v>3.164556962025322E-3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N2 L4_0.02_50%'!$M$104</c:f>
              <c:strCache>
                <c:ptCount val="1"/>
                <c:pt idx="0">
                  <c:v>N2_L4_0613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M$105:$M$135</c:f>
              <c:numCache>
                <c:formatCode>General</c:formatCode>
                <c:ptCount val="31"/>
                <c:pt idx="1">
                  <c:v>3.1034482758620714E-2</c:v>
                </c:pt>
                <c:pt idx="2">
                  <c:v>3.7931034482758613E-2</c:v>
                </c:pt>
                <c:pt idx="3">
                  <c:v>4.8275862068965461E-2</c:v>
                </c:pt>
                <c:pt idx="4">
                  <c:v>3.4482758620689717E-2</c:v>
                </c:pt>
                <c:pt idx="5">
                  <c:v>3.7931034482758613E-2</c:v>
                </c:pt>
                <c:pt idx="6">
                  <c:v>5.1724137931034517E-2</c:v>
                </c:pt>
                <c:pt idx="7">
                  <c:v>4.4827586206896627E-2</c:v>
                </c:pt>
                <c:pt idx="8">
                  <c:v>4.4827586206896627E-2</c:v>
                </c:pt>
                <c:pt idx="9">
                  <c:v>5.1724137931034517E-2</c:v>
                </c:pt>
                <c:pt idx="10">
                  <c:v>3.1034482758620714E-2</c:v>
                </c:pt>
                <c:pt idx="11">
                  <c:v>6.206896551724142E-2</c:v>
                </c:pt>
                <c:pt idx="12">
                  <c:v>4.8275862068965461E-2</c:v>
                </c:pt>
                <c:pt idx="13">
                  <c:v>5.1724137931034517E-2</c:v>
                </c:pt>
                <c:pt idx="14">
                  <c:v>6.206896551724142E-2</c:v>
                </c:pt>
                <c:pt idx="15">
                  <c:v>6.551724137931042E-2</c:v>
                </c:pt>
                <c:pt idx="16">
                  <c:v>3.7931034482758613E-2</c:v>
                </c:pt>
                <c:pt idx="17">
                  <c:v>2.0689655172413814E-2</c:v>
                </c:pt>
                <c:pt idx="18">
                  <c:v>3.4482758620689717E-2</c:v>
                </c:pt>
                <c:pt idx="19">
                  <c:v>4.13793103448276E-2</c:v>
                </c:pt>
                <c:pt idx="20">
                  <c:v>2.4137931034482793E-2</c:v>
                </c:pt>
                <c:pt idx="21">
                  <c:v>1.3793103448275905E-2</c:v>
                </c:pt>
                <c:pt idx="22">
                  <c:v>1.7241379310344803E-2</c:v>
                </c:pt>
                <c:pt idx="23">
                  <c:v>2.4137931034482793E-2</c:v>
                </c:pt>
                <c:pt idx="24">
                  <c:v>1.03448275862069E-2</c:v>
                </c:pt>
                <c:pt idx="25">
                  <c:v>3.4482758620689707E-3</c:v>
                </c:pt>
                <c:pt idx="26">
                  <c:v>3.4482758620689707E-3</c:v>
                </c:pt>
                <c:pt idx="27">
                  <c:v>3.4482758620689707E-3</c:v>
                </c:pt>
                <c:pt idx="28">
                  <c:v>0</c:v>
                </c:pt>
                <c:pt idx="29">
                  <c:v>0</c:v>
                </c:pt>
                <c:pt idx="30">
                  <c:v>3.4482758620689707E-3</c:v>
                </c:pt>
              </c:numCache>
            </c:numRef>
          </c:val>
        </c:ser>
        <c:ser>
          <c:idx val="12"/>
          <c:order val="12"/>
          <c:tx>
            <c:strRef>
              <c:f>'N2 L4_0.02_50%'!$N$104</c:f>
              <c:strCache>
                <c:ptCount val="1"/>
                <c:pt idx="0">
                  <c:v>N2_L4_0614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N$105:$N$135</c:f>
              <c:numCache>
                <c:formatCode>General</c:formatCode>
                <c:ptCount val="31"/>
                <c:pt idx="1">
                  <c:v>4.9549549549549585E-2</c:v>
                </c:pt>
                <c:pt idx="2">
                  <c:v>3.7162162162162199E-2</c:v>
                </c:pt>
                <c:pt idx="3">
                  <c:v>1.5765765765765806E-2</c:v>
                </c:pt>
                <c:pt idx="4">
                  <c:v>2.0270270270270313E-2</c:v>
                </c:pt>
                <c:pt idx="5">
                  <c:v>2.9279279279279317E-2</c:v>
                </c:pt>
                <c:pt idx="6">
                  <c:v>3.0405405405405414E-2</c:v>
                </c:pt>
                <c:pt idx="7">
                  <c:v>2.3648648648648692E-2</c:v>
                </c:pt>
                <c:pt idx="8">
                  <c:v>1.4639639639639601E-2</c:v>
                </c:pt>
                <c:pt idx="9">
                  <c:v>2.9279279279279317E-2</c:v>
                </c:pt>
                <c:pt idx="10">
                  <c:v>2.8153153153153199E-2</c:v>
                </c:pt>
                <c:pt idx="11">
                  <c:v>2.9279279279279317E-2</c:v>
                </c:pt>
                <c:pt idx="12">
                  <c:v>4.2792792792792821E-2</c:v>
                </c:pt>
                <c:pt idx="13">
                  <c:v>4.7297297297297321E-2</c:v>
                </c:pt>
                <c:pt idx="14">
                  <c:v>7.0945945945945901E-2</c:v>
                </c:pt>
                <c:pt idx="15">
                  <c:v>6.9819819819819814E-2</c:v>
                </c:pt>
                <c:pt idx="16">
                  <c:v>8.1081081081081099E-2</c:v>
                </c:pt>
                <c:pt idx="17">
                  <c:v>5.2927927927927935E-2</c:v>
                </c:pt>
                <c:pt idx="18">
                  <c:v>6.3063063063063099E-2</c:v>
                </c:pt>
                <c:pt idx="19">
                  <c:v>4.2792792792792821E-2</c:v>
                </c:pt>
                <c:pt idx="20">
                  <c:v>3.9414414414414414E-2</c:v>
                </c:pt>
                <c:pt idx="21">
                  <c:v>4.2792792792792821E-2</c:v>
                </c:pt>
                <c:pt idx="22">
                  <c:v>2.3648648648648692E-2</c:v>
                </c:pt>
                <c:pt idx="23">
                  <c:v>1.9144144144144101E-2</c:v>
                </c:pt>
                <c:pt idx="24">
                  <c:v>1.3513513513513504E-2</c:v>
                </c:pt>
                <c:pt idx="25">
                  <c:v>1.2387387387387401E-2</c:v>
                </c:pt>
                <c:pt idx="26">
                  <c:v>5.6306306306306321E-3</c:v>
                </c:pt>
                <c:pt idx="27">
                  <c:v>4.5045045045045001E-3</c:v>
                </c:pt>
                <c:pt idx="28">
                  <c:v>2.2522522522522509E-3</c:v>
                </c:pt>
                <c:pt idx="29">
                  <c:v>2.2522522522522509E-3</c:v>
                </c:pt>
                <c:pt idx="30">
                  <c:v>0</c:v>
                </c:pt>
              </c:numCache>
            </c:numRef>
          </c:val>
        </c:ser>
        <c:ser>
          <c:idx val="13"/>
          <c:order val="13"/>
          <c:tx>
            <c:strRef>
              <c:f>'N2 L4_0.02_50%'!$O$104</c:f>
              <c:strCache>
                <c:ptCount val="1"/>
                <c:pt idx="0">
                  <c:v>N2_L4_0615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O$105:$O$135</c:f>
              <c:numCache>
                <c:formatCode>General</c:formatCode>
                <c:ptCount val="31"/>
                <c:pt idx="1">
                  <c:v>5.2801030264005198E-2</c:v>
                </c:pt>
                <c:pt idx="2">
                  <c:v>5.9884095299420514E-2</c:v>
                </c:pt>
                <c:pt idx="3">
                  <c:v>4.7649710238248599E-2</c:v>
                </c:pt>
                <c:pt idx="4">
                  <c:v>4.5717965228589813E-2</c:v>
                </c:pt>
                <c:pt idx="5">
                  <c:v>4.8937540244687702E-2</c:v>
                </c:pt>
                <c:pt idx="6">
                  <c:v>5.3444945267224681E-2</c:v>
                </c:pt>
                <c:pt idx="7">
                  <c:v>4.8937540244687702E-2</c:v>
                </c:pt>
                <c:pt idx="8">
                  <c:v>4.7649710238248599E-2</c:v>
                </c:pt>
                <c:pt idx="9">
                  <c:v>6.439150032195752E-2</c:v>
                </c:pt>
                <c:pt idx="10">
                  <c:v>6.2459755312298797E-2</c:v>
                </c:pt>
                <c:pt idx="11">
                  <c:v>5.0225370251126902E-2</c:v>
                </c:pt>
                <c:pt idx="12">
                  <c:v>6.1171925305859562E-2</c:v>
                </c:pt>
                <c:pt idx="13">
                  <c:v>5.2157115260785578E-2</c:v>
                </c:pt>
                <c:pt idx="14">
                  <c:v>5.3444945267224681E-2</c:v>
                </c:pt>
                <c:pt idx="15">
                  <c:v>3.5415325177076615E-2</c:v>
                </c:pt>
                <c:pt idx="16">
                  <c:v>4.8937540244687702E-2</c:v>
                </c:pt>
                <c:pt idx="17">
                  <c:v>3.0907920154539602E-2</c:v>
                </c:pt>
                <c:pt idx="18">
                  <c:v>3.0264005151320002E-2</c:v>
                </c:pt>
                <c:pt idx="19">
                  <c:v>2.060528010302641E-2</c:v>
                </c:pt>
                <c:pt idx="20">
                  <c:v>1.8673535093367711E-2</c:v>
                </c:pt>
                <c:pt idx="21">
                  <c:v>7.0830650354153334E-3</c:v>
                </c:pt>
                <c:pt idx="22">
                  <c:v>1.03026400515132E-2</c:v>
                </c:pt>
                <c:pt idx="23">
                  <c:v>9.6587250482936295E-3</c:v>
                </c:pt>
                <c:pt idx="24">
                  <c:v>5.1513200257566035E-3</c:v>
                </c:pt>
                <c:pt idx="25">
                  <c:v>2.5756600128783009E-3</c:v>
                </c:pt>
                <c:pt idx="26">
                  <c:v>1.931745009658731E-3</c:v>
                </c:pt>
                <c:pt idx="27">
                  <c:v>6.4391500321957522E-4</c:v>
                </c:pt>
                <c:pt idx="28">
                  <c:v>0</c:v>
                </c:pt>
                <c:pt idx="29">
                  <c:v>6.4391500321957522E-4</c:v>
                </c:pt>
                <c:pt idx="30">
                  <c:v>0</c:v>
                </c:pt>
              </c:numCache>
            </c:numRef>
          </c:val>
        </c:ser>
        <c:ser>
          <c:idx val="14"/>
          <c:order val="14"/>
          <c:tx>
            <c:strRef>
              <c:f>'N2 L4_0.02_50%'!$P$104</c:f>
              <c:strCache>
                <c:ptCount val="1"/>
                <c:pt idx="0">
                  <c:v>N2_L4_0616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P$105:$P$135</c:f>
              <c:numCache>
                <c:formatCode>General</c:formatCode>
                <c:ptCount val="31"/>
                <c:pt idx="1">
                  <c:v>4.40251572327044E-2</c:v>
                </c:pt>
                <c:pt idx="2">
                  <c:v>2.8301886792452793E-2</c:v>
                </c:pt>
                <c:pt idx="3">
                  <c:v>1.88679245283019E-2</c:v>
                </c:pt>
                <c:pt idx="4">
                  <c:v>3.1446540880503131E-2</c:v>
                </c:pt>
                <c:pt idx="5">
                  <c:v>2.2012578616352207E-2</c:v>
                </c:pt>
                <c:pt idx="6">
                  <c:v>1.88679245283019E-2</c:v>
                </c:pt>
                <c:pt idx="7">
                  <c:v>1.57232704402516E-2</c:v>
                </c:pt>
                <c:pt idx="8">
                  <c:v>1.2578616352201295E-2</c:v>
                </c:pt>
                <c:pt idx="9">
                  <c:v>1.57232704402516E-2</c:v>
                </c:pt>
                <c:pt idx="10">
                  <c:v>6.2893081761006336E-3</c:v>
                </c:pt>
                <c:pt idx="11">
                  <c:v>1.2578616352201295E-2</c:v>
                </c:pt>
                <c:pt idx="12">
                  <c:v>2.515723270440251E-2</c:v>
                </c:pt>
                <c:pt idx="13">
                  <c:v>2.515723270440251E-2</c:v>
                </c:pt>
                <c:pt idx="14">
                  <c:v>2.2012578616352207E-2</c:v>
                </c:pt>
                <c:pt idx="15">
                  <c:v>5.0314465408804999E-2</c:v>
                </c:pt>
                <c:pt idx="16">
                  <c:v>5.3459119496855285E-2</c:v>
                </c:pt>
                <c:pt idx="17">
                  <c:v>6.6037735849056631E-2</c:v>
                </c:pt>
                <c:pt idx="18">
                  <c:v>0.10377358490566004</c:v>
                </c:pt>
                <c:pt idx="19">
                  <c:v>5.3459119496855285E-2</c:v>
                </c:pt>
                <c:pt idx="20">
                  <c:v>8.4905660377358555E-2</c:v>
                </c:pt>
                <c:pt idx="21">
                  <c:v>5.0314465408804999E-2</c:v>
                </c:pt>
                <c:pt idx="22">
                  <c:v>5.9748427672956017E-2</c:v>
                </c:pt>
                <c:pt idx="23">
                  <c:v>3.4591194968553514E-2</c:v>
                </c:pt>
                <c:pt idx="24">
                  <c:v>1.2578616352201295E-2</c:v>
                </c:pt>
                <c:pt idx="25">
                  <c:v>2.8301886792452793E-2</c:v>
                </c:pt>
                <c:pt idx="26">
                  <c:v>1.57232704402516E-2</c:v>
                </c:pt>
                <c:pt idx="27">
                  <c:v>3.144654088050312E-3</c:v>
                </c:pt>
                <c:pt idx="28">
                  <c:v>6.2893081761006336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5"/>
          <c:order val="15"/>
          <c:tx>
            <c:strRef>
              <c:f>'N2 L4_0.02_50%'!$Q$104</c:f>
              <c:strCache>
                <c:ptCount val="1"/>
                <c:pt idx="0">
                  <c:v>N2_L4_0617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Q$105:$Q$135</c:f>
              <c:numCache>
                <c:formatCode>General</c:formatCode>
                <c:ptCount val="31"/>
              </c:numCache>
            </c:numRef>
          </c:val>
        </c:ser>
        <c:ser>
          <c:idx val="16"/>
          <c:order val="16"/>
          <c:tx>
            <c:strRef>
              <c:f>'N2 L4_0.02_50%'!$R$104</c:f>
              <c:strCache>
                <c:ptCount val="1"/>
                <c:pt idx="0">
                  <c:v>N2_L4_0618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R$105:$R$135</c:f>
              <c:numCache>
                <c:formatCode>General</c:formatCode>
                <c:ptCount val="31"/>
                <c:pt idx="1">
                  <c:v>4.3936731107205626E-2</c:v>
                </c:pt>
                <c:pt idx="2">
                  <c:v>5.0966608084358503E-2</c:v>
                </c:pt>
                <c:pt idx="3">
                  <c:v>5.6239015817223216E-2</c:v>
                </c:pt>
                <c:pt idx="4">
                  <c:v>5.2724077328646833E-2</c:v>
                </c:pt>
                <c:pt idx="5">
                  <c:v>4.1007615700058585E-2</c:v>
                </c:pt>
                <c:pt idx="6">
                  <c:v>4.7451669595782099E-2</c:v>
                </c:pt>
                <c:pt idx="7">
                  <c:v>5.7410661980082031E-2</c:v>
                </c:pt>
                <c:pt idx="8">
                  <c:v>6.4440538957234922E-2</c:v>
                </c:pt>
                <c:pt idx="9">
                  <c:v>5.6239015817223216E-2</c:v>
                </c:pt>
                <c:pt idx="10">
                  <c:v>5.2724077328646833E-2</c:v>
                </c:pt>
                <c:pt idx="11">
                  <c:v>4.5108377270064379E-2</c:v>
                </c:pt>
                <c:pt idx="12">
                  <c:v>6.0925600468658497E-2</c:v>
                </c:pt>
                <c:pt idx="13">
                  <c:v>5.0380785002929113E-2</c:v>
                </c:pt>
                <c:pt idx="14">
                  <c:v>5.15524311657879E-2</c:v>
                </c:pt>
                <c:pt idx="15">
                  <c:v>4.2765084944346853E-2</c:v>
                </c:pt>
                <c:pt idx="16">
                  <c:v>3.6321031048623317E-2</c:v>
                </c:pt>
                <c:pt idx="17">
                  <c:v>3.2220269478617516E-2</c:v>
                </c:pt>
                <c:pt idx="18">
                  <c:v>2.2847100175746912E-2</c:v>
                </c:pt>
                <c:pt idx="19">
                  <c:v>1.9332161687170508E-2</c:v>
                </c:pt>
                <c:pt idx="20">
                  <c:v>2.0503807850029313E-2</c:v>
                </c:pt>
                <c:pt idx="21">
                  <c:v>1.5817223198593997E-2</c:v>
                </c:pt>
                <c:pt idx="22">
                  <c:v>5.2724077328646837E-3</c:v>
                </c:pt>
                <c:pt idx="23">
                  <c:v>8.201523140011718E-3</c:v>
                </c:pt>
                <c:pt idx="24">
                  <c:v>8.7873462214411308E-3</c:v>
                </c:pt>
                <c:pt idx="25">
                  <c:v>7.0298769771529003E-3</c:v>
                </c:pt>
                <c:pt idx="26">
                  <c:v>2.3432923257176307E-3</c:v>
                </c:pt>
                <c:pt idx="27">
                  <c:v>3.5149384885764519E-3</c:v>
                </c:pt>
                <c:pt idx="28">
                  <c:v>2.3432923257176307E-3</c:v>
                </c:pt>
                <c:pt idx="29">
                  <c:v>1.7574692442882201E-3</c:v>
                </c:pt>
                <c:pt idx="30">
                  <c:v>5.8582308142940821E-4</c:v>
                </c:pt>
              </c:numCache>
            </c:numRef>
          </c:val>
        </c:ser>
        <c:ser>
          <c:idx val="17"/>
          <c:order val="17"/>
          <c:tx>
            <c:strRef>
              <c:f>'N2 L4_0.02_50%'!$S$104</c:f>
              <c:strCache>
                <c:ptCount val="1"/>
                <c:pt idx="0">
                  <c:v>N2_L4_0619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S$105:$S$135</c:f>
              <c:numCache>
                <c:formatCode>General</c:formatCode>
                <c:ptCount val="31"/>
                <c:pt idx="1">
                  <c:v>5.681818181818183E-2</c:v>
                </c:pt>
                <c:pt idx="2">
                  <c:v>2.2727272727272717E-2</c:v>
                </c:pt>
                <c:pt idx="3">
                  <c:v>2.2727272727272717E-2</c:v>
                </c:pt>
                <c:pt idx="4">
                  <c:v>3.4090909090909102E-2</c:v>
                </c:pt>
                <c:pt idx="5">
                  <c:v>1.1363636363636404E-2</c:v>
                </c:pt>
                <c:pt idx="6">
                  <c:v>1.1363636363636404E-2</c:v>
                </c:pt>
                <c:pt idx="7">
                  <c:v>0</c:v>
                </c:pt>
                <c:pt idx="8">
                  <c:v>2.2727272727272717E-2</c:v>
                </c:pt>
                <c:pt idx="9">
                  <c:v>3.4090909090909102E-2</c:v>
                </c:pt>
                <c:pt idx="10">
                  <c:v>1.1363636363636404E-2</c:v>
                </c:pt>
                <c:pt idx="11">
                  <c:v>0</c:v>
                </c:pt>
                <c:pt idx="12">
                  <c:v>1.1363636363636404E-2</c:v>
                </c:pt>
                <c:pt idx="13">
                  <c:v>0</c:v>
                </c:pt>
                <c:pt idx="14">
                  <c:v>4.5454545454545497E-2</c:v>
                </c:pt>
                <c:pt idx="15">
                  <c:v>0</c:v>
                </c:pt>
                <c:pt idx="16">
                  <c:v>9.0909090909090939E-2</c:v>
                </c:pt>
                <c:pt idx="17">
                  <c:v>4.5454545454545497E-2</c:v>
                </c:pt>
                <c:pt idx="18">
                  <c:v>7.9545454545454503E-2</c:v>
                </c:pt>
                <c:pt idx="19">
                  <c:v>2.2727272727272717E-2</c:v>
                </c:pt>
                <c:pt idx="20">
                  <c:v>1.1363636363636404E-2</c:v>
                </c:pt>
                <c:pt idx="21">
                  <c:v>5.681818181818183E-2</c:v>
                </c:pt>
                <c:pt idx="22">
                  <c:v>4.5454545454545497E-2</c:v>
                </c:pt>
                <c:pt idx="23">
                  <c:v>1.1363636363636404E-2</c:v>
                </c:pt>
                <c:pt idx="24">
                  <c:v>3.4090909090909102E-2</c:v>
                </c:pt>
                <c:pt idx="25">
                  <c:v>6.8181818181818205E-2</c:v>
                </c:pt>
                <c:pt idx="26">
                  <c:v>5.681818181818183E-2</c:v>
                </c:pt>
                <c:pt idx="27">
                  <c:v>0</c:v>
                </c:pt>
                <c:pt idx="28">
                  <c:v>3.4090909090909102E-2</c:v>
                </c:pt>
                <c:pt idx="29">
                  <c:v>0</c:v>
                </c:pt>
                <c:pt idx="30">
                  <c:v>2.2727272727272717E-2</c:v>
                </c:pt>
              </c:numCache>
            </c:numRef>
          </c:val>
        </c:ser>
        <c:ser>
          <c:idx val="18"/>
          <c:order val="18"/>
          <c:tx>
            <c:strRef>
              <c:f>'N2 L4_0.02_50%'!$T$104</c:f>
              <c:strCache>
                <c:ptCount val="1"/>
                <c:pt idx="0">
                  <c:v>N2_L4_0621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T$105:$T$135</c:f>
              <c:numCache>
                <c:formatCode>General</c:formatCode>
                <c:ptCount val="31"/>
              </c:numCache>
            </c:numRef>
          </c:val>
        </c:ser>
        <c:ser>
          <c:idx val="19"/>
          <c:order val="19"/>
          <c:tx>
            <c:strRef>
              <c:f>'N2 L4_0.02_50%'!$U$104</c:f>
              <c:strCache>
                <c:ptCount val="1"/>
                <c:pt idx="0">
                  <c:v>N2_L4_0622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U$105:$U$135</c:f>
              <c:numCache>
                <c:formatCode>General</c:formatCode>
                <c:ptCount val="31"/>
                <c:pt idx="1">
                  <c:v>4.3112513144058916E-2</c:v>
                </c:pt>
                <c:pt idx="2">
                  <c:v>6.3091482649842323E-2</c:v>
                </c:pt>
                <c:pt idx="3">
                  <c:v>5.5730809674027298E-2</c:v>
                </c:pt>
                <c:pt idx="4">
                  <c:v>4.3112513144058916E-2</c:v>
                </c:pt>
                <c:pt idx="5">
                  <c:v>5.6782334384858017E-2</c:v>
                </c:pt>
                <c:pt idx="6">
                  <c:v>4.7318611987381749E-2</c:v>
                </c:pt>
                <c:pt idx="7">
                  <c:v>6.4143007360672979E-2</c:v>
                </c:pt>
                <c:pt idx="8">
                  <c:v>4.2060988433228225E-2</c:v>
                </c:pt>
                <c:pt idx="9">
                  <c:v>5.9936908517350215E-2</c:v>
                </c:pt>
                <c:pt idx="10">
                  <c:v>6.6246056782334375E-2</c:v>
                </c:pt>
                <c:pt idx="11">
                  <c:v>5.6782334384858017E-2</c:v>
                </c:pt>
                <c:pt idx="12">
                  <c:v>5.2576235541535225E-2</c:v>
                </c:pt>
                <c:pt idx="13">
                  <c:v>4.1009463722397485E-2</c:v>
                </c:pt>
                <c:pt idx="14">
                  <c:v>5.2576235541535225E-2</c:v>
                </c:pt>
                <c:pt idx="15">
                  <c:v>3.8906414300736103E-2</c:v>
                </c:pt>
                <c:pt idx="16">
                  <c:v>3.6803364879074728E-2</c:v>
                </c:pt>
                <c:pt idx="17">
                  <c:v>3.2597266035751804E-2</c:v>
                </c:pt>
                <c:pt idx="18">
                  <c:v>2.9442691903259707E-2</c:v>
                </c:pt>
                <c:pt idx="19">
                  <c:v>1.68243953732913E-2</c:v>
                </c:pt>
                <c:pt idx="20">
                  <c:v>1.8927444794952706E-2</c:v>
                </c:pt>
                <c:pt idx="21">
                  <c:v>5.2576235541535237E-3</c:v>
                </c:pt>
                <c:pt idx="22">
                  <c:v>7.3606729758149336E-3</c:v>
                </c:pt>
                <c:pt idx="23">
                  <c:v>4.2060988433228232E-3</c:v>
                </c:pt>
                <c:pt idx="24">
                  <c:v>3.1545741324921117E-3</c:v>
                </c:pt>
                <c:pt idx="25">
                  <c:v>1.0515247108306995E-3</c:v>
                </c:pt>
                <c:pt idx="26">
                  <c:v>1.0515247108306995E-3</c:v>
                </c:pt>
                <c:pt idx="27">
                  <c:v>1.0515247108306995E-3</c:v>
                </c:pt>
                <c:pt idx="28">
                  <c:v>0</c:v>
                </c:pt>
                <c:pt idx="29">
                  <c:v>0</c:v>
                </c:pt>
                <c:pt idx="30">
                  <c:v>1.0515247108306995E-3</c:v>
                </c:pt>
              </c:numCache>
            </c:numRef>
          </c:val>
        </c:ser>
        <c:ser>
          <c:idx val="20"/>
          <c:order val="20"/>
          <c:tx>
            <c:strRef>
              <c:f>'N2 L4_0.02_50%'!$V$104</c:f>
              <c:strCache>
                <c:ptCount val="1"/>
                <c:pt idx="0">
                  <c:v>N2_L4_0623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V$105:$V$135</c:f>
              <c:numCache>
                <c:formatCode>General</c:formatCode>
                <c:ptCount val="31"/>
                <c:pt idx="1">
                  <c:v>3.304597701149433E-2</c:v>
                </c:pt>
                <c:pt idx="2">
                  <c:v>4.0229885057471299E-2</c:v>
                </c:pt>
                <c:pt idx="3">
                  <c:v>3.1609195402298916E-2</c:v>
                </c:pt>
                <c:pt idx="4">
                  <c:v>1.5804597701149399E-2</c:v>
                </c:pt>
                <c:pt idx="5">
                  <c:v>3.1609195402298916E-2</c:v>
                </c:pt>
                <c:pt idx="6">
                  <c:v>1.5804597701149399E-2</c:v>
                </c:pt>
                <c:pt idx="7">
                  <c:v>2.5862068965517199E-2</c:v>
                </c:pt>
                <c:pt idx="8">
                  <c:v>1.7241379310344803E-2</c:v>
                </c:pt>
                <c:pt idx="9">
                  <c:v>3.1609195402298916E-2</c:v>
                </c:pt>
                <c:pt idx="10">
                  <c:v>3.5919540229885097E-2</c:v>
                </c:pt>
                <c:pt idx="11">
                  <c:v>5.8908045977011499E-2</c:v>
                </c:pt>
                <c:pt idx="12">
                  <c:v>5.0287356321839095E-2</c:v>
                </c:pt>
                <c:pt idx="13">
                  <c:v>7.1839080459770097E-2</c:v>
                </c:pt>
                <c:pt idx="14">
                  <c:v>6.465517241379308E-2</c:v>
                </c:pt>
                <c:pt idx="15">
                  <c:v>7.1839080459770097E-2</c:v>
                </c:pt>
                <c:pt idx="16">
                  <c:v>7.7586206896551727E-2</c:v>
                </c:pt>
                <c:pt idx="17">
                  <c:v>7.6149425287356298E-2</c:v>
                </c:pt>
                <c:pt idx="18">
                  <c:v>4.5977011494252887E-2</c:v>
                </c:pt>
                <c:pt idx="19">
                  <c:v>3.8793103448275912E-2</c:v>
                </c:pt>
                <c:pt idx="20">
                  <c:v>4.45402298850575E-2</c:v>
                </c:pt>
                <c:pt idx="21">
                  <c:v>1.7241379310344803E-2</c:v>
                </c:pt>
                <c:pt idx="22">
                  <c:v>1.5804597701149399E-2</c:v>
                </c:pt>
                <c:pt idx="23">
                  <c:v>8.6206896551724154E-3</c:v>
                </c:pt>
                <c:pt idx="24">
                  <c:v>1.1494252873563199E-2</c:v>
                </c:pt>
                <c:pt idx="25">
                  <c:v>7.1839080459770114E-3</c:v>
                </c:pt>
                <c:pt idx="26">
                  <c:v>2.8735632183908015E-3</c:v>
                </c:pt>
                <c:pt idx="27">
                  <c:v>4.3103448275862077E-3</c:v>
                </c:pt>
                <c:pt idx="28">
                  <c:v>0</c:v>
                </c:pt>
                <c:pt idx="29">
                  <c:v>0</c:v>
                </c:pt>
                <c:pt idx="30">
                  <c:v>2.8735632183908015E-3</c:v>
                </c:pt>
              </c:numCache>
            </c:numRef>
          </c:val>
        </c:ser>
        <c:ser>
          <c:idx val="21"/>
          <c:order val="21"/>
          <c:tx>
            <c:strRef>
              <c:f>'N2 L4_0.02_50%'!$W$104</c:f>
              <c:strCache>
                <c:ptCount val="1"/>
                <c:pt idx="0">
                  <c:v>N2_L4_0624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W$105:$W$135</c:f>
              <c:numCache>
                <c:formatCode>General</c:formatCode>
                <c:ptCount val="31"/>
                <c:pt idx="1">
                  <c:v>3.3898305084745811E-2</c:v>
                </c:pt>
                <c:pt idx="2">
                  <c:v>1.8252933507170797E-2</c:v>
                </c:pt>
                <c:pt idx="3">
                  <c:v>1.8252933507170797E-2</c:v>
                </c:pt>
                <c:pt idx="4">
                  <c:v>2.2164276401564514E-2</c:v>
                </c:pt>
                <c:pt idx="5">
                  <c:v>1.9556714471968703E-2</c:v>
                </c:pt>
                <c:pt idx="6">
                  <c:v>1.6949152542372906E-2</c:v>
                </c:pt>
                <c:pt idx="7">
                  <c:v>9.1264667535854039E-3</c:v>
                </c:pt>
                <c:pt idx="8">
                  <c:v>1.6949152542372906E-2</c:v>
                </c:pt>
                <c:pt idx="9">
                  <c:v>1.9556714471968703E-2</c:v>
                </c:pt>
                <c:pt idx="10">
                  <c:v>2.7379400260756206E-2</c:v>
                </c:pt>
                <c:pt idx="11">
                  <c:v>2.8683181225554105E-2</c:v>
                </c:pt>
                <c:pt idx="12">
                  <c:v>4.3024771838331234E-2</c:v>
                </c:pt>
                <c:pt idx="13">
                  <c:v>4.8239895697522781E-2</c:v>
                </c:pt>
                <c:pt idx="14">
                  <c:v>5.9973924380704015E-2</c:v>
                </c:pt>
                <c:pt idx="15">
                  <c:v>7.5619295958279029E-2</c:v>
                </c:pt>
                <c:pt idx="16">
                  <c:v>8.3441981747066504E-2</c:v>
                </c:pt>
                <c:pt idx="17">
                  <c:v>9.1264667535854035E-2</c:v>
                </c:pt>
                <c:pt idx="18">
                  <c:v>7.0404172099087406E-2</c:v>
                </c:pt>
                <c:pt idx="19">
                  <c:v>5.9973924380704015E-2</c:v>
                </c:pt>
                <c:pt idx="20">
                  <c:v>4.9543676662320714E-2</c:v>
                </c:pt>
                <c:pt idx="21">
                  <c:v>3.6505867014341616E-2</c:v>
                </c:pt>
                <c:pt idx="22">
                  <c:v>3.3898305084745811E-2</c:v>
                </c:pt>
                <c:pt idx="23">
                  <c:v>2.2164276401564514E-2</c:v>
                </c:pt>
                <c:pt idx="24">
                  <c:v>1.3037809647979107E-2</c:v>
                </c:pt>
                <c:pt idx="25">
                  <c:v>9.1264667535854039E-3</c:v>
                </c:pt>
                <c:pt idx="26">
                  <c:v>1.1734028683181205E-2</c:v>
                </c:pt>
                <c:pt idx="27">
                  <c:v>9.1264667535854039E-3</c:v>
                </c:pt>
                <c:pt idx="28">
                  <c:v>3.9113428943937396E-3</c:v>
                </c:pt>
                <c:pt idx="29">
                  <c:v>2.6075619295958309E-3</c:v>
                </c:pt>
                <c:pt idx="30">
                  <c:v>0</c:v>
                </c:pt>
              </c:numCache>
            </c:numRef>
          </c:val>
        </c:ser>
        <c:ser>
          <c:idx val="22"/>
          <c:order val="22"/>
          <c:tx>
            <c:strRef>
              <c:f>'N2 L4_0.02_50%'!$X$104</c:f>
              <c:strCache>
                <c:ptCount val="1"/>
                <c:pt idx="0">
                  <c:v>N2_L4_0625</c:v>
                </c:pt>
              </c:strCache>
            </c:strRef>
          </c:tx>
          <c:marker>
            <c:symbol val="none"/>
          </c:marker>
          <c:cat>
            <c:numRef>
              <c:f>'N2 L4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L4_0.02_50%'!$X$105:$X$135</c:f>
              <c:numCache>
                <c:formatCode>General</c:formatCode>
                <c:ptCount val="31"/>
                <c:pt idx="1">
                  <c:v>3.4161490683229802E-2</c:v>
                </c:pt>
                <c:pt idx="2">
                  <c:v>3.3126293995859195E-2</c:v>
                </c:pt>
                <c:pt idx="3">
                  <c:v>3.0020703933747391E-2</c:v>
                </c:pt>
                <c:pt idx="4">
                  <c:v>2.3809523809523808E-2</c:v>
                </c:pt>
                <c:pt idx="5">
                  <c:v>3.4161490683229802E-2</c:v>
                </c:pt>
                <c:pt idx="6">
                  <c:v>3.2091097308488602E-2</c:v>
                </c:pt>
                <c:pt idx="7">
                  <c:v>3.5196687370600402E-2</c:v>
                </c:pt>
                <c:pt idx="8">
                  <c:v>3.3126293995859195E-2</c:v>
                </c:pt>
                <c:pt idx="9">
                  <c:v>3.6231884057971016E-2</c:v>
                </c:pt>
                <c:pt idx="10">
                  <c:v>2.7950310559006215E-2</c:v>
                </c:pt>
                <c:pt idx="11">
                  <c:v>3.9337474120082795E-2</c:v>
                </c:pt>
                <c:pt idx="12">
                  <c:v>5.6935817805383003E-2</c:v>
                </c:pt>
                <c:pt idx="13">
                  <c:v>5.4865424430641845E-2</c:v>
                </c:pt>
                <c:pt idx="14">
                  <c:v>6.6252587991718431E-2</c:v>
                </c:pt>
                <c:pt idx="15">
                  <c:v>6.9358178053830224E-2</c:v>
                </c:pt>
                <c:pt idx="16">
                  <c:v>4.5548654244306416E-2</c:v>
                </c:pt>
                <c:pt idx="17">
                  <c:v>5.4865424430641845E-2</c:v>
                </c:pt>
                <c:pt idx="18">
                  <c:v>3.5196687370600402E-2</c:v>
                </c:pt>
                <c:pt idx="19">
                  <c:v>3.5196687370600402E-2</c:v>
                </c:pt>
                <c:pt idx="20">
                  <c:v>3.8302277432712202E-2</c:v>
                </c:pt>
                <c:pt idx="21">
                  <c:v>3.2091097308488602E-2</c:v>
                </c:pt>
                <c:pt idx="22">
                  <c:v>2.3809523809523808E-2</c:v>
                </c:pt>
                <c:pt idx="23">
                  <c:v>2.6915113871635608E-2</c:v>
                </c:pt>
                <c:pt idx="24">
                  <c:v>1.7598343685300201E-2</c:v>
                </c:pt>
                <c:pt idx="25">
                  <c:v>9.3167701863354005E-3</c:v>
                </c:pt>
                <c:pt idx="26">
                  <c:v>1.0351966873705995E-2</c:v>
                </c:pt>
                <c:pt idx="27">
                  <c:v>6.2111801242236038E-3</c:v>
                </c:pt>
                <c:pt idx="28">
                  <c:v>3.1055900621118019E-3</c:v>
                </c:pt>
                <c:pt idx="29">
                  <c:v>5.1759834368530003E-3</c:v>
                </c:pt>
                <c:pt idx="30">
                  <c:v>4.1407867494824002E-3</c:v>
                </c:pt>
              </c:numCache>
            </c:numRef>
          </c:val>
        </c:ser>
        <c:marker val="1"/>
        <c:axId val="162650752"/>
        <c:axId val="162673024"/>
      </c:lineChart>
      <c:catAx>
        <c:axId val="162650752"/>
        <c:scaling>
          <c:orientation val="minMax"/>
        </c:scaling>
        <c:axPos val="b"/>
        <c:numFmt formatCode="0.0_ " sourceLinked="1"/>
        <c:tickLblPos val="nextTo"/>
        <c:crossAx val="162673024"/>
        <c:crosses val="autoZero"/>
        <c:auto val="1"/>
        <c:lblAlgn val="ctr"/>
        <c:lblOffset val="100"/>
        <c:tickLblSkip val="5"/>
        <c:tickMarkSkip val="5"/>
      </c:catAx>
      <c:valAx>
        <c:axId val="162673024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2650752"/>
        <c:crosses val="autoZero"/>
        <c:crossBetween val="between"/>
      </c:valAx>
    </c:plotArea>
    <c:plotVisOnly val="1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>
                <a:latin typeface="Arial" pitchFamily="34" charset="0"/>
                <a:cs typeface="Arial" pitchFamily="34" charset="0"/>
              </a:rPr>
              <a:t>w.t.</a:t>
            </a:r>
            <a:r>
              <a:rPr lang="en-US" altLang="ja-JP" sz="1400" b="0" baseline="0">
                <a:latin typeface="Arial" pitchFamily="34" charset="0"/>
                <a:cs typeface="Arial" pitchFamily="34" charset="0"/>
              </a:rPr>
              <a:t> A1</a:t>
            </a:r>
            <a:endParaRPr lang="ja-JP" altLang="en-US" sz="1400" b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N2 A1_0.02_50%'!$B$104</c:f>
              <c:strCache>
                <c:ptCount val="1"/>
                <c:pt idx="0">
                  <c:v>N2_A1_40_30_01</c:v>
                </c:pt>
              </c:strCache>
            </c:strRef>
          </c:tx>
          <c:marker>
            <c:symbol val="none"/>
          </c:marker>
          <c:cat>
            <c:numRef>
              <c:f>'N2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1_0.02_50%'!$B$105:$B$135</c:f>
              <c:numCache>
                <c:formatCode>General</c:formatCode>
                <c:ptCount val="31"/>
                <c:pt idx="1">
                  <c:v>1.7460317460317506E-2</c:v>
                </c:pt>
                <c:pt idx="2">
                  <c:v>3.1746031746031698E-3</c:v>
                </c:pt>
                <c:pt idx="3">
                  <c:v>9.5238095238095229E-3</c:v>
                </c:pt>
                <c:pt idx="4">
                  <c:v>7.9365079365079413E-3</c:v>
                </c:pt>
                <c:pt idx="5">
                  <c:v>3.1746031746031698E-3</c:v>
                </c:pt>
                <c:pt idx="6">
                  <c:v>7.9365079365079413E-3</c:v>
                </c:pt>
                <c:pt idx="7">
                  <c:v>3.1746031746031698E-3</c:v>
                </c:pt>
                <c:pt idx="8">
                  <c:v>3.1746031746031698E-3</c:v>
                </c:pt>
                <c:pt idx="9">
                  <c:v>7.9365079365079413E-3</c:v>
                </c:pt>
                <c:pt idx="10">
                  <c:v>1.58730158730159E-2</c:v>
                </c:pt>
                <c:pt idx="11">
                  <c:v>1.58730158730159E-2</c:v>
                </c:pt>
                <c:pt idx="12">
                  <c:v>4.9206349206349198E-2</c:v>
                </c:pt>
                <c:pt idx="13">
                  <c:v>7.6190476190476197E-2</c:v>
                </c:pt>
                <c:pt idx="14">
                  <c:v>9.3650793650793734E-2</c:v>
                </c:pt>
                <c:pt idx="15">
                  <c:v>0.11111111111111099</c:v>
                </c:pt>
                <c:pt idx="16">
                  <c:v>0.10793650793650804</c:v>
                </c:pt>
                <c:pt idx="17">
                  <c:v>0.115873015873016</c:v>
                </c:pt>
                <c:pt idx="18">
                  <c:v>9.8412698412698396E-2</c:v>
                </c:pt>
                <c:pt idx="19">
                  <c:v>8.5714285714285701E-2</c:v>
                </c:pt>
                <c:pt idx="20">
                  <c:v>5.0793650793650814E-2</c:v>
                </c:pt>
                <c:pt idx="21">
                  <c:v>3.9682539682539715E-2</c:v>
                </c:pt>
                <c:pt idx="22">
                  <c:v>2.8571428571428602E-2</c:v>
                </c:pt>
                <c:pt idx="23">
                  <c:v>1.1111111111111101E-2</c:v>
                </c:pt>
                <c:pt idx="24">
                  <c:v>7.9365079365079413E-3</c:v>
                </c:pt>
                <c:pt idx="25">
                  <c:v>9.5238095238095229E-3</c:v>
                </c:pt>
                <c:pt idx="26">
                  <c:v>4.7619047619047597E-3</c:v>
                </c:pt>
                <c:pt idx="27">
                  <c:v>3.1746031746031698E-3</c:v>
                </c:pt>
                <c:pt idx="28">
                  <c:v>0</c:v>
                </c:pt>
                <c:pt idx="29">
                  <c:v>0</c:v>
                </c:pt>
                <c:pt idx="30">
                  <c:v>1.5873015873015901E-3</c:v>
                </c:pt>
              </c:numCache>
            </c:numRef>
          </c:val>
        </c:ser>
        <c:ser>
          <c:idx val="1"/>
          <c:order val="1"/>
          <c:tx>
            <c:strRef>
              <c:f>'N2 A1_0.02_50%'!$C$104</c:f>
              <c:strCache>
                <c:ptCount val="1"/>
                <c:pt idx="0">
                  <c:v>N2_A1_40_30_06</c:v>
                </c:pt>
              </c:strCache>
            </c:strRef>
          </c:tx>
          <c:marker>
            <c:symbol val="none"/>
          </c:marker>
          <c:cat>
            <c:numRef>
              <c:f>'N2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1_0.02_50%'!$C$105:$C$135</c:f>
              <c:numCache>
                <c:formatCode>General</c:formatCode>
                <c:ptCount val="31"/>
                <c:pt idx="1">
                  <c:v>7.19530102790015E-2</c:v>
                </c:pt>
                <c:pt idx="2">
                  <c:v>7.0484581497797419E-2</c:v>
                </c:pt>
                <c:pt idx="3">
                  <c:v>7.9295154185022004E-2</c:v>
                </c:pt>
                <c:pt idx="4">
                  <c:v>8.8105726872246728E-2</c:v>
                </c:pt>
                <c:pt idx="5">
                  <c:v>6.1674008810572695E-2</c:v>
                </c:pt>
                <c:pt idx="6">
                  <c:v>7.19530102790015E-2</c:v>
                </c:pt>
                <c:pt idx="7">
                  <c:v>6.828193832599122E-2</c:v>
                </c:pt>
                <c:pt idx="8">
                  <c:v>5.8002936857562436E-2</c:v>
                </c:pt>
                <c:pt idx="9">
                  <c:v>4.9192364170337725E-2</c:v>
                </c:pt>
                <c:pt idx="10">
                  <c:v>5.3597650513950101E-2</c:v>
                </c:pt>
                <c:pt idx="11">
                  <c:v>4.7723935389133637E-2</c:v>
                </c:pt>
                <c:pt idx="12">
                  <c:v>4.4787077826725454E-2</c:v>
                </c:pt>
                <c:pt idx="13">
                  <c:v>3.4508076358296599E-2</c:v>
                </c:pt>
                <c:pt idx="14">
                  <c:v>3.0837004405286306E-2</c:v>
                </c:pt>
                <c:pt idx="15">
                  <c:v>2.1292217327459617E-2</c:v>
                </c:pt>
                <c:pt idx="16">
                  <c:v>1.68869309838473E-2</c:v>
                </c:pt>
                <c:pt idx="17">
                  <c:v>1.02790014684288E-2</c:v>
                </c:pt>
                <c:pt idx="18">
                  <c:v>1.1013215859030799E-2</c:v>
                </c:pt>
                <c:pt idx="19">
                  <c:v>1.02790014684288E-2</c:v>
                </c:pt>
                <c:pt idx="20">
                  <c:v>7.3421439060205622E-3</c:v>
                </c:pt>
                <c:pt idx="21">
                  <c:v>5.1395007342143932E-3</c:v>
                </c:pt>
                <c:pt idx="22">
                  <c:v>1.46842878120411E-3</c:v>
                </c:pt>
                <c:pt idx="23">
                  <c:v>7.342143906020563E-4</c:v>
                </c:pt>
                <c:pt idx="24">
                  <c:v>2.2026431718061702E-3</c:v>
                </c:pt>
                <c:pt idx="25">
                  <c:v>0</c:v>
                </c:pt>
                <c:pt idx="26">
                  <c:v>7.342143906020563E-4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N2 A1_0.02_50%'!$D$104</c:f>
              <c:strCache>
                <c:ptCount val="1"/>
                <c:pt idx="0">
                  <c:v>N2_A1_40_30_07</c:v>
                </c:pt>
              </c:strCache>
            </c:strRef>
          </c:tx>
          <c:marker>
            <c:symbol val="none"/>
          </c:marker>
          <c:cat>
            <c:numRef>
              <c:f>'N2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1_0.02_50%'!$D$105:$D$135</c:f>
              <c:numCache>
                <c:formatCode>General</c:formatCode>
                <c:ptCount val="31"/>
                <c:pt idx="1">
                  <c:v>4.9030786773090099E-2</c:v>
                </c:pt>
                <c:pt idx="2">
                  <c:v>2.5085518814139118E-2</c:v>
                </c:pt>
                <c:pt idx="3">
                  <c:v>3.0786773090079808E-2</c:v>
                </c:pt>
                <c:pt idx="4">
                  <c:v>4.4469783352337519E-2</c:v>
                </c:pt>
                <c:pt idx="5">
                  <c:v>2.2805017103762818E-2</c:v>
                </c:pt>
                <c:pt idx="6">
                  <c:v>2.5085518814139118E-2</c:v>
                </c:pt>
                <c:pt idx="7">
                  <c:v>2.7366020524515401E-2</c:v>
                </c:pt>
                <c:pt idx="8">
                  <c:v>1.48232611174458E-2</c:v>
                </c:pt>
                <c:pt idx="9">
                  <c:v>1.5963511972634001E-2</c:v>
                </c:pt>
                <c:pt idx="10">
                  <c:v>2.052451539338649E-2</c:v>
                </c:pt>
                <c:pt idx="11">
                  <c:v>1.9384264538198401E-2</c:v>
                </c:pt>
                <c:pt idx="12">
                  <c:v>3.5347776510832402E-2</c:v>
                </c:pt>
                <c:pt idx="13">
                  <c:v>3.9908779931584898E-2</c:v>
                </c:pt>
                <c:pt idx="14">
                  <c:v>3.9908779931584898E-2</c:v>
                </c:pt>
                <c:pt idx="15">
                  <c:v>5.3591790193842623E-2</c:v>
                </c:pt>
                <c:pt idx="16">
                  <c:v>5.9293044469783403E-2</c:v>
                </c:pt>
                <c:pt idx="17">
                  <c:v>6.8415051311288499E-2</c:v>
                </c:pt>
                <c:pt idx="18">
                  <c:v>5.9293044469783403E-2</c:v>
                </c:pt>
                <c:pt idx="19">
                  <c:v>6.2713797035347851E-2</c:v>
                </c:pt>
                <c:pt idx="20">
                  <c:v>5.2451539338654499E-2</c:v>
                </c:pt>
                <c:pt idx="21">
                  <c:v>3.8768529076396788E-2</c:v>
                </c:pt>
                <c:pt idx="22">
                  <c:v>3.0786773090079808E-2</c:v>
                </c:pt>
                <c:pt idx="23">
                  <c:v>2.2805017103762818E-2</c:v>
                </c:pt>
                <c:pt idx="24">
                  <c:v>1.9384264538198401E-2</c:v>
                </c:pt>
                <c:pt idx="25">
                  <c:v>1.7103762827822101E-2</c:v>
                </c:pt>
                <c:pt idx="26">
                  <c:v>1.8244013683010301E-2</c:v>
                </c:pt>
                <c:pt idx="27">
                  <c:v>1.0262257696693301E-2</c:v>
                </c:pt>
                <c:pt idx="28">
                  <c:v>6.841505131128852E-3</c:v>
                </c:pt>
                <c:pt idx="29">
                  <c:v>5.7012542759407115E-3</c:v>
                </c:pt>
                <c:pt idx="30">
                  <c:v>3.4207525655644208E-3</c:v>
                </c:pt>
              </c:numCache>
            </c:numRef>
          </c:val>
        </c:ser>
        <c:ser>
          <c:idx val="3"/>
          <c:order val="3"/>
          <c:tx>
            <c:strRef>
              <c:f>'N2 A1_0.02_50%'!$E$104</c:f>
              <c:strCache>
                <c:ptCount val="1"/>
                <c:pt idx="0">
                  <c:v>N2_REX_A1_01</c:v>
                </c:pt>
              </c:strCache>
            </c:strRef>
          </c:tx>
          <c:marker>
            <c:symbol val="none"/>
          </c:marker>
          <c:cat>
            <c:numRef>
              <c:f>'N2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1_0.02_50%'!$E$105:$E$135</c:f>
              <c:numCache>
                <c:formatCode>General</c:formatCode>
                <c:ptCount val="31"/>
                <c:pt idx="1">
                  <c:v>3.3153430994602884E-2</c:v>
                </c:pt>
                <c:pt idx="2">
                  <c:v>3.6237471087124128E-2</c:v>
                </c:pt>
                <c:pt idx="3">
                  <c:v>2.3901310717039319E-2</c:v>
                </c:pt>
                <c:pt idx="4">
                  <c:v>3.3153430994602884E-2</c:v>
                </c:pt>
                <c:pt idx="5">
                  <c:v>3.0840400925212001E-2</c:v>
                </c:pt>
                <c:pt idx="6">
                  <c:v>2.6985350809560518E-2</c:v>
                </c:pt>
                <c:pt idx="7">
                  <c:v>2.7756360832690799E-2</c:v>
                </c:pt>
                <c:pt idx="8">
                  <c:v>2.5443330763299913E-2</c:v>
                </c:pt>
                <c:pt idx="9">
                  <c:v>3.4695451040863502E-2</c:v>
                </c:pt>
                <c:pt idx="10">
                  <c:v>3.7779491133384697E-2</c:v>
                </c:pt>
                <c:pt idx="11">
                  <c:v>6.2451811873554398E-2</c:v>
                </c:pt>
                <c:pt idx="12">
                  <c:v>7.8643022359290701E-2</c:v>
                </c:pt>
                <c:pt idx="13">
                  <c:v>6.3222821896684711E-2</c:v>
                </c:pt>
                <c:pt idx="14">
                  <c:v>9.4063222821896705E-2</c:v>
                </c:pt>
                <c:pt idx="15">
                  <c:v>8.4811102544333133E-2</c:v>
                </c:pt>
                <c:pt idx="16">
                  <c:v>7.0932922127987727E-2</c:v>
                </c:pt>
                <c:pt idx="17">
                  <c:v>7.0161912104857393E-2</c:v>
                </c:pt>
                <c:pt idx="18">
                  <c:v>5.9367771781033238E-2</c:v>
                </c:pt>
                <c:pt idx="19">
                  <c:v>3.1611410948342314E-2</c:v>
                </c:pt>
                <c:pt idx="20">
                  <c:v>1.6962220508866609E-2</c:v>
                </c:pt>
                <c:pt idx="21">
                  <c:v>1.1565150346954507E-2</c:v>
                </c:pt>
                <c:pt idx="22">
                  <c:v>1.1565150346954507E-2</c:v>
                </c:pt>
                <c:pt idx="23">
                  <c:v>6.1680801850424113E-3</c:v>
                </c:pt>
                <c:pt idx="24">
                  <c:v>7.710100231303012E-4</c:v>
                </c:pt>
                <c:pt idx="25">
                  <c:v>0</c:v>
                </c:pt>
                <c:pt idx="26">
                  <c:v>0</c:v>
                </c:pt>
                <c:pt idx="27">
                  <c:v>1.5420200462606005E-3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N2 A1_0.02_50%'!$F$104</c:f>
              <c:strCache>
                <c:ptCount val="1"/>
                <c:pt idx="0">
                  <c:v>N2_REX_A1_03</c:v>
                </c:pt>
              </c:strCache>
            </c:strRef>
          </c:tx>
          <c:marker>
            <c:symbol val="none"/>
          </c:marker>
          <c:cat>
            <c:numRef>
              <c:f>'N2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1_0.02_50%'!$F$105:$F$135</c:f>
              <c:numCache>
                <c:formatCode>General</c:formatCode>
                <c:ptCount val="31"/>
                <c:pt idx="1">
                  <c:v>5.2707235265932018E-2</c:v>
                </c:pt>
                <c:pt idx="2">
                  <c:v>5.1269765213224683E-2</c:v>
                </c:pt>
                <c:pt idx="3">
                  <c:v>4.7915668423574496E-2</c:v>
                </c:pt>
                <c:pt idx="4">
                  <c:v>4.6957355055102984E-2</c:v>
                </c:pt>
                <c:pt idx="5">
                  <c:v>4.8394825107810319E-2</c:v>
                </c:pt>
                <c:pt idx="6">
                  <c:v>6.4686152371825595E-2</c:v>
                </c:pt>
                <c:pt idx="7">
                  <c:v>5.9415428845232439E-2</c:v>
                </c:pt>
                <c:pt idx="8">
                  <c:v>5.2707235265932018E-2</c:v>
                </c:pt>
                <c:pt idx="9">
                  <c:v>6.6123622424532819E-2</c:v>
                </c:pt>
                <c:pt idx="10">
                  <c:v>5.7019645424053703E-2</c:v>
                </c:pt>
                <c:pt idx="11">
                  <c:v>5.1748921897460512E-2</c:v>
                </c:pt>
                <c:pt idx="12">
                  <c:v>5.8457115476760878E-2</c:v>
                </c:pt>
                <c:pt idx="13">
                  <c:v>4.9832295160517515E-2</c:v>
                </c:pt>
                <c:pt idx="14">
                  <c:v>4.4561571633924317E-2</c:v>
                </c:pt>
                <c:pt idx="15">
                  <c:v>3.8811691423095401E-2</c:v>
                </c:pt>
                <c:pt idx="16">
                  <c:v>3.3061811212266402E-2</c:v>
                </c:pt>
                <c:pt idx="17">
                  <c:v>4.1686631528509814E-2</c:v>
                </c:pt>
                <c:pt idx="18">
                  <c:v>2.4916147580258705E-2</c:v>
                </c:pt>
                <c:pt idx="19">
                  <c:v>2.0603737422137013E-2</c:v>
                </c:pt>
                <c:pt idx="20">
                  <c:v>1.6291327264015307E-2</c:v>
                </c:pt>
                <c:pt idx="21">
                  <c:v>1.2458073790129399E-2</c:v>
                </c:pt>
                <c:pt idx="22">
                  <c:v>7.1873502635361802E-3</c:v>
                </c:pt>
                <c:pt idx="23">
                  <c:v>5.2707235265932019E-3</c:v>
                </c:pt>
                <c:pt idx="24">
                  <c:v>3.83325347388596E-3</c:v>
                </c:pt>
                <c:pt idx="25">
                  <c:v>2.87494010541447E-3</c:v>
                </c:pt>
                <c:pt idx="26">
                  <c:v>9.5831336847149043E-4</c:v>
                </c:pt>
                <c:pt idx="27">
                  <c:v>9.5831336847149043E-4</c:v>
                </c:pt>
                <c:pt idx="28">
                  <c:v>9.5831336847149043E-4</c:v>
                </c:pt>
                <c:pt idx="29">
                  <c:v>0</c:v>
                </c:pt>
                <c:pt idx="30">
                  <c:v>4.79156684235745E-4</c:v>
                </c:pt>
              </c:numCache>
            </c:numRef>
          </c:val>
        </c:ser>
        <c:ser>
          <c:idx val="5"/>
          <c:order val="5"/>
          <c:tx>
            <c:strRef>
              <c:f>'N2 A1_0.02_50%'!$G$104</c:f>
              <c:strCache>
                <c:ptCount val="1"/>
                <c:pt idx="0">
                  <c:v>N2_REX_A1_05</c:v>
                </c:pt>
              </c:strCache>
            </c:strRef>
          </c:tx>
          <c:marker>
            <c:symbol val="none"/>
          </c:marker>
          <c:cat>
            <c:numRef>
              <c:f>'N2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1_0.02_50%'!$G$105:$G$135</c:f>
              <c:numCache>
                <c:formatCode>General</c:formatCode>
                <c:ptCount val="31"/>
                <c:pt idx="1">
                  <c:v>3.8095238095238099E-2</c:v>
                </c:pt>
                <c:pt idx="2">
                  <c:v>5.5782312925170122E-2</c:v>
                </c:pt>
                <c:pt idx="3">
                  <c:v>5.170068027210882E-2</c:v>
                </c:pt>
                <c:pt idx="4">
                  <c:v>4.4897959183673515E-2</c:v>
                </c:pt>
                <c:pt idx="5">
                  <c:v>5.8503401360544216E-2</c:v>
                </c:pt>
                <c:pt idx="6">
                  <c:v>6.3945578231292474E-2</c:v>
                </c:pt>
                <c:pt idx="7">
                  <c:v>5.4421768707482977E-2</c:v>
                </c:pt>
                <c:pt idx="8">
                  <c:v>6.3945578231292474E-2</c:v>
                </c:pt>
                <c:pt idx="9">
                  <c:v>6.5306122448979598E-2</c:v>
                </c:pt>
                <c:pt idx="10">
                  <c:v>6.1224489795918401E-2</c:v>
                </c:pt>
                <c:pt idx="11">
                  <c:v>5.0340136054421829E-2</c:v>
                </c:pt>
                <c:pt idx="12">
                  <c:v>6.1224489795918401E-2</c:v>
                </c:pt>
                <c:pt idx="13">
                  <c:v>5.9863945578231319E-2</c:v>
                </c:pt>
                <c:pt idx="14">
                  <c:v>6.6666666666666693E-2</c:v>
                </c:pt>
                <c:pt idx="15">
                  <c:v>3.5374149659863921E-2</c:v>
                </c:pt>
                <c:pt idx="16">
                  <c:v>2.9931972789115621E-2</c:v>
                </c:pt>
                <c:pt idx="17">
                  <c:v>2.4489795918367314E-2</c:v>
                </c:pt>
                <c:pt idx="18">
                  <c:v>2.585034013605441E-2</c:v>
                </c:pt>
                <c:pt idx="19">
                  <c:v>1.7687074829932006E-2</c:v>
                </c:pt>
                <c:pt idx="20">
                  <c:v>5.4421768707482981E-3</c:v>
                </c:pt>
                <c:pt idx="21">
                  <c:v>6.8027210884353722E-3</c:v>
                </c:pt>
                <c:pt idx="22">
                  <c:v>8.1632653061224497E-3</c:v>
                </c:pt>
                <c:pt idx="23">
                  <c:v>1.36054421768707E-3</c:v>
                </c:pt>
                <c:pt idx="24">
                  <c:v>1.36054421768707E-3</c:v>
                </c:pt>
                <c:pt idx="25">
                  <c:v>0</c:v>
                </c:pt>
                <c:pt idx="26">
                  <c:v>0</c:v>
                </c:pt>
                <c:pt idx="27">
                  <c:v>1.36054421768707E-3</c:v>
                </c:pt>
                <c:pt idx="28">
                  <c:v>1.36054421768707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6"/>
          <c:order val="6"/>
          <c:tx>
            <c:strRef>
              <c:f>'N2 A1_0.02_50%'!$H$104</c:f>
              <c:strCache>
                <c:ptCount val="1"/>
                <c:pt idx="0">
                  <c:v>N2_REX_A1_07</c:v>
                </c:pt>
              </c:strCache>
            </c:strRef>
          </c:tx>
          <c:marker>
            <c:symbol val="none"/>
          </c:marker>
          <c:cat>
            <c:numRef>
              <c:f>'N2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1_0.02_50%'!$H$105:$H$135</c:f>
              <c:numCache>
                <c:formatCode>General</c:formatCode>
                <c:ptCount val="31"/>
                <c:pt idx="1">
                  <c:v>5.955977557186018E-2</c:v>
                </c:pt>
                <c:pt idx="2">
                  <c:v>5.5243849805783299E-2</c:v>
                </c:pt>
                <c:pt idx="3">
                  <c:v>4.7906776003452715E-2</c:v>
                </c:pt>
                <c:pt idx="4">
                  <c:v>4.5748813120414303E-2</c:v>
                </c:pt>
                <c:pt idx="5">
                  <c:v>4.5748813120414303E-2</c:v>
                </c:pt>
                <c:pt idx="6">
                  <c:v>4.9633146309883497E-2</c:v>
                </c:pt>
                <c:pt idx="7">
                  <c:v>5.2654294346137234E-2</c:v>
                </c:pt>
                <c:pt idx="8">
                  <c:v>5.2654294346137234E-2</c:v>
                </c:pt>
                <c:pt idx="9">
                  <c:v>5.7833405265429412E-2</c:v>
                </c:pt>
                <c:pt idx="10">
                  <c:v>5.7401812688821802E-2</c:v>
                </c:pt>
                <c:pt idx="11">
                  <c:v>6.4738886491152406E-2</c:v>
                </c:pt>
                <c:pt idx="12">
                  <c:v>6.819162710401383E-2</c:v>
                </c:pt>
                <c:pt idx="13">
                  <c:v>6.6033664220975424E-2</c:v>
                </c:pt>
                <c:pt idx="14">
                  <c:v>5.5243849805783299E-2</c:v>
                </c:pt>
                <c:pt idx="15">
                  <c:v>4.6180405697021996E-2</c:v>
                </c:pt>
                <c:pt idx="16">
                  <c:v>3.4958998705222302E-2</c:v>
                </c:pt>
                <c:pt idx="17">
                  <c:v>2.5463962019853317E-2</c:v>
                </c:pt>
                <c:pt idx="18">
                  <c:v>2.1148036253776398E-2</c:v>
                </c:pt>
                <c:pt idx="19">
                  <c:v>1.46741476046612E-2</c:v>
                </c:pt>
                <c:pt idx="20">
                  <c:v>1.2947777298230509E-2</c:v>
                </c:pt>
                <c:pt idx="21">
                  <c:v>9.9266292619766949E-3</c:v>
                </c:pt>
                <c:pt idx="22">
                  <c:v>1.7263703064307309E-3</c:v>
                </c:pt>
                <c:pt idx="23">
                  <c:v>5.1791109192921916E-3</c:v>
                </c:pt>
                <c:pt idx="24">
                  <c:v>2.5895554596460902E-3</c:v>
                </c:pt>
                <c:pt idx="25">
                  <c:v>8.6318515321536502E-4</c:v>
                </c:pt>
                <c:pt idx="26">
                  <c:v>8.6318515321536502E-4</c:v>
                </c:pt>
                <c:pt idx="27">
                  <c:v>4.3159257660768191E-4</c:v>
                </c:pt>
                <c:pt idx="28">
                  <c:v>4.3159257660768191E-4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N2 A1_0.02_50%'!$I$104</c:f>
              <c:strCache>
                <c:ptCount val="1"/>
                <c:pt idx="0">
                  <c:v>N2_REX_A1_08</c:v>
                </c:pt>
              </c:strCache>
            </c:strRef>
          </c:tx>
          <c:marker>
            <c:symbol val="none"/>
          </c:marker>
          <c:cat>
            <c:numRef>
              <c:f>'N2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1_0.02_50%'!$I$105:$I$135</c:f>
              <c:numCache>
                <c:formatCode>General</c:formatCode>
                <c:ptCount val="31"/>
                <c:pt idx="1">
                  <c:v>4.0365575019040416E-2</c:v>
                </c:pt>
                <c:pt idx="2">
                  <c:v>5.3313023610053321E-2</c:v>
                </c:pt>
                <c:pt idx="3">
                  <c:v>3.5034272658035014E-2</c:v>
                </c:pt>
                <c:pt idx="4">
                  <c:v>3.3511043412033516E-2</c:v>
                </c:pt>
                <c:pt idx="5">
                  <c:v>4.3412033511043432E-2</c:v>
                </c:pt>
                <c:pt idx="6">
                  <c:v>4.3412033511043432E-2</c:v>
                </c:pt>
                <c:pt idx="7">
                  <c:v>4.0365575019040416E-2</c:v>
                </c:pt>
                <c:pt idx="8">
                  <c:v>4.3412033511043432E-2</c:v>
                </c:pt>
                <c:pt idx="9">
                  <c:v>5.4836252856054819E-2</c:v>
                </c:pt>
                <c:pt idx="10">
                  <c:v>5.9405940594059396E-2</c:v>
                </c:pt>
                <c:pt idx="11">
                  <c:v>7.1591774562071595E-2</c:v>
                </c:pt>
                <c:pt idx="12">
                  <c:v>8.5300837776085284E-2</c:v>
                </c:pt>
                <c:pt idx="13">
                  <c:v>6.7022086824067031E-2</c:v>
                </c:pt>
                <c:pt idx="14">
                  <c:v>6.397562833206398E-2</c:v>
                </c:pt>
                <c:pt idx="15">
                  <c:v>4.8743335872048717E-2</c:v>
                </c:pt>
                <c:pt idx="16">
                  <c:v>4.18888042650419E-2</c:v>
                </c:pt>
                <c:pt idx="17">
                  <c:v>4.6458492003046518E-2</c:v>
                </c:pt>
                <c:pt idx="18">
                  <c:v>2.3610053313023599E-2</c:v>
                </c:pt>
                <c:pt idx="19">
                  <c:v>3.1226199543031199E-2</c:v>
                </c:pt>
                <c:pt idx="20">
                  <c:v>1.3709063214013705E-2</c:v>
                </c:pt>
                <c:pt idx="21">
                  <c:v>8.3777608530083876E-3</c:v>
                </c:pt>
                <c:pt idx="22">
                  <c:v>4.5696877380045717E-3</c:v>
                </c:pt>
                <c:pt idx="23">
                  <c:v>3.04645849200305E-3</c:v>
                </c:pt>
                <c:pt idx="24">
                  <c:v>3.04645849200305E-3</c:v>
                </c:pt>
                <c:pt idx="25">
                  <c:v>3.04645849200305E-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8"/>
          <c:order val="8"/>
          <c:tx>
            <c:strRef>
              <c:f>'N2 A1_0.02_50%'!$J$104</c:f>
              <c:strCache>
                <c:ptCount val="1"/>
                <c:pt idx="0">
                  <c:v>N2_REX_A1_09</c:v>
                </c:pt>
              </c:strCache>
            </c:strRef>
          </c:tx>
          <c:marker>
            <c:symbol val="none"/>
          </c:marker>
          <c:cat>
            <c:numRef>
              <c:f>'N2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1_0.02_50%'!$J$105:$J$135</c:f>
              <c:numCache>
                <c:formatCode>General</c:formatCode>
                <c:ptCount val="31"/>
                <c:pt idx="1">
                  <c:v>3.6519386834986498E-2</c:v>
                </c:pt>
                <c:pt idx="2">
                  <c:v>4.6438232642019801E-2</c:v>
                </c:pt>
                <c:pt idx="3">
                  <c:v>3.8322813345356199E-2</c:v>
                </c:pt>
                <c:pt idx="4">
                  <c:v>4.1929666366095589E-2</c:v>
                </c:pt>
                <c:pt idx="5">
                  <c:v>4.1478809738503188E-2</c:v>
                </c:pt>
                <c:pt idx="6">
                  <c:v>4.6438232642019801E-2</c:v>
                </c:pt>
                <c:pt idx="7">
                  <c:v>4.9594229035166831E-2</c:v>
                </c:pt>
                <c:pt idx="8">
                  <c:v>5.0045085662759163E-2</c:v>
                </c:pt>
                <c:pt idx="9">
                  <c:v>5.3651938683498698E-2</c:v>
                </c:pt>
                <c:pt idx="10">
                  <c:v>5.5455365193868386E-2</c:v>
                </c:pt>
                <c:pt idx="11">
                  <c:v>5.9963931469792627E-2</c:v>
                </c:pt>
                <c:pt idx="12">
                  <c:v>6.2218214607754702E-2</c:v>
                </c:pt>
                <c:pt idx="13">
                  <c:v>6.4472497745716936E-2</c:v>
                </c:pt>
                <c:pt idx="14">
                  <c:v>7.3038773669972995E-2</c:v>
                </c:pt>
                <c:pt idx="15">
                  <c:v>4.4634806131650086E-2</c:v>
                </c:pt>
                <c:pt idx="16">
                  <c:v>5.7709648331830503E-2</c:v>
                </c:pt>
                <c:pt idx="17">
                  <c:v>4.7339945897204701E-2</c:v>
                </c:pt>
                <c:pt idx="18">
                  <c:v>3.3363390441839502E-2</c:v>
                </c:pt>
                <c:pt idx="19">
                  <c:v>1.5329125338142508E-2</c:v>
                </c:pt>
                <c:pt idx="20">
                  <c:v>1.7583408476104602E-2</c:v>
                </c:pt>
                <c:pt idx="21">
                  <c:v>1.3074842200180301E-2</c:v>
                </c:pt>
                <c:pt idx="22">
                  <c:v>3.155996393146981E-3</c:v>
                </c:pt>
                <c:pt idx="23">
                  <c:v>7.66456266907124E-3</c:v>
                </c:pt>
                <c:pt idx="24">
                  <c:v>3.155996393146981E-3</c:v>
                </c:pt>
                <c:pt idx="25">
                  <c:v>1.3525698827772804E-3</c:v>
                </c:pt>
                <c:pt idx="26">
                  <c:v>0</c:v>
                </c:pt>
                <c:pt idx="27">
                  <c:v>0</c:v>
                </c:pt>
                <c:pt idx="28">
                  <c:v>4.5085662759242624E-4</c:v>
                </c:pt>
                <c:pt idx="29">
                  <c:v>4.5085662759242624E-4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N2 A1_0.02_50%'!$K$104</c:f>
              <c:strCache>
                <c:ptCount val="1"/>
                <c:pt idx="0">
                  <c:v>N2_REX_A1_10</c:v>
                </c:pt>
              </c:strCache>
            </c:strRef>
          </c:tx>
          <c:marker>
            <c:symbol val="none"/>
          </c:marker>
          <c:cat>
            <c:numRef>
              <c:f>'N2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1_0.02_50%'!$K$105:$K$135</c:f>
              <c:numCache>
                <c:formatCode>General</c:formatCode>
                <c:ptCount val="31"/>
                <c:pt idx="1">
                  <c:v>2.4709302325581401E-2</c:v>
                </c:pt>
                <c:pt idx="2">
                  <c:v>1.0901162790697704E-2</c:v>
                </c:pt>
                <c:pt idx="3">
                  <c:v>1.0901162790697704E-2</c:v>
                </c:pt>
                <c:pt idx="4">
                  <c:v>1.01744186046512E-2</c:v>
                </c:pt>
                <c:pt idx="5">
                  <c:v>7.99418604651163E-3</c:v>
                </c:pt>
                <c:pt idx="6">
                  <c:v>1.01744186046512E-2</c:v>
                </c:pt>
                <c:pt idx="7">
                  <c:v>8.7209302325581446E-3</c:v>
                </c:pt>
                <c:pt idx="8">
                  <c:v>7.99418604651163E-3</c:v>
                </c:pt>
                <c:pt idx="9">
                  <c:v>1.4534883720930199E-2</c:v>
                </c:pt>
                <c:pt idx="10">
                  <c:v>2.3982558139534881E-2</c:v>
                </c:pt>
                <c:pt idx="11">
                  <c:v>4.4331395348837226E-2</c:v>
                </c:pt>
                <c:pt idx="12">
                  <c:v>5.7412790697674417E-2</c:v>
                </c:pt>
                <c:pt idx="13">
                  <c:v>8.3575581395348847E-2</c:v>
                </c:pt>
                <c:pt idx="14">
                  <c:v>0.118459302325581</c:v>
                </c:pt>
                <c:pt idx="15">
                  <c:v>0.12136627906976702</c:v>
                </c:pt>
                <c:pt idx="16">
                  <c:v>0.106831395348837</c:v>
                </c:pt>
                <c:pt idx="17">
                  <c:v>9.3023255813953501E-2</c:v>
                </c:pt>
                <c:pt idx="18">
                  <c:v>7.340116279069768E-2</c:v>
                </c:pt>
                <c:pt idx="19">
                  <c:v>5.450581395348842E-2</c:v>
                </c:pt>
                <c:pt idx="20">
                  <c:v>3.99709302325581E-2</c:v>
                </c:pt>
                <c:pt idx="21">
                  <c:v>1.9622093023255807E-2</c:v>
                </c:pt>
                <c:pt idx="22">
                  <c:v>1.308139534883721E-2</c:v>
                </c:pt>
                <c:pt idx="23">
                  <c:v>3.6337209302325616E-3</c:v>
                </c:pt>
                <c:pt idx="24">
                  <c:v>6.5406976744186137E-3</c:v>
                </c:pt>
                <c:pt idx="25">
                  <c:v>1.45348837209302E-3</c:v>
                </c:pt>
                <c:pt idx="26">
                  <c:v>0</c:v>
                </c:pt>
                <c:pt idx="27">
                  <c:v>2.9069767441860512E-3</c:v>
                </c:pt>
                <c:pt idx="28">
                  <c:v>1.45348837209302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N2 A1_0.02_50%'!$L$104</c:f>
              <c:strCache>
                <c:ptCount val="1"/>
                <c:pt idx="0">
                  <c:v>N2_REX_A1_11</c:v>
                </c:pt>
              </c:strCache>
            </c:strRef>
          </c:tx>
          <c:marker>
            <c:symbol val="none"/>
          </c:marker>
          <c:cat>
            <c:numRef>
              <c:f>'N2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1_0.02_50%'!$L$105:$L$135</c:f>
              <c:numCache>
                <c:formatCode>General</c:formatCode>
                <c:ptCount val="31"/>
                <c:pt idx="1">
                  <c:v>6.4527142369409388E-2</c:v>
                </c:pt>
                <c:pt idx="2">
                  <c:v>6.0088767497439403E-2</c:v>
                </c:pt>
                <c:pt idx="3">
                  <c:v>6.0771594400819404E-2</c:v>
                </c:pt>
                <c:pt idx="4">
                  <c:v>6.6234209627859295E-2</c:v>
                </c:pt>
                <c:pt idx="5">
                  <c:v>7.0331171048139324E-2</c:v>
                </c:pt>
                <c:pt idx="6">
                  <c:v>6.828269033799933E-2</c:v>
                </c:pt>
                <c:pt idx="7">
                  <c:v>7.1013997951519345E-2</c:v>
                </c:pt>
                <c:pt idx="8">
                  <c:v>6.6917036531239329E-2</c:v>
                </c:pt>
                <c:pt idx="9">
                  <c:v>5.2577671560259498E-2</c:v>
                </c:pt>
                <c:pt idx="10">
                  <c:v>5.6333219528849419E-2</c:v>
                </c:pt>
                <c:pt idx="11">
                  <c:v>5.4626152270399478E-2</c:v>
                </c:pt>
                <c:pt idx="12">
                  <c:v>5.1894844656879498E-2</c:v>
                </c:pt>
                <c:pt idx="13">
                  <c:v>3.7555479685899611E-2</c:v>
                </c:pt>
                <c:pt idx="14">
                  <c:v>3.3117104813929717E-2</c:v>
                </c:pt>
                <c:pt idx="15">
                  <c:v>3.4482758620689717E-2</c:v>
                </c:pt>
                <c:pt idx="16">
                  <c:v>2.9702970297029712E-2</c:v>
                </c:pt>
                <c:pt idx="17">
                  <c:v>2.5606008876749714E-2</c:v>
                </c:pt>
                <c:pt idx="18">
                  <c:v>1.3656538067599901E-2</c:v>
                </c:pt>
                <c:pt idx="19">
                  <c:v>1.6046432229429801E-2</c:v>
                </c:pt>
                <c:pt idx="20">
                  <c:v>1.0242403550699898E-2</c:v>
                </c:pt>
                <c:pt idx="21">
                  <c:v>3.4141345168999726E-3</c:v>
                </c:pt>
                <c:pt idx="22">
                  <c:v>3.7555479685899618E-3</c:v>
                </c:pt>
                <c:pt idx="23">
                  <c:v>3.0727210652099711E-3</c:v>
                </c:pt>
                <c:pt idx="24">
                  <c:v>2.3898941618299809E-3</c:v>
                </c:pt>
                <c:pt idx="25">
                  <c:v>1.0242403550699899E-3</c:v>
                </c:pt>
                <c:pt idx="26">
                  <c:v>0</c:v>
                </c:pt>
                <c:pt idx="27">
                  <c:v>0</c:v>
                </c:pt>
                <c:pt idx="28">
                  <c:v>3.4141345168999725E-4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N2 A1_0.02_50%'!$M$104</c:f>
              <c:strCache>
                <c:ptCount val="1"/>
                <c:pt idx="0">
                  <c:v>N2_REX_A1_12</c:v>
                </c:pt>
              </c:strCache>
            </c:strRef>
          </c:tx>
          <c:marker>
            <c:symbol val="none"/>
          </c:marker>
          <c:cat>
            <c:numRef>
              <c:f>'N2 A1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1_0.02_50%'!$M$105:$M$135</c:f>
              <c:numCache>
                <c:formatCode>General</c:formatCode>
                <c:ptCount val="31"/>
                <c:pt idx="1">
                  <c:v>5.1377513030528718E-2</c:v>
                </c:pt>
                <c:pt idx="2">
                  <c:v>5.2494415487714101E-2</c:v>
                </c:pt>
                <c:pt idx="3">
                  <c:v>4.8026805658972486E-2</c:v>
                </c:pt>
                <c:pt idx="4">
                  <c:v>5.3983618763961301E-2</c:v>
                </c:pt>
                <c:pt idx="5">
                  <c:v>5.9195830230826529E-2</c:v>
                </c:pt>
                <c:pt idx="6">
                  <c:v>5.3239017125837715E-2</c:v>
                </c:pt>
                <c:pt idx="7">
                  <c:v>6.6641846612062461E-2</c:v>
                </c:pt>
                <c:pt idx="8">
                  <c:v>5.6962025316455701E-2</c:v>
                </c:pt>
                <c:pt idx="9">
                  <c:v>5.2494415487714101E-2</c:v>
                </c:pt>
                <c:pt idx="10">
                  <c:v>6.1429635145197316E-2</c:v>
                </c:pt>
                <c:pt idx="11">
                  <c:v>5.4728220402084901E-2</c:v>
                </c:pt>
                <c:pt idx="12">
                  <c:v>5.9940431868950116E-2</c:v>
                </c:pt>
                <c:pt idx="13">
                  <c:v>5.9195830230826529E-2</c:v>
                </c:pt>
                <c:pt idx="14">
                  <c:v>4.9516008935219728E-2</c:v>
                </c:pt>
                <c:pt idx="15">
                  <c:v>4.095309009679822E-2</c:v>
                </c:pt>
                <c:pt idx="16">
                  <c:v>3.5740878629933012E-2</c:v>
                </c:pt>
                <c:pt idx="17">
                  <c:v>3.2390171258376801E-2</c:v>
                </c:pt>
                <c:pt idx="18">
                  <c:v>2.047654504839911E-2</c:v>
                </c:pt>
                <c:pt idx="19">
                  <c:v>1.8615040953090099E-2</c:v>
                </c:pt>
                <c:pt idx="20">
                  <c:v>1.22859270290395E-2</c:v>
                </c:pt>
                <c:pt idx="21">
                  <c:v>9.6798212956068531E-3</c:v>
                </c:pt>
                <c:pt idx="22">
                  <c:v>4.0953090096798222E-3</c:v>
                </c:pt>
                <c:pt idx="23">
                  <c:v>4.0953090096798222E-3</c:v>
                </c:pt>
                <c:pt idx="24">
                  <c:v>3.3507073715562208E-3</c:v>
                </c:pt>
                <c:pt idx="25">
                  <c:v>1.4892032762472101E-3</c:v>
                </c:pt>
                <c:pt idx="26">
                  <c:v>7.4460163812360442E-4</c:v>
                </c:pt>
                <c:pt idx="27">
                  <c:v>3.723008190618021E-4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marker val="1"/>
        <c:axId val="162759040"/>
        <c:axId val="162760576"/>
      </c:lineChart>
      <c:catAx>
        <c:axId val="162759040"/>
        <c:scaling>
          <c:orientation val="minMax"/>
        </c:scaling>
        <c:axPos val="b"/>
        <c:numFmt formatCode="0.0_ " sourceLinked="1"/>
        <c:tickLblPos val="nextTo"/>
        <c:crossAx val="162760576"/>
        <c:crosses val="autoZero"/>
        <c:auto val="1"/>
        <c:lblAlgn val="ctr"/>
        <c:lblOffset val="100"/>
        <c:tickLblSkip val="5"/>
        <c:tickMarkSkip val="5"/>
      </c:catAx>
      <c:valAx>
        <c:axId val="162760576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2759040"/>
        <c:crosses val="autoZero"/>
        <c:crossBetween val="between"/>
      </c:valAx>
    </c:plotArea>
    <c:plotVisOnly val="1"/>
  </c:chart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400"/>
            </a:pPr>
            <a:r>
              <a:rPr lang="en-US" altLang="ja-JP" sz="1400" b="0">
                <a:latin typeface="Arial" pitchFamily="34" charset="0"/>
                <a:cs typeface="Arial" pitchFamily="34" charset="0"/>
              </a:rPr>
              <a:t>w.t. A5</a:t>
            </a:r>
            <a:endParaRPr lang="ja-JP" altLang="en-US" sz="1400" b="0">
              <a:latin typeface="Arial" pitchFamily="34" charset="0"/>
              <a:cs typeface="Arial" pitchFamily="34" charset="0"/>
            </a:endParaRPr>
          </a:p>
        </c:rich>
      </c:tx>
      <c:layout/>
    </c:title>
    <c:plotArea>
      <c:layout/>
      <c:lineChart>
        <c:grouping val="standard"/>
        <c:ser>
          <c:idx val="0"/>
          <c:order val="0"/>
          <c:tx>
            <c:strRef>
              <c:f>'N2 A5_0.02_50%'!$B$104</c:f>
              <c:strCache>
                <c:ptCount val="1"/>
                <c:pt idx="0">
                  <c:v>N2_A5_001</c:v>
                </c:pt>
              </c:strCache>
            </c:strRef>
          </c:tx>
          <c:marker>
            <c:symbol val="none"/>
          </c:marker>
          <c:cat>
            <c:numRef>
              <c:f>'N2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5_0.02_50%'!$B$105:$B$135</c:f>
              <c:numCache>
                <c:formatCode>General</c:formatCode>
                <c:ptCount val="31"/>
                <c:pt idx="1">
                  <c:v>4.7957371225577312E-2</c:v>
                </c:pt>
                <c:pt idx="2">
                  <c:v>3.9076376554174119E-2</c:v>
                </c:pt>
                <c:pt idx="3">
                  <c:v>3.1971580817051502E-2</c:v>
                </c:pt>
                <c:pt idx="4">
                  <c:v>2.3090586145648281E-2</c:v>
                </c:pt>
                <c:pt idx="5">
                  <c:v>1.9538188277087011E-2</c:v>
                </c:pt>
                <c:pt idx="6">
                  <c:v>1.7761989342806407E-2</c:v>
                </c:pt>
                <c:pt idx="7">
                  <c:v>1.7761989342806407E-2</c:v>
                </c:pt>
                <c:pt idx="8">
                  <c:v>1.59857904085258E-2</c:v>
                </c:pt>
                <c:pt idx="9">
                  <c:v>3.1971580817051502E-2</c:v>
                </c:pt>
                <c:pt idx="10">
                  <c:v>4.4404973357016035E-2</c:v>
                </c:pt>
                <c:pt idx="11">
                  <c:v>3.9076376554174119E-2</c:v>
                </c:pt>
                <c:pt idx="12">
                  <c:v>3.1971580817051502E-2</c:v>
                </c:pt>
                <c:pt idx="13">
                  <c:v>4.4404973357016035E-2</c:v>
                </c:pt>
                <c:pt idx="14">
                  <c:v>4.2628774422735313E-2</c:v>
                </c:pt>
                <c:pt idx="15">
                  <c:v>3.5523978685612814E-2</c:v>
                </c:pt>
                <c:pt idx="16">
                  <c:v>4.7957371225577312E-2</c:v>
                </c:pt>
                <c:pt idx="17">
                  <c:v>5.6838365896980499E-2</c:v>
                </c:pt>
                <c:pt idx="18">
                  <c:v>2.3090586145648281E-2</c:v>
                </c:pt>
                <c:pt idx="19">
                  <c:v>3.5523978685612814E-2</c:v>
                </c:pt>
                <c:pt idx="20">
                  <c:v>3.7300177619893418E-2</c:v>
                </c:pt>
                <c:pt idx="21">
                  <c:v>2.486678507992901E-2</c:v>
                </c:pt>
                <c:pt idx="22">
                  <c:v>2.6642984014209607E-2</c:v>
                </c:pt>
                <c:pt idx="23">
                  <c:v>1.0657193605683801E-2</c:v>
                </c:pt>
                <c:pt idx="24">
                  <c:v>1.2433392539964498E-2</c:v>
                </c:pt>
                <c:pt idx="25">
                  <c:v>5.3285968028419202E-3</c:v>
                </c:pt>
                <c:pt idx="26">
                  <c:v>5.3285968028419202E-3</c:v>
                </c:pt>
                <c:pt idx="27">
                  <c:v>1.42095914742451E-2</c:v>
                </c:pt>
                <c:pt idx="28">
                  <c:v>3.5523978685612816E-3</c:v>
                </c:pt>
                <c:pt idx="29">
                  <c:v>3.5523978685612816E-3</c:v>
                </c:pt>
                <c:pt idx="30">
                  <c:v>7.1047957371225597E-3</c:v>
                </c:pt>
              </c:numCache>
            </c:numRef>
          </c:val>
        </c:ser>
        <c:ser>
          <c:idx val="1"/>
          <c:order val="1"/>
          <c:tx>
            <c:strRef>
              <c:f>'N2 A5_0.02_50%'!$C$104</c:f>
              <c:strCache>
                <c:ptCount val="1"/>
                <c:pt idx="0">
                  <c:v>N2_A5_003</c:v>
                </c:pt>
              </c:strCache>
            </c:strRef>
          </c:tx>
          <c:marker>
            <c:symbol val="none"/>
          </c:marker>
          <c:cat>
            <c:numRef>
              <c:f>'N2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5_0.02_50%'!$C$105:$C$135</c:f>
              <c:numCache>
                <c:formatCode>General</c:formatCode>
                <c:ptCount val="31"/>
                <c:pt idx="1">
                  <c:v>0.15025906735751299</c:v>
                </c:pt>
                <c:pt idx="2">
                  <c:v>9.3264248704663266E-2</c:v>
                </c:pt>
                <c:pt idx="3">
                  <c:v>5.1813471502590719E-2</c:v>
                </c:pt>
                <c:pt idx="4">
                  <c:v>3.6269430051813517E-2</c:v>
                </c:pt>
                <c:pt idx="5">
                  <c:v>3.2383419689119231E-2</c:v>
                </c:pt>
                <c:pt idx="6">
                  <c:v>2.3316062176165799E-2</c:v>
                </c:pt>
                <c:pt idx="7">
                  <c:v>2.2020725388601E-2</c:v>
                </c:pt>
                <c:pt idx="8">
                  <c:v>1.4248704663212406E-2</c:v>
                </c:pt>
                <c:pt idx="9">
                  <c:v>1.4248704663212406E-2</c:v>
                </c:pt>
                <c:pt idx="10">
                  <c:v>1.9430051813471506E-2</c:v>
                </c:pt>
                <c:pt idx="11">
                  <c:v>2.3316062176165799E-2</c:v>
                </c:pt>
                <c:pt idx="12">
                  <c:v>2.4611398963730602E-2</c:v>
                </c:pt>
                <c:pt idx="13">
                  <c:v>1.5544041450777204E-2</c:v>
                </c:pt>
                <c:pt idx="14">
                  <c:v>2.9792746113989601E-2</c:v>
                </c:pt>
                <c:pt idx="15">
                  <c:v>2.0725388601036301E-2</c:v>
                </c:pt>
                <c:pt idx="16">
                  <c:v>1.81347150259067E-2</c:v>
                </c:pt>
                <c:pt idx="17">
                  <c:v>1.4248704663212406E-2</c:v>
                </c:pt>
                <c:pt idx="18">
                  <c:v>6.4766839378238355E-3</c:v>
                </c:pt>
                <c:pt idx="19">
                  <c:v>5.1813471502590736E-3</c:v>
                </c:pt>
                <c:pt idx="20">
                  <c:v>5.1813471502590736E-3</c:v>
                </c:pt>
                <c:pt idx="21">
                  <c:v>5.1813471502590736E-3</c:v>
                </c:pt>
                <c:pt idx="22">
                  <c:v>5.1813471502590736E-3</c:v>
                </c:pt>
                <c:pt idx="23">
                  <c:v>3.8860103626943017E-3</c:v>
                </c:pt>
                <c:pt idx="24">
                  <c:v>6.4766839378238355E-3</c:v>
                </c:pt>
                <c:pt idx="25">
                  <c:v>3.8860103626943017E-3</c:v>
                </c:pt>
                <c:pt idx="26">
                  <c:v>1.2953367875647699E-3</c:v>
                </c:pt>
                <c:pt idx="27">
                  <c:v>1.2953367875647699E-3</c:v>
                </c:pt>
                <c:pt idx="28">
                  <c:v>3.8860103626943017E-3</c:v>
                </c:pt>
                <c:pt idx="29">
                  <c:v>1.2953367875647699E-3</c:v>
                </c:pt>
                <c:pt idx="30">
                  <c:v>0</c:v>
                </c:pt>
              </c:numCache>
            </c:numRef>
          </c:val>
        </c:ser>
        <c:ser>
          <c:idx val="2"/>
          <c:order val="2"/>
          <c:tx>
            <c:strRef>
              <c:f>'N2 A5_0.02_50%'!$D$104</c:f>
              <c:strCache>
                <c:ptCount val="1"/>
                <c:pt idx="0">
                  <c:v>N2_A5_004</c:v>
                </c:pt>
              </c:strCache>
            </c:strRef>
          </c:tx>
          <c:marker>
            <c:symbol val="none"/>
          </c:marker>
          <c:cat>
            <c:numRef>
              <c:f>'N2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5_0.02_50%'!$D$105:$D$135</c:f>
              <c:numCache>
                <c:formatCode>General</c:formatCode>
                <c:ptCount val="31"/>
                <c:pt idx="1">
                  <c:v>3.7617554858934199E-2</c:v>
                </c:pt>
                <c:pt idx="2">
                  <c:v>2.8213166144200601E-2</c:v>
                </c:pt>
                <c:pt idx="3">
                  <c:v>2.6645768025078415E-2</c:v>
                </c:pt>
                <c:pt idx="4">
                  <c:v>2.5078369905956108E-2</c:v>
                </c:pt>
                <c:pt idx="5">
                  <c:v>1.56739811912226E-2</c:v>
                </c:pt>
                <c:pt idx="6">
                  <c:v>1.2539184952978099E-2</c:v>
                </c:pt>
                <c:pt idx="7">
                  <c:v>1.41065830721003E-2</c:v>
                </c:pt>
                <c:pt idx="8">
                  <c:v>7.8369905956112828E-3</c:v>
                </c:pt>
                <c:pt idx="9">
                  <c:v>9.4043887147335394E-3</c:v>
                </c:pt>
                <c:pt idx="10">
                  <c:v>1.7241379310344803E-2</c:v>
                </c:pt>
                <c:pt idx="11">
                  <c:v>2.1943573667711609E-2</c:v>
                </c:pt>
                <c:pt idx="12">
                  <c:v>3.4482758620689717E-2</c:v>
                </c:pt>
                <c:pt idx="13">
                  <c:v>4.0752351097178716E-2</c:v>
                </c:pt>
                <c:pt idx="14">
                  <c:v>6.73981191222571E-2</c:v>
                </c:pt>
                <c:pt idx="15">
                  <c:v>7.2100313479623798E-2</c:v>
                </c:pt>
                <c:pt idx="16">
                  <c:v>8.1504702194357473E-2</c:v>
                </c:pt>
                <c:pt idx="17">
                  <c:v>7.5235109717868301E-2</c:v>
                </c:pt>
                <c:pt idx="18">
                  <c:v>5.7993730407523536E-2</c:v>
                </c:pt>
                <c:pt idx="19">
                  <c:v>3.9184952978056402E-2</c:v>
                </c:pt>
                <c:pt idx="20">
                  <c:v>4.3887147335423198E-2</c:v>
                </c:pt>
                <c:pt idx="21">
                  <c:v>2.3510971786833899E-2</c:v>
                </c:pt>
                <c:pt idx="22">
                  <c:v>3.1347962382445117E-2</c:v>
                </c:pt>
                <c:pt idx="23">
                  <c:v>1.7241379310344803E-2</c:v>
                </c:pt>
                <c:pt idx="24">
                  <c:v>1.2539184952978099E-2</c:v>
                </c:pt>
                <c:pt idx="25">
                  <c:v>9.4043887147335394E-3</c:v>
                </c:pt>
                <c:pt idx="26">
                  <c:v>4.7021943573667697E-3</c:v>
                </c:pt>
                <c:pt idx="27">
                  <c:v>3.1347962382445118E-3</c:v>
                </c:pt>
                <c:pt idx="28">
                  <c:v>3.1347962382445118E-3</c:v>
                </c:pt>
                <c:pt idx="29">
                  <c:v>6.2695924764890314E-3</c:v>
                </c:pt>
                <c:pt idx="30">
                  <c:v>3.1347962382445118E-3</c:v>
                </c:pt>
              </c:numCache>
            </c:numRef>
          </c:val>
        </c:ser>
        <c:ser>
          <c:idx val="3"/>
          <c:order val="3"/>
          <c:tx>
            <c:strRef>
              <c:f>'N2 A5_0.02_50%'!$E$104</c:f>
              <c:strCache>
                <c:ptCount val="1"/>
                <c:pt idx="0">
                  <c:v>N2_A5_40_30_01</c:v>
                </c:pt>
              </c:strCache>
            </c:strRef>
          </c:tx>
          <c:marker>
            <c:symbol val="none"/>
          </c:marker>
          <c:cat>
            <c:numRef>
              <c:f>'N2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5_0.02_50%'!$E$105:$E$135</c:f>
              <c:numCache>
                <c:formatCode>General</c:formatCode>
                <c:ptCount val="31"/>
                <c:pt idx="1">
                  <c:v>0</c:v>
                </c:pt>
                <c:pt idx="2">
                  <c:v>2.6548672566371709E-2</c:v>
                </c:pt>
                <c:pt idx="3">
                  <c:v>0</c:v>
                </c:pt>
                <c:pt idx="4">
                  <c:v>8.8495575221238972E-3</c:v>
                </c:pt>
                <c:pt idx="5">
                  <c:v>2.6548672566371709E-2</c:v>
                </c:pt>
                <c:pt idx="6">
                  <c:v>8.8495575221238972E-3</c:v>
                </c:pt>
                <c:pt idx="7">
                  <c:v>8.8495575221238972E-3</c:v>
                </c:pt>
                <c:pt idx="8">
                  <c:v>8.8495575221238972E-3</c:v>
                </c:pt>
                <c:pt idx="9">
                  <c:v>3.5398230088495602E-2</c:v>
                </c:pt>
                <c:pt idx="10">
                  <c:v>3.5398230088495602E-2</c:v>
                </c:pt>
                <c:pt idx="11">
                  <c:v>4.4247787610619496E-2</c:v>
                </c:pt>
                <c:pt idx="12">
                  <c:v>5.3097345132743404E-2</c:v>
                </c:pt>
                <c:pt idx="13">
                  <c:v>9.7345132743362803E-2</c:v>
                </c:pt>
                <c:pt idx="14">
                  <c:v>0.15929203539823011</c:v>
                </c:pt>
                <c:pt idx="15">
                  <c:v>0.10619469026548706</c:v>
                </c:pt>
                <c:pt idx="16">
                  <c:v>6.1946902654867297E-2</c:v>
                </c:pt>
                <c:pt idx="17">
                  <c:v>0.11504424778761109</c:v>
                </c:pt>
                <c:pt idx="18">
                  <c:v>3.5398230088495602E-2</c:v>
                </c:pt>
                <c:pt idx="19">
                  <c:v>1.7699115044247801E-2</c:v>
                </c:pt>
                <c:pt idx="20">
                  <c:v>2.6548672566371709E-2</c:v>
                </c:pt>
                <c:pt idx="21">
                  <c:v>1.7699115044247801E-2</c:v>
                </c:pt>
                <c:pt idx="22">
                  <c:v>8.8495575221238972E-3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4"/>
          <c:order val="4"/>
          <c:tx>
            <c:strRef>
              <c:f>'N2 A5_0.02_50%'!$F$104</c:f>
              <c:strCache>
                <c:ptCount val="1"/>
                <c:pt idx="0">
                  <c:v>N2_A5_40_30_02</c:v>
                </c:pt>
              </c:strCache>
            </c:strRef>
          </c:tx>
          <c:marker>
            <c:symbol val="none"/>
          </c:marker>
          <c:cat>
            <c:numRef>
              <c:f>'N2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5_0.02_50%'!$F$105:$F$135</c:f>
              <c:numCache>
                <c:formatCode>General</c:formatCode>
                <c:ptCount val="31"/>
                <c:pt idx="1">
                  <c:v>6.1728395061728399E-2</c:v>
                </c:pt>
                <c:pt idx="2">
                  <c:v>6.5255731922398627E-2</c:v>
                </c:pt>
                <c:pt idx="3">
                  <c:v>4.5855379188712485E-2</c:v>
                </c:pt>
                <c:pt idx="4">
                  <c:v>2.6455026455026509E-2</c:v>
                </c:pt>
                <c:pt idx="5">
                  <c:v>2.8218694885361599E-2</c:v>
                </c:pt>
                <c:pt idx="6">
                  <c:v>5.2910052910052898E-3</c:v>
                </c:pt>
                <c:pt idx="7">
                  <c:v>1.2345679012345704E-2</c:v>
                </c:pt>
                <c:pt idx="8">
                  <c:v>1.0582010582010601E-2</c:v>
                </c:pt>
                <c:pt idx="9">
                  <c:v>5.2910052910052898E-3</c:v>
                </c:pt>
                <c:pt idx="10">
                  <c:v>1.2345679012345704E-2</c:v>
                </c:pt>
                <c:pt idx="11">
                  <c:v>1.9400352733686108E-2</c:v>
                </c:pt>
                <c:pt idx="12">
                  <c:v>3.8800705467372111E-2</c:v>
                </c:pt>
                <c:pt idx="13">
                  <c:v>6.1728395061728399E-2</c:v>
                </c:pt>
                <c:pt idx="14">
                  <c:v>5.9964726631393329E-2</c:v>
                </c:pt>
                <c:pt idx="15">
                  <c:v>7.5837742504409195E-2</c:v>
                </c:pt>
                <c:pt idx="16">
                  <c:v>6.3492063492063502E-2</c:v>
                </c:pt>
                <c:pt idx="17">
                  <c:v>4.7619047619047616E-2</c:v>
                </c:pt>
                <c:pt idx="18">
                  <c:v>2.9982363315696599E-2</c:v>
                </c:pt>
                <c:pt idx="19">
                  <c:v>2.6455026455026509E-2</c:v>
                </c:pt>
                <c:pt idx="20">
                  <c:v>1.2345679012345704E-2</c:v>
                </c:pt>
                <c:pt idx="21">
                  <c:v>8.8183421516754758E-3</c:v>
                </c:pt>
                <c:pt idx="22">
                  <c:v>8.8183421516754758E-3</c:v>
                </c:pt>
                <c:pt idx="23">
                  <c:v>5.2910052910052898E-3</c:v>
                </c:pt>
                <c:pt idx="24">
                  <c:v>0</c:v>
                </c:pt>
                <c:pt idx="25">
                  <c:v>3.5273368606701921E-3</c:v>
                </c:pt>
                <c:pt idx="26">
                  <c:v>1.7636684303351004E-3</c:v>
                </c:pt>
                <c:pt idx="27">
                  <c:v>1.7636684303351004E-3</c:v>
                </c:pt>
                <c:pt idx="28">
                  <c:v>1.7636684303351004E-3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5"/>
          <c:order val="5"/>
          <c:tx>
            <c:strRef>
              <c:f>'N2 A5_0.02_50%'!$G$104</c:f>
              <c:strCache>
                <c:ptCount val="1"/>
                <c:pt idx="0">
                  <c:v>N2_A5_40_30_04</c:v>
                </c:pt>
              </c:strCache>
            </c:strRef>
          </c:tx>
          <c:marker>
            <c:symbol val="none"/>
          </c:marker>
          <c:cat>
            <c:numRef>
              <c:f>'N2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5_0.02_50%'!$G$105:$G$135</c:f>
              <c:numCache>
                <c:formatCode>General</c:formatCode>
                <c:ptCount val="31"/>
                <c:pt idx="1">
                  <c:v>7.3937153419593393E-2</c:v>
                </c:pt>
                <c:pt idx="2">
                  <c:v>6.8391866913123933E-2</c:v>
                </c:pt>
                <c:pt idx="3">
                  <c:v>4.8059149722735686E-2</c:v>
                </c:pt>
                <c:pt idx="4">
                  <c:v>1.8484288354898303E-2</c:v>
                </c:pt>
                <c:pt idx="5">
                  <c:v>2.0332717190388198E-2</c:v>
                </c:pt>
                <c:pt idx="6">
                  <c:v>1.4787430683918705E-2</c:v>
                </c:pt>
                <c:pt idx="7">
                  <c:v>1.8484288354898303E-2</c:v>
                </c:pt>
                <c:pt idx="8">
                  <c:v>1.6635859519408509E-2</c:v>
                </c:pt>
                <c:pt idx="9">
                  <c:v>2.2181146025878017E-2</c:v>
                </c:pt>
                <c:pt idx="10">
                  <c:v>2.95748613678373E-2</c:v>
                </c:pt>
                <c:pt idx="11">
                  <c:v>2.95748613678373E-2</c:v>
                </c:pt>
                <c:pt idx="12">
                  <c:v>4.6210720887245815E-2</c:v>
                </c:pt>
                <c:pt idx="13">
                  <c:v>6.2846580406654307E-2</c:v>
                </c:pt>
                <c:pt idx="14">
                  <c:v>6.2846580406654307E-2</c:v>
                </c:pt>
                <c:pt idx="15">
                  <c:v>7.3937153419593393E-2</c:v>
                </c:pt>
                <c:pt idx="16">
                  <c:v>0.10351201478743099</c:v>
                </c:pt>
                <c:pt idx="17">
                  <c:v>4.2513863216266198E-2</c:v>
                </c:pt>
                <c:pt idx="18">
                  <c:v>3.8817005545286498E-2</c:v>
                </c:pt>
                <c:pt idx="19">
                  <c:v>1.4787430683918705E-2</c:v>
                </c:pt>
                <c:pt idx="20">
                  <c:v>3.6968576709796698E-3</c:v>
                </c:pt>
                <c:pt idx="21">
                  <c:v>7.3937153419593319E-3</c:v>
                </c:pt>
                <c:pt idx="22">
                  <c:v>1.8484288354898301E-3</c:v>
                </c:pt>
                <c:pt idx="23">
                  <c:v>1.8484288354898301E-3</c:v>
                </c:pt>
                <c:pt idx="24">
                  <c:v>1.8484288354898301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1.8484288354898301E-3</c:v>
                </c:pt>
              </c:numCache>
            </c:numRef>
          </c:val>
        </c:ser>
        <c:ser>
          <c:idx val="6"/>
          <c:order val="6"/>
          <c:tx>
            <c:strRef>
              <c:f>'N2 A5_0.02_50%'!$H$104</c:f>
              <c:strCache>
                <c:ptCount val="1"/>
                <c:pt idx="0">
                  <c:v>N2_REX_A5_01</c:v>
                </c:pt>
              </c:strCache>
            </c:strRef>
          </c:tx>
          <c:marker>
            <c:symbol val="none"/>
          </c:marker>
          <c:cat>
            <c:numRef>
              <c:f>'N2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5_0.02_50%'!$H$105:$H$135</c:f>
              <c:numCache>
                <c:formatCode>General</c:formatCode>
                <c:ptCount val="31"/>
                <c:pt idx="1">
                  <c:v>0.109053497942387</c:v>
                </c:pt>
                <c:pt idx="2">
                  <c:v>6.3786008230452704E-2</c:v>
                </c:pt>
                <c:pt idx="3">
                  <c:v>3.4979423868312799E-2</c:v>
                </c:pt>
                <c:pt idx="4">
                  <c:v>3.2921810699588501E-2</c:v>
                </c:pt>
                <c:pt idx="5">
                  <c:v>1.2345679012345704E-2</c:v>
                </c:pt>
                <c:pt idx="6">
                  <c:v>1.2345679012345704E-2</c:v>
                </c:pt>
                <c:pt idx="7">
                  <c:v>1.8518518518518507E-2</c:v>
                </c:pt>
                <c:pt idx="8">
                  <c:v>1.6460905349794205E-2</c:v>
                </c:pt>
                <c:pt idx="9">
                  <c:v>1.2345679012345704E-2</c:v>
                </c:pt>
                <c:pt idx="10">
                  <c:v>2.4691358024691409E-2</c:v>
                </c:pt>
                <c:pt idx="11">
                  <c:v>1.6460905349794205E-2</c:v>
                </c:pt>
                <c:pt idx="12">
                  <c:v>3.7037037037037014E-2</c:v>
                </c:pt>
                <c:pt idx="13">
                  <c:v>6.3786008230452704E-2</c:v>
                </c:pt>
                <c:pt idx="14">
                  <c:v>6.7901234567901231E-2</c:v>
                </c:pt>
                <c:pt idx="15">
                  <c:v>4.1152263374485583E-2</c:v>
                </c:pt>
                <c:pt idx="16">
                  <c:v>3.4979423868312799E-2</c:v>
                </c:pt>
                <c:pt idx="17">
                  <c:v>2.8806584362139891E-2</c:v>
                </c:pt>
                <c:pt idx="18">
                  <c:v>1.0288065843621401E-2</c:v>
                </c:pt>
                <c:pt idx="19">
                  <c:v>4.11522633744856E-3</c:v>
                </c:pt>
                <c:pt idx="20">
                  <c:v>6.17283950617284E-3</c:v>
                </c:pt>
                <c:pt idx="21">
                  <c:v>8.23045267489712E-3</c:v>
                </c:pt>
                <c:pt idx="22">
                  <c:v>6.17283950617284E-3</c:v>
                </c:pt>
                <c:pt idx="23">
                  <c:v>2.05761316872428E-3</c:v>
                </c:pt>
                <c:pt idx="24">
                  <c:v>0</c:v>
                </c:pt>
                <c:pt idx="25">
                  <c:v>2.05761316872428E-3</c:v>
                </c:pt>
                <c:pt idx="26">
                  <c:v>0</c:v>
                </c:pt>
                <c:pt idx="27">
                  <c:v>6.17283950617284E-3</c:v>
                </c:pt>
                <c:pt idx="28">
                  <c:v>0</c:v>
                </c:pt>
                <c:pt idx="29">
                  <c:v>2.05761316872428E-3</c:v>
                </c:pt>
                <c:pt idx="30">
                  <c:v>0</c:v>
                </c:pt>
              </c:numCache>
            </c:numRef>
          </c:val>
        </c:ser>
        <c:ser>
          <c:idx val="7"/>
          <c:order val="7"/>
          <c:tx>
            <c:strRef>
              <c:f>'N2 A5_0.02_50%'!$I$104</c:f>
              <c:strCache>
                <c:ptCount val="1"/>
                <c:pt idx="0">
                  <c:v>N2_REX_A5_02</c:v>
                </c:pt>
              </c:strCache>
            </c:strRef>
          </c:tx>
          <c:marker>
            <c:symbol val="none"/>
          </c:marker>
          <c:cat>
            <c:numRef>
              <c:f>'N2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5_0.02_50%'!$I$105:$I$135</c:f>
              <c:numCache>
                <c:formatCode>General</c:formatCode>
                <c:ptCount val="31"/>
                <c:pt idx="1">
                  <c:v>2.2238163558106209E-2</c:v>
                </c:pt>
                <c:pt idx="2">
                  <c:v>3.1563845050215214E-2</c:v>
                </c:pt>
                <c:pt idx="3">
                  <c:v>2.0086083213773299E-2</c:v>
                </c:pt>
                <c:pt idx="4">
                  <c:v>1.0043041606886701E-2</c:v>
                </c:pt>
                <c:pt idx="5">
                  <c:v>1.0043041606886701E-2</c:v>
                </c:pt>
                <c:pt idx="6">
                  <c:v>9.3256814921090503E-3</c:v>
                </c:pt>
                <c:pt idx="7">
                  <c:v>1.2912482065997101E-2</c:v>
                </c:pt>
                <c:pt idx="8">
                  <c:v>1.9368723098995708E-2</c:v>
                </c:pt>
                <c:pt idx="9">
                  <c:v>2.0086083213773299E-2</c:v>
                </c:pt>
                <c:pt idx="10">
                  <c:v>5.3802008608321419E-2</c:v>
                </c:pt>
                <c:pt idx="11">
                  <c:v>5.8823529411764698E-2</c:v>
                </c:pt>
                <c:pt idx="12">
                  <c:v>9.1822094691535197E-2</c:v>
                </c:pt>
                <c:pt idx="13">
                  <c:v>0.12482065997130604</c:v>
                </c:pt>
                <c:pt idx="14">
                  <c:v>0.12051649928264002</c:v>
                </c:pt>
                <c:pt idx="15">
                  <c:v>9.8995695839311296E-2</c:v>
                </c:pt>
                <c:pt idx="16">
                  <c:v>7.4605451936872333E-2</c:v>
                </c:pt>
                <c:pt idx="17">
                  <c:v>5.0932568149210912E-2</c:v>
                </c:pt>
                <c:pt idx="18">
                  <c:v>3.3715925394548103E-2</c:v>
                </c:pt>
                <c:pt idx="19">
                  <c:v>1.79340028694405E-2</c:v>
                </c:pt>
                <c:pt idx="20">
                  <c:v>1.0760401721664304E-2</c:v>
                </c:pt>
                <c:pt idx="21">
                  <c:v>5.7388809182209498E-3</c:v>
                </c:pt>
                <c:pt idx="22">
                  <c:v>5.0215208034433316E-3</c:v>
                </c:pt>
                <c:pt idx="23">
                  <c:v>1.4347202295552401E-3</c:v>
                </c:pt>
                <c:pt idx="24">
                  <c:v>2.1520803443328602E-3</c:v>
                </c:pt>
                <c:pt idx="25">
                  <c:v>0</c:v>
                </c:pt>
                <c:pt idx="26">
                  <c:v>7.173601147776184E-4</c:v>
                </c:pt>
                <c:pt idx="27">
                  <c:v>1.4347202295552401E-3</c:v>
                </c:pt>
                <c:pt idx="28">
                  <c:v>7.173601147776184E-4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8"/>
          <c:order val="8"/>
          <c:tx>
            <c:strRef>
              <c:f>'N2 A5_0.02_50%'!$J$104</c:f>
              <c:strCache>
                <c:ptCount val="1"/>
                <c:pt idx="0">
                  <c:v>N2_REX_A5_04</c:v>
                </c:pt>
              </c:strCache>
            </c:strRef>
          </c:tx>
          <c:marker>
            <c:symbol val="none"/>
          </c:marker>
          <c:cat>
            <c:numRef>
              <c:f>'N2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5_0.02_50%'!$J$105:$J$135</c:f>
              <c:numCache>
                <c:formatCode>General</c:formatCode>
                <c:ptCount val="31"/>
                <c:pt idx="1">
                  <c:v>9.7701149425287431E-2</c:v>
                </c:pt>
                <c:pt idx="2">
                  <c:v>7.931034482758624E-2</c:v>
                </c:pt>
                <c:pt idx="3">
                  <c:v>4.8275862068965461E-2</c:v>
                </c:pt>
                <c:pt idx="4">
                  <c:v>4.13793103448276E-2</c:v>
                </c:pt>
                <c:pt idx="5">
                  <c:v>2.2988505747126402E-2</c:v>
                </c:pt>
                <c:pt idx="6">
                  <c:v>1.6091954022988502E-2</c:v>
                </c:pt>
                <c:pt idx="7">
                  <c:v>1.6091954022988502E-2</c:v>
                </c:pt>
                <c:pt idx="8">
                  <c:v>1.7241379310344803E-2</c:v>
                </c:pt>
                <c:pt idx="9">
                  <c:v>2.1839080459770118E-2</c:v>
                </c:pt>
                <c:pt idx="10">
                  <c:v>3.2183908045977011E-2</c:v>
                </c:pt>
                <c:pt idx="11">
                  <c:v>3.2183908045977011E-2</c:v>
                </c:pt>
                <c:pt idx="12">
                  <c:v>5.4022988505747119E-2</c:v>
                </c:pt>
                <c:pt idx="13">
                  <c:v>5.8620689655172399E-2</c:v>
                </c:pt>
                <c:pt idx="14">
                  <c:v>7.931034482758624E-2</c:v>
                </c:pt>
                <c:pt idx="15">
                  <c:v>5.8620689655172399E-2</c:v>
                </c:pt>
                <c:pt idx="16">
                  <c:v>4.5977011494252887E-2</c:v>
                </c:pt>
                <c:pt idx="17">
                  <c:v>2.4137931034482793E-2</c:v>
                </c:pt>
                <c:pt idx="18">
                  <c:v>2.4137931034482793E-2</c:v>
                </c:pt>
                <c:pt idx="19">
                  <c:v>1.1494252873563199E-2</c:v>
                </c:pt>
                <c:pt idx="20">
                  <c:v>5.7471264367816117E-3</c:v>
                </c:pt>
                <c:pt idx="21">
                  <c:v>8.0459770114942528E-3</c:v>
                </c:pt>
                <c:pt idx="22">
                  <c:v>6.8965517241379318E-3</c:v>
                </c:pt>
                <c:pt idx="23">
                  <c:v>1.1494252873563199E-3</c:v>
                </c:pt>
                <c:pt idx="24">
                  <c:v>3.4482758620689707E-3</c:v>
                </c:pt>
                <c:pt idx="25">
                  <c:v>2.2988505747126402E-3</c:v>
                </c:pt>
                <c:pt idx="26">
                  <c:v>1.1494252873563199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9"/>
          <c:order val="9"/>
          <c:tx>
            <c:strRef>
              <c:f>'N2 A5_0.02_50%'!$K$104</c:f>
              <c:strCache>
                <c:ptCount val="1"/>
                <c:pt idx="0">
                  <c:v>N2_REX_A5_05</c:v>
                </c:pt>
              </c:strCache>
            </c:strRef>
          </c:tx>
          <c:marker>
            <c:symbol val="none"/>
          </c:marker>
          <c:cat>
            <c:numRef>
              <c:f>'N2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5_0.02_50%'!$K$105:$K$135</c:f>
              <c:numCache>
                <c:formatCode>General</c:formatCode>
                <c:ptCount val="31"/>
                <c:pt idx="1">
                  <c:v>5.5045871559633003E-2</c:v>
                </c:pt>
                <c:pt idx="2">
                  <c:v>5.5045871559633003E-2</c:v>
                </c:pt>
                <c:pt idx="3">
                  <c:v>7.3394495412844027E-2</c:v>
                </c:pt>
                <c:pt idx="4">
                  <c:v>5.5045871559633003E-2</c:v>
                </c:pt>
                <c:pt idx="5">
                  <c:v>2.7522935779816515E-2</c:v>
                </c:pt>
                <c:pt idx="6">
                  <c:v>2.7522935779816515E-2</c:v>
                </c:pt>
                <c:pt idx="7">
                  <c:v>1.8348623853211E-2</c:v>
                </c:pt>
                <c:pt idx="8">
                  <c:v>9.1743119266055103E-3</c:v>
                </c:pt>
                <c:pt idx="9">
                  <c:v>1.8348623853211E-2</c:v>
                </c:pt>
                <c:pt idx="10">
                  <c:v>2.7522935779816515E-2</c:v>
                </c:pt>
                <c:pt idx="11">
                  <c:v>5.5045871559633003E-2</c:v>
                </c:pt>
                <c:pt idx="12">
                  <c:v>8.256880733944956E-2</c:v>
                </c:pt>
                <c:pt idx="13">
                  <c:v>7.3394495412844027E-2</c:v>
                </c:pt>
                <c:pt idx="14">
                  <c:v>0.10091743119266094</c:v>
                </c:pt>
                <c:pt idx="15">
                  <c:v>0.11926605504587204</c:v>
                </c:pt>
                <c:pt idx="16">
                  <c:v>3.6697247706422027E-2</c:v>
                </c:pt>
                <c:pt idx="17">
                  <c:v>3.6697247706422027E-2</c:v>
                </c:pt>
                <c:pt idx="18">
                  <c:v>2.7522935779816515E-2</c:v>
                </c:pt>
                <c:pt idx="19">
                  <c:v>0</c:v>
                </c:pt>
                <c:pt idx="20">
                  <c:v>0</c:v>
                </c:pt>
                <c:pt idx="21">
                  <c:v>9.1743119266055103E-3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0"/>
          <c:order val="10"/>
          <c:tx>
            <c:strRef>
              <c:f>'N2 A5_0.02_50%'!$L$104</c:f>
              <c:strCache>
                <c:ptCount val="1"/>
                <c:pt idx="0">
                  <c:v>N2_REX_A5_06</c:v>
                </c:pt>
              </c:strCache>
            </c:strRef>
          </c:tx>
          <c:marker>
            <c:symbol val="none"/>
          </c:marker>
          <c:cat>
            <c:numRef>
              <c:f>'N2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5_0.02_50%'!$L$105:$L$135</c:f>
              <c:numCache>
                <c:formatCode>General</c:formatCode>
                <c:ptCount val="31"/>
                <c:pt idx="1">
                  <c:v>0.111455108359133</c:v>
                </c:pt>
                <c:pt idx="2">
                  <c:v>8.4365325077399467E-2</c:v>
                </c:pt>
                <c:pt idx="3">
                  <c:v>6.9659442724458204E-2</c:v>
                </c:pt>
                <c:pt idx="4">
                  <c:v>4.4117647058823539E-2</c:v>
                </c:pt>
                <c:pt idx="5">
                  <c:v>3.0185758513931907E-2</c:v>
                </c:pt>
                <c:pt idx="6">
                  <c:v>3.09597523219814E-2</c:v>
                </c:pt>
                <c:pt idx="7">
                  <c:v>2.8637770897832801E-2</c:v>
                </c:pt>
                <c:pt idx="8">
                  <c:v>2.32198142414861E-2</c:v>
                </c:pt>
                <c:pt idx="9">
                  <c:v>3.1733746130031E-2</c:v>
                </c:pt>
                <c:pt idx="10">
                  <c:v>3.2507739938080503E-2</c:v>
                </c:pt>
                <c:pt idx="11">
                  <c:v>3.8699690402476811E-2</c:v>
                </c:pt>
                <c:pt idx="12">
                  <c:v>3.7151702786377722E-2</c:v>
                </c:pt>
                <c:pt idx="13">
                  <c:v>4.3343653250774002E-2</c:v>
                </c:pt>
                <c:pt idx="14">
                  <c:v>4.8761609907120737E-2</c:v>
                </c:pt>
                <c:pt idx="15">
                  <c:v>3.5603715170278619E-2</c:v>
                </c:pt>
                <c:pt idx="16">
                  <c:v>3.3281733746130006E-2</c:v>
                </c:pt>
                <c:pt idx="17">
                  <c:v>2.554179566563471E-2</c:v>
                </c:pt>
                <c:pt idx="18">
                  <c:v>2.0897832817337508E-2</c:v>
                </c:pt>
                <c:pt idx="19">
                  <c:v>1.2383900928792598E-2</c:v>
                </c:pt>
                <c:pt idx="20">
                  <c:v>5.4179566563467476E-3</c:v>
                </c:pt>
                <c:pt idx="21">
                  <c:v>1.54798761609907E-3</c:v>
                </c:pt>
                <c:pt idx="22">
                  <c:v>1.54798761609907E-3</c:v>
                </c:pt>
                <c:pt idx="23">
                  <c:v>2.3219814241486102E-3</c:v>
                </c:pt>
                <c:pt idx="24">
                  <c:v>2.3219814241486102E-3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7.7399380804953641E-4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1"/>
          <c:order val="11"/>
          <c:tx>
            <c:strRef>
              <c:f>'N2 A5_0.02_50%'!$M$104</c:f>
              <c:strCache>
                <c:ptCount val="1"/>
                <c:pt idx="0">
                  <c:v>N2_REX_A5_08</c:v>
                </c:pt>
              </c:strCache>
            </c:strRef>
          </c:tx>
          <c:marker>
            <c:symbol val="none"/>
          </c:marker>
          <c:cat>
            <c:numRef>
              <c:f>'N2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5_0.02_50%'!$M$105:$M$135</c:f>
              <c:numCache>
                <c:formatCode>General</c:formatCode>
                <c:ptCount val="31"/>
                <c:pt idx="1">
                  <c:v>0.10483870967741903</c:v>
                </c:pt>
                <c:pt idx="2">
                  <c:v>0.109879032258065</c:v>
                </c:pt>
                <c:pt idx="3">
                  <c:v>7.157258064516131E-2</c:v>
                </c:pt>
                <c:pt idx="4">
                  <c:v>4.7379032258064495E-2</c:v>
                </c:pt>
                <c:pt idx="5">
                  <c:v>3.5282258064516112E-2</c:v>
                </c:pt>
                <c:pt idx="6">
                  <c:v>3.8306451612903199E-2</c:v>
                </c:pt>
                <c:pt idx="7">
                  <c:v>2.6209677419354819E-2</c:v>
                </c:pt>
                <c:pt idx="8">
                  <c:v>2.9233870967741913E-2</c:v>
                </c:pt>
                <c:pt idx="9">
                  <c:v>3.0241935483871028E-2</c:v>
                </c:pt>
                <c:pt idx="10">
                  <c:v>3.3266129032258084E-2</c:v>
                </c:pt>
                <c:pt idx="11">
                  <c:v>3.4274193548387101E-2</c:v>
                </c:pt>
                <c:pt idx="12">
                  <c:v>4.3346774193548418E-2</c:v>
                </c:pt>
                <c:pt idx="13">
                  <c:v>3.8306451612903199E-2</c:v>
                </c:pt>
                <c:pt idx="14">
                  <c:v>3.7298387096774216E-2</c:v>
                </c:pt>
                <c:pt idx="15">
                  <c:v>4.13306451612903E-2</c:v>
                </c:pt>
                <c:pt idx="16">
                  <c:v>3.3266129032258084E-2</c:v>
                </c:pt>
                <c:pt idx="17">
                  <c:v>2.11693548387097E-2</c:v>
                </c:pt>
                <c:pt idx="18">
                  <c:v>1.5120967741935505E-2</c:v>
                </c:pt>
                <c:pt idx="19">
                  <c:v>2.21774193548387E-2</c:v>
                </c:pt>
                <c:pt idx="20">
                  <c:v>8.0645161290322648E-3</c:v>
                </c:pt>
                <c:pt idx="21">
                  <c:v>7.0564516129032334E-3</c:v>
                </c:pt>
                <c:pt idx="22">
                  <c:v>3.0241935483871028E-3</c:v>
                </c:pt>
                <c:pt idx="23">
                  <c:v>1.0080645161290301E-3</c:v>
                </c:pt>
                <c:pt idx="24">
                  <c:v>0</c:v>
                </c:pt>
                <c:pt idx="25">
                  <c:v>1.0080645161290301E-3</c:v>
                </c:pt>
                <c:pt idx="26">
                  <c:v>3.0241935483871028E-3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ser>
          <c:idx val="12"/>
          <c:order val="12"/>
          <c:tx>
            <c:strRef>
              <c:f>'N2 A5_0.02_50%'!$N$104</c:f>
              <c:strCache>
                <c:ptCount val="1"/>
                <c:pt idx="0">
                  <c:v>N2_REX_A5_09</c:v>
                </c:pt>
              </c:strCache>
            </c:strRef>
          </c:tx>
          <c:marker>
            <c:symbol val="none"/>
          </c:marker>
          <c:cat>
            <c:numRef>
              <c:f>'N2 A5_0.02_50%'!$A$105:$A$135</c:f>
              <c:numCache>
                <c:formatCode>0.0_ </c:formatCode>
                <c:ptCount val="31"/>
                <c:pt idx="0">
                  <c:v>0</c:v>
                </c:pt>
                <c:pt idx="1">
                  <c:v>2.0000000000000007E-2</c:v>
                </c:pt>
                <c:pt idx="2">
                  <c:v>4.0000000000000015E-2</c:v>
                </c:pt>
                <c:pt idx="3">
                  <c:v>6.0000000000000019E-2</c:v>
                </c:pt>
                <c:pt idx="4">
                  <c:v>8.0000000000000029E-2</c:v>
                </c:pt>
                <c:pt idx="5">
                  <c:v>0.1</c:v>
                </c:pt>
                <c:pt idx="6">
                  <c:v>0.12000000000000002</c:v>
                </c:pt>
                <c:pt idx="7">
                  <c:v>0.14000000000000001</c:v>
                </c:pt>
                <c:pt idx="8">
                  <c:v>0.16</c:v>
                </c:pt>
                <c:pt idx="9">
                  <c:v>0.18000000000000005</c:v>
                </c:pt>
                <c:pt idx="10">
                  <c:v>0.2</c:v>
                </c:pt>
                <c:pt idx="11">
                  <c:v>0.22</c:v>
                </c:pt>
                <c:pt idx="12">
                  <c:v>0.24000000000000005</c:v>
                </c:pt>
                <c:pt idx="13">
                  <c:v>0.26</c:v>
                </c:pt>
                <c:pt idx="14">
                  <c:v>0.28000000000000008</c:v>
                </c:pt>
                <c:pt idx="15">
                  <c:v>0.3000000000000001</c:v>
                </c:pt>
                <c:pt idx="16">
                  <c:v>0.32000000000000012</c:v>
                </c:pt>
                <c:pt idx="17">
                  <c:v>0.34</c:v>
                </c:pt>
                <c:pt idx="18">
                  <c:v>0.3600000000000001</c:v>
                </c:pt>
                <c:pt idx="19">
                  <c:v>0.38000000000000012</c:v>
                </c:pt>
                <c:pt idx="20">
                  <c:v>0.4</c:v>
                </c:pt>
                <c:pt idx="21">
                  <c:v>0.4200000000000001</c:v>
                </c:pt>
                <c:pt idx="22">
                  <c:v>0.44</c:v>
                </c:pt>
                <c:pt idx="23">
                  <c:v>0.46</c:v>
                </c:pt>
                <c:pt idx="24">
                  <c:v>0.48000000000000009</c:v>
                </c:pt>
                <c:pt idx="25">
                  <c:v>0.5</c:v>
                </c:pt>
                <c:pt idx="26">
                  <c:v>0.52</c:v>
                </c:pt>
                <c:pt idx="27">
                  <c:v>0.54</c:v>
                </c:pt>
                <c:pt idx="28">
                  <c:v>0.56000000000000005</c:v>
                </c:pt>
                <c:pt idx="29">
                  <c:v>0.58000000000000007</c:v>
                </c:pt>
                <c:pt idx="30">
                  <c:v>0.6000000000000002</c:v>
                </c:pt>
              </c:numCache>
            </c:numRef>
          </c:cat>
          <c:val>
            <c:numRef>
              <c:f>'N2 A5_0.02_50%'!$N$105:$N$135</c:f>
              <c:numCache>
                <c:formatCode>General</c:formatCode>
                <c:ptCount val="31"/>
                <c:pt idx="1">
                  <c:v>7.3170731707317097E-2</c:v>
                </c:pt>
                <c:pt idx="2">
                  <c:v>3.6585365853658514E-2</c:v>
                </c:pt>
                <c:pt idx="3">
                  <c:v>8.5365853658536633E-2</c:v>
                </c:pt>
                <c:pt idx="4">
                  <c:v>2.4390243902439001E-2</c:v>
                </c:pt>
                <c:pt idx="5">
                  <c:v>7.3170731707317097E-2</c:v>
                </c:pt>
                <c:pt idx="6">
                  <c:v>3.6585365853658514E-2</c:v>
                </c:pt>
                <c:pt idx="7">
                  <c:v>6.0975609756097601E-2</c:v>
                </c:pt>
                <c:pt idx="8">
                  <c:v>1.21951219512195E-2</c:v>
                </c:pt>
                <c:pt idx="9">
                  <c:v>2.4390243902439001E-2</c:v>
                </c:pt>
                <c:pt idx="10">
                  <c:v>3.6585365853658514E-2</c:v>
                </c:pt>
                <c:pt idx="11">
                  <c:v>2.4390243902439001E-2</c:v>
                </c:pt>
                <c:pt idx="12">
                  <c:v>7.3170731707317097E-2</c:v>
                </c:pt>
                <c:pt idx="13">
                  <c:v>4.8780487804878127E-2</c:v>
                </c:pt>
                <c:pt idx="14">
                  <c:v>4.8780487804878127E-2</c:v>
                </c:pt>
                <c:pt idx="15">
                  <c:v>6.0975609756097601E-2</c:v>
                </c:pt>
                <c:pt idx="16">
                  <c:v>2.4390243902439001E-2</c:v>
                </c:pt>
                <c:pt idx="17">
                  <c:v>4.8780487804878127E-2</c:v>
                </c:pt>
                <c:pt idx="18">
                  <c:v>1.21951219512195E-2</c:v>
                </c:pt>
                <c:pt idx="19">
                  <c:v>3.6585365853658514E-2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</c:numCache>
            </c:numRef>
          </c:val>
        </c:ser>
        <c:marker val="1"/>
        <c:axId val="164932224"/>
        <c:axId val="164966784"/>
      </c:lineChart>
      <c:catAx>
        <c:axId val="164932224"/>
        <c:scaling>
          <c:orientation val="minMax"/>
        </c:scaling>
        <c:axPos val="b"/>
        <c:numFmt formatCode="0.0_ " sourceLinked="1"/>
        <c:tickLblPos val="nextTo"/>
        <c:crossAx val="164966784"/>
        <c:crosses val="autoZero"/>
        <c:auto val="1"/>
        <c:lblAlgn val="ctr"/>
        <c:lblOffset val="100"/>
        <c:tickLblSkip val="5"/>
        <c:tickMarkSkip val="5"/>
      </c:catAx>
      <c:valAx>
        <c:axId val="164966784"/>
        <c:scaling>
          <c:orientation val="minMax"/>
          <c:max val="0.2"/>
        </c:scaling>
        <c:axPos val="l"/>
        <c:majorGridlines/>
        <c:numFmt formatCode="#,##0.00_);\(#,##0.00\)" sourceLinked="0"/>
        <c:tickLblPos val="nextTo"/>
        <c:crossAx val="164932224"/>
        <c:crosses val="autoZero"/>
        <c:crossBetween val="between"/>
      </c:valAx>
    </c:plotArea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97AE8C-D7AC-453F-8C3F-3FD7DBC98E29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E010C9-5305-4FF3-8F6A-A68D8146892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E010C9-5305-4FF3-8F6A-A68D81468921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7A6D6-A2F6-46AD-9704-08FE20E35EB4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C4298-BEDA-4266-B502-185E3944F345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7A6D6-A2F6-46AD-9704-08FE20E35EB4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C4298-BEDA-4266-B502-185E3944F345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7A6D6-A2F6-46AD-9704-08FE20E35EB4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C4298-BEDA-4266-B502-185E3944F345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7A6D6-A2F6-46AD-9704-08FE20E35EB4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C4298-BEDA-4266-B502-185E3944F345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7A6D6-A2F6-46AD-9704-08FE20E35EB4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C4298-BEDA-4266-B502-185E3944F345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7A6D6-A2F6-46AD-9704-08FE20E35EB4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C4298-BEDA-4266-B502-185E3944F345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7A6D6-A2F6-46AD-9704-08FE20E35EB4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C4298-BEDA-4266-B502-185E3944F345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7A6D6-A2F6-46AD-9704-08FE20E35EB4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C4298-BEDA-4266-B502-185E3944F345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7A6D6-A2F6-46AD-9704-08FE20E35EB4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C4298-BEDA-4266-B502-185E3944F345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7A6D6-A2F6-46AD-9704-08FE20E35EB4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C4298-BEDA-4266-B502-185E3944F345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7A6D6-A2F6-46AD-9704-08FE20E35EB4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C4298-BEDA-4266-B502-185E3944F345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7A6D6-A2F6-46AD-9704-08FE20E35EB4}" type="datetimeFigureOut">
              <a:rPr kumimoji="1" lang="ja-JP" altLang="en-US" smtClean="0"/>
              <a:pPr/>
              <a:t>2013/2/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8C4298-BEDA-4266-B502-185E3944F345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12" Type="http://schemas.openxmlformats.org/officeDocument/2006/relationships/chart" Target="../charts/chart10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5" Type="http://schemas.openxmlformats.org/officeDocument/2006/relationships/chart" Target="../charts/chart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7.xml"/><Relationship Id="rId3" Type="http://schemas.openxmlformats.org/officeDocument/2006/relationships/chart" Target="../charts/chart12.xml"/><Relationship Id="rId7" Type="http://schemas.openxmlformats.org/officeDocument/2006/relationships/chart" Target="../charts/chart16.xml"/><Relationship Id="rId12" Type="http://schemas.openxmlformats.org/officeDocument/2006/relationships/chart" Target="../charts/chart21.xml"/><Relationship Id="rId2" Type="http://schemas.openxmlformats.org/officeDocument/2006/relationships/chart" Target="../charts/chart1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5.xml"/><Relationship Id="rId11" Type="http://schemas.openxmlformats.org/officeDocument/2006/relationships/chart" Target="../charts/chart20.xml"/><Relationship Id="rId5" Type="http://schemas.openxmlformats.org/officeDocument/2006/relationships/chart" Target="../charts/chart14.xml"/><Relationship Id="rId10" Type="http://schemas.openxmlformats.org/officeDocument/2006/relationships/chart" Target="../charts/chart19.xml"/><Relationship Id="rId4" Type="http://schemas.openxmlformats.org/officeDocument/2006/relationships/chart" Target="../charts/chart13.xml"/><Relationship Id="rId9" Type="http://schemas.openxmlformats.org/officeDocument/2006/relationships/chart" Target="../charts/chart18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8.xml"/><Relationship Id="rId3" Type="http://schemas.openxmlformats.org/officeDocument/2006/relationships/chart" Target="../charts/chart23.xml"/><Relationship Id="rId7" Type="http://schemas.openxmlformats.org/officeDocument/2006/relationships/chart" Target="../charts/chart27.xml"/><Relationship Id="rId2" Type="http://schemas.openxmlformats.org/officeDocument/2006/relationships/chart" Target="../charts/chart2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6.xml"/><Relationship Id="rId5" Type="http://schemas.openxmlformats.org/officeDocument/2006/relationships/chart" Target="../charts/chart25.xml"/><Relationship Id="rId10" Type="http://schemas.openxmlformats.org/officeDocument/2006/relationships/chart" Target="../charts/chart30.xml"/><Relationship Id="rId4" Type="http://schemas.openxmlformats.org/officeDocument/2006/relationships/chart" Target="../charts/chart24.xml"/><Relationship Id="rId9" Type="http://schemas.openxmlformats.org/officeDocument/2006/relationships/chart" Target="../charts/chart2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" name="グラフ 26"/>
          <p:cNvGraphicFramePr/>
          <p:nvPr/>
        </p:nvGraphicFramePr>
        <p:xfrm>
          <a:off x="4581128" y="4737100"/>
          <a:ext cx="2088530" cy="2088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6" name="グラフ 25"/>
          <p:cNvGraphicFramePr/>
          <p:nvPr/>
        </p:nvGraphicFramePr>
        <p:xfrm>
          <a:off x="260350" y="6969224"/>
          <a:ext cx="2088530" cy="2088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グラフ 23"/>
          <p:cNvGraphicFramePr/>
          <p:nvPr/>
        </p:nvGraphicFramePr>
        <p:xfrm>
          <a:off x="2420888" y="4737100"/>
          <a:ext cx="2088530" cy="2088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3" name="グラフ 22"/>
          <p:cNvGraphicFramePr/>
          <p:nvPr/>
        </p:nvGraphicFramePr>
        <p:xfrm>
          <a:off x="260350" y="4736976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4" name="グラフ 13"/>
          <p:cNvGraphicFramePr/>
          <p:nvPr/>
        </p:nvGraphicFramePr>
        <p:xfrm>
          <a:off x="260350" y="2504728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3" name="グラフ 12"/>
          <p:cNvGraphicFramePr/>
          <p:nvPr/>
        </p:nvGraphicFramePr>
        <p:xfrm>
          <a:off x="4581128" y="273050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2" name="グラフ 11"/>
          <p:cNvGraphicFramePr/>
          <p:nvPr/>
        </p:nvGraphicFramePr>
        <p:xfrm>
          <a:off x="260350" y="273050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1" name="グラフ 10"/>
          <p:cNvGraphicFramePr/>
          <p:nvPr/>
        </p:nvGraphicFramePr>
        <p:xfrm>
          <a:off x="2420888" y="273050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5" name="グラフ 14"/>
          <p:cNvGraphicFramePr/>
          <p:nvPr/>
        </p:nvGraphicFramePr>
        <p:xfrm>
          <a:off x="2420888" y="2504728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28" name="グラフ 27"/>
          <p:cNvGraphicFramePr/>
          <p:nvPr/>
        </p:nvGraphicFramePr>
        <p:xfrm>
          <a:off x="2420888" y="6969224"/>
          <a:ext cx="2088530" cy="2088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" name="グラフ 29"/>
          <p:cNvGraphicFramePr/>
          <p:nvPr/>
        </p:nvGraphicFramePr>
        <p:xfrm>
          <a:off x="4581128" y="6969224"/>
          <a:ext cx="2088530" cy="2088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9" name="グラフ 28"/>
          <p:cNvGraphicFramePr/>
          <p:nvPr/>
        </p:nvGraphicFramePr>
        <p:xfrm>
          <a:off x="2420888" y="6969224"/>
          <a:ext cx="2088530" cy="2088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8" name="グラフ 27"/>
          <p:cNvGraphicFramePr/>
          <p:nvPr/>
        </p:nvGraphicFramePr>
        <p:xfrm>
          <a:off x="260350" y="6969224"/>
          <a:ext cx="2088530" cy="2088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7" name="グラフ 26"/>
          <p:cNvGraphicFramePr/>
          <p:nvPr/>
        </p:nvGraphicFramePr>
        <p:xfrm>
          <a:off x="4581128" y="4737100"/>
          <a:ext cx="2088530" cy="2088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6" name="グラフ 25"/>
          <p:cNvGraphicFramePr/>
          <p:nvPr/>
        </p:nvGraphicFramePr>
        <p:xfrm>
          <a:off x="2420888" y="4737100"/>
          <a:ext cx="2088530" cy="2088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5" name="グラフ 24"/>
          <p:cNvGraphicFramePr/>
          <p:nvPr/>
        </p:nvGraphicFramePr>
        <p:xfrm>
          <a:off x="260350" y="4737100"/>
          <a:ext cx="2088530" cy="2088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3" name="グラフ 22"/>
          <p:cNvGraphicFramePr/>
          <p:nvPr/>
        </p:nvGraphicFramePr>
        <p:xfrm>
          <a:off x="260350" y="2504728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0" name="グラフ 19"/>
          <p:cNvGraphicFramePr/>
          <p:nvPr/>
        </p:nvGraphicFramePr>
        <p:xfrm>
          <a:off x="260350" y="273050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9" name="グラフ 18"/>
          <p:cNvGraphicFramePr/>
          <p:nvPr/>
        </p:nvGraphicFramePr>
        <p:xfrm>
          <a:off x="4581128" y="273050"/>
          <a:ext cx="2088530" cy="20881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1" name="グラフ 20"/>
          <p:cNvGraphicFramePr/>
          <p:nvPr/>
        </p:nvGraphicFramePr>
        <p:xfrm>
          <a:off x="2420888" y="273050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24" name="グラフ 23"/>
          <p:cNvGraphicFramePr/>
          <p:nvPr/>
        </p:nvGraphicFramePr>
        <p:xfrm>
          <a:off x="2420888" y="2504728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" name="グラフ 26"/>
          <p:cNvGraphicFramePr/>
          <p:nvPr/>
        </p:nvGraphicFramePr>
        <p:xfrm>
          <a:off x="4581128" y="4736976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6" name="グラフ 25"/>
          <p:cNvGraphicFramePr/>
          <p:nvPr/>
        </p:nvGraphicFramePr>
        <p:xfrm>
          <a:off x="2420888" y="4736976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5" name="グラフ 24"/>
          <p:cNvGraphicFramePr/>
          <p:nvPr/>
        </p:nvGraphicFramePr>
        <p:xfrm>
          <a:off x="260350" y="4736976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グラフ 23"/>
          <p:cNvGraphicFramePr/>
          <p:nvPr/>
        </p:nvGraphicFramePr>
        <p:xfrm>
          <a:off x="4581128" y="2504728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3" name="グラフ 22"/>
          <p:cNvGraphicFramePr/>
          <p:nvPr/>
        </p:nvGraphicFramePr>
        <p:xfrm>
          <a:off x="2420888" y="2504728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2" name="グラフ 21"/>
          <p:cNvGraphicFramePr/>
          <p:nvPr/>
        </p:nvGraphicFramePr>
        <p:xfrm>
          <a:off x="260350" y="2504728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1" name="グラフ 20"/>
          <p:cNvGraphicFramePr/>
          <p:nvPr/>
        </p:nvGraphicFramePr>
        <p:xfrm>
          <a:off x="2420888" y="273050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0" name="グラフ 19"/>
          <p:cNvGraphicFramePr/>
          <p:nvPr/>
        </p:nvGraphicFramePr>
        <p:xfrm>
          <a:off x="4581128" y="273050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3" name="グラフ 12"/>
          <p:cNvGraphicFramePr/>
          <p:nvPr/>
        </p:nvGraphicFramePr>
        <p:xfrm>
          <a:off x="260350" y="273050"/>
          <a:ext cx="2088530" cy="2087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E8C78F21B45EF479F5CA629480F6AA8" ma:contentTypeVersion="7" ma:contentTypeDescription="Create a new document." ma:contentTypeScope="" ma:versionID="f671af6365ac414c1b586ce32e882c71">
  <xsd:schema xmlns:xsd="http://www.w3.org/2001/XMLSchema" xmlns:p="http://schemas.microsoft.com/office/2006/metadata/properties" xmlns:ns2="e0c5cd90-fa0d-4391-bd91-b400daf014db" targetNamespace="http://schemas.microsoft.com/office/2006/metadata/properties" ma:root="true" ma:fieldsID="9d3cfad310efeeb70853a035efe4057c" ns2:_="">
    <xsd:import namespace="e0c5cd90-fa0d-4391-bd91-b400daf014db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e0c5cd90-fa0d-4391-bd91-b400daf014db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e0c5cd90-fa0d-4391-bd91-b400daf014db">PPTX</FileFormat>
    <DocumentId xmlns="e0c5cd90-fa0d-4391-bd91-b400daf014db">Presentation 3.PPTX</DocumentId>
    <IsDeleted xmlns="e0c5cd90-fa0d-4391-bd91-b400daf014db">false</IsDeleted>
    <DocumentType xmlns="e0c5cd90-fa0d-4391-bd91-b400daf014db">Presentation</DocumentType>
    <Checked_x0020_Out_x0020_To xmlns="e0c5cd90-fa0d-4391-bd91-b400daf014db">
      <UserInfo>
        <DisplayName/>
        <AccountId xsi:nil="true"/>
        <AccountType/>
      </UserInfo>
    </Checked_x0020_Out_x0020_To>
    <TitleName xmlns="e0c5cd90-fa0d-4391-bd91-b400daf014db">Presentation 3.PPTX</TitleName>
    <StageName xmlns="e0c5cd90-fa0d-4391-bd91-b400daf014db" xsi:nil="true"/>
  </documentManagement>
</p:properties>
</file>

<file path=customXml/itemProps1.xml><?xml version="1.0" encoding="utf-8"?>
<ds:datastoreItem xmlns:ds="http://schemas.openxmlformats.org/officeDocument/2006/customXml" ds:itemID="{3DC1052D-C1C6-400F-BE7B-746E7BE3F548}"/>
</file>

<file path=customXml/itemProps2.xml><?xml version="1.0" encoding="utf-8"?>
<ds:datastoreItem xmlns:ds="http://schemas.openxmlformats.org/officeDocument/2006/customXml" ds:itemID="{E0EF8D52-A9B2-4941-A7A9-2CF64C8B8E0B}"/>
</file>

<file path=customXml/itemProps3.xml><?xml version="1.0" encoding="utf-8"?>
<ds:datastoreItem xmlns:ds="http://schemas.openxmlformats.org/officeDocument/2006/customXml" ds:itemID="{5C5F66FC-0070-41C6-8DF0-7A6FB0259457}"/>
</file>

<file path=docProps/app.xml><?xml version="1.0" encoding="utf-8"?>
<Properties xmlns="http://schemas.openxmlformats.org/officeDocument/2006/extended-properties" xmlns:vt="http://schemas.openxmlformats.org/officeDocument/2006/docPropsVTypes">
  <TotalTime>3965</TotalTime>
  <Words>66</Words>
  <Application>Microsoft Office PowerPoint</Application>
  <PresentationFormat>A4 210 x 297 mm</PresentationFormat>
  <Paragraphs>31</Paragraphs>
  <Slides>3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4" baseType="lpstr">
      <vt:lpstr>Office テーマ</vt:lpstr>
      <vt:lpstr>スライド 1</vt:lpstr>
      <vt:lpstr>スライド 2</vt:lpstr>
      <vt:lpstr>スライド 3</vt:lpstr>
    </vt:vector>
  </TitlesOfParts>
  <Company>UNITCOM P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furu</dc:creator>
  <cp:lastModifiedBy>Shingai</cp:lastModifiedBy>
  <cp:revision>95</cp:revision>
  <dcterms:created xsi:type="dcterms:W3CDTF">2013-01-18T00:51:31Z</dcterms:created>
  <dcterms:modified xsi:type="dcterms:W3CDTF">2013-02-07T06:59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E8C78F21B45EF479F5CA629480F6AA8</vt:lpwstr>
  </property>
</Properties>
</file>